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99" r:id="rId2"/>
    <p:sldId id="295" r:id="rId3"/>
    <p:sldId id="301" r:id="rId4"/>
    <p:sldId id="296" r:id="rId5"/>
    <p:sldId id="303" r:id="rId6"/>
    <p:sldId id="297" r:id="rId7"/>
    <p:sldId id="300" r:id="rId8"/>
    <p:sldId id="302" r:id="rId9"/>
    <p:sldId id="298" r:id="rId10"/>
  </p:sldIdLst>
  <p:sldSz cx="6858000" cy="9144000" type="screen4x3"/>
  <p:notesSz cx="6797675" cy="9926638"/>
  <p:defaultTextStyle>
    <a:defPPr>
      <a:defRPr lang="it-IT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33"/>
    <a:srgbClr val="0033CC"/>
    <a:srgbClr val="66FF33"/>
    <a:srgbClr val="CC00CC"/>
    <a:srgbClr val="00FF00"/>
    <a:srgbClr val="78A888"/>
    <a:srgbClr val="4CD45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516B166-1222-4F61-B848-148F91576E1C}" v="6" dt="2022-08-03T13:31:20.49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Stile medio 2 - Colore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Stile medio 2 - Colore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073A0DAA-6AF3-43AB-8588-CEC1D06C72B9}" styleName="Stile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75DCB02-9BB8-47FD-8907-85C794F793BA}" styleName="Stile con tema 1 - Colore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220" autoAdjust="0"/>
    <p:restoredTop sz="96357" autoAdjust="0"/>
  </p:normalViewPr>
  <p:slideViewPr>
    <p:cSldViewPr>
      <p:cViewPr>
        <p:scale>
          <a:sx n="150" d="100"/>
          <a:sy n="150" d="100"/>
        </p:scale>
        <p:origin x="1296" y="-3780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ilippo Acconcia" userId="844af49c-a8a0-47ac-a7dd-14a44b60cd18" providerId="ADAL" clId="{DB596444-B095-4C7A-8C02-1FB2A86092C2}"/>
    <pc:docChg chg="undo redo custSel modSld">
      <pc:chgData name="Filippo Acconcia" userId="844af49c-a8a0-47ac-a7dd-14a44b60cd18" providerId="ADAL" clId="{DB596444-B095-4C7A-8C02-1FB2A86092C2}" dt="2022-07-26T12:50:29.419" v="667" actId="1038"/>
      <pc:docMkLst>
        <pc:docMk/>
      </pc:docMkLst>
      <pc:sldChg chg="addSp delSp modSp mod">
        <pc:chgData name="Filippo Acconcia" userId="844af49c-a8a0-47ac-a7dd-14a44b60cd18" providerId="ADAL" clId="{DB596444-B095-4C7A-8C02-1FB2A86092C2}" dt="2022-07-26T12:50:29.419" v="667" actId="1038"/>
        <pc:sldMkLst>
          <pc:docMk/>
          <pc:sldMk cId="2620120220" sldId="296"/>
        </pc:sldMkLst>
        <pc:spChg chg="mod">
          <ac:chgData name="Filippo Acconcia" userId="844af49c-a8a0-47ac-a7dd-14a44b60cd18" providerId="ADAL" clId="{DB596444-B095-4C7A-8C02-1FB2A86092C2}" dt="2022-06-11T05:29:23.029" v="10" actId="20577"/>
          <ac:spMkLst>
            <pc:docMk/>
            <pc:sldMk cId="2620120220" sldId="296"/>
            <ac:spMk id="9" creationId="{1305C0EF-1BAE-46E6-ADA8-283FE5A8357E}"/>
          </ac:spMkLst>
        </pc:spChg>
        <pc:spChg chg="mod">
          <ac:chgData name="Filippo Acconcia" userId="844af49c-a8a0-47ac-a7dd-14a44b60cd18" providerId="ADAL" clId="{DB596444-B095-4C7A-8C02-1FB2A86092C2}" dt="2022-06-11T05:29:00.373" v="2" actId="20577"/>
          <ac:spMkLst>
            <pc:docMk/>
            <pc:sldMk cId="2620120220" sldId="296"/>
            <ac:spMk id="10" creationId="{DBC0E799-4484-4BB2-970D-A8FFD1E82367}"/>
          </ac:spMkLst>
        </pc:spChg>
        <pc:spChg chg="mod">
          <ac:chgData name="Filippo Acconcia" userId="844af49c-a8a0-47ac-a7dd-14a44b60cd18" providerId="ADAL" clId="{DB596444-B095-4C7A-8C02-1FB2A86092C2}" dt="2022-06-11T05:29:07.698" v="6" actId="20577"/>
          <ac:spMkLst>
            <pc:docMk/>
            <pc:sldMk cId="2620120220" sldId="296"/>
            <ac:spMk id="11" creationId="{A9B4F47D-D18F-4873-81B4-DD10B5C2A93F}"/>
          </ac:spMkLst>
        </pc:spChg>
        <pc:spChg chg="mod">
          <ac:chgData name="Filippo Acconcia" userId="844af49c-a8a0-47ac-a7dd-14a44b60cd18" providerId="ADAL" clId="{DB596444-B095-4C7A-8C02-1FB2A86092C2}" dt="2022-07-24T07:28:33.770" v="431" actId="2085"/>
          <ac:spMkLst>
            <pc:docMk/>
            <pc:sldMk cId="2620120220" sldId="296"/>
            <ac:spMk id="119" creationId="{C92280B0-FF3A-453F-8913-6416D71F08B0}"/>
          </ac:spMkLst>
        </pc:spChg>
        <pc:spChg chg="mod topLvl">
          <ac:chgData name="Filippo Acconcia" userId="844af49c-a8a0-47ac-a7dd-14a44b60cd18" providerId="ADAL" clId="{DB596444-B095-4C7A-8C02-1FB2A86092C2}" dt="2022-07-24T07:34:09.059" v="520" actId="164"/>
          <ac:spMkLst>
            <pc:docMk/>
            <pc:sldMk cId="2620120220" sldId="296"/>
            <ac:spMk id="136" creationId="{1BEB58A3-078C-443A-AEFA-0CD447F538EA}"/>
          </ac:spMkLst>
        </pc:spChg>
        <pc:spChg chg="mod topLvl">
          <ac:chgData name="Filippo Acconcia" userId="844af49c-a8a0-47ac-a7dd-14a44b60cd18" providerId="ADAL" clId="{DB596444-B095-4C7A-8C02-1FB2A86092C2}" dt="2022-07-26T12:50:29.419" v="667" actId="1038"/>
          <ac:spMkLst>
            <pc:docMk/>
            <pc:sldMk cId="2620120220" sldId="296"/>
            <ac:spMk id="137" creationId="{CB4EB2D3-D7A8-47AE-8A4B-FB0AAC039842}"/>
          </ac:spMkLst>
        </pc:spChg>
        <pc:spChg chg="mod topLvl">
          <ac:chgData name="Filippo Acconcia" userId="844af49c-a8a0-47ac-a7dd-14a44b60cd18" providerId="ADAL" clId="{DB596444-B095-4C7A-8C02-1FB2A86092C2}" dt="2022-07-24T07:34:09.059" v="520" actId="164"/>
          <ac:spMkLst>
            <pc:docMk/>
            <pc:sldMk cId="2620120220" sldId="296"/>
            <ac:spMk id="138" creationId="{B69C2601-30C6-47AD-AD56-7820B498DD2F}"/>
          </ac:spMkLst>
        </pc:spChg>
        <pc:spChg chg="mod topLvl">
          <ac:chgData name="Filippo Acconcia" userId="844af49c-a8a0-47ac-a7dd-14a44b60cd18" providerId="ADAL" clId="{DB596444-B095-4C7A-8C02-1FB2A86092C2}" dt="2022-07-24T07:34:09.059" v="520" actId="164"/>
          <ac:spMkLst>
            <pc:docMk/>
            <pc:sldMk cId="2620120220" sldId="296"/>
            <ac:spMk id="139" creationId="{1974C6C3-85C7-4584-AE1C-4764DE3FDE28}"/>
          </ac:spMkLst>
        </pc:spChg>
        <pc:spChg chg="mod topLvl">
          <ac:chgData name="Filippo Acconcia" userId="844af49c-a8a0-47ac-a7dd-14a44b60cd18" providerId="ADAL" clId="{DB596444-B095-4C7A-8C02-1FB2A86092C2}" dt="2022-07-24T07:34:09.059" v="520" actId="164"/>
          <ac:spMkLst>
            <pc:docMk/>
            <pc:sldMk cId="2620120220" sldId="296"/>
            <ac:spMk id="140" creationId="{5107AB64-D2D2-49E4-AB38-9038906EDBA5}"/>
          </ac:spMkLst>
        </pc:spChg>
        <pc:spChg chg="mod topLvl">
          <ac:chgData name="Filippo Acconcia" userId="844af49c-a8a0-47ac-a7dd-14a44b60cd18" providerId="ADAL" clId="{DB596444-B095-4C7A-8C02-1FB2A86092C2}" dt="2022-07-24T07:34:09.059" v="520" actId="164"/>
          <ac:spMkLst>
            <pc:docMk/>
            <pc:sldMk cId="2620120220" sldId="296"/>
            <ac:spMk id="147" creationId="{8259BCC2-C7D3-4C26-A659-B32DED109CEC}"/>
          </ac:spMkLst>
        </pc:spChg>
        <pc:spChg chg="mod topLvl">
          <ac:chgData name="Filippo Acconcia" userId="844af49c-a8a0-47ac-a7dd-14a44b60cd18" providerId="ADAL" clId="{DB596444-B095-4C7A-8C02-1FB2A86092C2}" dt="2022-07-24T07:34:09.059" v="520" actId="164"/>
          <ac:spMkLst>
            <pc:docMk/>
            <pc:sldMk cId="2620120220" sldId="296"/>
            <ac:spMk id="148" creationId="{75369A9A-F959-46D4-B24A-E99DD30C683B}"/>
          </ac:spMkLst>
        </pc:spChg>
        <pc:spChg chg="mod topLvl">
          <ac:chgData name="Filippo Acconcia" userId="844af49c-a8a0-47ac-a7dd-14a44b60cd18" providerId="ADAL" clId="{DB596444-B095-4C7A-8C02-1FB2A86092C2}" dt="2022-07-24T07:34:09.059" v="520" actId="164"/>
          <ac:spMkLst>
            <pc:docMk/>
            <pc:sldMk cId="2620120220" sldId="296"/>
            <ac:spMk id="149" creationId="{4CFDD517-8EC1-42CC-BCD3-D602FBC09CE6}"/>
          </ac:spMkLst>
        </pc:spChg>
        <pc:spChg chg="mod topLvl">
          <ac:chgData name="Filippo Acconcia" userId="844af49c-a8a0-47ac-a7dd-14a44b60cd18" providerId="ADAL" clId="{DB596444-B095-4C7A-8C02-1FB2A86092C2}" dt="2022-07-24T07:34:09.059" v="520" actId="164"/>
          <ac:spMkLst>
            <pc:docMk/>
            <pc:sldMk cId="2620120220" sldId="296"/>
            <ac:spMk id="150" creationId="{C446CCF3-52DA-4B93-AB4B-0C32825D1970}"/>
          </ac:spMkLst>
        </pc:spChg>
        <pc:spChg chg="mod topLvl">
          <ac:chgData name="Filippo Acconcia" userId="844af49c-a8a0-47ac-a7dd-14a44b60cd18" providerId="ADAL" clId="{DB596444-B095-4C7A-8C02-1FB2A86092C2}" dt="2022-07-24T07:34:09.059" v="520" actId="164"/>
          <ac:spMkLst>
            <pc:docMk/>
            <pc:sldMk cId="2620120220" sldId="296"/>
            <ac:spMk id="151" creationId="{7B01CB50-B967-4E8D-88CC-99EF0C65DC7B}"/>
          </ac:spMkLst>
        </pc:spChg>
        <pc:spChg chg="mod topLvl">
          <ac:chgData name="Filippo Acconcia" userId="844af49c-a8a0-47ac-a7dd-14a44b60cd18" providerId="ADAL" clId="{DB596444-B095-4C7A-8C02-1FB2A86092C2}" dt="2022-07-24T07:34:09.059" v="520" actId="164"/>
          <ac:spMkLst>
            <pc:docMk/>
            <pc:sldMk cId="2620120220" sldId="296"/>
            <ac:spMk id="152" creationId="{B085D9A1-7F54-41CF-BF2B-23837C5B2081}"/>
          </ac:spMkLst>
        </pc:spChg>
        <pc:grpChg chg="add mod">
          <ac:chgData name="Filippo Acconcia" userId="844af49c-a8a0-47ac-a7dd-14a44b60cd18" providerId="ADAL" clId="{DB596444-B095-4C7A-8C02-1FB2A86092C2}" dt="2022-07-24T07:34:36.806" v="531" actId="1036"/>
          <ac:grpSpMkLst>
            <pc:docMk/>
            <pc:sldMk cId="2620120220" sldId="296"/>
            <ac:grpSpMk id="47" creationId="{FB5409DF-EDEB-0B76-5765-8E2A2F9A9830}"/>
          </ac:grpSpMkLst>
        </pc:grpChg>
        <pc:grpChg chg="del">
          <ac:chgData name="Filippo Acconcia" userId="844af49c-a8a0-47ac-a7dd-14a44b60cd18" providerId="ADAL" clId="{DB596444-B095-4C7A-8C02-1FB2A86092C2}" dt="2022-07-24T07:25:57.215" v="426" actId="165"/>
          <ac:grpSpMkLst>
            <pc:docMk/>
            <pc:sldMk cId="2620120220" sldId="296"/>
            <ac:grpSpMk id="135" creationId="{0E35562E-E712-4BCC-A8C6-D8B41B85BB02}"/>
          </ac:grpSpMkLst>
        </pc:grpChg>
        <pc:grpChg chg="mod">
          <ac:chgData name="Filippo Acconcia" userId="844af49c-a8a0-47ac-a7dd-14a44b60cd18" providerId="ADAL" clId="{DB596444-B095-4C7A-8C02-1FB2A86092C2}" dt="2022-07-24T07:34:36.806" v="531" actId="1036"/>
          <ac:grpSpMkLst>
            <pc:docMk/>
            <pc:sldMk cId="2620120220" sldId="296"/>
            <ac:grpSpMk id="153" creationId="{F8F4CA2B-8B03-48C6-BDD3-51D135701CE1}"/>
          </ac:grpSpMkLst>
        </pc:grpChg>
        <pc:picChg chg="mod">
          <ac:chgData name="Filippo Acconcia" userId="844af49c-a8a0-47ac-a7dd-14a44b60cd18" providerId="ADAL" clId="{DB596444-B095-4C7A-8C02-1FB2A86092C2}" dt="2022-07-24T07:34:09.059" v="520" actId="164"/>
          <ac:picMkLst>
            <pc:docMk/>
            <pc:sldMk cId="2620120220" sldId="296"/>
            <ac:picMk id="41" creationId="{EFD6283A-FBA5-15BA-56D4-6B2AE1EC25CC}"/>
          </ac:picMkLst>
        </pc:picChg>
        <pc:picChg chg="mod">
          <ac:chgData name="Filippo Acconcia" userId="844af49c-a8a0-47ac-a7dd-14a44b60cd18" providerId="ADAL" clId="{DB596444-B095-4C7A-8C02-1FB2A86092C2}" dt="2022-07-24T07:34:09.059" v="520" actId="164"/>
          <ac:picMkLst>
            <pc:docMk/>
            <pc:sldMk cId="2620120220" sldId="296"/>
            <ac:picMk id="42" creationId="{35A7BA61-E4F7-003F-7912-204CB01DEA3F}"/>
          </ac:picMkLst>
        </pc:picChg>
        <pc:picChg chg="mod">
          <ac:chgData name="Filippo Acconcia" userId="844af49c-a8a0-47ac-a7dd-14a44b60cd18" providerId="ADAL" clId="{DB596444-B095-4C7A-8C02-1FB2A86092C2}" dt="2022-07-24T07:34:09.059" v="520" actId="164"/>
          <ac:picMkLst>
            <pc:docMk/>
            <pc:sldMk cId="2620120220" sldId="296"/>
            <ac:picMk id="43" creationId="{403C5477-1387-C68B-8353-E4FA87F36AAD}"/>
          </ac:picMkLst>
        </pc:picChg>
        <pc:picChg chg="mod">
          <ac:chgData name="Filippo Acconcia" userId="844af49c-a8a0-47ac-a7dd-14a44b60cd18" providerId="ADAL" clId="{DB596444-B095-4C7A-8C02-1FB2A86092C2}" dt="2022-07-24T07:34:09.059" v="520" actId="164"/>
          <ac:picMkLst>
            <pc:docMk/>
            <pc:sldMk cId="2620120220" sldId="296"/>
            <ac:picMk id="44" creationId="{B80D6CA0-1846-BAFE-29AE-CF371B027779}"/>
          </ac:picMkLst>
        </pc:picChg>
        <pc:picChg chg="mod">
          <ac:chgData name="Filippo Acconcia" userId="844af49c-a8a0-47ac-a7dd-14a44b60cd18" providerId="ADAL" clId="{DB596444-B095-4C7A-8C02-1FB2A86092C2}" dt="2022-07-24T07:34:09.059" v="520" actId="164"/>
          <ac:picMkLst>
            <pc:docMk/>
            <pc:sldMk cId="2620120220" sldId="296"/>
            <ac:picMk id="45" creationId="{445A7D8A-12E1-51F7-7D59-477AC6839067}"/>
          </ac:picMkLst>
        </pc:picChg>
        <pc:picChg chg="mod">
          <ac:chgData name="Filippo Acconcia" userId="844af49c-a8a0-47ac-a7dd-14a44b60cd18" providerId="ADAL" clId="{DB596444-B095-4C7A-8C02-1FB2A86092C2}" dt="2022-07-24T07:34:09.059" v="520" actId="164"/>
          <ac:picMkLst>
            <pc:docMk/>
            <pc:sldMk cId="2620120220" sldId="296"/>
            <ac:picMk id="46" creationId="{4C0DA9CD-1ECC-3636-CE76-636DC063B5F2}"/>
          </ac:picMkLst>
        </pc:picChg>
        <pc:picChg chg="del mod topLvl">
          <ac:chgData name="Filippo Acconcia" userId="844af49c-a8a0-47ac-a7dd-14a44b60cd18" providerId="ADAL" clId="{DB596444-B095-4C7A-8C02-1FB2A86092C2}" dt="2022-07-24T07:29:21.216" v="440" actId="478"/>
          <ac:picMkLst>
            <pc:docMk/>
            <pc:sldMk cId="2620120220" sldId="296"/>
            <ac:picMk id="141" creationId="{AC682B01-ED0E-44F6-8BF5-E05CE42ADB0E}"/>
          </ac:picMkLst>
        </pc:picChg>
        <pc:picChg chg="del mod topLvl">
          <ac:chgData name="Filippo Acconcia" userId="844af49c-a8a0-47ac-a7dd-14a44b60cd18" providerId="ADAL" clId="{DB596444-B095-4C7A-8C02-1FB2A86092C2}" dt="2022-07-24T07:29:18.762" v="439" actId="478"/>
          <ac:picMkLst>
            <pc:docMk/>
            <pc:sldMk cId="2620120220" sldId="296"/>
            <ac:picMk id="142" creationId="{69BCCAC2-BCEB-4174-9C02-4C9814EFC4BA}"/>
          </ac:picMkLst>
        </pc:picChg>
        <pc:picChg chg="del mod topLvl">
          <ac:chgData name="Filippo Acconcia" userId="844af49c-a8a0-47ac-a7dd-14a44b60cd18" providerId="ADAL" clId="{DB596444-B095-4C7A-8C02-1FB2A86092C2}" dt="2022-07-24T07:30:53.079" v="466" actId="478"/>
          <ac:picMkLst>
            <pc:docMk/>
            <pc:sldMk cId="2620120220" sldId="296"/>
            <ac:picMk id="143" creationId="{522C15E8-C4DC-4B9E-9104-A9E2A1915CCA}"/>
          </ac:picMkLst>
        </pc:picChg>
        <pc:picChg chg="del mod topLvl">
          <ac:chgData name="Filippo Acconcia" userId="844af49c-a8a0-47ac-a7dd-14a44b60cd18" providerId="ADAL" clId="{DB596444-B095-4C7A-8C02-1FB2A86092C2}" dt="2022-07-24T07:31:51.833" v="479" actId="478"/>
          <ac:picMkLst>
            <pc:docMk/>
            <pc:sldMk cId="2620120220" sldId="296"/>
            <ac:picMk id="144" creationId="{13591FE0-A9C4-4717-840B-E4EE95C27C3E}"/>
          </ac:picMkLst>
        </pc:picChg>
        <pc:picChg chg="del mod topLvl">
          <ac:chgData name="Filippo Acconcia" userId="844af49c-a8a0-47ac-a7dd-14a44b60cd18" providerId="ADAL" clId="{DB596444-B095-4C7A-8C02-1FB2A86092C2}" dt="2022-07-24T07:32:49.992" v="492" actId="478"/>
          <ac:picMkLst>
            <pc:docMk/>
            <pc:sldMk cId="2620120220" sldId="296"/>
            <ac:picMk id="145" creationId="{462DD40D-41F3-46DA-91CE-0C819FF2DE2F}"/>
          </ac:picMkLst>
        </pc:picChg>
        <pc:picChg chg="del mod topLvl">
          <ac:chgData name="Filippo Acconcia" userId="844af49c-a8a0-47ac-a7dd-14a44b60cd18" providerId="ADAL" clId="{DB596444-B095-4C7A-8C02-1FB2A86092C2}" dt="2022-07-24T07:33:32.517" v="500" actId="478"/>
          <ac:picMkLst>
            <pc:docMk/>
            <pc:sldMk cId="2620120220" sldId="296"/>
            <ac:picMk id="146" creationId="{CE47DE7B-B4BA-481D-933C-CE03007F9840}"/>
          </ac:picMkLst>
        </pc:picChg>
      </pc:sldChg>
      <pc:sldChg chg="delSp mod">
        <pc:chgData name="Filippo Acconcia" userId="844af49c-a8a0-47ac-a7dd-14a44b60cd18" providerId="ADAL" clId="{DB596444-B095-4C7A-8C02-1FB2A86092C2}" dt="2022-07-23T07:03:55.472" v="163" actId="478"/>
        <pc:sldMkLst>
          <pc:docMk/>
          <pc:sldMk cId="3763209997" sldId="297"/>
        </pc:sldMkLst>
        <pc:spChg chg="del">
          <ac:chgData name="Filippo Acconcia" userId="844af49c-a8a0-47ac-a7dd-14a44b60cd18" providerId="ADAL" clId="{DB596444-B095-4C7A-8C02-1FB2A86092C2}" dt="2022-07-23T07:03:55.472" v="163" actId="478"/>
          <ac:spMkLst>
            <pc:docMk/>
            <pc:sldMk cId="3763209997" sldId="297"/>
            <ac:spMk id="157" creationId="{2C531C44-EB30-0DB9-06D0-CFC4394FEB9B}"/>
          </ac:spMkLst>
        </pc:spChg>
      </pc:sldChg>
      <pc:sldChg chg="addSp delSp modSp mod">
        <pc:chgData name="Filippo Acconcia" userId="844af49c-a8a0-47ac-a7dd-14a44b60cd18" providerId="ADAL" clId="{DB596444-B095-4C7A-8C02-1FB2A86092C2}" dt="2022-07-23T08:16:48.410" v="380" actId="1038"/>
        <pc:sldMkLst>
          <pc:docMk/>
          <pc:sldMk cId="2307067035" sldId="302"/>
        </pc:sldMkLst>
        <pc:spChg chg="mod topLvl">
          <ac:chgData name="Filippo Acconcia" userId="844af49c-a8a0-47ac-a7dd-14a44b60cd18" providerId="ADAL" clId="{DB596444-B095-4C7A-8C02-1FB2A86092C2}" dt="2022-07-23T08:15:26.305" v="358" actId="164"/>
          <ac:spMkLst>
            <pc:docMk/>
            <pc:sldMk cId="2307067035" sldId="302"/>
            <ac:spMk id="20" creationId="{FAE24FF5-730D-4351-BBBA-E64C0C8CD160}"/>
          </ac:spMkLst>
        </pc:spChg>
        <pc:spChg chg="mod topLvl">
          <ac:chgData name="Filippo Acconcia" userId="844af49c-a8a0-47ac-a7dd-14a44b60cd18" providerId="ADAL" clId="{DB596444-B095-4C7A-8C02-1FB2A86092C2}" dt="2022-07-23T08:15:36.738" v="361" actId="164"/>
          <ac:spMkLst>
            <pc:docMk/>
            <pc:sldMk cId="2307067035" sldId="302"/>
            <ac:spMk id="21" creationId="{C9BA248E-8DE9-4309-9E5F-F2C6D2D8570C}"/>
          </ac:spMkLst>
        </pc:spChg>
        <pc:spChg chg="mod topLvl">
          <ac:chgData name="Filippo Acconcia" userId="844af49c-a8a0-47ac-a7dd-14a44b60cd18" providerId="ADAL" clId="{DB596444-B095-4C7A-8C02-1FB2A86092C2}" dt="2022-07-23T08:15:36.738" v="361" actId="164"/>
          <ac:spMkLst>
            <pc:docMk/>
            <pc:sldMk cId="2307067035" sldId="302"/>
            <ac:spMk id="22" creationId="{4C0D0416-CA53-401B-9460-CE3CA1E97481}"/>
          </ac:spMkLst>
        </pc:spChg>
        <pc:spChg chg="mod topLvl">
          <ac:chgData name="Filippo Acconcia" userId="844af49c-a8a0-47ac-a7dd-14a44b60cd18" providerId="ADAL" clId="{DB596444-B095-4C7A-8C02-1FB2A86092C2}" dt="2022-07-23T08:15:36.738" v="361" actId="164"/>
          <ac:spMkLst>
            <pc:docMk/>
            <pc:sldMk cId="2307067035" sldId="302"/>
            <ac:spMk id="23" creationId="{B111B969-ADDD-4C6B-9B19-35D787062134}"/>
          </ac:spMkLst>
        </pc:spChg>
        <pc:spChg chg="mod topLvl">
          <ac:chgData name="Filippo Acconcia" userId="844af49c-a8a0-47ac-a7dd-14a44b60cd18" providerId="ADAL" clId="{DB596444-B095-4C7A-8C02-1FB2A86092C2}" dt="2022-07-23T08:15:36.738" v="361" actId="164"/>
          <ac:spMkLst>
            <pc:docMk/>
            <pc:sldMk cId="2307067035" sldId="302"/>
            <ac:spMk id="24" creationId="{3B5BE2B2-D386-4108-8072-67C6CC95A2C9}"/>
          </ac:spMkLst>
        </pc:spChg>
        <pc:spChg chg="mod topLvl">
          <ac:chgData name="Filippo Acconcia" userId="844af49c-a8a0-47ac-a7dd-14a44b60cd18" providerId="ADAL" clId="{DB596444-B095-4C7A-8C02-1FB2A86092C2}" dt="2022-07-23T08:15:36.738" v="361" actId="164"/>
          <ac:spMkLst>
            <pc:docMk/>
            <pc:sldMk cId="2307067035" sldId="302"/>
            <ac:spMk id="25" creationId="{02861877-A49C-4779-8B42-21916FA31289}"/>
          </ac:spMkLst>
        </pc:spChg>
        <pc:spChg chg="mod topLvl">
          <ac:chgData name="Filippo Acconcia" userId="844af49c-a8a0-47ac-a7dd-14a44b60cd18" providerId="ADAL" clId="{DB596444-B095-4C7A-8C02-1FB2A86092C2}" dt="2022-07-23T08:15:36.738" v="361" actId="164"/>
          <ac:spMkLst>
            <pc:docMk/>
            <pc:sldMk cId="2307067035" sldId="302"/>
            <ac:spMk id="26" creationId="{36CCD239-EE37-4571-B961-33BCF21E33DC}"/>
          </ac:spMkLst>
        </pc:spChg>
        <pc:spChg chg="mod topLvl">
          <ac:chgData name="Filippo Acconcia" userId="844af49c-a8a0-47ac-a7dd-14a44b60cd18" providerId="ADAL" clId="{DB596444-B095-4C7A-8C02-1FB2A86092C2}" dt="2022-07-23T08:15:36.738" v="361" actId="164"/>
          <ac:spMkLst>
            <pc:docMk/>
            <pc:sldMk cId="2307067035" sldId="302"/>
            <ac:spMk id="27" creationId="{A06536CC-4912-44F9-802B-373324655E45}"/>
          </ac:spMkLst>
        </pc:spChg>
        <pc:spChg chg="del mod topLvl">
          <ac:chgData name="Filippo Acconcia" userId="844af49c-a8a0-47ac-a7dd-14a44b60cd18" providerId="ADAL" clId="{DB596444-B095-4C7A-8C02-1FB2A86092C2}" dt="2022-07-23T08:14:38.135" v="286" actId="478"/>
          <ac:spMkLst>
            <pc:docMk/>
            <pc:sldMk cId="2307067035" sldId="302"/>
            <ac:spMk id="29" creationId="{13E7CA6D-82EA-4683-96EC-69CE14D7F271}"/>
          </ac:spMkLst>
        </pc:spChg>
        <pc:spChg chg="mod topLvl">
          <ac:chgData name="Filippo Acconcia" userId="844af49c-a8a0-47ac-a7dd-14a44b60cd18" providerId="ADAL" clId="{DB596444-B095-4C7A-8C02-1FB2A86092C2}" dt="2022-07-23T07:56:37.058" v="241" actId="164"/>
          <ac:spMkLst>
            <pc:docMk/>
            <pc:sldMk cId="2307067035" sldId="302"/>
            <ac:spMk id="48" creationId="{E55FEA93-EBD7-488C-9473-55358D9DE48C}"/>
          </ac:spMkLst>
        </pc:spChg>
        <pc:spChg chg="mod topLvl">
          <ac:chgData name="Filippo Acconcia" userId="844af49c-a8a0-47ac-a7dd-14a44b60cd18" providerId="ADAL" clId="{DB596444-B095-4C7A-8C02-1FB2A86092C2}" dt="2022-07-23T07:56:37.058" v="241" actId="164"/>
          <ac:spMkLst>
            <pc:docMk/>
            <pc:sldMk cId="2307067035" sldId="302"/>
            <ac:spMk id="49" creationId="{78373B0A-D670-4B40-9A64-D5BBF7C5D21F}"/>
          </ac:spMkLst>
        </pc:spChg>
        <pc:spChg chg="mod topLvl">
          <ac:chgData name="Filippo Acconcia" userId="844af49c-a8a0-47ac-a7dd-14a44b60cd18" providerId="ADAL" clId="{DB596444-B095-4C7A-8C02-1FB2A86092C2}" dt="2022-07-23T07:56:37.058" v="241" actId="164"/>
          <ac:spMkLst>
            <pc:docMk/>
            <pc:sldMk cId="2307067035" sldId="302"/>
            <ac:spMk id="50" creationId="{065EA109-3923-4391-9D1F-87657F51028A}"/>
          </ac:spMkLst>
        </pc:spChg>
        <pc:spChg chg="mod topLvl">
          <ac:chgData name="Filippo Acconcia" userId="844af49c-a8a0-47ac-a7dd-14a44b60cd18" providerId="ADAL" clId="{DB596444-B095-4C7A-8C02-1FB2A86092C2}" dt="2022-07-23T07:56:37.058" v="241" actId="164"/>
          <ac:spMkLst>
            <pc:docMk/>
            <pc:sldMk cId="2307067035" sldId="302"/>
            <ac:spMk id="51" creationId="{FA91F10E-A2CC-4491-B65A-8859419CBAC5}"/>
          </ac:spMkLst>
        </pc:spChg>
        <pc:spChg chg="mod ord topLvl">
          <ac:chgData name="Filippo Acconcia" userId="844af49c-a8a0-47ac-a7dd-14a44b60cd18" providerId="ADAL" clId="{DB596444-B095-4C7A-8C02-1FB2A86092C2}" dt="2022-07-23T07:56:37.058" v="241" actId="164"/>
          <ac:spMkLst>
            <pc:docMk/>
            <pc:sldMk cId="2307067035" sldId="302"/>
            <ac:spMk id="52" creationId="{75FFF2A5-D73E-4D0F-BE4B-CA25D22A59E0}"/>
          </ac:spMkLst>
        </pc:spChg>
        <pc:spChg chg="mod topLvl">
          <ac:chgData name="Filippo Acconcia" userId="844af49c-a8a0-47ac-a7dd-14a44b60cd18" providerId="ADAL" clId="{DB596444-B095-4C7A-8C02-1FB2A86092C2}" dt="2022-07-23T07:56:37.058" v="241" actId="164"/>
          <ac:spMkLst>
            <pc:docMk/>
            <pc:sldMk cId="2307067035" sldId="302"/>
            <ac:spMk id="53" creationId="{E59DB48C-1568-48F9-A7BD-9F8C2B512295}"/>
          </ac:spMkLst>
        </pc:spChg>
        <pc:spChg chg="mod topLvl">
          <ac:chgData name="Filippo Acconcia" userId="844af49c-a8a0-47ac-a7dd-14a44b60cd18" providerId="ADAL" clId="{DB596444-B095-4C7A-8C02-1FB2A86092C2}" dt="2022-07-23T07:56:37.058" v="241" actId="164"/>
          <ac:spMkLst>
            <pc:docMk/>
            <pc:sldMk cId="2307067035" sldId="302"/>
            <ac:spMk id="54" creationId="{DEAB80A3-D7C6-46B4-99DC-33F386AB23FE}"/>
          </ac:spMkLst>
        </pc:spChg>
        <pc:spChg chg="mod topLvl">
          <ac:chgData name="Filippo Acconcia" userId="844af49c-a8a0-47ac-a7dd-14a44b60cd18" providerId="ADAL" clId="{DB596444-B095-4C7A-8C02-1FB2A86092C2}" dt="2022-07-23T07:56:37.058" v="241" actId="164"/>
          <ac:spMkLst>
            <pc:docMk/>
            <pc:sldMk cId="2307067035" sldId="302"/>
            <ac:spMk id="55" creationId="{9FB9D37B-4340-442C-BCAE-F74DCAE48668}"/>
          </ac:spMkLst>
        </pc:spChg>
        <pc:spChg chg="mod topLvl">
          <ac:chgData name="Filippo Acconcia" userId="844af49c-a8a0-47ac-a7dd-14a44b60cd18" providerId="ADAL" clId="{DB596444-B095-4C7A-8C02-1FB2A86092C2}" dt="2022-07-23T07:56:37.058" v="241" actId="164"/>
          <ac:spMkLst>
            <pc:docMk/>
            <pc:sldMk cId="2307067035" sldId="302"/>
            <ac:spMk id="56" creationId="{DDD86ABD-6BDE-4BC5-802F-1F23C1462A2C}"/>
          </ac:spMkLst>
        </pc:spChg>
        <pc:spChg chg="mod topLvl">
          <ac:chgData name="Filippo Acconcia" userId="844af49c-a8a0-47ac-a7dd-14a44b60cd18" providerId="ADAL" clId="{DB596444-B095-4C7A-8C02-1FB2A86092C2}" dt="2022-07-23T07:56:37.058" v="241" actId="164"/>
          <ac:spMkLst>
            <pc:docMk/>
            <pc:sldMk cId="2307067035" sldId="302"/>
            <ac:spMk id="57" creationId="{286ECD8B-3C9D-4753-B7AF-FF35070ED12E}"/>
          </ac:spMkLst>
        </pc:spChg>
        <pc:spChg chg="mod topLvl">
          <ac:chgData name="Filippo Acconcia" userId="844af49c-a8a0-47ac-a7dd-14a44b60cd18" providerId="ADAL" clId="{DB596444-B095-4C7A-8C02-1FB2A86092C2}" dt="2022-07-23T07:56:37.058" v="241" actId="164"/>
          <ac:spMkLst>
            <pc:docMk/>
            <pc:sldMk cId="2307067035" sldId="302"/>
            <ac:spMk id="58" creationId="{0CA6824A-E1A8-4854-B5CC-5881153B4511}"/>
          </ac:spMkLst>
        </pc:spChg>
        <pc:spChg chg="mod topLvl">
          <ac:chgData name="Filippo Acconcia" userId="844af49c-a8a0-47ac-a7dd-14a44b60cd18" providerId="ADAL" clId="{DB596444-B095-4C7A-8C02-1FB2A86092C2}" dt="2022-07-23T07:56:37.058" v="241" actId="164"/>
          <ac:spMkLst>
            <pc:docMk/>
            <pc:sldMk cId="2307067035" sldId="302"/>
            <ac:spMk id="59" creationId="{67E23C50-C0BC-4881-82F1-0463765E3F0C}"/>
          </ac:spMkLst>
        </pc:spChg>
        <pc:grpChg chg="mod">
          <ac:chgData name="Filippo Acconcia" userId="844af49c-a8a0-47ac-a7dd-14a44b60cd18" providerId="ADAL" clId="{DB596444-B095-4C7A-8C02-1FB2A86092C2}" dt="2022-07-23T08:16:13.701" v="366" actId="1035"/>
          <ac:grpSpMkLst>
            <pc:docMk/>
            <pc:sldMk cId="2307067035" sldId="302"/>
            <ac:grpSpMk id="3" creationId="{4B2C2836-7F11-4B1E-A829-33FBBFA1A42A}"/>
          </ac:grpSpMkLst>
        </pc:grpChg>
        <pc:grpChg chg="del">
          <ac:chgData name="Filippo Acconcia" userId="844af49c-a8a0-47ac-a7dd-14a44b60cd18" providerId="ADAL" clId="{DB596444-B095-4C7A-8C02-1FB2A86092C2}" dt="2022-07-23T08:11:19.188" v="243" actId="165"/>
          <ac:grpSpMkLst>
            <pc:docMk/>
            <pc:sldMk cId="2307067035" sldId="302"/>
            <ac:grpSpMk id="17" creationId="{D3F3FDC7-BFD8-4374-8EBA-38F750233C6B}"/>
          </ac:grpSpMkLst>
        </pc:grpChg>
        <pc:grpChg chg="del">
          <ac:chgData name="Filippo Acconcia" userId="844af49c-a8a0-47ac-a7dd-14a44b60cd18" providerId="ADAL" clId="{DB596444-B095-4C7A-8C02-1FB2A86092C2}" dt="2022-07-23T07:53:17.536" v="167" actId="165"/>
          <ac:grpSpMkLst>
            <pc:docMk/>
            <pc:sldMk cId="2307067035" sldId="302"/>
            <ac:grpSpMk id="46" creationId="{8E7AE439-5174-40DE-AE5B-A25F70D0BFEB}"/>
          </ac:grpSpMkLst>
        </pc:grpChg>
        <pc:grpChg chg="add mod">
          <ac:chgData name="Filippo Acconcia" userId="844af49c-a8a0-47ac-a7dd-14a44b60cd18" providerId="ADAL" clId="{DB596444-B095-4C7A-8C02-1FB2A86092C2}" dt="2022-07-23T07:56:37.058" v="241" actId="164"/>
          <ac:grpSpMkLst>
            <pc:docMk/>
            <pc:sldMk cId="2307067035" sldId="302"/>
            <ac:grpSpMk id="197" creationId="{0FC84507-3E65-C69C-17D3-B6592335F62D}"/>
          </ac:grpSpMkLst>
        </pc:grpChg>
        <pc:grpChg chg="add mod">
          <ac:chgData name="Filippo Acconcia" userId="844af49c-a8a0-47ac-a7dd-14a44b60cd18" providerId="ADAL" clId="{DB596444-B095-4C7A-8C02-1FB2A86092C2}" dt="2022-07-23T08:15:36.738" v="361" actId="164"/>
          <ac:grpSpMkLst>
            <pc:docMk/>
            <pc:sldMk cId="2307067035" sldId="302"/>
            <ac:grpSpMk id="200" creationId="{5509FD13-F636-B0C9-81DA-7BFA875729C2}"/>
          </ac:grpSpMkLst>
        </pc:grpChg>
        <pc:grpChg chg="add mod">
          <ac:chgData name="Filippo Acconcia" userId="844af49c-a8a0-47ac-a7dd-14a44b60cd18" providerId="ADAL" clId="{DB596444-B095-4C7A-8C02-1FB2A86092C2}" dt="2022-07-23T08:16:48.410" v="380" actId="1038"/>
          <ac:grpSpMkLst>
            <pc:docMk/>
            <pc:sldMk cId="2307067035" sldId="302"/>
            <ac:grpSpMk id="201" creationId="{B20980A9-76FF-6500-A5A9-6C6511A91338}"/>
          </ac:grpSpMkLst>
        </pc:grpChg>
        <pc:picChg chg="del mod topLvl">
          <ac:chgData name="Filippo Acconcia" userId="844af49c-a8a0-47ac-a7dd-14a44b60cd18" providerId="ADAL" clId="{DB596444-B095-4C7A-8C02-1FB2A86092C2}" dt="2022-07-23T08:13:54.532" v="274" actId="478"/>
          <ac:picMkLst>
            <pc:docMk/>
            <pc:sldMk cId="2307067035" sldId="302"/>
            <ac:picMk id="18" creationId="{ECBE3058-4EE7-4714-A2D6-DB8C96F5D362}"/>
          </ac:picMkLst>
        </pc:picChg>
        <pc:picChg chg="del mod topLvl">
          <ac:chgData name="Filippo Acconcia" userId="844af49c-a8a0-47ac-a7dd-14a44b60cd18" providerId="ADAL" clId="{DB596444-B095-4C7A-8C02-1FB2A86092C2}" dt="2022-07-23T08:13:57.937" v="275" actId="478"/>
          <ac:picMkLst>
            <pc:docMk/>
            <pc:sldMk cId="2307067035" sldId="302"/>
            <ac:picMk id="30" creationId="{B408DA22-BC21-4086-9141-DA0710295B6D}"/>
          </ac:picMkLst>
        </pc:picChg>
        <pc:picChg chg="del mod topLvl">
          <ac:chgData name="Filippo Acconcia" userId="844af49c-a8a0-47ac-a7dd-14a44b60cd18" providerId="ADAL" clId="{DB596444-B095-4C7A-8C02-1FB2A86092C2}" dt="2022-07-23T07:56:30.672" v="240" actId="478"/>
          <ac:picMkLst>
            <pc:docMk/>
            <pc:sldMk cId="2307067035" sldId="302"/>
            <ac:picMk id="47" creationId="{6FEB75BA-803C-416B-8217-0EE22A2813ED}"/>
          </ac:picMkLst>
        </pc:picChg>
        <pc:picChg chg="mod ord">
          <ac:chgData name="Filippo Acconcia" userId="844af49c-a8a0-47ac-a7dd-14a44b60cd18" providerId="ADAL" clId="{DB596444-B095-4C7A-8C02-1FB2A86092C2}" dt="2022-07-23T07:56:37.058" v="241" actId="164"/>
          <ac:picMkLst>
            <pc:docMk/>
            <pc:sldMk cId="2307067035" sldId="302"/>
            <ac:picMk id="196" creationId="{106B346E-41E9-91F5-3805-1AB39F780149}"/>
          </ac:picMkLst>
        </pc:picChg>
        <pc:picChg chg="mod ord">
          <ac:chgData name="Filippo Acconcia" userId="844af49c-a8a0-47ac-a7dd-14a44b60cd18" providerId="ADAL" clId="{DB596444-B095-4C7A-8C02-1FB2A86092C2}" dt="2022-07-23T08:15:36.738" v="361" actId="164"/>
          <ac:picMkLst>
            <pc:docMk/>
            <pc:sldMk cId="2307067035" sldId="302"/>
            <ac:picMk id="198" creationId="{8E17B733-2FD3-E275-6A28-5B27228289C2}"/>
          </ac:picMkLst>
        </pc:picChg>
        <pc:picChg chg="mod">
          <ac:chgData name="Filippo Acconcia" userId="844af49c-a8a0-47ac-a7dd-14a44b60cd18" providerId="ADAL" clId="{DB596444-B095-4C7A-8C02-1FB2A86092C2}" dt="2022-07-23T08:15:36.738" v="361" actId="164"/>
          <ac:picMkLst>
            <pc:docMk/>
            <pc:sldMk cId="2307067035" sldId="302"/>
            <ac:picMk id="199" creationId="{A4F446D6-90B1-35D1-7954-B8AFD1EF7FE5}"/>
          </ac:picMkLst>
        </pc:picChg>
        <pc:cxnChg chg="mod topLvl">
          <ac:chgData name="Filippo Acconcia" userId="844af49c-a8a0-47ac-a7dd-14a44b60cd18" providerId="ADAL" clId="{DB596444-B095-4C7A-8C02-1FB2A86092C2}" dt="2022-07-23T08:15:26.305" v="358" actId="164"/>
          <ac:cxnSpMkLst>
            <pc:docMk/>
            <pc:sldMk cId="2307067035" sldId="302"/>
            <ac:cxnSpMk id="19" creationId="{C7770BC5-2483-4661-A141-E2725D69B186}"/>
          </ac:cxnSpMkLst>
        </pc:cxnChg>
        <pc:cxnChg chg="mod topLvl">
          <ac:chgData name="Filippo Acconcia" userId="844af49c-a8a0-47ac-a7dd-14a44b60cd18" providerId="ADAL" clId="{DB596444-B095-4C7A-8C02-1FB2A86092C2}" dt="2022-07-23T08:15:36.738" v="361" actId="164"/>
          <ac:cxnSpMkLst>
            <pc:docMk/>
            <pc:sldMk cId="2307067035" sldId="302"/>
            <ac:cxnSpMk id="28" creationId="{709FD97A-7722-4BD3-B194-6014BE88A44E}"/>
          </ac:cxnSpMkLst>
        </pc:cxnChg>
        <pc:cxnChg chg="mod ord topLvl">
          <ac:chgData name="Filippo Acconcia" userId="844af49c-a8a0-47ac-a7dd-14a44b60cd18" providerId="ADAL" clId="{DB596444-B095-4C7A-8C02-1FB2A86092C2}" dt="2022-07-23T07:56:37.058" v="241" actId="164"/>
          <ac:cxnSpMkLst>
            <pc:docMk/>
            <pc:sldMk cId="2307067035" sldId="302"/>
            <ac:cxnSpMk id="60" creationId="{63C3D013-0061-4FDA-A362-787ABCEFD35E}"/>
          </ac:cxnSpMkLst>
        </pc:cxnChg>
      </pc:sldChg>
      <pc:sldChg chg="addSp delSp modSp mod">
        <pc:chgData name="Filippo Acconcia" userId="844af49c-a8a0-47ac-a7dd-14a44b60cd18" providerId="ADAL" clId="{DB596444-B095-4C7A-8C02-1FB2A86092C2}" dt="2022-07-26T10:34:30.018" v="658" actId="164"/>
        <pc:sldMkLst>
          <pc:docMk/>
          <pc:sldMk cId="2248971367" sldId="303"/>
        </pc:sldMkLst>
        <pc:spChg chg="add del mod">
          <ac:chgData name="Filippo Acconcia" userId="844af49c-a8a0-47ac-a7dd-14a44b60cd18" providerId="ADAL" clId="{DB596444-B095-4C7A-8C02-1FB2A86092C2}" dt="2022-07-25T06:48:39.463" v="566" actId="478"/>
          <ac:spMkLst>
            <pc:docMk/>
            <pc:sldMk cId="2248971367" sldId="303"/>
            <ac:spMk id="166" creationId="{FD8FCEB7-5BFF-88A5-3DA0-9F8ECC5804C5}"/>
          </ac:spMkLst>
        </pc:spChg>
        <pc:spChg chg="add del mod">
          <ac:chgData name="Filippo Acconcia" userId="844af49c-a8a0-47ac-a7dd-14a44b60cd18" providerId="ADAL" clId="{DB596444-B095-4C7A-8C02-1FB2A86092C2}" dt="2022-07-25T06:48:37.347" v="565" actId="478"/>
          <ac:spMkLst>
            <pc:docMk/>
            <pc:sldMk cId="2248971367" sldId="303"/>
            <ac:spMk id="167" creationId="{E1E6DE5E-48BF-C80B-770B-97297A73B8B9}"/>
          </ac:spMkLst>
        </pc:spChg>
        <pc:spChg chg="add del mod">
          <ac:chgData name="Filippo Acconcia" userId="844af49c-a8a0-47ac-a7dd-14a44b60cd18" providerId="ADAL" clId="{DB596444-B095-4C7A-8C02-1FB2A86092C2}" dt="2022-07-25T06:48:33.904" v="564" actId="478"/>
          <ac:spMkLst>
            <pc:docMk/>
            <pc:sldMk cId="2248971367" sldId="303"/>
            <ac:spMk id="170" creationId="{DB27ED10-31CD-2FE9-CF77-5DB7F7179FBB}"/>
          </ac:spMkLst>
        </pc:spChg>
        <pc:spChg chg="add mod topLvl">
          <ac:chgData name="Filippo Acconcia" userId="844af49c-a8a0-47ac-a7dd-14a44b60cd18" providerId="ADAL" clId="{DB596444-B095-4C7A-8C02-1FB2A86092C2}" dt="2022-07-26T10:34:30.018" v="658" actId="164"/>
          <ac:spMkLst>
            <pc:docMk/>
            <pc:sldMk cId="2248971367" sldId="303"/>
            <ac:spMk id="173" creationId="{A58538EB-D958-9005-54AC-B9CF97BB8039}"/>
          </ac:spMkLst>
        </pc:spChg>
        <pc:spChg chg="add del mod">
          <ac:chgData name="Filippo Acconcia" userId="844af49c-a8a0-47ac-a7dd-14a44b60cd18" providerId="ADAL" clId="{DB596444-B095-4C7A-8C02-1FB2A86092C2}" dt="2022-07-25T06:48:12.057" v="560" actId="478"/>
          <ac:spMkLst>
            <pc:docMk/>
            <pc:sldMk cId="2248971367" sldId="303"/>
            <ac:spMk id="175" creationId="{BBBC4050-06F7-9097-D2DB-A75C07E0B540}"/>
          </ac:spMkLst>
        </pc:spChg>
        <pc:spChg chg="add mod topLvl">
          <ac:chgData name="Filippo Acconcia" userId="844af49c-a8a0-47ac-a7dd-14a44b60cd18" providerId="ADAL" clId="{DB596444-B095-4C7A-8C02-1FB2A86092C2}" dt="2022-07-26T10:34:30.018" v="658" actId="164"/>
          <ac:spMkLst>
            <pc:docMk/>
            <pc:sldMk cId="2248971367" sldId="303"/>
            <ac:spMk id="177" creationId="{E3A12789-3C25-FCA8-DE04-5FCF50750CBA}"/>
          </ac:spMkLst>
        </pc:spChg>
        <pc:spChg chg="add del mod">
          <ac:chgData name="Filippo Acconcia" userId="844af49c-a8a0-47ac-a7dd-14a44b60cd18" providerId="ADAL" clId="{DB596444-B095-4C7A-8C02-1FB2A86092C2}" dt="2022-07-25T06:48:52.912" v="568" actId="478"/>
          <ac:spMkLst>
            <pc:docMk/>
            <pc:sldMk cId="2248971367" sldId="303"/>
            <ac:spMk id="180" creationId="{706B5DAB-C6C7-4A86-B7D8-948D5B528A1C}"/>
          </ac:spMkLst>
        </pc:spChg>
        <pc:spChg chg="add del mod">
          <ac:chgData name="Filippo Acconcia" userId="844af49c-a8a0-47ac-a7dd-14a44b60cd18" providerId="ADAL" clId="{DB596444-B095-4C7A-8C02-1FB2A86092C2}" dt="2022-07-25T06:48:49.267" v="567" actId="478"/>
          <ac:spMkLst>
            <pc:docMk/>
            <pc:sldMk cId="2248971367" sldId="303"/>
            <ac:spMk id="181" creationId="{07424D1E-1786-7D68-A2F1-1C83D6D9D3F1}"/>
          </ac:spMkLst>
        </pc:spChg>
        <pc:spChg chg="add mod topLvl">
          <ac:chgData name="Filippo Acconcia" userId="844af49c-a8a0-47ac-a7dd-14a44b60cd18" providerId="ADAL" clId="{DB596444-B095-4C7A-8C02-1FB2A86092C2}" dt="2022-07-26T10:34:30.018" v="658" actId="164"/>
          <ac:spMkLst>
            <pc:docMk/>
            <pc:sldMk cId="2248971367" sldId="303"/>
            <ac:spMk id="182" creationId="{E92C4116-E33E-E2C1-6FB5-A0E51CDA35F1}"/>
          </ac:spMkLst>
        </pc:spChg>
        <pc:spChg chg="add mod topLvl">
          <ac:chgData name="Filippo Acconcia" userId="844af49c-a8a0-47ac-a7dd-14a44b60cd18" providerId="ADAL" clId="{DB596444-B095-4C7A-8C02-1FB2A86092C2}" dt="2022-07-26T10:34:30.018" v="658" actId="164"/>
          <ac:spMkLst>
            <pc:docMk/>
            <pc:sldMk cId="2248971367" sldId="303"/>
            <ac:spMk id="183" creationId="{28524874-D819-A198-1571-FCACFD2C7484}"/>
          </ac:spMkLst>
        </pc:spChg>
        <pc:spChg chg="add mod">
          <ac:chgData name="Filippo Acconcia" userId="844af49c-a8a0-47ac-a7dd-14a44b60cd18" providerId="ADAL" clId="{DB596444-B095-4C7A-8C02-1FB2A86092C2}" dt="2022-06-11T05:44:46.459" v="77" actId="1076"/>
          <ac:spMkLst>
            <pc:docMk/>
            <pc:sldMk cId="2248971367" sldId="303"/>
            <ac:spMk id="191" creationId="{B29BBB48-13CD-71CF-1A68-901D8373CF6C}"/>
          </ac:spMkLst>
        </pc:spChg>
        <pc:spChg chg="add mod">
          <ac:chgData name="Filippo Acconcia" userId="844af49c-a8a0-47ac-a7dd-14a44b60cd18" providerId="ADAL" clId="{DB596444-B095-4C7A-8C02-1FB2A86092C2}" dt="2022-06-11T05:44:46.459" v="77" actId="1076"/>
          <ac:spMkLst>
            <pc:docMk/>
            <pc:sldMk cId="2248971367" sldId="303"/>
            <ac:spMk id="194" creationId="{25846EE5-72B1-10F3-6ECD-E9A550148D75}"/>
          </ac:spMkLst>
        </pc:spChg>
        <pc:spChg chg="add mod">
          <ac:chgData name="Filippo Acconcia" userId="844af49c-a8a0-47ac-a7dd-14a44b60cd18" providerId="ADAL" clId="{DB596444-B095-4C7A-8C02-1FB2A86092C2}" dt="2022-06-11T05:44:49.635" v="78"/>
          <ac:spMkLst>
            <pc:docMk/>
            <pc:sldMk cId="2248971367" sldId="303"/>
            <ac:spMk id="195" creationId="{3C665EE7-44DF-207E-A446-46773804AF45}"/>
          </ac:spMkLst>
        </pc:spChg>
        <pc:spChg chg="add mod">
          <ac:chgData name="Filippo Acconcia" userId="844af49c-a8a0-47ac-a7dd-14a44b60cd18" providerId="ADAL" clId="{DB596444-B095-4C7A-8C02-1FB2A86092C2}" dt="2022-06-11T05:45:15.830" v="87" actId="1036"/>
          <ac:spMkLst>
            <pc:docMk/>
            <pc:sldMk cId="2248971367" sldId="303"/>
            <ac:spMk id="196" creationId="{0FDACA94-FCE0-606D-2B8F-4C10610CC02E}"/>
          </ac:spMkLst>
        </pc:spChg>
        <pc:spChg chg="mod topLvl">
          <ac:chgData name="Filippo Acconcia" userId="844af49c-a8a0-47ac-a7dd-14a44b60cd18" providerId="ADAL" clId="{DB596444-B095-4C7A-8C02-1FB2A86092C2}" dt="2022-07-26T10:34:30.018" v="658" actId="164"/>
          <ac:spMkLst>
            <pc:docMk/>
            <pc:sldMk cId="2248971367" sldId="303"/>
            <ac:spMk id="197" creationId="{961F6ADF-D7BC-4A78-BD0D-F656A11C271F}"/>
          </ac:spMkLst>
        </pc:spChg>
        <pc:spChg chg="mod topLvl">
          <ac:chgData name="Filippo Acconcia" userId="844af49c-a8a0-47ac-a7dd-14a44b60cd18" providerId="ADAL" clId="{DB596444-B095-4C7A-8C02-1FB2A86092C2}" dt="2022-07-26T10:34:30.018" v="658" actId="164"/>
          <ac:spMkLst>
            <pc:docMk/>
            <pc:sldMk cId="2248971367" sldId="303"/>
            <ac:spMk id="198" creationId="{D96FF9FF-38D3-4EAC-923C-DDBC56D02CBA}"/>
          </ac:spMkLst>
        </pc:spChg>
        <pc:spChg chg="mod topLvl">
          <ac:chgData name="Filippo Acconcia" userId="844af49c-a8a0-47ac-a7dd-14a44b60cd18" providerId="ADAL" clId="{DB596444-B095-4C7A-8C02-1FB2A86092C2}" dt="2022-07-26T10:34:30.018" v="658" actId="164"/>
          <ac:spMkLst>
            <pc:docMk/>
            <pc:sldMk cId="2248971367" sldId="303"/>
            <ac:spMk id="199" creationId="{DEF017D7-78AA-423A-9C7C-41C937FA4D8A}"/>
          </ac:spMkLst>
        </pc:spChg>
        <pc:spChg chg="mod topLvl">
          <ac:chgData name="Filippo Acconcia" userId="844af49c-a8a0-47ac-a7dd-14a44b60cd18" providerId="ADAL" clId="{DB596444-B095-4C7A-8C02-1FB2A86092C2}" dt="2022-07-26T10:34:30.018" v="658" actId="164"/>
          <ac:spMkLst>
            <pc:docMk/>
            <pc:sldMk cId="2248971367" sldId="303"/>
            <ac:spMk id="200" creationId="{0B60EDFE-93E5-40A2-8EE0-0C924CD540A9}"/>
          </ac:spMkLst>
        </pc:spChg>
        <pc:spChg chg="mod topLvl">
          <ac:chgData name="Filippo Acconcia" userId="844af49c-a8a0-47ac-a7dd-14a44b60cd18" providerId="ADAL" clId="{DB596444-B095-4C7A-8C02-1FB2A86092C2}" dt="2022-07-26T10:34:30.018" v="658" actId="164"/>
          <ac:spMkLst>
            <pc:docMk/>
            <pc:sldMk cId="2248971367" sldId="303"/>
            <ac:spMk id="201" creationId="{32A45BA7-1477-4991-B980-6DC3DBF13993}"/>
          </ac:spMkLst>
        </pc:spChg>
        <pc:spChg chg="add mod topLvl">
          <ac:chgData name="Filippo Acconcia" userId="844af49c-a8a0-47ac-a7dd-14a44b60cd18" providerId="ADAL" clId="{DB596444-B095-4C7A-8C02-1FB2A86092C2}" dt="2022-07-26T10:34:30.018" v="658" actId="164"/>
          <ac:spMkLst>
            <pc:docMk/>
            <pc:sldMk cId="2248971367" sldId="303"/>
            <ac:spMk id="202" creationId="{9FDDCB9C-BB7E-234F-0CB9-0748B74ECE04}"/>
          </ac:spMkLst>
        </pc:spChg>
        <pc:spChg chg="del mod topLvl">
          <ac:chgData name="Filippo Acconcia" userId="844af49c-a8a0-47ac-a7dd-14a44b60cd18" providerId="ADAL" clId="{DB596444-B095-4C7A-8C02-1FB2A86092C2}" dt="2022-07-25T06:49:28.104" v="577" actId="478"/>
          <ac:spMkLst>
            <pc:docMk/>
            <pc:sldMk cId="2248971367" sldId="303"/>
            <ac:spMk id="203" creationId="{BED747A0-5733-41C8-A3F4-735CE1BB5D1C}"/>
          </ac:spMkLst>
        </pc:spChg>
        <pc:spChg chg="add mod">
          <ac:chgData name="Filippo Acconcia" userId="844af49c-a8a0-47ac-a7dd-14a44b60cd18" providerId="ADAL" clId="{DB596444-B095-4C7A-8C02-1FB2A86092C2}" dt="2022-06-11T05:45:15.830" v="87" actId="1036"/>
          <ac:spMkLst>
            <pc:docMk/>
            <pc:sldMk cId="2248971367" sldId="303"/>
            <ac:spMk id="204" creationId="{5D84D910-8E3E-03F1-AF43-09DB62945D35}"/>
          </ac:spMkLst>
        </pc:spChg>
        <pc:spChg chg="add mod">
          <ac:chgData name="Filippo Acconcia" userId="844af49c-a8a0-47ac-a7dd-14a44b60cd18" providerId="ADAL" clId="{DB596444-B095-4C7A-8C02-1FB2A86092C2}" dt="2022-06-11T05:45:15.830" v="87" actId="1036"/>
          <ac:spMkLst>
            <pc:docMk/>
            <pc:sldMk cId="2248971367" sldId="303"/>
            <ac:spMk id="205" creationId="{1F6DF63C-F273-1907-E241-48F7532D37A9}"/>
          </ac:spMkLst>
        </pc:spChg>
        <pc:spChg chg="add mod">
          <ac:chgData name="Filippo Acconcia" userId="844af49c-a8a0-47ac-a7dd-14a44b60cd18" providerId="ADAL" clId="{DB596444-B095-4C7A-8C02-1FB2A86092C2}" dt="2022-06-11T05:45:44.838" v="90" actId="6549"/>
          <ac:spMkLst>
            <pc:docMk/>
            <pc:sldMk cId="2248971367" sldId="303"/>
            <ac:spMk id="206" creationId="{211C68C3-53B9-5FD4-F971-0A4218DDE6E5}"/>
          </ac:spMkLst>
        </pc:spChg>
        <pc:spChg chg="add mod topLvl">
          <ac:chgData name="Filippo Acconcia" userId="844af49c-a8a0-47ac-a7dd-14a44b60cd18" providerId="ADAL" clId="{DB596444-B095-4C7A-8C02-1FB2A86092C2}" dt="2022-07-26T10:34:30.018" v="658" actId="164"/>
          <ac:spMkLst>
            <pc:docMk/>
            <pc:sldMk cId="2248971367" sldId="303"/>
            <ac:spMk id="207" creationId="{9D44D22C-775B-794A-5C5A-C0C299403E98}"/>
          </ac:spMkLst>
        </pc:spChg>
        <pc:spChg chg="add mod topLvl">
          <ac:chgData name="Filippo Acconcia" userId="844af49c-a8a0-47ac-a7dd-14a44b60cd18" providerId="ADAL" clId="{DB596444-B095-4C7A-8C02-1FB2A86092C2}" dt="2022-07-26T10:34:30.018" v="658" actId="164"/>
          <ac:spMkLst>
            <pc:docMk/>
            <pc:sldMk cId="2248971367" sldId="303"/>
            <ac:spMk id="208" creationId="{81040BEF-766C-D939-8D43-496880AD845D}"/>
          </ac:spMkLst>
        </pc:spChg>
        <pc:spChg chg="mod topLvl">
          <ac:chgData name="Filippo Acconcia" userId="844af49c-a8a0-47ac-a7dd-14a44b60cd18" providerId="ADAL" clId="{DB596444-B095-4C7A-8C02-1FB2A86092C2}" dt="2022-07-26T10:34:30.018" v="658" actId="164"/>
          <ac:spMkLst>
            <pc:docMk/>
            <pc:sldMk cId="2248971367" sldId="303"/>
            <ac:spMk id="211" creationId="{2521AD77-69B4-4592-8708-256546A50988}"/>
          </ac:spMkLst>
        </pc:spChg>
        <pc:spChg chg="mod topLvl">
          <ac:chgData name="Filippo Acconcia" userId="844af49c-a8a0-47ac-a7dd-14a44b60cd18" providerId="ADAL" clId="{DB596444-B095-4C7A-8C02-1FB2A86092C2}" dt="2022-07-26T10:34:30.018" v="658" actId="164"/>
          <ac:spMkLst>
            <pc:docMk/>
            <pc:sldMk cId="2248971367" sldId="303"/>
            <ac:spMk id="213" creationId="{30C7387D-AD67-479C-AB7A-06EE58C74C1A}"/>
          </ac:spMkLst>
        </pc:spChg>
        <pc:spChg chg="mod topLvl">
          <ac:chgData name="Filippo Acconcia" userId="844af49c-a8a0-47ac-a7dd-14a44b60cd18" providerId="ADAL" clId="{DB596444-B095-4C7A-8C02-1FB2A86092C2}" dt="2022-07-26T10:34:30.018" v="658" actId="164"/>
          <ac:spMkLst>
            <pc:docMk/>
            <pc:sldMk cId="2248971367" sldId="303"/>
            <ac:spMk id="215" creationId="{9B7D52DC-031D-47B9-A525-5EFDB819724F}"/>
          </ac:spMkLst>
        </pc:spChg>
        <pc:spChg chg="mod topLvl">
          <ac:chgData name="Filippo Acconcia" userId="844af49c-a8a0-47ac-a7dd-14a44b60cd18" providerId="ADAL" clId="{DB596444-B095-4C7A-8C02-1FB2A86092C2}" dt="2022-07-26T10:33:31.277" v="647" actId="165"/>
          <ac:spMkLst>
            <pc:docMk/>
            <pc:sldMk cId="2248971367" sldId="303"/>
            <ac:spMk id="216" creationId="{A86D6EC8-6E2F-4EFB-B557-36F7D66DD808}"/>
          </ac:spMkLst>
        </pc:spChg>
        <pc:spChg chg="mod topLvl">
          <ac:chgData name="Filippo Acconcia" userId="844af49c-a8a0-47ac-a7dd-14a44b60cd18" providerId="ADAL" clId="{DB596444-B095-4C7A-8C02-1FB2A86092C2}" dt="2022-07-26T10:33:31.277" v="647" actId="165"/>
          <ac:spMkLst>
            <pc:docMk/>
            <pc:sldMk cId="2248971367" sldId="303"/>
            <ac:spMk id="217" creationId="{9F717EEE-AAA8-4DF2-9A6F-2614483D9879}"/>
          </ac:spMkLst>
        </pc:spChg>
        <pc:spChg chg="mod topLvl">
          <ac:chgData name="Filippo Acconcia" userId="844af49c-a8a0-47ac-a7dd-14a44b60cd18" providerId="ADAL" clId="{DB596444-B095-4C7A-8C02-1FB2A86092C2}" dt="2022-07-26T10:33:31.277" v="647" actId="165"/>
          <ac:spMkLst>
            <pc:docMk/>
            <pc:sldMk cId="2248971367" sldId="303"/>
            <ac:spMk id="218" creationId="{06121880-ACF9-4995-89C8-04B04945349F}"/>
          </ac:spMkLst>
        </pc:spChg>
        <pc:spChg chg="mod topLvl">
          <ac:chgData name="Filippo Acconcia" userId="844af49c-a8a0-47ac-a7dd-14a44b60cd18" providerId="ADAL" clId="{DB596444-B095-4C7A-8C02-1FB2A86092C2}" dt="2022-07-26T10:33:31.277" v="647" actId="165"/>
          <ac:spMkLst>
            <pc:docMk/>
            <pc:sldMk cId="2248971367" sldId="303"/>
            <ac:spMk id="219" creationId="{4B0D22FD-8EBC-40BD-8177-77E38720BF92}"/>
          </ac:spMkLst>
        </pc:spChg>
        <pc:spChg chg="add mod">
          <ac:chgData name="Filippo Acconcia" userId="844af49c-a8a0-47ac-a7dd-14a44b60cd18" providerId="ADAL" clId="{DB596444-B095-4C7A-8C02-1FB2A86092C2}" dt="2022-06-11T05:45:46.513" v="91" actId="6549"/>
          <ac:spMkLst>
            <pc:docMk/>
            <pc:sldMk cId="2248971367" sldId="303"/>
            <ac:spMk id="220" creationId="{6B112BC7-C8DF-BCD2-E8CF-8019FDB9F10B}"/>
          </ac:spMkLst>
        </pc:spChg>
        <pc:spChg chg="add mod">
          <ac:chgData name="Filippo Acconcia" userId="844af49c-a8a0-47ac-a7dd-14a44b60cd18" providerId="ADAL" clId="{DB596444-B095-4C7A-8C02-1FB2A86092C2}" dt="2022-06-11T05:46:08.577" v="93" actId="1076"/>
          <ac:spMkLst>
            <pc:docMk/>
            <pc:sldMk cId="2248971367" sldId="303"/>
            <ac:spMk id="221" creationId="{688ED16D-6BC7-781B-85E5-C9189FA95D9A}"/>
          </ac:spMkLst>
        </pc:spChg>
        <pc:spChg chg="add mod">
          <ac:chgData name="Filippo Acconcia" userId="844af49c-a8a0-47ac-a7dd-14a44b60cd18" providerId="ADAL" clId="{DB596444-B095-4C7A-8C02-1FB2A86092C2}" dt="2022-06-11T05:46:15.572" v="99" actId="1037"/>
          <ac:spMkLst>
            <pc:docMk/>
            <pc:sldMk cId="2248971367" sldId="303"/>
            <ac:spMk id="222" creationId="{3AC94FEE-FA7F-EAFD-7B5C-FB5E0E2E92A1}"/>
          </ac:spMkLst>
        </pc:spChg>
        <pc:spChg chg="add mod">
          <ac:chgData name="Filippo Acconcia" userId="844af49c-a8a0-47ac-a7dd-14a44b60cd18" providerId="ADAL" clId="{DB596444-B095-4C7A-8C02-1FB2A86092C2}" dt="2022-06-11T05:49:24.586" v="107" actId="1076"/>
          <ac:spMkLst>
            <pc:docMk/>
            <pc:sldMk cId="2248971367" sldId="303"/>
            <ac:spMk id="223" creationId="{7B5FB96A-B5C5-5261-3093-B947DA3F51AF}"/>
          </ac:spMkLst>
        </pc:spChg>
        <pc:spChg chg="add mod">
          <ac:chgData name="Filippo Acconcia" userId="844af49c-a8a0-47ac-a7dd-14a44b60cd18" providerId="ADAL" clId="{DB596444-B095-4C7A-8C02-1FB2A86092C2}" dt="2022-06-11T05:49:37.179" v="109" actId="1076"/>
          <ac:spMkLst>
            <pc:docMk/>
            <pc:sldMk cId="2248971367" sldId="303"/>
            <ac:spMk id="224" creationId="{C9490657-70FE-3502-85D2-3423E1C9C6DB}"/>
          </ac:spMkLst>
        </pc:spChg>
        <pc:spChg chg="add mod">
          <ac:chgData name="Filippo Acconcia" userId="844af49c-a8a0-47ac-a7dd-14a44b60cd18" providerId="ADAL" clId="{DB596444-B095-4C7A-8C02-1FB2A86092C2}" dt="2022-06-11T05:49:46.218" v="118" actId="1038"/>
          <ac:spMkLst>
            <pc:docMk/>
            <pc:sldMk cId="2248971367" sldId="303"/>
            <ac:spMk id="225" creationId="{B4139019-D1B9-2E61-2C5E-D2DB55C0084D}"/>
          </ac:spMkLst>
        </pc:spChg>
        <pc:spChg chg="add mod">
          <ac:chgData name="Filippo Acconcia" userId="844af49c-a8a0-47ac-a7dd-14a44b60cd18" providerId="ADAL" clId="{DB596444-B095-4C7A-8C02-1FB2A86092C2}" dt="2022-06-11T05:49:51.183" v="120" actId="1076"/>
          <ac:spMkLst>
            <pc:docMk/>
            <pc:sldMk cId="2248971367" sldId="303"/>
            <ac:spMk id="226" creationId="{04C96369-71AB-5838-3F97-A4F17AB3A84E}"/>
          </ac:spMkLst>
        </pc:spChg>
        <pc:spChg chg="add mod">
          <ac:chgData name="Filippo Acconcia" userId="844af49c-a8a0-47ac-a7dd-14a44b60cd18" providerId="ADAL" clId="{DB596444-B095-4C7A-8C02-1FB2A86092C2}" dt="2022-06-11T05:50:33.222" v="129" actId="1076"/>
          <ac:spMkLst>
            <pc:docMk/>
            <pc:sldMk cId="2248971367" sldId="303"/>
            <ac:spMk id="227" creationId="{C60D6C0D-485D-DFF5-6955-170883933B70}"/>
          </ac:spMkLst>
        </pc:spChg>
        <pc:spChg chg="mod topLvl">
          <ac:chgData name="Filippo Acconcia" userId="844af49c-a8a0-47ac-a7dd-14a44b60cd18" providerId="ADAL" clId="{DB596444-B095-4C7A-8C02-1FB2A86092C2}" dt="2022-07-26T10:34:30.018" v="658" actId="164"/>
          <ac:spMkLst>
            <pc:docMk/>
            <pc:sldMk cId="2248971367" sldId="303"/>
            <ac:spMk id="229" creationId="{325F5CF5-CFDC-48CA-B519-D62DD64F2388}"/>
          </ac:spMkLst>
        </pc:spChg>
        <pc:spChg chg="add mod">
          <ac:chgData name="Filippo Acconcia" userId="844af49c-a8a0-47ac-a7dd-14a44b60cd18" providerId="ADAL" clId="{DB596444-B095-4C7A-8C02-1FB2A86092C2}" dt="2022-06-11T05:50:36.364" v="131" actId="1076"/>
          <ac:spMkLst>
            <pc:docMk/>
            <pc:sldMk cId="2248971367" sldId="303"/>
            <ac:spMk id="230" creationId="{9AE2B585-63AD-8341-2D2E-0B56EF96EA7A}"/>
          </ac:spMkLst>
        </pc:spChg>
        <pc:spChg chg="add mod">
          <ac:chgData name="Filippo Acconcia" userId="844af49c-a8a0-47ac-a7dd-14a44b60cd18" providerId="ADAL" clId="{DB596444-B095-4C7A-8C02-1FB2A86092C2}" dt="2022-06-11T05:50:40.219" v="133" actId="1076"/>
          <ac:spMkLst>
            <pc:docMk/>
            <pc:sldMk cId="2248971367" sldId="303"/>
            <ac:spMk id="231" creationId="{FEDC1F1C-B51F-8D6F-AC4C-4469E2A0E7F2}"/>
          </ac:spMkLst>
        </pc:spChg>
        <pc:spChg chg="add del mod">
          <ac:chgData name="Filippo Acconcia" userId="844af49c-a8a0-47ac-a7dd-14a44b60cd18" providerId="ADAL" clId="{DB596444-B095-4C7A-8C02-1FB2A86092C2}" dt="2022-06-11T05:53:15.529" v="160" actId="1038"/>
          <ac:spMkLst>
            <pc:docMk/>
            <pc:sldMk cId="2248971367" sldId="303"/>
            <ac:spMk id="232" creationId="{BB1DFB66-D278-ECA1-6246-A6610CD0A3E9}"/>
          </ac:spMkLst>
        </pc:spChg>
        <pc:spChg chg="mod">
          <ac:chgData name="Filippo Acconcia" userId="844af49c-a8a0-47ac-a7dd-14a44b60cd18" providerId="ADAL" clId="{DB596444-B095-4C7A-8C02-1FB2A86092C2}" dt="2022-07-26T10:33:31.277" v="647" actId="165"/>
          <ac:spMkLst>
            <pc:docMk/>
            <pc:sldMk cId="2248971367" sldId="303"/>
            <ac:spMk id="234" creationId="{B922982A-31EA-A8F9-0D30-7B609C1D8300}"/>
          </ac:spMkLst>
        </pc:spChg>
        <pc:spChg chg="mod">
          <ac:chgData name="Filippo Acconcia" userId="844af49c-a8a0-47ac-a7dd-14a44b60cd18" providerId="ADAL" clId="{DB596444-B095-4C7A-8C02-1FB2A86092C2}" dt="2022-07-26T10:33:31.277" v="647" actId="165"/>
          <ac:spMkLst>
            <pc:docMk/>
            <pc:sldMk cId="2248971367" sldId="303"/>
            <ac:spMk id="235" creationId="{12D3346F-25D1-A9E7-1844-4A4D27B6304C}"/>
          </ac:spMkLst>
        </pc:spChg>
        <pc:spChg chg="mod">
          <ac:chgData name="Filippo Acconcia" userId="844af49c-a8a0-47ac-a7dd-14a44b60cd18" providerId="ADAL" clId="{DB596444-B095-4C7A-8C02-1FB2A86092C2}" dt="2022-07-26T10:33:31.277" v="647" actId="165"/>
          <ac:spMkLst>
            <pc:docMk/>
            <pc:sldMk cId="2248971367" sldId="303"/>
            <ac:spMk id="236" creationId="{599F4223-DB4F-0DA7-9F58-41549815FE8E}"/>
          </ac:spMkLst>
        </pc:spChg>
        <pc:spChg chg="mod">
          <ac:chgData name="Filippo Acconcia" userId="844af49c-a8a0-47ac-a7dd-14a44b60cd18" providerId="ADAL" clId="{DB596444-B095-4C7A-8C02-1FB2A86092C2}" dt="2022-07-26T10:33:31.277" v="647" actId="165"/>
          <ac:spMkLst>
            <pc:docMk/>
            <pc:sldMk cId="2248971367" sldId="303"/>
            <ac:spMk id="237" creationId="{9E12EC15-01AF-77AC-D70C-A0D5B7060EED}"/>
          </ac:spMkLst>
        </pc:spChg>
        <pc:spChg chg="mod">
          <ac:chgData name="Filippo Acconcia" userId="844af49c-a8a0-47ac-a7dd-14a44b60cd18" providerId="ADAL" clId="{DB596444-B095-4C7A-8C02-1FB2A86092C2}" dt="2022-07-26T10:33:31.277" v="647" actId="165"/>
          <ac:spMkLst>
            <pc:docMk/>
            <pc:sldMk cId="2248971367" sldId="303"/>
            <ac:spMk id="239" creationId="{82AFED8E-F0A1-54E7-877B-FF81603BD37E}"/>
          </ac:spMkLst>
        </pc:spChg>
        <pc:spChg chg="mod">
          <ac:chgData name="Filippo Acconcia" userId="844af49c-a8a0-47ac-a7dd-14a44b60cd18" providerId="ADAL" clId="{DB596444-B095-4C7A-8C02-1FB2A86092C2}" dt="2022-07-26T10:33:31.277" v="647" actId="165"/>
          <ac:spMkLst>
            <pc:docMk/>
            <pc:sldMk cId="2248971367" sldId="303"/>
            <ac:spMk id="240" creationId="{4813D7DF-4D23-84A5-8B62-9E0F4BE2A679}"/>
          </ac:spMkLst>
        </pc:spChg>
        <pc:spChg chg="mod">
          <ac:chgData name="Filippo Acconcia" userId="844af49c-a8a0-47ac-a7dd-14a44b60cd18" providerId="ADAL" clId="{DB596444-B095-4C7A-8C02-1FB2A86092C2}" dt="2022-07-26T10:33:31.277" v="647" actId="165"/>
          <ac:spMkLst>
            <pc:docMk/>
            <pc:sldMk cId="2248971367" sldId="303"/>
            <ac:spMk id="241" creationId="{7988A363-A1C4-F64B-7432-87F305477A6A}"/>
          </ac:spMkLst>
        </pc:spChg>
        <pc:spChg chg="mod">
          <ac:chgData name="Filippo Acconcia" userId="844af49c-a8a0-47ac-a7dd-14a44b60cd18" providerId="ADAL" clId="{DB596444-B095-4C7A-8C02-1FB2A86092C2}" dt="2022-07-26T10:33:31.277" v="647" actId="165"/>
          <ac:spMkLst>
            <pc:docMk/>
            <pc:sldMk cId="2248971367" sldId="303"/>
            <ac:spMk id="242" creationId="{F4A5D80D-D3D3-17F6-949B-9B9B41AB4AD4}"/>
          </ac:spMkLst>
        </pc:spChg>
        <pc:spChg chg="mod">
          <ac:chgData name="Filippo Acconcia" userId="844af49c-a8a0-47ac-a7dd-14a44b60cd18" providerId="ADAL" clId="{DB596444-B095-4C7A-8C02-1FB2A86092C2}" dt="2022-07-26T10:33:31.277" v="647" actId="165"/>
          <ac:spMkLst>
            <pc:docMk/>
            <pc:sldMk cId="2248971367" sldId="303"/>
            <ac:spMk id="244" creationId="{6E7CE3C7-C636-EC69-9EEC-C647CE87F4D7}"/>
          </ac:spMkLst>
        </pc:spChg>
        <pc:spChg chg="mod">
          <ac:chgData name="Filippo Acconcia" userId="844af49c-a8a0-47ac-a7dd-14a44b60cd18" providerId="ADAL" clId="{DB596444-B095-4C7A-8C02-1FB2A86092C2}" dt="2022-07-26T10:33:31.277" v="647" actId="165"/>
          <ac:spMkLst>
            <pc:docMk/>
            <pc:sldMk cId="2248971367" sldId="303"/>
            <ac:spMk id="245" creationId="{D7E153C0-2E1C-6AF1-4482-915EDF9C50D7}"/>
          </ac:spMkLst>
        </pc:spChg>
        <pc:spChg chg="mod">
          <ac:chgData name="Filippo Acconcia" userId="844af49c-a8a0-47ac-a7dd-14a44b60cd18" providerId="ADAL" clId="{DB596444-B095-4C7A-8C02-1FB2A86092C2}" dt="2022-07-26T10:33:31.277" v="647" actId="165"/>
          <ac:spMkLst>
            <pc:docMk/>
            <pc:sldMk cId="2248971367" sldId="303"/>
            <ac:spMk id="246" creationId="{C4B391F6-5E7E-415E-2109-D9C14E2C54E7}"/>
          </ac:spMkLst>
        </pc:spChg>
        <pc:spChg chg="mod">
          <ac:chgData name="Filippo Acconcia" userId="844af49c-a8a0-47ac-a7dd-14a44b60cd18" providerId="ADAL" clId="{DB596444-B095-4C7A-8C02-1FB2A86092C2}" dt="2022-07-26T10:33:31.277" v="647" actId="165"/>
          <ac:spMkLst>
            <pc:docMk/>
            <pc:sldMk cId="2248971367" sldId="303"/>
            <ac:spMk id="247" creationId="{CE0CEBC5-409F-1708-1F4D-9A28493E8F5D}"/>
          </ac:spMkLst>
        </pc:spChg>
        <pc:spChg chg="del mod topLvl">
          <ac:chgData name="Filippo Acconcia" userId="844af49c-a8a0-47ac-a7dd-14a44b60cd18" providerId="ADAL" clId="{DB596444-B095-4C7A-8C02-1FB2A86092C2}" dt="2022-07-23T16:01:16.803" v="416" actId="478"/>
          <ac:spMkLst>
            <pc:docMk/>
            <pc:sldMk cId="2248971367" sldId="303"/>
            <ac:spMk id="281" creationId="{AA5F8B2E-13F7-4F95-9E8D-850AAC0F9C52}"/>
          </ac:spMkLst>
        </pc:spChg>
        <pc:spChg chg="del mod topLvl">
          <ac:chgData name="Filippo Acconcia" userId="844af49c-a8a0-47ac-a7dd-14a44b60cd18" providerId="ADAL" clId="{DB596444-B095-4C7A-8C02-1FB2A86092C2}" dt="2022-07-23T16:01:14.158" v="415" actId="478"/>
          <ac:spMkLst>
            <pc:docMk/>
            <pc:sldMk cId="2248971367" sldId="303"/>
            <ac:spMk id="282" creationId="{0825A960-5FD4-4305-AB2A-801771B0D8AB}"/>
          </ac:spMkLst>
        </pc:spChg>
        <pc:spChg chg="del mod topLvl">
          <ac:chgData name="Filippo Acconcia" userId="844af49c-a8a0-47ac-a7dd-14a44b60cd18" providerId="ADAL" clId="{DB596444-B095-4C7A-8C02-1FB2A86092C2}" dt="2022-07-23T16:01:14.158" v="415" actId="478"/>
          <ac:spMkLst>
            <pc:docMk/>
            <pc:sldMk cId="2248971367" sldId="303"/>
            <ac:spMk id="283" creationId="{533E99F7-1879-4753-9A22-7F567903A68E}"/>
          </ac:spMkLst>
        </pc:spChg>
        <pc:spChg chg="del mod topLvl">
          <ac:chgData name="Filippo Acconcia" userId="844af49c-a8a0-47ac-a7dd-14a44b60cd18" providerId="ADAL" clId="{DB596444-B095-4C7A-8C02-1FB2A86092C2}" dt="2022-07-23T16:01:14.158" v="415" actId="478"/>
          <ac:spMkLst>
            <pc:docMk/>
            <pc:sldMk cId="2248971367" sldId="303"/>
            <ac:spMk id="284" creationId="{9232BCE7-EAED-4432-ADAC-D09C6F9904AF}"/>
          </ac:spMkLst>
        </pc:spChg>
        <pc:spChg chg="del mod topLvl">
          <ac:chgData name="Filippo Acconcia" userId="844af49c-a8a0-47ac-a7dd-14a44b60cd18" providerId="ADAL" clId="{DB596444-B095-4C7A-8C02-1FB2A86092C2}" dt="2022-07-23T16:01:14.158" v="415" actId="478"/>
          <ac:spMkLst>
            <pc:docMk/>
            <pc:sldMk cId="2248971367" sldId="303"/>
            <ac:spMk id="286" creationId="{181DDF4D-6E8B-4043-AC79-1E982D1EBCDF}"/>
          </ac:spMkLst>
        </pc:spChg>
        <pc:spChg chg="del mod topLvl">
          <ac:chgData name="Filippo Acconcia" userId="844af49c-a8a0-47ac-a7dd-14a44b60cd18" providerId="ADAL" clId="{DB596444-B095-4C7A-8C02-1FB2A86092C2}" dt="2022-07-23T16:01:14.158" v="415" actId="478"/>
          <ac:spMkLst>
            <pc:docMk/>
            <pc:sldMk cId="2248971367" sldId="303"/>
            <ac:spMk id="287" creationId="{AEDEF880-A6B7-4447-A461-7E175D1E3591}"/>
          </ac:spMkLst>
        </pc:spChg>
        <pc:spChg chg="del mod topLvl">
          <ac:chgData name="Filippo Acconcia" userId="844af49c-a8a0-47ac-a7dd-14a44b60cd18" providerId="ADAL" clId="{DB596444-B095-4C7A-8C02-1FB2A86092C2}" dt="2022-07-23T16:01:14.158" v="415" actId="478"/>
          <ac:spMkLst>
            <pc:docMk/>
            <pc:sldMk cId="2248971367" sldId="303"/>
            <ac:spMk id="288" creationId="{F200C89C-03E3-4FB9-A4E6-5F282B480623}"/>
          </ac:spMkLst>
        </pc:spChg>
        <pc:spChg chg="del mod topLvl">
          <ac:chgData name="Filippo Acconcia" userId="844af49c-a8a0-47ac-a7dd-14a44b60cd18" providerId="ADAL" clId="{DB596444-B095-4C7A-8C02-1FB2A86092C2}" dt="2022-07-23T16:01:14.158" v="415" actId="478"/>
          <ac:spMkLst>
            <pc:docMk/>
            <pc:sldMk cId="2248971367" sldId="303"/>
            <ac:spMk id="289" creationId="{A9878631-33DC-49BF-B413-1C3E69BDFCB1}"/>
          </ac:spMkLst>
        </pc:spChg>
        <pc:spChg chg="del mod topLvl">
          <ac:chgData name="Filippo Acconcia" userId="844af49c-a8a0-47ac-a7dd-14a44b60cd18" providerId="ADAL" clId="{DB596444-B095-4C7A-8C02-1FB2A86092C2}" dt="2022-07-23T16:01:14.158" v="415" actId="478"/>
          <ac:spMkLst>
            <pc:docMk/>
            <pc:sldMk cId="2248971367" sldId="303"/>
            <ac:spMk id="291" creationId="{137B2A78-0A04-40EA-8E87-278CD9225ABA}"/>
          </ac:spMkLst>
        </pc:spChg>
        <pc:spChg chg="del mod topLvl">
          <ac:chgData name="Filippo Acconcia" userId="844af49c-a8a0-47ac-a7dd-14a44b60cd18" providerId="ADAL" clId="{DB596444-B095-4C7A-8C02-1FB2A86092C2}" dt="2022-07-23T16:01:14.158" v="415" actId="478"/>
          <ac:spMkLst>
            <pc:docMk/>
            <pc:sldMk cId="2248971367" sldId="303"/>
            <ac:spMk id="292" creationId="{29394DE3-EBFC-4753-9915-EF45A75C5D94}"/>
          </ac:spMkLst>
        </pc:spChg>
        <pc:spChg chg="del mod topLvl">
          <ac:chgData name="Filippo Acconcia" userId="844af49c-a8a0-47ac-a7dd-14a44b60cd18" providerId="ADAL" clId="{DB596444-B095-4C7A-8C02-1FB2A86092C2}" dt="2022-07-23T16:01:14.158" v="415" actId="478"/>
          <ac:spMkLst>
            <pc:docMk/>
            <pc:sldMk cId="2248971367" sldId="303"/>
            <ac:spMk id="293" creationId="{36DF659A-76C6-472A-9A36-C4055B7FFA2E}"/>
          </ac:spMkLst>
        </pc:spChg>
        <pc:spChg chg="del mod topLvl">
          <ac:chgData name="Filippo Acconcia" userId="844af49c-a8a0-47ac-a7dd-14a44b60cd18" providerId="ADAL" clId="{DB596444-B095-4C7A-8C02-1FB2A86092C2}" dt="2022-07-23T16:01:14.158" v="415" actId="478"/>
          <ac:spMkLst>
            <pc:docMk/>
            <pc:sldMk cId="2248971367" sldId="303"/>
            <ac:spMk id="294" creationId="{E89656B8-8F27-4068-8AE8-943F77ECBDFD}"/>
          </ac:spMkLst>
        </pc:spChg>
        <pc:grpChg chg="add mod topLvl">
          <ac:chgData name="Filippo Acconcia" userId="844af49c-a8a0-47ac-a7dd-14a44b60cd18" providerId="ADAL" clId="{DB596444-B095-4C7A-8C02-1FB2A86092C2}" dt="2022-07-26T10:34:30.018" v="658" actId="164"/>
          <ac:grpSpMkLst>
            <pc:docMk/>
            <pc:sldMk cId="2248971367" sldId="303"/>
            <ac:grpSpMk id="2" creationId="{8C748785-C034-A082-BA2C-B67844B142A3}"/>
          </ac:grpSpMkLst>
        </pc:grpChg>
        <pc:grpChg chg="add del mod ord">
          <ac:chgData name="Filippo Acconcia" userId="844af49c-a8a0-47ac-a7dd-14a44b60cd18" providerId="ADAL" clId="{DB596444-B095-4C7A-8C02-1FB2A86092C2}" dt="2022-07-26T10:33:31.277" v="647" actId="165"/>
          <ac:grpSpMkLst>
            <pc:docMk/>
            <pc:sldMk cId="2248971367" sldId="303"/>
            <ac:grpSpMk id="4" creationId="{723EE2F6-8CFF-719D-697A-CE64E166B17F}"/>
          </ac:grpSpMkLst>
        </pc:grpChg>
        <pc:grpChg chg="add mod">
          <ac:chgData name="Filippo Acconcia" userId="844af49c-a8a0-47ac-a7dd-14a44b60cd18" providerId="ADAL" clId="{DB596444-B095-4C7A-8C02-1FB2A86092C2}" dt="2022-07-26T10:34:30.018" v="658" actId="164"/>
          <ac:grpSpMkLst>
            <pc:docMk/>
            <pc:sldMk cId="2248971367" sldId="303"/>
            <ac:grpSpMk id="8" creationId="{3687F337-D1D3-01DE-47C0-02127BEE8341}"/>
          </ac:grpSpMkLst>
        </pc:grpChg>
        <pc:grpChg chg="del mod topLvl">
          <ac:chgData name="Filippo Acconcia" userId="844af49c-a8a0-47ac-a7dd-14a44b60cd18" providerId="ADAL" clId="{DB596444-B095-4C7A-8C02-1FB2A86092C2}" dt="2022-07-23T15:59:59.175" v="399" actId="165"/>
          <ac:grpSpMkLst>
            <pc:docMk/>
            <pc:sldMk cId="2248971367" sldId="303"/>
            <ac:grpSpMk id="202" creationId="{8567DF3F-789F-4D62-9472-9773ACD16442}"/>
          </ac:grpSpMkLst>
        </pc:grpChg>
        <pc:grpChg chg="del mod topLvl">
          <ac:chgData name="Filippo Acconcia" userId="844af49c-a8a0-47ac-a7dd-14a44b60cd18" providerId="ADAL" clId="{DB596444-B095-4C7A-8C02-1FB2A86092C2}" dt="2022-07-23T15:59:59.175" v="399" actId="165"/>
          <ac:grpSpMkLst>
            <pc:docMk/>
            <pc:sldMk cId="2248971367" sldId="303"/>
            <ac:grpSpMk id="207" creationId="{20534432-D8E9-463A-BB4D-FFE46E5B8C3A}"/>
          </ac:grpSpMkLst>
        </pc:grpChg>
        <pc:grpChg chg="del mod topLvl">
          <ac:chgData name="Filippo Acconcia" userId="844af49c-a8a0-47ac-a7dd-14a44b60cd18" providerId="ADAL" clId="{DB596444-B095-4C7A-8C02-1FB2A86092C2}" dt="2022-07-23T15:59:59.175" v="399" actId="165"/>
          <ac:grpSpMkLst>
            <pc:docMk/>
            <pc:sldMk cId="2248971367" sldId="303"/>
            <ac:grpSpMk id="208" creationId="{F4D9AC33-35E4-461B-A0FB-B8783173C8EA}"/>
          </ac:grpSpMkLst>
        </pc:grpChg>
        <pc:grpChg chg="del mod topLvl">
          <ac:chgData name="Filippo Acconcia" userId="844af49c-a8a0-47ac-a7dd-14a44b60cd18" providerId="ADAL" clId="{DB596444-B095-4C7A-8C02-1FB2A86092C2}" dt="2022-07-23T15:59:59.175" v="399" actId="165"/>
          <ac:grpSpMkLst>
            <pc:docMk/>
            <pc:sldMk cId="2248971367" sldId="303"/>
            <ac:grpSpMk id="209" creationId="{5D0BF3F4-A8AA-4952-8BFB-EC205E025FCE}"/>
          </ac:grpSpMkLst>
        </pc:grpChg>
        <pc:grpChg chg="add mod topLvl">
          <ac:chgData name="Filippo Acconcia" userId="844af49c-a8a0-47ac-a7dd-14a44b60cd18" providerId="ADAL" clId="{DB596444-B095-4C7A-8C02-1FB2A86092C2}" dt="2022-07-26T10:34:30.018" v="658" actId="164"/>
          <ac:grpSpMkLst>
            <pc:docMk/>
            <pc:sldMk cId="2248971367" sldId="303"/>
            <ac:grpSpMk id="233" creationId="{80D7B6E0-9BBE-5A14-8AA3-9E88D1714DF4}"/>
          </ac:grpSpMkLst>
        </pc:grpChg>
        <pc:grpChg chg="add mod topLvl">
          <ac:chgData name="Filippo Acconcia" userId="844af49c-a8a0-47ac-a7dd-14a44b60cd18" providerId="ADAL" clId="{DB596444-B095-4C7A-8C02-1FB2A86092C2}" dt="2022-07-26T10:34:30.018" v="658" actId="164"/>
          <ac:grpSpMkLst>
            <pc:docMk/>
            <pc:sldMk cId="2248971367" sldId="303"/>
            <ac:grpSpMk id="238" creationId="{3E02D2D2-D06E-FDD8-28CF-AC552DABB223}"/>
          </ac:grpSpMkLst>
        </pc:grpChg>
        <pc:grpChg chg="add mod topLvl">
          <ac:chgData name="Filippo Acconcia" userId="844af49c-a8a0-47ac-a7dd-14a44b60cd18" providerId="ADAL" clId="{DB596444-B095-4C7A-8C02-1FB2A86092C2}" dt="2022-07-26T10:34:30.018" v="658" actId="164"/>
          <ac:grpSpMkLst>
            <pc:docMk/>
            <pc:sldMk cId="2248971367" sldId="303"/>
            <ac:grpSpMk id="243" creationId="{6B068DF0-3320-AE1C-1853-32320CFD3DD8}"/>
          </ac:grpSpMkLst>
        </pc:grpChg>
        <pc:grpChg chg="del mod topLvl">
          <ac:chgData name="Filippo Acconcia" userId="844af49c-a8a0-47ac-a7dd-14a44b60cd18" providerId="ADAL" clId="{DB596444-B095-4C7A-8C02-1FB2A86092C2}" dt="2022-07-23T15:59:59.175" v="399" actId="165"/>
          <ac:grpSpMkLst>
            <pc:docMk/>
            <pc:sldMk cId="2248971367" sldId="303"/>
            <ac:grpSpMk id="279" creationId="{534913A8-7EC1-4DA0-9BB4-57E87CE21156}"/>
          </ac:grpSpMkLst>
        </pc:grpChg>
        <pc:grpChg chg="del mod topLvl">
          <ac:chgData name="Filippo Acconcia" userId="844af49c-a8a0-47ac-a7dd-14a44b60cd18" providerId="ADAL" clId="{DB596444-B095-4C7A-8C02-1FB2A86092C2}" dt="2022-07-23T15:59:59.175" v="399" actId="165"/>
          <ac:grpSpMkLst>
            <pc:docMk/>
            <pc:sldMk cId="2248971367" sldId="303"/>
            <ac:grpSpMk id="280" creationId="{84B844FE-DF46-4CBA-BF68-E6589F00F083}"/>
          </ac:grpSpMkLst>
        </pc:grpChg>
        <pc:grpChg chg="del mod topLvl">
          <ac:chgData name="Filippo Acconcia" userId="844af49c-a8a0-47ac-a7dd-14a44b60cd18" providerId="ADAL" clId="{DB596444-B095-4C7A-8C02-1FB2A86092C2}" dt="2022-07-23T15:59:59.175" v="399" actId="165"/>
          <ac:grpSpMkLst>
            <pc:docMk/>
            <pc:sldMk cId="2248971367" sldId="303"/>
            <ac:grpSpMk id="285" creationId="{5FF5CC32-B259-4CD5-B47D-C87F5A3D7BB2}"/>
          </ac:grpSpMkLst>
        </pc:grpChg>
        <pc:grpChg chg="del mod topLvl">
          <ac:chgData name="Filippo Acconcia" userId="844af49c-a8a0-47ac-a7dd-14a44b60cd18" providerId="ADAL" clId="{DB596444-B095-4C7A-8C02-1FB2A86092C2}" dt="2022-07-23T15:59:59.175" v="399" actId="165"/>
          <ac:grpSpMkLst>
            <pc:docMk/>
            <pc:sldMk cId="2248971367" sldId="303"/>
            <ac:grpSpMk id="290" creationId="{26AA60CB-82E9-45FB-8F7E-40079B4F6448}"/>
          </ac:grpSpMkLst>
        </pc:grpChg>
        <pc:grpChg chg="del">
          <ac:chgData name="Filippo Acconcia" userId="844af49c-a8a0-47ac-a7dd-14a44b60cd18" providerId="ADAL" clId="{DB596444-B095-4C7A-8C02-1FB2A86092C2}" dt="2022-07-23T15:59:56.597" v="398" actId="165"/>
          <ac:grpSpMkLst>
            <pc:docMk/>
            <pc:sldMk cId="2248971367" sldId="303"/>
            <ac:grpSpMk id="296" creationId="{0B2E1F5F-A878-4B59-AF2C-56A70CD29430}"/>
          </ac:grpSpMkLst>
        </pc:grpChg>
        <pc:graphicFrameChg chg="add del mod">
          <ac:chgData name="Filippo Acconcia" userId="844af49c-a8a0-47ac-a7dd-14a44b60cd18" providerId="ADAL" clId="{DB596444-B095-4C7A-8C02-1FB2A86092C2}" dt="2022-06-11T05:42:22.474" v="27"/>
          <ac:graphicFrameMkLst>
            <pc:docMk/>
            <pc:sldMk cId="2248971367" sldId="303"/>
            <ac:graphicFrameMk id="2" creationId="{AC1CF9B6-5506-F563-6FC6-EC5F130BE4BC}"/>
          </ac:graphicFrameMkLst>
        </pc:graphicFrameChg>
        <pc:graphicFrameChg chg="add del mod">
          <ac:chgData name="Filippo Acconcia" userId="844af49c-a8a0-47ac-a7dd-14a44b60cd18" providerId="ADAL" clId="{DB596444-B095-4C7A-8C02-1FB2A86092C2}" dt="2022-06-11T05:43:27.092" v="57" actId="478"/>
          <ac:graphicFrameMkLst>
            <pc:docMk/>
            <pc:sldMk cId="2248971367" sldId="303"/>
            <ac:graphicFrameMk id="3" creationId="{4302C6F1-706C-32A2-6381-F44783FB0A1B}"/>
          </ac:graphicFrameMkLst>
        </pc:graphicFrameChg>
        <pc:graphicFrameChg chg="add del mod">
          <ac:chgData name="Filippo Acconcia" userId="844af49c-a8a0-47ac-a7dd-14a44b60cd18" providerId="ADAL" clId="{DB596444-B095-4C7A-8C02-1FB2A86092C2}" dt="2022-06-11T05:44:00.628" v="70" actId="478"/>
          <ac:graphicFrameMkLst>
            <pc:docMk/>
            <pc:sldMk cId="2248971367" sldId="303"/>
            <ac:graphicFrameMk id="4" creationId="{F4DFC2FF-0A8E-C5C1-7139-FE9F06BD5E61}"/>
          </ac:graphicFrameMkLst>
        </pc:graphicFrameChg>
        <pc:picChg chg="del mod ord topLvl">
          <ac:chgData name="Filippo Acconcia" userId="844af49c-a8a0-47ac-a7dd-14a44b60cd18" providerId="ADAL" clId="{DB596444-B095-4C7A-8C02-1FB2A86092C2}" dt="2022-07-26T10:34:19.920" v="656" actId="478"/>
          <ac:picMkLst>
            <pc:docMk/>
            <pc:sldMk cId="2248971367" sldId="303"/>
            <ac:picMk id="3" creationId="{56589BA1-D75F-CE8D-1C22-41760DDDC53A}"/>
          </ac:picMkLst>
        </pc:picChg>
        <pc:picChg chg="mod ord">
          <ac:chgData name="Filippo Acconcia" userId="844af49c-a8a0-47ac-a7dd-14a44b60cd18" providerId="ADAL" clId="{DB596444-B095-4C7A-8C02-1FB2A86092C2}" dt="2022-07-26T10:34:30.018" v="658" actId="164"/>
          <ac:picMkLst>
            <pc:docMk/>
            <pc:sldMk cId="2248971367" sldId="303"/>
            <ac:picMk id="7" creationId="{E02E0452-0B57-4A1A-A873-B565B5AC312A}"/>
          </ac:picMkLst>
        </pc:picChg>
        <pc:picChg chg="del mod topLvl">
          <ac:chgData name="Filippo Acconcia" userId="844af49c-a8a0-47ac-a7dd-14a44b60cd18" providerId="ADAL" clId="{DB596444-B095-4C7A-8C02-1FB2A86092C2}" dt="2022-07-25T06:46:52.342" v="540" actId="478"/>
          <ac:picMkLst>
            <pc:docMk/>
            <pc:sldMk cId="2248971367" sldId="303"/>
            <ac:picMk id="295" creationId="{2B2610D0-E72F-449F-890B-2D3DA6CEF886}"/>
          </ac:picMkLst>
        </pc:picChg>
        <pc:cxnChg chg="mod topLvl">
          <ac:chgData name="Filippo Acconcia" userId="844af49c-a8a0-47ac-a7dd-14a44b60cd18" providerId="ADAL" clId="{DB596444-B095-4C7A-8C02-1FB2A86092C2}" dt="2022-07-26T10:34:30.018" v="658" actId="164"/>
          <ac:cxnSpMkLst>
            <pc:docMk/>
            <pc:sldMk cId="2248971367" sldId="303"/>
            <ac:cxnSpMk id="210" creationId="{10289708-7DA6-4F83-8633-52AC0FE8109B}"/>
          </ac:cxnSpMkLst>
        </pc:cxnChg>
        <pc:cxnChg chg="mod topLvl">
          <ac:chgData name="Filippo Acconcia" userId="844af49c-a8a0-47ac-a7dd-14a44b60cd18" providerId="ADAL" clId="{DB596444-B095-4C7A-8C02-1FB2A86092C2}" dt="2022-07-26T10:34:30.018" v="658" actId="164"/>
          <ac:cxnSpMkLst>
            <pc:docMk/>
            <pc:sldMk cId="2248971367" sldId="303"/>
            <ac:cxnSpMk id="212" creationId="{53F2FA05-1438-48F7-A37D-6B7A4621318D}"/>
          </ac:cxnSpMkLst>
        </pc:cxnChg>
        <pc:cxnChg chg="mod topLvl">
          <ac:chgData name="Filippo Acconcia" userId="844af49c-a8a0-47ac-a7dd-14a44b60cd18" providerId="ADAL" clId="{DB596444-B095-4C7A-8C02-1FB2A86092C2}" dt="2022-07-26T10:34:30.018" v="658" actId="164"/>
          <ac:cxnSpMkLst>
            <pc:docMk/>
            <pc:sldMk cId="2248971367" sldId="303"/>
            <ac:cxnSpMk id="214" creationId="{444CEB4D-54BA-4DBC-B53D-10E302080913}"/>
          </ac:cxnSpMkLst>
        </pc:cxnChg>
        <pc:cxnChg chg="mod topLvl">
          <ac:chgData name="Filippo Acconcia" userId="844af49c-a8a0-47ac-a7dd-14a44b60cd18" providerId="ADAL" clId="{DB596444-B095-4C7A-8C02-1FB2A86092C2}" dt="2022-07-26T10:34:30.018" v="658" actId="164"/>
          <ac:cxnSpMkLst>
            <pc:docMk/>
            <pc:sldMk cId="2248971367" sldId="303"/>
            <ac:cxnSpMk id="228" creationId="{DCA7DF36-E0CE-4E0A-A069-4A0A82A30397}"/>
          </ac:cxnSpMkLst>
        </pc:cxnChg>
      </pc:sldChg>
    </pc:docChg>
  </pc:docChgLst>
  <pc:docChgLst>
    <pc:chgData name="Filippo Acconcia" userId="844af49c-a8a0-47ac-a7dd-14a44b60cd18" providerId="ADAL" clId="{B609A75A-164F-4066-A006-F59E853DC491}"/>
    <pc:docChg chg="undo redo custSel addSld delSld modSld sldOrd">
      <pc:chgData name="Filippo Acconcia" userId="844af49c-a8a0-47ac-a7dd-14a44b60cd18" providerId="ADAL" clId="{B609A75A-164F-4066-A006-F59E853DC491}" dt="2022-04-29T07:39:17.186" v="1976" actId="1038"/>
      <pc:docMkLst>
        <pc:docMk/>
      </pc:docMkLst>
      <pc:sldChg chg="addSp delSp modSp mod">
        <pc:chgData name="Filippo Acconcia" userId="844af49c-a8a0-47ac-a7dd-14a44b60cd18" providerId="ADAL" clId="{B609A75A-164F-4066-A006-F59E853DC491}" dt="2022-04-01T08:55:21.426" v="1313" actId="1038"/>
        <pc:sldMkLst>
          <pc:docMk/>
          <pc:sldMk cId="2888039256" sldId="295"/>
        </pc:sldMkLst>
        <pc:spChg chg="del mod">
          <ac:chgData name="Filippo Acconcia" userId="844af49c-a8a0-47ac-a7dd-14a44b60cd18" providerId="ADAL" clId="{B609A75A-164F-4066-A006-F59E853DC491}" dt="2022-03-25T07:44:58.576" v="12" actId="478"/>
          <ac:spMkLst>
            <pc:docMk/>
            <pc:sldMk cId="2888039256" sldId="295"/>
            <ac:spMk id="5" creationId="{5F6E9D74-198D-4C0F-867A-54DB5919EEFF}"/>
          </ac:spMkLst>
        </pc:spChg>
        <pc:spChg chg="mod">
          <ac:chgData name="Filippo Acconcia" userId="844af49c-a8a0-47ac-a7dd-14a44b60cd18" providerId="ADAL" clId="{B609A75A-164F-4066-A006-F59E853DC491}" dt="2022-04-01T08:55:13.116" v="1306" actId="552"/>
          <ac:spMkLst>
            <pc:docMk/>
            <pc:sldMk cId="2888039256" sldId="295"/>
            <ac:spMk id="88" creationId="{5F141403-98E2-44F3-856D-84F9A0EADDA5}"/>
          </ac:spMkLst>
        </pc:spChg>
        <pc:spChg chg="mod">
          <ac:chgData name="Filippo Acconcia" userId="844af49c-a8a0-47ac-a7dd-14a44b60cd18" providerId="ADAL" clId="{B609A75A-164F-4066-A006-F59E853DC491}" dt="2022-04-01T08:54:09.845" v="1282" actId="1037"/>
          <ac:spMkLst>
            <pc:docMk/>
            <pc:sldMk cId="2888039256" sldId="295"/>
            <ac:spMk id="96" creationId="{970C19F9-AB05-4498-A2B2-2E944F559A7E}"/>
          </ac:spMkLst>
        </pc:spChg>
        <pc:spChg chg="mod">
          <ac:chgData name="Filippo Acconcia" userId="844af49c-a8a0-47ac-a7dd-14a44b60cd18" providerId="ADAL" clId="{B609A75A-164F-4066-A006-F59E853DC491}" dt="2022-03-25T07:45:08.296" v="13"/>
          <ac:spMkLst>
            <pc:docMk/>
            <pc:sldMk cId="2888039256" sldId="295"/>
            <ac:spMk id="106" creationId="{6051DCAE-D2C8-4C59-A48F-045989667A93}"/>
          </ac:spMkLst>
        </pc:spChg>
        <pc:spChg chg="mod">
          <ac:chgData name="Filippo Acconcia" userId="844af49c-a8a0-47ac-a7dd-14a44b60cd18" providerId="ADAL" clId="{B609A75A-164F-4066-A006-F59E853DC491}" dt="2022-03-25T07:45:08.296" v="13"/>
          <ac:spMkLst>
            <pc:docMk/>
            <pc:sldMk cId="2888039256" sldId="295"/>
            <ac:spMk id="107" creationId="{AC2F678F-F600-4747-A78A-4417D595D6E5}"/>
          </ac:spMkLst>
        </pc:spChg>
        <pc:spChg chg="mod">
          <ac:chgData name="Filippo Acconcia" userId="844af49c-a8a0-47ac-a7dd-14a44b60cd18" providerId="ADAL" clId="{B609A75A-164F-4066-A006-F59E853DC491}" dt="2022-03-25T07:45:08.296" v="13"/>
          <ac:spMkLst>
            <pc:docMk/>
            <pc:sldMk cId="2888039256" sldId="295"/>
            <ac:spMk id="108" creationId="{8C9F2B22-58B8-422B-834F-1814C672E033}"/>
          </ac:spMkLst>
        </pc:spChg>
        <pc:spChg chg="mod">
          <ac:chgData name="Filippo Acconcia" userId="844af49c-a8a0-47ac-a7dd-14a44b60cd18" providerId="ADAL" clId="{B609A75A-164F-4066-A006-F59E853DC491}" dt="2022-03-25T07:45:08.296" v="13"/>
          <ac:spMkLst>
            <pc:docMk/>
            <pc:sldMk cId="2888039256" sldId="295"/>
            <ac:spMk id="109" creationId="{A51E3BCB-BF13-46FD-AE17-6BA6830F8C97}"/>
          </ac:spMkLst>
        </pc:spChg>
        <pc:spChg chg="mod">
          <ac:chgData name="Filippo Acconcia" userId="844af49c-a8a0-47ac-a7dd-14a44b60cd18" providerId="ADAL" clId="{B609A75A-164F-4066-A006-F59E853DC491}" dt="2022-03-25T07:45:08.296" v="13"/>
          <ac:spMkLst>
            <pc:docMk/>
            <pc:sldMk cId="2888039256" sldId="295"/>
            <ac:spMk id="110" creationId="{27F2720F-5CB5-4C8E-91C3-66E6FB4A21E9}"/>
          </ac:spMkLst>
        </pc:spChg>
        <pc:spChg chg="mod">
          <ac:chgData name="Filippo Acconcia" userId="844af49c-a8a0-47ac-a7dd-14a44b60cd18" providerId="ADAL" clId="{B609A75A-164F-4066-A006-F59E853DC491}" dt="2022-03-25T07:45:08.296" v="13"/>
          <ac:spMkLst>
            <pc:docMk/>
            <pc:sldMk cId="2888039256" sldId="295"/>
            <ac:spMk id="111" creationId="{44C6444A-8361-4702-B361-B2E074BB7C36}"/>
          </ac:spMkLst>
        </pc:spChg>
        <pc:spChg chg="mod">
          <ac:chgData name="Filippo Acconcia" userId="844af49c-a8a0-47ac-a7dd-14a44b60cd18" providerId="ADAL" clId="{B609A75A-164F-4066-A006-F59E853DC491}" dt="2022-03-25T07:45:08.296" v="13"/>
          <ac:spMkLst>
            <pc:docMk/>
            <pc:sldMk cId="2888039256" sldId="295"/>
            <ac:spMk id="113" creationId="{DBDDFF25-CAEB-4BCB-A352-6578268AE898}"/>
          </ac:spMkLst>
        </pc:spChg>
        <pc:spChg chg="mod">
          <ac:chgData name="Filippo Acconcia" userId="844af49c-a8a0-47ac-a7dd-14a44b60cd18" providerId="ADAL" clId="{B609A75A-164F-4066-A006-F59E853DC491}" dt="2022-03-25T07:45:08.296" v="13"/>
          <ac:spMkLst>
            <pc:docMk/>
            <pc:sldMk cId="2888039256" sldId="295"/>
            <ac:spMk id="114" creationId="{7D92297D-AFB2-4DE8-AF4E-9B4FB14773CA}"/>
          </ac:spMkLst>
        </pc:spChg>
        <pc:spChg chg="mod topLvl">
          <ac:chgData name="Filippo Acconcia" userId="844af49c-a8a0-47ac-a7dd-14a44b60cd18" providerId="ADAL" clId="{B609A75A-164F-4066-A006-F59E853DC491}" dt="2022-04-01T08:54:57.863" v="1299" actId="164"/>
          <ac:spMkLst>
            <pc:docMk/>
            <pc:sldMk cId="2888039256" sldId="295"/>
            <ac:spMk id="126" creationId="{B877142C-1A13-4302-B75F-0C9E820E9AB9}"/>
          </ac:spMkLst>
        </pc:spChg>
        <pc:spChg chg="mod topLvl">
          <ac:chgData name="Filippo Acconcia" userId="844af49c-a8a0-47ac-a7dd-14a44b60cd18" providerId="ADAL" clId="{B609A75A-164F-4066-A006-F59E853DC491}" dt="2022-04-01T08:54:57.863" v="1299" actId="164"/>
          <ac:spMkLst>
            <pc:docMk/>
            <pc:sldMk cId="2888039256" sldId="295"/>
            <ac:spMk id="127" creationId="{A5541041-4480-4F0C-A464-5B1210A7C37F}"/>
          </ac:spMkLst>
        </pc:spChg>
        <pc:spChg chg="mod">
          <ac:chgData name="Filippo Acconcia" userId="844af49c-a8a0-47ac-a7dd-14a44b60cd18" providerId="ADAL" clId="{B609A75A-164F-4066-A006-F59E853DC491}" dt="2022-04-01T08:55:13.116" v="1306" actId="552"/>
          <ac:spMkLst>
            <pc:docMk/>
            <pc:sldMk cId="2888039256" sldId="295"/>
            <ac:spMk id="147" creationId="{0F7A31F7-4AAC-46BF-B86E-1B1092BFED7D}"/>
          </ac:spMkLst>
        </pc:spChg>
        <pc:spChg chg="mod">
          <ac:chgData name="Filippo Acconcia" userId="844af49c-a8a0-47ac-a7dd-14a44b60cd18" providerId="ADAL" clId="{B609A75A-164F-4066-A006-F59E853DC491}" dt="2022-04-01T08:54:09.845" v="1282" actId="1037"/>
          <ac:spMkLst>
            <pc:docMk/>
            <pc:sldMk cId="2888039256" sldId="295"/>
            <ac:spMk id="148" creationId="{B475F295-EC05-4EBB-8B70-9E4A2516E1AA}"/>
          </ac:spMkLst>
        </pc:spChg>
        <pc:spChg chg="mod">
          <ac:chgData name="Filippo Acconcia" userId="844af49c-a8a0-47ac-a7dd-14a44b60cd18" providerId="ADAL" clId="{B609A75A-164F-4066-A006-F59E853DC491}" dt="2022-04-01T08:55:13.116" v="1306" actId="552"/>
          <ac:spMkLst>
            <pc:docMk/>
            <pc:sldMk cId="2888039256" sldId="295"/>
            <ac:spMk id="156" creationId="{48DC79B3-B365-4875-9242-0B92EE392CF8}"/>
          </ac:spMkLst>
        </pc:spChg>
        <pc:spChg chg="add mod">
          <ac:chgData name="Filippo Acconcia" userId="844af49c-a8a0-47ac-a7dd-14a44b60cd18" providerId="ADAL" clId="{B609A75A-164F-4066-A006-F59E853DC491}" dt="2022-03-28T06:52:51.199" v="90" actId="20577"/>
          <ac:spMkLst>
            <pc:docMk/>
            <pc:sldMk cId="2888039256" sldId="295"/>
            <ac:spMk id="157" creationId="{0E75F2E8-9137-4F6F-AE7E-084650A18054}"/>
          </ac:spMkLst>
        </pc:spChg>
        <pc:spChg chg="del">
          <ac:chgData name="Filippo Acconcia" userId="844af49c-a8a0-47ac-a7dd-14a44b60cd18" providerId="ADAL" clId="{B609A75A-164F-4066-A006-F59E853DC491}" dt="2022-03-25T07:52:41.185" v="17" actId="478"/>
          <ac:spMkLst>
            <pc:docMk/>
            <pc:sldMk cId="2888039256" sldId="295"/>
            <ac:spMk id="157" creationId="{A723373F-D198-44A9-8229-65948A422739}"/>
          </ac:spMkLst>
        </pc:spChg>
        <pc:spChg chg="mod topLvl">
          <ac:chgData name="Filippo Acconcia" userId="844af49c-a8a0-47ac-a7dd-14a44b60cd18" providerId="ADAL" clId="{B609A75A-164F-4066-A006-F59E853DC491}" dt="2022-04-01T08:54:57.863" v="1299" actId="164"/>
          <ac:spMkLst>
            <pc:docMk/>
            <pc:sldMk cId="2888039256" sldId="295"/>
            <ac:spMk id="158" creationId="{2D74B9CF-8DB7-48C9-B286-56A255842300}"/>
          </ac:spMkLst>
        </pc:spChg>
        <pc:spChg chg="mod topLvl">
          <ac:chgData name="Filippo Acconcia" userId="844af49c-a8a0-47ac-a7dd-14a44b60cd18" providerId="ADAL" clId="{B609A75A-164F-4066-A006-F59E853DC491}" dt="2022-04-01T08:54:57.863" v="1299" actId="164"/>
          <ac:spMkLst>
            <pc:docMk/>
            <pc:sldMk cId="2888039256" sldId="295"/>
            <ac:spMk id="159" creationId="{8BAA827C-58B6-43F6-B1F6-3216A91F9E80}"/>
          </ac:spMkLst>
        </pc:spChg>
        <pc:spChg chg="mod topLvl">
          <ac:chgData name="Filippo Acconcia" userId="844af49c-a8a0-47ac-a7dd-14a44b60cd18" providerId="ADAL" clId="{B609A75A-164F-4066-A006-F59E853DC491}" dt="2022-04-01T08:54:57.863" v="1299" actId="164"/>
          <ac:spMkLst>
            <pc:docMk/>
            <pc:sldMk cId="2888039256" sldId="295"/>
            <ac:spMk id="160" creationId="{B46C4965-43E6-4AF8-B21D-D442DB4A3327}"/>
          </ac:spMkLst>
        </pc:spChg>
        <pc:spChg chg="mod topLvl">
          <ac:chgData name="Filippo Acconcia" userId="844af49c-a8a0-47ac-a7dd-14a44b60cd18" providerId="ADAL" clId="{B609A75A-164F-4066-A006-F59E853DC491}" dt="2022-04-01T08:54:57.863" v="1299" actId="164"/>
          <ac:spMkLst>
            <pc:docMk/>
            <pc:sldMk cId="2888039256" sldId="295"/>
            <ac:spMk id="161" creationId="{4DAC1F6A-9B35-4988-8FCF-FE580A642A58}"/>
          </ac:spMkLst>
        </pc:spChg>
        <pc:spChg chg="mod topLvl">
          <ac:chgData name="Filippo Acconcia" userId="844af49c-a8a0-47ac-a7dd-14a44b60cd18" providerId="ADAL" clId="{B609A75A-164F-4066-A006-F59E853DC491}" dt="2022-04-01T08:54:57.863" v="1299" actId="164"/>
          <ac:spMkLst>
            <pc:docMk/>
            <pc:sldMk cId="2888039256" sldId="295"/>
            <ac:spMk id="162" creationId="{D950C0E2-9792-490E-9ACE-12E65888DE78}"/>
          </ac:spMkLst>
        </pc:spChg>
        <pc:spChg chg="add mod">
          <ac:chgData name="Filippo Acconcia" userId="844af49c-a8a0-47ac-a7dd-14a44b60cd18" providerId="ADAL" clId="{B609A75A-164F-4066-A006-F59E853DC491}" dt="2022-04-01T08:55:13.116" v="1306" actId="552"/>
          <ac:spMkLst>
            <pc:docMk/>
            <pc:sldMk cId="2888039256" sldId="295"/>
            <ac:spMk id="163" creationId="{ADDDBA1C-7034-43D9-8DED-BFB514D1D6B6}"/>
          </ac:spMkLst>
        </pc:spChg>
        <pc:spChg chg="add mod">
          <ac:chgData name="Filippo Acconcia" userId="844af49c-a8a0-47ac-a7dd-14a44b60cd18" providerId="ADAL" clId="{B609A75A-164F-4066-A006-F59E853DC491}" dt="2022-04-01T08:54:29.048" v="1289" actId="313"/>
          <ac:spMkLst>
            <pc:docMk/>
            <pc:sldMk cId="2888039256" sldId="295"/>
            <ac:spMk id="164" creationId="{C598F0F0-7F50-4217-820A-313BB815C59F}"/>
          </ac:spMkLst>
        </pc:spChg>
        <pc:grpChg chg="add mod">
          <ac:chgData name="Filippo Acconcia" userId="844af49c-a8a0-47ac-a7dd-14a44b60cd18" providerId="ADAL" clId="{B609A75A-164F-4066-A006-F59E853DC491}" dt="2022-04-01T08:55:03.050" v="1302" actId="1036"/>
          <ac:grpSpMkLst>
            <pc:docMk/>
            <pc:sldMk cId="2888039256" sldId="295"/>
            <ac:grpSpMk id="2" creationId="{A1C015AB-B898-4979-AFBF-C2BDB14F2D9B}"/>
          </ac:grpSpMkLst>
        </pc:grpChg>
        <pc:grpChg chg="mod">
          <ac:chgData name="Filippo Acconcia" userId="844af49c-a8a0-47ac-a7dd-14a44b60cd18" providerId="ADAL" clId="{B609A75A-164F-4066-A006-F59E853DC491}" dt="2022-04-01T08:55:17.685" v="1311" actId="1037"/>
          <ac:grpSpMkLst>
            <pc:docMk/>
            <pc:sldMk cId="2888039256" sldId="295"/>
            <ac:grpSpMk id="71" creationId="{19628C25-E179-424E-B139-7B7C0AE38B1B}"/>
          </ac:grpSpMkLst>
        </pc:grpChg>
        <pc:grpChg chg="mod">
          <ac:chgData name="Filippo Acconcia" userId="844af49c-a8a0-47ac-a7dd-14a44b60cd18" providerId="ADAL" clId="{B609A75A-164F-4066-A006-F59E853DC491}" dt="2022-04-01T08:55:21.426" v="1313" actId="1038"/>
          <ac:grpSpMkLst>
            <pc:docMk/>
            <pc:sldMk cId="2888039256" sldId="295"/>
            <ac:grpSpMk id="89" creationId="{BCF3E8D0-66FD-44BE-A2AC-EA034F5E2E13}"/>
          </ac:grpSpMkLst>
        </pc:grpChg>
        <pc:grpChg chg="mod">
          <ac:chgData name="Filippo Acconcia" userId="844af49c-a8a0-47ac-a7dd-14a44b60cd18" providerId="ADAL" clId="{B609A75A-164F-4066-A006-F59E853DC491}" dt="2022-04-01T08:54:05.082" v="1279" actId="1076"/>
          <ac:grpSpMkLst>
            <pc:docMk/>
            <pc:sldMk cId="2888039256" sldId="295"/>
            <ac:grpSpMk id="97" creationId="{DD5F5B2A-CC68-4A57-9293-46C090F8304E}"/>
          </ac:grpSpMkLst>
        </pc:grpChg>
        <pc:grpChg chg="add mod">
          <ac:chgData name="Filippo Acconcia" userId="844af49c-a8a0-47ac-a7dd-14a44b60cd18" providerId="ADAL" clId="{B609A75A-164F-4066-A006-F59E853DC491}" dt="2022-04-01T08:55:21.426" v="1313" actId="1038"/>
          <ac:grpSpMkLst>
            <pc:docMk/>
            <pc:sldMk cId="2888039256" sldId="295"/>
            <ac:grpSpMk id="104" creationId="{A02B97BC-E35A-4BA3-A24B-48325D30302B}"/>
          </ac:grpSpMkLst>
        </pc:grpChg>
        <pc:grpChg chg="mod">
          <ac:chgData name="Filippo Acconcia" userId="844af49c-a8a0-47ac-a7dd-14a44b60cd18" providerId="ADAL" clId="{B609A75A-164F-4066-A006-F59E853DC491}" dt="2022-03-25T07:45:08.296" v="13"/>
          <ac:grpSpMkLst>
            <pc:docMk/>
            <pc:sldMk cId="2888039256" sldId="295"/>
            <ac:grpSpMk id="112" creationId="{450FDBD4-B19D-43B5-9F76-8673D7685484}"/>
          </ac:grpSpMkLst>
        </pc:grpChg>
        <pc:grpChg chg="add del mod">
          <ac:chgData name="Filippo Acconcia" userId="844af49c-a8a0-47ac-a7dd-14a44b60cd18" providerId="ADAL" clId="{B609A75A-164F-4066-A006-F59E853DC491}" dt="2022-04-01T08:54:48.185" v="1292" actId="165"/>
          <ac:grpSpMkLst>
            <pc:docMk/>
            <pc:sldMk cId="2888039256" sldId="295"/>
            <ac:grpSpMk id="116" creationId="{51375FE5-39E7-4AB2-84C8-F1677E0836FE}"/>
          </ac:grpSpMkLst>
        </pc:grpChg>
        <pc:grpChg chg="mod">
          <ac:chgData name="Filippo Acconcia" userId="844af49c-a8a0-47ac-a7dd-14a44b60cd18" providerId="ADAL" clId="{B609A75A-164F-4066-A006-F59E853DC491}" dt="2022-04-01T08:54:05.082" v="1279" actId="1076"/>
          <ac:grpSpMkLst>
            <pc:docMk/>
            <pc:sldMk cId="2888039256" sldId="295"/>
            <ac:grpSpMk id="123" creationId="{59541AB8-63FD-4849-A88B-2927A82587C4}"/>
          </ac:grpSpMkLst>
        </pc:grpChg>
        <pc:grpChg chg="mod">
          <ac:chgData name="Filippo Acconcia" userId="844af49c-a8a0-47ac-a7dd-14a44b60cd18" providerId="ADAL" clId="{B609A75A-164F-4066-A006-F59E853DC491}" dt="2022-04-01T08:55:03.050" v="1302" actId="1036"/>
          <ac:grpSpMkLst>
            <pc:docMk/>
            <pc:sldMk cId="2888039256" sldId="295"/>
            <ac:grpSpMk id="149" creationId="{4766C56B-99B3-4A21-B905-02006B2FD621}"/>
          </ac:grpSpMkLst>
        </pc:grpChg>
        <pc:picChg chg="mod">
          <ac:chgData name="Filippo Acconcia" userId="844af49c-a8a0-47ac-a7dd-14a44b60cd18" providerId="ADAL" clId="{B609A75A-164F-4066-A006-F59E853DC491}" dt="2022-03-25T07:45:08.296" v="13"/>
          <ac:picMkLst>
            <pc:docMk/>
            <pc:sldMk cId="2888039256" sldId="295"/>
            <ac:picMk id="105" creationId="{34537AE8-7A55-48EC-9628-21DE7FA060BD}"/>
          </ac:picMkLst>
        </pc:picChg>
        <pc:picChg chg="mod">
          <ac:chgData name="Filippo Acconcia" userId="844af49c-a8a0-47ac-a7dd-14a44b60cd18" providerId="ADAL" clId="{B609A75A-164F-4066-A006-F59E853DC491}" dt="2022-03-25T07:45:08.296" v="13"/>
          <ac:picMkLst>
            <pc:docMk/>
            <pc:sldMk cId="2888039256" sldId="295"/>
            <ac:picMk id="115" creationId="{6578727A-9AF4-453B-80AD-345848813B74}"/>
          </ac:picMkLst>
        </pc:picChg>
        <pc:picChg chg="mod topLvl">
          <ac:chgData name="Filippo Acconcia" userId="844af49c-a8a0-47ac-a7dd-14a44b60cd18" providerId="ADAL" clId="{B609A75A-164F-4066-A006-F59E853DC491}" dt="2022-04-01T08:54:57.863" v="1299" actId="164"/>
          <ac:picMkLst>
            <pc:docMk/>
            <pc:sldMk cId="2888039256" sldId="295"/>
            <ac:picMk id="117" creationId="{26A403BC-692B-4C1F-9717-7FB08341D918}"/>
          </ac:picMkLst>
        </pc:picChg>
      </pc:sldChg>
      <pc:sldChg chg="addSp delSp modSp mod">
        <pc:chgData name="Filippo Acconcia" userId="844af49c-a8a0-47ac-a7dd-14a44b60cd18" providerId="ADAL" clId="{B609A75A-164F-4066-A006-F59E853DC491}" dt="2022-03-30T08:05:07.951" v="456" actId="1038"/>
        <pc:sldMkLst>
          <pc:docMk/>
          <pc:sldMk cId="2620120220" sldId="296"/>
        </pc:sldMkLst>
        <pc:spChg chg="mod">
          <ac:chgData name="Filippo Acconcia" userId="844af49c-a8a0-47ac-a7dd-14a44b60cd18" providerId="ADAL" clId="{B609A75A-164F-4066-A006-F59E853DC491}" dt="2022-03-28T07:32:12.176" v="220" actId="12788"/>
          <ac:spMkLst>
            <pc:docMk/>
            <pc:sldMk cId="2620120220" sldId="296"/>
            <ac:spMk id="39" creationId="{8A01E6F1-0440-4ED6-B837-21F248CD0B8D}"/>
          </ac:spMkLst>
        </pc:spChg>
        <pc:spChg chg="mod">
          <ac:chgData name="Filippo Acconcia" userId="844af49c-a8a0-47ac-a7dd-14a44b60cd18" providerId="ADAL" clId="{B609A75A-164F-4066-A006-F59E853DC491}" dt="2022-03-28T07:32:21.674" v="238" actId="1038"/>
          <ac:spMkLst>
            <pc:docMk/>
            <pc:sldMk cId="2620120220" sldId="296"/>
            <ac:spMk id="40" creationId="{88E0AE6A-D758-4B38-925D-58E303D2D885}"/>
          </ac:spMkLst>
        </pc:spChg>
        <pc:spChg chg="mod">
          <ac:chgData name="Filippo Acconcia" userId="844af49c-a8a0-47ac-a7dd-14a44b60cd18" providerId="ADAL" clId="{B609A75A-164F-4066-A006-F59E853DC491}" dt="2022-03-28T07:32:12.176" v="220" actId="12788"/>
          <ac:spMkLst>
            <pc:docMk/>
            <pc:sldMk cId="2620120220" sldId="296"/>
            <ac:spMk id="92" creationId="{E9CF0909-687C-4E54-9BB8-8832A3B56B91}"/>
          </ac:spMkLst>
        </pc:spChg>
        <pc:spChg chg="mod">
          <ac:chgData name="Filippo Acconcia" userId="844af49c-a8a0-47ac-a7dd-14a44b60cd18" providerId="ADAL" clId="{B609A75A-164F-4066-A006-F59E853DC491}" dt="2022-03-28T07:32:12.176" v="220" actId="12788"/>
          <ac:spMkLst>
            <pc:docMk/>
            <pc:sldMk cId="2620120220" sldId="296"/>
            <ac:spMk id="119" creationId="{C92280B0-FF3A-453F-8913-6416D71F08B0}"/>
          </ac:spMkLst>
        </pc:spChg>
        <pc:spChg chg="mod">
          <ac:chgData name="Filippo Acconcia" userId="844af49c-a8a0-47ac-a7dd-14a44b60cd18" providerId="ADAL" clId="{B609A75A-164F-4066-A006-F59E853DC491}" dt="2022-03-28T07:31:10.757" v="205" actId="1035"/>
          <ac:spMkLst>
            <pc:docMk/>
            <pc:sldMk cId="2620120220" sldId="296"/>
            <ac:spMk id="126" creationId="{0D203BCE-4839-473E-A5CE-AB1C75748440}"/>
          </ac:spMkLst>
        </pc:spChg>
        <pc:spChg chg="mod">
          <ac:chgData name="Filippo Acconcia" userId="844af49c-a8a0-47ac-a7dd-14a44b60cd18" providerId="ADAL" clId="{B609A75A-164F-4066-A006-F59E853DC491}" dt="2022-03-28T07:30:40.514" v="186" actId="1076"/>
          <ac:spMkLst>
            <pc:docMk/>
            <pc:sldMk cId="2620120220" sldId="296"/>
            <ac:spMk id="162" creationId="{510DF2C2-36F6-44BE-BB26-F0FD8A9A79B9}"/>
          </ac:spMkLst>
        </pc:spChg>
        <pc:spChg chg="add mod">
          <ac:chgData name="Filippo Acconcia" userId="844af49c-a8a0-47ac-a7dd-14a44b60cd18" providerId="ADAL" clId="{B609A75A-164F-4066-A006-F59E853DC491}" dt="2022-03-28T07:28:40.024" v="146" actId="20577"/>
          <ac:spMkLst>
            <pc:docMk/>
            <pc:sldMk cId="2620120220" sldId="296"/>
            <ac:spMk id="204" creationId="{56595A4C-E202-46D6-8C35-E92377F2E95A}"/>
          </ac:spMkLst>
        </pc:spChg>
        <pc:grpChg chg="mod">
          <ac:chgData name="Filippo Acconcia" userId="844af49c-a8a0-47ac-a7dd-14a44b60cd18" providerId="ADAL" clId="{B609A75A-164F-4066-A006-F59E853DC491}" dt="2022-03-28T07:32:18.592" v="231" actId="1038"/>
          <ac:grpSpMkLst>
            <pc:docMk/>
            <pc:sldMk cId="2620120220" sldId="296"/>
            <ac:grpSpMk id="2" creationId="{79BF29A4-9A77-43C2-8CF8-380CD9378097}"/>
          </ac:grpSpMkLst>
        </pc:grpChg>
        <pc:grpChg chg="mod">
          <ac:chgData name="Filippo Acconcia" userId="844af49c-a8a0-47ac-a7dd-14a44b60cd18" providerId="ADAL" clId="{B609A75A-164F-4066-A006-F59E853DC491}" dt="2022-03-28T07:32:17.505" v="228" actId="1038"/>
          <ac:grpSpMkLst>
            <pc:docMk/>
            <pc:sldMk cId="2620120220" sldId="296"/>
            <ac:grpSpMk id="26" creationId="{E39CF939-00E1-4278-9E9C-B77A1AF487B0}"/>
          </ac:grpSpMkLst>
        </pc:grpChg>
        <pc:grpChg chg="del mod">
          <ac:chgData name="Filippo Acconcia" userId="844af49c-a8a0-47ac-a7dd-14a44b60cd18" providerId="ADAL" clId="{B609A75A-164F-4066-A006-F59E853DC491}" dt="2022-03-28T07:31:35.515" v="209" actId="21"/>
          <ac:grpSpMkLst>
            <pc:docMk/>
            <pc:sldMk cId="2620120220" sldId="296"/>
            <ac:grpSpMk id="41" creationId="{145C4BD0-3163-4E4F-ADDF-3781A36814D3}"/>
          </ac:grpSpMkLst>
        </pc:grpChg>
        <pc:grpChg chg="del mod">
          <ac:chgData name="Filippo Acconcia" userId="844af49c-a8a0-47ac-a7dd-14a44b60cd18" providerId="ADAL" clId="{B609A75A-164F-4066-A006-F59E853DC491}" dt="2022-03-28T07:31:35.515" v="209" actId="21"/>
          <ac:grpSpMkLst>
            <pc:docMk/>
            <pc:sldMk cId="2620120220" sldId="296"/>
            <ac:grpSpMk id="93" creationId="{330071B1-C6CD-4C2F-AD1F-8F9B0F215A79}"/>
          </ac:grpSpMkLst>
        </pc:grpChg>
        <pc:grpChg chg="mod">
          <ac:chgData name="Filippo Acconcia" userId="844af49c-a8a0-47ac-a7dd-14a44b60cd18" providerId="ADAL" clId="{B609A75A-164F-4066-A006-F59E853DC491}" dt="2022-03-28T07:31:57.553" v="216" actId="1036"/>
          <ac:grpSpMkLst>
            <pc:docMk/>
            <pc:sldMk cId="2620120220" sldId="296"/>
            <ac:grpSpMk id="120" creationId="{6F93F66D-1ED6-4A72-B1C0-B713F6244D97}"/>
          </ac:grpSpMkLst>
        </pc:grpChg>
        <pc:grpChg chg="mod">
          <ac:chgData name="Filippo Acconcia" userId="844af49c-a8a0-47ac-a7dd-14a44b60cd18" providerId="ADAL" clId="{B609A75A-164F-4066-A006-F59E853DC491}" dt="2022-03-30T08:05:00.821" v="453" actId="1076"/>
          <ac:grpSpMkLst>
            <pc:docMk/>
            <pc:sldMk cId="2620120220" sldId="296"/>
            <ac:grpSpMk id="135" creationId="{0E35562E-E712-4BCC-A8C6-D8B41B85BB02}"/>
          </ac:grpSpMkLst>
        </pc:grpChg>
        <pc:grpChg chg="mod">
          <ac:chgData name="Filippo Acconcia" userId="844af49c-a8a0-47ac-a7dd-14a44b60cd18" providerId="ADAL" clId="{B609A75A-164F-4066-A006-F59E853DC491}" dt="2022-03-30T08:05:07.951" v="456" actId="1038"/>
          <ac:grpSpMkLst>
            <pc:docMk/>
            <pc:sldMk cId="2620120220" sldId="296"/>
            <ac:grpSpMk id="153" creationId="{F8F4CA2B-8B03-48C6-BDD3-51D135701CE1}"/>
          </ac:grpSpMkLst>
        </pc:grpChg>
        <pc:grpChg chg="mod">
          <ac:chgData name="Filippo Acconcia" userId="844af49c-a8a0-47ac-a7dd-14a44b60cd18" providerId="ADAL" clId="{B609A75A-164F-4066-A006-F59E853DC491}" dt="2022-03-28T07:32:01.919" v="217" actId="1076"/>
          <ac:grpSpMkLst>
            <pc:docMk/>
            <pc:sldMk cId="2620120220" sldId="296"/>
            <ac:grpSpMk id="171" creationId="{89C73608-F000-4954-8FE0-7D60CE53DB7B}"/>
          </ac:grpSpMkLst>
        </pc:grpChg>
        <pc:picChg chg="mod">
          <ac:chgData name="Filippo Acconcia" userId="844af49c-a8a0-47ac-a7dd-14a44b60cd18" providerId="ADAL" clId="{B609A75A-164F-4066-A006-F59E853DC491}" dt="2022-03-28T07:30:44.809" v="188" actId="1076"/>
          <ac:picMkLst>
            <pc:docMk/>
            <pc:sldMk cId="2620120220" sldId="296"/>
            <ac:picMk id="168" creationId="{E25080C9-E95F-4BE8-B219-4AB6F76E692E}"/>
          </ac:picMkLst>
        </pc:picChg>
      </pc:sldChg>
      <pc:sldChg chg="addSp delSp modSp mod">
        <pc:chgData name="Filippo Acconcia" userId="844af49c-a8a0-47ac-a7dd-14a44b60cd18" providerId="ADAL" clId="{B609A75A-164F-4066-A006-F59E853DC491}" dt="2022-04-01T10:44:00.737" v="1785" actId="554"/>
        <pc:sldMkLst>
          <pc:docMk/>
          <pc:sldMk cId="3763209997" sldId="297"/>
        </pc:sldMkLst>
        <pc:spChg chg="add del mod">
          <ac:chgData name="Filippo Acconcia" userId="844af49c-a8a0-47ac-a7dd-14a44b60cd18" providerId="ADAL" clId="{B609A75A-164F-4066-A006-F59E853DC491}" dt="2022-04-01T10:44:00.737" v="1785" actId="554"/>
          <ac:spMkLst>
            <pc:docMk/>
            <pc:sldMk cId="3763209997" sldId="297"/>
            <ac:spMk id="59" creationId="{3B1B5FC7-F40B-4E8C-BA81-43C08EDD4EBE}"/>
          </ac:spMkLst>
        </pc:spChg>
        <pc:spChg chg="mod">
          <ac:chgData name="Filippo Acconcia" userId="844af49c-a8a0-47ac-a7dd-14a44b60cd18" providerId="ADAL" clId="{B609A75A-164F-4066-A006-F59E853DC491}" dt="2022-04-01T10:44:00.737" v="1785" actId="554"/>
          <ac:spMkLst>
            <pc:docMk/>
            <pc:sldMk cId="3763209997" sldId="297"/>
            <ac:spMk id="60" creationId="{A98BF58D-0577-47FC-A25C-DB0867D0C225}"/>
          </ac:spMkLst>
        </pc:spChg>
        <pc:spChg chg="mod">
          <ac:chgData name="Filippo Acconcia" userId="844af49c-a8a0-47ac-a7dd-14a44b60cd18" providerId="ADAL" clId="{B609A75A-164F-4066-A006-F59E853DC491}" dt="2022-04-01T10:43:31.914" v="1770" actId="1036"/>
          <ac:spMkLst>
            <pc:docMk/>
            <pc:sldMk cId="3763209997" sldId="297"/>
            <ac:spMk id="61" creationId="{028FEF38-D09D-4825-A3A3-FFE39F11B9E7}"/>
          </ac:spMkLst>
        </pc:spChg>
        <pc:spChg chg="mod">
          <ac:chgData name="Filippo Acconcia" userId="844af49c-a8a0-47ac-a7dd-14a44b60cd18" providerId="ADAL" clId="{B609A75A-164F-4066-A006-F59E853DC491}" dt="2022-04-01T10:43:31.914" v="1770" actId="1036"/>
          <ac:spMkLst>
            <pc:docMk/>
            <pc:sldMk cId="3763209997" sldId="297"/>
            <ac:spMk id="62" creationId="{92AB2CEA-7E11-44F9-B7A9-5AE3D670EFA2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80" creationId="{629D329A-98FA-4FF4-BE4F-A0104EDFCC79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82" creationId="{3C595544-B7E6-485D-995D-21AE8375425C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83" creationId="{27635DB8-7D4C-47A1-9DDA-B42C0E712735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84" creationId="{0D284285-9ABC-4DEE-9E6E-F17BE7E36B55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85" creationId="{D5F1174E-138F-4004-97FE-DC1ED5663FAC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86" creationId="{6F79CE76-15D4-4843-99FE-44DB170288DA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87" creationId="{E89DA5EF-2790-4977-B82F-B6906B0F1EDA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88" creationId="{7D39B66F-70F1-44CA-A51C-86184EBBC083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89" creationId="{B3DCA6E8-D70C-4789-BB4D-AB6A031E5963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95" creationId="{D3D28C12-9AEE-4116-A386-A5F03982F429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96" creationId="{0C51EDC0-42D1-41AA-A22B-723AE3641310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97" creationId="{5F0E3E49-6601-4199-85E1-3EE95BEDF23D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98" creationId="{5B102A67-EAF9-4C0F-A136-A3143A4ABCAD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99" creationId="{DF5AD2A6-3A9C-4B92-B8C3-2F844D6A26D9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00" creationId="{95BB355B-EEA4-4FA4-9E40-CAD15F82F4C1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01" creationId="{2303146D-9676-423C-BBF7-90D262AC39DE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02" creationId="{C7093A6F-5AC8-4C71-B5E7-5969B6683A82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04" creationId="{73F1110B-F717-46B2-913C-0AA43B28FA45}"/>
          </ac:spMkLst>
        </pc:spChg>
        <pc:spChg chg="add mod">
          <ac:chgData name="Filippo Acconcia" userId="844af49c-a8a0-47ac-a7dd-14a44b60cd18" providerId="ADAL" clId="{B609A75A-164F-4066-A006-F59E853DC491}" dt="2022-04-01T10:43:47.064" v="1780" actId="1036"/>
          <ac:spMkLst>
            <pc:docMk/>
            <pc:sldMk cId="3763209997" sldId="297"/>
            <ac:spMk id="105" creationId="{53592686-7A78-4900-AD7A-3038A56BC1B6}"/>
          </ac:spMkLst>
        </pc:spChg>
        <pc:spChg chg="add mod">
          <ac:chgData name="Filippo Acconcia" userId="844af49c-a8a0-47ac-a7dd-14a44b60cd18" providerId="ADAL" clId="{B609A75A-164F-4066-A006-F59E853DC491}" dt="2022-03-30T08:37:03.389" v="460" actId="20577"/>
          <ac:spMkLst>
            <pc:docMk/>
            <pc:sldMk cId="3763209997" sldId="297"/>
            <ac:spMk id="106" creationId="{E5EF98AB-F50C-4370-B8FD-EED0B3491049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14" creationId="{8A154FC8-7A17-4F84-B94D-471ABD4ED65A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15" creationId="{D9303AF9-F424-4331-90F4-A1F234D52930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16" creationId="{45047D4A-BAAD-4105-AB69-0579EE466302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17" creationId="{0543DD9D-E79E-4E2A-88DD-1253BD4F5F54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18" creationId="{67DBBE56-6305-4274-BBF0-1CC2B24CCB9E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19" creationId="{1DE31D22-6324-4C0A-BC06-9DB106BF5FCE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20" creationId="{D0E536EB-CB0C-470E-B6D7-D721D68ED95C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21" creationId="{44DE9505-DCA0-4AA6-965D-6DAD455BD75E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23" creationId="{BF38C2ED-2D8C-40BA-B9C6-F8E1339938CD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28" creationId="{F9F8888E-39F6-402C-86DF-7BDFEA150510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29" creationId="{AB1D785C-CC97-4494-89AB-4A36F9211206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30" creationId="{C9F9ECCC-CD5C-41F2-A53D-2D69DCF4EF8F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31" creationId="{2E2746F0-CB2D-4E9B-A536-45EA92AE4C13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32" creationId="{276D6CC7-3C17-48DF-93A8-D3718DA1DE8A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33" creationId="{E098F481-FDCB-4EDB-B97B-7B11D6299BD6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34" creationId="{3FCCE0E6-90B8-4EC7-AF2B-943DBED30F03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35" creationId="{1A77C52C-7405-4006-BAC2-6E1BD3735C2A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37" creationId="{78808666-2A9C-4AE0-9EA7-580A8A1CF889}"/>
          </ac:spMkLst>
        </pc:spChg>
        <pc:spChg chg="add mod">
          <ac:chgData name="Filippo Acconcia" userId="844af49c-a8a0-47ac-a7dd-14a44b60cd18" providerId="ADAL" clId="{B609A75A-164F-4066-A006-F59E853DC491}" dt="2022-04-01T10:43:56.309" v="1784" actId="12789"/>
          <ac:spMkLst>
            <pc:docMk/>
            <pc:sldMk cId="3763209997" sldId="297"/>
            <ac:spMk id="138" creationId="{10D8CD09-42D2-41AE-8DA4-5D4C590CC888}"/>
          </ac:spMkLst>
        </pc:spChg>
        <pc:spChg chg="add mod">
          <ac:chgData name="Filippo Acconcia" userId="844af49c-a8a0-47ac-a7dd-14a44b60cd18" providerId="ADAL" clId="{B609A75A-164F-4066-A006-F59E853DC491}" dt="2022-04-01T10:43:56.309" v="1784" actId="12789"/>
          <ac:spMkLst>
            <pc:docMk/>
            <pc:sldMk cId="3763209997" sldId="297"/>
            <ac:spMk id="139" creationId="{B63F3BBD-6564-4852-964B-A7442C404310}"/>
          </ac:spMkLst>
        </pc:spChg>
        <pc:spChg chg="add mod">
          <ac:chgData name="Filippo Acconcia" userId="844af49c-a8a0-47ac-a7dd-14a44b60cd18" providerId="ADAL" clId="{B609A75A-164F-4066-A006-F59E853DC491}" dt="2022-04-01T10:43:31.914" v="1770" actId="1036"/>
          <ac:spMkLst>
            <pc:docMk/>
            <pc:sldMk cId="3763209997" sldId="297"/>
            <ac:spMk id="140" creationId="{E772652D-48E5-4015-A9D4-7084AC5D7A5F}"/>
          </ac:spMkLst>
        </pc:spChg>
        <pc:spChg chg="add mod">
          <ac:chgData name="Filippo Acconcia" userId="844af49c-a8a0-47ac-a7dd-14a44b60cd18" providerId="ADAL" clId="{B609A75A-164F-4066-A006-F59E853DC491}" dt="2022-04-01T10:43:31.914" v="1770" actId="1036"/>
          <ac:spMkLst>
            <pc:docMk/>
            <pc:sldMk cId="3763209997" sldId="297"/>
            <ac:spMk id="141" creationId="{7ECA4B5D-1ABE-46C6-9BFC-8D16DD7F7AE5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46" creationId="{DCCDB41F-E298-43C4-BAC6-F3BC4533FB82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47" creationId="{342BF821-54B4-437A-9272-35B190EAA52B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48" creationId="{DD01EE0A-5DB3-41C2-9FDB-A032DB34EFB1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49" creationId="{B6FBDF47-FB48-4B7F-983C-4EAA75A85B87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50" creationId="{E6AF3F95-B7A8-487A-B32B-DF6E34762152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51" creationId="{ED2C62AB-6A78-427D-B5A1-B240929F502C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52" creationId="{28BAF767-B307-43CA-B444-EC8EB49B32B9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53" creationId="{931C6803-3CB5-420E-AF73-5AADF311F62F}"/>
          </ac:spMkLst>
        </pc:spChg>
        <pc:spChg chg="mod">
          <ac:chgData name="Filippo Acconcia" userId="844af49c-a8a0-47ac-a7dd-14a44b60cd18" providerId="ADAL" clId="{B609A75A-164F-4066-A006-F59E853DC491}" dt="2022-04-01T09:53:18.742" v="1591"/>
          <ac:spMkLst>
            <pc:docMk/>
            <pc:sldMk cId="3763209997" sldId="297"/>
            <ac:spMk id="155" creationId="{6CB3F053-AC6E-4A0A-8607-045FC46214F5}"/>
          </ac:spMkLst>
        </pc:spChg>
        <pc:spChg chg="add mod">
          <ac:chgData name="Filippo Acconcia" userId="844af49c-a8a0-47ac-a7dd-14a44b60cd18" providerId="ADAL" clId="{B609A75A-164F-4066-A006-F59E853DC491}" dt="2022-04-01T10:43:47.064" v="1780" actId="1036"/>
          <ac:spMkLst>
            <pc:docMk/>
            <pc:sldMk cId="3763209997" sldId="297"/>
            <ac:spMk id="156" creationId="{2C170365-7A0B-466A-A5BC-C718C1A4D52F}"/>
          </ac:spMkLst>
        </pc:spChg>
        <pc:spChg chg="mod topLvl">
          <ac:chgData name="Filippo Acconcia" userId="844af49c-a8a0-47ac-a7dd-14a44b60cd18" providerId="ADAL" clId="{B609A75A-164F-4066-A006-F59E853DC491}" dt="2022-04-01T10:18:49.336" v="1628" actId="164"/>
          <ac:spMkLst>
            <pc:docMk/>
            <pc:sldMk cId="3763209997" sldId="297"/>
            <ac:spMk id="159" creationId="{02ABF6E7-B689-4A9A-90ED-730F9489E35F}"/>
          </ac:spMkLst>
        </pc:spChg>
        <pc:spChg chg="mod topLvl">
          <ac:chgData name="Filippo Acconcia" userId="844af49c-a8a0-47ac-a7dd-14a44b60cd18" providerId="ADAL" clId="{B609A75A-164F-4066-A006-F59E853DC491}" dt="2022-04-01T10:18:49.336" v="1628" actId="164"/>
          <ac:spMkLst>
            <pc:docMk/>
            <pc:sldMk cId="3763209997" sldId="297"/>
            <ac:spMk id="160" creationId="{0598B533-B209-46F3-8D38-8BBD90AC9AA0}"/>
          </ac:spMkLst>
        </pc:spChg>
        <pc:spChg chg="mod topLvl">
          <ac:chgData name="Filippo Acconcia" userId="844af49c-a8a0-47ac-a7dd-14a44b60cd18" providerId="ADAL" clId="{B609A75A-164F-4066-A006-F59E853DC491}" dt="2022-04-01T10:20:12.985" v="1692" actId="20577"/>
          <ac:spMkLst>
            <pc:docMk/>
            <pc:sldMk cId="3763209997" sldId="297"/>
            <ac:spMk id="161" creationId="{E31DD807-4F20-477F-8341-FD0D8242DB42}"/>
          </ac:spMkLst>
        </pc:spChg>
        <pc:spChg chg="mod topLvl">
          <ac:chgData name="Filippo Acconcia" userId="844af49c-a8a0-47ac-a7dd-14a44b60cd18" providerId="ADAL" clId="{B609A75A-164F-4066-A006-F59E853DC491}" dt="2022-04-01T10:18:49.336" v="1628" actId="164"/>
          <ac:spMkLst>
            <pc:docMk/>
            <pc:sldMk cId="3763209997" sldId="297"/>
            <ac:spMk id="162" creationId="{89D4976B-1B4F-4515-B7D4-55C45CA5034D}"/>
          </ac:spMkLst>
        </pc:spChg>
        <pc:spChg chg="mod topLvl">
          <ac:chgData name="Filippo Acconcia" userId="844af49c-a8a0-47ac-a7dd-14a44b60cd18" providerId="ADAL" clId="{B609A75A-164F-4066-A006-F59E853DC491}" dt="2022-04-01T10:18:49.336" v="1628" actId="164"/>
          <ac:spMkLst>
            <pc:docMk/>
            <pc:sldMk cId="3763209997" sldId="297"/>
            <ac:spMk id="163" creationId="{DC4233B9-348B-4BC0-881F-5871CEC7C50F}"/>
          </ac:spMkLst>
        </pc:spChg>
        <pc:spChg chg="mod topLvl">
          <ac:chgData name="Filippo Acconcia" userId="844af49c-a8a0-47ac-a7dd-14a44b60cd18" providerId="ADAL" clId="{B609A75A-164F-4066-A006-F59E853DC491}" dt="2022-04-01T10:18:49.336" v="1628" actId="164"/>
          <ac:spMkLst>
            <pc:docMk/>
            <pc:sldMk cId="3763209997" sldId="297"/>
            <ac:spMk id="165" creationId="{EE29A55C-ABDE-4B06-A9C0-F54C0E17D6D2}"/>
          </ac:spMkLst>
        </pc:spChg>
        <pc:spChg chg="mod topLvl">
          <ac:chgData name="Filippo Acconcia" userId="844af49c-a8a0-47ac-a7dd-14a44b60cd18" providerId="ADAL" clId="{B609A75A-164F-4066-A006-F59E853DC491}" dt="2022-04-01T10:18:49.336" v="1628" actId="164"/>
          <ac:spMkLst>
            <pc:docMk/>
            <pc:sldMk cId="3763209997" sldId="297"/>
            <ac:spMk id="166" creationId="{3A875101-BF41-488A-A956-035B235B2706}"/>
          </ac:spMkLst>
        </pc:spChg>
        <pc:spChg chg="mod topLvl">
          <ac:chgData name="Filippo Acconcia" userId="844af49c-a8a0-47ac-a7dd-14a44b60cd18" providerId="ADAL" clId="{B609A75A-164F-4066-A006-F59E853DC491}" dt="2022-04-01T10:18:49.336" v="1628" actId="164"/>
          <ac:spMkLst>
            <pc:docMk/>
            <pc:sldMk cId="3763209997" sldId="297"/>
            <ac:spMk id="167" creationId="{EE468CF2-D30D-4B95-8719-03B197CD0D5F}"/>
          </ac:spMkLst>
        </pc:spChg>
        <pc:spChg chg="mod topLvl">
          <ac:chgData name="Filippo Acconcia" userId="844af49c-a8a0-47ac-a7dd-14a44b60cd18" providerId="ADAL" clId="{B609A75A-164F-4066-A006-F59E853DC491}" dt="2022-04-01T10:18:49.336" v="1628" actId="164"/>
          <ac:spMkLst>
            <pc:docMk/>
            <pc:sldMk cId="3763209997" sldId="297"/>
            <ac:spMk id="168" creationId="{4BBF1DFF-AC56-436C-A50F-BA886635B759}"/>
          </ac:spMkLst>
        </pc:spChg>
        <pc:spChg chg="mod topLvl">
          <ac:chgData name="Filippo Acconcia" userId="844af49c-a8a0-47ac-a7dd-14a44b60cd18" providerId="ADAL" clId="{B609A75A-164F-4066-A006-F59E853DC491}" dt="2022-04-01T10:18:49.336" v="1628" actId="164"/>
          <ac:spMkLst>
            <pc:docMk/>
            <pc:sldMk cId="3763209997" sldId="297"/>
            <ac:spMk id="169" creationId="{025902BF-91BC-456E-82CD-0D296918EA95}"/>
          </ac:spMkLst>
        </pc:spChg>
        <pc:spChg chg="mod topLvl">
          <ac:chgData name="Filippo Acconcia" userId="844af49c-a8a0-47ac-a7dd-14a44b60cd18" providerId="ADAL" clId="{B609A75A-164F-4066-A006-F59E853DC491}" dt="2022-04-01T10:31:46.467" v="1707" actId="164"/>
          <ac:spMkLst>
            <pc:docMk/>
            <pc:sldMk cId="3763209997" sldId="297"/>
            <ac:spMk id="173" creationId="{FBA9E13E-74C6-4E82-9969-EC3A8B5C2B99}"/>
          </ac:spMkLst>
        </pc:spChg>
        <pc:spChg chg="mod topLvl">
          <ac:chgData name="Filippo Acconcia" userId="844af49c-a8a0-47ac-a7dd-14a44b60cd18" providerId="ADAL" clId="{B609A75A-164F-4066-A006-F59E853DC491}" dt="2022-04-01T10:31:46.467" v="1707" actId="164"/>
          <ac:spMkLst>
            <pc:docMk/>
            <pc:sldMk cId="3763209997" sldId="297"/>
            <ac:spMk id="174" creationId="{CF5E07D8-54D5-4A57-B61F-5D9D733C65B9}"/>
          </ac:spMkLst>
        </pc:spChg>
        <pc:spChg chg="mod topLvl">
          <ac:chgData name="Filippo Acconcia" userId="844af49c-a8a0-47ac-a7dd-14a44b60cd18" providerId="ADAL" clId="{B609A75A-164F-4066-A006-F59E853DC491}" dt="2022-04-01T10:31:46.467" v="1707" actId="164"/>
          <ac:spMkLst>
            <pc:docMk/>
            <pc:sldMk cId="3763209997" sldId="297"/>
            <ac:spMk id="175" creationId="{8677AEB8-902F-4CCD-B487-F95C922B8C80}"/>
          </ac:spMkLst>
        </pc:spChg>
        <pc:spChg chg="mod topLvl">
          <ac:chgData name="Filippo Acconcia" userId="844af49c-a8a0-47ac-a7dd-14a44b60cd18" providerId="ADAL" clId="{B609A75A-164F-4066-A006-F59E853DC491}" dt="2022-04-01T10:31:46.467" v="1707" actId="164"/>
          <ac:spMkLst>
            <pc:docMk/>
            <pc:sldMk cId="3763209997" sldId="297"/>
            <ac:spMk id="176" creationId="{61F03427-9263-441D-9334-82A10EA34BC1}"/>
          </ac:spMkLst>
        </pc:spChg>
        <pc:spChg chg="mod topLvl">
          <ac:chgData name="Filippo Acconcia" userId="844af49c-a8a0-47ac-a7dd-14a44b60cd18" providerId="ADAL" clId="{B609A75A-164F-4066-A006-F59E853DC491}" dt="2022-04-01T10:31:46.467" v="1707" actId="164"/>
          <ac:spMkLst>
            <pc:docMk/>
            <pc:sldMk cId="3763209997" sldId="297"/>
            <ac:spMk id="177" creationId="{2511D2D5-54D8-427A-A282-852B98EAAE0B}"/>
          </ac:spMkLst>
        </pc:spChg>
        <pc:spChg chg="mod topLvl">
          <ac:chgData name="Filippo Acconcia" userId="844af49c-a8a0-47ac-a7dd-14a44b60cd18" providerId="ADAL" clId="{B609A75A-164F-4066-A006-F59E853DC491}" dt="2022-04-01T10:31:46.467" v="1707" actId="164"/>
          <ac:spMkLst>
            <pc:docMk/>
            <pc:sldMk cId="3763209997" sldId="297"/>
            <ac:spMk id="179" creationId="{5BE40EC5-6733-450B-A654-E1429EF56153}"/>
          </ac:spMkLst>
        </pc:spChg>
        <pc:spChg chg="mod topLvl">
          <ac:chgData name="Filippo Acconcia" userId="844af49c-a8a0-47ac-a7dd-14a44b60cd18" providerId="ADAL" clId="{B609A75A-164F-4066-A006-F59E853DC491}" dt="2022-04-01T10:31:46.467" v="1707" actId="164"/>
          <ac:spMkLst>
            <pc:docMk/>
            <pc:sldMk cId="3763209997" sldId="297"/>
            <ac:spMk id="180" creationId="{5B5A5EBB-3884-44E2-9DEC-AD48B52667EE}"/>
          </ac:spMkLst>
        </pc:spChg>
        <pc:spChg chg="mod topLvl">
          <ac:chgData name="Filippo Acconcia" userId="844af49c-a8a0-47ac-a7dd-14a44b60cd18" providerId="ADAL" clId="{B609A75A-164F-4066-A006-F59E853DC491}" dt="2022-04-01T10:31:46.467" v="1707" actId="164"/>
          <ac:spMkLst>
            <pc:docMk/>
            <pc:sldMk cId="3763209997" sldId="297"/>
            <ac:spMk id="181" creationId="{9677D3A4-3800-4B1C-B90D-46A8A734BC5D}"/>
          </ac:spMkLst>
        </pc:spChg>
        <pc:spChg chg="mod topLvl">
          <ac:chgData name="Filippo Acconcia" userId="844af49c-a8a0-47ac-a7dd-14a44b60cd18" providerId="ADAL" clId="{B609A75A-164F-4066-A006-F59E853DC491}" dt="2022-04-01T10:31:46.467" v="1707" actId="164"/>
          <ac:spMkLst>
            <pc:docMk/>
            <pc:sldMk cId="3763209997" sldId="297"/>
            <ac:spMk id="182" creationId="{FB49925A-764B-49EC-95EA-BA36B08EDD20}"/>
          </ac:spMkLst>
        </pc:spChg>
        <pc:spChg chg="mod topLvl">
          <ac:chgData name="Filippo Acconcia" userId="844af49c-a8a0-47ac-a7dd-14a44b60cd18" providerId="ADAL" clId="{B609A75A-164F-4066-A006-F59E853DC491}" dt="2022-04-01T10:31:46.467" v="1707" actId="164"/>
          <ac:spMkLst>
            <pc:docMk/>
            <pc:sldMk cId="3763209997" sldId="297"/>
            <ac:spMk id="183" creationId="{B68941ED-B29C-4F2B-827C-A788AF78D02F}"/>
          </ac:spMkLst>
        </pc:spChg>
        <pc:spChg chg="mod topLvl">
          <ac:chgData name="Filippo Acconcia" userId="844af49c-a8a0-47ac-a7dd-14a44b60cd18" providerId="ADAL" clId="{B609A75A-164F-4066-A006-F59E853DC491}" dt="2022-04-01T10:43:26.403" v="1765" actId="164"/>
          <ac:spMkLst>
            <pc:docMk/>
            <pc:sldMk cId="3763209997" sldId="297"/>
            <ac:spMk id="188" creationId="{66FA5CF4-6CA0-4FB1-B9BD-D8EB02608EDA}"/>
          </ac:spMkLst>
        </pc:spChg>
        <pc:spChg chg="mod topLvl">
          <ac:chgData name="Filippo Acconcia" userId="844af49c-a8a0-47ac-a7dd-14a44b60cd18" providerId="ADAL" clId="{B609A75A-164F-4066-A006-F59E853DC491}" dt="2022-04-01T10:43:26.403" v="1765" actId="164"/>
          <ac:spMkLst>
            <pc:docMk/>
            <pc:sldMk cId="3763209997" sldId="297"/>
            <ac:spMk id="189" creationId="{DFA82E58-C160-4E48-BD6C-5EFBA5DB4BBF}"/>
          </ac:spMkLst>
        </pc:spChg>
        <pc:spChg chg="mod topLvl">
          <ac:chgData name="Filippo Acconcia" userId="844af49c-a8a0-47ac-a7dd-14a44b60cd18" providerId="ADAL" clId="{B609A75A-164F-4066-A006-F59E853DC491}" dt="2022-04-01T10:43:26.403" v="1765" actId="164"/>
          <ac:spMkLst>
            <pc:docMk/>
            <pc:sldMk cId="3763209997" sldId="297"/>
            <ac:spMk id="190" creationId="{DBBC2261-2923-4E5F-9BB6-57031BE60FAE}"/>
          </ac:spMkLst>
        </pc:spChg>
        <pc:spChg chg="mod topLvl">
          <ac:chgData name="Filippo Acconcia" userId="844af49c-a8a0-47ac-a7dd-14a44b60cd18" providerId="ADAL" clId="{B609A75A-164F-4066-A006-F59E853DC491}" dt="2022-04-01T10:43:26.403" v="1765" actId="164"/>
          <ac:spMkLst>
            <pc:docMk/>
            <pc:sldMk cId="3763209997" sldId="297"/>
            <ac:spMk id="191" creationId="{84C63672-E5F1-4541-9411-371B2B6EDB11}"/>
          </ac:spMkLst>
        </pc:spChg>
        <pc:spChg chg="mod topLvl">
          <ac:chgData name="Filippo Acconcia" userId="844af49c-a8a0-47ac-a7dd-14a44b60cd18" providerId="ADAL" clId="{B609A75A-164F-4066-A006-F59E853DC491}" dt="2022-04-01T10:43:26.403" v="1765" actId="164"/>
          <ac:spMkLst>
            <pc:docMk/>
            <pc:sldMk cId="3763209997" sldId="297"/>
            <ac:spMk id="192" creationId="{5048865E-981B-437D-8608-716ABFACA9B2}"/>
          </ac:spMkLst>
        </pc:spChg>
        <pc:spChg chg="mod topLvl">
          <ac:chgData name="Filippo Acconcia" userId="844af49c-a8a0-47ac-a7dd-14a44b60cd18" providerId="ADAL" clId="{B609A75A-164F-4066-A006-F59E853DC491}" dt="2022-04-01T10:43:26.403" v="1765" actId="164"/>
          <ac:spMkLst>
            <pc:docMk/>
            <pc:sldMk cId="3763209997" sldId="297"/>
            <ac:spMk id="194" creationId="{CC981ECB-1FEC-4ACF-8CBB-FB60B75ACBB3}"/>
          </ac:spMkLst>
        </pc:spChg>
        <pc:spChg chg="mod topLvl">
          <ac:chgData name="Filippo Acconcia" userId="844af49c-a8a0-47ac-a7dd-14a44b60cd18" providerId="ADAL" clId="{B609A75A-164F-4066-A006-F59E853DC491}" dt="2022-04-01T10:43:26.403" v="1765" actId="164"/>
          <ac:spMkLst>
            <pc:docMk/>
            <pc:sldMk cId="3763209997" sldId="297"/>
            <ac:spMk id="195" creationId="{BB3CAF97-ADA8-41EE-A151-22C43569750C}"/>
          </ac:spMkLst>
        </pc:spChg>
        <pc:spChg chg="mod topLvl">
          <ac:chgData name="Filippo Acconcia" userId="844af49c-a8a0-47ac-a7dd-14a44b60cd18" providerId="ADAL" clId="{B609A75A-164F-4066-A006-F59E853DC491}" dt="2022-04-01T10:43:26.403" v="1765" actId="164"/>
          <ac:spMkLst>
            <pc:docMk/>
            <pc:sldMk cId="3763209997" sldId="297"/>
            <ac:spMk id="196" creationId="{88307B80-28C4-4D86-BA0E-708B568B011A}"/>
          </ac:spMkLst>
        </pc:spChg>
        <pc:spChg chg="mod topLvl">
          <ac:chgData name="Filippo Acconcia" userId="844af49c-a8a0-47ac-a7dd-14a44b60cd18" providerId="ADAL" clId="{B609A75A-164F-4066-A006-F59E853DC491}" dt="2022-04-01T10:43:26.403" v="1765" actId="164"/>
          <ac:spMkLst>
            <pc:docMk/>
            <pc:sldMk cId="3763209997" sldId="297"/>
            <ac:spMk id="197" creationId="{0482B92F-5855-41A8-8EF2-E56C833BF9D3}"/>
          </ac:spMkLst>
        </pc:spChg>
        <pc:spChg chg="mod topLvl">
          <ac:chgData name="Filippo Acconcia" userId="844af49c-a8a0-47ac-a7dd-14a44b60cd18" providerId="ADAL" clId="{B609A75A-164F-4066-A006-F59E853DC491}" dt="2022-04-01T10:43:26.403" v="1765" actId="164"/>
          <ac:spMkLst>
            <pc:docMk/>
            <pc:sldMk cId="3763209997" sldId="297"/>
            <ac:spMk id="198" creationId="{4D0962CF-E703-43F1-8CC5-77BF951CA59C}"/>
          </ac:spMkLst>
        </pc:spChg>
        <pc:grpChg chg="mod">
          <ac:chgData name="Filippo Acconcia" userId="844af49c-a8a0-47ac-a7dd-14a44b60cd18" providerId="ADAL" clId="{B609A75A-164F-4066-A006-F59E853DC491}" dt="2022-04-01T10:43:51.247" v="1783" actId="1035"/>
          <ac:grpSpMkLst>
            <pc:docMk/>
            <pc:sldMk cId="3763209997" sldId="297"/>
            <ac:grpSpMk id="2" creationId="{C2C26514-7C88-40AB-998D-C434AFA67D67}"/>
          </ac:grpSpMkLst>
        </pc:grpChg>
        <pc:grpChg chg="mod">
          <ac:chgData name="Filippo Acconcia" userId="844af49c-a8a0-47ac-a7dd-14a44b60cd18" providerId="ADAL" clId="{B609A75A-164F-4066-A006-F59E853DC491}" dt="2022-04-01T10:43:51.247" v="1783" actId="1035"/>
          <ac:grpSpMkLst>
            <pc:docMk/>
            <pc:sldMk cId="3763209997" sldId="297"/>
            <ac:grpSpMk id="17" creationId="{DDA6C99E-5C99-4640-8272-5026C3237A2B}"/>
          </ac:grpSpMkLst>
        </pc:grpChg>
        <pc:grpChg chg="mod">
          <ac:chgData name="Filippo Acconcia" userId="844af49c-a8a0-47ac-a7dd-14a44b60cd18" providerId="ADAL" clId="{B609A75A-164F-4066-A006-F59E853DC491}" dt="2022-04-01T10:43:31.914" v="1770" actId="1036"/>
          <ac:grpSpMkLst>
            <pc:docMk/>
            <pc:sldMk cId="3763209997" sldId="297"/>
            <ac:grpSpMk id="31" creationId="{DE5DFA23-5114-4C80-9F25-A39AD022C0BE}"/>
          </ac:grpSpMkLst>
        </pc:grpChg>
        <pc:grpChg chg="mod">
          <ac:chgData name="Filippo Acconcia" userId="844af49c-a8a0-47ac-a7dd-14a44b60cd18" providerId="ADAL" clId="{B609A75A-164F-4066-A006-F59E853DC491}" dt="2022-04-01T10:43:31.914" v="1770" actId="1036"/>
          <ac:grpSpMkLst>
            <pc:docMk/>
            <pc:sldMk cId="3763209997" sldId="297"/>
            <ac:grpSpMk id="45" creationId="{C1D1A450-A4BB-435D-8BC8-E56E6CE15314}"/>
          </ac:grpSpMkLst>
        </pc:grpChg>
        <pc:grpChg chg="mod">
          <ac:chgData name="Filippo Acconcia" userId="844af49c-a8a0-47ac-a7dd-14a44b60cd18" providerId="ADAL" clId="{B609A75A-164F-4066-A006-F59E853DC491}" dt="2022-04-01T10:43:38.537" v="1773" actId="1035"/>
          <ac:grpSpMkLst>
            <pc:docMk/>
            <pc:sldMk cId="3763209997" sldId="297"/>
            <ac:grpSpMk id="63" creationId="{0620E518-3643-44BC-B410-9F808DBFCF73}"/>
          </ac:grpSpMkLst>
        </pc:grpChg>
        <pc:grpChg chg="del">
          <ac:chgData name="Filippo Acconcia" userId="844af49c-a8a0-47ac-a7dd-14a44b60cd18" providerId="ADAL" clId="{B609A75A-164F-4066-A006-F59E853DC491}" dt="2022-03-28T10:39:29.885" v="416" actId="478"/>
          <ac:grpSpMkLst>
            <pc:docMk/>
            <pc:sldMk cId="3763209997" sldId="297"/>
            <ac:grpSpMk id="77" creationId="{BD667554-D6E7-4836-A4FE-9B2E1DA52980}"/>
          </ac:grpSpMkLst>
        </pc:grpChg>
        <pc:grpChg chg="add mod">
          <ac:chgData name="Filippo Acconcia" userId="844af49c-a8a0-47ac-a7dd-14a44b60cd18" providerId="ADAL" clId="{B609A75A-164F-4066-A006-F59E853DC491}" dt="2022-04-01T10:43:51.247" v="1783" actId="1035"/>
          <ac:grpSpMkLst>
            <pc:docMk/>
            <pc:sldMk cId="3763209997" sldId="297"/>
            <ac:grpSpMk id="78" creationId="{643D45EB-1184-4ADA-B2F3-2AD611353D29}"/>
          </ac:grpSpMkLst>
        </pc:grpChg>
        <pc:grpChg chg="add del mod">
          <ac:chgData name="Filippo Acconcia" userId="844af49c-a8a0-47ac-a7dd-14a44b60cd18" providerId="ADAL" clId="{B609A75A-164F-4066-A006-F59E853DC491}" dt="2022-04-01T09:53:41.197" v="1604" actId="478"/>
          <ac:grpSpMkLst>
            <pc:docMk/>
            <pc:sldMk cId="3763209997" sldId="297"/>
            <ac:grpSpMk id="79" creationId="{13799A8E-7A67-4B06-A9DB-D3ABCB59BDC6}"/>
          </ac:grpSpMkLst>
        </pc:grpChg>
        <pc:grpChg chg="mod">
          <ac:chgData name="Filippo Acconcia" userId="844af49c-a8a0-47ac-a7dd-14a44b60cd18" providerId="ADAL" clId="{B609A75A-164F-4066-A006-F59E853DC491}" dt="2022-04-01T09:53:18.742" v="1591"/>
          <ac:grpSpMkLst>
            <pc:docMk/>
            <pc:sldMk cId="3763209997" sldId="297"/>
            <ac:grpSpMk id="81" creationId="{131B453B-9C25-434D-AC18-207BD6F44EF0}"/>
          </ac:grpSpMkLst>
        </pc:grpChg>
        <pc:grpChg chg="del">
          <ac:chgData name="Filippo Acconcia" userId="844af49c-a8a0-47ac-a7dd-14a44b60cd18" providerId="ADAL" clId="{B609A75A-164F-4066-A006-F59E853DC491}" dt="2022-03-28T10:39:29.885" v="416" actId="478"/>
          <ac:grpSpMkLst>
            <pc:docMk/>
            <pc:sldMk cId="3763209997" sldId="297"/>
            <ac:grpSpMk id="91" creationId="{D06B45C2-D1CC-475A-BC78-6969512106C4}"/>
          </ac:grpSpMkLst>
        </pc:grpChg>
        <pc:grpChg chg="add del mod">
          <ac:chgData name="Filippo Acconcia" userId="844af49c-a8a0-47ac-a7dd-14a44b60cd18" providerId="ADAL" clId="{B609A75A-164F-4066-A006-F59E853DC491}" dt="2022-04-01T09:53:41.829" v="1605" actId="478"/>
          <ac:grpSpMkLst>
            <pc:docMk/>
            <pc:sldMk cId="3763209997" sldId="297"/>
            <ac:grpSpMk id="94" creationId="{36B8FEEB-6D35-4204-9505-8E9EF093CF70}"/>
          </ac:grpSpMkLst>
        </pc:grpChg>
        <pc:grpChg chg="add del mod">
          <ac:chgData name="Filippo Acconcia" userId="844af49c-a8a0-47ac-a7dd-14a44b60cd18" providerId="ADAL" clId="{B609A75A-164F-4066-A006-F59E853DC491}" dt="2022-04-01T09:53:43.100" v="1607" actId="478"/>
          <ac:grpSpMkLst>
            <pc:docMk/>
            <pc:sldMk cId="3763209997" sldId="297"/>
            <ac:grpSpMk id="110" creationId="{8AF418EE-E8E1-46D9-8CEB-7234D746E881}"/>
          </ac:grpSpMkLst>
        </pc:grpChg>
        <pc:grpChg chg="add del mod">
          <ac:chgData name="Filippo Acconcia" userId="844af49c-a8a0-47ac-a7dd-14a44b60cd18" providerId="ADAL" clId="{B609A75A-164F-4066-A006-F59E853DC491}" dt="2022-04-01T09:53:42.445" v="1606" actId="478"/>
          <ac:grpSpMkLst>
            <pc:docMk/>
            <pc:sldMk cId="3763209997" sldId="297"/>
            <ac:grpSpMk id="124" creationId="{EF465673-12E7-4E3E-B11F-9E13FEE99DAE}"/>
          </ac:grpSpMkLst>
        </pc:grpChg>
        <pc:grpChg chg="add del mod">
          <ac:chgData name="Filippo Acconcia" userId="844af49c-a8a0-47ac-a7dd-14a44b60cd18" providerId="ADAL" clId="{B609A75A-164F-4066-A006-F59E853DC491}" dt="2022-04-01T09:53:40.288" v="1603" actId="478"/>
          <ac:grpSpMkLst>
            <pc:docMk/>
            <pc:sldMk cId="3763209997" sldId="297"/>
            <ac:grpSpMk id="142" creationId="{65BFEBF5-61B0-4F33-B84A-394C894AD0DD}"/>
          </ac:grpSpMkLst>
        </pc:grpChg>
        <pc:grpChg chg="add del mod">
          <ac:chgData name="Filippo Acconcia" userId="844af49c-a8a0-47ac-a7dd-14a44b60cd18" providerId="ADAL" clId="{B609A75A-164F-4066-A006-F59E853DC491}" dt="2022-04-01T10:17:24.766" v="1613" actId="165"/>
          <ac:grpSpMkLst>
            <pc:docMk/>
            <pc:sldMk cId="3763209997" sldId="297"/>
            <ac:grpSpMk id="157" creationId="{E298AF49-EA76-4D59-BACC-2CD712FD2772}"/>
          </ac:grpSpMkLst>
        </pc:grpChg>
        <pc:grpChg chg="add del mod">
          <ac:chgData name="Filippo Acconcia" userId="844af49c-a8a0-47ac-a7dd-14a44b60cd18" providerId="ADAL" clId="{B609A75A-164F-4066-A006-F59E853DC491}" dt="2022-04-01T10:30:46.721" v="1697" actId="165"/>
          <ac:grpSpMkLst>
            <pc:docMk/>
            <pc:sldMk cId="3763209997" sldId="297"/>
            <ac:grpSpMk id="171" creationId="{1322F0EE-1B19-4A8D-8C52-F9B1268B36D6}"/>
          </ac:grpSpMkLst>
        </pc:grpChg>
        <pc:grpChg chg="add mod">
          <ac:chgData name="Filippo Acconcia" userId="844af49c-a8a0-47ac-a7dd-14a44b60cd18" providerId="ADAL" clId="{B609A75A-164F-4066-A006-F59E853DC491}" dt="2022-04-01T10:43:51.247" v="1783" actId="1035"/>
          <ac:grpSpMkLst>
            <pc:docMk/>
            <pc:sldMk cId="3763209997" sldId="297"/>
            <ac:grpSpMk id="184" creationId="{5D58A688-E0B0-4DE1-B400-1851D0A3ADCA}"/>
          </ac:grpSpMkLst>
        </pc:grpChg>
        <pc:grpChg chg="add del mod">
          <ac:chgData name="Filippo Acconcia" userId="844af49c-a8a0-47ac-a7dd-14a44b60cd18" providerId="ADAL" clId="{B609A75A-164F-4066-A006-F59E853DC491}" dt="2022-04-01T10:42:40.469" v="1748" actId="165"/>
          <ac:grpSpMkLst>
            <pc:docMk/>
            <pc:sldMk cId="3763209997" sldId="297"/>
            <ac:grpSpMk id="186" creationId="{350FC543-3001-4FD8-AFDA-B6661FC914D7}"/>
          </ac:grpSpMkLst>
        </pc:grpChg>
        <pc:grpChg chg="add mod">
          <ac:chgData name="Filippo Acconcia" userId="844af49c-a8a0-47ac-a7dd-14a44b60cd18" providerId="ADAL" clId="{B609A75A-164F-4066-A006-F59E853DC491}" dt="2022-04-01T10:43:38.537" v="1773" actId="1035"/>
          <ac:grpSpMkLst>
            <pc:docMk/>
            <pc:sldMk cId="3763209997" sldId="297"/>
            <ac:grpSpMk id="199" creationId="{9CE67C69-47BE-492E-AF25-85FB71F3D2B5}"/>
          </ac:grpSpMkLst>
        </pc:grpChg>
        <pc:picChg chg="mod ord">
          <ac:chgData name="Filippo Acconcia" userId="844af49c-a8a0-47ac-a7dd-14a44b60cd18" providerId="ADAL" clId="{B609A75A-164F-4066-A006-F59E853DC491}" dt="2022-04-01T10:18:49.336" v="1628" actId="164"/>
          <ac:picMkLst>
            <pc:docMk/>
            <pc:sldMk cId="3763209997" sldId="297"/>
            <ac:picMk id="77" creationId="{74409266-1ED3-4227-92C3-05D633979D4D}"/>
          </ac:picMkLst>
        </pc:picChg>
        <pc:picChg chg="mod">
          <ac:chgData name="Filippo Acconcia" userId="844af49c-a8a0-47ac-a7dd-14a44b60cd18" providerId="ADAL" clId="{B609A75A-164F-4066-A006-F59E853DC491}" dt="2022-04-01T09:53:18.742" v="1591"/>
          <ac:picMkLst>
            <pc:docMk/>
            <pc:sldMk cId="3763209997" sldId="297"/>
            <ac:picMk id="91" creationId="{9F61607B-CF7F-4B3A-8D09-B997A8D42EFB}"/>
          </ac:picMkLst>
        </pc:picChg>
        <pc:picChg chg="mod">
          <ac:chgData name="Filippo Acconcia" userId="844af49c-a8a0-47ac-a7dd-14a44b60cd18" providerId="ADAL" clId="{B609A75A-164F-4066-A006-F59E853DC491}" dt="2022-04-01T09:53:18.742" v="1591"/>
          <ac:picMkLst>
            <pc:docMk/>
            <pc:sldMk cId="3763209997" sldId="297"/>
            <ac:picMk id="92" creationId="{134163FA-F8C0-4945-9B1A-BDF71D16BAC3}"/>
          </ac:picMkLst>
        </pc:picChg>
        <pc:picChg chg="mod">
          <ac:chgData name="Filippo Acconcia" userId="844af49c-a8a0-47ac-a7dd-14a44b60cd18" providerId="ADAL" clId="{B609A75A-164F-4066-A006-F59E853DC491}" dt="2022-04-01T09:53:18.742" v="1591"/>
          <ac:picMkLst>
            <pc:docMk/>
            <pc:sldMk cId="3763209997" sldId="297"/>
            <ac:picMk id="93" creationId="{6AE78F7D-57B1-4121-BF8A-3ED54E6D73F1}"/>
          </ac:picMkLst>
        </pc:picChg>
        <pc:picChg chg="mod">
          <ac:chgData name="Filippo Acconcia" userId="844af49c-a8a0-47ac-a7dd-14a44b60cd18" providerId="ADAL" clId="{B609A75A-164F-4066-A006-F59E853DC491}" dt="2022-04-01T09:53:18.742" v="1591"/>
          <ac:picMkLst>
            <pc:docMk/>
            <pc:sldMk cId="3763209997" sldId="297"/>
            <ac:picMk id="107" creationId="{E3078B8C-2294-4036-B31A-5287B045C8C2}"/>
          </ac:picMkLst>
        </pc:picChg>
        <pc:picChg chg="mod">
          <ac:chgData name="Filippo Acconcia" userId="844af49c-a8a0-47ac-a7dd-14a44b60cd18" providerId="ADAL" clId="{B609A75A-164F-4066-A006-F59E853DC491}" dt="2022-04-01T09:53:18.742" v="1591"/>
          <ac:picMkLst>
            <pc:docMk/>
            <pc:sldMk cId="3763209997" sldId="297"/>
            <ac:picMk id="108" creationId="{26BC76CF-B0E0-4A5A-BDA0-8FF675A13A7E}"/>
          </ac:picMkLst>
        </pc:picChg>
        <pc:picChg chg="mod">
          <ac:chgData name="Filippo Acconcia" userId="844af49c-a8a0-47ac-a7dd-14a44b60cd18" providerId="ADAL" clId="{B609A75A-164F-4066-A006-F59E853DC491}" dt="2022-04-01T09:53:18.742" v="1591"/>
          <ac:picMkLst>
            <pc:docMk/>
            <pc:sldMk cId="3763209997" sldId="297"/>
            <ac:picMk id="109" creationId="{8F526E8E-0FA9-42B2-96F2-A9864997D09B}"/>
          </ac:picMkLst>
        </pc:picChg>
        <pc:picChg chg="mod">
          <ac:chgData name="Filippo Acconcia" userId="844af49c-a8a0-47ac-a7dd-14a44b60cd18" providerId="ADAL" clId="{B609A75A-164F-4066-A006-F59E853DC491}" dt="2022-04-01T09:53:18.742" v="1591"/>
          <ac:picMkLst>
            <pc:docMk/>
            <pc:sldMk cId="3763209997" sldId="297"/>
            <ac:picMk id="111" creationId="{1C10538F-DBDB-4EAE-8E7C-9BE723EDCCDE}"/>
          </ac:picMkLst>
        </pc:picChg>
        <pc:picChg chg="mod">
          <ac:chgData name="Filippo Acconcia" userId="844af49c-a8a0-47ac-a7dd-14a44b60cd18" providerId="ADAL" clId="{B609A75A-164F-4066-A006-F59E853DC491}" dt="2022-04-01T09:53:18.742" v="1591"/>
          <ac:picMkLst>
            <pc:docMk/>
            <pc:sldMk cId="3763209997" sldId="297"/>
            <ac:picMk id="112" creationId="{B45184CF-4B70-48DD-AD08-FD5439669696}"/>
          </ac:picMkLst>
        </pc:picChg>
        <pc:picChg chg="mod">
          <ac:chgData name="Filippo Acconcia" userId="844af49c-a8a0-47ac-a7dd-14a44b60cd18" providerId="ADAL" clId="{B609A75A-164F-4066-A006-F59E853DC491}" dt="2022-04-01T09:53:18.742" v="1591"/>
          <ac:picMkLst>
            <pc:docMk/>
            <pc:sldMk cId="3763209997" sldId="297"/>
            <ac:picMk id="113" creationId="{8185B8E4-F0E4-4AD2-868C-444DC3AB3D28}"/>
          </ac:picMkLst>
        </pc:picChg>
        <pc:picChg chg="mod">
          <ac:chgData name="Filippo Acconcia" userId="844af49c-a8a0-47ac-a7dd-14a44b60cd18" providerId="ADAL" clId="{B609A75A-164F-4066-A006-F59E853DC491}" dt="2022-04-01T09:53:18.742" v="1591"/>
          <ac:picMkLst>
            <pc:docMk/>
            <pc:sldMk cId="3763209997" sldId="297"/>
            <ac:picMk id="125" creationId="{83BA6B25-3C0C-4C03-87C4-96F2D25583BF}"/>
          </ac:picMkLst>
        </pc:picChg>
        <pc:picChg chg="mod">
          <ac:chgData name="Filippo Acconcia" userId="844af49c-a8a0-47ac-a7dd-14a44b60cd18" providerId="ADAL" clId="{B609A75A-164F-4066-A006-F59E853DC491}" dt="2022-04-01T09:53:18.742" v="1591"/>
          <ac:picMkLst>
            <pc:docMk/>
            <pc:sldMk cId="3763209997" sldId="297"/>
            <ac:picMk id="126" creationId="{7A353013-A3CD-46DD-82C9-9ECC756EEE8B}"/>
          </ac:picMkLst>
        </pc:picChg>
        <pc:picChg chg="mod">
          <ac:chgData name="Filippo Acconcia" userId="844af49c-a8a0-47ac-a7dd-14a44b60cd18" providerId="ADAL" clId="{B609A75A-164F-4066-A006-F59E853DC491}" dt="2022-04-01T09:53:18.742" v="1591"/>
          <ac:picMkLst>
            <pc:docMk/>
            <pc:sldMk cId="3763209997" sldId="297"/>
            <ac:picMk id="127" creationId="{BDA2E175-FD01-4C4F-8DE0-5195A21D9C81}"/>
          </ac:picMkLst>
        </pc:picChg>
        <pc:picChg chg="mod">
          <ac:chgData name="Filippo Acconcia" userId="844af49c-a8a0-47ac-a7dd-14a44b60cd18" providerId="ADAL" clId="{B609A75A-164F-4066-A006-F59E853DC491}" dt="2022-04-01T09:53:18.742" v="1591"/>
          <ac:picMkLst>
            <pc:docMk/>
            <pc:sldMk cId="3763209997" sldId="297"/>
            <ac:picMk id="143" creationId="{7D44D8DC-0182-4995-A493-0D051A739FC4}"/>
          </ac:picMkLst>
        </pc:picChg>
        <pc:picChg chg="mod">
          <ac:chgData name="Filippo Acconcia" userId="844af49c-a8a0-47ac-a7dd-14a44b60cd18" providerId="ADAL" clId="{B609A75A-164F-4066-A006-F59E853DC491}" dt="2022-04-01T09:53:18.742" v="1591"/>
          <ac:picMkLst>
            <pc:docMk/>
            <pc:sldMk cId="3763209997" sldId="297"/>
            <ac:picMk id="144" creationId="{4738A717-9332-4A67-A808-D4663CF52E60}"/>
          </ac:picMkLst>
        </pc:picChg>
        <pc:picChg chg="mod">
          <ac:chgData name="Filippo Acconcia" userId="844af49c-a8a0-47ac-a7dd-14a44b60cd18" providerId="ADAL" clId="{B609A75A-164F-4066-A006-F59E853DC491}" dt="2022-04-01T09:53:18.742" v="1591"/>
          <ac:picMkLst>
            <pc:docMk/>
            <pc:sldMk cId="3763209997" sldId="297"/>
            <ac:picMk id="145" creationId="{F39BF43A-FACA-4ADD-896A-C6D100992897}"/>
          </ac:picMkLst>
        </pc:picChg>
        <pc:picChg chg="del mod topLvl">
          <ac:chgData name="Filippo Acconcia" userId="844af49c-a8a0-47ac-a7dd-14a44b60cd18" providerId="ADAL" clId="{B609A75A-164F-4066-A006-F59E853DC491}" dt="2022-04-01T10:17:43.665" v="1618" actId="478"/>
          <ac:picMkLst>
            <pc:docMk/>
            <pc:sldMk cId="3763209997" sldId="297"/>
            <ac:picMk id="158" creationId="{52811FA7-2B44-4CF8-9F65-32E3EB8B847A}"/>
          </ac:picMkLst>
        </pc:picChg>
        <pc:picChg chg="mod">
          <ac:chgData name="Filippo Acconcia" userId="844af49c-a8a0-47ac-a7dd-14a44b60cd18" providerId="ADAL" clId="{B609A75A-164F-4066-A006-F59E853DC491}" dt="2022-04-01T10:31:46.467" v="1707" actId="164"/>
          <ac:picMkLst>
            <pc:docMk/>
            <pc:sldMk cId="3763209997" sldId="297"/>
            <ac:picMk id="170" creationId="{FDEC6134-D7FC-43F4-A5E5-E03DB03564A3}"/>
          </ac:picMkLst>
        </pc:picChg>
        <pc:picChg chg="del mod topLvl">
          <ac:chgData name="Filippo Acconcia" userId="844af49c-a8a0-47ac-a7dd-14a44b60cd18" providerId="ADAL" clId="{B609A75A-164F-4066-A006-F59E853DC491}" dt="2022-04-01T10:31:27.270" v="1702" actId="478"/>
          <ac:picMkLst>
            <pc:docMk/>
            <pc:sldMk cId="3763209997" sldId="297"/>
            <ac:picMk id="172" creationId="{5C671368-579E-452C-9B1F-1C455C38A515}"/>
          </ac:picMkLst>
        </pc:picChg>
        <pc:picChg chg="mod">
          <ac:chgData name="Filippo Acconcia" userId="844af49c-a8a0-47ac-a7dd-14a44b60cd18" providerId="ADAL" clId="{B609A75A-164F-4066-A006-F59E853DC491}" dt="2022-04-01T10:43:26.403" v="1765" actId="164"/>
          <ac:picMkLst>
            <pc:docMk/>
            <pc:sldMk cId="3763209997" sldId="297"/>
            <ac:picMk id="185" creationId="{CAEF0E98-78F5-4C69-9C3E-6E0DB277D951}"/>
          </ac:picMkLst>
        </pc:picChg>
        <pc:picChg chg="del mod topLvl">
          <ac:chgData name="Filippo Acconcia" userId="844af49c-a8a0-47ac-a7dd-14a44b60cd18" providerId="ADAL" clId="{B609A75A-164F-4066-A006-F59E853DC491}" dt="2022-04-01T10:43:10.371" v="1760" actId="478"/>
          <ac:picMkLst>
            <pc:docMk/>
            <pc:sldMk cId="3763209997" sldId="297"/>
            <ac:picMk id="187" creationId="{B95E4CE0-92B7-4757-8C75-BFCDE09630C4}"/>
          </ac:picMkLst>
        </pc:picChg>
        <pc:cxnChg chg="mod">
          <ac:chgData name="Filippo Acconcia" userId="844af49c-a8a0-47ac-a7dd-14a44b60cd18" providerId="ADAL" clId="{B609A75A-164F-4066-A006-F59E853DC491}" dt="2022-04-01T09:53:18.742" v="1591"/>
          <ac:cxnSpMkLst>
            <pc:docMk/>
            <pc:sldMk cId="3763209997" sldId="297"/>
            <ac:cxnSpMk id="90" creationId="{A86DAF8F-01CE-491D-AB1B-E9B632401E80}"/>
          </ac:cxnSpMkLst>
        </pc:cxnChg>
        <pc:cxnChg chg="mod">
          <ac:chgData name="Filippo Acconcia" userId="844af49c-a8a0-47ac-a7dd-14a44b60cd18" providerId="ADAL" clId="{B609A75A-164F-4066-A006-F59E853DC491}" dt="2022-04-01T09:53:18.742" v="1591"/>
          <ac:cxnSpMkLst>
            <pc:docMk/>
            <pc:sldMk cId="3763209997" sldId="297"/>
            <ac:cxnSpMk id="103" creationId="{08E6E678-4E97-40D0-A898-FE534806AD09}"/>
          </ac:cxnSpMkLst>
        </pc:cxnChg>
        <pc:cxnChg chg="mod">
          <ac:chgData name="Filippo Acconcia" userId="844af49c-a8a0-47ac-a7dd-14a44b60cd18" providerId="ADAL" clId="{B609A75A-164F-4066-A006-F59E853DC491}" dt="2022-04-01T09:53:18.742" v="1591"/>
          <ac:cxnSpMkLst>
            <pc:docMk/>
            <pc:sldMk cId="3763209997" sldId="297"/>
            <ac:cxnSpMk id="122" creationId="{03B13241-A5AA-4086-A3EE-BC0E5A860042}"/>
          </ac:cxnSpMkLst>
        </pc:cxnChg>
        <pc:cxnChg chg="mod">
          <ac:chgData name="Filippo Acconcia" userId="844af49c-a8a0-47ac-a7dd-14a44b60cd18" providerId="ADAL" clId="{B609A75A-164F-4066-A006-F59E853DC491}" dt="2022-04-01T09:53:18.742" v="1591"/>
          <ac:cxnSpMkLst>
            <pc:docMk/>
            <pc:sldMk cId="3763209997" sldId="297"/>
            <ac:cxnSpMk id="136" creationId="{65DBE1A0-9C0F-4BB2-96AF-47A5516A4BD6}"/>
          </ac:cxnSpMkLst>
        </pc:cxnChg>
        <pc:cxnChg chg="mod">
          <ac:chgData name="Filippo Acconcia" userId="844af49c-a8a0-47ac-a7dd-14a44b60cd18" providerId="ADAL" clId="{B609A75A-164F-4066-A006-F59E853DC491}" dt="2022-04-01T09:53:18.742" v="1591"/>
          <ac:cxnSpMkLst>
            <pc:docMk/>
            <pc:sldMk cId="3763209997" sldId="297"/>
            <ac:cxnSpMk id="154" creationId="{2424CD0F-A115-4B99-83D7-7EC564CBFB80}"/>
          </ac:cxnSpMkLst>
        </pc:cxnChg>
        <pc:cxnChg chg="mod topLvl">
          <ac:chgData name="Filippo Acconcia" userId="844af49c-a8a0-47ac-a7dd-14a44b60cd18" providerId="ADAL" clId="{B609A75A-164F-4066-A006-F59E853DC491}" dt="2022-04-01T10:18:49.336" v="1628" actId="164"/>
          <ac:cxnSpMkLst>
            <pc:docMk/>
            <pc:sldMk cId="3763209997" sldId="297"/>
            <ac:cxnSpMk id="164" creationId="{5AF45267-7455-4135-9CBE-F0FF98CE0B6A}"/>
          </ac:cxnSpMkLst>
        </pc:cxnChg>
        <pc:cxnChg chg="mod topLvl">
          <ac:chgData name="Filippo Acconcia" userId="844af49c-a8a0-47ac-a7dd-14a44b60cd18" providerId="ADAL" clId="{B609A75A-164F-4066-A006-F59E853DC491}" dt="2022-04-01T10:31:46.467" v="1707" actId="164"/>
          <ac:cxnSpMkLst>
            <pc:docMk/>
            <pc:sldMk cId="3763209997" sldId="297"/>
            <ac:cxnSpMk id="178" creationId="{B09E8C77-9320-4CFE-8BDE-F4962A008ED4}"/>
          </ac:cxnSpMkLst>
        </pc:cxnChg>
        <pc:cxnChg chg="mod topLvl">
          <ac:chgData name="Filippo Acconcia" userId="844af49c-a8a0-47ac-a7dd-14a44b60cd18" providerId="ADAL" clId="{B609A75A-164F-4066-A006-F59E853DC491}" dt="2022-04-01T10:43:26.403" v="1765" actId="164"/>
          <ac:cxnSpMkLst>
            <pc:docMk/>
            <pc:sldMk cId="3763209997" sldId="297"/>
            <ac:cxnSpMk id="193" creationId="{62E51882-824A-490C-B245-372CA06C7C94}"/>
          </ac:cxnSpMkLst>
        </pc:cxnChg>
      </pc:sldChg>
      <pc:sldChg chg="addSp delSp modSp new mod">
        <pc:chgData name="Filippo Acconcia" userId="844af49c-a8a0-47ac-a7dd-14a44b60cd18" providerId="ADAL" clId="{B609A75A-164F-4066-A006-F59E853DC491}" dt="2022-04-01T08:45:28.242" v="1157"/>
        <pc:sldMkLst>
          <pc:docMk/>
          <pc:sldMk cId="3258456422" sldId="298"/>
        </pc:sldMkLst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4" creationId="{F269A9C5-C50F-4F4E-AD2A-8581373D1365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5" creationId="{EBFE015F-B1DC-45F8-A2E7-8F7CC17B18D4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6" creationId="{CB3092A4-3C5E-48E3-A006-03E7D5C6745E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7" creationId="{59EDA055-8EDC-467B-8A05-A03E80A05D1B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8" creationId="{08DB564F-F651-4C7E-B2F6-29E18A2F7D07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9" creationId="{BA2D4766-4ED2-4AD7-ACB9-AE21C04F1B83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0" creationId="{7E96D9DE-3219-40D8-AEFB-F44F08FA2D8F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1" creationId="{6F3F11FA-FC71-4B4A-8F64-EDAD709E4B83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2" creationId="{5BB720E4-B903-442A-9FE6-837240AF3D3A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3" creationId="{307BB6AF-D7CD-4D4A-8AF2-2083C572DCBD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4" creationId="{AD3C62A8-217C-414A-8C33-7341DFD862CB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5" creationId="{29A1EC0A-ACDF-442F-98AD-8834C6AD2151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9" creationId="{21126608-6207-48D8-8AA2-BB2EA75E3203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20" creationId="{47EB6CDF-6658-4E41-BDFB-E65A4E3708FF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21" creationId="{B8F6DCF3-AED3-4F00-81B9-6CC7B3EFE81F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22" creationId="{6D752404-014D-43A7-A6D7-4FFBD3DB4CB6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23" creationId="{42CBE36A-CA48-4D2E-AFD3-8B490FDD5236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24" creationId="{DA0B2EAC-1CFC-4016-8F20-C748754AE4E4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25" creationId="{361BC066-16B7-4D61-9C03-198DC091E052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26" creationId="{ECD4FE44-2F0C-4A61-940F-E702FA63314D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27" creationId="{C595E93E-6C14-48B7-99A5-051226E793CD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28" creationId="{51F57EA8-420A-49DF-ADD0-5AB80DF09FB1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29" creationId="{0DF0E540-6CE8-439E-985E-43FB6BCB71CE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30" creationId="{B594FFEF-08CB-4464-BAFF-5F79B361FE8F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34" creationId="{E79C50BA-2A9C-41C2-9C8E-3D5C37F825B6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35" creationId="{313BCA21-6EE0-47B4-85C0-58BC29BA73E5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36" creationId="{5047940E-4D2F-4656-B025-887617E1791B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37" creationId="{20569BFB-FA58-4BAE-9150-9230AE8643CA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38" creationId="{C3263BC3-6566-446F-AB49-4D477B21C3E3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39" creationId="{26FC982A-AEFB-4D8E-81D4-4DB734AEEB31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40" creationId="{0FAD7A8E-E786-448E-A116-B630AACC5182}"/>
          </ac:spMkLst>
        </pc:spChg>
        <pc:spChg chg="add del mod">
          <ac:chgData name="Filippo Acconcia" userId="844af49c-a8a0-47ac-a7dd-14a44b60cd18" providerId="ADAL" clId="{B609A75A-164F-4066-A006-F59E853DC491}" dt="2022-04-01T08:45:28.242" v="1157"/>
          <ac:spMkLst>
            <pc:docMk/>
            <pc:sldMk cId="3258456422" sldId="298"/>
            <ac:spMk id="40" creationId="{1B48EF0C-8F13-4315-8CE9-7E5539471489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41" creationId="{6A0B37C5-3D83-4CC8-94A9-AD934B28C810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42" creationId="{9A69D6F8-6972-4D87-B07B-265F223AA46E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43" creationId="{5EF295D8-5ACA-4286-AE04-DE4AD854972D}"/>
          </ac:spMkLst>
        </pc:spChg>
        <pc:spChg chg="mod">
          <ac:chgData name="Filippo Acconcia" userId="844af49c-a8a0-47ac-a7dd-14a44b60cd18" providerId="ADAL" clId="{B609A75A-164F-4066-A006-F59E853DC491}" dt="2022-04-01T08:44:48.642" v="1154"/>
          <ac:spMkLst>
            <pc:docMk/>
            <pc:sldMk cId="3258456422" sldId="298"/>
            <ac:spMk id="43" creationId="{95138511-45E3-4E8A-9BA1-23A3E8411045}"/>
          </ac:spMkLst>
        </pc:spChg>
        <pc:spChg chg="mod">
          <ac:chgData name="Filippo Acconcia" userId="844af49c-a8a0-47ac-a7dd-14a44b60cd18" providerId="ADAL" clId="{B609A75A-164F-4066-A006-F59E853DC491}" dt="2022-04-01T08:44:48.642" v="1154"/>
          <ac:spMkLst>
            <pc:docMk/>
            <pc:sldMk cId="3258456422" sldId="298"/>
            <ac:spMk id="44" creationId="{0101C61D-C1DB-4E90-9730-F99459DE589F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44" creationId="{29EBE68C-D007-4129-A8A5-5C6BCF7811D4}"/>
          </ac:spMkLst>
        </pc:spChg>
        <pc:spChg chg="mod">
          <ac:chgData name="Filippo Acconcia" userId="844af49c-a8a0-47ac-a7dd-14a44b60cd18" providerId="ADAL" clId="{B609A75A-164F-4066-A006-F59E853DC491}" dt="2022-04-01T08:44:48.642" v="1154"/>
          <ac:spMkLst>
            <pc:docMk/>
            <pc:sldMk cId="3258456422" sldId="298"/>
            <ac:spMk id="45" creationId="{3AB23226-1643-4572-AEFA-98077F27E092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45" creationId="{F27E611D-29DC-4A06-B96A-7FC00F54387B}"/>
          </ac:spMkLst>
        </pc:spChg>
        <pc:spChg chg="mod">
          <ac:chgData name="Filippo Acconcia" userId="844af49c-a8a0-47ac-a7dd-14a44b60cd18" providerId="ADAL" clId="{B609A75A-164F-4066-A006-F59E853DC491}" dt="2022-04-01T08:44:48.642" v="1154"/>
          <ac:spMkLst>
            <pc:docMk/>
            <pc:sldMk cId="3258456422" sldId="298"/>
            <ac:spMk id="46" creationId="{8C6045A8-5F51-4673-86AC-7123AF21A566}"/>
          </ac:spMkLst>
        </pc:spChg>
        <pc:spChg chg="mod">
          <ac:chgData name="Filippo Acconcia" userId="844af49c-a8a0-47ac-a7dd-14a44b60cd18" providerId="ADAL" clId="{B609A75A-164F-4066-A006-F59E853DC491}" dt="2022-04-01T08:44:48.642" v="1154"/>
          <ac:spMkLst>
            <pc:docMk/>
            <pc:sldMk cId="3258456422" sldId="298"/>
            <ac:spMk id="47" creationId="{33DCB87D-F31B-4ED9-BAE8-304BC2F3030F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47" creationId="{A3011307-9585-4292-AD15-B000B585839E}"/>
          </ac:spMkLst>
        </pc:spChg>
        <pc:spChg chg="mod">
          <ac:chgData name="Filippo Acconcia" userId="844af49c-a8a0-47ac-a7dd-14a44b60cd18" providerId="ADAL" clId="{B609A75A-164F-4066-A006-F59E853DC491}" dt="2022-04-01T08:44:48.642" v="1154"/>
          <ac:spMkLst>
            <pc:docMk/>
            <pc:sldMk cId="3258456422" sldId="298"/>
            <ac:spMk id="48" creationId="{22950080-D6F5-4186-80C4-2816A085BD57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48" creationId="{96538BE0-D1B4-4D14-BB57-C4505FE19115}"/>
          </ac:spMkLst>
        </pc:spChg>
        <pc:spChg chg="mod">
          <ac:chgData name="Filippo Acconcia" userId="844af49c-a8a0-47ac-a7dd-14a44b60cd18" providerId="ADAL" clId="{B609A75A-164F-4066-A006-F59E853DC491}" dt="2022-04-01T08:44:48.642" v="1154"/>
          <ac:spMkLst>
            <pc:docMk/>
            <pc:sldMk cId="3258456422" sldId="298"/>
            <ac:spMk id="49" creationId="{994E89E8-D805-4BE2-9853-B58B8972C14C}"/>
          </ac:spMkLst>
        </pc:spChg>
        <pc:spChg chg="mod">
          <ac:chgData name="Filippo Acconcia" userId="844af49c-a8a0-47ac-a7dd-14a44b60cd18" providerId="ADAL" clId="{B609A75A-164F-4066-A006-F59E853DC491}" dt="2022-04-01T08:44:48.642" v="1154"/>
          <ac:spMkLst>
            <pc:docMk/>
            <pc:sldMk cId="3258456422" sldId="298"/>
            <ac:spMk id="50" creationId="{9AFE51A8-386A-4C2B-A254-7EE94A2D35BF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51" creationId="{55D983ED-952F-43D1-A0F9-3D1BDF747F28}"/>
          </ac:spMkLst>
        </pc:spChg>
        <pc:spChg chg="mod">
          <ac:chgData name="Filippo Acconcia" userId="844af49c-a8a0-47ac-a7dd-14a44b60cd18" providerId="ADAL" clId="{B609A75A-164F-4066-A006-F59E853DC491}" dt="2022-04-01T08:44:48.642" v="1154"/>
          <ac:spMkLst>
            <pc:docMk/>
            <pc:sldMk cId="3258456422" sldId="298"/>
            <ac:spMk id="51" creationId="{C20F6A1E-7C93-460B-B66D-062369D9C239}"/>
          </ac:spMkLst>
        </pc:spChg>
        <pc:spChg chg="mod">
          <ac:chgData name="Filippo Acconcia" userId="844af49c-a8a0-47ac-a7dd-14a44b60cd18" providerId="ADAL" clId="{B609A75A-164F-4066-A006-F59E853DC491}" dt="2022-04-01T08:44:48.642" v="1154"/>
          <ac:spMkLst>
            <pc:docMk/>
            <pc:sldMk cId="3258456422" sldId="298"/>
            <ac:spMk id="52" creationId="{AEA74B64-C53B-4F6D-9AB1-1CBE134A55E8}"/>
          </ac:spMkLst>
        </pc:spChg>
        <pc:spChg chg="mod">
          <ac:chgData name="Filippo Acconcia" userId="844af49c-a8a0-47ac-a7dd-14a44b60cd18" providerId="ADAL" clId="{B609A75A-164F-4066-A006-F59E853DC491}" dt="2022-04-01T08:44:48.642" v="1154"/>
          <ac:spMkLst>
            <pc:docMk/>
            <pc:sldMk cId="3258456422" sldId="298"/>
            <ac:spMk id="53" creationId="{CB92931D-85A8-402B-83D3-340D5AE68FAA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53" creationId="{E2AC71C6-7299-4274-96DE-E92124D3F7DF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54" creationId="{34C4FD79-8DCA-4E9D-B159-5706CAFD39E9}"/>
          </ac:spMkLst>
        </pc:spChg>
        <pc:spChg chg="mod">
          <ac:chgData name="Filippo Acconcia" userId="844af49c-a8a0-47ac-a7dd-14a44b60cd18" providerId="ADAL" clId="{B609A75A-164F-4066-A006-F59E853DC491}" dt="2022-04-01T08:44:48.642" v="1154"/>
          <ac:spMkLst>
            <pc:docMk/>
            <pc:sldMk cId="3258456422" sldId="298"/>
            <ac:spMk id="54" creationId="{6FED8AD1-6CAA-4BD2-B26C-0EA40BCF1C6A}"/>
          </ac:spMkLst>
        </pc:spChg>
        <pc:spChg chg="mod">
          <ac:chgData name="Filippo Acconcia" userId="844af49c-a8a0-47ac-a7dd-14a44b60cd18" providerId="ADAL" clId="{B609A75A-164F-4066-A006-F59E853DC491}" dt="2022-04-01T08:44:48.642" v="1154"/>
          <ac:spMkLst>
            <pc:docMk/>
            <pc:sldMk cId="3258456422" sldId="298"/>
            <ac:spMk id="55" creationId="{23DEBDB3-6DA8-410D-9F71-78183B7C83D5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55" creationId="{F01E611C-4F09-4120-9636-BF65872CBAF1}"/>
          </ac:spMkLst>
        </pc:spChg>
        <pc:spChg chg="mod">
          <ac:chgData name="Filippo Acconcia" userId="844af49c-a8a0-47ac-a7dd-14a44b60cd18" providerId="ADAL" clId="{B609A75A-164F-4066-A006-F59E853DC491}" dt="2022-04-01T08:44:48.642" v="1154"/>
          <ac:spMkLst>
            <pc:docMk/>
            <pc:sldMk cId="3258456422" sldId="298"/>
            <ac:spMk id="56" creationId="{1F4E2D37-7596-4C46-98BC-EEB4C7120521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56" creationId="{5F0D44B5-3567-4848-A3DB-06EFB118C296}"/>
          </ac:spMkLst>
        </pc:spChg>
        <pc:spChg chg="mod">
          <ac:chgData name="Filippo Acconcia" userId="844af49c-a8a0-47ac-a7dd-14a44b60cd18" providerId="ADAL" clId="{B609A75A-164F-4066-A006-F59E853DC491}" dt="2022-04-01T08:44:48.642" v="1154"/>
          <ac:spMkLst>
            <pc:docMk/>
            <pc:sldMk cId="3258456422" sldId="298"/>
            <ac:spMk id="57" creationId="{8DA84D93-8544-4201-8EA7-99AF9B809A6C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57" creationId="{9E3741DB-FB39-425C-BC94-C4D18C161A4C}"/>
          </ac:spMkLst>
        </pc:spChg>
        <pc:spChg chg="mod">
          <ac:chgData name="Filippo Acconcia" userId="844af49c-a8a0-47ac-a7dd-14a44b60cd18" providerId="ADAL" clId="{B609A75A-164F-4066-A006-F59E853DC491}" dt="2022-04-01T08:44:48.642" v="1154"/>
          <ac:spMkLst>
            <pc:docMk/>
            <pc:sldMk cId="3258456422" sldId="298"/>
            <ac:spMk id="58" creationId="{06628D9F-EC18-46E8-8721-1CC9755D609D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58" creationId="{5D627ED2-398D-4ACB-9CFD-A080F5E68A3A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59" creationId="{56DEB2DC-9497-4B0A-B347-36E5A1AE0D81}"/>
          </ac:spMkLst>
        </pc:spChg>
        <pc:spChg chg="mod">
          <ac:chgData name="Filippo Acconcia" userId="844af49c-a8a0-47ac-a7dd-14a44b60cd18" providerId="ADAL" clId="{B609A75A-164F-4066-A006-F59E853DC491}" dt="2022-04-01T08:44:48.642" v="1154"/>
          <ac:spMkLst>
            <pc:docMk/>
            <pc:sldMk cId="3258456422" sldId="298"/>
            <ac:spMk id="59" creationId="{5F37FFFB-A3E9-49D2-99D9-6C5AFF080D79}"/>
          </ac:spMkLst>
        </pc:spChg>
        <pc:spChg chg="mod">
          <ac:chgData name="Filippo Acconcia" userId="844af49c-a8a0-47ac-a7dd-14a44b60cd18" providerId="ADAL" clId="{B609A75A-164F-4066-A006-F59E853DC491}" dt="2022-04-01T08:44:48.642" v="1154"/>
          <ac:spMkLst>
            <pc:docMk/>
            <pc:sldMk cId="3258456422" sldId="298"/>
            <ac:spMk id="60" creationId="{CFD02A92-2EE1-4520-84A8-05EFFF03E852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60" creationId="{FFC91B45-FAC3-427A-8C0C-5B77562C0E26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61" creationId="{A5D071F2-F286-4E0F-AB3B-2EDD29720D43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62" creationId="{FA3044A9-6829-4F58-9CDB-175B586F5247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63" creationId="{B8EB7993-4C34-4404-B03C-3E8F48C58EF5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64" creationId="{F9CB8F2D-195C-48D3-9CA7-8E083FE2738E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66" creationId="{81153DF7-3A30-4711-BAD2-8EDA18069188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69" creationId="{1B8C817E-9EA2-45E7-B132-23570CF6E6F2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71" creationId="{B9D72985-C593-4688-82E6-D1F95639A228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72" creationId="{B56382DD-54D9-49E0-8C55-FDBB2F258C7A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73" creationId="{39F07AE5-2B1B-4C74-B08E-0981C38B37F5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74" creationId="{0478D530-D3B9-4191-ACF1-E639EDA31EE4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75" creationId="{8DAD2520-D2EE-4876-9A71-EAC99F960D65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76" creationId="{D86CADB8-907E-470E-8B6D-C20DD0E1A4A3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77" creationId="{8DFBF3D1-3E70-493A-A311-C15EA8DADC48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78" creationId="{A2CCB5B4-4051-4310-B12C-71E342B10AE9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79" creationId="{7E284A23-548B-432A-A7CD-2D2169F504B8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80" creationId="{435664C6-1455-4AB1-8C6E-D74750F382FA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81" creationId="{A53AD5B2-4DAF-46C6-9650-3FC6420B64C6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82" creationId="{457BA2F5-BDD2-48ED-B984-8FBC9747ECEA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84" creationId="{3D7D454F-35ED-43EE-A306-7A0090CF0B36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87" creationId="{8291B811-2616-4FF6-B672-388B9BF0FE75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88" creationId="{F7DD490E-AF3B-45D6-91EE-0CDADC4D6F7D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89" creationId="{0A8C620C-2F56-4F74-BC9E-96704357FCF8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90" creationId="{4E21430E-15D8-4AB1-9853-DC68161AA0A5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91" creationId="{88ECB72E-032D-4655-AD2D-C47FCBBFAF0F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92" creationId="{2D712E86-E336-4703-98F6-EF03605DD6BC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93" creationId="{B8D00E3C-0225-4CA3-9B46-4E51E123B8E3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94" creationId="{5B16A0B9-C21B-47B6-92DD-8CA10E1A7790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95" creationId="{E3E8E979-77D7-4C19-A730-FA35F9C09E51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96" creationId="{2F087681-4E72-4792-AEF3-D80408533CB9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97" creationId="{2671B67E-178E-4764-9C39-F1845C955DD9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98" creationId="{32D519DB-9474-40C3-BA4C-CF49A58F9759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00" creationId="{3054FD95-1283-476D-8ECC-86247E1AEB89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01" creationId="{A7AFB876-5E08-4B41-8D8F-1C40BDF01507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04" creationId="{DF2440EF-A633-4B3F-9F25-480F9A065C71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05" creationId="{0D7B0444-25FF-4643-A349-74C18660FB6C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06" creationId="{5614A3C0-BBC1-452C-AC3E-C14A66A04EDF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07" creationId="{B79CEBA7-7F0D-48F3-8814-D5B7E03F8898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08" creationId="{2B5ADA48-1FBE-455D-9E19-399D1749A1E0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09" creationId="{4BAE403E-97CF-4FF3-88DC-2295C7530943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10" creationId="{96EE6C16-2EC8-48BD-8532-1163749B18A6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11" creationId="{A32A5F13-D8C8-4FC2-873E-3AF76445B309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12" creationId="{AE72F59D-0F25-4CAE-B8D2-27F65163AF11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13" creationId="{59508B7B-D25B-4A25-946A-5E88ADDE075A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14" creationId="{24B116BD-92ED-4CC1-B8ED-7C0E3FB85AA5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15" creationId="{669BD7DF-9823-4EE5-9F36-B90018DC14CB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16" creationId="{447CF7BB-1F97-4E74-A1CB-1D5F3A54BEB9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17" creationId="{67B113E6-36D1-4E50-8754-01853460C78F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18" creationId="{8F916F5D-7B90-4B96-961B-0619DBDBDA0F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19" creationId="{3DBF0324-AA1E-473F-B33E-AFC464C4B4E7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20" creationId="{BFE6BAC1-F8EA-4129-AE54-7D0B192C9A66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21" creationId="{478F806E-D440-426A-B7A5-7881E5432403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22" creationId="{1EA035E7-E4E6-43D5-A378-DEA1F789EB6F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23" creationId="{F3155F86-F475-452C-A1CA-81FDEA0836BC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24" creationId="{1BF2DBA0-0D49-4776-9DC5-A0D57511AA34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25" creationId="{EB40536A-E8ED-40D4-BD54-B02FCC373BF8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26" creationId="{34046D67-3428-4463-B599-EADA3C6F8AEE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27" creationId="{07E84EF9-2756-4A60-88A5-3C4554B53093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29" creationId="{43847CA3-B40E-4FA8-97C1-DE7C7728B38B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32" creationId="{8F308146-418E-4FF5-AD10-16879E3690DA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33" creationId="{354AE59F-0B8D-41A3-8382-9A47B6EDE47E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34" creationId="{91E74D1E-CC53-494B-B52A-3E56DC4A708C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35" creationId="{423F0CD2-CB85-49D9-9045-40B1B1F9C28D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36" creationId="{5F25E1C6-A499-49D9-A2DA-49AAFB128CA6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37" creationId="{B9B80723-EC4D-4154-9AA2-37C482300C0B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38" creationId="{06EAC53F-61B8-4320-B129-5718FA2E86CE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39" creationId="{84AFDEFA-168E-4E19-ADE8-733A1593133C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40" creationId="{F782F43E-D7A7-4FC4-A1B9-153894A338F0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41" creationId="{D7F0BBEE-BDF6-4496-8C87-0CBF63A0182F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42" creationId="{61190318-A0BE-4A04-9599-826039574A3B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43" creationId="{B96D4701-2594-4C87-8B5B-7B27A3EE69AF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44" creationId="{096833F6-EEF0-4C77-9CCF-6946CDF98D1C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45" creationId="{5C4874EB-7BA4-4849-82B1-7E8AD8A364AA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46" creationId="{393A3A4E-275E-442E-AA5E-2EA8D03FCF5F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47" creationId="{61BC16DF-FF62-47F1-A429-4440870FAFEE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48" creationId="{8E9CB6F1-B998-4B33-84E0-94D99A417004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49" creationId="{39734160-4CF4-452C-85D0-EE4EFA7D2901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50" creationId="{CC75D534-980D-4082-9756-5348F12ECC53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51" creationId="{8A4C5398-73AB-4040-A236-1C7C3B451D23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52" creationId="{ADB40F28-DB8A-40AC-9E62-0D76C1344244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54" creationId="{C8FF4307-2E5C-48B9-8BDE-CC9C64D2D203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55" creationId="{5634CE8A-0A52-4DB2-B562-2CD5FCF5AD70}"/>
          </ac:spMkLst>
        </pc:spChg>
        <pc:spChg chg="mod">
          <ac:chgData name="Filippo Acconcia" userId="844af49c-a8a0-47ac-a7dd-14a44b60cd18" providerId="ADAL" clId="{B609A75A-164F-4066-A006-F59E853DC491}" dt="2022-03-24T10:11:10.883" v="1"/>
          <ac:spMkLst>
            <pc:docMk/>
            <pc:sldMk cId="3258456422" sldId="298"/>
            <ac:spMk id="156" creationId="{589FDBC0-3CD1-464E-90EA-22F22BC4ECBC}"/>
          </ac:spMkLst>
        </pc:spChg>
        <pc:spChg chg="add del mod">
          <ac:chgData name="Filippo Acconcia" userId="844af49c-a8a0-47ac-a7dd-14a44b60cd18" providerId="ADAL" clId="{B609A75A-164F-4066-A006-F59E853DC491}" dt="2022-03-28T07:44:13.973" v="324" actId="21"/>
          <ac:spMkLst>
            <pc:docMk/>
            <pc:sldMk cId="3258456422" sldId="298"/>
            <ac:spMk id="157" creationId="{D89293AD-9BE9-40D6-B178-DA385ADD11BC}"/>
          </ac:spMkLst>
        </pc:spChg>
        <pc:spChg chg="add del mod">
          <ac:chgData name="Filippo Acconcia" userId="844af49c-a8a0-47ac-a7dd-14a44b60cd18" providerId="ADAL" clId="{B609A75A-164F-4066-A006-F59E853DC491}" dt="2022-03-28T07:44:13.973" v="324" actId="21"/>
          <ac:spMkLst>
            <pc:docMk/>
            <pc:sldMk cId="3258456422" sldId="298"/>
            <ac:spMk id="158" creationId="{19567E7A-E91E-4D1F-B698-8D7C2A3BFA94}"/>
          </ac:spMkLst>
        </pc:spChg>
        <pc:spChg chg="add del mod">
          <ac:chgData name="Filippo Acconcia" userId="844af49c-a8a0-47ac-a7dd-14a44b60cd18" providerId="ADAL" clId="{B609A75A-164F-4066-A006-F59E853DC491}" dt="2022-03-28T07:46:28.201" v="353" actId="21"/>
          <ac:spMkLst>
            <pc:docMk/>
            <pc:sldMk cId="3258456422" sldId="298"/>
            <ac:spMk id="159" creationId="{19EFD18E-C1C8-4315-9747-D81F32686A5C}"/>
          </ac:spMkLst>
        </pc:spChg>
        <pc:spChg chg="add del mod">
          <ac:chgData name="Filippo Acconcia" userId="844af49c-a8a0-47ac-a7dd-14a44b60cd18" providerId="ADAL" clId="{B609A75A-164F-4066-A006-F59E853DC491}" dt="2022-03-28T07:46:28.201" v="353" actId="21"/>
          <ac:spMkLst>
            <pc:docMk/>
            <pc:sldMk cId="3258456422" sldId="298"/>
            <ac:spMk id="160" creationId="{2D34A65D-F844-40AA-A73E-8621BD060BE6}"/>
          </ac:spMkLst>
        </pc:spChg>
        <pc:spChg chg="add del mod">
          <ac:chgData name="Filippo Acconcia" userId="844af49c-a8a0-47ac-a7dd-14a44b60cd18" providerId="ADAL" clId="{B609A75A-164F-4066-A006-F59E853DC491}" dt="2022-03-28T07:46:28.201" v="353" actId="21"/>
          <ac:spMkLst>
            <pc:docMk/>
            <pc:sldMk cId="3258456422" sldId="298"/>
            <ac:spMk id="161" creationId="{A9CC378A-C24D-4047-BB33-F17CC61A7C07}"/>
          </ac:spMkLst>
        </pc:spChg>
        <pc:spChg chg="add del mod">
          <ac:chgData name="Filippo Acconcia" userId="844af49c-a8a0-47ac-a7dd-14a44b60cd18" providerId="ADAL" clId="{B609A75A-164F-4066-A006-F59E853DC491}" dt="2022-03-28T07:46:28.201" v="353" actId="21"/>
          <ac:spMkLst>
            <pc:docMk/>
            <pc:sldMk cId="3258456422" sldId="298"/>
            <ac:spMk id="162" creationId="{5FDBEDCB-DFA3-46A2-AF40-AC656954897E}"/>
          </ac:spMkLst>
        </pc:spChg>
        <pc:spChg chg="add del mod">
          <ac:chgData name="Filippo Acconcia" userId="844af49c-a8a0-47ac-a7dd-14a44b60cd18" providerId="ADAL" clId="{B609A75A-164F-4066-A006-F59E853DC491}" dt="2022-03-28T07:46:28.201" v="353" actId="21"/>
          <ac:spMkLst>
            <pc:docMk/>
            <pc:sldMk cId="3258456422" sldId="298"/>
            <ac:spMk id="163" creationId="{2743AD8D-C429-427C-A5B7-2CCD61FF9C43}"/>
          </ac:spMkLst>
        </pc:spChg>
        <pc:spChg chg="add del mod">
          <ac:chgData name="Filippo Acconcia" userId="844af49c-a8a0-47ac-a7dd-14a44b60cd18" providerId="ADAL" clId="{B609A75A-164F-4066-A006-F59E853DC491}" dt="2022-03-28T07:46:28.201" v="353" actId="21"/>
          <ac:spMkLst>
            <pc:docMk/>
            <pc:sldMk cId="3258456422" sldId="298"/>
            <ac:spMk id="164" creationId="{364F84DB-8EE5-4444-B0DB-0C9EE174E1AF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67" creationId="{F7F66051-10BA-4A44-B047-4C3743983FE3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68" creationId="{DA2DB61C-EADA-4BC5-B871-A40EDC790F00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69" creationId="{154EE112-6DD3-4000-91CB-1A0C45D2DC97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70" creationId="{CCE03654-6B28-4C5E-BA9C-88E8266D68B3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71" creationId="{9E88F261-0773-4E3E-B587-E2FB67A9C2DD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72" creationId="{A2B0ACBE-9B85-4C99-A11C-705A9A4B1A00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73" creationId="{DF4F5D58-0809-4C42-AA0A-21B381AE7F9D}"/>
          </ac:spMkLst>
        </pc:spChg>
        <pc:spChg chg="add mod">
          <ac:chgData name="Filippo Acconcia" userId="844af49c-a8a0-47ac-a7dd-14a44b60cd18" providerId="ADAL" clId="{B609A75A-164F-4066-A006-F59E853DC491}" dt="2022-03-28T07:53:39.037" v="415" actId="12789"/>
          <ac:spMkLst>
            <pc:docMk/>
            <pc:sldMk cId="3258456422" sldId="298"/>
            <ac:spMk id="176" creationId="{722B450F-3F9B-4F68-8078-9C725D33507C}"/>
          </ac:spMkLst>
        </pc:spChg>
        <pc:spChg chg="add mod">
          <ac:chgData name="Filippo Acconcia" userId="844af49c-a8a0-47ac-a7dd-14a44b60cd18" providerId="ADAL" clId="{B609A75A-164F-4066-A006-F59E853DC491}" dt="2022-03-28T07:53:39.037" v="415" actId="12789"/>
          <ac:spMkLst>
            <pc:docMk/>
            <pc:sldMk cId="3258456422" sldId="298"/>
            <ac:spMk id="177" creationId="{BC3E4455-CC19-43C4-A420-70C2643B7A92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80" creationId="{F0C193CB-5DBC-4163-B3F0-8120C9EA8ECF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81" creationId="{690A6B70-D5CF-4930-9DAA-EEE21A710337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82" creationId="{126F0C58-5133-4707-B063-FD26289B56B3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83" creationId="{0C20321D-E322-4CB5-9494-BE1E0EFDDF2C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84" creationId="{9F610B9C-8AEA-4190-8C54-979EEFA083A6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85" creationId="{34E3DA42-9A71-4182-8B19-8716F2D40CC4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86" creationId="{226A9FB2-56AF-47EC-92B3-4785F58D5DD9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87" creationId="{6EE46F5B-4E9B-43E1-8D28-3EB10B5FEE69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88" creationId="{60089EC9-331A-4088-8522-98484D3AF516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89" creationId="{81AF1C0F-2931-4A51-8C7A-56FFC39BD4B2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90" creationId="{B41157AF-4AF9-486C-AA0B-E278105C496A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91" creationId="{8E17F78A-417C-441E-9267-5C7F88F63DAF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92" creationId="{4A312E14-93C3-4457-8C0C-DA553C5BE143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93" creationId="{E91A7CCA-D491-4917-A284-28EE7196DE6D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94" creationId="{F3A27F4F-DC51-4694-87ED-11ABD125D200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95" creationId="{62F68469-E0F9-41CA-9CC3-CF3C904BEC10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96" creationId="{2F36735B-17A9-41BB-895B-AB50A87B5C57}"/>
          </ac:spMkLst>
        </pc:spChg>
        <pc:spChg chg="mod">
          <ac:chgData name="Filippo Acconcia" userId="844af49c-a8a0-47ac-a7dd-14a44b60cd18" providerId="ADAL" clId="{B609A75A-164F-4066-A006-F59E853DC491}" dt="2022-03-24T10:12:36.401" v="3"/>
          <ac:spMkLst>
            <pc:docMk/>
            <pc:sldMk cId="3258456422" sldId="298"/>
            <ac:spMk id="197" creationId="{4DAD287D-E728-4828-9B93-D7C85129D613}"/>
          </ac:spMkLst>
        </pc:spChg>
        <pc:spChg chg="add mod">
          <ac:chgData name="Filippo Acconcia" userId="844af49c-a8a0-47ac-a7dd-14a44b60cd18" providerId="ADAL" clId="{B609A75A-164F-4066-A006-F59E853DC491}" dt="2022-03-30T08:37:16.845" v="463" actId="20577"/>
          <ac:spMkLst>
            <pc:docMk/>
            <pc:sldMk cId="3258456422" sldId="298"/>
            <ac:spMk id="213" creationId="{F28BA8AA-D7EE-49F8-93D1-75E2EC8B2D89}"/>
          </ac:spMkLst>
        </pc:spChg>
        <pc:grpChg chg="add del mod">
          <ac:chgData name="Filippo Acconcia" userId="844af49c-a8a0-47ac-a7dd-14a44b60cd18" providerId="ADAL" clId="{B609A75A-164F-4066-A006-F59E853DC491}" dt="2022-03-28T07:44:13.973" v="324" actId="21"/>
          <ac:grpSpMkLst>
            <pc:docMk/>
            <pc:sldMk cId="3258456422" sldId="298"/>
            <ac:grpSpMk id="2" creationId="{41435C5C-C3EE-4520-A9D2-83BA2D657619}"/>
          </ac:grpSpMkLst>
        </pc:grpChg>
        <pc:grpChg chg="add del mod">
          <ac:chgData name="Filippo Acconcia" userId="844af49c-a8a0-47ac-a7dd-14a44b60cd18" providerId="ADAL" clId="{B609A75A-164F-4066-A006-F59E853DC491}" dt="2022-03-28T07:44:13.973" v="324" actId="21"/>
          <ac:grpSpMkLst>
            <pc:docMk/>
            <pc:sldMk cId="3258456422" sldId="298"/>
            <ac:grpSpMk id="17" creationId="{3CE1A6D9-7F20-43CA-A102-32EE9B93D233}"/>
          </ac:grpSpMkLst>
        </pc:grpChg>
        <pc:grpChg chg="add del mod">
          <ac:chgData name="Filippo Acconcia" userId="844af49c-a8a0-47ac-a7dd-14a44b60cd18" providerId="ADAL" clId="{B609A75A-164F-4066-A006-F59E853DC491}" dt="2022-03-28T07:46:28.201" v="353" actId="21"/>
          <ac:grpSpMkLst>
            <pc:docMk/>
            <pc:sldMk cId="3258456422" sldId="298"/>
            <ac:grpSpMk id="32" creationId="{DED46465-9326-4AC0-9683-11634376CFCA}"/>
          </ac:grpSpMkLst>
        </pc:grpChg>
        <pc:grpChg chg="add del mod">
          <ac:chgData name="Filippo Acconcia" userId="844af49c-a8a0-47ac-a7dd-14a44b60cd18" providerId="ADAL" clId="{B609A75A-164F-4066-A006-F59E853DC491}" dt="2022-04-01T08:45:28.242" v="1157"/>
          <ac:grpSpMkLst>
            <pc:docMk/>
            <pc:sldMk cId="3258456422" sldId="298"/>
            <ac:grpSpMk id="41" creationId="{E6E1A838-79E3-46A6-9C87-E6A6839AAF74}"/>
          </ac:grpSpMkLst>
        </pc:grpChg>
        <pc:grpChg chg="add del mod">
          <ac:chgData name="Filippo Acconcia" userId="844af49c-a8a0-47ac-a7dd-14a44b60cd18" providerId="ADAL" clId="{B609A75A-164F-4066-A006-F59E853DC491}" dt="2022-03-28T07:46:28.201" v="353" actId="21"/>
          <ac:grpSpMkLst>
            <pc:docMk/>
            <pc:sldMk cId="3258456422" sldId="298"/>
            <ac:grpSpMk id="49" creationId="{0268379C-2447-436D-83F4-8388D7FE9091}"/>
          </ac:grpSpMkLst>
        </pc:grpChg>
        <pc:grpChg chg="mod">
          <ac:chgData name="Filippo Acconcia" userId="844af49c-a8a0-47ac-a7dd-14a44b60cd18" providerId="ADAL" clId="{B609A75A-164F-4066-A006-F59E853DC491}" dt="2022-03-24T10:11:10.883" v="1"/>
          <ac:grpSpMkLst>
            <pc:docMk/>
            <pc:sldMk cId="3258456422" sldId="298"/>
            <ac:grpSpMk id="50" creationId="{4C6A9968-7C0C-4A83-A274-6AB81A5BF616}"/>
          </ac:grpSpMkLst>
        </pc:grpChg>
        <pc:grpChg chg="add del mod">
          <ac:chgData name="Filippo Acconcia" userId="844af49c-a8a0-47ac-a7dd-14a44b60cd18" providerId="ADAL" clId="{B609A75A-164F-4066-A006-F59E853DC491}" dt="2022-03-28T07:46:28.201" v="353" actId="21"/>
          <ac:grpSpMkLst>
            <pc:docMk/>
            <pc:sldMk cId="3258456422" sldId="298"/>
            <ac:grpSpMk id="67" creationId="{451B45C1-763D-4D2E-ADD9-78B8E340BC57}"/>
          </ac:grpSpMkLst>
        </pc:grpChg>
        <pc:grpChg chg="mod">
          <ac:chgData name="Filippo Acconcia" userId="844af49c-a8a0-47ac-a7dd-14a44b60cd18" providerId="ADAL" clId="{B609A75A-164F-4066-A006-F59E853DC491}" dt="2022-03-24T10:11:10.883" v="1"/>
          <ac:grpSpMkLst>
            <pc:docMk/>
            <pc:sldMk cId="3258456422" sldId="298"/>
            <ac:grpSpMk id="68" creationId="{4751BCF1-77D4-4110-8AAA-08DBD6F126C6}"/>
          </ac:grpSpMkLst>
        </pc:grpChg>
        <pc:grpChg chg="add del mod">
          <ac:chgData name="Filippo Acconcia" userId="844af49c-a8a0-47ac-a7dd-14a44b60cd18" providerId="ADAL" clId="{B609A75A-164F-4066-A006-F59E853DC491}" dt="2022-03-28T07:46:28.201" v="353" actId="21"/>
          <ac:grpSpMkLst>
            <pc:docMk/>
            <pc:sldMk cId="3258456422" sldId="298"/>
            <ac:grpSpMk id="85" creationId="{4F56522C-9152-4104-9FA1-88379486454C}"/>
          </ac:grpSpMkLst>
        </pc:grpChg>
        <pc:grpChg chg="add del mod">
          <ac:chgData name="Filippo Acconcia" userId="844af49c-a8a0-47ac-a7dd-14a44b60cd18" providerId="ADAL" clId="{B609A75A-164F-4066-A006-F59E853DC491}" dt="2022-03-28T07:46:28.201" v="353" actId="21"/>
          <ac:grpSpMkLst>
            <pc:docMk/>
            <pc:sldMk cId="3258456422" sldId="298"/>
            <ac:grpSpMk id="102" creationId="{B1354D6E-832C-4B26-AC43-88E369352CD8}"/>
          </ac:grpSpMkLst>
        </pc:grpChg>
        <pc:grpChg chg="add del mod">
          <ac:chgData name="Filippo Acconcia" userId="844af49c-a8a0-47ac-a7dd-14a44b60cd18" providerId="ADAL" clId="{B609A75A-164F-4066-A006-F59E853DC491}" dt="2022-03-28T07:46:28.201" v="353" actId="21"/>
          <ac:grpSpMkLst>
            <pc:docMk/>
            <pc:sldMk cId="3258456422" sldId="298"/>
            <ac:grpSpMk id="130" creationId="{9EDADBC2-AA51-4E47-BD48-6BC41BF29498}"/>
          </ac:grpSpMkLst>
        </pc:grpChg>
        <pc:grpChg chg="add mod">
          <ac:chgData name="Filippo Acconcia" userId="844af49c-a8a0-47ac-a7dd-14a44b60cd18" providerId="ADAL" clId="{B609A75A-164F-4066-A006-F59E853DC491}" dt="2022-03-24T10:12:38.621" v="4" actId="1076"/>
          <ac:grpSpMkLst>
            <pc:docMk/>
            <pc:sldMk cId="3258456422" sldId="298"/>
            <ac:grpSpMk id="165" creationId="{72649F00-0771-4DBF-8FE7-A69CB648D350}"/>
          </ac:grpSpMkLst>
        </pc:grpChg>
        <pc:grpChg chg="add mod">
          <ac:chgData name="Filippo Acconcia" userId="844af49c-a8a0-47ac-a7dd-14a44b60cd18" providerId="ADAL" clId="{B609A75A-164F-4066-A006-F59E853DC491}" dt="2022-03-28T07:53:28.094" v="411" actId="1076"/>
          <ac:grpSpMkLst>
            <pc:docMk/>
            <pc:sldMk cId="3258456422" sldId="298"/>
            <ac:grpSpMk id="178" creationId="{E992011D-766B-43CC-9AF2-4DCE84B1EACC}"/>
          </ac:grpSpMkLst>
        </pc:grpChg>
        <pc:grpChg chg="mod">
          <ac:chgData name="Filippo Acconcia" userId="844af49c-a8a0-47ac-a7dd-14a44b60cd18" providerId="ADAL" clId="{B609A75A-164F-4066-A006-F59E853DC491}" dt="2022-03-28T07:53:30.001" v="412" actId="1076"/>
          <ac:grpSpMkLst>
            <pc:docMk/>
            <pc:sldMk cId="3258456422" sldId="298"/>
            <ac:grpSpMk id="202" creationId="{793F8F83-D844-4696-BA94-330A01405D41}"/>
          </ac:grpSpMkLst>
        </pc:grpChg>
        <pc:picChg chg="mod">
          <ac:chgData name="Filippo Acconcia" userId="844af49c-a8a0-47ac-a7dd-14a44b60cd18" providerId="ADAL" clId="{B609A75A-164F-4066-A006-F59E853DC491}" dt="2022-03-24T10:11:10.883" v="1"/>
          <ac:picMkLst>
            <pc:docMk/>
            <pc:sldMk cId="3258456422" sldId="298"/>
            <ac:picMk id="3" creationId="{7619C6D1-96F9-4973-B550-8E59F56AD70F}"/>
          </ac:picMkLst>
        </pc:picChg>
        <pc:picChg chg="mod">
          <ac:chgData name="Filippo Acconcia" userId="844af49c-a8a0-47ac-a7dd-14a44b60cd18" providerId="ADAL" clId="{B609A75A-164F-4066-A006-F59E853DC491}" dt="2022-03-24T10:11:10.883" v="1"/>
          <ac:picMkLst>
            <pc:docMk/>
            <pc:sldMk cId="3258456422" sldId="298"/>
            <ac:picMk id="18" creationId="{99BFF3E1-2F8E-4095-A9E7-AAD217DA3349}"/>
          </ac:picMkLst>
        </pc:picChg>
        <pc:picChg chg="mod">
          <ac:chgData name="Filippo Acconcia" userId="844af49c-a8a0-47ac-a7dd-14a44b60cd18" providerId="ADAL" clId="{B609A75A-164F-4066-A006-F59E853DC491}" dt="2022-03-24T10:11:10.883" v="1"/>
          <ac:picMkLst>
            <pc:docMk/>
            <pc:sldMk cId="3258456422" sldId="298"/>
            <ac:picMk id="33" creationId="{76F9A622-E0B0-47DE-B4E2-A845B8182DA1}"/>
          </ac:picMkLst>
        </pc:picChg>
        <pc:picChg chg="mod">
          <ac:chgData name="Filippo Acconcia" userId="844af49c-a8a0-47ac-a7dd-14a44b60cd18" providerId="ADAL" clId="{B609A75A-164F-4066-A006-F59E853DC491}" dt="2022-04-01T08:44:48.642" v="1154"/>
          <ac:picMkLst>
            <pc:docMk/>
            <pc:sldMk cId="3258456422" sldId="298"/>
            <ac:picMk id="42" creationId="{A67D0DB9-733D-40F0-97F8-1F80D6B8B36A}"/>
          </ac:picMkLst>
        </pc:picChg>
        <pc:picChg chg="mod">
          <ac:chgData name="Filippo Acconcia" userId="844af49c-a8a0-47ac-a7dd-14a44b60cd18" providerId="ADAL" clId="{B609A75A-164F-4066-A006-F59E853DC491}" dt="2022-03-24T10:11:10.883" v="1"/>
          <ac:picMkLst>
            <pc:docMk/>
            <pc:sldMk cId="3258456422" sldId="298"/>
            <ac:picMk id="52" creationId="{F07E92B8-70D9-4202-85F0-9518AA7099BB}"/>
          </ac:picMkLst>
        </pc:picChg>
        <pc:picChg chg="mod">
          <ac:chgData name="Filippo Acconcia" userId="844af49c-a8a0-47ac-a7dd-14a44b60cd18" providerId="ADAL" clId="{B609A75A-164F-4066-A006-F59E853DC491}" dt="2022-03-24T10:11:10.883" v="1"/>
          <ac:picMkLst>
            <pc:docMk/>
            <pc:sldMk cId="3258456422" sldId="298"/>
            <ac:picMk id="70" creationId="{723B69FB-1009-4B70-A7DB-8AA28EBD95D6}"/>
          </ac:picMkLst>
        </pc:picChg>
        <pc:picChg chg="mod">
          <ac:chgData name="Filippo Acconcia" userId="844af49c-a8a0-47ac-a7dd-14a44b60cd18" providerId="ADAL" clId="{B609A75A-164F-4066-A006-F59E853DC491}" dt="2022-03-24T10:11:10.883" v="1"/>
          <ac:picMkLst>
            <pc:docMk/>
            <pc:sldMk cId="3258456422" sldId="298"/>
            <ac:picMk id="86" creationId="{6AD2C442-397D-4947-B81B-7BF98F5613C0}"/>
          </ac:picMkLst>
        </pc:picChg>
        <pc:picChg chg="mod">
          <ac:chgData name="Filippo Acconcia" userId="844af49c-a8a0-47ac-a7dd-14a44b60cd18" providerId="ADAL" clId="{B609A75A-164F-4066-A006-F59E853DC491}" dt="2022-03-24T10:11:10.883" v="1"/>
          <ac:picMkLst>
            <pc:docMk/>
            <pc:sldMk cId="3258456422" sldId="298"/>
            <ac:picMk id="103" creationId="{AFEB5A45-A477-4FF7-95CD-85B1E6D504C7}"/>
          </ac:picMkLst>
        </pc:picChg>
        <pc:picChg chg="mod">
          <ac:chgData name="Filippo Acconcia" userId="844af49c-a8a0-47ac-a7dd-14a44b60cd18" providerId="ADAL" clId="{B609A75A-164F-4066-A006-F59E853DC491}" dt="2022-03-24T10:11:10.883" v="1"/>
          <ac:picMkLst>
            <pc:docMk/>
            <pc:sldMk cId="3258456422" sldId="298"/>
            <ac:picMk id="131" creationId="{8D5B6452-EA41-4B63-A01A-C87659B099CE}"/>
          </ac:picMkLst>
        </pc:picChg>
        <pc:picChg chg="mod">
          <ac:chgData name="Filippo Acconcia" userId="844af49c-a8a0-47ac-a7dd-14a44b60cd18" providerId="ADAL" clId="{B609A75A-164F-4066-A006-F59E853DC491}" dt="2022-03-24T10:12:36.401" v="3"/>
          <ac:picMkLst>
            <pc:docMk/>
            <pc:sldMk cId="3258456422" sldId="298"/>
            <ac:picMk id="166" creationId="{E9D5BBC6-4AFC-4AC1-858B-0BB68BF84C0C}"/>
          </ac:picMkLst>
        </pc:picChg>
        <pc:picChg chg="mod">
          <ac:chgData name="Filippo Acconcia" userId="844af49c-a8a0-47ac-a7dd-14a44b60cd18" providerId="ADAL" clId="{B609A75A-164F-4066-A006-F59E853DC491}" dt="2022-03-24T10:12:36.401" v="3"/>
          <ac:picMkLst>
            <pc:docMk/>
            <pc:sldMk cId="3258456422" sldId="298"/>
            <ac:picMk id="174" creationId="{C21E8F30-5804-4386-A860-3109F297BBA7}"/>
          </ac:picMkLst>
        </pc:picChg>
        <pc:picChg chg="mod">
          <ac:chgData name="Filippo Acconcia" userId="844af49c-a8a0-47ac-a7dd-14a44b60cd18" providerId="ADAL" clId="{B609A75A-164F-4066-A006-F59E853DC491}" dt="2022-03-24T10:12:36.401" v="3"/>
          <ac:picMkLst>
            <pc:docMk/>
            <pc:sldMk cId="3258456422" sldId="298"/>
            <ac:picMk id="175" creationId="{7D791C7B-08C0-4CAE-8CAC-2ABABEDC9621}"/>
          </ac:picMkLst>
        </pc:picChg>
        <pc:picChg chg="mod">
          <ac:chgData name="Filippo Acconcia" userId="844af49c-a8a0-47ac-a7dd-14a44b60cd18" providerId="ADAL" clId="{B609A75A-164F-4066-A006-F59E853DC491}" dt="2022-03-24T10:12:36.401" v="3"/>
          <ac:picMkLst>
            <pc:docMk/>
            <pc:sldMk cId="3258456422" sldId="298"/>
            <ac:picMk id="179" creationId="{A13EA2F8-80C9-426A-8079-547D33F9AB10}"/>
          </ac:picMkLst>
        </pc:picChg>
        <pc:cxnChg chg="mod">
          <ac:chgData name="Filippo Acconcia" userId="844af49c-a8a0-47ac-a7dd-14a44b60cd18" providerId="ADAL" clId="{B609A75A-164F-4066-A006-F59E853DC491}" dt="2022-03-24T10:11:10.883" v="1"/>
          <ac:cxnSpMkLst>
            <pc:docMk/>
            <pc:sldMk cId="3258456422" sldId="298"/>
            <ac:cxnSpMk id="16" creationId="{171972B2-C321-4346-9233-00CDF39F6081}"/>
          </ac:cxnSpMkLst>
        </pc:cxnChg>
        <pc:cxnChg chg="mod">
          <ac:chgData name="Filippo Acconcia" userId="844af49c-a8a0-47ac-a7dd-14a44b60cd18" providerId="ADAL" clId="{B609A75A-164F-4066-A006-F59E853DC491}" dt="2022-03-24T10:11:10.883" v="1"/>
          <ac:cxnSpMkLst>
            <pc:docMk/>
            <pc:sldMk cId="3258456422" sldId="298"/>
            <ac:cxnSpMk id="31" creationId="{5E650F7D-5E46-4357-9B63-12843CC90025}"/>
          </ac:cxnSpMkLst>
        </pc:cxnChg>
        <pc:cxnChg chg="mod">
          <ac:chgData name="Filippo Acconcia" userId="844af49c-a8a0-47ac-a7dd-14a44b60cd18" providerId="ADAL" clId="{B609A75A-164F-4066-A006-F59E853DC491}" dt="2022-03-24T10:11:10.883" v="1"/>
          <ac:cxnSpMkLst>
            <pc:docMk/>
            <pc:sldMk cId="3258456422" sldId="298"/>
            <ac:cxnSpMk id="46" creationId="{17C04035-54AA-4DD0-80B2-4E5FEE36298A}"/>
          </ac:cxnSpMkLst>
        </pc:cxnChg>
        <pc:cxnChg chg="mod">
          <ac:chgData name="Filippo Acconcia" userId="844af49c-a8a0-47ac-a7dd-14a44b60cd18" providerId="ADAL" clId="{B609A75A-164F-4066-A006-F59E853DC491}" dt="2022-04-01T08:44:48.642" v="1154"/>
          <ac:cxnSpMkLst>
            <pc:docMk/>
            <pc:sldMk cId="3258456422" sldId="298"/>
            <ac:cxnSpMk id="61" creationId="{657FF6B5-3B6D-4855-9F0A-E0AC2D6A7298}"/>
          </ac:cxnSpMkLst>
        </pc:cxnChg>
        <pc:cxnChg chg="mod">
          <ac:chgData name="Filippo Acconcia" userId="844af49c-a8a0-47ac-a7dd-14a44b60cd18" providerId="ADAL" clId="{B609A75A-164F-4066-A006-F59E853DC491}" dt="2022-04-01T08:44:48.642" v="1154"/>
          <ac:cxnSpMkLst>
            <pc:docMk/>
            <pc:sldMk cId="3258456422" sldId="298"/>
            <ac:cxnSpMk id="62" creationId="{BA3C43F4-7614-4B1E-8165-58D0D0DCBFDD}"/>
          </ac:cxnSpMkLst>
        </pc:cxnChg>
        <pc:cxnChg chg="mod">
          <ac:chgData name="Filippo Acconcia" userId="844af49c-a8a0-47ac-a7dd-14a44b60cd18" providerId="ADAL" clId="{B609A75A-164F-4066-A006-F59E853DC491}" dt="2022-04-01T08:44:48.642" v="1154"/>
          <ac:cxnSpMkLst>
            <pc:docMk/>
            <pc:sldMk cId="3258456422" sldId="298"/>
            <ac:cxnSpMk id="63" creationId="{3CAE30B1-F2A4-4CB3-A2A6-D392AA9C416F}"/>
          </ac:cxnSpMkLst>
        </pc:cxnChg>
        <pc:cxnChg chg="mod">
          <ac:chgData name="Filippo Acconcia" userId="844af49c-a8a0-47ac-a7dd-14a44b60cd18" providerId="ADAL" clId="{B609A75A-164F-4066-A006-F59E853DC491}" dt="2022-04-01T08:44:48.642" v="1154"/>
          <ac:cxnSpMkLst>
            <pc:docMk/>
            <pc:sldMk cId="3258456422" sldId="298"/>
            <ac:cxnSpMk id="64" creationId="{573E707F-0972-4E25-BEB1-0B70D7A7686D}"/>
          </ac:cxnSpMkLst>
        </pc:cxnChg>
        <pc:cxnChg chg="mod">
          <ac:chgData name="Filippo Acconcia" userId="844af49c-a8a0-47ac-a7dd-14a44b60cd18" providerId="ADAL" clId="{B609A75A-164F-4066-A006-F59E853DC491}" dt="2022-03-24T10:11:10.883" v="1"/>
          <ac:cxnSpMkLst>
            <pc:docMk/>
            <pc:sldMk cId="3258456422" sldId="298"/>
            <ac:cxnSpMk id="65" creationId="{62CAFC7B-BAE7-4BEC-8695-71C348F275F6}"/>
          </ac:cxnSpMkLst>
        </pc:cxnChg>
        <pc:cxnChg chg="mod">
          <ac:chgData name="Filippo Acconcia" userId="844af49c-a8a0-47ac-a7dd-14a44b60cd18" providerId="ADAL" clId="{B609A75A-164F-4066-A006-F59E853DC491}" dt="2022-03-24T10:11:10.883" v="1"/>
          <ac:cxnSpMkLst>
            <pc:docMk/>
            <pc:sldMk cId="3258456422" sldId="298"/>
            <ac:cxnSpMk id="83" creationId="{A806A892-6D1B-473B-B3AB-28930D24A3AD}"/>
          </ac:cxnSpMkLst>
        </pc:cxnChg>
        <pc:cxnChg chg="mod">
          <ac:chgData name="Filippo Acconcia" userId="844af49c-a8a0-47ac-a7dd-14a44b60cd18" providerId="ADAL" clId="{B609A75A-164F-4066-A006-F59E853DC491}" dt="2022-03-24T10:11:10.883" v="1"/>
          <ac:cxnSpMkLst>
            <pc:docMk/>
            <pc:sldMk cId="3258456422" sldId="298"/>
            <ac:cxnSpMk id="99" creationId="{7E2F3CDC-889B-4B96-AD91-23051C7AC43E}"/>
          </ac:cxnSpMkLst>
        </pc:cxnChg>
        <pc:cxnChg chg="mod">
          <ac:chgData name="Filippo Acconcia" userId="844af49c-a8a0-47ac-a7dd-14a44b60cd18" providerId="ADAL" clId="{B609A75A-164F-4066-A006-F59E853DC491}" dt="2022-03-24T10:11:10.883" v="1"/>
          <ac:cxnSpMkLst>
            <pc:docMk/>
            <pc:sldMk cId="3258456422" sldId="298"/>
            <ac:cxnSpMk id="128" creationId="{96AA0E42-5067-48C5-8CC8-8757AE836C5A}"/>
          </ac:cxnSpMkLst>
        </pc:cxnChg>
        <pc:cxnChg chg="mod">
          <ac:chgData name="Filippo Acconcia" userId="844af49c-a8a0-47ac-a7dd-14a44b60cd18" providerId="ADAL" clId="{B609A75A-164F-4066-A006-F59E853DC491}" dt="2022-03-24T10:11:10.883" v="1"/>
          <ac:cxnSpMkLst>
            <pc:docMk/>
            <pc:sldMk cId="3258456422" sldId="298"/>
            <ac:cxnSpMk id="153" creationId="{AA38CC87-073A-4339-8A9E-D2D1A29CA3F0}"/>
          </ac:cxnSpMkLst>
        </pc:cxnChg>
        <pc:cxnChg chg="mod">
          <ac:chgData name="Filippo Acconcia" userId="844af49c-a8a0-47ac-a7dd-14a44b60cd18" providerId="ADAL" clId="{B609A75A-164F-4066-A006-F59E853DC491}" dt="2022-03-24T10:12:36.401" v="3"/>
          <ac:cxnSpMkLst>
            <pc:docMk/>
            <pc:sldMk cId="3258456422" sldId="298"/>
            <ac:cxnSpMk id="198" creationId="{C7568373-C7AF-4D7C-8927-DC90F76EFE16}"/>
          </ac:cxnSpMkLst>
        </pc:cxnChg>
        <pc:cxnChg chg="mod">
          <ac:chgData name="Filippo Acconcia" userId="844af49c-a8a0-47ac-a7dd-14a44b60cd18" providerId="ADAL" clId="{B609A75A-164F-4066-A006-F59E853DC491}" dt="2022-03-24T10:12:36.401" v="3"/>
          <ac:cxnSpMkLst>
            <pc:docMk/>
            <pc:sldMk cId="3258456422" sldId="298"/>
            <ac:cxnSpMk id="199" creationId="{E65CA244-A020-4F89-9A38-C8462FE3E2A3}"/>
          </ac:cxnSpMkLst>
        </pc:cxnChg>
        <pc:cxnChg chg="mod">
          <ac:chgData name="Filippo Acconcia" userId="844af49c-a8a0-47ac-a7dd-14a44b60cd18" providerId="ADAL" clId="{B609A75A-164F-4066-A006-F59E853DC491}" dt="2022-03-24T10:12:36.401" v="3"/>
          <ac:cxnSpMkLst>
            <pc:docMk/>
            <pc:sldMk cId="3258456422" sldId="298"/>
            <ac:cxnSpMk id="200" creationId="{1D054170-1036-4EA3-A662-46F0A9BEE234}"/>
          </ac:cxnSpMkLst>
        </pc:cxnChg>
        <pc:cxnChg chg="mod">
          <ac:chgData name="Filippo Acconcia" userId="844af49c-a8a0-47ac-a7dd-14a44b60cd18" providerId="ADAL" clId="{B609A75A-164F-4066-A006-F59E853DC491}" dt="2022-03-24T10:12:36.401" v="3"/>
          <ac:cxnSpMkLst>
            <pc:docMk/>
            <pc:sldMk cId="3258456422" sldId="298"/>
            <ac:cxnSpMk id="201" creationId="{3F8562DA-C7D5-4641-9FF1-169C08CBA121}"/>
          </ac:cxnSpMkLst>
        </pc:cxnChg>
      </pc:sldChg>
      <pc:sldChg chg="addSp modSp new mod ord">
        <pc:chgData name="Filippo Acconcia" userId="844af49c-a8a0-47ac-a7dd-14a44b60cd18" providerId="ADAL" clId="{B609A75A-164F-4066-A006-F59E853DC491}" dt="2022-03-28T06:50:55.180" v="88" actId="1037"/>
        <pc:sldMkLst>
          <pc:docMk/>
          <pc:sldMk cId="524157325" sldId="299"/>
        </pc:sldMkLst>
        <pc:spChg chg="add mod">
          <ac:chgData name="Filippo Acconcia" userId="844af49c-a8a0-47ac-a7dd-14a44b60cd18" providerId="ADAL" clId="{B609A75A-164F-4066-A006-F59E853DC491}" dt="2022-03-28T06:49:58.464" v="67" actId="555"/>
          <ac:spMkLst>
            <pc:docMk/>
            <pc:sldMk cId="524157325" sldId="299"/>
            <ac:spMk id="2" creationId="{316B9158-C0B5-4D78-858A-559D6B1DD6D0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5" creationId="{BBE25AD8-0940-4C48-BD28-9967A9B3C153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6" creationId="{7BD22699-3588-4716-B2D8-20E1EE66FAD0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7" creationId="{60F86EA1-2917-41A8-BD87-DB2960C8C162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8" creationId="{B594362E-B2BA-42E2-9AA3-9D9500F01814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9" creationId="{AA62B163-8FDD-468B-841B-253A8BC01CC6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10" creationId="{D4AEB573-52C9-4553-A6D9-1C5434F9CDBA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11" creationId="{FF03AD65-36E2-48FF-B567-950A267A7C01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12" creationId="{80039316-475F-430A-86AB-A2F385538157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13" creationId="{DEEC4D61-953D-40EC-9BBB-F96184B90E1F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14" creationId="{1D6FECB3-3B7A-43D7-9D7E-9537B592122D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15" creationId="{31503378-4E51-4C5A-80FF-DB545A1ACCA0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17" creationId="{C555BC9E-AF04-419E-8506-9946BA0DD2AC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21" creationId="{22B3C32F-2C85-4CEA-9526-C5B461F21C2F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22" creationId="{D838B54C-669B-4BE4-A92E-C59C496D3B4B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23" creationId="{950DA0E4-6A14-43FE-BCEA-87237798679A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24" creationId="{80986F7D-8B0C-444A-B1C3-B0E15FB0255E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25" creationId="{70F0A0FE-AE03-4E35-8E65-6B027F94E6FD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26" creationId="{A201F472-2EF1-4959-8863-728A4D769170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27" creationId="{DE77C392-BD96-4112-A53D-5A0D08584F54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28" creationId="{EA86B704-AE27-4FDB-9F10-6413D3B58B36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29" creationId="{C3407409-C9A3-451E-89E5-62A6F9280502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30" creationId="{D6C2FCC5-7E98-43CD-93D6-B8A25F0528BC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31" creationId="{340D8019-EF4C-49AA-B83F-DD0BDFFCCFA7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32" creationId="{93683D5D-0799-451D-A1CC-E493D4445440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33" creationId="{763227BC-CFB0-4279-8981-7160D95E1F8A}"/>
          </ac:spMkLst>
        </pc:spChg>
        <pc:spChg chg="mod">
          <ac:chgData name="Filippo Acconcia" userId="844af49c-a8a0-47ac-a7dd-14a44b60cd18" providerId="ADAL" clId="{B609A75A-164F-4066-A006-F59E853DC491}" dt="2022-03-25T07:37:29.685" v="9"/>
          <ac:spMkLst>
            <pc:docMk/>
            <pc:sldMk cId="524157325" sldId="299"/>
            <ac:spMk id="34" creationId="{22DF411A-2628-457C-A249-AF5F05891A25}"/>
          </ac:spMkLst>
        </pc:spChg>
        <pc:spChg chg="add mod">
          <ac:chgData name="Filippo Acconcia" userId="844af49c-a8a0-47ac-a7dd-14a44b60cd18" providerId="ADAL" clId="{B609A75A-164F-4066-A006-F59E853DC491}" dt="2022-03-28T06:49:53.953" v="66" actId="554"/>
          <ac:spMkLst>
            <pc:docMk/>
            <pc:sldMk cId="524157325" sldId="299"/>
            <ac:spMk id="35" creationId="{A4D471B4-2058-4662-9FBD-0FC35F688A73}"/>
          </ac:spMkLst>
        </pc:spChg>
        <pc:spChg chg="add mod">
          <ac:chgData name="Filippo Acconcia" userId="844af49c-a8a0-47ac-a7dd-14a44b60cd18" providerId="ADAL" clId="{B609A75A-164F-4066-A006-F59E853DC491}" dt="2022-03-28T06:46:39.063" v="43" actId="113"/>
          <ac:spMkLst>
            <pc:docMk/>
            <pc:sldMk cId="524157325" sldId="299"/>
            <ac:spMk id="55" creationId="{D8DDC295-74A1-4C27-8E81-5AA8830EDD83}"/>
          </ac:spMkLst>
        </pc:spChg>
        <pc:spChg chg="add mod">
          <ac:chgData name="Filippo Acconcia" userId="844af49c-a8a0-47ac-a7dd-14a44b60cd18" providerId="ADAL" clId="{B609A75A-164F-4066-A006-F59E853DC491}" dt="2022-03-28T06:49:58.464" v="67" actId="555"/>
          <ac:spMkLst>
            <pc:docMk/>
            <pc:sldMk cId="524157325" sldId="299"/>
            <ac:spMk id="56" creationId="{092CE28C-53C5-4E91-A620-FF06A0271AB8}"/>
          </ac:spMkLst>
        </pc:spChg>
        <pc:spChg chg="add mod">
          <ac:chgData name="Filippo Acconcia" userId="844af49c-a8a0-47ac-a7dd-14a44b60cd18" providerId="ADAL" clId="{B609A75A-164F-4066-A006-F59E853DC491}" dt="2022-03-28T06:49:53.953" v="66" actId="554"/>
          <ac:spMkLst>
            <pc:docMk/>
            <pc:sldMk cId="524157325" sldId="299"/>
            <ac:spMk id="57" creationId="{3697E222-4C5E-4402-9823-90BBBF27B729}"/>
          </ac:spMkLst>
        </pc:spChg>
        <pc:grpChg chg="add mod">
          <ac:chgData name="Filippo Acconcia" userId="844af49c-a8a0-47ac-a7dd-14a44b60cd18" providerId="ADAL" clId="{B609A75A-164F-4066-A006-F59E853DC491}" dt="2022-03-28T06:50:49.598" v="81" actId="12788"/>
          <ac:grpSpMkLst>
            <pc:docMk/>
            <pc:sldMk cId="524157325" sldId="299"/>
            <ac:grpSpMk id="3" creationId="{1BC9F02F-47C1-4382-B721-B7E945A7A312}"/>
          </ac:grpSpMkLst>
        </pc:grpChg>
        <pc:grpChg chg="add mod">
          <ac:chgData name="Filippo Acconcia" userId="844af49c-a8a0-47ac-a7dd-14a44b60cd18" providerId="ADAL" clId="{B609A75A-164F-4066-A006-F59E853DC491}" dt="2022-03-28T06:50:45.388" v="80" actId="12789"/>
          <ac:grpSpMkLst>
            <pc:docMk/>
            <pc:sldMk cId="524157325" sldId="299"/>
            <ac:grpSpMk id="18" creationId="{E7866D84-354A-4C45-B4F5-52C96357C86D}"/>
          </ac:grpSpMkLst>
        </pc:grpChg>
        <pc:grpChg chg="mod">
          <ac:chgData name="Filippo Acconcia" userId="844af49c-a8a0-47ac-a7dd-14a44b60cd18" providerId="ADAL" clId="{B609A75A-164F-4066-A006-F59E853DC491}" dt="2022-03-28T06:50:55.180" v="88" actId="1037"/>
          <ac:grpSpMkLst>
            <pc:docMk/>
            <pc:sldMk cId="524157325" sldId="299"/>
            <ac:grpSpMk id="36" creationId="{BC3B646A-50BD-4DD6-94F0-DD2AFFC472BB}"/>
          </ac:grpSpMkLst>
        </pc:grpChg>
        <pc:grpChg chg="mod">
          <ac:chgData name="Filippo Acconcia" userId="844af49c-a8a0-47ac-a7dd-14a44b60cd18" providerId="ADAL" clId="{B609A75A-164F-4066-A006-F59E853DC491}" dt="2022-03-28T06:50:39.543" v="78" actId="12789"/>
          <ac:grpSpMkLst>
            <pc:docMk/>
            <pc:sldMk cId="524157325" sldId="299"/>
            <ac:grpSpMk id="47" creationId="{2567293A-8F1E-4B22-8975-7CCF895B1837}"/>
          </ac:grpSpMkLst>
        </pc:grpChg>
        <pc:picChg chg="mod">
          <ac:chgData name="Filippo Acconcia" userId="844af49c-a8a0-47ac-a7dd-14a44b60cd18" providerId="ADAL" clId="{B609A75A-164F-4066-A006-F59E853DC491}" dt="2022-03-25T07:37:29.685" v="9"/>
          <ac:picMkLst>
            <pc:docMk/>
            <pc:sldMk cId="524157325" sldId="299"/>
            <ac:picMk id="4" creationId="{6FA4DF06-5507-4DAA-B9C0-6278FD7E5975}"/>
          </ac:picMkLst>
        </pc:picChg>
        <pc:picChg chg="mod">
          <ac:chgData name="Filippo Acconcia" userId="844af49c-a8a0-47ac-a7dd-14a44b60cd18" providerId="ADAL" clId="{B609A75A-164F-4066-A006-F59E853DC491}" dt="2022-03-25T07:37:29.685" v="9"/>
          <ac:picMkLst>
            <pc:docMk/>
            <pc:sldMk cId="524157325" sldId="299"/>
            <ac:picMk id="16" creationId="{535311CC-FE43-4416-B172-352BDDD39756}"/>
          </ac:picMkLst>
        </pc:picChg>
        <pc:picChg chg="mod">
          <ac:chgData name="Filippo Acconcia" userId="844af49c-a8a0-47ac-a7dd-14a44b60cd18" providerId="ADAL" clId="{B609A75A-164F-4066-A006-F59E853DC491}" dt="2022-03-25T07:37:29.685" v="9"/>
          <ac:picMkLst>
            <pc:docMk/>
            <pc:sldMk cId="524157325" sldId="299"/>
            <ac:picMk id="19" creationId="{7666B514-9B29-43B6-ADCF-756BBB286374}"/>
          </ac:picMkLst>
        </pc:picChg>
        <pc:picChg chg="mod">
          <ac:chgData name="Filippo Acconcia" userId="844af49c-a8a0-47ac-a7dd-14a44b60cd18" providerId="ADAL" clId="{B609A75A-164F-4066-A006-F59E853DC491}" dt="2022-03-25T07:37:29.685" v="9"/>
          <ac:picMkLst>
            <pc:docMk/>
            <pc:sldMk cId="524157325" sldId="299"/>
            <ac:picMk id="20" creationId="{56173108-F7C5-4FC7-A157-95A91F0865D8}"/>
          </ac:picMkLst>
        </pc:picChg>
      </pc:sldChg>
      <pc:sldChg chg="addSp delSp modSp mod ord">
        <pc:chgData name="Filippo Acconcia" userId="844af49c-a8a0-47ac-a7dd-14a44b60cd18" providerId="ADAL" clId="{B609A75A-164F-4066-A006-F59E853DC491}" dt="2022-03-30T08:37:09.102" v="461" actId="20577"/>
        <pc:sldMkLst>
          <pc:docMk/>
          <pc:sldMk cId="565039354" sldId="300"/>
        </pc:sldMkLst>
        <pc:spChg chg="mod">
          <ac:chgData name="Filippo Acconcia" userId="844af49c-a8a0-47ac-a7dd-14a44b60cd18" providerId="ADAL" clId="{B609A75A-164F-4066-A006-F59E853DC491}" dt="2022-03-28T07:42:28.455" v="313" actId="20577"/>
          <ac:spMkLst>
            <pc:docMk/>
            <pc:sldMk cId="565039354" sldId="300"/>
            <ac:spMk id="16" creationId="{2C412CC6-2FE3-4BC5-8A8C-6704728B72B4}"/>
          </ac:spMkLst>
        </pc:spChg>
        <pc:spChg chg="mod">
          <ac:chgData name="Filippo Acconcia" userId="844af49c-a8a0-47ac-a7dd-14a44b60cd18" providerId="ADAL" clId="{B609A75A-164F-4066-A006-F59E853DC491}" dt="2022-03-28T07:42:35.591" v="315" actId="20577"/>
          <ac:spMkLst>
            <pc:docMk/>
            <pc:sldMk cId="565039354" sldId="300"/>
            <ac:spMk id="17" creationId="{CB462BA4-0EAA-4B2B-8756-32B78EB0FB49}"/>
          </ac:spMkLst>
        </pc:spChg>
        <pc:spChg chg="mod">
          <ac:chgData name="Filippo Acconcia" userId="844af49c-a8a0-47ac-a7dd-14a44b60cd18" providerId="ADAL" clId="{B609A75A-164F-4066-A006-F59E853DC491}" dt="2022-03-28T07:42:33.207" v="314" actId="20577"/>
          <ac:spMkLst>
            <pc:docMk/>
            <pc:sldMk cId="565039354" sldId="300"/>
            <ac:spMk id="18" creationId="{9D9F9DC0-025B-4422-B22F-4ED437B44102}"/>
          </ac:spMkLst>
        </pc:spChg>
        <pc:spChg chg="add mod">
          <ac:chgData name="Filippo Acconcia" userId="844af49c-a8a0-47ac-a7dd-14a44b60cd18" providerId="ADAL" clId="{B609A75A-164F-4066-A006-F59E853DC491}" dt="2022-03-30T08:37:09.102" v="461" actId="20577"/>
          <ac:spMkLst>
            <pc:docMk/>
            <pc:sldMk cId="565039354" sldId="300"/>
            <ac:spMk id="123" creationId="{20F2705A-58C2-4916-AE8A-68383FF35F42}"/>
          </ac:spMkLst>
        </pc:spChg>
        <pc:spChg chg="mod">
          <ac:chgData name="Filippo Acconcia" userId="844af49c-a8a0-47ac-a7dd-14a44b60cd18" providerId="ADAL" clId="{B609A75A-164F-4066-A006-F59E853DC491}" dt="2022-03-28T07:43:29.270" v="316"/>
          <ac:spMkLst>
            <pc:docMk/>
            <pc:sldMk cId="565039354" sldId="300"/>
            <ac:spMk id="128" creationId="{7B42B44F-35F8-49AA-8672-774B7E3B86E6}"/>
          </ac:spMkLst>
        </pc:spChg>
        <pc:spChg chg="mod">
          <ac:chgData name="Filippo Acconcia" userId="844af49c-a8a0-47ac-a7dd-14a44b60cd18" providerId="ADAL" clId="{B609A75A-164F-4066-A006-F59E853DC491}" dt="2022-03-28T07:43:29.270" v="316"/>
          <ac:spMkLst>
            <pc:docMk/>
            <pc:sldMk cId="565039354" sldId="300"/>
            <ac:spMk id="129" creationId="{4D9558F2-0581-47F2-8887-A64FB8ED5B8B}"/>
          </ac:spMkLst>
        </pc:spChg>
        <pc:spChg chg="mod">
          <ac:chgData name="Filippo Acconcia" userId="844af49c-a8a0-47ac-a7dd-14a44b60cd18" providerId="ADAL" clId="{B609A75A-164F-4066-A006-F59E853DC491}" dt="2022-03-28T07:43:29.270" v="316"/>
          <ac:spMkLst>
            <pc:docMk/>
            <pc:sldMk cId="565039354" sldId="300"/>
            <ac:spMk id="130" creationId="{8AAFF4C4-5F90-4BAE-875D-213231859D03}"/>
          </ac:spMkLst>
        </pc:spChg>
        <pc:spChg chg="mod">
          <ac:chgData name="Filippo Acconcia" userId="844af49c-a8a0-47ac-a7dd-14a44b60cd18" providerId="ADAL" clId="{B609A75A-164F-4066-A006-F59E853DC491}" dt="2022-03-28T07:43:29.270" v="316"/>
          <ac:spMkLst>
            <pc:docMk/>
            <pc:sldMk cId="565039354" sldId="300"/>
            <ac:spMk id="131" creationId="{4A9FC0F5-4B76-443E-9F36-04D41C515577}"/>
          </ac:spMkLst>
        </pc:spChg>
        <pc:spChg chg="mod">
          <ac:chgData name="Filippo Acconcia" userId="844af49c-a8a0-47ac-a7dd-14a44b60cd18" providerId="ADAL" clId="{B609A75A-164F-4066-A006-F59E853DC491}" dt="2022-03-28T07:43:29.270" v="316"/>
          <ac:spMkLst>
            <pc:docMk/>
            <pc:sldMk cId="565039354" sldId="300"/>
            <ac:spMk id="132" creationId="{546B010A-4D7F-4732-81C6-319CD8294AA8}"/>
          </ac:spMkLst>
        </pc:spChg>
        <pc:spChg chg="mod">
          <ac:chgData name="Filippo Acconcia" userId="844af49c-a8a0-47ac-a7dd-14a44b60cd18" providerId="ADAL" clId="{B609A75A-164F-4066-A006-F59E853DC491}" dt="2022-03-28T07:43:29.270" v="316"/>
          <ac:spMkLst>
            <pc:docMk/>
            <pc:sldMk cId="565039354" sldId="300"/>
            <ac:spMk id="133" creationId="{4DED70C8-9748-40D7-913A-3D9B4E8D2BB2}"/>
          </ac:spMkLst>
        </pc:spChg>
        <pc:spChg chg="mod">
          <ac:chgData name="Filippo Acconcia" userId="844af49c-a8a0-47ac-a7dd-14a44b60cd18" providerId="ADAL" clId="{B609A75A-164F-4066-A006-F59E853DC491}" dt="2022-03-28T07:43:29.270" v="316"/>
          <ac:spMkLst>
            <pc:docMk/>
            <pc:sldMk cId="565039354" sldId="300"/>
            <ac:spMk id="134" creationId="{FA57130B-D52E-47EF-81F6-803D8EC54FE3}"/>
          </ac:spMkLst>
        </pc:spChg>
        <pc:spChg chg="mod">
          <ac:chgData name="Filippo Acconcia" userId="844af49c-a8a0-47ac-a7dd-14a44b60cd18" providerId="ADAL" clId="{B609A75A-164F-4066-A006-F59E853DC491}" dt="2022-03-28T07:43:29.270" v="316"/>
          <ac:spMkLst>
            <pc:docMk/>
            <pc:sldMk cId="565039354" sldId="300"/>
            <ac:spMk id="135" creationId="{695E53BF-FA78-4227-A2C8-C530D05F398E}"/>
          </ac:spMkLst>
        </pc:spChg>
        <pc:spChg chg="mod">
          <ac:chgData name="Filippo Acconcia" userId="844af49c-a8a0-47ac-a7dd-14a44b60cd18" providerId="ADAL" clId="{B609A75A-164F-4066-A006-F59E853DC491}" dt="2022-03-28T07:43:29.270" v="316"/>
          <ac:spMkLst>
            <pc:docMk/>
            <pc:sldMk cId="565039354" sldId="300"/>
            <ac:spMk id="137" creationId="{4722FA98-444C-458A-B94A-26B0967FD365}"/>
          </ac:spMkLst>
        </pc:spChg>
        <pc:spChg chg="mod">
          <ac:chgData name="Filippo Acconcia" userId="844af49c-a8a0-47ac-a7dd-14a44b60cd18" providerId="ADAL" clId="{B609A75A-164F-4066-A006-F59E853DC491}" dt="2022-03-28T07:43:29.270" v="316"/>
          <ac:spMkLst>
            <pc:docMk/>
            <pc:sldMk cId="565039354" sldId="300"/>
            <ac:spMk id="141" creationId="{8724EB49-8701-4537-B4E1-D9057017879E}"/>
          </ac:spMkLst>
        </pc:spChg>
        <pc:spChg chg="mod">
          <ac:chgData name="Filippo Acconcia" userId="844af49c-a8a0-47ac-a7dd-14a44b60cd18" providerId="ADAL" clId="{B609A75A-164F-4066-A006-F59E853DC491}" dt="2022-03-28T07:43:29.270" v="316"/>
          <ac:spMkLst>
            <pc:docMk/>
            <pc:sldMk cId="565039354" sldId="300"/>
            <ac:spMk id="142" creationId="{1D746C50-3887-4740-B6EF-B7D898307A0A}"/>
          </ac:spMkLst>
        </pc:spChg>
        <pc:spChg chg="mod">
          <ac:chgData name="Filippo Acconcia" userId="844af49c-a8a0-47ac-a7dd-14a44b60cd18" providerId="ADAL" clId="{B609A75A-164F-4066-A006-F59E853DC491}" dt="2022-03-28T07:43:29.270" v="316"/>
          <ac:spMkLst>
            <pc:docMk/>
            <pc:sldMk cId="565039354" sldId="300"/>
            <ac:spMk id="143" creationId="{000B35FD-A12D-4627-9576-CC3102F00E3E}"/>
          </ac:spMkLst>
        </pc:spChg>
        <pc:spChg chg="mod">
          <ac:chgData name="Filippo Acconcia" userId="844af49c-a8a0-47ac-a7dd-14a44b60cd18" providerId="ADAL" clId="{B609A75A-164F-4066-A006-F59E853DC491}" dt="2022-03-28T07:43:29.270" v="316"/>
          <ac:spMkLst>
            <pc:docMk/>
            <pc:sldMk cId="565039354" sldId="300"/>
            <ac:spMk id="144" creationId="{9B683EA1-22C5-4A79-910F-243139CB3965}"/>
          </ac:spMkLst>
        </pc:spChg>
        <pc:spChg chg="mod">
          <ac:chgData name="Filippo Acconcia" userId="844af49c-a8a0-47ac-a7dd-14a44b60cd18" providerId="ADAL" clId="{B609A75A-164F-4066-A006-F59E853DC491}" dt="2022-03-28T07:43:29.270" v="316"/>
          <ac:spMkLst>
            <pc:docMk/>
            <pc:sldMk cId="565039354" sldId="300"/>
            <ac:spMk id="145" creationId="{F3789B0B-CAF2-427C-B778-16008D6C9DA1}"/>
          </ac:spMkLst>
        </pc:spChg>
        <pc:spChg chg="mod">
          <ac:chgData name="Filippo Acconcia" userId="844af49c-a8a0-47ac-a7dd-14a44b60cd18" providerId="ADAL" clId="{B609A75A-164F-4066-A006-F59E853DC491}" dt="2022-03-28T07:43:29.270" v="316"/>
          <ac:spMkLst>
            <pc:docMk/>
            <pc:sldMk cId="565039354" sldId="300"/>
            <ac:spMk id="146" creationId="{2891A683-9504-4C64-A35C-CC01E343FC52}"/>
          </ac:spMkLst>
        </pc:spChg>
        <pc:spChg chg="mod">
          <ac:chgData name="Filippo Acconcia" userId="844af49c-a8a0-47ac-a7dd-14a44b60cd18" providerId="ADAL" clId="{B609A75A-164F-4066-A006-F59E853DC491}" dt="2022-03-28T07:43:29.270" v="316"/>
          <ac:spMkLst>
            <pc:docMk/>
            <pc:sldMk cId="565039354" sldId="300"/>
            <ac:spMk id="147" creationId="{ECDCDA93-3A27-4FFD-92F4-980177B532C2}"/>
          </ac:spMkLst>
        </pc:spChg>
        <pc:spChg chg="mod">
          <ac:chgData name="Filippo Acconcia" userId="844af49c-a8a0-47ac-a7dd-14a44b60cd18" providerId="ADAL" clId="{B609A75A-164F-4066-A006-F59E853DC491}" dt="2022-03-28T07:43:29.270" v="316"/>
          <ac:spMkLst>
            <pc:docMk/>
            <pc:sldMk cId="565039354" sldId="300"/>
            <ac:spMk id="148" creationId="{8AE2FE57-C681-4E0E-9931-2266CB9929F5}"/>
          </ac:spMkLst>
        </pc:spChg>
        <pc:spChg chg="mod">
          <ac:chgData name="Filippo Acconcia" userId="844af49c-a8a0-47ac-a7dd-14a44b60cd18" providerId="ADAL" clId="{B609A75A-164F-4066-A006-F59E853DC491}" dt="2022-03-28T07:43:29.270" v="316"/>
          <ac:spMkLst>
            <pc:docMk/>
            <pc:sldMk cId="565039354" sldId="300"/>
            <ac:spMk id="150" creationId="{E4512A35-5F28-49C7-B16A-C2284879782C}"/>
          </ac:spMkLst>
        </pc:spChg>
        <pc:grpChg chg="add del mod">
          <ac:chgData name="Filippo Acconcia" userId="844af49c-a8a0-47ac-a7dd-14a44b60cd18" providerId="ADAL" clId="{B609A75A-164F-4066-A006-F59E853DC491}" dt="2022-03-28T07:43:56.324" v="321" actId="21"/>
          <ac:grpSpMkLst>
            <pc:docMk/>
            <pc:sldMk cId="565039354" sldId="300"/>
            <ac:grpSpMk id="124" creationId="{DF3BC6D3-9CED-4414-994B-83829E723160}"/>
          </ac:grpSpMkLst>
        </pc:grpChg>
        <pc:grpChg chg="add del mod">
          <ac:chgData name="Filippo Acconcia" userId="844af49c-a8a0-47ac-a7dd-14a44b60cd18" providerId="ADAL" clId="{B609A75A-164F-4066-A006-F59E853DC491}" dt="2022-03-28T07:43:56.324" v="321" actId="21"/>
          <ac:grpSpMkLst>
            <pc:docMk/>
            <pc:sldMk cId="565039354" sldId="300"/>
            <ac:grpSpMk id="138" creationId="{E01D29DB-D21B-49E5-AE2C-7A3255684F5B}"/>
          </ac:grpSpMkLst>
        </pc:grpChg>
        <pc:picChg chg="mod">
          <ac:chgData name="Filippo Acconcia" userId="844af49c-a8a0-47ac-a7dd-14a44b60cd18" providerId="ADAL" clId="{B609A75A-164F-4066-A006-F59E853DC491}" dt="2022-03-28T07:43:29.270" v="316"/>
          <ac:picMkLst>
            <pc:docMk/>
            <pc:sldMk cId="565039354" sldId="300"/>
            <ac:picMk id="125" creationId="{A375201D-7EAE-4522-961C-6716D56CEB30}"/>
          </ac:picMkLst>
        </pc:picChg>
        <pc:picChg chg="mod">
          <ac:chgData name="Filippo Acconcia" userId="844af49c-a8a0-47ac-a7dd-14a44b60cd18" providerId="ADAL" clId="{B609A75A-164F-4066-A006-F59E853DC491}" dt="2022-03-28T07:43:29.270" v="316"/>
          <ac:picMkLst>
            <pc:docMk/>
            <pc:sldMk cId="565039354" sldId="300"/>
            <ac:picMk id="126" creationId="{1B439856-D439-43C2-BA4A-EC0B0E36683F}"/>
          </ac:picMkLst>
        </pc:picChg>
        <pc:picChg chg="mod">
          <ac:chgData name="Filippo Acconcia" userId="844af49c-a8a0-47ac-a7dd-14a44b60cd18" providerId="ADAL" clId="{B609A75A-164F-4066-A006-F59E853DC491}" dt="2022-03-28T07:43:29.270" v="316"/>
          <ac:picMkLst>
            <pc:docMk/>
            <pc:sldMk cId="565039354" sldId="300"/>
            <ac:picMk id="139" creationId="{D53F24FF-7830-481A-9475-2124277FE9B3}"/>
          </ac:picMkLst>
        </pc:picChg>
        <pc:picChg chg="mod">
          <ac:chgData name="Filippo Acconcia" userId="844af49c-a8a0-47ac-a7dd-14a44b60cd18" providerId="ADAL" clId="{B609A75A-164F-4066-A006-F59E853DC491}" dt="2022-03-28T07:43:29.270" v="316"/>
          <ac:picMkLst>
            <pc:docMk/>
            <pc:sldMk cId="565039354" sldId="300"/>
            <ac:picMk id="151" creationId="{3200B714-5521-4C36-AA59-8155FFB71A26}"/>
          </ac:picMkLst>
        </pc:picChg>
        <pc:cxnChg chg="mod">
          <ac:chgData name="Filippo Acconcia" userId="844af49c-a8a0-47ac-a7dd-14a44b60cd18" providerId="ADAL" clId="{B609A75A-164F-4066-A006-F59E853DC491}" dt="2022-03-28T07:43:29.270" v="316"/>
          <ac:cxnSpMkLst>
            <pc:docMk/>
            <pc:sldMk cId="565039354" sldId="300"/>
            <ac:cxnSpMk id="127" creationId="{46965BCF-DFA7-4677-9192-F010158F2047}"/>
          </ac:cxnSpMkLst>
        </pc:cxnChg>
        <pc:cxnChg chg="mod">
          <ac:chgData name="Filippo Acconcia" userId="844af49c-a8a0-47ac-a7dd-14a44b60cd18" providerId="ADAL" clId="{B609A75A-164F-4066-A006-F59E853DC491}" dt="2022-03-28T07:43:29.270" v="316"/>
          <ac:cxnSpMkLst>
            <pc:docMk/>
            <pc:sldMk cId="565039354" sldId="300"/>
            <ac:cxnSpMk id="136" creationId="{6275CEEB-5761-4E1C-81BB-F74A7205F7FE}"/>
          </ac:cxnSpMkLst>
        </pc:cxnChg>
        <pc:cxnChg chg="mod">
          <ac:chgData name="Filippo Acconcia" userId="844af49c-a8a0-47ac-a7dd-14a44b60cd18" providerId="ADAL" clId="{B609A75A-164F-4066-A006-F59E853DC491}" dt="2022-03-28T07:43:29.270" v="316"/>
          <ac:cxnSpMkLst>
            <pc:docMk/>
            <pc:sldMk cId="565039354" sldId="300"/>
            <ac:cxnSpMk id="140" creationId="{C84F6C9E-FBE6-4161-8D11-CF14626EADA5}"/>
          </ac:cxnSpMkLst>
        </pc:cxnChg>
        <pc:cxnChg chg="mod">
          <ac:chgData name="Filippo Acconcia" userId="844af49c-a8a0-47ac-a7dd-14a44b60cd18" providerId="ADAL" clId="{B609A75A-164F-4066-A006-F59E853DC491}" dt="2022-03-28T07:43:29.270" v="316"/>
          <ac:cxnSpMkLst>
            <pc:docMk/>
            <pc:sldMk cId="565039354" sldId="300"/>
            <ac:cxnSpMk id="149" creationId="{DAA7B629-1E60-4BFB-90D5-41EC1A8D3087}"/>
          </ac:cxnSpMkLst>
        </pc:cxnChg>
      </pc:sldChg>
      <pc:sldChg chg="addSp delSp modSp new mod ord">
        <pc:chgData name="Filippo Acconcia" userId="844af49c-a8a0-47ac-a7dd-14a44b60cd18" providerId="ADAL" clId="{B609A75A-164F-4066-A006-F59E853DC491}" dt="2022-04-01T08:51:35.654" v="1215" actId="1037"/>
        <pc:sldMkLst>
          <pc:docMk/>
          <pc:sldMk cId="706034829" sldId="301"/>
        </pc:sldMkLst>
        <pc:spChg chg="add mod">
          <ac:chgData name="Filippo Acconcia" userId="844af49c-a8a0-47ac-a7dd-14a44b60cd18" providerId="ADAL" clId="{B609A75A-164F-4066-A006-F59E853DC491}" dt="2022-03-30T08:37:21.735" v="464" actId="20577"/>
          <ac:spMkLst>
            <pc:docMk/>
            <pc:sldMk cId="706034829" sldId="301"/>
            <ac:spMk id="2" creationId="{5D2DCA17-BCD4-4265-8C5B-67AE7563323A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5" creationId="{D0F5BE67-F058-4417-B2A0-D796F52B1947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6" creationId="{7BE973A5-F903-4E13-B25C-7EE0DE125026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7" creationId="{861ACE1C-4EB7-41FA-BBF6-A4A078ECDBB8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8" creationId="{722F123D-3BCD-4A6F-842F-ECCAB95A1004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9" creationId="{9F2E1290-5CDD-4137-A8CE-EAB6897A5FEB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10" creationId="{074C831F-A311-4744-8E6C-BC838BDCEF4C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11" creationId="{7F532F38-2756-4137-9730-88DBADDD4A85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12" creationId="{1273CE91-4364-467A-A116-1D681B9D0C58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13" creationId="{485DB67B-2608-4E46-B0C9-2EFE0A662F8D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14" creationId="{55C95365-7C43-4060-B7AC-C1B61A25ECDF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15" creationId="{B550BC76-5388-4A7F-8632-AFAD7CA45807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16" creationId="{C08D65E0-AD55-43C2-AB55-06C997A77042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17" creationId="{CD5C318B-237D-427D-B671-66BCA356C577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18" creationId="{3FF7CDB6-7382-4B11-A16B-EAA6ABA48CF4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19" creationId="{D34A6D5C-687A-478E-A5CB-59858EAC8DB7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20" creationId="{ED1589F5-B734-4E78-A142-B50573668342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21" creationId="{A152D915-B9A9-4037-9191-60DB098CECBC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22" creationId="{BF26A098-8823-4951-83ED-AFA02619A22F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23" creationId="{6D3E48E0-E537-4C4A-B17A-34259C2C3C77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24" creationId="{8F864111-37C1-4FBA-B381-D6FC413F6C96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25" creationId="{E7BFB162-FCF9-48C7-95E0-572ADF3E5E21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26" creationId="{81AC96C3-63B3-4EDF-9661-8FD2E23FCDC0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27" creationId="{44BEDCCE-3AD6-4FB2-8C69-E327F7D4C2C8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28" creationId="{019E7390-BB8A-4AA9-A7D9-EC90AA2B15F7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29" creationId="{D8A8FF2F-BB59-4BB1-A4A0-3990FB20F396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30" creationId="{9C97D93A-1AB3-40BB-9898-D873207E47F9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31" creationId="{1925A82C-125A-4A3C-A957-21F0E4949276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32" creationId="{2CBA95FE-DF50-4189-8212-281822046532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33" creationId="{21F2B267-8E91-4513-A983-F980ACA61DF3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34" creationId="{4C7063DA-9322-4775-AB07-F5F29FF96FC4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35" creationId="{1D75C5F9-00D5-43F6-8E87-25BA2BDB0805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36" creationId="{233513F2-47E5-4033-BC6F-483C9593922E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37" creationId="{71DDAB67-CC63-49A7-A6E9-919C6480E29D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38" creationId="{21A3E982-C58E-43C9-A868-1E22EEAACBC3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39" creationId="{A9E3640D-8575-4621-9E7B-B7F4C9C2D8E6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40" creationId="{4A70788A-9330-428F-B4CD-D283C535CFB1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41" creationId="{DE669E3B-3F69-451B-821E-49C9077BECB7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42" creationId="{FD68021A-F583-4E5C-A5BC-52298F3CAEE1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43" creationId="{67146584-4AF8-4921-8348-F40F9CDAFCD5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44" creationId="{9DC1BBD2-94CD-4D50-ACD4-83DC5BDA8221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45" creationId="{7C9B86B0-1FA4-4710-90DA-0FEE5E1DEE62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46" creationId="{37845BF1-FD3C-4FF4-8DDC-7A073CE57EA3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47" creationId="{E701DCCF-3C18-4CDF-850D-CE563041A2AE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48" creationId="{BB72BFFE-FC68-440A-BE65-8C7D1FDF5284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49" creationId="{85217451-C212-423C-AA9F-66F5F13FCF9F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50" creationId="{CFF49531-70DD-4A93-95BA-C41EF8357694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51" creationId="{A8A8284C-D584-4011-964C-8310945E0253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52" creationId="{0DFBD1BA-6898-4E44-9C67-B61007D13498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53" creationId="{39991908-4CCB-4A6A-A650-8FF210CB44E6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56" creationId="{C29B7816-42C2-4837-B036-AAC3036B395B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57" creationId="{40001126-F78D-49FA-BC76-E9CE2E5AC7A8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58" creationId="{579EEED4-32A1-4966-A07E-669F7E6236DE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59" creationId="{D96C1713-F0C7-42AA-8E5F-6AB3453F1CDA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60" creationId="{A5AD5C36-5B22-4CA9-9F44-D0D5FE0555FA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61" creationId="{045C341E-EA47-40D9-9A8A-6E5C662638B2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62" creationId="{45C328D3-4F1F-4CB6-BB5E-5BE10ED5DF1E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63" creationId="{DC3B5F3A-0A09-4A8C-B242-3C44DB5BD687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64" creationId="{B64DD1C6-1216-4927-B021-56C7A290784F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65" creationId="{F02E70A7-3F6C-494B-8128-DBF44BD664D8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66" creationId="{525756E0-77F8-437D-9457-0B561E5EF590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67" creationId="{57B67629-A844-4E32-B541-B8F0F979DC81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68" creationId="{512E3101-220A-498F-A70C-E3B54592F58C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69" creationId="{96DEA3B3-A19A-4F15-A2E1-DFF98B3C652B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70" creationId="{D8D37C49-4926-46B2-BD6D-496B76C752CD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71" creationId="{50DA8524-BEA1-4490-A79C-5C8342795A93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72" creationId="{AA29CC81-2F65-4FBD-B9F8-86BD7C5502AF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73" creationId="{36B1117E-652C-4211-A3CF-4123C7F9B78C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74" creationId="{949FC756-CD8E-4D53-B87B-D434BAE4AC97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75" creationId="{DC218E8B-1A97-4FB3-A500-05D4A9D7B628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76" creationId="{A6F37DCD-68EC-44DC-9B8F-B03423FAAEBE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77" creationId="{6A3AB4C5-C796-4D23-8DD2-B2B89038696A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78" creationId="{C4A9ECEE-72B7-4E0C-BCFD-80D2AEE58C1E}"/>
          </ac:spMkLst>
        </pc:spChg>
        <pc:spChg chg="mod">
          <ac:chgData name="Filippo Acconcia" userId="844af49c-a8a0-47ac-a7dd-14a44b60cd18" providerId="ADAL" clId="{B609A75A-164F-4066-A006-F59E853DC491}" dt="2022-03-28T07:31:37.822" v="210"/>
          <ac:spMkLst>
            <pc:docMk/>
            <pc:sldMk cId="706034829" sldId="301"/>
            <ac:spMk id="79" creationId="{FB0118B9-0EBD-426A-9DFF-E1152F688C7E}"/>
          </ac:spMkLst>
        </pc:spChg>
        <pc:spChg chg="mod topLvl">
          <ac:chgData name="Filippo Acconcia" userId="844af49c-a8a0-47ac-a7dd-14a44b60cd18" providerId="ADAL" clId="{B609A75A-164F-4066-A006-F59E853DC491}" dt="2022-04-01T06:42:31.228" v="747" actId="164"/>
          <ac:spMkLst>
            <pc:docMk/>
            <pc:sldMk cId="706034829" sldId="301"/>
            <ac:spMk id="82" creationId="{C93BF847-46AB-4F5C-9DC5-42EE4383F1D2}"/>
          </ac:spMkLst>
        </pc:spChg>
        <pc:spChg chg="mod topLvl">
          <ac:chgData name="Filippo Acconcia" userId="844af49c-a8a0-47ac-a7dd-14a44b60cd18" providerId="ADAL" clId="{B609A75A-164F-4066-A006-F59E853DC491}" dt="2022-04-01T06:42:31.228" v="747" actId="164"/>
          <ac:spMkLst>
            <pc:docMk/>
            <pc:sldMk cId="706034829" sldId="301"/>
            <ac:spMk id="83" creationId="{0A62966A-1B5C-4EC7-9EF8-3147EDC42836}"/>
          </ac:spMkLst>
        </pc:spChg>
        <pc:spChg chg="mod topLvl">
          <ac:chgData name="Filippo Acconcia" userId="844af49c-a8a0-47ac-a7dd-14a44b60cd18" providerId="ADAL" clId="{B609A75A-164F-4066-A006-F59E853DC491}" dt="2022-04-01T06:42:31.228" v="747" actId="164"/>
          <ac:spMkLst>
            <pc:docMk/>
            <pc:sldMk cId="706034829" sldId="301"/>
            <ac:spMk id="84" creationId="{89A1E95F-B136-4CF4-8525-C9EBD969FC76}"/>
          </ac:spMkLst>
        </pc:spChg>
        <pc:spChg chg="mod topLvl">
          <ac:chgData name="Filippo Acconcia" userId="844af49c-a8a0-47ac-a7dd-14a44b60cd18" providerId="ADAL" clId="{B609A75A-164F-4066-A006-F59E853DC491}" dt="2022-04-01T06:42:31.228" v="747" actId="164"/>
          <ac:spMkLst>
            <pc:docMk/>
            <pc:sldMk cId="706034829" sldId="301"/>
            <ac:spMk id="85" creationId="{416B7B04-C170-4EE5-B5FE-DDFD29A95FD4}"/>
          </ac:spMkLst>
        </pc:spChg>
        <pc:spChg chg="del mod topLvl">
          <ac:chgData name="Filippo Acconcia" userId="844af49c-a8a0-47ac-a7dd-14a44b60cd18" providerId="ADAL" clId="{B609A75A-164F-4066-A006-F59E853DC491}" dt="2022-04-01T06:36:53.917" v="557" actId="478"/>
          <ac:spMkLst>
            <pc:docMk/>
            <pc:sldMk cId="706034829" sldId="301"/>
            <ac:spMk id="86" creationId="{96E24FA1-2E61-445F-A16E-08B4FA6F4825}"/>
          </ac:spMkLst>
        </pc:spChg>
        <pc:spChg chg="mod topLvl">
          <ac:chgData name="Filippo Acconcia" userId="844af49c-a8a0-47ac-a7dd-14a44b60cd18" providerId="ADAL" clId="{B609A75A-164F-4066-A006-F59E853DC491}" dt="2022-04-01T06:42:31.228" v="747" actId="164"/>
          <ac:spMkLst>
            <pc:docMk/>
            <pc:sldMk cId="706034829" sldId="301"/>
            <ac:spMk id="87" creationId="{E6148F63-12D9-43A9-9FBF-1DBA5E46CB8A}"/>
          </ac:spMkLst>
        </pc:spChg>
        <pc:spChg chg="mod topLvl">
          <ac:chgData name="Filippo Acconcia" userId="844af49c-a8a0-47ac-a7dd-14a44b60cd18" providerId="ADAL" clId="{B609A75A-164F-4066-A006-F59E853DC491}" dt="2022-04-01T06:42:31.228" v="747" actId="164"/>
          <ac:spMkLst>
            <pc:docMk/>
            <pc:sldMk cId="706034829" sldId="301"/>
            <ac:spMk id="88" creationId="{14598B10-9F2D-449E-BFCD-A7235AC8CF70}"/>
          </ac:spMkLst>
        </pc:spChg>
        <pc:spChg chg="del mod topLvl">
          <ac:chgData name="Filippo Acconcia" userId="844af49c-a8a0-47ac-a7dd-14a44b60cd18" providerId="ADAL" clId="{B609A75A-164F-4066-A006-F59E853DC491}" dt="2022-04-01T06:36:53.917" v="557" actId="478"/>
          <ac:spMkLst>
            <pc:docMk/>
            <pc:sldMk cId="706034829" sldId="301"/>
            <ac:spMk id="89" creationId="{32AEF1C5-AB87-4DF4-B4AA-8A408FA2D2FB}"/>
          </ac:spMkLst>
        </pc:spChg>
        <pc:spChg chg="mod topLvl">
          <ac:chgData name="Filippo Acconcia" userId="844af49c-a8a0-47ac-a7dd-14a44b60cd18" providerId="ADAL" clId="{B609A75A-164F-4066-A006-F59E853DC491}" dt="2022-04-01T06:38:32.341" v="640" actId="164"/>
          <ac:spMkLst>
            <pc:docMk/>
            <pc:sldMk cId="706034829" sldId="301"/>
            <ac:spMk id="91" creationId="{5C49F340-A0DD-46B3-97B6-FCF895A072AA}"/>
          </ac:spMkLst>
        </pc:spChg>
        <pc:spChg chg="del mod topLvl">
          <ac:chgData name="Filippo Acconcia" userId="844af49c-a8a0-47ac-a7dd-14a44b60cd18" providerId="ADAL" clId="{B609A75A-164F-4066-A006-F59E853DC491}" dt="2022-04-01T06:31:05.521" v="551" actId="478"/>
          <ac:spMkLst>
            <pc:docMk/>
            <pc:sldMk cId="706034829" sldId="301"/>
            <ac:spMk id="92" creationId="{696DE9D4-BC56-44BA-A221-177646AB5838}"/>
          </ac:spMkLst>
        </pc:spChg>
        <pc:spChg chg="del mod topLvl">
          <ac:chgData name="Filippo Acconcia" userId="844af49c-a8a0-47ac-a7dd-14a44b60cd18" providerId="ADAL" clId="{B609A75A-164F-4066-A006-F59E853DC491}" dt="2022-04-01T06:31:05.521" v="551" actId="478"/>
          <ac:spMkLst>
            <pc:docMk/>
            <pc:sldMk cId="706034829" sldId="301"/>
            <ac:spMk id="93" creationId="{2FADD85D-1AD5-42B0-AF7B-13063FB11A38}"/>
          </ac:spMkLst>
        </pc:spChg>
        <pc:spChg chg="del mod topLvl">
          <ac:chgData name="Filippo Acconcia" userId="844af49c-a8a0-47ac-a7dd-14a44b60cd18" providerId="ADAL" clId="{B609A75A-164F-4066-A006-F59E853DC491}" dt="2022-04-01T06:31:05.521" v="551" actId="478"/>
          <ac:spMkLst>
            <pc:docMk/>
            <pc:sldMk cId="706034829" sldId="301"/>
            <ac:spMk id="94" creationId="{C7282AAB-FC5A-4F72-A3BD-7614AF4AB2B6}"/>
          </ac:spMkLst>
        </pc:spChg>
        <pc:spChg chg="add mod">
          <ac:chgData name="Filippo Acconcia" userId="844af49c-a8a0-47ac-a7dd-14a44b60cd18" providerId="ADAL" clId="{B609A75A-164F-4066-A006-F59E853DC491}" dt="2022-04-01T06:42:31.228" v="747" actId="164"/>
          <ac:spMkLst>
            <pc:docMk/>
            <pc:sldMk cId="706034829" sldId="301"/>
            <ac:spMk id="96" creationId="{DE1F7433-875F-4B55-8206-A15DE8672A92}"/>
          </ac:spMkLst>
        </pc:spChg>
        <pc:spChg chg="add mod">
          <ac:chgData name="Filippo Acconcia" userId="844af49c-a8a0-47ac-a7dd-14a44b60cd18" providerId="ADAL" clId="{B609A75A-164F-4066-A006-F59E853DC491}" dt="2022-04-01T06:42:31.228" v="747" actId="164"/>
          <ac:spMkLst>
            <pc:docMk/>
            <pc:sldMk cId="706034829" sldId="301"/>
            <ac:spMk id="97" creationId="{10B2623E-8A6A-4034-BDDC-6FF9E4BA830F}"/>
          </ac:spMkLst>
        </pc:spChg>
        <pc:spChg chg="add mod">
          <ac:chgData name="Filippo Acconcia" userId="844af49c-a8a0-47ac-a7dd-14a44b60cd18" providerId="ADAL" clId="{B609A75A-164F-4066-A006-F59E853DC491}" dt="2022-04-01T06:42:31.228" v="747" actId="164"/>
          <ac:spMkLst>
            <pc:docMk/>
            <pc:sldMk cId="706034829" sldId="301"/>
            <ac:spMk id="98" creationId="{146C6FED-74F5-400A-9A41-7EDA2CA9B682}"/>
          </ac:spMkLst>
        </pc:spChg>
        <pc:spChg chg="add mod">
          <ac:chgData name="Filippo Acconcia" userId="844af49c-a8a0-47ac-a7dd-14a44b60cd18" providerId="ADAL" clId="{B609A75A-164F-4066-A006-F59E853DC491}" dt="2022-04-01T06:42:31.228" v="747" actId="164"/>
          <ac:spMkLst>
            <pc:docMk/>
            <pc:sldMk cId="706034829" sldId="301"/>
            <ac:spMk id="99" creationId="{4CB4C672-2590-47A4-8C80-6C8B9F57652E}"/>
          </ac:spMkLst>
        </pc:spChg>
        <pc:spChg chg="add mod">
          <ac:chgData name="Filippo Acconcia" userId="844af49c-a8a0-47ac-a7dd-14a44b60cd18" providerId="ADAL" clId="{B609A75A-164F-4066-A006-F59E853DC491}" dt="2022-04-01T06:42:31.228" v="747" actId="164"/>
          <ac:spMkLst>
            <pc:docMk/>
            <pc:sldMk cId="706034829" sldId="301"/>
            <ac:spMk id="100" creationId="{5051ED74-6485-4285-A9DD-935FA09B7505}"/>
          </ac:spMkLst>
        </pc:spChg>
        <pc:spChg chg="add mod">
          <ac:chgData name="Filippo Acconcia" userId="844af49c-a8a0-47ac-a7dd-14a44b60cd18" providerId="ADAL" clId="{B609A75A-164F-4066-A006-F59E853DC491}" dt="2022-04-01T06:42:31.228" v="747" actId="164"/>
          <ac:spMkLst>
            <pc:docMk/>
            <pc:sldMk cId="706034829" sldId="301"/>
            <ac:spMk id="101" creationId="{70FE8C55-C7C2-4401-A045-FB2365B7C0E7}"/>
          </ac:spMkLst>
        </pc:spChg>
        <pc:spChg chg="mod">
          <ac:chgData name="Filippo Acconcia" userId="844af49c-a8a0-47ac-a7dd-14a44b60cd18" providerId="ADAL" clId="{B609A75A-164F-4066-A006-F59E853DC491}" dt="2022-04-01T06:38:37.167" v="643"/>
          <ac:spMkLst>
            <pc:docMk/>
            <pc:sldMk cId="706034829" sldId="301"/>
            <ac:spMk id="105" creationId="{676E51CB-EB34-422B-94E9-DA9252C4F892}"/>
          </ac:spMkLst>
        </pc:spChg>
        <pc:spChg chg="mod">
          <ac:chgData name="Filippo Acconcia" userId="844af49c-a8a0-47ac-a7dd-14a44b60cd18" providerId="ADAL" clId="{B609A75A-164F-4066-A006-F59E853DC491}" dt="2022-04-01T06:38:41.630" v="655"/>
          <ac:spMkLst>
            <pc:docMk/>
            <pc:sldMk cId="706034829" sldId="301"/>
            <ac:spMk id="108" creationId="{B0BACDF3-A9C7-4649-ACFA-D79179FCB9E7}"/>
          </ac:spMkLst>
        </pc:spChg>
        <pc:spChg chg="mod">
          <ac:chgData name="Filippo Acconcia" userId="844af49c-a8a0-47ac-a7dd-14a44b60cd18" providerId="ADAL" clId="{B609A75A-164F-4066-A006-F59E853DC491}" dt="2022-04-01T06:38:45.023" v="666"/>
          <ac:spMkLst>
            <pc:docMk/>
            <pc:sldMk cId="706034829" sldId="301"/>
            <ac:spMk id="111" creationId="{AD8CCD6D-136E-41EA-8831-76DE00EF4BB9}"/>
          </ac:spMkLst>
        </pc:spChg>
        <pc:spChg chg="add mod">
          <ac:chgData name="Filippo Acconcia" userId="844af49c-a8a0-47ac-a7dd-14a44b60cd18" providerId="ADAL" clId="{B609A75A-164F-4066-A006-F59E853DC491}" dt="2022-04-01T06:41:19.611" v="703" actId="164"/>
          <ac:spMkLst>
            <pc:docMk/>
            <pc:sldMk cId="706034829" sldId="301"/>
            <ac:spMk id="114" creationId="{C3788B81-5CF4-48DB-8866-4420D3D02E9A}"/>
          </ac:spMkLst>
        </pc:spChg>
        <pc:spChg chg="mod">
          <ac:chgData name="Filippo Acconcia" userId="844af49c-a8a0-47ac-a7dd-14a44b60cd18" providerId="ADAL" clId="{B609A75A-164F-4066-A006-F59E853DC491}" dt="2022-04-01T06:41:42.957" v="718" actId="20577"/>
          <ac:spMkLst>
            <pc:docMk/>
            <pc:sldMk cId="706034829" sldId="301"/>
            <ac:spMk id="118" creationId="{8D4601F0-682A-4E1B-90E0-010438471764}"/>
          </ac:spMkLst>
        </pc:spChg>
        <pc:spChg chg="mod">
          <ac:chgData name="Filippo Acconcia" userId="844af49c-a8a0-47ac-a7dd-14a44b60cd18" providerId="ADAL" clId="{B609A75A-164F-4066-A006-F59E853DC491}" dt="2022-04-01T06:41:48.565" v="723" actId="20577"/>
          <ac:spMkLst>
            <pc:docMk/>
            <pc:sldMk cId="706034829" sldId="301"/>
            <ac:spMk id="121" creationId="{D37A94E3-D8BC-4FC9-A002-80F20F486975}"/>
          </ac:spMkLst>
        </pc:spChg>
        <pc:spChg chg="mod">
          <ac:chgData name="Filippo Acconcia" userId="844af49c-a8a0-47ac-a7dd-14a44b60cd18" providerId="ADAL" clId="{B609A75A-164F-4066-A006-F59E853DC491}" dt="2022-04-01T06:41:53.460" v="728" actId="20577"/>
          <ac:spMkLst>
            <pc:docMk/>
            <pc:sldMk cId="706034829" sldId="301"/>
            <ac:spMk id="124" creationId="{DAFB023E-B371-42CF-94FF-6FCD022C2515}"/>
          </ac:spMkLst>
        </pc:spChg>
        <pc:spChg chg="add mod">
          <ac:chgData name="Filippo Acconcia" userId="844af49c-a8a0-47ac-a7dd-14a44b60cd18" providerId="ADAL" clId="{B609A75A-164F-4066-A006-F59E853DC491}" dt="2022-04-01T07:32:09.577" v="1095" actId="552"/>
          <ac:spMkLst>
            <pc:docMk/>
            <pc:sldMk cId="706034829" sldId="301"/>
            <ac:spMk id="125" creationId="{75026240-77DD-487D-8EBE-7C96BA96032E}"/>
          </ac:spMkLst>
        </pc:spChg>
        <pc:spChg chg="mod topLvl">
          <ac:chgData name="Filippo Acconcia" userId="844af49c-a8a0-47ac-a7dd-14a44b60cd18" providerId="ADAL" clId="{B609A75A-164F-4066-A006-F59E853DC491}" dt="2022-04-01T06:45:12.629" v="773" actId="164"/>
          <ac:spMkLst>
            <pc:docMk/>
            <pc:sldMk cId="706034829" sldId="301"/>
            <ac:spMk id="129" creationId="{372F731D-C30C-4867-BF48-768670537171}"/>
          </ac:spMkLst>
        </pc:spChg>
        <pc:spChg chg="mod topLvl">
          <ac:chgData name="Filippo Acconcia" userId="844af49c-a8a0-47ac-a7dd-14a44b60cd18" providerId="ADAL" clId="{B609A75A-164F-4066-A006-F59E853DC491}" dt="2022-04-01T06:45:12.629" v="773" actId="164"/>
          <ac:spMkLst>
            <pc:docMk/>
            <pc:sldMk cId="706034829" sldId="301"/>
            <ac:spMk id="130" creationId="{528C6B97-75CE-446C-AFDE-285C70B635AE}"/>
          </ac:spMkLst>
        </pc:spChg>
        <pc:spChg chg="mod topLvl">
          <ac:chgData name="Filippo Acconcia" userId="844af49c-a8a0-47ac-a7dd-14a44b60cd18" providerId="ADAL" clId="{B609A75A-164F-4066-A006-F59E853DC491}" dt="2022-04-01T06:45:12.629" v="773" actId="164"/>
          <ac:spMkLst>
            <pc:docMk/>
            <pc:sldMk cId="706034829" sldId="301"/>
            <ac:spMk id="131" creationId="{FE0FFF49-5799-4B0B-A7B4-2EE605787035}"/>
          </ac:spMkLst>
        </pc:spChg>
        <pc:spChg chg="mod topLvl">
          <ac:chgData name="Filippo Acconcia" userId="844af49c-a8a0-47ac-a7dd-14a44b60cd18" providerId="ADAL" clId="{B609A75A-164F-4066-A006-F59E853DC491}" dt="2022-04-01T06:45:12.629" v="773" actId="164"/>
          <ac:spMkLst>
            <pc:docMk/>
            <pc:sldMk cId="706034829" sldId="301"/>
            <ac:spMk id="132" creationId="{25130578-6CEF-42C2-BD13-41B0057AA849}"/>
          </ac:spMkLst>
        </pc:spChg>
        <pc:spChg chg="mod topLvl">
          <ac:chgData name="Filippo Acconcia" userId="844af49c-a8a0-47ac-a7dd-14a44b60cd18" providerId="ADAL" clId="{B609A75A-164F-4066-A006-F59E853DC491}" dt="2022-04-01T06:45:12.629" v="773" actId="164"/>
          <ac:spMkLst>
            <pc:docMk/>
            <pc:sldMk cId="706034829" sldId="301"/>
            <ac:spMk id="133" creationId="{07F23D5A-A540-4892-9266-EF7E9757376D}"/>
          </ac:spMkLst>
        </pc:spChg>
        <pc:spChg chg="mod topLvl">
          <ac:chgData name="Filippo Acconcia" userId="844af49c-a8a0-47ac-a7dd-14a44b60cd18" providerId="ADAL" clId="{B609A75A-164F-4066-A006-F59E853DC491}" dt="2022-04-01T06:45:12.629" v="773" actId="164"/>
          <ac:spMkLst>
            <pc:docMk/>
            <pc:sldMk cId="706034829" sldId="301"/>
            <ac:spMk id="134" creationId="{5C822147-12C7-4C9E-AF59-B7CA9EADA58B}"/>
          </ac:spMkLst>
        </pc:spChg>
        <pc:spChg chg="mod topLvl">
          <ac:chgData name="Filippo Acconcia" userId="844af49c-a8a0-47ac-a7dd-14a44b60cd18" providerId="ADAL" clId="{B609A75A-164F-4066-A006-F59E853DC491}" dt="2022-04-01T06:45:12.629" v="773" actId="164"/>
          <ac:spMkLst>
            <pc:docMk/>
            <pc:sldMk cId="706034829" sldId="301"/>
            <ac:spMk id="136" creationId="{52D31821-CDBF-4107-B709-0BDA29FBF460}"/>
          </ac:spMkLst>
        </pc:spChg>
        <pc:spChg chg="mod topLvl">
          <ac:chgData name="Filippo Acconcia" userId="844af49c-a8a0-47ac-a7dd-14a44b60cd18" providerId="ADAL" clId="{B609A75A-164F-4066-A006-F59E853DC491}" dt="2022-04-01T06:45:12.629" v="773" actId="164"/>
          <ac:spMkLst>
            <pc:docMk/>
            <pc:sldMk cId="706034829" sldId="301"/>
            <ac:spMk id="137" creationId="{8B588263-3F63-4163-A3A5-D1F320734D27}"/>
          </ac:spMkLst>
        </pc:spChg>
        <pc:spChg chg="mod topLvl">
          <ac:chgData name="Filippo Acconcia" userId="844af49c-a8a0-47ac-a7dd-14a44b60cd18" providerId="ADAL" clId="{B609A75A-164F-4066-A006-F59E853DC491}" dt="2022-04-01T06:45:12.629" v="773" actId="164"/>
          <ac:spMkLst>
            <pc:docMk/>
            <pc:sldMk cId="706034829" sldId="301"/>
            <ac:spMk id="138" creationId="{E0D10F7E-82B8-4601-A727-2804792ED8A5}"/>
          </ac:spMkLst>
        </pc:spChg>
        <pc:spChg chg="mod topLvl">
          <ac:chgData name="Filippo Acconcia" userId="844af49c-a8a0-47ac-a7dd-14a44b60cd18" providerId="ADAL" clId="{B609A75A-164F-4066-A006-F59E853DC491}" dt="2022-04-01T06:45:12.629" v="773" actId="164"/>
          <ac:spMkLst>
            <pc:docMk/>
            <pc:sldMk cId="706034829" sldId="301"/>
            <ac:spMk id="139" creationId="{53A02144-BB88-4F01-B2D6-DF8DA839CB91}"/>
          </ac:spMkLst>
        </pc:spChg>
        <pc:spChg chg="del mod topLvl">
          <ac:chgData name="Filippo Acconcia" userId="844af49c-a8a0-47ac-a7dd-14a44b60cd18" providerId="ADAL" clId="{B609A75A-164F-4066-A006-F59E853DC491}" dt="2022-04-01T06:44:39.700" v="765" actId="478"/>
          <ac:spMkLst>
            <pc:docMk/>
            <pc:sldMk cId="706034829" sldId="301"/>
            <ac:spMk id="140" creationId="{BB58C66D-1165-46FB-913C-47B0BE61BC04}"/>
          </ac:spMkLst>
        </pc:spChg>
        <pc:spChg chg="del mod topLvl">
          <ac:chgData name="Filippo Acconcia" userId="844af49c-a8a0-47ac-a7dd-14a44b60cd18" providerId="ADAL" clId="{B609A75A-164F-4066-A006-F59E853DC491}" dt="2022-04-01T06:44:39.700" v="765" actId="478"/>
          <ac:spMkLst>
            <pc:docMk/>
            <pc:sldMk cId="706034829" sldId="301"/>
            <ac:spMk id="141" creationId="{76120FC5-2536-41A9-AA2E-976355E37012}"/>
          </ac:spMkLst>
        </pc:spChg>
        <pc:spChg chg="mod">
          <ac:chgData name="Filippo Acconcia" userId="844af49c-a8a0-47ac-a7dd-14a44b60cd18" providerId="ADAL" clId="{B609A75A-164F-4066-A006-F59E853DC491}" dt="2022-04-01T06:44:21.321" v="760" actId="165"/>
          <ac:spMkLst>
            <pc:docMk/>
            <pc:sldMk cId="706034829" sldId="301"/>
            <ac:spMk id="150" creationId="{04E90B94-311B-4894-B5FF-7B293011E0EA}"/>
          </ac:spMkLst>
        </pc:spChg>
        <pc:spChg chg="mod">
          <ac:chgData name="Filippo Acconcia" userId="844af49c-a8a0-47ac-a7dd-14a44b60cd18" providerId="ADAL" clId="{B609A75A-164F-4066-A006-F59E853DC491}" dt="2022-04-01T06:45:03.540" v="772" actId="20577"/>
          <ac:spMkLst>
            <pc:docMk/>
            <pc:sldMk cId="706034829" sldId="301"/>
            <ac:spMk id="152" creationId="{B0FFB154-DFC4-4846-AD64-0C0FCA479DF6}"/>
          </ac:spMkLst>
        </pc:spChg>
        <pc:spChg chg="mod">
          <ac:chgData name="Filippo Acconcia" userId="844af49c-a8a0-47ac-a7dd-14a44b60cd18" providerId="ADAL" clId="{B609A75A-164F-4066-A006-F59E853DC491}" dt="2022-04-01T06:44:21.321" v="760" actId="165"/>
          <ac:spMkLst>
            <pc:docMk/>
            <pc:sldMk cId="706034829" sldId="301"/>
            <ac:spMk id="154" creationId="{F3E8D19B-ACD0-4487-BB33-FA0205741030}"/>
          </ac:spMkLst>
        </pc:spChg>
        <pc:spChg chg="mod">
          <ac:chgData name="Filippo Acconcia" userId="844af49c-a8a0-47ac-a7dd-14a44b60cd18" providerId="ADAL" clId="{B609A75A-164F-4066-A006-F59E853DC491}" dt="2022-04-01T06:44:21.321" v="760" actId="165"/>
          <ac:spMkLst>
            <pc:docMk/>
            <pc:sldMk cId="706034829" sldId="301"/>
            <ac:spMk id="156" creationId="{225DB805-1CB0-4863-94C1-4888F7FF2D47}"/>
          </ac:spMkLst>
        </pc:spChg>
        <pc:spChg chg="mod">
          <ac:chgData name="Filippo Acconcia" userId="844af49c-a8a0-47ac-a7dd-14a44b60cd18" providerId="ADAL" clId="{B609A75A-164F-4066-A006-F59E853DC491}" dt="2022-04-01T06:44:21.321" v="760" actId="165"/>
          <ac:spMkLst>
            <pc:docMk/>
            <pc:sldMk cId="706034829" sldId="301"/>
            <ac:spMk id="158" creationId="{F61560E9-620A-4130-A132-F1CD3CE50AD5}"/>
          </ac:spMkLst>
        </pc:spChg>
        <pc:spChg chg="mod">
          <ac:chgData name="Filippo Acconcia" userId="844af49c-a8a0-47ac-a7dd-14a44b60cd18" providerId="ADAL" clId="{B609A75A-164F-4066-A006-F59E853DC491}" dt="2022-04-01T06:44:21.321" v="760" actId="165"/>
          <ac:spMkLst>
            <pc:docMk/>
            <pc:sldMk cId="706034829" sldId="301"/>
            <ac:spMk id="160" creationId="{498B128F-1298-4EE7-857E-BDCC450F25FB}"/>
          </ac:spMkLst>
        </pc:spChg>
        <pc:spChg chg="mod">
          <ac:chgData name="Filippo Acconcia" userId="844af49c-a8a0-47ac-a7dd-14a44b60cd18" providerId="ADAL" clId="{B609A75A-164F-4066-A006-F59E853DC491}" dt="2022-04-01T06:44:21.321" v="760" actId="165"/>
          <ac:spMkLst>
            <pc:docMk/>
            <pc:sldMk cId="706034829" sldId="301"/>
            <ac:spMk id="162" creationId="{521026B0-50F0-4E8A-9ABB-67FAC178F6CE}"/>
          </ac:spMkLst>
        </pc:spChg>
        <pc:spChg chg="mod">
          <ac:chgData name="Filippo Acconcia" userId="844af49c-a8a0-47ac-a7dd-14a44b60cd18" providerId="ADAL" clId="{B609A75A-164F-4066-A006-F59E853DC491}" dt="2022-04-01T06:44:21.321" v="760" actId="165"/>
          <ac:spMkLst>
            <pc:docMk/>
            <pc:sldMk cId="706034829" sldId="301"/>
            <ac:spMk id="164" creationId="{CC37ECE2-A925-4389-BB88-38EDF05D9F54}"/>
          </ac:spMkLst>
        </pc:spChg>
        <pc:spChg chg="add mod">
          <ac:chgData name="Filippo Acconcia" userId="844af49c-a8a0-47ac-a7dd-14a44b60cd18" providerId="ADAL" clId="{B609A75A-164F-4066-A006-F59E853DC491}" dt="2022-04-01T07:32:14.018" v="1096" actId="552"/>
          <ac:spMkLst>
            <pc:docMk/>
            <pc:sldMk cId="706034829" sldId="301"/>
            <ac:spMk id="165" creationId="{53C426DE-3C9C-4095-9F22-4A3538D7EA35}"/>
          </ac:spMkLst>
        </pc:spChg>
        <pc:spChg chg="add del mod">
          <ac:chgData name="Filippo Acconcia" userId="844af49c-a8a0-47ac-a7dd-14a44b60cd18" providerId="ADAL" clId="{B609A75A-164F-4066-A006-F59E853DC491}" dt="2022-04-01T06:52:06.669" v="776" actId="478"/>
          <ac:spMkLst>
            <pc:docMk/>
            <pc:sldMk cId="706034829" sldId="301"/>
            <ac:spMk id="168" creationId="{288709C5-C836-4CF7-9154-E54F3CCA48B8}"/>
          </ac:spMkLst>
        </pc:spChg>
        <pc:spChg chg="add mod">
          <ac:chgData name="Filippo Acconcia" userId="844af49c-a8a0-47ac-a7dd-14a44b60cd18" providerId="ADAL" clId="{B609A75A-164F-4066-A006-F59E853DC491}" dt="2022-04-01T08:51:35.654" v="1215" actId="1037"/>
          <ac:spMkLst>
            <pc:docMk/>
            <pc:sldMk cId="706034829" sldId="301"/>
            <ac:spMk id="169" creationId="{50FCF0BC-06A0-44FA-AD13-4E285A672083}"/>
          </ac:spMkLst>
        </pc:spChg>
        <pc:spChg chg="del mod topLvl">
          <ac:chgData name="Filippo Acconcia" userId="844af49c-a8a0-47ac-a7dd-14a44b60cd18" providerId="ADAL" clId="{B609A75A-164F-4066-A006-F59E853DC491}" dt="2022-04-01T07:56:09.346" v="1153" actId="478"/>
          <ac:spMkLst>
            <pc:docMk/>
            <pc:sldMk cId="706034829" sldId="301"/>
            <ac:spMk id="176" creationId="{A0B89BAB-170F-4FEE-88E3-C501792CF5F8}"/>
          </ac:spMkLst>
        </pc:spChg>
        <pc:spChg chg="del mod topLvl">
          <ac:chgData name="Filippo Acconcia" userId="844af49c-a8a0-47ac-a7dd-14a44b60cd18" providerId="ADAL" clId="{B609A75A-164F-4066-A006-F59E853DC491}" dt="2022-04-01T07:56:09.346" v="1153" actId="478"/>
          <ac:spMkLst>
            <pc:docMk/>
            <pc:sldMk cId="706034829" sldId="301"/>
            <ac:spMk id="177" creationId="{F30A3C6A-0753-4851-9EC9-AD079CA34200}"/>
          </ac:spMkLst>
        </pc:spChg>
        <pc:spChg chg="del mod topLvl">
          <ac:chgData name="Filippo Acconcia" userId="844af49c-a8a0-47ac-a7dd-14a44b60cd18" providerId="ADAL" clId="{B609A75A-164F-4066-A006-F59E853DC491}" dt="2022-04-01T07:56:09.346" v="1153" actId="478"/>
          <ac:spMkLst>
            <pc:docMk/>
            <pc:sldMk cId="706034829" sldId="301"/>
            <ac:spMk id="178" creationId="{582A5BB6-F11A-48BD-B44B-6451CA852CF3}"/>
          </ac:spMkLst>
        </pc:spChg>
        <pc:spChg chg="mod topLvl">
          <ac:chgData name="Filippo Acconcia" userId="844af49c-a8a0-47ac-a7dd-14a44b60cd18" providerId="ADAL" clId="{B609A75A-164F-4066-A006-F59E853DC491}" dt="2022-04-01T07:56:07.323" v="1152" actId="164"/>
          <ac:spMkLst>
            <pc:docMk/>
            <pc:sldMk cId="706034829" sldId="301"/>
            <ac:spMk id="179" creationId="{8FA549C0-AA37-49F9-AE3A-E1C1D70D6730}"/>
          </ac:spMkLst>
        </pc:spChg>
        <pc:spChg chg="mod topLvl">
          <ac:chgData name="Filippo Acconcia" userId="844af49c-a8a0-47ac-a7dd-14a44b60cd18" providerId="ADAL" clId="{B609A75A-164F-4066-A006-F59E853DC491}" dt="2022-04-01T07:56:07.323" v="1152" actId="164"/>
          <ac:spMkLst>
            <pc:docMk/>
            <pc:sldMk cId="706034829" sldId="301"/>
            <ac:spMk id="180" creationId="{0C456427-ED97-4733-9BED-1AC2EF20777D}"/>
          </ac:spMkLst>
        </pc:spChg>
        <pc:spChg chg="mod topLvl">
          <ac:chgData name="Filippo Acconcia" userId="844af49c-a8a0-47ac-a7dd-14a44b60cd18" providerId="ADAL" clId="{B609A75A-164F-4066-A006-F59E853DC491}" dt="2022-04-01T07:56:07.323" v="1152" actId="164"/>
          <ac:spMkLst>
            <pc:docMk/>
            <pc:sldMk cId="706034829" sldId="301"/>
            <ac:spMk id="181" creationId="{5F16C73D-6F2D-43EC-9872-0C8CBD9F9C4F}"/>
          </ac:spMkLst>
        </pc:spChg>
        <pc:spChg chg="mod topLvl">
          <ac:chgData name="Filippo Acconcia" userId="844af49c-a8a0-47ac-a7dd-14a44b60cd18" providerId="ADAL" clId="{B609A75A-164F-4066-A006-F59E853DC491}" dt="2022-04-01T07:56:07.323" v="1152" actId="164"/>
          <ac:spMkLst>
            <pc:docMk/>
            <pc:sldMk cId="706034829" sldId="301"/>
            <ac:spMk id="182" creationId="{555D44FE-3DD3-4626-A721-DEA063B28D07}"/>
          </ac:spMkLst>
        </pc:spChg>
        <pc:spChg chg="mod topLvl">
          <ac:chgData name="Filippo Acconcia" userId="844af49c-a8a0-47ac-a7dd-14a44b60cd18" providerId="ADAL" clId="{B609A75A-164F-4066-A006-F59E853DC491}" dt="2022-04-01T07:56:07.323" v="1152" actId="164"/>
          <ac:spMkLst>
            <pc:docMk/>
            <pc:sldMk cId="706034829" sldId="301"/>
            <ac:spMk id="183" creationId="{2CA7950B-D2AE-4F44-A53A-8FB592DA5DEC}"/>
          </ac:spMkLst>
        </pc:spChg>
        <pc:spChg chg="mod topLvl">
          <ac:chgData name="Filippo Acconcia" userId="844af49c-a8a0-47ac-a7dd-14a44b60cd18" providerId="ADAL" clId="{B609A75A-164F-4066-A006-F59E853DC491}" dt="2022-04-01T07:56:07.323" v="1152" actId="164"/>
          <ac:spMkLst>
            <pc:docMk/>
            <pc:sldMk cId="706034829" sldId="301"/>
            <ac:spMk id="185" creationId="{5E8901E5-0A0D-4DE1-9D7C-CF522054192F}"/>
          </ac:spMkLst>
        </pc:spChg>
        <pc:spChg chg="mod topLvl">
          <ac:chgData name="Filippo Acconcia" userId="844af49c-a8a0-47ac-a7dd-14a44b60cd18" providerId="ADAL" clId="{B609A75A-164F-4066-A006-F59E853DC491}" dt="2022-04-01T07:19:04.640" v="945" actId="164"/>
          <ac:spMkLst>
            <pc:docMk/>
            <pc:sldMk cId="706034829" sldId="301"/>
            <ac:spMk id="186" creationId="{EFC74B3D-31EA-4A8E-8678-33160D1C9681}"/>
          </ac:spMkLst>
        </pc:spChg>
        <pc:spChg chg="mod topLvl">
          <ac:chgData name="Filippo Acconcia" userId="844af49c-a8a0-47ac-a7dd-14a44b60cd18" providerId="ADAL" clId="{B609A75A-164F-4066-A006-F59E853DC491}" dt="2022-04-01T07:19:04.640" v="945" actId="164"/>
          <ac:spMkLst>
            <pc:docMk/>
            <pc:sldMk cId="706034829" sldId="301"/>
            <ac:spMk id="187" creationId="{E5829677-C302-4BB6-821F-8DFF94277C9B}"/>
          </ac:spMkLst>
        </pc:spChg>
        <pc:spChg chg="mod topLvl">
          <ac:chgData name="Filippo Acconcia" userId="844af49c-a8a0-47ac-a7dd-14a44b60cd18" providerId="ADAL" clId="{B609A75A-164F-4066-A006-F59E853DC491}" dt="2022-04-01T07:19:04.640" v="945" actId="164"/>
          <ac:spMkLst>
            <pc:docMk/>
            <pc:sldMk cId="706034829" sldId="301"/>
            <ac:spMk id="188" creationId="{7C433885-0390-4176-A673-3A771ACDD58A}"/>
          </ac:spMkLst>
        </pc:spChg>
        <pc:spChg chg="mod topLvl">
          <ac:chgData name="Filippo Acconcia" userId="844af49c-a8a0-47ac-a7dd-14a44b60cd18" providerId="ADAL" clId="{B609A75A-164F-4066-A006-F59E853DC491}" dt="2022-04-01T07:19:04.640" v="945" actId="164"/>
          <ac:spMkLst>
            <pc:docMk/>
            <pc:sldMk cId="706034829" sldId="301"/>
            <ac:spMk id="189" creationId="{E7E56788-B808-4B62-848A-774F7450994F}"/>
          </ac:spMkLst>
        </pc:spChg>
        <pc:spChg chg="mod topLvl">
          <ac:chgData name="Filippo Acconcia" userId="844af49c-a8a0-47ac-a7dd-14a44b60cd18" providerId="ADAL" clId="{B609A75A-164F-4066-A006-F59E853DC491}" dt="2022-04-01T07:21:55.917" v="1070" actId="164"/>
          <ac:spMkLst>
            <pc:docMk/>
            <pc:sldMk cId="706034829" sldId="301"/>
            <ac:spMk id="190" creationId="{CE049292-B954-48F9-B5DF-EDDEC5429B47}"/>
          </ac:spMkLst>
        </pc:spChg>
        <pc:spChg chg="del mod topLvl">
          <ac:chgData name="Filippo Acconcia" userId="844af49c-a8a0-47ac-a7dd-14a44b60cd18" providerId="ADAL" clId="{B609A75A-164F-4066-A006-F59E853DC491}" dt="2022-04-01T07:19:27.251" v="955" actId="478"/>
          <ac:spMkLst>
            <pc:docMk/>
            <pc:sldMk cId="706034829" sldId="301"/>
            <ac:spMk id="191" creationId="{39130091-F3C1-4CEF-9943-8F0FCB3BCB54}"/>
          </ac:spMkLst>
        </pc:spChg>
        <pc:spChg chg="del mod topLvl">
          <ac:chgData name="Filippo Acconcia" userId="844af49c-a8a0-47ac-a7dd-14a44b60cd18" providerId="ADAL" clId="{B609A75A-164F-4066-A006-F59E853DC491}" dt="2022-04-01T07:19:27.251" v="955" actId="478"/>
          <ac:spMkLst>
            <pc:docMk/>
            <pc:sldMk cId="706034829" sldId="301"/>
            <ac:spMk id="192" creationId="{FBF0A18C-419B-4359-9148-A57CDD933AA1}"/>
          </ac:spMkLst>
        </pc:spChg>
        <pc:spChg chg="del mod topLvl">
          <ac:chgData name="Filippo Acconcia" userId="844af49c-a8a0-47ac-a7dd-14a44b60cd18" providerId="ADAL" clId="{B609A75A-164F-4066-A006-F59E853DC491}" dt="2022-04-01T07:19:27.251" v="955" actId="478"/>
          <ac:spMkLst>
            <pc:docMk/>
            <pc:sldMk cId="706034829" sldId="301"/>
            <ac:spMk id="193" creationId="{38B5BA29-069F-4025-A574-C6FC53BB7B16}"/>
          </ac:spMkLst>
        </pc:spChg>
        <pc:spChg chg="del mod topLvl">
          <ac:chgData name="Filippo Acconcia" userId="844af49c-a8a0-47ac-a7dd-14a44b60cd18" providerId="ADAL" clId="{B609A75A-164F-4066-A006-F59E853DC491}" dt="2022-04-01T07:19:27.251" v="955" actId="478"/>
          <ac:spMkLst>
            <pc:docMk/>
            <pc:sldMk cId="706034829" sldId="301"/>
            <ac:spMk id="194" creationId="{DD9CC7BA-A6C2-497B-B68C-D1B21B5E9FB2}"/>
          </ac:spMkLst>
        </pc:spChg>
        <pc:spChg chg="del mod topLvl">
          <ac:chgData name="Filippo Acconcia" userId="844af49c-a8a0-47ac-a7dd-14a44b60cd18" providerId="ADAL" clId="{B609A75A-164F-4066-A006-F59E853DC491}" dt="2022-04-01T07:19:27.251" v="955" actId="478"/>
          <ac:spMkLst>
            <pc:docMk/>
            <pc:sldMk cId="706034829" sldId="301"/>
            <ac:spMk id="195" creationId="{2D9CB3AE-5EE5-42D9-82F9-E3BC41E7B293}"/>
          </ac:spMkLst>
        </pc:spChg>
        <pc:spChg chg="del mod topLvl">
          <ac:chgData name="Filippo Acconcia" userId="844af49c-a8a0-47ac-a7dd-14a44b60cd18" providerId="ADAL" clId="{B609A75A-164F-4066-A006-F59E853DC491}" dt="2022-04-01T07:19:27.251" v="955" actId="478"/>
          <ac:spMkLst>
            <pc:docMk/>
            <pc:sldMk cId="706034829" sldId="301"/>
            <ac:spMk id="196" creationId="{52ADC472-C9FC-46E3-BB9E-0D54772DAABE}"/>
          </ac:spMkLst>
        </pc:spChg>
        <pc:spChg chg="mod topLvl">
          <ac:chgData name="Filippo Acconcia" userId="844af49c-a8a0-47ac-a7dd-14a44b60cd18" providerId="ADAL" clId="{B609A75A-164F-4066-A006-F59E853DC491}" dt="2022-04-01T07:21:55.917" v="1070" actId="164"/>
          <ac:spMkLst>
            <pc:docMk/>
            <pc:sldMk cId="706034829" sldId="301"/>
            <ac:spMk id="206" creationId="{A7F53DD9-966C-4CAB-AFB8-EC584EBC7006}"/>
          </ac:spMkLst>
        </pc:spChg>
        <pc:spChg chg="mod topLvl">
          <ac:chgData name="Filippo Acconcia" userId="844af49c-a8a0-47ac-a7dd-14a44b60cd18" providerId="ADAL" clId="{B609A75A-164F-4066-A006-F59E853DC491}" dt="2022-04-01T07:21:55.917" v="1070" actId="164"/>
          <ac:spMkLst>
            <pc:docMk/>
            <pc:sldMk cId="706034829" sldId="301"/>
            <ac:spMk id="207" creationId="{C9DEA52C-891A-4813-BD70-2C80ECF0DD2A}"/>
          </ac:spMkLst>
        </pc:spChg>
        <pc:spChg chg="mod topLvl">
          <ac:chgData name="Filippo Acconcia" userId="844af49c-a8a0-47ac-a7dd-14a44b60cd18" providerId="ADAL" clId="{B609A75A-164F-4066-A006-F59E853DC491}" dt="2022-04-01T07:21:55.917" v="1070" actId="164"/>
          <ac:spMkLst>
            <pc:docMk/>
            <pc:sldMk cId="706034829" sldId="301"/>
            <ac:spMk id="208" creationId="{6C92B3D1-6766-4EA7-B4CD-B54BFC5B7BB3}"/>
          </ac:spMkLst>
        </pc:spChg>
        <pc:spChg chg="mod topLvl">
          <ac:chgData name="Filippo Acconcia" userId="844af49c-a8a0-47ac-a7dd-14a44b60cd18" providerId="ADAL" clId="{B609A75A-164F-4066-A006-F59E853DC491}" dt="2022-04-01T07:21:55.917" v="1070" actId="164"/>
          <ac:spMkLst>
            <pc:docMk/>
            <pc:sldMk cId="706034829" sldId="301"/>
            <ac:spMk id="209" creationId="{84ECEE61-768F-42DB-A0E6-83FDE9421A7B}"/>
          </ac:spMkLst>
        </pc:spChg>
        <pc:spChg chg="del mod topLvl">
          <ac:chgData name="Filippo Acconcia" userId="844af49c-a8a0-47ac-a7dd-14a44b60cd18" providerId="ADAL" clId="{B609A75A-164F-4066-A006-F59E853DC491}" dt="2022-04-01T07:17:51.258" v="831" actId="478"/>
          <ac:spMkLst>
            <pc:docMk/>
            <pc:sldMk cId="706034829" sldId="301"/>
            <ac:spMk id="210" creationId="{CE465E17-7414-4B29-A2D0-D8056B0D5B01}"/>
          </ac:spMkLst>
        </pc:spChg>
        <pc:spChg chg="del mod topLvl">
          <ac:chgData name="Filippo Acconcia" userId="844af49c-a8a0-47ac-a7dd-14a44b60cd18" providerId="ADAL" clId="{B609A75A-164F-4066-A006-F59E853DC491}" dt="2022-04-01T07:17:51.258" v="831" actId="478"/>
          <ac:spMkLst>
            <pc:docMk/>
            <pc:sldMk cId="706034829" sldId="301"/>
            <ac:spMk id="211" creationId="{F236EBE1-8980-41D9-9C7F-97AFFD93D3E0}"/>
          </ac:spMkLst>
        </pc:spChg>
        <pc:spChg chg="del mod topLvl">
          <ac:chgData name="Filippo Acconcia" userId="844af49c-a8a0-47ac-a7dd-14a44b60cd18" providerId="ADAL" clId="{B609A75A-164F-4066-A006-F59E853DC491}" dt="2022-04-01T07:17:51.258" v="831" actId="478"/>
          <ac:spMkLst>
            <pc:docMk/>
            <pc:sldMk cId="706034829" sldId="301"/>
            <ac:spMk id="213" creationId="{38AB7C9D-BEE3-40A3-A734-5D29B9386E12}"/>
          </ac:spMkLst>
        </pc:spChg>
        <pc:spChg chg="del mod topLvl">
          <ac:chgData name="Filippo Acconcia" userId="844af49c-a8a0-47ac-a7dd-14a44b60cd18" providerId="ADAL" clId="{B609A75A-164F-4066-A006-F59E853DC491}" dt="2022-04-01T07:17:51.258" v="831" actId="478"/>
          <ac:spMkLst>
            <pc:docMk/>
            <pc:sldMk cId="706034829" sldId="301"/>
            <ac:spMk id="214" creationId="{6E290DA7-5FD8-4184-B4F9-4FF12241D497}"/>
          </ac:spMkLst>
        </pc:spChg>
        <pc:spChg chg="del mod topLvl">
          <ac:chgData name="Filippo Acconcia" userId="844af49c-a8a0-47ac-a7dd-14a44b60cd18" providerId="ADAL" clId="{B609A75A-164F-4066-A006-F59E853DC491}" dt="2022-04-01T07:17:51.258" v="831" actId="478"/>
          <ac:spMkLst>
            <pc:docMk/>
            <pc:sldMk cId="706034829" sldId="301"/>
            <ac:spMk id="215" creationId="{0C9F66BA-AEBD-409D-B1BD-292EB5442B87}"/>
          </ac:spMkLst>
        </pc:spChg>
        <pc:spChg chg="del mod topLvl">
          <ac:chgData name="Filippo Acconcia" userId="844af49c-a8a0-47ac-a7dd-14a44b60cd18" providerId="ADAL" clId="{B609A75A-164F-4066-A006-F59E853DC491}" dt="2022-04-01T07:17:51.258" v="831" actId="478"/>
          <ac:spMkLst>
            <pc:docMk/>
            <pc:sldMk cId="706034829" sldId="301"/>
            <ac:spMk id="216" creationId="{D18BF892-0C40-4553-B275-7526923B8DD3}"/>
          </ac:spMkLst>
        </pc:spChg>
        <pc:spChg chg="del mod topLvl">
          <ac:chgData name="Filippo Acconcia" userId="844af49c-a8a0-47ac-a7dd-14a44b60cd18" providerId="ADAL" clId="{B609A75A-164F-4066-A006-F59E853DC491}" dt="2022-04-01T07:17:51.258" v="831" actId="478"/>
          <ac:spMkLst>
            <pc:docMk/>
            <pc:sldMk cId="706034829" sldId="301"/>
            <ac:spMk id="217" creationId="{C904F944-73AE-4694-B5F5-CEA6A86CE031}"/>
          </ac:spMkLst>
        </pc:spChg>
        <pc:spChg chg="del mod topLvl">
          <ac:chgData name="Filippo Acconcia" userId="844af49c-a8a0-47ac-a7dd-14a44b60cd18" providerId="ADAL" clId="{B609A75A-164F-4066-A006-F59E853DC491}" dt="2022-04-01T07:17:51.258" v="831" actId="478"/>
          <ac:spMkLst>
            <pc:docMk/>
            <pc:sldMk cId="706034829" sldId="301"/>
            <ac:spMk id="218" creationId="{36C9DF8B-40E4-440C-B0E8-92E3F0D0EAE6}"/>
          </ac:spMkLst>
        </pc:spChg>
        <pc:spChg chg="mod">
          <ac:chgData name="Filippo Acconcia" userId="844af49c-a8a0-47ac-a7dd-14a44b60cd18" providerId="ADAL" clId="{B609A75A-164F-4066-A006-F59E853DC491}" dt="2022-04-01T07:16:14.808" v="787" actId="165"/>
          <ac:spMkLst>
            <pc:docMk/>
            <pc:sldMk cId="706034829" sldId="301"/>
            <ac:spMk id="227" creationId="{D2E0CD09-1F05-438C-B1FA-4F45783FB996}"/>
          </ac:spMkLst>
        </pc:spChg>
        <pc:spChg chg="mod">
          <ac:chgData name="Filippo Acconcia" userId="844af49c-a8a0-47ac-a7dd-14a44b60cd18" providerId="ADAL" clId="{B609A75A-164F-4066-A006-F59E853DC491}" dt="2022-04-01T07:16:14.808" v="787" actId="165"/>
          <ac:spMkLst>
            <pc:docMk/>
            <pc:sldMk cId="706034829" sldId="301"/>
            <ac:spMk id="229" creationId="{EDB8C0AF-6B51-458B-A642-E6422ABA086B}"/>
          </ac:spMkLst>
        </pc:spChg>
        <pc:spChg chg="mod">
          <ac:chgData name="Filippo Acconcia" userId="844af49c-a8a0-47ac-a7dd-14a44b60cd18" providerId="ADAL" clId="{B609A75A-164F-4066-A006-F59E853DC491}" dt="2022-04-01T07:16:14.808" v="787" actId="165"/>
          <ac:spMkLst>
            <pc:docMk/>
            <pc:sldMk cId="706034829" sldId="301"/>
            <ac:spMk id="231" creationId="{71C6FCCB-52BB-4DDF-8BE8-1AACF1DB684F}"/>
          </ac:spMkLst>
        </pc:spChg>
        <pc:spChg chg="mod topLvl">
          <ac:chgData name="Filippo Acconcia" userId="844af49c-a8a0-47ac-a7dd-14a44b60cd18" providerId="ADAL" clId="{B609A75A-164F-4066-A006-F59E853DC491}" dt="2022-04-01T07:20:45.163" v="1012" actId="164"/>
          <ac:spMkLst>
            <pc:docMk/>
            <pc:sldMk cId="706034829" sldId="301"/>
            <ac:spMk id="233" creationId="{D4A00E6D-BDBF-4584-9D5D-25B97CBAB94A}"/>
          </ac:spMkLst>
        </pc:spChg>
        <pc:spChg chg="mod">
          <ac:chgData name="Filippo Acconcia" userId="844af49c-a8a0-47ac-a7dd-14a44b60cd18" providerId="ADAL" clId="{B609A75A-164F-4066-A006-F59E853DC491}" dt="2022-04-01T07:16:14.808" v="787" actId="165"/>
          <ac:spMkLst>
            <pc:docMk/>
            <pc:sldMk cId="706034829" sldId="301"/>
            <ac:spMk id="235" creationId="{155998AB-3F9F-4D29-A845-B05D52F1FDF7}"/>
          </ac:spMkLst>
        </pc:spChg>
        <pc:spChg chg="mod">
          <ac:chgData name="Filippo Acconcia" userId="844af49c-a8a0-47ac-a7dd-14a44b60cd18" providerId="ADAL" clId="{B609A75A-164F-4066-A006-F59E853DC491}" dt="2022-04-01T07:16:14.808" v="787" actId="165"/>
          <ac:spMkLst>
            <pc:docMk/>
            <pc:sldMk cId="706034829" sldId="301"/>
            <ac:spMk id="237" creationId="{12F8F396-47AC-4571-B28B-AE338ACFACAF}"/>
          </ac:spMkLst>
        </pc:spChg>
        <pc:spChg chg="mod">
          <ac:chgData name="Filippo Acconcia" userId="844af49c-a8a0-47ac-a7dd-14a44b60cd18" providerId="ADAL" clId="{B609A75A-164F-4066-A006-F59E853DC491}" dt="2022-04-01T07:16:14.808" v="787" actId="165"/>
          <ac:spMkLst>
            <pc:docMk/>
            <pc:sldMk cId="706034829" sldId="301"/>
            <ac:spMk id="239" creationId="{3E45AA8C-E6CB-44E6-BD5F-1D0DE08436A7}"/>
          </ac:spMkLst>
        </pc:spChg>
        <pc:spChg chg="mod">
          <ac:chgData name="Filippo Acconcia" userId="844af49c-a8a0-47ac-a7dd-14a44b60cd18" providerId="ADAL" clId="{B609A75A-164F-4066-A006-F59E853DC491}" dt="2022-04-01T07:16:14.808" v="787" actId="165"/>
          <ac:spMkLst>
            <pc:docMk/>
            <pc:sldMk cId="706034829" sldId="301"/>
            <ac:spMk id="241" creationId="{9A73C7B6-0118-4038-AB8E-F4DE7254F251}"/>
          </ac:spMkLst>
        </pc:spChg>
        <pc:spChg chg="add mod">
          <ac:chgData name="Filippo Acconcia" userId="844af49c-a8a0-47ac-a7dd-14a44b60cd18" providerId="ADAL" clId="{B609A75A-164F-4066-A006-F59E853DC491}" dt="2022-04-01T07:21:55.917" v="1070" actId="164"/>
          <ac:spMkLst>
            <pc:docMk/>
            <pc:sldMk cId="706034829" sldId="301"/>
            <ac:spMk id="242" creationId="{0A12603A-3A86-491F-B48D-4FF1351902F6}"/>
          </ac:spMkLst>
        </pc:spChg>
        <pc:spChg chg="mod">
          <ac:chgData name="Filippo Acconcia" userId="844af49c-a8a0-47ac-a7dd-14a44b60cd18" providerId="ADAL" clId="{B609A75A-164F-4066-A006-F59E853DC491}" dt="2022-04-01T07:19:05.545" v="946"/>
          <ac:spMkLst>
            <pc:docMk/>
            <pc:sldMk cId="706034829" sldId="301"/>
            <ac:spMk id="245" creationId="{4D33DACC-F0EB-4E42-BA19-9C12A5C6EE96}"/>
          </ac:spMkLst>
        </pc:spChg>
        <pc:spChg chg="mod">
          <ac:chgData name="Filippo Acconcia" userId="844af49c-a8a0-47ac-a7dd-14a44b60cd18" providerId="ADAL" clId="{B609A75A-164F-4066-A006-F59E853DC491}" dt="2022-04-01T07:19:05.545" v="946"/>
          <ac:spMkLst>
            <pc:docMk/>
            <pc:sldMk cId="706034829" sldId="301"/>
            <ac:spMk id="246" creationId="{4040B9DE-23BC-45EB-92E8-BF4167B2E7FF}"/>
          </ac:spMkLst>
        </pc:spChg>
        <pc:spChg chg="mod">
          <ac:chgData name="Filippo Acconcia" userId="844af49c-a8a0-47ac-a7dd-14a44b60cd18" providerId="ADAL" clId="{B609A75A-164F-4066-A006-F59E853DC491}" dt="2022-04-01T07:19:05.545" v="946"/>
          <ac:spMkLst>
            <pc:docMk/>
            <pc:sldMk cId="706034829" sldId="301"/>
            <ac:spMk id="247" creationId="{D935481E-ABFB-4C50-A9F1-E0D8235D7C8F}"/>
          </ac:spMkLst>
        </pc:spChg>
        <pc:spChg chg="mod">
          <ac:chgData name="Filippo Acconcia" userId="844af49c-a8a0-47ac-a7dd-14a44b60cd18" providerId="ADAL" clId="{B609A75A-164F-4066-A006-F59E853DC491}" dt="2022-04-01T07:19:05.545" v="946"/>
          <ac:spMkLst>
            <pc:docMk/>
            <pc:sldMk cId="706034829" sldId="301"/>
            <ac:spMk id="248" creationId="{57CCDC4B-0B56-4193-AAA2-8142FD7973D6}"/>
          </ac:spMkLst>
        </pc:spChg>
        <pc:spChg chg="mod">
          <ac:chgData name="Filippo Acconcia" userId="844af49c-a8a0-47ac-a7dd-14a44b60cd18" providerId="ADAL" clId="{B609A75A-164F-4066-A006-F59E853DC491}" dt="2022-04-01T07:19:08.898" v="948"/>
          <ac:spMkLst>
            <pc:docMk/>
            <pc:sldMk cId="706034829" sldId="301"/>
            <ac:spMk id="250" creationId="{321C0E35-3C1C-457A-8608-62B37C78522C}"/>
          </ac:spMkLst>
        </pc:spChg>
        <pc:spChg chg="mod">
          <ac:chgData name="Filippo Acconcia" userId="844af49c-a8a0-47ac-a7dd-14a44b60cd18" providerId="ADAL" clId="{B609A75A-164F-4066-A006-F59E853DC491}" dt="2022-04-01T07:19:08.898" v="948"/>
          <ac:spMkLst>
            <pc:docMk/>
            <pc:sldMk cId="706034829" sldId="301"/>
            <ac:spMk id="251" creationId="{B2CC48C4-5B8A-4E7B-8796-008777CC42D2}"/>
          </ac:spMkLst>
        </pc:spChg>
        <pc:spChg chg="mod">
          <ac:chgData name="Filippo Acconcia" userId="844af49c-a8a0-47ac-a7dd-14a44b60cd18" providerId="ADAL" clId="{B609A75A-164F-4066-A006-F59E853DC491}" dt="2022-04-01T07:19:08.898" v="948"/>
          <ac:spMkLst>
            <pc:docMk/>
            <pc:sldMk cId="706034829" sldId="301"/>
            <ac:spMk id="252" creationId="{F30A35ED-2AEE-4DF8-B24E-DF3AC7702537}"/>
          </ac:spMkLst>
        </pc:spChg>
        <pc:spChg chg="mod">
          <ac:chgData name="Filippo Acconcia" userId="844af49c-a8a0-47ac-a7dd-14a44b60cd18" providerId="ADAL" clId="{B609A75A-164F-4066-A006-F59E853DC491}" dt="2022-04-01T07:19:08.898" v="948"/>
          <ac:spMkLst>
            <pc:docMk/>
            <pc:sldMk cId="706034829" sldId="301"/>
            <ac:spMk id="253" creationId="{A8BB8688-B58F-481F-9242-B589F6825BA7}"/>
          </ac:spMkLst>
        </pc:spChg>
        <pc:spChg chg="mod">
          <ac:chgData name="Filippo Acconcia" userId="844af49c-a8a0-47ac-a7dd-14a44b60cd18" providerId="ADAL" clId="{B609A75A-164F-4066-A006-F59E853DC491}" dt="2022-04-01T07:19:12.016" v="950"/>
          <ac:spMkLst>
            <pc:docMk/>
            <pc:sldMk cId="706034829" sldId="301"/>
            <ac:spMk id="255" creationId="{5375DAAC-7B32-4BD5-B6B8-1592C7855D86}"/>
          </ac:spMkLst>
        </pc:spChg>
        <pc:spChg chg="mod">
          <ac:chgData name="Filippo Acconcia" userId="844af49c-a8a0-47ac-a7dd-14a44b60cd18" providerId="ADAL" clId="{B609A75A-164F-4066-A006-F59E853DC491}" dt="2022-04-01T07:19:12.016" v="950"/>
          <ac:spMkLst>
            <pc:docMk/>
            <pc:sldMk cId="706034829" sldId="301"/>
            <ac:spMk id="256" creationId="{781D7A49-C8F9-4896-A83F-DC8FA0B1F049}"/>
          </ac:spMkLst>
        </pc:spChg>
        <pc:spChg chg="mod">
          <ac:chgData name="Filippo Acconcia" userId="844af49c-a8a0-47ac-a7dd-14a44b60cd18" providerId="ADAL" clId="{B609A75A-164F-4066-A006-F59E853DC491}" dt="2022-04-01T07:19:12.016" v="950"/>
          <ac:spMkLst>
            <pc:docMk/>
            <pc:sldMk cId="706034829" sldId="301"/>
            <ac:spMk id="257" creationId="{06ED8857-66EC-4960-8DD3-E59669B9E879}"/>
          </ac:spMkLst>
        </pc:spChg>
        <pc:spChg chg="mod">
          <ac:chgData name="Filippo Acconcia" userId="844af49c-a8a0-47ac-a7dd-14a44b60cd18" providerId="ADAL" clId="{B609A75A-164F-4066-A006-F59E853DC491}" dt="2022-04-01T07:19:12.016" v="950"/>
          <ac:spMkLst>
            <pc:docMk/>
            <pc:sldMk cId="706034829" sldId="301"/>
            <ac:spMk id="258" creationId="{95085925-2F0D-4C8B-8D66-68682CE1BBAF}"/>
          </ac:spMkLst>
        </pc:spChg>
        <pc:spChg chg="mod">
          <ac:chgData name="Filippo Acconcia" userId="844af49c-a8a0-47ac-a7dd-14a44b60cd18" providerId="ADAL" clId="{B609A75A-164F-4066-A006-F59E853DC491}" dt="2022-04-01T07:21:13.663" v="1035" actId="1037"/>
          <ac:spMkLst>
            <pc:docMk/>
            <pc:sldMk cId="706034829" sldId="301"/>
            <ac:spMk id="264" creationId="{69E3A460-09C0-4D23-9B18-DFCB6BD0C6A0}"/>
          </ac:spMkLst>
        </pc:spChg>
        <pc:spChg chg="mod">
          <ac:chgData name="Filippo Acconcia" userId="844af49c-a8a0-47ac-a7dd-14a44b60cd18" providerId="ADAL" clId="{B609A75A-164F-4066-A006-F59E853DC491}" dt="2022-04-01T07:21:22.533" v="1045" actId="1037"/>
          <ac:spMkLst>
            <pc:docMk/>
            <pc:sldMk cId="706034829" sldId="301"/>
            <ac:spMk id="267" creationId="{57633AA7-C645-4C2A-B711-079993EEAE38}"/>
          </ac:spMkLst>
        </pc:spChg>
        <pc:spChg chg="mod">
          <ac:chgData name="Filippo Acconcia" userId="844af49c-a8a0-47ac-a7dd-14a44b60cd18" providerId="ADAL" clId="{B609A75A-164F-4066-A006-F59E853DC491}" dt="2022-04-01T07:21:40.214" v="1064" actId="1037"/>
          <ac:spMkLst>
            <pc:docMk/>
            <pc:sldMk cId="706034829" sldId="301"/>
            <ac:spMk id="270" creationId="{C19B390E-622F-4126-A245-357E645EA16F}"/>
          </ac:spMkLst>
        </pc:spChg>
        <pc:spChg chg="add mod">
          <ac:chgData name="Filippo Acconcia" userId="844af49c-a8a0-47ac-a7dd-14a44b60cd18" providerId="ADAL" clId="{B609A75A-164F-4066-A006-F59E853DC491}" dt="2022-04-01T08:51:35.654" v="1215" actId="1037"/>
          <ac:spMkLst>
            <pc:docMk/>
            <pc:sldMk cId="706034829" sldId="301"/>
            <ac:spMk id="272" creationId="{1BBD55A0-98C2-47A1-90AF-09AF9F6E4108}"/>
          </ac:spMkLst>
        </pc:spChg>
        <pc:spChg chg="add mod">
          <ac:chgData name="Filippo Acconcia" userId="844af49c-a8a0-47ac-a7dd-14a44b60cd18" providerId="ADAL" clId="{B609A75A-164F-4066-A006-F59E853DC491}" dt="2022-04-01T08:51:20.966" v="1189" actId="1076"/>
          <ac:spMkLst>
            <pc:docMk/>
            <pc:sldMk cId="706034829" sldId="301"/>
            <ac:spMk id="273" creationId="{9369B27E-9BB3-4F12-94BD-4DA1474EFB38}"/>
          </ac:spMkLst>
        </pc:spChg>
        <pc:spChg chg="add mod">
          <ac:chgData name="Filippo Acconcia" userId="844af49c-a8a0-47ac-a7dd-14a44b60cd18" providerId="ADAL" clId="{B609A75A-164F-4066-A006-F59E853DC491}" dt="2022-04-01T08:51:35.654" v="1215" actId="1037"/>
          <ac:spMkLst>
            <pc:docMk/>
            <pc:sldMk cId="706034829" sldId="301"/>
            <ac:spMk id="274" creationId="{20230811-7E23-40C4-952A-4194E7890510}"/>
          </ac:spMkLst>
        </pc:spChg>
        <pc:spChg chg="mod topLvl">
          <ac:chgData name="Filippo Acconcia" userId="844af49c-a8a0-47ac-a7dd-14a44b60cd18" providerId="ADAL" clId="{B609A75A-164F-4066-A006-F59E853DC491}" dt="2022-04-01T07:56:07.323" v="1152" actId="164"/>
          <ac:spMkLst>
            <pc:docMk/>
            <pc:sldMk cId="706034829" sldId="301"/>
            <ac:spMk id="277" creationId="{2D739848-91AC-4E72-907E-56B7435B8532}"/>
          </ac:spMkLst>
        </pc:spChg>
        <pc:spChg chg="mod topLvl">
          <ac:chgData name="Filippo Acconcia" userId="844af49c-a8a0-47ac-a7dd-14a44b60cd18" providerId="ADAL" clId="{B609A75A-164F-4066-A006-F59E853DC491}" dt="2022-04-01T07:56:07.323" v="1152" actId="164"/>
          <ac:spMkLst>
            <pc:docMk/>
            <pc:sldMk cId="706034829" sldId="301"/>
            <ac:spMk id="278" creationId="{F80109B7-1D05-4B39-8AF2-D0C4CB7B2034}"/>
          </ac:spMkLst>
        </pc:spChg>
        <pc:spChg chg="mod topLvl">
          <ac:chgData name="Filippo Acconcia" userId="844af49c-a8a0-47ac-a7dd-14a44b60cd18" providerId="ADAL" clId="{B609A75A-164F-4066-A006-F59E853DC491}" dt="2022-04-01T07:56:07.323" v="1152" actId="164"/>
          <ac:spMkLst>
            <pc:docMk/>
            <pc:sldMk cId="706034829" sldId="301"/>
            <ac:spMk id="279" creationId="{59876370-C010-4BD0-89E4-C5013378D93F}"/>
          </ac:spMkLst>
        </pc:spChg>
        <pc:spChg chg="mod topLvl">
          <ac:chgData name="Filippo Acconcia" userId="844af49c-a8a0-47ac-a7dd-14a44b60cd18" providerId="ADAL" clId="{B609A75A-164F-4066-A006-F59E853DC491}" dt="2022-04-01T07:56:07.323" v="1152" actId="164"/>
          <ac:spMkLst>
            <pc:docMk/>
            <pc:sldMk cId="706034829" sldId="301"/>
            <ac:spMk id="280" creationId="{5B03F997-5322-43BA-A9D0-ABCA92366EE4}"/>
          </ac:spMkLst>
        </pc:spChg>
        <pc:spChg chg="del mod topLvl">
          <ac:chgData name="Filippo Acconcia" userId="844af49c-a8a0-47ac-a7dd-14a44b60cd18" providerId="ADAL" clId="{B609A75A-164F-4066-A006-F59E853DC491}" dt="2022-04-01T07:55:08.962" v="1108" actId="478"/>
          <ac:spMkLst>
            <pc:docMk/>
            <pc:sldMk cId="706034829" sldId="301"/>
            <ac:spMk id="281" creationId="{AE6456F5-332B-4858-B63F-3D0E8A5931A9}"/>
          </ac:spMkLst>
        </pc:spChg>
        <pc:spChg chg="del mod topLvl">
          <ac:chgData name="Filippo Acconcia" userId="844af49c-a8a0-47ac-a7dd-14a44b60cd18" providerId="ADAL" clId="{B609A75A-164F-4066-A006-F59E853DC491}" dt="2022-04-01T07:55:08.962" v="1108" actId="478"/>
          <ac:spMkLst>
            <pc:docMk/>
            <pc:sldMk cId="706034829" sldId="301"/>
            <ac:spMk id="282" creationId="{4B84B18F-F99F-4FEF-A16E-6F8D2CE7CF2D}"/>
          </ac:spMkLst>
        </pc:spChg>
        <pc:spChg chg="del mod topLvl">
          <ac:chgData name="Filippo Acconcia" userId="844af49c-a8a0-47ac-a7dd-14a44b60cd18" providerId="ADAL" clId="{B609A75A-164F-4066-A006-F59E853DC491}" dt="2022-04-01T07:55:08.962" v="1108" actId="478"/>
          <ac:spMkLst>
            <pc:docMk/>
            <pc:sldMk cId="706034829" sldId="301"/>
            <ac:spMk id="284" creationId="{B98F5B34-6F58-4AAC-8404-EF355097EC89}"/>
          </ac:spMkLst>
        </pc:spChg>
        <pc:spChg chg="del mod topLvl">
          <ac:chgData name="Filippo Acconcia" userId="844af49c-a8a0-47ac-a7dd-14a44b60cd18" providerId="ADAL" clId="{B609A75A-164F-4066-A006-F59E853DC491}" dt="2022-04-01T07:55:08.962" v="1108" actId="478"/>
          <ac:spMkLst>
            <pc:docMk/>
            <pc:sldMk cId="706034829" sldId="301"/>
            <ac:spMk id="285" creationId="{39EB89A8-7BC5-4C97-90FB-003531CD8BE2}"/>
          </ac:spMkLst>
        </pc:spChg>
        <pc:spChg chg="del mod topLvl">
          <ac:chgData name="Filippo Acconcia" userId="844af49c-a8a0-47ac-a7dd-14a44b60cd18" providerId="ADAL" clId="{B609A75A-164F-4066-A006-F59E853DC491}" dt="2022-04-01T07:55:08.962" v="1108" actId="478"/>
          <ac:spMkLst>
            <pc:docMk/>
            <pc:sldMk cId="706034829" sldId="301"/>
            <ac:spMk id="286" creationId="{E3148ECA-90BD-4CE2-88BE-9C7674501926}"/>
          </ac:spMkLst>
        </pc:spChg>
        <pc:spChg chg="del mod topLvl">
          <ac:chgData name="Filippo Acconcia" userId="844af49c-a8a0-47ac-a7dd-14a44b60cd18" providerId="ADAL" clId="{B609A75A-164F-4066-A006-F59E853DC491}" dt="2022-04-01T07:55:08.962" v="1108" actId="478"/>
          <ac:spMkLst>
            <pc:docMk/>
            <pc:sldMk cId="706034829" sldId="301"/>
            <ac:spMk id="287" creationId="{3CEF3344-9806-4119-9E32-A3E3CF48F81A}"/>
          </ac:spMkLst>
        </pc:spChg>
        <pc:spChg chg="mod">
          <ac:chgData name="Filippo Acconcia" userId="844af49c-a8a0-47ac-a7dd-14a44b60cd18" providerId="ADAL" clId="{B609A75A-164F-4066-A006-F59E853DC491}" dt="2022-04-01T07:53:58.119" v="1102" actId="165"/>
          <ac:spMkLst>
            <pc:docMk/>
            <pc:sldMk cId="706034829" sldId="301"/>
            <ac:spMk id="294" creationId="{8EA5E9CF-512B-478B-A31C-4664026725E9}"/>
          </ac:spMkLst>
        </pc:spChg>
        <pc:spChg chg="mod">
          <ac:chgData name="Filippo Acconcia" userId="844af49c-a8a0-47ac-a7dd-14a44b60cd18" providerId="ADAL" clId="{B609A75A-164F-4066-A006-F59E853DC491}" dt="2022-04-01T07:53:58.119" v="1102" actId="165"/>
          <ac:spMkLst>
            <pc:docMk/>
            <pc:sldMk cId="706034829" sldId="301"/>
            <ac:spMk id="296" creationId="{D34198B7-F3FA-4542-8993-03993920B33C}"/>
          </ac:spMkLst>
        </pc:spChg>
        <pc:spChg chg="mod">
          <ac:chgData name="Filippo Acconcia" userId="844af49c-a8a0-47ac-a7dd-14a44b60cd18" providerId="ADAL" clId="{B609A75A-164F-4066-A006-F59E853DC491}" dt="2022-04-01T07:53:58.119" v="1102" actId="165"/>
          <ac:spMkLst>
            <pc:docMk/>
            <pc:sldMk cId="706034829" sldId="301"/>
            <ac:spMk id="298" creationId="{D96FFBBA-DB2B-40E1-B472-B2D8DF7239BC}"/>
          </ac:spMkLst>
        </pc:spChg>
        <pc:spChg chg="mod">
          <ac:chgData name="Filippo Acconcia" userId="844af49c-a8a0-47ac-a7dd-14a44b60cd18" providerId="ADAL" clId="{B609A75A-164F-4066-A006-F59E853DC491}" dt="2022-04-01T07:53:58.119" v="1102" actId="165"/>
          <ac:spMkLst>
            <pc:docMk/>
            <pc:sldMk cId="706034829" sldId="301"/>
            <ac:spMk id="300" creationId="{EF8B4BFB-B5F0-4252-AC35-AC4218077FD5}"/>
          </ac:spMkLst>
        </pc:spChg>
        <pc:spChg chg="mod">
          <ac:chgData name="Filippo Acconcia" userId="844af49c-a8a0-47ac-a7dd-14a44b60cd18" providerId="ADAL" clId="{B609A75A-164F-4066-A006-F59E853DC491}" dt="2022-04-01T07:53:58.119" v="1102" actId="165"/>
          <ac:spMkLst>
            <pc:docMk/>
            <pc:sldMk cId="706034829" sldId="301"/>
            <ac:spMk id="302" creationId="{BC99CC3D-707F-4F07-806E-9AF2AAE7D309}"/>
          </ac:spMkLst>
        </pc:spChg>
        <pc:spChg chg="mod">
          <ac:chgData name="Filippo Acconcia" userId="844af49c-a8a0-47ac-a7dd-14a44b60cd18" providerId="ADAL" clId="{B609A75A-164F-4066-A006-F59E853DC491}" dt="2022-04-01T07:53:58.119" v="1102" actId="165"/>
          <ac:spMkLst>
            <pc:docMk/>
            <pc:sldMk cId="706034829" sldId="301"/>
            <ac:spMk id="304" creationId="{30DEF561-BCED-4A2B-9FBB-DD03F516C870}"/>
          </ac:spMkLst>
        </pc:spChg>
        <pc:grpChg chg="add del mod">
          <ac:chgData name="Filippo Acconcia" userId="844af49c-a8a0-47ac-a7dd-14a44b60cd18" providerId="ADAL" clId="{B609A75A-164F-4066-A006-F59E853DC491}" dt="2022-04-01T07:31:31.514" v="1087" actId="21"/>
          <ac:grpSpMkLst>
            <pc:docMk/>
            <pc:sldMk cId="706034829" sldId="301"/>
            <ac:grpSpMk id="3" creationId="{6B457B3F-0579-450D-A6A0-F6C5542FDC5D}"/>
          </ac:grpSpMkLst>
        </pc:grpChg>
        <pc:grpChg chg="add del mod">
          <ac:chgData name="Filippo Acconcia" userId="844af49c-a8a0-47ac-a7dd-14a44b60cd18" providerId="ADAL" clId="{B609A75A-164F-4066-A006-F59E853DC491}" dt="2022-04-01T07:31:29.756" v="1086" actId="478"/>
          <ac:grpSpMkLst>
            <pc:docMk/>
            <pc:sldMk cId="706034829" sldId="301"/>
            <ac:grpSpMk id="54" creationId="{53613709-DB41-4047-AF56-53F3AE1381BC}"/>
          </ac:grpSpMkLst>
        </pc:grpChg>
        <pc:grpChg chg="add del mod">
          <ac:chgData name="Filippo Acconcia" userId="844af49c-a8a0-47ac-a7dd-14a44b60cd18" providerId="ADAL" clId="{B609A75A-164F-4066-A006-F59E853DC491}" dt="2022-04-01T06:30:24.642" v="545" actId="165"/>
          <ac:grpSpMkLst>
            <pc:docMk/>
            <pc:sldMk cId="706034829" sldId="301"/>
            <ac:grpSpMk id="80" creationId="{BEFE8B52-9CA6-4761-A74D-3256751F50A7}"/>
          </ac:grpSpMkLst>
        </pc:grpChg>
        <pc:grpChg chg="add del mod">
          <ac:chgData name="Filippo Acconcia" userId="844af49c-a8a0-47ac-a7dd-14a44b60cd18" providerId="ADAL" clId="{B609A75A-164F-4066-A006-F59E853DC491}" dt="2022-04-01T06:42:31.228" v="747" actId="164"/>
          <ac:grpSpMkLst>
            <pc:docMk/>
            <pc:sldMk cId="706034829" sldId="301"/>
            <ac:grpSpMk id="102" creationId="{52443CD1-83FE-4719-BF3A-1C131D1F3E38}"/>
          </ac:grpSpMkLst>
        </pc:grpChg>
        <pc:grpChg chg="add mod">
          <ac:chgData name="Filippo Acconcia" userId="844af49c-a8a0-47ac-a7dd-14a44b60cd18" providerId="ADAL" clId="{B609A75A-164F-4066-A006-F59E853DC491}" dt="2022-04-01T06:42:31.228" v="747" actId="164"/>
          <ac:grpSpMkLst>
            <pc:docMk/>
            <pc:sldMk cId="706034829" sldId="301"/>
            <ac:grpSpMk id="103" creationId="{3C8BA307-BB78-4D39-B395-74D42021DF21}"/>
          </ac:grpSpMkLst>
        </pc:grpChg>
        <pc:grpChg chg="add mod">
          <ac:chgData name="Filippo Acconcia" userId="844af49c-a8a0-47ac-a7dd-14a44b60cd18" providerId="ADAL" clId="{B609A75A-164F-4066-A006-F59E853DC491}" dt="2022-04-01T06:42:31.228" v="747" actId="164"/>
          <ac:grpSpMkLst>
            <pc:docMk/>
            <pc:sldMk cId="706034829" sldId="301"/>
            <ac:grpSpMk id="106" creationId="{4AA33AE8-DF69-403A-8EF4-FBE061688CD1}"/>
          </ac:grpSpMkLst>
        </pc:grpChg>
        <pc:grpChg chg="add mod">
          <ac:chgData name="Filippo Acconcia" userId="844af49c-a8a0-47ac-a7dd-14a44b60cd18" providerId="ADAL" clId="{B609A75A-164F-4066-A006-F59E853DC491}" dt="2022-04-01T06:42:31.228" v="747" actId="164"/>
          <ac:grpSpMkLst>
            <pc:docMk/>
            <pc:sldMk cId="706034829" sldId="301"/>
            <ac:grpSpMk id="109" creationId="{59C48473-B5BA-4180-AA96-356E660744F7}"/>
          </ac:grpSpMkLst>
        </pc:grpChg>
        <pc:grpChg chg="add mod">
          <ac:chgData name="Filippo Acconcia" userId="844af49c-a8a0-47ac-a7dd-14a44b60cd18" providerId="ADAL" clId="{B609A75A-164F-4066-A006-F59E853DC491}" dt="2022-04-01T06:42:31.228" v="747" actId="164"/>
          <ac:grpSpMkLst>
            <pc:docMk/>
            <pc:sldMk cId="706034829" sldId="301"/>
            <ac:grpSpMk id="115" creationId="{88342D0A-4697-479C-B3E8-A32C37FEB50D}"/>
          </ac:grpSpMkLst>
        </pc:grpChg>
        <pc:grpChg chg="add mod">
          <ac:chgData name="Filippo Acconcia" userId="844af49c-a8a0-47ac-a7dd-14a44b60cd18" providerId="ADAL" clId="{B609A75A-164F-4066-A006-F59E853DC491}" dt="2022-04-01T06:42:31.228" v="747" actId="164"/>
          <ac:grpSpMkLst>
            <pc:docMk/>
            <pc:sldMk cId="706034829" sldId="301"/>
            <ac:grpSpMk id="116" creationId="{B08FB395-2352-4815-91B6-E274509B2C71}"/>
          </ac:grpSpMkLst>
        </pc:grpChg>
        <pc:grpChg chg="add mod">
          <ac:chgData name="Filippo Acconcia" userId="844af49c-a8a0-47ac-a7dd-14a44b60cd18" providerId="ADAL" clId="{B609A75A-164F-4066-A006-F59E853DC491}" dt="2022-04-01T06:42:31.228" v="747" actId="164"/>
          <ac:grpSpMkLst>
            <pc:docMk/>
            <pc:sldMk cId="706034829" sldId="301"/>
            <ac:grpSpMk id="119" creationId="{865245CE-E75A-4268-8453-FB47279E6FA3}"/>
          </ac:grpSpMkLst>
        </pc:grpChg>
        <pc:grpChg chg="add mod">
          <ac:chgData name="Filippo Acconcia" userId="844af49c-a8a0-47ac-a7dd-14a44b60cd18" providerId="ADAL" clId="{B609A75A-164F-4066-A006-F59E853DC491}" dt="2022-04-01T06:42:31.228" v="747" actId="164"/>
          <ac:grpSpMkLst>
            <pc:docMk/>
            <pc:sldMk cId="706034829" sldId="301"/>
            <ac:grpSpMk id="122" creationId="{AF475F74-B704-4E4A-8EED-7173B2A9E68B}"/>
          </ac:grpSpMkLst>
        </pc:grpChg>
        <pc:grpChg chg="add mod">
          <ac:chgData name="Filippo Acconcia" userId="844af49c-a8a0-47ac-a7dd-14a44b60cd18" providerId="ADAL" clId="{B609A75A-164F-4066-A006-F59E853DC491}" dt="2022-04-01T06:42:45.707" v="753" actId="12789"/>
          <ac:grpSpMkLst>
            <pc:docMk/>
            <pc:sldMk cId="706034829" sldId="301"/>
            <ac:grpSpMk id="126" creationId="{AC3A529B-3606-4A73-9A66-FAAAAF8CCE76}"/>
          </ac:grpSpMkLst>
        </pc:grpChg>
        <pc:grpChg chg="add del mod">
          <ac:chgData name="Filippo Acconcia" userId="844af49c-a8a0-47ac-a7dd-14a44b60cd18" providerId="ADAL" clId="{B609A75A-164F-4066-A006-F59E853DC491}" dt="2022-04-01T06:44:21.321" v="760" actId="165"/>
          <ac:grpSpMkLst>
            <pc:docMk/>
            <pc:sldMk cId="706034829" sldId="301"/>
            <ac:grpSpMk id="127" creationId="{A9AC4047-35AE-4051-BA96-B6DA60BD12AC}"/>
          </ac:grpSpMkLst>
        </pc:grpChg>
        <pc:grpChg chg="mod topLvl">
          <ac:chgData name="Filippo Acconcia" userId="844af49c-a8a0-47ac-a7dd-14a44b60cd18" providerId="ADAL" clId="{B609A75A-164F-4066-A006-F59E853DC491}" dt="2022-04-01T06:45:12.629" v="773" actId="164"/>
          <ac:grpSpMkLst>
            <pc:docMk/>
            <pc:sldMk cId="706034829" sldId="301"/>
            <ac:grpSpMk id="135" creationId="{368D347A-363A-4A32-ADCD-BFC7CE14E15F}"/>
          </ac:grpSpMkLst>
        </pc:grpChg>
        <pc:grpChg chg="mod topLvl">
          <ac:chgData name="Filippo Acconcia" userId="844af49c-a8a0-47ac-a7dd-14a44b60cd18" providerId="ADAL" clId="{B609A75A-164F-4066-A006-F59E853DC491}" dt="2022-04-01T06:45:12.629" v="773" actId="164"/>
          <ac:grpSpMkLst>
            <pc:docMk/>
            <pc:sldMk cId="706034829" sldId="301"/>
            <ac:grpSpMk id="142" creationId="{55CE88A2-8BC1-4881-BF21-C70EBA78EB56}"/>
          </ac:grpSpMkLst>
        </pc:grpChg>
        <pc:grpChg chg="mod topLvl">
          <ac:chgData name="Filippo Acconcia" userId="844af49c-a8a0-47ac-a7dd-14a44b60cd18" providerId="ADAL" clId="{B609A75A-164F-4066-A006-F59E853DC491}" dt="2022-04-01T06:45:12.629" v="773" actId="164"/>
          <ac:grpSpMkLst>
            <pc:docMk/>
            <pc:sldMk cId="706034829" sldId="301"/>
            <ac:grpSpMk id="143" creationId="{EF928566-E06E-4266-BC3D-2958FE4FE7E4}"/>
          </ac:grpSpMkLst>
        </pc:grpChg>
        <pc:grpChg chg="del mod topLvl">
          <ac:chgData name="Filippo Acconcia" userId="844af49c-a8a0-47ac-a7dd-14a44b60cd18" providerId="ADAL" clId="{B609A75A-164F-4066-A006-F59E853DC491}" dt="2022-04-01T06:44:39.700" v="765" actId="478"/>
          <ac:grpSpMkLst>
            <pc:docMk/>
            <pc:sldMk cId="706034829" sldId="301"/>
            <ac:grpSpMk id="144" creationId="{4D21E1F0-350B-4D95-9134-39428072012C}"/>
          </ac:grpSpMkLst>
        </pc:grpChg>
        <pc:grpChg chg="mod topLvl">
          <ac:chgData name="Filippo Acconcia" userId="844af49c-a8a0-47ac-a7dd-14a44b60cd18" providerId="ADAL" clId="{B609A75A-164F-4066-A006-F59E853DC491}" dt="2022-04-01T06:45:12.629" v="773" actId="164"/>
          <ac:grpSpMkLst>
            <pc:docMk/>
            <pc:sldMk cId="706034829" sldId="301"/>
            <ac:grpSpMk id="145" creationId="{8AF8057F-ABD3-4D51-8ADE-A57B1839418F}"/>
          </ac:grpSpMkLst>
        </pc:grpChg>
        <pc:grpChg chg="mod topLvl">
          <ac:chgData name="Filippo Acconcia" userId="844af49c-a8a0-47ac-a7dd-14a44b60cd18" providerId="ADAL" clId="{B609A75A-164F-4066-A006-F59E853DC491}" dt="2022-04-01T06:45:12.629" v="773" actId="164"/>
          <ac:grpSpMkLst>
            <pc:docMk/>
            <pc:sldMk cId="706034829" sldId="301"/>
            <ac:grpSpMk id="146" creationId="{9F1BD8F2-52E0-4274-9090-127D61D9AC81}"/>
          </ac:grpSpMkLst>
        </pc:grpChg>
        <pc:grpChg chg="mod topLvl">
          <ac:chgData name="Filippo Acconcia" userId="844af49c-a8a0-47ac-a7dd-14a44b60cd18" providerId="ADAL" clId="{B609A75A-164F-4066-A006-F59E853DC491}" dt="2022-04-01T06:45:12.629" v="773" actId="164"/>
          <ac:grpSpMkLst>
            <pc:docMk/>
            <pc:sldMk cId="706034829" sldId="301"/>
            <ac:grpSpMk id="147" creationId="{DEF1396D-432C-4F10-8628-C091C522E940}"/>
          </ac:grpSpMkLst>
        </pc:grpChg>
        <pc:grpChg chg="del mod topLvl">
          <ac:chgData name="Filippo Acconcia" userId="844af49c-a8a0-47ac-a7dd-14a44b60cd18" providerId="ADAL" clId="{B609A75A-164F-4066-A006-F59E853DC491}" dt="2022-04-01T06:44:52.582" v="767" actId="478"/>
          <ac:grpSpMkLst>
            <pc:docMk/>
            <pc:sldMk cId="706034829" sldId="301"/>
            <ac:grpSpMk id="148" creationId="{D7FBD8C2-E635-45A6-B20B-F42CA21D1064}"/>
          </ac:grpSpMkLst>
        </pc:grpChg>
        <pc:grpChg chg="add mod">
          <ac:chgData name="Filippo Acconcia" userId="844af49c-a8a0-47ac-a7dd-14a44b60cd18" providerId="ADAL" clId="{B609A75A-164F-4066-A006-F59E853DC491}" dt="2022-04-01T06:45:12.629" v="773" actId="164"/>
          <ac:grpSpMkLst>
            <pc:docMk/>
            <pc:sldMk cId="706034829" sldId="301"/>
            <ac:grpSpMk id="167" creationId="{5B70D7B7-B254-460E-A755-3476FAC47228}"/>
          </ac:grpSpMkLst>
        </pc:grpChg>
        <pc:grpChg chg="add del mod">
          <ac:chgData name="Filippo Acconcia" userId="844af49c-a8a0-47ac-a7dd-14a44b60cd18" providerId="ADAL" clId="{B609A75A-164F-4066-A006-F59E853DC491}" dt="2022-04-01T07:17:39.924" v="828" actId="165"/>
          <ac:grpSpMkLst>
            <pc:docMk/>
            <pc:sldMk cId="706034829" sldId="301"/>
            <ac:grpSpMk id="170" creationId="{876B8EB9-420C-4A89-A120-B868EBB25BCB}"/>
          </ac:grpSpMkLst>
        </pc:grpChg>
        <pc:grpChg chg="del mod topLvl">
          <ac:chgData name="Filippo Acconcia" userId="844af49c-a8a0-47ac-a7dd-14a44b60cd18" providerId="ADAL" clId="{B609A75A-164F-4066-A006-F59E853DC491}" dt="2022-04-01T07:17:42.043" v="829" actId="165"/>
          <ac:grpSpMkLst>
            <pc:docMk/>
            <pc:sldMk cId="706034829" sldId="301"/>
            <ac:grpSpMk id="171" creationId="{9BB917B8-EE14-4294-9965-58A818B3F7AF}"/>
          </ac:grpSpMkLst>
        </pc:grpChg>
        <pc:grpChg chg="del mod topLvl">
          <ac:chgData name="Filippo Acconcia" userId="844af49c-a8a0-47ac-a7dd-14a44b60cd18" providerId="ADAL" clId="{B609A75A-164F-4066-A006-F59E853DC491}" dt="2022-04-01T07:17:42.043" v="829" actId="165"/>
          <ac:grpSpMkLst>
            <pc:docMk/>
            <pc:sldMk cId="706034829" sldId="301"/>
            <ac:grpSpMk id="172" creationId="{09FFC748-E6FA-4945-8AC9-741800613C58}"/>
          </ac:grpSpMkLst>
        </pc:grpChg>
        <pc:grpChg chg="add del mod">
          <ac:chgData name="Filippo Acconcia" userId="844af49c-a8a0-47ac-a7dd-14a44b60cd18" providerId="ADAL" clId="{B609A75A-164F-4066-A006-F59E853DC491}" dt="2022-04-01T07:16:14.808" v="787" actId="165"/>
          <ac:grpSpMkLst>
            <pc:docMk/>
            <pc:sldMk cId="706034829" sldId="301"/>
            <ac:grpSpMk id="204" creationId="{217C4BAC-D6E6-46C5-8B3C-A762D055E479}"/>
          </ac:grpSpMkLst>
        </pc:grpChg>
        <pc:grpChg chg="del mod topLvl">
          <ac:chgData name="Filippo Acconcia" userId="844af49c-a8a0-47ac-a7dd-14a44b60cd18" providerId="ADAL" clId="{B609A75A-164F-4066-A006-F59E853DC491}" dt="2022-04-01T07:17:48.051" v="830" actId="478"/>
          <ac:grpSpMkLst>
            <pc:docMk/>
            <pc:sldMk cId="706034829" sldId="301"/>
            <ac:grpSpMk id="212" creationId="{C2018FE9-EE44-438C-A5EB-B4EABF593E08}"/>
          </ac:grpSpMkLst>
        </pc:grpChg>
        <pc:grpChg chg="del mod topLvl">
          <ac:chgData name="Filippo Acconcia" userId="844af49c-a8a0-47ac-a7dd-14a44b60cd18" providerId="ADAL" clId="{B609A75A-164F-4066-A006-F59E853DC491}" dt="2022-04-01T07:17:48.051" v="830" actId="478"/>
          <ac:grpSpMkLst>
            <pc:docMk/>
            <pc:sldMk cId="706034829" sldId="301"/>
            <ac:grpSpMk id="219" creationId="{80A3263E-4F2C-42BC-9D92-F3A0E8854E91}"/>
          </ac:grpSpMkLst>
        </pc:grpChg>
        <pc:grpChg chg="del mod topLvl">
          <ac:chgData name="Filippo Acconcia" userId="844af49c-a8a0-47ac-a7dd-14a44b60cd18" providerId="ADAL" clId="{B609A75A-164F-4066-A006-F59E853DC491}" dt="2022-04-01T07:17:48.051" v="830" actId="478"/>
          <ac:grpSpMkLst>
            <pc:docMk/>
            <pc:sldMk cId="706034829" sldId="301"/>
            <ac:grpSpMk id="220" creationId="{DCF8748F-D7A2-4C2F-8888-186034ED707B}"/>
          </ac:grpSpMkLst>
        </pc:grpChg>
        <pc:grpChg chg="del mod topLvl">
          <ac:chgData name="Filippo Acconcia" userId="844af49c-a8a0-47ac-a7dd-14a44b60cd18" providerId="ADAL" clId="{B609A75A-164F-4066-A006-F59E853DC491}" dt="2022-04-01T07:17:48.051" v="830" actId="478"/>
          <ac:grpSpMkLst>
            <pc:docMk/>
            <pc:sldMk cId="706034829" sldId="301"/>
            <ac:grpSpMk id="221" creationId="{249B61EC-3BCD-495E-B590-D504B86DF4D1}"/>
          </ac:grpSpMkLst>
        </pc:grpChg>
        <pc:grpChg chg="del mod topLvl">
          <ac:chgData name="Filippo Acconcia" userId="844af49c-a8a0-47ac-a7dd-14a44b60cd18" providerId="ADAL" clId="{B609A75A-164F-4066-A006-F59E853DC491}" dt="2022-04-01T07:20:01.269" v="959" actId="165"/>
          <ac:grpSpMkLst>
            <pc:docMk/>
            <pc:sldMk cId="706034829" sldId="301"/>
            <ac:grpSpMk id="222" creationId="{66EA0336-94FA-4C41-A427-1E9A4220E908}"/>
          </ac:grpSpMkLst>
        </pc:grpChg>
        <pc:grpChg chg="del mod topLvl">
          <ac:chgData name="Filippo Acconcia" userId="844af49c-a8a0-47ac-a7dd-14a44b60cd18" providerId="ADAL" clId="{B609A75A-164F-4066-A006-F59E853DC491}" dt="2022-04-01T07:31:48.539" v="1091" actId="478"/>
          <ac:grpSpMkLst>
            <pc:docMk/>
            <pc:sldMk cId="706034829" sldId="301"/>
            <ac:grpSpMk id="223" creationId="{2AAB64AC-8FDB-4579-9D65-1E86E704ECBB}"/>
          </ac:grpSpMkLst>
        </pc:grpChg>
        <pc:grpChg chg="del mod topLvl">
          <ac:chgData name="Filippo Acconcia" userId="844af49c-a8a0-47ac-a7dd-14a44b60cd18" providerId="ADAL" clId="{B609A75A-164F-4066-A006-F59E853DC491}" dt="2022-04-01T07:31:48.539" v="1091" actId="478"/>
          <ac:grpSpMkLst>
            <pc:docMk/>
            <pc:sldMk cId="706034829" sldId="301"/>
            <ac:grpSpMk id="224" creationId="{C4C53CA1-254B-4AA7-A5C7-FEA2AC373550}"/>
          </ac:grpSpMkLst>
        </pc:grpChg>
        <pc:grpChg chg="del mod topLvl">
          <ac:chgData name="Filippo Acconcia" userId="844af49c-a8a0-47ac-a7dd-14a44b60cd18" providerId="ADAL" clId="{B609A75A-164F-4066-A006-F59E853DC491}" dt="2022-04-01T07:31:48.539" v="1091" actId="478"/>
          <ac:grpSpMkLst>
            <pc:docMk/>
            <pc:sldMk cId="706034829" sldId="301"/>
            <ac:grpSpMk id="225" creationId="{73334595-4371-4754-AF8A-682EEA6E3A76}"/>
          </ac:grpSpMkLst>
        </pc:grpChg>
        <pc:grpChg chg="add mod">
          <ac:chgData name="Filippo Acconcia" userId="844af49c-a8a0-47ac-a7dd-14a44b60cd18" providerId="ADAL" clId="{B609A75A-164F-4066-A006-F59E853DC491}" dt="2022-04-01T07:21:55.917" v="1070" actId="164"/>
          <ac:grpSpMkLst>
            <pc:docMk/>
            <pc:sldMk cId="706034829" sldId="301"/>
            <ac:grpSpMk id="243" creationId="{A519A47A-7556-4C9A-A913-3E43868FFEFF}"/>
          </ac:grpSpMkLst>
        </pc:grpChg>
        <pc:grpChg chg="add mod">
          <ac:chgData name="Filippo Acconcia" userId="844af49c-a8a0-47ac-a7dd-14a44b60cd18" providerId="ADAL" clId="{B609A75A-164F-4066-A006-F59E853DC491}" dt="2022-04-01T07:21:55.917" v="1070" actId="164"/>
          <ac:grpSpMkLst>
            <pc:docMk/>
            <pc:sldMk cId="706034829" sldId="301"/>
            <ac:grpSpMk id="244" creationId="{4BE32831-0C41-4EBD-BC24-A2BA1D96D182}"/>
          </ac:grpSpMkLst>
        </pc:grpChg>
        <pc:grpChg chg="add mod">
          <ac:chgData name="Filippo Acconcia" userId="844af49c-a8a0-47ac-a7dd-14a44b60cd18" providerId="ADAL" clId="{B609A75A-164F-4066-A006-F59E853DC491}" dt="2022-04-01T07:21:55.917" v="1070" actId="164"/>
          <ac:grpSpMkLst>
            <pc:docMk/>
            <pc:sldMk cId="706034829" sldId="301"/>
            <ac:grpSpMk id="249" creationId="{9E0F502F-366D-4B90-AD92-8D5B091A828C}"/>
          </ac:grpSpMkLst>
        </pc:grpChg>
        <pc:grpChg chg="add mod">
          <ac:chgData name="Filippo Acconcia" userId="844af49c-a8a0-47ac-a7dd-14a44b60cd18" providerId="ADAL" clId="{B609A75A-164F-4066-A006-F59E853DC491}" dt="2022-04-01T07:21:55.917" v="1070" actId="164"/>
          <ac:grpSpMkLst>
            <pc:docMk/>
            <pc:sldMk cId="706034829" sldId="301"/>
            <ac:grpSpMk id="254" creationId="{80220653-9845-4EFB-86E9-8B85A1E519AC}"/>
          </ac:grpSpMkLst>
        </pc:grpChg>
        <pc:grpChg chg="add mod">
          <ac:chgData name="Filippo Acconcia" userId="844af49c-a8a0-47ac-a7dd-14a44b60cd18" providerId="ADAL" clId="{B609A75A-164F-4066-A006-F59E853DC491}" dt="2022-04-01T07:21:55.917" v="1070" actId="164"/>
          <ac:grpSpMkLst>
            <pc:docMk/>
            <pc:sldMk cId="706034829" sldId="301"/>
            <ac:grpSpMk id="261" creationId="{553C324E-DAFA-4D1E-810C-72E1A8692F9A}"/>
          </ac:grpSpMkLst>
        </pc:grpChg>
        <pc:grpChg chg="add mod">
          <ac:chgData name="Filippo Acconcia" userId="844af49c-a8a0-47ac-a7dd-14a44b60cd18" providerId="ADAL" clId="{B609A75A-164F-4066-A006-F59E853DC491}" dt="2022-04-01T07:21:55.917" v="1070" actId="164"/>
          <ac:grpSpMkLst>
            <pc:docMk/>
            <pc:sldMk cId="706034829" sldId="301"/>
            <ac:grpSpMk id="262" creationId="{BD2DCBE6-606D-4A5D-A3A7-3CBD2676E9A2}"/>
          </ac:grpSpMkLst>
        </pc:grpChg>
        <pc:grpChg chg="add mod">
          <ac:chgData name="Filippo Acconcia" userId="844af49c-a8a0-47ac-a7dd-14a44b60cd18" providerId="ADAL" clId="{B609A75A-164F-4066-A006-F59E853DC491}" dt="2022-04-01T07:21:55.917" v="1070" actId="164"/>
          <ac:grpSpMkLst>
            <pc:docMk/>
            <pc:sldMk cId="706034829" sldId="301"/>
            <ac:grpSpMk id="265" creationId="{7A4DF4F0-FD3F-4D5E-938F-66D94441280C}"/>
          </ac:grpSpMkLst>
        </pc:grpChg>
        <pc:grpChg chg="add mod">
          <ac:chgData name="Filippo Acconcia" userId="844af49c-a8a0-47ac-a7dd-14a44b60cd18" providerId="ADAL" clId="{B609A75A-164F-4066-A006-F59E853DC491}" dt="2022-04-01T07:21:55.917" v="1070" actId="164"/>
          <ac:grpSpMkLst>
            <pc:docMk/>
            <pc:sldMk cId="706034829" sldId="301"/>
            <ac:grpSpMk id="268" creationId="{910AC7A8-86E7-4503-803C-27571A9BBD65}"/>
          </ac:grpSpMkLst>
        </pc:grpChg>
        <pc:grpChg chg="add mod">
          <ac:chgData name="Filippo Acconcia" userId="844af49c-a8a0-47ac-a7dd-14a44b60cd18" providerId="ADAL" clId="{B609A75A-164F-4066-A006-F59E853DC491}" dt="2022-04-01T08:51:27.984" v="1211" actId="1035"/>
          <ac:grpSpMkLst>
            <pc:docMk/>
            <pc:sldMk cId="706034829" sldId="301"/>
            <ac:grpSpMk id="271" creationId="{30715158-9BBA-4454-A5EE-144388B7ED34}"/>
          </ac:grpSpMkLst>
        </pc:grpChg>
        <pc:grpChg chg="add del mod">
          <ac:chgData name="Filippo Acconcia" userId="844af49c-a8a0-47ac-a7dd-14a44b60cd18" providerId="ADAL" clId="{B609A75A-164F-4066-A006-F59E853DC491}" dt="2022-04-01T07:53:58.119" v="1102" actId="165"/>
          <ac:grpSpMkLst>
            <pc:docMk/>
            <pc:sldMk cId="706034829" sldId="301"/>
            <ac:grpSpMk id="275" creationId="{3898808B-6C6D-4228-9DD9-C60A9FA54751}"/>
          </ac:grpSpMkLst>
        </pc:grpChg>
        <pc:grpChg chg="del mod topLvl">
          <ac:chgData name="Filippo Acconcia" userId="844af49c-a8a0-47ac-a7dd-14a44b60cd18" providerId="ADAL" clId="{B609A75A-164F-4066-A006-F59E853DC491}" dt="2022-04-01T07:55:08.962" v="1108" actId="478"/>
          <ac:grpSpMkLst>
            <pc:docMk/>
            <pc:sldMk cId="706034829" sldId="301"/>
            <ac:grpSpMk id="283" creationId="{4BD3375C-97DD-4AB6-B527-55E23EF26384}"/>
          </ac:grpSpMkLst>
        </pc:grpChg>
        <pc:grpChg chg="del mod topLvl">
          <ac:chgData name="Filippo Acconcia" userId="844af49c-a8a0-47ac-a7dd-14a44b60cd18" providerId="ADAL" clId="{B609A75A-164F-4066-A006-F59E853DC491}" dt="2022-04-01T07:55:08.962" v="1108" actId="478"/>
          <ac:grpSpMkLst>
            <pc:docMk/>
            <pc:sldMk cId="706034829" sldId="301"/>
            <ac:grpSpMk id="288" creationId="{BA9C094E-9B43-4E18-B824-CE26F9F3C468}"/>
          </ac:grpSpMkLst>
        </pc:grpChg>
        <pc:grpChg chg="del mod topLvl">
          <ac:chgData name="Filippo Acconcia" userId="844af49c-a8a0-47ac-a7dd-14a44b60cd18" providerId="ADAL" clId="{B609A75A-164F-4066-A006-F59E853DC491}" dt="2022-04-01T07:55:08.962" v="1108" actId="478"/>
          <ac:grpSpMkLst>
            <pc:docMk/>
            <pc:sldMk cId="706034829" sldId="301"/>
            <ac:grpSpMk id="289" creationId="{26F7172D-BDFA-4FCD-86A0-ADD298949AFE}"/>
          </ac:grpSpMkLst>
        </pc:grpChg>
        <pc:grpChg chg="del mod topLvl">
          <ac:chgData name="Filippo Acconcia" userId="844af49c-a8a0-47ac-a7dd-14a44b60cd18" providerId="ADAL" clId="{B609A75A-164F-4066-A006-F59E853DC491}" dt="2022-04-01T07:55:47.586" v="1142" actId="478"/>
          <ac:grpSpMkLst>
            <pc:docMk/>
            <pc:sldMk cId="706034829" sldId="301"/>
            <ac:grpSpMk id="290" creationId="{DD8B4068-DD10-40B1-A05A-F52B024F01BC}"/>
          </ac:grpSpMkLst>
        </pc:grpChg>
        <pc:grpChg chg="del mod topLvl">
          <ac:chgData name="Filippo Acconcia" userId="844af49c-a8a0-47ac-a7dd-14a44b60cd18" providerId="ADAL" clId="{B609A75A-164F-4066-A006-F59E853DC491}" dt="2022-04-01T07:55:47.586" v="1142" actId="478"/>
          <ac:grpSpMkLst>
            <pc:docMk/>
            <pc:sldMk cId="706034829" sldId="301"/>
            <ac:grpSpMk id="291" creationId="{07486FB1-A5CC-4002-B349-5DBCEC1087C8}"/>
          </ac:grpSpMkLst>
        </pc:grpChg>
        <pc:grpChg chg="del mod topLvl">
          <ac:chgData name="Filippo Acconcia" userId="844af49c-a8a0-47ac-a7dd-14a44b60cd18" providerId="ADAL" clId="{B609A75A-164F-4066-A006-F59E853DC491}" dt="2022-04-01T07:55:47.586" v="1142" actId="478"/>
          <ac:grpSpMkLst>
            <pc:docMk/>
            <pc:sldMk cId="706034829" sldId="301"/>
            <ac:grpSpMk id="292" creationId="{22978EF6-A4C2-481E-943A-30CB56C90FDC}"/>
          </ac:grpSpMkLst>
        </pc:grpChg>
        <pc:grpChg chg="add mod">
          <ac:chgData name="Filippo Acconcia" userId="844af49c-a8a0-47ac-a7dd-14a44b60cd18" providerId="ADAL" clId="{B609A75A-164F-4066-A006-F59E853DC491}" dt="2022-04-01T08:51:15.863" v="1187" actId="1076"/>
          <ac:grpSpMkLst>
            <pc:docMk/>
            <pc:sldMk cId="706034829" sldId="301"/>
            <ac:grpSpMk id="306" creationId="{A65B5E4D-80A0-4206-9F58-64150E916510}"/>
          </ac:grpSpMkLst>
        </pc:grpChg>
        <pc:picChg chg="mod">
          <ac:chgData name="Filippo Acconcia" userId="844af49c-a8a0-47ac-a7dd-14a44b60cd18" providerId="ADAL" clId="{B609A75A-164F-4066-A006-F59E853DC491}" dt="2022-03-28T07:31:37.822" v="210"/>
          <ac:picMkLst>
            <pc:docMk/>
            <pc:sldMk cId="706034829" sldId="301"/>
            <ac:picMk id="4" creationId="{415BC4E7-E3CA-43B9-9814-6CE2648A4AA8}"/>
          </ac:picMkLst>
        </pc:picChg>
        <pc:picChg chg="mod">
          <ac:chgData name="Filippo Acconcia" userId="844af49c-a8a0-47ac-a7dd-14a44b60cd18" providerId="ADAL" clId="{B609A75A-164F-4066-A006-F59E853DC491}" dt="2022-03-28T07:31:37.822" v="210"/>
          <ac:picMkLst>
            <pc:docMk/>
            <pc:sldMk cId="706034829" sldId="301"/>
            <ac:picMk id="55" creationId="{0E30DB2B-ECC0-4FA0-A97D-1A44C24AFECF}"/>
          </ac:picMkLst>
        </pc:picChg>
        <pc:picChg chg="del mod topLvl">
          <ac:chgData name="Filippo Acconcia" userId="844af49c-a8a0-47ac-a7dd-14a44b60cd18" providerId="ADAL" clId="{B609A75A-164F-4066-A006-F59E853DC491}" dt="2022-04-01T06:31:01.598" v="550" actId="478"/>
          <ac:picMkLst>
            <pc:docMk/>
            <pc:sldMk cId="706034829" sldId="301"/>
            <ac:picMk id="81" creationId="{AC253776-9329-4A65-BA7A-07429FB85544}"/>
          </ac:picMkLst>
        </pc:picChg>
        <pc:picChg chg="mod ord">
          <ac:chgData name="Filippo Acconcia" userId="844af49c-a8a0-47ac-a7dd-14a44b60cd18" providerId="ADAL" clId="{B609A75A-164F-4066-A006-F59E853DC491}" dt="2022-04-01T06:42:31.228" v="747" actId="164"/>
          <ac:picMkLst>
            <pc:docMk/>
            <pc:sldMk cId="706034829" sldId="301"/>
            <ac:picMk id="95" creationId="{96EB1645-5E89-4C93-890F-504ABF9143F8}"/>
          </ac:picMkLst>
        </pc:picChg>
        <pc:picChg chg="del mod topLvl">
          <ac:chgData name="Filippo Acconcia" userId="844af49c-a8a0-47ac-a7dd-14a44b60cd18" providerId="ADAL" clId="{B609A75A-164F-4066-A006-F59E853DC491}" dt="2022-04-01T06:44:32.099" v="763" actId="478"/>
          <ac:picMkLst>
            <pc:docMk/>
            <pc:sldMk cId="706034829" sldId="301"/>
            <ac:picMk id="128" creationId="{8E6A62FC-C5EE-43AA-A505-14B32056C63A}"/>
          </ac:picMkLst>
        </pc:picChg>
        <pc:picChg chg="mod ord">
          <ac:chgData name="Filippo Acconcia" userId="844af49c-a8a0-47ac-a7dd-14a44b60cd18" providerId="ADAL" clId="{B609A75A-164F-4066-A006-F59E853DC491}" dt="2022-04-01T06:45:12.629" v="773" actId="164"/>
          <ac:picMkLst>
            <pc:docMk/>
            <pc:sldMk cId="706034829" sldId="301"/>
            <ac:picMk id="166" creationId="{06854DB8-1A58-491B-9830-304B666A6974}"/>
          </ac:picMkLst>
        </pc:picChg>
        <pc:picChg chg="del mod topLvl">
          <ac:chgData name="Filippo Acconcia" userId="844af49c-a8a0-47ac-a7dd-14a44b60cd18" providerId="ADAL" clId="{B609A75A-164F-4066-A006-F59E853DC491}" dt="2022-04-01T07:56:09.346" v="1153" actId="478"/>
          <ac:picMkLst>
            <pc:docMk/>
            <pc:sldMk cId="706034829" sldId="301"/>
            <ac:picMk id="173" creationId="{98505861-168E-43EF-B205-4ACA4FE5D0C2}"/>
          </ac:picMkLst>
        </pc:picChg>
        <pc:picChg chg="del mod topLvl">
          <ac:chgData name="Filippo Acconcia" userId="844af49c-a8a0-47ac-a7dd-14a44b60cd18" providerId="ADAL" clId="{B609A75A-164F-4066-A006-F59E853DC491}" dt="2022-04-01T07:56:09.346" v="1153" actId="478"/>
          <ac:picMkLst>
            <pc:docMk/>
            <pc:sldMk cId="706034829" sldId="301"/>
            <ac:picMk id="174" creationId="{C5C57F8C-8A17-466C-83D5-1123DEB6FB33}"/>
          </ac:picMkLst>
        </pc:picChg>
        <pc:picChg chg="del mod topLvl">
          <ac:chgData name="Filippo Acconcia" userId="844af49c-a8a0-47ac-a7dd-14a44b60cd18" providerId="ADAL" clId="{B609A75A-164F-4066-A006-F59E853DC491}" dt="2022-04-01T07:56:09.346" v="1153" actId="478"/>
          <ac:picMkLst>
            <pc:docMk/>
            <pc:sldMk cId="706034829" sldId="301"/>
            <ac:picMk id="175" creationId="{C6428FAB-83A1-49B8-847B-33843429E8D7}"/>
          </ac:picMkLst>
        </pc:picChg>
        <pc:picChg chg="del mod topLvl">
          <ac:chgData name="Filippo Acconcia" userId="844af49c-a8a0-47ac-a7dd-14a44b60cd18" providerId="ADAL" clId="{B609A75A-164F-4066-A006-F59E853DC491}" dt="2022-04-01T07:19:27.251" v="955" actId="478"/>
          <ac:picMkLst>
            <pc:docMk/>
            <pc:sldMk cId="706034829" sldId="301"/>
            <ac:picMk id="197" creationId="{CBF01A15-AFDD-4C5F-9F68-14661D81BCE0}"/>
          </ac:picMkLst>
        </pc:picChg>
        <pc:picChg chg="del mod topLvl">
          <ac:chgData name="Filippo Acconcia" userId="844af49c-a8a0-47ac-a7dd-14a44b60cd18" providerId="ADAL" clId="{B609A75A-164F-4066-A006-F59E853DC491}" dt="2022-04-01T07:19:27.251" v="955" actId="478"/>
          <ac:picMkLst>
            <pc:docMk/>
            <pc:sldMk cId="706034829" sldId="301"/>
            <ac:picMk id="198" creationId="{AAA58774-5478-4410-8DFF-3533474E0E94}"/>
          </ac:picMkLst>
        </pc:picChg>
        <pc:picChg chg="del mod topLvl">
          <ac:chgData name="Filippo Acconcia" userId="844af49c-a8a0-47ac-a7dd-14a44b60cd18" providerId="ADAL" clId="{B609A75A-164F-4066-A006-F59E853DC491}" dt="2022-04-01T07:19:27.251" v="955" actId="478"/>
          <ac:picMkLst>
            <pc:docMk/>
            <pc:sldMk cId="706034829" sldId="301"/>
            <ac:picMk id="199" creationId="{CFECDCAF-E878-429B-BD66-E9C7931845F5}"/>
          </ac:picMkLst>
        </pc:picChg>
        <pc:picChg chg="del mod topLvl">
          <ac:chgData name="Filippo Acconcia" userId="844af49c-a8a0-47ac-a7dd-14a44b60cd18" providerId="ADAL" clId="{B609A75A-164F-4066-A006-F59E853DC491}" dt="2022-04-01T07:19:27.251" v="955" actId="478"/>
          <ac:picMkLst>
            <pc:docMk/>
            <pc:sldMk cId="706034829" sldId="301"/>
            <ac:picMk id="200" creationId="{3EDAE9FB-5BEA-40E6-8B5D-65A6E4878F34}"/>
          </ac:picMkLst>
        </pc:picChg>
        <pc:picChg chg="del mod topLvl">
          <ac:chgData name="Filippo Acconcia" userId="844af49c-a8a0-47ac-a7dd-14a44b60cd18" providerId="ADAL" clId="{B609A75A-164F-4066-A006-F59E853DC491}" dt="2022-04-01T07:19:27.251" v="955" actId="478"/>
          <ac:picMkLst>
            <pc:docMk/>
            <pc:sldMk cId="706034829" sldId="301"/>
            <ac:picMk id="201" creationId="{014F7EC9-9D91-4073-8F77-EC3C4092FBDE}"/>
          </ac:picMkLst>
        </pc:picChg>
        <pc:picChg chg="del mod topLvl">
          <ac:chgData name="Filippo Acconcia" userId="844af49c-a8a0-47ac-a7dd-14a44b60cd18" providerId="ADAL" clId="{B609A75A-164F-4066-A006-F59E853DC491}" dt="2022-04-01T07:19:27.251" v="955" actId="478"/>
          <ac:picMkLst>
            <pc:docMk/>
            <pc:sldMk cId="706034829" sldId="301"/>
            <ac:picMk id="202" creationId="{79A9A3C9-32F5-4680-9EBB-FB64C1D3F1A7}"/>
          </ac:picMkLst>
        </pc:picChg>
        <pc:picChg chg="mod ord">
          <ac:chgData name="Filippo Acconcia" userId="844af49c-a8a0-47ac-a7dd-14a44b60cd18" providerId="ADAL" clId="{B609A75A-164F-4066-A006-F59E853DC491}" dt="2022-04-01T07:21:55.917" v="1070" actId="164"/>
          <ac:picMkLst>
            <pc:docMk/>
            <pc:sldMk cId="706034829" sldId="301"/>
            <ac:picMk id="203" creationId="{41AED2C8-C643-40FB-86DD-9C303D3E80AF}"/>
          </ac:picMkLst>
        </pc:picChg>
        <pc:picChg chg="del mod topLvl">
          <ac:chgData name="Filippo Acconcia" userId="844af49c-a8a0-47ac-a7dd-14a44b60cd18" providerId="ADAL" clId="{B609A75A-164F-4066-A006-F59E853DC491}" dt="2022-04-01T07:16:43.107" v="792" actId="478"/>
          <ac:picMkLst>
            <pc:docMk/>
            <pc:sldMk cId="706034829" sldId="301"/>
            <ac:picMk id="205" creationId="{0A263B86-7532-45DB-82D5-00CB32BC7963}"/>
          </ac:picMkLst>
        </pc:picChg>
        <pc:picChg chg="del mod topLvl">
          <ac:chgData name="Filippo Acconcia" userId="844af49c-a8a0-47ac-a7dd-14a44b60cd18" providerId="ADAL" clId="{B609A75A-164F-4066-A006-F59E853DC491}" dt="2022-04-01T07:55:01.057" v="1107" actId="478"/>
          <ac:picMkLst>
            <pc:docMk/>
            <pc:sldMk cId="706034829" sldId="301"/>
            <ac:picMk id="276" creationId="{873A0AF0-4035-4C6E-9146-5ACC5E7EA4C9}"/>
          </ac:picMkLst>
        </pc:picChg>
        <pc:picChg chg="mod ord">
          <ac:chgData name="Filippo Acconcia" userId="844af49c-a8a0-47ac-a7dd-14a44b60cd18" providerId="ADAL" clId="{B609A75A-164F-4066-A006-F59E853DC491}" dt="2022-04-01T07:56:07.323" v="1152" actId="164"/>
          <ac:picMkLst>
            <pc:docMk/>
            <pc:sldMk cId="706034829" sldId="301"/>
            <ac:picMk id="305" creationId="{5366FC90-1652-4A15-AB63-405DB21508C4}"/>
          </ac:picMkLst>
        </pc:picChg>
        <pc:cxnChg chg="mod topLvl">
          <ac:chgData name="Filippo Acconcia" userId="844af49c-a8a0-47ac-a7dd-14a44b60cd18" providerId="ADAL" clId="{B609A75A-164F-4066-A006-F59E853DC491}" dt="2022-04-01T06:38:32.341" v="640" actId="164"/>
          <ac:cxnSpMkLst>
            <pc:docMk/>
            <pc:sldMk cId="706034829" sldId="301"/>
            <ac:cxnSpMk id="90" creationId="{290862B8-FF7E-45BC-A900-99B65E70A038}"/>
          </ac:cxnSpMkLst>
        </pc:cxnChg>
        <pc:cxnChg chg="mod">
          <ac:chgData name="Filippo Acconcia" userId="844af49c-a8a0-47ac-a7dd-14a44b60cd18" providerId="ADAL" clId="{B609A75A-164F-4066-A006-F59E853DC491}" dt="2022-04-01T06:38:37.167" v="643"/>
          <ac:cxnSpMkLst>
            <pc:docMk/>
            <pc:sldMk cId="706034829" sldId="301"/>
            <ac:cxnSpMk id="104" creationId="{A9DD0DC0-B9D4-4CC8-A491-7A9938002E1F}"/>
          </ac:cxnSpMkLst>
        </pc:cxnChg>
        <pc:cxnChg chg="mod">
          <ac:chgData name="Filippo Acconcia" userId="844af49c-a8a0-47ac-a7dd-14a44b60cd18" providerId="ADAL" clId="{B609A75A-164F-4066-A006-F59E853DC491}" dt="2022-04-01T06:38:41.630" v="655"/>
          <ac:cxnSpMkLst>
            <pc:docMk/>
            <pc:sldMk cId="706034829" sldId="301"/>
            <ac:cxnSpMk id="107" creationId="{D42E3D3A-B961-49EE-9273-A0E74D236EA7}"/>
          </ac:cxnSpMkLst>
        </pc:cxnChg>
        <pc:cxnChg chg="mod">
          <ac:chgData name="Filippo Acconcia" userId="844af49c-a8a0-47ac-a7dd-14a44b60cd18" providerId="ADAL" clId="{B609A75A-164F-4066-A006-F59E853DC491}" dt="2022-04-01T06:38:45.023" v="666"/>
          <ac:cxnSpMkLst>
            <pc:docMk/>
            <pc:sldMk cId="706034829" sldId="301"/>
            <ac:cxnSpMk id="110" creationId="{5969F767-E54D-4AD2-B0FE-566D3BB8F2D6}"/>
          </ac:cxnSpMkLst>
        </pc:cxnChg>
        <pc:cxnChg chg="add mod">
          <ac:chgData name="Filippo Acconcia" userId="844af49c-a8a0-47ac-a7dd-14a44b60cd18" providerId="ADAL" clId="{B609A75A-164F-4066-A006-F59E853DC491}" dt="2022-04-01T06:41:19.611" v="703" actId="164"/>
          <ac:cxnSpMkLst>
            <pc:docMk/>
            <pc:sldMk cId="706034829" sldId="301"/>
            <ac:cxnSpMk id="113" creationId="{19E9E798-8124-4BFF-801E-55DA3229D65E}"/>
          </ac:cxnSpMkLst>
        </pc:cxnChg>
        <pc:cxnChg chg="mod">
          <ac:chgData name="Filippo Acconcia" userId="844af49c-a8a0-47ac-a7dd-14a44b60cd18" providerId="ADAL" clId="{B609A75A-164F-4066-A006-F59E853DC491}" dt="2022-04-01T06:41:20.567" v="704"/>
          <ac:cxnSpMkLst>
            <pc:docMk/>
            <pc:sldMk cId="706034829" sldId="301"/>
            <ac:cxnSpMk id="117" creationId="{124A8897-DE0F-4EC7-A848-48A53A9335AF}"/>
          </ac:cxnSpMkLst>
        </pc:cxnChg>
        <pc:cxnChg chg="mod">
          <ac:chgData name="Filippo Acconcia" userId="844af49c-a8a0-47ac-a7dd-14a44b60cd18" providerId="ADAL" clId="{B609A75A-164F-4066-A006-F59E853DC491}" dt="2022-04-01T06:41:27.278" v="708"/>
          <ac:cxnSpMkLst>
            <pc:docMk/>
            <pc:sldMk cId="706034829" sldId="301"/>
            <ac:cxnSpMk id="120" creationId="{1EDBAC32-4A87-44B2-9C21-4E096AE237F9}"/>
          </ac:cxnSpMkLst>
        </pc:cxnChg>
        <pc:cxnChg chg="mod">
          <ac:chgData name="Filippo Acconcia" userId="844af49c-a8a0-47ac-a7dd-14a44b60cd18" providerId="ADAL" clId="{B609A75A-164F-4066-A006-F59E853DC491}" dt="2022-04-01T06:41:32.337" v="710"/>
          <ac:cxnSpMkLst>
            <pc:docMk/>
            <pc:sldMk cId="706034829" sldId="301"/>
            <ac:cxnSpMk id="123" creationId="{14179007-3C03-43E0-812E-596DEF1EB5F9}"/>
          </ac:cxnSpMkLst>
        </pc:cxnChg>
        <pc:cxnChg chg="mod">
          <ac:chgData name="Filippo Acconcia" userId="844af49c-a8a0-47ac-a7dd-14a44b60cd18" providerId="ADAL" clId="{B609A75A-164F-4066-A006-F59E853DC491}" dt="2022-04-01T06:44:21.321" v="760" actId="165"/>
          <ac:cxnSpMkLst>
            <pc:docMk/>
            <pc:sldMk cId="706034829" sldId="301"/>
            <ac:cxnSpMk id="149" creationId="{0834F4F2-525C-4340-823F-4D4FAD2D5018}"/>
          </ac:cxnSpMkLst>
        </pc:cxnChg>
        <pc:cxnChg chg="mod">
          <ac:chgData name="Filippo Acconcia" userId="844af49c-a8a0-47ac-a7dd-14a44b60cd18" providerId="ADAL" clId="{B609A75A-164F-4066-A006-F59E853DC491}" dt="2022-04-01T06:44:21.321" v="760" actId="165"/>
          <ac:cxnSpMkLst>
            <pc:docMk/>
            <pc:sldMk cId="706034829" sldId="301"/>
            <ac:cxnSpMk id="151" creationId="{95F54199-C894-452F-BF4C-1AFA6FB2498D}"/>
          </ac:cxnSpMkLst>
        </pc:cxnChg>
        <pc:cxnChg chg="mod">
          <ac:chgData name="Filippo Acconcia" userId="844af49c-a8a0-47ac-a7dd-14a44b60cd18" providerId="ADAL" clId="{B609A75A-164F-4066-A006-F59E853DC491}" dt="2022-04-01T06:44:21.321" v="760" actId="165"/>
          <ac:cxnSpMkLst>
            <pc:docMk/>
            <pc:sldMk cId="706034829" sldId="301"/>
            <ac:cxnSpMk id="153" creationId="{712E7AEF-0753-4C37-A8F6-73A02674EF05}"/>
          </ac:cxnSpMkLst>
        </pc:cxnChg>
        <pc:cxnChg chg="mod">
          <ac:chgData name="Filippo Acconcia" userId="844af49c-a8a0-47ac-a7dd-14a44b60cd18" providerId="ADAL" clId="{B609A75A-164F-4066-A006-F59E853DC491}" dt="2022-04-01T06:44:21.321" v="760" actId="165"/>
          <ac:cxnSpMkLst>
            <pc:docMk/>
            <pc:sldMk cId="706034829" sldId="301"/>
            <ac:cxnSpMk id="155" creationId="{C7748CFA-134A-445C-A394-74968904E0D8}"/>
          </ac:cxnSpMkLst>
        </pc:cxnChg>
        <pc:cxnChg chg="mod">
          <ac:chgData name="Filippo Acconcia" userId="844af49c-a8a0-47ac-a7dd-14a44b60cd18" providerId="ADAL" clId="{B609A75A-164F-4066-A006-F59E853DC491}" dt="2022-04-01T06:44:21.321" v="760" actId="165"/>
          <ac:cxnSpMkLst>
            <pc:docMk/>
            <pc:sldMk cId="706034829" sldId="301"/>
            <ac:cxnSpMk id="157" creationId="{F7C9A818-7D59-46AD-BEED-A99D321ED918}"/>
          </ac:cxnSpMkLst>
        </pc:cxnChg>
        <pc:cxnChg chg="mod">
          <ac:chgData name="Filippo Acconcia" userId="844af49c-a8a0-47ac-a7dd-14a44b60cd18" providerId="ADAL" clId="{B609A75A-164F-4066-A006-F59E853DC491}" dt="2022-04-01T06:44:21.321" v="760" actId="165"/>
          <ac:cxnSpMkLst>
            <pc:docMk/>
            <pc:sldMk cId="706034829" sldId="301"/>
            <ac:cxnSpMk id="159" creationId="{58952811-F575-4185-AC33-2CD5F3D2025C}"/>
          </ac:cxnSpMkLst>
        </pc:cxnChg>
        <pc:cxnChg chg="mod">
          <ac:chgData name="Filippo Acconcia" userId="844af49c-a8a0-47ac-a7dd-14a44b60cd18" providerId="ADAL" clId="{B609A75A-164F-4066-A006-F59E853DC491}" dt="2022-04-01T06:44:21.321" v="760" actId="165"/>
          <ac:cxnSpMkLst>
            <pc:docMk/>
            <pc:sldMk cId="706034829" sldId="301"/>
            <ac:cxnSpMk id="161" creationId="{D8EF2CF1-7359-4B48-8161-89A5439C21CB}"/>
          </ac:cxnSpMkLst>
        </pc:cxnChg>
        <pc:cxnChg chg="mod">
          <ac:chgData name="Filippo Acconcia" userId="844af49c-a8a0-47ac-a7dd-14a44b60cd18" providerId="ADAL" clId="{B609A75A-164F-4066-A006-F59E853DC491}" dt="2022-04-01T06:44:21.321" v="760" actId="165"/>
          <ac:cxnSpMkLst>
            <pc:docMk/>
            <pc:sldMk cId="706034829" sldId="301"/>
            <ac:cxnSpMk id="163" creationId="{341099FA-F727-4C47-AEFC-C9EE4884243D}"/>
          </ac:cxnSpMkLst>
        </pc:cxnChg>
        <pc:cxnChg chg="mod topLvl">
          <ac:chgData name="Filippo Acconcia" userId="844af49c-a8a0-47ac-a7dd-14a44b60cd18" providerId="ADAL" clId="{B609A75A-164F-4066-A006-F59E853DC491}" dt="2022-04-01T07:56:07.323" v="1152" actId="164"/>
          <ac:cxnSpMkLst>
            <pc:docMk/>
            <pc:sldMk cId="706034829" sldId="301"/>
            <ac:cxnSpMk id="184" creationId="{93F64027-2E68-4392-A8A3-970D78D7EE3F}"/>
          </ac:cxnSpMkLst>
        </pc:cxnChg>
        <pc:cxnChg chg="mod">
          <ac:chgData name="Filippo Acconcia" userId="844af49c-a8a0-47ac-a7dd-14a44b60cd18" providerId="ADAL" clId="{B609A75A-164F-4066-A006-F59E853DC491}" dt="2022-04-01T07:16:14.808" v="787" actId="165"/>
          <ac:cxnSpMkLst>
            <pc:docMk/>
            <pc:sldMk cId="706034829" sldId="301"/>
            <ac:cxnSpMk id="226" creationId="{9853976C-F1D1-41E5-A352-CE1B4B2E9A10}"/>
          </ac:cxnSpMkLst>
        </pc:cxnChg>
        <pc:cxnChg chg="mod">
          <ac:chgData name="Filippo Acconcia" userId="844af49c-a8a0-47ac-a7dd-14a44b60cd18" providerId="ADAL" clId="{B609A75A-164F-4066-A006-F59E853DC491}" dt="2022-04-01T07:16:14.808" v="787" actId="165"/>
          <ac:cxnSpMkLst>
            <pc:docMk/>
            <pc:sldMk cId="706034829" sldId="301"/>
            <ac:cxnSpMk id="228" creationId="{ED96C6E3-93F5-4A8F-B9E8-2F622671FDD1}"/>
          </ac:cxnSpMkLst>
        </pc:cxnChg>
        <pc:cxnChg chg="mod">
          <ac:chgData name="Filippo Acconcia" userId="844af49c-a8a0-47ac-a7dd-14a44b60cd18" providerId="ADAL" clId="{B609A75A-164F-4066-A006-F59E853DC491}" dt="2022-04-01T07:16:14.808" v="787" actId="165"/>
          <ac:cxnSpMkLst>
            <pc:docMk/>
            <pc:sldMk cId="706034829" sldId="301"/>
            <ac:cxnSpMk id="230" creationId="{863BD892-B236-4641-B12B-1D80883AF207}"/>
          </ac:cxnSpMkLst>
        </pc:cxnChg>
        <pc:cxnChg chg="mod topLvl">
          <ac:chgData name="Filippo Acconcia" userId="844af49c-a8a0-47ac-a7dd-14a44b60cd18" providerId="ADAL" clId="{B609A75A-164F-4066-A006-F59E853DC491}" dt="2022-04-01T07:20:45.163" v="1012" actId="164"/>
          <ac:cxnSpMkLst>
            <pc:docMk/>
            <pc:sldMk cId="706034829" sldId="301"/>
            <ac:cxnSpMk id="232" creationId="{AF14BB26-CF92-47AB-9E04-51C12C4CCA1B}"/>
          </ac:cxnSpMkLst>
        </pc:cxnChg>
        <pc:cxnChg chg="mod">
          <ac:chgData name="Filippo Acconcia" userId="844af49c-a8a0-47ac-a7dd-14a44b60cd18" providerId="ADAL" clId="{B609A75A-164F-4066-A006-F59E853DC491}" dt="2022-04-01T07:16:14.808" v="787" actId="165"/>
          <ac:cxnSpMkLst>
            <pc:docMk/>
            <pc:sldMk cId="706034829" sldId="301"/>
            <ac:cxnSpMk id="234" creationId="{5A02BFF5-531C-4128-A091-DD96748B4248}"/>
          </ac:cxnSpMkLst>
        </pc:cxnChg>
        <pc:cxnChg chg="mod">
          <ac:chgData name="Filippo Acconcia" userId="844af49c-a8a0-47ac-a7dd-14a44b60cd18" providerId="ADAL" clId="{B609A75A-164F-4066-A006-F59E853DC491}" dt="2022-04-01T07:16:14.808" v="787" actId="165"/>
          <ac:cxnSpMkLst>
            <pc:docMk/>
            <pc:sldMk cId="706034829" sldId="301"/>
            <ac:cxnSpMk id="236" creationId="{CBDDDEA4-A1AC-4923-9E3D-B256B47FEFFE}"/>
          </ac:cxnSpMkLst>
        </pc:cxnChg>
        <pc:cxnChg chg="mod">
          <ac:chgData name="Filippo Acconcia" userId="844af49c-a8a0-47ac-a7dd-14a44b60cd18" providerId="ADAL" clId="{B609A75A-164F-4066-A006-F59E853DC491}" dt="2022-04-01T07:16:14.808" v="787" actId="165"/>
          <ac:cxnSpMkLst>
            <pc:docMk/>
            <pc:sldMk cId="706034829" sldId="301"/>
            <ac:cxnSpMk id="238" creationId="{81530FDC-2A37-46F7-9603-F26C00C0A051}"/>
          </ac:cxnSpMkLst>
        </pc:cxnChg>
        <pc:cxnChg chg="mod">
          <ac:chgData name="Filippo Acconcia" userId="844af49c-a8a0-47ac-a7dd-14a44b60cd18" providerId="ADAL" clId="{B609A75A-164F-4066-A006-F59E853DC491}" dt="2022-04-01T07:16:14.808" v="787" actId="165"/>
          <ac:cxnSpMkLst>
            <pc:docMk/>
            <pc:sldMk cId="706034829" sldId="301"/>
            <ac:cxnSpMk id="240" creationId="{B58A3911-F810-4CFA-87AD-149DB36EB4E7}"/>
          </ac:cxnSpMkLst>
        </pc:cxnChg>
        <pc:cxnChg chg="add del">
          <ac:chgData name="Filippo Acconcia" userId="844af49c-a8a0-47ac-a7dd-14a44b60cd18" providerId="ADAL" clId="{B609A75A-164F-4066-A006-F59E853DC491}" dt="2022-04-01T07:19:55.222" v="957" actId="11529"/>
          <ac:cxnSpMkLst>
            <pc:docMk/>
            <pc:sldMk cId="706034829" sldId="301"/>
            <ac:cxnSpMk id="260" creationId="{08F32311-BBF0-4870-B571-732B305F99E6}"/>
          </ac:cxnSpMkLst>
        </pc:cxnChg>
        <pc:cxnChg chg="mod">
          <ac:chgData name="Filippo Acconcia" userId="844af49c-a8a0-47ac-a7dd-14a44b60cd18" providerId="ADAL" clId="{B609A75A-164F-4066-A006-F59E853DC491}" dt="2022-04-01T07:20:46.114" v="1013"/>
          <ac:cxnSpMkLst>
            <pc:docMk/>
            <pc:sldMk cId="706034829" sldId="301"/>
            <ac:cxnSpMk id="263" creationId="{62C2D1D5-697B-484A-A67D-10BFC154680F}"/>
          </ac:cxnSpMkLst>
        </pc:cxnChg>
        <pc:cxnChg chg="mod">
          <ac:chgData name="Filippo Acconcia" userId="844af49c-a8a0-47ac-a7dd-14a44b60cd18" providerId="ADAL" clId="{B609A75A-164F-4066-A006-F59E853DC491}" dt="2022-04-01T07:20:50.225" v="1015"/>
          <ac:cxnSpMkLst>
            <pc:docMk/>
            <pc:sldMk cId="706034829" sldId="301"/>
            <ac:cxnSpMk id="266" creationId="{77096135-92C7-4498-95FA-8D0BADC60760}"/>
          </ac:cxnSpMkLst>
        </pc:cxnChg>
        <pc:cxnChg chg="mod">
          <ac:chgData name="Filippo Acconcia" userId="844af49c-a8a0-47ac-a7dd-14a44b60cd18" providerId="ADAL" clId="{B609A75A-164F-4066-A006-F59E853DC491}" dt="2022-04-01T07:20:54.481" v="1017"/>
          <ac:cxnSpMkLst>
            <pc:docMk/>
            <pc:sldMk cId="706034829" sldId="301"/>
            <ac:cxnSpMk id="269" creationId="{09F74C1D-9834-43FC-AF51-C8B322B859A0}"/>
          </ac:cxnSpMkLst>
        </pc:cxnChg>
        <pc:cxnChg chg="mod">
          <ac:chgData name="Filippo Acconcia" userId="844af49c-a8a0-47ac-a7dd-14a44b60cd18" providerId="ADAL" clId="{B609A75A-164F-4066-A006-F59E853DC491}" dt="2022-04-01T07:53:58.119" v="1102" actId="165"/>
          <ac:cxnSpMkLst>
            <pc:docMk/>
            <pc:sldMk cId="706034829" sldId="301"/>
            <ac:cxnSpMk id="293" creationId="{13C902E2-98C0-4879-BCCA-D1BAE24BAF49}"/>
          </ac:cxnSpMkLst>
        </pc:cxnChg>
        <pc:cxnChg chg="mod">
          <ac:chgData name="Filippo Acconcia" userId="844af49c-a8a0-47ac-a7dd-14a44b60cd18" providerId="ADAL" clId="{B609A75A-164F-4066-A006-F59E853DC491}" dt="2022-04-01T07:53:58.119" v="1102" actId="165"/>
          <ac:cxnSpMkLst>
            <pc:docMk/>
            <pc:sldMk cId="706034829" sldId="301"/>
            <ac:cxnSpMk id="295" creationId="{A1952635-CDAE-4508-84B9-FB44001E060F}"/>
          </ac:cxnSpMkLst>
        </pc:cxnChg>
        <pc:cxnChg chg="mod">
          <ac:chgData name="Filippo Acconcia" userId="844af49c-a8a0-47ac-a7dd-14a44b60cd18" providerId="ADAL" clId="{B609A75A-164F-4066-A006-F59E853DC491}" dt="2022-04-01T07:53:58.119" v="1102" actId="165"/>
          <ac:cxnSpMkLst>
            <pc:docMk/>
            <pc:sldMk cId="706034829" sldId="301"/>
            <ac:cxnSpMk id="297" creationId="{4C48FBAD-07E6-4C5B-92F5-1B3E4FEA8423}"/>
          </ac:cxnSpMkLst>
        </pc:cxnChg>
        <pc:cxnChg chg="mod">
          <ac:chgData name="Filippo Acconcia" userId="844af49c-a8a0-47ac-a7dd-14a44b60cd18" providerId="ADAL" clId="{B609A75A-164F-4066-A006-F59E853DC491}" dt="2022-04-01T07:53:58.119" v="1102" actId="165"/>
          <ac:cxnSpMkLst>
            <pc:docMk/>
            <pc:sldMk cId="706034829" sldId="301"/>
            <ac:cxnSpMk id="299" creationId="{2E27D215-3205-4BAB-823C-ECB0AE91BD95}"/>
          </ac:cxnSpMkLst>
        </pc:cxnChg>
        <pc:cxnChg chg="mod">
          <ac:chgData name="Filippo Acconcia" userId="844af49c-a8a0-47ac-a7dd-14a44b60cd18" providerId="ADAL" clId="{B609A75A-164F-4066-A006-F59E853DC491}" dt="2022-04-01T07:53:58.119" v="1102" actId="165"/>
          <ac:cxnSpMkLst>
            <pc:docMk/>
            <pc:sldMk cId="706034829" sldId="301"/>
            <ac:cxnSpMk id="301" creationId="{C4C73FEE-5020-4B66-B1D6-5E57219B731F}"/>
          </ac:cxnSpMkLst>
        </pc:cxnChg>
        <pc:cxnChg chg="mod">
          <ac:chgData name="Filippo Acconcia" userId="844af49c-a8a0-47ac-a7dd-14a44b60cd18" providerId="ADAL" clId="{B609A75A-164F-4066-A006-F59E853DC491}" dt="2022-04-01T07:53:58.119" v="1102" actId="165"/>
          <ac:cxnSpMkLst>
            <pc:docMk/>
            <pc:sldMk cId="706034829" sldId="301"/>
            <ac:cxnSpMk id="303" creationId="{3107BC7D-995C-4351-869D-22A3CAD8FF68}"/>
          </ac:cxnSpMkLst>
        </pc:cxnChg>
      </pc:sldChg>
      <pc:sldChg chg="addSp modSp new mod">
        <pc:chgData name="Filippo Acconcia" userId="844af49c-a8a0-47ac-a7dd-14a44b60cd18" providerId="ADAL" clId="{B609A75A-164F-4066-A006-F59E853DC491}" dt="2022-03-30T08:37:12.918" v="462" actId="20577"/>
        <pc:sldMkLst>
          <pc:docMk/>
          <pc:sldMk cId="2307067035" sldId="302"/>
        </pc:sldMkLst>
        <pc:spChg chg="add mod">
          <ac:chgData name="Filippo Acconcia" userId="844af49c-a8a0-47ac-a7dd-14a44b60cd18" providerId="ADAL" clId="{B609A75A-164F-4066-A006-F59E853DC491}" dt="2022-03-30T08:37:12.918" v="462" actId="20577"/>
          <ac:spMkLst>
            <pc:docMk/>
            <pc:sldMk cId="2307067035" sldId="302"/>
            <ac:spMk id="2" creationId="{B14641C2-1A37-4311-BD94-1DD69E890193}"/>
          </ac:spMkLst>
        </pc:spChg>
        <pc:spChg chg="mod">
          <ac:chgData name="Filippo Acconcia" userId="844af49c-a8a0-47ac-a7dd-14a44b60cd18" providerId="ADAL" clId="{B609A75A-164F-4066-A006-F59E853DC491}" dt="2022-03-28T07:43:57.956" v="322"/>
          <ac:spMkLst>
            <pc:docMk/>
            <pc:sldMk cId="2307067035" sldId="302"/>
            <ac:spMk id="7" creationId="{4FAC1AAB-337A-4F06-9A3B-789144D77C82}"/>
          </ac:spMkLst>
        </pc:spChg>
        <pc:spChg chg="mod">
          <ac:chgData name="Filippo Acconcia" userId="844af49c-a8a0-47ac-a7dd-14a44b60cd18" providerId="ADAL" clId="{B609A75A-164F-4066-A006-F59E853DC491}" dt="2022-03-28T07:43:57.956" v="322"/>
          <ac:spMkLst>
            <pc:docMk/>
            <pc:sldMk cId="2307067035" sldId="302"/>
            <ac:spMk id="8" creationId="{9AD1915C-F91D-4398-A0A9-B2B86AB5795A}"/>
          </ac:spMkLst>
        </pc:spChg>
        <pc:spChg chg="mod">
          <ac:chgData name="Filippo Acconcia" userId="844af49c-a8a0-47ac-a7dd-14a44b60cd18" providerId="ADAL" clId="{B609A75A-164F-4066-A006-F59E853DC491}" dt="2022-03-28T07:43:57.956" v="322"/>
          <ac:spMkLst>
            <pc:docMk/>
            <pc:sldMk cId="2307067035" sldId="302"/>
            <ac:spMk id="9" creationId="{8C5B4B0B-00B4-4D9A-9F43-F6E2BD4E2E4F}"/>
          </ac:spMkLst>
        </pc:spChg>
        <pc:spChg chg="mod">
          <ac:chgData name="Filippo Acconcia" userId="844af49c-a8a0-47ac-a7dd-14a44b60cd18" providerId="ADAL" clId="{B609A75A-164F-4066-A006-F59E853DC491}" dt="2022-03-28T07:43:57.956" v="322"/>
          <ac:spMkLst>
            <pc:docMk/>
            <pc:sldMk cId="2307067035" sldId="302"/>
            <ac:spMk id="10" creationId="{CC4DB14A-7A90-47D3-8413-0524C76E0B25}"/>
          </ac:spMkLst>
        </pc:spChg>
        <pc:spChg chg="mod">
          <ac:chgData name="Filippo Acconcia" userId="844af49c-a8a0-47ac-a7dd-14a44b60cd18" providerId="ADAL" clId="{B609A75A-164F-4066-A006-F59E853DC491}" dt="2022-03-28T07:43:57.956" v="322"/>
          <ac:spMkLst>
            <pc:docMk/>
            <pc:sldMk cId="2307067035" sldId="302"/>
            <ac:spMk id="11" creationId="{7D93643A-B6EB-49E3-9111-A471CA9A3F73}"/>
          </ac:spMkLst>
        </pc:spChg>
        <pc:spChg chg="mod">
          <ac:chgData name="Filippo Acconcia" userId="844af49c-a8a0-47ac-a7dd-14a44b60cd18" providerId="ADAL" clId="{B609A75A-164F-4066-A006-F59E853DC491}" dt="2022-03-28T07:43:57.956" v="322"/>
          <ac:spMkLst>
            <pc:docMk/>
            <pc:sldMk cId="2307067035" sldId="302"/>
            <ac:spMk id="12" creationId="{3AEBACF6-9EB6-439A-A1A6-C66DE0753284}"/>
          </ac:spMkLst>
        </pc:spChg>
        <pc:spChg chg="mod">
          <ac:chgData name="Filippo Acconcia" userId="844af49c-a8a0-47ac-a7dd-14a44b60cd18" providerId="ADAL" clId="{B609A75A-164F-4066-A006-F59E853DC491}" dt="2022-03-28T07:43:57.956" v="322"/>
          <ac:spMkLst>
            <pc:docMk/>
            <pc:sldMk cId="2307067035" sldId="302"/>
            <ac:spMk id="13" creationId="{221D75E1-F834-4F49-80BD-D3C38D7286A3}"/>
          </ac:spMkLst>
        </pc:spChg>
        <pc:spChg chg="mod">
          <ac:chgData name="Filippo Acconcia" userId="844af49c-a8a0-47ac-a7dd-14a44b60cd18" providerId="ADAL" clId="{B609A75A-164F-4066-A006-F59E853DC491}" dt="2022-03-28T07:43:57.956" v="322"/>
          <ac:spMkLst>
            <pc:docMk/>
            <pc:sldMk cId="2307067035" sldId="302"/>
            <ac:spMk id="14" creationId="{14525585-F52A-40A2-AB38-516A54D83FAA}"/>
          </ac:spMkLst>
        </pc:spChg>
        <pc:spChg chg="mod">
          <ac:chgData name="Filippo Acconcia" userId="844af49c-a8a0-47ac-a7dd-14a44b60cd18" providerId="ADAL" clId="{B609A75A-164F-4066-A006-F59E853DC491}" dt="2022-03-28T07:43:57.956" v="322"/>
          <ac:spMkLst>
            <pc:docMk/>
            <pc:sldMk cId="2307067035" sldId="302"/>
            <ac:spMk id="16" creationId="{9354A362-58E0-4274-837D-B0953FDE9254}"/>
          </ac:spMkLst>
        </pc:spChg>
        <pc:spChg chg="mod">
          <ac:chgData name="Filippo Acconcia" userId="844af49c-a8a0-47ac-a7dd-14a44b60cd18" providerId="ADAL" clId="{B609A75A-164F-4066-A006-F59E853DC491}" dt="2022-03-28T07:43:57.956" v="322"/>
          <ac:spMkLst>
            <pc:docMk/>
            <pc:sldMk cId="2307067035" sldId="302"/>
            <ac:spMk id="20" creationId="{FAE24FF5-730D-4351-BBBA-E64C0C8CD160}"/>
          </ac:spMkLst>
        </pc:spChg>
        <pc:spChg chg="mod">
          <ac:chgData name="Filippo Acconcia" userId="844af49c-a8a0-47ac-a7dd-14a44b60cd18" providerId="ADAL" clId="{B609A75A-164F-4066-A006-F59E853DC491}" dt="2022-03-28T07:43:57.956" v="322"/>
          <ac:spMkLst>
            <pc:docMk/>
            <pc:sldMk cId="2307067035" sldId="302"/>
            <ac:spMk id="21" creationId="{C9BA248E-8DE9-4309-9E5F-F2C6D2D8570C}"/>
          </ac:spMkLst>
        </pc:spChg>
        <pc:spChg chg="mod">
          <ac:chgData name="Filippo Acconcia" userId="844af49c-a8a0-47ac-a7dd-14a44b60cd18" providerId="ADAL" clId="{B609A75A-164F-4066-A006-F59E853DC491}" dt="2022-03-28T07:43:57.956" v="322"/>
          <ac:spMkLst>
            <pc:docMk/>
            <pc:sldMk cId="2307067035" sldId="302"/>
            <ac:spMk id="22" creationId="{4C0D0416-CA53-401B-9460-CE3CA1E97481}"/>
          </ac:spMkLst>
        </pc:spChg>
        <pc:spChg chg="mod">
          <ac:chgData name="Filippo Acconcia" userId="844af49c-a8a0-47ac-a7dd-14a44b60cd18" providerId="ADAL" clId="{B609A75A-164F-4066-A006-F59E853DC491}" dt="2022-03-28T07:43:57.956" v="322"/>
          <ac:spMkLst>
            <pc:docMk/>
            <pc:sldMk cId="2307067035" sldId="302"/>
            <ac:spMk id="23" creationId="{B111B969-ADDD-4C6B-9B19-35D787062134}"/>
          </ac:spMkLst>
        </pc:spChg>
        <pc:spChg chg="mod">
          <ac:chgData name="Filippo Acconcia" userId="844af49c-a8a0-47ac-a7dd-14a44b60cd18" providerId="ADAL" clId="{B609A75A-164F-4066-A006-F59E853DC491}" dt="2022-03-28T07:43:57.956" v="322"/>
          <ac:spMkLst>
            <pc:docMk/>
            <pc:sldMk cId="2307067035" sldId="302"/>
            <ac:spMk id="24" creationId="{3B5BE2B2-D386-4108-8072-67C6CC95A2C9}"/>
          </ac:spMkLst>
        </pc:spChg>
        <pc:spChg chg="mod">
          <ac:chgData name="Filippo Acconcia" userId="844af49c-a8a0-47ac-a7dd-14a44b60cd18" providerId="ADAL" clId="{B609A75A-164F-4066-A006-F59E853DC491}" dt="2022-03-28T07:43:57.956" v="322"/>
          <ac:spMkLst>
            <pc:docMk/>
            <pc:sldMk cId="2307067035" sldId="302"/>
            <ac:spMk id="25" creationId="{02861877-A49C-4779-8B42-21916FA31289}"/>
          </ac:spMkLst>
        </pc:spChg>
        <pc:spChg chg="mod">
          <ac:chgData name="Filippo Acconcia" userId="844af49c-a8a0-47ac-a7dd-14a44b60cd18" providerId="ADAL" clId="{B609A75A-164F-4066-A006-F59E853DC491}" dt="2022-03-28T07:43:57.956" v="322"/>
          <ac:spMkLst>
            <pc:docMk/>
            <pc:sldMk cId="2307067035" sldId="302"/>
            <ac:spMk id="26" creationId="{36CCD239-EE37-4571-B961-33BCF21E33DC}"/>
          </ac:spMkLst>
        </pc:spChg>
        <pc:spChg chg="mod">
          <ac:chgData name="Filippo Acconcia" userId="844af49c-a8a0-47ac-a7dd-14a44b60cd18" providerId="ADAL" clId="{B609A75A-164F-4066-A006-F59E853DC491}" dt="2022-03-28T07:43:57.956" v="322"/>
          <ac:spMkLst>
            <pc:docMk/>
            <pc:sldMk cId="2307067035" sldId="302"/>
            <ac:spMk id="27" creationId="{A06536CC-4912-44F9-802B-373324655E45}"/>
          </ac:spMkLst>
        </pc:spChg>
        <pc:spChg chg="mod">
          <ac:chgData name="Filippo Acconcia" userId="844af49c-a8a0-47ac-a7dd-14a44b60cd18" providerId="ADAL" clId="{B609A75A-164F-4066-A006-F59E853DC491}" dt="2022-03-28T07:43:57.956" v="322"/>
          <ac:spMkLst>
            <pc:docMk/>
            <pc:sldMk cId="2307067035" sldId="302"/>
            <ac:spMk id="29" creationId="{13E7CA6D-82EA-4683-96EC-69CE14D7F271}"/>
          </ac:spMkLst>
        </pc:spChg>
        <pc:spChg chg="mod">
          <ac:chgData name="Filippo Acconcia" userId="844af49c-a8a0-47ac-a7dd-14a44b60cd18" providerId="ADAL" clId="{B609A75A-164F-4066-A006-F59E853DC491}" dt="2022-03-28T07:44:47.426" v="341" actId="1037"/>
          <ac:spMkLst>
            <pc:docMk/>
            <pc:sldMk cId="2307067035" sldId="302"/>
            <ac:spMk id="33" creationId="{FD659C48-E5B1-4C4B-9581-07FFD787A4CF}"/>
          </ac:spMkLst>
        </pc:spChg>
        <pc:spChg chg="mod">
          <ac:chgData name="Filippo Acconcia" userId="844af49c-a8a0-47ac-a7dd-14a44b60cd18" providerId="ADAL" clId="{B609A75A-164F-4066-A006-F59E853DC491}" dt="2022-03-28T07:44:16.204" v="325"/>
          <ac:spMkLst>
            <pc:docMk/>
            <pc:sldMk cId="2307067035" sldId="302"/>
            <ac:spMk id="34" creationId="{E158C8DC-E0BE-409B-B367-D2A0F464C106}"/>
          </ac:spMkLst>
        </pc:spChg>
        <pc:spChg chg="mod">
          <ac:chgData name="Filippo Acconcia" userId="844af49c-a8a0-47ac-a7dd-14a44b60cd18" providerId="ADAL" clId="{B609A75A-164F-4066-A006-F59E853DC491}" dt="2022-03-28T07:44:16.204" v="325"/>
          <ac:spMkLst>
            <pc:docMk/>
            <pc:sldMk cId="2307067035" sldId="302"/>
            <ac:spMk id="35" creationId="{7EBA4E4A-B8C0-4105-87CD-1A9747CF25E2}"/>
          </ac:spMkLst>
        </pc:spChg>
        <pc:spChg chg="mod">
          <ac:chgData name="Filippo Acconcia" userId="844af49c-a8a0-47ac-a7dd-14a44b60cd18" providerId="ADAL" clId="{B609A75A-164F-4066-A006-F59E853DC491}" dt="2022-03-28T07:44:16.204" v="325"/>
          <ac:spMkLst>
            <pc:docMk/>
            <pc:sldMk cId="2307067035" sldId="302"/>
            <ac:spMk id="36" creationId="{EFE50FCD-C152-43A8-B9BA-DD8762CB6891}"/>
          </ac:spMkLst>
        </pc:spChg>
        <pc:spChg chg="mod">
          <ac:chgData name="Filippo Acconcia" userId="844af49c-a8a0-47ac-a7dd-14a44b60cd18" providerId="ADAL" clId="{B609A75A-164F-4066-A006-F59E853DC491}" dt="2022-03-28T07:44:16.204" v="325"/>
          <ac:spMkLst>
            <pc:docMk/>
            <pc:sldMk cId="2307067035" sldId="302"/>
            <ac:spMk id="37" creationId="{3BD94BC8-E5B5-405B-A6E6-B412AAADF124}"/>
          </ac:spMkLst>
        </pc:spChg>
        <pc:spChg chg="mod">
          <ac:chgData name="Filippo Acconcia" userId="844af49c-a8a0-47ac-a7dd-14a44b60cd18" providerId="ADAL" clId="{B609A75A-164F-4066-A006-F59E853DC491}" dt="2022-03-28T07:44:16.204" v="325"/>
          <ac:spMkLst>
            <pc:docMk/>
            <pc:sldMk cId="2307067035" sldId="302"/>
            <ac:spMk id="38" creationId="{F626BF58-2ACF-4246-A3CD-E827E436724E}"/>
          </ac:spMkLst>
        </pc:spChg>
        <pc:spChg chg="mod">
          <ac:chgData name="Filippo Acconcia" userId="844af49c-a8a0-47ac-a7dd-14a44b60cd18" providerId="ADAL" clId="{B609A75A-164F-4066-A006-F59E853DC491}" dt="2022-03-28T07:44:16.204" v="325"/>
          <ac:spMkLst>
            <pc:docMk/>
            <pc:sldMk cId="2307067035" sldId="302"/>
            <ac:spMk id="39" creationId="{428AA797-D38D-4049-B886-CBC89A348B34}"/>
          </ac:spMkLst>
        </pc:spChg>
        <pc:spChg chg="mod">
          <ac:chgData name="Filippo Acconcia" userId="844af49c-a8a0-47ac-a7dd-14a44b60cd18" providerId="ADAL" clId="{B609A75A-164F-4066-A006-F59E853DC491}" dt="2022-03-28T07:44:16.204" v="325"/>
          <ac:spMkLst>
            <pc:docMk/>
            <pc:sldMk cId="2307067035" sldId="302"/>
            <ac:spMk id="40" creationId="{CB304EBE-658F-4322-B57D-E3AADC6B7268}"/>
          </ac:spMkLst>
        </pc:spChg>
        <pc:spChg chg="mod">
          <ac:chgData name="Filippo Acconcia" userId="844af49c-a8a0-47ac-a7dd-14a44b60cd18" providerId="ADAL" clId="{B609A75A-164F-4066-A006-F59E853DC491}" dt="2022-03-28T07:44:16.204" v="325"/>
          <ac:spMkLst>
            <pc:docMk/>
            <pc:sldMk cId="2307067035" sldId="302"/>
            <ac:spMk id="41" creationId="{DCFF686C-CFB2-47FD-B17C-5B93C18DBC1F}"/>
          </ac:spMkLst>
        </pc:spChg>
        <pc:spChg chg="mod">
          <ac:chgData name="Filippo Acconcia" userId="844af49c-a8a0-47ac-a7dd-14a44b60cd18" providerId="ADAL" clId="{B609A75A-164F-4066-A006-F59E853DC491}" dt="2022-03-28T07:44:16.204" v="325"/>
          <ac:spMkLst>
            <pc:docMk/>
            <pc:sldMk cId="2307067035" sldId="302"/>
            <ac:spMk id="42" creationId="{CDA0F690-446A-461A-A36F-0853C07E3FB0}"/>
          </ac:spMkLst>
        </pc:spChg>
        <pc:spChg chg="mod">
          <ac:chgData name="Filippo Acconcia" userId="844af49c-a8a0-47ac-a7dd-14a44b60cd18" providerId="ADAL" clId="{B609A75A-164F-4066-A006-F59E853DC491}" dt="2022-03-28T07:44:16.204" v="325"/>
          <ac:spMkLst>
            <pc:docMk/>
            <pc:sldMk cId="2307067035" sldId="302"/>
            <ac:spMk id="43" creationId="{0DDCE2B3-EDC0-4BDA-9313-E79B3D9C10BA}"/>
          </ac:spMkLst>
        </pc:spChg>
        <pc:spChg chg="mod">
          <ac:chgData name="Filippo Acconcia" userId="844af49c-a8a0-47ac-a7dd-14a44b60cd18" providerId="ADAL" clId="{B609A75A-164F-4066-A006-F59E853DC491}" dt="2022-03-28T07:44:16.204" v="325"/>
          <ac:spMkLst>
            <pc:docMk/>
            <pc:sldMk cId="2307067035" sldId="302"/>
            <ac:spMk id="44" creationId="{943BE0FA-209A-4CE9-A4E9-041A9FF2F32E}"/>
          </ac:spMkLst>
        </pc:spChg>
        <pc:spChg chg="mod">
          <ac:chgData name="Filippo Acconcia" userId="844af49c-a8a0-47ac-a7dd-14a44b60cd18" providerId="ADAL" clId="{B609A75A-164F-4066-A006-F59E853DC491}" dt="2022-03-28T07:44:51.689" v="346" actId="1038"/>
          <ac:spMkLst>
            <pc:docMk/>
            <pc:sldMk cId="2307067035" sldId="302"/>
            <ac:spMk id="48" creationId="{E55FEA93-EBD7-488C-9473-55358D9DE48C}"/>
          </ac:spMkLst>
        </pc:spChg>
        <pc:spChg chg="mod">
          <ac:chgData name="Filippo Acconcia" userId="844af49c-a8a0-47ac-a7dd-14a44b60cd18" providerId="ADAL" clId="{B609A75A-164F-4066-A006-F59E853DC491}" dt="2022-03-28T07:44:16.204" v="325"/>
          <ac:spMkLst>
            <pc:docMk/>
            <pc:sldMk cId="2307067035" sldId="302"/>
            <ac:spMk id="49" creationId="{78373B0A-D670-4B40-9A64-D5BBF7C5D21F}"/>
          </ac:spMkLst>
        </pc:spChg>
        <pc:spChg chg="mod">
          <ac:chgData name="Filippo Acconcia" userId="844af49c-a8a0-47ac-a7dd-14a44b60cd18" providerId="ADAL" clId="{B609A75A-164F-4066-A006-F59E853DC491}" dt="2022-03-28T07:44:16.204" v="325"/>
          <ac:spMkLst>
            <pc:docMk/>
            <pc:sldMk cId="2307067035" sldId="302"/>
            <ac:spMk id="50" creationId="{065EA109-3923-4391-9D1F-87657F51028A}"/>
          </ac:spMkLst>
        </pc:spChg>
        <pc:spChg chg="mod">
          <ac:chgData name="Filippo Acconcia" userId="844af49c-a8a0-47ac-a7dd-14a44b60cd18" providerId="ADAL" clId="{B609A75A-164F-4066-A006-F59E853DC491}" dt="2022-03-28T07:44:16.204" v="325"/>
          <ac:spMkLst>
            <pc:docMk/>
            <pc:sldMk cId="2307067035" sldId="302"/>
            <ac:spMk id="51" creationId="{FA91F10E-A2CC-4491-B65A-8859419CBAC5}"/>
          </ac:spMkLst>
        </pc:spChg>
        <pc:spChg chg="mod">
          <ac:chgData name="Filippo Acconcia" userId="844af49c-a8a0-47ac-a7dd-14a44b60cd18" providerId="ADAL" clId="{B609A75A-164F-4066-A006-F59E853DC491}" dt="2022-03-28T07:44:16.204" v="325"/>
          <ac:spMkLst>
            <pc:docMk/>
            <pc:sldMk cId="2307067035" sldId="302"/>
            <ac:spMk id="52" creationId="{75FFF2A5-D73E-4D0F-BE4B-CA25D22A59E0}"/>
          </ac:spMkLst>
        </pc:spChg>
        <pc:spChg chg="mod">
          <ac:chgData name="Filippo Acconcia" userId="844af49c-a8a0-47ac-a7dd-14a44b60cd18" providerId="ADAL" clId="{B609A75A-164F-4066-A006-F59E853DC491}" dt="2022-03-28T07:44:16.204" v="325"/>
          <ac:spMkLst>
            <pc:docMk/>
            <pc:sldMk cId="2307067035" sldId="302"/>
            <ac:spMk id="53" creationId="{E59DB48C-1568-48F9-A7BD-9F8C2B512295}"/>
          </ac:spMkLst>
        </pc:spChg>
        <pc:spChg chg="mod">
          <ac:chgData name="Filippo Acconcia" userId="844af49c-a8a0-47ac-a7dd-14a44b60cd18" providerId="ADAL" clId="{B609A75A-164F-4066-A006-F59E853DC491}" dt="2022-03-28T07:44:16.204" v="325"/>
          <ac:spMkLst>
            <pc:docMk/>
            <pc:sldMk cId="2307067035" sldId="302"/>
            <ac:spMk id="54" creationId="{DEAB80A3-D7C6-46B4-99DC-33F386AB23FE}"/>
          </ac:spMkLst>
        </pc:spChg>
        <pc:spChg chg="mod">
          <ac:chgData name="Filippo Acconcia" userId="844af49c-a8a0-47ac-a7dd-14a44b60cd18" providerId="ADAL" clId="{B609A75A-164F-4066-A006-F59E853DC491}" dt="2022-03-28T07:44:16.204" v="325"/>
          <ac:spMkLst>
            <pc:docMk/>
            <pc:sldMk cId="2307067035" sldId="302"/>
            <ac:spMk id="55" creationId="{9FB9D37B-4340-442C-BCAE-F74DCAE48668}"/>
          </ac:spMkLst>
        </pc:spChg>
        <pc:spChg chg="mod">
          <ac:chgData name="Filippo Acconcia" userId="844af49c-a8a0-47ac-a7dd-14a44b60cd18" providerId="ADAL" clId="{B609A75A-164F-4066-A006-F59E853DC491}" dt="2022-03-28T07:44:16.204" v="325"/>
          <ac:spMkLst>
            <pc:docMk/>
            <pc:sldMk cId="2307067035" sldId="302"/>
            <ac:spMk id="56" creationId="{DDD86ABD-6BDE-4BC5-802F-1F23C1462A2C}"/>
          </ac:spMkLst>
        </pc:spChg>
        <pc:spChg chg="mod">
          <ac:chgData name="Filippo Acconcia" userId="844af49c-a8a0-47ac-a7dd-14a44b60cd18" providerId="ADAL" clId="{B609A75A-164F-4066-A006-F59E853DC491}" dt="2022-03-28T07:44:16.204" v="325"/>
          <ac:spMkLst>
            <pc:docMk/>
            <pc:sldMk cId="2307067035" sldId="302"/>
            <ac:spMk id="57" creationId="{286ECD8B-3C9D-4753-B7AF-FF35070ED12E}"/>
          </ac:spMkLst>
        </pc:spChg>
        <pc:spChg chg="mod">
          <ac:chgData name="Filippo Acconcia" userId="844af49c-a8a0-47ac-a7dd-14a44b60cd18" providerId="ADAL" clId="{B609A75A-164F-4066-A006-F59E853DC491}" dt="2022-03-28T07:44:16.204" v="325"/>
          <ac:spMkLst>
            <pc:docMk/>
            <pc:sldMk cId="2307067035" sldId="302"/>
            <ac:spMk id="58" creationId="{0CA6824A-E1A8-4854-B5CC-5881153B4511}"/>
          </ac:spMkLst>
        </pc:spChg>
        <pc:spChg chg="mod">
          <ac:chgData name="Filippo Acconcia" userId="844af49c-a8a0-47ac-a7dd-14a44b60cd18" providerId="ADAL" clId="{B609A75A-164F-4066-A006-F59E853DC491}" dt="2022-03-28T07:44:16.204" v="325"/>
          <ac:spMkLst>
            <pc:docMk/>
            <pc:sldMk cId="2307067035" sldId="302"/>
            <ac:spMk id="59" creationId="{67E23C50-C0BC-4881-82F1-0463765E3F0C}"/>
          </ac:spMkLst>
        </pc:spChg>
        <pc:spChg chg="add mod">
          <ac:chgData name="Filippo Acconcia" userId="844af49c-a8a0-47ac-a7dd-14a44b60cd18" providerId="ADAL" clId="{B609A75A-164F-4066-A006-F59E853DC491}" dt="2022-03-28T07:50:57.784" v="407" actId="1037"/>
          <ac:spMkLst>
            <pc:docMk/>
            <pc:sldMk cId="2307067035" sldId="302"/>
            <ac:spMk id="61" creationId="{6922C0BB-7C13-409F-93FE-2F1832C01227}"/>
          </ac:spMkLst>
        </pc:spChg>
        <pc:spChg chg="add mod">
          <ac:chgData name="Filippo Acconcia" userId="844af49c-a8a0-47ac-a7dd-14a44b60cd18" providerId="ADAL" clId="{B609A75A-164F-4066-A006-F59E853DC491}" dt="2022-03-28T07:51:05.210" v="408" actId="12788"/>
          <ac:spMkLst>
            <pc:docMk/>
            <pc:sldMk cId="2307067035" sldId="302"/>
            <ac:spMk id="62" creationId="{301321A7-69B4-4147-B218-1388CADB8946}"/>
          </ac:spMkLst>
        </pc:spChg>
        <pc:spChg chg="add mod">
          <ac:chgData name="Filippo Acconcia" userId="844af49c-a8a0-47ac-a7dd-14a44b60cd18" providerId="ADAL" clId="{B609A75A-164F-4066-A006-F59E853DC491}" dt="2022-03-28T07:50:57.784" v="407" actId="1037"/>
          <ac:spMkLst>
            <pc:docMk/>
            <pc:sldMk cId="2307067035" sldId="302"/>
            <ac:spMk id="63" creationId="{E2C144C3-99CE-472E-9125-F27F2C7CB954}"/>
          </ac:spMkLst>
        </pc:spChg>
        <pc:spChg chg="add mod">
          <ac:chgData name="Filippo Acconcia" userId="844af49c-a8a0-47ac-a7dd-14a44b60cd18" providerId="ADAL" clId="{B609A75A-164F-4066-A006-F59E853DC491}" dt="2022-03-28T07:51:05.210" v="408" actId="12788"/>
          <ac:spMkLst>
            <pc:docMk/>
            <pc:sldMk cId="2307067035" sldId="302"/>
            <ac:spMk id="64" creationId="{3B9ED728-373B-4F49-B89C-60DD32CB71A9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67" creationId="{77A04565-8DB8-4FB8-8978-C880EB964CDD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68" creationId="{3694221F-4A5F-4E39-8DC5-770A61B853D5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69" creationId="{4641109E-1805-48E6-9DEA-FBDBB6494916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70" creationId="{60274499-8FF3-4819-B5A7-777EAAE33B15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71" creationId="{EC92B580-9DAE-413B-9622-2D45B147CA08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72" creationId="{24B1E45E-C1C9-449A-B920-269126A993A3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73" creationId="{8B77D8C2-4F0F-4862-AAC3-50AEA78DD9AE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74" creationId="{AC4F6746-1E71-4126-B2B5-15B286D964EF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75" creationId="{23C178FA-51F0-40B2-A0B9-4B29A803BC1D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76" creationId="{2B6025B9-E930-421E-9DD4-3F28D134B024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77" creationId="{6859EB66-F2E2-4B32-8BD9-BBC481D7B6DB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78" creationId="{8D4EC3AB-312C-41B0-8496-FBF75C6E6C27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80" creationId="{DD0C9786-0DB0-4338-9E39-FE50C86B09DA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81" creationId="{446E567A-B262-4BF4-B6CF-61A4A590E81D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84" creationId="{35359487-6AEA-4838-BD45-0DA6C0F4B165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86" creationId="{FC0E80E2-3C02-47AA-BC35-AE76A69C7350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87" creationId="{7B2C5F20-D9FF-4638-ADAC-4E51094F1789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88" creationId="{D308313F-B440-45D7-BE71-B9F34AA36CE5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89" creationId="{1ADBACA0-83FF-466A-BF65-488D0DBAE762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90" creationId="{C20B9299-99CF-4953-860C-C0DFBBF8409A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91" creationId="{F0A15366-ED7B-4BC9-B34C-FF7360077A5D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92" creationId="{918C89DB-A194-485A-994D-89CFE4DCBA6C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93" creationId="{D42BAEA4-6E69-4E1C-A343-F4D18A0259F8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94" creationId="{F8CD4335-6895-4D26-B05D-9C7BF3D9BF44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95" creationId="{397A4A73-FC54-478C-9BEE-6E9EEFE367E0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96" creationId="{27F922E9-B076-408D-8552-9C2BB72A8A0D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97" creationId="{70116E7F-C93D-4FFE-B4CD-3FCC80F19361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99" creationId="{DA2F492E-03C5-4D85-9387-3C96FD27C33D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02" creationId="{FE7A7670-D662-4995-8D0D-C837E230DFD7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04" creationId="{FD992E47-7C79-4E37-B92D-8EDDEEF4C3C3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05" creationId="{B66348E8-5950-4104-9220-144B255450CE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06" creationId="{18F96A3A-2D09-49F8-A7E8-DE6CF9359CA8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07" creationId="{69979651-FB30-4A02-8E9A-EB7CD5ED2C0E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08" creationId="{7DE343C8-C69E-4E51-BC5D-ECBEA1BAF9BE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09" creationId="{5F521781-8657-4CF0-A2DE-6421B14F4551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10" creationId="{E4193FF6-8A46-4581-9793-BADF555BB14F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11" creationId="{F7B52921-3417-4F58-86A8-A90D279B423A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12" creationId="{2ED7EE37-B822-402D-B632-E3C085EB4312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13" creationId="{741D3C70-2282-4F98-B5D5-568965AFE8E0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14" creationId="{E061E1BD-479D-4D42-81EF-849F0E43FA74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15" creationId="{DF660FD4-1006-4836-8D32-B8DB02E9A78E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17" creationId="{8E6F11EF-D084-45EA-B846-A63EBF7C3DE4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20" creationId="{67489E71-EEE0-46BD-B082-7842B4538989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21" creationId="{FB85F03D-B8BD-40BD-8E43-E479DB56354D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22" creationId="{BFEBB782-5E54-4E4A-80EF-BADC59FA0937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23" creationId="{4A102856-401B-4326-AFAD-0FA3A4AC8EE9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24" creationId="{11703306-4225-4610-8B0F-50B8C724BA15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25" creationId="{164C4FF6-F036-4AF0-9B52-983BCF9036DB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26" creationId="{DB319B45-62DD-46AF-B889-4D0BE4B956F5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27" creationId="{8E1D3AC1-E08D-4DA9-8CB5-3A0AD973054C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28" creationId="{5B6F2DCC-A587-4ADA-A724-955B04D31C49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29" creationId="{31AF8A3A-D267-4F83-9414-342B0458188B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30" creationId="{A9F44C3F-5485-4FEE-8398-315B79A4FA34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31" creationId="{2BE2A7C4-99AB-427C-91EB-67FBF5282AF8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33" creationId="{00A43494-C9E5-4041-A0ED-9D3700408ECC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34" creationId="{365EDFC7-5FE5-4C71-A429-ECD381E6DE29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37" creationId="{BC32C671-3F48-449E-AA3B-CDA7DC3621B9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38" creationId="{D476BE44-4B8A-4E61-9F55-85FB9208C8D4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39" creationId="{8F1BD62C-EF12-47EE-B818-D4D2250C54BA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40" creationId="{25EFC395-4309-46B7-805D-7D7C28B2ADF9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41" creationId="{138CCB11-9A51-4710-B650-6493D4D31E7A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42" creationId="{36FB178C-8934-487E-B81D-2B27E27E69BF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43" creationId="{D45FD00F-7B92-43AA-913C-5D44D11BF780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44" creationId="{08682E96-2EA8-4C8D-BC1F-1220DAB5F1A6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45" creationId="{20025BE4-995E-4991-A77E-8BAC349E316C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46" creationId="{3E126B37-49C8-4085-AB1B-491E73572CD9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47" creationId="{E2877C0C-AF93-4614-A8D8-A83EC037DE05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48" creationId="{332B7948-0982-4D8A-AD56-1D1DD3B3DE83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49" creationId="{15D9D3F1-13D1-450B-B0E5-3252BBA55325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50" creationId="{B447FC79-D48B-44D6-9183-CB4F8A058A6E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51" creationId="{2ABCCF9F-E17C-4DD2-A522-AFE00C36C1CE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52" creationId="{2512EC3B-3C9E-4432-A5A9-622D6D9E15AA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53" creationId="{81F28CBB-AAAB-482A-B29F-1EA842D1C894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54" creationId="{A77273CF-3156-44C0-9B15-3F7C4D2A52D9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55" creationId="{A7D58D27-ACAB-4C69-BBA8-1CA7AAFA1C5A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56" creationId="{165BE934-B676-4AAA-8551-4F896E77B4B5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57" creationId="{1A0BCF70-7D72-4DE1-ABC2-159062335538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58" creationId="{0F6DAAC4-126B-4B55-99DF-5B71F5BBF76C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59" creationId="{484C3F30-988F-4E79-9A49-6666EF48C75C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60" creationId="{2B0F3DE6-E29D-4E80-91E7-B40DB59716C2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62" creationId="{D728D339-CB60-449E-A204-5DF86C4438A6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65" creationId="{15C8DB80-AFBA-4DC6-AD2E-1A6DC42C16A8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66" creationId="{92F4682F-BA61-4158-9F6A-762834E6D9C4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67" creationId="{EC3DD950-3752-49A4-8599-DF59CA922E47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68" creationId="{3B788687-434D-4177-A5B9-713300D40A00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69" creationId="{8D1D2398-C43C-4A3F-A15A-8D9CA8046C3E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70" creationId="{3AD0AB0F-1FC5-40B0-BA93-E7FBD078EAC4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71" creationId="{3321A2EF-0A35-482F-A7A5-7D9D0E3C5283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72" creationId="{0FC44226-B94D-4D6A-8210-002B4C7F99B7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73" creationId="{A0918B94-3789-4B6C-9191-E28D32DE5939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74" creationId="{0CCB560F-63FF-41A7-909C-AC3D4FC20F5E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75" creationId="{30BBAA2C-AC95-4E38-9EA5-3AC1762E3899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76" creationId="{E6197E20-D375-460A-9940-A09C413D052E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77" creationId="{C8092721-8833-4285-B62A-FD27B23B350E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78" creationId="{95C7DB4A-87B5-4F22-8C3A-E3CDB7D41956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79" creationId="{45B0353D-0609-4DD1-A4BF-F109F5A9EBF6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80" creationId="{821E1AA2-84F8-4053-A424-292FDB9E2FFE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81" creationId="{8B03998C-E6C7-4286-B753-BEEB591055F0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82" creationId="{A4547C48-8D99-441A-B7C8-CF4628FA4802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83" creationId="{1B66C2F8-55FC-4250-986F-748069EFE0A2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84" creationId="{F85026A9-4200-4DF6-A407-2D5A1316CE44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85" creationId="{14A20722-FCA4-4B93-A248-C50E22101750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87" creationId="{869C99FE-074A-40AC-B819-2CFD91A5EFF1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88" creationId="{4CB34522-AF42-4823-8BD9-CC06E0446634}"/>
          </ac:spMkLst>
        </pc:spChg>
        <pc:spChg chg="mod">
          <ac:chgData name="Filippo Acconcia" userId="844af49c-a8a0-47ac-a7dd-14a44b60cd18" providerId="ADAL" clId="{B609A75A-164F-4066-A006-F59E853DC491}" dt="2022-03-28T07:46:30.113" v="354"/>
          <ac:spMkLst>
            <pc:docMk/>
            <pc:sldMk cId="2307067035" sldId="302"/>
            <ac:spMk id="189" creationId="{833A0256-6CC3-4EDD-A8C2-199E0174CD6A}"/>
          </ac:spMkLst>
        </pc:spChg>
        <pc:spChg chg="add mod">
          <ac:chgData name="Filippo Acconcia" userId="844af49c-a8a0-47ac-a7dd-14a44b60cd18" providerId="ADAL" clId="{B609A75A-164F-4066-A006-F59E853DC491}" dt="2022-03-28T07:50:57.784" v="407" actId="1037"/>
          <ac:spMkLst>
            <pc:docMk/>
            <pc:sldMk cId="2307067035" sldId="302"/>
            <ac:spMk id="190" creationId="{66AB2529-AF2E-499A-A293-A25699845206}"/>
          </ac:spMkLst>
        </pc:spChg>
        <pc:spChg chg="add mod">
          <ac:chgData name="Filippo Acconcia" userId="844af49c-a8a0-47ac-a7dd-14a44b60cd18" providerId="ADAL" clId="{B609A75A-164F-4066-A006-F59E853DC491}" dt="2022-03-28T07:51:05.210" v="408" actId="12788"/>
          <ac:spMkLst>
            <pc:docMk/>
            <pc:sldMk cId="2307067035" sldId="302"/>
            <ac:spMk id="191" creationId="{FD99DBB9-6F9A-4DD3-848A-6DF6EB7ECE28}"/>
          </ac:spMkLst>
        </pc:spChg>
        <pc:spChg chg="add mod">
          <ac:chgData name="Filippo Acconcia" userId="844af49c-a8a0-47ac-a7dd-14a44b60cd18" providerId="ADAL" clId="{B609A75A-164F-4066-A006-F59E853DC491}" dt="2022-03-28T07:50:57.784" v="407" actId="1037"/>
          <ac:spMkLst>
            <pc:docMk/>
            <pc:sldMk cId="2307067035" sldId="302"/>
            <ac:spMk id="192" creationId="{37DE3FBD-0C2B-4524-9FF0-466EA0724261}"/>
          </ac:spMkLst>
        </pc:spChg>
        <pc:spChg chg="add mod">
          <ac:chgData name="Filippo Acconcia" userId="844af49c-a8a0-47ac-a7dd-14a44b60cd18" providerId="ADAL" clId="{B609A75A-164F-4066-A006-F59E853DC491}" dt="2022-03-28T07:51:05.210" v="408" actId="12788"/>
          <ac:spMkLst>
            <pc:docMk/>
            <pc:sldMk cId="2307067035" sldId="302"/>
            <ac:spMk id="193" creationId="{13FFDA18-F145-474C-8E71-C2D24E03664E}"/>
          </ac:spMkLst>
        </pc:spChg>
        <pc:spChg chg="add mod">
          <ac:chgData name="Filippo Acconcia" userId="844af49c-a8a0-47ac-a7dd-14a44b60cd18" providerId="ADAL" clId="{B609A75A-164F-4066-A006-F59E853DC491}" dt="2022-03-28T07:50:57.784" v="407" actId="1037"/>
          <ac:spMkLst>
            <pc:docMk/>
            <pc:sldMk cId="2307067035" sldId="302"/>
            <ac:spMk id="194" creationId="{CDC8E2FA-B501-42F3-A144-8DD4DB640E43}"/>
          </ac:spMkLst>
        </pc:spChg>
        <pc:spChg chg="add mod">
          <ac:chgData name="Filippo Acconcia" userId="844af49c-a8a0-47ac-a7dd-14a44b60cd18" providerId="ADAL" clId="{B609A75A-164F-4066-A006-F59E853DC491}" dt="2022-03-28T07:51:05.210" v="408" actId="12788"/>
          <ac:spMkLst>
            <pc:docMk/>
            <pc:sldMk cId="2307067035" sldId="302"/>
            <ac:spMk id="195" creationId="{C2EFE8F3-22EE-4A8A-ABE9-9CFFB4F6F230}"/>
          </ac:spMkLst>
        </pc:spChg>
        <pc:grpChg chg="add mod">
          <ac:chgData name="Filippo Acconcia" userId="844af49c-a8a0-47ac-a7dd-14a44b60cd18" providerId="ADAL" clId="{B609A75A-164F-4066-A006-F59E853DC491}" dt="2022-03-28T07:47:14.963" v="392" actId="1035"/>
          <ac:grpSpMkLst>
            <pc:docMk/>
            <pc:sldMk cId="2307067035" sldId="302"/>
            <ac:grpSpMk id="3" creationId="{4B2C2836-7F11-4B1E-A829-33FBBFA1A42A}"/>
          </ac:grpSpMkLst>
        </pc:grpChg>
        <pc:grpChg chg="add mod">
          <ac:chgData name="Filippo Acconcia" userId="844af49c-a8a0-47ac-a7dd-14a44b60cd18" providerId="ADAL" clId="{B609A75A-164F-4066-A006-F59E853DC491}" dt="2022-03-28T07:47:14.963" v="392" actId="1035"/>
          <ac:grpSpMkLst>
            <pc:docMk/>
            <pc:sldMk cId="2307067035" sldId="302"/>
            <ac:grpSpMk id="17" creationId="{D3F3FDC7-BFD8-4374-8EBA-38F750233C6B}"/>
          </ac:grpSpMkLst>
        </pc:grpChg>
        <pc:grpChg chg="add mod">
          <ac:chgData name="Filippo Acconcia" userId="844af49c-a8a0-47ac-a7dd-14a44b60cd18" providerId="ADAL" clId="{B609A75A-164F-4066-A006-F59E853DC491}" dt="2022-03-28T07:47:14.963" v="392" actId="1035"/>
          <ac:grpSpMkLst>
            <pc:docMk/>
            <pc:sldMk cId="2307067035" sldId="302"/>
            <ac:grpSpMk id="31" creationId="{BC2DFB6B-1CDA-473C-B1BA-C9691DF202D6}"/>
          </ac:grpSpMkLst>
        </pc:grpChg>
        <pc:grpChg chg="add mod">
          <ac:chgData name="Filippo Acconcia" userId="844af49c-a8a0-47ac-a7dd-14a44b60cd18" providerId="ADAL" clId="{B609A75A-164F-4066-A006-F59E853DC491}" dt="2022-03-28T07:47:14.963" v="392" actId="1035"/>
          <ac:grpSpMkLst>
            <pc:docMk/>
            <pc:sldMk cId="2307067035" sldId="302"/>
            <ac:grpSpMk id="46" creationId="{8E7AE439-5174-40DE-AE5B-A25F70D0BFEB}"/>
          </ac:grpSpMkLst>
        </pc:grpChg>
        <pc:grpChg chg="add mod">
          <ac:chgData name="Filippo Acconcia" userId="844af49c-a8a0-47ac-a7dd-14a44b60cd18" providerId="ADAL" clId="{B609A75A-164F-4066-A006-F59E853DC491}" dt="2022-03-28T07:47:14.963" v="392" actId="1035"/>
          <ac:grpSpMkLst>
            <pc:docMk/>
            <pc:sldMk cId="2307067035" sldId="302"/>
            <ac:grpSpMk id="65" creationId="{4DB9F742-6131-4665-A145-802A22CB013A}"/>
          </ac:grpSpMkLst>
        </pc:grpChg>
        <pc:grpChg chg="add mod">
          <ac:chgData name="Filippo Acconcia" userId="844af49c-a8a0-47ac-a7dd-14a44b60cd18" providerId="ADAL" clId="{B609A75A-164F-4066-A006-F59E853DC491}" dt="2022-03-28T07:47:14.963" v="392" actId="1035"/>
          <ac:grpSpMkLst>
            <pc:docMk/>
            <pc:sldMk cId="2307067035" sldId="302"/>
            <ac:grpSpMk id="82" creationId="{19C8D64A-9DF6-47CF-ADEF-D3EFFFFDDA21}"/>
          </ac:grpSpMkLst>
        </pc:grpChg>
        <pc:grpChg chg="mod">
          <ac:chgData name="Filippo Acconcia" userId="844af49c-a8a0-47ac-a7dd-14a44b60cd18" providerId="ADAL" clId="{B609A75A-164F-4066-A006-F59E853DC491}" dt="2022-03-28T07:46:30.113" v="354"/>
          <ac:grpSpMkLst>
            <pc:docMk/>
            <pc:sldMk cId="2307067035" sldId="302"/>
            <ac:grpSpMk id="83" creationId="{43BB6C14-CA56-4C4F-9C3D-3B040F093363}"/>
          </ac:grpSpMkLst>
        </pc:grpChg>
        <pc:grpChg chg="add mod">
          <ac:chgData name="Filippo Acconcia" userId="844af49c-a8a0-47ac-a7dd-14a44b60cd18" providerId="ADAL" clId="{B609A75A-164F-4066-A006-F59E853DC491}" dt="2022-03-28T07:47:14.963" v="392" actId="1035"/>
          <ac:grpSpMkLst>
            <pc:docMk/>
            <pc:sldMk cId="2307067035" sldId="302"/>
            <ac:grpSpMk id="100" creationId="{0F10B6E2-C54F-4709-897B-4825D1D1B210}"/>
          </ac:grpSpMkLst>
        </pc:grpChg>
        <pc:grpChg chg="mod">
          <ac:chgData name="Filippo Acconcia" userId="844af49c-a8a0-47ac-a7dd-14a44b60cd18" providerId="ADAL" clId="{B609A75A-164F-4066-A006-F59E853DC491}" dt="2022-03-28T07:46:30.113" v="354"/>
          <ac:grpSpMkLst>
            <pc:docMk/>
            <pc:sldMk cId="2307067035" sldId="302"/>
            <ac:grpSpMk id="101" creationId="{798E0C87-3600-4929-B671-A0CF62A3D05C}"/>
          </ac:grpSpMkLst>
        </pc:grpChg>
        <pc:grpChg chg="add mod">
          <ac:chgData name="Filippo Acconcia" userId="844af49c-a8a0-47ac-a7dd-14a44b60cd18" providerId="ADAL" clId="{B609A75A-164F-4066-A006-F59E853DC491}" dt="2022-03-28T07:47:14.963" v="392" actId="1035"/>
          <ac:grpSpMkLst>
            <pc:docMk/>
            <pc:sldMk cId="2307067035" sldId="302"/>
            <ac:grpSpMk id="118" creationId="{9D070C9B-7C4E-4DA5-9569-7144F2C7F434}"/>
          </ac:grpSpMkLst>
        </pc:grpChg>
        <pc:grpChg chg="add mod">
          <ac:chgData name="Filippo Acconcia" userId="844af49c-a8a0-47ac-a7dd-14a44b60cd18" providerId="ADAL" clId="{B609A75A-164F-4066-A006-F59E853DC491}" dt="2022-03-28T07:47:14.963" v="392" actId="1035"/>
          <ac:grpSpMkLst>
            <pc:docMk/>
            <pc:sldMk cId="2307067035" sldId="302"/>
            <ac:grpSpMk id="135" creationId="{B0D69B71-AB4B-47FD-8D2E-A8B4D16853EE}"/>
          </ac:grpSpMkLst>
        </pc:grpChg>
        <pc:grpChg chg="add mod">
          <ac:chgData name="Filippo Acconcia" userId="844af49c-a8a0-47ac-a7dd-14a44b60cd18" providerId="ADAL" clId="{B609A75A-164F-4066-A006-F59E853DC491}" dt="2022-03-28T07:47:14.963" v="392" actId="1035"/>
          <ac:grpSpMkLst>
            <pc:docMk/>
            <pc:sldMk cId="2307067035" sldId="302"/>
            <ac:grpSpMk id="163" creationId="{E67CAB09-F861-4842-A463-5B3414763FC4}"/>
          </ac:grpSpMkLst>
        </pc:grpChg>
        <pc:picChg chg="mod">
          <ac:chgData name="Filippo Acconcia" userId="844af49c-a8a0-47ac-a7dd-14a44b60cd18" providerId="ADAL" clId="{B609A75A-164F-4066-A006-F59E853DC491}" dt="2022-03-28T07:43:57.956" v="322"/>
          <ac:picMkLst>
            <pc:docMk/>
            <pc:sldMk cId="2307067035" sldId="302"/>
            <ac:picMk id="4" creationId="{BAD7A9D0-AC7E-495E-BDA5-B5B993739C5C}"/>
          </ac:picMkLst>
        </pc:picChg>
        <pc:picChg chg="mod">
          <ac:chgData name="Filippo Acconcia" userId="844af49c-a8a0-47ac-a7dd-14a44b60cd18" providerId="ADAL" clId="{B609A75A-164F-4066-A006-F59E853DC491}" dt="2022-03-28T07:43:57.956" v="322"/>
          <ac:picMkLst>
            <pc:docMk/>
            <pc:sldMk cId="2307067035" sldId="302"/>
            <ac:picMk id="5" creationId="{2A2BD71D-0213-4216-9923-DE6A5DE32414}"/>
          </ac:picMkLst>
        </pc:picChg>
        <pc:picChg chg="mod">
          <ac:chgData name="Filippo Acconcia" userId="844af49c-a8a0-47ac-a7dd-14a44b60cd18" providerId="ADAL" clId="{B609A75A-164F-4066-A006-F59E853DC491}" dt="2022-03-28T07:43:57.956" v="322"/>
          <ac:picMkLst>
            <pc:docMk/>
            <pc:sldMk cId="2307067035" sldId="302"/>
            <ac:picMk id="18" creationId="{ECBE3058-4EE7-4714-A2D6-DB8C96F5D362}"/>
          </ac:picMkLst>
        </pc:picChg>
        <pc:picChg chg="mod">
          <ac:chgData name="Filippo Acconcia" userId="844af49c-a8a0-47ac-a7dd-14a44b60cd18" providerId="ADAL" clId="{B609A75A-164F-4066-A006-F59E853DC491}" dt="2022-03-28T07:43:57.956" v="322"/>
          <ac:picMkLst>
            <pc:docMk/>
            <pc:sldMk cId="2307067035" sldId="302"/>
            <ac:picMk id="30" creationId="{B408DA22-BC21-4086-9141-DA0710295B6D}"/>
          </ac:picMkLst>
        </pc:picChg>
        <pc:picChg chg="mod">
          <ac:chgData name="Filippo Acconcia" userId="844af49c-a8a0-47ac-a7dd-14a44b60cd18" providerId="ADAL" clId="{B609A75A-164F-4066-A006-F59E853DC491}" dt="2022-03-28T07:44:16.204" v="325"/>
          <ac:picMkLst>
            <pc:docMk/>
            <pc:sldMk cId="2307067035" sldId="302"/>
            <ac:picMk id="32" creationId="{D8366E1E-1675-45A7-A4D3-6050FB3DC32C}"/>
          </ac:picMkLst>
        </pc:picChg>
        <pc:picChg chg="mod">
          <ac:chgData name="Filippo Acconcia" userId="844af49c-a8a0-47ac-a7dd-14a44b60cd18" providerId="ADAL" clId="{B609A75A-164F-4066-A006-F59E853DC491}" dt="2022-03-28T07:44:16.204" v="325"/>
          <ac:picMkLst>
            <pc:docMk/>
            <pc:sldMk cId="2307067035" sldId="302"/>
            <ac:picMk id="47" creationId="{6FEB75BA-803C-416B-8217-0EE22A2813ED}"/>
          </ac:picMkLst>
        </pc:picChg>
        <pc:picChg chg="mod">
          <ac:chgData name="Filippo Acconcia" userId="844af49c-a8a0-47ac-a7dd-14a44b60cd18" providerId="ADAL" clId="{B609A75A-164F-4066-A006-F59E853DC491}" dt="2022-03-28T07:46:30.113" v="354"/>
          <ac:picMkLst>
            <pc:docMk/>
            <pc:sldMk cId="2307067035" sldId="302"/>
            <ac:picMk id="66" creationId="{80A26390-BA48-4CDA-8F50-9605A23598A4}"/>
          </ac:picMkLst>
        </pc:picChg>
        <pc:picChg chg="mod">
          <ac:chgData name="Filippo Acconcia" userId="844af49c-a8a0-47ac-a7dd-14a44b60cd18" providerId="ADAL" clId="{B609A75A-164F-4066-A006-F59E853DC491}" dt="2022-03-28T07:46:30.113" v="354"/>
          <ac:picMkLst>
            <pc:docMk/>
            <pc:sldMk cId="2307067035" sldId="302"/>
            <ac:picMk id="85" creationId="{75F3CE48-2AAC-436C-8128-99A4A7576124}"/>
          </ac:picMkLst>
        </pc:picChg>
        <pc:picChg chg="mod">
          <ac:chgData name="Filippo Acconcia" userId="844af49c-a8a0-47ac-a7dd-14a44b60cd18" providerId="ADAL" clId="{B609A75A-164F-4066-A006-F59E853DC491}" dt="2022-03-28T07:46:30.113" v="354"/>
          <ac:picMkLst>
            <pc:docMk/>
            <pc:sldMk cId="2307067035" sldId="302"/>
            <ac:picMk id="103" creationId="{AFE700C7-5D3A-4B81-A842-F91ED71C903D}"/>
          </ac:picMkLst>
        </pc:picChg>
        <pc:picChg chg="mod">
          <ac:chgData name="Filippo Acconcia" userId="844af49c-a8a0-47ac-a7dd-14a44b60cd18" providerId="ADAL" clId="{B609A75A-164F-4066-A006-F59E853DC491}" dt="2022-03-28T07:46:30.113" v="354"/>
          <ac:picMkLst>
            <pc:docMk/>
            <pc:sldMk cId="2307067035" sldId="302"/>
            <ac:picMk id="119" creationId="{F28EAB44-8F4C-4941-9AAB-831FA2060B3D}"/>
          </ac:picMkLst>
        </pc:picChg>
        <pc:picChg chg="mod">
          <ac:chgData name="Filippo Acconcia" userId="844af49c-a8a0-47ac-a7dd-14a44b60cd18" providerId="ADAL" clId="{B609A75A-164F-4066-A006-F59E853DC491}" dt="2022-03-28T07:46:30.113" v="354"/>
          <ac:picMkLst>
            <pc:docMk/>
            <pc:sldMk cId="2307067035" sldId="302"/>
            <ac:picMk id="136" creationId="{0752AC99-C942-4DDC-A664-A35538825075}"/>
          </ac:picMkLst>
        </pc:picChg>
        <pc:picChg chg="mod">
          <ac:chgData name="Filippo Acconcia" userId="844af49c-a8a0-47ac-a7dd-14a44b60cd18" providerId="ADAL" clId="{B609A75A-164F-4066-A006-F59E853DC491}" dt="2022-03-28T07:46:30.113" v="354"/>
          <ac:picMkLst>
            <pc:docMk/>
            <pc:sldMk cId="2307067035" sldId="302"/>
            <ac:picMk id="164" creationId="{269A9610-FC39-481F-BEA5-22675473647C}"/>
          </ac:picMkLst>
        </pc:picChg>
        <pc:cxnChg chg="mod">
          <ac:chgData name="Filippo Acconcia" userId="844af49c-a8a0-47ac-a7dd-14a44b60cd18" providerId="ADAL" clId="{B609A75A-164F-4066-A006-F59E853DC491}" dt="2022-03-28T07:43:57.956" v="322"/>
          <ac:cxnSpMkLst>
            <pc:docMk/>
            <pc:sldMk cId="2307067035" sldId="302"/>
            <ac:cxnSpMk id="6" creationId="{7D2504E0-274C-479B-9E11-FC5BF070981B}"/>
          </ac:cxnSpMkLst>
        </pc:cxnChg>
        <pc:cxnChg chg="mod">
          <ac:chgData name="Filippo Acconcia" userId="844af49c-a8a0-47ac-a7dd-14a44b60cd18" providerId="ADAL" clId="{B609A75A-164F-4066-A006-F59E853DC491}" dt="2022-03-28T07:43:57.956" v="322"/>
          <ac:cxnSpMkLst>
            <pc:docMk/>
            <pc:sldMk cId="2307067035" sldId="302"/>
            <ac:cxnSpMk id="15" creationId="{E3757363-C898-4B35-8853-1637A4223597}"/>
          </ac:cxnSpMkLst>
        </pc:cxnChg>
        <pc:cxnChg chg="mod">
          <ac:chgData name="Filippo Acconcia" userId="844af49c-a8a0-47ac-a7dd-14a44b60cd18" providerId="ADAL" clId="{B609A75A-164F-4066-A006-F59E853DC491}" dt="2022-03-28T07:43:57.956" v="322"/>
          <ac:cxnSpMkLst>
            <pc:docMk/>
            <pc:sldMk cId="2307067035" sldId="302"/>
            <ac:cxnSpMk id="19" creationId="{C7770BC5-2483-4661-A141-E2725D69B186}"/>
          </ac:cxnSpMkLst>
        </pc:cxnChg>
        <pc:cxnChg chg="mod">
          <ac:chgData name="Filippo Acconcia" userId="844af49c-a8a0-47ac-a7dd-14a44b60cd18" providerId="ADAL" clId="{B609A75A-164F-4066-A006-F59E853DC491}" dt="2022-03-28T07:43:57.956" v="322"/>
          <ac:cxnSpMkLst>
            <pc:docMk/>
            <pc:sldMk cId="2307067035" sldId="302"/>
            <ac:cxnSpMk id="28" creationId="{709FD97A-7722-4BD3-B194-6014BE88A44E}"/>
          </ac:cxnSpMkLst>
        </pc:cxnChg>
        <pc:cxnChg chg="mod">
          <ac:chgData name="Filippo Acconcia" userId="844af49c-a8a0-47ac-a7dd-14a44b60cd18" providerId="ADAL" clId="{B609A75A-164F-4066-A006-F59E853DC491}" dt="2022-03-28T07:44:16.204" v="325"/>
          <ac:cxnSpMkLst>
            <pc:docMk/>
            <pc:sldMk cId="2307067035" sldId="302"/>
            <ac:cxnSpMk id="45" creationId="{BFAA0EE3-2BEB-4D4E-B7FC-9C1BB1679707}"/>
          </ac:cxnSpMkLst>
        </pc:cxnChg>
        <pc:cxnChg chg="mod">
          <ac:chgData name="Filippo Acconcia" userId="844af49c-a8a0-47ac-a7dd-14a44b60cd18" providerId="ADAL" clId="{B609A75A-164F-4066-A006-F59E853DC491}" dt="2022-03-28T07:44:16.204" v="325"/>
          <ac:cxnSpMkLst>
            <pc:docMk/>
            <pc:sldMk cId="2307067035" sldId="302"/>
            <ac:cxnSpMk id="60" creationId="{63C3D013-0061-4FDA-A362-787ABCEFD35E}"/>
          </ac:cxnSpMkLst>
        </pc:cxnChg>
        <pc:cxnChg chg="mod">
          <ac:chgData name="Filippo Acconcia" userId="844af49c-a8a0-47ac-a7dd-14a44b60cd18" providerId="ADAL" clId="{B609A75A-164F-4066-A006-F59E853DC491}" dt="2022-03-28T07:46:30.113" v="354"/>
          <ac:cxnSpMkLst>
            <pc:docMk/>
            <pc:sldMk cId="2307067035" sldId="302"/>
            <ac:cxnSpMk id="79" creationId="{2F5BE2CE-B868-4D60-BAE7-E6EB4809C2FB}"/>
          </ac:cxnSpMkLst>
        </pc:cxnChg>
        <pc:cxnChg chg="mod">
          <ac:chgData name="Filippo Acconcia" userId="844af49c-a8a0-47ac-a7dd-14a44b60cd18" providerId="ADAL" clId="{B609A75A-164F-4066-A006-F59E853DC491}" dt="2022-03-28T07:46:30.113" v="354"/>
          <ac:cxnSpMkLst>
            <pc:docMk/>
            <pc:sldMk cId="2307067035" sldId="302"/>
            <ac:cxnSpMk id="98" creationId="{C4D91BB4-D3A3-4D36-B51E-97D33B1D39B4}"/>
          </ac:cxnSpMkLst>
        </pc:cxnChg>
        <pc:cxnChg chg="mod">
          <ac:chgData name="Filippo Acconcia" userId="844af49c-a8a0-47ac-a7dd-14a44b60cd18" providerId="ADAL" clId="{B609A75A-164F-4066-A006-F59E853DC491}" dt="2022-03-28T07:46:30.113" v="354"/>
          <ac:cxnSpMkLst>
            <pc:docMk/>
            <pc:sldMk cId="2307067035" sldId="302"/>
            <ac:cxnSpMk id="116" creationId="{BC24E35D-E970-4A63-B310-FEDCBEB31356}"/>
          </ac:cxnSpMkLst>
        </pc:cxnChg>
        <pc:cxnChg chg="mod">
          <ac:chgData name="Filippo Acconcia" userId="844af49c-a8a0-47ac-a7dd-14a44b60cd18" providerId="ADAL" clId="{B609A75A-164F-4066-A006-F59E853DC491}" dt="2022-03-28T07:46:30.113" v="354"/>
          <ac:cxnSpMkLst>
            <pc:docMk/>
            <pc:sldMk cId="2307067035" sldId="302"/>
            <ac:cxnSpMk id="132" creationId="{7E472366-925E-4162-BF56-671D19C7477D}"/>
          </ac:cxnSpMkLst>
        </pc:cxnChg>
        <pc:cxnChg chg="mod">
          <ac:chgData name="Filippo Acconcia" userId="844af49c-a8a0-47ac-a7dd-14a44b60cd18" providerId="ADAL" clId="{B609A75A-164F-4066-A006-F59E853DC491}" dt="2022-03-28T07:46:30.113" v="354"/>
          <ac:cxnSpMkLst>
            <pc:docMk/>
            <pc:sldMk cId="2307067035" sldId="302"/>
            <ac:cxnSpMk id="161" creationId="{C20F1291-F11C-4F11-9B3C-667D8BD5CC7D}"/>
          </ac:cxnSpMkLst>
        </pc:cxnChg>
        <pc:cxnChg chg="mod">
          <ac:chgData name="Filippo Acconcia" userId="844af49c-a8a0-47ac-a7dd-14a44b60cd18" providerId="ADAL" clId="{B609A75A-164F-4066-A006-F59E853DC491}" dt="2022-03-28T07:46:30.113" v="354"/>
          <ac:cxnSpMkLst>
            <pc:docMk/>
            <pc:sldMk cId="2307067035" sldId="302"/>
            <ac:cxnSpMk id="186" creationId="{CC8B3237-8B0E-45B3-BC9F-9B231A3B2577}"/>
          </ac:cxnSpMkLst>
        </pc:cxnChg>
      </pc:sldChg>
      <pc:sldChg chg="addSp delSp modSp new mod">
        <pc:chgData name="Filippo Acconcia" userId="844af49c-a8a0-47ac-a7dd-14a44b60cd18" providerId="ADAL" clId="{B609A75A-164F-4066-A006-F59E853DC491}" dt="2022-04-29T07:39:17.186" v="1976" actId="1038"/>
        <pc:sldMkLst>
          <pc:docMk/>
          <pc:sldMk cId="2248971367" sldId="303"/>
        </pc:sldMkLst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4" creationId="{7292C10C-0C51-4FDA-A050-AF63C032AD94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5" creationId="{4F522E5E-55C7-4349-A1A6-5BDFC2DD1B42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6" creationId="{0A4403AF-2F37-4A93-8379-56CD56136ECA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7" creationId="{843DC044-1D4C-4D3F-92F3-E374316408A8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8" creationId="{184A257C-21BF-4575-A47B-5C20DE8D6EFC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9" creationId="{858AFCC9-0B70-4A48-AC1D-6E2D1453BACF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10" creationId="{0977ADA9-BCC0-43A0-B1DB-E76FDB4CED79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11" creationId="{CD57B0A8-14C2-4403-9ECD-D2DC611E4C26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12" creationId="{19534475-1C40-4441-97EF-D4DCE0B2CBA0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13" creationId="{55874CD1-F769-420B-9C44-785A045EE985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14" creationId="{34F39BC2-A3C4-46DA-A8A7-34702F227130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15" creationId="{684F9BB8-0DF1-4DA5-9273-40A6DC445F55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16" creationId="{AD14C992-9167-4719-8D19-7B431BBDD3E2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17" creationId="{14AC4CD7-AF1F-42B8-81EF-D1F0F27C8F26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18" creationId="{109158F2-AD45-4673-9DA3-398A1DE398E0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19" creationId="{C4234AA4-2ED1-44A1-9DE6-BFE474D8D970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20" creationId="{0B9AE35F-F792-4618-93DA-9F88F36D4582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21" creationId="{F3A45031-6113-48A2-9370-BC2FAD4E7220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22" creationId="{904FB87B-DAE9-43C2-95BE-013195B24126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23" creationId="{79C6CDF2-B80B-4AF8-9EC5-23391BFED695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24" creationId="{7923E780-7AD0-4B44-AE0A-ED92945F7304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25" creationId="{E425B345-CE24-4583-BF5F-ACE7270C740F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26" creationId="{082C8E68-CF20-4984-A938-07EE273BA8C1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27" creationId="{425437DA-2264-4E50-A831-21B52D8585DF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28" creationId="{626263A2-6E69-4523-A07D-BDF4DFC85753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29" creationId="{912E34A7-2E00-486D-B739-3B6D871302E0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30" creationId="{D396CF2B-555F-42E4-96AE-DF6375EC6D52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31" creationId="{780EBCE3-26C8-42B8-89E1-81BF57BD30EF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32" creationId="{78144D58-8032-45F9-9011-4C4FA2A77352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33" creationId="{6384062C-0B16-4EAD-8C64-A2009BE9D499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34" creationId="{BD80920A-E538-4173-9542-5EC1D25C7181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35" creationId="{E180B045-FC6E-415D-8DA0-F0748E32C4E8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36" creationId="{4CE1B2F5-9828-48D5-AF02-8AC7D4099E0E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37" creationId="{D2B54421-7915-4435-A82D-D7647EC58DD4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38" creationId="{5A02F500-904D-4461-9F2B-A615300512EA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39" creationId="{1F70C17C-98B4-49FC-AAAD-7E1980CE8B29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40" creationId="{AEBC2408-A120-4B55-8844-548DC0030848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41" creationId="{EC6475DF-ADB5-470E-BF83-2B1829E1D830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42" creationId="{BAA4B575-57DD-4FF1-B264-4D6000DC684B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43" creationId="{7A627573-73F9-4359-AF25-221D05C0D4A8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44" creationId="{864256C5-B674-444A-8E0F-B2A3895EBC62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45" creationId="{0BB1BF75-8406-4C46-8F34-44D7010967C8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46" creationId="{85AA8C08-D3C1-4590-A540-BABB0AE5718E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47" creationId="{6623846D-A2A3-46F0-B28B-C9D89C7A4226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48" creationId="{9E4EA226-3348-4105-AFC7-BD20B766390E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49" creationId="{44E58596-2E0F-4022-898D-661A16F72B61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50" creationId="{C36EB95D-64BE-418E-BF34-A91659C7C553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51" creationId="{02DFD617-7E65-4DB2-9503-DCEB006435E9}"/>
          </ac:spMkLst>
        </pc:spChg>
        <pc:spChg chg="mod">
          <ac:chgData name="Filippo Acconcia" userId="844af49c-a8a0-47ac-a7dd-14a44b60cd18" providerId="ADAL" clId="{B609A75A-164F-4066-A006-F59E853DC491}" dt="2022-04-01T07:31:33.901" v="1088"/>
          <ac:spMkLst>
            <pc:docMk/>
            <pc:sldMk cId="2248971367" sldId="303"/>
            <ac:spMk id="52" creationId="{52ED955D-570A-46CA-A95D-BCBA4DAABC15}"/>
          </ac:spMkLst>
        </pc:spChg>
        <pc:spChg chg="add mod">
          <ac:chgData name="Filippo Acconcia" userId="844af49c-a8a0-47ac-a7dd-14a44b60cd18" providerId="ADAL" clId="{B609A75A-164F-4066-A006-F59E853DC491}" dt="2022-04-01T07:31:42.710" v="1090" actId="20577"/>
          <ac:spMkLst>
            <pc:docMk/>
            <pc:sldMk cId="2248971367" sldId="303"/>
            <ac:spMk id="53" creationId="{066D7556-77C7-44D9-BFDD-1EA1FF5DA3DB}"/>
          </ac:spMkLst>
        </pc:spChg>
        <pc:spChg chg="add mod">
          <ac:chgData name="Filippo Acconcia" userId="844af49c-a8a0-47ac-a7dd-14a44b60cd18" providerId="ADAL" clId="{B609A75A-164F-4066-A006-F59E853DC491}" dt="2022-04-29T07:39:17.186" v="1976" actId="1038"/>
          <ac:spMkLst>
            <pc:docMk/>
            <pc:sldMk cId="2248971367" sldId="303"/>
            <ac:spMk id="54" creationId="{235815AB-1DD5-4B7C-B34E-2A69F262252D}"/>
          </ac:spMkLst>
        </pc:spChg>
        <pc:spChg chg="add mod">
          <ac:chgData name="Filippo Acconcia" userId="844af49c-a8a0-47ac-a7dd-14a44b60cd18" providerId="ADAL" clId="{B609A75A-164F-4066-A006-F59E853DC491}" dt="2022-04-29T07:39:17.186" v="1976" actId="1038"/>
          <ac:spMkLst>
            <pc:docMk/>
            <pc:sldMk cId="2248971367" sldId="303"/>
            <ac:spMk id="55" creationId="{CBF44166-1A91-4A7B-B47B-004685A4E37F}"/>
          </ac:spMkLst>
        </pc:spChg>
        <pc:spChg chg="add del mod">
          <ac:chgData name="Filippo Acconcia" userId="844af49c-a8a0-47ac-a7dd-14a44b60cd18" providerId="ADAL" clId="{B609A75A-164F-4066-A006-F59E853DC491}" dt="2022-04-01T08:55:57.926" v="1314" actId="478"/>
          <ac:spMkLst>
            <pc:docMk/>
            <pc:sldMk cId="2248971367" sldId="303"/>
            <ac:spMk id="56" creationId="{E4BB6D7A-6703-44F4-82C1-13935AC30E17}"/>
          </ac:spMkLst>
        </pc:spChg>
        <pc:spChg chg="add mod">
          <ac:chgData name="Filippo Acconcia" userId="844af49c-a8a0-47ac-a7dd-14a44b60cd18" providerId="ADAL" clId="{B609A75A-164F-4066-A006-F59E853DC491}" dt="2022-04-29T07:39:17.186" v="1976" actId="1038"/>
          <ac:spMkLst>
            <pc:docMk/>
            <pc:sldMk cId="2248971367" sldId="303"/>
            <ac:spMk id="57" creationId="{C0E3BF50-FE3B-4DFA-943B-F8F41333CD7C}"/>
          </ac:spMkLst>
        </pc:spChg>
        <pc:spChg chg="add del mod">
          <ac:chgData name="Filippo Acconcia" userId="844af49c-a8a0-47ac-a7dd-14a44b60cd18" providerId="ADAL" clId="{B609A75A-164F-4066-A006-F59E853DC491}" dt="2022-04-01T09:48:38.571" v="1590" actId="478"/>
          <ac:spMkLst>
            <pc:docMk/>
            <pc:sldMk cId="2248971367" sldId="303"/>
            <ac:spMk id="58" creationId="{28BE3A3F-ED14-45C7-813E-425E7BDA66BF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60" creationId="{8FE50CFB-41DE-4297-90CC-1438ECF70E17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61" creationId="{868AA059-D9ED-4045-A008-18357EABE372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62" creationId="{9FCDB617-A432-4D2C-B43A-14F641A5B296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63" creationId="{2627E9B9-CEF6-46A3-8CD4-A74BDBAF9DDD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64" creationId="{058AC6F9-ADC6-41C7-98F9-32D60E31D6D9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65" creationId="{CB7EE5FE-2876-4BCE-8747-9A0CFF4043D2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66" creationId="{118B9461-E82B-4072-9530-CEE8D38D1D22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67" creationId="{51D53B96-9861-43EA-9093-82D1147A949B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75" creationId="{03A3E6D9-80E9-4B3D-80EB-A74033103A27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76" creationId="{6B002A2A-4171-4998-9EB7-4D2E878F5EC1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77" creationId="{12CFE826-FBB3-4515-8ECC-36F5EDBAAC28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78" creationId="{6E9CF3DA-E073-408D-B6FF-EAA5C181BF42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79" creationId="{60C973E1-CDB8-44A9-B661-2EC607F78AA4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86" creationId="{622E625F-1BCD-4154-A6D8-A4B042067269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87" creationId="{A8409997-43AD-4141-AF14-DAB9D5298768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88" creationId="{F3AC0804-3394-4E45-A260-5F1DA09719A0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89" creationId="{EFAC7BC8-7385-4447-9D86-A7A44D195C6B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90" creationId="{77F8E9A8-9A32-4075-98BC-1FE466A173A6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91" creationId="{9618A2E0-2E7D-4ED3-97D1-1D686B4A30A9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93" creationId="{B64C9A6C-C61F-4FC7-BBFB-70F1950F8CA7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94" creationId="{AB8464A4-6FBE-43D9-9E35-B6B6B852F363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95" creationId="{59056276-2B19-4653-906B-F920D0E42A64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96" creationId="{09A62704-6AED-4C52-A6C9-AA2825380592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97" creationId="{E102FC94-E976-49BB-AEA0-EB4D4D9F8B52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98" creationId="{142CFD50-28CA-449D-83AB-3EDCCF8501C5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99" creationId="{10E2867B-D5F7-427E-A4DF-C6CFF6DACDA8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00" creationId="{8A63711D-7639-457B-9841-1EF69DF5E05E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01" creationId="{3DB2BAB2-D592-41FD-ADAF-66DFC0F63229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02" creationId="{F30BD9F5-3043-47D8-8B20-FDC3C646FCC7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03" creationId="{3CF7FD95-9F62-4075-9CC4-7AFE4A38E450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13" creationId="{E300A6D6-C6BA-4DCC-9B81-135C1E32620F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17" creationId="{B0D2929A-BC50-4299-9E20-CE615E8146CD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18" creationId="{A4544824-25E9-450B-8289-096D16347B52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19" creationId="{761B9DF4-F8C9-485F-9629-A13D4381397E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20" creationId="{B07804BE-B36F-492C-BD6D-0FF5D753CE1B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20" creationId="{FF5F9D61-C233-4DFB-A08E-0679241BC3EA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21" creationId="{F17679FB-3174-4A2C-9D09-42D1AE54BC3C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22" creationId="{379A8B47-B638-484E-8892-DA4ABCB628FF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23" creationId="{242537BF-960F-4708-8664-48E88A2104B9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24" creationId="{8549E155-D34A-4393-B30C-890C21F76655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24" creationId="{B378328B-B5CD-40C0-8DAA-A9B5CF14D65B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25" creationId="{19B236DE-0A50-40B6-AD22-960EAEF47B18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25" creationId="{C9468E0D-3003-418D-BED6-1BD74D953A31}"/>
          </ac:spMkLst>
        </pc:spChg>
        <pc:spChg chg="del mod topLvl">
          <ac:chgData name="Filippo Acconcia" userId="844af49c-a8a0-47ac-a7dd-14a44b60cd18" providerId="ADAL" clId="{B609A75A-164F-4066-A006-F59E853DC491}" dt="2022-04-29T07:33:22.803" v="1800" actId="478"/>
          <ac:spMkLst>
            <pc:docMk/>
            <pc:sldMk cId="2248971367" sldId="303"/>
            <ac:spMk id="126" creationId="{473778A8-6ED3-49DC-A114-9027BB40162D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26" creationId="{BE617CA2-19D9-4816-8C7A-2F1D46D01A5E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27" creationId="{9DC4EB3A-5687-4EFD-9E89-FCB3DF3E2F33}"/>
          </ac:spMkLst>
        </pc:spChg>
        <pc:spChg chg="del mod topLvl">
          <ac:chgData name="Filippo Acconcia" userId="844af49c-a8a0-47ac-a7dd-14a44b60cd18" providerId="ADAL" clId="{B609A75A-164F-4066-A006-F59E853DC491}" dt="2022-04-29T07:33:22.803" v="1800" actId="478"/>
          <ac:spMkLst>
            <pc:docMk/>
            <pc:sldMk cId="2248971367" sldId="303"/>
            <ac:spMk id="127" creationId="{D22DD85B-B0F6-4F1F-9ECF-0E4E597F1894}"/>
          </ac:spMkLst>
        </pc:spChg>
        <pc:spChg chg="del mod topLvl">
          <ac:chgData name="Filippo Acconcia" userId="844af49c-a8a0-47ac-a7dd-14a44b60cd18" providerId="ADAL" clId="{B609A75A-164F-4066-A006-F59E853DC491}" dt="2022-04-29T07:33:22.803" v="1800" actId="478"/>
          <ac:spMkLst>
            <pc:docMk/>
            <pc:sldMk cId="2248971367" sldId="303"/>
            <ac:spMk id="128" creationId="{668E5461-FAB5-4264-8059-934192A9E5C0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28" creationId="{A0871309-755B-4637-8915-A8F60E06D254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29" creationId="{225C34BA-99E0-4889-9035-0339AFECC725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29" creationId="{DDAAEE3A-697C-45A0-B235-FC9DA33122BE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30" creationId="{14084380-23DF-40C0-A41E-A758E37BF8C7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30" creationId="{D0C6DC68-945B-4913-B0D5-D26663D76F86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31" creationId="{023E90AA-B02E-4935-A601-7203ACCA18D6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31" creationId="{92DA4F5E-624E-47FB-8C42-8EB21AA1C8CF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32" creationId="{45024E59-65C9-4886-91A0-4740BFF6B778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32" creationId="{8B38FAF4-29F4-41B2-AC33-99101F8B1D0B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33" creationId="{EE89DD8F-0FEA-4E4E-86B6-7B08488F96D1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34" creationId="{A6FFD1AF-394C-4C7A-9323-E00F91D48E83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35" creationId="{04F347B6-05FF-4C76-A30A-00E5D01E756E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36" creationId="{5AFAF8AF-DF56-43E7-8DC2-2E81FB20761D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37" creationId="{21EB1C4F-AFBA-4086-B55B-1F73860E787B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37" creationId="{C64DF925-D889-4994-B72B-9758AC0F60B7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38" creationId="{21AAC400-8737-4B33-A260-E6ED5ED4A8E7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38" creationId="{CCA8B98A-2691-4414-95E7-A4A1F1E955B2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39" creationId="{43E8FA07-5E81-453F-8AF6-851A1D845D8A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39" creationId="{BCEF702F-63BC-454B-9A31-FFA03FFF6D2C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40" creationId="{5CD3064E-8852-4EF3-AE06-08E6AA2EBEF6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41" creationId="{6FC445F6-E5A4-4BA4-B437-6B49B9C9E2FA}"/>
          </ac:spMkLst>
        </pc:spChg>
        <pc:spChg chg="mod">
          <ac:chgData name="Filippo Acconcia" userId="844af49c-a8a0-47ac-a7dd-14a44b60cd18" providerId="ADAL" clId="{B609A75A-164F-4066-A006-F59E853DC491}" dt="2022-04-01T08:52:04.533" v="1216"/>
          <ac:spMkLst>
            <pc:docMk/>
            <pc:sldMk cId="2248971367" sldId="303"/>
            <ac:spMk id="142" creationId="{32265F5C-623D-48BE-B9BC-BAEA1CC4DD53}"/>
          </ac:spMkLst>
        </pc:spChg>
        <pc:spChg chg="add del mod">
          <ac:chgData name="Filippo Acconcia" userId="844af49c-a8a0-47ac-a7dd-14a44b60cd18" providerId="ADAL" clId="{B609A75A-164F-4066-A006-F59E853DC491}" dt="2022-04-01T09:48:27.809" v="1588" actId="478"/>
          <ac:spMkLst>
            <pc:docMk/>
            <pc:sldMk cId="2248971367" sldId="303"/>
            <ac:spMk id="143" creationId="{0BF425C4-40AD-4192-A170-AF03E92AD167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44" creationId="{13E9D888-6349-4003-8BC6-B2DDF196B525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45" creationId="{F84EFF6F-4AA2-4893-B709-C8849A63FEE8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46" creationId="{298639ED-644D-4E2D-B106-0AF69426FC0F}"/>
          </ac:spMkLst>
        </pc:spChg>
        <pc:spChg chg="mod topLvl">
          <ac:chgData name="Filippo Acconcia" userId="844af49c-a8a0-47ac-a7dd-14a44b60cd18" providerId="ADAL" clId="{B609A75A-164F-4066-A006-F59E853DC491}" dt="2022-04-01T09:38:35.591" v="1392" actId="164"/>
          <ac:spMkLst>
            <pc:docMk/>
            <pc:sldMk cId="2248971367" sldId="303"/>
            <ac:spMk id="147" creationId="{FD33D232-623A-423C-AB16-68589B988C9D}"/>
          </ac:spMkLst>
        </pc:spChg>
        <pc:spChg chg="mod topLvl">
          <ac:chgData name="Filippo Acconcia" userId="844af49c-a8a0-47ac-a7dd-14a44b60cd18" providerId="ADAL" clId="{B609A75A-164F-4066-A006-F59E853DC491}" dt="2022-04-01T09:38:35.591" v="1392" actId="164"/>
          <ac:spMkLst>
            <pc:docMk/>
            <pc:sldMk cId="2248971367" sldId="303"/>
            <ac:spMk id="148" creationId="{1007F6C9-F5B4-48AF-9877-64E63BC5750B}"/>
          </ac:spMkLst>
        </pc:spChg>
        <pc:spChg chg="mod topLvl">
          <ac:chgData name="Filippo Acconcia" userId="844af49c-a8a0-47ac-a7dd-14a44b60cd18" providerId="ADAL" clId="{B609A75A-164F-4066-A006-F59E853DC491}" dt="2022-04-01T09:38:35.591" v="1392" actId="164"/>
          <ac:spMkLst>
            <pc:docMk/>
            <pc:sldMk cId="2248971367" sldId="303"/>
            <ac:spMk id="149" creationId="{D1CF2D2A-58CB-45F6-85AC-E63F0D40DC62}"/>
          </ac:spMkLst>
        </pc:spChg>
        <pc:spChg chg="mod topLvl">
          <ac:chgData name="Filippo Acconcia" userId="844af49c-a8a0-47ac-a7dd-14a44b60cd18" providerId="ADAL" clId="{B609A75A-164F-4066-A006-F59E853DC491}" dt="2022-04-01T09:38:35.591" v="1392" actId="164"/>
          <ac:spMkLst>
            <pc:docMk/>
            <pc:sldMk cId="2248971367" sldId="303"/>
            <ac:spMk id="150" creationId="{51040684-128A-45BD-9E6D-43C59B4668A0}"/>
          </ac:spMkLst>
        </pc:spChg>
        <pc:spChg chg="mod topLvl">
          <ac:chgData name="Filippo Acconcia" userId="844af49c-a8a0-47ac-a7dd-14a44b60cd18" providerId="ADAL" clId="{B609A75A-164F-4066-A006-F59E853DC491}" dt="2022-04-01T09:38:35.591" v="1392" actId="164"/>
          <ac:spMkLst>
            <pc:docMk/>
            <pc:sldMk cId="2248971367" sldId="303"/>
            <ac:spMk id="151" creationId="{2AB2FD14-6708-451A-9E50-F9B8C2EC7118}"/>
          </ac:spMkLst>
        </pc:spChg>
        <pc:spChg chg="mod topLvl">
          <ac:chgData name="Filippo Acconcia" userId="844af49c-a8a0-47ac-a7dd-14a44b60cd18" providerId="ADAL" clId="{B609A75A-164F-4066-A006-F59E853DC491}" dt="2022-04-01T09:38:35.591" v="1392" actId="164"/>
          <ac:spMkLst>
            <pc:docMk/>
            <pc:sldMk cId="2248971367" sldId="303"/>
            <ac:spMk id="153" creationId="{B506C4AB-7F8A-4D43-AA24-343068F02160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54" creationId="{73A36DF0-F20E-4384-98EA-1A80D80FC0A7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55" creationId="{5354C72D-C25E-4FD8-AC43-9DAA2BB3158A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56" creationId="{037E5C03-36DA-40DA-9776-C4CB8D802259}"/>
          </ac:spMkLst>
        </pc:spChg>
        <pc:spChg chg="mod">
          <ac:chgData name="Filippo Acconcia" userId="844af49c-a8a0-47ac-a7dd-14a44b60cd18" providerId="ADAL" clId="{B609A75A-164F-4066-A006-F59E853DC491}" dt="2022-04-01T09:36:00.810" v="1318" actId="165"/>
          <ac:spMkLst>
            <pc:docMk/>
            <pc:sldMk cId="2248971367" sldId="303"/>
            <ac:spMk id="161" creationId="{7F7F84BA-FFF0-46D5-A277-2812B947D301}"/>
          </ac:spMkLst>
        </pc:spChg>
        <pc:spChg chg="mod">
          <ac:chgData name="Filippo Acconcia" userId="844af49c-a8a0-47ac-a7dd-14a44b60cd18" providerId="ADAL" clId="{B609A75A-164F-4066-A006-F59E853DC491}" dt="2022-04-01T09:36:00.810" v="1318" actId="165"/>
          <ac:spMkLst>
            <pc:docMk/>
            <pc:sldMk cId="2248971367" sldId="303"/>
            <ac:spMk id="163" creationId="{4855CB99-4570-4875-8483-1A921A352062}"/>
          </ac:spMkLst>
        </pc:spChg>
        <pc:spChg chg="mod">
          <ac:chgData name="Filippo Acconcia" userId="844af49c-a8a0-47ac-a7dd-14a44b60cd18" providerId="ADAL" clId="{B609A75A-164F-4066-A006-F59E853DC491}" dt="2022-04-01T09:36:00.810" v="1318" actId="165"/>
          <ac:spMkLst>
            <pc:docMk/>
            <pc:sldMk cId="2248971367" sldId="303"/>
            <ac:spMk id="165" creationId="{AA2465F8-0E2D-4481-87FD-4FC64E857915}"/>
          </ac:spMkLst>
        </pc:spChg>
        <pc:spChg chg="del mod topLvl">
          <ac:chgData name="Filippo Acconcia" userId="844af49c-a8a0-47ac-a7dd-14a44b60cd18" providerId="ADAL" clId="{B609A75A-164F-4066-A006-F59E853DC491}" dt="2022-04-01T09:38:38.109" v="1393" actId="478"/>
          <ac:spMkLst>
            <pc:docMk/>
            <pc:sldMk cId="2248971367" sldId="303"/>
            <ac:spMk id="166" creationId="{86547DE2-C81B-4756-8D5E-5B1553F34A72}"/>
          </ac:spMkLst>
        </pc:spChg>
        <pc:spChg chg="del mod topLvl">
          <ac:chgData name="Filippo Acconcia" userId="844af49c-a8a0-47ac-a7dd-14a44b60cd18" providerId="ADAL" clId="{B609A75A-164F-4066-A006-F59E853DC491}" dt="2022-04-01T09:38:38.109" v="1393" actId="478"/>
          <ac:spMkLst>
            <pc:docMk/>
            <pc:sldMk cId="2248971367" sldId="303"/>
            <ac:spMk id="167" creationId="{BC9531D2-21FF-4564-B10A-039D520F9C2A}"/>
          </ac:spMkLst>
        </pc:spChg>
        <pc:spChg chg="mod topLvl">
          <ac:chgData name="Filippo Acconcia" userId="844af49c-a8a0-47ac-a7dd-14a44b60cd18" providerId="ADAL" clId="{B609A75A-164F-4066-A006-F59E853DC491}" dt="2022-04-01T09:38:35.591" v="1392" actId="164"/>
          <ac:spMkLst>
            <pc:docMk/>
            <pc:sldMk cId="2248971367" sldId="303"/>
            <ac:spMk id="168" creationId="{05A04480-E907-4589-82C2-2B0704386F6A}"/>
          </ac:spMkLst>
        </pc:spChg>
        <pc:spChg chg="mod topLvl">
          <ac:chgData name="Filippo Acconcia" userId="844af49c-a8a0-47ac-a7dd-14a44b60cd18" providerId="ADAL" clId="{B609A75A-164F-4066-A006-F59E853DC491}" dt="2022-04-01T09:38:35.591" v="1392" actId="164"/>
          <ac:spMkLst>
            <pc:docMk/>
            <pc:sldMk cId="2248971367" sldId="303"/>
            <ac:spMk id="169" creationId="{35ED9D53-7BF3-476F-A8F7-EC15C1D992D2}"/>
          </ac:spMkLst>
        </pc:spChg>
        <pc:spChg chg="del mod topLvl">
          <ac:chgData name="Filippo Acconcia" userId="844af49c-a8a0-47ac-a7dd-14a44b60cd18" providerId="ADAL" clId="{B609A75A-164F-4066-A006-F59E853DC491}" dt="2022-04-29T07:36:13.696" v="1937" actId="478"/>
          <ac:spMkLst>
            <pc:docMk/>
            <pc:sldMk cId="2248971367" sldId="303"/>
            <ac:spMk id="170" creationId="{2A4F86D1-C6E3-4364-B1EE-14BAD601EFCF}"/>
          </ac:spMkLst>
        </pc:spChg>
        <pc:spChg chg="mod">
          <ac:chgData name="Filippo Acconcia" userId="844af49c-a8a0-47ac-a7dd-14a44b60cd18" providerId="ADAL" clId="{B609A75A-164F-4066-A006-F59E853DC491}" dt="2022-04-01T09:36:00.810" v="1318" actId="165"/>
          <ac:spMkLst>
            <pc:docMk/>
            <pc:sldMk cId="2248971367" sldId="303"/>
            <ac:spMk id="170" creationId="{DDAA5245-0B89-480F-9A24-549F65726433}"/>
          </ac:spMkLst>
        </pc:spChg>
        <pc:spChg chg="mod">
          <ac:chgData name="Filippo Acconcia" userId="844af49c-a8a0-47ac-a7dd-14a44b60cd18" providerId="ADAL" clId="{B609A75A-164F-4066-A006-F59E853DC491}" dt="2022-04-01T09:36:00.810" v="1318" actId="165"/>
          <ac:spMkLst>
            <pc:docMk/>
            <pc:sldMk cId="2248971367" sldId="303"/>
            <ac:spMk id="171" creationId="{1EC8C185-C680-4D22-8797-555FB1A72704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71" creationId="{67892828-16B1-4882-B260-CA503E4007D9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72" creationId="{2B98EA01-DEEB-4773-9657-E4F89B0A3099}"/>
          </ac:spMkLst>
        </pc:spChg>
        <pc:spChg chg="mod">
          <ac:chgData name="Filippo Acconcia" userId="844af49c-a8a0-47ac-a7dd-14a44b60cd18" providerId="ADAL" clId="{B609A75A-164F-4066-A006-F59E853DC491}" dt="2022-04-01T09:36:00.810" v="1318" actId="165"/>
          <ac:spMkLst>
            <pc:docMk/>
            <pc:sldMk cId="2248971367" sldId="303"/>
            <ac:spMk id="172" creationId="{ADFFC069-02EE-4AF3-A794-50F87CED47E6}"/>
          </ac:spMkLst>
        </pc:spChg>
        <pc:spChg chg="mod">
          <ac:chgData name="Filippo Acconcia" userId="844af49c-a8a0-47ac-a7dd-14a44b60cd18" providerId="ADAL" clId="{B609A75A-164F-4066-A006-F59E853DC491}" dt="2022-04-01T09:36:00.810" v="1318" actId="165"/>
          <ac:spMkLst>
            <pc:docMk/>
            <pc:sldMk cId="2248971367" sldId="303"/>
            <ac:spMk id="173" creationId="{CB6FED16-CB0D-4EB2-82AD-908C655661DF}"/>
          </ac:spMkLst>
        </pc:spChg>
        <pc:spChg chg="del mod topLvl">
          <ac:chgData name="Filippo Acconcia" userId="844af49c-a8a0-47ac-a7dd-14a44b60cd18" providerId="ADAL" clId="{B609A75A-164F-4066-A006-F59E853DC491}" dt="2022-04-29T07:36:13.696" v="1937" actId="478"/>
          <ac:spMkLst>
            <pc:docMk/>
            <pc:sldMk cId="2248971367" sldId="303"/>
            <ac:spMk id="173" creationId="{FE1EDE52-4460-42FA-B5A5-B7ABD47BF8B5}"/>
          </ac:spMkLst>
        </pc:spChg>
        <pc:spChg chg="mod">
          <ac:chgData name="Filippo Acconcia" userId="844af49c-a8a0-47ac-a7dd-14a44b60cd18" providerId="ADAL" clId="{B609A75A-164F-4066-A006-F59E853DC491}" dt="2022-04-01T09:36:00.810" v="1318" actId="165"/>
          <ac:spMkLst>
            <pc:docMk/>
            <pc:sldMk cId="2248971367" sldId="303"/>
            <ac:spMk id="174" creationId="{29A81E97-D149-4DCC-A949-1BBBE45953AE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74" creationId="{A1B26510-2BF8-4A23-B573-EC7570301EAC}"/>
          </ac:spMkLst>
        </pc:spChg>
        <pc:spChg chg="mod">
          <ac:chgData name="Filippo Acconcia" userId="844af49c-a8a0-47ac-a7dd-14a44b60cd18" providerId="ADAL" clId="{B609A75A-164F-4066-A006-F59E853DC491}" dt="2022-04-01T09:36:00.810" v="1318" actId="165"/>
          <ac:spMkLst>
            <pc:docMk/>
            <pc:sldMk cId="2248971367" sldId="303"/>
            <ac:spMk id="175" creationId="{41CC168F-615A-4DE1-BF31-ED52AB3ED5C8}"/>
          </ac:spMkLst>
        </pc:spChg>
        <pc:spChg chg="mod topLvl">
          <ac:chgData name="Filippo Acconcia" userId="844af49c-a8a0-47ac-a7dd-14a44b60cd18" providerId="ADAL" clId="{B609A75A-164F-4066-A006-F59E853DC491}" dt="2022-04-29T07:38:59.294" v="1966" actId="164"/>
          <ac:spMkLst>
            <pc:docMk/>
            <pc:sldMk cId="2248971367" sldId="303"/>
            <ac:spMk id="176" creationId="{0D951320-FE35-4C18-AED4-E84C58465A39}"/>
          </ac:spMkLst>
        </pc:spChg>
        <pc:spChg chg="mod">
          <ac:chgData name="Filippo Acconcia" userId="844af49c-a8a0-47ac-a7dd-14a44b60cd18" providerId="ADAL" clId="{B609A75A-164F-4066-A006-F59E853DC491}" dt="2022-04-01T09:36:00.810" v="1318" actId="165"/>
          <ac:spMkLst>
            <pc:docMk/>
            <pc:sldMk cId="2248971367" sldId="303"/>
            <ac:spMk id="176" creationId="{6CA46EC1-DFF3-47F2-9E59-63464954BC5E}"/>
          </ac:spMkLst>
        </pc:spChg>
        <pc:spChg chg="mod">
          <ac:chgData name="Filippo Acconcia" userId="844af49c-a8a0-47ac-a7dd-14a44b60cd18" providerId="ADAL" clId="{B609A75A-164F-4066-A006-F59E853DC491}" dt="2022-04-01T09:36:00.810" v="1318" actId="165"/>
          <ac:spMkLst>
            <pc:docMk/>
            <pc:sldMk cId="2248971367" sldId="303"/>
            <ac:spMk id="177" creationId="{2CE4DB8E-E190-4451-9B38-6EDDCEA009B5}"/>
          </ac:spMkLst>
        </pc:spChg>
        <pc:spChg chg="mod">
          <ac:chgData name="Filippo Acconcia" userId="844af49c-a8a0-47ac-a7dd-14a44b60cd18" providerId="ADAL" clId="{B609A75A-164F-4066-A006-F59E853DC491}" dt="2022-04-01T09:36:00.810" v="1318" actId="165"/>
          <ac:spMkLst>
            <pc:docMk/>
            <pc:sldMk cId="2248971367" sldId="303"/>
            <ac:spMk id="179" creationId="{0E58E1AE-23E6-417D-9FAC-13D1A8F7C676}"/>
          </ac:spMkLst>
        </pc:spChg>
        <pc:spChg chg="mod">
          <ac:chgData name="Filippo Acconcia" userId="844af49c-a8a0-47ac-a7dd-14a44b60cd18" providerId="ADAL" clId="{B609A75A-164F-4066-A006-F59E853DC491}" dt="2022-04-01T09:36:00.810" v="1318" actId="165"/>
          <ac:spMkLst>
            <pc:docMk/>
            <pc:sldMk cId="2248971367" sldId="303"/>
            <ac:spMk id="180" creationId="{2D95F09F-AABB-4E27-830A-C08BFC0580EC}"/>
          </ac:spMkLst>
        </pc:spChg>
        <pc:spChg chg="mod">
          <ac:chgData name="Filippo Acconcia" userId="844af49c-a8a0-47ac-a7dd-14a44b60cd18" providerId="ADAL" clId="{B609A75A-164F-4066-A006-F59E853DC491}" dt="2022-04-01T09:36:00.810" v="1318" actId="165"/>
          <ac:spMkLst>
            <pc:docMk/>
            <pc:sldMk cId="2248971367" sldId="303"/>
            <ac:spMk id="181" creationId="{3BF432F3-4295-4165-BBFE-9BB115275A40}"/>
          </ac:spMkLst>
        </pc:spChg>
        <pc:spChg chg="mod">
          <ac:chgData name="Filippo Acconcia" userId="844af49c-a8a0-47ac-a7dd-14a44b60cd18" providerId="ADAL" clId="{B609A75A-164F-4066-A006-F59E853DC491}" dt="2022-04-01T09:36:00.810" v="1318" actId="165"/>
          <ac:spMkLst>
            <pc:docMk/>
            <pc:sldMk cId="2248971367" sldId="303"/>
            <ac:spMk id="182" creationId="{B66ACC69-72A6-4ACB-B7C8-22A7C72AF7D2}"/>
          </ac:spMkLst>
        </pc:spChg>
        <pc:spChg chg="mod">
          <ac:chgData name="Filippo Acconcia" userId="844af49c-a8a0-47ac-a7dd-14a44b60cd18" providerId="ADAL" clId="{B609A75A-164F-4066-A006-F59E853DC491}" dt="2022-04-01T09:36:00.810" v="1318" actId="165"/>
          <ac:spMkLst>
            <pc:docMk/>
            <pc:sldMk cId="2248971367" sldId="303"/>
            <ac:spMk id="183" creationId="{9E27752F-EE2A-4A1E-BB83-6881E82C273B}"/>
          </ac:spMkLst>
        </pc:spChg>
        <pc:spChg chg="add mod">
          <ac:chgData name="Filippo Acconcia" userId="844af49c-a8a0-47ac-a7dd-14a44b60cd18" providerId="ADAL" clId="{B609A75A-164F-4066-A006-F59E853DC491}" dt="2022-04-01T09:38:35.591" v="1392" actId="164"/>
          <ac:spMkLst>
            <pc:docMk/>
            <pc:sldMk cId="2248971367" sldId="303"/>
            <ac:spMk id="185" creationId="{08AC1209-52FE-447C-B57C-B6BB40942C86}"/>
          </ac:spMkLst>
        </pc:spChg>
        <pc:spChg chg="add mod">
          <ac:chgData name="Filippo Acconcia" userId="844af49c-a8a0-47ac-a7dd-14a44b60cd18" providerId="ADAL" clId="{B609A75A-164F-4066-A006-F59E853DC491}" dt="2022-04-01T09:38:35.591" v="1392" actId="164"/>
          <ac:spMkLst>
            <pc:docMk/>
            <pc:sldMk cId="2248971367" sldId="303"/>
            <ac:spMk id="186" creationId="{08C7A70E-A278-4ED2-99A8-7A9C9CED0567}"/>
          </ac:spMkLst>
        </pc:spChg>
        <pc:spChg chg="add mod">
          <ac:chgData name="Filippo Acconcia" userId="844af49c-a8a0-47ac-a7dd-14a44b60cd18" providerId="ADAL" clId="{B609A75A-164F-4066-A006-F59E853DC491}" dt="2022-04-01T09:38:35.591" v="1392" actId="164"/>
          <ac:spMkLst>
            <pc:docMk/>
            <pc:sldMk cId="2248971367" sldId="303"/>
            <ac:spMk id="187" creationId="{1E232DC9-4F58-444A-922C-BCEF577988FE}"/>
          </ac:spMkLst>
        </pc:spChg>
        <pc:spChg chg="add mod">
          <ac:chgData name="Filippo Acconcia" userId="844af49c-a8a0-47ac-a7dd-14a44b60cd18" providerId="ADAL" clId="{B609A75A-164F-4066-A006-F59E853DC491}" dt="2022-04-01T09:38:35.591" v="1392" actId="164"/>
          <ac:spMkLst>
            <pc:docMk/>
            <pc:sldMk cId="2248971367" sldId="303"/>
            <ac:spMk id="188" creationId="{2AB44B7F-A396-4B38-AAB6-EC373D7D6B3D}"/>
          </ac:spMkLst>
        </pc:spChg>
        <pc:spChg chg="add mod">
          <ac:chgData name="Filippo Acconcia" userId="844af49c-a8a0-47ac-a7dd-14a44b60cd18" providerId="ADAL" clId="{B609A75A-164F-4066-A006-F59E853DC491}" dt="2022-04-01T09:38:35.591" v="1392" actId="164"/>
          <ac:spMkLst>
            <pc:docMk/>
            <pc:sldMk cId="2248971367" sldId="303"/>
            <ac:spMk id="189" creationId="{F5C6FA80-E4EF-4596-9FBA-30C53B2AF350}"/>
          </ac:spMkLst>
        </pc:spChg>
        <pc:spChg chg="add mod">
          <ac:chgData name="Filippo Acconcia" userId="844af49c-a8a0-47ac-a7dd-14a44b60cd18" providerId="ADAL" clId="{B609A75A-164F-4066-A006-F59E853DC491}" dt="2022-04-01T09:38:35.591" v="1392" actId="164"/>
          <ac:spMkLst>
            <pc:docMk/>
            <pc:sldMk cId="2248971367" sldId="303"/>
            <ac:spMk id="190" creationId="{07F5D6F3-D282-4BC7-B335-9C10D6EAF876}"/>
          </ac:spMkLst>
        </pc:spChg>
        <pc:spChg chg="mod">
          <ac:chgData name="Filippo Acconcia" userId="844af49c-a8a0-47ac-a7dd-14a44b60cd18" providerId="ADAL" clId="{B609A75A-164F-4066-A006-F59E853DC491}" dt="2022-04-29T07:35:07.918" v="1906" actId="165"/>
          <ac:spMkLst>
            <pc:docMk/>
            <pc:sldMk cId="2248971367" sldId="303"/>
            <ac:spMk id="195" creationId="{288AFA92-E16A-4432-9F9D-628BF26F9D18}"/>
          </ac:spMkLst>
        </pc:spChg>
        <pc:spChg chg="mod">
          <ac:chgData name="Filippo Acconcia" userId="844af49c-a8a0-47ac-a7dd-14a44b60cd18" providerId="ADAL" clId="{B609A75A-164F-4066-A006-F59E853DC491}" dt="2022-04-29T07:35:07.918" v="1906" actId="165"/>
          <ac:spMkLst>
            <pc:docMk/>
            <pc:sldMk cId="2248971367" sldId="303"/>
            <ac:spMk id="196" creationId="{A4706994-BBC0-4ABC-9CAA-766E6DF514D2}"/>
          </ac:spMkLst>
        </pc:spChg>
        <pc:spChg chg="mod topLvl">
          <ac:chgData name="Filippo Acconcia" userId="844af49c-a8a0-47ac-a7dd-14a44b60cd18" providerId="ADAL" clId="{B609A75A-164F-4066-A006-F59E853DC491}" dt="2022-04-01T09:44:04.943" v="1523" actId="164"/>
          <ac:spMkLst>
            <pc:docMk/>
            <pc:sldMk cId="2248971367" sldId="303"/>
            <ac:spMk id="197" creationId="{961F6ADF-D7BC-4A78-BD0D-F656A11C271F}"/>
          </ac:spMkLst>
        </pc:spChg>
        <pc:spChg chg="mod topLvl">
          <ac:chgData name="Filippo Acconcia" userId="844af49c-a8a0-47ac-a7dd-14a44b60cd18" providerId="ADAL" clId="{B609A75A-164F-4066-A006-F59E853DC491}" dt="2022-04-01T09:44:04.943" v="1523" actId="164"/>
          <ac:spMkLst>
            <pc:docMk/>
            <pc:sldMk cId="2248971367" sldId="303"/>
            <ac:spMk id="198" creationId="{D96FF9FF-38D3-4EAC-923C-DDBC56D02CBA}"/>
          </ac:spMkLst>
        </pc:spChg>
        <pc:spChg chg="mod topLvl">
          <ac:chgData name="Filippo Acconcia" userId="844af49c-a8a0-47ac-a7dd-14a44b60cd18" providerId="ADAL" clId="{B609A75A-164F-4066-A006-F59E853DC491}" dt="2022-04-01T09:44:04.943" v="1523" actId="164"/>
          <ac:spMkLst>
            <pc:docMk/>
            <pc:sldMk cId="2248971367" sldId="303"/>
            <ac:spMk id="199" creationId="{DEF017D7-78AA-423A-9C7C-41C937FA4D8A}"/>
          </ac:spMkLst>
        </pc:spChg>
        <pc:spChg chg="mod topLvl">
          <ac:chgData name="Filippo Acconcia" userId="844af49c-a8a0-47ac-a7dd-14a44b60cd18" providerId="ADAL" clId="{B609A75A-164F-4066-A006-F59E853DC491}" dt="2022-04-01T09:44:04.943" v="1523" actId="164"/>
          <ac:spMkLst>
            <pc:docMk/>
            <pc:sldMk cId="2248971367" sldId="303"/>
            <ac:spMk id="200" creationId="{0B60EDFE-93E5-40A2-8EE0-0C924CD540A9}"/>
          </ac:spMkLst>
        </pc:spChg>
        <pc:spChg chg="mod topLvl">
          <ac:chgData name="Filippo Acconcia" userId="844af49c-a8a0-47ac-a7dd-14a44b60cd18" providerId="ADAL" clId="{B609A75A-164F-4066-A006-F59E853DC491}" dt="2022-04-01T09:44:04.943" v="1523" actId="164"/>
          <ac:spMkLst>
            <pc:docMk/>
            <pc:sldMk cId="2248971367" sldId="303"/>
            <ac:spMk id="201" creationId="{32A45BA7-1477-4991-B980-6DC3DBF13993}"/>
          </ac:spMkLst>
        </pc:spChg>
        <pc:spChg chg="mod topLvl">
          <ac:chgData name="Filippo Acconcia" userId="844af49c-a8a0-47ac-a7dd-14a44b60cd18" providerId="ADAL" clId="{B609A75A-164F-4066-A006-F59E853DC491}" dt="2022-04-01T09:44:04.943" v="1523" actId="164"/>
          <ac:spMkLst>
            <pc:docMk/>
            <pc:sldMk cId="2248971367" sldId="303"/>
            <ac:spMk id="203" creationId="{BED747A0-5733-41C8-A3F4-735CE1BB5D1C}"/>
          </ac:spMkLst>
        </pc:spChg>
        <pc:spChg chg="mod">
          <ac:chgData name="Filippo Acconcia" userId="844af49c-a8a0-47ac-a7dd-14a44b60cd18" providerId="ADAL" clId="{B609A75A-164F-4066-A006-F59E853DC491}" dt="2022-04-29T07:35:07.918" v="1906" actId="165"/>
          <ac:spMkLst>
            <pc:docMk/>
            <pc:sldMk cId="2248971367" sldId="303"/>
            <ac:spMk id="204" creationId="{4D6BAE87-53E7-44F3-8C24-F8DE4300FDC2}"/>
          </ac:spMkLst>
        </pc:spChg>
        <pc:spChg chg="mod">
          <ac:chgData name="Filippo Acconcia" userId="844af49c-a8a0-47ac-a7dd-14a44b60cd18" providerId="ADAL" clId="{B609A75A-164F-4066-A006-F59E853DC491}" dt="2022-04-29T07:35:07.918" v="1906" actId="165"/>
          <ac:spMkLst>
            <pc:docMk/>
            <pc:sldMk cId="2248971367" sldId="303"/>
            <ac:spMk id="205" creationId="{AF964955-A63D-4EE9-9286-230EE500A4C6}"/>
          </ac:spMkLst>
        </pc:spChg>
        <pc:spChg chg="mod">
          <ac:chgData name="Filippo Acconcia" userId="844af49c-a8a0-47ac-a7dd-14a44b60cd18" providerId="ADAL" clId="{B609A75A-164F-4066-A006-F59E853DC491}" dt="2022-04-29T07:35:07.918" v="1906" actId="165"/>
          <ac:spMkLst>
            <pc:docMk/>
            <pc:sldMk cId="2248971367" sldId="303"/>
            <ac:spMk id="206" creationId="{08119391-1065-45AB-AD7C-7EE705EBE15A}"/>
          </ac:spMkLst>
        </pc:spChg>
        <pc:spChg chg="mod">
          <ac:chgData name="Filippo Acconcia" userId="844af49c-a8a0-47ac-a7dd-14a44b60cd18" providerId="ADAL" clId="{B609A75A-164F-4066-A006-F59E853DC491}" dt="2022-04-01T09:39:19.449" v="1402" actId="165"/>
          <ac:spMkLst>
            <pc:docMk/>
            <pc:sldMk cId="2248971367" sldId="303"/>
            <ac:spMk id="211" creationId="{2521AD77-69B4-4592-8708-256546A50988}"/>
          </ac:spMkLst>
        </pc:spChg>
        <pc:spChg chg="mod">
          <ac:chgData name="Filippo Acconcia" userId="844af49c-a8a0-47ac-a7dd-14a44b60cd18" providerId="ADAL" clId="{B609A75A-164F-4066-A006-F59E853DC491}" dt="2022-04-01T09:39:19.449" v="1402" actId="165"/>
          <ac:spMkLst>
            <pc:docMk/>
            <pc:sldMk cId="2248971367" sldId="303"/>
            <ac:spMk id="213" creationId="{30C7387D-AD67-479C-AB7A-06EE58C74C1A}"/>
          </ac:spMkLst>
        </pc:spChg>
        <pc:spChg chg="mod">
          <ac:chgData name="Filippo Acconcia" userId="844af49c-a8a0-47ac-a7dd-14a44b60cd18" providerId="ADAL" clId="{B609A75A-164F-4066-A006-F59E853DC491}" dt="2022-04-01T09:39:19.449" v="1402" actId="165"/>
          <ac:spMkLst>
            <pc:docMk/>
            <pc:sldMk cId="2248971367" sldId="303"/>
            <ac:spMk id="215" creationId="{9B7D52DC-031D-47B9-A525-5EFDB819724F}"/>
          </ac:spMkLst>
        </pc:spChg>
        <pc:spChg chg="mod topLvl">
          <ac:chgData name="Filippo Acconcia" userId="844af49c-a8a0-47ac-a7dd-14a44b60cd18" providerId="ADAL" clId="{B609A75A-164F-4066-A006-F59E853DC491}" dt="2022-04-01T09:41:11.354" v="1465" actId="164"/>
          <ac:spMkLst>
            <pc:docMk/>
            <pc:sldMk cId="2248971367" sldId="303"/>
            <ac:spMk id="216" creationId="{A86D6EC8-6E2F-4EFB-B557-36F7D66DD808}"/>
          </ac:spMkLst>
        </pc:spChg>
        <pc:spChg chg="mod topLvl">
          <ac:chgData name="Filippo Acconcia" userId="844af49c-a8a0-47ac-a7dd-14a44b60cd18" providerId="ADAL" clId="{B609A75A-164F-4066-A006-F59E853DC491}" dt="2022-04-01T09:41:11.354" v="1465" actId="164"/>
          <ac:spMkLst>
            <pc:docMk/>
            <pc:sldMk cId="2248971367" sldId="303"/>
            <ac:spMk id="217" creationId="{9F717EEE-AAA8-4DF2-9A6F-2614483D9879}"/>
          </ac:spMkLst>
        </pc:spChg>
        <pc:spChg chg="mod topLvl">
          <ac:chgData name="Filippo Acconcia" userId="844af49c-a8a0-47ac-a7dd-14a44b60cd18" providerId="ADAL" clId="{B609A75A-164F-4066-A006-F59E853DC491}" dt="2022-04-01T09:41:11.354" v="1465" actId="164"/>
          <ac:spMkLst>
            <pc:docMk/>
            <pc:sldMk cId="2248971367" sldId="303"/>
            <ac:spMk id="218" creationId="{06121880-ACF9-4995-89C8-04B04945349F}"/>
          </ac:spMkLst>
        </pc:spChg>
        <pc:spChg chg="mod topLvl">
          <ac:chgData name="Filippo Acconcia" userId="844af49c-a8a0-47ac-a7dd-14a44b60cd18" providerId="ADAL" clId="{B609A75A-164F-4066-A006-F59E853DC491}" dt="2022-04-01T09:41:11.354" v="1465" actId="164"/>
          <ac:spMkLst>
            <pc:docMk/>
            <pc:sldMk cId="2248971367" sldId="303"/>
            <ac:spMk id="219" creationId="{4B0D22FD-8EBC-40BD-8177-77E38720BF92}"/>
          </ac:spMkLst>
        </pc:spChg>
        <pc:spChg chg="mod">
          <ac:chgData name="Filippo Acconcia" userId="844af49c-a8a0-47ac-a7dd-14a44b60cd18" providerId="ADAL" clId="{B609A75A-164F-4066-A006-F59E853DC491}" dt="2022-04-01T09:39:19.449" v="1402" actId="165"/>
          <ac:spMkLst>
            <pc:docMk/>
            <pc:sldMk cId="2248971367" sldId="303"/>
            <ac:spMk id="220" creationId="{52F85E96-A9C5-42BE-B71C-3DF54E80AA80}"/>
          </ac:spMkLst>
        </pc:spChg>
        <pc:spChg chg="mod">
          <ac:chgData name="Filippo Acconcia" userId="844af49c-a8a0-47ac-a7dd-14a44b60cd18" providerId="ADAL" clId="{B609A75A-164F-4066-A006-F59E853DC491}" dt="2022-04-29T07:35:07.918" v="1906" actId="165"/>
          <ac:spMkLst>
            <pc:docMk/>
            <pc:sldMk cId="2248971367" sldId="303"/>
            <ac:spMk id="220" creationId="{A116812A-9D20-460C-8876-FFF275504D4D}"/>
          </ac:spMkLst>
        </pc:spChg>
        <pc:spChg chg="mod">
          <ac:chgData name="Filippo Acconcia" userId="844af49c-a8a0-47ac-a7dd-14a44b60cd18" providerId="ADAL" clId="{B609A75A-164F-4066-A006-F59E853DC491}" dt="2022-04-29T07:35:07.918" v="1906" actId="165"/>
          <ac:spMkLst>
            <pc:docMk/>
            <pc:sldMk cId="2248971367" sldId="303"/>
            <ac:spMk id="221" creationId="{3E7353D6-4FFD-465B-8546-295076024A6C}"/>
          </ac:spMkLst>
        </pc:spChg>
        <pc:spChg chg="mod">
          <ac:chgData name="Filippo Acconcia" userId="844af49c-a8a0-47ac-a7dd-14a44b60cd18" providerId="ADAL" clId="{B609A75A-164F-4066-A006-F59E853DC491}" dt="2022-04-01T09:39:19.449" v="1402" actId="165"/>
          <ac:spMkLst>
            <pc:docMk/>
            <pc:sldMk cId="2248971367" sldId="303"/>
            <ac:spMk id="221" creationId="{82F36F13-70BA-450C-815A-994D0F9D3E90}"/>
          </ac:spMkLst>
        </pc:spChg>
        <pc:spChg chg="mod">
          <ac:chgData name="Filippo Acconcia" userId="844af49c-a8a0-47ac-a7dd-14a44b60cd18" providerId="ADAL" clId="{B609A75A-164F-4066-A006-F59E853DC491}" dt="2022-04-01T09:39:19.449" v="1402" actId="165"/>
          <ac:spMkLst>
            <pc:docMk/>
            <pc:sldMk cId="2248971367" sldId="303"/>
            <ac:spMk id="222" creationId="{05898E80-95A8-4ED3-B2E4-99BF45192633}"/>
          </ac:spMkLst>
        </pc:spChg>
        <pc:spChg chg="mod">
          <ac:chgData name="Filippo Acconcia" userId="844af49c-a8a0-47ac-a7dd-14a44b60cd18" providerId="ADAL" clId="{B609A75A-164F-4066-A006-F59E853DC491}" dt="2022-04-29T07:35:07.918" v="1906" actId="165"/>
          <ac:spMkLst>
            <pc:docMk/>
            <pc:sldMk cId="2248971367" sldId="303"/>
            <ac:spMk id="222" creationId="{F028CC6D-8879-4CAB-B6E7-466925870FA8}"/>
          </ac:spMkLst>
        </pc:spChg>
        <pc:spChg chg="mod">
          <ac:chgData name="Filippo Acconcia" userId="844af49c-a8a0-47ac-a7dd-14a44b60cd18" providerId="ADAL" clId="{B609A75A-164F-4066-A006-F59E853DC491}" dt="2022-04-29T07:35:07.918" v="1906" actId="165"/>
          <ac:spMkLst>
            <pc:docMk/>
            <pc:sldMk cId="2248971367" sldId="303"/>
            <ac:spMk id="223" creationId="{13AC3EA3-2312-4DD4-A8AF-47EBC337AD89}"/>
          </ac:spMkLst>
        </pc:spChg>
        <pc:spChg chg="mod">
          <ac:chgData name="Filippo Acconcia" userId="844af49c-a8a0-47ac-a7dd-14a44b60cd18" providerId="ADAL" clId="{B609A75A-164F-4066-A006-F59E853DC491}" dt="2022-04-01T09:39:19.449" v="1402" actId="165"/>
          <ac:spMkLst>
            <pc:docMk/>
            <pc:sldMk cId="2248971367" sldId="303"/>
            <ac:spMk id="223" creationId="{4246E453-66B1-4A24-A33D-1F918926C7CD}"/>
          </ac:spMkLst>
        </pc:spChg>
        <pc:spChg chg="mod">
          <ac:chgData name="Filippo Acconcia" userId="844af49c-a8a0-47ac-a7dd-14a44b60cd18" providerId="ADAL" clId="{B609A75A-164F-4066-A006-F59E853DC491}" dt="2022-04-01T09:39:19.449" v="1402" actId="165"/>
          <ac:spMkLst>
            <pc:docMk/>
            <pc:sldMk cId="2248971367" sldId="303"/>
            <ac:spMk id="224" creationId="{B21BA2E1-AD00-4FC7-8527-0B4BC752CBA7}"/>
          </ac:spMkLst>
        </pc:spChg>
        <pc:spChg chg="mod">
          <ac:chgData name="Filippo Acconcia" userId="844af49c-a8a0-47ac-a7dd-14a44b60cd18" providerId="ADAL" clId="{B609A75A-164F-4066-A006-F59E853DC491}" dt="2022-04-29T07:35:07.918" v="1906" actId="165"/>
          <ac:spMkLst>
            <pc:docMk/>
            <pc:sldMk cId="2248971367" sldId="303"/>
            <ac:spMk id="224" creationId="{EB96C978-CA48-43BB-B8F7-86C7562F4053}"/>
          </ac:spMkLst>
        </pc:spChg>
        <pc:spChg chg="mod">
          <ac:chgData name="Filippo Acconcia" userId="844af49c-a8a0-47ac-a7dd-14a44b60cd18" providerId="ADAL" clId="{B609A75A-164F-4066-A006-F59E853DC491}" dt="2022-04-01T09:39:19.449" v="1402" actId="165"/>
          <ac:spMkLst>
            <pc:docMk/>
            <pc:sldMk cId="2248971367" sldId="303"/>
            <ac:spMk id="225" creationId="{152C2D21-609A-4DD1-9A0E-30C121655819}"/>
          </ac:spMkLst>
        </pc:spChg>
        <pc:spChg chg="mod">
          <ac:chgData name="Filippo Acconcia" userId="844af49c-a8a0-47ac-a7dd-14a44b60cd18" providerId="ADAL" clId="{B609A75A-164F-4066-A006-F59E853DC491}" dt="2022-04-29T07:35:07.918" v="1906" actId="165"/>
          <ac:spMkLst>
            <pc:docMk/>
            <pc:sldMk cId="2248971367" sldId="303"/>
            <ac:spMk id="225" creationId="{6F5264CE-51DD-4EC8-8B7B-DBAB73EE15D0}"/>
          </ac:spMkLst>
        </pc:spChg>
        <pc:spChg chg="mod">
          <ac:chgData name="Filippo Acconcia" userId="844af49c-a8a0-47ac-a7dd-14a44b60cd18" providerId="ADAL" clId="{B609A75A-164F-4066-A006-F59E853DC491}" dt="2022-04-01T09:39:19.449" v="1402" actId="165"/>
          <ac:spMkLst>
            <pc:docMk/>
            <pc:sldMk cId="2248971367" sldId="303"/>
            <ac:spMk id="226" creationId="{AFF86CFF-260F-48DC-9C94-AD886DE4D9DC}"/>
          </ac:spMkLst>
        </pc:spChg>
        <pc:spChg chg="mod">
          <ac:chgData name="Filippo Acconcia" userId="844af49c-a8a0-47ac-a7dd-14a44b60cd18" providerId="ADAL" clId="{B609A75A-164F-4066-A006-F59E853DC491}" dt="2022-04-29T07:35:07.918" v="1906" actId="165"/>
          <ac:spMkLst>
            <pc:docMk/>
            <pc:sldMk cId="2248971367" sldId="303"/>
            <ac:spMk id="226" creationId="{D65722F6-6101-4B36-B5C7-682A352CAF37}"/>
          </ac:spMkLst>
        </pc:spChg>
        <pc:spChg chg="mod">
          <ac:chgData name="Filippo Acconcia" userId="844af49c-a8a0-47ac-a7dd-14a44b60cd18" providerId="ADAL" clId="{B609A75A-164F-4066-A006-F59E853DC491}" dt="2022-04-01T09:39:19.449" v="1402" actId="165"/>
          <ac:spMkLst>
            <pc:docMk/>
            <pc:sldMk cId="2248971367" sldId="303"/>
            <ac:spMk id="227" creationId="{CA6FDC35-0979-4420-83BE-D73BA3887DCB}"/>
          </ac:spMkLst>
        </pc:spChg>
        <pc:spChg chg="mod">
          <ac:chgData name="Filippo Acconcia" userId="844af49c-a8a0-47ac-a7dd-14a44b60cd18" providerId="ADAL" clId="{B609A75A-164F-4066-A006-F59E853DC491}" dt="2022-04-01T09:39:19.449" v="1402" actId="165"/>
          <ac:spMkLst>
            <pc:docMk/>
            <pc:sldMk cId="2248971367" sldId="303"/>
            <ac:spMk id="229" creationId="{325F5CF5-CFDC-48CA-B519-D62DD64F2388}"/>
          </ac:spMkLst>
        </pc:spChg>
        <pc:spChg chg="mod">
          <ac:chgData name="Filippo Acconcia" userId="844af49c-a8a0-47ac-a7dd-14a44b60cd18" providerId="ADAL" clId="{B609A75A-164F-4066-A006-F59E853DC491}" dt="2022-04-29T07:35:07.918" v="1906" actId="165"/>
          <ac:spMkLst>
            <pc:docMk/>
            <pc:sldMk cId="2248971367" sldId="303"/>
            <ac:spMk id="230" creationId="{8EAC0A07-3440-4C49-84E6-35D1354F66AC}"/>
          </ac:spMkLst>
        </pc:spChg>
        <pc:spChg chg="mod">
          <ac:chgData name="Filippo Acconcia" userId="844af49c-a8a0-47ac-a7dd-14a44b60cd18" providerId="ADAL" clId="{B609A75A-164F-4066-A006-F59E853DC491}" dt="2022-04-01T09:39:19.449" v="1402" actId="165"/>
          <ac:spMkLst>
            <pc:docMk/>
            <pc:sldMk cId="2248971367" sldId="303"/>
            <ac:spMk id="230" creationId="{E6F7B868-3699-4D90-8002-0663B8DC83B3}"/>
          </ac:spMkLst>
        </pc:spChg>
        <pc:spChg chg="mod">
          <ac:chgData name="Filippo Acconcia" userId="844af49c-a8a0-47ac-a7dd-14a44b60cd18" providerId="ADAL" clId="{B609A75A-164F-4066-A006-F59E853DC491}" dt="2022-04-01T09:39:19.449" v="1402" actId="165"/>
          <ac:spMkLst>
            <pc:docMk/>
            <pc:sldMk cId="2248971367" sldId="303"/>
            <ac:spMk id="231" creationId="{15F832E6-3714-4F30-AE58-31BF7F424794}"/>
          </ac:spMkLst>
        </pc:spChg>
        <pc:spChg chg="mod">
          <ac:chgData name="Filippo Acconcia" userId="844af49c-a8a0-47ac-a7dd-14a44b60cd18" providerId="ADAL" clId="{B609A75A-164F-4066-A006-F59E853DC491}" dt="2022-04-29T07:35:07.918" v="1906" actId="165"/>
          <ac:spMkLst>
            <pc:docMk/>
            <pc:sldMk cId="2248971367" sldId="303"/>
            <ac:spMk id="232" creationId="{291A29D3-E7C5-4E36-92EF-9F6FDC927A50}"/>
          </ac:spMkLst>
        </pc:spChg>
        <pc:spChg chg="mod">
          <ac:chgData name="Filippo Acconcia" userId="844af49c-a8a0-47ac-a7dd-14a44b60cd18" providerId="ADAL" clId="{B609A75A-164F-4066-A006-F59E853DC491}" dt="2022-04-01T09:39:19.449" v="1402" actId="165"/>
          <ac:spMkLst>
            <pc:docMk/>
            <pc:sldMk cId="2248971367" sldId="303"/>
            <ac:spMk id="232" creationId="{6C56E8F3-AC4D-444F-BDB3-8DC797D8062D}"/>
          </ac:spMkLst>
        </pc:spChg>
        <pc:spChg chg="mod">
          <ac:chgData name="Filippo Acconcia" userId="844af49c-a8a0-47ac-a7dd-14a44b60cd18" providerId="ADAL" clId="{B609A75A-164F-4066-A006-F59E853DC491}" dt="2022-04-01T09:39:19.449" v="1402" actId="165"/>
          <ac:spMkLst>
            <pc:docMk/>
            <pc:sldMk cId="2248971367" sldId="303"/>
            <ac:spMk id="233" creationId="{0CDA3C09-977A-489C-8859-0BEE59E5F51F}"/>
          </ac:spMkLst>
        </pc:spChg>
        <pc:spChg chg="mod">
          <ac:chgData name="Filippo Acconcia" userId="844af49c-a8a0-47ac-a7dd-14a44b60cd18" providerId="ADAL" clId="{B609A75A-164F-4066-A006-F59E853DC491}" dt="2022-04-29T07:35:07.918" v="1906" actId="165"/>
          <ac:spMkLst>
            <pc:docMk/>
            <pc:sldMk cId="2248971367" sldId="303"/>
            <ac:spMk id="234" creationId="{2BE83890-521E-435E-A794-977C3802F540}"/>
          </ac:spMkLst>
        </pc:spChg>
        <pc:spChg chg="mod">
          <ac:chgData name="Filippo Acconcia" userId="844af49c-a8a0-47ac-a7dd-14a44b60cd18" providerId="ADAL" clId="{B609A75A-164F-4066-A006-F59E853DC491}" dt="2022-04-29T07:35:07.918" v="1906" actId="165"/>
          <ac:spMkLst>
            <pc:docMk/>
            <pc:sldMk cId="2248971367" sldId="303"/>
            <ac:spMk id="235" creationId="{35FA24D5-A8D9-4692-9E72-86FF83FB206C}"/>
          </ac:spMkLst>
        </pc:spChg>
        <pc:spChg chg="mod">
          <ac:chgData name="Filippo Acconcia" userId="844af49c-a8a0-47ac-a7dd-14a44b60cd18" providerId="ADAL" clId="{B609A75A-164F-4066-A006-F59E853DC491}" dt="2022-04-29T07:35:07.918" v="1906" actId="165"/>
          <ac:spMkLst>
            <pc:docMk/>
            <pc:sldMk cId="2248971367" sldId="303"/>
            <ac:spMk id="236" creationId="{FB8FA02F-18E2-4535-B84D-EF8DC702F92A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37" creationId="{B6BF0687-3C14-48A0-9A50-63439EF7BA66}"/>
          </ac:spMkLst>
        </pc:spChg>
        <pc:spChg chg="mod">
          <ac:chgData name="Filippo Acconcia" userId="844af49c-a8a0-47ac-a7dd-14a44b60cd18" providerId="ADAL" clId="{B609A75A-164F-4066-A006-F59E853DC491}" dt="2022-04-29T07:35:07.918" v="1906" actId="165"/>
          <ac:spMkLst>
            <pc:docMk/>
            <pc:sldMk cId="2248971367" sldId="303"/>
            <ac:spMk id="237" creationId="{E8766C5A-0CE9-4B15-A2C9-D0BA4EBE0988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38" creationId="{64555617-F980-4988-9978-5038D8C51582}"/>
          </ac:spMkLst>
        </pc:spChg>
        <pc:spChg chg="mod">
          <ac:chgData name="Filippo Acconcia" userId="844af49c-a8a0-47ac-a7dd-14a44b60cd18" providerId="ADAL" clId="{B609A75A-164F-4066-A006-F59E853DC491}" dt="2022-04-29T07:35:07.918" v="1906" actId="165"/>
          <ac:spMkLst>
            <pc:docMk/>
            <pc:sldMk cId="2248971367" sldId="303"/>
            <ac:spMk id="238" creationId="{CE24C731-1CA4-4E2D-9705-E12EE36680D1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39" creationId="{1348EC8E-5036-49ED-804A-DE346DF488EF}"/>
          </ac:spMkLst>
        </pc:spChg>
        <pc:spChg chg="mod">
          <ac:chgData name="Filippo Acconcia" userId="844af49c-a8a0-47ac-a7dd-14a44b60cd18" providerId="ADAL" clId="{B609A75A-164F-4066-A006-F59E853DC491}" dt="2022-04-29T07:35:07.918" v="1906" actId="165"/>
          <ac:spMkLst>
            <pc:docMk/>
            <pc:sldMk cId="2248971367" sldId="303"/>
            <ac:spMk id="240" creationId="{530542DA-FC5C-40DD-B151-926A652A96E8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40" creationId="{64B96211-05F5-4717-B8AB-0F19D3B812D7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41" creationId="{29CC5589-77B5-4857-B9AA-1B011EEBEE29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43" creationId="{463CCE2F-E5EC-4196-AD9F-FC24337DC564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51" creationId="{3ED8169C-5331-4ED7-8D10-87FA0FAD77A7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53" creationId="{D95CD09D-A6F7-4662-8626-4560D276F369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55" creationId="{D4D9127D-A6DA-4E47-A530-2FB2A115FCFA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56" creationId="{1183E141-0B14-4C28-942F-4E57B8ED094C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57" creationId="{69076DC5-B54C-4140-B37A-12735E78EDAC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58" creationId="{873FCC2B-BADB-4B39-BCCC-AC2461B56B06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59" creationId="{D7F0C462-F44F-4AFF-8300-38D310742296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60" creationId="{96CA6EED-2AF7-4226-B1C0-A7CD1BB61AC2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61" creationId="{91020B3D-D01C-4A32-8628-C461C0753632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62" creationId="{6977E66E-6E5E-46BE-9648-88F292D0C658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63" creationId="{7BA64F2C-3B1C-45A3-B043-7D5303BBADF2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64" creationId="{57195359-E405-4D20-89A8-AB9D5BB55003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65" creationId="{B96417F8-FF42-4008-AA2E-F03B25D68612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66" creationId="{31B98CDF-AC61-48F0-87F9-933362FBF8D9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67" creationId="{F8426D52-0F30-4BDD-9BCF-B0A1AFE2634B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69" creationId="{D7A2A818-0700-4733-9B66-88F515EE9519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70" creationId="{E9A0A299-2EB8-46D9-B8BD-B23D15E626C9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71" creationId="{6C436A6E-ED3B-4BC6-A17C-A7AFFF714EC1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72" creationId="{BFCD40A0-61CA-49BA-AC9A-84EB894B1F81}"/>
          </ac:spMkLst>
        </pc:spChg>
        <pc:spChg chg="mod">
          <ac:chgData name="Filippo Acconcia" userId="844af49c-a8a0-47ac-a7dd-14a44b60cd18" providerId="ADAL" clId="{B609A75A-164F-4066-A006-F59E853DC491}" dt="2022-04-01T09:39:05.833" v="1398"/>
          <ac:spMkLst>
            <pc:docMk/>
            <pc:sldMk cId="2248971367" sldId="303"/>
            <ac:spMk id="273" creationId="{B69EED78-9D83-4F22-93DA-5294E894531B}"/>
          </ac:spMkLst>
        </pc:spChg>
        <pc:spChg chg="mod">
          <ac:chgData name="Filippo Acconcia" userId="844af49c-a8a0-47ac-a7dd-14a44b60cd18" providerId="ADAL" clId="{B609A75A-164F-4066-A006-F59E853DC491}" dt="2022-04-01T09:40:26.691" v="1426"/>
          <ac:spMkLst>
            <pc:docMk/>
            <pc:sldMk cId="2248971367" sldId="303"/>
            <ac:spMk id="276" creationId="{54A71DCD-B988-465E-96B4-1E8E260D773E}"/>
          </ac:spMkLst>
        </pc:spChg>
        <pc:spChg chg="mod">
          <ac:chgData name="Filippo Acconcia" userId="844af49c-a8a0-47ac-a7dd-14a44b60cd18" providerId="ADAL" clId="{B609A75A-164F-4066-A006-F59E853DC491}" dt="2022-04-01T09:40:26.691" v="1426"/>
          <ac:spMkLst>
            <pc:docMk/>
            <pc:sldMk cId="2248971367" sldId="303"/>
            <ac:spMk id="277" creationId="{6B8F2FC0-C11F-4EA3-ADBA-A4794972C2D7}"/>
          </ac:spMkLst>
        </pc:spChg>
        <pc:spChg chg="mod">
          <ac:chgData name="Filippo Acconcia" userId="844af49c-a8a0-47ac-a7dd-14a44b60cd18" providerId="ADAL" clId="{B609A75A-164F-4066-A006-F59E853DC491}" dt="2022-04-01T09:40:26.691" v="1426"/>
          <ac:spMkLst>
            <pc:docMk/>
            <pc:sldMk cId="2248971367" sldId="303"/>
            <ac:spMk id="278" creationId="{79B8310E-F788-4F17-97F6-F0DECF71DFDC}"/>
          </ac:spMkLst>
        </pc:spChg>
        <pc:spChg chg="mod">
          <ac:chgData name="Filippo Acconcia" userId="844af49c-a8a0-47ac-a7dd-14a44b60cd18" providerId="ADAL" clId="{B609A75A-164F-4066-A006-F59E853DC491}" dt="2022-04-01T09:41:12.244" v="1466"/>
          <ac:spMkLst>
            <pc:docMk/>
            <pc:sldMk cId="2248971367" sldId="303"/>
            <ac:spMk id="281" creationId="{AA5F8B2E-13F7-4F95-9E8D-850AAC0F9C52}"/>
          </ac:spMkLst>
        </pc:spChg>
        <pc:spChg chg="mod">
          <ac:chgData name="Filippo Acconcia" userId="844af49c-a8a0-47ac-a7dd-14a44b60cd18" providerId="ADAL" clId="{B609A75A-164F-4066-A006-F59E853DC491}" dt="2022-04-01T09:41:12.244" v="1466"/>
          <ac:spMkLst>
            <pc:docMk/>
            <pc:sldMk cId="2248971367" sldId="303"/>
            <ac:spMk id="282" creationId="{0825A960-5FD4-4305-AB2A-801771B0D8AB}"/>
          </ac:spMkLst>
        </pc:spChg>
        <pc:spChg chg="mod">
          <ac:chgData name="Filippo Acconcia" userId="844af49c-a8a0-47ac-a7dd-14a44b60cd18" providerId="ADAL" clId="{B609A75A-164F-4066-A006-F59E853DC491}" dt="2022-04-01T09:41:12.244" v="1466"/>
          <ac:spMkLst>
            <pc:docMk/>
            <pc:sldMk cId="2248971367" sldId="303"/>
            <ac:spMk id="283" creationId="{533E99F7-1879-4753-9A22-7F567903A68E}"/>
          </ac:spMkLst>
        </pc:spChg>
        <pc:spChg chg="mod">
          <ac:chgData name="Filippo Acconcia" userId="844af49c-a8a0-47ac-a7dd-14a44b60cd18" providerId="ADAL" clId="{B609A75A-164F-4066-A006-F59E853DC491}" dt="2022-04-01T09:41:12.244" v="1466"/>
          <ac:spMkLst>
            <pc:docMk/>
            <pc:sldMk cId="2248971367" sldId="303"/>
            <ac:spMk id="284" creationId="{9232BCE7-EAED-4432-ADAC-D09C6F9904AF}"/>
          </ac:spMkLst>
        </pc:spChg>
        <pc:spChg chg="mod">
          <ac:chgData name="Filippo Acconcia" userId="844af49c-a8a0-47ac-a7dd-14a44b60cd18" providerId="ADAL" clId="{B609A75A-164F-4066-A006-F59E853DC491}" dt="2022-04-01T09:41:16.686" v="1468"/>
          <ac:spMkLst>
            <pc:docMk/>
            <pc:sldMk cId="2248971367" sldId="303"/>
            <ac:spMk id="286" creationId="{181DDF4D-6E8B-4043-AC79-1E982D1EBCDF}"/>
          </ac:spMkLst>
        </pc:spChg>
        <pc:spChg chg="mod">
          <ac:chgData name="Filippo Acconcia" userId="844af49c-a8a0-47ac-a7dd-14a44b60cd18" providerId="ADAL" clId="{B609A75A-164F-4066-A006-F59E853DC491}" dt="2022-04-01T09:41:16.686" v="1468"/>
          <ac:spMkLst>
            <pc:docMk/>
            <pc:sldMk cId="2248971367" sldId="303"/>
            <ac:spMk id="287" creationId="{AEDEF880-A6B7-4447-A461-7E175D1E3591}"/>
          </ac:spMkLst>
        </pc:spChg>
        <pc:spChg chg="mod">
          <ac:chgData name="Filippo Acconcia" userId="844af49c-a8a0-47ac-a7dd-14a44b60cd18" providerId="ADAL" clId="{B609A75A-164F-4066-A006-F59E853DC491}" dt="2022-04-01T09:41:16.686" v="1468"/>
          <ac:spMkLst>
            <pc:docMk/>
            <pc:sldMk cId="2248971367" sldId="303"/>
            <ac:spMk id="288" creationId="{F200C89C-03E3-4FB9-A4E6-5F282B480623}"/>
          </ac:spMkLst>
        </pc:spChg>
        <pc:spChg chg="mod">
          <ac:chgData name="Filippo Acconcia" userId="844af49c-a8a0-47ac-a7dd-14a44b60cd18" providerId="ADAL" clId="{B609A75A-164F-4066-A006-F59E853DC491}" dt="2022-04-01T09:41:16.686" v="1468"/>
          <ac:spMkLst>
            <pc:docMk/>
            <pc:sldMk cId="2248971367" sldId="303"/>
            <ac:spMk id="289" creationId="{A9878631-33DC-49BF-B413-1C3E69BDFCB1}"/>
          </ac:spMkLst>
        </pc:spChg>
        <pc:spChg chg="mod">
          <ac:chgData name="Filippo Acconcia" userId="844af49c-a8a0-47ac-a7dd-14a44b60cd18" providerId="ADAL" clId="{B609A75A-164F-4066-A006-F59E853DC491}" dt="2022-04-01T09:41:24.377" v="1481"/>
          <ac:spMkLst>
            <pc:docMk/>
            <pc:sldMk cId="2248971367" sldId="303"/>
            <ac:spMk id="291" creationId="{137B2A78-0A04-40EA-8E87-278CD9225ABA}"/>
          </ac:spMkLst>
        </pc:spChg>
        <pc:spChg chg="mod">
          <ac:chgData name="Filippo Acconcia" userId="844af49c-a8a0-47ac-a7dd-14a44b60cd18" providerId="ADAL" clId="{B609A75A-164F-4066-A006-F59E853DC491}" dt="2022-04-01T09:41:24.377" v="1481"/>
          <ac:spMkLst>
            <pc:docMk/>
            <pc:sldMk cId="2248971367" sldId="303"/>
            <ac:spMk id="292" creationId="{29394DE3-EBFC-4753-9915-EF45A75C5D94}"/>
          </ac:spMkLst>
        </pc:spChg>
        <pc:spChg chg="mod">
          <ac:chgData name="Filippo Acconcia" userId="844af49c-a8a0-47ac-a7dd-14a44b60cd18" providerId="ADAL" clId="{B609A75A-164F-4066-A006-F59E853DC491}" dt="2022-04-01T09:41:24.377" v="1481"/>
          <ac:spMkLst>
            <pc:docMk/>
            <pc:sldMk cId="2248971367" sldId="303"/>
            <ac:spMk id="293" creationId="{36DF659A-76C6-472A-9A36-C4055B7FFA2E}"/>
          </ac:spMkLst>
        </pc:spChg>
        <pc:spChg chg="mod">
          <ac:chgData name="Filippo Acconcia" userId="844af49c-a8a0-47ac-a7dd-14a44b60cd18" providerId="ADAL" clId="{B609A75A-164F-4066-A006-F59E853DC491}" dt="2022-04-01T09:41:24.377" v="1481"/>
          <ac:spMkLst>
            <pc:docMk/>
            <pc:sldMk cId="2248971367" sldId="303"/>
            <ac:spMk id="294" creationId="{E89656B8-8F27-4068-8AE8-943F77ECBDFD}"/>
          </ac:spMkLst>
        </pc:spChg>
        <pc:spChg chg="mod topLvl">
          <ac:chgData name="Filippo Acconcia" userId="844af49c-a8a0-47ac-a7dd-14a44b60cd18" providerId="ADAL" clId="{B609A75A-164F-4066-A006-F59E853DC491}" dt="2022-04-01T09:47:59.808" v="1567" actId="164"/>
          <ac:spMkLst>
            <pc:docMk/>
            <pc:sldMk cId="2248971367" sldId="303"/>
            <ac:spMk id="299" creationId="{1011C501-DC66-4B25-ADF3-37C5E804078F}"/>
          </ac:spMkLst>
        </pc:spChg>
        <pc:spChg chg="mod topLvl">
          <ac:chgData name="Filippo Acconcia" userId="844af49c-a8a0-47ac-a7dd-14a44b60cd18" providerId="ADAL" clId="{B609A75A-164F-4066-A006-F59E853DC491}" dt="2022-04-01T09:47:59.808" v="1567" actId="164"/>
          <ac:spMkLst>
            <pc:docMk/>
            <pc:sldMk cId="2248971367" sldId="303"/>
            <ac:spMk id="300" creationId="{7415D6DC-7B59-4266-9C53-261F6450A80C}"/>
          </ac:spMkLst>
        </pc:spChg>
        <pc:spChg chg="mod topLvl">
          <ac:chgData name="Filippo Acconcia" userId="844af49c-a8a0-47ac-a7dd-14a44b60cd18" providerId="ADAL" clId="{B609A75A-164F-4066-A006-F59E853DC491}" dt="2022-04-01T09:47:59.808" v="1567" actId="164"/>
          <ac:spMkLst>
            <pc:docMk/>
            <pc:sldMk cId="2248971367" sldId="303"/>
            <ac:spMk id="301" creationId="{46E4D7E9-F0EB-40BE-B980-2D15271B53DB}"/>
          </ac:spMkLst>
        </pc:spChg>
        <pc:spChg chg="mod topLvl">
          <ac:chgData name="Filippo Acconcia" userId="844af49c-a8a0-47ac-a7dd-14a44b60cd18" providerId="ADAL" clId="{B609A75A-164F-4066-A006-F59E853DC491}" dt="2022-04-01T09:47:59.808" v="1567" actId="164"/>
          <ac:spMkLst>
            <pc:docMk/>
            <pc:sldMk cId="2248971367" sldId="303"/>
            <ac:spMk id="302" creationId="{13FE9D52-B251-46C5-8D49-8B47C610F079}"/>
          </ac:spMkLst>
        </pc:spChg>
        <pc:spChg chg="mod topLvl">
          <ac:chgData name="Filippo Acconcia" userId="844af49c-a8a0-47ac-a7dd-14a44b60cd18" providerId="ADAL" clId="{B609A75A-164F-4066-A006-F59E853DC491}" dt="2022-04-01T09:47:59.808" v="1567" actId="164"/>
          <ac:spMkLst>
            <pc:docMk/>
            <pc:sldMk cId="2248971367" sldId="303"/>
            <ac:spMk id="303" creationId="{8B171AC2-DA4A-4878-AD70-AFBB3A52816D}"/>
          </ac:spMkLst>
        </pc:spChg>
        <pc:spChg chg="mod topLvl">
          <ac:chgData name="Filippo Acconcia" userId="844af49c-a8a0-47ac-a7dd-14a44b60cd18" providerId="ADAL" clId="{B609A75A-164F-4066-A006-F59E853DC491}" dt="2022-04-01T09:47:59.808" v="1567" actId="164"/>
          <ac:spMkLst>
            <pc:docMk/>
            <pc:sldMk cId="2248971367" sldId="303"/>
            <ac:spMk id="305" creationId="{00FF61D6-D4D7-4F73-82E7-B9A7993511FF}"/>
          </ac:spMkLst>
        </pc:spChg>
        <pc:spChg chg="mod">
          <ac:chgData name="Filippo Acconcia" userId="844af49c-a8a0-47ac-a7dd-14a44b60cd18" providerId="ADAL" clId="{B609A75A-164F-4066-A006-F59E853DC491}" dt="2022-04-01T09:46:41.888" v="1560" actId="165"/>
          <ac:spMkLst>
            <pc:docMk/>
            <pc:sldMk cId="2248971367" sldId="303"/>
            <ac:spMk id="313" creationId="{46A1FEAC-A3C2-416E-A54C-B226C3F96084}"/>
          </ac:spMkLst>
        </pc:spChg>
        <pc:spChg chg="mod">
          <ac:chgData name="Filippo Acconcia" userId="844af49c-a8a0-47ac-a7dd-14a44b60cd18" providerId="ADAL" clId="{B609A75A-164F-4066-A006-F59E853DC491}" dt="2022-04-01T09:46:41.888" v="1560" actId="165"/>
          <ac:spMkLst>
            <pc:docMk/>
            <pc:sldMk cId="2248971367" sldId="303"/>
            <ac:spMk id="314" creationId="{B65DE2CA-A68C-4549-B4A4-1F7030EB16CA}"/>
          </ac:spMkLst>
        </pc:spChg>
        <pc:spChg chg="mod">
          <ac:chgData name="Filippo Acconcia" userId="844af49c-a8a0-47ac-a7dd-14a44b60cd18" providerId="ADAL" clId="{B609A75A-164F-4066-A006-F59E853DC491}" dt="2022-04-01T09:46:41.888" v="1560" actId="165"/>
          <ac:spMkLst>
            <pc:docMk/>
            <pc:sldMk cId="2248971367" sldId="303"/>
            <ac:spMk id="315" creationId="{CC2E8697-3E27-4091-8DE9-D553BA14A8CE}"/>
          </ac:spMkLst>
        </pc:spChg>
        <pc:spChg chg="mod">
          <ac:chgData name="Filippo Acconcia" userId="844af49c-a8a0-47ac-a7dd-14a44b60cd18" providerId="ADAL" clId="{B609A75A-164F-4066-A006-F59E853DC491}" dt="2022-04-01T09:46:41.888" v="1560" actId="165"/>
          <ac:spMkLst>
            <pc:docMk/>
            <pc:sldMk cId="2248971367" sldId="303"/>
            <ac:spMk id="316" creationId="{02576811-2D75-4F22-8944-1F156E9FAED8}"/>
          </ac:spMkLst>
        </pc:spChg>
        <pc:spChg chg="mod">
          <ac:chgData name="Filippo Acconcia" userId="844af49c-a8a0-47ac-a7dd-14a44b60cd18" providerId="ADAL" clId="{B609A75A-164F-4066-A006-F59E853DC491}" dt="2022-04-01T09:46:41.888" v="1560" actId="165"/>
          <ac:spMkLst>
            <pc:docMk/>
            <pc:sldMk cId="2248971367" sldId="303"/>
            <ac:spMk id="317" creationId="{F96133BA-D653-48B1-A1AC-1B0C0FD23A4A}"/>
          </ac:spMkLst>
        </pc:spChg>
        <pc:spChg chg="mod">
          <ac:chgData name="Filippo Acconcia" userId="844af49c-a8a0-47ac-a7dd-14a44b60cd18" providerId="ADAL" clId="{B609A75A-164F-4066-A006-F59E853DC491}" dt="2022-04-01T09:46:41.888" v="1560" actId="165"/>
          <ac:spMkLst>
            <pc:docMk/>
            <pc:sldMk cId="2248971367" sldId="303"/>
            <ac:spMk id="318" creationId="{C6F2F194-6FCF-4068-AC93-B0DA8B88F642}"/>
          </ac:spMkLst>
        </pc:spChg>
        <pc:spChg chg="mod">
          <ac:chgData name="Filippo Acconcia" userId="844af49c-a8a0-47ac-a7dd-14a44b60cd18" providerId="ADAL" clId="{B609A75A-164F-4066-A006-F59E853DC491}" dt="2022-04-01T09:46:41.888" v="1560" actId="165"/>
          <ac:spMkLst>
            <pc:docMk/>
            <pc:sldMk cId="2248971367" sldId="303"/>
            <ac:spMk id="319" creationId="{5FDB147E-AAB7-4B86-9BA7-2C9E36AA9C7E}"/>
          </ac:spMkLst>
        </pc:spChg>
        <pc:spChg chg="mod">
          <ac:chgData name="Filippo Acconcia" userId="844af49c-a8a0-47ac-a7dd-14a44b60cd18" providerId="ADAL" clId="{B609A75A-164F-4066-A006-F59E853DC491}" dt="2022-04-01T09:46:41.888" v="1560" actId="165"/>
          <ac:spMkLst>
            <pc:docMk/>
            <pc:sldMk cId="2248971367" sldId="303"/>
            <ac:spMk id="320" creationId="{FB318E39-DA1C-4117-8F36-D6C83D86B703}"/>
          </ac:spMkLst>
        </pc:spChg>
        <pc:spChg chg="mod">
          <ac:chgData name="Filippo Acconcia" userId="844af49c-a8a0-47ac-a7dd-14a44b60cd18" providerId="ADAL" clId="{B609A75A-164F-4066-A006-F59E853DC491}" dt="2022-04-01T09:46:41.888" v="1560" actId="165"/>
          <ac:spMkLst>
            <pc:docMk/>
            <pc:sldMk cId="2248971367" sldId="303"/>
            <ac:spMk id="321" creationId="{3E6644DA-A7FE-4E15-BBCA-D04049A3FB95}"/>
          </ac:spMkLst>
        </pc:spChg>
        <pc:spChg chg="mod">
          <ac:chgData name="Filippo Acconcia" userId="844af49c-a8a0-47ac-a7dd-14a44b60cd18" providerId="ADAL" clId="{B609A75A-164F-4066-A006-F59E853DC491}" dt="2022-04-01T09:46:41.888" v="1560" actId="165"/>
          <ac:spMkLst>
            <pc:docMk/>
            <pc:sldMk cId="2248971367" sldId="303"/>
            <ac:spMk id="322" creationId="{E208BE4D-8D1B-4D40-A9CE-3591465E7A6D}"/>
          </ac:spMkLst>
        </pc:spChg>
        <pc:spChg chg="mod">
          <ac:chgData name="Filippo Acconcia" userId="844af49c-a8a0-47ac-a7dd-14a44b60cd18" providerId="ADAL" clId="{B609A75A-164F-4066-A006-F59E853DC491}" dt="2022-04-01T09:46:41.888" v="1560" actId="165"/>
          <ac:spMkLst>
            <pc:docMk/>
            <pc:sldMk cId="2248971367" sldId="303"/>
            <ac:spMk id="323" creationId="{E752FD00-D55A-4BFB-B7F7-6336BD73A7C2}"/>
          </ac:spMkLst>
        </pc:spChg>
        <pc:spChg chg="mod">
          <ac:chgData name="Filippo Acconcia" userId="844af49c-a8a0-47ac-a7dd-14a44b60cd18" providerId="ADAL" clId="{B609A75A-164F-4066-A006-F59E853DC491}" dt="2022-04-01T09:46:41.888" v="1560" actId="165"/>
          <ac:spMkLst>
            <pc:docMk/>
            <pc:sldMk cId="2248971367" sldId="303"/>
            <ac:spMk id="324" creationId="{9C47DA50-32C0-4236-B376-8F69F22B1700}"/>
          </ac:spMkLst>
        </pc:spChg>
        <pc:spChg chg="mod">
          <ac:chgData name="Filippo Acconcia" userId="844af49c-a8a0-47ac-a7dd-14a44b60cd18" providerId="ADAL" clId="{B609A75A-164F-4066-A006-F59E853DC491}" dt="2022-04-01T09:46:41.888" v="1560" actId="165"/>
          <ac:spMkLst>
            <pc:docMk/>
            <pc:sldMk cId="2248971367" sldId="303"/>
            <ac:spMk id="326" creationId="{957993FE-9AC0-4B4B-9BE0-4D869B57B6ED}"/>
          </ac:spMkLst>
        </pc:spChg>
        <pc:spChg chg="mod">
          <ac:chgData name="Filippo Acconcia" userId="844af49c-a8a0-47ac-a7dd-14a44b60cd18" providerId="ADAL" clId="{B609A75A-164F-4066-A006-F59E853DC491}" dt="2022-04-01T09:46:41.888" v="1560" actId="165"/>
          <ac:spMkLst>
            <pc:docMk/>
            <pc:sldMk cId="2248971367" sldId="303"/>
            <ac:spMk id="328" creationId="{A557DFA7-5B8C-4236-B08B-5DE2F4CA882E}"/>
          </ac:spMkLst>
        </pc:spChg>
        <pc:spChg chg="mod">
          <ac:chgData name="Filippo Acconcia" userId="844af49c-a8a0-47ac-a7dd-14a44b60cd18" providerId="ADAL" clId="{B609A75A-164F-4066-A006-F59E853DC491}" dt="2022-04-01T09:46:41.888" v="1560" actId="165"/>
          <ac:spMkLst>
            <pc:docMk/>
            <pc:sldMk cId="2248971367" sldId="303"/>
            <ac:spMk id="330" creationId="{203EDB89-EE55-491E-B4DF-A791CF7BF191}"/>
          </ac:spMkLst>
        </pc:spChg>
        <pc:spChg chg="mod">
          <ac:chgData name="Filippo Acconcia" userId="844af49c-a8a0-47ac-a7dd-14a44b60cd18" providerId="ADAL" clId="{B609A75A-164F-4066-A006-F59E853DC491}" dt="2022-04-01T09:46:41.888" v="1560" actId="165"/>
          <ac:spMkLst>
            <pc:docMk/>
            <pc:sldMk cId="2248971367" sldId="303"/>
            <ac:spMk id="331" creationId="{00D39245-095F-4A24-9149-DB4D849C07CA}"/>
          </ac:spMkLst>
        </pc:spChg>
        <pc:spChg chg="mod">
          <ac:chgData name="Filippo Acconcia" userId="844af49c-a8a0-47ac-a7dd-14a44b60cd18" providerId="ADAL" clId="{B609A75A-164F-4066-A006-F59E853DC491}" dt="2022-04-01T09:46:41.888" v="1560" actId="165"/>
          <ac:spMkLst>
            <pc:docMk/>
            <pc:sldMk cId="2248971367" sldId="303"/>
            <ac:spMk id="332" creationId="{D47F7886-1156-49CF-BDF3-0B9CC509AD11}"/>
          </ac:spMkLst>
        </pc:spChg>
        <pc:spChg chg="mod">
          <ac:chgData name="Filippo Acconcia" userId="844af49c-a8a0-47ac-a7dd-14a44b60cd18" providerId="ADAL" clId="{B609A75A-164F-4066-A006-F59E853DC491}" dt="2022-04-01T09:46:41.888" v="1560" actId="165"/>
          <ac:spMkLst>
            <pc:docMk/>
            <pc:sldMk cId="2248971367" sldId="303"/>
            <ac:spMk id="333" creationId="{9811493B-364C-411A-A558-8974CA27FD2F}"/>
          </ac:spMkLst>
        </pc:spChg>
        <pc:spChg chg="mod">
          <ac:chgData name="Filippo Acconcia" userId="844af49c-a8a0-47ac-a7dd-14a44b60cd18" providerId="ADAL" clId="{B609A75A-164F-4066-A006-F59E853DC491}" dt="2022-04-01T09:46:41.888" v="1560" actId="165"/>
          <ac:spMkLst>
            <pc:docMk/>
            <pc:sldMk cId="2248971367" sldId="303"/>
            <ac:spMk id="334" creationId="{3AFD2EAF-93F4-4BA1-A543-0C4CB27E3D3E}"/>
          </ac:spMkLst>
        </pc:spChg>
        <pc:spChg chg="mod">
          <ac:chgData name="Filippo Acconcia" userId="844af49c-a8a0-47ac-a7dd-14a44b60cd18" providerId="ADAL" clId="{B609A75A-164F-4066-A006-F59E853DC491}" dt="2022-04-01T09:46:41.888" v="1560" actId="165"/>
          <ac:spMkLst>
            <pc:docMk/>
            <pc:sldMk cId="2248971367" sldId="303"/>
            <ac:spMk id="336" creationId="{4CA36B8E-8327-4A11-9733-1A412BA1CACE}"/>
          </ac:spMkLst>
        </pc:spChg>
        <pc:spChg chg="add mod">
          <ac:chgData name="Filippo Acconcia" userId="844af49c-a8a0-47ac-a7dd-14a44b60cd18" providerId="ADAL" clId="{B609A75A-164F-4066-A006-F59E853DC491}" dt="2022-04-29T07:39:17.186" v="1976" actId="1038"/>
          <ac:spMkLst>
            <pc:docMk/>
            <pc:sldMk cId="2248971367" sldId="303"/>
            <ac:spMk id="337" creationId="{55B8A910-E482-48D0-A11F-AC09C5FF87F3}"/>
          </ac:spMkLst>
        </pc:spChg>
        <pc:grpChg chg="add del mod">
          <ac:chgData name="Filippo Acconcia" userId="844af49c-a8a0-47ac-a7dd-14a44b60cd18" providerId="ADAL" clId="{B609A75A-164F-4066-A006-F59E853DC491}" dt="2022-04-01T09:44:24.174" v="1528" actId="478"/>
          <ac:grpSpMkLst>
            <pc:docMk/>
            <pc:sldMk cId="2248971367" sldId="303"/>
            <ac:grpSpMk id="2" creationId="{0144537F-727B-4157-9BBE-292FDF71D974}"/>
          </ac:grpSpMkLst>
        </pc:grpChg>
        <pc:grpChg chg="add del mod">
          <ac:chgData name="Filippo Acconcia" userId="844af49c-a8a0-47ac-a7dd-14a44b60cd18" providerId="ADAL" clId="{B609A75A-164F-4066-A006-F59E853DC491}" dt="2022-04-29T07:38:18.341" v="1948" actId="165"/>
          <ac:grpSpMkLst>
            <pc:docMk/>
            <pc:sldMk cId="2248971367" sldId="303"/>
            <ac:grpSpMk id="4" creationId="{A0A707AA-70E3-46D7-B4F0-DD6796A76406}"/>
          </ac:grpSpMkLst>
        </pc:grpChg>
        <pc:grpChg chg="add mod">
          <ac:chgData name="Filippo Acconcia" userId="844af49c-a8a0-47ac-a7dd-14a44b60cd18" providerId="ADAL" clId="{B609A75A-164F-4066-A006-F59E853DC491}" dt="2022-04-29T07:39:17.186" v="1976" actId="1038"/>
          <ac:grpSpMkLst>
            <pc:docMk/>
            <pc:sldMk cId="2248971367" sldId="303"/>
            <ac:grpSpMk id="6" creationId="{048D73EE-AB17-4596-AA73-F07C8B30DF84}"/>
          </ac:grpSpMkLst>
        </pc:grpChg>
        <pc:grpChg chg="add del mod">
          <ac:chgData name="Filippo Acconcia" userId="844af49c-a8a0-47ac-a7dd-14a44b60cd18" providerId="ADAL" clId="{B609A75A-164F-4066-A006-F59E853DC491}" dt="2022-04-01T09:48:38.571" v="1590" actId="478"/>
          <ac:grpSpMkLst>
            <pc:docMk/>
            <pc:sldMk cId="2248971367" sldId="303"/>
            <ac:grpSpMk id="59" creationId="{3012FAC2-794B-4BBD-82B0-F87E13BF80CA}"/>
          </ac:grpSpMkLst>
        </pc:grpChg>
        <pc:grpChg chg="add del mod">
          <ac:chgData name="Filippo Acconcia" userId="844af49c-a8a0-47ac-a7dd-14a44b60cd18" providerId="ADAL" clId="{B609A75A-164F-4066-A006-F59E853DC491}" dt="2022-04-01T09:48:38.571" v="1590" actId="478"/>
          <ac:grpSpMkLst>
            <pc:docMk/>
            <pc:sldMk cId="2248971367" sldId="303"/>
            <ac:grpSpMk id="74" creationId="{FB328076-F9D9-4AFE-8CB6-13CC06B459CF}"/>
          </ac:grpSpMkLst>
        </pc:grpChg>
        <pc:grpChg chg="add del mod">
          <ac:chgData name="Filippo Acconcia" userId="844af49c-a8a0-47ac-a7dd-14a44b60cd18" providerId="ADAL" clId="{B609A75A-164F-4066-A006-F59E853DC491}" dt="2022-04-01T09:48:38.571" v="1590" actId="478"/>
          <ac:grpSpMkLst>
            <pc:docMk/>
            <pc:sldMk cId="2248971367" sldId="303"/>
            <ac:grpSpMk id="92" creationId="{9855E9BE-F779-4BA2-A340-DA71A2153A79}"/>
          </ac:grpSpMkLst>
        </pc:grpChg>
        <pc:grpChg chg="add del mod">
          <ac:chgData name="Filippo Acconcia" userId="844af49c-a8a0-47ac-a7dd-14a44b60cd18" providerId="ADAL" clId="{B609A75A-164F-4066-A006-F59E853DC491}" dt="2022-04-21T13:12:36.266" v="1786" actId="478"/>
          <ac:grpSpMkLst>
            <pc:docMk/>
            <pc:sldMk cId="2248971367" sldId="303"/>
            <ac:grpSpMk id="110" creationId="{463C47D9-C274-4AC2-BBE8-8400A4D2503F}"/>
          </ac:grpSpMkLst>
        </pc:grpChg>
        <pc:grpChg chg="mod">
          <ac:chgData name="Filippo Acconcia" userId="844af49c-a8a0-47ac-a7dd-14a44b60cd18" providerId="ADAL" clId="{B609A75A-164F-4066-A006-F59E853DC491}" dt="2022-04-01T08:52:04.533" v="1216"/>
          <ac:grpSpMkLst>
            <pc:docMk/>
            <pc:sldMk cId="2248971367" sldId="303"/>
            <ac:grpSpMk id="111" creationId="{AC0D2138-772B-43DC-8262-32DF17A9FBA6}"/>
          </ac:grpSpMkLst>
        </pc:grpChg>
        <pc:grpChg chg="add del mod">
          <ac:chgData name="Filippo Acconcia" userId="844af49c-a8a0-47ac-a7dd-14a44b60cd18" providerId="ADAL" clId="{B609A75A-164F-4066-A006-F59E853DC491}" dt="2022-04-29T07:33:14.590" v="1798" actId="165"/>
          <ac:grpSpMkLst>
            <pc:docMk/>
            <pc:sldMk cId="2248971367" sldId="303"/>
            <ac:grpSpMk id="117" creationId="{0D211A28-E7BE-40DB-8B2E-633B7271BBA5}"/>
          </ac:grpSpMkLst>
        </pc:grpChg>
        <pc:grpChg chg="del mod topLvl">
          <ac:chgData name="Filippo Acconcia" userId="844af49c-a8a0-47ac-a7dd-14a44b60cd18" providerId="ADAL" clId="{B609A75A-164F-4066-A006-F59E853DC491}" dt="2022-04-29T07:33:17.343" v="1799" actId="165"/>
          <ac:grpSpMkLst>
            <pc:docMk/>
            <pc:sldMk cId="2248971367" sldId="303"/>
            <ac:grpSpMk id="118" creationId="{D1747539-4301-4FC9-8E89-861EDD8B6548}"/>
          </ac:grpSpMkLst>
        </pc:grpChg>
        <pc:grpChg chg="add del mod">
          <ac:chgData name="Filippo Acconcia" userId="844af49c-a8a0-47ac-a7dd-14a44b60cd18" providerId="ADAL" clId="{B609A75A-164F-4066-A006-F59E853DC491}" dt="2022-04-01T09:36:00.810" v="1318" actId="165"/>
          <ac:grpSpMkLst>
            <pc:docMk/>
            <pc:sldMk cId="2248971367" sldId="303"/>
            <ac:grpSpMk id="144" creationId="{86C3F212-6208-44DA-875F-2552CBC58BAE}"/>
          </ac:grpSpMkLst>
        </pc:grpChg>
        <pc:grpChg chg="del mod topLvl">
          <ac:chgData name="Filippo Acconcia" userId="844af49c-a8a0-47ac-a7dd-14a44b60cd18" providerId="ADAL" clId="{B609A75A-164F-4066-A006-F59E853DC491}" dt="2022-04-01T09:38:38.109" v="1393" actId="478"/>
          <ac:grpSpMkLst>
            <pc:docMk/>
            <pc:sldMk cId="2248971367" sldId="303"/>
            <ac:grpSpMk id="146" creationId="{CC8A63B4-4881-4730-B3EA-9503991A3995}"/>
          </ac:grpSpMkLst>
        </pc:grpChg>
        <pc:grpChg chg="mod topLvl">
          <ac:chgData name="Filippo Acconcia" userId="844af49c-a8a0-47ac-a7dd-14a44b60cd18" providerId="ADAL" clId="{B609A75A-164F-4066-A006-F59E853DC491}" dt="2022-04-01T09:38:35.591" v="1392" actId="164"/>
          <ac:grpSpMkLst>
            <pc:docMk/>
            <pc:sldMk cId="2248971367" sldId="303"/>
            <ac:grpSpMk id="152" creationId="{D32598A7-D19F-4862-8F6F-AD78E8B19C69}"/>
          </ac:grpSpMkLst>
        </pc:grpChg>
        <pc:grpChg chg="del mod topLvl">
          <ac:chgData name="Filippo Acconcia" userId="844af49c-a8a0-47ac-a7dd-14a44b60cd18" providerId="ADAL" clId="{B609A75A-164F-4066-A006-F59E853DC491}" dt="2022-04-01T09:38:38.109" v="1393" actId="478"/>
          <ac:grpSpMkLst>
            <pc:docMk/>
            <pc:sldMk cId="2248971367" sldId="303"/>
            <ac:grpSpMk id="154" creationId="{C382D318-B484-4C1C-B02C-7B507377C6A0}"/>
          </ac:grpSpMkLst>
        </pc:grpChg>
        <pc:grpChg chg="del mod topLvl">
          <ac:chgData name="Filippo Acconcia" userId="844af49c-a8a0-47ac-a7dd-14a44b60cd18" providerId="ADAL" clId="{B609A75A-164F-4066-A006-F59E853DC491}" dt="2022-04-01T09:38:38.109" v="1393" actId="478"/>
          <ac:grpSpMkLst>
            <pc:docMk/>
            <pc:sldMk cId="2248971367" sldId="303"/>
            <ac:grpSpMk id="155" creationId="{771397BE-BA77-41D5-B61E-FC3134361522}"/>
          </ac:grpSpMkLst>
        </pc:grpChg>
        <pc:grpChg chg="del mod topLvl">
          <ac:chgData name="Filippo Acconcia" userId="844af49c-a8a0-47ac-a7dd-14a44b60cd18" providerId="ADAL" clId="{B609A75A-164F-4066-A006-F59E853DC491}" dt="2022-04-01T09:36:50.990" v="1348" actId="165"/>
          <ac:grpSpMkLst>
            <pc:docMk/>
            <pc:sldMk cId="2248971367" sldId="303"/>
            <ac:grpSpMk id="156" creationId="{01D2346A-8229-4730-BDA6-F0E69C24B07D}"/>
          </ac:grpSpMkLst>
        </pc:grpChg>
        <pc:grpChg chg="mod topLvl">
          <ac:chgData name="Filippo Acconcia" userId="844af49c-a8a0-47ac-a7dd-14a44b60cd18" providerId="ADAL" clId="{B609A75A-164F-4066-A006-F59E853DC491}" dt="2022-04-01T09:38:35.591" v="1392" actId="164"/>
          <ac:grpSpMkLst>
            <pc:docMk/>
            <pc:sldMk cId="2248971367" sldId="303"/>
            <ac:grpSpMk id="157" creationId="{2774B794-9021-49F0-8712-CA058D01C532}"/>
          </ac:grpSpMkLst>
        </pc:grpChg>
        <pc:grpChg chg="mod topLvl">
          <ac:chgData name="Filippo Acconcia" userId="844af49c-a8a0-47ac-a7dd-14a44b60cd18" providerId="ADAL" clId="{B609A75A-164F-4066-A006-F59E853DC491}" dt="2022-04-01T09:38:35.591" v="1392" actId="164"/>
          <ac:grpSpMkLst>
            <pc:docMk/>
            <pc:sldMk cId="2248971367" sldId="303"/>
            <ac:grpSpMk id="158" creationId="{983D8859-7FC2-4D5E-8E1B-A282F62D059F}"/>
          </ac:grpSpMkLst>
        </pc:grpChg>
        <pc:grpChg chg="mod topLvl">
          <ac:chgData name="Filippo Acconcia" userId="844af49c-a8a0-47ac-a7dd-14a44b60cd18" providerId="ADAL" clId="{B609A75A-164F-4066-A006-F59E853DC491}" dt="2022-04-01T09:38:35.591" v="1392" actId="164"/>
          <ac:grpSpMkLst>
            <pc:docMk/>
            <pc:sldMk cId="2248971367" sldId="303"/>
            <ac:grpSpMk id="159" creationId="{6F91A53D-F303-449C-BB62-64F0332EBADD}"/>
          </ac:grpSpMkLst>
        </pc:grpChg>
        <pc:grpChg chg="add del mod">
          <ac:chgData name="Filippo Acconcia" userId="844af49c-a8a0-47ac-a7dd-14a44b60cd18" providerId="ADAL" clId="{B609A75A-164F-4066-A006-F59E853DC491}" dt="2022-04-29T07:35:07.918" v="1906" actId="165"/>
          <ac:grpSpMkLst>
            <pc:docMk/>
            <pc:sldMk cId="2248971367" sldId="303"/>
            <ac:grpSpMk id="166" creationId="{851A5E63-08DF-496D-B9A2-1BB2BB64A16B}"/>
          </ac:grpSpMkLst>
        </pc:grpChg>
        <pc:grpChg chg="del mod topLvl">
          <ac:chgData name="Filippo Acconcia" userId="844af49c-a8a0-47ac-a7dd-14a44b60cd18" providerId="ADAL" clId="{B609A75A-164F-4066-A006-F59E853DC491}" dt="2022-04-29T07:36:13.696" v="1937" actId="478"/>
          <ac:grpSpMkLst>
            <pc:docMk/>
            <pc:sldMk cId="2248971367" sldId="303"/>
            <ac:grpSpMk id="175" creationId="{93F1ACDA-CEC3-4F40-B948-C7F97ADF06F6}"/>
          </ac:grpSpMkLst>
        </pc:grpChg>
        <pc:grpChg chg="del mod topLvl">
          <ac:chgData name="Filippo Acconcia" userId="844af49c-a8a0-47ac-a7dd-14a44b60cd18" providerId="ADAL" clId="{B609A75A-164F-4066-A006-F59E853DC491}" dt="2022-04-29T07:36:13.696" v="1937" actId="478"/>
          <ac:grpSpMkLst>
            <pc:docMk/>
            <pc:sldMk cId="2248971367" sldId="303"/>
            <ac:grpSpMk id="177" creationId="{041D64CC-5FF9-4F66-BD26-743E8E4D4B87}"/>
          </ac:grpSpMkLst>
        </pc:grpChg>
        <pc:grpChg chg="del mod topLvl">
          <ac:chgData name="Filippo Acconcia" userId="844af49c-a8a0-47ac-a7dd-14a44b60cd18" providerId="ADAL" clId="{B609A75A-164F-4066-A006-F59E853DC491}" dt="2022-04-29T07:36:13.696" v="1937" actId="478"/>
          <ac:grpSpMkLst>
            <pc:docMk/>
            <pc:sldMk cId="2248971367" sldId="303"/>
            <ac:grpSpMk id="180" creationId="{7927402D-2C41-4790-B69F-C657F8E61882}"/>
          </ac:grpSpMkLst>
        </pc:grpChg>
        <pc:grpChg chg="del mod topLvl">
          <ac:chgData name="Filippo Acconcia" userId="844af49c-a8a0-47ac-a7dd-14a44b60cd18" providerId="ADAL" clId="{B609A75A-164F-4066-A006-F59E853DC491}" dt="2022-04-29T07:36:13.696" v="1937" actId="478"/>
          <ac:grpSpMkLst>
            <pc:docMk/>
            <pc:sldMk cId="2248971367" sldId="303"/>
            <ac:grpSpMk id="181" creationId="{76D02308-051F-4221-BBDA-C736F73007DF}"/>
          </ac:grpSpMkLst>
        </pc:grpChg>
        <pc:grpChg chg="del mod topLvl">
          <ac:chgData name="Filippo Acconcia" userId="844af49c-a8a0-47ac-a7dd-14a44b60cd18" providerId="ADAL" clId="{B609A75A-164F-4066-A006-F59E853DC491}" dt="2022-04-29T07:36:13.696" v="1937" actId="478"/>
          <ac:grpSpMkLst>
            <pc:docMk/>
            <pc:sldMk cId="2248971367" sldId="303"/>
            <ac:grpSpMk id="182" creationId="{9903BAFC-4264-4CCF-A84A-4FE6AD510051}"/>
          </ac:grpSpMkLst>
        </pc:grpChg>
        <pc:grpChg chg="del mod topLvl">
          <ac:chgData name="Filippo Acconcia" userId="844af49c-a8a0-47ac-a7dd-14a44b60cd18" providerId="ADAL" clId="{B609A75A-164F-4066-A006-F59E853DC491}" dt="2022-04-29T07:36:13.696" v="1937" actId="478"/>
          <ac:grpSpMkLst>
            <pc:docMk/>
            <pc:sldMk cId="2248971367" sldId="303"/>
            <ac:grpSpMk id="183" creationId="{8BF233CE-08F2-43EA-B70B-788309E2B675}"/>
          </ac:grpSpMkLst>
        </pc:grpChg>
        <pc:grpChg chg="del mod topLvl">
          <ac:chgData name="Filippo Acconcia" userId="844af49c-a8a0-47ac-a7dd-14a44b60cd18" providerId="ADAL" clId="{B609A75A-164F-4066-A006-F59E853DC491}" dt="2022-04-29T07:36:13.696" v="1937" actId="478"/>
          <ac:grpSpMkLst>
            <pc:docMk/>
            <pc:sldMk cId="2248971367" sldId="303"/>
            <ac:grpSpMk id="191" creationId="{6C9D2C98-0FA0-41D1-A246-0B8A8049BAEC}"/>
          </ac:grpSpMkLst>
        </pc:grpChg>
        <pc:grpChg chg="add mod">
          <ac:chgData name="Filippo Acconcia" userId="844af49c-a8a0-47ac-a7dd-14a44b60cd18" providerId="ADAL" clId="{B609A75A-164F-4066-A006-F59E853DC491}" dt="2022-04-29T07:39:17.186" v="1976" actId="1038"/>
          <ac:grpSpMkLst>
            <pc:docMk/>
            <pc:sldMk cId="2248971367" sldId="303"/>
            <ac:grpSpMk id="193" creationId="{94AE7D3B-82B1-4FE8-A978-7EC0EE7D64FE}"/>
          </ac:grpSpMkLst>
        </pc:grpChg>
        <pc:grpChg chg="del mod topLvl">
          <ac:chgData name="Filippo Acconcia" userId="844af49c-a8a0-47ac-a7dd-14a44b60cd18" providerId="ADAL" clId="{B609A75A-164F-4066-A006-F59E853DC491}" dt="2022-04-29T07:36:13.696" v="1937" actId="478"/>
          <ac:grpSpMkLst>
            <pc:docMk/>
            <pc:sldMk cId="2248971367" sldId="303"/>
            <ac:grpSpMk id="194" creationId="{3A342552-7103-4865-BAAB-5C48C3E97C86}"/>
          </ac:grpSpMkLst>
        </pc:grpChg>
        <pc:grpChg chg="add del mod">
          <ac:chgData name="Filippo Acconcia" userId="844af49c-a8a0-47ac-a7dd-14a44b60cd18" providerId="ADAL" clId="{B609A75A-164F-4066-A006-F59E853DC491}" dt="2022-04-01T09:39:19.449" v="1402" actId="165"/>
          <ac:grpSpMkLst>
            <pc:docMk/>
            <pc:sldMk cId="2248971367" sldId="303"/>
            <ac:grpSpMk id="194" creationId="{C2C657E6-D17A-4C68-9FC6-5FAE874941E9}"/>
          </ac:grpSpMkLst>
        </pc:grpChg>
        <pc:grpChg chg="del mod topLvl">
          <ac:chgData name="Filippo Acconcia" userId="844af49c-a8a0-47ac-a7dd-14a44b60cd18" providerId="ADAL" clId="{B609A75A-164F-4066-A006-F59E853DC491}" dt="2022-04-01T09:39:28.644" v="1404" actId="478"/>
          <ac:grpSpMkLst>
            <pc:docMk/>
            <pc:sldMk cId="2248971367" sldId="303"/>
            <ac:grpSpMk id="196" creationId="{DB7AFF83-F04B-4D23-A442-719CBB5976EF}"/>
          </ac:grpSpMkLst>
        </pc:grpChg>
        <pc:grpChg chg="mod topLvl">
          <ac:chgData name="Filippo Acconcia" userId="844af49c-a8a0-47ac-a7dd-14a44b60cd18" providerId="ADAL" clId="{B609A75A-164F-4066-A006-F59E853DC491}" dt="2022-04-01T09:44:04.943" v="1523" actId="164"/>
          <ac:grpSpMkLst>
            <pc:docMk/>
            <pc:sldMk cId="2248971367" sldId="303"/>
            <ac:grpSpMk id="202" creationId="{8567DF3F-789F-4D62-9472-9773ACD16442}"/>
          </ac:grpSpMkLst>
        </pc:grpChg>
        <pc:grpChg chg="del mod topLvl">
          <ac:chgData name="Filippo Acconcia" userId="844af49c-a8a0-47ac-a7dd-14a44b60cd18" providerId="ADAL" clId="{B609A75A-164F-4066-A006-F59E853DC491}" dt="2022-04-01T09:39:28.644" v="1404" actId="478"/>
          <ac:grpSpMkLst>
            <pc:docMk/>
            <pc:sldMk cId="2248971367" sldId="303"/>
            <ac:grpSpMk id="204" creationId="{5E14F6A4-333A-4F04-A2AB-9D44AABC4677}"/>
          </ac:grpSpMkLst>
        </pc:grpChg>
        <pc:grpChg chg="del mod topLvl">
          <ac:chgData name="Filippo Acconcia" userId="844af49c-a8a0-47ac-a7dd-14a44b60cd18" providerId="ADAL" clId="{B609A75A-164F-4066-A006-F59E853DC491}" dt="2022-04-01T09:39:28.644" v="1404" actId="478"/>
          <ac:grpSpMkLst>
            <pc:docMk/>
            <pc:sldMk cId="2248971367" sldId="303"/>
            <ac:grpSpMk id="205" creationId="{4E262F72-BDD8-4924-AC81-9C400E5C5ADB}"/>
          </ac:grpSpMkLst>
        </pc:grpChg>
        <pc:grpChg chg="del mod topLvl">
          <ac:chgData name="Filippo Acconcia" userId="844af49c-a8a0-47ac-a7dd-14a44b60cd18" providerId="ADAL" clId="{B609A75A-164F-4066-A006-F59E853DC491}" dt="2022-04-01T09:39:25.562" v="1403" actId="165"/>
          <ac:grpSpMkLst>
            <pc:docMk/>
            <pc:sldMk cId="2248971367" sldId="303"/>
            <ac:grpSpMk id="206" creationId="{512ED4C4-4D7D-45EA-BC3D-09DE4BF698F0}"/>
          </ac:grpSpMkLst>
        </pc:grpChg>
        <pc:grpChg chg="mod topLvl">
          <ac:chgData name="Filippo Acconcia" userId="844af49c-a8a0-47ac-a7dd-14a44b60cd18" providerId="ADAL" clId="{B609A75A-164F-4066-A006-F59E853DC491}" dt="2022-04-01T09:44:04.943" v="1523" actId="164"/>
          <ac:grpSpMkLst>
            <pc:docMk/>
            <pc:sldMk cId="2248971367" sldId="303"/>
            <ac:grpSpMk id="207" creationId="{20534432-D8E9-463A-BB4D-FFE46E5B8C3A}"/>
          </ac:grpSpMkLst>
        </pc:grpChg>
        <pc:grpChg chg="mod topLvl">
          <ac:chgData name="Filippo Acconcia" userId="844af49c-a8a0-47ac-a7dd-14a44b60cd18" providerId="ADAL" clId="{B609A75A-164F-4066-A006-F59E853DC491}" dt="2022-04-01T09:44:04.943" v="1523" actId="164"/>
          <ac:grpSpMkLst>
            <pc:docMk/>
            <pc:sldMk cId="2248971367" sldId="303"/>
            <ac:grpSpMk id="208" creationId="{F4D9AC33-35E4-461B-A0FB-B8783173C8EA}"/>
          </ac:grpSpMkLst>
        </pc:grpChg>
        <pc:grpChg chg="mod topLvl">
          <ac:chgData name="Filippo Acconcia" userId="844af49c-a8a0-47ac-a7dd-14a44b60cd18" providerId="ADAL" clId="{B609A75A-164F-4066-A006-F59E853DC491}" dt="2022-04-01T09:44:04.943" v="1523" actId="164"/>
          <ac:grpSpMkLst>
            <pc:docMk/>
            <pc:sldMk cId="2248971367" sldId="303"/>
            <ac:grpSpMk id="209" creationId="{5D0BF3F4-A8AA-4952-8BFB-EC205E025FCE}"/>
          </ac:grpSpMkLst>
        </pc:grpChg>
        <pc:grpChg chg="add del mod">
          <ac:chgData name="Filippo Acconcia" userId="844af49c-a8a0-47ac-a7dd-14a44b60cd18" providerId="ADAL" clId="{B609A75A-164F-4066-A006-F59E853DC491}" dt="2022-04-01T09:39:13.286" v="1401" actId="478"/>
          <ac:grpSpMkLst>
            <pc:docMk/>
            <pc:sldMk cId="2248971367" sldId="303"/>
            <ac:grpSpMk id="234" creationId="{08164B66-0506-4B03-9D87-249E4F7F6891}"/>
          </ac:grpSpMkLst>
        </pc:grpChg>
        <pc:grpChg chg="mod">
          <ac:chgData name="Filippo Acconcia" userId="844af49c-a8a0-47ac-a7dd-14a44b60cd18" providerId="ADAL" clId="{B609A75A-164F-4066-A006-F59E853DC491}" dt="2022-04-01T09:39:05.833" v="1398"/>
          <ac:grpSpMkLst>
            <pc:docMk/>
            <pc:sldMk cId="2248971367" sldId="303"/>
            <ac:grpSpMk id="236" creationId="{1F9B3DDE-98C4-4D88-A023-ADCBD0EDE60A}"/>
          </ac:grpSpMkLst>
        </pc:grpChg>
        <pc:grpChg chg="mod">
          <ac:chgData name="Filippo Acconcia" userId="844af49c-a8a0-47ac-a7dd-14a44b60cd18" providerId="ADAL" clId="{B609A75A-164F-4066-A006-F59E853DC491}" dt="2022-04-01T09:39:05.833" v="1398"/>
          <ac:grpSpMkLst>
            <pc:docMk/>
            <pc:sldMk cId="2248971367" sldId="303"/>
            <ac:grpSpMk id="242" creationId="{BFD40212-5365-47DF-87B3-7EC1A4486BFC}"/>
          </ac:grpSpMkLst>
        </pc:grpChg>
        <pc:grpChg chg="mod">
          <ac:chgData name="Filippo Acconcia" userId="844af49c-a8a0-47ac-a7dd-14a44b60cd18" providerId="ADAL" clId="{B609A75A-164F-4066-A006-F59E853DC491}" dt="2022-04-01T09:39:05.833" v="1398"/>
          <ac:grpSpMkLst>
            <pc:docMk/>
            <pc:sldMk cId="2248971367" sldId="303"/>
            <ac:grpSpMk id="244" creationId="{3D4181EB-5E36-4FCD-9970-430A56F56CD2}"/>
          </ac:grpSpMkLst>
        </pc:grpChg>
        <pc:grpChg chg="mod">
          <ac:chgData name="Filippo Acconcia" userId="844af49c-a8a0-47ac-a7dd-14a44b60cd18" providerId="ADAL" clId="{B609A75A-164F-4066-A006-F59E853DC491}" dt="2022-04-01T09:39:05.833" v="1398"/>
          <ac:grpSpMkLst>
            <pc:docMk/>
            <pc:sldMk cId="2248971367" sldId="303"/>
            <ac:grpSpMk id="245" creationId="{224F2BD8-BE73-4A37-83D0-4C9AE779772F}"/>
          </ac:grpSpMkLst>
        </pc:grpChg>
        <pc:grpChg chg="mod">
          <ac:chgData name="Filippo Acconcia" userId="844af49c-a8a0-47ac-a7dd-14a44b60cd18" providerId="ADAL" clId="{B609A75A-164F-4066-A006-F59E853DC491}" dt="2022-04-01T09:39:05.833" v="1398"/>
          <ac:grpSpMkLst>
            <pc:docMk/>
            <pc:sldMk cId="2248971367" sldId="303"/>
            <ac:grpSpMk id="246" creationId="{6804A19F-8390-4484-93C0-7274E33606AF}"/>
          </ac:grpSpMkLst>
        </pc:grpChg>
        <pc:grpChg chg="mod">
          <ac:chgData name="Filippo Acconcia" userId="844af49c-a8a0-47ac-a7dd-14a44b60cd18" providerId="ADAL" clId="{B609A75A-164F-4066-A006-F59E853DC491}" dt="2022-04-01T09:39:05.833" v="1398"/>
          <ac:grpSpMkLst>
            <pc:docMk/>
            <pc:sldMk cId="2248971367" sldId="303"/>
            <ac:grpSpMk id="247" creationId="{3E863FCC-A7EC-4194-AA99-814E027CAA65}"/>
          </ac:grpSpMkLst>
        </pc:grpChg>
        <pc:grpChg chg="mod">
          <ac:chgData name="Filippo Acconcia" userId="844af49c-a8a0-47ac-a7dd-14a44b60cd18" providerId="ADAL" clId="{B609A75A-164F-4066-A006-F59E853DC491}" dt="2022-04-01T09:39:05.833" v="1398"/>
          <ac:grpSpMkLst>
            <pc:docMk/>
            <pc:sldMk cId="2248971367" sldId="303"/>
            <ac:grpSpMk id="248" creationId="{3F8573E7-29F3-4307-9FDF-EEF29EC97AFB}"/>
          </ac:grpSpMkLst>
        </pc:grpChg>
        <pc:grpChg chg="mod">
          <ac:chgData name="Filippo Acconcia" userId="844af49c-a8a0-47ac-a7dd-14a44b60cd18" providerId="ADAL" clId="{B609A75A-164F-4066-A006-F59E853DC491}" dt="2022-04-01T09:39:05.833" v="1398"/>
          <ac:grpSpMkLst>
            <pc:docMk/>
            <pc:sldMk cId="2248971367" sldId="303"/>
            <ac:grpSpMk id="249" creationId="{84DF2EEF-4E5B-4163-BD34-161E834CB8E8}"/>
          </ac:grpSpMkLst>
        </pc:grpChg>
        <pc:grpChg chg="add del mod">
          <ac:chgData name="Filippo Acconcia" userId="844af49c-a8a0-47ac-a7dd-14a44b60cd18" providerId="ADAL" clId="{B609A75A-164F-4066-A006-F59E853DC491}" dt="2022-04-01T09:40:35.848" v="1429" actId="165"/>
          <ac:grpSpMkLst>
            <pc:docMk/>
            <pc:sldMk cId="2248971367" sldId="303"/>
            <ac:grpSpMk id="274" creationId="{34EBDA0D-C081-4A09-952D-516B3E2EAADD}"/>
          </ac:grpSpMkLst>
        </pc:grpChg>
        <pc:grpChg chg="add del mod">
          <ac:chgData name="Filippo Acconcia" userId="844af49c-a8a0-47ac-a7dd-14a44b60cd18" providerId="ADAL" clId="{B609A75A-164F-4066-A006-F59E853DC491}" dt="2022-04-01T09:40:31.156" v="1428" actId="478"/>
          <ac:grpSpMkLst>
            <pc:docMk/>
            <pc:sldMk cId="2248971367" sldId="303"/>
            <ac:grpSpMk id="275" creationId="{882DB610-9A43-4E13-AABC-F55E1C84C6D1}"/>
          </ac:grpSpMkLst>
        </pc:grpChg>
        <pc:grpChg chg="add mod">
          <ac:chgData name="Filippo Acconcia" userId="844af49c-a8a0-47ac-a7dd-14a44b60cd18" providerId="ADAL" clId="{B609A75A-164F-4066-A006-F59E853DC491}" dt="2022-04-01T09:44:04.943" v="1523" actId="164"/>
          <ac:grpSpMkLst>
            <pc:docMk/>
            <pc:sldMk cId="2248971367" sldId="303"/>
            <ac:grpSpMk id="279" creationId="{534913A8-7EC1-4DA0-9BB4-57E87CE21156}"/>
          </ac:grpSpMkLst>
        </pc:grpChg>
        <pc:grpChg chg="add mod">
          <ac:chgData name="Filippo Acconcia" userId="844af49c-a8a0-47ac-a7dd-14a44b60cd18" providerId="ADAL" clId="{B609A75A-164F-4066-A006-F59E853DC491}" dt="2022-04-01T09:44:04.943" v="1523" actId="164"/>
          <ac:grpSpMkLst>
            <pc:docMk/>
            <pc:sldMk cId="2248971367" sldId="303"/>
            <ac:grpSpMk id="280" creationId="{84B844FE-DF46-4CBA-BF68-E6589F00F083}"/>
          </ac:grpSpMkLst>
        </pc:grpChg>
        <pc:grpChg chg="add mod">
          <ac:chgData name="Filippo Acconcia" userId="844af49c-a8a0-47ac-a7dd-14a44b60cd18" providerId="ADAL" clId="{B609A75A-164F-4066-A006-F59E853DC491}" dt="2022-04-01T09:44:04.943" v="1523" actId="164"/>
          <ac:grpSpMkLst>
            <pc:docMk/>
            <pc:sldMk cId="2248971367" sldId="303"/>
            <ac:grpSpMk id="285" creationId="{5FF5CC32-B259-4CD5-B47D-C87F5A3D7BB2}"/>
          </ac:grpSpMkLst>
        </pc:grpChg>
        <pc:grpChg chg="add mod">
          <ac:chgData name="Filippo Acconcia" userId="844af49c-a8a0-47ac-a7dd-14a44b60cd18" providerId="ADAL" clId="{B609A75A-164F-4066-A006-F59E853DC491}" dt="2022-04-01T09:44:04.943" v="1523" actId="164"/>
          <ac:grpSpMkLst>
            <pc:docMk/>
            <pc:sldMk cId="2248971367" sldId="303"/>
            <ac:grpSpMk id="290" creationId="{26AA60CB-82E9-45FB-8F7E-40079B4F6448}"/>
          </ac:grpSpMkLst>
        </pc:grpChg>
        <pc:grpChg chg="add mod">
          <ac:chgData name="Filippo Acconcia" userId="844af49c-a8a0-47ac-a7dd-14a44b60cd18" providerId="ADAL" clId="{B609A75A-164F-4066-A006-F59E853DC491}" dt="2022-04-29T07:39:17.186" v="1976" actId="1038"/>
          <ac:grpSpMkLst>
            <pc:docMk/>
            <pc:sldMk cId="2248971367" sldId="303"/>
            <ac:grpSpMk id="296" creationId="{0B2E1F5F-A878-4B59-AF2C-56A70CD29430}"/>
          </ac:grpSpMkLst>
        </pc:grpChg>
        <pc:grpChg chg="add del mod">
          <ac:chgData name="Filippo Acconcia" userId="844af49c-a8a0-47ac-a7dd-14a44b60cd18" providerId="ADAL" clId="{B609A75A-164F-4066-A006-F59E853DC491}" dt="2022-04-01T09:46:41.888" v="1560" actId="165"/>
          <ac:grpSpMkLst>
            <pc:docMk/>
            <pc:sldMk cId="2248971367" sldId="303"/>
            <ac:grpSpMk id="297" creationId="{DE2AF425-6594-4672-94D8-D18DE6BD0394}"/>
          </ac:grpSpMkLst>
        </pc:grpChg>
        <pc:grpChg chg="mod topLvl">
          <ac:chgData name="Filippo Acconcia" userId="844af49c-a8a0-47ac-a7dd-14a44b60cd18" providerId="ADAL" clId="{B609A75A-164F-4066-A006-F59E853DC491}" dt="2022-04-01T09:47:59.808" v="1567" actId="164"/>
          <ac:grpSpMkLst>
            <pc:docMk/>
            <pc:sldMk cId="2248971367" sldId="303"/>
            <ac:grpSpMk id="304" creationId="{19774E60-F852-4765-A8E0-6778AFCEAFD1}"/>
          </ac:grpSpMkLst>
        </pc:grpChg>
        <pc:grpChg chg="mod topLvl">
          <ac:chgData name="Filippo Acconcia" userId="844af49c-a8a0-47ac-a7dd-14a44b60cd18" providerId="ADAL" clId="{B609A75A-164F-4066-A006-F59E853DC491}" dt="2022-04-01T09:47:59.808" v="1567" actId="164"/>
          <ac:grpSpMkLst>
            <pc:docMk/>
            <pc:sldMk cId="2248971367" sldId="303"/>
            <ac:grpSpMk id="306" creationId="{0EF79575-67A2-40A9-B115-4B2A3A0473EB}"/>
          </ac:grpSpMkLst>
        </pc:grpChg>
        <pc:grpChg chg="mod topLvl">
          <ac:chgData name="Filippo Acconcia" userId="844af49c-a8a0-47ac-a7dd-14a44b60cd18" providerId="ADAL" clId="{B609A75A-164F-4066-A006-F59E853DC491}" dt="2022-04-01T09:47:59.808" v="1567" actId="164"/>
          <ac:grpSpMkLst>
            <pc:docMk/>
            <pc:sldMk cId="2248971367" sldId="303"/>
            <ac:grpSpMk id="307" creationId="{BC395F8F-B4F1-4BF9-88D7-D200BA51371E}"/>
          </ac:grpSpMkLst>
        </pc:grpChg>
        <pc:grpChg chg="mod topLvl">
          <ac:chgData name="Filippo Acconcia" userId="844af49c-a8a0-47ac-a7dd-14a44b60cd18" providerId="ADAL" clId="{B609A75A-164F-4066-A006-F59E853DC491}" dt="2022-04-01T09:47:59.808" v="1567" actId="164"/>
          <ac:grpSpMkLst>
            <pc:docMk/>
            <pc:sldMk cId="2248971367" sldId="303"/>
            <ac:grpSpMk id="308" creationId="{D60B6672-6A29-4670-B92D-423C0122027E}"/>
          </ac:grpSpMkLst>
        </pc:grpChg>
        <pc:grpChg chg="mod topLvl">
          <ac:chgData name="Filippo Acconcia" userId="844af49c-a8a0-47ac-a7dd-14a44b60cd18" providerId="ADAL" clId="{B609A75A-164F-4066-A006-F59E853DC491}" dt="2022-04-01T09:47:59.808" v="1567" actId="164"/>
          <ac:grpSpMkLst>
            <pc:docMk/>
            <pc:sldMk cId="2248971367" sldId="303"/>
            <ac:grpSpMk id="309" creationId="{4A1A15F7-7534-4E16-B001-2C175A484812}"/>
          </ac:grpSpMkLst>
        </pc:grpChg>
        <pc:grpChg chg="mod topLvl">
          <ac:chgData name="Filippo Acconcia" userId="844af49c-a8a0-47ac-a7dd-14a44b60cd18" providerId="ADAL" clId="{B609A75A-164F-4066-A006-F59E853DC491}" dt="2022-04-01T09:47:59.808" v="1567" actId="164"/>
          <ac:grpSpMkLst>
            <pc:docMk/>
            <pc:sldMk cId="2248971367" sldId="303"/>
            <ac:grpSpMk id="310" creationId="{00C6485E-F495-4E8D-9415-F2DE8CB58310}"/>
          </ac:grpSpMkLst>
        </pc:grpChg>
        <pc:grpChg chg="mod topLvl">
          <ac:chgData name="Filippo Acconcia" userId="844af49c-a8a0-47ac-a7dd-14a44b60cd18" providerId="ADAL" clId="{B609A75A-164F-4066-A006-F59E853DC491}" dt="2022-04-01T09:47:59.808" v="1567" actId="164"/>
          <ac:grpSpMkLst>
            <pc:docMk/>
            <pc:sldMk cId="2248971367" sldId="303"/>
            <ac:grpSpMk id="311" creationId="{56E1F2A2-1FA9-4C49-AB95-F33AF633D9B0}"/>
          </ac:grpSpMkLst>
        </pc:grpChg>
        <pc:grpChg chg="mod topLvl">
          <ac:chgData name="Filippo Acconcia" userId="844af49c-a8a0-47ac-a7dd-14a44b60cd18" providerId="ADAL" clId="{B609A75A-164F-4066-A006-F59E853DC491}" dt="2022-04-01T09:47:59.808" v="1567" actId="164"/>
          <ac:grpSpMkLst>
            <pc:docMk/>
            <pc:sldMk cId="2248971367" sldId="303"/>
            <ac:grpSpMk id="312" creationId="{96E2AE30-BCC9-4D3F-AFED-E27E49E86F3D}"/>
          </ac:grpSpMkLst>
        </pc:grpChg>
        <pc:grpChg chg="add mod">
          <ac:chgData name="Filippo Acconcia" userId="844af49c-a8a0-47ac-a7dd-14a44b60cd18" providerId="ADAL" clId="{B609A75A-164F-4066-A006-F59E853DC491}" dt="2022-04-29T07:39:17.186" v="1976" actId="1038"/>
          <ac:grpSpMkLst>
            <pc:docMk/>
            <pc:sldMk cId="2248971367" sldId="303"/>
            <ac:grpSpMk id="339" creationId="{EAEEC81B-8E74-4A4A-B31A-FF895BF47386}"/>
          </ac:grpSpMkLst>
        </pc:grpChg>
        <pc:picChg chg="del mod">
          <ac:chgData name="Filippo Acconcia" userId="844af49c-a8a0-47ac-a7dd-14a44b60cd18" providerId="ADAL" clId="{B609A75A-164F-4066-A006-F59E853DC491}" dt="2022-04-29T07:36:15.770" v="1938" actId="478"/>
          <ac:picMkLst>
            <pc:docMk/>
            <pc:sldMk cId="2248971367" sldId="303"/>
            <ac:picMk id="2" creationId="{9159E864-47F2-475B-9A9E-18B0385C2821}"/>
          </ac:picMkLst>
        </pc:picChg>
        <pc:picChg chg="del mod topLvl">
          <ac:chgData name="Filippo Acconcia" userId="844af49c-a8a0-47ac-a7dd-14a44b60cd18" providerId="ADAL" clId="{B609A75A-164F-4066-A006-F59E853DC491}" dt="2022-04-29T07:38:39.147" v="1953" actId="478"/>
          <ac:picMkLst>
            <pc:docMk/>
            <pc:sldMk cId="2248971367" sldId="303"/>
            <ac:picMk id="3" creationId="{6DF78467-A496-46C4-A5A3-67A027DC2E6A}"/>
          </ac:picMkLst>
        </pc:picChg>
        <pc:picChg chg="mod">
          <ac:chgData name="Filippo Acconcia" userId="844af49c-a8a0-47ac-a7dd-14a44b60cd18" providerId="ADAL" clId="{B609A75A-164F-4066-A006-F59E853DC491}" dt="2022-04-01T07:31:33.901" v="1088"/>
          <ac:picMkLst>
            <pc:docMk/>
            <pc:sldMk cId="2248971367" sldId="303"/>
            <ac:picMk id="3" creationId="{C4AD2282-CBEF-49E7-8EB0-5890E4AB9B5D}"/>
          </ac:picMkLst>
        </pc:picChg>
        <pc:picChg chg="mod ord">
          <ac:chgData name="Filippo Acconcia" userId="844af49c-a8a0-47ac-a7dd-14a44b60cd18" providerId="ADAL" clId="{B609A75A-164F-4066-A006-F59E853DC491}" dt="2022-04-29T07:38:59.294" v="1966" actId="164"/>
          <ac:picMkLst>
            <pc:docMk/>
            <pc:sldMk cId="2248971367" sldId="303"/>
            <ac:picMk id="5" creationId="{5C6FE331-07F5-4863-8EC6-C4795229CA15}"/>
          </ac:picMkLst>
        </pc:picChg>
        <pc:picChg chg="mod">
          <ac:chgData name="Filippo Acconcia" userId="844af49c-a8a0-47ac-a7dd-14a44b60cd18" providerId="ADAL" clId="{B609A75A-164F-4066-A006-F59E853DC491}" dt="2022-04-01T08:52:04.533" v="1216"/>
          <ac:picMkLst>
            <pc:docMk/>
            <pc:sldMk cId="2248971367" sldId="303"/>
            <ac:picMk id="68" creationId="{85829028-0948-49D7-B49E-07864F46BDC3}"/>
          </ac:picMkLst>
        </pc:picChg>
        <pc:picChg chg="mod">
          <ac:chgData name="Filippo Acconcia" userId="844af49c-a8a0-47ac-a7dd-14a44b60cd18" providerId="ADAL" clId="{B609A75A-164F-4066-A006-F59E853DC491}" dt="2022-04-01T08:52:04.533" v="1216"/>
          <ac:picMkLst>
            <pc:docMk/>
            <pc:sldMk cId="2248971367" sldId="303"/>
            <ac:picMk id="69" creationId="{4EA22198-7825-4634-8EF5-45B2CFC68E16}"/>
          </ac:picMkLst>
        </pc:picChg>
        <pc:picChg chg="mod">
          <ac:chgData name="Filippo Acconcia" userId="844af49c-a8a0-47ac-a7dd-14a44b60cd18" providerId="ADAL" clId="{B609A75A-164F-4066-A006-F59E853DC491}" dt="2022-04-01T08:52:04.533" v="1216"/>
          <ac:picMkLst>
            <pc:docMk/>
            <pc:sldMk cId="2248971367" sldId="303"/>
            <ac:picMk id="70" creationId="{08001051-1193-4A27-97DF-B4EF2EB656E0}"/>
          </ac:picMkLst>
        </pc:picChg>
        <pc:picChg chg="mod">
          <ac:chgData name="Filippo Acconcia" userId="844af49c-a8a0-47ac-a7dd-14a44b60cd18" providerId="ADAL" clId="{B609A75A-164F-4066-A006-F59E853DC491}" dt="2022-04-01T08:52:04.533" v="1216"/>
          <ac:picMkLst>
            <pc:docMk/>
            <pc:sldMk cId="2248971367" sldId="303"/>
            <ac:picMk id="71" creationId="{80E6465C-40EF-4800-B4FE-2E139C414FE0}"/>
          </ac:picMkLst>
        </pc:picChg>
        <pc:picChg chg="mod">
          <ac:chgData name="Filippo Acconcia" userId="844af49c-a8a0-47ac-a7dd-14a44b60cd18" providerId="ADAL" clId="{B609A75A-164F-4066-A006-F59E853DC491}" dt="2022-04-01T08:52:04.533" v="1216"/>
          <ac:picMkLst>
            <pc:docMk/>
            <pc:sldMk cId="2248971367" sldId="303"/>
            <ac:picMk id="72" creationId="{8F437C11-192A-4CF9-B23A-2C3E42A65180}"/>
          </ac:picMkLst>
        </pc:picChg>
        <pc:picChg chg="mod">
          <ac:chgData name="Filippo Acconcia" userId="844af49c-a8a0-47ac-a7dd-14a44b60cd18" providerId="ADAL" clId="{B609A75A-164F-4066-A006-F59E853DC491}" dt="2022-04-01T08:52:04.533" v="1216"/>
          <ac:picMkLst>
            <pc:docMk/>
            <pc:sldMk cId="2248971367" sldId="303"/>
            <ac:picMk id="73" creationId="{8F56FA8C-671A-4891-A9FC-F37DE60393CA}"/>
          </ac:picMkLst>
        </pc:picChg>
        <pc:picChg chg="mod">
          <ac:chgData name="Filippo Acconcia" userId="844af49c-a8a0-47ac-a7dd-14a44b60cd18" providerId="ADAL" clId="{B609A75A-164F-4066-A006-F59E853DC491}" dt="2022-04-01T08:52:04.533" v="1216"/>
          <ac:picMkLst>
            <pc:docMk/>
            <pc:sldMk cId="2248971367" sldId="303"/>
            <ac:picMk id="80" creationId="{4F48B4C2-3673-45E5-9653-651E5EE8C739}"/>
          </ac:picMkLst>
        </pc:picChg>
        <pc:picChg chg="mod">
          <ac:chgData name="Filippo Acconcia" userId="844af49c-a8a0-47ac-a7dd-14a44b60cd18" providerId="ADAL" clId="{B609A75A-164F-4066-A006-F59E853DC491}" dt="2022-04-01T08:52:04.533" v="1216"/>
          <ac:picMkLst>
            <pc:docMk/>
            <pc:sldMk cId="2248971367" sldId="303"/>
            <ac:picMk id="81" creationId="{E0693068-77AE-4F27-B309-EC793AF49957}"/>
          </ac:picMkLst>
        </pc:picChg>
        <pc:picChg chg="mod">
          <ac:chgData name="Filippo Acconcia" userId="844af49c-a8a0-47ac-a7dd-14a44b60cd18" providerId="ADAL" clId="{B609A75A-164F-4066-A006-F59E853DC491}" dt="2022-04-01T08:52:04.533" v="1216"/>
          <ac:picMkLst>
            <pc:docMk/>
            <pc:sldMk cId="2248971367" sldId="303"/>
            <ac:picMk id="82" creationId="{D50B43F5-C3B1-4E97-A506-643BC244D383}"/>
          </ac:picMkLst>
        </pc:picChg>
        <pc:picChg chg="mod">
          <ac:chgData name="Filippo Acconcia" userId="844af49c-a8a0-47ac-a7dd-14a44b60cd18" providerId="ADAL" clId="{B609A75A-164F-4066-A006-F59E853DC491}" dt="2022-04-01T08:52:04.533" v="1216"/>
          <ac:picMkLst>
            <pc:docMk/>
            <pc:sldMk cId="2248971367" sldId="303"/>
            <ac:picMk id="83" creationId="{B9D89EF3-5F5F-467F-99BD-BB70C89862E5}"/>
          </ac:picMkLst>
        </pc:picChg>
        <pc:picChg chg="mod">
          <ac:chgData name="Filippo Acconcia" userId="844af49c-a8a0-47ac-a7dd-14a44b60cd18" providerId="ADAL" clId="{B609A75A-164F-4066-A006-F59E853DC491}" dt="2022-04-01T08:52:04.533" v="1216"/>
          <ac:picMkLst>
            <pc:docMk/>
            <pc:sldMk cId="2248971367" sldId="303"/>
            <ac:picMk id="84" creationId="{0EC8E2AB-62A7-4E22-AEEF-1B4CD9D9B5AC}"/>
          </ac:picMkLst>
        </pc:picChg>
        <pc:picChg chg="mod">
          <ac:chgData name="Filippo Acconcia" userId="844af49c-a8a0-47ac-a7dd-14a44b60cd18" providerId="ADAL" clId="{B609A75A-164F-4066-A006-F59E853DC491}" dt="2022-04-01T08:52:04.533" v="1216"/>
          <ac:picMkLst>
            <pc:docMk/>
            <pc:sldMk cId="2248971367" sldId="303"/>
            <ac:picMk id="85" creationId="{D4FABF4C-0B55-4F1E-8648-CD81D38F5FE4}"/>
          </ac:picMkLst>
        </pc:picChg>
        <pc:picChg chg="mod">
          <ac:chgData name="Filippo Acconcia" userId="844af49c-a8a0-47ac-a7dd-14a44b60cd18" providerId="ADAL" clId="{B609A75A-164F-4066-A006-F59E853DC491}" dt="2022-04-01T08:52:04.533" v="1216"/>
          <ac:picMkLst>
            <pc:docMk/>
            <pc:sldMk cId="2248971367" sldId="303"/>
            <ac:picMk id="104" creationId="{F2B31A3A-C804-4139-BF23-E90804801CA5}"/>
          </ac:picMkLst>
        </pc:picChg>
        <pc:picChg chg="mod">
          <ac:chgData name="Filippo Acconcia" userId="844af49c-a8a0-47ac-a7dd-14a44b60cd18" providerId="ADAL" clId="{B609A75A-164F-4066-A006-F59E853DC491}" dt="2022-04-01T08:52:04.533" v="1216"/>
          <ac:picMkLst>
            <pc:docMk/>
            <pc:sldMk cId="2248971367" sldId="303"/>
            <ac:picMk id="105" creationId="{6C89742F-F345-4C12-87CE-E8B41B14C45A}"/>
          </ac:picMkLst>
        </pc:picChg>
        <pc:picChg chg="mod">
          <ac:chgData name="Filippo Acconcia" userId="844af49c-a8a0-47ac-a7dd-14a44b60cd18" providerId="ADAL" clId="{B609A75A-164F-4066-A006-F59E853DC491}" dt="2022-04-01T08:52:04.533" v="1216"/>
          <ac:picMkLst>
            <pc:docMk/>
            <pc:sldMk cId="2248971367" sldId="303"/>
            <ac:picMk id="106" creationId="{8B61D491-974E-4E7E-BE7D-0D9EE5E43AC9}"/>
          </ac:picMkLst>
        </pc:picChg>
        <pc:picChg chg="mod">
          <ac:chgData name="Filippo Acconcia" userId="844af49c-a8a0-47ac-a7dd-14a44b60cd18" providerId="ADAL" clId="{B609A75A-164F-4066-A006-F59E853DC491}" dt="2022-04-01T08:52:04.533" v="1216"/>
          <ac:picMkLst>
            <pc:docMk/>
            <pc:sldMk cId="2248971367" sldId="303"/>
            <ac:picMk id="107" creationId="{48BDCFF3-C736-40B3-8068-048D26E056C9}"/>
          </ac:picMkLst>
        </pc:picChg>
        <pc:picChg chg="mod">
          <ac:chgData name="Filippo Acconcia" userId="844af49c-a8a0-47ac-a7dd-14a44b60cd18" providerId="ADAL" clId="{B609A75A-164F-4066-A006-F59E853DC491}" dt="2022-04-01T08:52:04.533" v="1216"/>
          <ac:picMkLst>
            <pc:docMk/>
            <pc:sldMk cId="2248971367" sldId="303"/>
            <ac:picMk id="108" creationId="{27AAAA2E-69E5-43F9-80AD-8CAA41920552}"/>
          </ac:picMkLst>
        </pc:picChg>
        <pc:picChg chg="mod">
          <ac:chgData name="Filippo Acconcia" userId="844af49c-a8a0-47ac-a7dd-14a44b60cd18" providerId="ADAL" clId="{B609A75A-164F-4066-A006-F59E853DC491}" dt="2022-04-01T08:52:04.533" v="1216"/>
          <ac:picMkLst>
            <pc:docMk/>
            <pc:sldMk cId="2248971367" sldId="303"/>
            <ac:picMk id="109" creationId="{3F7DED58-00A9-4281-B75F-AAF9660D4190}"/>
          </ac:picMkLst>
        </pc:picChg>
        <pc:picChg chg="mod">
          <ac:chgData name="Filippo Acconcia" userId="844af49c-a8a0-47ac-a7dd-14a44b60cd18" providerId="ADAL" clId="{B609A75A-164F-4066-A006-F59E853DC491}" dt="2022-04-01T08:52:04.533" v="1216"/>
          <ac:picMkLst>
            <pc:docMk/>
            <pc:sldMk cId="2248971367" sldId="303"/>
            <ac:picMk id="114" creationId="{B6F50DA7-38FC-4B0F-B43B-452BED1D27C7}"/>
          </ac:picMkLst>
        </pc:picChg>
        <pc:picChg chg="mod">
          <ac:chgData name="Filippo Acconcia" userId="844af49c-a8a0-47ac-a7dd-14a44b60cd18" providerId="ADAL" clId="{B609A75A-164F-4066-A006-F59E853DC491}" dt="2022-04-01T08:52:04.533" v="1216"/>
          <ac:picMkLst>
            <pc:docMk/>
            <pc:sldMk cId="2248971367" sldId="303"/>
            <ac:picMk id="115" creationId="{C812912F-072C-451E-8CA7-63B64F3BBC6F}"/>
          </ac:picMkLst>
        </pc:picChg>
        <pc:picChg chg="mod">
          <ac:chgData name="Filippo Acconcia" userId="844af49c-a8a0-47ac-a7dd-14a44b60cd18" providerId="ADAL" clId="{B609A75A-164F-4066-A006-F59E853DC491}" dt="2022-04-01T08:52:04.533" v="1216"/>
          <ac:picMkLst>
            <pc:docMk/>
            <pc:sldMk cId="2248971367" sldId="303"/>
            <ac:picMk id="116" creationId="{093614DF-8F0A-4576-9213-A771FD2A23FA}"/>
          </ac:picMkLst>
        </pc:picChg>
        <pc:picChg chg="del mod topLvl">
          <ac:chgData name="Filippo Acconcia" userId="844af49c-a8a0-47ac-a7dd-14a44b60cd18" providerId="ADAL" clId="{B609A75A-164F-4066-A006-F59E853DC491}" dt="2022-04-29T07:33:22.803" v="1800" actId="478"/>
          <ac:picMkLst>
            <pc:docMk/>
            <pc:sldMk cId="2248971367" sldId="303"/>
            <ac:picMk id="121" creationId="{F7104D47-6974-4105-B7AC-61378A9EC439}"/>
          </ac:picMkLst>
        </pc:picChg>
        <pc:picChg chg="del mod topLvl">
          <ac:chgData name="Filippo Acconcia" userId="844af49c-a8a0-47ac-a7dd-14a44b60cd18" providerId="ADAL" clId="{B609A75A-164F-4066-A006-F59E853DC491}" dt="2022-04-29T07:33:22.803" v="1800" actId="478"/>
          <ac:picMkLst>
            <pc:docMk/>
            <pc:sldMk cId="2248971367" sldId="303"/>
            <ac:picMk id="122" creationId="{4C21279D-A623-4E84-AB5E-3177B4277C54}"/>
          </ac:picMkLst>
        </pc:picChg>
        <pc:picChg chg="del mod topLvl">
          <ac:chgData name="Filippo Acconcia" userId="844af49c-a8a0-47ac-a7dd-14a44b60cd18" providerId="ADAL" clId="{B609A75A-164F-4066-A006-F59E853DC491}" dt="2022-04-29T07:33:22.803" v="1800" actId="478"/>
          <ac:picMkLst>
            <pc:docMk/>
            <pc:sldMk cId="2248971367" sldId="303"/>
            <ac:picMk id="123" creationId="{8C5EFBEA-A81D-4922-8E4A-A83628A5B37F}"/>
          </ac:picMkLst>
        </pc:picChg>
        <pc:picChg chg="del mod topLvl">
          <ac:chgData name="Filippo Acconcia" userId="844af49c-a8a0-47ac-a7dd-14a44b60cd18" providerId="ADAL" clId="{B609A75A-164F-4066-A006-F59E853DC491}" dt="2022-04-01T09:36:21.081" v="1323" actId="478"/>
          <ac:picMkLst>
            <pc:docMk/>
            <pc:sldMk cId="2248971367" sldId="303"/>
            <ac:picMk id="145" creationId="{D099CA99-9EB1-4117-8925-55B00FF05662}"/>
          </ac:picMkLst>
        </pc:picChg>
        <pc:picChg chg="del mod topLvl">
          <ac:chgData name="Filippo Acconcia" userId="844af49c-a8a0-47ac-a7dd-14a44b60cd18" providerId="ADAL" clId="{B609A75A-164F-4066-A006-F59E853DC491}" dt="2022-04-29T07:36:13.696" v="1937" actId="478"/>
          <ac:picMkLst>
            <pc:docMk/>
            <pc:sldMk cId="2248971367" sldId="303"/>
            <ac:picMk id="167" creationId="{2B7700C8-8E2D-482C-971B-4EB33AB6001D}"/>
          </ac:picMkLst>
        </pc:picChg>
        <pc:picChg chg="mod ord">
          <ac:chgData name="Filippo Acconcia" userId="844af49c-a8a0-47ac-a7dd-14a44b60cd18" providerId="ADAL" clId="{B609A75A-164F-4066-A006-F59E853DC491}" dt="2022-04-01T09:38:35.591" v="1392" actId="164"/>
          <ac:picMkLst>
            <pc:docMk/>
            <pc:sldMk cId="2248971367" sldId="303"/>
            <ac:picMk id="184" creationId="{56F6AE17-20E9-46D5-89CC-D8A0A01E7DDE}"/>
          </ac:picMkLst>
        </pc:picChg>
        <pc:picChg chg="del mod topLvl">
          <ac:chgData name="Filippo Acconcia" userId="844af49c-a8a0-47ac-a7dd-14a44b60cd18" providerId="ADAL" clId="{B609A75A-164F-4066-A006-F59E853DC491}" dt="2022-04-01T09:43:43.908" v="1515" actId="478"/>
          <ac:picMkLst>
            <pc:docMk/>
            <pc:sldMk cId="2248971367" sldId="303"/>
            <ac:picMk id="195" creationId="{E47461B0-24C2-4E69-AE5B-76B01E9D7CB6}"/>
          </ac:picMkLst>
        </pc:picChg>
        <pc:picChg chg="mod">
          <ac:chgData name="Filippo Acconcia" userId="844af49c-a8a0-47ac-a7dd-14a44b60cd18" providerId="ADAL" clId="{B609A75A-164F-4066-A006-F59E853DC491}" dt="2022-04-01T09:39:05.833" v="1398"/>
          <ac:picMkLst>
            <pc:docMk/>
            <pc:sldMk cId="2248971367" sldId="303"/>
            <ac:picMk id="235" creationId="{CEC69D52-07D8-4A70-9DDF-64E39549D5B8}"/>
          </ac:picMkLst>
        </pc:picChg>
        <pc:picChg chg="mod ord">
          <ac:chgData name="Filippo Acconcia" userId="844af49c-a8a0-47ac-a7dd-14a44b60cd18" providerId="ADAL" clId="{B609A75A-164F-4066-A006-F59E853DC491}" dt="2022-04-01T09:44:04.943" v="1523" actId="164"/>
          <ac:picMkLst>
            <pc:docMk/>
            <pc:sldMk cId="2248971367" sldId="303"/>
            <ac:picMk id="295" creationId="{2B2610D0-E72F-449F-890B-2D3DA6CEF886}"/>
          </ac:picMkLst>
        </pc:picChg>
        <pc:picChg chg="del mod topLvl">
          <ac:chgData name="Filippo Acconcia" userId="844af49c-a8a0-47ac-a7dd-14a44b60cd18" providerId="ADAL" clId="{B609A75A-164F-4066-A006-F59E853DC491}" dt="2022-04-01T09:47:53.399" v="1566" actId="478"/>
          <ac:picMkLst>
            <pc:docMk/>
            <pc:sldMk cId="2248971367" sldId="303"/>
            <ac:picMk id="298" creationId="{7BC310D6-2D11-495C-9444-5C0E9009BAFE}"/>
          </ac:picMkLst>
        </pc:picChg>
        <pc:picChg chg="mod ord">
          <ac:chgData name="Filippo Acconcia" userId="844af49c-a8a0-47ac-a7dd-14a44b60cd18" providerId="ADAL" clId="{B609A75A-164F-4066-A006-F59E853DC491}" dt="2022-04-01T09:47:59.808" v="1567" actId="164"/>
          <ac:picMkLst>
            <pc:docMk/>
            <pc:sldMk cId="2248971367" sldId="303"/>
            <ac:picMk id="338" creationId="{A378D208-082C-48CE-8CD8-9B94061457C5}"/>
          </ac:picMkLst>
        </pc:picChg>
        <pc:cxnChg chg="mod">
          <ac:chgData name="Filippo Acconcia" userId="844af49c-a8a0-47ac-a7dd-14a44b60cd18" providerId="ADAL" clId="{B609A75A-164F-4066-A006-F59E853DC491}" dt="2022-04-01T08:52:04.533" v="1216"/>
          <ac:cxnSpMkLst>
            <pc:docMk/>
            <pc:sldMk cId="2248971367" sldId="303"/>
            <ac:cxnSpMk id="112" creationId="{E5E965CE-A3E6-4307-B29C-DF6909385CB6}"/>
          </ac:cxnSpMkLst>
        </pc:cxnChg>
        <pc:cxnChg chg="mod topLvl">
          <ac:chgData name="Filippo Acconcia" userId="844af49c-a8a0-47ac-a7dd-14a44b60cd18" providerId="ADAL" clId="{B609A75A-164F-4066-A006-F59E853DC491}" dt="2022-04-29T07:38:59.294" v="1966" actId="164"/>
          <ac:cxnSpMkLst>
            <pc:docMk/>
            <pc:sldMk cId="2248971367" sldId="303"/>
            <ac:cxnSpMk id="119" creationId="{B0E5D94D-20EC-4934-99BA-9904BDEDB3F1}"/>
          </ac:cxnSpMkLst>
        </pc:cxnChg>
        <pc:cxnChg chg="mod">
          <ac:chgData name="Filippo Acconcia" userId="844af49c-a8a0-47ac-a7dd-14a44b60cd18" providerId="ADAL" clId="{B609A75A-164F-4066-A006-F59E853DC491}" dt="2022-04-21T13:12:36.266" v="1786" actId="478"/>
          <ac:cxnSpMkLst>
            <pc:docMk/>
            <pc:sldMk cId="2248971367" sldId="303"/>
            <ac:cxnSpMk id="133" creationId="{E9A0CE2D-8CD6-4E95-AF16-7858F40B7761}"/>
          </ac:cxnSpMkLst>
        </pc:cxnChg>
        <pc:cxnChg chg="mod">
          <ac:chgData name="Filippo Acconcia" userId="844af49c-a8a0-47ac-a7dd-14a44b60cd18" providerId="ADAL" clId="{B609A75A-164F-4066-A006-F59E853DC491}" dt="2022-04-21T13:12:36.266" v="1786" actId="478"/>
          <ac:cxnSpMkLst>
            <pc:docMk/>
            <pc:sldMk cId="2248971367" sldId="303"/>
            <ac:cxnSpMk id="134" creationId="{2331443A-25DB-4C34-A8FC-7C61877BB5A8}"/>
          </ac:cxnSpMkLst>
        </pc:cxnChg>
        <pc:cxnChg chg="mod">
          <ac:chgData name="Filippo Acconcia" userId="844af49c-a8a0-47ac-a7dd-14a44b60cd18" providerId="ADAL" clId="{B609A75A-164F-4066-A006-F59E853DC491}" dt="2022-04-21T13:12:36.266" v="1786" actId="478"/>
          <ac:cxnSpMkLst>
            <pc:docMk/>
            <pc:sldMk cId="2248971367" sldId="303"/>
            <ac:cxnSpMk id="135" creationId="{F8664B7C-D0B8-41AF-A648-3E370E7FF325}"/>
          </ac:cxnSpMkLst>
        </pc:cxnChg>
        <pc:cxnChg chg="mod">
          <ac:chgData name="Filippo Acconcia" userId="844af49c-a8a0-47ac-a7dd-14a44b60cd18" providerId="ADAL" clId="{B609A75A-164F-4066-A006-F59E853DC491}" dt="2022-04-21T13:12:36.266" v="1786" actId="478"/>
          <ac:cxnSpMkLst>
            <pc:docMk/>
            <pc:sldMk cId="2248971367" sldId="303"/>
            <ac:cxnSpMk id="136" creationId="{C5CEC9D1-7FB6-4406-9502-FB4DA030BE9B}"/>
          </ac:cxnSpMkLst>
        </pc:cxnChg>
        <pc:cxnChg chg="mod topLvl">
          <ac:chgData name="Filippo Acconcia" userId="844af49c-a8a0-47ac-a7dd-14a44b60cd18" providerId="ADAL" clId="{B609A75A-164F-4066-A006-F59E853DC491}" dt="2022-04-29T07:38:59.294" v="1966" actId="164"/>
          <ac:cxnSpMkLst>
            <pc:docMk/>
            <pc:sldMk cId="2248971367" sldId="303"/>
            <ac:cxnSpMk id="140" creationId="{1B5B8713-46D4-44D2-9BCE-695B82E00D39}"/>
          </ac:cxnSpMkLst>
        </pc:cxnChg>
        <pc:cxnChg chg="mod topLvl">
          <ac:chgData name="Filippo Acconcia" userId="844af49c-a8a0-47ac-a7dd-14a44b60cd18" providerId="ADAL" clId="{B609A75A-164F-4066-A006-F59E853DC491}" dt="2022-04-29T07:38:59.294" v="1966" actId="164"/>
          <ac:cxnSpMkLst>
            <pc:docMk/>
            <pc:sldMk cId="2248971367" sldId="303"/>
            <ac:cxnSpMk id="141" creationId="{5BA9DB61-C822-44FB-A611-35859B8554EF}"/>
          </ac:cxnSpMkLst>
        </pc:cxnChg>
        <pc:cxnChg chg="mod topLvl">
          <ac:chgData name="Filippo Acconcia" userId="844af49c-a8a0-47ac-a7dd-14a44b60cd18" providerId="ADAL" clId="{B609A75A-164F-4066-A006-F59E853DC491}" dt="2022-04-29T07:38:59.294" v="1966" actId="164"/>
          <ac:cxnSpMkLst>
            <pc:docMk/>
            <pc:sldMk cId="2248971367" sldId="303"/>
            <ac:cxnSpMk id="142" creationId="{BD72CAA4-B39A-43B8-836D-500022D2B2F2}"/>
          </ac:cxnSpMkLst>
        </pc:cxnChg>
        <pc:cxnChg chg="mod topLvl">
          <ac:chgData name="Filippo Acconcia" userId="844af49c-a8a0-47ac-a7dd-14a44b60cd18" providerId="ADAL" clId="{B609A75A-164F-4066-A006-F59E853DC491}" dt="2022-04-29T07:38:59.294" v="1966" actId="164"/>
          <ac:cxnSpMkLst>
            <pc:docMk/>
            <pc:sldMk cId="2248971367" sldId="303"/>
            <ac:cxnSpMk id="143" creationId="{9D4F57CF-4F09-4237-854B-6D73985788A7}"/>
          </ac:cxnSpMkLst>
        </pc:cxnChg>
        <pc:cxnChg chg="mod">
          <ac:chgData name="Filippo Acconcia" userId="844af49c-a8a0-47ac-a7dd-14a44b60cd18" providerId="ADAL" clId="{B609A75A-164F-4066-A006-F59E853DC491}" dt="2022-04-01T09:36:00.810" v="1318" actId="165"/>
          <ac:cxnSpMkLst>
            <pc:docMk/>
            <pc:sldMk cId="2248971367" sldId="303"/>
            <ac:cxnSpMk id="160" creationId="{2ABA0B76-B562-4E00-9CE1-EC4130FDD6E6}"/>
          </ac:cxnSpMkLst>
        </pc:cxnChg>
        <pc:cxnChg chg="mod">
          <ac:chgData name="Filippo Acconcia" userId="844af49c-a8a0-47ac-a7dd-14a44b60cd18" providerId="ADAL" clId="{B609A75A-164F-4066-A006-F59E853DC491}" dt="2022-04-01T09:36:00.810" v="1318" actId="165"/>
          <ac:cxnSpMkLst>
            <pc:docMk/>
            <pc:sldMk cId="2248971367" sldId="303"/>
            <ac:cxnSpMk id="162" creationId="{1E9ABE8B-3859-425B-847E-E63600CD770F}"/>
          </ac:cxnSpMkLst>
        </pc:cxnChg>
        <pc:cxnChg chg="mod">
          <ac:chgData name="Filippo Acconcia" userId="844af49c-a8a0-47ac-a7dd-14a44b60cd18" providerId="ADAL" clId="{B609A75A-164F-4066-A006-F59E853DC491}" dt="2022-04-01T09:36:00.810" v="1318" actId="165"/>
          <ac:cxnSpMkLst>
            <pc:docMk/>
            <pc:sldMk cId="2248971367" sldId="303"/>
            <ac:cxnSpMk id="164" creationId="{E8BEF3F7-B2AC-41C0-8322-97A78211F434}"/>
          </ac:cxnSpMkLst>
        </pc:cxnChg>
        <pc:cxnChg chg="mod">
          <ac:chgData name="Filippo Acconcia" userId="844af49c-a8a0-47ac-a7dd-14a44b60cd18" providerId="ADAL" clId="{B609A75A-164F-4066-A006-F59E853DC491}" dt="2022-04-01T09:36:00.810" v="1318" actId="165"/>
          <ac:cxnSpMkLst>
            <pc:docMk/>
            <pc:sldMk cId="2248971367" sldId="303"/>
            <ac:cxnSpMk id="178" creationId="{E553F8D1-0DC2-4574-934E-64AD72B9C3F1}"/>
          </ac:cxnSpMkLst>
        </pc:cxnChg>
        <pc:cxnChg chg="add mod">
          <ac:chgData name="Filippo Acconcia" userId="844af49c-a8a0-47ac-a7dd-14a44b60cd18" providerId="ADAL" clId="{B609A75A-164F-4066-A006-F59E853DC491}" dt="2022-04-01T09:38:35.591" v="1392" actId="164"/>
          <ac:cxnSpMkLst>
            <pc:docMk/>
            <pc:sldMk cId="2248971367" sldId="303"/>
            <ac:cxnSpMk id="192" creationId="{E60B0391-641E-4978-9532-BE98FFD9E6B8}"/>
          </ac:cxnSpMkLst>
        </pc:cxnChg>
        <pc:cxnChg chg="mod">
          <ac:chgData name="Filippo Acconcia" userId="844af49c-a8a0-47ac-a7dd-14a44b60cd18" providerId="ADAL" clId="{B609A75A-164F-4066-A006-F59E853DC491}" dt="2022-04-01T09:39:19.449" v="1402" actId="165"/>
          <ac:cxnSpMkLst>
            <pc:docMk/>
            <pc:sldMk cId="2248971367" sldId="303"/>
            <ac:cxnSpMk id="210" creationId="{10289708-7DA6-4F83-8633-52AC0FE8109B}"/>
          </ac:cxnSpMkLst>
        </pc:cxnChg>
        <pc:cxnChg chg="mod">
          <ac:chgData name="Filippo Acconcia" userId="844af49c-a8a0-47ac-a7dd-14a44b60cd18" providerId="ADAL" clId="{B609A75A-164F-4066-A006-F59E853DC491}" dt="2022-04-01T09:39:19.449" v="1402" actId="165"/>
          <ac:cxnSpMkLst>
            <pc:docMk/>
            <pc:sldMk cId="2248971367" sldId="303"/>
            <ac:cxnSpMk id="212" creationId="{53F2FA05-1438-48F7-A37D-6B7A4621318D}"/>
          </ac:cxnSpMkLst>
        </pc:cxnChg>
        <pc:cxnChg chg="mod">
          <ac:chgData name="Filippo Acconcia" userId="844af49c-a8a0-47ac-a7dd-14a44b60cd18" providerId="ADAL" clId="{B609A75A-164F-4066-A006-F59E853DC491}" dt="2022-04-01T09:39:19.449" v="1402" actId="165"/>
          <ac:cxnSpMkLst>
            <pc:docMk/>
            <pc:sldMk cId="2248971367" sldId="303"/>
            <ac:cxnSpMk id="214" creationId="{444CEB4D-54BA-4DBC-B53D-10E302080913}"/>
          </ac:cxnSpMkLst>
        </pc:cxnChg>
        <pc:cxnChg chg="mod">
          <ac:chgData name="Filippo Acconcia" userId="844af49c-a8a0-47ac-a7dd-14a44b60cd18" providerId="ADAL" clId="{B609A75A-164F-4066-A006-F59E853DC491}" dt="2022-04-29T07:35:07.918" v="1906" actId="165"/>
          <ac:cxnSpMkLst>
            <pc:docMk/>
            <pc:sldMk cId="2248971367" sldId="303"/>
            <ac:cxnSpMk id="227" creationId="{4F66CC50-E7D5-4230-B467-A5547E108937}"/>
          </ac:cxnSpMkLst>
        </pc:cxnChg>
        <pc:cxnChg chg="mod">
          <ac:chgData name="Filippo Acconcia" userId="844af49c-a8a0-47ac-a7dd-14a44b60cd18" providerId="ADAL" clId="{B609A75A-164F-4066-A006-F59E853DC491}" dt="2022-04-01T09:39:19.449" v="1402" actId="165"/>
          <ac:cxnSpMkLst>
            <pc:docMk/>
            <pc:sldMk cId="2248971367" sldId="303"/>
            <ac:cxnSpMk id="228" creationId="{DCA7DF36-E0CE-4E0A-A069-4A0A82A30397}"/>
          </ac:cxnSpMkLst>
        </pc:cxnChg>
        <pc:cxnChg chg="mod">
          <ac:chgData name="Filippo Acconcia" userId="844af49c-a8a0-47ac-a7dd-14a44b60cd18" providerId="ADAL" clId="{B609A75A-164F-4066-A006-F59E853DC491}" dt="2022-04-29T07:35:07.918" v="1906" actId="165"/>
          <ac:cxnSpMkLst>
            <pc:docMk/>
            <pc:sldMk cId="2248971367" sldId="303"/>
            <ac:cxnSpMk id="231" creationId="{7B9144DC-86BC-4402-BE02-8CFE7DB23285}"/>
          </ac:cxnSpMkLst>
        </pc:cxnChg>
        <pc:cxnChg chg="mod">
          <ac:chgData name="Filippo Acconcia" userId="844af49c-a8a0-47ac-a7dd-14a44b60cd18" providerId="ADAL" clId="{B609A75A-164F-4066-A006-F59E853DC491}" dt="2022-04-29T07:35:07.918" v="1906" actId="165"/>
          <ac:cxnSpMkLst>
            <pc:docMk/>
            <pc:sldMk cId="2248971367" sldId="303"/>
            <ac:cxnSpMk id="233" creationId="{7CD06197-87D1-4E33-A9F8-638AF8319822}"/>
          </ac:cxnSpMkLst>
        </pc:cxnChg>
        <pc:cxnChg chg="mod">
          <ac:chgData name="Filippo Acconcia" userId="844af49c-a8a0-47ac-a7dd-14a44b60cd18" providerId="ADAL" clId="{B609A75A-164F-4066-A006-F59E853DC491}" dt="2022-04-29T07:35:07.918" v="1906" actId="165"/>
          <ac:cxnSpMkLst>
            <pc:docMk/>
            <pc:sldMk cId="2248971367" sldId="303"/>
            <ac:cxnSpMk id="239" creationId="{CDC1701B-AD56-4A29-96F0-9675ED37DD3A}"/>
          </ac:cxnSpMkLst>
        </pc:cxnChg>
        <pc:cxnChg chg="mod">
          <ac:chgData name="Filippo Acconcia" userId="844af49c-a8a0-47ac-a7dd-14a44b60cd18" providerId="ADAL" clId="{B609A75A-164F-4066-A006-F59E853DC491}" dt="2022-04-01T09:39:05.833" v="1398"/>
          <ac:cxnSpMkLst>
            <pc:docMk/>
            <pc:sldMk cId="2248971367" sldId="303"/>
            <ac:cxnSpMk id="250" creationId="{E123C345-8972-4E76-B49C-171FAF4090DE}"/>
          </ac:cxnSpMkLst>
        </pc:cxnChg>
        <pc:cxnChg chg="mod">
          <ac:chgData name="Filippo Acconcia" userId="844af49c-a8a0-47ac-a7dd-14a44b60cd18" providerId="ADAL" clId="{B609A75A-164F-4066-A006-F59E853DC491}" dt="2022-04-01T09:39:05.833" v="1398"/>
          <ac:cxnSpMkLst>
            <pc:docMk/>
            <pc:sldMk cId="2248971367" sldId="303"/>
            <ac:cxnSpMk id="252" creationId="{4D5DEF2C-A6B8-4A48-8FC1-B2A768C200DA}"/>
          </ac:cxnSpMkLst>
        </pc:cxnChg>
        <pc:cxnChg chg="mod">
          <ac:chgData name="Filippo Acconcia" userId="844af49c-a8a0-47ac-a7dd-14a44b60cd18" providerId="ADAL" clId="{B609A75A-164F-4066-A006-F59E853DC491}" dt="2022-04-01T09:39:05.833" v="1398"/>
          <ac:cxnSpMkLst>
            <pc:docMk/>
            <pc:sldMk cId="2248971367" sldId="303"/>
            <ac:cxnSpMk id="254" creationId="{0B778896-242D-499D-88F6-A747F55FA15B}"/>
          </ac:cxnSpMkLst>
        </pc:cxnChg>
        <pc:cxnChg chg="mod">
          <ac:chgData name="Filippo Acconcia" userId="844af49c-a8a0-47ac-a7dd-14a44b60cd18" providerId="ADAL" clId="{B609A75A-164F-4066-A006-F59E853DC491}" dt="2022-04-01T09:39:05.833" v="1398"/>
          <ac:cxnSpMkLst>
            <pc:docMk/>
            <pc:sldMk cId="2248971367" sldId="303"/>
            <ac:cxnSpMk id="268" creationId="{B6075C0D-91B1-49F5-8AC6-2346EF4B3E06}"/>
          </ac:cxnSpMkLst>
        </pc:cxnChg>
        <pc:cxnChg chg="mod">
          <ac:chgData name="Filippo Acconcia" userId="844af49c-a8a0-47ac-a7dd-14a44b60cd18" providerId="ADAL" clId="{B609A75A-164F-4066-A006-F59E853DC491}" dt="2022-04-01T09:46:41.888" v="1560" actId="165"/>
          <ac:cxnSpMkLst>
            <pc:docMk/>
            <pc:sldMk cId="2248971367" sldId="303"/>
            <ac:cxnSpMk id="325" creationId="{D3413494-B456-439D-B2E3-8F8502010DEB}"/>
          </ac:cxnSpMkLst>
        </pc:cxnChg>
        <pc:cxnChg chg="mod">
          <ac:chgData name="Filippo Acconcia" userId="844af49c-a8a0-47ac-a7dd-14a44b60cd18" providerId="ADAL" clId="{B609A75A-164F-4066-A006-F59E853DC491}" dt="2022-04-01T09:46:41.888" v="1560" actId="165"/>
          <ac:cxnSpMkLst>
            <pc:docMk/>
            <pc:sldMk cId="2248971367" sldId="303"/>
            <ac:cxnSpMk id="327" creationId="{AD20C177-B203-49C6-BF20-4F32C9C6B6B2}"/>
          </ac:cxnSpMkLst>
        </pc:cxnChg>
        <pc:cxnChg chg="mod">
          <ac:chgData name="Filippo Acconcia" userId="844af49c-a8a0-47ac-a7dd-14a44b60cd18" providerId="ADAL" clId="{B609A75A-164F-4066-A006-F59E853DC491}" dt="2022-04-01T09:46:41.888" v="1560" actId="165"/>
          <ac:cxnSpMkLst>
            <pc:docMk/>
            <pc:sldMk cId="2248971367" sldId="303"/>
            <ac:cxnSpMk id="329" creationId="{E6AD7934-6D53-4FE6-8F5F-24B785AD8E8B}"/>
          </ac:cxnSpMkLst>
        </pc:cxnChg>
        <pc:cxnChg chg="mod">
          <ac:chgData name="Filippo Acconcia" userId="844af49c-a8a0-47ac-a7dd-14a44b60cd18" providerId="ADAL" clId="{B609A75A-164F-4066-A006-F59E853DC491}" dt="2022-04-01T09:46:41.888" v="1560" actId="165"/>
          <ac:cxnSpMkLst>
            <pc:docMk/>
            <pc:sldMk cId="2248971367" sldId="303"/>
            <ac:cxnSpMk id="335" creationId="{0D60D72F-82A9-44B1-9257-0E14D568CFE0}"/>
          </ac:cxnSpMkLst>
        </pc:cxnChg>
      </pc:sldChg>
      <pc:sldChg chg="addSp modSp new del mod">
        <pc:chgData name="Filippo Acconcia" userId="844af49c-a8a0-47ac-a7dd-14a44b60cd18" providerId="ADAL" clId="{B609A75A-164F-4066-A006-F59E853DC491}" dt="2022-04-01T08:53:16.999" v="1226" actId="47"/>
        <pc:sldMkLst>
          <pc:docMk/>
          <pc:sldMk cId="636385627" sldId="304"/>
        </pc:sldMkLst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3" creationId="{C9B5486C-7D7B-48CF-A934-75D09A2FD889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5" creationId="{4C34955A-94F2-45C2-9275-A363D74598B5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6" creationId="{F9732008-A526-4AE1-A9FC-0293636F8D87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7" creationId="{D05559CA-3A8D-416B-9730-BF5F2F9BBC28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8" creationId="{2D430271-4224-491D-8D5F-8C0FD6A5CB2F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9" creationId="{B39EF2CE-17AB-4E4E-895C-46E2F895B454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10" creationId="{DD73376C-3E6C-4F8C-9CE9-341D440E9E70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11" creationId="{A4ACB1D2-BAAF-4E90-9B8A-B630258D6356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12" creationId="{1677F0B9-B739-4BE7-895B-84CC56A9456A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18" creationId="{2D491BC3-8C97-44B4-8C16-7775F0819B52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19" creationId="{8EAA30F6-26C9-4838-8EF6-E71FC1C714A6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20" creationId="{A91C7717-3ACB-44C2-8D19-1E31C892AFB4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21" creationId="{471FA01B-5DF2-4160-90AD-83D25659DA52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22" creationId="{660B4179-64E4-43CD-AF41-34D61FBBAC59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23" creationId="{D4AECEAE-946F-4FDD-B52B-871F8E9BB2C8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24" creationId="{265234E7-4172-4120-9C8A-1D5BE2E6D138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25" creationId="{A78E3D8C-EA13-40E3-87EB-FD04A677A4B1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27" creationId="{58C2AD4B-BF8A-4D46-840F-4ED450F041DD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35" creationId="{6EA98977-6CB2-4F34-BD89-CCFEBB5BDBAB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36" creationId="{7601BDF2-0C88-45F9-A7CB-2C8DF57EDF9B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37" creationId="{0C48C12B-8093-47E9-AD6F-85497FEFF7FB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38" creationId="{433B1824-A219-4BDC-85A0-A9729E75FE4A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39" creationId="{DEA2DAB0-8D4B-43D4-9E73-63E7C5305924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40" creationId="{6A647ED9-A18E-429D-9D42-6352ABECB863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41" creationId="{106AF89A-1FF2-40B3-B565-03F7D4F4E60D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42" creationId="{141F869D-4513-4A4E-81A3-033C54C9C084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44" creationId="{A267434D-8B9D-4387-B910-164D1F060114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49" creationId="{1BE1C57B-EF30-48AF-B33B-5A61B3D68976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50" creationId="{6B55501B-0248-4654-899F-D390C0A72DBC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51" creationId="{45217D79-FF6A-4E7B-92F9-95B222522883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52" creationId="{FA38D5D8-EC90-44FE-8A11-C9401772ACD0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53" creationId="{A167C496-EF54-4293-8E57-16AE664F6A61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54" creationId="{C73B87E8-5784-4C5B-91F1-5929255D1CC8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55" creationId="{8B604BC3-B21B-44C7-B410-965C9314800D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56" creationId="{5D661C60-BDFD-4051-BA08-4DED5537F01A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58" creationId="{E68CC658-C4F1-4401-84B4-F514BCE17A33}"/>
          </ac:spMkLst>
        </pc:spChg>
        <pc:spChg chg="add mod">
          <ac:chgData name="Filippo Acconcia" userId="844af49c-a8a0-47ac-a7dd-14a44b60cd18" providerId="ADAL" clId="{B609A75A-164F-4066-A006-F59E853DC491}" dt="2022-04-01T08:52:53.230" v="1222" actId="1076"/>
          <ac:spMkLst>
            <pc:docMk/>
            <pc:sldMk cId="636385627" sldId="304"/>
            <ac:spMk id="59" creationId="{841774F8-78CE-4061-A1C4-472591AF4D33}"/>
          </ac:spMkLst>
        </pc:spChg>
        <pc:spChg chg="add mod">
          <ac:chgData name="Filippo Acconcia" userId="844af49c-a8a0-47ac-a7dd-14a44b60cd18" providerId="ADAL" clId="{B609A75A-164F-4066-A006-F59E853DC491}" dt="2022-04-01T08:52:53.230" v="1222" actId="1076"/>
          <ac:spMkLst>
            <pc:docMk/>
            <pc:sldMk cId="636385627" sldId="304"/>
            <ac:spMk id="60" creationId="{791D26D3-A076-4895-9018-D16F4871F7D5}"/>
          </ac:spMkLst>
        </pc:spChg>
        <pc:spChg chg="add mod">
          <ac:chgData name="Filippo Acconcia" userId="844af49c-a8a0-47ac-a7dd-14a44b60cd18" providerId="ADAL" clId="{B609A75A-164F-4066-A006-F59E853DC491}" dt="2022-04-01T08:52:53.230" v="1222" actId="1076"/>
          <ac:spMkLst>
            <pc:docMk/>
            <pc:sldMk cId="636385627" sldId="304"/>
            <ac:spMk id="61" creationId="{7F7BEF55-C4EA-45F8-B9B1-42A5A3BE27C7}"/>
          </ac:spMkLst>
        </pc:spChg>
        <pc:spChg chg="add mod">
          <ac:chgData name="Filippo Acconcia" userId="844af49c-a8a0-47ac-a7dd-14a44b60cd18" providerId="ADAL" clId="{B609A75A-164F-4066-A006-F59E853DC491}" dt="2022-04-01T08:52:53.230" v="1222" actId="1076"/>
          <ac:spMkLst>
            <pc:docMk/>
            <pc:sldMk cId="636385627" sldId="304"/>
            <ac:spMk id="62" creationId="{29981F20-A04A-432A-8796-066E2A01FA84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67" creationId="{DE86A926-C0D8-40D6-A1FE-57F1D787F4FA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68" creationId="{E29873E8-9E8A-4667-9FFB-0EE0D76CF3CE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69" creationId="{39EBCB84-3AD5-44F0-9D2A-84F807E645E5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70" creationId="{06E4F4D5-F4C5-48BE-8843-96C7E4ABA365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71" creationId="{144B2705-718A-4279-AC88-E2EF76925838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72" creationId="{BE87B4A1-6715-4BFD-B87B-3355B7844B1A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73" creationId="{160E30B5-EC62-4E4D-B5A6-306A7EEE823B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74" creationId="{094AF3E1-A107-4C19-86C8-FEFEE9F9773A}"/>
          </ac:spMkLst>
        </pc:spChg>
        <pc:spChg chg="mod">
          <ac:chgData name="Filippo Acconcia" userId="844af49c-a8a0-47ac-a7dd-14a44b60cd18" providerId="ADAL" clId="{B609A75A-164F-4066-A006-F59E853DC491}" dt="2022-04-01T08:52:50.455" v="1221"/>
          <ac:spMkLst>
            <pc:docMk/>
            <pc:sldMk cId="636385627" sldId="304"/>
            <ac:spMk id="76" creationId="{08EEED2A-AB9B-4966-AB6B-C4A5EC37BD15}"/>
          </ac:spMkLst>
        </pc:spChg>
        <pc:spChg chg="add mod">
          <ac:chgData name="Filippo Acconcia" userId="844af49c-a8a0-47ac-a7dd-14a44b60cd18" providerId="ADAL" clId="{B609A75A-164F-4066-A006-F59E853DC491}" dt="2022-04-01T08:52:53.230" v="1222" actId="1076"/>
          <ac:spMkLst>
            <pc:docMk/>
            <pc:sldMk cId="636385627" sldId="304"/>
            <ac:spMk id="77" creationId="{B10681D8-2B69-42DF-86E3-E5F7EF14214F}"/>
          </ac:spMkLst>
        </pc:spChg>
        <pc:spChg chg="add mod">
          <ac:chgData name="Filippo Acconcia" userId="844af49c-a8a0-47ac-a7dd-14a44b60cd18" providerId="ADAL" clId="{B609A75A-164F-4066-A006-F59E853DC491}" dt="2022-04-01T08:52:53.230" v="1222" actId="1076"/>
          <ac:spMkLst>
            <pc:docMk/>
            <pc:sldMk cId="636385627" sldId="304"/>
            <ac:spMk id="78" creationId="{B6B10CFD-FC7E-404B-AEEB-071DF8C50D8D}"/>
          </ac:spMkLst>
        </pc:spChg>
        <pc:spChg chg="add mod">
          <ac:chgData name="Filippo Acconcia" userId="844af49c-a8a0-47ac-a7dd-14a44b60cd18" providerId="ADAL" clId="{B609A75A-164F-4066-A006-F59E853DC491}" dt="2022-04-01T08:53:02.789" v="1225" actId="20577"/>
          <ac:spMkLst>
            <pc:docMk/>
            <pc:sldMk cId="636385627" sldId="304"/>
            <ac:spMk id="79" creationId="{CB820F1E-36DF-4AF4-89CA-97B8AEA37B2F}"/>
          </ac:spMkLst>
        </pc:spChg>
        <pc:grpChg chg="add mod">
          <ac:chgData name="Filippo Acconcia" userId="844af49c-a8a0-47ac-a7dd-14a44b60cd18" providerId="ADAL" clId="{B609A75A-164F-4066-A006-F59E853DC491}" dt="2022-04-01T08:52:53.230" v="1222" actId="1076"/>
          <ac:grpSpMkLst>
            <pc:docMk/>
            <pc:sldMk cId="636385627" sldId="304"/>
            <ac:grpSpMk id="2" creationId="{0154A1B9-FA97-4F0F-ABAB-2E6A13595542}"/>
          </ac:grpSpMkLst>
        </pc:grpChg>
        <pc:grpChg chg="mod">
          <ac:chgData name="Filippo Acconcia" userId="844af49c-a8a0-47ac-a7dd-14a44b60cd18" providerId="ADAL" clId="{B609A75A-164F-4066-A006-F59E853DC491}" dt="2022-04-01T08:52:50.455" v="1221"/>
          <ac:grpSpMkLst>
            <pc:docMk/>
            <pc:sldMk cId="636385627" sldId="304"/>
            <ac:grpSpMk id="4" creationId="{C00CF5A7-A307-4EF3-8F98-D356E2B98FA5}"/>
          </ac:grpSpMkLst>
        </pc:grpChg>
        <pc:grpChg chg="add mod">
          <ac:chgData name="Filippo Acconcia" userId="844af49c-a8a0-47ac-a7dd-14a44b60cd18" providerId="ADAL" clId="{B609A75A-164F-4066-A006-F59E853DC491}" dt="2022-04-01T08:52:53.230" v="1222" actId="1076"/>
          <ac:grpSpMkLst>
            <pc:docMk/>
            <pc:sldMk cId="636385627" sldId="304"/>
            <ac:grpSpMk id="17" creationId="{D4D0B8B9-4800-4CB1-9A14-1A012E9EDDD7}"/>
          </ac:grpSpMkLst>
        </pc:grpChg>
        <pc:grpChg chg="add mod">
          <ac:chgData name="Filippo Acconcia" userId="844af49c-a8a0-47ac-a7dd-14a44b60cd18" providerId="ADAL" clId="{B609A75A-164F-4066-A006-F59E853DC491}" dt="2022-04-01T08:52:53.230" v="1222" actId="1076"/>
          <ac:grpSpMkLst>
            <pc:docMk/>
            <pc:sldMk cId="636385627" sldId="304"/>
            <ac:grpSpMk id="31" creationId="{1B6FD9E4-5C85-4CDD-8C5C-A8CBD1FA7195}"/>
          </ac:grpSpMkLst>
        </pc:grpChg>
        <pc:grpChg chg="add mod">
          <ac:chgData name="Filippo Acconcia" userId="844af49c-a8a0-47ac-a7dd-14a44b60cd18" providerId="ADAL" clId="{B609A75A-164F-4066-A006-F59E853DC491}" dt="2022-04-01T08:52:53.230" v="1222" actId="1076"/>
          <ac:grpSpMkLst>
            <pc:docMk/>
            <pc:sldMk cId="636385627" sldId="304"/>
            <ac:grpSpMk id="45" creationId="{94F45E19-6764-4F74-92DB-B95CA5532DAA}"/>
          </ac:grpSpMkLst>
        </pc:grpChg>
        <pc:grpChg chg="add mod">
          <ac:chgData name="Filippo Acconcia" userId="844af49c-a8a0-47ac-a7dd-14a44b60cd18" providerId="ADAL" clId="{B609A75A-164F-4066-A006-F59E853DC491}" dt="2022-04-01T08:52:53.230" v="1222" actId="1076"/>
          <ac:grpSpMkLst>
            <pc:docMk/>
            <pc:sldMk cId="636385627" sldId="304"/>
            <ac:grpSpMk id="63" creationId="{8A19D6F3-B0FB-41AD-BA5B-94F3159F4557}"/>
          </ac:grpSpMkLst>
        </pc:grpChg>
        <pc:picChg chg="mod">
          <ac:chgData name="Filippo Acconcia" userId="844af49c-a8a0-47ac-a7dd-14a44b60cd18" providerId="ADAL" clId="{B609A75A-164F-4066-A006-F59E853DC491}" dt="2022-04-01T08:52:50.455" v="1221"/>
          <ac:picMkLst>
            <pc:docMk/>
            <pc:sldMk cId="636385627" sldId="304"/>
            <ac:picMk id="14" creationId="{ADBA7CC1-7DEF-4F0F-BA3C-1A7B9521C38A}"/>
          </ac:picMkLst>
        </pc:picChg>
        <pc:picChg chg="mod">
          <ac:chgData name="Filippo Acconcia" userId="844af49c-a8a0-47ac-a7dd-14a44b60cd18" providerId="ADAL" clId="{B609A75A-164F-4066-A006-F59E853DC491}" dt="2022-04-01T08:52:50.455" v="1221"/>
          <ac:picMkLst>
            <pc:docMk/>
            <pc:sldMk cId="636385627" sldId="304"/>
            <ac:picMk id="15" creationId="{549784A0-B8D9-4CD5-920F-3C01F7F96351}"/>
          </ac:picMkLst>
        </pc:picChg>
        <pc:picChg chg="mod">
          <ac:chgData name="Filippo Acconcia" userId="844af49c-a8a0-47ac-a7dd-14a44b60cd18" providerId="ADAL" clId="{B609A75A-164F-4066-A006-F59E853DC491}" dt="2022-04-01T08:52:50.455" v="1221"/>
          <ac:picMkLst>
            <pc:docMk/>
            <pc:sldMk cId="636385627" sldId="304"/>
            <ac:picMk id="16" creationId="{4F9327D7-22C3-4AAF-819A-2327C613369B}"/>
          </ac:picMkLst>
        </pc:picChg>
        <pc:picChg chg="mod">
          <ac:chgData name="Filippo Acconcia" userId="844af49c-a8a0-47ac-a7dd-14a44b60cd18" providerId="ADAL" clId="{B609A75A-164F-4066-A006-F59E853DC491}" dt="2022-04-01T08:52:50.455" v="1221"/>
          <ac:picMkLst>
            <pc:docMk/>
            <pc:sldMk cId="636385627" sldId="304"/>
            <ac:picMk id="28" creationId="{C7F1CD99-54A8-46FB-ADD4-4E110EFED8E4}"/>
          </ac:picMkLst>
        </pc:picChg>
        <pc:picChg chg="mod">
          <ac:chgData name="Filippo Acconcia" userId="844af49c-a8a0-47ac-a7dd-14a44b60cd18" providerId="ADAL" clId="{B609A75A-164F-4066-A006-F59E853DC491}" dt="2022-04-01T08:52:50.455" v="1221"/>
          <ac:picMkLst>
            <pc:docMk/>
            <pc:sldMk cId="636385627" sldId="304"/>
            <ac:picMk id="29" creationId="{8BD277BB-7F37-467D-84CE-E9D6FA8A3626}"/>
          </ac:picMkLst>
        </pc:picChg>
        <pc:picChg chg="mod">
          <ac:chgData name="Filippo Acconcia" userId="844af49c-a8a0-47ac-a7dd-14a44b60cd18" providerId="ADAL" clId="{B609A75A-164F-4066-A006-F59E853DC491}" dt="2022-04-01T08:52:50.455" v="1221"/>
          <ac:picMkLst>
            <pc:docMk/>
            <pc:sldMk cId="636385627" sldId="304"/>
            <ac:picMk id="30" creationId="{099FAC7D-F96A-4AB9-87A1-2B531D1B65F5}"/>
          </ac:picMkLst>
        </pc:picChg>
        <pc:picChg chg="mod">
          <ac:chgData name="Filippo Acconcia" userId="844af49c-a8a0-47ac-a7dd-14a44b60cd18" providerId="ADAL" clId="{B609A75A-164F-4066-A006-F59E853DC491}" dt="2022-04-01T08:52:50.455" v="1221"/>
          <ac:picMkLst>
            <pc:docMk/>
            <pc:sldMk cId="636385627" sldId="304"/>
            <ac:picMk id="32" creationId="{52F8C2A5-8D14-4341-9B05-39A9C548776D}"/>
          </ac:picMkLst>
        </pc:picChg>
        <pc:picChg chg="mod">
          <ac:chgData name="Filippo Acconcia" userId="844af49c-a8a0-47ac-a7dd-14a44b60cd18" providerId="ADAL" clId="{B609A75A-164F-4066-A006-F59E853DC491}" dt="2022-04-01T08:52:50.455" v="1221"/>
          <ac:picMkLst>
            <pc:docMk/>
            <pc:sldMk cId="636385627" sldId="304"/>
            <ac:picMk id="33" creationId="{2DC7209E-7332-473F-BCB8-D944DD6E99F3}"/>
          </ac:picMkLst>
        </pc:picChg>
        <pc:picChg chg="mod">
          <ac:chgData name="Filippo Acconcia" userId="844af49c-a8a0-47ac-a7dd-14a44b60cd18" providerId="ADAL" clId="{B609A75A-164F-4066-A006-F59E853DC491}" dt="2022-04-01T08:52:50.455" v="1221"/>
          <ac:picMkLst>
            <pc:docMk/>
            <pc:sldMk cId="636385627" sldId="304"/>
            <ac:picMk id="34" creationId="{8D0B4E8F-CDE1-4A0B-932D-B4AEFB41133A}"/>
          </ac:picMkLst>
        </pc:picChg>
        <pc:picChg chg="mod">
          <ac:chgData name="Filippo Acconcia" userId="844af49c-a8a0-47ac-a7dd-14a44b60cd18" providerId="ADAL" clId="{B609A75A-164F-4066-A006-F59E853DC491}" dt="2022-04-01T08:52:50.455" v="1221"/>
          <ac:picMkLst>
            <pc:docMk/>
            <pc:sldMk cId="636385627" sldId="304"/>
            <ac:picMk id="46" creationId="{0C81AB5B-0A95-4AD1-B28D-0C181C7EBA76}"/>
          </ac:picMkLst>
        </pc:picChg>
        <pc:picChg chg="mod">
          <ac:chgData name="Filippo Acconcia" userId="844af49c-a8a0-47ac-a7dd-14a44b60cd18" providerId="ADAL" clId="{B609A75A-164F-4066-A006-F59E853DC491}" dt="2022-04-01T08:52:50.455" v="1221"/>
          <ac:picMkLst>
            <pc:docMk/>
            <pc:sldMk cId="636385627" sldId="304"/>
            <ac:picMk id="47" creationId="{71BA5372-5CB1-4CC9-BF5B-A0602D6ABD24}"/>
          </ac:picMkLst>
        </pc:picChg>
        <pc:picChg chg="mod">
          <ac:chgData name="Filippo Acconcia" userId="844af49c-a8a0-47ac-a7dd-14a44b60cd18" providerId="ADAL" clId="{B609A75A-164F-4066-A006-F59E853DC491}" dt="2022-04-01T08:52:50.455" v="1221"/>
          <ac:picMkLst>
            <pc:docMk/>
            <pc:sldMk cId="636385627" sldId="304"/>
            <ac:picMk id="48" creationId="{31404CF7-09A5-49BC-9AFC-0F6D662456D6}"/>
          </ac:picMkLst>
        </pc:picChg>
        <pc:picChg chg="mod">
          <ac:chgData name="Filippo Acconcia" userId="844af49c-a8a0-47ac-a7dd-14a44b60cd18" providerId="ADAL" clId="{B609A75A-164F-4066-A006-F59E853DC491}" dt="2022-04-01T08:52:50.455" v="1221"/>
          <ac:picMkLst>
            <pc:docMk/>
            <pc:sldMk cId="636385627" sldId="304"/>
            <ac:picMk id="64" creationId="{F3F460F0-F967-4A80-AA73-CEC00E07D5F1}"/>
          </ac:picMkLst>
        </pc:picChg>
        <pc:picChg chg="mod">
          <ac:chgData name="Filippo Acconcia" userId="844af49c-a8a0-47ac-a7dd-14a44b60cd18" providerId="ADAL" clId="{B609A75A-164F-4066-A006-F59E853DC491}" dt="2022-04-01T08:52:50.455" v="1221"/>
          <ac:picMkLst>
            <pc:docMk/>
            <pc:sldMk cId="636385627" sldId="304"/>
            <ac:picMk id="65" creationId="{A9F25ECE-3A05-4DC6-97D7-2163158480CE}"/>
          </ac:picMkLst>
        </pc:picChg>
        <pc:picChg chg="mod">
          <ac:chgData name="Filippo Acconcia" userId="844af49c-a8a0-47ac-a7dd-14a44b60cd18" providerId="ADAL" clId="{B609A75A-164F-4066-A006-F59E853DC491}" dt="2022-04-01T08:52:50.455" v="1221"/>
          <ac:picMkLst>
            <pc:docMk/>
            <pc:sldMk cId="636385627" sldId="304"/>
            <ac:picMk id="66" creationId="{CA14F0E0-D077-48CE-A427-494C82ADA7F6}"/>
          </ac:picMkLst>
        </pc:picChg>
        <pc:cxnChg chg="mod">
          <ac:chgData name="Filippo Acconcia" userId="844af49c-a8a0-47ac-a7dd-14a44b60cd18" providerId="ADAL" clId="{B609A75A-164F-4066-A006-F59E853DC491}" dt="2022-04-01T08:52:50.455" v="1221"/>
          <ac:cxnSpMkLst>
            <pc:docMk/>
            <pc:sldMk cId="636385627" sldId="304"/>
            <ac:cxnSpMk id="13" creationId="{1D36E230-5F95-4F5C-B147-EFDD0E315C42}"/>
          </ac:cxnSpMkLst>
        </pc:cxnChg>
        <pc:cxnChg chg="mod">
          <ac:chgData name="Filippo Acconcia" userId="844af49c-a8a0-47ac-a7dd-14a44b60cd18" providerId="ADAL" clId="{B609A75A-164F-4066-A006-F59E853DC491}" dt="2022-04-01T08:52:50.455" v="1221"/>
          <ac:cxnSpMkLst>
            <pc:docMk/>
            <pc:sldMk cId="636385627" sldId="304"/>
            <ac:cxnSpMk id="26" creationId="{00121BB5-B234-4653-A1B4-6A6B675F40F5}"/>
          </ac:cxnSpMkLst>
        </pc:cxnChg>
        <pc:cxnChg chg="mod">
          <ac:chgData name="Filippo Acconcia" userId="844af49c-a8a0-47ac-a7dd-14a44b60cd18" providerId="ADAL" clId="{B609A75A-164F-4066-A006-F59E853DC491}" dt="2022-04-01T08:52:50.455" v="1221"/>
          <ac:cxnSpMkLst>
            <pc:docMk/>
            <pc:sldMk cId="636385627" sldId="304"/>
            <ac:cxnSpMk id="43" creationId="{A756B832-EFE4-4C0F-BA31-FABF36AA9929}"/>
          </ac:cxnSpMkLst>
        </pc:cxnChg>
        <pc:cxnChg chg="mod">
          <ac:chgData name="Filippo Acconcia" userId="844af49c-a8a0-47ac-a7dd-14a44b60cd18" providerId="ADAL" clId="{B609A75A-164F-4066-A006-F59E853DC491}" dt="2022-04-01T08:52:50.455" v="1221"/>
          <ac:cxnSpMkLst>
            <pc:docMk/>
            <pc:sldMk cId="636385627" sldId="304"/>
            <ac:cxnSpMk id="57" creationId="{6B300953-1487-4541-A4B7-7D7FD8C2B7B0}"/>
          </ac:cxnSpMkLst>
        </pc:cxnChg>
        <pc:cxnChg chg="mod">
          <ac:chgData name="Filippo Acconcia" userId="844af49c-a8a0-47ac-a7dd-14a44b60cd18" providerId="ADAL" clId="{B609A75A-164F-4066-A006-F59E853DC491}" dt="2022-04-01T08:52:50.455" v="1221"/>
          <ac:cxnSpMkLst>
            <pc:docMk/>
            <pc:sldMk cId="636385627" sldId="304"/>
            <ac:cxnSpMk id="75" creationId="{182B314B-D5AE-4BF9-AE68-BAE40DD45C25}"/>
          </ac:cxnSpMkLst>
        </pc:cxnChg>
      </pc:sldChg>
    </pc:docChg>
  </pc:docChgLst>
  <pc:docChgLst>
    <pc:chgData name="Filippo Acconcia" userId="844af49c-a8a0-47ac-a7dd-14a44b60cd18" providerId="ADAL" clId="{C516B166-1222-4F61-B848-148F91576E1C}"/>
    <pc:docChg chg="custSel modSld sldOrd">
      <pc:chgData name="Filippo Acconcia" userId="844af49c-a8a0-47ac-a7dd-14a44b60cd18" providerId="ADAL" clId="{C516B166-1222-4F61-B848-148F91576E1C}" dt="2022-08-03T13:31:20.497" v="49" actId="164"/>
      <pc:docMkLst>
        <pc:docMk/>
      </pc:docMkLst>
      <pc:sldChg chg="addSp delSp modSp mod">
        <pc:chgData name="Filippo Acconcia" userId="844af49c-a8a0-47ac-a7dd-14a44b60cd18" providerId="ADAL" clId="{C516B166-1222-4F61-B848-148F91576E1C}" dt="2022-08-03T13:31:20.497" v="49" actId="164"/>
        <pc:sldMkLst>
          <pc:docMk/>
          <pc:sldMk cId="2620120220" sldId="296"/>
        </pc:sldMkLst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174" creationId="{E24257B3-5DA0-4B5C-83A1-D104B991DD68}"/>
          </ac:spMkLst>
        </pc:spChg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178" creationId="{A0A82956-22D8-4DEA-8639-B2ADD72EBCBB}"/>
          </ac:spMkLst>
        </pc:spChg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179" creationId="{604A7B3C-50EB-4160-BD52-A62247203F67}"/>
          </ac:spMkLst>
        </pc:spChg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180" creationId="{3190244A-F5A3-4F11-BF2B-66F534ED4427}"/>
          </ac:spMkLst>
        </pc:spChg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181" creationId="{5F4AF4AA-0CA1-4A9E-81FB-483048AC2F60}"/>
          </ac:spMkLst>
        </pc:spChg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182" creationId="{A11B54A8-37E6-412E-9FC6-8C1A721F0A4E}"/>
          </ac:spMkLst>
        </pc:spChg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183" creationId="{86C6DEB9-889B-4FC0-A43E-30302F1441EA}"/>
          </ac:spMkLst>
        </pc:spChg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184" creationId="{88261562-989E-40B4-81D0-C8137C0858C7}"/>
          </ac:spMkLst>
        </pc:spChg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185" creationId="{A970EBBC-9B1D-4886-B9A0-35DBB044CFE5}"/>
          </ac:spMkLst>
        </pc:spChg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186" creationId="{F0D191E3-44E8-4827-856C-4964055ED77F}"/>
          </ac:spMkLst>
        </pc:spChg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187" creationId="{4CE9BEC2-39F0-4BF1-BBB7-55DFE62E7E58}"/>
          </ac:spMkLst>
        </pc:spChg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188" creationId="{0CB76EB6-7FBA-46F2-BF41-3DD4597CF140}"/>
          </ac:spMkLst>
        </pc:spChg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189" creationId="{CA1D6382-3B31-439B-A747-2FC78B08C8A2}"/>
          </ac:spMkLst>
        </pc:spChg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190" creationId="{BD4F8F30-3D0C-4E49-A0B5-0E39CBC4A083}"/>
          </ac:spMkLst>
        </pc:spChg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191" creationId="{E4373DF3-BB03-4DD5-A4C3-7D1D3706C909}"/>
          </ac:spMkLst>
        </pc:spChg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192" creationId="{6DF62CD4-47B3-4E20-AD1D-70B95C89690A}"/>
          </ac:spMkLst>
        </pc:spChg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193" creationId="{ADBC4FD5-3044-4F40-AA40-0A9D4C1D5D70}"/>
          </ac:spMkLst>
        </pc:spChg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198" creationId="{C986196D-83B0-48BC-9BA2-493BA160D90A}"/>
          </ac:spMkLst>
        </pc:spChg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199" creationId="{F234B049-1FD6-4695-858F-28BF88EB4FB2}"/>
          </ac:spMkLst>
        </pc:spChg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200" creationId="{96A673C5-F4E1-4EDE-94C2-35A8BF839D2D}"/>
          </ac:spMkLst>
        </pc:spChg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201" creationId="{070A51A8-231E-4D78-99B0-82C47E36370C}"/>
          </ac:spMkLst>
        </pc:spChg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202" creationId="{2567F7C0-31A3-454A-AA13-B6404D53394E}"/>
          </ac:spMkLst>
        </pc:spChg>
        <pc:spChg chg="mod topLvl">
          <ac:chgData name="Filippo Acconcia" userId="844af49c-a8a0-47ac-a7dd-14a44b60cd18" providerId="ADAL" clId="{C516B166-1222-4F61-B848-148F91576E1C}" dt="2022-08-03T13:31:20.497" v="49" actId="164"/>
          <ac:spMkLst>
            <pc:docMk/>
            <pc:sldMk cId="2620120220" sldId="296"/>
            <ac:spMk id="203" creationId="{DBC91E65-57A0-405C-8E53-31E761F8DD13}"/>
          </ac:spMkLst>
        </pc:spChg>
        <pc:spChg chg="mod">
          <ac:chgData name="Filippo Acconcia" userId="844af49c-a8a0-47ac-a7dd-14a44b60cd18" providerId="ADAL" clId="{C516B166-1222-4F61-B848-148F91576E1C}" dt="2022-08-03T10:08:19.491" v="5" actId="20577"/>
          <ac:spMkLst>
            <pc:docMk/>
            <pc:sldMk cId="2620120220" sldId="296"/>
            <ac:spMk id="204" creationId="{56595A4C-E202-46D6-8C35-E92377F2E95A}"/>
          </ac:spMkLst>
        </pc:spChg>
        <pc:grpChg chg="add mod">
          <ac:chgData name="Filippo Acconcia" userId="844af49c-a8a0-47ac-a7dd-14a44b60cd18" providerId="ADAL" clId="{C516B166-1222-4F61-B848-148F91576E1C}" dt="2022-08-03T13:31:20.497" v="49" actId="164"/>
          <ac:grpSpMkLst>
            <pc:docMk/>
            <pc:sldMk cId="2620120220" sldId="296"/>
            <ac:grpSpMk id="51" creationId="{2C30E6CD-EE92-FADD-3535-67C8CB6D18CB}"/>
          </ac:grpSpMkLst>
        </pc:grpChg>
        <pc:grpChg chg="del">
          <ac:chgData name="Filippo Acconcia" userId="844af49c-a8a0-47ac-a7dd-14a44b60cd18" providerId="ADAL" clId="{C516B166-1222-4F61-B848-148F91576E1C}" dt="2022-08-03T13:29:24.309" v="9" actId="165"/>
          <ac:grpSpMkLst>
            <pc:docMk/>
            <pc:sldMk cId="2620120220" sldId="296"/>
            <ac:grpSpMk id="171" creationId="{89C73608-F000-4954-8FE0-7D60CE53DB7B}"/>
          </ac:grpSpMkLst>
        </pc:grpChg>
        <pc:grpChg chg="del mod topLvl">
          <ac:chgData name="Filippo Acconcia" userId="844af49c-a8a0-47ac-a7dd-14a44b60cd18" providerId="ADAL" clId="{C516B166-1222-4F61-B848-148F91576E1C}" dt="2022-08-03T13:29:27.523" v="10" actId="165"/>
          <ac:grpSpMkLst>
            <pc:docMk/>
            <pc:sldMk cId="2620120220" sldId="296"/>
            <ac:grpSpMk id="172" creationId="{66B498A5-5F8F-44FB-AEA5-423CC99BFD55}"/>
          </ac:grpSpMkLst>
        </pc:grpChg>
        <pc:picChg chg="mod">
          <ac:chgData name="Filippo Acconcia" userId="844af49c-a8a0-47ac-a7dd-14a44b60cd18" providerId="ADAL" clId="{C516B166-1222-4F61-B848-148F91576E1C}" dt="2022-08-03T13:31:20.497" v="49" actId="164"/>
          <ac:picMkLst>
            <pc:docMk/>
            <pc:sldMk cId="2620120220" sldId="296"/>
            <ac:picMk id="48" creationId="{D3954EFE-F1B3-5EED-0DA7-D0B7EDBFAC01}"/>
          </ac:picMkLst>
        </pc:picChg>
        <pc:picChg chg="mod">
          <ac:chgData name="Filippo Acconcia" userId="844af49c-a8a0-47ac-a7dd-14a44b60cd18" providerId="ADAL" clId="{C516B166-1222-4F61-B848-148F91576E1C}" dt="2022-08-03T13:31:20.497" v="49" actId="164"/>
          <ac:picMkLst>
            <pc:docMk/>
            <pc:sldMk cId="2620120220" sldId="296"/>
            <ac:picMk id="49" creationId="{28CE2940-CAE8-14FD-D54B-4015055243AA}"/>
          </ac:picMkLst>
        </pc:picChg>
        <pc:picChg chg="mod ord">
          <ac:chgData name="Filippo Acconcia" userId="844af49c-a8a0-47ac-a7dd-14a44b60cd18" providerId="ADAL" clId="{C516B166-1222-4F61-B848-148F91576E1C}" dt="2022-08-03T13:31:20.497" v="49" actId="164"/>
          <ac:picMkLst>
            <pc:docMk/>
            <pc:sldMk cId="2620120220" sldId="296"/>
            <ac:picMk id="50" creationId="{6A1A8334-06FA-53DB-9934-75797D36FB46}"/>
          </ac:picMkLst>
        </pc:picChg>
        <pc:picChg chg="del mod topLvl">
          <ac:chgData name="Filippo Acconcia" userId="844af49c-a8a0-47ac-a7dd-14a44b60cd18" providerId="ADAL" clId="{C516B166-1222-4F61-B848-148F91576E1C}" dt="2022-08-03T13:30:18.314" v="17" actId="478"/>
          <ac:picMkLst>
            <pc:docMk/>
            <pc:sldMk cId="2620120220" sldId="296"/>
            <ac:picMk id="175" creationId="{00413BD4-21A4-40D0-BCDB-EEB3C7144BDB}"/>
          </ac:picMkLst>
        </pc:picChg>
        <pc:picChg chg="del mod topLvl">
          <ac:chgData name="Filippo Acconcia" userId="844af49c-a8a0-47ac-a7dd-14a44b60cd18" providerId="ADAL" clId="{C516B166-1222-4F61-B848-148F91576E1C}" dt="2022-08-03T13:30:16.413" v="16" actId="478"/>
          <ac:picMkLst>
            <pc:docMk/>
            <pc:sldMk cId="2620120220" sldId="296"/>
            <ac:picMk id="176" creationId="{10463265-4DCA-41CF-98AC-ECDBC4F0C76B}"/>
          </ac:picMkLst>
        </pc:picChg>
        <pc:picChg chg="del mod topLvl">
          <ac:chgData name="Filippo Acconcia" userId="844af49c-a8a0-47ac-a7dd-14a44b60cd18" providerId="ADAL" clId="{C516B166-1222-4F61-B848-148F91576E1C}" dt="2022-08-03T13:30:32.970" v="20" actId="478"/>
          <ac:picMkLst>
            <pc:docMk/>
            <pc:sldMk cId="2620120220" sldId="296"/>
            <ac:picMk id="177" creationId="{9ACF2981-93D7-4E62-B54D-502D8E65A987}"/>
          </ac:picMkLst>
        </pc:picChg>
        <pc:cxnChg chg="mod topLvl">
          <ac:chgData name="Filippo Acconcia" userId="844af49c-a8a0-47ac-a7dd-14a44b60cd18" providerId="ADAL" clId="{C516B166-1222-4F61-B848-148F91576E1C}" dt="2022-08-03T13:31:20.497" v="49" actId="164"/>
          <ac:cxnSpMkLst>
            <pc:docMk/>
            <pc:sldMk cId="2620120220" sldId="296"/>
            <ac:cxnSpMk id="173" creationId="{00EA1F7E-4704-439D-959D-0184BC3702B4}"/>
          </ac:cxnSpMkLst>
        </pc:cxnChg>
        <pc:cxnChg chg="mod topLvl">
          <ac:chgData name="Filippo Acconcia" userId="844af49c-a8a0-47ac-a7dd-14a44b60cd18" providerId="ADAL" clId="{C516B166-1222-4F61-B848-148F91576E1C}" dt="2022-08-03T13:31:20.497" v="49" actId="164"/>
          <ac:cxnSpMkLst>
            <pc:docMk/>
            <pc:sldMk cId="2620120220" sldId="296"/>
            <ac:cxnSpMk id="194" creationId="{190D3AA0-1DE1-49EA-B91E-11256308CF2B}"/>
          </ac:cxnSpMkLst>
        </pc:cxnChg>
        <pc:cxnChg chg="mod topLvl">
          <ac:chgData name="Filippo Acconcia" userId="844af49c-a8a0-47ac-a7dd-14a44b60cd18" providerId="ADAL" clId="{C516B166-1222-4F61-B848-148F91576E1C}" dt="2022-08-03T13:31:20.497" v="49" actId="164"/>
          <ac:cxnSpMkLst>
            <pc:docMk/>
            <pc:sldMk cId="2620120220" sldId="296"/>
            <ac:cxnSpMk id="195" creationId="{301602ED-9CC6-476E-8EBA-09D920D82D00}"/>
          </ac:cxnSpMkLst>
        </pc:cxnChg>
        <pc:cxnChg chg="mod topLvl">
          <ac:chgData name="Filippo Acconcia" userId="844af49c-a8a0-47ac-a7dd-14a44b60cd18" providerId="ADAL" clId="{C516B166-1222-4F61-B848-148F91576E1C}" dt="2022-08-03T13:31:20.497" v="49" actId="164"/>
          <ac:cxnSpMkLst>
            <pc:docMk/>
            <pc:sldMk cId="2620120220" sldId="296"/>
            <ac:cxnSpMk id="196" creationId="{C9B61802-5344-471A-9CD0-C7D8261D21DC}"/>
          </ac:cxnSpMkLst>
        </pc:cxnChg>
        <pc:cxnChg chg="mod topLvl">
          <ac:chgData name="Filippo Acconcia" userId="844af49c-a8a0-47ac-a7dd-14a44b60cd18" providerId="ADAL" clId="{C516B166-1222-4F61-B848-148F91576E1C}" dt="2022-08-03T13:31:20.497" v="49" actId="164"/>
          <ac:cxnSpMkLst>
            <pc:docMk/>
            <pc:sldMk cId="2620120220" sldId="296"/>
            <ac:cxnSpMk id="197" creationId="{B7E2454C-C888-4890-BD4B-5137B473BCFA}"/>
          </ac:cxnSpMkLst>
        </pc:cxnChg>
      </pc:sldChg>
      <pc:sldChg chg="modSp mod ord">
        <pc:chgData name="Filippo Acconcia" userId="844af49c-a8a0-47ac-a7dd-14a44b60cd18" providerId="ADAL" clId="{C516B166-1222-4F61-B848-148F91576E1C}" dt="2022-08-03T09:56:52.963" v="2"/>
        <pc:sldMkLst>
          <pc:docMk/>
          <pc:sldMk cId="706034829" sldId="301"/>
        </pc:sldMkLst>
        <pc:spChg chg="mod">
          <ac:chgData name="Filippo Acconcia" userId="844af49c-a8a0-47ac-a7dd-14a44b60cd18" providerId="ADAL" clId="{C516B166-1222-4F61-B848-148F91576E1C}" dt="2022-08-03T09:56:47.834" v="0" actId="20577"/>
          <ac:spMkLst>
            <pc:docMk/>
            <pc:sldMk cId="706034829" sldId="301"/>
            <ac:spMk id="2" creationId="{5D2DCA17-BCD4-4265-8C5B-67AE7563323A}"/>
          </ac:spMkLst>
        </pc:spChg>
      </pc:sldChg>
      <pc:sldChg chg="modSp mod">
        <pc:chgData name="Filippo Acconcia" userId="844af49c-a8a0-47ac-a7dd-14a44b60cd18" providerId="ADAL" clId="{C516B166-1222-4F61-B848-148F91576E1C}" dt="2022-08-03T09:59:50.940" v="3" actId="20577"/>
        <pc:sldMkLst>
          <pc:docMk/>
          <pc:sldMk cId="2248971367" sldId="303"/>
        </pc:sldMkLst>
        <pc:spChg chg="mod">
          <ac:chgData name="Filippo Acconcia" userId="844af49c-a8a0-47ac-a7dd-14a44b60cd18" providerId="ADAL" clId="{C516B166-1222-4F61-B848-148F91576E1C}" dt="2022-08-03T09:59:50.940" v="3" actId="20577"/>
          <ac:spMkLst>
            <pc:docMk/>
            <pc:sldMk cId="2248971367" sldId="303"/>
            <ac:spMk id="53" creationId="{066D7556-77C7-44D9-BFDD-1EA1FF5DA3DB}"/>
          </ac:spMkLst>
        </pc:spChg>
      </pc:sldChg>
    </pc:docChg>
  </pc:docChgLst>
  <pc:docChgLst>
    <pc:chgData name="Filippo Acconcia" userId="844af49c-a8a0-47ac-a7dd-14a44b60cd18" providerId="ADAL" clId="{998C6BF7-482B-421C-8ECC-9091B23559F6}"/>
    <pc:docChg chg="undo custSel addSld delSld modSld sldOrd">
      <pc:chgData name="Filippo Acconcia" userId="844af49c-a8a0-47ac-a7dd-14a44b60cd18" providerId="ADAL" clId="{998C6BF7-482B-421C-8ECC-9091B23559F6}" dt="2022-06-10T17:23:29.897" v="1199" actId="1037"/>
      <pc:docMkLst>
        <pc:docMk/>
      </pc:docMkLst>
      <pc:sldChg chg="del">
        <pc:chgData name="Filippo Acconcia" userId="844af49c-a8a0-47ac-a7dd-14a44b60cd18" providerId="ADAL" clId="{998C6BF7-482B-421C-8ECC-9091B23559F6}" dt="2022-03-24T06:46:00.165" v="0" actId="47"/>
        <pc:sldMkLst>
          <pc:docMk/>
          <pc:sldMk cId="0" sldId="274"/>
        </pc:sldMkLst>
      </pc:sldChg>
      <pc:sldChg chg="del">
        <pc:chgData name="Filippo Acconcia" userId="844af49c-a8a0-47ac-a7dd-14a44b60cd18" providerId="ADAL" clId="{998C6BF7-482B-421C-8ECC-9091B23559F6}" dt="2022-03-24T06:46:00.525" v="2" actId="47"/>
        <pc:sldMkLst>
          <pc:docMk/>
          <pc:sldMk cId="484687289" sldId="284"/>
        </pc:sldMkLst>
      </pc:sldChg>
      <pc:sldChg chg="del">
        <pc:chgData name="Filippo Acconcia" userId="844af49c-a8a0-47ac-a7dd-14a44b60cd18" providerId="ADAL" clId="{998C6BF7-482B-421C-8ECC-9091B23559F6}" dt="2022-03-24T06:46:00.337" v="1" actId="47"/>
        <pc:sldMkLst>
          <pc:docMk/>
          <pc:sldMk cId="269001550" sldId="285"/>
        </pc:sldMkLst>
      </pc:sldChg>
      <pc:sldChg chg="del">
        <pc:chgData name="Filippo Acconcia" userId="844af49c-a8a0-47ac-a7dd-14a44b60cd18" providerId="ADAL" clId="{998C6BF7-482B-421C-8ECC-9091B23559F6}" dt="2022-03-24T06:46:02.196" v="3" actId="47"/>
        <pc:sldMkLst>
          <pc:docMk/>
          <pc:sldMk cId="991056031" sldId="286"/>
        </pc:sldMkLst>
      </pc:sldChg>
      <pc:sldChg chg="del">
        <pc:chgData name="Filippo Acconcia" userId="844af49c-a8a0-47ac-a7dd-14a44b60cd18" providerId="ADAL" clId="{998C6BF7-482B-421C-8ECC-9091B23559F6}" dt="2022-03-24T06:46:02.274" v="4" actId="47"/>
        <pc:sldMkLst>
          <pc:docMk/>
          <pc:sldMk cId="1411678621" sldId="289"/>
        </pc:sldMkLst>
      </pc:sldChg>
      <pc:sldChg chg="del">
        <pc:chgData name="Filippo Acconcia" userId="844af49c-a8a0-47ac-a7dd-14a44b60cd18" providerId="ADAL" clId="{998C6BF7-482B-421C-8ECC-9091B23559F6}" dt="2022-03-24T06:46:02.337" v="5" actId="47"/>
        <pc:sldMkLst>
          <pc:docMk/>
          <pc:sldMk cId="434117186" sldId="290"/>
        </pc:sldMkLst>
      </pc:sldChg>
      <pc:sldChg chg="del">
        <pc:chgData name="Filippo Acconcia" userId="844af49c-a8a0-47ac-a7dd-14a44b60cd18" providerId="ADAL" clId="{998C6BF7-482B-421C-8ECC-9091B23559F6}" dt="2022-03-24T06:46:02.399" v="6" actId="47"/>
        <pc:sldMkLst>
          <pc:docMk/>
          <pc:sldMk cId="1203508377" sldId="291"/>
        </pc:sldMkLst>
      </pc:sldChg>
      <pc:sldChg chg="del">
        <pc:chgData name="Filippo Acconcia" userId="844af49c-a8a0-47ac-a7dd-14a44b60cd18" providerId="ADAL" clId="{998C6BF7-482B-421C-8ECC-9091B23559F6}" dt="2022-03-24T06:46:02.743" v="7" actId="47"/>
        <pc:sldMkLst>
          <pc:docMk/>
          <pc:sldMk cId="1168483038" sldId="292"/>
        </pc:sldMkLst>
      </pc:sldChg>
      <pc:sldChg chg="del">
        <pc:chgData name="Filippo Acconcia" userId="844af49c-a8a0-47ac-a7dd-14a44b60cd18" providerId="ADAL" clId="{998C6BF7-482B-421C-8ECC-9091B23559F6}" dt="2022-03-24T06:46:02.899" v="8" actId="47"/>
        <pc:sldMkLst>
          <pc:docMk/>
          <pc:sldMk cId="2343428689" sldId="293"/>
        </pc:sldMkLst>
      </pc:sldChg>
      <pc:sldChg chg="del">
        <pc:chgData name="Filippo Acconcia" userId="844af49c-a8a0-47ac-a7dd-14a44b60cd18" providerId="ADAL" clId="{998C6BF7-482B-421C-8ECC-9091B23559F6}" dt="2022-03-24T06:46:03.165" v="9" actId="47"/>
        <pc:sldMkLst>
          <pc:docMk/>
          <pc:sldMk cId="3273756066" sldId="294"/>
        </pc:sldMkLst>
      </pc:sldChg>
      <pc:sldChg chg="addSp delSp modSp mod">
        <pc:chgData name="Filippo Acconcia" userId="844af49c-a8a0-47ac-a7dd-14a44b60cd18" providerId="ADAL" clId="{998C6BF7-482B-421C-8ECC-9091B23559F6}" dt="2022-04-02T06:54:09.062" v="563" actId="1038"/>
        <pc:sldMkLst>
          <pc:docMk/>
          <pc:sldMk cId="2888039256" sldId="295"/>
        </pc:sldMkLst>
        <pc:spChg chg="add mod">
          <ac:chgData name="Filippo Acconcia" userId="844af49c-a8a0-47ac-a7dd-14a44b60cd18" providerId="ADAL" clId="{998C6BF7-482B-421C-8ECC-9091B23559F6}" dt="2022-03-24T06:49:12.926" v="21" actId="20577"/>
          <ac:spMkLst>
            <pc:docMk/>
            <pc:sldMk cId="2888039256" sldId="295"/>
            <ac:spMk id="5" creationId="{5F6E9D74-198D-4C0F-867A-54DB5919EEFF}"/>
          </ac:spMkLst>
        </pc:spChg>
        <pc:spChg chg="del">
          <ac:chgData name="Filippo Acconcia" userId="844af49c-a8a0-47ac-a7dd-14a44b60cd18" providerId="ADAL" clId="{998C6BF7-482B-421C-8ECC-9091B23559F6}" dt="2022-03-24T06:46:08.556" v="11" actId="478"/>
          <ac:spMkLst>
            <pc:docMk/>
            <pc:sldMk cId="2888039256" sldId="295"/>
            <ac:spMk id="36" creationId="{9EDB0FC0-650F-4C7C-8969-1863368C4170}"/>
          </ac:spMkLst>
        </pc:spChg>
        <pc:spChg chg="del">
          <ac:chgData name="Filippo Acconcia" userId="844af49c-a8a0-47ac-a7dd-14a44b60cd18" providerId="ADAL" clId="{998C6BF7-482B-421C-8ECC-9091B23559F6}" dt="2022-03-24T06:46:08.556" v="11" actId="478"/>
          <ac:spMkLst>
            <pc:docMk/>
            <pc:sldMk cId="2888039256" sldId="295"/>
            <ac:spMk id="37" creationId="{349A5B54-27DF-4272-8AC7-451456BFEA22}"/>
          </ac:spMkLst>
        </pc:spChg>
        <pc:spChg chg="del">
          <ac:chgData name="Filippo Acconcia" userId="844af49c-a8a0-47ac-a7dd-14a44b60cd18" providerId="ADAL" clId="{998C6BF7-482B-421C-8ECC-9091B23559F6}" dt="2022-03-24T06:46:08.556" v="11" actId="478"/>
          <ac:spMkLst>
            <pc:docMk/>
            <pc:sldMk cId="2888039256" sldId="295"/>
            <ac:spMk id="59" creationId="{CF0868FA-9204-4A66-92CB-24F41FB127B8}"/>
          </ac:spMkLst>
        </pc:spChg>
        <pc:spChg chg="del">
          <ac:chgData name="Filippo Acconcia" userId="844af49c-a8a0-47ac-a7dd-14a44b60cd18" providerId="ADAL" clId="{998C6BF7-482B-421C-8ECC-9091B23559F6}" dt="2022-03-24T06:46:08.556" v="11" actId="478"/>
          <ac:spMkLst>
            <pc:docMk/>
            <pc:sldMk cId="2888039256" sldId="295"/>
            <ac:spMk id="60" creationId="{B01FDBD1-720B-4D82-B77E-804983CD093A}"/>
          </ac:spMkLst>
        </pc:spChg>
        <pc:spChg chg="del">
          <ac:chgData name="Filippo Acconcia" userId="844af49c-a8a0-47ac-a7dd-14a44b60cd18" providerId="ADAL" clId="{998C6BF7-482B-421C-8ECC-9091B23559F6}" dt="2022-03-24T06:46:08.556" v="11" actId="478"/>
          <ac:spMkLst>
            <pc:docMk/>
            <pc:sldMk cId="2888039256" sldId="295"/>
            <ac:spMk id="67" creationId="{3126A325-6E24-4123-BCB2-979E9C855EB1}"/>
          </ac:spMkLst>
        </pc:spChg>
        <pc:spChg chg="del">
          <ac:chgData name="Filippo Acconcia" userId="844af49c-a8a0-47ac-a7dd-14a44b60cd18" providerId="ADAL" clId="{998C6BF7-482B-421C-8ECC-9091B23559F6}" dt="2022-03-24T06:46:08.556" v="11" actId="478"/>
          <ac:spMkLst>
            <pc:docMk/>
            <pc:sldMk cId="2888039256" sldId="295"/>
            <ac:spMk id="70" creationId="{16E1CB1A-92B0-480D-BED0-D9103DB48093}"/>
          </ac:spMkLst>
        </pc:spChg>
        <pc:spChg chg="mod">
          <ac:chgData name="Filippo Acconcia" userId="844af49c-a8a0-47ac-a7dd-14a44b60cd18" providerId="ADAL" clId="{998C6BF7-482B-421C-8ECC-9091B23559F6}" dt="2022-03-24T06:46:24.683" v="12"/>
          <ac:spMkLst>
            <pc:docMk/>
            <pc:sldMk cId="2888039256" sldId="295"/>
            <ac:spMk id="73" creationId="{BC5D6DFD-A1B7-4F5B-8E6C-D7DC24CC51E7}"/>
          </ac:spMkLst>
        </pc:spChg>
        <pc:spChg chg="mod">
          <ac:chgData name="Filippo Acconcia" userId="844af49c-a8a0-47ac-a7dd-14a44b60cd18" providerId="ADAL" clId="{998C6BF7-482B-421C-8ECC-9091B23559F6}" dt="2022-03-24T06:46:24.683" v="12"/>
          <ac:spMkLst>
            <pc:docMk/>
            <pc:sldMk cId="2888039256" sldId="295"/>
            <ac:spMk id="74" creationId="{FEDAA042-B3D5-42E8-BD48-8922A14BC130}"/>
          </ac:spMkLst>
        </pc:spChg>
        <pc:spChg chg="mod">
          <ac:chgData name="Filippo Acconcia" userId="844af49c-a8a0-47ac-a7dd-14a44b60cd18" providerId="ADAL" clId="{998C6BF7-482B-421C-8ECC-9091B23559F6}" dt="2022-03-24T06:46:24.683" v="12"/>
          <ac:spMkLst>
            <pc:docMk/>
            <pc:sldMk cId="2888039256" sldId="295"/>
            <ac:spMk id="75" creationId="{A7439430-C946-49B2-A38F-138B8B2C4BC4}"/>
          </ac:spMkLst>
        </pc:spChg>
        <pc:spChg chg="mod">
          <ac:chgData name="Filippo Acconcia" userId="844af49c-a8a0-47ac-a7dd-14a44b60cd18" providerId="ADAL" clId="{998C6BF7-482B-421C-8ECC-9091B23559F6}" dt="2022-03-24T06:46:24.683" v="12"/>
          <ac:spMkLst>
            <pc:docMk/>
            <pc:sldMk cId="2888039256" sldId="295"/>
            <ac:spMk id="76" creationId="{F50E6A00-7DC9-472E-A9E7-682FBBD2C2F7}"/>
          </ac:spMkLst>
        </pc:spChg>
        <pc:spChg chg="mod">
          <ac:chgData name="Filippo Acconcia" userId="844af49c-a8a0-47ac-a7dd-14a44b60cd18" providerId="ADAL" clId="{998C6BF7-482B-421C-8ECC-9091B23559F6}" dt="2022-03-24T06:46:24.683" v="12"/>
          <ac:spMkLst>
            <pc:docMk/>
            <pc:sldMk cId="2888039256" sldId="295"/>
            <ac:spMk id="77" creationId="{920F0185-833E-4D87-9E3B-082ED33FD968}"/>
          </ac:spMkLst>
        </pc:spChg>
        <pc:spChg chg="mod">
          <ac:chgData name="Filippo Acconcia" userId="844af49c-a8a0-47ac-a7dd-14a44b60cd18" providerId="ADAL" clId="{998C6BF7-482B-421C-8ECC-9091B23559F6}" dt="2022-03-24T06:46:24.683" v="12"/>
          <ac:spMkLst>
            <pc:docMk/>
            <pc:sldMk cId="2888039256" sldId="295"/>
            <ac:spMk id="78" creationId="{F9B98650-CEF1-4D33-93D9-3A3184F567BE}"/>
          </ac:spMkLst>
        </pc:spChg>
        <pc:spChg chg="mod">
          <ac:chgData name="Filippo Acconcia" userId="844af49c-a8a0-47ac-a7dd-14a44b60cd18" providerId="ADAL" clId="{998C6BF7-482B-421C-8ECC-9091B23559F6}" dt="2022-03-24T06:46:24.683" v="12"/>
          <ac:spMkLst>
            <pc:docMk/>
            <pc:sldMk cId="2888039256" sldId="295"/>
            <ac:spMk id="80" creationId="{9A4F88D4-D9BE-4D31-9C97-7FCC25CE0424}"/>
          </ac:spMkLst>
        </pc:spChg>
        <pc:spChg chg="mod">
          <ac:chgData name="Filippo Acconcia" userId="844af49c-a8a0-47ac-a7dd-14a44b60cd18" providerId="ADAL" clId="{998C6BF7-482B-421C-8ECC-9091B23559F6}" dt="2022-03-24T06:46:24.683" v="12"/>
          <ac:spMkLst>
            <pc:docMk/>
            <pc:sldMk cId="2888039256" sldId="295"/>
            <ac:spMk id="81" creationId="{6B6DD363-A73D-4DF1-B9F6-EB28E3676392}"/>
          </ac:spMkLst>
        </pc:spChg>
        <pc:spChg chg="mod">
          <ac:chgData name="Filippo Acconcia" userId="844af49c-a8a0-47ac-a7dd-14a44b60cd18" providerId="ADAL" clId="{998C6BF7-482B-421C-8ECC-9091B23559F6}" dt="2022-03-24T06:46:24.683" v="12"/>
          <ac:spMkLst>
            <pc:docMk/>
            <pc:sldMk cId="2888039256" sldId="295"/>
            <ac:spMk id="87" creationId="{16D79FAB-AC59-4662-A29C-BA367CA84F8E}"/>
          </ac:spMkLst>
        </pc:spChg>
        <pc:spChg chg="add mod">
          <ac:chgData name="Filippo Acconcia" userId="844af49c-a8a0-47ac-a7dd-14a44b60cd18" providerId="ADAL" clId="{998C6BF7-482B-421C-8ECC-9091B23559F6}" dt="2022-04-02T06:53:59.778" v="561" actId="552"/>
          <ac:spMkLst>
            <pc:docMk/>
            <pc:sldMk cId="2888039256" sldId="295"/>
            <ac:spMk id="88" creationId="{5F141403-98E2-44F3-856D-84F9A0EADDA5}"/>
          </ac:spMkLst>
        </pc:spChg>
        <pc:spChg chg="mod">
          <ac:chgData name="Filippo Acconcia" userId="844af49c-a8a0-47ac-a7dd-14a44b60cd18" providerId="ADAL" clId="{998C6BF7-482B-421C-8ECC-9091B23559F6}" dt="2022-03-24T06:49:01.329" v="13"/>
          <ac:spMkLst>
            <pc:docMk/>
            <pc:sldMk cId="2888039256" sldId="295"/>
            <ac:spMk id="92" creationId="{1962CEFB-166A-4063-9C2C-61D6D5A1C255}"/>
          </ac:spMkLst>
        </pc:spChg>
        <pc:spChg chg="mod">
          <ac:chgData name="Filippo Acconcia" userId="844af49c-a8a0-47ac-a7dd-14a44b60cd18" providerId="ADAL" clId="{998C6BF7-482B-421C-8ECC-9091B23559F6}" dt="2022-03-24T06:49:01.329" v="13"/>
          <ac:spMkLst>
            <pc:docMk/>
            <pc:sldMk cId="2888039256" sldId="295"/>
            <ac:spMk id="93" creationId="{1EC44456-E8AD-4E5F-808E-A725FFA79347}"/>
          </ac:spMkLst>
        </pc:spChg>
        <pc:spChg chg="mod">
          <ac:chgData name="Filippo Acconcia" userId="844af49c-a8a0-47ac-a7dd-14a44b60cd18" providerId="ADAL" clId="{998C6BF7-482B-421C-8ECC-9091B23559F6}" dt="2022-03-24T06:49:01.329" v="13"/>
          <ac:spMkLst>
            <pc:docMk/>
            <pc:sldMk cId="2888039256" sldId="295"/>
            <ac:spMk id="94" creationId="{AA0F5479-06BD-4196-8889-00116FEDCA5B}"/>
          </ac:spMkLst>
        </pc:spChg>
        <pc:spChg chg="mod">
          <ac:chgData name="Filippo Acconcia" userId="844af49c-a8a0-47ac-a7dd-14a44b60cd18" providerId="ADAL" clId="{998C6BF7-482B-421C-8ECC-9091B23559F6}" dt="2022-03-24T06:49:01.329" v="13"/>
          <ac:spMkLst>
            <pc:docMk/>
            <pc:sldMk cId="2888039256" sldId="295"/>
            <ac:spMk id="95" creationId="{E55E1A0A-B7E9-4F2B-90CB-6A1FB6F3E213}"/>
          </ac:spMkLst>
        </pc:spChg>
        <pc:spChg chg="add mod">
          <ac:chgData name="Filippo Acconcia" userId="844af49c-a8a0-47ac-a7dd-14a44b60cd18" providerId="ADAL" clId="{998C6BF7-482B-421C-8ECC-9091B23559F6}" dt="2022-03-24T06:49:03.279" v="14" actId="1076"/>
          <ac:spMkLst>
            <pc:docMk/>
            <pc:sldMk cId="2888039256" sldId="295"/>
            <ac:spMk id="96" creationId="{970C19F9-AB05-4498-A2B2-2E944F559A7E}"/>
          </ac:spMkLst>
        </pc:spChg>
        <pc:spChg chg="mod topLvl">
          <ac:chgData name="Filippo Acconcia" userId="844af49c-a8a0-47ac-a7dd-14a44b60cd18" providerId="ADAL" clId="{998C6BF7-482B-421C-8ECC-9091B23559F6}" dt="2022-04-02T06:46:51.777" v="510" actId="164"/>
          <ac:spMkLst>
            <pc:docMk/>
            <pc:sldMk cId="2888039256" sldId="295"/>
            <ac:spMk id="98" creationId="{980843F9-B073-4F48-A0F2-BDCB60A82DCF}"/>
          </ac:spMkLst>
        </pc:spChg>
        <pc:spChg chg="mod topLvl">
          <ac:chgData name="Filippo Acconcia" userId="844af49c-a8a0-47ac-a7dd-14a44b60cd18" providerId="ADAL" clId="{998C6BF7-482B-421C-8ECC-9091B23559F6}" dt="2022-04-02T06:46:51.777" v="510" actId="164"/>
          <ac:spMkLst>
            <pc:docMk/>
            <pc:sldMk cId="2888039256" sldId="295"/>
            <ac:spMk id="99" creationId="{A1F4BF96-A504-4862-9A59-D54620FC3923}"/>
          </ac:spMkLst>
        </pc:spChg>
        <pc:spChg chg="mod topLvl">
          <ac:chgData name="Filippo Acconcia" userId="844af49c-a8a0-47ac-a7dd-14a44b60cd18" providerId="ADAL" clId="{998C6BF7-482B-421C-8ECC-9091B23559F6}" dt="2022-04-02T06:46:40.010" v="508" actId="164"/>
          <ac:spMkLst>
            <pc:docMk/>
            <pc:sldMk cId="2888039256" sldId="295"/>
            <ac:spMk id="101" creationId="{967F4E44-D8F5-471E-9678-CD03AA1FCD10}"/>
          </ac:spMkLst>
        </pc:spChg>
        <pc:spChg chg="mod topLvl">
          <ac:chgData name="Filippo Acconcia" userId="844af49c-a8a0-47ac-a7dd-14a44b60cd18" providerId="ADAL" clId="{998C6BF7-482B-421C-8ECC-9091B23559F6}" dt="2022-04-02T06:46:40.010" v="508" actId="164"/>
          <ac:spMkLst>
            <pc:docMk/>
            <pc:sldMk cId="2888039256" sldId="295"/>
            <ac:spMk id="102" creationId="{48F5E098-7612-4944-8A22-396DC25216EF}"/>
          </ac:spMkLst>
        </pc:spChg>
        <pc:spChg chg="mod topLvl">
          <ac:chgData name="Filippo Acconcia" userId="844af49c-a8a0-47ac-a7dd-14a44b60cd18" providerId="ADAL" clId="{998C6BF7-482B-421C-8ECC-9091B23559F6}" dt="2022-04-02T06:46:40.010" v="508" actId="164"/>
          <ac:spMkLst>
            <pc:docMk/>
            <pc:sldMk cId="2888039256" sldId="295"/>
            <ac:spMk id="103" creationId="{7CB7C46F-912B-4E3C-B0B2-13A0A58A3DF9}"/>
          </ac:spMkLst>
        </pc:spChg>
        <pc:spChg chg="mod topLvl">
          <ac:chgData name="Filippo Acconcia" userId="844af49c-a8a0-47ac-a7dd-14a44b60cd18" providerId="ADAL" clId="{998C6BF7-482B-421C-8ECC-9091B23559F6}" dt="2022-04-02T06:46:40.010" v="508" actId="164"/>
          <ac:spMkLst>
            <pc:docMk/>
            <pc:sldMk cId="2888039256" sldId="295"/>
            <ac:spMk id="118" creationId="{6D9C65CF-BBA6-4772-88A4-8C552C93356F}"/>
          </ac:spMkLst>
        </pc:spChg>
        <pc:spChg chg="del">
          <ac:chgData name="Filippo Acconcia" userId="844af49c-a8a0-47ac-a7dd-14a44b60cd18" providerId="ADAL" clId="{998C6BF7-482B-421C-8ECC-9091B23559F6}" dt="2022-03-24T06:46:08.556" v="11" actId="478"/>
          <ac:spMkLst>
            <pc:docMk/>
            <pc:sldMk cId="2888039256" sldId="295"/>
            <ac:spMk id="126" creationId="{25761FC0-70C3-4108-BF28-64A00E5C9F72}"/>
          </ac:spMkLst>
        </pc:spChg>
        <pc:spChg chg="del">
          <ac:chgData name="Filippo Acconcia" userId="844af49c-a8a0-47ac-a7dd-14a44b60cd18" providerId="ADAL" clId="{998C6BF7-482B-421C-8ECC-9091B23559F6}" dt="2022-03-24T06:46:08.556" v="11" actId="478"/>
          <ac:spMkLst>
            <pc:docMk/>
            <pc:sldMk cId="2888039256" sldId="295"/>
            <ac:spMk id="127" creationId="{B213346A-3E5F-4D11-BC55-514300ACB90E}"/>
          </ac:spMkLst>
        </pc:spChg>
        <pc:spChg chg="mod">
          <ac:chgData name="Filippo Acconcia" userId="844af49c-a8a0-47ac-a7dd-14a44b60cd18" providerId="ADAL" clId="{998C6BF7-482B-421C-8ECC-9091B23559F6}" dt="2022-03-24T06:49:24.375" v="22"/>
          <ac:spMkLst>
            <pc:docMk/>
            <pc:sldMk cId="2888039256" sldId="295"/>
            <ac:spMk id="130" creationId="{511B1A61-1D3C-493D-93F6-4E4BF6C94E63}"/>
          </ac:spMkLst>
        </pc:spChg>
        <pc:spChg chg="mod">
          <ac:chgData name="Filippo Acconcia" userId="844af49c-a8a0-47ac-a7dd-14a44b60cd18" providerId="ADAL" clId="{998C6BF7-482B-421C-8ECC-9091B23559F6}" dt="2022-03-24T06:49:24.375" v="22"/>
          <ac:spMkLst>
            <pc:docMk/>
            <pc:sldMk cId="2888039256" sldId="295"/>
            <ac:spMk id="131" creationId="{FBF230F3-D7C1-4B9C-A85E-26C6B0C04159}"/>
          </ac:spMkLst>
        </pc:spChg>
        <pc:spChg chg="mod">
          <ac:chgData name="Filippo Acconcia" userId="844af49c-a8a0-47ac-a7dd-14a44b60cd18" providerId="ADAL" clId="{998C6BF7-482B-421C-8ECC-9091B23559F6}" dt="2022-03-24T06:49:24.375" v="22"/>
          <ac:spMkLst>
            <pc:docMk/>
            <pc:sldMk cId="2888039256" sldId="295"/>
            <ac:spMk id="132" creationId="{BF7DE380-7CDC-4774-A543-97207DE32659}"/>
          </ac:spMkLst>
        </pc:spChg>
        <pc:spChg chg="mod">
          <ac:chgData name="Filippo Acconcia" userId="844af49c-a8a0-47ac-a7dd-14a44b60cd18" providerId="ADAL" clId="{998C6BF7-482B-421C-8ECC-9091B23559F6}" dt="2022-03-24T06:49:24.375" v="22"/>
          <ac:spMkLst>
            <pc:docMk/>
            <pc:sldMk cId="2888039256" sldId="295"/>
            <ac:spMk id="133" creationId="{E9C011D7-C55C-4FCB-B647-F6F988132127}"/>
          </ac:spMkLst>
        </pc:spChg>
        <pc:spChg chg="mod">
          <ac:chgData name="Filippo Acconcia" userId="844af49c-a8a0-47ac-a7dd-14a44b60cd18" providerId="ADAL" clId="{998C6BF7-482B-421C-8ECC-9091B23559F6}" dt="2022-03-24T06:49:24.375" v="22"/>
          <ac:spMkLst>
            <pc:docMk/>
            <pc:sldMk cId="2888039256" sldId="295"/>
            <ac:spMk id="134" creationId="{FE141C4D-94C2-4515-AE49-967D1E1755D3}"/>
          </ac:spMkLst>
        </pc:spChg>
        <pc:spChg chg="mod">
          <ac:chgData name="Filippo Acconcia" userId="844af49c-a8a0-47ac-a7dd-14a44b60cd18" providerId="ADAL" clId="{998C6BF7-482B-421C-8ECC-9091B23559F6}" dt="2022-03-24T06:49:24.375" v="22"/>
          <ac:spMkLst>
            <pc:docMk/>
            <pc:sldMk cId="2888039256" sldId="295"/>
            <ac:spMk id="135" creationId="{9FFC2E81-5E01-4053-A717-E2EFAC290499}"/>
          </ac:spMkLst>
        </pc:spChg>
        <pc:spChg chg="mod">
          <ac:chgData name="Filippo Acconcia" userId="844af49c-a8a0-47ac-a7dd-14a44b60cd18" providerId="ADAL" clId="{998C6BF7-482B-421C-8ECC-9091B23559F6}" dt="2022-03-24T06:49:24.375" v="22"/>
          <ac:spMkLst>
            <pc:docMk/>
            <pc:sldMk cId="2888039256" sldId="295"/>
            <ac:spMk id="136" creationId="{31D3AC15-8EF8-4BBC-9067-0327E518F4C7}"/>
          </ac:spMkLst>
        </pc:spChg>
        <pc:spChg chg="mod">
          <ac:chgData name="Filippo Acconcia" userId="844af49c-a8a0-47ac-a7dd-14a44b60cd18" providerId="ADAL" clId="{998C6BF7-482B-421C-8ECC-9091B23559F6}" dt="2022-03-24T06:49:24.375" v="22"/>
          <ac:spMkLst>
            <pc:docMk/>
            <pc:sldMk cId="2888039256" sldId="295"/>
            <ac:spMk id="137" creationId="{EBAC89FE-F83B-4EB9-BB64-A0B9CDEF4B3E}"/>
          </ac:spMkLst>
        </pc:spChg>
        <pc:spChg chg="mod">
          <ac:chgData name="Filippo Acconcia" userId="844af49c-a8a0-47ac-a7dd-14a44b60cd18" providerId="ADAL" clId="{998C6BF7-482B-421C-8ECC-9091B23559F6}" dt="2022-03-24T06:49:24.375" v="22"/>
          <ac:spMkLst>
            <pc:docMk/>
            <pc:sldMk cId="2888039256" sldId="295"/>
            <ac:spMk id="138" creationId="{FEE2621A-C148-4FC8-A92A-D0FED4A5BC48}"/>
          </ac:spMkLst>
        </pc:spChg>
        <pc:spChg chg="mod">
          <ac:chgData name="Filippo Acconcia" userId="844af49c-a8a0-47ac-a7dd-14a44b60cd18" providerId="ADAL" clId="{998C6BF7-482B-421C-8ECC-9091B23559F6}" dt="2022-03-24T06:49:24.375" v="22"/>
          <ac:spMkLst>
            <pc:docMk/>
            <pc:sldMk cId="2888039256" sldId="295"/>
            <ac:spMk id="139" creationId="{46655F57-F83F-4108-8A96-27F96A8E2C95}"/>
          </ac:spMkLst>
        </pc:spChg>
        <pc:spChg chg="mod">
          <ac:chgData name="Filippo Acconcia" userId="844af49c-a8a0-47ac-a7dd-14a44b60cd18" providerId="ADAL" clId="{998C6BF7-482B-421C-8ECC-9091B23559F6}" dt="2022-04-02T06:44:55.070" v="495" actId="20577"/>
          <ac:spMkLst>
            <pc:docMk/>
            <pc:sldMk cId="2888039256" sldId="295"/>
            <ac:spMk id="140" creationId="{13B21C2F-3AD6-46FC-A4B5-C2AF1ECCA40C}"/>
          </ac:spMkLst>
        </pc:spChg>
        <pc:spChg chg="mod">
          <ac:chgData name="Filippo Acconcia" userId="844af49c-a8a0-47ac-a7dd-14a44b60cd18" providerId="ADAL" clId="{998C6BF7-482B-421C-8ECC-9091B23559F6}" dt="2022-03-24T06:49:24.375" v="22"/>
          <ac:spMkLst>
            <pc:docMk/>
            <pc:sldMk cId="2888039256" sldId="295"/>
            <ac:spMk id="141" creationId="{532540F2-D026-45ED-93B1-B31ADF84B78B}"/>
          </ac:spMkLst>
        </pc:spChg>
        <pc:spChg chg="mod">
          <ac:chgData name="Filippo Acconcia" userId="844af49c-a8a0-47ac-a7dd-14a44b60cd18" providerId="ADAL" clId="{998C6BF7-482B-421C-8ECC-9091B23559F6}" dt="2022-03-24T06:49:24.375" v="22"/>
          <ac:spMkLst>
            <pc:docMk/>
            <pc:sldMk cId="2888039256" sldId="295"/>
            <ac:spMk id="142" creationId="{7A11009D-3937-4B9A-ABE7-23FB2FAF6E92}"/>
          </ac:spMkLst>
        </pc:spChg>
        <pc:spChg chg="mod">
          <ac:chgData name="Filippo Acconcia" userId="844af49c-a8a0-47ac-a7dd-14a44b60cd18" providerId="ADAL" clId="{998C6BF7-482B-421C-8ECC-9091B23559F6}" dt="2022-03-24T06:49:24.375" v="22"/>
          <ac:spMkLst>
            <pc:docMk/>
            <pc:sldMk cId="2888039256" sldId="295"/>
            <ac:spMk id="143" creationId="{5FF821D0-D63B-4CBB-8F59-39EEA071FB1C}"/>
          </ac:spMkLst>
        </pc:spChg>
        <pc:spChg chg="mod">
          <ac:chgData name="Filippo Acconcia" userId="844af49c-a8a0-47ac-a7dd-14a44b60cd18" providerId="ADAL" clId="{998C6BF7-482B-421C-8ECC-9091B23559F6}" dt="2022-03-24T06:49:24.375" v="22"/>
          <ac:spMkLst>
            <pc:docMk/>
            <pc:sldMk cId="2888039256" sldId="295"/>
            <ac:spMk id="144" creationId="{63F540F3-230B-477D-A1BC-F04AF48F7BDD}"/>
          </ac:spMkLst>
        </pc:spChg>
        <pc:spChg chg="add mod">
          <ac:chgData name="Filippo Acconcia" userId="844af49c-a8a0-47ac-a7dd-14a44b60cd18" providerId="ADAL" clId="{998C6BF7-482B-421C-8ECC-9091B23559F6}" dt="2022-04-02T06:53:59.778" v="561" actId="552"/>
          <ac:spMkLst>
            <pc:docMk/>
            <pc:sldMk cId="2888039256" sldId="295"/>
            <ac:spMk id="147" creationId="{0F7A31F7-4AAC-46BF-B86E-1B1092BFED7D}"/>
          </ac:spMkLst>
        </pc:spChg>
        <pc:spChg chg="add mod">
          <ac:chgData name="Filippo Acconcia" userId="844af49c-a8a0-47ac-a7dd-14a44b60cd18" providerId="ADAL" clId="{998C6BF7-482B-421C-8ECC-9091B23559F6}" dt="2022-04-02T06:46:56.021" v="511" actId="1037"/>
          <ac:spMkLst>
            <pc:docMk/>
            <pc:sldMk cId="2888039256" sldId="295"/>
            <ac:spMk id="148" creationId="{B475F295-EC05-4EBB-8B70-9E4A2516E1AA}"/>
          </ac:spMkLst>
        </pc:spChg>
        <pc:spChg chg="mod">
          <ac:chgData name="Filippo Acconcia" userId="844af49c-a8a0-47ac-a7dd-14a44b60cd18" providerId="ADAL" clId="{998C6BF7-482B-421C-8ECC-9091B23559F6}" dt="2022-03-24T06:49:33.835" v="24"/>
          <ac:spMkLst>
            <pc:docMk/>
            <pc:sldMk cId="2888039256" sldId="295"/>
            <ac:spMk id="150" creationId="{9DC5C0F6-0784-4E92-9595-E3781FFB4174}"/>
          </ac:spMkLst>
        </pc:spChg>
        <pc:spChg chg="mod">
          <ac:chgData name="Filippo Acconcia" userId="844af49c-a8a0-47ac-a7dd-14a44b60cd18" providerId="ADAL" clId="{998C6BF7-482B-421C-8ECC-9091B23559F6}" dt="2022-03-24T06:49:33.835" v="24"/>
          <ac:spMkLst>
            <pc:docMk/>
            <pc:sldMk cId="2888039256" sldId="295"/>
            <ac:spMk id="151" creationId="{4F0AC9F4-FDD2-40F7-83D3-E70877C64421}"/>
          </ac:spMkLst>
        </pc:spChg>
        <pc:spChg chg="mod">
          <ac:chgData name="Filippo Acconcia" userId="844af49c-a8a0-47ac-a7dd-14a44b60cd18" providerId="ADAL" clId="{998C6BF7-482B-421C-8ECC-9091B23559F6}" dt="2022-03-24T06:49:33.835" v="24"/>
          <ac:spMkLst>
            <pc:docMk/>
            <pc:sldMk cId="2888039256" sldId="295"/>
            <ac:spMk id="152" creationId="{181825F4-6099-49DE-8668-2A9E3D8810EE}"/>
          </ac:spMkLst>
        </pc:spChg>
        <pc:spChg chg="mod">
          <ac:chgData name="Filippo Acconcia" userId="844af49c-a8a0-47ac-a7dd-14a44b60cd18" providerId="ADAL" clId="{998C6BF7-482B-421C-8ECC-9091B23559F6}" dt="2022-03-24T06:49:33.835" v="24"/>
          <ac:spMkLst>
            <pc:docMk/>
            <pc:sldMk cId="2888039256" sldId="295"/>
            <ac:spMk id="153" creationId="{5FD8853A-F9E6-4CC6-B36D-61B887BE9E2A}"/>
          </ac:spMkLst>
        </pc:spChg>
        <pc:spChg chg="add mod">
          <ac:chgData name="Filippo Acconcia" userId="844af49c-a8a0-47ac-a7dd-14a44b60cd18" providerId="ADAL" clId="{998C6BF7-482B-421C-8ECC-9091B23559F6}" dt="2022-04-02T06:53:59.778" v="561" actId="552"/>
          <ac:spMkLst>
            <pc:docMk/>
            <pc:sldMk cId="2888039256" sldId="295"/>
            <ac:spMk id="156" creationId="{48DC79B3-B365-4875-9242-0B92EE392CF8}"/>
          </ac:spMkLst>
        </pc:spChg>
        <pc:spChg chg="add mod">
          <ac:chgData name="Filippo Acconcia" userId="844af49c-a8a0-47ac-a7dd-14a44b60cd18" providerId="ADAL" clId="{998C6BF7-482B-421C-8ECC-9091B23559F6}" dt="2022-03-24T06:49:41.911" v="28" actId="20577"/>
          <ac:spMkLst>
            <pc:docMk/>
            <pc:sldMk cId="2888039256" sldId="295"/>
            <ac:spMk id="157" creationId="{A723373F-D198-44A9-8229-65948A422739}"/>
          </ac:spMkLst>
        </pc:spChg>
        <pc:spChg chg="mod">
          <ac:chgData name="Filippo Acconcia" userId="844af49c-a8a0-47ac-a7dd-14a44b60cd18" providerId="ADAL" clId="{998C6BF7-482B-421C-8ECC-9091B23559F6}" dt="2022-04-02T06:53:59.778" v="561" actId="552"/>
          <ac:spMkLst>
            <pc:docMk/>
            <pc:sldMk cId="2888039256" sldId="295"/>
            <ac:spMk id="163" creationId="{ADDDBA1C-7034-43D9-8DED-BFB514D1D6B6}"/>
          </ac:spMkLst>
        </pc:spChg>
        <pc:spChg chg="mod">
          <ac:chgData name="Filippo Acconcia" userId="844af49c-a8a0-47ac-a7dd-14a44b60cd18" providerId="ADAL" clId="{998C6BF7-482B-421C-8ECC-9091B23559F6}" dt="2022-04-02T06:53:50.028" v="560" actId="553"/>
          <ac:spMkLst>
            <pc:docMk/>
            <pc:sldMk cId="2888039256" sldId="295"/>
            <ac:spMk id="164" creationId="{C598F0F0-7F50-4217-820A-313BB815C59F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167" creationId="{E73BF370-AABD-4AD4-B139-D1FE19DA32CE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168" creationId="{6DDD9A39-49F2-461D-8B5E-EE5394A013DF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169" creationId="{048A82DD-A454-4857-B40C-48F4A23FFCE7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170" creationId="{CBD479AC-7A1B-42E8-B8A7-561A2235D9C2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171" creationId="{5433B2F3-3B74-4662-B104-9D51C23987B5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173" creationId="{E730FC9B-F3E4-4F7D-B9DC-CE0A95AAC671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181" creationId="{BB805933-CAE9-4354-B7EE-E4CA0FD4F7A0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183" creationId="{B42A14A6-6D12-4A73-AEA1-C410BCA066E5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185" creationId="{751BAED4-CD23-4BF1-AC48-A7D105FBB484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186" creationId="{DDF651C1-6C69-4479-8B59-DEDAB16C5434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187" creationId="{3CCDD469-6E59-471A-BE99-F644BA876E11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188" creationId="{54EDB50E-C0D8-4B54-B3E7-0E2281E4AD5E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189" creationId="{8AE13744-DCD1-4506-B31E-389B600B71FD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190" creationId="{6B078CF0-7D74-4064-8C27-8EA844EEA63A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191" creationId="{68816AA2-A272-4FED-BE63-0C966F146F8B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192" creationId="{077AFF7C-A624-4EA6-B4F0-0BA07AE6FB51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193" creationId="{4DDD943E-3134-44E8-9572-1F45BA2E43B7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194" creationId="{54DC69DE-25DE-4279-8044-2CE2E1971A93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195" creationId="{2BA12012-6486-48C0-B4F5-F54BDF616579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196" creationId="{9960E007-57F0-41D7-A869-00AC2AF4D5A3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197" creationId="{D161D12A-9A44-4E01-99B4-07E44104BC4C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199" creationId="{92D9B2EF-99B1-4C7E-84A9-E5C11447AF4A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200" creationId="{A85383B7-33C1-46B5-AF5D-46BEC9947A8F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201" creationId="{8FDD5798-C67B-4824-8D1C-9B17575FCCBE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202" creationId="{8F2ECBEF-C578-46E9-9734-0A5CB6A8DD87}"/>
          </ac:spMkLst>
        </pc:spChg>
        <pc:spChg chg="mod">
          <ac:chgData name="Filippo Acconcia" userId="844af49c-a8a0-47ac-a7dd-14a44b60cd18" providerId="ADAL" clId="{998C6BF7-482B-421C-8ECC-9091B23559F6}" dt="2022-04-02T06:34:16.173" v="146"/>
          <ac:spMkLst>
            <pc:docMk/>
            <pc:sldMk cId="2888039256" sldId="295"/>
            <ac:spMk id="203" creationId="{FEF24FE8-C8AF-4052-9F1D-8024859FB2E9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07" creationId="{223961EF-EA8F-458F-8515-790DD280AF35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08" creationId="{C63FDFBB-66E2-4E04-8304-F3890EC89FC8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09" creationId="{4EE7947A-8435-49EB-8293-A7AEA595D912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10" creationId="{55EA0D00-2975-4E31-98E2-3EB683230033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11" creationId="{7D255FC8-0269-48B1-B16E-2728DE39578B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13" creationId="{A0A837FA-9193-427D-BB56-46E25250A9B0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21" creationId="{424BFAD0-0634-452A-9099-62819AD7ED38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23" creationId="{026A2212-9077-418D-837A-10BC86831521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25" creationId="{9F3CB951-EB3A-4BA8-A09F-C255FF623719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26" creationId="{2303C595-20F1-42E6-96A6-DF09C8043A86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27" creationId="{D774693F-FBB3-4DFD-9790-F9FC7590FFA4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28" creationId="{5A9664E0-A83B-4976-AAED-0A2752D67557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29" creationId="{F278DC90-5363-4CC4-804F-A1CE744AB985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30" creationId="{AC986F28-1A2B-42DA-BD85-6D5FF6C8D765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31" creationId="{FE821C3E-97D4-4ACC-9A69-FDE8E1C55DB5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32" creationId="{6351DB96-545E-4568-A5E1-9C6C5FD9160D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33" creationId="{96D87A7C-FD1B-4425-BEA8-CB0684AC15F3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34" creationId="{34A237A4-D324-4127-A96D-183E98594289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35" creationId="{A52AA168-C50D-4208-BDE4-C2E588671D9A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36" creationId="{F1E301CC-9D4F-48EB-9CBE-1C577FBC8EB0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37" creationId="{CA6277F7-B4A5-4638-B930-4EE6502A72CD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39" creationId="{6C4647FE-9962-40B6-96D0-F545299BE6D2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40" creationId="{1F8A7C67-782C-4832-ACDB-4DCEFC946471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41" creationId="{7FFD3AFA-B229-4AB8-8F89-F21AAAA274D1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42" creationId="{0BBF7393-4D71-4F9C-989B-2CB7669C09DA}"/>
          </ac:spMkLst>
        </pc:spChg>
        <pc:spChg chg="mod">
          <ac:chgData name="Filippo Acconcia" userId="844af49c-a8a0-47ac-a7dd-14a44b60cd18" providerId="ADAL" clId="{998C6BF7-482B-421C-8ECC-9091B23559F6}" dt="2022-04-02T06:34:35.196" v="190"/>
          <ac:spMkLst>
            <pc:docMk/>
            <pc:sldMk cId="2888039256" sldId="295"/>
            <ac:spMk id="243" creationId="{3B73BA29-DF10-4504-B831-6A20C259ADB9}"/>
          </ac:spMkLst>
        </pc:spChg>
        <pc:spChg chg="mod topLvl">
          <ac:chgData name="Filippo Acconcia" userId="844af49c-a8a0-47ac-a7dd-14a44b60cd18" providerId="ADAL" clId="{998C6BF7-482B-421C-8ECC-9091B23559F6}" dt="2022-04-02T06:49:03.657" v="542" actId="164"/>
          <ac:spMkLst>
            <pc:docMk/>
            <pc:sldMk cId="2888039256" sldId="295"/>
            <ac:spMk id="247" creationId="{E5A90B38-A891-4103-A485-58AAF3F6CB37}"/>
          </ac:spMkLst>
        </pc:spChg>
        <pc:spChg chg="mod topLvl">
          <ac:chgData name="Filippo Acconcia" userId="844af49c-a8a0-47ac-a7dd-14a44b60cd18" providerId="ADAL" clId="{998C6BF7-482B-421C-8ECC-9091B23559F6}" dt="2022-04-02T06:49:03.657" v="542" actId="164"/>
          <ac:spMkLst>
            <pc:docMk/>
            <pc:sldMk cId="2888039256" sldId="295"/>
            <ac:spMk id="248" creationId="{492BF0BE-BA36-4A3E-8D41-977ACD949C82}"/>
          </ac:spMkLst>
        </pc:spChg>
        <pc:spChg chg="mod topLvl">
          <ac:chgData name="Filippo Acconcia" userId="844af49c-a8a0-47ac-a7dd-14a44b60cd18" providerId="ADAL" clId="{998C6BF7-482B-421C-8ECC-9091B23559F6}" dt="2022-04-02T06:49:03.657" v="542" actId="164"/>
          <ac:spMkLst>
            <pc:docMk/>
            <pc:sldMk cId="2888039256" sldId="295"/>
            <ac:spMk id="249" creationId="{EBD6ED03-E6DD-4986-B87C-1B08C4B72F85}"/>
          </ac:spMkLst>
        </pc:spChg>
        <pc:spChg chg="del mod topLvl">
          <ac:chgData name="Filippo Acconcia" userId="844af49c-a8a0-47ac-a7dd-14a44b60cd18" providerId="ADAL" clId="{998C6BF7-482B-421C-8ECC-9091B23559F6}" dt="2022-04-02T06:41:02.484" v="243" actId="478"/>
          <ac:spMkLst>
            <pc:docMk/>
            <pc:sldMk cId="2888039256" sldId="295"/>
            <ac:spMk id="250" creationId="{5E7CE525-7692-4573-92EB-44C235AE7C2D}"/>
          </ac:spMkLst>
        </pc:spChg>
        <pc:spChg chg="mod topLvl">
          <ac:chgData name="Filippo Acconcia" userId="844af49c-a8a0-47ac-a7dd-14a44b60cd18" providerId="ADAL" clId="{998C6BF7-482B-421C-8ECC-9091B23559F6}" dt="2022-04-02T06:49:03.657" v="542" actId="164"/>
          <ac:spMkLst>
            <pc:docMk/>
            <pc:sldMk cId="2888039256" sldId="295"/>
            <ac:spMk id="251" creationId="{FA1A5BD9-5E8F-43F9-9380-5FD61E896254}"/>
          </ac:spMkLst>
        </pc:spChg>
        <pc:spChg chg="mod topLvl">
          <ac:chgData name="Filippo Acconcia" userId="844af49c-a8a0-47ac-a7dd-14a44b60cd18" providerId="ADAL" clId="{998C6BF7-482B-421C-8ECC-9091B23559F6}" dt="2022-04-02T06:49:03.657" v="542" actId="164"/>
          <ac:spMkLst>
            <pc:docMk/>
            <pc:sldMk cId="2888039256" sldId="295"/>
            <ac:spMk id="253" creationId="{8295EDDF-5D40-41E6-B58B-30BE0BDDE76D}"/>
          </ac:spMkLst>
        </pc:spChg>
        <pc:spChg chg="mod topLvl">
          <ac:chgData name="Filippo Acconcia" userId="844af49c-a8a0-47ac-a7dd-14a44b60cd18" providerId="ADAL" clId="{998C6BF7-482B-421C-8ECC-9091B23559F6}" dt="2022-04-02T06:49:03.657" v="542" actId="164"/>
          <ac:spMkLst>
            <pc:docMk/>
            <pc:sldMk cId="2888039256" sldId="295"/>
            <ac:spMk id="261" creationId="{792D36BD-E73F-4BDF-91F9-A79226F6D27F}"/>
          </ac:spMkLst>
        </pc:spChg>
        <pc:spChg chg="mod topLvl">
          <ac:chgData name="Filippo Acconcia" userId="844af49c-a8a0-47ac-a7dd-14a44b60cd18" providerId="ADAL" clId="{998C6BF7-482B-421C-8ECC-9091B23559F6}" dt="2022-04-02T06:49:03.657" v="542" actId="164"/>
          <ac:spMkLst>
            <pc:docMk/>
            <pc:sldMk cId="2888039256" sldId="295"/>
            <ac:spMk id="263" creationId="{68804833-8CC4-4B44-8D0A-4236BD81E4FC}"/>
          </ac:spMkLst>
        </pc:spChg>
        <pc:spChg chg="del mod topLvl">
          <ac:chgData name="Filippo Acconcia" userId="844af49c-a8a0-47ac-a7dd-14a44b60cd18" providerId="ADAL" clId="{998C6BF7-482B-421C-8ECC-9091B23559F6}" dt="2022-04-02T06:42:52.702" v="370" actId="478"/>
          <ac:spMkLst>
            <pc:docMk/>
            <pc:sldMk cId="2888039256" sldId="295"/>
            <ac:spMk id="265" creationId="{30C9A542-2B06-4193-A67E-A13E75D879AD}"/>
          </ac:spMkLst>
        </pc:spChg>
        <pc:spChg chg="mod topLvl">
          <ac:chgData name="Filippo Acconcia" userId="844af49c-a8a0-47ac-a7dd-14a44b60cd18" providerId="ADAL" clId="{998C6BF7-482B-421C-8ECC-9091B23559F6}" dt="2022-04-02T06:42:10.072" v="322" actId="164"/>
          <ac:spMkLst>
            <pc:docMk/>
            <pc:sldMk cId="2888039256" sldId="295"/>
            <ac:spMk id="266" creationId="{1EC665D7-B7EF-4428-ABA5-BE11D59AF7D0}"/>
          </ac:spMkLst>
        </pc:spChg>
        <pc:spChg chg="mod topLvl">
          <ac:chgData name="Filippo Acconcia" userId="844af49c-a8a0-47ac-a7dd-14a44b60cd18" providerId="ADAL" clId="{998C6BF7-482B-421C-8ECC-9091B23559F6}" dt="2022-04-02T06:42:10.072" v="322" actId="164"/>
          <ac:spMkLst>
            <pc:docMk/>
            <pc:sldMk cId="2888039256" sldId="295"/>
            <ac:spMk id="267" creationId="{498A0912-6D0B-4541-95C0-B8CEEC60E289}"/>
          </ac:spMkLst>
        </pc:spChg>
        <pc:spChg chg="mod topLvl">
          <ac:chgData name="Filippo Acconcia" userId="844af49c-a8a0-47ac-a7dd-14a44b60cd18" providerId="ADAL" clId="{998C6BF7-482B-421C-8ECC-9091B23559F6}" dt="2022-04-02T06:42:10.072" v="322" actId="164"/>
          <ac:spMkLst>
            <pc:docMk/>
            <pc:sldMk cId="2888039256" sldId="295"/>
            <ac:spMk id="268" creationId="{FA8BAE55-E9C8-4073-8119-B840A467BABE}"/>
          </ac:spMkLst>
        </pc:spChg>
        <pc:spChg chg="mod topLvl">
          <ac:chgData name="Filippo Acconcia" userId="844af49c-a8a0-47ac-a7dd-14a44b60cd18" providerId="ADAL" clId="{998C6BF7-482B-421C-8ECC-9091B23559F6}" dt="2022-04-02T06:42:10.072" v="322" actId="164"/>
          <ac:spMkLst>
            <pc:docMk/>
            <pc:sldMk cId="2888039256" sldId="295"/>
            <ac:spMk id="269" creationId="{A06CA732-D1EE-43C4-AFC1-8C6AB2A3F9FE}"/>
          </ac:spMkLst>
        </pc:spChg>
        <pc:spChg chg="mod">
          <ac:chgData name="Filippo Acconcia" userId="844af49c-a8a0-47ac-a7dd-14a44b60cd18" providerId="ADAL" clId="{998C6BF7-482B-421C-8ECC-9091B23559F6}" dt="2022-04-02T06:39:02.401" v="234" actId="165"/>
          <ac:spMkLst>
            <pc:docMk/>
            <pc:sldMk cId="2888039256" sldId="295"/>
            <ac:spMk id="270" creationId="{09722975-5679-4939-8A62-665F7178C7FF}"/>
          </ac:spMkLst>
        </pc:spChg>
        <pc:spChg chg="mod">
          <ac:chgData name="Filippo Acconcia" userId="844af49c-a8a0-47ac-a7dd-14a44b60cd18" providerId="ADAL" clId="{998C6BF7-482B-421C-8ECC-9091B23559F6}" dt="2022-04-02T06:39:02.401" v="234" actId="165"/>
          <ac:spMkLst>
            <pc:docMk/>
            <pc:sldMk cId="2888039256" sldId="295"/>
            <ac:spMk id="271" creationId="{DE41AE24-2A3E-4A1C-97EC-33E69205BBA8}"/>
          </ac:spMkLst>
        </pc:spChg>
        <pc:spChg chg="mod">
          <ac:chgData name="Filippo Acconcia" userId="844af49c-a8a0-47ac-a7dd-14a44b60cd18" providerId="ADAL" clId="{998C6BF7-482B-421C-8ECC-9091B23559F6}" dt="2022-04-02T06:39:02.401" v="234" actId="165"/>
          <ac:spMkLst>
            <pc:docMk/>
            <pc:sldMk cId="2888039256" sldId="295"/>
            <ac:spMk id="272" creationId="{37FE76B0-C799-4FA6-8ABD-10FA7793F4FA}"/>
          </ac:spMkLst>
        </pc:spChg>
        <pc:spChg chg="mod">
          <ac:chgData name="Filippo Acconcia" userId="844af49c-a8a0-47ac-a7dd-14a44b60cd18" providerId="ADAL" clId="{998C6BF7-482B-421C-8ECC-9091B23559F6}" dt="2022-04-02T06:39:02.401" v="234" actId="165"/>
          <ac:spMkLst>
            <pc:docMk/>
            <pc:sldMk cId="2888039256" sldId="295"/>
            <ac:spMk id="273" creationId="{B8254F2E-2740-4802-BCA1-9FBB694FDF38}"/>
          </ac:spMkLst>
        </pc:spChg>
        <pc:spChg chg="mod">
          <ac:chgData name="Filippo Acconcia" userId="844af49c-a8a0-47ac-a7dd-14a44b60cd18" providerId="ADAL" clId="{998C6BF7-482B-421C-8ECC-9091B23559F6}" dt="2022-04-02T06:39:02.401" v="234" actId="165"/>
          <ac:spMkLst>
            <pc:docMk/>
            <pc:sldMk cId="2888039256" sldId="295"/>
            <ac:spMk id="274" creationId="{D395CFF0-8C31-41E6-AD3D-3EFDFD41CF86}"/>
          </ac:spMkLst>
        </pc:spChg>
        <pc:spChg chg="mod">
          <ac:chgData name="Filippo Acconcia" userId="844af49c-a8a0-47ac-a7dd-14a44b60cd18" providerId="ADAL" clId="{998C6BF7-482B-421C-8ECC-9091B23559F6}" dt="2022-04-02T06:39:02.401" v="234" actId="165"/>
          <ac:spMkLst>
            <pc:docMk/>
            <pc:sldMk cId="2888039256" sldId="295"/>
            <ac:spMk id="275" creationId="{2E8ADFED-F321-43DB-BE1A-001E5EB80662}"/>
          </ac:spMkLst>
        </pc:spChg>
        <pc:spChg chg="mod">
          <ac:chgData name="Filippo Acconcia" userId="844af49c-a8a0-47ac-a7dd-14a44b60cd18" providerId="ADAL" clId="{998C6BF7-482B-421C-8ECC-9091B23559F6}" dt="2022-04-02T06:39:02.401" v="234" actId="165"/>
          <ac:spMkLst>
            <pc:docMk/>
            <pc:sldMk cId="2888039256" sldId="295"/>
            <ac:spMk id="276" creationId="{3C36970E-6257-4DED-914A-B1CDFF652221}"/>
          </ac:spMkLst>
        </pc:spChg>
        <pc:spChg chg="mod">
          <ac:chgData name="Filippo Acconcia" userId="844af49c-a8a0-47ac-a7dd-14a44b60cd18" providerId="ADAL" clId="{998C6BF7-482B-421C-8ECC-9091B23559F6}" dt="2022-04-02T06:39:02.401" v="234" actId="165"/>
          <ac:spMkLst>
            <pc:docMk/>
            <pc:sldMk cId="2888039256" sldId="295"/>
            <ac:spMk id="277" creationId="{96CBF167-6556-4682-94B7-B6BC4AD9F987}"/>
          </ac:spMkLst>
        </pc:spChg>
        <pc:spChg chg="mod">
          <ac:chgData name="Filippo Acconcia" userId="844af49c-a8a0-47ac-a7dd-14a44b60cd18" providerId="ADAL" clId="{998C6BF7-482B-421C-8ECC-9091B23559F6}" dt="2022-04-02T06:39:02.401" v="234" actId="165"/>
          <ac:spMkLst>
            <pc:docMk/>
            <pc:sldMk cId="2888039256" sldId="295"/>
            <ac:spMk id="279" creationId="{FCCFFDCD-C08C-4778-B30F-B574FA9DE214}"/>
          </ac:spMkLst>
        </pc:spChg>
        <pc:spChg chg="mod">
          <ac:chgData name="Filippo Acconcia" userId="844af49c-a8a0-47ac-a7dd-14a44b60cd18" providerId="ADAL" clId="{998C6BF7-482B-421C-8ECC-9091B23559F6}" dt="2022-04-02T06:39:02.401" v="234" actId="165"/>
          <ac:spMkLst>
            <pc:docMk/>
            <pc:sldMk cId="2888039256" sldId="295"/>
            <ac:spMk id="280" creationId="{E6F7FC52-E5FD-41CD-8084-89061217E8BC}"/>
          </ac:spMkLst>
        </pc:spChg>
        <pc:spChg chg="mod">
          <ac:chgData name="Filippo Acconcia" userId="844af49c-a8a0-47ac-a7dd-14a44b60cd18" providerId="ADAL" clId="{998C6BF7-482B-421C-8ECC-9091B23559F6}" dt="2022-04-02T06:39:02.401" v="234" actId="165"/>
          <ac:spMkLst>
            <pc:docMk/>
            <pc:sldMk cId="2888039256" sldId="295"/>
            <ac:spMk id="281" creationId="{DC80BA10-63AF-4CE2-8335-FF35DD773E01}"/>
          </ac:spMkLst>
        </pc:spChg>
        <pc:spChg chg="mod">
          <ac:chgData name="Filippo Acconcia" userId="844af49c-a8a0-47ac-a7dd-14a44b60cd18" providerId="ADAL" clId="{998C6BF7-482B-421C-8ECC-9091B23559F6}" dt="2022-04-02T06:39:02.401" v="234" actId="165"/>
          <ac:spMkLst>
            <pc:docMk/>
            <pc:sldMk cId="2888039256" sldId="295"/>
            <ac:spMk id="282" creationId="{14DA91CA-3D70-4A41-AA86-4AD9A0939AAF}"/>
          </ac:spMkLst>
        </pc:spChg>
        <pc:spChg chg="mod">
          <ac:chgData name="Filippo Acconcia" userId="844af49c-a8a0-47ac-a7dd-14a44b60cd18" providerId="ADAL" clId="{998C6BF7-482B-421C-8ECC-9091B23559F6}" dt="2022-04-02T06:39:02.401" v="234" actId="165"/>
          <ac:spMkLst>
            <pc:docMk/>
            <pc:sldMk cId="2888039256" sldId="295"/>
            <ac:spMk id="283" creationId="{E2C8BA88-E15D-49EF-9124-036153E3A9D1}"/>
          </ac:spMkLst>
        </pc:spChg>
        <pc:spChg chg="mod">
          <ac:chgData name="Filippo Acconcia" userId="844af49c-a8a0-47ac-a7dd-14a44b60cd18" providerId="ADAL" clId="{998C6BF7-482B-421C-8ECC-9091B23559F6}" dt="2022-04-02T06:42:11.127" v="323"/>
          <ac:spMkLst>
            <pc:docMk/>
            <pc:sldMk cId="2888039256" sldId="295"/>
            <ac:spMk id="285" creationId="{F908660A-973D-4341-9498-BEFAC1B7E2B0}"/>
          </ac:spMkLst>
        </pc:spChg>
        <pc:spChg chg="mod">
          <ac:chgData name="Filippo Acconcia" userId="844af49c-a8a0-47ac-a7dd-14a44b60cd18" providerId="ADAL" clId="{998C6BF7-482B-421C-8ECC-9091B23559F6}" dt="2022-04-02T06:42:11.127" v="323"/>
          <ac:spMkLst>
            <pc:docMk/>
            <pc:sldMk cId="2888039256" sldId="295"/>
            <ac:spMk id="286" creationId="{80FC49AE-336B-49BC-976C-769B4AF93082}"/>
          </ac:spMkLst>
        </pc:spChg>
        <pc:spChg chg="mod">
          <ac:chgData name="Filippo Acconcia" userId="844af49c-a8a0-47ac-a7dd-14a44b60cd18" providerId="ADAL" clId="{998C6BF7-482B-421C-8ECC-9091B23559F6}" dt="2022-04-02T06:42:11.127" v="323"/>
          <ac:spMkLst>
            <pc:docMk/>
            <pc:sldMk cId="2888039256" sldId="295"/>
            <ac:spMk id="287" creationId="{AF2BA13E-85ED-4E5F-9110-FC5ED094EA59}"/>
          </ac:spMkLst>
        </pc:spChg>
        <pc:spChg chg="mod">
          <ac:chgData name="Filippo Acconcia" userId="844af49c-a8a0-47ac-a7dd-14a44b60cd18" providerId="ADAL" clId="{998C6BF7-482B-421C-8ECC-9091B23559F6}" dt="2022-04-02T06:42:11.127" v="323"/>
          <ac:spMkLst>
            <pc:docMk/>
            <pc:sldMk cId="2888039256" sldId="295"/>
            <ac:spMk id="288" creationId="{A2555F32-8250-491F-A849-66C2C29F5E9D}"/>
          </ac:spMkLst>
        </pc:spChg>
        <pc:spChg chg="add del mod">
          <ac:chgData name="Filippo Acconcia" userId="844af49c-a8a0-47ac-a7dd-14a44b60cd18" providerId="ADAL" clId="{998C6BF7-482B-421C-8ECC-9091B23559F6}" dt="2022-04-02T06:47:14.213" v="521" actId="478"/>
          <ac:spMkLst>
            <pc:docMk/>
            <pc:sldMk cId="2888039256" sldId="295"/>
            <ac:spMk id="289" creationId="{3146D252-954F-41DC-8C46-5D447181C8F5}"/>
          </ac:spMkLst>
        </pc:spChg>
        <pc:spChg chg="add mod">
          <ac:chgData name="Filippo Acconcia" userId="844af49c-a8a0-47ac-a7dd-14a44b60cd18" providerId="ADAL" clId="{998C6BF7-482B-421C-8ECC-9091B23559F6}" dt="2022-04-02T06:53:50.028" v="560" actId="553"/>
          <ac:spMkLst>
            <pc:docMk/>
            <pc:sldMk cId="2888039256" sldId="295"/>
            <ac:spMk id="290" creationId="{071644AA-D8A1-466D-95F0-21903A450386}"/>
          </ac:spMkLst>
        </pc:spChg>
        <pc:spChg chg="add mod">
          <ac:chgData name="Filippo Acconcia" userId="844af49c-a8a0-47ac-a7dd-14a44b60cd18" providerId="ADAL" clId="{998C6BF7-482B-421C-8ECC-9091B23559F6}" dt="2022-04-02T06:49:07.898" v="543" actId="164"/>
          <ac:spMkLst>
            <pc:docMk/>
            <pc:sldMk cId="2888039256" sldId="295"/>
            <ac:spMk id="292" creationId="{66B0CB90-ADCA-40E2-BE82-5D5E627282B4}"/>
          </ac:spMkLst>
        </pc:spChg>
        <pc:spChg chg="add mod">
          <ac:chgData name="Filippo Acconcia" userId="844af49c-a8a0-47ac-a7dd-14a44b60cd18" providerId="ADAL" clId="{998C6BF7-482B-421C-8ECC-9091B23559F6}" dt="2022-04-02T06:49:07.898" v="543" actId="164"/>
          <ac:spMkLst>
            <pc:docMk/>
            <pc:sldMk cId="2888039256" sldId="295"/>
            <ac:spMk id="293" creationId="{B9D9E56A-A4CD-4218-B385-F2B3DA9137DB}"/>
          </ac:spMkLst>
        </pc:spChg>
        <pc:spChg chg="add mod">
          <ac:chgData name="Filippo Acconcia" userId="844af49c-a8a0-47ac-a7dd-14a44b60cd18" providerId="ADAL" clId="{998C6BF7-482B-421C-8ECC-9091B23559F6}" dt="2022-04-02T06:49:07.898" v="543" actId="164"/>
          <ac:spMkLst>
            <pc:docMk/>
            <pc:sldMk cId="2888039256" sldId="295"/>
            <ac:spMk id="294" creationId="{C28B5FEA-C3C0-44AC-BC36-E3B6F536A59A}"/>
          </ac:spMkLst>
        </pc:spChg>
        <pc:spChg chg="add mod">
          <ac:chgData name="Filippo Acconcia" userId="844af49c-a8a0-47ac-a7dd-14a44b60cd18" providerId="ADAL" clId="{998C6BF7-482B-421C-8ECC-9091B23559F6}" dt="2022-04-02T06:49:07.898" v="543" actId="164"/>
          <ac:spMkLst>
            <pc:docMk/>
            <pc:sldMk cId="2888039256" sldId="295"/>
            <ac:spMk id="295" creationId="{B71988FE-7F1A-4542-BA4B-1D77396B44EA}"/>
          </ac:spMkLst>
        </pc:spChg>
        <pc:spChg chg="add mod">
          <ac:chgData name="Filippo Acconcia" userId="844af49c-a8a0-47ac-a7dd-14a44b60cd18" providerId="ADAL" clId="{998C6BF7-482B-421C-8ECC-9091B23559F6}" dt="2022-04-02T06:49:07.898" v="543" actId="164"/>
          <ac:spMkLst>
            <pc:docMk/>
            <pc:sldMk cId="2888039256" sldId="295"/>
            <ac:spMk id="296" creationId="{581AA0AC-5F45-4568-AD3F-8DC3B3288FDE}"/>
          </ac:spMkLst>
        </pc:spChg>
        <pc:spChg chg="mod">
          <ac:chgData name="Filippo Acconcia" userId="844af49c-a8a0-47ac-a7dd-14a44b60cd18" providerId="ADAL" clId="{998C6BF7-482B-421C-8ECC-9091B23559F6}" dt="2022-04-02T06:47:26.188" v="525"/>
          <ac:spMkLst>
            <pc:docMk/>
            <pc:sldMk cId="2888039256" sldId="295"/>
            <ac:spMk id="298" creationId="{7CD011B4-6BDB-440C-96AA-E7F60D3D8A32}"/>
          </ac:spMkLst>
        </pc:spChg>
        <pc:spChg chg="mod">
          <ac:chgData name="Filippo Acconcia" userId="844af49c-a8a0-47ac-a7dd-14a44b60cd18" providerId="ADAL" clId="{998C6BF7-482B-421C-8ECC-9091B23559F6}" dt="2022-04-02T06:47:26.188" v="525"/>
          <ac:spMkLst>
            <pc:docMk/>
            <pc:sldMk cId="2888039256" sldId="295"/>
            <ac:spMk id="299" creationId="{64A36740-2C8F-4ADE-865C-F0006E9AE7B0}"/>
          </ac:spMkLst>
        </pc:spChg>
        <pc:spChg chg="mod">
          <ac:chgData name="Filippo Acconcia" userId="844af49c-a8a0-47ac-a7dd-14a44b60cd18" providerId="ADAL" clId="{998C6BF7-482B-421C-8ECC-9091B23559F6}" dt="2022-04-02T06:47:26.188" v="525"/>
          <ac:spMkLst>
            <pc:docMk/>
            <pc:sldMk cId="2888039256" sldId="295"/>
            <ac:spMk id="300" creationId="{B5D04853-29AA-42C6-9A93-CAAC8382AFAB}"/>
          </ac:spMkLst>
        </pc:spChg>
        <pc:spChg chg="mod">
          <ac:chgData name="Filippo Acconcia" userId="844af49c-a8a0-47ac-a7dd-14a44b60cd18" providerId="ADAL" clId="{998C6BF7-482B-421C-8ECC-9091B23559F6}" dt="2022-04-02T06:47:26.188" v="525"/>
          <ac:spMkLst>
            <pc:docMk/>
            <pc:sldMk cId="2888039256" sldId="295"/>
            <ac:spMk id="301" creationId="{96EB47AA-5426-4088-ABBA-6DD32999E25D}"/>
          </ac:spMkLst>
        </pc:spChg>
        <pc:spChg chg="add mod">
          <ac:chgData name="Filippo Acconcia" userId="844af49c-a8a0-47ac-a7dd-14a44b60cd18" providerId="ADAL" clId="{998C6BF7-482B-421C-8ECC-9091B23559F6}" dt="2022-04-02T06:49:07.898" v="543" actId="164"/>
          <ac:spMkLst>
            <pc:docMk/>
            <pc:sldMk cId="2888039256" sldId="295"/>
            <ac:spMk id="303" creationId="{0ECBF540-B328-4F81-BFEC-4443BF109AC1}"/>
          </ac:spMkLst>
        </pc:spChg>
        <pc:spChg chg="add mod">
          <ac:chgData name="Filippo Acconcia" userId="844af49c-a8a0-47ac-a7dd-14a44b60cd18" providerId="ADAL" clId="{998C6BF7-482B-421C-8ECC-9091B23559F6}" dt="2022-04-02T06:49:07.898" v="543" actId="164"/>
          <ac:spMkLst>
            <pc:docMk/>
            <pc:sldMk cId="2888039256" sldId="295"/>
            <ac:spMk id="305" creationId="{65EFDC6D-9C11-4530-BFBF-1F109104162E}"/>
          </ac:spMkLst>
        </pc:spChg>
        <pc:spChg chg="mod">
          <ac:chgData name="Filippo Acconcia" userId="844af49c-a8a0-47ac-a7dd-14a44b60cd18" providerId="ADAL" clId="{998C6BF7-482B-421C-8ECC-9091B23559F6}" dt="2022-04-02T06:47:26.188" v="525"/>
          <ac:spMkLst>
            <pc:docMk/>
            <pc:sldMk cId="2888039256" sldId="295"/>
            <ac:spMk id="307" creationId="{B2EEF01F-E6AD-4D2D-9872-D7DE53CDBA00}"/>
          </ac:spMkLst>
        </pc:spChg>
        <pc:spChg chg="mod">
          <ac:chgData name="Filippo Acconcia" userId="844af49c-a8a0-47ac-a7dd-14a44b60cd18" providerId="ADAL" clId="{998C6BF7-482B-421C-8ECC-9091B23559F6}" dt="2022-04-02T06:47:26.188" v="525"/>
          <ac:spMkLst>
            <pc:docMk/>
            <pc:sldMk cId="2888039256" sldId="295"/>
            <ac:spMk id="308" creationId="{7588CD57-945C-4855-A7F1-0EF5638F7CDE}"/>
          </ac:spMkLst>
        </pc:spChg>
        <pc:spChg chg="mod">
          <ac:chgData name="Filippo Acconcia" userId="844af49c-a8a0-47ac-a7dd-14a44b60cd18" providerId="ADAL" clId="{998C6BF7-482B-421C-8ECC-9091B23559F6}" dt="2022-04-02T06:47:26.188" v="525"/>
          <ac:spMkLst>
            <pc:docMk/>
            <pc:sldMk cId="2888039256" sldId="295"/>
            <ac:spMk id="309" creationId="{0ED780A9-93EE-42B7-A2C1-53A93C961501}"/>
          </ac:spMkLst>
        </pc:spChg>
        <pc:spChg chg="mod">
          <ac:chgData name="Filippo Acconcia" userId="844af49c-a8a0-47ac-a7dd-14a44b60cd18" providerId="ADAL" clId="{998C6BF7-482B-421C-8ECC-9091B23559F6}" dt="2022-04-02T06:47:26.188" v="525"/>
          <ac:spMkLst>
            <pc:docMk/>
            <pc:sldMk cId="2888039256" sldId="295"/>
            <ac:spMk id="310" creationId="{44B57060-DF92-4E89-ACE0-D2B1AD711F20}"/>
          </ac:spMkLst>
        </pc:spChg>
        <pc:spChg chg="add mod">
          <ac:chgData name="Filippo Acconcia" userId="844af49c-a8a0-47ac-a7dd-14a44b60cd18" providerId="ADAL" clId="{998C6BF7-482B-421C-8ECC-9091B23559F6}" dt="2022-04-02T06:50:03.238" v="550" actId="164"/>
          <ac:spMkLst>
            <pc:docMk/>
            <pc:sldMk cId="2888039256" sldId="295"/>
            <ac:spMk id="312" creationId="{4C0F2C87-3CAF-4446-A137-4CF6716C83A6}"/>
          </ac:spMkLst>
        </pc:spChg>
        <pc:spChg chg="add mod">
          <ac:chgData name="Filippo Acconcia" userId="844af49c-a8a0-47ac-a7dd-14a44b60cd18" providerId="ADAL" clId="{998C6BF7-482B-421C-8ECC-9091B23559F6}" dt="2022-04-02T06:50:03.238" v="550" actId="164"/>
          <ac:spMkLst>
            <pc:docMk/>
            <pc:sldMk cId="2888039256" sldId="295"/>
            <ac:spMk id="313" creationId="{9361F823-074E-483A-B3B4-08C067FA1C4B}"/>
          </ac:spMkLst>
        </pc:spChg>
        <pc:spChg chg="add mod">
          <ac:chgData name="Filippo Acconcia" userId="844af49c-a8a0-47ac-a7dd-14a44b60cd18" providerId="ADAL" clId="{998C6BF7-482B-421C-8ECC-9091B23559F6}" dt="2022-04-02T06:50:03.238" v="550" actId="164"/>
          <ac:spMkLst>
            <pc:docMk/>
            <pc:sldMk cId="2888039256" sldId="295"/>
            <ac:spMk id="314" creationId="{E77F972B-01E9-4229-9283-A6A23815074E}"/>
          </ac:spMkLst>
        </pc:spChg>
        <pc:spChg chg="add mod">
          <ac:chgData name="Filippo Acconcia" userId="844af49c-a8a0-47ac-a7dd-14a44b60cd18" providerId="ADAL" clId="{998C6BF7-482B-421C-8ECC-9091B23559F6}" dt="2022-04-02T06:50:03.238" v="550" actId="164"/>
          <ac:spMkLst>
            <pc:docMk/>
            <pc:sldMk cId="2888039256" sldId="295"/>
            <ac:spMk id="315" creationId="{67F4BC49-D3C2-4CEA-97EF-D686B4168658}"/>
          </ac:spMkLst>
        </pc:spChg>
        <pc:spChg chg="add mod">
          <ac:chgData name="Filippo Acconcia" userId="844af49c-a8a0-47ac-a7dd-14a44b60cd18" providerId="ADAL" clId="{998C6BF7-482B-421C-8ECC-9091B23559F6}" dt="2022-04-02T06:50:03.238" v="550" actId="164"/>
          <ac:spMkLst>
            <pc:docMk/>
            <pc:sldMk cId="2888039256" sldId="295"/>
            <ac:spMk id="316" creationId="{A38A55C6-1D1F-4CF9-BDCC-32830BFC3F6E}"/>
          </ac:spMkLst>
        </pc:spChg>
        <pc:spChg chg="mod">
          <ac:chgData name="Filippo Acconcia" userId="844af49c-a8a0-47ac-a7dd-14a44b60cd18" providerId="ADAL" clId="{998C6BF7-482B-421C-8ECC-9091B23559F6}" dt="2022-04-02T06:47:29.665" v="527"/>
          <ac:spMkLst>
            <pc:docMk/>
            <pc:sldMk cId="2888039256" sldId="295"/>
            <ac:spMk id="318" creationId="{7A17778D-A4D9-47C3-B946-00F57ED383FE}"/>
          </ac:spMkLst>
        </pc:spChg>
        <pc:spChg chg="mod">
          <ac:chgData name="Filippo Acconcia" userId="844af49c-a8a0-47ac-a7dd-14a44b60cd18" providerId="ADAL" clId="{998C6BF7-482B-421C-8ECC-9091B23559F6}" dt="2022-04-02T06:47:29.665" v="527"/>
          <ac:spMkLst>
            <pc:docMk/>
            <pc:sldMk cId="2888039256" sldId="295"/>
            <ac:spMk id="319" creationId="{396EF412-D43F-4FA0-ABDE-187EBA9B5747}"/>
          </ac:spMkLst>
        </pc:spChg>
        <pc:spChg chg="mod">
          <ac:chgData name="Filippo Acconcia" userId="844af49c-a8a0-47ac-a7dd-14a44b60cd18" providerId="ADAL" clId="{998C6BF7-482B-421C-8ECC-9091B23559F6}" dt="2022-04-02T06:47:29.665" v="527"/>
          <ac:spMkLst>
            <pc:docMk/>
            <pc:sldMk cId="2888039256" sldId="295"/>
            <ac:spMk id="320" creationId="{193AF1EC-F20E-4AE5-9D1E-D4190987F9F5}"/>
          </ac:spMkLst>
        </pc:spChg>
        <pc:spChg chg="mod">
          <ac:chgData name="Filippo Acconcia" userId="844af49c-a8a0-47ac-a7dd-14a44b60cd18" providerId="ADAL" clId="{998C6BF7-482B-421C-8ECC-9091B23559F6}" dt="2022-04-02T06:47:29.665" v="527"/>
          <ac:spMkLst>
            <pc:docMk/>
            <pc:sldMk cId="2888039256" sldId="295"/>
            <ac:spMk id="321" creationId="{02EEA326-3E89-4E55-8CFA-3BA0D7C95B5C}"/>
          </ac:spMkLst>
        </pc:spChg>
        <pc:spChg chg="add mod">
          <ac:chgData name="Filippo Acconcia" userId="844af49c-a8a0-47ac-a7dd-14a44b60cd18" providerId="ADAL" clId="{998C6BF7-482B-421C-8ECC-9091B23559F6}" dt="2022-04-02T06:50:03.238" v="550" actId="164"/>
          <ac:spMkLst>
            <pc:docMk/>
            <pc:sldMk cId="2888039256" sldId="295"/>
            <ac:spMk id="323" creationId="{E4675C96-9FD4-45FB-8EF1-564C8EB64631}"/>
          </ac:spMkLst>
        </pc:spChg>
        <pc:spChg chg="add mod">
          <ac:chgData name="Filippo Acconcia" userId="844af49c-a8a0-47ac-a7dd-14a44b60cd18" providerId="ADAL" clId="{998C6BF7-482B-421C-8ECC-9091B23559F6}" dt="2022-04-02T06:50:03.238" v="550" actId="164"/>
          <ac:spMkLst>
            <pc:docMk/>
            <pc:sldMk cId="2888039256" sldId="295"/>
            <ac:spMk id="325" creationId="{043DB477-E129-4A74-ADFC-E23ED3206788}"/>
          </ac:spMkLst>
        </pc:spChg>
        <pc:spChg chg="mod">
          <ac:chgData name="Filippo Acconcia" userId="844af49c-a8a0-47ac-a7dd-14a44b60cd18" providerId="ADAL" clId="{998C6BF7-482B-421C-8ECC-9091B23559F6}" dt="2022-04-02T06:47:29.665" v="527"/>
          <ac:spMkLst>
            <pc:docMk/>
            <pc:sldMk cId="2888039256" sldId="295"/>
            <ac:spMk id="327" creationId="{D41269B5-DC13-4733-B249-3D6B3E0E56D3}"/>
          </ac:spMkLst>
        </pc:spChg>
        <pc:spChg chg="mod">
          <ac:chgData name="Filippo Acconcia" userId="844af49c-a8a0-47ac-a7dd-14a44b60cd18" providerId="ADAL" clId="{998C6BF7-482B-421C-8ECC-9091B23559F6}" dt="2022-04-02T06:47:29.665" v="527"/>
          <ac:spMkLst>
            <pc:docMk/>
            <pc:sldMk cId="2888039256" sldId="295"/>
            <ac:spMk id="328" creationId="{FA94A825-580D-41E5-9137-59215DDE4448}"/>
          </ac:spMkLst>
        </pc:spChg>
        <pc:spChg chg="mod">
          <ac:chgData name="Filippo Acconcia" userId="844af49c-a8a0-47ac-a7dd-14a44b60cd18" providerId="ADAL" clId="{998C6BF7-482B-421C-8ECC-9091B23559F6}" dt="2022-04-02T06:47:29.665" v="527"/>
          <ac:spMkLst>
            <pc:docMk/>
            <pc:sldMk cId="2888039256" sldId="295"/>
            <ac:spMk id="329" creationId="{A2272671-5A08-4F19-82B3-BB5651FCF045}"/>
          </ac:spMkLst>
        </pc:spChg>
        <pc:spChg chg="mod">
          <ac:chgData name="Filippo Acconcia" userId="844af49c-a8a0-47ac-a7dd-14a44b60cd18" providerId="ADAL" clId="{998C6BF7-482B-421C-8ECC-9091B23559F6}" dt="2022-04-02T06:47:29.665" v="527"/>
          <ac:spMkLst>
            <pc:docMk/>
            <pc:sldMk cId="2888039256" sldId="295"/>
            <ac:spMk id="330" creationId="{2C9A0BD2-6D3F-4285-97A7-7CBA166A2DFA}"/>
          </ac:spMkLst>
        </pc:spChg>
        <pc:grpChg chg="add mod">
          <ac:chgData name="Filippo Acconcia" userId="844af49c-a8a0-47ac-a7dd-14a44b60cd18" providerId="ADAL" clId="{998C6BF7-482B-421C-8ECC-9091B23559F6}" dt="2022-04-02T06:49:03.657" v="542" actId="164"/>
          <ac:grpSpMkLst>
            <pc:docMk/>
            <pc:sldMk cId="2888039256" sldId="295"/>
            <ac:grpSpMk id="4" creationId="{165BACF5-04D4-4417-B495-B6956CAEC77C}"/>
          </ac:grpSpMkLst>
        </pc:grpChg>
        <pc:grpChg chg="add mod">
          <ac:chgData name="Filippo Acconcia" userId="844af49c-a8a0-47ac-a7dd-14a44b60cd18" providerId="ADAL" clId="{998C6BF7-482B-421C-8ECC-9091B23559F6}" dt="2022-04-02T06:46:51.777" v="510" actId="164"/>
          <ac:grpSpMkLst>
            <pc:docMk/>
            <pc:sldMk cId="2888039256" sldId="295"/>
            <ac:grpSpMk id="5" creationId="{5C72323A-9DBE-444F-8E24-70C60BC074E9}"/>
          </ac:grpSpMkLst>
        </pc:grpChg>
        <pc:grpChg chg="add mod">
          <ac:chgData name="Filippo Acconcia" userId="844af49c-a8a0-47ac-a7dd-14a44b60cd18" providerId="ADAL" clId="{998C6BF7-482B-421C-8ECC-9091B23559F6}" dt="2022-04-02T06:46:51.777" v="510" actId="164"/>
          <ac:grpSpMkLst>
            <pc:docMk/>
            <pc:sldMk cId="2888039256" sldId="295"/>
            <ac:grpSpMk id="6" creationId="{F163F9A8-BCC1-4C67-9C65-8EEAC238969A}"/>
          </ac:grpSpMkLst>
        </pc:grpChg>
        <pc:grpChg chg="add mod">
          <ac:chgData name="Filippo Acconcia" userId="844af49c-a8a0-47ac-a7dd-14a44b60cd18" providerId="ADAL" clId="{998C6BF7-482B-421C-8ECC-9091B23559F6}" dt="2022-04-02T06:46:51.777" v="510" actId="164"/>
          <ac:grpSpMkLst>
            <pc:docMk/>
            <pc:sldMk cId="2888039256" sldId="295"/>
            <ac:grpSpMk id="7" creationId="{FD92E6C2-63F5-4B28-B451-DB618F119AFC}"/>
          </ac:grpSpMkLst>
        </pc:grpChg>
        <pc:grpChg chg="add mod">
          <ac:chgData name="Filippo Acconcia" userId="844af49c-a8a0-47ac-a7dd-14a44b60cd18" providerId="ADAL" clId="{998C6BF7-482B-421C-8ECC-9091B23559F6}" dt="2022-04-02T06:54:09.062" v="563" actId="1038"/>
          <ac:grpSpMkLst>
            <pc:docMk/>
            <pc:sldMk cId="2888039256" sldId="295"/>
            <ac:grpSpMk id="9" creationId="{B39059B5-01B5-4391-92F6-CC580C17673D}"/>
          </ac:grpSpMkLst>
        </pc:grpChg>
        <pc:grpChg chg="add mod">
          <ac:chgData name="Filippo Acconcia" userId="844af49c-a8a0-47ac-a7dd-14a44b60cd18" providerId="ADAL" clId="{998C6BF7-482B-421C-8ECC-9091B23559F6}" dt="2022-04-02T06:53:38.099" v="558" actId="12789"/>
          <ac:grpSpMkLst>
            <pc:docMk/>
            <pc:sldMk cId="2888039256" sldId="295"/>
            <ac:grpSpMk id="10" creationId="{8A546845-0863-45A1-9C4E-7C1C0C90F17F}"/>
          </ac:grpSpMkLst>
        </pc:grpChg>
        <pc:grpChg chg="add mod">
          <ac:chgData name="Filippo Acconcia" userId="844af49c-a8a0-47ac-a7dd-14a44b60cd18" providerId="ADAL" clId="{998C6BF7-482B-421C-8ECC-9091B23559F6}" dt="2022-04-02T06:54:09.062" v="563" actId="1038"/>
          <ac:grpSpMkLst>
            <pc:docMk/>
            <pc:sldMk cId="2888039256" sldId="295"/>
            <ac:grpSpMk id="12" creationId="{4B3337F3-FCC5-4124-88E2-64BDEADF355F}"/>
          </ac:grpSpMkLst>
        </pc:grpChg>
        <pc:grpChg chg="del">
          <ac:chgData name="Filippo Acconcia" userId="844af49c-a8a0-47ac-a7dd-14a44b60cd18" providerId="ADAL" clId="{998C6BF7-482B-421C-8ECC-9091B23559F6}" dt="2022-03-24T06:46:08.556" v="11" actId="478"/>
          <ac:grpSpMkLst>
            <pc:docMk/>
            <pc:sldMk cId="2888039256" sldId="295"/>
            <ac:grpSpMk id="12" creationId="{7A0F8146-9589-42AD-A38D-1EC1B6E4E76A}"/>
          </ac:grpSpMkLst>
        </pc:grpChg>
        <pc:grpChg chg="add mod">
          <ac:chgData name="Filippo Acconcia" userId="844af49c-a8a0-47ac-a7dd-14a44b60cd18" providerId="ADAL" clId="{998C6BF7-482B-421C-8ECC-9091B23559F6}" dt="2022-03-24T06:46:24.683" v="12"/>
          <ac:grpSpMkLst>
            <pc:docMk/>
            <pc:sldMk cId="2888039256" sldId="295"/>
            <ac:grpSpMk id="71" creationId="{19628C25-E179-424E-B139-7B7C0AE38B1B}"/>
          </ac:grpSpMkLst>
        </pc:grpChg>
        <pc:grpChg chg="del">
          <ac:chgData name="Filippo Acconcia" userId="844af49c-a8a0-47ac-a7dd-14a44b60cd18" providerId="ADAL" clId="{998C6BF7-482B-421C-8ECC-9091B23559F6}" dt="2022-03-24T06:46:08.556" v="11" actId="478"/>
          <ac:grpSpMkLst>
            <pc:docMk/>
            <pc:sldMk cId="2888039256" sldId="295"/>
            <ac:grpSpMk id="72" creationId="{1B36A0BE-D3CA-4624-AD00-94E8905720E6}"/>
          </ac:grpSpMkLst>
        </pc:grpChg>
        <pc:grpChg chg="mod">
          <ac:chgData name="Filippo Acconcia" userId="844af49c-a8a0-47ac-a7dd-14a44b60cd18" providerId="ADAL" clId="{998C6BF7-482B-421C-8ECC-9091B23559F6}" dt="2022-03-24T06:46:24.683" v="12"/>
          <ac:grpSpMkLst>
            <pc:docMk/>
            <pc:sldMk cId="2888039256" sldId="295"/>
            <ac:grpSpMk id="79" creationId="{C0D78641-345C-4940-8C3E-C7EF1DD120F9}"/>
          </ac:grpSpMkLst>
        </pc:grpChg>
        <pc:grpChg chg="add mod">
          <ac:chgData name="Filippo Acconcia" userId="844af49c-a8a0-47ac-a7dd-14a44b60cd18" providerId="ADAL" clId="{998C6BF7-482B-421C-8ECC-9091B23559F6}" dt="2022-03-24T06:49:03.279" v="14" actId="1076"/>
          <ac:grpSpMkLst>
            <pc:docMk/>
            <pc:sldMk cId="2888039256" sldId="295"/>
            <ac:grpSpMk id="89" creationId="{BCF3E8D0-66FD-44BE-A2AC-EA034F5E2E13}"/>
          </ac:grpSpMkLst>
        </pc:grpChg>
        <pc:grpChg chg="add del mod">
          <ac:chgData name="Filippo Acconcia" userId="844af49c-a8a0-47ac-a7dd-14a44b60cd18" providerId="ADAL" clId="{998C6BF7-482B-421C-8ECC-9091B23559F6}" dt="2022-04-02T06:46:29.079" v="496" actId="165"/>
          <ac:grpSpMkLst>
            <pc:docMk/>
            <pc:sldMk cId="2888039256" sldId="295"/>
            <ac:grpSpMk id="97" creationId="{DD5F5B2A-CC68-4A57-9293-46C090F8304E}"/>
          </ac:grpSpMkLst>
        </pc:grpChg>
        <pc:grpChg chg="del mod topLvl">
          <ac:chgData name="Filippo Acconcia" userId="844af49c-a8a0-47ac-a7dd-14a44b60cd18" providerId="ADAL" clId="{998C6BF7-482B-421C-8ECC-9091B23559F6}" dt="2022-04-02T06:46:32.617" v="497" actId="165"/>
          <ac:grpSpMkLst>
            <pc:docMk/>
            <pc:sldMk cId="2888039256" sldId="295"/>
            <ac:grpSpMk id="100" creationId="{7DE8EE5F-3F9C-4475-9AA9-BA3B86B94B48}"/>
          </ac:grpSpMkLst>
        </pc:grpChg>
        <pc:grpChg chg="add del mod">
          <ac:chgData name="Filippo Acconcia" userId="844af49c-a8a0-47ac-a7dd-14a44b60cd18" providerId="ADAL" clId="{998C6BF7-482B-421C-8ECC-9091B23559F6}" dt="2022-04-02T06:47:21.750" v="524" actId="478"/>
          <ac:grpSpMkLst>
            <pc:docMk/>
            <pc:sldMk cId="2888039256" sldId="295"/>
            <ac:grpSpMk id="116" creationId="{6341BE11-9A67-44F9-9EEB-E47F2C74802C}"/>
          </ac:grpSpMkLst>
        </pc:grpChg>
        <pc:grpChg chg="add mod">
          <ac:chgData name="Filippo Acconcia" userId="844af49c-a8a0-47ac-a7dd-14a44b60cd18" providerId="ADAL" clId="{998C6BF7-482B-421C-8ECC-9091B23559F6}" dt="2022-04-02T06:46:59.054" v="515" actId="1037"/>
          <ac:grpSpMkLst>
            <pc:docMk/>
            <pc:sldMk cId="2888039256" sldId="295"/>
            <ac:grpSpMk id="123" creationId="{59541AB8-63FD-4849-A88B-2927A82587C4}"/>
          </ac:grpSpMkLst>
        </pc:grpChg>
        <pc:grpChg chg="add mod">
          <ac:chgData name="Filippo Acconcia" userId="844af49c-a8a0-47ac-a7dd-14a44b60cd18" providerId="ADAL" clId="{998C6BF7-482B-421C-8ECC-9091B23559F6}" dt="2022-03-24T06:49:35.362" v="25" actId="1076"/>
          <ac:grpSpMkLst>
            <pc:docMk/>
            <pc:sldMk cId="2888039256" sldId="295"/>
            <ac:grpSpMk id="149" creationId="{4766C56B-99B3-4A21-B905-02006B2FD621}"/>
          </ac:grpSpMkLst>
        </pc:grpChg>
        <pc:grpChg chg="mod">
          <ac:chgData name="Filippo Acconcia" userId="844af49c-a8a0-47ac-a7dd-14a44b60cd18" providerId="ADAL" clId="{998C6BF7-482B-421C-8ECC-9091B23559F6}" dt="2022-04-02T06:34:16.173" v="146"/>
          <ac:grpSpMkLst>
            <pc:docMk/>
            <pc:sldMk cId="2888039256" sldId="295"/>
            <ac:grpSpMk id="166" creationId="{C5456E37-AA05-42CF-BE1C-04FD3AF87BEE}"/>
          </ac:grpSpMkLst>
        </pc:grpChg>
        <pc:grpChg chg="mod">
          <ac:chgData name="Filippo Acconcia" userId="844af49c-a8a0-47ac-a7dd-14a44b60cd18" providerId="ADAL" clId="{998C6BF7-482B-421C-8ECC-9091B23559F6}" dt="2022-04-02T06:34:16.173" v="146"/>
          <ac:grpSpMkLst>
            <pc:docMk/>
            <pc:sldMk cId="2888039256" sldId="295"/>
            <ac:grpSpMk id="172" creationId="{6E1CA858-F911-4BD3-8579-511CEF50EA6F}"/>
          </ac:grpSpMkLst>
        </pc:grpChg>
        <pc:grpChg chg="mod">
          <ac:chgData name="Filippo Acconcia" userId="844af49c-a8a0-47ac-a7dd-14a44b60cd18" providerId="ADAL" clId="{998C6BF7-482B-421C-8ECC-9091B23559F6}" dt="2022-04-02T06:34:16.173" v="146"/>
          <ac:grpSpMkLst>
            <pc:docMk/>
            <pc:sldMk cId="2888039256" sldId="295"/>
            <ac:grpSpMk id="174" creationId="{2C52EA3F-D899-43CA-B77E-C77C7F53D9E5}"/>
          </ac:grpSpMkLst>
        </pc:grpChg>
        <pc:grpChg chg="mod">
          <ac:chgData name="Filippo Acconcia" userId="844af49c-a8a0-47ac-a7dd-14a44b60cd18" providerId="ADAL" clId="{998C6BF7-482B-421C-8ECC-9091B23559F6}" dt="2022-04-02T06:34:16.173" v="146"/>
          <ac:grpSpMkLst>
            <pc:docMk/>
            <pc:sldMk cId="2888039256" sldId="295"/>
            <ac:grpSpMk id="175" creationId="{B4D8994C-AE1A-493B-9BEC-A1EB761CF5E7}"/>
          </ac:grpSpMkLst>
        </pc:grpChg>
        <pc:grpChg chg="mod">
          <ac:chgData name="Filippo Acconcia" userId="844af49c-a8a0-47ac-a7dd-14a44b60cd18" providerId="ADAL" clId="{998C6BF7-482B-421C-8ECC-9091B23559F6}" dt="2022-04-02T06:34:16.173" v="146"/>
          <ac:grpSpMkLst>
            <pc:docMk/>
            <pc:sldMk cId="2888039256" sldId="295"/>
            <ac:grpSpMk id="176" creationId="{5D2A5ACD-7819-4164-A163-99222E2C5C2B}"/>
          </ac:grpSpMkLst>
        </pc:grpChg>
        <pc:grpChg chg="mod">
          <ac:chgData name="Filippo Acconcia" userId="844af49c-a8a0-47ac-a7dd-14a44b60cd18" providerId="ADAL" clId="{998C6BF7-482B-421C-8ECC-9091B23559F6}" dt="2022-04-02T06:34:16.173" v="146"/>
          <ac:grpSpMkLst>
            <pc:docMk/>
            <pc:sldMk cId="2888039256" sldId="295"/>
            <ac:grpSpMk id="177" creationId="{B4F3E945-8C45-47A9-AE12-5966479C7C8F}"/>
          </ac:grpSpMkLst>
        </pc:grpChg>
        <pc:grpChg chg="mod">
          <ac:chgData name="Filippo Acconcia" userId="844af49c-a8a0-47ac-a7dd-14a44b60cd18" providerId="ADAL" clId="{998C6BF7-482B-421C-8ECC-9091B23559F6}" dt="2022-04-02T06:34:16.173" v="146"/>
          <ac:grpSpMkLst>
            <pc:docMk/>
            <pc:sldMk cId="2888039256" sldId="295"/>
            <ac:grpSpMk id="178" creationId="{11E8AC16-A9FB-44CF-BC0C-ABD3DD64A6ED}"/>
          </ac:grpSpMkLst>
        </pc:grpChg>
        <pc:grpChg chg="mod">
          <ac:chgData name="Filippo Acconcia" userId="844af49c-a8a0-47ac-a7dd-14a44b60cd18" providerId="ADAL" clId="{998C6BF7-482B-421C-8ECC-9091B23559F6}" dt="2022-04-02T06:34:16.173" v="146"/>
          <ac:grpSpMkLst>
            <pc:docMk/>
            <pc:sldMk cId="2888039256" sldId="295"/>
            <ac:grpSpMk id="179" creationId="{415ED47C-F228-4F2F-AED4-515F6DE78DC9}"/>
          </ac:grpSpMkLst>
        </pc:grpChg>
        <pc:grpChg chg="add del mod">
          <ac:chgData name="Filippo Acconcia" userId="844af49c-a8a0-47ac-a7dd-14a44b60cd18" providerId="ADAL" clId="{998C6BF7-482B-421C-8ECC-9091B23559F6}" dt="2022-04-02T06:47:21.750" v="524" actId="478"/>
          <ac:grpSpMkLst>
            <pc:docMk/>
            <pc:sldMk cId="2888039256" sldId="295"/>
            <ac:grpSpMk id="204" creationId="{D6D8C50C-3A0A-4896-A7DC-62B16B553ABF}"/>
          </ac:grpSpMkLst>
        </pc:grpChg>
        <pc:grpChg chg="mod">
          <ac:chgData name="Filippo Acconcia" userId="844af49c-a8a0-47ac-a7dd-14a44b60cd18" providerId="ADAL" clId="{998C6BF7-482B-421C-8ECC-9091B23559F6}" dt="2022-04-02T06:34:35.196" v="190"/>
          <ac:grpSpMkLst>
            <pc:docMk/>
            <pc:sldMk cId="2888039256" sldId="295"/>
            <ac:grpSpMk id="206" creationId="{4090D5B4-6FA2-4E1F-A90C-86DF829C1410}"/>
          </ac:grpSpMkLst>
        </pc:grpChg>
        <pc:grpChg chg="mod">
          <ac:chgData name="Filippo Acconcia" userId="844af49c-a8a0-47ac-a7dd-14a44b60cd18" providerId="ADAL" clId="{998C6BF7-482B-421C-8ECC-9091B23559F6}" dt="2022-04-02T06:34:35.196" v="190"/>
          <ac:grpSpMkLst>
            <pc:docMk/>
            <pc:sldMk cId="2888039256" sldId="295"/>
            <ac:grpSpMk id="212" creationId="{14E0AA12-951E-4A0A-B395-004988688C82}"/>
          </ac:grpSpMkLst>
        </pc:grpChg>
        <pc:grpChg chg="mod">
          <ac:chgData name="Filippo Acconcia" userId="844af49c-a8a0-47ac-a7dd-14a44b60cd18" providerId="ADAL" clId="{998C6BF7-482B-421C-8ECC-9091B23559F6}" dt="2022-04-02T06:34:35.196" v="190"/>
          <ac:grpSpMkLst>
            <pc:docMk/>
            <pc:sldMk cId="2888039256" sldId="295"/>
            <ac:grpSpMk id="214" creationId="{DF6F9012-3857-4127-96E3-5F2B75325980}"/>
          </ac:grpSpMkLst>
        </pc:grpChg>
        <pc:grpChg chg="mod">
          <ac:chgData name="Filippo Acconcia" userId="844af49c-a8a0-47ac-a7dd-14a44b60cd18" providerId="ADAL" clId="{998C6BF7-482B-421C-8ECC-9091B23559F6}" dt="2022-04-02T06:34:35.196" v="190"/>
          <ac:grpSpMkLst>
            <pc:docMk/>
            <pc:sldMk cId="2888039256" sldId="295"/>
            <ac:grpSpMk id="215" creationId="{9D1ABB4A-DF86-418B-9021-E65198279138}"/>
          </ac:grpSpMkLst>
        </pc:grpChg>
        <pc:grpChg chg="mod">
          <ac:chgData name="Filippo Acconcia" userId="844af49c-a8a0-47ac-a7dd-14a44b60cd18" providerId="ADAL" clId="{998C6BF7-482B-421C-8ECC-9091B23559F6}" dt="2022-04-02T06:34:35.196" v="190"/>
          <ac:grpSpMkLst>
            <pc:docMk/>
            <pc:sldMk cId="2888039256" sldId="295"/>
            <ac:grpSpMk id="216" creationId="{13344FE5-78F5-41B4-85EA-70A39FA1B615}"/>
          </ac:grpSpMkLst>
        </pc:grpChg>
        <pc:grpChg chg="mod">
          <ac:chgData name="Filippo Acconcia" userId="844af49c-a8a0-47ac-a7dd-14a44b60cd18" providerId="ADAL" clId="{998C6BF7-482B-421C-8ECC-9091B23559F6}" dt="2022-04-02T06:34:35.196" v="190"/>
          <ac:grpSpMkLst>
            <pc:docMk/>
            <pc:sldMk cId="2888039256" sldId="295"/>
            <ac:grpSpMk id="217" creationId="{084D62F6-B7E5-4FEE-B0B9-E611F443FB09}"/>
          </ac:grpSpMkLst>
        </pc:grpChg>
        <pc:grpChg chg="mod">
          <ac:chgData name="Filippo Acconcia" userId="844af49c-a8a0-47ac-a7dd-14a44b60cd18" providerId="ADAL" clId="{998C6BF7-482B-421C-8ECC-9091B23559F6}" dt="2022-04-02T06:34:35.196" v="190"/>
          <ac:grpSpMkLst>
            <pc:docMk/>
            <pc:sldMk cId="2888039256" sldId="295"/>
            <ac:grpSpMk id="218" creationId="{0B7E3A1F-FEE4-4D83-89BC-F02323EC0B7F}"/>
          </ac:grpSpMkLst>
        </pc:grpChg>
        <pc:grpChg chg="mod">
          <ac:chgData name="Filippo Acconcia" userId="844af49c-a8a0-47ac-a7dd-14a44b60cd18" providerId="ADAL" clId="{998C6BF7-482B-421C-8ECC-9091B23559F6}" dt="2022-04-02T06:34:35.196" v="190"/>
          <ac:grpSpMkLst>
            <pc:docMk/>
            <pc:sldMk cId="2888039256" sldId="295"/>
            <ac:grpSpMk id="219" creationId="{C7E08454-981F-4FEA-B24E-8F4B0D42C797}"/>
          </ac:grpSpMkLst>
        </pc:grpChg>
        <pc:grpChg chg="add del mod">
          <ac:chgData name="Filippo Acconcia" userId="844af49c-a8a0-47ac-a7dd-14a44b60cd18" providerId="ADAL" clId="{998C6BF7-482B-421C-8ECC-9091B23559F6}" dt="2022-04-02T06:39:02.401" v="234" actId="165"/>
          <ac:grpSpMkLst>
            <pc:docMk/>
            <pc:sldMk cId="2888039256" sldId="295"/>
            <ac:grpSpMk id="244" creationId="{D9FE3597-2AF5-4979-8195-3FF77DFBA6D2}"/>
          </ac:grpSpMkLst>
        </pc:grpChg>
        <pc:grpChg chg="del mod topLvl">
          <ac:chgData name="Filippo Acconcia" userId="844af49c-a8a0-47ac-a7dd-14a44b60cd18" providerId="ADAL" clId="{998C6BF7-482B-421C-8ECC-9091B23559F6}" dt="2022-04-02T06:39:31.305" v="240" actId="478"/>
          <ac:grpSpMkLst>
            <pc:docMk/>
            <pc:sldMk cId="2888039256" sldId="295"/>
            <ac:grpSpMk id="246" creationId="{8426DD6A-9E17-404B-BB7E-37587054B934}"/>
          </ac:grpSpMkLst>
        </pc:grpChg>
        <pc:grpChg chg="del mod topLvl">
          <ac:chgData name="Filippo Acconcia" userId="844af49c-a8a0-47ac-a7dd-14a44b60cd18" providerId="ADAL" clId="{998C6BF7-482B-421C-8ECC-9091B23559F6}" dt="2022-04-02T06:42:51.284" v="369" actId="478"/>
          <ac:grpSpMkLst>
            <pc:docMk/>
            <pc:sldMk cId="2888039256" sldId="295"/>
            <ac:grpSpMk id="252" creationId="{DE5782C2-6E72-4138-8243-D67E04CA63DD}"/>
          </ac:grpSpMkLst>
        </pc:grpChg>
        <pc:grpChg chg="del mod topLvl">
          <ac:chgData name="Filippo Acconcia" userId="844af49c-a8a0-47ac-a7dd-14a44b60cd18" providerId="ADAL" clId="{998C6BF7-482B-421C-8ECC-9091B23559F6}" dt="2022-04-02T06:39:31.305" v="240" actId="478"/>
          <ac:grpSpMkLst>
            <pc:docMk/>
            <pc:sldMk cId="2888039256" sldId="295"/>
            <ac:grpSpMk id="254" creationId="{5C74C3CD-F7FB-4C0F-BA9B-699A46F9EC02}"/>
          </ac:grpSpMkLst>
        </pc:grpChg>
        <pc:grpChg chg="del mod topLvl">
          <ac:chgData name="Filippo Acconcia" userId="844af49c-a8a0-47ac-a7dd-14a44b60cd18" providerId="ADAL" clId="{998C6BF7-482B-421C-8ECC-9091B23559F6}" dt="2022-04-02T06:39:31.305" v="240" actId="478"/>
          <ac:grpSpMkLst>
            <pc:docMk/>
            <pc:sldMk cId="2888039256" sldId="295"/>
            <ac:grpSpMk id="255" creationId="{125B8DAC-FFCB-46C3-B594-606395761F25}"/>
          </ac:grpSpMkLst>
        </pc:grpChg>
        <pc:grpChg chg="del mod topLvl">
          <ac:chgData name="Filippo Acconcia" userId="844af49c-a8a0-47ac-a7dd-14a44b60cd18" providerId="ADAL" clId="{998C6BF7-482B-421C-8ECC-9091B23559F6}" dt="2022-04-02T06:41:14.536" v="247" actId="165"/>
          <ac:grpSpMkLst>
            <pc:docMk/>
            <pc:sldMk cId="2888039256" sldId="295"/>
            <ac:grpSpMk id="256" creationId="{B80FBF8F-1342-44EA-AEAD-55DC02FA8A02}"/>
          </ac:grpSpMkLst>
        </pc:grpChg>
        <pc:grpChg chg="del mod topLvl">
          <ac:chgData name="Filippo Acconcia" userId="844af49c-a8a0-47ac-a7dd-14a44b60cd18" providerId="ADAL" clId="{998C6BF7-482B-421C-8ECC-9091B23559F6}" dt="2022-04-02T06:42:52.702" v="370" actId="478"/>
          <ac:grpSpMkLst>
            <pc:docMk/>
            <pc:sldMk cId="2888039256" sldId="295"/>
            <ac:grpSpMk id="257" creationId="{2BD733B9-C560-4EFE-B06E-33473827A9D4}"/>
          </ac:grpSpMkLst>
        </pc:grpChg>
        <pc:grpChg chg="del mod topLvl">
          <ac:chgData name="Filippo Acconcia" userId="844af49c-a8a0-47ac-a7dd-14a44b60cd18" providerId="ADAL" clId="{998C6BF7-482B-421C-8ECC-9091B23559F6}" dt="2022-04-02T06:43:00.934" v="373" actId="165"/>
          <ac:grpSpMkLst>
            <pc:docMk/>
            <pc:sldMk cId="2888039256" sldId="295"/>
            <ac:grpSpMk id="258" creationId="{D2F76149-9B46-4424-8AA2-E0B27D7CBFC0}"/>
          </ac:grpSpMkLst>
        </pc:grpChg>
        <pc:grpChg chg="del mod topLvl">
          <ac:chgData name="Filippo Acconcia" userId="844af49c-a8a0-47ac-a7dd-14a44b60cd18" providerId="ADAL" clId="{998C6BF7-482B-421C-8ECC-9091B23559F6}" dt="2022-04-02T06:43:04.418" v="374" actId="165"/>
          <ac:grpSpMkLst>
            <pc:docMk/>
            <pc:sldMk cId="2888039256" sldId="295"/>
            <ac:grpSpMk id="259" creationId="{F92F58AC-22B2-4EEE-AE45-4F59624F334F}"/>
          </ac:grpSpMkLst>
        </pc:grpChg>
        <pc:grpChg chg="add mod">
          <ac:chgData name="Filippo Acconcia" userId="844af49c-a8a0-47ac-a7dd-14a44b60cd18" providerId="ADAL" clId="{998C6BF7-482B-421C-8ECC-9091B23559F6}" dt="2022-04-02T06:49:03.657" v="542" actId="164"/>
          <ac:grpSpMkLst>
            <pc:docMk/>
            <pc:sldMk cId="2888039256" sldId="295"/>
            <ac:grpSpMk id="284" creationId="{62033196-8877-418A-9C79-E344AF61F6F6}"/>
          </ac:grpSpMkLst>
        </pc:grpChg>
        <pc:grpChg chg="add mod">
          <ac:chgData name="Filippo Acconcia" userId="844af49c-a8a0-47ac-a7dd-14a44b60cd18" providerId="ADAL" clId="{998C6BF7-482B-421C-8ECC-9091B23559F6}" dt="2022-04-02T06:49:07.898" v="543" actId="164"/>
          <ac:grpSpMkLst>
            <pc:docMk/>
            <pc:sldMk cId="2888039256" sldId="295"/>
            <ac:grpSpMk id="297" creationId="{A851B962-2868-4C20-90D1-D596D3FABE2C}"/>
          </ac:grpSpMkLst>
        </pc:grpChg>
        <pc:grpChg chg="add mod">
          <ac:chgData name="Filippo Acconcia" userId="844af49c-a8a0-47ac-a7dd-14a44b60cd18" providerId="ADAL" clId="{998C6BF7-482B-421C-8ECC-9091B23559F6}" dt="2022-04-02T06:49:07.898" v="543" actId="164"/>
          <ac:grpSpMkLst>
            <pc:docMk/>
            <pc:sldMk cId="2888039256" sldId="295"/>
            <ac:grpSpMk id="306" creationId="{D48D2497-F76A-4052-8B38-F3BCD029A0DE}"/>
          </ac:grpSpMkLst>
        </pc:grpChg>
        <pc:grpChg chg="add mod">
          <ac:chgData name="Filippo Acconcia" userId="844af49c-a8a0-47ac-a7dd-14a44b60cd18" providerId="ADAL" clId="{998C6BF7-482B-421C-8ECC-9091B23559F6}" dt="2022-04-02T06:50:03.238" v="550" actId="164"/>
          <ac:grpSpMkLst>
            <pc:docMk/>
            <pc:sldMk cId="2888039256" sldId="295"/>
            <ac:grpSpMk id="317" creationId="{9DE63326-DFBD-4353-86C3-6398D63EA89F}"/>
          </ac:grpSpMkLst>
        </pc:grpChg>
        <pc:grpChg chg="add mod">
          <ac:chgData name="Filippo Acconcia" userId="844af49c-a8a0-47ac-a7dd-14a44b60cd18" providerId="ADAL" clId="{998C6BF7-482B-421C-8ECC-9091B23559F6}" dt="2022-04-02T06:50:03.238" v="550" actId="164"/>
          <ac:grpSpMkLst>
            <pc:docMk/>
            <pc:sldMk cId="2888039256" sldId="295"/>
            <ac:grpSpMk id="326" creationId="{C00D9D9E-09DC-4C46-8BF9-F0DEE92CC5B7}"/>
          </ac:grpSpMkLst>
        </pc:grpChg>
        <pc:picChg chg="del">
          <ac:chgData name="Filippo Acconcia" userId="844af49c-a8a0-47ac-a7dd-14a44b60cd18" providerId="ADAL" clId="{998C6BF7-482B-421C-8ECC-9091B23559F6}" dt="2022-03-24T06:46:08.556" v="11" actId="478"/>
          <ac:picMkLst>
            <pc:docMk/>
            <pc:sldMk cId="2888039256" sldId="295"/>
            <ac:picMk id="2" creationId="{4CBE46D0-A623-46B9-9534-71797073D1C7}"/>
          </ac:picMkLst>
        </pc:picChg>
        <pc:picChg chg="del">
          <ac:chgData name="Filippo Acconcia" userId="844af49c-a8a0-47ac-a7dd-14a44b60cd18" providerId="ADAL" clId="{998C6BF7-482B-421C-8ECC-9091B23559F6}" dt="2022-03-24T06:46:08.556" v="11" actId="478"/>
          <ac:picMkLst>
            <pc:docMk/>
            <pc:sldMk cId="2888039256" sldId="295"/>
            <ac:picMk id="3" creationId="{2448C309-40FA-4C0F-92A7-24A3DD9AC942}"/>
          </ac:picMkLst>
        </pc:picChg>
        <pc:picChg chg="add del mod ord">
          <ac:chgData name="Filippo Acconcia" userId="844af49c-a8a0-47ac-a7dd-14a44b60cd18" providerId="ADAL" clId="{998C6BF7-482B-421C-8ECC-9091B23559F6}" dt="2022-04-02T06:49:03.657" v="542" actId="164"/>
          <ac:picMkLst>
            <pc:docMk/>
            <pc:sldMk cId="2888039256" sldId="295"/>
            <ac:picMk id="3" creationId="{69B81066-AC21-4CDD-8A85-AF6E176965F3}"/>
          </ac:picMkLst>
        </pc:picChg>
        <pc:picChg chg="mod ord">
          <ac:chgData name="Filippo Acconcia" userId="844af49c-a8a0-47ac-a7dd-14a44b60cd18" providerId="ADAL" clId="{998C6BF7-482B-421C-8ECC-9091B23559F6}" dt="2022-04-02T06:49:07.898" v="543" actId="164"/>
          <ac:picMkLst>
            <pc:docMk/>
            <pc:sldMk cId="2888039256" sldId="295"/>
            <ac:picMk id="8" creationId="{97A6F030-C44D-4BDB-B296-374C6622C38A}"/>
          </ac:picMkLst>
        </pc:picChg>
        <pc:picChg chg="mod ord">
          <ac:chgData name="Filippo Acconcia" userId="844af49c-a8a0-47ac-a7dd-14a44b60cd18" providerId="ADAL" clId="{998C6BF7-482B-421C-8ECC-9091B23559F6}" dt="2022-04-02T06:50:03.238" v="550" actId="164"/>
          <ac:picMkLst>
            <pc:docMk/>
            <pc:sldMk cId="2888039256" sldId="295"/>
            <ac:picMk id="11" creationId="{84589174-2489-43BD-BBF2-19F8D86E77CB}"/>
          </ac:picMkLst>
        </pc:picChg>
        <pc:picChg chg="mod">
          <ac:chgData name="Filippo Acconcia" userId="844af49c-a8a0-47ac-a7dd-14a44b60cd18" providerId="ADAL" clId="{998C6BF7-482B-421C-8ECC-9091B23559F6}" dt="2022-03-24T06:46:24.683" v="12"/>
          <ac:picMkLst>
            <pc:docMk/>
            <pc:sldMk cId="2888039256" sldId="295"/>
            <ac:picMk id="83" creationId="{DD4B2141-008B-427C-B4B7-E460FE33E0F5}"/>
          </ac:picMkLst>
        </pc:picChg>
        <pc:picChg chg="mod">
          <ac:chgData name="Filippo Acconcia" userId="844af49c-a8a0-47ac-a7dd-14a44b60cd18" providerId="ADAL" clId="{998C6BF7-482B-421C-8ECC-9091B23559F6}" dt="2022-03-24T06:46:24.683" v="12"/>
          <ac:picMkLst>
            <pc:docMk/>
            <pc:sldMk cId="2888039256" sldId="295"/>
            <ac:picMk id="84" creationId="{8DA32114-7C70-4CEE-BF08-E8B72CCCE389}"/>
          </ac:picMkLst>
        </pc:picChg>
        <pc:picChg chg="mod">
          <ac:chgData name="Filippo Acconcia" userId="844af49c-a8a0-47ac-a7dd-14a44b60cd18" providerId="ADAL" clId="{998C6BF7-482B-421C-8ECC-9091B23559F6}" dt="2022-03-24T06:46:24.683" v="12"/>
          <ac:picMkLst>
            <pc:docMk/>
            <pc:sldMk cId="2888039256" sldId="295"/>
            <ac:picMk id="85" creationId="{499E7C11-8A87-433B-B67C-254713957AB6}"/>
          </ac:picMkLst>
        </pc:picChg>
        <pc:picChg chg="mod">
          <ac:chgData name="Filippo Acconcia" userId="844af49c-a8a0-47ac-a7dd-14a44b60cd18" providerId="ADAL" clId="{998C6BF7-482B-421C-8ECC-9091B23559F6}" dt="2022-03-24T06:49:01.329" v="13"/>
          <ac:picMkLst>
            <pc:docMk/>
            <pc:sldMk cId="2888039256" sldId="295"/>
            <ac:picMk id="90" creationId="{1CAE8395-6925-4414-A685-BFAD4523B818}"/>
          </ac:picMkLst>
        </pc:picChg>
        <pc:picChg chg="mod">
          <ac:chgData name="Filippo Acconcia" userId="844af49c-a8a0-47ac-a7dd-14a44b60cd18" providerId="ADAL" clId="{998C6BF7-482B-421C-8ECC-9091B23559F6}" dt="2022-03-24T06:49:01.329" v="13"/>
          <ac:picMkLst>
            <pc:docMk/>
            <pc:sldMk cId="2888039256" sldId="295"/>
            <ac:picMk id="91" creationId="{C5E02D75-AD83-47B6-A04E-2A3F4B49FBE5}"/>
          </ac:picMkLst>
        </pc:picChg>
        <pc:picChg chg="del">
          <ac:chgData name="Filippo Acconcia" userId="844af49c-a8a0-47ac-a7dd-14a44b60cd18" providerId="ADAL" clId="{998C6BF7-482B-421C-8ECC-9091B23559F6}" dt="2022-03-24T06:46:08.556" v="11" actId="478"/>
          <ac:picMkLst>
            <pc:docMk/>
            <pc:sldMk cId="2888039256" sldId="295"/>
            <ac:picMk id="117" creationId="{EA6E6079-163A-4FE2-92CF-B5B7577A5458}"/>
          </ac:picMkLst>
        </pc:picChg>
        <pc:picChg chg="mod topLvl">
          <ac:chgData name="Filippo Acconcia" userId="844af49c-a8a0-47ac-a7dd-14a44b60cd18" providerId="ADAL" clId="{998C6BF7-482B-421C-8ECC-9091B23559F6}" dt="2022-04-02T06:46:45.572" v="509" actId="338"/>
          <ac:picMkLst>
            <pc:docMk/>
            <pc:sldMk cId="2888039256" sldId="295"/>
            <ac:picMk id="119" creationId="{2437D470-7B97-47BB-858D-BA9E17C43E84}"/>
          </ac:picMkLst>
        </pc:picChg>
        <pc:picChg chg="mod topLvl">
          <ac:chgData name="Filippo Acconcia" userId="844af49c-a8a0-47ac-a7dd-14a44b60cd18" providerId="ADAL" clId="{998C6BF7-482B-421C-8ECC-9091B23559F6}" dt="2022-04-02T06:46:45.572" v="509" actId="338"/>
          <ac:picMkLst>
            <pc:docMk/>
            <pc:sldMk cId="2888039256" sldId="295"/>
            <ac:picMk id="120" creationId="{C93F3201-7689-439D-9348-1CE7EAE608CC}"/>
          </ac:picMkLst>
        </pc:picChg>
        <pc:picChg chg="mod topLvl">
          <ac:chgData name="Filippo Acconcia" userId="844af49c-a8a0-47ac-a7dd-14a44b60cd18" providerId="ADAL" clId="{998C6BF7-482B-421C-8ECC-9091B23559F6}" dt="2022-04-02T06:46:45.572" v="509" actId="338"/>
          <ac:picMkLst>
            <pc:docMk/>
            <pc:sldMk cId="2888039256" sldId="295"/>
            <ac:picMk id="121" creationId="{7F51D9D0-A617-49B4-B859-F87B82162A2C}"/>
          </ac:picMkLst>
        </pc:picChg>
        <pc:picChg chg="mod topLvl">
          <ac:chgData name="Filippo Acconcia" userId="844af49c-a8a0-47ac-a7dd-14a44b60cd18" providerId="ADAL" clId="{998C6BF7-482B-421C-8ECC-9091B23559F6}" dt="2022-04-02T06:46:45.572" v="509" actId="338"/>
          <ac:picMkLst>
            <pc:docMk/>
            <pc:sldMk cId="2888039256" sldId="295"/>
            <ac:picMk id="122" creationId="{B7D9E4F4-19D9-41A3-BE89-6FD1D475C9FC}"/>
          </ac:picMkLst>
        </pc:picChg>
        <pc:picChg chg="mod">
          <ac:chgData name="Filippo Acconcia" userId="844af49c-a8a0-47ac-a7dd-14a44b60cd18" providerId="ADAL" clId="{998C6BF7-482B-421C-8ECC-9091B23559F6}" dt="2022-03-24T06:49:24.375" v="22"/>
          <ac:picMkLst>
            <pc:docMk/>
            <pc:sldMk cId="2888039256" sldId="295"/>
            <ac:picMk id="124" creationId="{5DDF323F-7AB0-46D1-B6BB-EEA8B24BF766}"/>
          </ac:picMkLst>
        </pc:picChg>
        <pc:picChg chg="mod">
          <ac:chgData name="Filippo Acconcia" userId="844af49c-a8a0-47ac-a7dd-14a44b60cd18" providerId="ADAL" clId="{998C6BF7-482B-421C-8ECC-9091B23559F6}" dt="2022-03-24T06:49:24.375" v="22"/>
          <ac:picMkLst>
            <pc:docMk/>
            <pc:sldMk cId="2888039256" sldId="295"/>
            <ac:picMk id="125" creationId="{2A3369F2-9072-495F-A57D-8499B57EE466}"/>
          </ac:picMkLst>
        </pc:picChg>
        <pc:picChg chg="mod">
          <ac:chgData name="Filippo Acconcia" userId="844af49c-a8a0-47ac-a7dd-14a44b60cd18" providerId="ADAL" clId="{998C6BF7-482B-421C-8ECC-9091B23559F6}" dt="2022-03-24T06:49:24.375" v="22"/>
          <ac:picMkLst>
            <pc:docMk/>
            <pc:sldMk cId="2888039256" sldId="295"/>
            <ac:picMk id="128" creationId="{2C7EF384-BB6B-4911-B00A-EDA30588D75B}"/>
          </ac:picMkLst>
        </pc:picChg>
        <pc:picChg chg="mod">
          <ac:chgData name="Filippo Acconcia" userId="844af49c-a8a0-47ac-a7dd-14a44b60cd18" providerId="ADAL" clId="{998C6BF7-482B-421C-8ECC-9091B23559F6}" dt="2022-03-24T06:49:24.375" v="22"/>
          <ac:picMkLst>
            <pc:docMk/>
            <pc:sldMk cId="2888039256" sldId="295"/>
            <ac:picMk id="129" creationId="{CBBDCA6F-7108-44DE-979D-CDB4A2B4D23B}"/>
          </ac:picMkLst>
        </pc:picChg>
        <pc:picChg chg="mod">
          <ac:chgData name="Filippo Acconcia" userId="844af49c-a8a0-47ac-a7dd-14a44b60cd18" providerId="ADAL" clId="{998C6BF7-482B-421C-8ECC-9091B23559F6}" dt="2022-03-24T06:49:33.835" v="24"/>
          <ac:picMkLst>
            <pc:docMk/>
            <pc:sldMk cId="2888039256" sldId="295"/>
            <ac:picMk id="154" creationId="{EF5592CA-6FFB-450F-928F-12F81461A72A}"/>
          </ac:picMkLst>
        </pc:picChg>
        <pc:picChg chg="mod">
          <ac:chgData name="Filippo Acconcia" userId="844af49c-a8a0-47ac-a7dd-14a44b60cd18" providerId="ADAL" clId="{998C6BF7-482B-421C-8ECC-9091B23559F6}" dt="2022-03-24T06:49:33.835" v="24"/>
          <ac:picMkLst>
            <pc:docMk/>
            <pc:sldMk cId="2888039256" sldId="295"/>
            <ac:picMk id="155" creationId="{DFB5D778-DAF9-4DD9-8F3C-BE520A3C12EE}"/>
          </ac:picMkLst>
        </pc:picChg>
        <pc:picChg chg="mod">
          <ac:chgData name="Filippo Acconcia" userId="844af49c-a8a0-47ac-a7dd-14a44b60cd18" providerId="ADAL" clId="{998C6BF7-482B-421C-8ECC-9091B23559F6}" dt="2022-04-02T06:34:16.173" v="146"/>
          <ac:picMkLst>
            <pc:docMk/>
            <pc:sldMk cId="2888039256" sldId="295"/>
            <ac:picMk id="165" creationId="{3CBE0DB2-BE88-49E5-B974-A45AFABDE0C6}"/>
          </ac:picMkLst>
        </pc:picChg>
        <pc:picChg chg="mod">
          <ac:chgData name="Filippo Acconcia" userId="844af49c-a8a0-47ac-a7dd-14a44b60cd18" providerId="ADAL" clId="{998C6BF7-482B-421C-8ECC-9091B23559F6}" dt="2022-04-02T06:34:35.196" v="190"/>
          <ac:picMkLst>
            <pc:docMk/>
            <pc:sldMk cId="2888039256" sldId="295"/>
            <ac:picMk id="205" creationId="{28ED18E1-947A-4675-A9AB-2660C8803D39}"/>
          </ac:picMkLst>
        </pc:picChg>
        <pc:picChg chg="del mod topLvl">
          <ac:chgData name="Filippo Acconcia" userId="844af49c-a8a0-47ac-a7dd-14a44b60cd18" providerId="ADAL" clId="{998C6BF7-482B-421C-8ECC-9091B23559F6}" dt="2022-04-02T06:39:22.909" v="239" actId="478"/>
          <ac:picMkLst>
            <pc:docMk/>
            <pc:sldMk cId="2888039256" sldId="295"/>
            <ac:picMk id="245" creationId="{1AD68A12-AE8D-46E9-852B-35485DD5D41F}"/>
          </ac:picMkLst>
        </pc:picChg>
        <pc:picChg chg="add del mod">
          <ac:chgData name="Filippo Acconcia" userId="844af49c-a8a0-47ac-a7dd-14a44b60cd18" providerId="ADAL" clId="{998C6BF7-482B-421C-8ECC-9091B23559F6}" dt="2022-04-02T06:48:56.446" v="541" actId="478"/>
          <ac:picMkLst>
            <pc:docMk/>
            <pc:sldMk cId="2888039256" sldId="295"/>
            <ac:picMk id="291" creationId="{F6C5D79F-2B7E-4FE1-BB9B-8070847D2B25}"/>
          </ac:picMkLst>
        </pc:picChg>
        <pc:picChg chg="add del mod">
          <ac:chgData name="Filippo Acconcia" userId="844af49c-a8a0-47ac-a7dd-14a44b60cd18" providerId="ADAL" clId="{998C6BF7-482B-421C-8ECC-9091B23559F6}" dt="2022-04-02T06:49:56.711" v="549" actId="478"/>
          <ac:picMkLst>
            <pc:docMk/>
            <pc:sldMk cId="2888039256" sldId="295"/>
            <ac:picMk id="311" creationId="{92A23FC4-0388-430C-8C0E-EEF7DCF75507}"/>
          </ac:picMkLst>
        </pc:picChg>
        <pc:cxnChg chg="mod">
          <ac:chgData name="Filippo Acconcia" userId="844af49c-a8a0-47ac-a7dd-14a44b60cd18" providerId="ADAL" clId="{998C6BF7-482B-421C-8ECC-9091B23559F6}" dt="2022-03-24T06:46:24.683" v="12"/>
          <ac:cxnSpMkLst>
            <pc:docMk/>
            <pc:sldMk cId="2888039256" sldId="295"/>
            <ac:cxnSpMk id="82" creationId="{8644FAC1-1850-4BD0-9CB5-46529D9D8F9D}"/>
          </ac:cxnSpMkLst>
        </pc:cxnChg>
        <pc:cxnChg chg="mod">
          <ac:chgData name="Filippo Acconcia" userId="844af49c-a8a0-47ac-a7dd-14a44b60cd18" providerId="ADAL" clId="{998C6BF7-482B-421C-8ECC-9091B23559F6}" dt="2022-03-24T06:46:24.683" v="12"/>
          <ac:cxnSpMkLst>
            <pc:docMk/>
            <pc:sldMk cId="2888039256" sldId="295"/>
            <ac:cxnSpMk id="86" creationId="{73DA890C-1518-40ED-92F4-EB5826C9BC2F}"/>
          </ac:cxnSpMkLst>
        </pc:cxnChg>
        <pc:cxnChg chg="mod">
          <ac:chgData name="Filippo Acconcia" userId="844af49c-a8a0-47ac-a7dd-14a44b60cd18" providerId="ADAL" clId="{998C6BF7-482B-421C-8ECC-9091B23559F6}" dt="2022-03-24T06:49:24.375" v="22"/>
          <ac:cxnSpMkLst>
            <pc:docMk/>
            <pc:sldMk cId="2888039256" sldId="295"/>
            <ac:cxnSpMk id="145" creationId="{9EBBC8B2-3E13-4123-82E4-794997404E90}"/>
          </ac:cxnSpMkLst>
        </pc:cxnChg>
        <pc:cxnChg chg="mod">
          <ac:chgData name="Filippo Acconcia" userId="844af49c-a8a0-47ac-a7dd-14a44b60cd18" providerId="ADAL" clId="{998C6BF7-482B-421C-8ECC-9091B23559F6}" dt="2022-03-24T06:49:24.375" v="22"/>
          <ac:cxnSpMkLst>
            <pc:docMk/>
            <pc:sldMk cId="2888039256" sldId="295"/>
            <ac:cxnSpMk id="146" creationId="{6E5D3C05-AF2D-4EB4-9CB8-6C1A1FFA9311}"/>
          </ac:cxnSpMkLst>
        </pc:cxnChg>
        <pc:cxnChg chg="mod">
          <ac:chgData name="Filippo Acconcia" userId="844af49c-a8a0-47ac-a7dd-14a44b60cd18" providerId="ADAL" clId="{998C6BF7-482B-421C-8ECC-9091B23559F6}" dt="2022-04-02T06:34:16.173" v="146"/>
          <ac:cxnSpMkLst>
            <pc:docMk/>
            <pc:sldMk cId="2888039256" sldId="295"/>
            <ac:cxnSpMk id="180" creationId="{E05DABDE-7269-49FC-8929-F0D0271BBBF8}"/>
          </ac:cxnSpMkLst>
        </pc:cxnChg>
        <pc:cxnChg chg="mod">
          <ac:chgData name="Filippo Acconcia" userId="844af49c-a8a0-47ac-a7dd-14a44b60cd18" providerId="ADAL" clId="{998C6BF7-482B-421C-8ECC-9091B23559F6}" dt="2022-04-02T06:34:16.173" v="146"/>
          <ac:cxnSpMkLst>
            <pc:docMk/>
            <pc:sldMk cId="2888039256" sldId="295"/>
            <ac:cxnSpMk id="182" creationId="{3B13A0DB-81E5-4CC3-B139-12B468425F8E}"/>
          </ac:cxnSpMkLst>
        </pc:cxnChg>
        <pc:cxnChg chg="mod">
          <ac:chgData name="Filippo Acconcia" userId="844af49c-a8a0-47ac-a7dd-14a44b60cd18" providerId="ADAL" clId="{998C6BF7-482B-421C-8ECC-9091B23559F6}" dt="2022-04-02T06:34:16.173" v="146"/>
          <ac:cxnSpMkLst>
            <pc:docMk/>
            <pc:sldMk cId="2888039256" sldId="295"/>
            <ac:cxnSpMk id="184" creationId="{2D23776F-F035-41C7-BDB4-A810FFDF38CA}"/>
          </ac:cxnSpMkLst>
        </pc:cxnChg>
        <pc:cxnChg chg="mod">
          <ac:chgData name="Filippo Acconcia" userId="844af49c-a8a0-47ac-a7dd-14a44b60cd18" providerId="ADAL" clId="{998C6BF7-482B-421C-8ECC-9091B23559F6}" dt="2022-04-02T06:34:16.173" v="146"/>
          <ac:cxnSpMkLst>
            <pc:docMk/>
            <pc:sldMk cId="2888039256" sldId="295"/>
            <ac:cxnSpMk id="198" creationId="{D41D4163-B89C-4EBA-9757-351C4ECAE1B6}"/>
          </ac:cxnSpMkLst>
        </pc:cxnChg>
        <pc:cxnChg chg="mod">
          <ac:chgData name="Filippo Acconcia" userId="844af49c-a8a0-47ac-a7dd-14a44b60cd18" providerId="ADAL" clId="{998C6BF7-482B-421C-8ECC-9091B23559F6}" dt="2022-04-02T06:34:35.196" v="190"/>
          <ac:cxnSpMkLst>
            <pc:docMk/>
            <pc:sldMk cId="2888039256" sldId="295"/>
            <ac:cxnSpMk id="220" creationId="{753F1DCB-8A7E-42BC-8470-8CD9A3F13C58}"/>
          </ac:cxnSpMkLst>
        </pc:cxnChg>
        <pc:cxnChg chg="mod">
          <ac:chgData name="Filippo Acconcia" userId="844af49c-a8a0-47ac-a7dd-14a44b60cd18" providerId="ADAL" clId="{998C6BF7-482B-421C-8ECC-9091B23559F6}" dt="2022-04-02T06:34:35.196" v="190"/>
          <ac:cxnSpMkLst>
            <pc:docMk/>
            <pc:sldMk cId="2888039256" sldId="295"/>
            <ac:cxnSpMk id="222" creationId="{A51DEFD5-C4B4-46EB-B85D-D85113F060EF}"/>
          </ac:cxnSpMkLst>
        </pc:cxnChg>
        <pc:cxnChg chg="mod">
          <ac:chgData name="Filippo Acconcia" userId="844af49c-a8a0-47ac-a7dd-14a44b60cd18" providerId="ADAL" clId="{998C6BF7-482B-421C-8ECC-9091B23559F6}" dt="2022-04-02T06:34:35.196" v="190"/>
          <ac:cxnSpMkLst>
            <pc:docMk/>
            <pc:sldMk cId="2888039256" sldId="295"/>
            <ac:cxnSpMk id="224" creationId="{ECD83F1B-4761-4037-9587-C9CF6109D62C}"/>
          </ac:cxnSpMkLst>
        </pc:cxnChg>
        <pc:cxnChg chg="mod">
          <ac:chgData name="Filippo Acconcia" userId="844af49c-a8a0-47ac-a7dd-14a44b60cd18" providerId="ADAL" clId="{998C6BF7-482B-421C-8ECC-9091B23559F6}" dt="2022-04-02T06:34:35.196" v="190"/>
          <ac:cxnSpMkLst>
            <pc:docMk/>
            <pc:sldMk cId="2888039256" sldId="295"/>
            <ac:cxnSpMk id="238" creationId="{F6247F6B-BE1F-41A5-8893-12761B47C67D}"/>
          </ac:cxnSpMkLst>
        </pc:cxnChg>
        <pc:cxnChg chg="mod topLvl">
          <ac:chgData name="Filippo Acconcia" userId="844af49c-a8a0-47ac-a7dd-14a44b60cd18" providerId="ADAL" clId="{998C6BF7-482B-421C-8ECC-9091B23559F6}" dt="2022-04-02T06:49:03.657" v="542" actId="164"/>
          <ac:cxnSpMkLst>
            <pc:docMk/>
            <pc:sldMk cId="2888039256" sldId="295"/>
            <ac:cxnSpMk id="260" creationId="{87D40D7B-C2E4-4BE3-BCE0-8CFCC1EF47D2}"/>
          </ac:cxnSpMkLst>
        </pc:cxnChg>
        <pc:cxnChg chg="mod topLvl">
          <ac:chgData name="Filippo Acconcia" userId="844af49c-a8a0-47ac-a7dd-14a44b60cd18" providerId="ADAL" clId="{998C6BF7-482B-421C-8ECC-9091B23559F6}" dt="2022-04-02T06:49:03.657" v="542" actId="164"/>
          <ac:cxnSpMkLst>
            <pc:docMk/>
            <pc:sldMk cId="2888039256" sldId="295"/>
            <ac:cxnSpMk id="262" creationId="{F51D0045-CC3B-4CBF-ADEA-8C601A0400EA}"/>
          </ac:cxnSpMkLst>
        </pc:cxnChg>
        <pc:cxnChg chg="del mod topLvl">
          <ac:chgData name="Filippo Acconcia" userId="844af49c-a8a0-47ac-a7dd-14a44b60cd18" providerId="ADAL" clId="{998C6BF7-482B-421C-8ECC-9091B23559F6}" dt="2022-04-02T06:43:05.858" v="375" actId="478"/>
          <ac:cxnSpMkLst>
            <pc:docMk/>
            <pc:sldMk cId="2888039256" sldId="295"/>
            <ac:cxnSpMk id="264" creationId="{7F7F437D-57AD-47C0-B8CA-D921EB6AF875}"/>
          </ac:cxnSpMkLst>
        </pc:cxnChg>
        <pc:cxnChg chg="mod">
          <ac:chgData name="Filippo Acconcia" userId="844af49c-a8a0-47ac-a7dd-14a44b60cd18" providerId="ADAL" clId="{998C6BF7-482B-421C-8ECC-9091B23559F6}" dt="2022-04-02T06:39:02.401" v="234" actId="165"/>
          <ac:cxnSpMkLst>
            <pc:docMk/>
            <pc:sldMk cId="2888039256" sldId="295"/>
            <ac:cxnSpMk id="278" creationId="{1F175B7A-68F8-4CDC-9504-DA90A90AD0F3}"/>
          </ac:cxnSpMkLst>
        </pc:cxnChg>
        <pc:cxnChg chg="add mod">
          <ac:chgData name="Filippo Acconcia" userId="844af49c-a8a0-47ac-a7dd-14a44b60cd18" providerId="ADAL" clId="{998C6BF7-482B-421C-8ECC-9091B23559F6}" dt="2022-04-02T06:49:07.898" v="543" actId="164"/>
          <ac:cxnSpMkLst>
            <pc:docMk/>
            <pc:sldMk cId="2888039256" sldId="295"/>
            <ac:cxnSpMk id="302" creationId="{775EB987-96BD-4B73-A0D9-248322C24CF9}"/>
          </ac:cxnSpMkLst>
        </pc:cxnChg>
        <pc:cxnChg chg="add mod">
          <ac:chgData name="Filippo Acconcia" userId="844af49c-a8a0-47ac-a7dd-14a44b60cd18" providerId="ADAL" clId="{998C6BF7-482B-421C-8ECC-9091B23559F6}" dt="2022-04-02T06:49:07.898" v="543" actId="164"/>
          <ac:cxnSpMkLst>
            <pc:docMk/>
            <pc:sldMk cId="2888039256" sldId="295"/>
            <ac:cxnSpMk id="304" creationId="{F7B293F4-FD46-4EF3-93E7-5EFD8FE69A25}"/>
          </ac:cxnSpMkLst>
        </pc:cxnChg>
        <pc:cxnChg chg="add mod">
          <ac:chgData name="Filippo Acconcia" userId="844af49c-a8a0-47ac-a7dd-14a44b60cd18" providerId="ADAL" clId="{998C6BF7-482B-421C-8ECC-9091B23559F6}" dt="2022-04-02T06:50:03.238" v="550" actId="164"/>
          <ac:cxnSpMkLst>
            <pc:docMk/>
            <pc:sldMk cId="2888039256" sldId="295"/>
            <ac:cxnSpMk id="322" creationId="{ED4F6FE6-B780-4031-A202-4B3401350706}"/>
          </ac:cxnSpMkLst>
        </pc:cxnChg>
        <pc:cxnChg chg="add mod">
          <ac:chgData name="Filippo Acconcia" userId="844af49c-a8a0-47ac-a7dd-14a44b60cd18" providerId="ADAL" clId="{998C6BF7-482B-421C-8ECC-9091B23559F6}" dt="2022-04-02T06:50:03.238" v="550" actId="164"/>
          <ac:cxnSpMkLst>
            <pc:docMk/>
            <pc:sldMk cId="2888039256" sldId="295"/>
            <ac:cxnSpMk id="324" creationId="{D511AFC3-A053-4C6D-9F05-BE6B8BAC622E}"/>
          </ac:cxnSpMkLst>
        </pc:cxnChg>
      </pc:sldChg>
      <pc:sldChg chg="del">
        <pc:chgData name="Filippo Acconcia" userId="844af49c-a8a0-47ac-a7dd-14a44b60cd18" providerId="ADAL" clId="{998C6BF7-482B-421C-8ECC-9091B23559F6}" dt="2022-03-24T06:46:03.624" v="10" actId="47"/>
        <pc:sldMkLst>
          <pc:docMk/>
          <pc:sldMk cId="1382004982" sldId="296"/>
        </pc:sldMkLst>
      </pc:sldChg>
      <pc:sldChg chg="addSp modSp new mod">
        <pc:chgData name="Filippo Acconcia" userId="844af49c-a8a0-47ac-a7dd-14a44b60cd18" providerId="ADAL" clId="{998C6BF7-482B-421C-8ECC-9091B23559F6}" dt="2022-03-26T07:22:53.592" v="49" actId="1076"/>
        <pc:sldMkLst>
          <pc:docMk/>
          <pc:sldMk cId="2620120220" sldId="296"/>
        </pc:sldMkLst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4" creationId="{69249F7E-59C4-480B-9F2F-38680BD52BF1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5" creationId="{DC6DDC4D-7A12-41BB-A98F-DB1A71F514D0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6" creationId="{4D5066DA-1577-4E43-966A-CA94809FFB50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7" creationId="{0A9C8B70-1DC0-4D8E-9741-68876777B6BF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8" creationId="{720AE546-D4F1-496F-872E-47B776822887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9" creationId="{1305C0EF-1BAE-46E6-ADA8-283FE5A8357E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10" creationId="{DBC0E799-4484-4BB2-970D-A8FFD1E82367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11" creationId="{A9B4F47D-D18F-4873-81B4-DD10B5C2A93F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12" creationId="{987EC4C4-A88E-4A35-9E27-109E48EFA864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13" creationId="{24676B1B-A884-406F-AF3D-42AF74632969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14" creationId="{E7078F6E-41F1-405D-B553-206C9D983531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15" creationId="{572CA6AF-6151-411B-B0A8-FFD3F8615099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16" creationId="{DFA68455-3E95-48F9-A6FE-91E7A0C44F7B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17" creationId="{4B8BFA68-2CE1-4B6B-AF74-F97EB2E1D9D2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18" creationId="{452FFEC8-8394-4F3E-830E-ECB802E7C123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20" creationId="{A5E76571-DEF3-417F-8022-3D35E29FD3E9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21" creationId="{76FA0EA6-8CEE-4128-A4FE-B2A0D8F48713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22" creationId="{4620D002-9B6A-4C73-AF44-ADAEC613211B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23" creationId="{AEE7D0E3-A1AE-4391-A93C-36493A8CAE57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28" creationId="{2FF1220E-BCD6-4F5D-B8A5-425CF4F1E8CD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29" creationId="{5A719318-5AC9-46FD-84C6-E42B8B50F1C9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30" creationId="{8C841988-523D-49AE-AA63-A922D59AC834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31" creationId="{8D15FBBE-A98E-4C23-B5C3-37F999FAA3AA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32" creationId="{D45E1F19-07AD-410F-BC91-0DD6283DB572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33" creationId="{DC7AD6B5-C5DB-4135-BCDF-2DBD17535FFA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34" creationId="{D5CDF359-0CBD-4644-84C8-951086287344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35" creationId="{25998730-B131-42CD-94D4-982B837E3DD6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36" creationId="{2A4E6340-9047-48BD-8BA1-398817C13C68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37" creationId="{EAE95D58-72C1-43DF-A5E9-898A50AD82D7}"/>
          </ac:spMkLst>
        </pc:spChg>
        <pc:spChg chg="mod">
          <ac:chgData name="Filippo Acconcia" userId="844af49c-a8a0-47ac-a7dd-14a44b60cd18" providerId="ADAL" clId="{998C6BF7-482B-421C-8ECC-9091B23559F6}" dt="2022-03-24T06:50:14.934" v="30"/>
          <ac:spMkLst>
            <pc:docMk/>
            <pc:sldMk cId="2620120220" sldId="296"/>
            <ac:spMk id="38" creationId="{019464BD-A4C2-4DEB-B5A8-69C3D626AEF8}"/>
          </ac:spMkLst>
        </pc:spChg>
        <pc:spChg chg="add mod">
          <ac:chgData name="Filippo Acconcia" userId="844af49c-a8a0-47ac-a7dd-14a44b60cd18" providerId="ADAL" clId="{998C6BF7-482B-421C-8ECC-9091B23559F6}" dt="2022-03-26T07:22:41.702" v="46" actId="1076"/>
          <ac:spMkLst>
            <pc:docMk/>
            <pc:sldMk cId="2620120220" sldId="296"/>
            <ac:spMk id="39" creationId="{8A01E6F1-0440-4ED6-B837-21F248CD0B8D}"/>
          </ac:spMkLst>
        </pc:spChg>
        <pc:spChg chg="add mod">
          <ac:chgData name="Filippo Acconcia" userId="844af49c-a8a0-47ac-a7dd-14a44b60cd18" providerId="ADAL" clId="{998C6BF7-482B-421C-8ECC-9091B23559F6}" dt="2022-03-26T07:22:41.702" v="46" actId="1076"/>
          <ac:spMkLst>
            <pc:docMk/>
            <pc:sldMk cId="2620120220" sldId="296"/>
            <ac:spMk id="40" creationId="{88E0AE6A-D758-4B38-925D-58E303D2D885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43" creationId="{010F3158-2636-4931-9C21-ED315EA3E980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44" creationId="{B498F315-18BB-4A5A-BE07-0E8F72CF1AE7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45" creationId="{F34D97BD-98C6-49F3-8446-C9FAE2ECE495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46" creationId="{D02D2593-722F-4E17-9947-62FA4345B912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47" creationId="{9B2BFA0F-79EC-40D6-840B-3F40BB772152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48" creationId="{6DB1AA80-77FE-489C-B0C3-A66CD8A4FEEC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49" creationId="{E9C05D2C-08D8-4941-9F96-3C670EC369A1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50" creationId="{F9FF63CD-1353-42CC-A1D4-61599A985BF6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51" creationId="{D91D4456-D896-4576-A0A5-AAB906A235A5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52" creationId="{26D943AC-2543-44E6-9E50-BEE0E842918C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53" creationId="{178B5F44-1E85-47B0-BF3A-1531FF1BBC91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54" creationId="{C6D4D7F9-488F-45AA-8F74-A52E37607E1E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55" creationId="{D5B0F797-DF0C-4AF5-82A1-0CEB9A2AC0E1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56" creationId="{5DF1DC42-33FB-4BC3-A586-FF45E3436E7F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57" creationId="{E89E76E9-541A-46FE-BE92-CAC1C327241E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58" creationId="{9979873D-0808-4703-98D3-D9283E33F6C7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59" creationId="{DADFCAF3-3660-49E7-8CE7-51FB71B45D67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60" creationId="{EB31B7AE-65CD-4916-881D-9E15C532B267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61" creationId="{3F712C5B-DA47-412F-AFE0-AE32931ABF0C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62" creationId="{D072D776-BD49-431C-AA29-302A92E75017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63" creationId="{AF50F78E-6945-4A0F-8439-CCA019134308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64" creationId="{80EF68DB-B0E4-458E-BE94-B59D7F574EBC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65" creationId="{8C5BB8AF-4769-47A2-8671-67393D849CC1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66" creationId="{AFF00524-40D1-43E0-AD92-3536ED5E8FB9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67" creationId="{97E07050-CA57-432F-BE37-C54663FCD5B1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68" creationId="{E5987EA4-45C7-414F-BB15-8F8868079F0D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69" creationId="{3EAFD1F9-26D8-4E7D-8792-F3F5E554FE45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70" creationId="{D54EF837-8AFF-44FB-9803-C5A1F4162389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71" creationId="{7BA424E7-846A-4420-9798-6554C76CE553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72" creationId="{9CF97B58-0EC9-4F85-9F25-431A8E7A5ACD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73" creationId="{76A02664-3325-484B-AD8B-C253EFEDCA98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74" creationId="{AC917209-136A-4489-86B1-EA85B5D137F9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75" creationId="{044C5394-78C0-4DF3-9332-B2EEE054D167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76" creationId="{5AAD93FF-6995-420D-94CE-276FD40B7662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77" creationId="{F52976FA-5093-4D9F-8ADF-01F5729A2B91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78" creationId="{39F70325-2DE9-4BD4-9B97-3BA2483D4145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79" creationId="{841A5C08-01B2-45A1-AF34-F7DC21EA587C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80" creationId="{B5F291AF-6306-4E63-92B2-C1FCC3B2500C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81" creationId="{9EF6A343-A4F3-40AA-8DDD-A210E8B5A6E0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82" creationId="{DFFBBDA1-592D-4BE2-BDA6-3A3FA32AF8D9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83" creationId="{B017C46B-B5FA-4959-A226-1521C23FA275}"/>
          </ac:spMkLst>
        </pc:spChg>
        <pc:spChg chg="mod">
          <ac:chgData name="Filippo Acconcia" userId="844af49c-a8a0-47ac-a7dd-14a44b60cd18" providerId="ADAL" clId="{998C6BF7-482B-421C-8ECC-9091B23559F6}" dt="2022-03-26T07:13:49.171" v="41" actId="1076"/>
          <ac:spMkLst>
            <pc:docMk/>
            <pc:sldMk cId="2620120220" sldId="296"/>
            <ac:spMk id="84" creationId="{0D8B9A86-6F2D-4D40-A45B-B6C7F10C772B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85" creationId="{38B865CE-8B61-4006-BCA8-43C77885D638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86" creationId="{3CC55216-BCEA-472B-8B28-FA192766A03A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87" creationId="{1A597D16-8D24-4165-975D-EA05979A5987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88" creationId="{7A3DE783-7386-470B-8C3C-33C16E4FCB10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89" creationId="{91385D68-35CA-43CC-A367-2E34498FAC5D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90" creationId="{496EC165-31EF-427F-B657-ECBFBDCF1DAA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91" creationId="{FB79D450-95C5-4F0D-A1E0-A3BF331F28A8}"/>
          </ac:spMkLst>
        </pc:spChg>
        <pc:spChg chg="add mod">
          <ac:chgData name="Filippo Acconcia" userId="844af49c-a8a0-47ac-a7dd-14a44b60cd18" providerId="ADAL" clId="{998C6BF7-482B-421C-8ECC-9091B23559F6}" dt="2022-03-26T07:22:48.426" v="47" actId="1076"/>
          <ac:spMkLst>
            <pc:docMk/>
            <pc:sldMk cId="2620120220" sldId="296"/>
            <ac:spMk id="92" creationId="{E9CF0909-687C-4E54-9BB8-8832A3B56B91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95" creationId="{344EA534-BCE5-467C-B957-D0E450E9C3C4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96" creationId="{67421DA1-6536-4AD3-A536-905F17606D4A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97" creationId="{3E0F89C4-A794-4612-8C9D-BF3222E40158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98" creationId="{27459D88-C212-460A-A731-98D985475D51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99" creationId="{252E63FB-25D5-4DB2-97A9-CF3AAED381E3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100" creationId="{4F7E501F-3B6D-4189-8529-3F8A1EC93089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101" creationId="{95FDC632-3CE0-4459-A6CF-1622E372B324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102" creationId="{E943AC0E-26A3-4B15-BB5C-56F7B70511DA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103" creationId="{79A7965D-210D-4B52-9A28-73DD45189F84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104" creationId="{F41B0618-D24D-4255-A3B7-C0F96E6EC228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105" creationId="{4CAA97D5-874F-4DDE-8A20-2DB39829BFDD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106" creationId="{43201DF7-C4D9-4F6C-B5A9-DEE727DB558E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107" creationId="{04025F72-8EA9-4CC6-95D3-CF496942E5B8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108" creationId="{1794498D-719D-4B42-820D-8C4D4BEEC364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109" creationId="{92AD07A5-0D89-4031-BD4E-7E3C88B83711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110" creationId="{606656D4-B318-49F4-8771-F4F4E151B8CF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111" creationId="{E80C056C-FC99-4763-9D23-261AC9FEE9EB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112" creationId="{D1675CAD-4267-46DB-B61B-46E7E33DF6C8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113" creationId="{0D8A0080-7E4D-4932-977E-407833C42B81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114" creationId="{72F72573-FC50-4E3F-8CF0-49753FA8547A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115" creationId="{1E95A3A7-1479-4430-B844-7D4AB3CF0FCC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116" creationId="{D1510110-2805-41D2-9047-FCD301FE7A5D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117" creationId="{FCC86894-EC46-4BF8-9C32-F2C771C8D384}"/>
          </ac:spMkLst>
        </pc:spChg>
        <pc:spChg chg="mod">
          <ac:chgData name="Filippo Acconcia" userId="844af49c-a8a0-47ac-a7dd-14a44b60cd18" providerId="ADAL" clId="{998C6BF7-482B-421C-8ECC-9091B23559F6}" dt="2022-03-24T06:51:36.126" v="32"/>
          <ac:spMkLst>
            <pc:docMk/>
            <pc:sldMk cId="2620120220" sldId="296"/>
            <ac:spMk id="118" creationId="{6303361F-EFC9-46F1-B609-C9A660EC5B84}"/>
          </ac:spMkLst>
        </pc:spChg>
        <pc:spChg chg="add mod">
          <ac:chgData name="Filippo Acconcia" userId="844af49c-a8a0-47ac-a7dd-14a44b60cd18" providerId="ADAL" clId="{998C6BF7-482B-421C-8ECC-9091B23559F6}" dt="2022-03-26T07:22:48.426" v="47" actId="1076"/>
          <ac:spMkLst>
            <pc:docMk/>
            <pc:sldMk cId="2620120220" sldId="296"/>
            <ac:spMk id="119" creationId="{C92280B0-FF3A-453F-8913-6416D71F08B0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21" creationId="{B5628D7D-FA2E-4A7B-AF47-66F883456C9D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22" creationId="{B3F58DE2-6AC1-485B-B2E9-078DCE0977B1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23" creationId="{783ACCBC-032F-4B9B-9973-8C3977231EB5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24" creationId="{EFE13FCF-C8E7-434E-A14D-707151F2C8C3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25" creationId="{8F276876-1880-4838-B2EC-39D739C2F1E0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26" creationId="{0D203BCE-4839-473E-A5CE-AB1C75748440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27" creationId="{4041220B-276C-4457-AA94-377C700D1D36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28" creationId="{5AF75563-27BA-47C9-B7E1-988197B71B5E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36" creationId="{1BEB58A3-078C-443A-AEFA-0CD447F538EA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37" creationId="{CB4EB2D3-D7A8-47AE-8A4B-FB0AAC039842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38" creationId="{B69C2601-30C6-47AD-AD56-7820B498DD2F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39" creationId="{1974C6C3-85C7-4584-AE1C-4764DE3FDE28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40" creationId="{5107AB64-D2D2-49E4-AB38-9038906EDBA5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47" creationId="{8259BCC2-C7D3-4C26-A659-B32DED109CEC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48" creationId="{75369A9A-F959-46D4-B24A-E99DD30C683B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49" creationId="{4CFDD517-8EC1-42CC-BCD3-D602FBC09CE6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50" creationId="{C446CCF3-52DA-4B93-AB4B-0C32825D1970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51" creationId="{7B01CB50-B967-4E8D-88CC-99EF0C65DC7B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52" creationId="{B085D9A1-7F54-41CF-BF2B-23837C5B2081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54" creationId="{E37A8507-11DD-4690-A959-1C9142EF181E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55" creationId="{F01C96C0-60F6-478A-B4D2-28470828AA26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56" creationId="{D57AEFE4-FFC6-44BA-9E9F-A684518ABD24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57" creationId="{0479D374-375D-45D8-ADB6-7A14B32314DE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58" creationId="{1B056BF2-E187-4D27-B6E1-0F97DC09C3FA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59" creationId="{48F356A9-69E6-415B-A54E-06CA0B040C08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60" creationId="{BE258AF2-A53A-4498-9105-5FDE14649C4D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61" creationId="{C848FE93-D20F-4FC2-A13C-DBE4D5FB6581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62" creationId="{510DF2C2-36F6-44BE-BB26-F0FD8A9A79B9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63" creationId="{8756A90D-2A4E-4E76-B7F8-F492FC94E785}"/>
          </ac:spMkLst>
        </pc:spChg>
        <pc:spChg chg="mod">
          <ac:chgData name="Filippo Acconcia" userId="844af49c-a8a0-47ac-a7dd-14a44b60cd18" providerId="ADAL" clId="{998C6BF7-482B-421C-8ECC-9091B23559F6}" dt="2022-03-26T07:14:08.288" v="43"/>
          <ac:spMkLst>
            <pc:docMk/>
            <pc:sldMk cId="2620120220" sldId="296"/>
            <ac:spMk id="164" creationId="{15ACFDE6-B3C6-4F57-B671-6F869DEA8011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174" creationId="{E24257B3-5DA0-4B5C-83A1-D104B991DD68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178" creationId="{A0A82956-22D8-4DEA-8639-B2ADD72EBCBB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179" creationId="{604A7B3C-50EB-4160-BD52-A62247203F67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180" creationId="{3190244A-F5A3-4F11-BF2B-66F534ED4427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181" creationId="{5F4AF4AA-0CA1-4A9E-81FB-483048AC2F60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182" creationId="{A11B54A8-37E6-412E-9FC6-8C1A721F0A4E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183" creationId="{86C6DEB9-889B-4FC0-A43E-30302F1441EA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184" creationId="{88261562-989E-40B4-81D0-C8137C0858C7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185" creationId="{A970EBBC-9B1D-4886-B9A0-35DBB044CFE5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186" creationId="{F0D191E3-44E8-4827-856C-4964055ED77F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187" creationId="{4CE9BEC2-39F0-4BF1-BBB7-55DFE62E7E58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188" creationId="{0CB76EB6-7FBA-46F2-BF41-3DD4597CF140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189" creationId="{CA1D6382-3B31-439B-A747-2FC78B08C8A2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190" creationId="{BD4F8F30-3D0C-4E49-A0B5-0E39CBC4A083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191" creationId="{E4373DF3-BB03-4DD5-A4C3-7D1D3706C909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192" creationId="{6DF62CD4-47B3-4E20-AD1D-70B95C89690A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193" creationId="{ADBC4FD5-3044-4F40-AA40-0A9D4C1D5D70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198" creationId="{C986196D-83B0-48BC-9BA2-493BA160D90A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199" creationId="{F234B049-1FD6-4695-858F-28BF88EB4FB2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200" creationId="{96A673C5-F4E1-4EDE-94C2-35A8BF839D2D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201" creationId="{070A51A8-231E-4D78-99B0-82C47E36370C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202" creationId="{2567F7C0-31A3-454A-AA13-B6404D53394E}"/>
          </ac:spMkLst>
        </pc:spChg>
        <pc:spChg chg="mod">
          <ac:chgData name="Filippo Acconcia" userId="844af49c-a8a0-47ac-a7dd-14a44b60cd18" providerId="ADAL" clId="{998C6BF7-482B-421C-8ECC-9091B23559F6}" dt="2022-03-26T07:22:51.353" v="48"/>
          <ac:spMkLst>
            <pc:docMk/>
            <pc:sldMk cId="2620120220" sldId="296"/>
            <ac:spMk id="203" creationId="{DBC91E65-57A0-405C-8E53-31E761F8DD13}"/>
          </ac:spMkLst>
        </pc:spChg>
        <pc:grpChg chg="add mod">
          <ac:chgData name="Filippo Acconcia" userId="844af49c-a8a0-47ac-a7dd-14a44b60cd18" providerId="ADAL" clId="{998C6BF7-482B-421C-8ECC-9091B23559F6}" dt="2022-03-26T07:22:41.702" v="46" actId="1076"/>
          <ac:grpSpMkLst>
            <pc:docMk/>
            <pc:sldMk cId="2620120220" sldId="296"/>
            <ac:grpSpMk id="2" creationId="{79BF29A4-9A77-43C2-8CF8-380CD9378097}"/>
          </ac:grpSpMkLst>
        </pc:grpChg>
        <pc:grpChg chg="mod">
          <ac:chgData name="Filippo Acconcia" userId="844af49c-a8a0-47ac-a7dd-14a44b60cd18" providerId="ADAL" clId="{998C6BF7-482B-421C-8ECC-9091B23559F6}" dt="2022-03-24T06:50:14.934" v="30"/>
          <ac:grpSpMkLst>
            <pc:docMk/>
            <pc:sldMk cId="2620120220" sldId="296"/>
            <ac:grpSpMk id="19" creationId="{F56CED00-19E0-47D8-930A-63D27825BD6A}"/>
          </ac:grpSpMkLst>
        </pc:grpChg>
        <pc:grpChg chg="add mod">
          <ac:chgData name="Filippo Acconcia" userId="844af49c-a8a0-47ac-a7dd-14a44b60cd18" providerId="ADAL" clId="{998C6BF7-482B-421C-8ECC-9091B23559F6}" dt="2022-03-26T07:22:41.702" v="46" actId="1076"/>
          <ac:grpSpMkLst>
            <pc:docMk/>
            <pc:sldMk cId="2620120220" sldId="296"/>
            <ac:grpSpMk id="26" creationId="{E39CF939-00E1-4278-9E9C-B77A1AF487B0}"/>
          </ac:grpSpMkLst>
        </pc:grpChg>
        <pc:grpChg chg="add mod">
          <ac:chgData name="Filippo Acconcia" userId="844af49c-a8a0-47ac-a7dd-14a44b60cd18" providerId="ADAL" clId="{998C6BF7-482B-421C-8ECC-9091B23559F6}" dt="2022-03-26T07:22:48.426" v="47" actId="1076"/>
          <ac:grpSpMkLst>
            <pc:docMk/>
            <pc:sldMk cId="2620120220" sldId="296"/>
            <ac:grpSpMk id="41" creationId="{145C4BD0-3163-4E4F-ADDF-3781A36814D3}"/>
          </ac:grpSpMkLst>
        </pc:grpChg>
        <pc:grpChg chg="add mod">
          <ac:chgData name="Filippo Acconcia" userId="844af49c-a8a0-47ac-a7dd-14a44b60cd18" providerId="ADAL" clId="{998C6BF7-482B-421C-8ECC-9091B23559F6}" dt="2022-03-26T07:22:48.426" v="47" actId="1076"/>
          <ac:grpSpMkLst>
            <pc:docMk/>
            <pc:sldMk cId="2620120220" sldId="296"/>
            <ac:grpSpMk id="93" creationId="{330071B1-C6CD-4C2F-AD1F-8F9B0F215A79}"/>
          </ac:grpSpMkLst>
        </pc:grpChg>
        <pc:grpChg chg="add mod">
          <ac:chgData name="Filippo Acconcia" userId="844af49c-a8a0-47ac-a7dd-14a44b60cd18" providerId="ADAL" clId="{998C6BF7-482B-421C-8ECC-9091B23559F6}" dt="2022-03-26T07:22:48.426" v="47" actId="1076"/>
          <ac:grpSpMkLst>
            <pc:docMk/>
            <pc:sldMk cId="2620120220" sldId="296"/>
            <ac:grpSpMk id="120" creationId="{6F93F66D-1ED6-4A72-B1C0-B713F6244D97}"/>
          </ac:grpSpMkLst>
        </pc:grpChg>
        <pc:grpChg chg="add mod">
          <ac:chgData name="Filippo Acconcia" userId="844af49c-a8a0-47ac-a7dd-14a44b60cd18" providerId="ADAL" clId="{998C6BF7-482B-421C-8ECC-9091B23559F6}" dt="2022-03-26T07:22:48.426" v="47" actId="1076"/>
          <ac:grpSpMkLst>
            <pc:docMk/>
            <pc:sldMk cId="2620120220" sldId="296"/>
            <ac:grpSpMk id="135" creationId="{0E35562E-E712-4BCC-A8C6-D8B41B85BB02}"/>
          </ac:grpSpMkLst>
        </pc:grpChg>
        <pc:grpChg chg="add mod">
          <ac:chgData name="Filippo Acconcia" userId="844af49c-a8a0-47ac-a7dd-14a44b60cd18" providerId="ADAL" clId="{998C6BF7-482B-421C-8ECC-9091B23559F6}" dt="2022-03-26T07:22:48.426" v="47" actId="1076"/>
          <ac:grpSpMkLst>
            <pc:docMk/>
            <pc:sldMk cId="2620120220" sldId="296"/>
            <ac:grpSpMk id="153" creationId="{F8F4CA2B-8B03-48C6-BDD3-51D135701CE1}"/>
          </ac:grpSpMkLst>
        </pc:grpChg>
        <pc:grpChg chg="add mod">
          <ac:chgData name="Filippo Acconcia" userId="844af49c-a8a0-47ac-a7dd-14a44b60cd18" providerId="ADAL" clId="{998C6BF7-482B-421C-8ECC-9091B23559F6}" dt="2022-03-26T07:22:53.592" v="49" actId="1076"/>
          <ac:grpSpMkLst>
            <pc:docMk/>
            <pc:sldMk cId="2620120220" sldId="296"/>
            <ac:grpSpMk id="171" creationId="{89C73608-F000-4954-8FE0-7D60CE53DB7B}"/>
          </ac:grpSpMkLst>
        </pc:grpChg>
        <pc:grpChg chg="mod">
          <ac:chgData name="Filippo Acconcia" userId="844af49c-a8a0-47ac-a7dd-14a44b60cd18" providerId="ADAL" clId="{998C6BF7-482B-421C-8ECC-9091B23559F6}" dt="2022-03-26T07:22:51.353" v="48"/>
          <ac:grpSpMkLst>
            <pc:docMk/>
            <pc:sldMk cId="2620120220" sldId="296"/>
            <ac:grpSpMk id="172" creationId="{66B498A5-5F8F-44FB-AEA5-423CC99BFD55}"/>
          </ac:grpSpMkLst>
        </pc:grpChg>
        <pc:picChg chg="mod">
          <ac:chgData name="Filippo Acconcia" userId="844af49c-a8a0-47ac-a7dd-14a44b60cd18" providerId="ADAL" clId="{998C6BF7-482B-421C-8ECC-9091B23559F6}" dt="2022-03-24T06:50:14.934" v="30"/>
          <ac:picMkLst>
            <pc:docMk/>
            <pc:sldMk cId="2620120220" sldId="296"/>
            <ac:picMk id="3" creationId="{24113030-64BA-4170-936F-84C4B6371B83}"/>
          </ac:picMkLst>
        </pc:picChg>
        <pc:picChg chg="mod">
          <ac:chgData name="Filippo Acconcia" userId="844af49c-a8a0-47ac-a7dd-14a44b60cd18" providerId="ADAL" clId="{998C6BF7-482B-421C-8ECC-9091B23559F6}" dt="2022-03-24T06:50:14.934" v="30"/>
          <ac:picMkLst>
            <pc:docMk/>
            <pc:sldMk cId="2620120220" sldId="296"/>
            <ac:picMk id="24" creationId="{E2ADDA44-A11B-4CFD-9500-3996AC8265AB}"/>
          </ac:picMkLst>
        </pc:picChg>
        <pc:picChg chg="mod">
          <ac:chgData name="Filippo Acconcia" userId="844af49c-a8a0-47ac-a7dd-14a44b60cd18" providerId="ADAL" clId="{998C6BF7-482B-421C-8ECC-9091B23559F6}" dt="2022-03-24T06:50:14.934" v="30"/>
          <ac:picMkLst>
            <pc:docMk/>
            <pc:sldMk cId="2620120220" sldId="296"/>
            <ac:picMk id="25" creationId="{A17BF55B-DC68-41BB-ACAE-EAD2EFB732AC}"/>
          </ac:picMkLst>
        </pc:picChg>
        <pc:picChg chg="mod">
          <ac:chgData name="Filippo Acconcia" userId="844af49c-a8a0-47ac-a7dd-14a44b60cd18" providerId="ADAL" clId="{998C6BF7-482B-421C-8ECC-9091B23559F6}" dt="2022-03-24T06:50:14.934" v="30"/>
          <ac:picMkLst>
            <pc:docMk/>
            <pc:sldMk cId="2620120220" sldId="296"/>
            <ac:picMk id="27" creationId="{2626B503-4B49-484D-BF4A-9C00AD030123}"/>
          </ac:picMkLst>
        </pc:picChg>
        <pc:picChg chg="mod">
          <ac:chgData name="Filippo Acconcia" userId="844af49c-a8a0-47ac-a7dd-14a44b60cd18" providerId="ADAL" clId="{998C6BF7-482B-421C-8ECC-9091B23559F6}" dt="2022-03-24T06:51:36.126" v="32"/>
          <ac:picMkLst>
            <pc:docMk/>
            <pc:sldMk cId="2620120220" sldId="296"/>
            <ac:picMk id="42" creationId="{35CC6BBA-0FB1-44D9-9F01-F9F647D093D7}"/>
          </ac:picMkLst>
        </pc:picChg>
        <pc:picChg chg="mod">
          <ac:chgData name="Filippo Acconcia" userId="844af49c-a8a0-47ac-a7dd-14a44b60cd18" providerId="ADAL" clId="{998C6BF7-482B-421C-8ECC-9091B23559F6}" dt="2022-03-24T06:51:36.126" v="32"/>
          <ac:picMkLst>
            <pc:docMk/>
            <pc:sldMk cId="2620120220" sldId="296"/>
            <ac:picMk id="94" creationId="{8F2EEB09-28AF-4F85-A00E-6991A2AE089A}"/>
          </ac:picMkLst>
        </pc:picChg>
        <pc:picChg chg="mod">
          <ac:chgData name="Filippo Acconcia" userId="844af49c-a8a0-47ac-a7dd-14a44b60cd18" providerId="ADAL" clId="{998C6BF7-482B-421C-8ECC-9091B23559F6}" dt="2022-03-26T07:14:08.288" v="43"/>
          <ac:picMkLst>
            <pc:docMk/>
            <pc:sldMk cId="2620120220" sldId="296"/>
            <ac:picMk id="129" creationId="{13540AE9-9A8F-4C53-9954-A4017140FED0}"/>
          </ac:picMkLst>
        </pc:picChg>
        <pc:picChg chg="mod">
          <ac:chgData name="Filippo Acconcia" userId="844af49c-a8a0-47ac-a7dd-14a44b60cd18" providerId="ADAL" clId="{998C6BF7-482B-421C-8ECC-9091B23559F6}" dt="2022-03-26T07:14:08.288" v="43"/>
          <ac:picMkLst>
            <pc:docMk/>
            <pc:sldMk cId="2620120220" sldId="296"/>
            <ac:picMk id="130" creationId="{B7356E3C-CC90-4318-B591-6B0D4B7D0469}"/>
          </ac:picMkLst>
        </pc:picChg>
        <pc:picChg chg="mod">
          <ac:chgData name="Filippo Acconcia" userId="844af49c-a8a0-47ac-a7dd-14a44b60cd18" providerId="ADAL" clId="{998C6BF7-482B-421C-8ECC-9091B23559F6}" dt="2022-03-26T07:14:08.288" v="43"/>
          <ac:picMkLst>
            <pc:docMk/>
            <pc:sldMk cId="2620120220" sldId="296"/>
            <ac:picMk id="131" creationId="{40525933-21C9-484D-89A9-8AB6E381D1F5}"/>
          </ac:picMkLst>
        </pc:picChg>
        <pc:picChg chg="mod">
          <ac:chgData name="Filippo Acconcia" userId="844af49c-a8a0-47ac-a7dd-14a44b60cd18" providerId="ADAL" clId="{998C6BF7-482B-421C-8ECC-9091B23559F6}" dt="2022-03-26T07:14:08.288" v="43"/>
          <ac:picMkLst>
            <pc:docMk/>
            <pc:sldMk cId="2620120220" sldId="296"/>
            <ac:picMk id="132" creationId="{78A03315-883A-4D3D-B540-FE1498435386}"/>
          </ac:picMkLst>
        </pc:picChg>
        <pc:picChg chg="mod">
          <ac:chgData name="Filippo Acconcia" userId="844af49c-a8a0-47ac-a7dd-14a44b60cd18" providerId="ADAL" clId="{998C6BF7-482B-421C-8ECC-9091B23559F6}" dt="2022-03-26T07:14:08.288" v="43"/>
          <ac:picMkLst>
            <pc:docMk/>
            <pc:sldMk cId="2620120220" sldId="296"/>
            <ac:picMk id="133" creationId="{46AB9EBA-9BD2-4DA6-8FDC-DE030BE56E2E}"/>
          </ac:picMkLst>
        </pc:picChg>
        <pc:picChg chg="mod">
          <ac:chgData name="Filippo Acconcia" userId="844af49c-a8a0-47ac-a7dd-14a44b60cd18" providerId="ADAL" clId="{998C6BF7-482B-421C-8ECC-9091B23559F6}" dt="2022-03-26T07:14:08.288" v="43"/>
          <ac:picMkLst>
            <pc:docMk/>
            <pc:sldMk cId="2620120220" sldId="296"/>
            <ac:picMk id="134" creationId="{0E0A67DC-A042-430A-AF07-4DE1AA433D07}"/>
          </ac:picMkLst>
        </pc:picChg>
        <pc:picChg chg="mod">
          <ac:chgData name="Filippo Acconcia" userId="844af49c-a8a0-47ac-a7dd-14a44b60cd18" providerId="ADAL" clId="{998C6BF7-482B-421C-8ECC-9091B23559F6}" dt="2022-03-26T07:14:08.288" v="43"/>
          <ac:picMkLst>
            <pc:docMk/>
            <pc:sldMk cId="2620120220" sldId="296"/>
            <ac:picMk id="141" creationId="{AC682B01-ED0E-44F6-8BF5-E05CE42ADB0E}"/>
          </ac:picMkLst>
        </pc:picChg>
        <pc:picChg chg="mod">
          <ac:chgData name="Filippo Acconcia" userId="844af49c-a8a0-47ac-a7dd-14a44b60cd18" providerId="ADAL" clId="{998C6BF7-482B-421C-8ECC-9091B23559F6}" dt="2022-03-26T07:14:08.288" v="43"/>
          <ac:picMkLst>
            <pc:docMk/>
            <pc:sldMk cId="2620120220" sldId="296"/>
            <ac:picMk id="142" creationId="{69BCCAC2-BCEB-4174-9C02-4C9814EFC4BA}"/>
          </ac:picMkLst>
        </pc:picChg>
        <pc:picChg chg="mod">
          <ac:chgData name="Filippo Acconcia" userId="844af49c-a8a0-47ac-a7dd-14a44b60cd18" providerId="ADAL" clId="{998C6BF7-482B-421C-8ECC-9091B23559F6}" dt="2022-03-26T07:14:08.288" v="43"/>
          <ac:picMkLst>
            <pc:docMk/>
            <pc:sldMk cId="2620120220" sldId="296"/>
            <ac:picMk id="143" creationId="{522C15E8-C4DC-4B9E-9104-A9E2A1915CCA}"/>
          </ac:picMkLst>
        </pc:picChg>
        <pc:picChg chg="mod">
          <ac:chgData name="Filippo Acconcia" userId="844af49c-a8a0-47ac-a7dd-14a44b60cd18" providerId="ADAL" clId="{998C6BF7-482B-421C-8ECC-9091B23559F6}" dt="2022-03-26T07:14:08.288" v="43"/>
          <ac:picMkLst>
            <pc:docMk/>
            <pc:sldMk cId="2620120220" sldId="296"/>
            <ac:picMk id="144" creationId="{13591FE0-A9C4-4717-840B-E4EE95C27C3E}"/>
          </ac:picMkLst>
        </pc:picChg>
        <pc:picChg chg="mod">
          <ac:chgData name="Filippo Acconcia" userId="844af49c-a8a0-47ac-a7dd-14a44b60cd18" providerId="ADAL" clId="{998C6BF7-482B-421C-8ECC-9091B23559F6}" dt="2022-03-26T07:14:08.288" v="43"/>
          <ac:picMkLst>
            <pc:docMk/>
            <pc:sldMk cId="2620120220" sldId="296"/>
            <ac:picMk id="145" creationId="{462DD40D-41F3-46DA-91CE-0C819FF2DE2F}"/>
          </ac:picMkLst>
        </pc:picChg>
        <pc:picChg chg="mod">
          <ac:chgData name="Filippo Acconcia" userId="844af49c-a8a0-47ac-a7dd-14a44b60cd18" providerId="ADAL" clId="{998C6BF7-482B-421C-8ECC-9091B23559F6}" dt="2022-03-26T07:14:08.288" v="43"/>
          <ac:picMkLst>
            <pc:docMk/>
            <pc:sldMk cId="2620120220" sldId="296"/>
            <ac:picMk id="146" creationId="{CE47DE7B-B4BA-481D-933C-CE03007F9840}"/>
          </ac:picMkLst>
        </pc:picChg>
        <pc:picChg chg="mod">
          <ac:chgData name="Filippo Acconcia" userId="844af49c-a8a0-47ac-a7dd-14a44b60cd18" providerId="ADAL" clId="{998C6BF7-482B-421C-8ECC-9091B23559F6}" dt="2022-03-26T07:14:08.288" v="43"/>
          <ac:picMkLst>
            <pc:docMk/>
            <pc:sldMk cId="2620120220" sldId="296"/>
            <ac:picMk id="165" creationId="{555B3935-6D1F-42ED-B90C-2F744DCEF939}"/>
          </ac:picMkLst>
        </pc:picChg>
        <pc:picChg chg="mod">
          <ac:chgData name="Filippo Acconcia" userId="844af49c-a8a0-47ac-a7dd-14a44b60cd18" providerId="ADAL" clId="{998C6BF7-482B-421C-8ECC-9091B23559F6}" dt="2022-03-26T07:14:08.288" v="43"/>
          <ac:picMkLst>
            <pc:docMk/>
            <pc:sldMk cId="2620120220" sldId="296"/>
            <ac:picMk id="166" creationId="{0D934417-5A26-4B3C-B4BC-7A5AE3CD61BF}"/>
          </ac:picMkLst>
        </pc:picChg>
        <pc:picChg chg="mod">
          <ac:chgData name="Filippo Acconcia" userId="844af49c-a8a0-47ac-a7dd-14a44b60cd18" providerId="ADAL" clId="{998C6BF7-482B-421C-8ECC-9091B23559F6}" dt="2022-03-26T07:14:08.288" v="43"/>
          <ac:picMkLst>
            <pc:docMk/>
            <pc:sldMk cId="2620120220" sldId="296"/>
            <ac:picMk id="167" creationId="{60C29577-5656-43ED-936E-1B0C9897EA7D}"/>
          </ac:picMkLst>
        </pc:picChg>
        <pc:picChg chg="mod">
          <ac:chgData name="Filippo Acconcia" userId="844af49c-a8a0-47ac-a7dd-14a44b60cd18" providerId="ADAL" clId="{998C6BF7-482B-421C-8ECC-9091B23559F6}" dt="2022-03-26T07:14:08.288" v="43"/>
          <ac:picMkLst>
            <pc:docMk/>
            <pc:sldMk cId="2620120220" sldId="296"/>
            <ac:picMk id="168" creationId="{E25080C9-E95F-4BE8-B219-4AB6F76E692E}"/>
          </ac:picMkLst>
        </pc:picChg>
        <pc:picChg chg="mod">
          <ac:chgData name="Filippo Acconcia" userId="844af49c-a8a0-47ac-a7dd-14a44b60cd18" providerId="ADAL" clId="{998C6BF7-482B-421C-8ECC-9091B23559F6}" dt="2022-03-26T07:14:08.288" v="43"/>
          <ac:picMkLst>
            <pc:docMk/>
            <pc:sldMk cId="2620120220" sldId="296"/>
            <ac:picMk id="169" creationId="{683EE112-6C56-4276-9CE8-BDF2AFB8F6EA}"/>
          </ac:picMkLst>
        </pc:picChg>
        <pc:picChg chg="mod">
          <ac:chgData name="Filippo Acconcia" userId="844af49c-a8a0-47ac-a7dd-14a44b60cd18" providerId="ADAL" clId="{998C6BF7-482B-421C-8ECC-9091B23559F6}" dt="2022-03-26T07:14:08.288" v="43"/>
          <ac:picMkLst>
            <pc:docMk/>
            <pc:sldMk cId="2620120220" sldId="296"/>
            <ac:picMk id="170" creationId="{E6D64E62-ADB5-440C-AB83-085301FB0684}"/>
          </ac:picMkLst>
        </pc:picChg>
        <pc:picChg chg="mod">
          <ac:chgData name="Filippo Acconcia" userId="844af49c-a8a0-47ac-a7dd-14a44b60cd18" providerId="ADAL" clId="{998C6BF7-482B-421C-8ECC-9091B23559F6}" dt="2022-03-26T07:22:51.353" v="48"/>
          <ac:picMkLst>
            <pc:docMk/>
            <pc:sldMk cId="2620120220" sldId="296"/>
            <ac:picMk id="175" creationId="{00413BD4-21A4-40D0-BCDB-EEB3C7144BDB}"/>
          </ac:picMkLst>
        </pc:picChg>
        <pc:picChg chg="mod">
          <ac:chgData name="Filippo Acconcia" userId="844af49c-a8a0-47ac-a7dd-14a44b60cd18" providerId="ADAL" clId="{998C6BF7-482B-421C-8ECC-9091B23559F6}" dt="2022-03-26T07:22:51.353" v="48"/>
          <ac:picMkLst>
            <pc:docMk/>
            <pc:sldMk cId="2620120220" sldId="296"/>
            <ac:picMk id="176" creationId="{10463265-4DCA-41CF-98AC-ECDBC4F0C76B}"/>
          </ac:picMkLst>
        </pc:picChg>
        <pc:picChg chg="mod">
          <ac:chgData name="Filippo Acconcia" userId="844af49c-a8a0-47ac-a7dd-14a44b60cd18" providerId="ADAL" clId="{998C6BF7-482B-421C-8ECC-9091B23559F6}" dt="2022-03-26T07:22:51.353" v="48"/>
          <ac:picMkLst>
            <pc:docMk/>
            <pc:sldMk cId="2620120220" sldId="296"/>
            <ac:picMk id="177" creationId="{9ACF2981-93D7-4E62-B54D-502D8E65A987}"/>
          </ac:picMkLst>
        </pc:picChg>
        <pc:cxnChg chg="mod">
          <ac:chgData name="Filippo Acconcia" userId="844af49c-a8a0-47ac-a7dd-14a44b60cd18" providerId="ADAL" clId="{998C6BF7-482B-421C-8ECC-9091B23559F6}" dt="2022-03-26T07:22:51.353" v="48"/>
          <ac:cxnSpMkLst>
            <pc:docMk/>
            <pc:sldMk cId="2620120220" sldId="296"/>
            <ac:cxnSpMk id="173" creationId="{00EA1F7E-4704-439D-959D-0184BC3702B4}"/>
          </ac:cxnSpMkLst>
        </pc:cxnChg>
        <pc:cxnChg chg="mod">
          <ac:chgData name="Filippo Acconcia" userId="844af49c-a8a0-47ac-a7dd-14a44b60cd18" providerId="ADAL" clId="{998C6BF7-482B-421C-8ECC-9091B23559F6}" dt="2022-03-26T07:22:51.353" v="48"/>
          <ac:cxnSpMkLst>
            <pc:docMk/>
            <pc:sldMk cId="2620120220" sldId="296"/>
            <ac:cxnSpMk id="194" creationId="{190D3AA0-1DE1-49EA-B91E-11256308CF2B}"/>
          </ac:cxnSpMkLst>
        </pc:cxnChg>
        <pc:cxnChg chg="mod">
          <ac:chgData name="Filippo Acconcia" userId="844af49c-a8a0-47ac-a7dd-14a44b60cd18" providerId="ADAL" clId="{998C6BF7-482B-421C-8ECC-9091B23559F6}" dt="2022-03-26T07:22:51.353" v="48"/>
          <ac:cxnSpMkLst>
            <pc:docMk/>
            <pc:sldMk cId="2620120220" sldId="296"/>
            <ac:cxnSpMk id="195" creationId="{301602ED-9CC6-476E-8EBA-09D920D82D00}"/>
          </ac:cxnSpMkLst>
        </pc:cxnChg>
        <pc:cxnChg chg="mod">
          <ac:chgData name="Filippo Acconcia" userId="844af49c-a8a0-47ac-a7dd-14a44b60cd18" providerId="ADAL" clId="{998C6BF7-482B-421C-8ECC-9091B23559F6}" dt="2022-03-26T07:22:51.353" v="48"/>
          <ac:cxnSpMkLst>
            <pc:docMk/>
            <pc:sldMk cId="2620120220" sldId="296"/>
            <ac:cxnSpMk id="196" creationId="{C9B61802-5344-471A-9CD0-C7D8261D21DC}"/>
          </ac:cxnSpMkLst>
        </pc:cxnChg>
        <pc:cxnChg chg="mod">
          <ac:chgData name="Filippo Acconcia" userId="844af49c-a8a0-47ac-a7dd-14a44b60cd18" providerId="ADAL" clId="{998C6BF7-482B-421C-8ECC-9091B23559F6}" dt="2022-03-26T07:22:51.353" v="48"/>
          <ac:cxnSpMkLst>
            <pc:docMk/>
            <pc:sldMk cId="2620120220" sldId="296"/>
            <ac:cxnSpMk id="197" creationId="{B7E2454C-C888-4890-BD4B-5137B473BCFA}"/>
          </ac:cxnSpMkLst>
        </pc:cxnChg>
      </pc:sldChg>
      <pc:sldChg chg="addSp delSp modSp new mod">
        <pc:chgData name="Filippo Acconcia" userId="844af49c-a8a0-47ac-a7dd-14a44b60cd18" providerId="ADAL" clId="{998C6BF7-482B-421C-8ECC-9091B23559F6}" dt="2022-06-10T17:20:20.570" v="1184" actId="478"/>
        <pc:sldMkLst>
          <pc:docMk/>
          <pc:sldMk cId="3763209997" sldId="297"/>
        </pc:sldMkLst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3" creationId="{ACA426E4-E63E-482B-A530-16A0DD60B19F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5" creationId="{E594B0AF-995F-4392-8729-15A388FC90D8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6" creationId="{9F648F7D-3A54-4BB8-9708-5A8E2522F097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7" creationId="{3883E053-8F57-4917-A4B1-17A20BEE6917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8" creationId="{4105BE4F-728D-4F38-8B3E-D379A8687631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9" creationId="{3F16DAC9-D517-45B7-80A9-F29F004BFD76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10" creationId="{CE7EA7DC-48DD-4A8C-BD56-F0CB84D5D0C5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11" creationId="{A2A50D95-6783-48FC-821C-00F439DF74A0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12" creationId="{2AE91BE3-87DC-49B6-A11D-4BB814638FFD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18" creationId="{08AFD039-6312-40E1-828E-46484D1BA365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19" creationId="{E78976FD-CD00-4929-A719-B26F1DE35036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20" creationId="{1E6A8447-B75A-4F83-A87B-3A0C7DB7B353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21" creationId="{B8FAE10A-0EF7-413D-A973-569FA237B83D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22" creationId="{0A8B3ECC-B848-4B5B-A5D2-D14C402CCA94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23" creationId="{BBBDCBE4-B904-4B48-868C-3C45F23B8E27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24" creationId="{932EEEF3-FEA0-4D46-B966-98F5C914D35A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25" creationId="{C1FB2A24-E270-463C-B92E-D3FF2B2BACFE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27" creationId="{51D6ED7D-6357-4BD2-A0B2-F55E6B873EB7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35" creationId="{EE05A7A2-6809-4B99-9D11-3A3E30B35285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36" creationId="{9B6955AA-FF06-4D0C-8D9B-4D5B8141AAC2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37" creationId="{DC5B18C4-C474-48E7-9874-71489EAF2174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38" creationId="{5DF010E2-D12D-4173-BCA7-0F6867630B0D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39" creationId="{E97816E9-4ECA-438B-9F63-934C7A82F60F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40" creationId="{92526E48-2384-4EF7-AF25-7D2F56C6AC9E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41" creationId="{5EC7CD1A-83BE-475C-B49C-2ACEC9487C81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42" creationId="{D0B529ED-2BD0-41DC-B888-FE672871BA20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44" creationId="{6CCD55EA-6726-4808-85D2-EDB201AF86B5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49" creationId="{23D1068B-E4A6-4435-8E97-8240939C372D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50" creationId="{C0A84E8B-22C5-42ED-89F2-005426BEC26F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51" creationId="{90F9A237-9796-4359-B603-EF38DBC24144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52" creationId="{5EA33D65-3FF3-41C1-A5A3-EF8A4E144928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53" creationId="{5D08BCCC-50BA-4496-A6BC-2FFBEBF304BB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54" creationId="{1A456423-E15F-4DB0-BE5F-3792E3331328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55" creationId="{5950BD74-C15B-4883-9617-D6A3EC421940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56" creationId="{FCE24B4A-8A60-482B-87C6-9581FDD21085}"/>
          </ac:spMkLst>
        </pc:spChg>
        <pc:spChg chg="mod">
          <ac:chgData name="Filippo Acconcia" userId="844af49c-a8a0-47ac-a7dd-14a44b60cd18" providerId="ADAL" clId="{998C6BF7-482B-421C-8ECC-9091B23559F6}" dt="2022-03-24T06:53:31.642" v="35"/>
          <ac:spMkLst>
            <pc:docMk/>
            <pc:sldMk cId="3763209997" sldId="297"/>
            <ac:spMk id="58" creationId="{AD1FFD70-4ADD-4EED-A5BC-0DF461EBD133}"/>
          </ac:spMkLst>
        </pc:spChg>
        <pc:spChg chg="add mod">
          <ac:chgData name="Filippo Acconcia" userId="844af49c-a8a0-47ac-a7dd-14a44b60cd18" providerId="ADAL" clId="{998C6BF7-482B-421C-8ECC-9091B23559F6}" dt="2022-03-26T07:25:05.153" v="50" actId="1076"/>
          <ac:spMkLst>
            <pc:docMk/>
            <pc:sldMk cId="3763209997" sldId="297"/>
            <ac:spMk id="59" creationId="{3B1B5FC7-F40B-4E8C-BA81-43C08EDD4EBE}"/>
          </ac:spMkLst>
        </pc:spChg>
        <pc:spChg chg="add mod">
          <ac:chgData name="Filippo Acconcia" userId="844af49c-a8a0-47ac-a7dd-14a44b60cd18" providerId="ADAL" clId="{998C6BF7-482B-421C-8ECC-9091B23559F6}" dt="2022-03-26T07:25:05.153" v="50" actId="1076"/>
          <ac:spMkLst>
            <pc:docMk/>
            <pc:sldMk cId="3763209997" sldId="297"/>
            <ac:spMk id="60" creationId="{A98BF58D-0577-47FC-A25C-DB0867D0C225}"/>
          </ac:spMkLst>
        </pc:spChg>
        <pc:spChg chg="add mod">
          <ac:chgData name="Filippo Acconcia" userId="844af49c-a8a0-47ac-a7dd-14a44b60cd18" providerId="ADAL" clId="{998C6BF7-482B-421C-8ECC-9091B23559F6}" dt="2022-03-26T07:25:05.153" v="50" actId="1076"/>
          <ac:spMkLst>
            <pc:docMk/>
            <pc:sldMk cId="3763209997" sldId="297"/>
            <ac:spMk id="61" creationId="{028FEF38-D09D-4825-A3A3-FFE39F11B9E7}"/>
          </ac:spMkLst>
        </pc:spChg>
        <pc:spChg chg="add mod">
          <ac:chgData name="Filippo Acconcia" userId="844af49c-a8a0-47ac-a7dd-14a44b60cd18" providerId="ADAL" clId="{998C6BF7-482B-421C-8ECC-9091B23559F6}" dt="2022-03-26T07:25:05.153" v="50" actId="1076"/>
          <ac:spMkLst>
            <pc:docMk/>
            <pc:sldMk cId="3763209997" sldId="297"/>
            <ac:spMk id="62" creationId="{92AB2CEA-7E11-44F9-B7A9-5AE3D670EFA2}"/>
          </ac:spMkLst>
        </pc:spChg>
        <pc:spChg chg="mod">
          <ac:chgData name="Filippo Acconcia" userId="844af49c-a8a0-47ac-a7dd-14a44b60cd18" providerId="ADAL" clId="{998C6BF7-482B-421C-8ECC-9091B23559F6}" dt="2022-03-26T07:25:06.635" v="51"/>
          <ac:spMkLst>
            <pc:docMk/>
            <pc:sldMk cId="3763209997" sldId="297"/>
            <ac:spMk id="67" creationId="{12C05A33-4F28-4647-9D36-63EF1EB98C38}"/>
          </ac:spMkLst>
        </pc:spChg>
        <pc:spChg chg="mod">
          <ac:chgData name="Filippo Acconcia" userId="844af49c-a8a0-47ac-a7dd-14a44b60cd18" providerId="ADAL" clId="{998C6BF7-482B-421C-8ECC-9091B23559F6}" dt="2022-03-26T07:25:06.635" v="51"/>
          <ac:spMkLst>
            <pc:docMk/>
            <pc:sldMk cId="3763209997" sldId="297"/>
            <ac:spMk id="68" creationId="{23457DB9-29FE-49E6-B12B-D5AB36B86B61}"/>
          </ac:spMkLst>
        </pc:spChg>
        <pc:spChg chg="mod">
          <ac:chgData name="Filippo Acconcia" userId="844af49c-a8a0-47ac-a7dd-14a44b60cd18" providerId="ADAL" clId="{998C6BF7-482B-421C-8ECC-9091B23559F6}" dt="2022-03-26T07:25:06.635" v="51"/>
          <ac:spMkLst>
            <pc:docMk/>
            <pc:sldMk cId="3763209997" sldId="297"/>
            <ac:spMk id="69" creationId="{CC0983BB-8AF5-41C3-AFBA-AF74BE4C65B9}"/>
          </ac:spMkLst>
        </pc:spChg>
        <pc:spChg chg="mod">
          <ac:chgData name="Filippo Acconcia" userId="844af49c-a8a0-47ac-a7dd-14a44b60cd18" providerId="ADAL" clId="{998C6BF7-482B-421C-8ECC-9091B23559F6}" dt="2022-03-26T07:25:06.635" v="51"/>
          <ac:spMkLst>
            <pc:docMk/>
            <pc:sldMk cId="3763209997" sldId="297"/>
            <ac:spMk id="70" creationId="{AA08B73D-37C7-4593-B682-A0E65AB64231}"/>
          </ac:spMkLst>
        </pc:spChg>
        <pc:spChg chg="mod">
          <ac:chgData name="Filippo Acconcia" userId="844af49c-a8a0-47ac-a7dd-14a44b60cd18" providerId="ADAL" clId="{998C6BF7-482B-421C-8ECC-9091B23559F6}" dt="2022-03-26T07:25:06.635" v="51"/>
          <ac:spMkLst>
            <pc:docMk/>
            <pc:sldMk cId="3763209997" sldId="297"/>
            <ac:spMk id="71" creationId="{5EE156E3-DE78-4356-80D0-4EE0DD39A5BE}"/>
          </ac:spMkLst>
        </pc:spChg>
        <pc:spChg chg="mod">
          <ac:chgData name="Filippo Acconcia" userId="844af49c-a8a0-47ac-a7dd-14a44b60cd18" providerId="ADAL" clId="{998C6BF7-482B-421C-8ECC-9091B23559F6}" dt="2022-03-26T07:25:06.635" v="51"/>
          <ac:spMkLst>
            <pc:docMk/>
            <pc:sldMk cId="3763209997" sldId="297"/>
            <ac:spMk id="72" creationId="{E7DEAE76-F363-4211-A0F0-76410FCD2BE4}"/>
          </ac:spMkLst>
        </pc:spChg>
        <pc:spChg chg="mod">
          <ac:chgData name="Filippo Acconcia" userId="844af49c-a8a0-47ac-a7dd-14a44b60cd18" providerId="ADAL" clId="{998C6BF7-482B-421C-8ECC-9091B23559F6}" dt="2022-03-26T07:25:06.635" v="51"/>
          <ac:spMkLst>
            <pc:docMk/>
            <pc:sldMk cId="3763209997" sldId="297"/>
            <ac:spMk id="73" creationId="{9F39A8AC-8A84-4187-8E8D-9EDE46961B73}"/>
          </ac:spMkLst>
        </pc:spChg>
        <pc:spChg chg="mod">
          <ac:chgData name="Filippo Acconcia" userId="844af49c-a8a0-47ac-a7dd-14a44b60cd18" providerId="ADAL" clId="{998C6BF7-482B-421C-8ECC-9091B23559F6}" dt="2022-03-26T07:25:06.635" v="51"/>
          <ac:spMkLst>
            <pc:docMk/>
            <pc:sldMk cId="3763209997" sldId="297"/>
            <ac:spMk id="74" creationId="{F6F079FC-876A-4860-9A27-A0B158900FC7}"/>
          </ac:spMkLst>
        </pc:spChg>
        <pc:spChg chg="mod">
          <ac:chgData name="Filippo Acconcia" userId="844af49c-a8a0-47ac-a7dd-14a44b60cd18" providerId="ADAL" clId="{998C6BF7-482B-421C-8ECC-9091B23559F6}" dt="2022-03-26T07:25:06.635" v="51"/>
          <ac:spMkLst>
            <pc:docMk/>
            <pc:sldMk cId="3763209997" sldId="297"/>
            <ac:spMk id="76" creationId="{9692E7A3-B434-40D9-8081-E44C76E40A6B}"/>
          </ac:spMkLst>
        </pc:spChg>
        <pc:spChg chg="mod">
          <ac:chgData name="Filippo Acconcia" userId="844af49c-a8a0-47ac-a7dd-14a44b60cd18" providerId="ADAL" clId="{998C6BF7-482B-421C-8ECC-9091B23559F6}" dt="2022-03-26T07:34:20.317" v="61"/>
          <ac:spMkLst>
            <pc:docMk/>
            <pc:sldMk cId="3763209997" sldId="297"/>
            <ac:spMk id="81" creationId="{C7DE4C4E-71E4-489C-A446-8AE20ED5509F}"/>
          </ac:spMkLst>
        </pc:spChg>
        <pc:spChg chg="mod">
          <ac:chgData name="Filippo Acconcia" userId="844af49c-a8a0-47ac-a7dd-14a44b60cd18" providerId="ADAL" clId="{998C6BF7-482B-421C-8ECC-9091B23559F6}" dt="2022-03-26T07:34:20.317" v="61"/>
          <ac:spMkLst>
            <pc:docMk/>
            <pc:sldMk cId="3763209997" sldId="297"/>
            <ac:spMk id="82" creationId="{EC909A95-8678-4F29-ABFE-3D7A370D69B5}"/>
          </ac:spMkLst>
        </pc:spChg>
        <pc:spChg chg="mod">
          <ac:chgData name="Filippo Acconcia" userId="844af49c-a8a0-47ac-a7dd-14a44b60cd18" providerId="ADAL" clId="{998C6BF7-482B-421C-8ECC-9091B23559F6}" dt="2022-03-26T07:34:20.317" v="61"/>
          <ac:spMkLst>
            <pc:docMk/>
            <pc:sldMk cId="3763209997" sldId="297"/>
            <ac:spMk id="83" creationId="{529BA27D-1582-4C79-8689-1099DAC11CD4}"/>
          </ac:spMkLst>
        </pc:spChg>
        <pc:spChg chg="mod">
          <ac:chgData name="Filippo Acconcia" userId="844af49c-a8a0-47ac-a7dd-14a44b60cd18" providerId="ADAL" clId="{998C6BF7-482B-421C-8ECC-9091B23559F6}" dt="2022-03-26T07:34:20.317" v="61"/>
          <ac:spMkLst>
            <pc:docMk/>
            <pc:sldMk cId="3763209997" sldId="297"/>
            <ac:spMk id="84" creationId="{85712F6C-B74A-408E-A0B1-4A421A6B3A99}"/>
          </ac:spMkLst>
        </pc:spChg>
        <pc:spChg chg="mod">
          <ac:chgData name="Filippo Acconcia" userId="844af49c-a8a0-47ac-a7dd-14a44b60cd18" providerId="ADAL" clId="{998C6BF7-482B-421C-8ECC-9091B23559F6}" dt="2022-03-26T07:34:20.317" v="61"/>
          <ac:spMkLst>
            <pc:docMk/>
            <pc:sldMk cId="3763209997" sldId="297"/>
            <ac:spMk id="85" creationId="{C6E549E3-A216-4538-8D1B-0D8951700602}"/>
          </ac:spMkLst>
        </pc:spChg>
        <pc:spChg chg="mod">
          <ac:chgData name="Filippo Acconcia" userId="844af49c-a8a0-47ac-a7dd-14a44b60cd18" providerId="ADAL" clId="{998C6BF7-482B-421C-8ECC-9091B23559F6}" dt="2022-03-26T07:34:20.317" v="61"/>
          <ac:spMkLst>
            <pc:docMk/>
            <pc:sldMk cId="3763209997" sldId="297"/>
            <ac:spMk id="86" creationId="{267ED6C9-EBE9-4041-98B4-45DB96C2B705}"/>
          </ac:spMkLst>
        </pc:spChg>
        <pc:spChg chg="mod">
          <ac:chgData name="Filippo Acconcia" userId="844af49c-a8a0-47ac-a7dd-14a44b60cd18" providerId="ADAL" clId="{998C6BF7-482B-421C-8ECC-9091B23559F6}" dt="2022-03-26T07:34:20.317" v="61"/>
          <ac:spMkLst>
            <pc:docMk/>
            <pc:sldMk cId="3763209997" sldId="297"/>
            <ac:spMk id="87" creationId="{F3AD4A9D-C947-4F97-9B46-AF350DF0649C}"/>
          </ac:spMkLst>
        </pc:spChg>
        <pc:spChg chg="mod">
          <ac:chgData name="Filippo Acconcia" userId="844af49c-a8a0-47ac-a7dd-14a44b60cd18" providerId="ADAL" clId="{998C6BF7-482B-421C-8ECC-9091B23559F6}" dt="2022-03-26T07:34:20.317" v="61"/>
          <ac:spMkLst>
            <pc:docMk/>
            <pc:sldMk cId="3763209997" sldId="297"/>
            <ac:spMk id="88" creationId="{DE5866B3-0AEB-4195-92EF-BA451B27CED8}"/>
          </ac:spMkLst>
        </pc:spChg>
        <pc:spChg chg="mod">
          <ac:chgData name="Filippo Acconcia" userId="844af49c-a8a0-47ac-a7dd-14a44b60cd18" providerId="ADAL" clId="{998C6BF7-482B-421C-8ECC-9091B23559F6}" dt="2022-03-26T07:34:20.317" v="61"/>
          <ac:spMkLst>
            <pc:docMk/>
            <pc:sldMk cId="3763209997" sldId="297"/>
            <ac:spMk id="90" creationId="{9B7F9AC1-142D-434C-827F-E53C24339D36}"/>
          </ac:spMkLst>
        </pc:spChg>
        <pc:spChg chg="mod">
          <ac:chgData name="Filippo Acconcia" userId="844af49c-a8a0-47ac-a7dd-14a44b60cd18" providerId="ADAL" clId="{998C6BF7-482B-421C-8ECC-9091B23559F6}" dt="2022-03-26T07:34:20.317" v="61"/>
          <ac:spMkLst>
            <pc:docMk/>
            <pc:sldMk cId="3763209997" sldId="297"/>
            <ac:spMk id="94" creationId="{3B32E810-E1C4-45F8-8F6C-DF754D115071}"/>
          </ac:spMkLst>
        </pc:spChg>
        <pc:spChg chg="mod">
          <ac:chgData name="Filippo Acconcia" userId="844af49c-a8a0-47ac-a7dd-14a44b60cd18" providerId="ADAL" clId="{998C6BF7-482B-421C-8ECC-9091B23559F6}" dt="2022-03-26T07:34:20.317" v="61"/>
          <ac:spMkLst>
            <pc:docMk/>
            <pc:sldMk cId="3763209997" sldId="297"/>
            <ac:spMk id="95" creationId="{F2215A61-48CC-4266-82A2-1D1A485EC530}"/>
          </ac:spMkLst>
        </pc:spChg>
        <pc:spChg chg="mod">
          <ac:chgData name="Filippo Acconcia" userId="844af49c-a8a0-47ac-a7dd-14a44b60cd18" providerId="ADAL" clId="{998C6BF7-482B-421C-8ECC-9091B23559F6}" dt="2022-03-26T07:34:20.317" v="61"/>
          <ac:spMkLst>
            <pc:docMk/>
            <pc:sldMk cId="3763209997" sldId="297"/>
            <ac:spMk id="96" creationId="{C41ACCC2-4FE4-44BD-8B7D-1773572FA453}"/>
          </ac:spMkLst>
        </pc:spChg>
        <pc:spChg chg="mod">
          <ac:chgData name="Filippo Acconcia" userId="844af49c-a8a0-47ac-a7dd-14a44b60cd18" providerId="ADAL" clId="{998C6BF7-482B-421C-8ECC-9091B23559F6}" dt="2022-03-26T07:34:20.317" v="61"/>
          <ac:spMkLst>
            <pc:docMk/>
            <pc:sldMk cId="3763209997" sldId="297"/>
            <ac:spMk id="97" creationId="{E8B7002D-E244-4A72-AE44-AC02AC2F94E2}"/>
          </ac:spMkLst>
        </pc:spChg>
        <pc:spChg chg="mod">
          <ac:chgData name="Filippo Acconcia" userId="844af49c-a8a0-47ac-a7dd-14a44b60cd18" providerId="ADAL" clId="{998C6BF7-482B-421C-8ECC-9091B23559F6}" dt="2022-03-26T07:34:20.317" v="61"/>
          <ac:spMkLst>
            <pc:docMk/>
            <pc:sldMk cId="3763209997" sldId="297"/>
            <ac:spMk id="98" creationId="{3EF68A21-0E07-4664-B81C-1F024FA65B08}"/>
          </ac:spMkLst>
        </pc:spChg>
        <pc:spChg chg="mod">
          <ac:chgData name="Filippo Acconcia" userId="844af49c-a8a0-47ac-a7dd-14a44b60cd18" providerId="ADAL" clId="{998C6BF7-482B-421C-8ECC-9091B23559F6}" dt="2022-03-26T07:34:20.317" v="61"/>
          <ac:spMkLst>
            <pc:docMk/>
            <pc:sldMk cId="3763209997" sldId="297"/>
            <ac:spMk id="99" creationId="{4B349FAB-C141-4AF3-9D2B-544336B95065}"/>
          </ac:spMkLst>
        </pc:spChg>
        <pc:spChg chg="mod">
          <ac:chgData name="Filippo Acconcia" userId="844af49c-a8a0-47ac-a7dd-14a44b60cd18" providerId="ADAL" clId="{998C6BF7-482B-421C-8ECC-9091B23559F6}" dt="2022-03-26T07:34:20.317" v="61"/>
          <ac:spMkLst>
            <pc:docMk/>
            <pc:sldMk cId="3763209997" sldId="297"/>
            <ac:spMk id="100" creationId="{B9C9CFF4-1B47-42F9-852E-8B8561B59737}"/>
          </ac:spMkLst>
        </pc:spChg>
        <pc:spChg chg="mod">
          <ac:chgData name="Filippo Acconcia" userId="844af49c-a8a0-47ac-a7dd-14a44b60cd18" providerId="ADAL" clId="{998C6BF7-482B-421C-8ECC-9091B23559F6}" dt="2022-03-26T07:34:20.317" v="61"/>
          <ac:spMkLst>
            <pc:docMk/>
            <pc:sldMk cId="3763209997" sldId="297"/>
            <ac:spMk id="101" creationId="{FB55908C-A6E0-464B-ABEB-E04AAD282A32}"/>
          </ac:spMkLst>
        </pc:spChg>
        <pc:spChg chg="mod">
          <ac:chgData name="Filippo Acconcia" userId="844af49c-a8a0-47ac-a7dd-14a44b60cd18" providerId="ADAL" clId="{998C6BF7-482B-421C-8ECC-9091B23559F6}" dt="2022-03-26T07:34:20.317" v="61"/>
          <ac:spMkLst>
            <pc:docMk/>
            <pc:sldMk cId="3763209997" sldId="297"/>
            <ac:spMk id="103" creationId="{D8D175D0-AA8F-4650-A600-8F7A03D45C54}"/>
          </ac:spMkLst>
        </pc:spChg>
        <pc:spChg chg="mod">
          <ac:chgData name="Filippo Acconcia" userId="844af49c-a8a0-47ac-a7dd-14a44b60cd18" providerId="ADAL" clId="{998C6BF7-482B-421C-8ECC-9091B23559F6}" dt="2022-05-07T06:18:36.486" v="687" actId="20577"/>
          <ac:spMkLst>
            <pc:docMk/>
            <pc:sldMk cId="3763209997" sldId="297"/>
            <ac:spMk id="106" creationId="{E5EF98AB-F50C-4370-B8FD-EED0B3491049}"/>
          </ac:spMkLst>
        </pc:spChg>
        <pc:spChg chg="mod topLvl">
          <ac:chgData name="Filippo Acconcia" userId="844af49c-a8a0-47ac-a7dd-14a44b60cd18" providerId="ADAL" clId="{998C6BF7-482B-421C-8ECC-9091B23559F6}" dt="2022-04-01T13:36:43.367" v="101" actId="164"/>
          <ac:spMkLst>
            <pc:docMk/>
            <pc:sldMk cId="3763209997" sldId="297"/>
            <ac:spMk id="125" creationId="{583D0BA4-803E-4059-9463-044E2B1B781F}"/>
          </ac:spMkLst>
        </pc:spChg>
        <pc:spChg chg="mod topLvl">
          <ac:chgData name="Filippo Acconcia" userId="844af49c-a8a0-47ac-a7dd-14a44b60cd18" providerId="ADAL" clId="{998C6BF7-482B-421C-8ECC-9091B23559F6}" dt="2022-04-01T13:36:43.367" v="101" actId="164"/>
          <ac:spMkLst>
            <pc:docMk/>
            <pc:sldMk cId="3763209997" sldId="297"/>
            <ac:spMk id="126" creationId="{BB244E21-DC1E-47A4-8370-33F715EDAC0C}"/>
          </ac:spMkLst>
        </pc:spChg>
        <pc:spChg chg="mod topLvl">
          <ac:chgData name="Filippo Acconcia" userId="844af49c-a8a0-47ac-a7dd-14a44b60cd18" providerId="ADAL" clId="{998C6BF7-482B-421C-8ECC-9091B23559F6}" dt="2022-04-01T13:36:43.367" v="101" actId="164"/>
          <ac:spMkLst>
            <pc:docMk/>
            <pc:sldMk cId="3763209997" sldId="297"/>
            <ac:spMk id="127" creationId="{73761CD7-5C7D-4AF2-A0CB-87F5C94445A9}"/>
          </ac:spMkLst>
        </pc:spChg>
        <pc:spChg chg="mod topLvl">
          <ac:chgData name="Filippo Acconcia" userId="844af49c-a8a0-47ac-a7dd-14a44b60cd18" providerId="ADAL" clId="{998C6BF7-482B-421C-8ECC-9091B23559F6}" dt="2022-04-01T13:36:43.367" v="101" actId="164"/>
          <ac:spMkLst>
            <pc:docMk/>
            <pc:sldMk cId="3763209997" sldId="297"/>
            <ac:spMk id="128" creationId="{47CD8135-983F-4048-84EB-A2D2BB6672E1}"/>
          </ac:spMkLst>
        </pc:spChg>
        <pc:spChg chg="mod topLvl">
          <ac:chgData name="Filippo Acconcia" userId="844af49c-a8a0-47ac-a7dd-14a44b60cd18" providerId="ADAL" clId="{998C6BF7-482B-421C-8ECC-9091B23559F6}" dt="2022-04-01T13:36:43.367" v="101" actId="164"/>
          <ac:spMkLst>
            <pc:docMk/>
            <pc:sldMk cId="3763209997" sldId="297"/>
            <ac:spMk id="129" creationId="{E9C3B578-3E6A-4279-A00C-452FB51F69F7}"/>
          </ac:spMkLst>
        </pc:spChg>
        <pc:spChg chg="mod topLvl">
          <ac:chgData name="Filippo Acconcia" userId="844af49c-a8a0-47ac-a7dd-14a44b60cd18" providerId="ADAL" clId="{998C6BF7-482B-421C-8ECC-9091B23559F6}" dt="2022-04-01T13:36:43.367" v="101" actId="164"/>
          <ac:spMkLst>
            <pc:docMk/>
            <pc:sldMk cId="3763209997" sldId="297"/>
            <ac:spMk id="131" creationId="{1EEF53BC-2BCD-4B92-9444-FC3658B605EB}"/>
          </ac:spMkLst>
        </pc:spChg>
        <pc:spChg chg="mod topLvl">
          <ac:chgData name="Filippo Acconcia" userId="844af49c-a8a0-47ac-a7dd-14a44b60cd18" providerId="ADAL" clId="{998C6BF7-482B-421C-8ECC-9091B23559F6}" dt="2022-04-01T13:36:43.367" v="101" actId="164"/>
          <ac:spMkLst>
            <pc:docMk/>
            <pc:sldMk cId="3763209997" sldId="297"/>
            <ac:spMk id="132" creationId="{D804BF9B-C423-4770-9B85-36D3D2B2E78D}"/>
          </ac:spMkLst>
        </pc:spChg>
        <pc:spChg chg="mod topLvl">
          <ac:chgData name="Filippo Acconcia" userId="844af49c-a8a0-47ac-a7dd-14a44b60cd18" providerId="ADAL" clId="{998C6BF7-482B-421C-8ECC-9091B23559F6}" dt="2022-04-01T13:36:43.367" v="101" actId="164"/>
          <ac:spMkLst>
            <pc:docMk/>
            <pc:sldMk cId="3763209997" sldId="297"/>
            <ac:spMk id="133" creationId="{3D412561-2D1D-4833-8A49-643F65F860A3}"/>
          </ac:spMkLst>
        </pc:spChg>
        <pc:spChg chg="mod topLvl">
          <ac:chgData name="Filippo Acconcia" userId="844af49c-a8a0-47ac-a7dd-14a44b60cd18" providerId="ADAL" clId="{998C6BF7-482B-421C-8ECC-9091B23559F6}" dt="2022-04-01T13:36:43.367" v="101" actId="164"/>
          <ac:spMkLst>
            <pc:docMk/>
            <pc:sldMk cId="3763209997" sldId="297"/>
            <ac:spMk id="134" creationId="{F872BDC9-E794-42C3-8BA6-1C9A7EFFA0A6}"/>
          </ac:spMkLst>
        </pc:spChg>
        <pc:spChg chg="mod topLvl">
          <ac:chgData name="Filippo Acconcia" userId="844af49c-a8a0-47ac-a7dd-14a44b60cd18" providerId="ADAL" clId="{998C6BF7-482B-421C-8ECC-9091B23559F6}" dt="2022-04-01T13:36:43.367" v="101" actId="164"/>
          <ac:spMkLst>
            <pc:docMk/>
            <pc:sldMk cId="3763209997" sldId="297"/>
            <ac:spMk id="135" creationId="{988DAE6F-C4AC-4AB0-BD42-6F0F209CB067}"/>
          </ac:spMkLst>
        </pc:spChg>
        <pc:spChg chg="mod">
          <ac:chgData name="Filippo Acconcia" userId="844af49c-a8a0-47ac-a7dd-14a44b60cd18" providerId="ADAL" clId="{998C6BF7-482B-421C-8ECC-9091B23559F6}" dt="2022-04-01T13:35:04.123" v="83" actId="1035"/>
          <ac:spMkLst>
            <pc:docMk/>
            <pc:sldMk cId="3763209997" sldId="297"/>
            <ac:spMk id="140" creationId="{E772652D-48E5-4015-A9D4-7084AC5D7A5F}"/>
          </ac:spMkLst>
        </pc:spChg>
        <pc:spChg chg="mod">
          <ac:chgData name="Filippo Acconcia" userId="844af49c-a8a0-47ac-a7dd-14a44b60cd18" providerId="ADAL" clId="{998C6BF7-482B-421C-8ECC-9091B23559F6}" dt="2022-04-01T13:35:04.123" v="83" actId="1035"/>
          <ac:spMkLst>
            <pc:docMk/>
            <pc:sldMk cId="3763209997" sldId="297"/>
            <ac:spMk id="141" creationId="{7ECA4B5D-1ABE-46C6-9BFC-8D16DD7F7AE5}"/>
          </ac:spMkLst>
        </pc:spChg>
        <pc:spChg chg="mod topLvl">
          <ac:chgData name="Filippo Acconcia" userId="844af49c-a8a0-47ac-a7dd-14a44b60cd18" providerId="ADAL" clId="{998C6BF7-482B-421C-8ECC-9091B23559F6}" dt="2022-04-01T13:40:43.579" v="144" actId="164"/>
          <ac:spMkLst>
            <pc:docMk/>
            <pc:sldMk cId="3763209997" sldId="297"/>
            <ac:spMk id="144" creationId="{4C94DAB0-F3CA-4490-A40D-69554016E1AE}"/>
          </ac:spMkLst>
        </pc:spChg>
        <pc:spChg chg="mod topLvl">
          <ac:chgData name="Filippo Acconcia" userId="844af49c-a8a0-47ac-a7dd-14a44b60cd18" providerId="ADAL" clId="{998C6BF7-482B-421C-8ECC-9091B23559F6}" dt="2022-04-01T13:40:43.579" v="144" actId="164"/>
          <ac:spMkLst>
            <pc:docMk/>
            <pc:sldMk cId="3763209997" sldId="297"/>
            <ac:spMk id="145" creationId="{09077916-4A8E-4271-B7CC-FEDCD04501B2}"/>
          </ac:spMkLst>
        </pc:spChg>
        <pc:spChg chg="mod topLvl">
          <ac:chgData name="Filippo Acconcia" userId="844af49c-a8a0-47ac-a7dd-14a44b60cd18" providerId="ADAL" clId="{998C6BF7-482B-421C-8ECC-9091B23559F6}" dt="2022-04-01T13:40:43.579" v="144" actId="164"/>
          <ac:spMkLst>
            <pc:docMk/>
            <pc:sldMk cId="3763209997" sldId="297"/>
            <ac:spMk id="146" creationId="{607BAB7D-9332-4928-9D32-92CF3508C2ED}"/>
          </ac:spMkLst>
        </pc:spChg>
        <pc:spChg chg="mod topLvl">
          <ac:chgData name="Filippo Acconcia" userId="844af49c-a8a0-47ac-a7dd-14a44b60cd18" providerId="ADAL" clId="{998C6BF7-482B-421C-8ECC-9091B23559F6}" dt="2022-04-01T13:40:43.579" v="144" actId="164"/>
          <ac:spMkLst>
            <pc:docMk/>
            <pc:sldMk cId="3763209997" sldId="297"/>
            <ac:spMk id="147" creationId="{EB8CA924-7CC1-42BD-9C97-E6C46C6C126F}"/>
          </ac:spMkLst>
        </pc:spChg>
        <pc:spChg chg="mod topLvl">
          <ac:chgData name="Filippo Acconcia" userId="844af49c-a8a0-47ac-a7dd-14a44b60cd18" providerId="ADAL" clId="{998C6BF7-482B-421C-8ECC-9091B23559F6}" dt="2022-04-01T13:40:43.579" v="144" actId="164"/>
          <ac:spMkLst>
            <pc:docMk/>
            <pc:sldMk cId="3763209997" sldId="297"/>
            <ac:spMk id="148" creationId="{A01F8C62-DFAA-4181-9345-BD7664388AAF}"/>
          </ac:spMkLst>
        </pc:spChg>
        <pc:spChg chg="mod topLvl">
          <ac:chgData name="Filippo Acconcia" userId="844af49c-a8a0-47ac-a7dd-14a44b60cd18" providerId="ADAL" clId="{998C6BF7-482B-421C-8ECC-9091B23559F6}" dt="2022-04-01T13:40:43.579" v="144" actId="164"/>
          <ac:spMkLst>
            <pc:docMk/>
            <pc:sldMk cId="3763209997" sldId="297"/>
            <ac:spMk id="150" creationId="{55B0AE4D-AD4E-413D-B7AC-66FE124F9A91}"/>
          </ac:spMkLst>
        </pc:spChg>
        <pc:spChg chg="mod topLvl">
          <ac:chgData name="Filippo Acconcia" userId="844af49c-a8a0-47ac-a7dd-14a44b60cd18" providerId="ADAL" clId="{998C6BF7-482B-421C-8ECC-9091B23559F6}" dt="2022-04-01T13:40:43.579" v="144" actId="164"/>
          <ac:spMkLst>
            <pc:docMk/>
            <pc:sldMk cId="3763209997" sldId="297"/>
            <ac:spMk id="151" creationId="{4CE85E1F-FC75-46C3-9694-41FA9F84BEC9}"/>
          </ac:spMkLst>
        </pc:spChg>
        <pc:spChg chg="mod topLvl">
          <ac:chgData name="Filippo Acconcia" userId="844af49c-a8a0-47ac-a7dd-14a44b60cd18" providerId="ADAL" clId="{998C6BF7-482B-421C-8ECC-9091B23559F6}" dt="2022-04-01T13:40:43.579" v="144" actId="164"/>
          <ac:spMkLst>
            <pc:docMk/>
            <pc:sldMk cId="3763209997" sldId="297"/>
            <ac:spMk id="152" creationId="{E5D4ADAB-5C0D-488B-9C05-FC2959F79D10}"/>
          </ac:spMkLst>
        </pc:spChg>
        <pc:spChg chg="mod topLvl">
          <ac:chgData name="Filippo Acconcia" userId="844af49c-a8a0-47ac-a7dd-14a44b60cd18" providerId="ADAL" clId="{998C6BF7-482B-421C-8ECC-9091B23559F6}" dt="2022-04-01T13:40:43.579" v="144" actId="164"/>
          <ac:spMkLst>
            <pc:docMk/>
            <pc:sldMk cId="3763209997" sldId="297"/>
            <ac:spMk id="153" creationId="{E7D36588-7CBF-42ED-904D-7FDFE84AEECC}"/>
          </ac:spMkLst>
        </pc:spChg>
        <pc:spChg chg="mod topLvl">
          <ac:chgData name="Filippo Acconcia" userId="844af49c-a8a0-47ac-a7dd-14a44b60cd18" providerId="ADAL" clId="{998C6BF7-482B-421C-8ECC-9091B23559F6}" dt="2022-04-01T13:40:43.579" v="144" actId="164"/>
          <ac:spMkLst>
            <pc:docMk/>
            <pc:sldMk cId="3763209997" sldId="297"/>
            <ac:spMk id="154" creationId="{CFF514FC-F5F7-44D1-85D2-221FB5245895}"/>
          </ac:spMkLst>
        </pc:spChg>
        <pc:spChg chg="add mod">
          <ac:chgData name="Filippo Acconcia" userId="844af49c-a8a0-47ac-a7dd-14a44b60cd18" providerId="ADAL" clId="{998C6BF7-482B-421C-8ECC-9091B23559F6}" dt="2022-06-10T17:19:35.881" v="1166" actId="1076"/>
          <ac:spMkLst>
            <pc:docMk/>
            <pc:sldMk cId="3763209997" sldId="297"/>
            <ac:spMk id="155" creationId="{5632CC6B-1E3D-AEBC-9E4E-F7E92F8658AA}"/>
          </ac:spMkLst>
        </pc:spChg>
        <pc:spChg chg="add mod">
          <ac:chgData name="Filippo Acconcia" userId="844af49c-a8a0-47ac-a7dd-14a44b60cd18" providerId="ADAL" clId="{998C6BF7-482B-421C-8ECC-9091B23559F6}" dt="2022-06-10T17:19:35.881" v="1166" actId="1076"/>
          <ac:spMkLst>
            <pc:docMk/>
            <pc:sldMk cId="3763209997" sldId="297"/>
            <ac:spMk id="157" creationId="{2C531C44-EB30-0DB9-06D0-CFC4394FEB9B}"/>
          </ac:spMkLst>
        </pc:spChg>
        <pc:spChg chg="add mod">
          <ac:chgData name="Filippo Acconcia" userId="844af49c-a8a0-47ac-a7dd-14a44b60cd18" providerId="ADAL" clId="{998C6BF7-482B-421C-8ECC-9091B23559F6}" dt="2022-06-10T17:19:41.558" v="1168" actId="1076"/>
          <ac:spMkLst>
            <pc:docMk/>
            <pc:sldMk cId="3763209997" sldId="297"/>
            <ac:spMk id="158" creationId="{EA08C1E8-93EB-677D-E171-A427CC7DB63F}"/>
          </ac:spMkLst>
        </pc:spChg>
        <pc:spChg chg="add mod">
          <ac:chgData name="Filippo Acconcia" userId="844af49c-a8a0-47ac-a7dd-14a44b60cd18" providerId="ADAL" clId="{998C6BF7-482B-421C-8ECC-9091B23559F6}" dt="2022-06-10T17:19:46.457" v="1170" actId="1076"/>
          <ac:spMkLst>
            <pc:docMk/>
            <pc:sldMk cId="3763209997" sldId="297"/>
            <ac:spMk id="171" creationId="{0C7B8FA3-0FA5-458B-B5E2-A7E003E6246E}"/>
          </ac:spMkLst>
        </pc:spChg>
        <pc:spChg chg="add mod">
          <ac:chgData name="Filippo Acconcia" userId="844af49c-a8a0-47ac-a7dd-14a44b60cd18" providerId="ADAL" clId="{998C6BF7-482B-421C-8ECC-9091B23559F6}" dt="2022-06-10T17:19:49.110" v="1171" actId="1076"/>
          <ac:spMkLst>
            <pc:docMk/>
            <pc:sldMk cId="3763209997" sldId="297"/>
            <ac:spMk id="172" creationId="{6D3C9C40-C35D-4D19-818A-8A7115E0265A}"/>
          </ac:spMkLst>
        </pc:spChg>
        <pc:spChg chg="add mod">
          <ac:chgData name="Filippo Acconcia" userId="844af49c-a8a0-47ac-a7dd-14a44b60cd18" providerId="ADAL" clId="{998C6BF7-482B-421C-8ECC-9091B23559F6}" dt="2022-06-10T17:19:54.615" v="1173" actId="1076"/>
          <ac:spMkLst>
            <pc:docMk/>
            <pc:sldMk cId="3763209997" sldId="297"/>
            <ac:spMk id="186" creationId="{1CB2BFDF-43E4-9AE9-D39E-46B0458AE1AB}"/>
          </ac:spMkLst>
        </pc:spChg>
        <pc:spChg chg="add mod">
          <ac:chgData name="Filippo Acconcia" userId="844af49c-a8a0-47ac-a7dd-14a44b60cd18" providerId="ADAL" clId="{998C6BF7-482B-421C-8ECC-9091B23559F6}" dt="2022-06-10T17:19:57.157" v="1174" actId="1076"/>
          <ac:spMkLst>
            <pc:docMk/>
            <pc:sldMk cId="3763209997" sldId="297"/>
            <ac:spMk id="187" creationId="{B4ABB131-DBA5-50BA-300D-2B02BAE26004}"/>
          </ac:spMkLst>
        </pc:spChg>
        <pc:spChg chg="add del mod">
          <ac:chgData name="Filippo Acconcia" userId="844af49c-a8a0-47ac-a7dd-14a44b60cd18" providerId="ADAL" clId="{998C6BF7-482B-421C-8ECC-9091B23559F6}" dt="2022-06-10T17:20:20.570" v="1184" actId="478"/>
          <ac:spMkLst>
            <pc:docMk/>
            <pc:sldMk cId="3763209997" sldId="297"/>
            <ac:spMk id="200" creationId="{8206489B-32DA-9434-7FEE-D9D33EA0068A}"/>
          </ac:spMkLst>
        </pc:spChg>
        <pc:spChg chg="add mod">
          <ac:chgData name="Filippo Acconcia" userId="844af49c-a8a0-47ac-a7dd-14a44b60cd18" providerId="ADAL" clId="{998C6BF7-482B-421C-8ECC-9091B23559F6}" dt="2022-06-10T17:20:14.606" v="1181" actId="1076"/>
          <ac:spMkLst>
            <pc:docMk/>
            <pc:sldMk cId="3763209997" sldId="297"/>
            <ac:spMk id="201" creationId="{321D0A2A-A0E8-542F-679C-C64F52EAB79E}"/>
          </ac:spMkLst>
        </pc:spChg>
        <pc:spChg chg="add mod">
          <ac:chgData name="Filippo Acconcia" userId="844af49c-a8a0-47ac-a7dd-14a44b60cd18" providerId="ADAL" clId="{998C6BF7-482B-421C-8ECC-9091B23559F6}" dt="2022-06-10T17:20:11.278" v="1180" actId="1076"/>
          <ac:spMkLst>
            <pc:docMk/>
            <pc:sldMk cId="3763209997" sldId="297"/>
            <ac:spMk id="202" creationId="{F824F9EA-02CF-3BE4-8B8E-C4AD2A9A0035}"/>
          </ac:spMkLst>
        </pc:spChg>
        <pc:spChg chg="add mod">
          <ac:chgData name="Filippo Acconcia" userId="844af49c-a8a0-47ac-a7dd-14a44b60cd18" providerId="ADAL" clId="{998C6BF7-482B-421C-8ECC-9091B23559F6}" dt="2022-06-10T17:20:08.389" v="1179" actId="1076"/>
          <ac:spMkLst>
            <pc:docMk/>
            <pc:sldMk cId="3763209997" sldId="297"/>
            <ac:spMk id="203" creationId="{783356E2-AC2E-D9C1-6028-F7E0BD680242}"/>
          </ac:spMkLst>
        </pc:spChg>
        <pc:spChg chg="add mod">
          <ac:chgData name="Filippo Acconcia" userId="844af49c-a8a0-47ac-a7dd-14a44b60cd18" providerId="ADAL" clId="{998C6BF7-482B-421C-8ECC-9091B23559F6}" dt="2022-06-10T17:20:18.902" v="1183" actId="1076"/>
          <ac:spMkLst>
            <pc:docMk/>
            <pc:sldMk cId="3763209997" sldId="297"/>
            <ac:spMk id="204" creationId="{A3B7EE65-8705-40B7-36D6-F9A9CBC3639F}"/>
          </ac:spMkLst>
        </pc:spChg>
        <pc:grpChg chg="add mod">
          <ac:chgData name="Filippo Acconcia" userId="844af49c-a8a0-47ac-a7dd-14a44b60cd18" providerId="ADAL" clId="{998C6BF7-482B-421C-8ECC-9091B23559F6}" dt="2022-03-26T07:25:05.153" v="50" actId="1076"/>
          <ac:grpSpMkLst>
            <pc:docMk/>
            <pc:sldMk cId="3763209997" sldId="297"/>
            <ac:grpSpMk id="2" creationId="{C2C26514-7C88-40AB-998D-C434AFA67D67}"/>
          </ac:grpSpMkLst>
        </pc:grpChg>
        <pc:grpChg chg="mod">
          <ac:chgData name="Filippo Acconcia" userId="844af49c-a8a0-47ac-a7dd-14a44b60cd18" providerId="ADAL" clId="{998C6BF7-482B-421C-8ECC-9091B23559F6}" dt="2022-03-24T06:53:31.642" v="35"/>
          <ac:grpSpMkLst>
            <pc:docMk/>
            <pc:sldMk cId="3763209997" sldId="297"/>
            <ac:grpSpMk id="4" creationId="{206A4C5E-3841-4524-A248-F898B370451C}"/>
          </ac:grpSpMkLst>
        </pc:grpChg>
        <pc:grpChg chg="add mod">
          <ac:chgData name="Filippo Acconcia" userId="844af49c-a8a0-47ac-a7dd-14a44b60cd18" providerId="ADAL" clId="{998C6BF7-482B-421C-8ECC-9091B23559F6}" dt="2022-03-26T07:25:05.153" v="50" actId="1076"/>
          <ac:grpSpMkLst>
            <pc:docMk/>
            <pc:sldMk cId="3763209997" sldId="297"/>
            <ac:grpSpMk id="17" creationId="{DDA6C99E-5C99-4640-8272-5026C3237A2B}"/>
          </ac:grpSpMkLst>
        </pc:grpChg>
        <pc:grpChg chg="add mod">
          <ac:chgData name="Filippo Acconcia" userId="844af49c-a8a0-47ac-a7dd-14a44b60cd18" providerId="ADAL" clId="{998C6BF7-482B-421C-8ECC-9091B23559F6}" dt="2022-03-26T07:25:05.153" v="50" actId="1076"/>
          <ac:grpSpMkLst>
            <pc:docMk/>
            <pc:sldMk cId="3763209997" sldId="297"/>
            <ac:grpSpMk id="31" creationId="{DE5DFA23-5114-4C80-9F25-A39AD022C0BE}"/>
          </ac:grpSpMkLst>
        </pc:grpChg>
        <pc:grpChg chg="add mod">
          <ac:chgData name="Filippo Acconcia" userId="844af49c-a8a0-47ac-a7dd-14a44b60cd18" providerId="ADAL" clId="{998C6BF7-482B-421C-8ECC-9091B23559F6}" dt="2022-03-26T07:25:05.153" v="50" actId="1076"/>
          <ac:grpSpMkLst>
            <pc:docMk/>
            <pc:sldMk cId="3763209997" sldId="297"/>
            <ac:grpSpMk id="45" creationId="{C1D1A450-A4BB-435D-8BC8-E56E6CE15314}"/>
          </ac:grpSpMkLst>
        </pc:grpChg>
        <pc:grpChg chg="add mod">
          <ac:chgData name="Filippo Acconcia" userId="844af49c-a8a0-47ac-a7dd-14a44b60cd18" providerId="ADAL" clId="{998C6BF7-482B-421C-8ECC-9091B23559F6}" dt="2022-03-26T07:25:12.539" v="53" actId="1076"/>
          <ac:grpSpMkLst>
            <pc:docMk/>
            <pc:sldMk cId="3763209997" sldId="297"/>
            <ac:grpSpMk id="63" creationId="{0620E518-3643-44BC-B410-9F808DBFCF73}"/>
          </ac:grpSpMkLst>
        </pc:grpChg>
        <pc:grpChg chg="add mod">
          <ac:chgData name="Filippo Acconcia" userId="844af49c-a8a0-47ac-a7dd-14a44b60cd18" providerId="ADAL" clId="{998C6BF7-482B-421C-8ECC-9091B23559F6}" dt="2022-03-26T07:34:24.272" v="62" actId="1076"/>
          <ac:grpSpMkLst>
            <pc:docMk/>
            <pc:sldMk cId="3763209997" sldId="297"/>
            <ac:grpSpMk id="77" creationId="{BD667554-D6E7-4836-A4FE-9B2E1DA52980}"/>
          </ac:grpSpMkLst>
        </pc:grpChg>
        <pc:grpChg chg="mod">
          <ac:chgData name="Filippo Acconcia" userId="844af49c-a8a0-47ac-a7dd-14a44b60cd18" providerId="ADAL" clId="{998C6BF7-482B-421C-8ECC-9091B23559F6}" dt="2022-04-01T13:36:58.327" v="123" actId="553"/>
          <ac:grpSpMkLst>
            <pc:docMk/>
            <pc:sldMk cId="3763209997" sldId="297"/>
            <ac:grpSpMk id="78" creationId="{643D45EB-1184-4ADA-B2F3-2AD611353D29}"/>
          </ac:grpSpMkLst>
        </pc:grpChg>
        <pc:grpChg chg="add mod">
          <ac:chgData name="Filippo Acconcia" userId="844af49c-a8a0-47ac-a7dd-14a44b60cd18" providerId="ADAL" clId="{998C6BF7-482B-421C-8ECC-9091B23559F6}" dt="2022-04-01T13:40:45.375" v="145" actId="1036"/>
          <ac:grpSpMkLst>
            <pc:docMk/>
            <pc:sldMk cId="3763209997" sldId="297"/>
            <ac:grpSpMk id="80" creationId="{8458CE33-19EB-4E9E-A722-8EF2C4A2F746}"/>
          </ac:grpSpMkLst>
        </pc:grpChg>
        <pc:grpChg chg="add mod">
          <ac:chgData name="Filippo Acconcia" userId="844af49c-a8a0-47ac-a7dd-14a44b60cd18" providerId="ADAL" clId="{998C6BF7-482B-421C-8ECC-9091B23559F6}" dt="2022-04-01T13:40:45.375" v="145" actId="1036"/>
          <ac:grpSpMkLst>
            <pc:docMk/>
            <pc:sldMk cId="3763209997" sldId="297"/>
            <ac:grpSpMk id="82" creationId="{60A7B16D-42CF-4C53-BF53-DB7196C531DC}"/>
          </ac:grpSpMkLst>
        </pc:grpChg>
        <pc:grpChg chg="add mod">
          <ac:chgData name="Filippo Acconcia" userId="844af49c-a8a0-47ac-a7dd-14a44b60cd18" providerId="ADAL" clId="{998C6BF7-482B-421C-8ECC-9091B23559F6}" dt="2022-03-26T07:34:24.272" v="62" actId="1076"/>
          <ac:grpSpMkLst>
            <pc:docMk/>
            <pc:sldMk cId="3763209997" sldId="297"/>
            <ac:grpSpMk id="91" creationId="{D06B45C2-D1CC-475A-BC78-6969512106C4}"/>
          </ac:grpSpMkLst>
        </pc:grpChg>
        <pc:grpChg chg="add del mod">
          <ac:chgData name="Filippo Acconcia" userId="844af49c-a8a0-47ac-a7dd-14a44b60cd18" providerId="ADAL" clId="{998C6BF7-482B-421C-8ECC-9091B23559F6}" dt="2022-04-01T13:36:06.818" v="89" actId="165"/>
          <ac:grpSpMkLst>
            <pc:docMk/>
            <pc:sldMk cId="3763209997" sldId="297"/>
            <ac:grpSpMk id="123" creationId="{08608946-6A09-41B3-BD45-A6C8398C5B0F}"/>
          </ac:grpSpMkLst>
        </pc:grpChg>
        <pc:grpChg chg="add del mod">
          <ac:chgData name="Filippo Acconcia" userId="844af49c-a8a0-47ac-a7dd-14a44b60cd18" providerId="ADAL" clId="{998C6BF7-482B-421C-8ECC-9091B23559F6}" dt="2022-04-01T13:40:02.854" v="132" actId="165"/>
          <ac:grpSpMkLst>
            <pc:docMk/>
            <pc:sldMk cId="3763209997" sldId="297"/>
            <ac:grpSpMk id="142" creationId="{2C637980-64E5-4FF8-9EFF-7601F3739350}"/>
          </ac:grpSpMkLst>
        </pc:grpChg>
        <pc:grpChg chg="mod">
          <ac:chgData name="Filippo Acconcia" userId="844af49c-a8a0-47ac-a7dd-14a44b60cd18" providerId="ADAL" clId="{998C6BF7-482B-421C-8ECC-9091B23559F6}" dt="2022-04-01T13:34:58.840" v="68" actId="552"/>
          <ac:grpSpMkLst>
            <pc:docMk/>
            <pc:sldMk cId="3763209997" sldId="297"/>
            <ac:grpSpMk id="184" creationId="{5D58A688-E0B0-4DE1-B400-1851D0A3ADCA}"/>
          </ac:grpSpMkLst>
        </pc:grpChg>
        <pc:picChg chg="mod">
          <ac:chgData name="Filippo Acconcia" userId="844af49c-a8a0-47ac-a7dd-14a44b60cd18" providerId="ADAL" clId="{998C6BF7-482B-421C-8ECC-9091B23559F6}" dt="2022-03-24T06:53:31.642" v="35"/>
          <ac:picMkLst>
            <pc:docMk/>
            <pc:sldMk cId="3763209997" sldId="297"/>
            <ac:picMk id="14" creationId="{6181B0D2-58E1-451F-9880-7ED05286D313}"/>
          </ac:picMkLst>
        </pc:picChg>
        <pc:picChg chg="mod">
          <ac:chgData name="Filippo Acconcia" userId="844af49c-a8a0-47ac-a7dd-14a44b60cd18" providerId="ADAL" clId="{998C6BF7-482B-421C-8ECC-9091B23559F6}" dt="2022-03-24T06:53:31.642" v="35"/>
          <ac:picMkLst>
            <pc:docMk/>
            <pc:sldMk cId="3763209997" sldId="297"/>
            <ac:picMk id="15" creationId="{862A2712-1AD1-4691-BE0A-19BDDD50D52A}"/>
          </ac:picMkLst>
        </pc:picChg>
        <pc:picChg chg="mod">
          <ac:chgData name="Filippo Acconcia" userId="844af49c-a8a0-47ac-a7dd-14a44b60cd18" providerId="ADAL" clId="{998C6BF7-482B-421C-8ECC-9091B23559F6}" dt="2022-03-24T06:53:31.642" v="35"/>
          <ac:picMkLst>
            <pc:docMk/>
            <pc:sldMk cId="3763209997" sldId="297"/>
            <ac:picMk id="16" creationId="{4109BB2D-C202-4270-ADDE-143A032AFF7A}"/>
          </ac:picMkLst>
        </pc:picChg>
        <pc:picChg chg="mod">
          <ac:chgData name="Filippo Acconcia" userId="844af49c-a8a0-47ac-a7dd-14a44b60cd18" providerId="ADAL" clId="{998C6BF7-482B-421C-8ECC-9091B23559F6}" dt="2022-03-24T06:53:31.642" v="35"/>
          <ac:picMkLst>
            <pc:docMk/>
            <pc:sldMk cId="3763209997" sldId="297"/>
            <ac:picMk id="28" creationId="{CAE2944E-97A1-4C8A-ABD1-1B5E182972D9}"/>
          </ac:picMkLst>
        </pc:picChg>
        <pc:picChg chg="mod">
          <ac:chgData name="Filippo Acconcia" userId="844af49c-a8a0-47ac-a7dd-14a44b60cd18" providerId="ADAL" clId="{998C6BF7-482B-421C-8ECC-9091B23559F6}" dt="2022-03-24T06:53:31.642" v="35"/>
          <ac:picMkLst>
            <pc:docMk/>
            <pc:sldMk cId="3763209997" sldId="297"/>
            <ac:picMk id="29" creationId="{9236AE0A-7BBC-4203-BBD8-6F753D0BFD8F}"/>
          </ac:picMkLst>
        </pc:picChg>
        <pc:picChg chg="mod">
          <ac:chgData name="Filippo Acconcia" userId="844af49c-a8a0-47ac-a7dd-14a44b60cd18" providerId="ADAL" clId="{998C6BF7-482B-421C-8ECC-9091B23559F6}" dt="2022-03-24T06:53:31.642" v="35"/>
          <ac:picMkLst>
            <pc:docMk/>
            <pc:sldMk cId="3763209997" sldId="297"/>
            <ac:picMk id="30" creationId="{21D52002-EA94-4475-8424-97AAF3DF6527}"/>
          </ac:picMkLst>
        </pc:picChg>
        <pc:picChg chg="mod">
          <ac:chgData name="Filippo Acconcia" userId="844af49c-a8a0-47ac-a7dd-14a44b60cd18" providerId="ADAL" clId="{998C6BF7-482B-421C-8ECC-9091B23559F6}" dt="2022-03-24T06:53:31.642" v="35"/>
          <ac:picMkLst>
            <pc:docMk/>
            <pc:sldMk cId="3763209997" sldId="297"/>
            <ac:picMk id="32" creationId="{4668BCCF-54D9-42EF-A0C3-967209ED0C98}"/>
          </ac:picMkLst>
        </pc:picChg>
        <pc:picChg chg="mod">
          <ac:chgData name="Filippo Acconcia" userId="844af49c-a8a0-47ac-a7dd-14a44b60cd18" providerId="ADAL" clId="{998C6BF7-482B-421C-8ECC-9091B23559F6}" dt="2022-03-24T06:53:31.642" v="35"/>
          <ac:picMkLst>
            <pc:docMk/>
            <pc:sldMk cId="3763209997" sldId="297"/>
            <ac:picMk id="33" creationId="{A8A11E5A-A619-4202-BE6E-E3A782707D37}"/>
          </ac:picMkLst>
        </pc:picChg>
        <pc:picChg chg="mod">
          <ac:chgData name="Filippo Acconcia" userId="844af49c-a8a0-47ac-a7dd-14a44b60cd18" providerId="ADAL" clId="{998C6BF7-482B-421C-8ECC-9091B23559F6}" dt="2022-03-24T06:53:31.642" v="35"/>
          <ac:picMkLst>
            <pc:docMk/>
            <pc:sldMk cId="3763209997" sldId="297"/>
            <ac:picMk id="34" creationId="{0B865855-9DC7-427F-A20D-4CF18D8D41D4}"/>
          </ac:picMkLst>
        </pc:picChg>
        <pc:picChg chg="mod">
          <ac:chgData name="Filippo Acconcia" userId="844af49c-a8a0-47ac-a7dd-14a44b60cd18" providerId="ADAL" clId="{998C6BF7-482B-421C-8ECC-9091B23559F6}" dt="2022-03-24T06:53:31.642" v="35"/>
          <ac:picMkLst>
            <pc:docMk/>
            <pc:sldMk cId="3763209997" sldId="297"/>
            <ac:picMk id="46" creationId="{EC4CD116-F811-4B58-AE94-519D4B1ECA64}"/>
          </ac:picMkLst>
        </pc:picChg>
        <pc:picChg chg="mod">
          <ac:chgData name="Filippo Acconcia" userId="844af49c-a8a0-47ac-a7dd-14a44b60cd18" providerId="ADAL" clId="{998C6BF7-482B-421C-8ECC-9091B23559F6}" dt="2022-03-24T06:53:31.642" v="35"/>
          <ac:picMkLst>
            <pc:docMk/>
            <pc:sldMk cId="3763209997" sldId="297"/>
            <ac:picMk id="47" creationId="{FF3BC238-68F5-4B9C-A897-9FE1744CC38C}"/>
          </ac:picMkLst>
        </pc:picChg>
        <pc:picChg chg="mod">
          <ac:chgData name="Filippo Acconcia" userId="844af49c-a8a0-47ac-a7dd-14a44b60cd18" providerId="ADAL" clId="{998C6BF7-482B-421C-8ECC-9091B23559F6}" dt="2022-03-24T06:53:31.642" v="35"/>
          <ac:picMkLst>
            <pc:docMk/>
            <pc:sldMk cId="3763209997" sldId="297"/>
            <ac:picMk id="48" creationId="{29646F95-C6C5-480B-A11F-66673FCCF7FA}"/>
          </ac:picMkLst>
        </pc:picChg>
        <pc:picChg chg="mod">
          <ac:chgData name="Filippo Acconcia" userId="844af49c-a8a0-47ac-a7dd-14a44b60cd18" providerId="ADAL" clId="{998C6BF7-482B-421C-8ECC-9091B23559F6}" dt="2022-03-26T07:25:06.635" v="51"/>
          <ac:picMkLst>
            <pc:docMk/>
            <pc:sldMk cId="3763209997" sldId="297"/>
            <ac:picMk id="64" creationId="{687A6460-CE69-492B-9CE6-4DDBEAE80AEB}"/>
          </ac:picMkLst>
        </pc:picChg>
        <pc:picChg chg="mod">
          <ac:chgData name="Filippo Acconcia" userId="844af49c-a8a0-47ac-a7dd-14a44b60cd18" providerId="ADAL" clId="{998C6BF7-482B-421C-8ECC-9091B23559F6}" dt="2022-03-26T07:25:06.635" v="51"/>
          <ac:picMkLst>
            <pc:docMk/>
            <pc:sldMk cId="3763209997" sldId="297"/>
            <ac:picMk id="65" creationId="{6FBA60D3-3A5C-4994-9C95-4F22B3300A49}"/>
          </ac:picMkLst>
        </pc:picChg>
        <pc:picChg chg="mod">
          <ac:chgData name="Filippo Acconcia" userId="844af49c-a8a0-47ac-a7dd-14a44b60cd18" providerId="ADAL" clId="{998C6BF7-482B-421C-8ECC-9091B23559F6}" dt="2022-03-26T07:25:06.635" v="51"/>
          <ac:picMkLst>
            <pc:docMk/>
            <pc:sldMk cId="3763209997" sldId="297"/>
            <ac:picMk id="66" creationId="{3595E195-3CDD-4601-8F31-DDB59A24C7E9}"/>
          </ac:picMkLst>
        </pc:picChg>
        <pc:picChg chg="mod">
          <ac:chgData name="Filippo Acconcia" userId="844af49c-a8a0-47ac-a7dd-14a44b60cd18" providerId="ADAL" clId="{998C6BF7-482B-421C-8ECC-9091B23559F6}" dt="2022-03-26T07:34:20.317" v="61"/>
          <ac:picMkLst>
            <pc:docMk/>
            <pc:sldMk cId="3763209997" sldId="297"/>
            <ac:picMk id="78" creationId="{C072C116-7902-423D-AA75-D668815CF265}"/>
          </ac:picMkLst>
        </pc:picChg>
        <pc:picChg chg="mod">
          <ac:chgData name="Filippo Acconcia" userId="844af49c-a8a0-47ac-a7dd-14a44b60cd18" providerId="ADAL" clId="{998C6BF7-482B-421C-8ECC-9091B23559F6}" dt="2022-03-26T07:34:20.317" v="61"/>
          <ac:picMkLst>
            <pc:docMk/>
            <pc:sldMk cId="3763209997" sldId="297"/>
            <ac:picMk id="79" creationId="{67730DE9-9035-449B-95EF-C380FE811970}"/>
          </ac:picMkLst>
        </pc:picChg>
        <pc:picChg chg="mod ord">
          <ac:chgData name="Filippo Acconcia" userId="844af49c-a8a0-47ac-a7dd-14a44b60cd18" providerId="ADAL" clId="{998C6BF7-482B-421C-8ECC-9091B23559F6}" dt="2022-04-01T13:36:43.367" v="101" actId="164"/>
          <ac:picMkLst>
            <pc:docMk/>
            <pc:sldMk cId="3763209997" sldId="297"/>
            <ac:picMk id="79" creationId="{AEC89909-7C8E-42CD-A668-70DB01AC0BF2}"/>
          </ac:picMkLst>
        </pc:picChg>
        <pc:picChg chg="mod ord">
          <ac:chgData name="Filippo Acconcia" userId="844af49c-a8a0-47ac-a7dd-14a44b60cd18" providerId="ADAL" clId="{998C6BF7-482B-421C-8ECC-9091B23559F6}" dt="2022-04-01T13:40:43.579" v="144" actId="164"/>
          <ac:picMkLst>
            <pc:docMk/>
            <pc:sldMk cId="3763209997" sldId="297"/>
            <ac:picMk id="81" creationId="{33104A2D-9E3E-42C1-AE6B-88D28E135D33}"/>
          </ac:picMkLst>
        </pc:picChg>
        <pc:picChg chg="mod">
          <ac:chgData name="Filippo Acconcia" userId="844af49c-a8a0-47ac-a7dd-14a44b60cd18" providerId="ADAL" clId="{998C6BF7-482B-421C-8ECC-9091B23559F6}" dt="2022-03-26T07:34:20.317" v="61"/>
          <ac:picMkLst>
            <pc:docMk/>
            <pc:sldMk cId="3763209997" sldId="297"/>
            <ac:picMk id="92" creationId="{E99DCC9E-AFA4-4A83-B0F3-742F64ECCB37}"/>
          </ac:picMkLst>
        </pc:picChg>
        <pc:picChg chg="mod">
          <ac:chgData name="Filippo Acconcia" userId="844af49c-a8a0-47ac-a7dd-14a44b60cd18" providerId="ADAL" clId="{998C6BF7-482B-421C-8ECC-9091B23559F6}" dt="2022-03-26T07:34:20.317" v="61"/>
          <ac:picMkLst>
            <pc:docMk/>
            <pc:sldMk cId="3763209997" sldId="297"/>
            <ac:picMk id="104" creationId="{16E86A3B-8BAF-42B8-BD1A-05123003FFE7}"/>
          </ac:picMkLst>
        </pc:picChg>
        <pc:picChg chg="del mod topLvl">
          <ac:chgData name="Filippo Acconcia" userId="844af49c-a8a0-47ac-a7dd-14a44b60cd18" providerId="ADAL" clId="{998C6BF7-482B-421C-8ECC-9091B23559F6}" dt="2022-04-01T13:36:29.974" v="94" actId="478"/>
          <ac:picMkLst>
            <pc:docMk/>
            <pc:sldMk cId="3763209997" sldId="297"/>
            <ac:picMk id="124" creationId="{52CB6484-51E9-4F2B-9456-0D632C2583B4}"/>
          </ac:picMkLst>
        </pc:picChg>
        <pc:picChg chg="del mod topLvl">
          <ac:chgData name="Filippo Acconcia" userId="844af49c-a8a0-47ac-a7dd-14a44b60cd18" providerId="ADAL" clId="{998C6BF7-482B-421C-8ECC-9091B23559F6}" dt="2022-04-01T13:40:18.718" v="137" actId="478"/>
          <ac:picMkLst>
            <pc:docMk/>
            <pc:sldMk cId="3763209997" sldId="297"/>
            <ac:picMk id="143" creationId="{255282F0-3A74-4EB0-AE54-4DB1C0379836}"/>
          </ac:picMkLst>
        </pc:picChg>
        <pc:cxnChg chg="mod">
          <ac:chgData name="Filippo Acconcia" userId="844af49c-a8a0-47ac-a7dd-14a44b60cd18" providerId="ADAL" clId="{998C6BF7-482B-421C-8ECC-9091B23559F6}" dt="2022-03-24T06:53:31.642" v="35"/>
          <ac:cxnSpMkLst>
            <pc:docMk/>
            <pc:sldMk cId="3763209997" sldId="297"/>
            <ac:cxnSpMk id="13" creationId="{13DEAE0E-330E-4E66-8FD2-B68CBF7BEB60}"/>
          </ac:cxnSpMkLst>
        </pc:cxnChg>
        <pc:cxnChg chg="mod">
          <ac:chgData name="Filippo Acconcia" userId="844af49c-a8a0-47ac-a7dd-14a44b60cd18" providerId="ADAL" clId="{998C6BF7-482B-421C-8ECC-9091B23559F6}" dt="2022-03-24T06:53:31.642" v="35"/>
          <ac:cxnSpMkLst>
            <pc:docMk/>
            <pc:sldMk cId="3763209997" sldId="297"/>
            <ac:cxnSpMk id="26" creationId="{941CB2B0-E317-4EF5-81C0-5744A4981B4B}"/>
          </ac:cxnSpMkLst>
        </pc:cxnChg>
        <pc:cxnChg chg="mod">
          <ac:chgData name="Filippo Acconcia" userId="844af49c-a8a0-47ac-a7dd-14a44b60cd18" providerId="ADAL" clId="{998C6BF7-482B-421C-8ECC-9091B23559F6}" dt="2022-03-24T06:53:31.642" v="35"/>
          <ac:cxnSpMkLst>
            <pc:docMk/>
            <pc:sldMk cId="3763209997" sldId="297"/>
            <ac:cxnSpMk id="43" creationId="{DF233ED4-5FC5-462E-9397-62FD6F101E3A}"/>
          </ac:cxnSpMkLst>
        </pc:cxnChg>
        <pc:cxnChg chg="mod">
          <ac:chgData name="Filippo Acconcia" userId="844af49c-a8a0-47ac-a7dd-14a44b60cd18" providerId="ADAL" clId="{998C6BF7-482B-421C-8ECC-9091B23559F6}" dt="2022-03-24T06:53:31.642" v="35"/>
          <ac:cxnSpMkLst>
            <pc:docMk/>
            <pc:sldMk cId="3763209997" sldId="297"/>
            <ac:cxnSpMk id="57" creationId="{CB6D06FF-30DE-4C94-92E2-B6E37AB5E5CF}"/>
          </ac:cxnSpMkLst>
        </pc:cxnChg>
        <pc:cxnChg chg="mod">
          <ac:chgData name="Filippo Acconcia" userId="844af49c-a8a0-47ac-a7dd-14a44b60cd18" providerId="ADAL" clId="{998C6BF7-482B-421C-8ECC-9091B23559F6}" dt="2022-03-26T07:25:06.635" v="51"/>
          <ac:cxnSpMkLst>
            <pc:docMk/>
            <pc:sldMk cId="3763209997" sldId="297"/>
            <ac:cxnSpMk id="75" creationId="{CE8D3CB2-CBF0-4A22-BFF9-77CA5A448468}"/>
          </ac:cxnSpMkLst>
        </pc:cxnChg>
        <pc:cxnChg chg="mod">
          <ac:chgData name="Filippo Acconcia" userId="844af49c-a8a0-47ac-a7dd-14a44b60cd18" providerId="ADAL" clId="{998C6BF7-482B-421C-8ECC-9091B23559F6}" dt="2022-03-26T07:34:20.317" v="61"/>
          <ac:cxnSpMkLst>
            <pc:docMk/>
            <pc:sldMk cId="3763209997" sldId="297"/>
            <ac:cxnSpMk id="80" creationId="{D55F0E7E-250C-4D16-9A31-57E28611ABD4}"/>
          </ac:cxnSpMkLst>
        </pc:cxnChg>
        <pc:cxnChg chg="mod">
          <ac:chgData name="Filippo Acconcia" userId="844af49c-a8a0-47ac-a7dd-14a44b60cd18" providerId="ADAL" clId="{998C6BF7-482B-421C-8ECC-9091B23559F6}" dt="2022-03-26T07:34:20.317" v="61"/>
          <ac:cxnSpMkLst>
            <pc:docMk/>
            <pc:sldMk cId="3763209997" sldId="297"/>
            <ac:cxnSpMk id="89" creationId="{BDA55623-17F4-461E-930E-8536BE832219}"/>
          </ac:cxnSpMkLst>
        </pc:cxnChg>
        <pc:cxnChg chg="mod">
          <ac:chgData name="Filippo Acconcia" userId="844af49c-a8a0-47ac-a7dd-14a44b60cd18" providerId="ADAL" clId="{998C6BF7-482B-421C-8ECC-9091B23559F6}" dt="2022-03-26T07:34:20.317" v="61"/>
          <ac:cxnSpMkLst>
            <pc:docMk/>
            <pc:sldMk cId="3763209997" sldId="297"/>
            <ac:cxnSpMk id="93" creationId="{AB46D730-9DDD-4E00-8EE1-9073CA3822A7}"/>
          </ac:cxnSpMkLst>
        </pc:cxnChg>
        <pc:cxnChg chg="mod">
          <ac:chgData name="Filippo Acconcia" userId="844af49c-a8a0-47ac-a7dd-14a44b60cd18" providerId="ADAL" clId="{998C6BF7-482B-421C-8ECC-9091B23559F6}" dt="2022-03-26T07:34:20.317" v="61"/>
          <ac:cxnSpMkLst>
            <pc:docMk/>
            <pc:sldMk cId="3763209997" sldId="297"/>
            <ac:cxnSpMk id="102" creationId="{E24A325B-5F7A-4594-9200-1FF25BE5B79A}"/>
          </ac:cxnSpMkLst>
        </pc:cxnChg>
        <pc:cxnChg chg="mod topLvl">
          <ac:chgData name="Filippo Acconcia" userId="844af49c-a8a0-47ac-a7dd-14a44b60cd18" providerId="ADAL" clId="{998C6BF7-482B-421C-8ECC-9091B23559F6}" dt="2022-04-01T13:36:43.367" v="101" actId="164"/>
          <ac:cxnSpMkLst>
            <pc:docMk/>
            <pc:sldMk cId="3763209997" sldId="297"/>
            <ac:cxnSpMk id="130" creationId="{40FFCC47-FA3D-49DB-A82E-05FE9ACE1A42}"/>
          </ac:cxnSpMkLst>
        </pc:cxnChg>
        <pc:cxnChg chg="mod topLvl">
          <ac:chgData name="Filippo Acconcia" userId="844af49c-a8a0-47ac-a7dd-14a44b60cd18" providerId="ADAL" clId="{998C6BF7-482B-421C-8ECC-9091B23559F6}" dt="2022-04-01T13:40:43.579" v="144" actId="164"/>
          <ac:cxnSpMkLst>
            <pc:docMk/>
            <pc:sldMk cId="3763209997" sldId="297"/>
            <ac:cxnSpMk id="149" creationId="{382095F2-0E7F-497B-9124-CFCF683E1F6E}"/>
          </ac:cxnSpMkLst>
        </pc:cxnChg>
      </pc:sldChg>
      <pc:sldChg chg="addSp delSp modSp mod">
        <pc:chgData name="Filippo Acconcia" userId="844af49c-a8a0-47ac-a7dd-14a44b60cd18" providerId="ADAL" clId="{998C6BF7-482B-421C-8ECC-9091B23559F6}" dt="2022-05-07T06:28:38.191" v="724" actId="20577"/>
        <pc:sldMkLst>
          <pc:docMk/>
          <pc:sldMk cId="3258456422" sldId="298"/>
        </pc:sldMkLst>
        <pc:spChg chg="mod">
          <ac:chgData name="Filippo Acconcia" userId="844af49c-a8a0-47ac-a7dd-14a44b60cd18" providerId="ADAL" clId="{998C6BF7-482B-421C-8ECC-9091B23559F6}" dt="2022-03-25T06:03:24.762" v="38"/>
          <ac:spMkLst>
            <pc:docMk/>
            <pc:sldMk cId="3258456422" sldId="298"/>
            <ac:spMk id="204" creationId="{DCA808C7-C71B-43F5-9A0D-A45FF2F99C50}"/>
          </ac:spMkLst>
        </pc:spChg>
        <pc:spChg chg="mod">
          <ac:chgData name="Filippo Acconcia" userId="844af49c-a8a0-47ac-a7dd-14a44b60cd18" providerId="ADAL" clId="{998C6BF7-482B-421C-8ECC-9091B23559F6}" dt="2022-03-25T06:03:24.762" v="38"/>
          <ac:spMkLst>
            <pc:docMk/>
            <pc:sldMk cId="3258456422" sldId="298"/>
            <ac:spMk id="205" creationId="{9E321AAD-6460-40B4-B0CC-9CF91DCA7F77}"/>
          </ac:spMkLst>
        </pc:spChg>
        <pc:spChg chg="mod">
          <ac:chgData name="Filippo Acconcia" userId="844af49c-a8a0-47ac-a7dd-14a44b60cd18" providerId="ADAL" clId="{998C6BF7-482B-421C-8ECC-9091B23559F6}" dt="2022-03-25T06:03:24.762" v="38"/>
          <ac:spMkLst>
            <pc:docMk/>
            <pc:sldMk cId="3258456422" sldId="298"/>
            <ac:spMk id="206" creationId="{8FA969DD-4B58-4B95-BAC6-A87FDD5589F2}"/>
          </ac:spMkLst>
        </pc:spChg>
        <pc:spChg chg="mod">
          <ac:chgData name="Filippo Acconcia" userId="844af49c-a8a0-47ac-a7dd-14a44b60cd18" providerId="ADAL" clId="{998C6BF7-482B-421C-8ECC-9091B23559F6}" dt="2022-03-25T06:03:24.762" v="38"/>
          <ac:spMkLst>
            <pc:docMk/>
            <pc:sldMk cId="3258456422" sldId="298"/>
            <ac:spMk id="207" creationId="{CB7A6E6E-AA2A-4A34-BE4D-0FD2810E3E2D}"/>
          </ac:spMkLst>
        </pc:spChg>
        <pc:spChg chg="mod">
          <ac:chgData name="Filippo Acconcia" userId="844af49c-a8a0-47ac-a7dd-14a44b60cd18" providerId="ADAL" clId="{998C6BF7-482B-421C-8ECC-9091B23559F6}" dt="2022-03-25T06:03:24.762" v="38"/>
          <ac:spMkLst>
            <pc:docMk/>
            <pc:sldMk cId="3258456422" sldId="298"/>
            <ac:spMk id="208" creationId="{0305B1D0-3CC2-45A9-B789-148C09980178}"/>
          </ac:spMkLst>
        </pc:spChg>
        <pc:spChg chg="mod">
          <ac:chgData name="Filippo Acconcia" userId="844af49c-a8a0-47ac-a7dd-14a44b60cd18" providerId="ADAL" clId="{998C6BF7-482B-421C-8ECC-9091B23559F6}" dt="2022-03-25T06:03:24.762" v="38"/>
          <ac:spMkLst>
            <pc:docMk/>
            <pc:sldMk cId="3258456422" sldId="298"/>
            <ac:spMk id="209" creationId="{A0F0CD7B-0DC7-4F8E-8997-E0F2A51AFD7E}"/>
          </ac:spMkLst>
        </pc:spChg>
        <pc:spChg chg="mod">
          <ac:chgData name="Filippo Acconcia" userId="844af49c-a8a0-47ac-a7dd-14a44b60cd18" providerId="ADAL" clId="{998C6BF7-482B-421C-8ECC-9091B23559F6}" dt="2022-03-25T06:03:24.762" v="38"/>
          <ac:spMkLst>
            <pc:docMk/>
            <pc:sldMk cId="3258456422" sldId="298"/>
            <ac:spMk id="210" creationId="{B22B8FEE-8C4E-4415-AFF9-C95ADA6D4E8E}"/>
          </ac:spMkLst>
        </pc:spChg>
        <pc:spChg chg="mod">
          <ac:chgData name="Filippo Acconcia" userId="844af49c-a8a0-47ac-a7dd-14a44b60cd18" providerId="ADAL" clId="{998C6BF7-482B-421C-8ECC-9091B23559F6}" dt="2022-05-07T06:28:38.191" v="724" actId="20577"/>
          <ac:spMkLst>
            <pc:docMk/>
            <pc:sldMk cId="3258456422" sldId="298"/>
            <ac:spMk id="213" creationId="{F28BA8AA-D7EE-49F8-93D1-75E2EC8B2D89}"/>
          </ac:spMkLst>
        </pc:spChg>
        <pc:grpChg chg="del">
          <ac:chgData name="Filippo Acconcia" userId="844af49c-a8a0-47ac-a7dd-14a44b60cd18" providerId="ADAL" clId="{998C6BF7-482B-421C-8ECC-9091B23559F6}" dt="2022-03-25T06:03:16.486" v="37" actId="478"/>
          <ac:grpSpMkLst>
            <pc:docMk/>
            <pc:sldMk cId="3258456422" sldId="298"/>
            <ac:grpSpMk id="165" creationId="{72649F00-0771-4DBF-8FE7-A69CB648D350}"/>
          </ac:grpSpMkLst>
        </pc:grpChg>
        <pc:grpChg chg="add mod">
          <ac:chgData name="Filippo Acconcia" userId="844af49c-a8a0-47ac-a7dd-14a44b60cd18" providerId="ADAL" clId="{998C6BF7-482B-421C-8ECC-9091B23559F6}" dt="2022-03-25T06:03:26.667" v="39" actId="1076"/>
          <ac:grpSpMkLst>
            <pc:docMk/>
            <pc:sldMk cId="3258456422" sldId="298"/>
            <ac:grpSpMk id="202" creationId="{793F8F83-D844-4696-BA94-330A01405D41}"/>
          </ac:grpSpMkLst>
        </pc:grpChg>
        <pc:picChg chg="mod">
          <ac:chgData name="Filippo Acconcia" userId="844af49c-a8a0-47ac-a7dd-14a44b60cd18" providerId="ADAL" clId="{998C6BF7-482B-421C-8ECC-9091B23559F6}" dt="2022-03-25T06:03:24.762" v="38"/>
          <ac:picMkLst>
            <pc:docMk/>
            <pc:sldMk cId="3258456422" sldId="298"/>
            <ac:picMk id="203" creationId="{8453B090-7BAB-4F3C-921E-3E2A99E12B59}"/>
          </ac:picMkLst>
        </pc:picChg>
        <pc:picChg chg="mod">
          <ac:chgData name="Filippo Acconcia" userId="844af49c-a8a0-47ac-a7dd-14a44b60cd18" providerId="ADAL" clId="{998C6BF7-482B-421C-8ECC-9091B23559F6}" dt="2022-03-25T06:03:24.762" v="38"/>
          <ac:picMkLst>
            <pc:docMk/>
            <pc:sldMk cId="3258456422" sldId="298"/>
            <ac:picMk id="211" creationId="{3F09A956-F582-408E-85AF-6DDBFC8B2AD3}"/>
          </ac:picMkLst>
        </pc:picChg>
        <pc:picChg chg="mod">
          <ac:chgData name="Filippo Acconcia" userId="844af49c-a8a0-47ac-a7dd-14a44b60cd18" providerId="ADAL" clId="{998C6BF7-482B-421C-8ECC-9091B23559F6}" dt="2022-03-25T06:03:24.762" v="38"/>
          <ac:picMkLst>
            <pc:docMk/>
            <pc:sldMk cId="3258456422" sldId="298"/>
            <ac:picMk id="212" creationId="{AEB187C6-B6BA-4809-89F5-C2BF03D92940}"/>
          </ac:picMkLst>
        </pc:picChg>
      </pc:sldChg>
      <pc:sldChg chg="addSp modSp mod">
        <pc:chgData name="Filippo Acconcia" userId="844af49c-a8a0-47ac-a7dd-14a44b60cd18" providerId="ADAL" clId="{998C6BF7-482B-421C-8ECC-9091B23559F6}" dt="2022-03-26T07:31:21.589" v="60" actId="1076"/>
        <pc:sldMkLst>
          <pc:docMk/>
          <pc:sldMk cId="524157325" sldId="299"/>
        </pc:sldMkLst>
        <pc:spChg chg="mod">
          <ac:chgData name="Filippo Acconcia" userId="844af49c-a8a0-47ac-a7dd-14a44b60cd18" providerId="ADAL" clId="{998C6BF7-482B-421C-8ECC-9091B23559F6}" dt="2022-03-26T07:30:10.600" v="54"/>
          <ac:spMkLst>
            <pc:docMk/>
            <pc:sldMk cId="524157325" sldId="299"/>
            <ac:spMk id="38" creationId="{6B6118C3-1FCD-41D0-8EB2-F3CE5F2013D9}"/>
          </ac:spMkLst>
        </pc:spChg>
        <pc:spChg chg="mod">
          <ac:chgData name="Filippo Acconcia" userId="844af49c-a8a0-47ac-a7dd-14a44b60cd18" providerId="ADAL" clId="{998C6BF7-482B-421C-8ECC-9091B23559F6}" dt="2022-03-26T07:30:10.600" v="54"/>
          <ac:spMkLst>
            <pc:docMk/>
            <pc:sldMk cId="524157325" sldId="299"/>
            <ac:spMk id="39" creationId="{05ADB9C7-ED3C-4CEA-B4C4-600902B58A00}"/>
          </ac:spMkLst>
        </pc:spChg>
        <pc:spChg chg="mod">
          <ac:chgData name="Filippo Acconcia" userId="844af49c-a8a0-47ac-a7dd-14a44b60cd18" providerId="ADAL" clId="{998C6BF7-482B-421C-8ECC-9091B23559F6}" dt="2022-03-26T07:30:10.600" v="54"/>
          <ac:spMkLst>
            <pc:docMk/>
            <pc:sldMk cId="524157325" sldId="299"/>
            <ac:spMk id="40" creationId="{94B37797-9143-4BCC-82A2-2E12547DEDFC}"/>
          </ac:spMkLst>
        </pc:spChg>
        <pc:spChg chg="mod">
          <ac:chgData name="Filippo Acconcia" userId="844af49c-a8a0-47ac-a7dd-14a44b60cd18" providerId="ADAL" clId="{998C6BF7-482B-421C-8ECC-9091B23559F6}" dt="2022-03-26T07:30:10.600" v="54"/>
          <ac:spMkLst>
            <pc:docMk/>
            <pc:sldMk cId="524157325" sldId="299"/>
            <ac:spMk id="41" creationId="{E8A26B7A-E60B-4796-B42D-56EC93B61994}"/>
          </ac:spMkLst>
        </pc:spChg>
        <pc:spChg chg="mod">
          <ac:chgData name="Filippo Acconcia" userId="844af49c-a8a0-47ac-a7dd-14a44b60cd18" providerId="ADAL" clId="{998C6BF7-482B-421C-8ECC-9091B23559F6}" dt="2022-03-26T07:30:10.600" v="54"/>
          <ac:spMkLst>
            <pc:docMk/>
            <pc:sldMk cId="524157325" sldId="299"/>
            <ac:spMk id="42" creationId="{B0649728-C6D0-483B-A9A8-54DDA5310B09}"/>
          </ac:spMkLst>
        </pc:spChg>
        <pc:spChg chg="mod">
          <ac:chgData name="Filippo Acconcia" userId="844af49c-a8a0-47ac-a7dd-14a44b60cd18" providerId="ADAL" clId="{998C6BF7-482B-421C-8ECC-9091B23559F6}" dt="2022-03-26T07:30:10.600" v="54"/>
          <ac:spMkLst>
            <pc:docMk/>
            <pc:sldMk cId="524157325" sldId="299"/>
            <ac:spMk id="43" creationId="{E2D58A4F-ADF8-4669-BDF3-430BAF0A18A7}"/>
          </ac:spMkLst>
        </pc:spChg>
        <pc:spChg chg="mod">
          <ac:chgData name="Filippo Acconcia" userId="844af49c-a8a0-47ac-a7dd-14a44b60cd18" providerId="ADAL" clId="{998C6BF7-482B-421C-8ECC-9091B23559F6}" dt="2022-03-26T07:30:10.600" v="54"/>
          <ac:spMkLst>
            <pc:docMk/>
            <pc:sldMk cId="524157325" sldId="299"/>
            <ac:spMk id="44" creationId="{C3963A1E-D042-40EB-BAE0-4831550C0CD1}"/>
          </ac:spMkLst>
        </pc:spChg>
        <pc:spChg chg="mod">
          <ac:chgData name="Filippo Acconcia" userId="844af49c-a8a0-47ac-a7dd-14a44b60cd18" providerId="ADAL" clId="{998C6BF7-482B-421C-8ECC-9091B23559F6}" dt="2022-03-26T07:30:10.600" v="54"/>
          <ac:spMkLst>
            <pc:docMk/>
            <pc:sldMk cId="524157325" sldId="299"/>
            <ac:spMk id="48" creationId="{6A4C2DDC-9A76-42A7-879B-DD22253FF9C1}"/>
          </ac:spMkLst>
        </pc:spChg>
        <pc:spChg chg="mod">
          <ac:chgData name="Filippo Acconcia" userId="844af49c-a8a0-47ac-a7dd-14a44b60cd18" providerId="ADAL" clId="{998C6BF7-482B-421C-8ECC-9091B23559F6}" dt="2022-03-26T07:30:10.600" v="54"/>
          <ac:spMkLst>
            <pc:docMk/>
            <pc:sldMk cId="524157325" sldId="299"/>
            <ac:spMk id="49" creationId="{892F1EE2-33CA-4D56-BF9C-6E3C88A1E528}"/>
          </ac:spMkLst>
        </pc:spChg>
        <pc:spChg chg="mod">
          <ac:chgData name="Filippo Acconcia" userId="844af49c-a8a0-47ac-a7dd-14a44b60cd18" providerId="ADAL" clId="{998C6BF7-482B-421C-8ECC-9091B23559F6}" dt="2022-03-26T07:30:10.600" v="54"/>
          <ac:spMkLst>
            <pc:docMk/>
            <pc:sldMk cId="524157325" sldId="299"/>
            <ac:spMk id="52" creationId="{0F7B6342-FB80-481A-A979-35CEAC77A106}"/>
          </ac:spMkLst>
        </pc:spChg>
        <pc:spChg chg="mod">
          <ac:chgData name="Filippo Acconcia" userId="844af49c-a8a0-47ac-a7dd-14a44b60cd18" providerId="ADAL" clId="{998C6BF7-482B-421C-8ECC-9091B23559F6}" dt="2022-03-26T07:30:10.600" v="54"/>
          <ac:spMkLst>
            <pc:docMk/>
            <pc:sldMk cId="524157325" sldId="299"/>
            <ac:spMk id="53" creationId="{C244CB18-FB88-4A0D-A6AF-D066C88982CC}"/>
          </ac:spMkLst>
        </pc:spChg>
        <pc:spChg chg="mod">
          <ac:chgData name="Filippo Acconcia" userId="844af49c-a8a0-47ac-a7dd-14a44b60cd18" providerId="ADAL" clId="{998C6BF7-482B-421C-8ECC-9091B23559F6}" dt="2022-03-26T07:30:10.600" v="54"/>
          <ac:spMkLst>
            <pc:docMk/>
            <pc:sldMk cId="524157325" sldId="299"/>
            <ac:spMk id="54" creationId="{053C23CD-0EE3-4199-8A9B-C228F4FC535C}"/>
          </ac:spMkLst>
        </pc:spChg>
        <pc:grpChg chg="mod">
          <ac:chgData name="Filippo Acconcia" userId="844af49c-a8a0-47ac-a7dd-14a44b60cd18" providerId="ADAL" clId="{998C6BF7-482B-421C-8ECC-9091B23559F6}" dt="2022-03-26T07:31:17.660" v="59" actId="1076"/>
          <ac:grpSpMkLst>
            <pc:docMk/>
            <pc:sldMk cId="524157325" sldId="299"/>
            <ac:grpSpMk id="3" creationId="{1BC9F02F-47C1-4382-B721-B7E945A7A312}"/>
          </ac:grpSpMkLst>
        </pc:grpChg>
        <pc:grpChg chg="mod">
          <ac:chgData name="Filippo Acconcia" userId="844af49c-a8a0-47ac-a7dd-14a44b60cd18" providerId="ADAL" clId="{998C6BF7-482B-421C-8ECC-9091B23559F6}" dt="2022-03-26T07:31:16.257" v="58" actId="1076"/>
          <ac:grpSpMkLst>
            <pc:docMk/>
            <pc:sldMk cId="524157325" sldId="299"/>
            <ac:grpSpMk id="18" creationId="{E7866D84-354A-4C45-B4F5-52C96357C86D}"/>
          </ac:grpSpMkLst>
        </pc:grpChg>
        <pc:grpChg chg="add mod">
          <ac:chgData name="Filippo Acconcia" userId="844af49c-a8a0-47ac-a7dd-14a44b60cd18" providerId="ADAL" clId="{998C6BF7-482B-421C-8ECC-9091B23559F6}" dt="2022-03-26T07:30:12.377" v="55" actId="1076"/>
          <ac:grpSpMkLst>
            <pc:docMk/>
            <pc:sldMk cId="524157325" sldId="299"/>
            <ac:grpSpMk id="36" creationId="{BC3B646A-50BD-4DD6-94F0-DD2AFFC472BB}"/>
          </ac:grpSpMkLst>
        </pc:grpChg>
        <pc:grpChg chg="add mod">
          <ac:chgData name="Filippo Acconcia" userId="844af49c-a8a0-47ac-a7dd-14a44b60cd18" providerId="ADAL" clId="{998C6BF7-482B-421C-8ECC-9091B23559F6}" dt="2022-03-26T07:31:21.589" v="60" actId="1076"/>
          <ac:grpSpMkLst>
            <pc:docMk/>
            <pc:sldMk cId="524157325" sldId="299"/>
            <ac:grpSpMk id="47" creationId="{2567293A-8F1E-4B22-8975-7CCF895B1837}"/>
          </ac:grpSpMkLst>
        </pc:grpChg>
        <pc:picChg chg="mod">
          <ac:chgData name="Filippo Acconcia" userId="844af49c-a8a0-47ac-a7dd-14a44b60cd18" providerId="ADAL" clId="{998C6BF7-482B-421C-8ECC-9091B23559F6}" dt="2022-03-26T07:30:10.600" v="54"/>
          <ac:picMkLst>
            <pc:docMk/>
            <pc:sldMk cId="524157325" sldId="299"/>
            <ac:picMk id="37" creationId="{A7EA384C-CEA9-4A00-9254-71D02387E8FD}"/>
          </ac:picMkLst>
        </pc:picChg>
        <pc:picChg chg="mod">
          <ac:chgData name="Filippo Acconcia" userId="844af49c-a8a0-47ac-a7dd-14a44b60cd18" providerId="ADAL" clId="{998C6BF7-482B-421C-8ECC-9091B23559F6}" dt="2022-03-26T07:30:10.600" v="54"/>
          <ac:picMkLst>
            <pc:docMk/>
            <pc:sldMk cId="524157325" sldId="299"/>
            <ac:picMk id="45" creationId="{28F1FC0E-ABA5-47EE-8A7C-321B17B978D9}"/>
          </ac:picMkLst>
        </pc:picChg>
        <pc:picChg chg="mod">
          <ac:chgData name="Filippo Acconcia" userId="844af49c-a8a0-47ac-a7dd-14a44b60cd18" providerId="ADAL" clId="{998C6BF7-482B-421C-8ECC-9091B23559F6}" dt="2022-03-26T07:30:10.600" v="54"/>
          <ac:picMkLst>
            <pc:docMk/>
            <pc:sldMk cId="524157325" sldId="299"/>
            <ac:picMk id="46" creationId="{11F8A21D-BFFA-434F-A07E-D901B26EBC7D}"/>
          </ac:picMkLst>
        </pc:picChg>
        <pc:picChg chg="mod">
          <ac:chgData name="Filippo Acconcia" userId="844af49c-a8a0-47ac-a7dd-14a44b60cd18" providerId="ADAL" clId="{998C6BF7-482B-421C-8ECC-9091B23559F6}" dt="2022-03-26T07:30:10.600" v="54"/>
          <ac:picMkLst>
            <pc:docMk/>
            <pc:sldMk cId="524157325" sldId="299"/>
            <ac:picMk id="50" creationId="{2ED5568B-B6DD-4DB5-A102-950A3EB5C03B}"/>
          </ac:picMkLst>
        </pc:picChg>
        <pc:picChg chg="mod">
          <ac:chgData name="Filippo Acconcia" userId="844af49c-a8a0-47ac-a7dd-14a44b60cd18" providerId="ADAL" clId="{998C6BF7-482B-421C-8ECC-9091B23559F6}" dt="2022-03-26T07:30:10.600" v="54"/>
          <ac:picMkLst>
            <pc:docMk/>
            <pc:sldMk cId="524157325" sldId="299"/>
            <ac:picMk id="51" creationId="{18FBCB4A-2D81-462D-8F21-2B751EF06B0C}"/>
          </ac:picMkLst>
        </pc:picChg>
      </pc:sldChg>
      <pc:sldChg chg="addSp delSp modSp new mod">
        <pc:chgData name="Filippo Acconcia" userId="844af49c-a8a0-47ac-a7dd-14a44b60cd18" providerId="ADAL" clId="{998C6BF7-482B-421C-8ECC-9091B23559F6}" dt="2022-06-10T17:23:29.897" v="1199" actId="1037"/>
        <pc:sldMkLst>
          <pc:docMk/>
          <pc:sldMk cId="565039354" sldId="300"/>
        </pc:sldMkLst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4" creationId="{D4B17F64-05EC-41C8-A835-82BA65E338EA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5" creationId="{A2F0D6A8-373F-4329-A8B9-25DC85AED1B4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6" creationId="{D6621BD0-75C8-426D-B2B6-A04B4F6D83CB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7" creationId="{FF7E894A-E59E-441F-87C8-A482FF038306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8" creationId="{3830807B-C6DB-4151-A0CE-E81245C68F0C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9" creationId="{DE48DBFB-254E-4A78-B8CA-5029E2BAA069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10" creationId="{0A2E551C-418C-44EE-9F02-80CF58A2A16D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11" creationId="{E087C7B1-8665-40C2-AA53-8C6D4D1A704B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12" creationId="{89491D4D-A6FE-4392-92CF-1D64BB0CDB03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14" creationId="{C158FDAF-C8A9-4241-8A5F-AF2BA97AAC66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15" creationId="{9B28DED5-DE34-4C6C-8D2E-DB4DA2CA7BD8}"/>
          </ac:spMkLst>
        </pc:spChg>
        <pc:spChg chg="add mod">
          <ac:chgData name="Filippo Acconcia" userId="844af49c-a8a0-47ac-a7dd-14a44b60cd18" providerId="ADAL" clId="{998C6BF7-482B-421C-8ECC-9091B23559F6}" dt="2022-05-07T06:23:13.888" v="706" actId="1036"/>
          <ac:spMkLst>
            <pc:docMk/>
            <pc:sldMk cId="565039354" sldId="300"/>
            <ac:spMk id="16" creationId="{2C412CC6-2FE3-4BC5-8A8C-6704728B72B4}"/>
          </ac:spMkLst>
        </pc:spChg>
        <pc:spChg chg="add mod">
          <ac:chgData name="Filippo Acconcia" userId="844af49c-a8a0-47ac-a7dd-14a44b60cd18" providerId="ADAL" clId="{998C6BF7-482B-421C-8ECC-9091B23559F6}" dt="2022-05-07T06:23:13.888" v="706" actId="1036"/>
          <ac:spMkLst>
            <pc:docMk/>
            <pc:sldMk cId="565039354" sldId="300"/>
            <ac:spMk id="17" creationId="{CB462BA4-0EAA-4B2B-8756-32B78EB0FB49}"/>
          </ac:spMkLst>
        </pc:spChg>
        <pc:spChg chg="add mod">
          <ac:chgData name="Filippo Acconcia" userId="844af49c-a8a0-47ac-a7dd-14a44b60cd18" providerId="ADAL" clId="{998C6BF7-482B-421C-8ECC-9091B23559F6}" dt="2022-05-07T06:23:13.888" v="706" actId="1036"/>
          <ac:spMkLst>
            <pc:docMk/>
            <pc:sldMk cId="565039354" sldId="300"/>
            <ac:spMk id="18" creationId="{9D9F9DC0-025B-4422-B22F-4ED437B44102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21" creationId="{9B8FCA8D-1544-40D6-A4F2-F13C1CB17611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23" creationId="{480A0642-F990-4F75-B6AE-3C0AC457F349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24" creationId="{82E1BB24-B3B4-4BB8-A099-BCE674B8E5DC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25" creationId="{D58BE646-10A3-4774-BB69-EAC415BD7D53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26" creationId="{75CF1A0E-CB7A-4AE8-9334-A8FA10C10120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27" creationId="{3D5AD23D-892A-45CF-A706-09CB87EC493E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28" creationId="{7101BE7F-F4DE-42B1-BF86-BB79BD4A2583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29" creationId="{37AFAC89-8279-4F2C-9E80-625E1148F735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30" creationId="{BBB01764-AF33-4EB3-B0C0-B3AAF33E4533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33" creationId="{A0F7B88C-8D90-4E66-B21D-1E54C30C0BB4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35" creationId="{B7F972FD-4DF2-48D8-A3C8-36BB19B359BD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36" creationId="{58A04907-BD4E-42AE-BA61-54D03204B2FA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37" creationId="{EE7EBAC0-AE1B-4A3E-988B-288334EF9554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38" creationId="{6FC6974D-01EB-4414-A617-39358607658B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39" creationId="{F9B0B322-1FDF-498A-86AA-F961D72D6C26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40" creationId="{CDBF4EB6-EB86-4031-AE40-CA11E84270B0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41" creationId="{5F9FB924-335A-4FE6-8073-66AC05D2EEF9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42" creationId="{6D8D2C9F-6534-45EF-9096-69A9C5649270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45" creationId="{964D2ECD-92C7-4235-A21C-ACCBAB74FB3C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47" creationId="{A2EE8B45-9244-4B4E-A424-229C93BAAF74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48" creationId="{9E588C35-CA89-43D9-8411-A1033A0D78B0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49" creationId="{FF5595C0-EFBC-4D21-9CB9-1D92BD0AC840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50" creationId="{2F1FA737-F4DC-49B9-BB05-31C800A21CDC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51" creationId="{76BDBA03-2FB4-4E7B-98E2-F60985C825D5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52" creationId="{88984384-FC68-413A-803D-2EEFFAD7B376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53" creationId="{08B610D3-3BBD-4878-A7BD-2B4655EABCAC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54" creationId="{B76C650B-E3F6-48DC-B437-F08B8CD19F05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57" creationId="{6E2A3BDA-B4A4-4C95-AA31-F1D8271AB09E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59" creationId="{30E38861-EC35-4731-84F1-2355B5679DA1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60" creationId="{3CBB8E06-BBD7-48AD-9A1B-7BD7899D23DA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61" creationId="{74A2870E-92E7-43D4-81BD-F6F3F3AD0C06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62" creationId="{60C8665F-3B32-4F45-A1C2-56E5BAF71152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63" creationId="{D0211F36-FB82-44D0-88E7-52FC19C2E5B7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64" creationId="{B6DDD3A3-32E2-48E4-9E25-63F91CBAE59F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65" creationId="{DA53A709-0696-4CA1-92D3-074239B40452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66" creationId="{4A544DAA-9B97-4236-94E8-157594EEAAE2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75" creationId="{85F1C71A-1879-4A9E-B606-2C1CA41A6AE3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76" creationId="{FF48C64C-3D1E-4B51-BD3E-10EB6348C383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77" creationId="{A0969ADD-F02E-43BE-B060-64899A11BE37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82" creationId="{44BC3936-AF5A-478A-8162-5C809233BC07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83" creationId="{6F3910FE-5A10-4980-9DCB-49A885E42C6A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84" creationId="{58D04381-1500-440A-8FBC-B0D3EC0E0ACD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85" creationId="{28BF46E3-A806-4C41-BE58-DF75255C4B5F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86" creationId="{1B609547-1D04-45E2-892B-8F38EEB62B41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87" creationId="{3427B71C-2D66-44EE-9A37-8C8CFE198488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88" creationId="{B00C0859-A1B9-4E43-986F-E4515713F9AD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90" creationId="{B24875B1-CE78-425A-A8E7-3858F087A939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91" creationId="{E1E66D87-D2F8-4941-B4CF-E01F36D9C8F8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97" creationId="{29E2B53E-770D-4DF9-A3C9-23514E895DED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98" creationId="{2B932DD7-54D6-4778-8314-2AAECF51C05F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104" creationId="{91ECE71C-FF62-4C01-87D1-70AC4B7BA086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105" creationId="{9F801F84-ADC1-4D25-9754-5249DA39E9E5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111" creationId="{78149BC0-A3ED-4DAC-9876-9666116DFCB5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112" creationId="{3454AE03-4BC2-406A-87E0-667ECEFD9A0C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118" creationId="{54F9C130-0EE9-4469-9F87-EB97FCB62981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120" creationId="{27871BFB-8D66-4BBA-9981-AE284BF48062}"/>
          </ac:spMkLst>
        </pc:spChg>
        <pc:spChg chg="mod">
          <ac:chgData name="Filippo Acconcia" userId="844af49c-a8a0-47ac-a7dd-14a44b60cd18" providerId="ADAL" clId="{998C6BF7-482B-421C-8ECC-9091B23559F6}" dt="2022-03-26T07:37:13.347" v="64"/>
          <ac:spMkLst>
            <pc:docMk/>
            <pc:sldMk cId="565039354" sldId="300"/>
            <ac:spMk id="122" creationId="{E439406F-BD93-4D02-8552-B42716EEEADD}"/>
          </ac:spMkLst>
        </pc:spChg>
        <pc:spChg chg="mod">
          <ac:chgData name="Filippo Acconcia" userId="844af49c-a8a0-47ac-a7dd-14a44b60cd18" providerId="ADAL" clId="{998C6BF7-482B-421C-8ECC-9091B23559F6}" dt="2022-05-07T06:20:59.072" v="688" actId="20577"/>
          <ac:spMkLst>
            <pc:docMk/>
            <pc:sldMk cId="565039354" sldId="300"/>
            <ac:spMk id="123" creationId="{20F2705A-58C2-4916-AE8A-68383FF35F42}"/>
          </ac:spMkLst>
        </pc:spChg>
        <pc:spChg chg="add mod">
          <ac:chgData name="Filippo Acconcia" userId="844af49c-a8a0-47ac-a7dd-14a44b60cd18" providerId="ADAL" clId="{998C6BF7-482B-421C-8ECC-9091B23559F6}" dt="2022-05-07T06:23:23.802" v="712" actId="20577"/>
          <ac:spMkLst>
            <pc:docMk/>
            <pc:sldMk cId="565039354" sldId="300"/>
            <ac:spMk id="124" creationId="{1BD8F1E7-1014-61D5-E0B2-8CA13D34F920}"/>
          </ac:spMkLst>
        </pc:spChg>
        <pc:spChg chg="add del mod">
          <ac:chgData name="Filippo Acconcia" userId="844af49c-a8a0-47ac-a7dd-14a44b60cd18" providerId="ADAL" clId="{998C6BF7-482B-421C-8ECC-9091B23559F6}" dt="2022-05-07T13:34:25.389" v="873" actId="478"/>
          <ac:spMkLst>
            <pc:docMk/>
            <pc:sldMk cId="565039354" sldId="300"/>
            <ac:spMk id="125" creationId="{7AC463B6-680F-D139-64C6-E22C396BD6F0}"/>
          </ac:spMkLst>
        </pc:spChg>
        <pc:spChg chg="mod topLvl">
          <ac:chgData name="Filippo Acconcia" userId="844af49c-a8a0-47ac-a7dd-14a44b60cd18" providerId="ADAL" clId="{998C6BF7-482B-421C-8ECC-9091B23559F6}" dt="2022-05-07T13:34:34.719" v="882" actId="1035"/>
          <ac:spMkLst>
            <pc:docMk/>
            <pc:sldMk cId="565039354" sldId="300"/>
            <ac:spMk id="128" creationId="{839FD5C3-2FB3-051B-CE7E-2CC5C0FF8849}"/>
          </ac:spMkLst>
        </pc:spChg>
        <pc:spChg chg="mod topLvl">
          <ac:chgData name="Filippo Acconcia" userId="844af49c-a8a0-47ac-a7dd-14a44b60cd18" providerId="ADAL" clId="{998C6BF7-482B-421C-8ECC-9091B23559F6}" dt="2022-05-07T13:34:23.687" v="872" actId="164"/>
          <ac:spMkLst>
            <pc:docMk/>
            <pc:sldMk cId="565039354" sldId="300"/>
            <ac:spMk id="129" creationId="{BF97247F-5FA1-51BA-934F-AEA447C87751}"/>
          </ac:spMkLst>
        </pc:spChg>
        <pc:spChg chg="mod topLvl">
          <ac:chgData name="Filippo Acconcia" userId="844af49c-a8a0-47ac-a7dd-14a44b60cd18" providerId="ADAL" clId="{998C6BF7-482B-421C-8ECC-9091B23559F6}" dt="2022-05-07T13:34:23.687" v="872" actId="164"/>
          <ac:spMkLst>
            <pc:docMk/>
            <pc:sldMk cId="565039354" sldId="300"/>
            <ac:spMk id="130" creationId="{B90BAB2B-7F23-54C0-7EA2-6D710804324B}"/>
          </ac:spMkLst>
        </pc:spChg>
        <pc:spChg chg="mod topLvl">
          <ac:chgData name="Filippo Acconcia" userId="844af49c-a8a0-47ac-a7dd-14a44b60cd18" providerId="ADAL" clId="{998C6BF7-482B-421C-8ECC-9091B23559F6}" dt="2022-05-07T13:34:23.687" v="872" actId="164"/>
          <ac:spMkLst>
            <pc:docMk/>
            <pc:sldMk cId="565039354" sldId="300"/>
            <ac:spMk id="131" creationId="{4A9FC5ED-85E5-E0AE-FD0C-A5AA9A33431A}"/>
          </ac:spMkLst>
        </pc:spChg>
        <pc:spChg chg="mod topLvl">
          <ac:chgData name="Filippo Acconcia" userId="844af49c-a8a0-47ac-a7dd-14a44b60cd18" providerId="ADAL" clId="{998C6BF7-482B-421C-8ECC-9091B23559F6}" dt="2022-05-07T13:34:23.687" v="872" actId="164"/>
          <ac:spMkLst>
            <pc:docMk/>
            <pc:sldMk cId="565039354" sldId="300"/>
            <ac:spMk id="132" creationId="{36E9C9B1-59EA-6678-2DDB-737DA5DF5F2A}"/>
          </ac:spMkLst>
        </pc:spChg>
        <pc:spChg chg="mod topLvl">
          <ac:chgData name="Filippo Acconcia" userId="844af49c-a8a0-47ac-a7dd-14a44b60cd18" providerId="ADAL" clId="{998C6BF7-482B-421C-8ECC-9091B23559F6}" dt="2022-05-07T13:34:23.687" v="872" actId="164"/>
          <ac:spMkLst>
            <pc:docMk/>
            <pc:sldMk cId="565039354" sldId="300"/>
            <ac:spMk id="133" creationId="{24059A23-F087-5931-B52B-E7551C1827E5}"/>
          </ac:spMkLst>
        </pc:spChg>
        <pc:spChg chg="mod topLvl">
          <ac:chgData name="Filippo Acconcia" userId="844af49c-a8a0-47ac-a7dd-14a44b60cd18" providerId="ADAL" clId="{998C6BF7-482B-421C-8ECC-9091B23559F6}" dt="2022-05-07T13:34:23.687" v="872" actId="164"/>
          <ac:spMkLst>
            <pc:docMk/>
            <pc:sldMk cId="565039354" sldId="300"/>
            <ac:spMk id="134" creationId="{8FD63A47-7CE2-6F2A-BB53-550F85ADFBB8}"/>
          </ac:spMkLst>
        </pc:spChg>
        <pc:spChg chg="mod topLvl">
          <ac:chgData name="Filippo Acconcia" userId="844af49c-a8a0-47ac-a7dd-14a44b60cd18" providerId="ADAL" clId="{998C6BF7-482B-421C-8ECC-9091B23559F6}" dt="2022-05-07T13:34:23.687" v="872" actId="164"/>
          <ac:spMkLst>
            <pc:docMk/>
            <pc:sldMk cId="565039354" sldId="300"/>
            <ac:spMk id="135" creationId="{5DA52A71-1CC9-2A76-DFF8-EED78857AB78}"/>
          </ac:spMkLst>
        </pc:spChg>
        <pc:spChg chg="mod topLvl">
          <ac:chgData name="Filippo Acconcia" userId="844af49c-a8a0-47ac-a7dd-14a44b60cd18" providerId="ADAL" clId="{998C6BF7-482B-421C-8ECC-9091B23559F6}" dt="2022-05-07T13:34:23.687" v="872" actId="164"/>
          <ac:spMkLst>
            <pc:docMk/>
            <pc:sldMk cId="565039354" sldId="300"/>
            <ac:spMk id="136" creationId="{3223305F-39F7-662D-4E8A-9A9D525B840D}"/>
          </ac:spMkLst>
        </pc:spChg>
        <pc:spChg chg="mod topLvl">
          <ac:chgData name="Filippo Acconcia" userId="844af49c-a8a0-47ac-a7dd-14a44b60cd18" providerId="ADAL" clId="{998C6BF7-482B-421C-8ECC-9091B23559F6}" dt="2022-05-07T13:34:23.687" v="872" actId="164"/>
          <ac:spMkLst>
            <pc:docMk/>
            <pc:sldMk cId="565039354" sldId="300"/>
            <ac:spMk id="138" creationId="{75BB2D6D-6DF6-5962-E3E9-BF7BEE60D892}"/>
          </ac:spMkLst>
        </pc:spChg>
        <pc:spChg chg="mod topLvl">
          <ac:chgData name="Filippo Acconcia" userId="844af49c-a8a0-47ac-a7dd-14a44b60cd18" providerId="ADAL" clId="{998C6BF7-482B-421C-8ECC-9091B23559F6}" dt="2022-05-07T13:34:23.687" v="872" actId="164"/>
          <ac:spMkLst>
            <pc:docMk/>
            <pc:sldMk cId="565039354" sldId="300"/>
            <ac:spMk id="139" creationId="{942060BE-5EBE-2EC7-DF16-D6B8C5025815}"/>
          </ac:spMkLst>
        </pc:spChg>
        <pc:spChg chg="add mod">
          <ac:chgData name="Filippo Acconcia" userId="844af49c-a8a0-47ac-a7dd-14a44b60cd18" providerId="ADAL" clId="{998C6BF7-482B-421C-8ECC-9091B23559F6}" dt="2022-05-07T13:34:23.687" v="872" actId="164"/>
          <ac:spMkLst>
            <pc:docMk/>
            <pc:sldMk cId="565039354" sldId="300"/>
            <ac:spMk id="141" creationId="{F501B7B5-3700-86A1-6FE5-4C61A5617311}"/>
          </ac:spMkLst>
        </pc:spChg>
        <pc:spChg chg="add del mod">
          <ac:chgData name="Filippo Acconcia" userId="844af49c-a8a0-47ac-a7dd-14a44b60cd18" providerId="ADAL" clId="{998C6BF7-482B-421C-8ECC-9091B23559F6}" dt="2022-06-10T17:23:22.793" v="1188" actId="478"/>
          <ac:spMkLst>
            <pc:docMk/>
            <pc:sldMk cId="565039354" sldId="300"/>
            <ac:spMk id="142" creationId="{B544E596-C044-1706-13E6-56F231D7FB17}"/>
          </ac:spMkLst>
        </pc:spChg>
        <pc:spChg chg="add mod">
          <ac:chgData name="Filippo Acconcia" userId="844af49c-a8a0-47ac-a7dd-14a44b60cd18" providerId="ADAL" clId="{998C6BF7-482B-421C-8ECC-9091B23559F6}" dt="2022-06-10T17:23:29.897" v="1199" actId="1037"/>
          <ac:spMkLst>
            <pc:docMk/>
            <pc:sldMk cId="565039354" sldId="300"/>
            <ac:spMk id="143" creationId="{E264C86E-C034-57E9-2239-5A32F06A61B4}"/>
          </ac:spMkLst>
        </pc:spChg>
        <pc:grpChg chg="add mod">
          <ac:chgData name="Filippo Acconcia" userId="844af49c-a8a0-47ac-a7dd-14a44b60cd18" providerId="ADAL" clId="{998C6BF7-482B-421C-8ECC-9091B23559F6}" dt="2022-05-07T13:34:43.172" v="888" actId="1038"/>
          <ac:grpSpMkLst>
            <pc:docMk/>
            <pc:sldMk cId="565039354" sldId="300"/>
            <ac:grpSpMk id="2" creationId="{2D2571A8-9A72-4410-A823-981F84185F30}"/>
          </ac:grpSpMkLst>
        </pc:grpChg>
        <pc:grpChg chg="add mod">
          <ac:chgData name="Filippo Acconcia" userId="844af49c-a8a0-47ac-a7dd-14a44b60cd18" providerId="ADAL" clId="{998C6BF7-482B-421C-8ECC-9091B23559F6}" dt="2022-05-07T06:23:13.888" v="706" actId="1036"/>
          <ac:grpSpMkLst>
            <pc:docMk/>
            <pc:sldMk cId="565039354" sldId="300"/>
            <ac:grpSpMk id="19" creationId="{F19430C4-FBC8-4EAE-B3EE-65C524F726E5}"/>
          </ac:grpSpMkLst>
        </pc:grpChg>
        <pc:grpChg chg="mod">
          <ac:chgData name="Filippo Acconcia" userId="844af49c-a8a0-47ac-a7dd-14a44b60cd18" providerId="ADAL" clId="{998C6BF7-482B-421C-8ECC-9091B23559F6}" dt="2022-03-26T07:37:13.347" v="64"/>
          <ac:grpSpMkLst>
            <pc:docMk/>
            <pc:sldMk cId="565039354" sldId="300"/>
            <ac:grpSpMk id="20" creationId="{76E7C58C-9296-4214-9DAA-7BE79C625B8B}"/>
          </ac:grpSpMkLst>
        </pc:grpChg>
        <pc:grpChg chg="add mod">
          <ac:chgData name="Filippo Acconcia" userId="844af49c-a8a0-47ac-a7dd-14a44b60cd18" providerId="ADAL" clId="{998C6BF7-482B-421C-8ECC-9091B23559F6}" dt="2022-05-07T06:23:13.888" v="706" actId="1036"/>
          <ac:grpSpMkLst>
            <pc:docMk/>
            <pc:sldMk cId="565039354" sldId="300"/>
            <ac:grpSpMk id="31" creationId="{62A4D444-A841-45C0-9DF5-29E25A43DB44}"/>
          </ac:grpSpMkLst>
        </pc:grpChg>
        <pc:grpChg chg="mod">
          <ac:chgData name="Filippo Acconcia" userId="844af49c-a8a0-47ac-a7dd-14a44b60cd18" providerId="ADAL" clId="{998C6BF7-482B-421C-8ECC-9091B23559F6}" dt="2022-03-26T07:37:13.347" v="64"/>
          <ac:grpSpMkLst>
            <pc:docMk/>
            <pc:sldMk cId="565039354" sldId="300"/>
            <ac:grpSpMk id="32" creationId="{4CFFF11F-9924-4C29-ACB3-25CA3D693CAD}"/>
          </ac:grpSpMkLst>
        </pc:grpChg>
        <pc:grpChg chg="add mod">
          <ac:chgData name="Filippo Acconcia" userId="844af49c-a8a0-47ac-a7dd-14a44b60cd18" providerId="ADAL" clId="{998C6BF7-482B-421C-8ECC-9091B23559F6}" dt="2022-05-07T06:23:13.888" v="706" actId="1036"/>
          <ac:grpSpMkLst>
            <pc:docMk/>
            <pc:sldMk cId="565039354" sldId="300"/>
            <ac:grpSpMk id="43" creationId="{96953F45-2CE4-4B60-B67E-29E713A61D2E}"/>
          </ac:grpSpMkLst>
        </pc:grpChg>
        <pc:grpChg chg="mod">
          <ac:chgData name="Filippo Acconcia" userId="844af49c-a8a0-47ac-a7dd-14a44b60cd18" providerId="ADAL" clId="{998C6BF7-482B-421C-8ECC-9091B23559F6}" dt="2022-03-26T07:37:13.347" v="64"/>
          <ac:grpSpMkLst>
            <pc:docMk/>
            <pc:sldMk cId="565039354" sldId="300"/>
            <ac:grpSpMk id="44" creationId="{2799C63A-C347-4E57-A1B9-2B92F920472A}"/>
          </ac:grpSpMkLst>
        </pc:grpChg>
        <pc:grpChg chg="add mod">
          <ac:chgData name="Filippo Acconcia" userId="844af49c-a8a0-47ac-a7dd-14a44b60cd18" providerId="ADAL" clId="{998C6BF7-482B-421C-8ECC-9091B23559F6}" dt="2022-05-07T06:23:13.888" v="706" actId="1036"/>
          <ac:grpSpMkLst>
            <pc:docMk/>
            <pc:sldMk cId="565039354" sldId="300"/>
            <ac:grpSpMk id="55" creationId="{1575C35E-584A-40F1-B438-FD221F11FA49}"/>
          </ac:grpSpMkLst>
        </pc:grpChg>
        <pc:grpChg chg="mod">
          <ac:chgData name="Filippo Acconcia" userId="844af49c-a8a0-47ac-a7dd-14a44b60cd18" providerId="ADAL" clId="{998C6BF7-482B-421C-8ECC-9091B23559F6}" dt="2022-03-26T07:37:13.347" v="64"/>
          <ac:grpSpMkLst>
            <pc:docMk/>
            <pc:sldMk cId="565039354" sldId="300"/>
            <ac:grpSpMk id="56" creationId="{E6069AA2-970C-49FC-8F8F-2C0240B3D51C}"/>
          </ac:grpSpMkLst>
        </pc:grpChg>
        <pc:grpChg chg="add mod">
          <ac:chgData name="Filippo Acconcia" userId="844af49c-a8a0-47ac-a7dd-14a44b60cd18" providerId="ADAL" clId="{998C6BF7-482B-421C-8ECC-9091B23559F6}" dt="2022-05-07T06:23:13.888" v="706" actId="1036"/>
          <ac:grpSpMkLst>
            <pc:docMk/>
            <pc:sldMk cId="565039354" sldId="300"/>
            <ac:grpSpMk id="67" creationId="{51684A25-7CE4-468B-A6FC-13B124E27331}"/>
          </ac:grpSpMkLst>
        </pc:grpChg>
        <pc:grpChg chg="mod">
          <ac:chgData name="Filippo Acconcia" userId="844af49c-a8a0-47ac-a7dd-14a44b60cd18" providerId="ADAL" clId="{998C6BF7-482B-421C-8ECC-9091B23559F6}" dt="2022-03-26T07:37:13.347" v="64"/>
          <ac:grpSpMkLst>
            <pc:docMk/>
            <pc:sldMk cId="565039354" sldId="300"/>
            <ac:grpSpMk id="71" creationId="{4CBECAA3-CD59-4C08-B80D-99C4CB31570E}"/>
          </ac:grpSpMkLst>
        </pc:grpChg>
        <pc:grpChg chg="mod">
          <ac:chgData name="Filippo Acconcia" userId="844af49c-a8a0-47ac-a7dd-14a44b60cd18" providerId="ADAL" clId="{998C6BF7-482B-421C-8ECC-9091B23559F6}" dt="2022-03-26T07:37:13.347" v="64"/>
          <ac:grpSpMkLst>
            <pc:docMk/>
            <pc:sldMk cId="565039354" sldId="300"/>
            <ac:grpSpMk id="72" creationId="{5053D13E-4003-49A1-B29E-13A432FCE7A6}"/>
          </ac:grpSpMkLst>
        </pc:grpChg>
        <pc:grpChg chg="mod">
          <ac:chgData name="Filippo Acconcia" userId="844af49c-a8a0-47ac-a7dd-14a44b60cd18" providerId="ADAL" clId="{998C6BF7-482B-421C-8ECC-9091B23559F6}" dt="2022-03-26T07:37:13.347" v="64"/>
          <ac:grpSpMkLst>
            <pc:docMk/>
            <pc:sldMk cId="565039354" sldId="300"/>
            <ac:grpSpMk id="73" creationId="{97C9707A-A8D1-4B41-86AE-20A76BD489C6}"/>
          </ac:grpSpMkLst>
        </pc:grpChg>
        <pc:grpChg chg="mod">
          <ac:chgData name="Filippo Acconcia" userId="844af49c-a8a0-47ac-a7dd-14a44b60cd18" providerId="ADAL" clId="{998C6BF7-482B-421C-8ECC-9091B23559F6}" dt="2022-03-26T07:37:13.347" v="64"/>
          <ac:grpSpMkLst>
            <pc:docMk/>
            <pc:sldMk cId="565039354" sldId="300"/>
            <ac:grpSpMk id="78" creationId="{521438DC-8507-47E4-9F89-D5D6D7FF2308}"/>
          </ac:grpSpMkLst>
        </pc:grpChg>
        <pc:grpChg chg="mod">
          <ac:chgData name="Filippo Acconcia" userId="844af49c-a8a0-47ac-a7dd-14a44b60cd18" providerId="ADAL" clId="{998C6BF7-482B-421C-8ECC-9091B23559F6}" dt="2022-03-26T07:37:13.347" v="64"/>
          <ac:grpSpMkLst>
            <pc:docMk/>
            <pc:sldMk cId="565039354" sldId="300"/>
            <ac:grpSpMk id="79" creationId="{E9E7A2AE-4282-4D29-A96D-DD377E15C7B3}"/>
          </ac:grpSpMkLst>
        </pc:grpChg>
        <pc:grpChg chg="mod">
          <ac:chgData name="Filippo Acconcia" userId="844af49c-a8a0-47ac-a7dd-14a44b60cd18" providerId="ADAL" clId="{998C6BF7-482B-421C-8ECC-9091B23559F6}" dt="2022-03-26T07:37:13.347" v="64"/>
          <ac:grpSpMkLst>
            <pc:docMk/>
            <pc:sldMk cId="565039354" sldId="300"/>
            <ac:grpSpMk id="80" creationId="{FFF07A84-5B3E-4C69-BED6-B384E858DEC7}"/>
          </ac:grpSpMkLst>
        </pc:grpChg>
        <pc:grpChg chg="mod">
          <ac:chgData name="Filippo Acconcia" userId="844af49c-a8a0-47ac-a7dd-14a44b60cd18" providerId="ADAL" clId="{998C6BF7-482B-421C-8ECC-9091B23559F6}" dt="2022-03-26T07:37:13.347" v="64"/>
          <ac:grpSpMkLst>
            <pc:docMk/>
            <pc:sldMk cId="565039354" sldId="300"/>
            <ac:grpSpMk id="81" creationId="{9257644D-10FD-4FD2-8F72-FA9ACD54B440}"/>
          </ac:grpSpMkLst>
        </pc:grpChg>
        <pc:grpChg chg="mod">
          <ac:chgData name="Filippo Acconcia" userId="844af49c-a8a0-47ac-a7dd-14a44b60cd18" providerId="ADAL" clId="{998C6BF7-482B-421C-8ECC-9091B23559F6}" dt="2022-03-26T07:37:13.347" v="64"/>
          <ac:grpSpMkLst>
            <pc:docMk/>
            <pc:sldMk cId="565039354" sldId="300"/>
            <ac:grpSpMk id="89" creationId="{8ADBCAA5-231F-4A32-8DFF-A36003AAC227}"/>
          </ac:grpSpMkLst>
        </pc:grpChg>
        <pc:grpChg chg="mod">
          <ac:chgData name="Filippo Acconcia" userId="844af49c-a8a0-47ac-a7dd-14a44b60cd18" providerId="ADAL" clId="{998C6BF7-482B-421C-8ECC-9091B23559F6}" dt="2022-03-26T07:37:13.347" v="64"/>
          <ac:grpSpMkLst>
            <pc:docMk/>
            <pc:sldMk cId="565039354" sldId="300"/>
            <ac:grpSpMk id="92" creationId="{67D6826E-7529-489A-89CC-EC8D28EED3A7}"/>
          </ac:grpSpMkLst>
        </pc:grpChg>
        <pc:grpChg chg="mod">
          <ac:chgData name="Filippo Acconcia" userId="844af49c-a8a0-47ac-a7dd-14a44b60cd18" providerId="ADAL" clId="{998C6BF7-482B-421C-8ECC-9091B23559F6}" dt="2022-03-26T07:37:13.347" v="64"/>
          <ac:grpSpMkLst>
            <pc:docMk/>
            <pc:sldMk cId="565039354" sldId="300"/>
            <ac:grpSpMk id="96" creationId="{FDD331BD-5613-4987-BE66-E16D8B972271}"/>
          </ac:grpSpMkLst>
        </pc:grpChg>
        <pc:grpChg chg="mod">
          <ac:chgData name="Filippo Acconcia" userId="844af49c-a8a0-47ac-a7dd-14a44b60cd18" providerId="ADAL" clId="{998C6BF7-482B-421C-8ECC-9091B23559F6}" dt="2022-03-26T07:37:13.347" v="64"/>
          <ac:grpSpMkLst>
            <pc:docMk/>
            <pc:sldMk cId="565039354" sldId="300"/>
            <ac:grpSpMk id="99" creationId="{EA0F4D5D-0E06-4476-A779-32F609AF92EF}"/>
          </ac:grpSpMkLst>
        </pc:grpChg>
        <pc:grpChg chg="mod">
          <ac:chgData name="Filippo Acconcia" userId="844af49c-a8a0-47ac-a7dd-14a44b60cd18" providerId="ADAL" clId="{998C6BF7-482B-421C-8ECC-9091B23559F6}" dt="2022-03-26T07:37:13.347" v="64"/>
          <ac:grpSpMkLst>
            <pc:docMk/>
            <pc:sldMk cId="565039354" sldId="300"/>
            <ac:grpSpMk id="103" creationId="{E9AF0441-1310-498D-B50E-3D1F00B19C50}"/>
          </ac:grpSpMkLst>
        </pc:grpChg>
        <pc:grpChg chg="mod">
          <ac:chgData name="Filippo Acconcia" userId="844af49c-a8a0-47ac-a7dd-14a44b60cd18" providerId="ADAL" clId="{998C6BF7-482B-421C-8ECC-9091B23559F6}" dt="2022-03-26T07:37:13.347" v="64"/>
          <ac:grpSpMkLst>
            <pc:docMk/>
            <pc:sldMk cId="565039354" sldId="300"/>
            <ac:grpSpMk id="106" creationId="{3CBB101D-7A3A-436D-B6E2-A05C0023077E}"/>
          </ac:grpSpMkLst>
        </pc:grpChg>
        <pc:grpChg chg="mod">
          <ac:chgData name="Filippo Acconcia" userId="844af49c-a8a0-47ac-a7dd-14a44b60cd18" providerId="ADAL" clId="{998C6BF7-482B-421C-8ECC-9091B23559F6}" dt="2022-03-26T07:37:13.347" v="64"/>
          <ac:grpSpMkLst>
            <pc:docMk/>
            <pc:sldMk cId="565039354" sldId="300"/>
            <ac:grpSpMk id="110" creationId="{6B7024D0-D32D-48AE-817C-E71E4B6D768F}"/>
          </ac:grpSpMkLst>
        </pc:grpChg>
        <pc:grpChg chg="mod">
          <ac:chgData name="Filippo Acconcia" userId="844af49c-a8a0-47ac-a7dd-14a44b60cd18" providerId="ADAL" clId="{998C6BF7-482B-421C-8ECC-9091B23559F6}" dt="2022-03-26T07:37:13.347" v="64"/>
          <ac:grpSpMkLst>
            <pc:docMk/>
            <pc:sldMk cId="565039354" sldId="300"/>
            <ac:grpSpMk id="113" creationId="{F5E75AEC-FE87-4A94-9D15-D56EEB243E96}"/>
          </ac:grpSpMkLst>
        </pc:grpChg>
        <pc:grpChg chg="add del mod">
          <ac:chgData name="Filippo Acconcia" userId="844af49c-a8a0-47ac-a7dd-14a44b60cd18" providerId="ADAL" clId="{998C6BF7-482B-421C-8ECC-9091B23559F6}" dt="2022-05-07T13:31:32.925" v="729" actId="165"/>
          <ac:grpSpMkLst>
            <pc:docMk/>
            <pc:sldMk cId="565039354" sldId="300"/>
            <ac:grpSpMk id="126" creationId="{5B143048-B88F-1E15-4834-13C165FBEA8D}"/>
          </ac:grpSpMkLst>
        </pc:grpChg>
        <pc:grpChg chg="add mod">
          <ac:chgData name="Filippo Acconcia" userId="844af49c-a8a0-47ac-a7dd-14a44b60cd18" providerId="ADAL" clId="{998C6BF7-482B-421C-8ECC-9091B23559F6}" dt="2022-05-07T13:34:43.172" v="888" actId="1038"/>
          <ac:grpSpMkLst>
            <pc:docMk/>
            <pc:sldMk cId="565039354" sldId="300"/>
            <ac:grpSpMk id="144" creationId="{84D2B6B1-D731-6CA7-C609-8F6ACD77D91C}"/>
          </ac:grpSpMkLst>
        </pc:grpChg>
        <pc:picChg chg="mod">
          <ac:chgData name="Filippo Acconcia" userId="844af49c-a8a0-47ac-a7dd-14a44b60cd18" providerId="ADAL" clId="{998C6BF7-482B-421C-8ECC-9091B23559F6}" dt="2022-03-26T07:37:13.347" v="64"/>
          <ac:picMkLst>
            <pc:docMk/>
            <pc:sldMk cId="565039354" sldId="300"/>
            <ac:picMk id="3" creationId="{296D37A3-6C7B-48E1-B58B-963824D5E9B3}"/>
          </ac:picMkLst>
        </pc:picChg>
        <pc:picChg chg="mod">
          <ac:chgData name="Filippo Acconcia" userId="844af49c-a8a0-47ac-a7dd-14a44b60cd18" providerId="ADAL" clId="{998C6BF7-482B-421C-8ECC-9091B23559F6}" dt="2022-03-26T07:37:13.347" v="64"/>
          <ac:picMkLst>
            <pc:docMk/>
            <pc:sldMk cId="565039354" sldId="300"/>
            <ac:picMk id="22" creationId="{31DD98A5-97CF-4FE7-AF7A-4F3001A20897}"/>
          </ac:picMkLst>
        </pc:picChg>
        <pc:picChg chg="mod">
          <ac:chgData name="Filippo Acconcia" userId="844af49c-a8a0-47ac-a7dd-14a44b60cd18" providerId="ADAL" clId="{998C6BF7-482B-421C-8ECC-9091B23559F6}" dt="2022-03-26T07:37:13.347" v="64"/>
          <ac:picMkLst>
            <pc:docMk/>
            <pc:sldMk cId="565039354" sldId="300"/>
            <ac:picMk id="34" creationId="{AD5F9ED2-AF86-417D-9370-2F187EFFE80F}"/>
          </ac:picMkLst>
        </pc:picChg>
        <pc:picChg chg="mod">
          <ac:chgData name="Filippo Acconcia" userId="844af49c-a8a0-47ac-a7dd-14a44b60cd18" providerId="ADAL" clId="{998C6BF7-482B-421C-8ECC-9091B23559F6}" dt="2022-03-26T07:37:13.347" v="64"/>
          <ac:picMkLst>
            <pc:docMk/>
            <pc:sldMk cId="565039354" sldId="300"/>
            <ac:picMk id="46" creationId="{A0B57B78-0C29-4E9F-A723-6AD08B3183F3}"/>
          </ac:picMkLst>
        </pc:picChg>
        <pc:picChg chg="mod">
          <ac:chgData name="Filippo Acconcia" userId="844af49c-a8a0-47ac-a7dd-14a44b60cd18" providerId="ADAL" clId="{998C6BF7-482B-421C-8ECC-9091B23559F6}" dt="2022-03-26T07:37:13.347" v="64"/>
          <ac:picMkLst>
            <pc:docMk/>
            <pc:sldMk cId="565039354" sldId="300"/>
            <ac:picMk id="58" creationId="{5BFB6100-FEB1-4BC2-92A4-DF8F70EB9883}"/>
          </ac:picMkLst>
        </pc:picChg>
        <pc:picChg chg="mod">
          <ac:chgData name="Filippo Acconcia" userId="844af49c-a8a0-47ac-a7dd-14a44b60cd18" providerId="ADAL" clId="{998C6BF7-482B-421C-8ECC-9091B23559F6}" dt="2022-03-26T07:37:13.347" v="64"/>
          <ac:picMkLst>
            <pc:docMk/>
            <pc:sldMk cId="565039354" sldId="300"/>
            <ac:picMk id="68" creationId="{32452A8A-01E8-47A8-B6C7-A8DB7CB5DFCC}"/>
          </ac:picMkLst>
        </pc:picChg>
        <pc:picChg chg="mod">
          <ac:chgData name="Filippo Acconcia" userId="844af49c-a8a0-47ac-a7dd-14a44b60cd18" providerId="ADAL" clId="{998C6BF7-482B-421C-8ECC-9091B23559F6}" dt="2022-03-26T07:37:13.347" v="64"/>
          <ac:picMkLst>
            <pc:docMk/>
            <pc:sldMk cId="565039354" sldId="300"/>
            <ac:picMk id="69" creationId="{37FB062A-27F5-4EA8-BB07-2807FB78B23F}"/>
          </ac:picMkLst>
        </pc:picChg>
        <pc:picChg chg="mod">
          <ac:chgData name="Filippo Acconcia" userId="844af49c-a8a0-47ac-a7dd-14a44b60cd18" providerId="ADAL" clId="{998C6BF7-482B-421C-8ECC-9091B23559F6}" dt="2022-03-26T07:37:13.347" v="64"/>
          <ac:picMkLst>
            <pc:docMk/>
            <pc:sldMk cId="565039354" sldId="300"/>
            <ac:picMk id="70" creationId="{DDCBD06D-CD52-468B-A4FF-2C2C1F42CA73}"/>
          </ac:picMkLst>
        </pc:picChg>
        <pc:picChg chg="mod">
          <ac:chgData name="Filippo Acconcia" userId="844af49c-a8a0-47ac-a7dd-14a44b60cd18" providerId="ADAL" clId="{998C6BF7-482B-421C-8ECC-9091B23559F6}" dt="2022-03-26T07:37:13.347" v="64"/>
          <ac:picMkLst>
            <pc:docMk/>
            <pc:sldMk cId="565039354" sldId="300"/>
            <ac:picMk id="74" creationId="{CFF5F31E-7ABB-46F5-8BE0-B4D5D0CF028D}"/>
          </ac:picMkLst>
        </pc:picChg>
        <pc:picChg chg="mod">
          <ac:chgData name="Filippo Acconcia" userId="844af49c-a8a0-47ac-a7dd-14a44b60cd18" providerId="ADAL" clId="{998C6BF7-482B-421C-8ECC-9091B23559F6}" dt="2022-03-26T07:37:13.347" v="64"/>
          <ac:picMkLst>
            <pc:docMk/>
            <pc:sldMk cId="565039354" sldId="300"/>
            <ac:picMk id="117" creationId="{BC2A0841-E8DC-45C3-970E-F936A911EE24}"/>
          </ac:picMkLst>
        </pc:picChg>
        <pc:picChg chg="mod">
          <ac:chgData name="Filippo Acconcia" userId="844af49c-a8a0-47ac-a7dd-14a44b60cd18" providerId="ADAL" clId="{998C6BF7-482B-421C-8ECC-9091B23559F6}" dt="2022-03-26T07:37:13.347" v="64"/>
          <ac:picMkLst>
            <pc:docMk/>
            <pc:sldMk cId="565039354" sldId="300"/>
            <ac:picMk id="119" creationId="{DCE165A3-3ABD-4821-A11F-B23A27511579}"/>
          </ac:picMkLst>
        </pc:picChg>
        <pc:picChg chg="mod">
          <ac:chgData name="Filippo Acconcia" userId="844af49c-a8a0-47ac-a7dd-14a44b60cd18" providerId="ADAL" clId="{998C6BF7-482B-421C-8ECC-9091B23559F6}" dt="2022-03-26T07:37:13.347" v="64"/>
          <ac:picMkLst>
            <pc:docMk/>
            <pc:sldMk cId="565039354" sldId="300"/>
            <ac:picMk id="121" creationId="{DE639F3C-F477-475E-92CF-9E576390A9BB}"/>
          </ac:picMkLst>
        </pc:picChg>
        <pc:picChg chg="del mod topLvl">
          <ac:chgData name="Filippo Acconcia" userId="844af49c-a8a0-47ac-a7dd-14a44b60cd18" providerId="ADAL" clId="{998C6BF7-482B-421C-8ECC-9091B23559F6}" dt="2022-05-07T13:32:03.438" v="735" actId="478"/>
          <ac:picMkLst>
            <pc:docMk/>
            <pc:sldMk cId="565039354" sldId="300"/>
            <ac:picMk id="127" creationId="{DA0E584D-5350-56E2-F657-FA857D7438FC}"/>
          </ac:picMkLst>
        </pc:picChg>
        <pc:picChg chg="mod ord">
          <ac:chgData name="Filippo Acconcia" userId="844af49c-a8a0-47ac-a7dd-14a44b60cd18" providerId="ADAL" clId="{998C6BF7-482B-421C-8ECC-9091B23559F6}" dt="2022-05-07T13:34:23.687" v="872" actId="164"/>
          <ac:picMkLst>
            <pc:docMk/>
            <pc:sldMk cId="565039354" sldId="300"/>
            <ac:picMk id="140" creationId="{991E5D44-39D3-C499-4CC8-E6911E4F0BA1}"/>
          </ac:picMkLst>
        </pc:picChg>
        <pc:cxnChg chg="mod">
          <ac:chgData name="Filippo Acconcia" userId="844af49c-a8a0-47ac-a7dd-14a44b60cd18" providerId="ADAL" clId="{998C6BF7-482B-421C-8ECC-9091B23559F6}" dt="2022-03-26T07:37:13.347" v="64"/>
          <ac:cxnSpMkLst>
            <pc:docMk/>
            <pc:sldMk cId="565039354" sldId="300"/>
            <ac:cxnSpMk id="13" creationId="{990AD752-65B6-4FE6-8D5D-D588F7048BF8}"/>
          </ac:cxnSpMkLst>
        </pc:cxnChg>
        <pc:cxnChg chg="mod">
          <ac:chgData name="Filippo Acconcia" userId="844af49c-a8a0-47ac-a7dd-14a44b60cd18" providerId="ADAL" clId="{998C6BF7-482B-421C-8ECC-9091B23559F6}" dt="2022-03-26T07:37:13.347" v="64"/>
          <ac:cxnSpMkLst>
            <pc:docMk/>
            <pc:sldMk cId="565039354" sldId="300"/>
            <ac:cxnSpMk id="93" creationId="{A6F5AE65-E8CA-4736-9BA1-C11922C5FB64}"/>
          </ac:cxnSpMkLst>
        </pc:cxnChg>
        <pc:cxnChg chg="mod">
          <ac:chgData name="Filippo Acconcia" userId="844af49c-a8a0-47ac-a7dd-14a44b60cd18" providerId="ADAL" clId="{998C6BF7-482B-421C-8ECC-9091B23559F6}" dt="2022-03-26T07:37:13.347" v="64"/>
          <ac:cxnSpMkLst>
            <pc:docMk/>
            <pc:sldMk cId="565039354" sldId="300"/>
            <ac:cxnSpMk id="94" creationId="{F7B0B581-242B-47A0-AE7C-DABE7290399F}"/>
          </ac:cxnSpMkLst>
        </pc:cxnChg>
        <pc:cxnChg chg="mod">
          <ac:chgData name="Filippo Acconcia" userId="844af49c-a8a0-47ac-a7dd-14a44b60cd18" providerId="ADAL" clId="{998C6BF7-482B-421C-8ECC-9091B23559F6}" dt="2022-03-26T07:37:13.347" v="64"/>
          <ac:cxnSpMkLst>
            <pc:docMk/>
            <pc:sldMk cId="565039354" sldId="300"/>
            <ac:cxnSpMk id="95" creationId="{D5BD76FC-9A4A-497A-AEAE-DE35D11A2849}"/>
          </ac:cxnSpMkLst>
        </pc:cxnChg>
        <pc:cxnChg chg="mod">
          <ac:chgData name="Filippo Acconcia" userId="844af49c-a8a0-47ac-a7dd-14a44b60cd18" providerId="ADAL" clId="{998C6BF7-482B-421C-8ECC-9091B23559F6}" dt="2022-03-26T07:37:13.347" v="64"/>
          <ac:cxnSpMkLst>
            <pc:docMk/>
            <pc:sldMk cId="565039354" sldId="300"/>
            <ac:cxnSpMk id="100" creationId="{FC44CB71-4C4F-4DC4-8CBF-ACB2CFB408C4}"/>
          </ac:cxnSpMkLst>
        </pc:cxnChg>
        <pc:cxnChg chg="mod">
          <ac:chgData name="Filippo Acconcia" userId="844af49c-a8a0-47ac-a7dd-14a44b60cd18" providerId="ADAL" clId="{998C6BF7-482B-421C-8ECC-9091B23559F6}" dt="2022-03-26T07:37:13.347" v="64"/>
          <ac:cxnSpMkLst>
            <pc:docMk/>
            <pc:sldMk cId="565039354" sldId="300"/>
            <ac:cxnSpMk id="101" creationId="{B3746972-03B9-459B-84E3-02D62E477EE8}"/>
          </ac:cxnSpMkLst>
        </pc:cxnChg>
        <pc:cxnChg chg="mod">
          <ac:chgData name="Filippo Acconcia" userId="844af49c-a8a0-47ac-a7dd-14a44b60cd18" providerId="ADAL" clId="{998C6BF7-482B-421C-8ECC-9091B23559F6}" dt="2022-03-26T07:37:13.347" v="64"/>
          <ac:cxnSpMkLst>
            <pc:docMk/>
            <pc:sldMk cId="565039354" sldId="300"/>
            <ac:cxnSpMk id="102" creationId="{3D114599-51BD-40FD-B9FA-052011FAF5CD}"/>
          </ac:cxnSpMkLst>
        </pc:cxnChg>
        <pc:cxnChg chg="mod">
          <ac:chgData name="Filippo Acconcia" userId="844af49c-a8a0-47ac-a7dd-14a44b60cd18" providerId="ADAL" clId="{998C6BF7-482B-421C-8ECC-9091B23559F6}" dt="2022-03-26T07:37:13.347" v="64"/>
          <ac:cxnSpMkLst>
            <pc:docMk/>
            <pc:sldMk cId="565039354" sldId="300"/>
            <ac:cxnSpMk id="107" creationId="{ADDE9204-E638-44D9-A0FC-58B4FF465BB2}"/>
          </ac:cxnSpMkLst>
        </pc:cxnChg>
        <pc:cxnChg chg="mod">
          <ac:chgData name="Filippo Acconcia" userId="844af49c-a8a0-47ac-a7dd-14a44b60cd18" providerId="ADAL" clId="{998C6BF7-482B-421C-8ECC-9091B23559F6}" dt="2022-03-26T07:37:13.347" v="64"/>
          <ac:cxnSpMkLst>
            <pc:docMk/>
            <pc:sldMk cId="565039354" sldId="300"/>
            <ac:cxnSpMk id="108" creationId="{5A9257B7-110B-40A1-B2A1-D33854443ED2}"/>
          </ac:cxnSpMkLst>
        </pc:cxnChg>
        <pc:cxnChg chg="mod">
          <ac:chgData name="Filippo Acconcia" userId="844af49c-a8a0-47ac-a7dd-14a44b60cd18" providerId="ADAL" clId="{998C6BF7-482B-421C-8ECC-9091B23559F6}" dt="2022-03-26T07:37:13.347" v="64"/>
          <ac:cxnSpMkLst>
            <pc:docMk/>
            <pc:sldMk cId="565039354" sldId="300"/>
            <ac:cxnSpMk id="109" creationId="{E3887EFD-0486-4220-A463-4F1B0E59161D}"/>
          </ac:cxnSpMkLst>
        </pc:cxnChg>
        <pc:cxnChg chg="mod">
          <ac:chgData name="Filippo Acconcia" userId="844af49c-a8a0-47ac-a7dd-14a44b60cd18" providerId="ADAL" clId="{998C6BF7-482B-421C-8ECC-9091B23559F6}" dt="2022-03-26T07:37:13.347" v="64"/>
          <ac:cxnSpMkLst>
            <pc:docMk/>
            <pc:sldMk cId="565039354" sldId="300"/>
            <ac:cxnSpMk id="114" creationId="{9859C4C0-172B-4E84-BFF9-69847D4E004C}"/>
          </ac:cxnSpMkLst>
        </pc:cxnChg>
        <pc:cxnChg chg="mod">
          <ac:chgData name="Filippo Acconcia" userId="844af49c-a8a0-47ac-a7dd-14a44b60cd18" providerId="ADAL" clId="{998C6BF7-482B-421C-8ECC-9091B23559F6}" dt="2022-03-26T07:37:13.347" v="64"/>
          <ac:cxnSpMkLst>
            <pc:docMk/>
            <pc:sldMk cId="565039354" sldId="300"/>
            <ac:cxnSpMk id="115" creationId="{D3FA6D89-B695-426B-B8DF-1F4AEF0B0F29}"/>
          </ac:cxnSpMkLst>
        </pc:cxnChg>
        <pc:cxnChg chg="mod">
          <ac:chgData name="Filippo Acconcia" userId="844af49c-a8a0-47ac-a7dd-14a44b60cd18" providerId="ADAL" clId="{998C6BF7-482B-421C-8ECC-9091B23559F6}" dt="2022-03-26T07:37:13.347" v="64"/>
          <ac:cxnSpMkLst>
            <pc:docMk/>
            <pc:sldMk cId="565039354" sldId="300"/>
            <ac:cxnSpMk id="116" creationId="{C54609EE-C91A-41EE-9559-1B27DDD3AC3A}"/>
          </ac:cxnSpMkLst>
        </pc:cxnChg>
        <pc:cxnChg chg="mod topLvl">
          <ac:chgData name="Filippo Acconcia" userId="844af49c-a8a0-47ac-a7dd-14a44b60cd18" providerId="ADAL" clId="{998C6BF7-482B-421C-8ECC-9091B23559F6}" dt="2022-05-07T13:34:23.687" v="872" actId="164"/>
          <ac:cxnSpMkLst>
            <pc:docMk/>
            <pc:sldMk cId="565039354" sldId="300"/>
            <ac:cxnSpMk id="137" creationId="{1AE36AD9-3159-1792-955C-327220C0CBC3}"/>
          </ac:cxnSpMkLst>
        </pc:cxnChg>
      </pc:sldChg>
      <pc:sldChg chg="addSp delSp modSp mod ord">
        <pc:chgData name="Filippo Acconcia" userId="844af49c-a8a0-47ac-a7dd-14a44b60cd18" providerId="ADAL" clId="{998C6BF7-482B-421C-8ECC-9091B23559F6}" dt="2022-06-10T17:03:01.055" v="1122" actId="1038"/>
        <pc:sldMkLst>
          <pc:docMk/>
          <pc:sldMk cId="706034829" sldId="301"/>
        </pc:sldMkLst>
        <pc:spChg chg="mod">
          <ac:chgData name="Filippo Acconcia" userId="844af49c-a8a0-47ac-a7dd-14a44b60cd18" providerId="ADAL" clId="{998C6BF7-482B-421C-8ECC-9091B23559F6}" dt="2022-05-07T06:10:09.070" v="686" actId="20577"/>
          <ac:spMkLst>
            <pc:docMk/>
            <pc:sldMk cId="706034829" sldId="301"/>
            <ac:spMk id="2" creationId="{5D2DCA17-BCD4-4265-8C5B-67AE7563323A}"/>
          </ac:spMkLst>
        </pc:spChg>
        <pc:spChg chg="mod topLvl">
          <ac:chgData name="Filippo Acconcia" userId="844af49c-a8a0-47ac-a7dd-14a44b60cd18" providerId="ADAL" clId="{998C6BF7-482B-421C-8ECC-9091B23559F6}" dt="2022-04-11T15:28:54.251" v="667" actId="164"/>
          <ac:spMkLst>
            <pc:docMk/>
            <pc:sldMk cId="706034829" sldId="301"/>
            <ac:spMk id="144" creationId="{DCE473C1-36C8-477E-9D83-55EB39080C40}"/>
          </ac:spMkLst>
        </pc:spChg>
        <pc:spChg chg="mod topLvl">
          <ac:chgData name="Filippo Acconcia" userId="844af49c-a8a0-47ac-a7dd-14a44b60cd18" providerId="ADAL" clId="{998C6BF7-482B-421C-8ECC-9091B23559F6}" dt="2022-04-11T15:28:54.251" v="667" actId="164"/>
          <ac:spMkLst>
            <pc:docMk/>
            <pc:sldMk cId="706034829" sldId="301"/>
            <ac:spMk id="148" creationId="{4A94EE74-2440-4979-8E35-7D78231E33D4}"/>
          </ac:spMkLst>
        </pc:spChg>
        <pc:spChg chg="mod topLvl">
          <ac:chgData name="Filippo Acconcia" userId="844af49c-a8a0-47ac-a7dd-14a44b60cd18" providerId="ADAL" clId="{998C6BF7-482B-421C-8ECC-9091B23559F6}" dt="2022-04-11T15:28:54.251" v="667" actId="164"/>
          <ac:spMkLst>
            <pc:docMk/>
            <pc:sldMk cId="706034829" sldId="301"/>
            <ac:spMk id="149" creationId="{6B2D878E-C19E-473C-B6E0-11194BDC80ED}"/>
          </ac:spMkLst>
        </pc:spChg>
        <pc:spChg chg="mod topLvl">
          <ac:chgData name="Filippo Acconcia" userId="844af49c-a8a0-47ac-a7dd-14a44b60cd18" providerId="ADAL" clId="{998C6BF7-482B-421C-8ECC-9091B23559F6}" dt="2022-04-11T15:28:54.251" v="667" actId="164"/>
          <ac:spMkLst>
            <pc:docMk/>
            <pc:sldMk cId="706034829" sldId="301"/>
            <ac:spMk id="150" creationId="{3C57893B-3EB8-4287-9DB3-4205FAB6CA2C}"/>
          </ac:spMkLst>
        </pc:spChg>
        <pc:spChg chg="mod topLvl">
          <ac:chgData name="Filippo Acconcia" userId="844af49c-a8a0-47ac-a7dd-14a44b60cd18" providerId="ADAL" clId="{998C6BF7-482B-421C-8ECC-9091B23559F6}" dt="2022-04-11T15:28:54.251" v="667" actId="164"/>
          <ac:spMkLst>
            <pc:docMk/>
            <pc:sldMk cId="706034829" sldId="301"/>
            <ac:spMk id="157" creationId="{2CE5EA72-67BA-4A33-A540-AA4180FDCBBA}"/>
          </ac:spMkLst>
        </pc:spChg>
        <pc:spChg chg="mod topLvl">
          <ac:chgData name="Filippo Acconcia" userId="844af49c-a8a0-47ac-a7dd-14a44b60cd18" providerId="ADAL" clId="{998C6BF7-482B-421C-8ECC-9091B23559F6}" dt="2022-04-11T15:28:54.251" v="667" actId="164"/>
          <ac:spMkLst>
            <pc:docMk/>
            <pc:sldMk cId="706034829" sldId="301"/>
            <ac:spMk id="158" creationId="{47106044-6353-4CAC-BB72-451389BFC3CA}"/>
          </ac:spMkLst>
        </pc:spChg>
        <pc:spChg chg="add mod">
          <ac:chgData name="Filippo Acconcia" userId="844af49c-a8a0-47ac-a7dd-14a44b60cd18" providerId="ADAL" clId="{998C6BF7-482B-421C-8ECC-9091B23559F6}" dt="2022-05-11T10:14:38.054" v="965" actId="1035"/>
          <ac:spMkLst>
            <pc:docMk/>
            <pc:sldMk cId="706034829" sldId="301"/>
            <ac:spMk id="168" creationId="{DF684F17-3D51-03B2-4770-26F90483B01F}"/>
          </ac:spMkLst>
        </pc:spChg>
        <pc:spChg chg="mod">
          <ac:chgData name="Filippo Acconcia" userId="844af49c-a8a0-47ac-a7dd-14a44b60cd18" providerId="ADAL" clId="{998C6BF7-482B-421C-8ECC-9091B23559F6}" dt="2022-05-11T09:50:53.869" v="905" actId="1037"/>
          <ac:spMkLst>
            <pc:docMk/>
            <pc:sldMk cId="706034829" sldId="301"/>
            <ac:spMk id="169" creationId="{50FCF0BC-06A0-44FA-AD13-4E285A672083}"/>
          </ac:spMkLst>
        </pc:spChg>
        <pc:spChg chg="del mod topLvl">
          <ac:chgData name="Filippo Acconcia" userId="844af49c-a8a0-47ac-a7dd-14a44b60cd18" providerId="ADAL" clId="{998C6BF7-482B-421C-8ECC-9091B23559F6}" dt="2022-04-11T15:26:06.474" v="594" actId="478"/>
          <ac:spMkLst>
            <pc:docMk/>
            <pc:sldMk cId="706034829" sldId="301"/>
            <ac:spMk id="170" creationId="{DD55A1C2-64D7-437C-8740-45B33F027D71}"/>
          </ac:spMkLst>
        </pc:spChg>
        <pc:spChg chg="add mod">
          <ac:chgData name="Filippo Acconcia" userId="844af49c-a8a0-47ac-a7dd-14a44b60cd18" providerId="ADAL" clId="{998C6BF7-482B-421C-8ECC-9091B23559F6}" dt="2022-05-11T10:14:38.054" v="965" actId="1035"/>
          <ac:spMkLst>
            <pc:docMk/>
            <pc:sldMk cId="706034829" sldId="301"/>
            <ac:spMk id="170" creationId="{FB4A362A-865F-FC36-EE21-BC375CA921A2}"/>
          </ac:spMkLst>
        </pc:spChg>
        <pc:spChg chg="del mod topLvl">
          <ac:chgData name="Filippo Acconcia" userId="844af49c-a8a0-47ac-a7dd-14a44b60cd18" providerId="ADAL" clId="{998C6BF7-482B-421C-8ECC-9091B23559F6}" dt="2022-04-11T15:26:06.474" v="594" actId="478"/>
          <ac:spMkLst>
            <pc:docMk/>
            <pc:sldMk cId="706034829" sldId="301"/>
            <ac:spMk id="171" creationId="{C66128DB-62E1-4000-9F61-0A016A7EBBA8}"/>
          </ac:spMkLst>
        </pc:spChg>
        <pc:spChg chg="del mod topLvl">
          <ac:chgData name="Filippo Acconcia" userId="844af49c-a8a0-47ac-a7dd-14a44b60cd18" providerId="ADAL" clId="{998C6BF7-482B-421C-8ECC-9091B23559F6}" dt="2022-04-11T15:26:06.474" v="594" actId="478"/>
          <ac:spMkLst>
            <pc:docMk/>
            <pc:sldMk cId="706034829" sldId="301"/>
            <ac:spMk id="172" creationId="{49A1BB0F-D604-453B-82B2-0A84EC588C61}"/>
          </ac:spMkLst>
        </pc:spChg>
        <pc:spChg chg="mod topLvl">
          <ac:chgData name="Filippo Acconcia" userId="844af49c-a8a0-47ac-a7dd-14a44b60cd18" providerId="ADAL" clId="{998C6BF7-482B-421C-8ECC-9091B23559F6}" dt="2022-05-11T10:14:34.673" v="959" actId="164"/>
          <ac:spMkLst>
            <pc:docMk/>
            <pc:sldMk cId="706034829" sldId="301"/>
            <ac:spMk id="173" creationId="{777A88F4-AEC3-7F54-3E97-D50D795E73C4}"/>
          </ac:spMkLst>
        </pc:spChg>
        <pc:spChg chg="del mod topLvl">
          <ac:chgData name="Filippo Acconcia" userId="844af49c-a8a0-47ac-a7dd-14a44b60cd18" providerId="ADAL" clId="{998C6BF7-482B-421C-8ECC-9091B23559F6}" dt="2022-04-11T15:26:06.474" v="594" actId="478"/>
          <ac:spMkLst>
            <pc:docMk/>
            <pc:sldMk cId="706034829" sldId="301"/>
            <ac:spMk id="173" creationId="{EBF6C49E-8E4B-46CE-8062-7BD8842F2FC1}"/>
          </ac:spMkLst>
        </pc:spChg>
        <pc:spChg chg="mod topLvl">
          <ac:chgData name="Filippo Acconcia" userId="844af49c-a8a0-47ac-a7dd-14a44b60cd18" providerId="ADAL" clId="{998C6BF7-482B-421C-8ECC-9091B23559F6}" dt="2022-05-11T10:14:34.673" v="959" actId="164"/>
          <ac:spMkLst>
            <pc:docMk/>
            <pc:sldMk cId="706034829" sldId="301"/>
            <ac:spMk id="174" creationId="{CEA67595-84D6-EDBC-BE1C-5066B330CDC0}"/>
          </ac:spMkLst>
        </pc:spChg>
        <pc:spChg chg="del mod topLvl">
          <ac:chgData name="Filippo Acconcia" userId="844af49c-a8a0-47ac-a7dd-14a44b60cd18" providerId="ADAL" clId="{998C6BF7-482B-421C-8ECC-9091B23559F6}" dt="2022-04-11T15:26:06.474" v="594" actId="478"/>
          <ac:spMkLst>
            <pc:docMk/>
            <pc:sldMk cId="706034829" sldId="301"/>
            <ac:spMk id="174" creationId="{EFD7AC82-329C-4A39-B57C-2C9C7051BF97}"/>
          </ac:spMkLst>
        </pc:spChg>
        <pc:spChg chg="mod topLvl">
          <ac:chgData name="Filippo Acconcia" userId="844af49c-a8a0-47ac-a7dd-14a44b60cd18" providerId="ADAL" clId="{998C6BF7-482B-421C-8ECC-9091B23559F6}" dt="2022-05-11T10:14:34.673" v="959" actId="164"/>
          <ac:spMkLst>
            <pc:docMk/>
            <pc:sldMk cId="706034829" sldId="301"/>
            <ac:spMk id="175" creationId="{1628DD2B-3AE1-52E3-89CC-37AA0D5240F4}"/>
          </ac:spMkLst>
        </pc:spChg>
        <pc:spChg chg="del mod topLvl">
          <ac:chgData name="Filippo Acconcia" userId="844af49c-a8a0-47ac-a7dd-14a44b60cd18" providerId="ADAL" clId="{998C6BF7-482B-421C-8ECC-9091B23559F6}" dt="2022-04-11T15:26:06.474" v="594" actId="478"/>
          <ac:spMkLst>
            <pc:docMk/>
            <pc:sldMk cId="706034829" sldId="301"/>
            <ac:spMk id="175" creationId="{BFF9DF4A-572D-47BC-BD3E-C8273665392E}"/>
          </ac:spMkLst>
        </pc:spChg>
        <pc:spChg chg="mod topLvl">
          <ac:chgData name="Filippo Acconcia" userId="844af49c-a8a0-47ac-a7dd-14a44b60cd18" providerId="ADAL" clId="{998C6BF7-482B-421C-8ECC-9091B23559F6}" dt="2022-05-11T10:14:34.673" v="959" actId="164"/>
          <ac:spMkLst>
            <pc:docMk/>
            <pc:sldMk cId="706034829" sldId="301"/>
            <ac:spMk id="176" creationId="{76119EAD-92EA-0B03-6E9D-4DA798AEFED2}"/>
          </ac:spMkLst>
        </pc:spChg>
        <pc:spChg chg="mod topLvl">
          <ac:chgData name="Filippo Acconcia" userId="844af49c-a8a0-47ac-a7dd-14a44b60cd18" providerId="ADAL" clId="{998C6BF7-482B-421C-8ECC-9091B23559F6}" dt="2022-05-11T10:14:34.673" v="959" actId="164"/>
          <ac:spMkLst>
            <pc:docMk/>
            <pc:sldMk cId="706034829" sldId="301"/>
            <ac:spMk id="177" creationId="{1C2A3682-9642-42A6-6D95-292A705F605D}"/>
          </ac:spMkLst>
        </pc:spChg>
        <pc:spChg chg="mod topLvl">
          <ac:chgData name="Filippo Acconcia" userId="844af49c-a8a0-47ac-a7dd-14a44b60cd18" providerId="ADAL" clId="{998C6BF7-482B-421C-8ECC-9091B23559F6}" dt="2022-05-11T10:14:34.673" v="959" actId="164"/>
          <ac:spMkLst>
            <pc:docMk/>
            <pc:sldMk cId="706034829" sldId="301"/>
            <ac:spMk id="191" creationId="{BC7EDF32-D6FE-2472-AE81-372EDC2616CB}"/>
          </ac:spMkLst>
        </pc:spChg>
        <pc:spChg chg="mod topLvl">
          <ac:chgData name="Filippo Acconcia" userId="844af49c-a8a0-47ac-a7dd-14a44b60cd18" providerId="ADAL" clId="{998C6BF7-482B-421C-8ECC-9091B23559F6}" dt="2022-05-11T10:14:34.673" v="959" actId="164"/>
          <ac:spMkLst>
            <pc:docMk/>
            <pc:sldMk cId="706034829" sldId="301"/>
            <ac:spMk id="192" creationId="{1656B70F-2D14-4A02-534F-3295DC071373}"/>
          </ac:spMkLst>
        </pc:spChg>
        <pc:spChg chg="mod topLvl">
          <ac:chgData name="Filippo Acconcia" userId="844af49c-a8a0-47ac-a7dd-14a44b60cd18" providerId="ADAL" clId="{998C6BF7-482B-421C-8ECC-9091B23559F6}" dt="2022-05-11T10:14:34.673" v="959" actId="164"/>
          <ac:spMkLst>
            <pc:docMk/>
            <pc:sldMk cId="706034829" sldId="301"/>
            <ac:spMk id="193" creationId="{79792095-9B3F-AFE8-9800-3863A610E435}"/>
          </ac:spMkLst>
        </pc:spChg>
        <pc:spChg chg="mod topLvl">
          <ac:chgData name="Filippo Acconcia" userId="844af49c-a8a0-47ac-a7dd-14a44b60cd18" providerId="ADAL" clId="{998C6BF7-482B-421C-8ECC-9091B23559F6}" dt="2022-05-11T10:14:34.673" v="959" actId="164"/>
          <ac:spMkLst>
            <pc:docMk/>
            <pc:sldMk cId="706034829" sldId="301"/>
            <ac:spMk id="194" creationId="{2825BBA4-EF78-07FC-5F1F-61B28B70E38B}"/>
          </ac:spMkLst>
        </pc:spChg>
        <pc:spChg chg="mod topLvl">
          <ac:chgData name="Filippo Acconcia" userId="844af49c-a8a0-47ac-a7dd-14a44b60cd18" providerId="ADAL" clId="{998C6BF7-482B-421C-8ECC-9091B23559F6}" dt="2022-05-11T10:14:34.673" v="959" actId="164"/>
          <ac:spMkLst>
            <pc:docMk/>
            <pc:sldMk cId="706034829" sldId="301"/>
            <ac:spMk id="195" creationId="{23D75452-6A16-7143-658D-E1CEB264FAFF}"/>
          </ac:spMkLst>
        </pc:spChg>
        <pc:spChg chg="add mod">
          <ac:chgData name="Filippo Acconcia" userId="844af49c-a8a0-47ac-a7dd-14a44b60cd18" providerId="ADAL" clId="{998C6BF7-482B-421C-8ECC-9091B23559F6}" dt="2022-06-10T16:51:05.748" v="1047" actId="1035"/>
          <ac:spMkLst>
            <pc:docMk/>
            <pc:sldMk cId="706034829" sldId="301"/>
            <ac:spMk id="196" creationId="{7D9FEF7E-468A-EF35-AF45-BB097316E280}"/>
          </ac:spMkLst>
        </pc:spChg>
        <pc:spChg chg="mod">
          <ac:chgData name="Filippo Acconcia" userId="844af49c-a8a0-47ac-a7dd-14a44b60cd18" providerId="ADAL" clId="{998C6BF7-482B-421C-8ECC-9091B23559F6}" dt="2022-04-11T15:24:10.763" v="568" actId="165"/>
          <ac:spMkLst>
            <pc:docMk/>
            <pc:sldMk cId="706034829" sldId="301"/>
            <ac:spMk id="196" creationId="{F12F9887-806C-48C7-8A76-B73A401F898F}"/>
          </ac:spMkLst>
        </pc:spChg>
        <pc:spChg chg="add mod">
          <ac:chgData name="Filippo Acconcia" userId="844af49c-a8a0-47ac-a7dd-14a44b60cd18" providerId="ADAL" clId="{998C6BF7-482B-421C-8ECC-9091B23559F6}" dt="2022-06-10T16:51:37.668" v="1064" actId="1038"/>
          <ac:spMkLst>
            <pc:docMk/>
            <pc:sldMk cId="706034829" sldId="301"/>
            <ac:spMk id="197" creationId="{3847CBC2-D36D-4A2B-C254-41385A6F8C62}"/>
          </ac:spMkLst>
        </pc:spChg>
        <pc:spChg chg="mod">
          <ac:chgData name="Filippo Acconcia" userId="844af49c-a8a0-47ac-a7dd-14a44b60cd18" providerId="ADAL" clId="{998C6BF7-482B-421C-8ECC-9091B23559F6}" dt="2022-04-11T15:24:10.763" v="568" actId="165"/>
          <ac:spMkLst>
            <pc:docMk/>
            <pc:sldMk cId="706034829" sldId="301"/>
            <ac:spMk id="198" creationId="{C57F181B-D931-446F-B902-B6DE55DF88D7}"/>
          </ac:spMkLst>
        </pc:spChg>
        <pc:spChg chg="add mod">
          <ac:chgData name="Filippo Acconcia" userId="844af49c-a8a0-47ac-a7dd-14a44b60cd18" providerId="ADAL" clId="{998C6BF7-482B-421C-8ECC-9091B23559F6}" dt="2022-06-10T16:52:09.261" v="1070" actId="1076"/>
          <ac:spMkLst>
            <pc:docMk/>
            <pc:sldMk cId="706034829" sldId="301"/>
            <ac:spMk id="198" creationId="{FE2C251E-4CA9-93A6-6E46-9B00C8733EFF}"/>
          </ac:spMkLst>
        </pc:spChg>
        <pc:spChg chg="add mod">
          <ac:chgData name="Filippo Acconcia" userId="844af49c-a8a0-47ac-a7dd-14a44b60cd18" providerId="ADAL" clId="{998C6BF7-482B-421C-8ECC-9091B23559F6}" dt="2022-06-10T16:52:18.205" v="1077" actId="1038"/>
          <ac:spMkLst>
            <pc:docMk/>
            <pc:sldMk cId="706034829" sldId="301"/>
            <ac:spMk id="199" creationId="{26B21501-EC22-0645-E09D-95B478D6B382}"/>
          </ac:spMkLst>
        </pc:spChg>
        <pc:spChg chg="mod">
          <ac:chgData name="Filippo Acconcia" userId="844af49c-a8a0-47ac-a7dd-14a44b60cd18" providerId="ADAL" clId="{998C6BF7-482B-421C-8ECC-9091B23559F6}" dt="2022-04-11T15:24:10.763" v="568" actId="165"/>
          <ac:spMkLst>
            <pc:docMk/>
            <pc:sldMk cId="706034829" sldId="301"/>
            <ac:spMk id="200" creationId="{3BCAAC9C-FED3-4BF1-8A5D-D79E3E71E7AF}"/>
          </ac:spMkLst>
        </pc:spChg>
        <pc:spChg chg="add mod">
          <ac:chgData name="Filippo Acconcia" userId="844af49c-a8a0-47ac-a7dd-14a44b60cd18" providerId="ADAL" clId="{998C6BF7-482B-421C-8ECC-9091B23559F6}" dt="2022-06-10T16:52:44.032" v="1079" actId="1076"/>
          <ac:spMkLst>
            <pc:docMk/>
            <pc:sldMk cId="706034829" sldId="301"/>
            <ac:spMk id="201" creationId="{5CF3A833-D593-3537-E472-F81BE29D4EF1}"/>
          </ac:spMkLst>
        </pc:spChg>
        <pc:spChg chg="mod">
          <ac:chgData name="Filippo Acconcia" userId="844af49c-a8a0-47ac-a7dd-14a44b60cd18" providerId="ADAL" clId="{998C6BF7-482B-421C-8ECC-9091B23559F6}" dt="2022-04-11T15:24:10.763" v="568" actId="165"/>
          <ac:spMkLst>
            <pc:docMk/>
            <pc:sldMk cId="706034829" sldId="301"/>
            <ac:spMk id="202" creationId="{116EC286-32D9-46AE-B123-378E5B0A66AE}"/>
          </ac:spMkLst>
        </pc:spChg>
        <pc:spChg chg="mod topLvl">
          <ac:chgData name="Filippo Acconcia" userId="844af49c-a8a0-47ac-a7dd-14a44b60cd18" providerId="ADAL" clId="{998C6BF7-482B-421C-8ECC-9091B23559F6}" dt="2022-05-11T10:40:19.380" v="1036" actId="20577"/>
          <ac:spMkLst>
            <pc:docMk/>
            <pc:sldMk cId="706034829" sldId="301"/>
            <ac:spMk id="202" creationId="{576461EF-BB1C-9D34-2AE1-DC17824E8A8F}"/>
          </ac:spMkLst>
        </pc:spChg>
        <pc:spChg chg="mod topLvl">
          <ac:chgData name="Filippo Acconcia" userId="844af49c-a8a0-47ac-a7dd-14a44b60cd18" providerId="ADAL" clId="{998C6BF7-482B-421C-8ECC-9091B23559F6}" dt="2022-05-11T10:20:27.881" v="1029" actId="164"/>
          <ac:spMkLst>
            <pc:docMk/>
            <pc:sldMk cId="706034829" sldId="301"/>
            <ac:spMk id="204" creationId="{0232F8B3-6DD7-D596-7345-D726E5D91F35}"/>
          </ac:spMkLst>
        </pc:spChg>
        <pc:spChg chg="mod topLvl">
          <ac:chgData name="Filippo Acconcia" userId="844af49c-a8a0-47ac-a7dd-14a44b60cd18" providerId="ADAL" clId="{998C6BF7-482B-421C-8ECC-9091B23559F6}" dt="2022-05-11T10:20:27.881" v="1029" actId="164"/>
          <ac:spMkLst>
            <pc:docMk/>
            <pc:sldMk cId="706034829" sldId="301"/>
            <ac:spMk id="205" creationId="{789DA033-7ABB-A3CB-7E27-FB8DA13F9574}"/>
          </ac:spMkLst>
        </pc:spChg>
        <pc:spChg chg="mod">
          <ac:chgData name="Filippo Acconcia" userId="844af49c-a8a0-47ac-a7dd-14a44b60cd18" providerId="ADAL" clId="{998C6BF7-482B-421C-8ECC-9091B23559F6}" dt="2022-04-11T15:24:10.763" v="568" actId="165"/>
          <ac:spMkLst>
            <pc:docMk/>
            <pc:sldMk cId="706034829" sldId="301"/>
            <ac:spMk id="205" creationId="{D9F7669B-603B-43BD-8EC6-D76AE7BB453C}"/>
          </ac:spMkLst>
        </pc:spChg>
        <pc:spChg chg="mod topLvl">
          <ac:chgData name="Filippo Acconcia" userId="844af49c-a8a0-47ac-a7dd-14a44b60cd18" providerId="ADAL" clId="{998C6BF7-482B-421C-8ECC-9091B23559F6}" dt="2022-05-11T10:20:27.881" v="1029" actId="164"/>
          <ac:spMkLst>
            <pc:docMk/>
            <pc:sldMk cId="706034829" sldId="301"/>
            <ac:spMk id="210" creationId="{3167185B-88F3-E6CD-BC43-5E03F5C68ECD}"/>
          </ac:spMkLst>
        </pc:spChg>
        <pc:spChg chg="mod topLvl">
          <ac:chgData name="Filippo Acconcia" userId="844af49c-a8a0-47ac-a7dd-14a44b60cd18" providerId="ADAL" clId="{998C6BF7-482B-421C-8ECC-9091B23559F6}" dt="2022-05-11T10:20:27.881" v="1029" actId="164"/>
          <ac:spMkLst>
            <pc:docMk/>
            <pc:sldMk cId="706034829" sldId="301"/>
            <ac:spMk id="211" creationId="{2F173B55-22EF-50DE-8C21-6EAE33881F04}"/>
          </ac:spMkLst>
        </pc:spChg>
        <pc:spChg chg="mod">
          <ac:chgData name="Filippo Acconcia" userId="844af49c-a8a0-47ac-a7dd-14a44b60cd18" providerId="ADAL" clId="{998C6BF7-482B-421C-8ECC-9091B23559F6}" dt="2022-04-11T15:24:10.763" v="568" actId="165"/>
          <ac:spMkLst>
            <pc:docMk/>
            <pc:sldMk cId="706034829" sldId="301"/>
            <ac:spMk id="211" creationId="{716F56CC-12CE-42FD-A242-9EADF586D446}"/>
          </ac:spMkLst>
        </pc:spChg>
        <pc:spChg chg="mod topLvl">
          <ac:chgData name="Filippo Acconcia" userId="844af49c-a8a0-47ac-a7dd-14a44b60cd18" providerId="ADAL" clId="{998C6BF7-482B-421C-8ECC-9091B23559F6}" dt="2022-05-11T10:20:27.881" v="1029" actId="164"/>
          <ac:spMkLst>
            <pc:docMk/>
            <pc:sldMk cId="706034829" sldId="301"/>
            <ac:spMk id="212" creationId="{63D860E3-F207-1C3C-6CE2-485A67C25211}"/>
          </ac:spMkLst>
        </pc:spChg>
        <pc:spChg chg="mod topLvl">
          <ac:chgData name="Filippo Acconcia" userId="844af49c-a8a0-47ac-a7dd-14a44b60cd18" providerId="ADAL" clId="{998C6BF7-482B-421C-8ECC-9091B23559F6}" dt="2022-05-11T10:20:27.881" v="1029" actId="164"/>
          <ac:spMkLst>
            <pc:docMk/>
            <pc:sldMk cId="706034829" sldId="301"/>
            <ac:spMk id="213" creationId="{8DC925BD-F634-B978-413D-FF82CE2B415A}"/>
          </ac:spMkLst>
        </pc:spChg>
        <pc:spChg chg="mod">
          <ac:chgData name="Filippo Acconcia" userId="844af49c-a8a0-47ac-a7dd-14a44b60cd18" providerId="ADAL" clId="{998C6BF7-482B-421C-8ECC-9091B23559F6}" dt="2022-04-11T15:24:10.763" v="568" actId="165"/>
          <ac:spMkLst>
            <pc:docMk/>
            <pc:sldMk cId="706034829" sldId="301"/>
            <ac:spMk id="213" creationId="{C7963525-2F36-4A0A-AD9A-8C5CC6596F0E}"/>
          </ac:spMkLst>
        </pc:spChg>
        <pc:spChg chg="mod topLvl">
          <ac:chgData name="Filippo Acconcia" userId="844af49c-a8a0-47ac-a7dd-14a44b60cd18" providerId="ADAL" clId="{998C6BF7-482B-421C-8ECC-9091B23559F6}" dt="2022-05-11T10:20:27.881" v="1029" actId="164"/>
          <ac:spMkLst>
            <pc:docMk/>
            <pc:sldMk cId="706034829" sldId="301"/>
            <ac:spMk id="214" creationId="{9E92291F-93EC-4F2B-8CCF-1B537809C3DF}"/>
          </ac:spMkLst>
        </pc:spChg>
        <pc:spChg chg="mod topLvl">
          <ac:chgData name="Filippo Acconcia" userId="844af49c-a8a0-47ac-a7dd-14a44b60cd18" providerId="ADAL" clId="{998C6BF7-482B-421C-8ECC-9091B23559F6}" dt="2022-04-11T15:28:54.251" v="667" actId="164"/>
          <ac:spMkLst>
            <pc:docMk/>
            <pc:sldMk cId="706034829" sldId="301"/>
            <ac:spMk id="215" creationId="{7E35C53C-94B5-4ECD-9541-03B0E6424869}"/>
          </ac:spMkLst>
        </pc:spChg>
        <pc:spChg chg="add mod">
          <ac:chgData name="Filippo Acconcia" userId="844af49c-a8a0-47ac-a7dd-14a44b60cd18" providerId="ADAL" clId="{998C6BF7-482B-421C-8ECC-9091B23559F6}" dt="2022-04-11T15:28:54.251" v="667" actId="164"/>
          <ac:spMkLst>
            <pc:docMk/>
            <pc:sldMk cId="706034829" sldId="301"/>
            <ac:spMk id="216" creationId="{C3718229-B96C-4DEA-A92E-06B70C4A7C59}"/>
          </ac:spMkLst>
        </pc:spChg>
        <pc:spChg chg="add mod">
          <ac:chgData name="Filippo Acconcia" userId="844af49c-a8a0-47ac-a7dd-14a44b60cd18" providerId="ADAL" clId="{998C6BF7-482B-421C-8ECC-9091B23559F6}" dt="2022-04-11T15:28:54.251" v="667" actId="164"/>
          <ac:spMkLst>
            <pc:docMk/>
            <pc:sldMk cId="706034829" sldId="301"/>
            <ac:spMk id="217" creationId="{FD755104-9BBB-4C50-9CD4-707A4D8AE627}"/>
          </ac:spMkLst>
        </pc:spChg>
        <pc:spChg chg="add mod">
          <ac:chgData name="Filippo Acconcia" userId="844af49c-a8a0-47ac-a7dd-14a44b60cd18" providerId="ADAL" clId="{998C6BF7-482B-421C-8ECC-9091B23559F6}" dt="2022-04-11T15:28:54.251" v="667" actId="164"/>
          <ac:spMkLst>
            <pc:docMk/>
            <pc:sldMk cId="706034829" sldId="301"/>
            <ac:spMk id="218" creationId="{E6247A58-E4DB-4EDF-8438-B134313E8C79}"/>
          </ac:spMkLst>
        </pc:spChg>
        <pc:spChg chg="add mod">
          <ac:chgData name="Filippo Acconcia" userId="844af49c-a8a0-47ac-a7dd-14a44b60cd18" providerId="ADAL" clId="{998C6BF7-482B-421C-8ECC-9091B23559F6}" dt="2022-04-11T15:28:54.251" v="667" actId="164"/>
          <ac:spMkLst>
            <pc:docMk/>
            <pc:sldMk cId="706034829" sldId="301"/>
            <ac:spMk id="219" creationId="{22AB805A-C1CE-4901-A63A-A74082053814}"/>
          </ac:spMkLst>
        </pc:spChg>
        <pc:spChg chg="add mod">
          <ac:chgData name="Filippo Acconcia" userId="844af49c-a8a0-47ac-a7dd-14a44b60cd18" providerId="ADAL" clId="{998C6BF7-482B-421C-8ECC-9091B23559F6}" dt="2022-04-11T15:28:54.251" v="667" actId="164"/>
          <ac:spMkLst>
            <pc:docMk/>
            <pc:sldMk cId="706034829" sldId="301"/>
            <ac:spMk id="220" creationId="{AE812724-FF40-4251-A5F0-45AF5DD84328}"/>
          </ac:spMkLst>
        </pc:spChg>
        <pc:spChg chg="add mod">
          <ac:chgData name="Filippo Acconcia" userId="844af49c-a8a0-47ac-a7dd-14a44b60cd18" providerId="ADAL" clId="{998C6BF7-482B-421C-8ECC-9091B23559F6}" dt="2022-04-11T15:28:54.251" v="667" actId="164"/>
          <ac:spMkLst>
            <pc:docMk/>
            <pc:sldMk cId="706034829" sldId="301"/>
            <ac:spMk id="221" creationId="{1A800532-F2C5-47B1-BE29-CEABD49AFFBB}"/>
          </ac:spMkLst>
        </pc:spChg>
        <pc:spChg chg="add del mod">
          <ac:chgData name="Filippo Acconcia" userId="844af49c-a8a0-47ac-a7dd-14a44b60cd18" providerId="ADAL" clId="{998C6BF7-482B-421C-8ECC-9091B23559F6}" dt="2022-06-10T17:03:01.055" v="1122" actId="1038"/>
          <ac:spMkLst>
            <pc:docMk/>
            <pc:sldMk cId="706034829" sldId="301"/>
            <ac:spMk id="222" creationId="{E892C7DF-4B81-4608-BBB7-CE19D6E99E7C}"/>
          </ac:spMkLst>
        </pc:spChg>
        <pc:spChg chg="add mod">
          <ac:chgData name="Filippo Acconcia" userId="844af49c-a8a0-47ac-a7dd-14a44b60cd18" providerId="ADAL" clId="{998C6BF7-482B-421C-8ECC-9091B23559F6}" dt="2022-04-11T15:28:54.251" v="667" actId="164"/>
          <ac:spMkLst>
            <pc:docMk/>
            <pc:sldMk cId="706034829" sldId="301"/>
            <ac:spMk id="223" creationId="{5893BBC1-0836-42AB-9DF2-123B2DC6400A}"/>
          </ac:spMkLst>
        </pc:spChg>
        <pc:spChg chg="mod topLvl">
          <ac:chgData name="Filippo Acconcia" userId="844af49c-a8a0-47ac-a7dd-14a44b60cd18" providerId="ADAL" clId="{998C6BF7-482B-421C-8ECC-9091B23559F6}" dt="2022-05-11T10:20:27.881" v="1029" actId="164"/>
          <ac:spMkLst>
            <pc:docMk/>
            <pc:sldMk cId="706034829" sldId="301"/>
            <ac:spMk id="225" creationId="{5933AC2E-300D-7076-EA03-1041217DC624}"/>
          </ac:spMkLst>
        </pc:spChg>
        <pc:spChg chg="add mod">
          <ac:chgData name="Filippo Acconcia" userId="844af49c-a8a0-47ac-a7dd-14a44b60cd18" providerId="ADAL" clId="{998C6BF7-482B-421C-8ECC-9091B23559F6}" dt="2022-06-10T16:52:53.258" v="1086" actId="1036"/>
          <ac:spMkLst>
            <pc:docMk/>
            <pc:sldMk cId="706034829" sldId="301"/>
            <ac:spMk id="226" creationId="{18FCC738-A54E-0ED6-BB35-1DCECC24C960}"/>
          </ac:spMkLst>
        </pc:spChg>
        <pc:spChg chg="mod">
          <ac:chgData name="Filippo Acconcia" userId="844af49c-a8a0-47ac-a7dd-14a44b60cd18" providerId="ADAL" clId="{998C6BF7-482B-421C-8ECC-9091B23559F6}" dt="2022-05-11T10:15:05.809" v="968" actId="165"/>
          <ac:spMkLst>
            <pc:docMk/>
            <pc:sldMk cId="706034829" sldId="301"/>
            <ac:spMk id="226" creationId="{44F0B18C-C978-1B2E-FA84-B09AADA68A89}"/>
          </ac:spMkLst>
        </pc:spChg>
        <pc:spChg chg="add mod">
          <ac:chgData name="Filippo Acconcia" userId="844af49c-a8a0-47ac-a7dd-14a44b60cd18" providerId="ADAL" clId="{998C6BF7-482B-421C-8ECC-9091B23559F6}" dt="2022-06-10T16:57:54.962" v="1095" actId="1036"/>
          <ac:spMkLst>
            <pc:docMk/>
            <pc:sldMk cId="706034829" sldId="301"/>
            <ac:spMk id="227" creationId="{6A9EC4EA-EC7E-52E8-92F0-BF8AF8128FA0}"/>
          </ac:spMkLst>
        </pc:spChg>
        <pc:spChg chg="mod">
          <ac:chgData name="Filippo Acconcia" userId="844af49c-a8a0-47ac-a7dd-14a44b60cd18" providerId="ADAL" clId="{998C6BF7-482B-421C-8ECC-9091B23559F6}" dt="2022-05-11T10:15:05.809" v="968" actId="165"/>
          <ac:spMkLst>
            <pc:docMk/>
            <pc:sldMk cId="706034829" sldId="301"/>
            <ac:spMk id="227" creationId="{D73F60D2-6F8E-E92F-728F-D5A79854A83F}"/>
          </ac:spMkLst>
        </pc:spChg>
        <pc:spChg chg="add mod">
          <ac:chgData name="Filippo Acconcia" userId="844af49c-a8a0-47ac-a7dd-14a44b60cd18" providerId="ADAL" clId="{998C6BF7-482B-421C-8ECC-9091B23559F6}" dt="2022-06-10T16:58:26.603" v="1106" actId="20577"/>
          <ac:spMkLst>
            <pc:docMk/>
            <pc:sldMk cId="706034829" sldId="301"/>
            <ac:spMk id="228" creationId="{18A464AD-A5FF-7BBC-B0A8-DC99B1BCC1C1}"/>
          </ac:spMkLst>
        </pc:spChg>
        <pc:spChg chg="mod">
          <ac:chgData name="Filippo Acconcia" userId="844af49c-a8a0-47ac-a7dd-14a44b60cd18" providerId="ADAL" clId="{998C6BF7-482B-421C-8ECC-9091B23559F6}" dt="2022-05-11T10:15:05.809" v="968" actId="165"/>
          <ac:spMkLst>
            <pc:docMk/>
            <pc:sldMk cId="706034829" sldId="301"/>
            <ac:spMk id="228" creationId="{3EEE93EB-B835-82EC-5A6F-3FC093BF6505}"/>
          </ac:spMkLst>
        </pc:spChg>
        <pc:spChg chg="mod">
          <ac:chgData name="Filippo Acconcia" userId="844af49c-a8a0-47ac-a7dd-14a44b60cd18" providerId="ADAL" clId="{998C6BF7-482B-421C-8ECC-9091B23559F6}" dt="2022-05-11T10:15:05.809" v="968" actId="165"/>
          <ac:spMkLst>
            <pc:docMk/>
            <pc:sldMk cId="706034829" sldId="301"/>
            <ac:spMk id="229" creationId="{178D0240-B9BB-F852-024E-F540A98C568B}"/>
          </ac:spMkLst>
        </pc:spChg>
        <pc:spChg chg="add mod">
          <ac:chgData name="Filippo Acconcia" userId="844af49c-a8a0-47ac-a7dd-14a44b60cd18" providerId="ADAL" clId="{998C6BF7-482B-421C-8ECC-9091B23559F6}" dt="2022-06-10T16:58:13.091" v="1102" actId="1076"/>
          <ac:spMkLst>
            <pc:docMk/>
            <pc:sldMk cId="706034829" sldId="301"/>
            <ac:spMk id="229" creationId="{D3B1F18F-10AF-F582-EA2D-8FE39CBD098F}"/>
          </ac:spMkLst>
        </pc:spChg>
        <pc:spChg chg="mod">
          <ac:chgData name="Filippo Acconcia" userId="844af49c-a8a0-47ac-a7dd-14a44b60cd18" providerId="ADAL" clId="{998C6BF7-482B-421C-8ECC-9091B23559F6}" dt="2022-05-11T10:15:05.809" v="968" actId="165"/>
          <ac:spMkLst>
            <pc:docMk/>
            <pc:sldMk cId="706034829" sldId="301"/>
            <ac:spMk id="230" creationId="{803686FC-5FAA-8E92-B421-8E08235F8502}"/>
          </ac:spMkLst>
        </pc:spChg>
        <pc:spChg chg="add mod">
          <ac:chgData name="Filippo Acconcia" userId="844af49c-a8a0-47ac-a7dd-14a44b60cd18" providerId="ADAL" clId="{998C6BF7-482B-421C-8ECC-9091B23559F6}" dt="2022-06-10T16:58:35.213" v="1115" actId="14100"/>
          <ac:spMkLst>
            <pc:docMk/>
            <pc:sldMk cId="706034829" sldId="301"/>
            <ac:spMk id="230" creationId="{8BE0EEF2-5CF8-6AFE-8567-AAD97E4B9AC5}"/>
          </ac:spMkLst>
        </pc:spChg>
        <pc:spChg chg="mod">
          <ac:chgData name="Filippo Acconcia" userId="844af49c-a8a0-47ac-a7dd-14a44b60cd18" providerId="ADAL" clId="{998C6BF7-482B-421C-8ECC-9091B23559F6}" dt="2022-05-11T10:15:05.809" v="968" actId="165"/>
          <ac:spMkLst>
            <pc:docMk/>
            <pc:sldMk cId="706034829" sldId="301"/>
            <ac:spMk id="231" creationId="{E6142B0C-172F-18B9-2CD4-58823FE28EEB}"/>
          </ac:spMkLst>
        </pc:spChg>
        <pc:spChg chg="mod">
          <ac:chgData name="Filippo Acconcia" userId="844af49c-a8a0-47ac-a7dd-14a44b60cd18" providerId="ADAL" clId="{998C6BF7-482B-421C-8ECC-9091B23559F6}" dt="2022-05-11T10:15:05.809" v="968" actId="165"/>
          <ac:spMkLst>
            <pc:docMk/>
            <pc:sldMk cId="706034829" sldId="301"/>
            <ac:spMk id="234" creationId="{4F82600F-6EF4-3294-EA5B-E8193A35AF1E}"/>
          </ac:spMkLst>
        </pc:spChg>
        <pc:spChg chg="mod">
          <ac:chgData name="Filippo Acconcia" userId="844af49c-a8a0-47ac-a7dd-14a44b60cd18" providerId="ADAL" clId="{998C6BF7-482B-421C-8ECC-9091B23559F6}" dt="2022-05-11T10:15:05.809" v="968" actId="165"/>
          <ac:spMkLst>
            <pc:docMk/>
            <pc:sldMk cId="706034829" sldId="301"/>
            <ac:spMk id="235" creationId="{F193C8D5-B48D-8B09-590F-192C4100F2C1}"/>
          </ac:spMkLst>
        </pc:spChg>
        <pc:spChg chg="mod">
          <ac:chgData name="Filippo Acconcia" userId="844af49c-a8a0-47ac-a7dd-14a44b60cd18" providerId="ADAL" clId="{998C6BF7-482B-421C-8ECC-9091B23559F6}" dt="2022-05-11T10:15:05.809" v="968" actId="165"/>
          <ac:spMkLst>
            <pc:docMk/>
            <pc:sldMk cId="706034829" sldId="301"/>
            <ac:spMk id="236" creationId="{C6376426-0236-574F-90B1-53AC25A517AE}"/>
          </ac:spMkLst>
        </pc:spChg>
        <pc:spChg chg="mod">
          <ac:chgData name="Filippo Acconcia" userId="844af49c-a8a0-47ac-a7dd-14a44b60cd18" providerId="ADAL" clId="{998C6BF7-482B-421C-8ECC-9091B23559F6}" dt="2022-05-11T10:15:05.809" v="968" actId="165"/>
          <ac:spMkLst>
            <pc:docMk/>
            <pc:sldMk cId="706034829" sldId="301"/>
            <ac:spMk id="237" creationId="{B3803384-8EBD-46E2-4B4A-FCEF29C3AF61}"/>
          </ac:spMkLst>
        </pc:spChg>
        <pc:spChg chg="mod">
          <ac:chgData name="Filippo Acconcia" userId="844af49c-a8a0-47ac-a7dd-14a44b60cd18" providerId="ADAL" clId="{998C6BF7-482B-421C-8ECC-9091B23559F6}" dt="2022-05-11T10:15:05.809" v="968" actId="165"/>
          <ac:spMkLst>
            <pc:docMk/>
            <pc:sldMk cId="706034829" sldId="301"/>
            <ac:spMk id="238" creationId="{2DBCF776-3F4D-A433-C464-9FE8CDD6BAF5}"/>
          </ac:spMkLst>
        </pc:spChg>
        <pc:spChg chg="mod">
          <ac:chgData name="Filippo Acconcia" userId="844af49c-a8a0-47ac-a7dd-14a44b60cd18" providerId="ADAL" clId="{998C6BF7-482B-421C-8ECC-9091B23559F6}" dt="2022-05-11T09:51:09.803" v="927" actId="554"/>
          <ac:spMkLst>
            <pc:docMk/>
            <pc:sldMk cId="706034829" sldId="301"/>
            <ac:spMk id="272" creationId="{1BBD55A0-98C2-47A1-90AF-09AF9F6E4108}"/>
          </ac:spMkLst>
        </pc:spChg>
        <pc:spChg chg="del">
          <ac:chgData name="Filippo Acconcia" userId="844af49c-a8a0-47ac-a7dd-14a44b60cd18" providerId="ADAL" clId="{998C6BF7-482B-421C-8ECC-9091B23559F6}" dt="2022-04-11T15:24:07.449" v="566" actId="478"/>
          <ac:spMkLst>
            <pc:docMk/>
            <pc:sldMk cId="706034829" sldId="301"/>
            <ac:spMk id="273" creationId="{9369B27E-9BB3-4F12-94BD-4DA1474EFB38}"/>
          </ac:spMkLst>
        </pc:spChg>
        <pc:spChg chg="mod">
          <ac:chgData name="Filippo Acconcia" userId="844af49c-a8a0-47ac-a7dd-14a44b60cd18" providerId="ADAL" clId="{998C6BF7-482B-421C-8ECC-9091B23559F6}" dt="2022-05-11T09:51:09.803" v="927" actId="554"/>
          <ac:spMkLst>
            <pc:docMk/>
            <pc:sldMk cId="706034829" sldId="301"/>
            <ac:spMk id="274" creationId="{20230811-7E23-40C4-952A-4194E7890510}"/>
          </ac:spMkLst>
        </pc:spChg>
        <pc:grpChg chg="add mod">
          <ac:chgData name="Filippo Acconcia" userId="844af49c-a8a0-47ac-a7dd-14a44b60cd18" providerId="ADAL" clId="{998C6BF7-482B-421C-8ECC-9091B23559F6}" dt="2022-05-11T09:50:57.647" v="925" actId="1037"/>
          <ac:grpSpMkLst>
            <pc:docMk/>
            <pc:sldMk cId="706034829" sldId="301"/>
            <ac:grpSpMk id="4" creationId="{D86C858F-6C7D-4761-B011-0F88734AD2B5}"/>
          </ac:grpSpMkLst>
        </pc:grpChg>
        <pc:grpChg chg="add mod">
          <ac:chgData name="Filippo Acconcia" userId="844af49c-a8a0-47ac-a7dd-14a44b60cd18" providerId="ADAL" clId="{998C6BF7-482B-421C-8ECC-9091B23559F6}" dt="2022-05-11T10:14:34.673" v="959" actId="164"/>
          <ac:grpSpMkLst>
            <pc:docMk/>
            <pc:sldMk cId="706034829" sldId="301"/>
            <ac:grpSpMk id="6" creationId="{1B25964C-CA1F-2EB9-3B08-95660632C1DC}"/>
          </ac:grpSpMkLst>
        </pc:grpChg>
        <pc:grpChg chg="add mod">
          <ac:chgData name="Filippo Acconcia" userId="844af49c-a8a0-47ac-a7dd-14a44b60cd18" providerId="ADAL" clId="{998C6BF7-482B-421C-8ECC-9091B23559F6}" dt="2022-05-11T10:20:27.881" v="1029" actId="164"/>
          <ac:grpSpMkLst>
            <pc:docMk/>
            <pc:sldMk cId="706034829" sldId="301"/>
            <ac:grpSpMk id="10" creationId="{A317D85F-F269-C400-4C66-51AAC734B2DC}"/>
          </ac:grpSpMkLst>
        </pc:grpChg>
        <pc:grpChg chg="add del mod">
          <ac:chgData name="Filippo Acconcia" userId="844af49c-a8a0-47ac-a7dd-14a44b60cd18" providerId="ADAL" clId="{998C6BF7-482B-421C-8ECC-9091B23559F6}" dt="2022-04-11T15:24:10.763" v="568" actId="165"/>
          <ac:grpSpMkLst>
            <pc:docMk/>
            <pc:sldMk cId="706034829" sldId="301"/>
            <ac:grpSpMk id="140" creationId="{EE3BA8EC-7D40-4006-B8E3-3D0CF3796E52}"/>
          </ac:grpSpMkLst>
        </pc:grpChg>
        <pc:grpChg chg="del mod topLvl">
          <ac:chgData name="Filippo Acconcia" userId="844af49c-a8a0-47ac-a7dd-14a44b60cd18" providerId="ADAL" clId="{998C6BF7-482B-421C-8ECC-9091B23559F6}" dt="2022-04-11T15:27:47.436" v="642" actId="165"/>
          <ac:grpSpMkLst>
            <pc:docMk/>
            <pc:sldMk cId="706034829" sldId="301"/>
            <ac:grpSpMk id="168" creationId="{3E18D1F2-59F3-40CA-8674-93D2987E0DD6}"/>
          </ac:grpSpMkLst>
        </pc:grpChg>
        <pc:grpChg chg="add del mod">
          <ac:chgData name="Filippo Acconcia" userId="844af49c-a8a0-47ac-a7dd-14a44b60cd18" providerId="ADAL" clId="{998C6BF7-482B-421C-8ECC-9091B23559F6}" dt="2022-05-11T10:13:44.358" v="949" actId="165"/>
          <ac:grpSpMkLst>
            <pc:docMk/>
            <pc:sldMk cId="706034829" sldId="301"/>
            <ac:grpSpMk id="171" creationId="{A69134DC-3ACD-8F13-3819-1C72DE477A4A}"/>
          </ac:grpSpMkLst>
        </pc:grpChg>
        <pc:grpChg chg="del mod topLvl">
          <ac:chgData name="Filippo Acconcia" userId="844af49c-a8a0-47ac-a7dd-14a44b60cd18" providerId="ADAL" clId="{998C6BF7-482B-421C-8ECC-9091B23559F6}" dt="2022-04-11T15:26:06.474" v="594" actId="478"/>
          <ac:grpSpMkLst>
            <pc:docMk/>
            <pc:sldMk cId="706034829" sldId="301"/>
            <ac:grpSpMk id="176" creationId="{D756118C-A575-4F05-B4D7-CB981761023F}"/>
          </ac:grpSpMkLst>
        </pc:grpChg>
        <pc:grpChg chg="del mod topLvl">
          <ac:chgData name="Filippo Acconcia" userId="844af49c-a8a0-47ac-a7dd-14a44b60cd18" providerId="ADAL" clId="{998C6BF7-482B-421C-8ECC-9091B23559F6}" dt="2022-04-11T15:26:06.474" v="594" actId="478"/>
          <ac:grpSpMkLst>
            <pc:docMk/>
            <pc:sldMk cId="706034829" sldId="301"/>
            <ac:grpSpMk id="177" creationId="{07296473-150C-481A-AA99-3AA4E01D1A89}"/>
          </ac:grpSpMkLst>
        </pc:grpChg>
        <pc:grpChg chg="del mod topLvl">
          <ac:chgData name="Filippo Acconcia" userId="844af49c-a8a0-47ac-a7dd-14a44b60cd18" providerId="ADAL" clId="{998C6BF7-482B-421C-8ECC-9091B23559F6}" dt="2022-04-11T15:26:06.474" v="594" actId="478"/>
          <ac:grpSpMkLst>
            <pc:docMk/>
            <pc:sldMk cId="706034829" sldId="301"/>
            <ac:grpSpMk id="178" creationId="{4D14F3F3-41D4-4279-97B7-074F0E18466D}"/>
          </ac:grpSpMkLst>
        </pc:grpChg>
        <pc:grpChg chg="del mod topLvl">
          <ac:chgData name="Filippo Acconcia" userId="844af49c-a8a0-47ac-a7dd-14a44b60cd18" providerId="ADAL" clId="{998C6BF7-482B-421C-8ECC-9091B23559F6}" dt="2022-04-11T15:25:49.017" v="589" actId="478"/>
          <ac:grpSpMkLst>
            <pc:docMk/>
            <pc:sldMk cId="706034829" sldId="301"/>
            <ac:grpSpMk id="191" creationId="{9FBD6B3C-4B25-4488-8422-CBF931EBDE4E}"/>
          </ac:grpSpMkLst>
        </pc:grpChg>
        <pc:grpChg chg="del mod topLvl">
          <ac:chgData name="Filippo Acconcia" userId="844af49c-a8a0-47ac-a7dd-14a44b60cd18" providerId="ADAL" clId="{998C6BF7-482B-421C-8ECC-9091B23559F6}" dt="2022-04-11T15:25:49.017" v="589" actId="478"/>
          <ac:grpSpMkLst>
            <pc:docMk/>
            <pc:sldMk cId="706034829" sldId="301"/>
            <ac:grpSpMk id="192" creationId="{7C4A1ADA-EB43-4967-9715-2889F56D5496}"/>
          </ac:grpSpMkLst>
        </pc:grpChg>
        <pc:grpChg chg="del mod topLvl">
          <ac:chgData name="Filippo Acconcia" userId="844af49c-a8a0-47ac-a7dd-14a44b60cd18" providerId="ADAL" clId="{998C6BF7-482B-421C-8ECC-9091B23559F6}" dt="2022-04-11T15:25:49.017" v="589" actId="478"/>
          <ac:grpSpMkLst>
            <pc:docMk/>
            <pc:sldMk cId="706034829" sldId="301"/>
            <ac:grpSpMk id="193" creationId="{D42965E2-5240-4968-B92B-79BCB37D066A}"/>
          </ac:grpSpMkLst>
        </pc:grpChg>
        <pc:grpChg chg="del mod topLvl">
          <ac:chgData name="Filippo Acconcia" userId="844af49c-a8a0-47ac-a7dd-14a44b60cd18" providerId="ADAL" clId="{998C6BF7-482B-421C-8ECC-9091B23559F6}" dt="2022-04-11T15:25:49.017" v="589" actId="478"/>
          <ac:grpSpMkLst>
            <pc:docMk/>
            <pc:sldMk cId="706034829" sldId="301"/>
            <ac:grpSpMk id="194" creationId="{62BAD6CA-00E4-46EB-B313-585F9F7986C6}"/>
          </ac:grpSpMkLst>
        </pc:grpChg>
        <pc:grpChg chg="add del mod">
          <ac:chgData name="Filippo Acconcia" userId="844af49c-a8a0-47ac-a7dd-14a44b60cd18" providerId="ADAL" clId="{998C6BF7-482B-421C-8ECC-9091B23559F6}" dt="2022-05-11T10:15:05.809" v="968" actId="165"/>
          <ac:grpSpMkLst>
            <pc:docMk/>
            <pc:sldMk cId="706034829" sldId="301"/>
            <ac:grpSpMk id="196" creationId="{FCD13521-2747-1F55-83F5-F05A195AF95B}"/>
          </ac:grpSpMkLst>
        </pc:grpChg>
        <pc:grpChg chg="del mod topLvl">
          <ac:chgData name="Filippo Acconcia" userId="844af49c-a8a0-47ac-a7dd-14a44b60cd18" providerId="ADAL" clId="{998C6BF7-482B-421C-8ECC-9091B23559F6}" dt="2022-05-11T10:15:07.980" v="969" actId="478"/>
          <ac:grpSpMkLst>
            <pc:docMk/>
            <pc:sldMk cId="706034829" sldId="301"/>
            <ac:grpSpMk id="197" creationId="{BF1B2379-A343-CBB4-DDAE-C1E73B0FA2DF}"/>
          </ac:grpSpMkLst>
        </pc:grpChg>
        <pc:grpChg chg="del mod topLvl">
          <ac:chgData name="Filippo Acconcia" userId="844af49c-a8a0-47ac-a7dd-14a44b60cd18" providerId="ADAL" clId="{998C6BF7-482B-421C-8ECC-9091B23559F6}" dt="2022-05-11T10:18:49.093" v="985" actId="165"/>
          <ac:grpSpMkLst>
            <pc:docMk/>
            <pc:sldMk cId="706034829" sldId="301"/>
            <ac:grpSpMk id="198" creationId="{E801CA08-BE95-C098-F2AE-8A32DF378724}"/>
          </ac:grpSpMkLst>
        </pc:grpChg>
        <pc:grpChg chg="mod">
          <ac:chgData name="Filippo Acconcia" userId="844af49c-a8a0-47ac-a7dd-14a44b60cd18" providerId="ADAL" clId="{998C6BF7-482B-421C-8ECC-9091B23559F6}" dt="2022-05-11T09:50:53.869" v="905" actId="1037"/>
          <ac:grpSpMkLst>
            <pc:docMk/>
            <pc:sldMk cId="706034829" sldId="301"/>
            <ac:grpSpMk id="271" creationId="{30715158-9BBA-4454-A5EE-144388B7ED34}"/>
          </ac:grpSpMkLst>
        </pc:grpChg>
        <pc:grpChg chg="mod">
          <ac:chgData name="Filippo Acconcia" userId="844af49c-a8a0-47ac-a7dd-14a44b60cd18" providerId="ADAL" clId="{998C6BF7-482B-421C-8ECC-9091B23559F6}" dt="2022-05-11T10:13:22.917" v="937" actId="552"/>
          <ac:grpSpMkLst>
            <pc:docMk/>
            <pc:sldMk cId="706034829" sldId="301"/>
            <ac:grpSpMk id="306" creationId="{A65B5E4D-80A0-4206-9F58-64150E916510}"/>
          </ac:grpSpMkLst>
        </pc:grpChg>
        <pc:graphicFrameChg chg="add del mod">
          <ac:chgData name="Filippo Acconcia" userId="844af49c-a8a0-47ac-a7dd-14a44b60cd18" providerId="ADAL" clId="{998C6BF7-482B-421C-8ECC-9091B23559F6}" dt="2022-06-10T16:52:01.818" v="1068"/>
          <ac:graphicFrameMkLst>
            <pc:docMk/>
            <pc:sldMk cId="706034829" sldId="301"/>
            <ac:graphicFrameMk id="11" creationId="{5B78E592-DF76-216E-0DBC-7802350D9A39}"/>
          </ac:graphicFrameMkLst>
        </pc:graphicFrameChg>
        <pc:picChg chg="mod ord">
          <ac:chgData name="Filippo Acconcia" userId="844af49c-a8a0-47ac-a7dd-14a44b60cd18" providerId="ADAL" clId="{998C6BF7-482B-421C-8ECC-9091B23559F6}" dt="2022-04-11T15:28:54.251" v="667" actId="164"/>
          <ac:picMkLst>
            <pc:docMk/>
            <pc:sldMk cId="706034829" sldId="301"/>
            <ac:picMk id="3" creationId="{35221DE0-2889-47DA-832C-E20D32CD98CA}"/>
          </ac:picMkLst>
        </pc:picChg>
        <pc:picChg chg="mod ord">
          <ac:chgData name="Filippo Acconcia" userId="844af49c-a8a0-47ac-a7dd-14a44b60cd18" providerId="ADAL" clId="{998C6BF7-482B-421C-8ECC-9091B23559F6}" dt="2022-05-11T10:14:34.673" v="959" actId="164"/>
          <ac:picMkLst>
            <pc:docMk/>
            <pc:sldMk cId="706034829" sldId="301"/>
            <ac:picMk id="5" creationId="{084C6643-7EFF-FA1A-5440-C283A94AF6A0}"/>
          </ac:picMkLst>
        </pc:picChg>
        <pc:picChg chg="mod">
          <ac:chgData name="Filippo Acconcia" userId="844af49c-a8a0-47ac-a7dd-14a44b60cd18" providerId="ADAL" clId="{998C6BF7-482B-421C-8ECC-9091B23559F6}" dt="2022-05-11T10:20:27.881" v="1029" actId="164"/>
          <ac:picMkLst>
            <pc:docMk/>
            <pc:sldMk cId="706034829" sldId="301"/>
            <ac:picMk id="7" creationId="{8EC5228E-05C1-7BB7-9600-97C1227C9820}"/>
          </ac:picMkLst>
        </pc:picChg>
        <pc:picChg chg="mod">
          <ac:chgData name="Filippo Acconcia" userId="844af49c-a8a0-47ac-a7dd-14a44b60cd18" providerId="ADAL" clId="{998C6BF7-482B-421C-8ECC-9091B23559F6}" dt="2022-05-11T10:20:27.881" v="1029" actId="164"/>
          <ac:picMkLst>
            <pc:docMk/>
            <pc:sldMk cId="706034829" sldId="301"/>
            <ac:picMk id="8" creationId="{05F4D5EA-BB72-0C43-73C7-FDDC3EF9BFF4}"/>
          </ac:picMkLst>
        </pc:picChg>
        <pc:picChg chg="mod">
          <ac:chgData name="Filippo Acconcia" userId="844af49c-a8a0-47ac-a7dd-14a44b60cd18" providerId="ADAL" clId="{998C6BF7-482B-421C-8ECC-9091B23559F6}" dt="2022-05-11T10:20:27.881" v="1029" actId="164"/>
          <ac:picMkLst>
            <pc:docMk/>
            <pc:sldMk cId="706034829" sldId="301"/>
            <ac:picMk id="9" creationId="{358FCCF9-4A40-B321-6FA5-5E76FB4C89B3}"/>
          </ac:picMkLst>
        </pc:picChg>
        <pc:picChg chg="del mod topLvl">
          <ac:chgData name="Filippo Acconcia" userId="844af49c-a8a0-47ac-a7dd-14a44b60cd18" providerId="ADAL" clId="{998C6BF7-482B-421C-8ECC-9091B23559F6}" dt="2022-04-11T15:25:44.256" v="588" actId="478"/>
          <ac:picMkLst>
            <pc:docMk/>
            <pc:sldMk cId="706034829" sldId="301"/>
            <ac:picMk id="141" creationId="{234CDD3E-2525-46F5-B4E4-712F21E5A629}"/>
          </ac:picMkLst>
        </pc:picChg>
        <pc:picChg chg="del mod topLvl">
          <ac:chgData name="Filippo Acconcia" userId="844af49c-a8a0-47ac-a7dd-14a44b60cd18" providerId="ADAL" clId="{998C6BF7-482B-421C-8ECC-9091B23559F6}" dt="2022-05-11T10:14:29.037" v="958" actId="478"/>
          <ac:picMkLst>
            <pc:docMk/>
            <pc:sldMk cId="706034829" sldId="301"/>
            <ac:picMk id="172" creationId="{E4603C42-9EF7-1BF5-DB10-C3E28F8513BE}"/>
          </ac:picMkLst>
        </pc:picChg>
        <pc:picChg chg="del mod topLvl">
          <ac:chgData name="Filippo Acconcia" userId="844af49c-a8a0-47ac-a7dd-14a44b60cd18" providerId="ADAL" clId="{998C6BF7-482B-421C-8ECC-9091B23559F6}" dt="2022-05-11T10:19:45.163" v="997" actId="478"/>
          <ac:picMkLst>
            <pc:docMk/>
            <pc:sldMk cId="706034829" sldId="301"/>
            <ac:picMk id="199" creationId="{2B0DE11C-9BF1-9E30-6D82-4D8EA3858F2F}"/>
          </ac:picMkLst>
        </pc:picChg>
        <pc:picChg chg="mod topLvl">
          <ac:chgData name="Filippo Acconcia" userId="844af49c-a8a0-47ac-a7dd-14a44b60cd18" providerId="ADAL" clId="{998C6BF7-482B-421C-8ECC-9091B23559F6}" dt="2022-05-11T10:20:27.881" v="1029" actId="164"/>
          <ac:picMkLst>
            <pc:docMk/>
            <pc:sldMk cId="706034829" sldId="301"/>
            <ac:picMk id="200" creationId="{A4D254B6-0089-C75B-ED2F-FEB4F9C5E82F}"/>
          </ac:picMkLst>
        </pc:picChg>
        <pc:picChg chg="del mod topLvl">
          <ac:chgData name="Filippo Acconcia" userId="844af49c-a8a0-47ac-a7dd-14a44b60cd18" providerId="ADAL" clId="{998C6BF7-482B-421C-8ECC-9091B23559F6}" dt="2022-05-11T10:19:44.578" v="996" actId="478"/>
          <ac:picMkLst>
            <pc:docMk/>
            <pc:sldMk cId="706034829" sldId="301"/>
            <ac:picMk id="201" creationId="{38D15331-A6A6-44EB-2446-38CEC935A4CE}"/>
          </ac:picMkLst>
        </pc:picChg>
        <pc:picChg chg="mod">
          <ac:chgData name="Filippo Acconcia" userId="844af49c-a8a0-47ac-a7dd-14a44b60cd18" providerId="ADAL" clId="{998C6BF7-482B-421C-8ECC-9091B23559F6}" dt="2022-05-11T10:15:05.809" v="968" actId="165"/>
          <ac:picMkLst>
            <pc:docMk/>
            <pc:sldMk cId="706034829" sldId="301"/>
            <ac:picMk id="239" creationId="{3BA03176-268A-140F-DCF3-F815FF7EC326}"/>
          </ac:picMkLst>
        </pc:picChg>
        <pc:picChg chg="mod">
          <ac:chgData name="Filippo Acconcia" userId="844af49c-a8a0-47ac-a7dd-14a44b60cd18" providerId="ADAL" clId="{998C6BF7-482B-421C-8ECC-9091B23559F6}" dt="2022-05-11T10:15:05.809" v="968" actId="165"/>
          <ac:picMkLst>
            <pc:docMk/>
            <pc:sldMk cId="706034829" sldId="301"/>
            <ac:picMk id="240" creationId="{383F0830-08F9-15B8-640E-489C76102BDE}"/>
          </ac:picMkLst>
        </pc:picChg>
        <pc:picChg chg="mod">
          <ac:chgData name="Filippo Acconcia" userId="844af49c-a8a0-47ac-a7dd-14a44b60cd18" providerId="ADAL" clId="{998C6BF7-482B-421C-8ECC-9091B23559F6}" dt="2022-05-11T10:15:05.809" v="968" actId="165"/>
          <ac:picMkLst>
            <pc:docMk/>
            <pc:sldMk cId="706034829" sldId="301"/>
            <ac:picMk id="241" creationId="{9F56F615-B2A1-6358-D253-AF8151D8C8FA}"/>
          </ac:picMkLst>
        </pc:picChg>
        <pc:picChg chg="mod">
          <ac:chgData name="Filippo Acconcia" userId="844af49c-a8a0-47ac-a7dd-14a44b60cd18" providerId="ADAL" clId="{998C6BF7-482B-421C-8ECC-9091B23559F6}" dt="2022-05-11T10:15:05.809" v="968" actId="165"/>
          <ac:picMkLst>
            <pc:docMk/>
            <pc:sldMk cId="706034829" sldId="301"/>
            <ac:picMk id="259" creationId="{137231F2-CB71-9842-9C7A-9FCC81CDB7E5}"/>
          </ac:picMkLst>
        </pc:picChg>
        <pc:picChg chg="mod">
          <ac:chgData name="Filippo Acconcia" userId="844af49c-a8a0-47ac-a7dd-14a44b60cd18" providerId="ADAL" clId="{998C6BF7-482B-421C-8ECC-9091B23559F6}" dt="2022-05-11T10:15:05.809" v="968" actId="165"/>
          <ac:picMkLst>
            <pc:docMk/>
            <pc:sldMk cId="706034829" sldId="301"/>
            <ac:picMk id="260" creationId="{DE359E22-F333-23E6-C56A-C341614E9908}"/>
          </ac:picMkLst>
        </pc:picChg>
        <pc:picChg chg="mod">
          <ac:chgData name="Filippo Acconcia" userId="844af49c-a8a0-47ac-a7dd-14a44b60cd18" providerId="ADAL" clId="{998C6BF7-482B-421C-8ECC-9091B23559F6}" dt="2022-05-11T10:15:05.809" v="968" actId="165"/>
          <ac:picMkLst>
            <pc:docMk/>
            <pc:sldMk cId="706034829" sldId="301"/>
            <ac:picMk id="273" creationId="{092330EF-14B5-5661-C324-2030424F3FDC}"/>
          </ac:picMkLst>
        </pc:picChg>
        <pc:cxnChg chg="mod topLvl">
          <ac:chgData name="Filippo Acconcia" userId="844af49c-a8a0-47ac-a7dd-14a44b60cd18" providerId="ADAL" clId="{998C6BF7-482B-421C-8ECC-9091B23559F6}" dt="2022-05-11T10:14:34.673" v="959" actId="164"/>
          <ac:cxnSpMkLst>
            <pc:docMk/>
            <pc:sldMk cId="706034829" sldId="301"/>
            <ac:cxnSpMk id="178" creationId="{63E483D7-A459-34C1-3A96-2278CCD42510}"/>
          </ac:cxnSpMkLst>
        </pc:cxnChg>
        <pc:cxnChg chg="mod">
          <ac:chgData name="Filippo Acconcia" userId="844af49c-a8a0-47ac-a7dd-14a44b60cd18" providerId="ADAL" clId="{998C6BF7-482B-421C-8ECC-9091B23559F6}" dt="2022-04-11T15:24:10.763" v="568" actId="165"/>
          <ac:cxnSpMkLst>
            <pc:docMk/>
            <pc:sldMk cId="706034829" sldId="301"/>
            <ac:cxnSpMk id="195" creationId="{EA9C0695-07B3-4406-85A7-6243682B0A52}"/>
          </ac:cxnSpMkLst>
        </pc:cxnChg>
        <pc:cxnChg chg="mod">
          <ac:chgData name="Filippo Acconcia" userId="844af49c-a8a0-47ac-a7dd-14a44b60cd18" providerId="ADAL" clId="{998C6BF7-482B-421C-8ECC-9091B23559F6}" dt="2022-04-11T15:24:10.763" v="568" actId="165"/>
          <ac:cxnSpMkLst>
            <pc:docMk/>
            <pc:sldMk cId="706034829" sldId="301"/>
            <ac:cxnSpMk id="197" creationId="{A9DEE924-0B13-4DD1-BA29-B781ECF5CFED}"/>
          </ac:cxnSpMkLst>
        </pc:cxnChg>
        <pc:cxnChg chg="mod">
          <ac:chgData name="Filippo Acconcia" userId="844af49c-a8a0-47ac-a7dd-14a44b60cd18" providerId="ADAL" clId="{998C6BF7-482B-421C-8ECC-9091B23559F6}" dt="2022-04-11T15:24:10.763" v="568" actId="165"/>
          <ac:cxnSpMkLst>
            <pc:docMk/>
            <pc:sldMk cId="706034829" sldId="301"/>
            <ac:cxnSpMk id="199" creationId="{49A3A927-DD8D-4076-B70D-72B4D330BA2E}"/>
          </ac:cxnSpMkLst>
        </pc:cxnChg>
        <pc:cxnChg chg="mod">
          <ac:chgData name="Filippo Acconcia" userId="844af49c-a8a0-47ac-a7dd-14a44b60cd18" providerId="ADAL" clId="{998C6BF7-482B-421C-8ECC-9091B23559F6}" dt="2022-04-11T15:24:10.763" v="568" actId="165"/>
          <ac:cxnSpMkLst>
            <pc:docMk/>
            <pc:sldMk cId="706034829" sldId="301"/>
            <ac:cxnSpMk id="201" creationId="{B62DB2A8-46C6-4617-957F-FA5EDED6EBC2}"/>
          </ac:cxnSpMkLst>
        </pc:cxnChg>
        <pc:cxnChg chg="mod">
          <ac:chgData name="Filippo Acconcia" userId="844af49c-a8a0-47ac-a7dd-14a44b60cd18" providerId="ADAL" clId="{998C6BF7-482B-421C-8ECC-9091B23559F6}" dt="2022-04-11T15:24:10.763" v="568" actId="165"/>
          <ac:cxnSpMkLst>
            <pc:docMk/>
            <pc:sldMk cId="706034829" sldId="301"/>
            <ac:cxnSpMk id="204" creationId="{586C121C-1C2A-42E3-A7F5-4C9035423A5D}"/>
          </ac:cxnSpMkLst>
        </pc:cxnChg>
        <pc:cxnChg chg="mod">
          <ac:chgData name="Filippo Acconcia" userId="844af49c-a8a0-47ac-a7dd-14a44b60cd18" providerId="ADAL" clId="{998C6BF7-482B-421C-8ECC-9091B23559F6}" dt="2022-04-11T15:24:10.763" v="568" actId="165"/>
          <ac:cxnSpMkLst>
            <pc:docMk/>
            <pc:sldMk cId="706034829" sldId="301"/>
            <ac:cxnSpMk id="210" creationId="{9001DEB7-6AF2-4471-8A6C-18D42FD2A340}"/>
          </ac:cxnSpMkLst>
        </pc:cxnChg>
        <pc:cxnChg chg="mod">
          <ac:chgData name="Filippo Acconcia" userId="844af49c-a8a0-47ac-a7dd-14a44b60cd18" providerId="ADAL" clId="{998C6BF7-482B-421C-8ECC-9091B23559F6}" dt="2022-04-11T15:24:10.763" v="568" actId="165"/>
          <ac:cxnSpMkLst>
            <pc:docMk/>
            <pc:sldMk cId="706034829" sldId="301"/>
            <ac:cxnSpMk id="212" creationId="{0F0BF936-69A8-4241-B220-136D5B0EBBAC}"/>
          </ac:cxnSpMkLst>
        </pc:cxnChg>
        <pc:cxnChg chg="del mod topLvl">
          <ac:chgData name="Filippo Acconcia" userId="844af49c-a8a0-47ac-a7dd-14a44b60cd18" providerId="ADAL" clId="{998C6BF7-482B-421C-8ECC-9091B23559F6}" dt="2022-04-11T15:27:50.057" v="643" actId="478"/>
          <ac:cxnSpMkLst>
            <pc:docMk/>
            <pc:sldMk cId="706034829" sldId="301"/>
            <ac:cxnSpMk id="214" creationId="{5502040A-11E1-4EF8-B94E-D16F1C2AF3BF}"/>
          </ac:cxnSpMkLst>
        </pc:cxnChg>
        <pc:cxnChg chg="mod topLvl">
          <ac:chgData name="Filippo Acconcia" userId="844af49c-a8a0-47ac-a7dd-14a44b60cd18" providerId="ADAL" clId="{998C6BF7-482B-421C-8ECC-9091B23559F6}" dt="2022-05-11T10:20:27.881" v="1029" actId="164"/>
          <ac:cxnSpMkLst>
            <pc:docMk/>
            <pc:sldMk cId="706034829" sldId="301"/>
            <ac:cxnSpMk id="224" creationId="{0F271A20-82C8-2D7C-1D0E-F89918417A8B}"/>
          </ac:cxnSpMkLst>
        </pc:cxnChg>
      </pc:sldChg>
      <pc:sldChg chg="modSp mod">
        <pc:chgData name="Filippo Acconcia" userId="844af49c-a8a0-47ac-a7dd-14a44b60cd18" providerId="ADAL" clId="{998C6BF7-482B-421C-8ECC-9091B23559F6}" dt="2022-06-10T17:13:29.738" v="1161" actId="1038"/>
        <pc:sldMkLst>
          <pc:docMk/>
          <pc:sldMk cId="2307067035" sldId="302"/>
        </pc:sldMkLst>
        <pc:spChg chg="mod">
          <ac:chgData name="Filippo Acconcia" userId="844af49c-a8a0-47ac-a7dd-14a44b60cd18" providerId="ADAL" clId="{998C6BF7-482B-421C-8ECC-9091B23559F6}" dt="2022-05-07T06:24:40.625" v="723" actId="20577"/>
          <ac:spMkLst>
            <pc:docMk/>
            <pc:sldMk cId="2307067035" sldId="302"/>
            <ac:spMk id="2" creationId="{B14641C2-1A37-4311-BD94-1DD69E890193}"/>
          </ac:spMkLst>
        </pc:spChg>
        <pc:spChg chg="mod">
          <ac:chgData name="Filippo Acconcia" userId="844af49c-a8a0-47ac-a7dd-14a44b60cd18" providerId="ADAL" clId="{998C6BF7-482B-421C-8ECC-9091B23559F6}" dt="2022-06-10T17:10:35.678" v="1134" actId="1038"/>
          <ac:spMkLst>
            <pc:docMk/>
            <pc:sldMk cId="2307067035" sldId="302"/>
            <ac:spMk id="42" creationId="{CDA0F690-446A-461A-A36F-0853C07E3FB0}"/>
          </ac:spMkLst>
        </pc:spChg>
        <pc:spChg chg="mod">
          <ac:chgData name="Filippo Acconcia" userId="844af49c-a8a0-47ac-a7dd-14a44b60cd18" providerId="ADAL" clId="{998C6BF7-482B-421C-8ECC-9091B23559F6}" dt="2022-06-10T17:10:30.885" v="1128" actId="1038"/>
          <ac:spMkLst>
            <pc:docMk/>
            <pc:sldMk cId="2307067035" sldId="302"/>
            <ac:spMk id="43" creationId="{0DDCE2B3-EDC0-4BDA-9313-E79B3D9C10BA}"/>
          </ac:spMkLst>
        </pc:spChg>
        <pc:spChg chg="mod">
          <ac:chgData name="Filippo Acconcia" userId="844af49c-a8a0-47ac-a7dd-14a44b60cd18" providerId="ADAL" clId="{998C6BF7-482B-421C-8ECC-9091B23559F6}" dt="2022-06-10T17:10:41.001" v="1141" actId="1038"/>
          <ac:spMkLst>
            <pc:docMk/>
            <pc:sldMk cId="2307067035" sldId="302"/>
            <ac:spMk id="44" creationId="{943BE0FA-209A-4CE9-A4E9-041A9FF2F32E}"/>
          </ac:spMkLst>
        </pc:spChg>
        <pc:spChg chg="mod">
          <ac:chgData name="Filippo Acconcia" userId="844af49c-a8a0-47ac-a7dd-14a44b60cd18" providerId="ADAL" clId="{998C6BF7-482B-421C-8ECC-9091B23559F6}" dt="2022-06-10T17:13:23.287" v="1158" actId="1037"/>
          <ac:spMkLst>
            <pc:docMk/>
            <pc:sldMk cId="2307067035" sldId="302"/>
            <ac:spMk id="57" creationId="{286ECD8B-3C9D-4753-B7AF-FF35070ED12E}"/>
          </ac:spMkLst>
        </pc:spChg>
        <pc:spChg chg="mod">
          <ac:chgData name="Filippo Acconcia" userId="844af49c-a8a0-47ac-a7dd-14a44b60cd18" providerId="ADAL" clId="{998C6BF7-482B-421C-8ECC-9091B23559F6}" dt="2022-06-10T17:13:17.730" v="1153" actId="20577"/>
          <ac:spMkLst>
            <pc:docMk/>
            <pc:sldMk cId="2307067035" sldId="302"/>
            <ac:spMk id="58" creationId="{0CA6824A-E1A8-4854-B5CC-5881153B4511}"/>
          </ac:spMkLst>
        </pc:spChg>
        <pc:spChg chg="mod">
          <ac:chgData name="Filippo Acconcia" userId="844af49c-a8a0-47ac-a7dd-14a44b60cd18" providerId="ADAL" clId="{998C6BF7-482B-421C-8ECC-9091B23559F6}" dt="2022-06-10T17:13:29.738" v="1161" actId="1038"/>
          <ac:spMkLst>
            <pc:docMk/>
            <pc:sldMk cId="2307067035" sldId="302"/>
            <ac:spMk id="59" creationId="{67E23C50-C0BC-4881-82F1-0463765E3F0C}"/>
          </ac:spMkLst>
        </pc:spChg>
      </pc:sldChg>
      <pc:sldChg chg="modSp mod ord">
        <pc:chgData name="Filippo Acconcia" userId="844af49c-a8a0-47ac-a7dd-14a44b60cd18" providerId="ADAL" clId="{998C6BF7-482B-421C-8ECC-9091B23559F6}" dt="2022-05-07T06:08:15.669" v="683" actId="20577"/>
        <pc:sldMkLst>
          <pc:docMk/>
          <pc:sldMk cId="2248971367" sldId="303"/>
        </pc:sldMkLst>
        <pc:spChg chg="mod">
          <ac:chgData name="Filippo Acconcia" userId="844af49c-a8a0-47ac-a7dd-14a44b60cd18" providerId="ADAL" clId="{998C6BF7-482B-421C-8ECC-9091B23559F6}" dt="2022-05-07T06:08:15.669" v="683" actId="20577"/>
          <ac:spMkLst>
            <pc:docMk/>
            <pc:sldMk cId="2248971367" sldId="303"/>
            <ac:spMk id="53" creationId="{066D7556-77C7-44D9-BFDD-1EA1FF5DA3DB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>
            <a:extLst>
              <a:ext uri="{FF2B5EF4-FFF2-40B4-BE49-F238E27FC236}">
                <a16:creationId xmlns:a16="http://schemas.microsoft.com/office/drawing/2014/main" id="{3021E025-0A0C-48B1-8E0F-284826AC1F7A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AAD1D041-419B-4C71-976A-1EB4D9DD3D2E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D616DD4C-8BBB-49EC-A3AB-1185B6705009}" type="datetimeFigureOut">
              <a:rPr lang="it-IT"/>
              <a:pPr>
                <a:defRPr/>
              </a:pPr>
              <a:t>03/08/2022</a:t>
            </a:fld>
            <a:endParaRPr lang="it-IT"/>
          </a:p>
        </p:txBody>
      </p:sp>
      <p:sp>
        <p:nvSpPr>
          <p:cNvPr id="4" name="Segnaposto immagine diapositiva 3">
            <a:extLst>
              <a:ext uri="{FF2B5EF4-FFF2-40B4-BE49-F238E27FC236}">
                <a16:creationId xmlns:a16="http://schemas.microsoft.com/office/drawing/2014/main" id="{181F25FA-92D7-42AA-9C47-5338B3E177A6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it-IT" noProof="0"/>
          </a:p>
        </p:txBody>
      </p:sp>
      <p:sp>
        <p:nvSpPr>
          <p:cNvPr id="5" name="Segnaposto note 4">
            <a:extLst>
              <a:ext uri="{FF2B5EF4-FFF2-40B4-BE49-F238E27FC236}">
                <a16:creationId xmlns:a16="http://schemas.microsoft.com/office/drawing/2014/main" id="{D253DCF8-DC00-4CCA-9F21-635E20B52A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noProof="0"/>
              <a:t>Fare clic per modificare stili del testo dello schema</a:t>
            </a:r>
          </a:p>
          <a:p>
            <a:pPr lvl="1"/>
            <a:r>
              <a:rPr lang="it-IT" noProof="0"/>
              <a:t>Secondo livello</a:t>
            </a:r>
          </a:p>
          <a:p>
            <a:pPr lvl="2"/>
            <a:r>
              <a:rPr lang="it-IT" noProof="0"/>
              <a:t>Terzo livello</a:t>
            </a:r>
          </a:p>
          <a:p>
            <a:pPr lvl="3"/>
            <a:r>
              <a:rPr lang="it-IT" noProof="0"/>
              <a:t>Quarto livello</a:t>
            </a:r>
          </a:p>
          <a:p>
            <a:pPr lvl="4"/>
            <a:r>
              <a:rPr lang="it-IT" noProof="0"/>
              <a:t>Quinto livello</a:t>
            </a:r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C663B98-C022-4041-A89C-ADAC415DE94B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3C8DE6C-8A0F-4705-92AC-76234166F35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8475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9FE68639-4BBA-40F2-9C3B-4084CA34D622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D9514660-86CD-45DB-AE8B-5936BAE4F4DD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1561FFAD-9379-43FC-8B78-5BE4691C3106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E65D37CF-48F9-4387-BE7B-8D8E8E515780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905632C-C3F3-40E4-891C-4DC6F92A814C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3495887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6946567F-0E2E-4B5C-958A-3D53B5833585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D3E5FFC9-0B25-4466-9999-63B214776542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2EF991A3-A697-4C39-A6E6-8354B3B3FE82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994CCE1-A803-48EA-BFEE-3D7A5711F6E5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693924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AE9F3A0E-DFA2-414F-AACC-C757146D0155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59F83E6D-FD47-4333-9BB4-C2B2D047A1E5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59936280-C49D-4499-9FFE-C0454B0286BA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3FE9A32-FE2A-4B66-8D75-A677DFC6383A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2715064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2A29C7EE-9B73-4F54-BBF8-C0FCDADCAC29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CA952E95-410A-48E8-896C-C93ADE225EF7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2FF7DBB3-CC8C-4E74-B25F-23BEC850F3ED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8227B1C-6EA9-4CD5-B734-4F445F381245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2848185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3E0F3FD4-97DC-4B24-868F-4403FB4296D5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03B1F413-F51B-456A-9C65-206961954B58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EA4CF9C0-DB95-4226-BB0B-D9E351636CF0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A725DB-3DF0-4651-B7BB-BBA5C8B96229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1175608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F2CD04F2-D219-4F1C-80F6-C60A38DE0A5D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BE2A8EBF-9C18-45C9-898C-BB9C6F4980CA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041DDE6E-7044-4DEF-B417-ED24CFE1E51A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3D94E8F-0893-4B89-A039-83D6207FA328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35484747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Rectangle 4">
            <a:extLst>
              <a:ext uri="{FF2B5EF4-FFF2-40B4-BE49-F238E27FC236}">
                <a16:creationId xmlns:a16="http://schemas.microsoft.com/office/drawing/2014/main" id="{1D52F4CB-6E78-4124-A8BC-4B727BA671E3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8" name="Rectangle 5">
            <a:extLst>
              <a:ext uri="{FF2B5EF4-FFF2-40B4-BE49-F238E27FC236}">
                <a16:creationId xmlns:a16="http://schemas.microsoft.com/office/drawing/2014/main" id="{E93D6CB8-A271-4419-99EF-111E8414FE16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0365CF9C-13E7-4EF5-993B-DDEE96F4D66B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B7DC509-43C6-42C8-8B00-7FC1D3BBAAF1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2070500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B549663A-ED8E-47D3-9994-4EEFB2A162B5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DD9171D5-9A3F-4700-B673-A340A1ED03D5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69091EDA-4D73-4D4F-8B8A-73230ADDA966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B21F5FC-7CD5-4C74-B005-AC914435E9B5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18703317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>
            <a:extLst>
              <a:ext uri="{FF2B5EF4-FFF2-40B4-BE49-F238E27FC236}">
                <a16:creationId xmlns:a16="http://schemas.microsoft.com/office/drawing/2014/main" id="{DA164BC1-5526-41A8-9B70-6F5D8D27314C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3" name="Rectangle 5">
            <a:extLst>
              <a:ext uri="{FF2B5EF4-FFF2-40B4-BE49-F238E27FC236}">
                <a16:creationId xmlns:a16="http://schemas.microsoft.com/office/drawing/2014/main" id="{40EE2281-3A74-4E0E-8AD9-6CBA9BB6158E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4" name="Rectangle 6">
            <a:extLst>
              <a:ext uri="{FF2B5EF4-FFF2-40B4-BE49-F238E27FC236}">
                <a16:creationId xmlns:a16="http://schemas.microsoft.com/office/drawing/2014/main" id="{64654261-B3DA-4AC5-8612-2C8A45C3BA2F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8DBB4F-6C17-46DF-AC1F-34A58AE0D79A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509790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017F993-B2FD-4B42-976B-BB9A6B7814D9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490F29C-94BE-4CA0-BADF-B3FB5A11C56B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D7BD6B2-B19A-4C8A-AEDF-75A67352B30D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2D5634-6A9B-4AD9-9E89-39A494A56E90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17161804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E4507C6C-8193-43E9-B046-32D9A06F730B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D9996A1-173E-42B1-9422-1D0A6CE95D5F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CB81C91-7131-46FE-B01D-F4B79EE15A18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3EA1B89-A8B4-44B5-B159-1D3CD701084F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6466334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>
            <a:extLst>
              <a:ext uri="{FF2B5EF4-FFF2-40B4-BE49-F238E27FC236}">
                <a16:creationId xmlns:a16="http://schemas.microsoft.com/office/drawing/2014/main" id="{6A8808E6-C826-4A67-94F4-C5574BC7716A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altLang="en-US"/>
              <a:t>Click to edit Master title style</a:t>
            </a:r>
          </a:p>
        </p:txBody>
      </p:sp>
      <p:sp>
        <p:nvSpPr>
          <p:cNvPr id="1027" name="Rectangle 3">
            <a:extLst>
              <a:ext uri="{FF2B5EF4-FFF2-40B4-BE49-F238E27FC236}">
                <a16:creationId xmlns:a16="http://schemas.microsoft.com/office/drawing/2014/main" id="{E73F13FC-927E-4931-9B85-E5FB1205E753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altLang="en-US"/>
              <a:t>Click to edit Master text styles</a:t>
            </a:r>
          </a:p>
          <a:p>
            <a:pPr lvl="1"/>
            <a:r>
              <a:rPr lang="it-IT" altLang="en-US"/>
              <a:t>Second level</a:t>
            </a:r>
          </a:p>
          <a:p>
            <a:pPr lvl="2"/>
            <a:r>
              <a:rPr lang="it-IT" altLang="en-US"/>
              <a:t>Third level</a:t>
            </a:r>
          </a:p>
          <a:p>
            <a:pPr lvl="3"/>
            <a:r>
              <a:rPr lang="it-IT" altLang="en-US"/>
              <a:t>Fourth level</a:t>
            </a:r>
          </a:p>
          <a:p>
            <a:pPr lvl="4"/>
            <a:r>
              <a:rPr lang="it-IT" altLang="en-US"/>
              <a:t>Fifth level</a:t>
            </a:r>
          </a:p>
        </p:txBody>
      </p:sp>
      <p:sp>
        <p:nvSpPr>
          <p:cNvPr id="1028" name="Rectangle 4">
            <a:extLst>
              <a:ext uri="{FF2B5EF4-FFF2-40B4-BE49-F238E27FC236}">
                <a16:creationId xmlns:a16="http://schemas.microsoft.com/office/drawing/2014/main" id="{C5DCBBBD-636D-4787-976F-47E1021DA95E}"/>
              </a:ext>
            </a:extLst>
          </p:cNvPr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1029" name="Rectangle 5">
            <a:extLst>
              <a:ext uri="{FF2B5EF4-FFF2-40B4-BE49-F238E27FC236}">
                <a16:creationId xmlns:a16="http://schemas.microsoft.com/office/drawing/2014/main" id="{9B981123-E30F-4283-BC00-9D52238C8899}"/>
              </a:ext>
            </a:extLst>
          </p:cNvPr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1030" name="Rectangle 6">
            <a:extLst>
              <a:ext uri="{FF2B5EF4-FFF2-40B4-BE49-F238E27FC236}">
                <a16:creationId xmlns:a16="http://schemas.microsoft.com/office/drawing/2014/main" id="{613F572F-7760-4F0B-A0FC-0581F94A2778}"/>
              </a:ext>
            </a:extLst>
          </p:cNvPr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9FE7A969-CF52-4352-B69C-73B19C67AF77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microsoft.com/office/2007/relationships/hdphoto" Target="../media/hdphoto4.wdp"/><Relationship Id="rId3" Type="http://schemas.openxmlformats.org/officeDocument/2006/relationships/image" Target="../media/image2.png"/><Relationship Id="rId7" Type="http://schemas.microsoft.com/office/2007/relationships/hdphoto" Target="../media/hdphoto1.wdp"/><Relationship Id="rId12" Type="http://schemas.openxmlformats.org/officeDocument/2006/relationships/image" Target="../media/image8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microsoft.com/office/2007/relationships/hdphoto" Target="../media/hdphoto3.wdp"/><Relationship Id="rId5" Type="http://schemas.openxmlformats.org/officeDocument/2006/relationships/image" Target="../media/image4.png"/><Relationship Id="rId15" Type="http://schemas.microsoft.com/office/2007/relationships/hdphoto" Target="../media/hdphoto5.wdp"/><Relationship Id="rId10" Type="http://schemas.openxmlformats.org/officeDocument/2006/relationships/image" Target="../media/image7.png"/><Relationship Id="rId4" Type="http://schemas.openxmlformats.org/officeDocument/2006/relationships/image" Target="../media/image3.png"/><Relationship Id="rId9" Type="http://schemas.microsoft.com/office/2007/relationships/hdphoto" Target="../media/hdphoto2.wdp"/><Relationship Id="rId14" Type="http://schemas.openxmlformats.org/officeDocument/2006/relationships/image" Target="../media/image9.png"/></Relationships>
</file>

<file path=ppt/slides/_rels/slide2.xml.rels><?xml version="1.0" encoding="UTF-8" standalone="yes"?>
<Relationships xmlns="http://schemas.openxmlformats.org/package/2006/relationships"><Relationship Id="rId13" Type="http://schemas.microsoft.com/office/2007/relationships/hdphoto" Target="../media/hdphoto11.wdp"/><Relationship Id="rId18" Type="http://schemas.openxmlformats.org/officeDocument/2006/relationships/image" Target="../media/image18.png"/><Relationship Id="rId26" Type="http://schemas.microsoft.com/office/2007/relationships/hdphoto" Target="../media/hdphoto17.wdp"/><Relationship Id="rId3" Type="http://schemas.microsoft.com/office/2007/relationships/hdphoto" Target="../media/hdphoto6.wdp"/><Relationship Id="rId21" Type="http://schemas.openxmlformats.org/officeDocument/2006/relationships/image" Target="../media/image20.png"/><Relationship Id="rId34" Type="http://schemas.openxmlformats.org/officeDocument/2006/relationships/image" Target="../media/image28.png"/><Relationship Id="rId7" Type="http://schemas.microsoft.com/office/2007/relationships/hdphoto" Target="../media/hdphoto8.wdp"/><Relationship Id="rId12" Type="http://schemas.openxmlformats.org/officeDocument/2006/relationships/image" Target="../media/image15.png"/><Relationship Id="rId17" Type="http://schemas.microsoft.com/office/2007/relationships/hdphoto" Target="../media/hdphoto13.wdp"/><Relationship Id="rId25" Type="http://schemas.openxmlformats.org/officeDocument/2006/relationships/image" Target="../media/image22.png"/><Relationship Id="rId33" Type="http://schemas.openxmlformats.org/officeDocument/2006/relationships/image" Target="../media/image27.png"/><Relationship Id="rId2" Type="http://schemas.openxmlformats.org/officeDocument/2006/relationships/image" Target="../media/image10.png"/><Relationship Id="rId16" Type="http://schemas.openxmlformats.org/officeDocument/2006/relationships/image" Target="../media/image17.png"/><Relationship Id="rId20" Type="http://schemas.openxmlformats.org/officeDocument/2006/relationships/image" Target="../media/image19.png"/><Relationship Id="rId29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11" Type="http://schemas.microsoft.com/office/2007/relationships/hdphoto" Target="../media/hdphoto10.wdp"/><Relationship Id="rId24" Type="http://schemas.microsoft.com/office/2007/relationships/hdphoto" Target="../media/hdphoto16.wdp"/><Relationship Id="rId32" Type="http://schemas.openxmlformats.org/officeDocument/2006/relationships/image" Target="../media/image26.png"/><Relationship Id="rId5" Type="http://schemas.microsoft.com/office/2007/relationships/hdphoto" Target="../media/hdphoto7.wdp"/><Relationship Id="rId15" Type="http://schemas.microsoft.com/office/2007/relationships/hdphoto" Target="../media/hdphoto12.wdp"/><Relationship Id="rId23" Type="http://schemas.openxmlformats.org/officeDocument/2006/relationships/image" Target="../media/image21.png"/><Relationship Id="rId28" Type="http://schemas.microsoft.com/office/2007/relationships/hdphoto" Target="../media/hdphoto18.wdp"/><Relationship Id="rId36" Type="http://schemas.openxmlformats.org/officeDocument/2006/relationships/image" Target="../media/image30.png"/><Relationship Id="rId10" Type="http://schemas.openxmlformats.org/officeDocument/2006/relationships/image" Target="../media/image14.png"/><Relationship Id="rId19" Type="http://schemas.microsoft.com/office/2007/relationships/hdphoto" Target="../media/hdphoto14.wdp"/><Relationship Id="rId31" Type="http://schemas.openxmlformats.org/officeDocument/2006/relationships/image" Target="../media/image25.png"/><Relationship Id="rId4" Type="http://schemas.openxmlformats.org/officeDocument/2006/relationships/image" Target="../media/image11.png"/><Relationship Id="rId9" Type="http://schemas.microsoft.com/office/2007/relationships/hdphoto" Target="../media/hdphoto9.wdp"/><Relationship Id="rId14" Type="http://schemas.openxmlformats.org/officeDocument/2006/relationships/image" Target="../media/image16.png"/><Relationship Id="rId22" Type="http://schemas.microsoft.com/office/2007/relationships/hdphoto" Target="../media/hdphoto15.wdp"/><Relationship Id="rId27" Type="http://schemas.openxmlformats.org/officeDocument/2006/relationships/image" Target="../media/image23.png"/><Relationship Id="rId30" Type="http://schemas.microsoft.com/office/2007/relationships/hdphoto" Target="../media/hdphoto19.wdp"/><Relationship Id="rId35" Type="http://schemas.openxmlformats.org/officeDocument/2006/relationships/image" Target="../media/image29.png"/><Relationship Id="rId8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13" Type="http://schemas.microsoft.com/office/2007/relationships/hdphoto" Target="../media/hdphoto22.wdp"/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12" Type="http://schemas.openxmlformats.org/officeDocument/2006/relationships/image" Target="../media/image39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11" Type="http://schemas.microsoft.com/office/2007/relationships/hdphoto" Target="../media/hdphoto21.wdp"/><Relationship Id="rId5" Type="http://schemas.openxmlformats.org/officeDocument/2006/relationships/image" Target="../media/image34.png"/><Relationship Id="rId15" Type="http://schemas.microsoft.com/office/2007/relationships/hdphoto" Target="../media/hdphoto23.wdp"/><Relationship Id="rId10" Type="http://schemas.openxmlformats.org/officeDocument/2006/relationships/image" Target="../media/image38.png"/><Relationship Id="rId4" Type="http://schemas.openxmlformats.org/officeDocument/2006/relationships/image" Target="../media/image33.png"/><Relationship Id="rId9" Type="http://schemas.microsoft.com/office/2007/relationships/hdphoto" Target="../media/hdphoto20.wdp"/><Relationship Id="rId14" Type="http://schemas.openxmlformats.org/officeDocument/2006/relationships/image" Target="../media/image40.png"/></Relationships>
</file>

<file path=ppt/slides/_rels/slide4.xml.rels><?xml version="1.0" encoding="UTF-8" standalone="yes"?>
<Relationships xmlns="http://schemas.openxmlformats.org/package/2006/relationships"><Relationship Id="rId13" Type="http://schemas.microsoft.com/office/2007/relationships/hdphoto" Target="../media/hdphoto28.wdp"/><Relationship Id="rId18" Type="http://schemas.openxmlformats.org/officeDocument/2006/relationships/image" Target="../media/image50.png"/><Relationship Id="rId26" Type="http://schemas.openxmlformats.org/officeDocument/2006/relationships/image" Target="../media/image54.png"/><Relationship Id="rId39" Type="http://schemas.microsoft.com/office/2007/relationships/hdphoto" Target="../media/hdphoto41.wdp"/><Relationship Id="rId21" Type="http://schemas.microsoft.com/office/2007/relationships/hdphoto" Target="../media/hdphoto32.wdp"/><Relationship Id="rId34" Type="http://schemas.openxmlformats.org/officeDocument/2006/relationships/image" Target="../media/image58.png"/><Relationship Id="rId42" Type="http://schemas.openxmlformats.org/officeDocument/2006/relationships/image" Target="../media/image62.png"/><Relationship Id="rId7" Type="http://schemas.openxmlformats.org/officeDocument/2006/relationships/image" Target="../media/image44.png"/><Relationship Id="rId2" Type="http://schemas.openxmlformats.org/officeDocument/2006/relationships/image" Target="../media/image41.png"/><Relationship Id="rId16" Type="http://schemas.openxmlformats.org/officeDocument/2006/relationships/image" Target="../media/image49.png"/><Relationship Id="rId29" Type="http://schemas.microsoft.com/office/2007/relationships/hdphoto" Target="../media/hdphoto36.wdp"/><Relationship Id="rId1" Type="http://schemas.openxmlformats.org/officeDocument/2006/relationships/slideLayout" Target="../slideLayouts/slideLayout7.xml"/><Relationship Id="rId6" Type="http://schemas.microsoft.com/office/2007/relationships/hdphoto" Target="../media/hdphoto25.wdp"/><Relationship Id="rId11" Type="http://schemas.microsoft.com/office/2007/relationships/hdphoto" Target="../media/hdphoto27.wdp"/><Relationship Id="rId24" Type="http://schemas.openxmlformats.org/officeDocument/2006/relationships/image" Target="../media/image53.png"/><Relationship Id="rId32" Type="http://schemas.openxmlformats.org/officeDocument/2006/relationships/image" Target="../media/image57.png"/><Relationship Id="rId37" Type="http://schemas.microsoft.com/office/2007/relationships/hdphoto" Target="../media/hdphoto40.wdp"/><Relationship Id="rId40" Type="http://schemas.openxmlformats.org/officeDocument/2006/relationships/image" Target="../media/image61.png"/><Relationship Id="rId45" Type="http://schemas.openxmlformats.org/officeDocument/2006/relationships/image" Target="../media/image64.png"/><Relationship Id="rId5" Type="http://schemas.openxmlformats.org/officeDocument/2006/relationships/image" Target="../media/image43.png"/><Relationship Id="rId15" Type="http://schemas.microsoft.com/office/2007/relationships/hdphoto" Target="../media/hdphoto29.wdp"/><Relationship Id="rId23" Type="http://schemas.microsoft.com/office/2007/relationships/hdphoto" Target="../media/hdphoto33.wdp"/><Relationship Id="rId28" Type="http://schemas.openxmlformats.org/officeDocument/2006/relationships/image" Target="../media/image55.png"/><Relationship Id="rId36" Type="http://schemas.openxmlformats.org/officeDocument/2006/relationships/image" Target="../media/image59.png"/><Relationship Id="rId10" Type="http://schemas.openxmlformats.org/officeDocument/2006/relationships/image" Target="../media/image46.png"/><Relationship Id="rId19" Type="http://schemas.microsoft.com/office/2007/relationships/hdphoto" Target="../media/hdphoto31.wdp"/><Relationship Id="rId31" Type="http://schemas.microsoft.com/office/2007/relationships/hdphoto" Target="../media/hdphoto37.wdp"/><Relationship Id="rId44" Type="http://schemas.openxmlformats.org/officeDocument/2006/relationships/image" Target="../media/image63.png"/><Relationship Id="rId4" Type="http://schemas.microsoft.com/office/2007/relationships/hdphoto" Target="../media/hdphoto24.wdp"/><Relationship Id="rId9" Type="http://schemas.microsoft.com/office/2007/relationships/hdphoto" Target="../media/hdphoto26.wdp"/><Relationship Id="rId14" Type="http://schemas.openxmlformats.org/officeDocument/2006/relationships/image" Target="../media/image48.png"/><Relationship Id="rId22" Type="http://schemas.openxmlformats.org/officeDocument/2006/relationships/image" Target="../media/image52.png"/><Relationship Id="rId27" Type="http://schemas.microsoft.com/office/2007/relationships/hdphoto" Target="../media/hdphoto35.wdp"/><Relationship Id="rId30" Type="http://schemas.openxmlformats.org/officeDocument/2006/relationships/image" Target="../media/image56.png"/><Relationship Id="rId35" Type="http://schemas.microsoft.com/office/2007/relationships/hdphoto" Target="../media/hdphoto39.wdp"/><Relationship Id="rId43" Type="http://schemas.microsoft.com/office/2007/relationships/hdphoto" Target="../media/hdphoto43.wdp"/><Relationship Id="rId8" Type="http://schemas.openxmlformats.org/officeDocument/2006/relationships/image" Target="../media/image45.png"/><Relationship Id="rId3" Type="http://schemas.openxmlformats.org/officeDocument/2006/relationships/image" Target="../media/image42.png"/><Relationship Id="rId12" Type="http://schemas.openxmlformats.org/officeDocument/2006/relationships/image" Target="../media/image47.png"/><Relationship Id="rId17" Type="http://schemas.microsoft.com/office/2007/relationships/hdphoto" Target="../media/hdphoto30.wdp"/><Relationship Id="rId25" Type="http://schemas.microsoft.com/office/2007/relationships/hdphoto" Target="../media/hdphoto34.wdp"/><Relationship Id="rId33" Type="http://schemas.microsoft.com/office/2007/relationships/hdphoto" Target="../media/hdphoto38.wdp"/><Relationship Id="rId38" Type="http://schemas.openxmlformats.org/officeDocument/2006/relationships/image" Target="../media/image60.png"/><Relationship Id="rId46" Type="http://schemas.openxmlformats.org/officeDocument/2006/relationships/image" Target="../media/image65.png"/><Relationship Id="rId20" Type="http://schemas.openxmlformats.org/officeDocument/2006/relationships/image" Target="../media/image51.png"/><Relationship Id="rId41" Type="http://schemas.microsoft.com/office/2007/relationships/hdphoto" Target="../media/hdphoto42.wdp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png"/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9.png"/><Relationship Id="rId4" Type="http://schemas.openxmlformats.org/officeDocument/2006/relationships/image" Target="../media/image68.png"/></Relationships>
</file>

<file path=ppt/slides/_rels/slide6.xml.rels><?xml version="1.0" encoding="UTF-8" standalone="yes"?>
<Relationships xmlns="http://schemas.openxmlformats.org/package/2006/relationships"><Relationship Id="rId13" Type="http://schemas.microsoft.com/office/2007/relationships/hdphoto" Target="../media/hdphoto49.wdp"/><Relationship Id="rId18" Type="http://schemas.openxmlformats.org/officeDocument/2006/relationships/image" Target="../media/image78.png"/><Relationship Id="rId26" Type="http://schemas.openxmlformats.org/officeDocument/2006/relationships/image" Target="../media/image82.png"/><Relationship Id="rId3" Type="http://schemas.microsoft.com/office/2007/relationships/hdphoto" Target="../media/hdphoto44.wdp"/><Relationship Id="rId21" Type="http://schemas.microsoft.com/office/2007/relationships/hdphoto" Target="../media/hdphoto53.wdp"/><Relationship Id="rId34" Type="http://schemas.openxmlformats.org/officeDocument/2006/relationships/image" Target="../media/image87.png"/><Relationship Id="rId7" Type="http://schemas.microsoft.com/office/2007/relationships/hdphoto" Target="../media/hdphoto46.wdp"/><Relationship Id="rId12" Type="http://schemas.openxmlformats.org/officeDocument/2006/relationships/image" Target="../media/image75.png"/><Relationship Id="rId17" Type="http://schemas.microsoft.com/office/2007/relationships/hdphoto" Target="../media/hdphoto51.wdp"/><Relationship Id="rId25" Type="http://schemas.microsoft.com/office/2007/relationships/hdphoto" Target="../media/hdphoto55.wdp"/><Relationship Id="rId33" Type="http://schemas.openxmlformats.org/officeDocument/2006/relationships/image" Target="../media/image86.png"/><Relationship Id="rId2" Type="http://schemas.openxmlformats.org/officeDocument/2006/relationships/image" Target="../media/image70.png"/><Relationship Id="rId16" Type="http://schemas.openxmlformats.org/officeDocument/2006/relationships/image" Target="../media/image77.png"/><Relationship Id="rId20" Type="http://schemas.openxmlformats.org/officeDocument/2006/relationships/image" Target="../media/image79.png"/><Relationship Id="rId29" Type="http://schemas.microsoft.com/office/2007/relationships/hdphoto" Target="../media/hdphoto57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2.png"/><Relationship Id="rId11" Type="http://schemas.microsoft.com/office/2007/relationships/hdphoto" Target="../media/hdphoto48.wdp"/><Relationship Id="rId24" Type="http://schemas.openxmlformats.org/officeDocument/2006/relationships/image" Target="../media/image81.png"/><Relationship Id="rId32" Type="http://schemas.openxmlformats.org/officeDocument/2006/relationships/image" Target="../media/image85.png"/><Relationship Id="rId5" Type="http://schemas.microsoft.com/office/2007/relationships/hdphoto" Target="../media/hdphoto45.wdp"/><Relationship Id="rId15" Type="http://schemas.microsoft.com/office/2007/relationships/hdphoto" Target="../media/hdphoto50.wdp"/><Relationship Id="rId23" Type="http://schemas.microsoft.com/office/2007/relationships/hdphoto" Target="../media/hdphoto54.wdp"/><Relationship Id="rId28" Type="http://schemas.openxmlformats.org/officeDocument/2006/relationships/image" Target="../media/image83.png"/><Relationship Id="rId36" Type="http://schemas.openxmlformats.org/officeDocument/2006/relationships/image" Target="../media/image89.png"/><Relationship Id="rId10" Type="http://schemas.openxmlformats.org/officeDocument/2006/relationships/image" Target="../media/image74.png"/><Relationship Id="rId19" Type="http://schemas.microsoft.com/office/2007/relationships/hdphoto" Target="../media/hdphoto52.wdp"/><Relationship Id="rId31" Type="http://schemas.microsoft.com/office/2007/relationships/hdphoto" Target="../media/hdphoto58.wdp"/><Relationship Id="rId4" Type="http://schemas.openxmlformats.org/officeDocument/2006/relationships/image" Target="../media/image71.png"/><Relationship Id="rId9" Type="http://schemas.microsoft.com/office/2007/relationships/hdphoto" Target="../media/hdphoto47.wdp"/><Relationship Id="rId14" Type="http://schemas.openxmlformats.org/officeDocument/2006/relationships/image" Target="../media/image76.png"/><Relationship Id="rId22" Type="http://schemas.openxmlformats.org/officeDocument/2006/relationships/image" Target="../media/image80.png"/><Relationship Id="rId27" Type="http://schemas.microsoft.com/office/2007/relationships/hdphoto" Target="../media/hdphoto56.wdp"/><Relationship Id="rId30" Type="http://schemas.openxmlformats.org/officeDocument/2006/relationships/image" Target="../media/image84.png"/><Relationship Id="rId35" Type="http://schemas.openxmlformats.org/officeDocument/2006/relationships/image" Target="../media/image88.png"/><Relationship Id="rId8" Type="http://schemas.openxmlformats.org/officeDocument/2006/relationships/image" Target="../media/image73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96.png"/><Relationship Id="rId13" Type="http://schemas.openxmlformats.org/officeDocument/2006/relationships/image" Target="../media/image101.png"/><Relationship Id="rId3" Type="http://schemas.openxmlformats.org/officeDocument/2006/relationships/image" Target="../media/image91.png"/><Relationship Id="rId7" Type="http://schemas.openxmlformats.org/officeDocument/2006/relationships/image" Target="../media/image95.png"/><Relationship Id="rId12" Type="http://schemas.openxmlformats.org/officeDocument/2006/relationships/image" Target="../media/image100.png"/><Relationship Id="rId2" Type="http://schemas.openxmlformats.org/officeDocument/2006/relationships/image" Target="../media/image9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4.png"/><Relationship Id="rId11" Type="http://schemas.openxmlformats.org/officeDocument/2006/relationships/image" Target="../media/image99.png"/><Relationship Id="rId5" Type="http://schemas.openxmlformats.org/officeDocument/2006/relationships/image" Target="../media/image93.png"/><Relationship Id="rId10" Type="http://schemas.openxmlformats.org/officeDocument/2006/relationships/image" Target="../media/image98.png"/><Relationship Id="rId4" Type="http://schemas.openxmlformats.org/officeDocument/2006/relationships/image" Target="../media/image92.png"/><Relationship Id="rId9" Type="http://schemas.openxmlformats.org/officeDocument/2006/relationships/image" Target="../media/image97.png"/><Relationship Id="rId14" Type="http://schemas.openxmlformats.org/officeDocument/2006/relationships/image" Target="../media/image102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7.png"/><Relationship Id="rId13" Type="http://schemas.openxmlformats.org/officeDocument/2006/relationships/image" Target="../media/image112.png"/><Relationship Id="rId3" Type="http://schemas.microsoft.com/office/2007/relationships/hdphoto" Target="../media/hdphoto59.wdp"/><Relationship Id="rId7" Type="http://schemas.openxmlformats.org/officeDocument/2006/relationships/image" Target="../media/image106.png"/><Relationship Id="rId12" Type="http://schemas.openxmlformats.org/officeDocument/2006/relationships/image" Target="../media/image111.png"/><Relationship Id="rId2" Type="http://schemas.openxmlformats.org/officeDocument/2006/relationships/image" Target="../media/image10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5.png"/><Relationship Id="rId11" Type="http://schemas.openxmlformats.org/officeDocument/2006/relationships/image" Target="../media/image110.png"/><Relationship Id="rId5" Type="http://schemas.microsoft.com/office/2007/relationships/hdphoto" Target="../media/hdphoto60.wdp"/><Relationship Id="rId15" Type="http://schemas.openxmlformats.org/officeDocument/2006/relationships/image" Target="../media/image114.png"/><Relationship Id="rId10" Type="http://schemas.openxmlformats.org/officeDocument/2006/relationships/image" Target="../media/image109.png"/><Relationship Id="rId4" Type="http://schemas.openxmlformats.org/officeDocument/2006/relationships/image" Target="../media/image104.png"/><Relationship Id="rId9" Type="http://schemas.openxmlformats.org/officeDocument/2006/relationships/image" Target="../media/image108.png"/><Relationship Id="rId14" Type="http://schemas.openxmlformats.org/officeDocument/2006/relationships/image" Target="../media/image113.png"/></Relationships>
</file>

<file path=ppt/slides/_rels/slide9.xml.rels><?xml version="1.0" encoding="UTF-8" standalone="yes"?>
<Relationships xmlns="http://schemas.openxmlformats.org/package/2006/relationships"><Relationship Id="rId8" Type="http://schemas.microsoft.com/office/2007/relationships/hdphoto" Target="../media/hdphoto63.wdp"/><Relationship Id="rId3" Type="http://schemas.openxmlformats.org/officeDocument/2006/relationships/image" Target="../media/image116.png"/><Relationship Id="rId7" Type="http://schemas.openxmlformats.org/officeDocument/2006/relationships/image" Target="../media/image118.png"/><Relationship Id="rId2" Type="http://schemas.openxmlformats.org/officeDocument/2006/relationships/image" Target="../media/image115.png"/><Relationship Id="rId1" Type="http://schemas.openxmlformats.org/officeDocument/2006/relationships/slideLayout" Target="../slideLayouts/slideLayout7.xml"/><Relationship Id="rId6" Type="http://schemas.microsoft.com/office/2007/relationships/hdphoto" Target="../media/hdphoto62.wdp"/><Relationship Id="rId5" Type="http://schemas.openxmlformats.org/officeDocument/2006/relationships/image" Target="../media/image117.png"/><Relationship Id="rId4" Type="http://schemas.microsoft.com/office/2007/relationships/hdphoto" Target="../media/hdphoto6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316B9158-C0B5-4D78-858A-559D6B1DD6D0}"/>
              </a:ext>
            </a:extLst>
          </p:cNvPr>
          <p:cNvSpPr txBox="1"/>
          <p:nvPr/>
        </p:nvSpPr>
        <p:spPr>
          <a:xfrm>
            <a:off x="404664" y="467544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a)</a:t>
            </a:r>
          </a:p>
        </p:txBody>
      </p:sp>
      <p:grpSp>
        <p:nvGrpSpPr>
          <p:cNvPr id="3" name="Gruppo 2">
            <a:extLst>
              <a:ext uri="{FF2B5EF4-FFF2-40B4-BE49-F238E27FC236}">
                <a16:creationId xmlns:a16="http://schemas.microsoft.com/office/drawing/2014/main" id="{1BC9F02F-47C1-4382-B721-B7E945A7A312}"/>
              </a:ext>
            </a:extLst>
          </p:cNvPr>
          <p:cNvGrpSpPr/>
          <p:nvPr/>
        </p:nvGrpSpPr>
        <p:grpSpPr>
          <a:xfrm>
            <a:off x="653613" y="2813242"/>
            <a:ext cx="1987255" cy="1717316"/>
            <a:chOff x="712293" y="6194276"/>
            <a:chExt cx="1987255" cy="1717316"/>
          </a:xfrm>
        </p:grpSpPr>
        <p:pic>
          <p:nvPicPr>
            <p:cNvPr id="4" name="Immagine 3">
              <a:extLst>
                <a:ext uri="{FF2B5EF4-FFF2-40B4-BE49-F238E27FC236}">
                  <a16:creationId xmlns:a16="http://schemas.microsoft.com/office/drawing/2014/main" id="{6FA4DF06-5507-4DAA-B9C0-6278FD7E597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44416" y="6655205"/>
              <a:ext cx="1245036" cy="849600"/>
            </a:xfrm>
            <a:prstGeom prst="rect">
              <a:avLst/>
            </a:prstGeom>
          </p:spPr>
        </p:pic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BBE25AD8-0940-4C48-BD28-9967A9B3C153}"/>
                </a:ext>
              </a:extLst>
            </p:cNvPr>
            <p:cNvSpPr txBox="1"/>
            <p:nvPr/>
          </p:nvSpPr>
          <p:spPr>
            <a:xfrm rot="16200000">
              <a:off x="95778" y="6833412"/>
              <a:ext cx="169469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/>
                <a:t>Tel 20 </a:t>
              </a:r>
              <a:r>
                <a:rPr lang="el-G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it-IT" sz="1200" dirty="0"/>
                <a:t>M </a:t>
              </a:r>
              <a:r>
                <a:rPr lang="it-IT" sz="1200" dirty="0" err="1"/>
                <a:t>Effect</a:t>
              </a:r>
              <a:r>
                <a:rPr lang="it-IT" sz="1200" dirty="0"/>
                <a:t> </a:t>
              </a:r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</a:t>
              </a:r>
              <a:r>
                <a:rPr lang="it-IT" sz="1200" dirty="0" err="1"/>
                <a:t>respective</a:t>
              </a:r>
              <a:r>
                <a:rPr lang="it-IT" sz="1200" dirty="0"/>
                <a:t> C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7BD22699-3588-4716-B2D8-20E1EE66FAD0}"/>
                </a:ext>
              </a:extLst>
            </p:cNvPr>
            <p:cNvSpPr txBox="1"/>
            <p:nvPr/>
          </p:nvSpPr>
          <p:spPr>
            <a:xfrm>
              <a:off x="1041591" y="6518296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2</a:t>
              </a:r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60F86EA1-2917-41A8-BD87-DB2960C8C162}"/>
                </a:ext>
              </a:extLst>
            </p:cNvPr>
            <p:cNvSpPr txBox="1"/>
            <p:nvPr/>
          </p:nvSpPr>
          <p:spPr>
            <a:xfrm>
              <a:off x="1041591" y="6916676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6</a:t>
              </a: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B594362E-B2BA-42E2-9AA3-9D9500F01814}"/>
                </a:ext>
              </a:extLst>
            </p:cNvPr>
            <p:cNvSpPr txBox="1"/>
            <p:nvPr/>
          </p:nvSpPr>
          <p:spPr>
            <a:xfrm>
              <a:off x="1041591" y="732332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AA62B163-8FDD-468B-841B-253A8BC01CC6}"/>
                </a:ext>
              </a:extLst>
            </p:cNvPr>
            <p:cNvSpPr txBox="1"/>
            <p:nvPr/>
          </p:nvSpPr>
          <p:spPr>
            <a:xfrm>
              <a:off x="1067278" y="7230677"/>
              <a:ext cx="12089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it-IT" sz="1200" dirty="0"/>
                <a:t>SKBR3</a:t>
              </a: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D4AEB573-52C9-4553-A6D9-1C5434F9CDBA}"/>
                </a:ext>
              </a:extLst>
            </p:cNvPr>
            <p:cNvSpPr txBox="1"/>
            <p:nvPr/>
          </p:nvSpPr>
          <p:spPr>
            <a:xfrm>
              <a:off x="1498883" y="6365088"/>
              <a:ext cx="11588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/>
                <a:t>siRNA</a:t>
              </a:r>
              <a:r>
                <a:rPr lang="it-IT" sz="1200" dirty="0"/>
                <a:t> FOXA1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FF03AD65-36E2-48FF-B567-950A267A7C01}"/>
                </a:ext>
              </a:extLst>
            </p:cNvPr>
            <p:cNvSpPr txBox="1"/>
            <p:nvPr/>
          </p:nvSpPr>
          <p:spPr>
            <a:xfrm>
              <a:off x="1498883" y="6194276"/>
              <a:ext cx="9696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/>
                <a:t>siRNA</a:t>
              </a:r>
              <a:r>
                <a:rPr lang="it-IT" sz="1200" dirty="0"/>
                <a:t> CTR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80039316-475F-430A-86AB-A2F385538157}"/>
                </a:ext>
              </a:extLst>
            </p:cNvPr>
            <p:cNvSpPr txBox="1"/>
            <p:nvPr/>
          </p:nvSpPr>
          <p:spPr>
            <a:xfrm>
              <a:off x="1373923" y="7553556"/>
              <a:ext cx="12089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sz="1200" dirty="0"/>
                <a:t> Time (Days)</a:t>
              </a: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DEEC4D61-953D-40EC-9BBB-F96184B90E1F}"/>
                </a:ext>
              </a:extLst>
            </p:cNvPr>
            <p:cNvSpPr txBox="1"/>
            <p:nvPr/>
          </p:nvSpPr>
          <p:spPr>
            <a:xfrm>
              <a:off x="2031061" y="744111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2</a:t>
              </a: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1D6FECB3-3B7A-43D7-9D7E-9537B592122D}"/>
                </a:ext>
              </a:extLst>
            </p:cNvPr>
            <p:cNvSpPr txBox="1"/>
            <p:nvPr/>
          </p:nvSpPr>
          <p:spPr>
            <a:xfrm>
              <a:off x="1637680" y="743876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</a:t>
              </a:r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31503378-4E51-4C5A-80FF-DB545A1ACCA0}"/>
                </a:ext>
              </a:extLst>
            </p:cNvPr>
            <p:cNvSpPr txBox="1"/>
            <p:nvPr/>
          </p:nvSpPr>
          <p:spPr>
            <a:xfrm>
              <a:off x="1254813" y="743876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</a:t>
              </a:r>
            </a:p>
          </p:txBody>
        </p:sp>
        <p:pic>
          <p:nvPicPr>
            <p:cNvPr id="16" name="Immagine 15">
              <a:extLst>
                <a:ext uri="{FF2B5EF4-FFF2-40B4-BE49-F238E27FC236}">
                  <a16:creationId xmlns:a16="http://schemas.microsoft.com/office/drawing/2014/main" id="{535311CC-FE43-4416-B172-352BDDD397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42844"/>
            <a:stretch/>
          </p:blipFill>
          <p:spPr>
            <a:xfrm>
              <a:off x="1364448" y="6309888"/>
              <a:ext cx="185112" cy="260725"/>
            </a:xfrm>
            <a:prstGeom prst="rect">
              <a:avLst/>
            </a:prstGeom>
          </p:spPr>
        </p:pic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C555BC9E-AF04-419E-8506-9946BA0DD2AC}"/>
                </a:ext>
              </a:extLst>
            </p:cNvPr>
            <p:cNvSpPr txBox="1"/>
            <p:nvPr/>
          </p:nvSpPr>
          <p:spPr>
            <a:xfrm>
              <a:off x="2429922" y="743876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3</a:t>
              </a:r>
            </a:p>
          </p:txBody>
        </p:sp>
      </p:grpSp>
      <p:grpSp>
        <p:nvGrpSpPr>
          <p:cNvPr id="18" name="Gruppo 17">
            <a:extLst>
              <a:ext uri="{FF2B5EF4-FFF2-40B4-BE49-F238E27FC236}">
                <a16:creationId xmlns:a16="http://schemas.microsoft.com/office/drawing/2014/main" id="{E7866D84-354A-4C45-B4F5-52C96357C86D}"/>
              </a:ext>
            </a:extLst>
          </p:cNvPr>
          <p:cNvGrpSpPr/>
          <p:nvPr/>
        </p:nvGrpSpPr>
        <p:grpSpPr>
          <a:xfrm>
            <a:off x="3266242" y="2813242"/>
            <a:ext cx="1987255" cy="1717316"/>
            <a:chOff x="4621668" y="4336442"/>
            <a:chExt cx="1987255" cy="1717316"/>
          </a:xfrm>
        </p:grpSpPr>
        <p:pic>
          <p:nvPicPr>
            <p:cNvPr id="19" name="Immagine 18">
              <a:extLst>
                <a:ext uri="{FF2B5EF4-FFF2-40B4-BE49-F238E27FC236}">
                  <a16:creationId xmlns:a16="http://schemas.microsoft.com/office/drawing/2014/main" id="{7666B514-9B29-43B6-ADCF-756BBB28637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257442" y="4797371"/>
              <a:ext cx="1245036" cy="849600"/>
            </a:xfrm>
            <a:prstGeom prst="rect">
              <a:avLst/>
            </a:prstGeom>
          </p:spPr>
        </p:pic>
        <p:pic>
          <p:nvPicPr>
            <p:cNvPr id="20" name="Immagine 19">
              <a:extLst>
                <a:ext uri="{FF2B5EF4-FFF2-40B4-BE49-F238E27FC236}">
                  <a16:creationId xmlns:a16="http://schemas.microsoft.com/office/drawing/2014/main" id="{56173108-F7C5-4FC7-A157-95A91F0865D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 flipV="1">
              <a:off x="5273823" y="4453579"/>
              <a:ext cx="194400" cy="259200"/>
            </a:xfrm>
            <a:prstGeom prst="rect">
              <a:avLst/>
            </a:prstGeom>
          </p:spPr>
        </p:pic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22B3C32F-2C85-4CEA-9526-C5B461F21C2F}"/>
                </a:ext>
              </a:extLst>
            </p:cNvPr>
            <p:cNvSpPr txBox="1"/>
            <p:nvPr/>
          </p:nvSpPr>
          <p:spPr>
            <a:xfrm rot="16200000">
              <a:off x="4005153" y="4975578"/>
              <a:ext cx="169469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/>
                <a:t>Tel 40 </a:t>
              </a:r>
              <a:r>
                <a:rPr lang="el-G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it-IT" sz="1200" dirty="0"/>
                <a:t>M </a:t>
              </a:r>
              <a:r>
                <a:rPr lang="it-IT" sz="1200" dirty="0" err="1"/>
                <a:t>Effect</a:t>
              </a:r>
              <a:r>
                <a:rPr lang="it-IT" sz="1200" dirty="0"/>
                <a:t> </a:t>
              </a:r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</a:t>
              </a:r>
              <a:r>
                <a:rPr lang="it-IT" sz="1200" dirty="0" err="1"/>
                <a:t>respective</a:t>
              </a:r>
              <a:r>
                <a:rPr lang="it-IT" sz="1200" dirty="0"/>
                <a:t> C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D838B54C-669B-4BE4-A92E-C59C496D3B4B}"/>
                </a:ext>
              </a:extLst>
            </p:cNvPr>
            <p:cNvSpPr txBox="1"/>
            <p:nvPr/>
          </p:nvSpPr>
          <p:spPr>
            <a:xfrm>
              <a:off x="4950966" y="467633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2</a:t>
              </a:r>
            </a:p>
          </p:txBody>
        </p:sp>
        <p:sp>
          <p:nvSpPr>
            <p:cNvPr id="23" name="CasellaDiTesto 22">
              <a:extLst>
                <a:ext uri="{FF2B5EF4-FFF2-40B4-BE49-F238E27FC236}">
                  <a16:creationId xmlns:a16="http://schemas.microsoft.com/office/drawing/2014/main" id="{950DA0E4-6A14-43FE-BCEA-87237798679A}"/>
                </a:ext>
              </a:extLst>
            </p:cNvPr>
            <p:cNvSpPr txBox="1"/>
            <p:nvPr/>
          </p:nvSpPr>
          <p:spPr>
            <a:xfrm>
              <a:off x="4950966" y="5013573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6</a:t>
              </a:r>
            </a:p>
          </p:txBody>
        </p: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id="{80986F7D-8B0C-444A-B1C3-B0E15FB0255E}"/>
                </a:ext>
              </a:extLst>
            </p:cNvPr>
            <p:cNvSpPr txBox="1"/>
            <p:nvPr/>
          </p:nvSpPr>
          <p:spPr>
            <a:xfrm>
              <a:off x="4950966" y="5348213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70F0A0FE-AE03-4E35-8E65-6B027F94E6FD}"/>
                </a:ext>
              </a:extLst>
            </p:cNvPr>
            <p:cNvSpPr txBox="1"/>
            <p:nvPr/>
          </p:nvSpPr>
          <p:spPr>
            <a:xfrm>
              <a:off x="5158021" y="5394275"/>
              <a:ext cx="70881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it-IT" sz="1200" dirty="0"/>
                <a:t>SKOV</a:t>
              </a:r>
            </a:p>
          </p:txBody>
        </p:sp>
        <p:sp>
          <p:nvSpPr>
            <p:cNvPr id="26" name="CasellaDiTesto 25">
              <a:extLst>
                <a:ext uri="{FF2B5EF4-FFF2-40B4-BE49-F238E27FC236}">
                  <a16:creationId xmlns:a16="http://schemas.microsoft.com/office/drawing/2014/main" id="{A201F472-2EF1-4959-8863-728A4D769170}"/>
                </a:ext>
              </a:extLst>
            </p:cNvPr>
            <p:cNvSpPr txBox="1"/>
            <p:nvPr/>
          </p:nvSpPr>
          <p:spPr>
            <a:xfrm>
              <a:off x="5408258" y="4507254"/>
              <a:ext cx="10390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Flag-FOXA1</a:t>
              </a:r>
            </a:p>
          </p:txBody>
        </p:sp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id="{DE77C392-BD96-4112-A53D-5A0D08584F54}"/>
                </a:ext>
              </a:extLst>
            </p:cNvPr>
            <p:cNvSpPr txBox="1"/>
            <p:nvPr/>
          </p:nvSpPr>
          <p:spPr>
            <a:xfrm>
              <a:off x="5408258" y="4336442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CTR</a:t>
              </a:r>
            </a:p>
          </p:txBody>
        </p:sp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id="{EA86B704-AE27-4FDB-9F10-6413D3B58B36}"/>
                </a:ext>
              </a:extLst>
            </p:cNvPr>
            <p:cNvSpPr txBox="1"/>
            <p:nvPr/>
          </p:nvSpPr>
          <p:spPr>
            <a:xfrm>
              <a:off x="5283298" y="5695722"/>
              <a:ext cx="12089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sz="1200" dirty="0"/>
                <a:t> Time (Days)</a:t>
              </a:r>
            </a:p>
          </p:txBody>
        </p:sp>
        <p:sp>
          <p:nvSpPr>
            <p:cNvPr id="29" name="CasellaDiTesto 28">
              <a:extLst>
                <a:ext uri="{FF2B5EF4-FFF2-40B4-BE49-F238E27FC236}">
                  <a16:creationId xmlns:a16="http://schemas.microsoft.com/office/drawing/2014/main" id="{C3407409-C9A3-451E-89E5-62A6F9280502}"/>
                </a:ext>
              </a:extLst>
            </p:cNvPr>
            <p:cNvSpPr txBox="1"/>
            <p:nvPr/>
          </p:nvSpPr>
          <p:spPr>
            <a:xfrm>
              <a:off x="5630060" y="5580931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2</a:t>
              </a:r>
            </a:p>
          </p:txBody>
        </p:sp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id="{D6C2FCC5-7E98-43CD-93D6-B8A25F0528BC}"/>
                </a:ext>
              </a:extLst>
            </p:cNvPr>
            <p:cNvSpPr txBox="1"/>
            <p:nvPr/>
          </p:nvSpPr>
          <p:spPr>
            <a:xfrm>
              <a:off x="5865134" y="5580931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3</a:t>
              </a:r>
            </a:p>
          </p:txBody>
        </p:sp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id="{340D8019-EF4C-49AA-B83F-DD0BDFFCCFA7}"/>
                </a:ext>
              </a:extLst>
            </p:cNvPr>
            <p:cNvSpPr txBox="1"/>
            <p:nvPr/>
          </p:nvSpPr>
          <p:spPr>
            <a:xfrm>
              <a:off x="5391811" y="5580931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</a:t>
              </a:r>
            </a:p>
          </p:txBody>
        </p:sp>
        <p:sp>
          <p:nvSpPr>
            <p:cNvPr id="32" name="CasellaDiTesto 31">
              <a:extLst>
                <a:ext uri="{FF2B5EF4-FFF2-40B4-BE49-F238E27FC236}">
                  <a16:creationId xmlns:a16="http://schemas.microsoft.com/office/drawing/2014/main" id="{93683D5D-0799-451D-A1CC-E493D4445440}"/>
                </a:ext>
              </a:extLst>
            </p:cNvPr>
            <p:cNvSpPr txBox="1"/>
            <p:nvPr/>
          </p:nvSpPr>
          <p:spPr>
            <a:xfrm>
              <a:off x="5164188" y="5580931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</a:t>
              </a:r>
            </a:p>
          </p:txBody>
        </p: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id="{763227BC-CFB0-4279-8981-7160D95E1F8A}"/>
                </a:ext>
              </a:extLst>
            </p:cNvPr>
            <p:cNvSpPr txBox="1"/>
            <p:nvPr/>
          </p:nvSpPr>
          <p:spPr>
            <a:xfrm>
              <a:off x="6104347" y="5580931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4</a:t>
              </a:r>
            </a:p>
          </p:txBody>
        </p:sp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id="{22DF411A-2628-457C-A249-AF5F05891A25}"/>
                </a:ext>
              </a:extLst>
            </p:cNvPr>
            <p:cNvSpPr txBox="1"/>
            <p:nvPr/>
          </p:nvSpPr>
          <p:spPr>
            <a:xfrm>
              <a:off x="6339297" y="5580931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5</a:t>
              </a:r>
            </a:p>
          </p:txBody>
        </p:sp>
      </p:grp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A4D471B4-2058-4662-9FBD-0FC35F688A73}"/>
              </a:ext>
            </a:extLst>
          </p:cNvPr>
          <p:cNvSpPr txBox="1"/>
          <p:nvPr/>
        </p:nvSpPr>
        <p:spPr>
          <a:xfrm>
            <a:off x="404664" y="2709790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c)</a:t>
            </a:r>
          </a:p>
        </p:txBody>
      </p:sp>
      <p:grpSp>
        <p:nvGrpSpPr>
          <p:cNvPr id="36" name="Gruppo 35">
            <a:extLst>
              <a:ext uri="{FF2B5EF4-FFF2-40B4-BE49-F238E27FC236}">
                <a16:creationId xmlns:a16="http://schemas.microsoft.com/office/drawing/2014/main" id="{BC3B646A-50BD-4DD6-94F0-DD2AFFC472BB}"/>
              </a:ext>
            </a:extLst>
          </p:cNvPr>
          <p:cNvGrpSpPr/>
          <p:nvPr/>
        </p:nvGrpSpPr>
        <p:grpSpPr>
          <a:xfrm>
            <a:off x="980728" y="888859"/>
            <a:ext cx="1742236" cy="1169618"/>
            <a:chOff x="903498" y="629695"/>
            <a:chExt cx="1742236" cy="1169618"/>
          </a:xfrm>
        </p:grpSpPr>
        <p:pic>
          <p:nvPicPr>
            <p:cNvPr id="37" name="Immagine 36">
              <a:extLst>
                <a:ext uri="{FF2B5EF4-FFF2-40B4-BE49-F238E27FC236}">
                  <a16:creationId xmlns:a16="http://schemas.microsoft.com/office/drawing/2014/main" id="{A7EA384C-CEA9-4A00-9254-71D02387E8F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924397" y="1392258"/>
              <a:ext cx="1080000" cy="15108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8" name="CasellaDiTesto 37">
              <a:extLst>
                <a:ext uri="{FF2B5EF4-FFF2-40B4-BE49-F238E27FC236}">
                  <a16:creationId xmlns:a16="http://schemas.microsoft.com/office/drawing/2014/main" id="{6B6118C3-1FCD-41D0-8EB2-F3CE5F2013D9}"/>
                </a:ext>
              </a:extLst>
            </p:cNvPr>
            <p:cNvSpPr txBox="1"/>
            <p:nvPr/>
          </p:nvSpPr>
          <p:spPr>
            <a:xfrm>
              <a:off x="2013830" y="1553092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/>
                <a:t>Vinculin</a:t>
              </a:r>
              <a:endParaRPr lang="it-IT" sz="1000" dirty="0"/>
            </a:p>
          </p:txBody>
        </p:sp>
        <p:sp>
          <p:nvSpPr>
            <p:cNvPr id="39" name="CasellaDiTesto 38">
              <a:extLst>
                <a:ext uri="{FF2B5EF4-FFF2-40B4-BE49-F238E27FC236}">
                  <a16:creationId xmlns:a16="http://schemas.microsoft.com/office/drawing/2014/main" id="{05ADB9C7-ED3C-4CEA-B4C4-600902B58A00}"/>
                </a:ext>
              </a:extLst>
            </p:cNvPr>
            <p:cNvSpPr txBox="1"/>
            <p:nvPr/>
          </p:nvSpPr>
          <p:spPr>
            <a:xfrm>
              <a:off x="2013830" y="1150109"/>
              <a:ext cx="6030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FOXA1</a:t>
              </a:r>
            </a:p>
          </p:txBody>
        </p:sp>
        <p:sp>
          <p:nvSpPr>
            <p:cNvPr id="40" name="CasellaDiTesto 39">
              <a:extLst>
                <a:ext uri="{FF2B5EF4-FFF2-40B4-BE49-F238E27FC236}">
                  <a16:creationId xmlns:a16="http://schemas.microsoft.com/office/drawing/2014/main" id="{94B37797-9143-4BCC-82A2-2E12547DEDFC}"/>
                </a:ext>
              </a:extLst>
            </p:cNvPr>
            <p:cNvSpPr txBox="1"/>
            <p:nvPr/>
          </p:nvSpPr>
          <p:spPr>
            <a:xfrm>
              <a:off x="2013830" y="1344688"/>
              <a:ext cx="4299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ER</a:t>
              </a:r>
              <a:r>
                <a:rPr lang="el-G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endParaRPr lang="it-IT" sz="1000" dirty="0"/>
            </a:p>
          </p:txBody>
        </p:sp>
        <p:sp>
          <p:nvSpPr>
            <p:cNvPr id="41" name="CasellaDiTesto 40">
              <a:extLst>
                <a:ext uri="{FF2B5EF4-FFF2-40B4-BE49-F238E27FC236}">
                  <a16:creationId xmlns:a16="http://schemas.microsoft.com/office/drawing/2014/main" id="{E8A26B7A-E60B-4796-B42D-56EC93B61994}"/>
                </a:ext>
              </a:extLst>
            </p:cNvPr>
            <p:cNvSpPr txBox="1"/>
            <p:nvPr/>
          </p:nvSpPr>
          <p:spPr>
            <a:xfrm rot="16200000">
              <a:off x="781991" y="871428"/>
              <a:ext cx="4892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/>
                <a:t>HeLa</a:t>
              </a:r>
              <a:endParaRPr lang="it-IT" sz="1000" dirty="0"/>
            </a:p>
          </p:txBody>
        </p:sp>
        <p:sp>
          <p:nvSpPr>
            <p:cNvPr id="42" name="CasellaDiTesto 41">
              <a:extLst>
                <a:ext uri="{FF2B5EF4-FFF2-40B4-BE49-F238E27FC236}">
                  <a16:creationId xmlns:a16="http://schemas.microsoft.com/office/drawing/2014/main" id="{B0649728-C6D0-483B-A9A8-54DDA5310B09}"/>
                </a:ext>
              </a:extLst>
            </p:cNvPr>
            <p:cNvSpPr txBox="1"/>
            <p:nvPr/>
          </p:nvSpPr>
          <p:spPr>
            <a:xfrm rot="16200000">
              <a:off x="1022980" y="811315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SKOV3</a:t>
              </a:r>
            </a:p>
          </p:txBody>
        </p:sp>
        <p:sp>
          <p:nvSpPr>
            <p:cNvPr id="43" name="CasellaDiTesto 42">
              <a:extLst>
                <a:ext uri="{FF2B5EF4-FFF2-40B4-BE49-F238E27FC236}">
                  <a16:creationId xmlns:a16="http://schemas.microsoft.com/office/drawing/2014/main" id="{E2D58A4F-ADF8-4669-BDF3-430BAF0A18A7}"/>
                </a:ext>
              </a:extLst>
            </p:cNvPr>
            <p:cNvSpPr txBox="1"/>
            <p:nvPr/>
          </p:nvSpPr>
          <p:spPr>
            <a:xfrm rot="16200000">
              <a:off x="1324687" y="827345"/>
              <a:ext cx="5774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MCF-7</a:t>
              </a:r>
            </a:p>
          </p:txBody>
        </p:sp>
        <p:sp>
          <p:nvSpPr>
            <p:cNvPr id="44" name="CasellaDiTesto 43">
              <a:extLst>
                <a:ext uri="{FF2B5EF4-FFF2-40B4-BE49-F238E27FC236}">
                  <a16:creationId xmlns:a16="http://schemas.microsoft.com/office/drawing/2014/main" id="{C3963A1E-D042-40EB-BAE0-4831550C0CD1}"/>
                </a:ext>
              </a:extLst>
            </p:cNvPr>
            <p:cNvSpPr txBox="1"/>
            <p:nvPr/>
          </p:nvSpPr>
          <p:spPr>
            <a:xfrm rot="16200000">
              <a:off x="1591137" y="814521"/>
              <a:ext cx="6030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SKBR3</a:t>
              </a:r>
            </a:p>
          </p:txBody>
        </p:sp>
        <p:pic>
          <p:nvPicPr>
            <p:cNvPr id="45" name="Immagine 44">
              <a:extLst>
                <a:ext uri="{FF2B5EF4-FFF2-40B4-BE49-F238E27FC236}">
                  <a16:creationId xmlns:a16="http://schemas.microsoft.com/office/drawing/2014/main" id="{28F1FC0E-ABA5-47EE-8A7C-321B17B978D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924397" y="1197679"/>
              <a:ext cx="1080000" cy="15108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6" name="Immagine 45">
              <a:extLst>
                <a:ext uri="{FF2B5EF4-FFF2-40B4-BE49-F238E27FC236}">
                  <a16:creationId xmlns:a16="http://schemas.microsoft.com/office/drawing/2014/main" id="{11F8A21D-BFFA-434F-A07E-D901B26EBC7D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924397" y="1600662"/>
              <a:ext cx="1080000" cy="15108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47" name="Gruppo 46">
            <a:extLst>
              <a:ext uri="{FF2B5EF4-FFF2-40B4-BE49-F238E27FC236}">
                <a16:creationId xmlns:a16="http://schemas.microsoft.com/office/drawing/2014/main" id="{2567293A-8F1E-4B22-8975-7CCF895B1837}"/>
              </a:ext>
            </a:extLst>
          </p:cNvPr>
          <p:cNvGrpSpPr/>
          <p:nvPr/>
        </p:nvGrpSpPr>
        <p:grpSpPr>
          <a:xfrm>
            <a:off x="4055031" y="653132"/>
            <a:ext cx="1390193" cy="1641072"/>
            <a:chOff x="1288282" y="4331142"/>
            <a:chExt cx="1390193" cy="1641072"/>
          </a:xfrm>
        </p:grpSpPr>
        <p:sp>
          <p:nvSpPr>
            <p:cNvPr id="48" name="CasellaDiTesto 47">
              <a:extLst>
                <a:ext uri="{FF2B5EF4-FFF2-40B4-BE49-F238E27FC236}">
                  <a16:creationId xmlns:a16="http://schemas.microsoft.com/office/drawing/2014/main" id="{6A4C2DDC-9A76-42A7-879B-DD22253FF9C1}"/>
                </a:ext>
              </a:extLst>
            </p:cNvPr>
            <p:cNvSpPr txBox="1"/>
            <p:nvPr/>
          </p:nvSpPr>
          <p:spPr>
            <a:xfrm>
              <a:off x="1961163" y="5479143"/>
              <a:ext cx="7173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/>
                <a:t>Vinculin</a:t>
              </a:r>
              <a:endParaRPr lang="it-IT" sz="1200" dirty="0"/>
            </a:p>
          </p:txBody>
        </p:sp>
        <p:sp>
          <p:nvSpPr>
            <p:cNvPr id="49" name="CasellaDiTesto 48">
              <a:extLst>
                <a:ext uri="{FF2B5EF4-FFF2-40B4-BE49-F238E27FC236}">
                  <a16:creationId xmlns:a16="http://schemas.microsoft.com/office/drawing/2014/main" id="{892F1EE2-33CA-4D56-BF9C-6E3C88A1E528}"/>
                </a:ext>
              </a:extLst>
            </p:cNvPr>
            <p:cNvSpPr txBox="1"/>
            <p:nvPr/>
          </p:nvSpPr>
          <p:spPr>
            <a:xfrm>
              <a:off x="1951489" y="5218008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Flag</a:t>
              </a:r>
            </a:p>
          </p:txBody>
        </p:sp>
        <p:pic>
          <p:nvPicPr>
            <p:cNvPr id="50" name="Immagine 49">
              <a:extLst>
                <a:ext uri="{FF2B5EF4-FFF2-40B4-BE49-F238E27FC236}">
                  <a16:creationId xmlns:a16="http://schemas.microsoft.com/office/drawing/2014/main" id="{2ED5568B-B6DD-4DB5-A102-950A3EB5C03B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288282" y="5248159"/>
              <a:ext cx="720000" cy="21669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1" name="Immagine 50">
              <a:extLst>
                <a:ext uri="{FF2B5EF4-FFF2-40B4-BE49-F238E27FC236}">
                  <a16:creationId xmlns:a16="http://schemas.microsoft.com/office/drawing/2014/main" id="{18FBCB4A-2D81-462D-8F21-2B751EF06B0C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288282" y="5509294"/>
              <a:ext cx="720000" cy="21669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2" name="CasellaDiTesto 51">
              <a:extLst>
                <a:ext uri="{FF2B5EF4-FFF2-40B4-BE49-F238E27FC236}">
                  <a16:creationId xmlns:a16="http://schemas.microsoft.com/office/drawing/2014/main" id="{0F7B6342-FB80-481A-A979-35CEAC77A106}"/>
                </a:ext>
              </a:extLst>
            </p:cNvPr>
            <p:cNvSpPr txBox="1"/>
            <p:nvPr/>
          </p:nvSpPr>
          <p:spPr>
            <a:xfrm rot="16200000">
              <a:off x="1203005" y="4878247"/>
              <a:ext cx="4491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CTR</a:t>
              </a:r>
            </a:p>
          </p:txBody>
        </p:sp>
        <p:sp>
          <p:nvSpPr>
            <p:cNvPr id="53" name="CasellaDiTesto 52">
              <a:extLst>
                <a:ext uri="{FF2B5EF4-FFF2-40B4-BE49-F238E27FC236}">
                  <a16:creationId xmlns:a16="http://schemas.microsoft.com/office/drawing/2014/main" id="{C244CB18-FB88-4A0D-A6AF-D066C88982CC}"/>
                </a:ext>
              </a:extLst>
            </p:cNvPr>
            <p:cNvSpPr txBox="1"/>
            <p:nvPr/>
          </p:nvSpPr>
          <p:spPr>
            <a:xfrm rot="16200000">
              <a:off x="1376255" y="4655430"/>
              <a:ext cx="8947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Flag-FOXA1</a:t>
              </a:r>
            </a:p>
          </p:txBody>
        </p:sp>
        <p:sp>
          <p:nvSpPr>
            <p:cNvPr id="54" name="CasellaDiTesto 53">
              <a:extLst>
                <a:ext uri="{FF2B5EF4-FFF2-40B4-BE49-F238E27FC236}">
                  <a16:creationId xmlns:a16="http://schemas.microsoft.com/office/drawing/2014/main" id="{053C23CD-0EE3-4199-8A9B-C228F4FC535C}"/>
                </a:ext>
              </a:extLst>
            </p:cNvPr>
            <p:cNvSpPr txBox="1"/>
            <p:nvPr/>
          </p:nvSpPr>
          <p:spPr>
            <a:xfrm>
              <a:off x="1306770" y="5695215"/>
              <a:ext cx="6976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SKOV3</a:t>
              </a:r>
            </a:p>
          </p:txBody>
        </p:sp>
      </p:grpSp>
      <p:sp>
        <p:nvSpPr>
          <p:cNvPr id="55" name="CasellaDiTesto 54">
            <a:extLst>
              <a:ext uri="{FF2B5EF4-FFF2-40B4-BE49-F238E27FC236}">
                <a16:creationId xmlns:a16="http://schemas.microsoft.com/office/drawing/2014/main" id="{D8DDC295-74A1-4C27-8E81-5AA8830EDD83}"/>
              </a:ext>
            </a:extLst>
          </p:cNvPr>
          <p:cNvSpPr txBox="1"/>
          <p:nvPr/>
        </p:nvSpPr>
        <p:spPr>
          <a:xfrm>
            <a:off x="2240213" y="0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ementary</a:t>
            </a:r>
            <a:r>
              <a:rPr lang="it-IT" b="1" dirty="0"/>
              <a:t> Fig. 1</a:t>
            </a:r>
          </a:p>
        </p:txBody>
      </p:sp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092CE28C-53C5-4E91-A620-FF06A0271AB8}"/>
              </a:ext>
            </a:extLst>
          </p:cNvPr>
          <p:cNvSpPr txBox="1"/>
          <p:nvPr/>
        </p:nvSpPr>
        <p:spPr>
          <a:xfrm>
            <a:off x="2761567" y="467544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b)</a:t>
            </a:r>
          </a:p>
        </p:txBody>
      </p:sp>
      <p:sp>
        <p:nvSpPr>
          <p:cNvPr id="57" name="CasellaDiTesto 56">
            <a:extLst>
              <a:ext uri="{FF2B5EF4-FFF2-40B4-BE49-F238E27FC236}">
                <a16:creationId xmlns:a16="http://schemas.microsoft.com/office/drawing/2014/main" id="{3697E222-4C5E-4402-9823-90BBBF27B729}"/>
              </a:ext>
            </a:extLst>
          </p:cNvPr>
          <p:cNvSpPr txBox="1"/>
          <p:nvPr/>
        </p:nvSpPr>
        <p:spPr>
          <a:xfrm>
            <a:off x="2761567" y="2709790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d)</a:t>
            </a:r>
          </a:p>
        </p:txBody>
      </p:sp>
    </p:spTree>
    <p:extLst>
      <p:ext uri="{BB962C8B-B14F-4D97-AF65-F5344CB8AC3E}">
        <p14:creationId xmlns:p14="http://schemas.microsoft.com/office/powerpoint/2010/main" val="5241573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1" name="Gruppo 70">
            <a:extLst>
              <a:ext uri="{FF2B5EF4-FFF2-40B4-BE49-F238E27FC236}">
                <a16:creationId xmlns:a16="http://schemas.microsoft.com/office/drawing/2014/main" id="{19628C25-E179-424E-B139-7B7C0AE38B1B}"/>
              </a:ext>
            </a:extLst>
          </p:cNvPr>
          <p:cNvGrpSpPr/>
          <p:nvPr/>
        </p:nvGrpSpPr>
        <p:grpSpPr>
          <a:xfrm>
            <a:off x="548680" y="749507"/>
            <a:ext cx="1922698" cy="1020416"/>
            <a:chOff x="2467651" y="611560"/>
            <a:chExt cx="1922698" cy="1020416"/>
          </a:xfrm>
        </p:grpSpPr>
        <p:sp>
          <p:nvSpPr>
            <p:cNvPr id="73" name="CasellaDiTesto 72">
              <a:extLst>
                <a:ext uri="{FF2B5EF4-FFF2-40B4-BE49-F238E27FC236}">
                  <a16:creationId xmlns:a16="http://schemas.microsoft.com/office/drawing/2014/main" id="{BC5D6DFD-A1B7-4F5B-8E6C-D7DC24CC51E7}"/>
                </a:ext>
              </a:extLst>
            </p:cNvPr>
            <p:cNvSpPr txBox="1"/>
            <p:nvPr/>
          </p:nvSpPr>
          <p:spPr>
            <a:xfrm>
              <a:off x="3758445" y="1182584"/>
              <a:ext cx="4363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ER</a:t>
              </a:r>
              <a:r>
                <a:rPr lang="el-GR" sz="1000" dirty="0">
                  <a:latin typeface="+mn-lt"/>
                  <a:cs typeface="Times New Roman" panose="02020603050405020304" pitchFamily="18" charset="0"/>
                </a:rPr>
                <a:t>α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74" name="CasellaDiTesto 73">
              <a:extLst>
                <a:ext uri="{FF2B5EF4-FFF2-40B4-BE49-F238E27FC236}">
                  <a16:creationId xmlns:a16="http://schemas.microsoft.com/office/drawing/2014/main" id="{FEDAA042-B3D5-42E8-BD48-8922A14BC130}"/>
                </a:ext>
              </a:extLst>
            </p:cNvPr>
            <p:cNvSpPr txBox="1"/>
            <p:nvPr/>
          </p:nvSpPr>
          <p:spPr>
            <a:xfrm>
              <a:off x="3758445" y="1385755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Vinculin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75" name="CasellaDiTesto 74">
              <a:extLst>
                <a:ext uri="{FF2B5EF4-FFF2-40B4-BE49-F238E27FC236}">
                  <a16:creationId xmlns:a16="http://schemas.microsoft.com/office/drawing/2014/main" id="{A7439430-C946-49B2-A38F-138B8B2C4BC4}"/>
                </a:ext>
              </a:extLst>
            </p:cNvPr>
            <p:cNvSpPr txBox="1"/>
            <p:nvPr/>
          </p:nvSpPr>
          <p:spPr>
            <a:xfrm>
              <a:off x="2731629" y="83408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76" name="CasellaDiTesto 75">
              <a:extLst>
                <a:ext uri="{FF2B5EF4-FFF2-40B4-BE49-F238E27FC236}">
                  <a16:creationId xmlns:a16="http://schemas.microsoft.com/office/drawing/2014/main" id="{F50E6A00-7DC9-472E-A9E7-682FBBD2C2F7}"/>
                </a:ext>
              </a:extLst>
            </p:cNvPr>
            <p:cNvSpPr txBox="1"/>
            <p:nvPr/>
          </p:nvSpPr>
          <p:spPr>
            <a:xfrm>
              <a:off x="2961293" y="834085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24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77" name="CasellaDiTesto 76">
              <a:extLst>
                <a:ext uri="{FF2B5EF4-FFF2-40B4-BE49-F238E27FC236}">
                  <a16:creationId xmlns:a16="http://schemas.microsoft.com/office/drawing/2014/main" id="{920F0185-833E-4D87-9E3B-082ED33FD968}"/>
                </a:ext>
              </a:extLst>
            </p:cNvPr>
            <p:cNvSpPr txBox="1"/>
            <p:nvPr/>
          </p:nvSpPr>
          <p:spPr>
            <a:xfrm>
              <a:off x="3230416" y="834085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48</a:t>
              </a:r>
            </a:p>
          </p:txBody>
        </p:sp>
        <p:sp>
          <p:nvSpPr>
            <p:cNvPr id="78" name="CasellaDiTesto 77">
              <a:extLst>
                <a:ext uri="{FF2B5EF4-FFF2-40B4-BE49-F238E27FC236}">
                  <a16:creationId xmlns:a16="http://schemas.microsoft.com/office/drawing/2014/main" id="{F9B98650-CEF1-4D33-93D9-3A3184F567BE}"/>
                </a:ext>
              </a:extLst>
            </p:cNvPr>
            <p:cNvSpPr txBox="1"/>
            <p:nvPr/>
          </p:nvSpPr>
          <p:spPr>
            <a:xfrm>
              <a:off x="3515187" y="834085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72</a:t>
              </a:r>
            </a:p>
          </p:txBody>
        </p:sp>
        <p:grpSp>
          <p:nvGrpSpPr>
            <p:cNvPr id="79" name="Gruppo 78">
              <a:extLst>
                <a:ext uri="{FF2B5EF4-FFF2-40B4-BE49-F238E27FC236}">
                  <a16:creationId xmlns:a16="http://schemas.microsoft.com/office/drawing/2014/main" id="{C0D78641-345C-4940-8C3E-C7EF1DD120F9}"/>
                </a:ext>
              </a:extLst>
            </p:cNvPr>
            <p:cNvGrpSpPr/>
            <p:nvPr/>
          </p:nvGrpSpPr>
          <p:grpSpPr>
            <a:xfrm>
              <a:off x="2467651" y="1018969"/>
              <a:ext cx="246221" cy="577402"/>
              <a:chOff x="1138682" y="2796947"/>
              <a:chExt cx="246221" cy="577402"/>
            </a:xfrm>
          </p:grpSpPr>
          <p:cxnSp>
            <p:nvCxnSpPr>
              <p:cNvPr id="86" name="Connettore diritto 85">
                <a:extLst>
                  <a:ext uri="{FF2B5EF4-FFF2-40B4-BE49-F238E27FC236}">
                    <a16:creationId xmlns:a16="http://schemas.microsoft.com/office/drawing/2014/main" id="{73DA890C-1518-40ED-92F4-EB5826C9BC2F}"/>
                  </a:ext>
                </a:extLst>
              </p:cNvPr>
              <p:cNvCxnSpPr/>
              <p:nvPr/>
            </p:nvCxnSpPr>
            <p:spPr>
              <a:xfrm>
                <a:off x="1340768" y="2932780"/>
                <a:ext cx="0" cy="30728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CasellaDiTesto 86">
                <a:extLst>
                  <a:ext uri="{FF2B5EF4-FFF2-40B4-BE49-F238E27FC236}">
                    <a16:creationId xmlns:a16="http://schemas.microsoft.com/office/drawing/2014/main" id="{16D79FAB-AC59-4662-A29C-BA367CA84F8E}"/>
                  </a:ext>
                </a:extLst>
              </p:cNvPr>
              <p:cNvSpPr txBox="1"/>
              <p:nvPr/>
            </p:nvSpPr>
            <p:spPr>
              <a:xfrm rot="16200000">
                <a:off x="973092" y="2962537"/>
                <a:ext cx="57740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+mn-lt"/>
                  </a:rPr>
                  <a:t>MCF-7</a:t>
                </a:r>
              </a:p>
            </p:txBody>
          </p:sp>
        </p:grpSp>
        <p:sp>
          <p:nvSpPr>
            <p:cNvPr id="80" name="CasellaDiTesto 79">
              <a:extLst>
                <a:ext uri="{FF2B5EF4-FFF2-40B4-BE49-F238E27FC236}">
                  <a16:creationId xmlns:a16="http://schemas.microsoft.com/office/drawing/2014/main" id="{9A4F88D4-D9BE-4D31-9C97-7FCC25CE0424}"/>
                </a:ext>
              </a:extLst>
            </p:cNvPr>
            <p:cNvSpPr txBox="1"/>
            <p:nvPr/>
          </p:nvSpPr>
          <p:spPr>
            <a:xfrm>
              <a:off x="2952580" y="611560"/>
              <a:ext cx="8691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FOXA1 </a:t>
              </a:r>
              <a:r>
                <a:rPr lang="it-IT" sz="1000" dirty="0" err="1">
                  <a:latin typeface="+mn-lt"/>
                </a:rPr>
                <a:t>siRNA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81" name="CasellaDiTesto 80">
              <a:extLst>
                <a:ext uri="{FF2B5EF4-FFF2-40B4-BE49-F238E27FC236}">
                  <a16:creationId xmlns:a16="http://schemas.microsoft.com/office/drawing/2014/main" id="{6B6DD363-A73D-4DF1-B9F6-EB28E3676392}"/>
                </a:ext>
              </a:extLst>
            </p:cNvPr>
            <p:cNvSpPr txBox="1"/>
            <p:nvPr/>
          </p:nvSpPr>
          <p:spPr>
            <a:xfrm>
              <a:off x="3758445" y="983449"/>
              <a:ext cx="53572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FOXA1</a:t>
              </a:r>
            </a:p>
          </p:txBody>
        </p:sp>
        <p:cxnSp>
          <p:nvCxnSpPr>
            <p:cNvPr id="82" name="Connettore diritto 81">
              <a:extLst>
                <a:ext uri="{FF2B5EF4-FFF2-40B4-BE49-F238E27FC236}">
                  <a16:creationId xmlns:a16="http://schemas.microsoft.com/office/drawing/2014/main" id="{8644FAC1-1850-4BD0-9CB5-46529D9D8F9D}"/>
                </a:ext>
              </a:extLst>
            </p:cNvPr>
            <p:cNvCxnSpPr>
              <a:cxnSpLocks/>
              <a:stCxn id="76" idx="0"/>
              <a:endCxn id="78" idx="0"/>
            </p:cNvCxnSpPr>
            <p:nvPr/>
          </p:nvCxnSpPr>
          <p:spPr>
            <a:xfrm>
              <a:off x="3119349" y="834085"/>
              <a:ext cx="55389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83" name="Immagine 82">
              <a:extLst>
                <a:ext uri="{FF2B5EF4-FFF2-40B4-BE49-F238E27FC236}">
                  <a16:creationId xmlns:a16="http://schemas.microsoft.com/office/drawing/2014/main" id="{DD4B2141-008B-427C-B4B7-E460FE33E0F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725508" y="1233055"/>
              <a:ext cx="1080000" cy="14527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4" name="Immagine 83">
              <a:extLst>
                <a:ext uri="{FF2B5EF4-FFF2-40B4-BE49-F238E27FC236}">
                  <a16:creationId xmlns:a16="http://schemas.microsoft.com/office/drawing/2014/main" id="{8DA32114-7C70-4CEE-BF08-E8B72CCCE38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725508" y="1033920"/>
              <a:ext cx="1080000" cy="14527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5" name="Immagine 84">
              <a:extLst>
                <a:ext uri="{FF2B5EF4-FFF2-40B4-BE49-F238E27FC236}">
                  <a16:creationId xmlns:a16="http://schemas.microsoft.com/office/drawing/2014/main" id="{499E7C11-8A87-433B-B67C-254713957AB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725508" y="1436226"/>
              <a:ext cx="1080000" cy="14527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88" name="CasellaDiTesto 87">
            <a:extLst>
              <a:ext uri="{FF2B5EF4-FFF2-40B4-BE49-F238E27FC236}">
                <a16:creationId xmlns:a16="http://schemas.microsoft.com/office/drawing/2014/main" id="{5F141403-98E2-44F3-856D-84F9A0EADDA5}"/>
              </a:ext>
            </a:extLst>
          </p:cNvPr>
          <p:cNvSpPr txBox="1"/>
          <p:nvPr/>
        </p:nvSpPr>
        <p:spPr>
          <a:xfrm>
            <a:off x="-27384" y="370250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a)</a:t>
            </a:r>
          </a:p>
        </p:txBody>
      </p:sp>
      <p:grpSp>
        <p:nvGrpSpPr>
          <p:cNvPr id="89" name="Gruppo 88">
            <a:extLst>
              <a:ext uri="{FF2B5EF4-FFF2-40B4-BE49-F238E27FC236}">
                <a16:creationId xmlns:a16="http://schemas.microsoft.com/office/drawing/2014/main" id="{BCF3E8D0-66FD-44BE-A2AC-EA034F5E2E13}"/>
              </a:ext>
            </a:extLst>
          </p:cNvPr>
          <p:cNvGrpSpPr/>
          <p:nvPr/>
        </p:nvGrpSpPr>
        <p:grpSpPr>
          <a:xfrm>
            <a:off x="4780258" y="522292"/>
            <a:ext cx="1385046" cy="1474846"/>
            <a:chOff x="4564234" y="405558"/>
            <a:chExt cx="1385046" cy="1474846"/>
          </a:xfrm>
        </p:grpSpPr>
        <p:pic>
          <p:nvPicPr>
            <p:cNvPr id="90" name="Immagine 89">
              <a:extLst>
                <a:ext uri="{FF2B5EF4-FFF2-40B4-BE49-F238E27FC236}">
                  <a16:creationId xmlns:a16="http://schemas.microsoft.com/office/drawing/2014/main" id="{1CAE8395-6925-4414-A685-BFAD4523B81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564234" y="1531020"/>
              <a:ext cx="720000" cy="11627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1" name="Immagine 90">
              <a:extLst>
                <a:ext uri="{FF2B5EF4-FFF2-40B4-BE49-F238E27FC236}">
                  <a16:creationId xmlns:a16="http://schemas.microsoft.com/office/drawing/2014/main" id="{C5E02D75-AD83-47B6-A04E-2A3F4B49FBE5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564234" y="1683769"/>
              <a:ext cx="720000" cy="11627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2" name="CasellaDiTesto 91">
              <a:extLst>
                <a:ext uri="{FF2B5EF4-FFF2-40B4-BE49-F238E27FC236}">
                  <a16:creationId xmlns:a16="http://schemas.microsoft.com/office/drawing/2014/main" id="{1962CEFB-166A-4063-9C2C-61D6D5A1C255}"/>
                </a:ext>
              </a:extLst>
            </p:cNvPr>
            <p:cNvSpPr txBox="1"/>
            <p:nvPr/>
          </p:nvSpPr>
          <p:spPr>
            <a:xfrm>
              <a:off x="5231968" y="1450656"/>
              <a:ext cx="6896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FOXA1</a:t>
              </a:r>
            </a:p>
          </p:txBody>
        </p:sp>
        <p:sp>
          <p:nvSpPr>
            <p:cNvPr id="93" name="CasellaDiTesto 92">
              <a:extLst>
                <a:ext uri="{FF2B5EF4-FFF2-40B4-BE49-F238E27FC236}">
                  <a16:creationId xmlns:a16="http://schemas.microsoft.com/office/drawing/2014/main" id="{1EC44456-E8AD-4E5F-808E-A725FFA79347}"/>
                </a:ext>
              </a:extLst>
            </p:cNvPr>
            <p:cNvSpPr txBox="1"/>
            <p:nvPr/>
          </p:nvSpPr>
          <p:spPr>
            <a:xfrm>
              <a:off x="5231968" y="1603405"/>
              <a:ext cx="7173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/>
                <a:t>Vinculin</a:t>
              </a:r>
              <a:endParaRPr lang="it-IT" sz="1200" dirty="0"/>
            </a:p>
          </p:txBody>
        </p:sp>
        <p:sp>
          <p:nvSpPr>
            <p:cNvPr id="94" name="CasellaDiTesto 93">
              <a:extLst>
                <a:ext uri="{FF2B5EF4-FFF2-40B4-BE49-F238E27FC236}">
                  <a16:creationId xmlns:a16="http://schemas.microsoft.com/office/drawing/2014/main" id="{AA0F5479-06BD-4196-8889-00116FEDCA5B}"/>
                </a:ext>
              </a:extLst>
            </p:cNvPr>
            <p:cNvSpPr txBox="1"/>
            <p:nvPr/>
          </p:nvSpPr>
          <p:spPr>
            <a:xfrm rot="16200000">
              <a:off x="4583287" y="846480"/>
              <a:ext cx="11588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/>
                <a:t>siRNA</a:t>
              </a:r>
              <a:r>
                <a:rPr lang="it-IT" sz="1200" dirty="0"/>
                <a:t> FOXA1</a:t>
              </a:r>
            </a:p>
          </p:txBody>
        </p:sp>
        <p:sp>
          <p:nvSpPr>
            <p:cNvPr id="95" name="CasellaDiTesto 94">
              <a:extLst>
                <a:ext uri="{FF2B5EF4-FFF2-40B4-BE49-F238E27FC236}">
                  <a16:creationId xmlns:a16="http://schemas.microsoft.com/office/drawing/2014/main" id="{E55E1A0A-B7E9-4F2B-90CB-6A1FB6F3E213}"/>
                </a:ext>
              </a:extLst>
            </p:cNvPr>
            <p:cNvSpPr txBox="1"/>
            <p:nvPr/>
          </p:nvSpPr>
          <p:spPr>
            <a:xfrm rot="16200000">
              <a:off x="4461622" y="1175672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CTR</a:t>
              </a:r>
            </a:p>
          </p:txBody>
        </p:sp>
      </p:grpSp>
      <p:sp>
        <p:nvSpPr>
          <p:cNvPr id="96" name="CasellaDiTesto 95">
            <a:extLst>
              <a:ext uri="{FF2B5EF4-FFF2-40B4-BE49-F238E27FC236}">
                <a16:creationId xmlns:a16="http://schemas.microsoft.com/office/drawing/2014/main" id="{970C19F9-AB05-4498-A2B2-2E944F559A7E}"/>
              </a:ext>
            </a:extLst>
          </p:cNvPr>
          <p:cNvSpPr txBox="1"/>
          <p:nvPr/>
        </p:nvSpPr>
        <p:spPr>
          <a:xfrm>
            <a:off x="2564904" y="355047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b)</a:t>
            </a:r>
          </a:p>
        </p:txBody>
      </p:sp>
      <p:grpSp>
        <p:nvGrpSpPr>
          <p:cNvPr id="7" name="Gruppo 6">
            <a:extLst>
              <a:ext uri="{FF2B5EF4-FFF2-40B4-BE49-F238E27FC236}">
                <a16:creationId xmlns:a16="http://schemas.microsoft.com/office/drawing/2014/main" id="{FD92E6C2-63F5-4B28-B451-DB618F119AFC}"/>
              </a:ext>
            </a:extLst>
          </p:cNvPr>
          <p:cNvGrpSpPr/>
          <p:nvPr/>
        </p:nvGrpSpPr>
        <p:grpSpPr>
          <a:xfrm>
            <a:off x="116632" y="2151668"/>
            <a:ext cx="1115087" cy="1688871"/>
            <a:chOff x="116632" y="2151668"/>
            <a:chExt cx="1115087" cy="1688871"/>
          </a:xfrm>
        </p:grpSpPr>
        <p:sp>
          <p:nvSpPr>
            <p:cNvPr id="98" name="CasellaDiTesto 97">
              <a:extLst>
                <a:ext uri="{FF2B5EF4-FFF2-40B4-BE49-F238E27FC236}">
                  <a16:creationId xmlns:a16="http://schemas.microsoft.com/office/drawing/2014/main" id="{980843F9-B073-4F48-A0F2-BDCB60A82DCF}"/>
                </a:ext>
              </a:extLst>
            </p:cNvPr>
            <p:cNvSpPr txBox="1"/>
            <p:nvPr/>
          </p:nvSpPr>
          <p:spPr>
            <a:xfrm rot="16200000">
              <a:off x="-38748" y="2634874"/>
              <a:ext cx="121263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siRNA</a:t>
              </a:r>
              <a:r>
                <a:rPr lang="it-IT" sz="1000" dirty="0">
                  <a:latin typeface="+mn-lt"/>
                </a:rPr>
                <a:t> FOXA1</a:t>
              </a:r>
            </a:p>
          </p:txBody>
        </p:sp>
        <p:sp>
          <p:nvSpPr>
            <p:cNvPr id="99" name="CasellaDiTesto 98">
              <a:extLst>
                <a:ext uri="{FF2B5EF4-FFF2-40B4-BE49-F238E27FC236}">
                  <a16:creationId xmlns:a16="http://schemas.microsoft.com/office/drawing/2014/main" id="{A1F4BF96-A504-4862-9A59-D54620FC3923}"/>
                </a:ext>
              </a:extLst>
            </p:cNvPr>
            <p:cNvSpPr txBox="1"/>
            <p:nvPr/>
          </p:nvSpPr>
          <p:spPr>
            <a:xfrm rot="16200000">
              <a:off x="-16955" y="2984494"/>
              <a:ext cx="513395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CTR</a:t>
              </a:r>
            </a:p>
          </p:txBody>
        </p:sp>
        <p:grpSp>
          <p:nvGrpSpPr>
            <p:cNvPr id="5" name="Gruppo 4">
              <a:extLst>
                <a:ext uri="{FF2B5EF4-FFF2-40B4-BE49-F238E27FC236}">
                  <a16:creationId xmlns:a16="http://schemas.microsoft.com/office/drawing/2014/main" id="{5C72323A-9DBE-444F-8E24-70C60BC074E9}"/>
                </a:ext>
              </a:extLst>
            </p:cNvPr>
            <p:cNvGrpSpPr/>
            <p:nvPr/>
          </p:nvGrpSpPr>
          <p:grpSpPr>
            <a:xfrm>
              <a:off x="599815" y="3218021"/>
              <a:ext cx="631904" cy="622518"/>
              <a:chOff x="599815" y="3218021"/>
              <a:chExt cx="631904" cy="622518"/>
            </a:xfrm>
          </p:grpSpPr>
          <p:sp>
            <p:nvSpPr>
              <p:cNvPr id="101" name="CasellaDiTesto 100">
                <a:extLst>
                  <a:ext uri="{FF2B5EF4-FFF2-40B4-BE49-F238E27FC236}">
                    <a16:creationId xmlns:a16="http://schemas.microsoft.com/office/drawing/2014/main" id="{967F4E44-D8F5-471E-9678-CD03AA1FCD10}"/>
                  </a:ext>
                </a:extLst>
              </p:cNvPr>
              <p:cNvSpPr txBox="1"/>
              <p:nvPr/>
            </p:nvSpPr>
            <p:spPr>
              <a:xfrm>
                <a:off x="599815" y="3466065"/>
                <a:ext cx="436338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+mn-lt"/>
                  </a:rPr>
                  <a:t>ER</a:t>
                </a:r>
                <a:r>
                  <a:rPr lang="el-GR" sz="1000" dirty="0">
                    <a:latin typeface="+mn-lt"/>
                    <a:cs typeface="Times New Roman" panose="02020603050405020304" pitchFamily="18" charset="0"/>
                  </a:rPr>
                  <a:t>α</a:t>
                </a:r>
                <a:endParaRPr lang="it-IT" sz="1000" dirty="0">
                  <a:latin typeface="+mn-lt"/>
                </a:endParaRPr>
              </a:p>
            </p:txBody>
          </p:sp>
          <p:sp>
            <p:nvSpPr>
              <p:cNvPr id="102" name="CasellaDiTesto 101">
                <a:extLst>
                  <a:ext uri="{FF2B5EF4-FFF2-40B4-BE49-F238E27FC236}">
                    <a16:creationId xmlns:a16="http://schemas.microsoft.com/office/drawing/2014/main" id="{48F5E098-7612-4944-8A22-396DC25216EF}"/>
                  </a:ext>
                </a:extLst>
              </p:cNvPr>
              <p:cNvSpPr txBox="1"/>
              <p:nvPr/>
            </p:nvSpPr>
            <p:spPr>
              <a:xfrm>
                <a:off x="599815" y="3594318"/>
                <a:ext cx="631904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err="1">
                    <a:latin typeface="+mn-lt"/>
                  </a:rPr>
                  <a:t>Vinculin</a:t>
                </a:r>
                <a:endParaRPr lang="it-IT" sz="1000" dirty="0">
                  <a:latin typeface="+mn-lt"/>
                </a:endParaRPr>
              </a:p>
            </p:txBody>
          </p:sp>
          <p:sp>
            <p:nvSpPr>
              <p:cNvPr id="103" name="CasellaDiTesto 102">
                <a:extLst>
                  <a:ext uri="{FF2B5EF4-FFF2-40B4-BE49-F238E27FC236}">
                    <a16:creationId xmlns:a16="http://schemas.microsoft.com/office/drawing/2014/main" id="{7CB7C46F-912B-4E3C-B0B2-13A0A58A3DF9}"/>
                  </a:ext>
                </a:extLst>
              </p:cNvPr>
              <p:cNvSpPr txBox="1"/>
              <p:nvPr/>
            </p:nvSpPr>
            <p:spPr>
              <a:xfrm>
                <a:off x="599815" y="3344316"/>
                <a:ext cx="603050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+mn-lt"/>
                  </a:rPr>
                  <a:t>FOXA1</a:t>
                </a:r>
              </a:p>
            </p:txBody>
          </p:sp>
          <p:sp>
            <p:nvSpPr>
              <p:cNvPr id="118" name="CasellaDiTesto 117">
                <a:extLst>
                  <a:ext uri="{FF2B5EF4-FFF2-40B4-BE49-F238E27FC236}">
                    <a16:creationId xmlns:a16="http://schemas.microsoft.com/office/drawing/2014/main" id="{6D9C65CF-BBA6-4772-88A4-8C552C93356F}"/>
                  </a:ext>
                </a:extLst>
              </p:cNvPr>
              <p:cNvSpPr txBox="1"/>
              <p:nvPr/>
            </p:nvSpPr>
            <p:spPr>
              <a:xfrm>
                <a:off x="599815" y="3218021"/>
                <a:ext cx="410690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+mn-lt"/>
                  </a:rPr>
                  <a:t>pS2</a:t>
                </a:r>
              </a:p>
            </p:txBody>
          </p:sp>
        </p:grpSp>
        <p:grpSp>
          <p:nvGrpSpPr>
            <p:cNvPr id="6" name="Gruppo 5">
              <a:extLst>
                <a:ext uri="{FF2B5EF4-FFF2-40B4-BE49-F238E27FC236}">
                  <a16:creationId xmlns:a16="http://schemas.microsoft.com/office/drawing/2014/main" id="{F163F9A8-BCC1-4C67-9C65-8EEAC238969A}"/>
                </a:ext>
              </a:extLst>
            </p:cNvPr>
            <p:cNvGrpSpPr/>
            <p:nvPr/>
          </p:nvGrpSpPr>
          <p:grpSpPr>
            <a:xfrm>
              <a:off x="139049" y="3299411"/>
              <a:ext cx="518400" cy="458544"/>
              <a:chOff x="139049" y="3299411"/>
              <a:chExt cx="518400" cy="458544"/>
            </a:xfrm>
          </p:grpSpPr>
          <p:pic>
            <p:nvPicPr>
              <p:cNvPr id="119" name="Immagine 118">
                <a:extLst>
                  <a:ext uri="{FF2B5EF4-FFF2-40B4-BE49-F238E27FC236}">
                    <a16:creationId xmlns:a16="http://schemas.microsoft.com/office/drawing/2014/main" id="{2437D470-7B97-47BB-858D-BA9E17C43E8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39049" y="3425706"/>
                <a:ext cx="518400" cy="8344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20" name="Immagine 119">
                <a:extLst>
                  <a:ext uri="{FF2B5EF4-FFF2-40B4-BE49-F238E27FC236}">
                    <a16:creationId xmlns:a16="http://schemas.microsoft.com/office/drawing/2014/main" id="{C93F3201-7689-439D-9348-1CE7EAE608C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39049" y="3299411"/>
                <a:ext cx="518400" cy="8344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21" name="Immagine 120">
                <a:extLst>
                  <a:ext uri="{FF2B5EF4-FFF2-40B4-BE49-F238E27FC236}">
                    <a16:creationId xmlns:a16="http://schemas.microsoft.com/office/drawing/2014/main" id="{7F51D9D0-A617-49B4-B859-F87B82162A2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39049" y="3546261"/>
                <a:ext cx="518400" cy="8344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22" name="Immagine 121">
                <a:extLst>
                  <a:ext uri="{FF2B5EF4-FFF2-40B4-BE49-F238E27FC236}">
                    <a16:creationId xmlns:a16="http://schemas.microsoft.com/office/drawing/2014/main" id="{B7D9E4F4-19D9-41A3-BE89-6FD1D475C9F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39049" y="3674514"/>
                <a:ext cx="518400" cy="8344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</p:grpSp>
      <p:grpSp>
        <p:nvGrpSpPr>
          <p:cNvPr id="123" name="Gruppo 122">
            <a:extLst>
              <a:ext uri="{FF2B5EF4-FFF2-40B4-BE49-F238E27FC236}">
                <a16:creationId xmlns:a16="http://schemas.microsoft.com/office/drawing/2014/main" id="{59541AB8-63FD-4849-A88B-2927A82587C4}"/>
              </a:ext>
            </a:extLst>
          </p:cNvPr>
          <p:cNvGrpSpPr/>
          <p:nvPr/>
        </p:nvGrpSpPr>
        <p:grpSpPr>
          <a:xfrm>
            <a:off x="1310288" y="2649412"/>
            <a:ext cx="2464763" cy="1191127"/>
            <a:chOff x="3164718" y="2444769"/>
            <a:chExt cx="2464763" cy="1191127"/>
          </a:xfrm>
        </p:grpSpPr>
        <p:pic>
          <p:nvPicPr>
            <p:cNvPr id="124" name="Immagine 123">
              <a:extLst>
                <a:ext uri="{FF2B5EF4-FFF2-40B4-BE49-F238E27FC236}">
                  <a16:creationId xmlns:a16="http://schemas.microsoft.com/office/drawing/2014/main" id="{5DDF323F-7AB0-46D1-B6BB-EEA8B24BF766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3197933" y="2898865"/>
              <a:ext cx="1800000" cy="13989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5" name="Immagine 124">
              <a:extLst>
                <a:ext uri="{FF2B5EF4-FFF2-40B4-BE49-F238E27FC236}">
                  <a16:creationId xmlns:a16="http://schemas.microsoft.com/office/drawing/2014/main" id="{2A3369F2-9072-495F-A57D-8499B57EE466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197933" y="3071466"/>
              <a:ext cx="1800000" cy="13989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8" name="Immagine 127">
              <a:extLst>
                <a:ext uri="{FF2B5EF4-FFF2-40B4-BE49-F238E27FC236}">
                  <a16:creationId xmlns:a16="http://schemas.microsoft.com/office/drawing/2014/main" id="{2C7EF384-BB6B-4911-B00A-EDA30588D75B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197933" y="3257010"/>
              <a:ext cx="1800000" cy="13989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9" name="Immagine 128">
              <a:extLst>
                <a:ext uri="{FF2B5EF4-FFF2-40B4-BE49-F238E27FC236}">
                  <a16:creationId xmlns:a16="http://schemas.microsoft.com/office/drawing/2014/main" id="{CBBDCA6F-7108-44DE-979D-CDB4A2B4D23B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197933" y="3442837"/>
              <a:ext cx="1800000" cy="13989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0" name="CasellaDiTesto 129">
              <a:extLst>
                <a:ext uri="{FF2B5EF4-FFF2-40B4-BE49-F238E27FC236}">
                  <a16:creationId xmlns:a16="http://schemas.microsoft.com/office/drawing/2014/main" id="{511B1A61-1D3C-493D-93F6-4E4BF6C94E63}"/>
                </a:ext>
              </a:extLst>
            </p:cNvPr>
            <p:cNvSpPr txBox="1"/>
            <p:nvPr/>
          </p:nvSpPr>
          <p:spPr>
            <a:xfrm>
              <a:off x="4029245" y="2444769"/>
              <a:ext cx="121263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siRNA</a:t>
              </a:r>
              <a:r>
                <a:rPr lang="it-IT" sz="1000" dirty="0">
                  <a:latin typeface="+mn-lt"/>
                </a:rPr>
                <a:t> FOXA1</a:t>
              </a:r>
            </a:p>
          </p:txBody>
        </p:sp>
        <p:sp>
          <p:nvSpPr>
            <p:cNvPr id="131" name="CasellaDiTesto 130">
              <a:extLst>
                <a:ext uri="{FF2B5EF4-FFF2-40B4-BE49-F238E27FC236}">
                  <a16:creationId xmlns:a16="http://schemas.microsoft.com/office/drawing/2014/main" id="{FBF230F3-D7C1-4B9C-A85E-26C6B0C04159}"/>
                </a:ext>
              </a:extLst>
            </p:cNvPr>
            <p:cNvSpPr txBox="1"/>
            <p:nvPr/>
          </p:nvSpPr>
          <p:spPr>
            <a:xfrm>
              <a:off x="3382138" y="2444769"/>
              <a:ext cx="513395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CTR</a:t>
              </a:r>
            </a:p>
          </p:txBody>
        </p:sp>
        <p:sp>
          <p:nvSpPr>
            <p:cNvPr id="132" name="CasellaDiTesto 131">
              <a:extLst>
                <a:ext uri="{FF2B5EF4-FFF2-40B4-BE49-F238E27FC236}">
                  <a16:creationId xmlns:a16="http://schemas.microsoft.com/office/drawing/2014/main" id="{BF7DE380-7CDC-4774-A543-97207DE32659}"/>
                </a:ext>
              </a:extLst>
            </p:cNvPr>
            <p:cNvSpPr txBox="1"/>
            <p:nvPr/>
          </p:nvSpPr>
          <p:spPr>
            <a:xfrm>
              <a:off x="4963914" y="3018304"/>
              <a:ext cx="43633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ER</a:t>
              </a:r>
              <a:r>
                <a:rPr lang="el-GR" sz="1000" dirty="0">
                  <a:latin typeface="+mn-lt"/>
                  <a:cs typeface="Times New Roman" panose="02020603050405020304" pitchFamily="18" charset="0"/>
                </a:rPr>
                <a:t>α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133" name="CasellaDiTesto 132">
              <a:extLst>
                <a:ext uri="{FF2B5EF4-FFF2-40B4-BE49-F238E27FC236}">
                  <a16:creationId xmlns:a16="http://schemas.microsoft.com/office/drawing/2014/main" id="{E9C011D7-C55C-4FCB-B647-F6F988132127}"/>
                </a:ext>
              </a:extLst>
            </p:cNvPr>
            <p:cNvSpPr txBox="1"/>
            <p:nvPr/>
          </p:nvSpPr>
          <p:spPr>
            <a:xfrm>
              <a:off x="4963914" y="3389675"/>
              <a:ext cx="63190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Vinculin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134" name="CasellaDiTesto 133">
              <a:extLst>
                <a:ext uri="{FF2B5EF4-FFF2-40B4-BE49-F238E27FC236}">
                  <a16:creationId xmlns:a16="http://schemas.microsoft.com/office/drawing/2014/main" id="{FE141C4D-94C2-4515-AE49-967D1E1755D3}"/>
                </a:ext>
              </a:extLst>
            </p:cNvPr>
            <p:cNvSpPr txBox="1"/>
            <p:nvPr/>
          </p:nvSpPr>
          <p:spPr>
            <a:xfrm>
              <a:off x="4963914" y="3203848"/>
              <a:ext cx="60305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FOXA1</a:t>
              </a:r>
            </a:p>
          </p:txBody>
        </p:sp>
        <p:sp>
          <p:nvSpPr>
            <p:cNvPr id="135" name="CasellaDiTesto 134">
              <a:extLst>
                <a:ext uri="{FF2B5EF4-FFF2-40B4-BE49-F238E27FC236}">
                  <a16:creationId xmlns:a16="http://schemas.microsoft.com/office/drawing/2014/main" id="{9FFC2E81-5E01-4053-A717-E2EFAC290499}"/>
                </a:ext>
              </a:extLst>
            </p:cNvPr>
            <p:cNvSpPr txBox="1"/>
            <p:nvPr/>
          </p:nvSpPr>
          <p:spPr>
            <a:xfrm>
              <a:off x="4963914" y="2845703"/>
              <a:ext cx="41069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pS2</a:t>
              </a:r>
            </a:p>
          </p:txBody>
        </p:sp>
        <p:sp>
          <p:nvSpPr>
            <p:cNvPr id="136" name="CasellaDiTesto 135">
              <a:extLst>
                <a:ext uri="{FF2B5EF4-FFF2-40B4-BE49-F238E27FC236}">
                  <a16:creationId xmlns:a16="http://schemas.microsoft.com/office/drawing/2014/main" id="{31D3AC15-8EF8-4BBC-9067-0327E518F4C7}"/>
                </a:ext>
              </a:extLst>
            </p:cNvPr>
            <p:cNvSpPr txBox="1"/>
            <p:nvPr/>
          </p:nvSpPr>
          <p:spPr>
            <a:xfrm>
              <a:off x="4045976" y="265334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137" name="CasellaDiTesto 136">
              <a:extLst>
                <a:ext uri="{FF2B5EF4-FFF2-40B4-BE49-F238E27FC236}">
                  <a16:creationId xmlns:a16="http://schemas.microsoft.com/office/drawing/2014/main" id="{EBAC89FE-F83B-4EB9-BB64-A0B9CDEF4B3E}"/>
                </a:ext>
              </a:extLst>
            </p:cNvPr>
            <p:cNvSpPr txBox="1"/>
            <p:nvPr/>
          </p:nvSpPr>
          <p:spPr>
            <a:xfrm>
              <a:off x="4216265" y="265334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</a:t>
              </a:r>
            </a:p>
          </p:txBody>
        </p:sp>
        <p:sp>
          <p:nvSpPr>
            <p:cNvPr id="138" name="CasellaDiTesto 137">
              <a:extLst>
                <a:ext uri="{FF2B5EF4-FFF2-40B4-BE49-F238E27FC236}">
                  <a16:creationId xmlns:a16="http://schemas.microsoft.com/office/drawing/2014/main" id="{FEE2621A-C148-4FC8-A92A-D0FED4A5BC48}"/>
                </a:ext>
              </a:extLst>
            </p:cNvPr>
            <p:cNvSpPr txBox="1"/>
            <p:nvPr/>
          </p:nvSpPr>
          <p:spPr>
            <a:xfrm>
              <a:off x="4437888" y="265334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20</a:t>
              </a:r>
            </a:p>
          </p:txBody>
        </p:sp>
        <p:sp>
          <p:nvSpPr>
            <p:cNvPr id="139" name="CasellaDiTesto 138">
              <a:extLst>
                <a:ext uri="{FF2B5EF4-FFF2-40B4-BE49-F238E27FC236}">
                  <a16:creationId xmlns:a16="http://schemas.microsoft.com/office/drawing/2014/main" id="{46655F57-F83F-4108-8A96-27F96A8E2C95}"/>
                </a:ext>
              </a:extLst>
            </p:cNvPr>
            <p:cNvSpPr txBox="1"/>
            <p:nvPr/>
          </p:nvSpPr>
          <p:spPr>
            <a:xfrm>
              <a:off x="4698907" y="265334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40</a:t>
              </a:r>
            </a:p>
          </p:txBody>
        </p:sp>
        <p:sp>
          <p:nvSpPr>
            <p:cNvPr id="140" name="CasellaDiTesto 139">
              <a:extLst>
                <a:ext uri="{FF2B5EF4-FFF2-40B4-BE49-F238E27FC236}">
                  <a16:creationId xmlns:a16="http://schemas.microsoft.com/office/drawing/2014/main" id="{13B21C2F-3AD6-46FC-A4B5-C2AF1ECCA40C}"/>
                </a:ext>
              </a:extLst>
            </p:cNvPr>
            <p:cNvSpPr txBox="1"/>
            <p:nvPr/>
          </p:nvSpPr>
          <p:spPr>
            <a:xfrm>
              <a:off x="4963914" y="2653343"/>
              <a:ext cx="6655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Tel (µM)</a:t>
              </a:r>
            </a:p>
          </p:txBody>
        </p:sp>
        <p:sp>
          <p:nvSpPr>
            <p:cNvPr id="141" name="CasellaDiTesto 140">
              <a:extLst>
                <a:ext uri="{FF2B5EF4-FFF2-40B4-BE49-F238E27FC236}">
                  <a16:creationId xmlns:a16="http://schemas.microsoft.com/office/drawing/2014/main" id="{532540F2-D026-45ED-93B1-B31ADF84B78B}"/>
                </a:ext>
              </a:extLst>
            </p:cNvPr>
            <p:cNvSpPr txBox="1"/>
            <p:nvPr/>
          </p:nvSpPr>
          <p:spPr>
            <a:xfrm>
              <a:off x="3164718" y="265334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142" name="CasellaDiTesto 141">
              <a:extLst>
                <a:ext uri="{FF2B5EF4-FFF2-40B4-BE49-F238E27FC236}">
                  <a16:creationId xmlns:a16="http://schemas.microsoft.com/office/drawing/2014/main" id="{7A11009D-3937-4B9A-ABE7-23FB2FAF6E92}"/>
                </a:ext>
              </a:extLst>
            </p:cNvPr>
            <p:cNvSpPr txBox="1"/>
            <p:nvPr/>
          </p:nvSpPr>
          <p:spPr>
            <a:xfrm>
              <a:off x="3335007" y="265334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</a:t>
              </a:r>
            </a:p>
          </p:txBody>
        </p:sp>
        <p:sp>
          <p:nvSpPr>
            <p:cNvPr id="143" name="CasellaDiTesto 142">
              <a:extLst>
                <a:ext uri="{FF2B5EF4-FFF2-40B4-BE49-F238E27FC236}">
                  <a16:creationId xmlns:a16="http://schemas.microsoft.com/office/drawing/2014/main" id="{5FF821D0-D63B-4CBB-8F59-39EEA071FB1C}"/>
                </a:ext>
              </a:extLst>
            </p:cNvPr>
            <p:cNvSpPr txBox="1"/>
            <p:nvPr/>
          </p:nvSpPr>
          <p:spPr>
            <a:xfrm>
              <a:off x="3556630" y="265334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20</a:t>
              </a:r>
            </a:p>
          </p:txBody>
        </p:sp>
        <p:sp>
          <p:nvSpPr>
            <p:cNvPr id="144" name="CasellaDiTesto 143">
              <a:extLst>
                <a:ext uri="{FF2B5EF4-FFF2-40B4-BE49-F238E27FC236}">
                  <a16:creationId xmlns:a16="http://schemas.microsoft.com/office/drawing/2014/main" id="{63F540F3-230B-477D-A1BC-F04AF48F7BDD}"/>
                </a:ext>
              </a:extLst>
            </p:cNvPr>
            <p:cNvSpPr txBox="1"/>
            <p:nvPr/>
          </p:nvSpPr>
          <p:spPr>
            <a:xfrm>
              <a:off x="3817649" y="265334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40</a:t>
              </a:r>
            </a:p>
          </p:txBody>
        </p:sp>
        <p:cxnSp>
          <p:nvCxnSpPr>
            <p:cNvPr id="145" name="Connettore diritto 144">
              <a:extLst>
                <a:ext uri="{FF2B5EF4-FFF2-40B4-BE49-F238E27FC236}">
                  <a16:creationId xmlns:a16="http://schemas.microsoft.com/office/drawing/2014/main" id="{9EBBC8B2-3E13-4123-82E4-794997404E90}"/>
                </a:ext>
              </a:extLst>
            </p:cNvPr>
            <p:cNvCxnSpPr>
              <a:stCxn id="141" idx="0"/>
              <a:endCxn id="144" idx="0"/>
            </p:cNvCxnSpPr>
            <p:nvPr/>
          </p:nvCxnSpPr>
          <p:spPr>
            <a:xfrm>
              <a:off x="3292317" y="2653343"/>
              <a:ext cx="68819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6" name="Connettore diritto 145">
              <a:extLst>
                <a:ext uri="{FF2B5EF4-FFF2-40B4-BE49-F238E27FC236}">
                  <a16:creationId xmlns:a16="http://schemas.microsoft.com/office/drawing/2014/main" id="{6E5D3C05-AF2D-4EB4-9CB8-6C1A1FFA9311}"/>
                </a:ext>
              </a:extLst>
            </p:cNvPr>
            <p:cNvCxnSpPr>
              <a:stCxn id="136" idx="0"/>
              <a:endCxn id="139" idx="0"/>
            </p:cNvCxnSpPr>
            <p:nvPr/>
          </p:nvCxnSpPr>
          <p:spPr>
            <a:xfrm>
              <a:off x="4173575" y="2653343"/>
              <a:ext cx="68819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47" name="CasellaDiTesto 146">
            <a:extLst>
              <a:ext uri="{FF2B5EF4-FFF2-40B4-BE49-F238E27FC236}">
                <a16:creationId xmlns:a16="http://schemas.microsoft.com/office/drawing/2014/main" id="{0F7A31F7-4AAC-46BF-B86E-1B1092BFED7D}"/>
              </a:ext>
            </a:extLst>
          </p:cNvPr>
          <p:cNvSpPr txBox="1"/>
          <p:nvPr/>
        </p:nvSpPr>
        <p:spPr>
          <a:xfrm>
            <a:off x="-27384" y="2103920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c)</a:t>
            </a:r>
          </a:p>
        </p:txBody>
      </p:sp>
      <p:sp>
        <p:nvSpPr>
          <p:cNvPr id="148" name="CasellaDiTesto 147">
            <a:extLst>
              <a:ext uri="{FF2B5EF4-FFF2-40B4-BE49-F238E27FC236}">
                <a16:creationId xmlns:a16="http://schemas.microsoft.com/office/drawing/2014/main" id="{B475F295-EC05-4EBB-8B70-9E4A2516E1AA}"/>
              </a:ext>
            </a:extLst>
          </p:cNvPr>
          <p:cNvSpPr txBox="1"/>
          <p:nvPr/>
        </p:nvSpPr>
        <p:spPr>
          <a:xfrm>
            <a:off x="1052736" y="2103920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d)</a:t>
            </a:r>
          </a:p>
        </p:txBody>
      </p:sp>
      <p:grpSp>
        <p:nvGrpSpPr>
          <p:cNvPr id="149" name="Gruppo 148">
            <a:extLst>
              <a:ext uri="{FF2B5EF4-FFF2-40B4-BE49-F238E27FC236}">
                <a16:creationId xmlns:a16="http://schemas.microsoft.com/office/drawing/2014/main" id="{4766C56B-99B3-4A21-B905-02006B2FD621}"/>
              </a:ext>
            </a:extLst>
          </p:cNvPr>
          <p:cNvGrpSpPr/>
          <p:nvPr/>
        </p:nvGrpSpPr>
        <p:grpSpPr>
          <a:xfrm>
            <a:off x="1556792" y="6937018"/>
            <a:ext cx="1218410" cy="1554720"/>
            <a:chOff x="2382310" y="139213"/>
            <a:chExt cx="1218410" cy="1554720"/>
          </a:xfrm>
        </p:grpSpPr>
        <p:sp>
          <p:nvSpPr>
            <p:cNvPr id="150" name="CasellaDiTesto 149">
              <a:extLst>
                <a:ext uri="{FF2B5EF4-FFF2-40B4-BE49-F238E27FC236}">
                  <a16:creationId xmlns:a16="http://schemas.microsoft.com/office/drawing/2014/main" id="{9DC5C0F6-0784-4E92-9595-E3781FFB4174}"/>
                </a:ext>
              </a:extLst>
            </p:cNvPr>
            <p:cNvSpPr txBox="1"/>
            <p:nvPr/>
          </p:nvSpPr>
          <p:spPr>
            <a:xfrm rot="16200000">
              <a:off x="2249679" y="580135"/>
              <a:ext cx="11588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/>
                <a:t>siRNA</a:t>
              </a:r>
              <a:r>
                <a:rPr lang="it-IT" sz="1200" dirty="0"/>
                <a:t> FOXA1</a:t>
              </a:r>
            </a:p>
          </p:txBody>
        </p:sp>
        <p:sp>
          <p:nvSpPr>
            <p:cNvPr id="151" name="CasellaDiTesto 150">
              <a:extLst>
                <a:ext uri="{FF2B5EF4-FFF2-40B4-BE49-F238E27FC236}">
                  <a16:creationId xmlns:a16="http://schemas.microsoft.com/office/drawing/2014/main" id="{4F0AC9F4-FDD2-40F7-83D3-E70877C64421}"/>
                </a:ext>
              </a:extLst>
            </p:cNvPr>
            <p:cNvSpPr txBox="1"/>
            <p:nvPr/>
          </p:nvSpPr>
          <p:spPr>
            <a:xfrm rot="16200000">
              <a:off x="2270581" y="909327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CTR</a:t>
              </a:r>
            </a:p>
          </p:txBody>
        </p:sp>
        <p:sp>
          <p:nvSpPr>
            <p:cNvPr id="152" name="CasellaDiTesto 151">
              <a:extLst>
                <a:ext uri="{FF2B5EF4-FFF2-40B4-BE49-F238E27FC236}">
                  <a16:creationId xmlns:a16="http://schemas.microsoft.com/office/drawing/2014/main" id="{181825F4-6099-49DE-8668-2A9E3D8810EE}"/>
                </a:ext>
              </a:extLst>
            </p:cNvPr>
            <p:cNvSpPr txBox="1"/>
            <p:nvPr/>
          </p:nvSpPr>
          <p:spPr>
            <a:xfrm>
              <a:off x="2883408" y="1416934"/>
              <a:ext cx="7173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/>
                <a:t>Vinculin</a:t>
              </a:r>
              <a:endParaRPr lang="it-IT" sz="1200" dirty="0"/>
            </a:p>
          </p:txBody>
        </p:sp>
        <p:sp>
          <p:nvSpPr>
            <p:cNvPr id="153" name="CasellaDiTesto 152">
              <a:extLst>
                <a:ext uri="{FF2B5EF4-FFF2-40B4-BE49-F238E27FC236}">
                  <a16:creationId xmlns:a16="http://schemas.microsoft.com/office/drawing/2014/main" id="{5FD8853A-F9E6-4CC6-B36D-61B887BE9E2A}"/>
                </a:ext>
              </a:extLst>
            </p:cNvPr>
            <p:cNvSpPr txBox="1"/>
            <p:nvPr/>
          </p:nvSpPr>
          <p:spPr>
            <a:xfrm>
              <a:off x="2882859" y="1212685"/>
              <a:ext cx="6896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FOXA1</a:t>
              </a:r>
            </a:p>
          </p:txBody>
        </p:sp>
        <p:pic>
          <p:nvPicPr>
            <p:cNvPr id="154" name="Immagine 153">
              <a:extLst>
                <a:ext uri="{FF2B5EF4-FFF2-40B4-BE49-F238E27FC236}">
                  <a16:creationId xmlns:a16="http://schemas.microsoft.com/office/drawing/2014/main" id="{EF5592CA-6FFB-450F-928F-12F81461A72A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397154" y="1268296"/>
              <a:ext cx="540000" cy="16577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55" name="Immagine 154">
              <a:extLst>
                <a:ext uri="{FF2B5EF4-FFF2-40B4-BE49-F238E27FC236}">
                  <a16:creationId xmlns:a16="http://schemas.microsoft.com/office/drawing/2014/main" id="{DFB5D778-DAF9-4DD9-8F3C-BE520A3C12EE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>
              <a:extLst>
                <a:ext uri="{BEBA8EAE-BF5A-486C-A8C5-ECC9F3942E4B}">
                  <a14:imgProps xmlns:a14="http://schemas.microsoft.com/office/drawing/2010/main">
                    <a14:imgLayer r:embed="rId30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397154" y="1472545"/>
              <a:ext cx="540000" cy="16577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156" name="CasellaDiTesto 155">
            <a:extLst>
              <a:ext uri="{FF2B5EF4-FFF2-40B4-BE49-F238E27FC236}">
                <a16:creationId xmlns:a16="http://schemas.microsoft.com/office/drawing/2014/main" id="{48DC79B3-B365-4875-9242-0B92EE392CF8}"/>
              </a:ext>
            </a:extLst>
          </p:cNvPr>
          <p:cNvSpPr txBox="1"/>
          <p:nvPr/>
        </p:nvSpPr>
        <p:spPr>
          <a:xfrm>
            <a:off x="-27384" y="6630035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e)</a:t>
            </a:r>
          </a:p>
        </p:txBody>
      </p:sp>
      <p:grpSp>
        <p:nvGrpSpPr>
          <p:cNvPr id="104" name="Gruppo 103">
            <a:extLst>
              <a:ext uri="{FF2B5EF4-FFF2-40B4-BE49-F238E27FC236}">
                <a16:creationId xmlns:a16="http://schemas.microsoft.com/office/drawing/2014/main" id="{A02B97BC-E35A-4BA3-A24B-48325D30302B}"/>
              </a:ext>
            </a:extLst>
          </p:cNvPr>
          <p:cNvGrpSpPr/>
          <p:nvPr/>
        </p:nvGrpSpPr>
        <p:grpSpPr>
          <a:xfrm>
            <a:off x="3079664" y="467711"/>
            <a:ext cx="1610521" cy="1584009"/>
            <a:chOff x="248872" y="695454"/>
            <a:chExt cx="1610521" cy="1584009"/>
          </a:xfrm>
        </p:grpSpPr>
        <p:pic>
          <p:nvPicPr>
            <p:cNvPr id="105" name="Immagine 104">
              <a:extLst>
                <a:ext uri="{FF2B5EF4-FFF2-40B4-BE49-F238E27FC236}">
                  <a16:creationId xmlns:a16="http://schemas.microsoft.com/office/drawing/2014/main" id="{34537AE8-7A55-48EC-9628-21DE7FA060BD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1043411" y="1210261"/>
              <a:ext cx="580889" cy="849600"/>
            </a:xfrm>
            <a:prstGeom prst="rect">
              <a:avLst/>
            </a:prstGeom>
          </p:spPr>
        </p:pic>
        <p:sp>
          <p:nvSpPr>
            <p:cNvPr id="106" name="CasellaDiTesto 105">
              <a:extLst>
                <a:ext uri="{FF2B5EF4-FFF2-40B4-BE49-F238E27FC236}">
                  <a16:creationId xmlns:a16="http://schemas.microsoft.com/office/drawing/2014/main" id="{6051DCAE-D2C8-4C59-A48F-045989667A93}"/>
                </a:ext>
              </a:extLst>
            </p:cNvPr>
            <p:cNvSpPr txBox="1"/>
            <p:nvPr/>
          </p:nvSpPr>
          <p:spPr>
            <a:xfrm rot="16200000">
              <a:off x="-99140" y="1388468"/>
              <a:ext cx="115768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/>
                <a:t>ERE Activity</a:t>
              </a:r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CTR)</a:t>
              </a:r>
            </a:p>
          </p:txBody>
        </p:sp>
        <p:sp>
          <p:nvSpPr>
            <p:cNvPr id="107" name="CasellaDiTesto 106">
              <a:extLst>
                <a:ext uri="{FF2B5EF4-FFF2-40B4-BE49-F238E27FC236}">
                  <a16:creationId xmlns:a16="http://schemas.microsoft.com/office/drawing/2014/main" id="{AC2F678F-F600-4747-A78A-4417D595D6E5}"/>
                </a:ext>
              </a:extLst>
            </p:cNvPr>
            <p:cNvSpPr txBox="1"/>
            <p:nvPr/>
          </p:nvSpPr>
          <p:spPr>
            <a:xfrm>
              <a:off x="735281" y="1073352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2</a:t>
              </a:r>
            </a:p>
          </p:txBody>
        </p:sp>
        <p:sp>
          <p:nvSpPr>
            <p:cNvPr id="108" name="CasellaDiTesto 107">
              <a:extLst>
                <a:ext uri="{FF2B5EF4-FFF2-40B4-BE49-F238E27FC236}">
                  <a16:creationId xmlns:a16="http://schemas.microsoft.com/office/drawing/2014/main" id="{8C9F2B22-58B8-422B-834F-1814C672E033}"/>
                </a:ext>
              </a:extLst>
            </p:cNvPr>
            <p:cNvSpPr txBox="1"/>
            <p:nvPr/>
          </p:nvSpPr>
          <p:spPr>
            <a:xfrm>
              <a:off x="735281" y="148365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6</a:t>
              </a:r>
            </a:p>
          </p:txBody>
        </p:sp>
        <p:sp>
          <p:nvSpPr>
            <p:cNvPr id="109" name="CasellaDiTesto 108">
              <a:extLst>
                <a:ext uri="{FF2B5EF4-FFF2-40B4-BE49-F238E27FC236}">
                  <a16:creationId xmlns:a16="http://schemas.microsoft.com/office/drawing/2014/main" id="{A51E3BCB-BF13-46FD-AE17-6BA6830F8C97}"/>
                </a:ext>
              </a:extLst>
            </p:cNvPr>
            <p:cNvSpPr txBox="1"/>
            <p:nvPr/>
          </p:nvSpPr>
          <p:spPr>
            <a:xfrm>
              <a:off x="735281" y="1878380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110" name="CasellaDiTesto 109">
              <a:extLst>
                <a:ext uri="{FF2B5EF4-FFF2-40B4-BE49-F238E27FC236}">
                  <a16:creationId xmlns:a16="http://schemas.microsoft.com/office/drawing/2014/main" id="{27F2720F-5CB5-4C8E-91C3-66E6FB4A21E9}"/>
                </a:ext>
              </a:extLst>
            </p:cNvPr>
            <p:cNvSpPr txBox="1"/>
            <p:nvPr/>
          </p:nvSpPr>
          <p:spPr>
            <a:xfrm>
              <a:off x="1297413" y="1483416"/>
              <a:ext cx="3449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/>
                <a:t>****</a:t>
              </a:r>
            </a:p>
          </p:txBody>
        </p:sp>
        <p:sp>
          <p:nvSpPr>
            <p:cNvPr id="111" name="CasellaDiTesto 110">
              <a:extLst>
                <a:ext uri="{FF2B5EF4-FFF2-40B4-BE49-F238E27FC236}">
                  <a16:creationId xmlns:a16="http://schemas.microsoft.com/office/drawing/2014/main" id="{44C6444A-8361-4702-B361-B2E074BB7C36}"/>
                </a:ext>
              </a:extLst>
            </p:cNvPr>
            <p:cNvSpPr txBox="1"/>
            <p:nvPr/>
          </p:nvSpPr>
          <p:spPr>
            <a:xfrm>
              <a:off x="1003576" y="2002464"/>
              <a:ext cx="69027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it-IT" sz="1200" dirty="0"/>
                <a:t>MCF-7</a:t>
              </a:r>
            </a:p>
          </p:txBody>
        </p:sp>
        <p:grpSp>
          <p:nvGrpSpPr>
            <p:cNvPr id="112" name="Gruppo 111">
              <a:extLst>
                <a:ext uri="{FF2B5EF4-FFF2-40B4-BE49-F238E27FC236}">
                  <a16:creationId xmlns:a16="http://schemas.microsoft.com/office/drawing/2014/main" id="{450FDBD4-B19D-43B5-9F76-8673D7685484}"/>
                </a:ext>
              </a:extLst>
            </p:cNvPr>
            <p:cNvGrpSpPr/>
            <p:nvPr/>
          </p:nvGrpSpPr>
          <p:grpSpPr>
            <a:xfrm>
              <a:off x="589307" y="695454"/>
              <a:ext cx="1270086" cy="458441"/>
              <a:chOff x="316363" y="623624"/>
              <a:chExt cx="1270086" cy="458441"/>
            </a:xfrm>
          </p:grpSpPr>
          <p:sp>
            <p:nvSpPr>
              <p:cNvPr id="113" name="CasellaDiTesto 112">
                <a:extLst>
                  <a:ext uri="{FF2B5EF4-FFF2-40B4-BE49-F238E27FC236}">
                    <a16:creationId xmlns:a16="http://schemas.microsoft.com/office/drawing/2014/main" id="{DBDDFF25-CAEB-4BCB-A352-6578268AE898}"/>
                  </a:ext>
                </a:extLst>
              </p:cNvPr>
              <p:cNvSpPr txBox="1"/>
              <p:nvPr/>
            </p:nvSpPr>
            <p:spPr>
              <a:xfrm>
                <a:off x="427606" y="805066"/>
                <a:ext cx="11588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err="1"/>
                  <a:t>siRNA</a:t>
                </a:r>
                <a:r>
                  <a:rPr lang="it-IT" sz="1200" dirty="0"/>
                  <a:t> FOXA1</a:t>
                </a:r>
              </a:p>
            </p:txBody>
          </p:sp>
          <p:sp>
            <p:nvSpPr>
              <p:cNvPr id="114" name="CasellaDiTesto 113">
                <a:extLst>
                  <a:ext uri="{FF2B5EF4-FFF2-40B4-BE49-F238E27FC236}">
                    <a16:creationId xmlns:a16="http://schemas.microsoft.com/office/drawing/2014/main" id="{7D92297D-AFB2-4DE8-AF4E-9B4FB14773CA}"/>
                  </a:ext>
                </a:extLst>
              </p:cNvPr>
              <p:cNvSpPr txBox="1"/>
              <p:nvPr/>
            </p:nvSpPr>
            <p:spPr>
              <a:xfrm>
                <a:off x="427606" y="623624"/>
                <a:ext cx="96968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err="1"/>
                  <a:t>siRNA</a:t>
                </a:r>
                <a:r>
                  <a:rPr lang="it-IT" sz="1200" dirty="0"/>
                  <a:t> CTR</a:t>
                </a:r>
              </a:p>
            </p:txBody>
          </p:sp>
          <p:pic>
            <p:nvPicPr>
              <p:cNvPr id="115" name="Immagine 114">
                <a:extLst>
                  <a:ext uri="{FF2B5EF4-FFF2-40B4-BE49-F238E27FC236}">
                    <a16:creationId xmlns:a16="http://schemas.microsoft.com/office/drawing/2014/main" id="{6578727A-9AF4-453B-80AD-345848813B7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2"/>
              <a:srcRect t="1" b="33090"/>
              <a:stretch/>
            </p:blipFill>
            <p:spPr>
              <a:xfrm>
                <a:off x="316363" y="701678"/>
                <a:ext cx="152790" cy="332252"/>
              </a:xfrm>
              <a:prstGeom prst="rect">
                <a:avLst/>
              </a:prstGeom>
            </p:spPr>
          </p:pic>
        </p:grpSp>
      </p:grpSp>
      <p:grpSp>
        <p:nvGrpSpPr>
          <p:cNvPr id="2" name="Gruppo 1">
            <a:extLst>
              <a:ext uri="{FF2B5EF4-FFF2-40B4-BE49-F238E27FC236}">
                <a16:creationId xmlns:a16="http://schemas.microsoft.com/office/drawing/2014/main" id="{A1C015AB-B898-4979-AFBF-C2BDB14F2D9B}"/>
              </a:ext>
            </a:extLst>
          </p:cNvPr>
          <p:cNvGrpSpPr/>
          <p:nvPr/>
        </p:nvGrpSpPr>
        <p:grpSpPr>
          <a:xfrm>
            <a:off x="3507843" y="6699959"/>
            <a:ext cx="1505333" cy="2552561"/>
            <a:chOff x="3507843" y="6487443"/>
            <a:chExt cx="1505333" cy="2552561"/>
          </a:xfrm>
        </p:grpSpPr>
        <p:pic>
          <p:nvPicPr>
            <p:cNvPr id="117" name="Immagine 116">
              <a:extLst>
                <a:ext uri="{FF2B5EF4-FFF2-40B4-BE49-F238E27FC236}">
                  <a16:creationId xmlns:a16="http://schemas.microsoft.com/office/drawing/2014/main" id="{26A403BC-692B-4C1F-9717-7FB08341D918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/>
            <a:stretch>
              <a:fillRect/>
            </a:stretch>
          </p:blipFill>
          <p:spPr>
            <a:xfrm>
              <a:off x="4139966" y="6759228"/>
              <a:ext cx="873210" cy="1260000"/>
            </a:xfrm>
            <a:prstGeom prst="rect">
              <a:avLst/>
            </a:prstGeom>
          </p:spPr>
        </p:pic>
        <p:sp>
          <p:nvSpPr>
            <p:cNvPr id="126" name="CasellaDiTesto 125">
              <a:extLst>
                <a:ext uri="{FF2B5EF4-FFF2-40B4-BE49-F238E27FC236}">
                  <a16:creationId xmlns:a16="http://schemas.microsoft.com/office/drawing/2014/main" id="{B877142C-1A13-4302-B75F-0C9E820E9AB9}"/>
                </a:ext>
              </a:extLst>
            </p:cNvPr>
            <p:cNvSpPr txBox="1"/>
            <p:nvPr/>
          </p:nvSpPr>
          <p:spPr>
            <a:xfrm rot="18185247">
              <a:off x="3988659" y="8313843"/>
              <a:ext cx="11753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/>
                <a:t>siRNA</a:t>
              </a:r>
              <a:r>
                <a:rPr lang="it-IT" sz="1200" dirty="0"/>
                <a:t> FOXA1</a:t>
              </a:r>
            </a:p>
          </p:txBody>
        </p:sp>
        <p:sp>
          <p:nvSpPr>
            <p:cNvPr id="127" name="CasellaDiTesto 126">
              <a:extLst>
                <a:ext uri="{FF2B5EF4-FFF2-40B4-BE49-F238E27FC236}">
                  <a16:creationId xmlns:a16="http://schemas.microsoft.com/office/drawing/2014/main" id="{A5541041-4480-4F0C-A464-5B1210A7C37F}"/>
                </a:ext>
              </a:extLst>
            </p:cNvPr>
            <p:cNvSpPr txBox="1"/>
            <p:nvPr/>
          </p:nvSpPr>
          <p:spPr>
            <a:xfrm rot="16200000">
              <a:off x="2856864" y="7138422"/>
              <a:ext cx="176362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ESR1-promoter activity</a:t>
              </a:r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CTR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158" name="CasellaDiTesto 157">
              <a:extLst>
                <a:ext uri="{FF2B5EF4-FFF2-40B4-BE49-F238E27FC236}">
                  <a16:creationId xmlns:a16="http://schemas.microsoft.com/office/drawing/2014/main" id="{2D74B9CF-8DB7-48C9-B286-56A255842300}"/>
                </a:ext>
              </a:extLst>
            </p:cNvPr>
            <p:cNvSpPr txBox="1"/>
            <p:nvPr/>
          </p:nvSpPr>
          <p:spPr>
            <a:xfrm>
              <a:off x="3837141" y="6641485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2</a:t>
              </a:r>
            </a:p>
          </p:txBody>
        </p:sp>
        <p:sp>
          <p:nvSpPr>
            <p:cNvPr id="159" name="CasellaDiTesto 158">
              <a:extLst>
                <a:ext uri="{FF2B5EF4-FFF2-40B4-BE49-F238E27FC236}">
                  <a16:creationId xmlns:a16="http://schemas.microsoft.com/office/drawing/2014/main" id="{8BAA827C-58B6-43F6-B1F6-3216A91F9E80}"/>
                </a:ext>
              </a:extLst>
            </p:cNvPr>
            <p:cNvSpPr txBox="1"/>
            <p:nvPr/>
          </p:nvSpPr>
          <p:spPr>
            <a:xfrm>
              <a:off x="3837141" y="723280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6</a:t>
              </a:r>
            </a:p>
          </p:txBody>
        </p:sp>
        <p:sp>
          <p:nvSpPr>
            <p:cNvPr id="160" name="CasellaDiTesto 159">
              <a:extLst>
                <a:ext uri="{FF2B5EF4-FFF2-40B4-BE49-F238E27FC236}">
                  <a16:creationId xmlns:a16="http://schemas.microsoft.com/office/drawing/2014/main" id="{B46C4965-43E6-4AF8-B21D-D442DB4A3327}"/>
                </a:ext>
              </a:extLst>
            </p:cNvPr>
            <p:cNvSpPr txBox="1"/>
            <p:nvPr/>
          </p:nvSpPr>
          <p:spPr>
            <a:xfrm>
              <a:off x="3837141" y="783407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161" name="CasellaDiTesto 160">
              <a:extLst>
                <a:ext uri="{FF2B5EF4-FFF2-40B4-BE49-F238E27FC236}">
                  <a16:creationId xmlns:a16="http://schemas.microsoft.com/office/drawing/2014/main" id="{4DAC1F6A-9B35-4988-8FCF-FE580A642A58}"/>
                </a:ext>
              </a:extLst>
            </p:cNvPr>
            <p:cNvSpPr txBox="1"/>
            <p:nvPr/>
          </p:nvSpPr>
          <p:spPr>
            <a:xfrm>
              <a:off x="4609511" y="6933029"/>
              <a:ext cx="30328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</a:t>
              </a:r>
            </a:p>
            <a:p>
              <a:r>
                <a:rPr lang="it-IT" sz="1200" dirty="0"/>
                <a:t>**</a:t>
              </a:r>
            </a:p>
          </p:txBody>
        </p:sp>
        <p:sp>
          <p:nvSpPr>
            <p:cNvPr id="162" name="CasellaDiTesto 161">
              <a:extLst>
                <a:ext uri="{FF2B5EF4-FFF2-40B4-BE49-F238E27FC236}">
                  <a16:creationId xmlns:a16="http://schemas.microsoft.com/office/drawing/2014/main" id="{D950C0E2-9792-490E-9ACE-12E65888DE78}"/>
                </a:ext>
              </a:extLst>
            </p:cNvPr>
            <p:cNvSpPr txBox="1"/>
            <p:nvPr/>
          </p:nvSpPr>
          <p:spPr>
            <a:xfrm rot="18185247">
              <a:off x="4162892" y="8044911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CTR</a:t>
              </a:r>
            </a:p>
          </p:txBody>
        </p:sp>
      </p:grpSp>
      <p:sp>
        <p:nvSpPr>
          <p:cNvPr id="157" name="CasellaDiTesto 156">
            <a:extLst>
              <a:ext uri="{FF2B5EF4-FFF2-40B4-BE49-F238E27FC236}">
                <a16:creationId xmlns:a16="http://schemas.microsoft.com/office/drawing/2014/main" id="{0E75F2E8-9137-4F6F-AE7E-084650A18054}"/>
              </a:ext>
            </a:extLst>
          </p:cNvPr>
          <p:cNvSpPr txBox="1"/>
          <p:nvPr/>
        </p:nvSpPr>
        <p:spPr>
          <a:xfrm>
            <a:off x="2240213" y="0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ementary</a:t>
            </a:r>
            <a:r>
              <a:rPr lang="it-IT" b="1" dirty="0"/>
              <a:t> Fig. 2</a:t>
            </a:r>
          </a:p>
        </p:txBody>
      </p:sp>
      <p:sp>
        <p:nvSpPr>
          <p:cNvPr id="163" name="CasellaDiTesto 162">
            <a:extLst>
              <a:ext uri="{FF2B5EF4-FFF2-40B4-BE49-F238E27FC236}">
                <a16:creationId xmlns:a16="http://schemas.microsoft.com/office/drawing/2014/main" id="{ADDDBA1C-7034-43D9-8DED-BFB514D1D6B6}"/>
              </a:ext>
            </a:extLst>
          </p:cNvPr>
          <p:cNvSpPr txBox="1"/>
          <p:nvPr/>
        </p:nvSpPr>
        <p:spPr>
          <a:xfrm>
            <a:off x="-27384" y="4107734"/>
            <a:ext cx="420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d’’)</a:t>
            </a:r>
          </a:p>
        </p:txBody>
      </p:sp>
      <p:sp>
        <p:nvSpPr>
          <p:cNvPr id="164" name="CasellaDiTesto 163">
            <a:extLst>
              <a:ext uri="{FF2B5EF4-FFF2-40B4-BE49-F238E27FC236}">
                <a16:creationId xmlns:a16="http://schemas.microsoft.com/office/drawing/2014/main" id="{C598F0F0-7F50-4217-820A-313BB815C59F}"/>
              </a:ext>
            </a:extLst>
          </p:cNvPr>
          <p:cNvSpPr txBox="1"/>
          <p:nvPr/>
        </p:nvSpPr>
        <p:spPr>
          <a:xfrm>
            <a:off x="3408164" y="4107734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d’’’)</a:t>
            </a:r>
          </a:p>
        </p:txBody>
      </p:sp>
      <p:grpSp>
        <p:nvGrpSpPr>
          <p:cNvPr id="9" name="Gruppo 8">
            <a:extLst>
              <a:ext uri="{FF2B5EF4-FFF2-40B4-BE49-F238E27FC236}">
                <a16:creationId xmlns:a16="http://schemas.microsoft.com/office/drawing/2014/main" id="{B39059B5-01B5-4391-92F6-CC580C17673D}"/>
              </a:ext>
            </a:extLst>
          </p:cNvPr>
          <p:cNvGrpSpPr/>
          <p:nvPr/>
        </p:nvGrpSpPr>
        <p:grpSpPr>
          <a:xfrm>
            <a:off x="3835883" y="2482185"/>
            <a:ext cx="3049501" cy="1665609"/>
            <a:chOff x="3789042" y="2482185"/>
            <a:chExt cx="3049501" cy="1665609"/>
          </a:xfrm>
        </p:grpSpPr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69B81066-AC21-4CDD-8A85-AF6E176965F3}"/>
                </a:ext>
              </a:extLst>
            </p:cNvPr>
            <p:cNvPicPr>
              <a:picLocks noChangeAspect="1"/>
            </p:cNvPicPr>
            <p:nvPr/>
          </p:nvPicPr>
          <p:blipFill>
            <a:blip r:embed="rId34"/>
            <a:stretch>
              <a:fillRect/>
            </a:stretch>
          </p:blipFill>
          <p:spPr>
            <a:xfrm>
              <a:off x="4419153" y="2658304"/>
              <a:ext cx="1829589" cy="1260000"/>
            </a:xfrm>
            <a:prstGeom prst="rect">
              <a:avLst/>
            </a:prstGeom>
          </p:spPr>
        </p:pic>
        <p:sp>
          <p:nvSpPr>
            <p:cNvPr id="247" name="CasellaDiTesto 246">
              <a:extLst>
                <a:ext uri="{FF2B5EF4-FFF2-40B4-BE49-F238E27FC236}">
                  <a16:creationId xmlns:a16="http://schemas.microsoft.com/office/drawing/2014/main" id="{E5A90B38-A891-4103-A485-58AAF3F6CB37}"/>
                </a:ext>
              </a:extLst>
            </p:cNvPr>
            <p:cNvSpPr txBox="1"/>
            <p:nvPr/>
          </p:nvSpPr>
          <p:spPr>
            <a:xfrm>
              <a:off x="6095454" y="3870795"/>
              <a:ext cx="743089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+mn-lt"/>
                </a:rPr>
                <a:t>Tel (µM)</a:t>
              </a:r>
            </a:p>
          </p:txBody>
        </p:sp>
        <p:sp>
          <p:nvSpPr>
            <p:cNvPr id="248" name="CasellaDiTesto 247">
              <a:extLst>
                <a:ext uri="{FF2B5EF4-FFF2-40B4-BE49-F238E27FC236}">
                  <a16:creationId xmlns:a16="http://schemas.microsoft.com/office/drawing/2014/main" id="{492BF0BE-BA36-4A3E-8D41-977ACD949C82}"/>
                </a:ext>
              </a:extLst>
            </p:cNvPr>
            <p:cNvSpPr txBox="1"/>
            <p:nvPr/>
          </p:nvSpPr>
          <p:spPr>
            <a:xfrm rot="16200000">
              <a:off x="3329621" y="3030282"/>
              <a:ext cx="138050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/>
                <a:t>pS2 </a:t>
              </a:r>
              <a:r>
                <a:rPr lang="it-IT" sz="1200" dirty="0" err="1"/>
                <a:t>Levels</a:t>
              </a:r>
              <a:endParaRPr lang="it-IT" sz="1200" dirty="0"/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0 - CTR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249" name="CasellaDiTesto 248">
              <a:extLst>
                <a:ext uri="{FF2B5EF4-FFF2-40B4-BE49-F238E27FC236}">
                  <a16:creationId xmlns:a16="http://schemas.microsoft.com/office/drawing/2014/main" id="{EBD6ED03-E6DD-4986-B87C-1B08C4B72F85}"/>
                </a:ext>
              </a:extLst>
            </p:cNvPr>
            <p:cNvSpPr txBox="1"/>
            <p:nvPr/>
          </p:nvSpPr>
          <p:spPr>
            <a:xfrm>
              <a:off x="4118336" y="2526995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2</a:t>
              </a:r>
            </a:p>
          </p:txBody>
        </p:sp>
        <p:sp>
          <p:nvSpPr>
            <p:cNvPr id="251" name="CasellaDiTesto 250">
              <a:extLst>
                <a:ext uri="{FF2B5EF4-FFF2-40B4-BE49-F238E27FC236}">
                  <a16:creationId xmlns:a16="http://schemas.microsoft.com/office/drawing/2014/main" id="{FA1A5BD9-5E8F-43F9-9380-5FD61E896254}"/>
                </a:ext>
              </a:extLst>
            </p:cNvPr>
            <p:cNvSpPr txBox="1"/>
            <p:nvPr/>
          </p:nvSpPr>
          <p:spPr>
            <a:xfrm>
              <a:off x="4118336" y="372593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253" name="CasellaDiTesto 252">
              <a:extLst>
                <a:ext uri="{FF2B5EF4-FFF2-40B4-BE49-F238E27FC236}">
                  <a16:creationId xmlns:a16="http://schemas.microsoft.com/office/drawing/2014/main" id="{8295EDDF-5D40-41E6-B58B-30BE0BDDE76D}"/>
                </a:ext>
              </a:extLst>
            </p:cNvPr>
            <p:cNvSpPr txBox="1"/>
            <p:nvPr/>
          </p:nvSpPr>
          <p:spPr>
            <a:xfrm>
              <a:off x="4118336" y="3131840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6</a:t>
              </a:r>
            </a:p>
          </p:txBody>
        </p:sp>
        <p:grpSp>
          <p:nvGrpSpPr>
            <p:cNvPr id="4" name="Gruppo 3">
              <a:extLst>
                <a:ext uri="{FF2B5EF4-FFF2-40B4-BE49-F238E27FC236}">
                  <a16:creationId xmlns:a16="http://schemas.microsoft.com/office/drawing/2014/main" id="{165BACF5-04D4-4417-B495-B6956CAEC77C}"/>
                </a:ext>
              </a:extLst>
            </p:cNvPr>
            <p:cNvGrpSpPr/>
            <p:nvPr/>
          </p:nvGrpSpPr>
          <p:grpSpPr>
            <a:xfrm>
              <a:off x="5306914" y="3870795"/>
              <a:ext cx="936748" cy="276999"/>
              <a:chOff x="5306914" y="3870795"/>
              <a:chExt cx="936748" cy="276999"/>
            </a:xfrm>
          </p:grpSpPr>
          <p:sp>
            <p:nvSpPr>
              <p:cNvPr id="266" name="CasellaDiTesto 265">
                <a:extLst>
                  <a:ext uri="{FF2B5EF4-FFF2-40B4-BE49-F238E27FC236}">
                    <a16:creationId xmlns:a16="http://schemas.microsoft.com/office/drawing/2014/main" id="{1EC665D7-B7EF-4428-ABA5-BE11D59AF7D0}"/>
                  </a:ext>
                </a:extLst>
              </p:cNvPr>
              <p:cNvSpPr txBox="1"/>
              <p:nvPr/>
            </p:nvSpPr>
            <p:spPr>
              <a:xfrm>
                <a:off x="5306914" y="3870795"/>
                <a:ext cx="26962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0</a:t>
                </a:r>
              </a:p>
            </p:txBody>
          </p:sp>
          <p:sp>
            <p:nvSpPr>
              <p:cNvPr id="267" name="CasellaDiTesto 266">
                <a:extLst>
                  <a:ext uri="{FF2B5EF4-FFF2-40B4-BE49-F238E27FC236}">
                    <a16:creationId xmlns:a16="http://schemas.microsoft.com/office/drawing/2014/main" id="{498A0912-6D0B-4541-95C0-B8CEEC60E289}"/>
                  </a:ext>
                </a:extLst>
              </p:cNvPr>
              <p:cNvSpPr txBox="1"/>
              <p:nvPr/>
            </p:nvSpPr>
            <p:spPr>
              <a:xfrm>
                <a:off x="5457924" y="3870795"/>
                <a:ext cx="35458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10</a:t>
                </a:r>
              </a:p>
            </p:txBody>
          </p:sp>
          <p:sp>
            <p:nvSpPr>
              <p:cNvPr id="268" name="CasellaDiTesto 267">
                <a:extLst>
                  <a:ext uri="{FF2B5EF4-FFF2-40B4-BE49-F238E27FC236}">
                    <a16:creationId xmlns:a16="http://schemas.microsoft.com/office/drawing/2014/main" id="{FA8BAE55-E9C8-4073-8119-B840A467BABE}"/>
                  </a:ext>
                </a:extLst>
              </p:cNvPr>
              <p:cNvSpPr txBox="1"/>
              <p:nvPr/>
            </p:nvSpPr>
            <p:spPr>
              <a:xfrm>
                <a:off x="5673054" y="3870795"/>
                <a:ext cx="35458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20</a:t>
                </a:r>
              </a:p>
            </p:txBody>
          </p:sp>
          <p:sp>
            <p:nvSpPr>
              <p:cNvPr id="269" name="CasellaDiTesto 268">
                <a:extLst>
                  <a:ext uri="{FF2B5EF4-FFF2-40B4-BE49-F238E27FC236}">
                    <a16:creationId xmlns:a16="http://schemas.microsoft.com/office/drawing/2014/main" id="{A06CA732-D1EE-43C4-AFC1-8C6AB2A3F9FE}"/>
                  </a:ext>
                </a:extLst>
              </p:cNvPr>
              <p:cNvSpPr txBox="1"/>
              <p:nvPr/>
            </p:nvSpPr>
            <p:spPr>
              <a:xfrm>
                <a:off x="5889078" y="3870795"/>
                <a:ext cx="35458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40</a:t>
                </a:r>
              </a:p>
            </p:txBody>
          </p:sp>
        </p:grpSp>
        <p:cxnSp>
          <p:nvCxnSpPr>
            <p:cNvPr id="262" name="Connettore diritto 261">
              <a:extLst>
                <a:ext uri="{FF2B5EF4-FFF2-40B4-BE49-F238E27FC236}">
                  <a16:creationId xmlns:a16="http://schemas.microsoft.com/office/drawing/2014/main" id="{F51D0045-CC3B-4CBF-ADEA-8C601A0400EA}"/>
                </a:ext>
              </a:extLst>
            </p:cNvPr>
            <p:cNvCxnSpPr>
              <a:cxnSpLocks/>
            </p:cNvCxnSpPr>
            <p:nvPr/>
          </p:nvCxnSpPr>
          <p:spPr>
            <a:xfrm>
              <a:off x="4581168" y="2740622"/>
              <a:ext cx="684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3" name="CasellaDiTesto 262">
              <a:extLst>
                <a:ext uri="{FF2B5EF4-FFF2-40B4-BE49-F238E27FC236}">
                  <a16:creationId xmlns:a16="http://schemas.microsoft.com/office/drawing/2014/main" id="{68804833-8CC4-4B44-8D0A-4236BD81E4FC}"/>
                </a:ext>
              </a:extLst>
            </p:cNvPr>
            <p:cNvSpPr txBox="1"/>
            <p:nvPr/>
          </p:nvSpPr>
          <p:spPr>
            <a:xfrm>
              <a:off x="4701184" y="2482185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CTR</a:t>
              </a:r>
            </a:p>
          </p:txBody>
        </p:sp>
        <p:cxnSp>
          <p:nvCxnSpPr>
            <p:cNvPr id="260" name="Connettore diritto 259">
              <a:extLst>
                <a:ext uri="{FF2B5EF4-FFF2-40B4-BE49-F238E27FC236}">
                  <a16:creationId xmlns:a16="http://schemas.microsoft.com/office/drawing/2014/main" id="{87D40D7B-C2E4-4BE3-BCE0-8CFCC1EF47D2}"/>
                </a:ext>
              </a:extLst>
            </p:cNvPr>
            <p:cNvCxnSpPr>
              <a:cxnSpLocks/>
            </p:cNvCxnSpPr>
            <p:nvPr/>
          </p:nvCxnSpPr>
          <p:spPr>
            <a:xfrm>
              <a:off x="5432564" y="2740622"/>
              <a:ext cx="684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1" name="CasellaDiTesto 260">
              <a:extLst>
                <a:ext uri="{FF2B5EF4-FFF2-40B4-BE49-F238E27FC236}">
                  <a16:creationId xmlns:a16="http://schemas.microsoft.com/office/drawing/2014/main" id="{792D36BD-E73F-4BDF-91F9-A79226F6D27F}"/>
                </a:ext>
              </a:extLst>
            </p:cNvPr>
            <p:cNvSpPr txBox="1"/>
            <p:nvPr/>
          </p:nvSpPr>
          <p:spPr>
            <a:xfrm>
              <a:off x="5205593" y="2482185"/>
              <a:ext cx="11588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/>
                <a:t>siRNA</a:t>
              </a:r>
              <a:r>
                <a:rPr lang="it-IT" sz="1200" dirty="0"/>
                <a:t> FOXA1</a:t>
              </a:r>
            </a:p>
          </p:txBody>
        </p:sp>
        <p:grpSp>
          <p:nvGrpSpPr>
            <p:cNvPr id="284" name="Gruppo 283">
              <a:extLst>
                <a:ext uri="{FF2B5EF4-FFF2-40B4-BE49-F238E27FC236}">
                  <a16:creationId xmlns:a16="http://schemas.microsoft.com/office/drawing/2014/main" id="{62033196-8877-418A-9C79-E344AF61F6F6}"/>
                </a:ext>
              </a:extLst>
            </p:cNvPr>
            <p:cNvGrpSpPr/>
            <p:nvPr/>
          </p:nvGrpSpPr>
          <p:grpSpPr>
            <a:xfrm>
              <a:off x="4488454" y="3870795"/>
              <a:ext cx="936748" cy="276999"/>
              <a:chOff x="5306914" y="3870795"/>
              <a:chExt cx="936748" cy="276999"/>
            </a:xfrm>
          </p:grpSpPr>
          <p:sp>
            <p:nvSpPr>
              <p:cNvPr id="285" name="CasellaDiTesto 284">
                <a:extLst>
                  <a:ext uri="{FF2B5EF4-FFF2-40B4-BE49-F238E27FC236}">
                    <a16:creationId xmlns:a16="http://schemas.microsoft.com/office/drawing/2014/main" id="{F908660A-973D-4341-9498-BEFAC1B7E2B0}"/>
                  </a:ext>
                </a:extLst>
              </p:cNvPr>
              <p:cNvSpPr txBox="1"/>
              <p:nvPr/>
            </p:nvSpPr>
            <p:spPr>
              <a:xfrm>
                <a:off x="5306914" y="3870795"/>
                <a:ext cx="26962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0</a:t>
                </a:r>
              </a:p>
            </p:txBody>
          </p:sp>
          <p:sp>
            <p:nvSpPr>
              <p:cNvPr id="286" name="CasellaDiTesto 285">
                <a:extLst>
                  <a:ext uri="{FF2B5EF4-FFF2-40B4-BE49-F238E27FC236}">
                    <a16:creationId xmlns:a16="http://schemas.microsoft.com/office/drawing/2014/main" id="{80FC49AE-336B-49BC-976C-769B4AF93082}"/>
                  </a:ext>
                </a:extLst>
              </p:cNvPr>
              <p:cNvSpPr txBox="1"/>
              <p:nvPr/>
            </p:nvSpPr>
            <p:spPr>
              <a:xfrm>
                <a:off x="5457924" y="3870795"/>
                <a:ext cx="35458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10</a:t>
                </a:r>
              </a:p>
            </p:txBody>
          </p:sp>
          <p:sp>
            <p:nvSpPr>
              <p:cNvPr id="287" name="CasellaDiTesto 286">
                <a:extLst>
                  <a:ext uri="{FF2B5EF4-FFF2-40B4-BE49-F238E27FC236}">
                    <a16:creationId xmlns:a16="http://schemas.microsoft.com/office/drawing/2014/main" id="{AF2BA13E-85ED-4E5F-9110-FC5ED094EA59}"/>
                  </a:ext>
                </a:extLst>
              </p:cNvPr>
              <p:cNvSpPr txBox="1"/>
              <p:nvPr/>
            </p:nvSpPr>
            <p:spPr>
              <a:xfrm>
                <a:off x="5673054" y="3870795"/>
                <a:ext cx="35458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20</a:t>
                </a:r>
              </a:p>
            </p:txBody>
          </p:sp>
          <p:sp>
            <p:nvSpPr>
              <p:cNvPr id="288" name="CasellaDiTesto 287">
                <a:extLst>
                  <a:ext uri="{FF2B5EF4-FFF2-40B4-BE49-F238E27FC236}">
                    <a16:creationId xmlns:a16="http://schemas.microsoft.com/office/drawing/2014/main" id="{A2555F32-8250-491F-A849-66C2C29F5E9D}"/>
                  </a:ext>
                </a:extLst>
              </p:cNvPr>
              <p:cNvSpPr txBox="1"/>
              <p:nvPr/>
            </p:nvSpPr>
            <p:spPr>
              <a:xfrm>
                <a:off x="5889078" y="3870795"/>
                <a:ext cx="35458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40</a:t>
                </a:r>
              </a:p>
            </p:txBody>
          </p:sp>
        </p:grpSp>
      </p:grpSp>
      <p:sp>
        <p:nvSpPr>
          <p:cNvPr id="290" name="CasellaDiTesto 289">
            <a:extLst>
              <a:ext uri="{FF2B5EF4-FFF2-40B4-BE49-F238E27FC236}">
                <a16:creationId xmlns:a16="http://schemas.microsoft.com/office/drawing/2014/main" id="{071644AA-D8A1-466D-95F0-21903A450386}"/>
              </a:ext>
            </a:extLst>
          </p:cNvPr>
          <p:cNvSpPr txBox="1"/>
          <p:nvPr/>
        </p:nvSpPr>
        <p:spPr>
          <a:xfrm>
            <a:off x="3478696" y="2118163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d’)</a:t>
            </a:r>
          </a:p>
        </p:txBody>
      </p:sp>
      <p:grpSp>
        <p:nvGrpSpPr>
          <p:cNvPr id="10" name="Gruppo 9">
            <a:extLst>
              <a:ext uri="{FF2B5EF4-FFF2-40B4-BE49-F238E27FC236}">
                <a16:creationId xmlns:a16="http://schemas.microsoft.com/office/drawing/2014/main" id="{8A546845-0863-45A1-9C4E-7C1C0C90F17F}"/>
              </a:ext>
            </a:extLst>
          </p:cNvPr>
          <p:cNvGrpSpPr/>
          <p:nvPr/>
        </p:nvGrpSpPr>
        <p:grpSpPr>
          <a:xfrm>
            <a:off x="138452" y="4501214"/>
            <a:ext cx="3049501" cy="1665609"/>
            <a:chOff x="138452" y="4557951"/>
            <a:chExt cx="3049501" cy="1665609"/>
          </a:xfrm>
        </p:grpSpPr>
        <p:pic>
          <p:nvPicPr>
            <p:cNvPr id="8" name="Immagine 7">
              <a:extLst>
                <a:ext uri="{FF2B5EF4-FFF2-40B4-BE49-F238E27FC236}">
                  <a16:creationId xmlns:a16="http://schemas.microsoft.com/office/drawing/2014/main" id="{97A6F030-C44D-4BDB-B296-374C6622C38A}"/>
                </a:ext>
              </a:extLst>
            </p:cNvPr>
            <p:cNvPicPr>
              <a:picLocks noChangeAspect="1"/>
            </p:cNvPicPr>
            <p:nvPr/>
          </p:nvPicPr>
          <p:blipFill>
            <a:blip r:embed="rId35"/>
            <a:stretch>
              <a:fillRect/>
            </a:stretch>
          </p:blipFill>
          <p:spPr>
            <a:xfrm>
              <a:off x="768563" y="4734070"/>
              <a:ext cx="1851907" cy="1260000"/>
            </a:xfrm>
            <a:prstGeom prst="rect">
              <a:avLst/>
            </a:prstGeom>
          </p:spPr>
        </p:pic>
        <p:sp>
          <p:nvSpPr>
            <p:cNvPr id="292" name="CasellaDiTesto 291">
              <a:extLst>
                <a:ext uri="{FF2B5EF4-FFF2-40B4-BE49-F238E27FC236}">
                  <a16:creationId xmlns:a16="http://schemas.microsoft.com/office/drawing/2014/main" id="{66B0CB90-ADCA-40E2-BE82-5D5E627282B4}"/>
                </a:ext>
              </a:extLst>
            </p:cNvPr>
            <p:cNvSpPr txBox="1"/>
            <p:nvPr/>
          </p:nvSpPr>
          <p:spPr>
            <a:xfrm>
              <a:off x="2444864" y="5946561"/>
              <a:ext cx="743089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+mn-lt"/>
                </a:rPr>
                <a:t>Tel (µM)</a:t>
              </a:r>
            </a:p>
          </p:txBody>
        </p:sp>
        <p:sp>
          <p:nvSpPr>
            <p:cNvPr id="293" name="CasellaDiTesto 292">
              <a:extLst>
                <a:ext uri="{FF2B5EF4-FFF2-40B4-BE49-F238E27FC236}">
                  <a16:creationId xmlns:a16="http://schemas.microsoft.com/office/drawing/2014/main" id="{B9D9E56A-A4CD-4218-B385-F2B3DA9137DB}"/>
                </a:ext>
              </a:extLst>
            </p:cNvPr>
            <p:cNvSpPr txBox="1"/>
            <p:nvPr/>
          </p:nvSpPr>
          <p:spPr>
            <a:xfrm rot="16200000">
              <a:off x="-320969" y="5106048"/>
              <a:ext cx="138050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/>
                <a:t>ER</a:t>
              </a:r>
              <a:r>
                <a:rPr lang="el-GR" sz="1200" dirty="0"/>
                <a:t>α</a:t>
              </a:r>
              <a:r>
                <a:rPr lang="it-IT" sz="1200" dirty="0"/>
                <a:t> </a:t>
              </a:r>
              <a:r>
                <a:rPr lang="it-IT" sz="1200" dirty="0" err="1"/>
                <a:t>Levels</a:t>
              </a:r>
              <a:endParaRPr lang="it-IT" sz="1200" dirty="0"/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0 - CTR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294" name="CasellaDiTesto 293">
              <a:extLst>
                <a:ext uri="{FF2B5EF4-FFF2-40B4-BE49-F238E27FC236}">
                  <a16:creationId xmlns:a16="http://schemas.microsoft.com/office/drawing/2014/main" id="{C28B5FEA-C3C0-44AC-BC36-E3B6F536A59A}"/>
                </a:ext>
              </a:extLst>
            </p:cNvPr>
            <p:cNvSpPr txBox="1"/>
            <p:nvPr/>
          </p:nvSpPr>
          <p:spPr>
            <a:xfrm>
              <a:off x="467746" y="4602761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2</a:t>
              </a:r>
            </a:p>
          </p:txBody>
        </p:sp>
        <p:sp>
          <p:nvSpPr>
            <p:cNvPr id="295" name="CasellaDiTesto 294">
              <a:extLst>
                <a:ext uri="{FF2B5EF4-FFF2-40B4-BE49-F238E27FC236}">
                  <a16:creationId xmlns:a16="http://schemas.microsoft.com/office/drawing/2014/main" id="{B71988FE-7F1A-4542-BA4B-1D77396B44EA}"/>
                </a:ext>
              </a:extLst>
            </p:cNvPr>
            <p:cNvSpPr txBox="1"/>
            <p:nvPr/>
          </p:nvSpPr>
          <p:spPr>
            <a:xfrm>
              <a:off x="467746" y="5801700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296" name="CasellaDiTesto 295">
              <a:extLst>
                <a:ext uri="{FF2B5EF4-FFF2-40B4-BE49-F238E27FC236}">
                  <a16:creationId xmlns:a16="http://schemas.microsoft.com/office/drawing/2014/main" id="{581AA0AC-5F45-4568-AD3F-8DC3B3288FDE}"/>
                </a:ext>
              </a:extLst>
            </p:cNvPr>
            <p:cNvSpPr txBox="1"/>
            <p:nvPr/>
          </p:nvSpPr>
          <p:spPr>
            <a:xfrm>
              <a:off x="467746" y="5207606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6</a:t>
              </a:r>
            </a:p>
          </p:txBody>
        </p:sp>
        <p:grpSp>
          <p:nvGrpSpPr>
            <p:cNvPr id="297" name="Gruppo 296">
              <a:extLst>
                <a:ext uri="{FF2B5EF4-FFF2-40B4-BE49-F238E27FC236}">
                  <a16:creationId xmlns:a16="http://schemas.microsoft.com/office/drawing/2014/main" id="{A851B962-2868-4C20-90D1-D596D3FABE2C}"/>
                </a:ext>
              </a:extLst>
            </p:cNvPr>
            <p:cNvGrpSpPr/>
            <p:nvPr/>
          </p:nvGrpSpPr>
          <p:grpSpPr>
            <a:xfrm>
              <a:off x="1656324" y="5946561"/>
              <a:ext cx="936748" cy="276999"/>
              <a:chOff x="5306914" y="3870795"/>
              <a:chExt cx="936748" cy="276999"/>
            </a:xfrm>
          </p:grpSpPr>
          <p:sp>
            <p:nvSpPr>
              <p:cNvPr id="298" name="CasellaDiTesto 297">
                <a:extLst>
                  <a:ext uri="{FF2B5EF4-FFF2-40B4-BE49-F238E27FC236}">
                    <a16:creationId xmlns:a16="http://schemas.microsoft.com/office/drawing/2014/main" id="{7CD011B4-6BDB-440C-96AA-E7F60D3D8A32}"/>
                  </a:ext>
                </a:extLst>
              </p:cNvPr>
              <p:cNvSpPr txBox="1"/>
              <p:nvPr/>
            </p:nvSpPr>
            <p:spPr>
              <a:xfrm>
                <a:off x="5306914" y="3870795"/>
                <a:ext cx="26962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0</a:t>
                </a:r>
              </a:p>
            </p:txBody>
          </p:sp>
          <p:sp>
            <p:nvSpPr>
              <p:cNvPr id="299" name="CasellaDiTesto 298">
                <a:extLst>
                  <a:ext uri="{FF2B5EF4-FFF2-40B4-BE49-F238E27FC236}">
                    <a16:creationId xmlns:a16="http://schemas.microsoft.com/office/drawing/2014/main" id="{64A36740-2C8F-4ADE-865C-F0006E9AE7B0}"/>
                  </a:ext>
                </a:extLst>
              </p:cNvPr>
              <p:cNvSpPr txBox="1"/>
              <p:nvPr/>
            </p:nvSpPr>
            <p:spPr>
              <a:xfrm>
                <a:off x="5457924" y="3870795"/>
                <a:ext cx="35458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10</a:t>
                </a:r>
              </a:p>
            </p:txBody>
          </p:sp>
          <p:sp>
            <p:nvSpPr>
              <p:cNvPr id="300" name="CasellaDiTesto 299">
                <a:extLst>
                  <a:ext uri="{FF2B5EF4-FFF2-40B4-BE49-F238E27FC236}">
                    <a16:creationId xmlns:a16="http://schemas.microsoft.com/office/drawing/2014/main" id="{B5D04853-29AA-42C6-9A93-CAAC8382AFAB}"/>
                  </a:ext>
                </a:extLst>
              </p:cNvPr>
              <p:cNvSpPr txBox="1"/>
              <p:nvPr/>
            </p:nvSpPr>
            <p:spPr>
              <a:xfrm>
                <a:off x="5673054" y="3870795"/>
                <a:ext cx="35458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20</a:t>
                </a:r>
              </a:p>
            </p:txBody>
          </p:sp>
          <p:sp>
            <p:nvSpPr>
              <p:cNvPr id="301" name="CasellaDiTesto 300">
                <a:extLst>
                  <a:ext uri="{FF2B5EF4-FFF2-40B4-BE49-F238E27FC236}">
                    <a16:creationId xmlns:a16="http://schemas.microsoft.com/office/drawing/2014/main" id="{96EB47AA-5426-4088-ABBA-6DD32999E25D}"/>
                  </a:ext>
                </a:extLst>
              </p:cNvPr>
              <p:cNvSpPr txBox="1"/>
              <p:nvPr/>
            </p:nvSpPr>
            <p:spPr>
              <a:xfrm>
                <a:off x="5889078" y="3870795"/>
                <a:ext cx="35458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40</a:t>
                </a:r>
              </a:p>
            </p:txBody>
          </p:sp>
        </p:grpSp>
        <p:cxnSp>
          <p:nvCxnSpPr>
            <p:cNvPr id="302" name="Connettore diritto 301">
              <a:extLst>
                <a:ext uri="{FF2B5EF4-FFF2-40B4-BE49-F238E27FC236}">
                  <a16:creationId xmlns:a16="http://schemas.microsoft.com/office/drawing/2014/main" id="{775EB987-96BD-4B73-A0D9-248322C24CF9}"/>
                </a:ext>
              </a:extLst>
            </p:cNvPr>
            <p:cNvCxnSpPr>
              <a:cxnSpLocks/>
            </p:cNvCxnSpPr>
            <p:nvPr/>
          </p:nvCxnSpPr>
          <p:spPr>
            <a:xfrm>
              <a:off x="930578" y="4816388"/>
              <a:ext cx="684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3" name="CasellaDiTesto 302">
              <a:extLst>
                <a:ext uri="{FF2B5EF4-FFF2-40B4-BE49-F238E27FC236}">
                  <a16:creationId xmlns:a16="http://schemas.microsoft.com/office/drawing/2014/main" id="{0ECBF540-B328-4F81-BFEC-4443BF109AC1}"/>
                </a:ext>
              </a:extLst>
            </p:cNvPr>
            <p:cNvSpPr txBox="1"/>
            <p:nvPr/>
          </p:nvSpPr>
          <p:spPr>
            <a:xfrm>
              <a:off x="1050594" y="4557951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CTR</a:t>
              </a:r>
            </a:p>
          </p:txBody>
        </p:sp>
        <p:cxnSp>
          <p:nvCxnSpPr>
            <p:cNvPr id="304" name="Connettore diritto 303">
              <a:extLst>
                <a:ext uri="{FF2B5EF4-FFF2-40B4-BE49-F238E27FC236}">
                  <a16:creationId xmlns:a16="http://schemas.microsoft.com/office/drawing/2014/main" id="{F7B293F4-FD46-4EF3-93E7-5EFD8FE69A25}"/>
                </a:ext>
              </a:extLst>
            </p:cNvPr>
            <p:cNvCxnSpPr>
              <a:cxnSpLocks/>
            </p:cNvCxnSpPr>
            <p:nvPr/>
          </p:nvCxnSpPr>
          <p:spPr>
            <a:xfrm>
              <a:off x="1781974" y="4816388"/>
              <a:ext cx="684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5" name="CasellaDiTesto 304">
              <a:extLst>
                <a:ext uri="{FF2B5EF4-FFF2-40B4-BE49-F238E27FC236}">
                  <a16:creationId xmlns:a16="http://schemas.microsoft.com/office/drawing/2014/main" id="{65EFDC6D-9C11-4530-BFBF-1F109104162E}"/>
                </a:ext>
              </a:extLst>
            </p:cNvPr>
            <p:cNvSpPr txBox="1"/>
            <p:nvPr/>
          </p:nvSpPr>
          <p:spPr>
            <a:xfrm>
              <a:off x="1555003" y="4557951"/>
              <a:ext cx="11588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/>
                <a:t>siRNA</a:t>
              </a:r>
              <a:r>
                <a:rPr lang="it-IT" sz="1200" dirty="0"/>
                <a:t> FOXA1</a:t>
              </a:r>
            </a:p>
          </p:txBody>
        </p:sp>
        <p:grpSp>
          <p:nvGrpSpPr>
            <p:cNvPr id="306" name="Gruppo 305">
              <a:extLst>
                <a:ext uri="{FF2B5EF4-FFF2-40B4-BE49-F238E27FC236}">
                  <a16:creationId xmlns:a16="http://schemas.microsoft.com/office/drawing/2014/main" id="{D48D2497-F76A-4052-8B38-F3BCD029A0DE}"/>
                </a:ext>
              </a:extLst>
            </p:cNvPr>
            <p:cNvGrpSpPr/>
            <p:nvPr/>
          </p:nvGrpSpPr>
          <p:grpSpPr>
            <a:xfrm>
              <a:off x="837864" y="5946561"/>
              <a:ext cx="936748" cy="276999"/>
              <a:chOff x="5306914" y="3870795"/>
              <a:chExt cx="936748" cy="276999"/>
            </a:xfrm>
          </p:grpSpPr>
          <p:sp>
            <p:nvSpPr>
              <p:cNvPr id="307" name="CasellaDiTesto 306">
                <a:extLst>
                  <a:ext uri="{FF2B5EF4-FFF2-40B4-BE49-F238E27FC236}">
                    <a16:creationId xmlns:a16="http://schemas.microsoft.com/office/drawing/2014/main" id="{B2EEF01F-E6AD-4D2D-9872-D7DE53CDBA00}"/>
                  </a:ext>
                </a:extLst>
              </p:cNvPr>
              <p:cNvSpPr txBox="1"/>
              <p:nvPr/>
            </p:nvSpPr>
            <p:spPr>
              <a:xfrm>
                <a:off x="5306914" y="3870795"/>
                <a:ext cx="26962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0</a:t>
                </a:r>
              </a:p>
            </p:txBody>
          </p:sp>
          <p:sp>
            <p:nvSpPr>
              <p:cNvPr id="308" name="CasellaDiTesto 307">
                <a:extLst>
                  <a:ext uri="{FF2B5EF4-FFF2-40B4-BE49-F238E27FC236}">
                    <a16:creationId xmlns:a16="http://schemas.microsoft.com/office/drawing/2014/main" id="{7588CD57-945C-4855-A7F1-0EF5638F7CDE}"/>
                  </a:ext>
                </a:extLst>
              </p:cNvPr>
              <p:cNvSpPr txBox="1"/>
              <p:nvPr/>
            </p:nvSpPr>
            <p:spPr>
              <a:xfrm>
                <a:off x="5457924" y="3870795"/>
                <a:ext cx="35458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10</a:t>
                </a:r>
              </a:p>
            </p:txBody>
          </p:sp>
          <p:sp>
            <p:nvSpPr>
              <p:cNvPr id="309" name="CasellaDiTesto 308">
                <a:extLst>
                  <a:ext uri="{FF2B5EF4-FFF2-40B4-BE49-F238E27FC236}">
                    <a16:creationId xmlns:a16="http://schemas.microsoft.com/office/drawing/2014/main" id="{0ED780A9-93EE-42B7-A2C1-53A93C961501}"/>
                  </a:ext>
                </a:extLst>
              </p:cNvPr>
              <p:cNvSpPr txBox="1"/>
              <p:nvPr/>
            </p:nvSpPr>
            <p:spPr>
              <a:xfrm>
                <a:off x="5673054" y="3870795"/>
                <a:ext cx="35458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20</a:t>
                </a:r>
              </a:p>
            </p:txBody>
          </p:sp>
          <p:sp>
            <p:nvSpPr>
              <p:cNvPr id="310" name="CasellaDiTesto 309">
                <a:extLst>
                  <a:ext uri="{FF2B5EF4-FFF2-40B4-BE49-F238E27FC236}">
                    <a16:creationId xmlns:a16="http://schemas.microsoft.com/office/drawing/2014/main" id="{44B57060-DF92-4E89-ACE0-D2B1AD711F20}"/>
                  </a:ext>
                </a:extLst>
              </p:cNvPr>
              <p:cNvSpPr txBox="1"/>
              <p:nvPr/>
            </p:nvSpPr>
            <p:spPr>
              <a:xfrm>
                <a:off x="5889078" y="3870795"/>
                <a:ext cx="35458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40</a:t>
                </a:r>
              </a:p>
            </p:txBody>
          </p:sp>
        </p:grpSp>
      </p:grpSp>
      <p:grpSp>
        <p:nvGrpSpPr>
          <p:cNvPr id="12" name="Gruppo 11">
            <a:extLst>
              <a:ext uri="{FF2B5EF4-FFF2-40B4-BE49-F238E27FC236}">
                <a16:creationId xmlns:a16="http://schemas.microsoft.com/office/drawing/2014/main" id="{4B3337F3-FCC5-4124-88E2-64BDEADF355F}"/>
              </a:ext>
            </a:extLst>
          </p:cNvPr>
          <p:cNvGrpSpPr/>
          <p:nvPr/>
        </p:nvGrpSpPr>
        <p:grpSpPr>
          <a:xfrm>
            <a:off x="3835883" y="4501214"/>
            <a:ext cx="3049501" cy="1665609"/>
            <a:chOff x="3604896" y="4444477"/>
            <a:chExt cx="3049501" cy="1665609"/>
          </a:xfrm>
        </p:grpSpPr>
        <p:pic>
          <p:nvPicPr>
            <p:cNvPr id="11" name="Immagine 10">
              <a:extLst>
                <a:ext uri="{FF2B5EF4-FFF2-40B4-BE49-F238E27FC236}">
                  <a16:creationId xmlns:a16="http://schemas.microsoft.com/office/drawing/2014/main" id="{84589174-2489-43BD-BBF2-19F8D86E77CB}"/>
                </a:ext>
              </a:extLst>
            </p:cNvPr>
            <p:cNvPicPr>
              <a:picLocks noChangeAspect="1"/>
            </p:cNvPicPr>
            <p:nvPr/>
          </p:nvPicPr>
          <p:blipFill>
            <a:blip r:embed="rId36"/>
            <a:stretch>
              <a:fillRect/>
            </a:stretch>
          </p:blipFill>
          <p:spPr>
            <a:xfrm>
              <a:off x="4235007" y="4620596"/>
              <a:ext cx="1834325" cy="1260000"/>
            </a:xfrm>
            <a:prstGeom prst="rect">
              <a:avLst/>
            </a:prstGeom>
          </p:spPr>
        </p:pic>
        <p:sp>
          <p:nvSpPr>
            <p:cNvPr id="312" name="CasellaDiTesto 311">
              <a:extLst>
                <a:ext uri="{FF2B5EF4-FFF2-40B4-BE49-F238E27FC236}">
                  <a16:creationId xmlns:a16="http://schemas.microsoft.com/office/drawing/2014/main" id="{4C0F2C87-3CAF-4446-A137-4CF6716C83A6}"/>
                </a:ext>
              </a:extLst>
            </p:cNvPr>
            <p:cNvSpPr txBox="1"/>
            <p:nvPr/>
          </p:nvSpPr>
          <p:spPr>
            <a:xfrm>
              <a:off x="5911308" y="5833087"/>
              <a:ext cx="743089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+mn-lt"/>
                </a:rPr>
                <a:t>Tel (µM)</a:t>
              </a:r>
            </a:p>
          </p:txBody>
        </p:sp>
        <p:sp>
          <p:nvSpPr>
            <p:cNvPr id="313" name="CasellaDiTesto 312">
              <a:extLst>
                <a:ext uri="{FF2B5EF4-FFF2-40B4-BE49-F238E27FC236}">
                  <a16:creationId xmlns:a16="http://schemas.microsoft.com/office/drawing/2014/main" id="{9361F823-074E-483A-B3B4-08C067FA1C4B}"/>
                </a:ext>
              </a:extLst>
            </p:cNvPr>
            <p:cNvSpPr txBox="1"/>
            <p:nvPr/>
          </p:nvSpPr>
          <p:spPr>
            <a:xfrm rot="16200000">
              <a:off x="3145475" y="4992574"/>
              <a:ext cx="138050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/>
                <a:t>FOXA1 </a:t>
              </a:r>
              <a:r>
                <a:rPr lang="it-IT" sz="1200" dirty="0" err="1"/>
                <a:t>Levels</a:t>
              </a:r>
              <a:endParaRPr lang="it-IT" sz="1200" dirty="0"/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0 - CTR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314" name="CasellaDiTesto 313">
              <a:extLst>
                <a:ext uri="{FF2B5EF4-FFF2-40B4-BE49-F238E27FC236}">
                  <a16:creationId xmlns:a16="http://schemas.microsoft.com/office/drawing/2014/main" id="{E77F972B-01E9-4229-9283-A6A23815074E}"/>
                </a:ext>
              </a:extLst>
            </p:cNvPr>
            <p:cNvSpPr txBox="1"/>
            <p:nvPr/>
          </p:nvSpPr>
          <p:spPr>
            <a:xfrm>
              <a:off x="3934190" y="448928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2</a:t>
              </a:r>
            </a:p>
          </p:txBody>
        </p:sp>
        <p:sp>
          <p:nvSpPr>
            <p:cNvPr id="315" name="CasellaDiTesto 314">
              <a:extLst>
                <a:ext uri="{FF2B5EF4-FFF2-40B4-BE49-F238E27FC236}">
                  <a16:creationId xmlns:a16="http://schemas.microsoft.com/office/drawing/2014/main" id="{67F4BC49-D3C2-4CEA-97EF-D686B4168658}"/>
                </a:ext>
              </a:extLst>
            </p:cNvPr>
            <p:cNvSpPr txBox="1"/>
            <p:nvPr/>
          </p:nvSpPr>
          <p:spPr>
            <a:xfrm>
              <a:off x="3934190" y="5688226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316" name="CasellaDiTesto 315">
              <a:extLst>
                <a:ext uri="{FF2B5EF4-FFF2-40B4-BE49-F238E27FC236}">
                  <a16:creationId xmlns:a16="http://schemas.microsoft.com/office/drawing/2014/main" id="{A38A55C6-1D1F-4CF9-BDCC-32830BFC3F6E}"/>
                </a:ext>
              </a:extLst>
            </p:cNvPr>
            <p:cNvSpPr txBox="1"/>
            <p:nvPr/>
          </p:nvSpPr>
          <p:spPr>
            <a:xfrm>
              <a:off x="3934190" y="5094132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6</a:t>
              </a:r>
            </a:p>
          </p:txBody>
        </p:sp>
        <p:grpSp>
          <p:nvGrpSpPr>
            <p:cNvPr id="317" name="Gruppo 316">
              <a:extLst>
                <a:ext uri="{FF2B5EF4-FFF2-40B4-BE49-F238E27FC236}">
                  <a16:creationId xmlns:a16="http://schemas.microsoft.com/office/drawing/2014/main" id="{9DE63326-DFBD-4353-86C3-6398D63EA89F}"/>
                </a:ext>
              </a:extLst>
            </p:cNvPr>
            <p:cNvGrpSpPr/>
            <p:nvPr/>
          </p:nvGrpSpPr>
          <p:grpSpPr>
            <a:xfrm>
              <a:off x="5122768" y="5833087"/>
              <a:ext cx="936748" cy="276999"/>
              <a:chOff x="5306914" y="3870795"/>
              <a:chExt cx="936748" cy="276999"/>
            </a:xfrm>
          </p:grpSpPr>
          <p:sp>
            <p:nvSpPr>
              <p:cNvPr id="318" name="CasellaDiTesto 317">
                <a:extLst>
                  <a:ext uri="{FF2B5EF4-FFF2-40B4-BE49-F238E27FC236}">
                    <a16:creationId xmlns:a16="http://schemas.microsoft.com/office/drawing/2014/main" id="{7A17778D-A4D9-47C3-B946-00F57ED383FE}"/>
                  </a:ext>
                </a:extLst>
              </p:cNvPr>
              <p:cNvSpPr txBox="1"/>
              <p:nvPr/>
            </p:nvSpPr>
            <p:spPr>
              <a:xfrm>
                <a:off x="5306914" y="3870795"/>
                <a:ext cx="26962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0</a:t>
                </a:r>
              </a:p>
            </p:txBody>
          </p:sp>
          <p:sp>
            <p:nvSpPr>
              <p:cNvPr id="319" name="CasellaDiTesto 318">
                <a:extLst>
                  <a:ext uri="{FF2B5EF4-FFF2-40B4-BE49-F238E27FC236}">
                    <a16:creationId xmlns:a16="http://schemas.microsoft.com/office/drawing/2014/main" id="{396EF412-D43F-4FA0-ABDE-187EBA9B5747}"/>
                  </a:ext>
                </a:extLst>
              </p:cNvPr>
              <p:cNvSpPr txBox="1"/>
              <p:nvPr/>
            </p:nvSpPr>
            <p:spPr>
              <a:xfrm>
                <a:off x="5457924" y="3870795"/>
                <a:ext cx="35458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10</a:t>
                </a:r>
              </a:p>
            </p:txBody>
          </p:sp>
          <p:sp>
            <p:nvSpPr>
              <p:cNvPr id="320" name="CasellaDiTesto 319">
                <a:extLst>
                  <a:ext uri="{FF2B5EF4-FFF2-40B4-BE49-F238E27FC236}">
                    <a16:creationId xmlns:a16="http://schemas.microsoft.com/office/drawing/2014/main" id="{193AF1EC-F20E-4AE5-9D1E-D4190987F9F5}"/>
                  </a:ext>
                </a:extLst>
              </p:cNvPr>
              <p:cNvSpPr txBox="1"/>
              <p:nvPr/>
            </p:nvSpPr>
            <p:spPr>
              <a:xfrm>
                <a:off x="5673054" y="3870795"/>
                <a:ext cx="35458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20</a:t>
                </a:r>
              </a:p>
            </p:txBody>
          </p:sp>
          <p:sp>
            <p:nvSpPr>
              <p:cNvPr id="321" name="CasellaDiTesto 320">
                <a:extLst>
                  <a:ext uri="{FF2B5EF4-FFF2-40B4-BE49-F238E27FC236}">
                    <a16:creationId xmlns:a16="http://schemas.microsoft.com/office/drawing/2014/main" id="{02EEA326-3E89-4E55-8CFA-3BA0D7C95B5C}"/>
                  </a:ext>
                </a:extLst>
              </p:cNvPr>
              <p:cNvSpPr txBox="1"/>
              <p:nvPr/>
            </p:nvSpPr>
            <p:spPr>
              <a:xfrm>
                <a:off x="5889078" y="3870795"/>
                <a:ext cx="35458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40</a:t>
                </a:r>
              </a:p>
            </p:txBody>
          </p:sp>
        </p:grpSp>
        <p:cxnSp>
          <p:nvCxnSpPr>
            <p:cNvPr id="322" name="Connettore diritto 321">
              <a:extLst>
                <a:ext uri="{FF2B5EF4-FFF2-40B4-BE49-F238E27FC236}">
                  <a16:creationId xmlns:a16="http://schemas.microsoft.com/office/drawing/2014/main" id="{ED4F6FE6-B780-4031-A202-4B3401350706}"/>
                </a:ext>
              </a:extLst>
            </p:cNvPr>
            <p:cNvCxnSpPr>
              <a:cxnSpLocks/>
            </p:cNvCxnSpPr>
            <p:nvPr/>
          </p:nvCxnSpPr>
          <p:spPr>
            <a:xfrm>
              <a:off x="4397022" y="4702914"/>
              <a:ext cx="684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3" name="CasellaDiTesto 322">
              <a:extLst>
                <a:ext uri="{FF2B5EF4-FFF2-40B4-BE49-F238E27FC236}">
                  <a16:creationId xmlns:a16="http://schemas.microsoft.com/office/drawing/2014/main" id="{E4675C96-9FD4-45FB-8EF1-564C8EB64631}"/>
                </a:ext>
              </a:extLst>
            </p:cNvPr>
            <p:cNvSpPr txBox="1"/>
            <p:nvPr/>
          </p:nvSpPr>
          <p:spPr>
            <a:xfrm>
              <a:off x="4517038" y="4444477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CTR</a:t>
              </a:r>
            </a:p>
          </p:txBody>
        </p:sp>
        <p:cxnSp>
          <p:nvCxnSpPr>
            <p:cNvPr id="324" name="Connettore diritto 323">
              <a:extLst>
                <a:ext uri="{FF2B5EF4-FFF2-40B4-BE49-F238E27FC236}">
                  <a16:creationId xmlns:a16="http://schemas.microsoft.com/office/drawing/2014/main" id="{D511AFC3-A053-4C6D-9F05-BE6B8BAC622E}"/>
                </a:ext>
              </a:extLst>
            </p:cNvPr>
            <p:cNvCxnSpPr>
              <a:cxnSpLocks/>
            </p:cNvCxnSpPr>
            <p:nvPr/>
          </p:nvCxnSpPr>
          <p:spPr>
            <a:xfrm>
              <a:off x="5248418" y="4702914"/>
              <a:ext cx="684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5" name="CasellaDiTesto 324">
              <a:extLst>
                <a:ext uri="{FF2B5EF4-FFF2-40B4-BE49-F238E27FC236}">
                  <a16:creationId xmlns:a16="http://schemas.microsoft.com/office/drawing/2014/main" id="{043DB477-E129-4A74-ADFC-E23ED3206788}"/>
                </a:ext>
              </a:extLst>
            </p:cNvPr>
            <p:cNvSpPr txBox="1"/>
            <p:nvPr/>
          </p:nvSpPr>
          <p:spPr>
            <a:xfrm>
              <a:off x="5021447" y="4444477"/>
              <a:ext cx="11588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/>
                <a:t>siRNA</a:t>
              </a:r>
              <a:r>
                <a:rPr lang="it-IT" sz="1200" dirty="0"/>
                <a:t> FOXA1</a:t>
              </a:r>
            </a:p>
          </p:txBody>
        </p:sp>
        <p:grpSp>
          <p:nvGrpSpPr>
            <p:cNvPr id="326" name="Gruppo 325">
              <a:extLst>
                <a:ext uri="{FF2B5EF4-FFF2-40B4-BE49-F238E27FC236}">
                  <a16:creationId xmlns:a16="http://schemas.microsoft.com/office/drawing/2014/main" id="{C00D9D9E-09DC-4C46-8BF9-F0DEE92CC5B7}"/>
                </a:ext>
              </a:extLst>
            </p:cNvPr>
            <p:cNvGrpSpPr/>
            <p:nvPr/>
          </p:nvGrpSpPr>
          <p:grpSpPr>
            <a:xfrm>
              <a:off x="4304308" y="5833087"/>
              <a:ext cx="936748" cy="276999"/>
              <a:chOff x="5306914" y="3870795"/>
              <a:chExt cx="936748" cy="276999"/>
            </a:xfrm>
          </p:grpSpPr>
          <p:sp>
            <p:nvSpPr>
              <p:cNvPr id="327" name="CasellaDiTesto 326">
                <a:extLst>
                  <a:ext uri="{FF2B5EF4-FFF2-40B4-BE49-F238E27FC236}">
                    <a16:creationId xmlns:a16="http://schemas.microsoft.com/office/drawing/2014/main" id="{D41269B5-DC13-4733-B249-3D6B3E0E56D3}"/>
                  </a:ext>
                </a:extLst>
              </p:cNvPr>
              <p:cNvSpPr txBox="1"/>
              <p:nvPr/>
            </p:nvSpPr>
            <p:spPr>
              <a:xfrm>
                <a:off x="5306914" y="3870795"/>
                <a:ext cx="26962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0</a:t>
                </a:r>
              </a:p>
            </p:txBody>
          </p:sp>
          <p:sp>
            <p:nvSpPr>
              <p:cNvPr id="328" name="CasellaDiTesto 327">
                <a:extLst>
                  <a:ext uri="{FF2B5EF4-FFF2-40B4-BE49-F238E27FC236}">
                    <a16:creationId xmlns:a16="http://schemas.microsoft.com/office/drawing/2014/main" id="{FA94A825-580D-41E5-9137-59215DDE4448}"/>
                  </a:ext>
                </a:extLst>
              </p:cNvPr>
              <p:cNvSpPr txBox="1"/>
              <p:nvPr/>
            </p:nvSpPr>
            <p:spPr>
              <a:xfrm>
                <a:off x="5457924" y="3870795"/>
                <a:ext cx="35458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10</a:t>
                </a:r>
              </a:p>
            </p:txBody>
          </p:sp>
          <p:sp>
            <p:nvSpPr>
              <p:cNvPr id="329" name="CasellaDiTesto 328">
                <a:extLst>
                  <a:ext uri="{FF2B5EF4-FFF2-40B4-BE49-F238E27FC236}">
                    <a16:creationId xmlns:a16="http://schemas.microsoft.com/office/drawing/2014/main" id="{A2272671-5A08-4F19-82B3-BB5651FCF045}"/>
                  </a:ext>
                </a:extLst>
              </p:cNvPr>
              <p:cNvSpPr txBox="1"/>
              <p:nvPr/>
            </p:nvSpPr>
            <p:spPr>
              <a:xfrm>
                <a:off x="5673054" y="3870795"/>
                <a:ext cx="35458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20</a:t>
                </a:r>
              </a:p>
            </p:txBody>
          </p:sp>
          <p:sp>
            <p:nvSpPr>
              <p:cNvPr id="330" name="CasellaDiTesto 329">
                <a:extLst>
                  <a:ext uri="{FF2B5EF4-FFF2-40B4-BE49-F238E27FC236}">
                    <a16:creationId xmlns:a16="http://schemas.microsoft.com/office/drawing/2014/main" id="{2C9A0BD2-6D3F-4285-97A7-7CBA166A2DFA}"/>
                  </a:ext>
                </a:extLst>
              </p:cNvPr>
              <p:cNvSpPr txBox="1"/>
              <p:nvPr/>
            </p:nvSpPr>
            <p:spPr>
              <a:xfrm>
                <a:off x="5889078" y="3870795"/>
                <a:ext cx="35458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+mn-lt"/>
                  </a:rPr>
                  <a:t>40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8880392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5D2DCA17-BCD4-4265-8C5B-67AE7563323A}"/>
              </a:ext>
            </a:extLst>
          </p:cNvPr>
          <p:cNvSpPr txBox="1"/>
          <p:nvPr/>
        </p:nvSpPr>
        <p:spPr>
          <a:xfrm>
            <a:off x="2240213" y="0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ementary</a:t>
            </a:r>
            <a:r>
              <a:rPr lang="it-IT" b="1" dirty="0"/>
              <a:t> Fig. 3</a:t>
            </a:r>
          </a:p>
        </p:txBody>
      </p:sp>
      <p:grpSp>
        <p:nvGrpSpPr>
          <p:cNvPr id="126" name="Gruppo 125">
            <a:extLst>
              <a:ext uri="{FF2B5EF4-FFF2-40B4-BE49-F238E27FC236}">
                <a16:creationId xmlns:a16="http://schemas.microsoft.com/office/drawing/2014/main" id="{AC3A529B-3606-4A73-9A66-FAAAAF8CCE76}"/>
              </a:ext>
            </a:extLst>
          </p:cNvPr>
          <p:cNvGrpSpPr/>
          <p:nvPr/>
        </p:nvGrpSpPr>
        <p:grpSpPr>
          <a:xfrm>
            <a:off x="433357" y="510119"/>
            <a:ext cx="2472307" cy="2078583"/>
            <a:chOff x="433357" y="485212"/>
            <a:chExt cx="2472307" cy="2078583"/>
          </a:xfrm>
        </p:grpSpPr>
        <p:pic>
          <p:nvPicPr>
            <p:cNvPr id="95" name="Immagine 94">
              <a:extLst>
                <a:ext uri="{FF2B5EF4-FFF2-40B4-BE49-F238E27FC236}">
                  <a16:creationId xmlns:a16="http://schemas.microsoft.com/office/drawing/2014/main" id="{96EB1645-5E89-4C93-890F-504ABF9143F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65478" y="952499"/>
              <a:ext cx="1840186" cy="1260000"/>
            </a:xfrm>
            <a:prstGeom prst="rect">
              <a:avLst/>
            </a:prstGeom>
          </p:spPr>
        </p:pic>
        <p:sp>
          <p:nvSpPr>
            <p:cNvPr id="82" name="CasellaDiTesto 81">
              <a:extLst>
                <a:ext uri="{FF2B5EF4-FFF2-40B4-BE49-F238E27FC236}">
                  <a16:creationId xmlns:a16="http://schemas.microsoft.com/office/drawing/2014/main" id="{C93BF847-46AB-4F5C-9DC5-42EE4383F1D2}"/>
                </a:ext>
              </a:extLst>
            </p:cNvPr>
            <p:cNvSpPr txBox="1"/>
            <p:nvPr/>
          </p:nvSpPr>
          <p:spPr>
            <a:xfrm rot="16200000">
              <a:off x="76529" y="1331693"/>
              <a:ext cx="117532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/>
                <a:t>FOXA1 </a:t>
              </a:r>
              <a:r>
                <a:rPr lang="it-IT" sz="1200" dirty="0" err="1"/>
                <a:t>Levels</a:t>
              </a:r>
              <a:endParaRPr lang="it-IT" sz="1200" dirty="0"/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-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83" name="CasellaDiTesto 82">
              <a:extLst>
                <a:ext uri="{FF2B5EF4-FFF2-40B4-BE49-F238E27FC236}">
                  <a16:creationId xmlns:a16="http://schemas.microsoft.com/office/drawing/2014/main" id="{0A62966A-1B5C-4EC7-9EF8-3147EDC42836}"/>
                </a:ext>
              </a:extLst>
            </p:cNvPr>
            <p:cNvSpPr txBox="1"/>
            <p:nvPr/>
          </p:nvSpPr>
          <p:spPr>
            <a:xfrm>
              <a:off x="762653" y="834756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2</a:t>
              </a:r>
            </a:p>
          </p:txBody>
        </p:sp>
        <p:sp>
          <p:nvSpPr>
            <p:cNvPr id="84" name="CasellaDiTesto 83">
              <a:extLst>
                <a:ext uri="{FF2B5EF4-FFF2-40B4-BE49-F238E27FC236}">
                  <a16:creationId xmlns:a16="http://schemas.microsoft.com/office/drawing/2014/main" id="{89A1E95F-B136-4CF4-8525-C9EBD969FC76}"/>
                </a:ext>
              </a:extLst>
            </p:cNvPr>
            <p:cNvSpPr txBox="1"/>
            <p:nvPr/>
          </p:nvSpPr>
          <p:spPr>
            <a:xfrm>
              <a:off x="762653" y="1426075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6</a:t>
              </a:r>
            </a:p>
          </p:txBody>
        </p:sp>
        <p:sp>
          <p:nvSpPr>
            <p:cNvPr id="85" name="CasellaDiTesto 84">
              <a:extLst>
                <a:ext uri="{FF2B5EF4-FFF2-40B4-BE49-F238E27FC236}">
                  <a16:creationId xmlns:a16="http://schemas.microsoft.com/office/drawing/2014/main" id="{416B7B04-C170-4EE5-B5FE-DDFD29A95FD4}"/>
                </a:ext>
              </a:extLst>
            </p:cNvPr>
            <p:cNvSpPr txBox="1"/>
            <p:nvPr/>
          </p:nvSpPr>
          <p:spPr>
            <a:xfrm>
              <a:off x="762653" y="2027345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87" name="CasellaDiTesto 86">
              <a:extLst>
                <a:ext uri="{FF2B5EF4-FFF2-40B4-BE49-F238E27FC236}">
                  <a16:creationId xmlns:a16="http://schemas.microsoft.com/office/drawing/2014/main" id="{E6148F63-12D9-43A9-9FBF-1DBA5E46CB8A}"/>
                </a:ext>
              </a:extLst>
            </p:cNvPr>
            <p:cNvSpPr txBox="1"/>
            <p:nvPr/>
          </p:nvSpPr>
          <p:spPr>
            <a:xfrm>
              <a:off x="1272832" y="2134761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+</a:t>
              </a:r>
            </a:p>
          </p:txBody>
        </p:sp>
        <p:sp>
          <p:nvSpPr>
            <p:cNvPr id="88" name="CasellaDiTesto 87">
              <a:extLst>
                <a:ext uri="{FF2B5EF4-FFF2-40B4-BE49-F238E27FC236}">
                  <a16:creationId xmlns:a16="http://schemas.microsoft.com/office/drawing/2014/main" id="{14598B10-9F2D-449E-BFCD-A7235AC8CF70}"/>
                </a:ext>
              </a:extLst>
            </p:cNvPr>
            <p:cNvSpPr txBox="1"/>
            <p:nvPr/>
          </p:nvSpPr>
          <p:spPr>
            <a:xfrm>
              <a:off x="1123414" y="2134761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-</a:t>
              </a:r>
            </a:p>
          </p:txBody>
        </p:sp>
        <p:grpSp>
          <p:nvGrpSpPr>
            <p:cNvPr id="102" name="Gruppo 101">
              <a:extLst>
                <a:ext uri="{FF2B5EF4-FFF2-40B4-BE49-F238E27FC236}">
                  <a16:creationId xmlns:a16="http://schemas.microsoft.com/office/drawing/2014/main" id="{52443CD1-83FE-4719-BF3A-1C131D1F3E38}"/>
                </a:ext>
              </a:extLst>
            </p:cNvPr>
            <p:cNvGrpSpPr/>
            <p:nvPr/>
          </p:nvGrpSpPr>
          <p:grpSpPr>
            <a:xfrm>
              <a:off x="1115218" y="2286796"/>
              <a:ext cx="380810" cy="276999"/>
              <a:chOff x="1115218" y="2318898"/>
              <a:chExt cx="380810" cy="276999"/>
            </a:xfrm>
          </p:grpSpPr>
          <p:cxnSp>
            <p:nvCxnSpPr>
              <p:cNvPr id="90" name="Connettore diritto 89">
                <a:extLst>
                  <a:ext uri="{FF2B5EF4-FFF2-40B4-BE49-F238E27FC236}">
                    <a16:creationId xmlns:a16="http://schemas.microsoft.com/office/drawing/2014/main" id="{290862B8-FF7E-45BC-A900-99B65E70A03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72971" y="2368893"/>
                <a:ext cx="288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1" name="CasellaDiTesto 90">
                <a:extLst>
                  <a:ext uri="{FF2B5EF4-FFF2-40B4-BE49-F238E27FC236}">
                    <a16:creationId xmlns:a16="http://schemas.microsoft.com/office/drawing/2014/main" id="{5C49F340-A0DD-46B3-97B6-FCF895A072AA}"/>
                  </a:ext>
                </a:extLst>
              </p:cNvPr>
              <p:cNvSpPr txBox="1"/>
              <p:nvPr/>
            </p:nvSpPr>
            <p:spPr>
              <a:xfrm>
                <a:off x="1115218" y="2318898"/>
                <a:ext cx="3808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Tel</a:t>
                </a:r>
              </a:p>
            </p:txBody>
          </p:sp>
        </p:grpSp>
        <p:sp>
          <p:nvSpPr>
            <p:cNvPr id="96" name="CasellaDiTesto 95">
              <a:extLst>
                <a:ext uri="{FF2B5EF4-FFF2-40B4-BE49-F238E27FC236}">
                  <a16:creationId xmlns:a16="http://schemas.microsoft.com/office/drawing/2014/main" id="{DE1F7433-875F-4B55-8206-A15DE8672A92}"/>
                </a:ext>
              </a:extLst>
            </p:cNvPr>
            <p:cNvSpPr txBox="1"/>
            <p:nvPr/>
          </p:nvSpPr>
          <p:spPr>
            <a:xfrm>
              <a:off x="1715736" y="2134761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+</a:t>
              </a:r>
            </a:p>
          </p:txBody>
        </p:sp>
        <p:sp>
          <p:nvSpPr>
            <p:cNvPr id="97" name="CasellaDiTesto 96">
              <a:extLst>
                <a:ext uri="{FF2B5EF4-FFF2-40B4-BE49-F238E27FC236}">
                  <a16:creationId xmlns:a16="http://schemas.microsoft.com/office/drawing/2014/main" id="{10B2623E-8A6A-4034-BDDC-6FF9E4BA830F}"/>
                </a:ext>
              </a:extLst>
            </p:cNvPr>
            <p:cNvSpPr txBox="1"/>
            <p:nvPr/>
          </p:nvSpPr>
          <p:spPr>
            <a:xfrm>
              <a:off x="1566318" y="2134761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-</a:t>
              </a:r>
            </a:p>
          </p:txBody>
        </p:sp>
        <p:sp>
          <p:nvSpPr>
            <p:cNvPr id="98" name="CasellaDiTesto 97">
              <a:extLst>
                <a:ext uri="{FF2B5EF4-FFF2-40B4-BE49-F238E27FC236}">
                  <a16:creationId xmlns:a16="http://schemas.microsoft.com/office/drawing/2014/main" id="{146C6FED-74F5-400A-9A41-7EDA2CA9B682}"/>
                </a:ext>
              </a:extLst>
            </p:cNvPr>
            <p:cNvSpPr txBox="1"/>
            <p:nvPr/>
          </p:nvSpPr>
          <p:spPr>
            <a:xfrm>
              <a:off x="2170269" y="2134761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+</a:t>
              </a:r>
            </a:p>
          </p:txBody>
        </p:sp>
        <p:sp>
          <p:nvSpPr>
            <p:cNvPr id="99" name="CasellaDiTesto 98">
              <a:extLst>
                <a:ext uri="{FF2B5EF4-FFF2-40B4-BE49-F238E27FC236}">
                  <a16:creationId xmlns:a16="http://schemas.microsoft.com/office/drawing/2014/main" id="{4CB4C672-2590-47A4-8C80-6C8B9F57652E}"/>
                </a:ext>
              </a:extLst>
            </p:cNvPr>
            <p:cNvSpPr txBox="1"/>
            <p:nvPr/>
          </p:nvSpPr>
          <p:spPr>
            <a:xfrm>
              <a:off x="2020851" y="2134761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-</a:t>
              </a:r>
            </a:p>
          </p:txBody>
        </p:sp>
        <p:sp>
          <p:nvSpPr>
            <p:cNvPr id="100" name="CasellaDiTesto 99">
              <a:extLst>
                <a:ext uri="{FF2B5EF4-FFF2-40B4-BE49-F238E27FC236}">
                  <a16:creationId xmlns:a16="http://schemas.microsoft.com/office/drawing/2014/main" id="{5051ED74-6485-4285-A9DD-935FA09B7505}"/>
                </a:ext>
              </a:extLst>
            </p:cNvPr>
            <p:cNvSpPr txBox="1"/>
            <p:nvPr/>
          </p:nvSpPr>
          <p:spPr>
            <a:xfrm>
              <a:off x="2616606" y="2134761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+</a:t>
              </a:r>
            </a:p>
          </p:txBody>
        </p:sp>
        <p:sp>
          <p:nvSpPr>
            <p:cNvPr id="101" name="CasellaDiTesto 100">
              <a:extLst>
                <a:ext uri="{FF2B5EF4-FFF2-40B4-BE49-F238E27FC236}">
                  <a16:creationId xmlns:a16="http://schemas.microsoft.com/office/drawing/2014/main" id="{70FE8C55-C7C2-4401-A045-FB2365B7C0E7}"/>
                </a:ext>
              </a:extLst>
            </p:cNvPr>
            <p:cNvSpPr txBox="1"/>
            <p:nvPr/>
          </p:nvSpPr>
          <p:spPr>
            <a:xfrm>
              <a:off x="2467188" y="2134761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-</a:t>
              </a:r>
            </a:p>
          </p:txBody>
        </p:sp>
        <p:grpSp>
          <p:nvGrpSpPr>
            <p:cNvPr id="103" name="Gruppo 102">
              <a:extLst>
                <a:ext uri="{FF2B5EF4-FFF2-40B4-BE49-F238E27FC236}">
                  <a16:creationId xmlns:a16="http://schemas.microsoft.com/office/drawing/2014/main" id="{3C8BA307-BB78-4D39-B395-74D42021DF21}"/>
                </a:ext>
              </a:extLst>
            </p:cNvPr>
            <p:cNvGrpSpPr/>
            <p:nvPr/>
          </p:nvGrpSpPr>
          <p:grpSpPr>
            <a:xfrm>
              <a:off x="1588978" y="2286796"/>
              <a:ext cx="380810" cy="276999"/>
              <a:chOff x="1115218" y="2318898"/>
              <a:chExt cx="380810" cy="276999"/>
            </a:xfrm>
          </p:grpSpPr>
          <p:cxnSp>
            <p:nvCxnSpPr>
              <p:cNvPr id="104" name="Connettore diritto 103">
                <a:extLst>
                  <a:ext uri="{FF2B5EF4-FFF2-40B4-BE49-F238E27FC236}">
                    <a16:creationId xmlns:a16="http://schemas.microsoft.com/office/drawing/2014/main" id="{A9DD0DC0-B9D4-4CC8-A491-7A9938002E1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72971" y="2368893"/>
                <a:ext cx="288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5" name="CasellaDiTesto 104">
                <a:extLst>
                  <a:ext uri="{FF2B5EF4-FFF2-40B4-BE49-F238E27FC236}">
                    <a16:creationId xmlns:a16="http://schemas.microsoft.com/office/drawing/2014/main" id="{676E51CB-EB34-422B-94E9-DA9252C4F892}"/>
                  </a:ext>
                </a:extLst>
              </p:cNvPr>
              <p:cNvSpPr txBox="1"/>
              <p:nvPr/>
            </p:nvSpPr>
            <p:spPr>
              <a:xfrm>
                <a:off x="1115218" y="2318898"/>
                <a:ext cx="3808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Tel</a:t>
                </a:r>
              </a:p>
            </p:txBody>
          </p:sp>
        </p:grpSp>
        <p:grpSp>
          <p:nvGrpSpPr>
            <p:cNvPr id="106" name="Gruppo 105">
              <a:extLst>
                <a:ext uri="{FF2B5EF4-FFF2-40B4-BE49-F238E27FC236}">
                  <a16:creationId xmlns:a16="http://schemas.microsoft.com/office/drawing/2014/main" id="{4AA33AE8-DF69-403A-8EF4-FBE061688CD1}"/>
                </a:ext>
              </a:extLst>
            </p:cNvPr>
            <p:cNvGrpSpPr/>
            <p:nvPr/>
          </p:nvGrpSpPr>
          <p:grpSpPr>
            <a:xfrm>
              <a:off x="2040078" y="2286796"/>
              <a:ext cx="380810" cy="276999"/>
              <a:chOff x="1115218" y="2318898"/>
              <a:chExt cx="380810" cy="276999"/>
            </a:xfrm>
          </p:grpSpPr>
          <p:cxnSp>
            <p:nvCxnSpPr>
              <p:cNvPr id="107" name="Connettore diritto 106">
                <a:extLst>
                  <a:ext uri="{FF2B5EF4-FFF2-40B4-BE49-F238E27FC236}">
                    <a16:creationId xmlns:a16="http://schemas.microsoft.com/office/drawing/2014/main" id="{D42E3D3A-B961-49EE-9273-A0E74D236EA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72971" y="2368893"/>
                <a:ext cx="288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8" name="CasellaDiTesto 107">
                <a:extLst>
                  <a:ext uri="{FF2B5EF4-FFF2-40B4-BE49-F238E27FC236}">
                    <a16:creationId xmlns:a16="http://schemas.microsoft.com/office/drawing/2014/main" id="{B0BACDF3-A9C7-4649-ACFA-D79179FCB9E7}"/>
                  </a:ext>
                </a:extLst>
              </p:cNvPr>
              <p:cNvSpPr txBox="1"/>
              <p:nvPr/>
            </p:nvSpPr>
            <p:spPr>
              <a:xfrm>
                <a:off x="1115218" y="2318898"/>
                <a:ext cx="3808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Tel</a:t>
                </a:r>
              </a:p>
            </p:txBody>
          </p:sp>
        </p:grpSp>
        <p:grpSp>
          <p:nvGrpSpPr>
            <p:cNvPr id="109" name="Gruppo 108">
              <a:extLst>
                <a:ext uri="{FF2B5EF4-FFF2-40B4-BE49-F238E27FC236}">
                  <a16:creationId xmlns:a16="http://schemas.microsoft.com/office/drawing/2014/main" id="{59C48473-B5BA-4180-AA96-356E660744F7}"/>
                </a:ext>
              </a:extLst>
            </p:cNvPr>
            <p:cNvGrpSpPr/>
            <p:nvPr/>
          </p:nvGrpSpPr>
          <p:grpSpPr>
            <a:xfrm>
              <a:off x="2472126" y="2286796"/>
              <a:ext cx="380810" cy="276999"/>
              <a:chOff x="1115218" y="2318898"/>
              <a:chExt cx="380810" cy="276999"/>
            </a:xfrm>
          </p:grpSpPr>
          <p:cxnSp>
            <p:nvCxnSpPr>
              <p:cNvPr id="110" name="Connettore diritto 109">
                <a:extLst>
                  <a:ext uri="{FF2B5EF4-FFF2-40B4-BE49-F238E27FC236}">
                    <a16:creationId xmlns:a16="http://schemas.microsoft.com/office/drawing/2014/main" id="{5969F767-E54D-4AD2-B0FE-566D3BB8F2D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72971" y="2368893"/>
                <a:ext cx="288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1" name="CasellaDiTesto 110">
                <a:extLst>
                  <a:ext uri="{FF2B5EF4-FFF2-40B4-BE49-F238E27FC236}">
                    <a16:creationId xmlns:a16="http://schemas.microsoft.com/office/drawing/2014/main" id="{AD8CCD6D-136E-41EA-8831-76DE00EF4BB9}"/>
                  </a:ext>
                </a:extLst>
              </p:cNvPr>
              <p:cNvSpPr txBox="1"/>
              <p:nvPr/>
            </p:nvSpPr>
            <p:spPr>
              <a:xfrm>
                <a:off x="1115218" y="2318898"/>
                <a:ext cx="3808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Tel</a:t>
                </a:r>
              </a:p>
            </p:txBody>
          </p:sp>
        </p:grpSp>
        <p:grpSp>
          <p:nvGrpSpPr>
            <p:cNvPr id="115" name="Gruppo 114">
              <a:extLst>
                <a:ext uri="{FF2B5EF4-FFF2-40B4-BE49-F238E27FC236}">
                  <a16:creationId xmlns:a16="http://schemas.microsoft.com/office/drawing/2014/main" id="{88342D0A-4697-479C-B3E8-A32C37FEB50D}"/>
                </a:ext>
              </a:extLst>
            </p:cNvPr>
            <p:cNvGrpSpPr/>
            <p:nvPr/>
          </p:nvGrpSpPr>
          <p:grpSpPr>
            <a:xfrm>
              <a:off x="1185919" y="502044"/>
              <a:ext cx="300452" cy="654346"/>
              <a:chOff x="1185919" y="502044"/>
              <a:chExt cx="300452" cy="654346"/>
            </a:xfrm>
          </p:grpSpPr>
          <p:cxnSp>
            <p:nvCxnSpPr>
              <p:cNvPr id="113" name="Connettore diritto 112">
                <a:extLst>
                  <a:ext uri="{FF2B5EF4-FFF2-40B4-BE49-F238E27FC236}">
                    <a16:creationId xmlns:a16="http://schemas.microsoft.com/office/drawing/2014/main" id="{19E9E798-8124-4BFF-801E-55DA3229D65E}"/>
                  </a:ext>
                </a:extLst>
              </p:cNvPr>
              <p:cNvCxnSpPr/>
              <p:nvPr/>
            </p:nvCxnSpPr>
            <p:spPr>
              <a:xfrm>
                <a:off x="1185919" y="1111755"/>
                <a:ext cx="30045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4" name="CasellaDiTesto 113">
                <a:extLst>
                  <a:ext uri="{FF2B5EF4-FFF2-40B4-BE49-F238E27FC236}">
                    <a16:creationId xmlns:a16="http://schemas.microsoft.com/office/drawing/2014/main" id="{C3788B81-5CF4-48DB-8866-4420D3D02E9A}"/>
                  </a:ext>
                </a:extLst>
              </p:cNvPr>
              <p:cNvSpPr txBox="1"/>
              <p:nvPr/>
            </p:nvSpPr>
            <p:spPr>
              <a:xfrm rot="16200000">
                <a:off x="1012519" y="690717"/>
                <a:ext cx="65434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MCF-7</a:t>
                </a:r>
              </a:p>
            </p:txBody>
          </p:sp>
        </p:grpSp>
        <p:grpSp>
          <p:nvGrpSpPr>
            <p:cNvPr id="116" name="Gruppo 115">
              <a:extLst>
                <a:ext uri="{FF2B5EF4-FFF2-40B4-BE49-F238E27FC236}">
                  <a16:creationId xmlns:a16="http://schemas.microsoft.com/office/drawing/2014/main" id="{B08FB395-2352-4815-91B6-E274509B2C71}"/>
                </a:ext>
              </a:extLst>
            </p:cNvPr>
            <p:cNvGrpSpPr/>
            <p:nvPr/>
          </p:nvGrpSpPr>
          <p:grpSpPr>
            <a:xfrm>
              <a:off x="1668403" y="489444"/>
              <a:ext cx="300452" cy="679545"/>
              <a:chOff x="1185919" y="489444"/>
              <a:chExt cx="300452" cy="679545"/>
            </a:xfrm>
          </p:grpSpPr>
          <p:cxnSp>
            <p:nvCxnSpPr>
              <p:cNvPr id="117" name="Connettore diritto 116">
                <a:extLst>
                  <a:ext uri="{FF2B5EF4-FFF2-40B4-BE49-F238E27FC236}">
                    <a16:creationId xmlns:a16="http://schemas.microsoft.com/office/drawing/2014/main" id="{124A8897-DE0F-4EC7-A848-48A53A9335AF}"/>
                  </a:ext>
                </a:extLst>
              </p:cNvPr>
              <p:cNvCxnSpPr/>
              <p:nvPr/>
            </p:nvCxnSpPr>
            <p:spPr>
              <a:xfrm>
                <a:off x="1185919" y="1111755"/>
                <a:ext cx="30045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8" name="CasellaDiTesto 117">
                <a:extLst>
                  <a:ext uri="{FF2B5EF4-FFF2-40B4-BE49-F238E27FC236}">
                    <a16:creationId xmlns:a16="http://schemas.microsoft.com/office/drawing/2014/main" id="{8D4601F0-682A-4E1B-90E0-010438471764}"/>
                  </a:ext>
                </a:extLst>
              </p:cNvPr>
              <p:cNvSpPr txBox="1"/>
              <p:nvPr/>
            </p:nvSpPr>
            <p:spPr>
              <a:xfrm rot="16200000">
                <a:off x="999921" y="690717"/>
                <a:ext cx="67954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BT-474</a:t>
                </a:r>
              </a:p>
            </p:txBody>
          </p:sp>
        </p:grpSp>
        <p:grpSp>
          <p:nvGrpSpPr>
            <p:cNvPr id="119" name="Gruppo 118">
              <a:extLst>
                <a:ext uri="{FF2B5EF4-FFF2-40B4-BE49-F238E27FC236}">
                  <a16:creationId xmlns:a16="http://schemas.microsoft.com/office/drawing/2014/main" id="{865245CE-E75A-4268-8453-FB47279E6FA3}"/>
                </a:ext>
              </a:extLst>
            </p:cNvPr>
            <p:cNvGrpSpPr/>
            <p:nvPr/>
          </p:nvGrpSpPr>
          <p:grpSpPr>
            <a:xfrm>
              <a:off x="2080257" y="485212"/>
              <a:ext cx="300452" cy="688009"/>
              <a:chOff x="1185919" y="485212"/>
              <a:chExt cx="300452" cy="688009"/>
            </a:xfrm>
          </p:grpSpPr>
          <p:cxnSp>
            <p:nvCxnSpPr>
              <p:cNvPr id="120" name="Connettore diritto 119">
                <a:extLst>
                  <a:ext uri="{FF2B5EF4-FFF2-40B4-BE49-F238E27FC236}">
                    <a16:creationId xmlns:a16="http://schemas.microsoft.com/office/drawing/2014/main" id="{1EDBAC32-4A87-44B2-9C21-4E096AE237F9}"/>
                  </a:ext>
                </a:extLst>
              </p:cNvPr>
              <p:cNvCxnSpPr/>
              <p:nvPr/>
            </p:nvCxnSpPr>
            <p:spPr>
              <a:xfrm>
                <a:off x="1185919" y="1111755"/>
                <a:ext cx="30045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1" name="CasellaDiTesto 120">
                <a:extLst>
                  <a:ext uri="{FF2B5EF4-FFF2-40B4-BE49-F238E27FC236}">
                    <a16:creationId xmlns:a16="http://schemas.microsoft.com/office/drawing/2014/main" id="{D37A94E3-D8BC-4FC9-A002-80F20F486975}"/>
                  </a:ext>
                </a:extLst>
              </p:cNvPr>
              <p:cNvSpPr txBox="1"/>
              <p:nvPr/>
            </p:nvSpPr>
            <p:spPr>
              <a:xfrm rot="16200000">
                <a:off x="995689" y="690717"/>
                <a:ext cx="68800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SKBR3</a:t>
                </a:r>
              </a:p>
            </p:txBody>
          </p:sp>
        </p:grpSp>
        <p:grpSp>
          <p:nvGrpSpPr>
            <p:cNvPr id="122" name="Gruppo 121">
              <a:extLst>
                <a:ext uri="{FF2B5EF4-FFF2-40B4-BE49-F238E27FC236}">
                  <a16:creationId xmlns:a16="http://schemas.microsoft.com/office/drawing/2014/main" id="{AF475F74-B704-4E4A-8EED-7173B2A9E68B}"/>
                </a:ext>
              </a:extLst>
            </p:cNvPr>
            <p:cNvGrpSpPr/>
            <p:nvPr/>
          </p:nvGrpSpPr>
          <p:grpSpPr>
            <a:xfrm>
              <a:off x="2603597" y="502845"/>
              <a:ext cx="300452" cy="652743"/>
              <a:chOff x="1185919" y="502845"/>
              <a:chExt cx="300452" cy="652743"/>
            </a:xfrm>
          </p:grpSpPr>
          <p:cxnSp>
            <p:nvCxnSpPr>
              <p:cNvPr id="123" name="Connettore diritto 122">
                <a:extLst>
                  <a:ext uri="{FF2B5EF4-FFF2-40B4-BE49-F238E27FC236}">
                    <a16:creationId xmlns:a16="http://schemas.microsoft.com/office/drawing/2014/main" id="{14179007-3C03-43E0-812E-596DEF1EB5F9}"/>
                  </a:ext>
                </a:extLst>
              </p:cNvPr>
              <p:cNvCxnSpPr/>
              <p:nvPr/>
            </p:nvCxnSpPr>
            <p:spPr>
              <a:xfrm>
                <a:off x="1185919" y="1111755"/>
                <a:ext cx="30045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4" name="CasellaDiTesto 123">
                <a:extLst>
                  <a:ext uri="{FF2B5EF4-FFF2-40B4-BE49-F238E27FC236}">
                    <a16:creationId xmlns:a16="http://schemas.microsoft.com/office/drawing/2014/main" id="{DAFB023E-B371-42CF-94FF-6FCD022C2515}"/>
                  </a:ext>
                </a:extLst>
              </p:cNvPr>
              <p:cNvSpPr txBox="1"/>
              <p:nvPr/>
            </p:nvSpPr>
            <p:spPr>
              <a:xfrm rot="16200000">
                <a:off x="1013321" y="690717"/>
                <a:ext cx="6527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AU565</a:t>
                </a:r>
              </a:p>
            </p:txBody>
          </p:sp>
        </p:grpSp>
      </p:grpSp>
      <p:sp>
        <p:nvSpPr>
          <p:cNvPr id="125" name="CasellaDiTesto 124">
            <a:extLst>
              <a:ext uri="{FF2B5EF4-FFF2-40B4-BE49-F238E27FC236}">
                <a16:creationId xmlns:a16="http://schemas.microsoft.com/office/drawing/2014/main" id="{75026240-77DD-487D-8EBE-7C96BA96032E}"/>
              </a:ext>
            </a:extLst>
          </p:cNvPr>
          <p:cNvSpPr txBox="1"/>
          <p:nvPr/>
        </p:nvSpPr>
        <p:spPr>
          <a:xfrm>
            <a:off x="288029" y="387849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a)</a:t>
            </a:r>
          </a:p>
        </p:txBody>
      </p:sp>
      <p:grpSp>
        <p:nvGrpSpPr>
          <p:cNvPr id="167" name="Gruppo 166">
            <a:extLst>
              <a:ext uri="{FF2B5EF4-FFF2-40B4-BE49-F238E27FC236}">
                <a16:creationId xmlns:a16="http://schemas.microsoft.com/office/drawing/2014/main" id="{5B70D7B7-B254-460E-A755-3476FAC47228}"/>
              </a:ext>
            </a:extLst>
          </p:cNvPr>
          <p:cNvGrpSpPr/>
          <p:nvPr/>
        </p:nvGrpSpPr>
        <p:grpSpPr>
          <a:xfrm>
            <a:off x="3720383" y="390727"/>
            <a:ext cx="2011346" cy="2197975"/>
            <a:chOff x="3720383" y="390727"/>
            <a:chExt cx="2011346" cy="2197975"/>
          </a:xfrm>
        </p:grpSpPr>
        <p:pic>
          <p:nvPicPr>
            <p:cNvPr id="166" name="Immagine 165">
              <a:extLst>
                <a:ext uri="{FF2B5EF4-FFF2-40B4-BE49-F238E27FC236}">
                  <a16:creationId xmlns:a16="http://schemas.microsoft.com/office/drawing/2014/main" id="{06854DB8-1A58-491B-9830-304B666A697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352504" y="977406"/>
              <a:ext cx="1355410" cy="1260000"/>
            </a:xfrm>
            <a:prstGeom prst="rect">
              <a:avLst/>
            </a:prstGeom>
          </p:spPr>
        </p:pic>
        <p:sp>
          <p:nvSpPr>
            <p:cNvPr id="129" name="CasellaDiTesto 128">
              <a:extLst>
                <a:ext uri="{FF2B5EF4-FFF2-40B4-BE49-F238E27FC236}">
                  <a16:creationId xmlns:a16="http://schemas.microsoft.com/office/drawing/2014/main" id="{372F731D-C30C-4867-BF48-768670537171}"/>
                </a:ext>
              </a:extLst>
            </p:cNvPr>
            <p:cNvSpPr txBox="1"/>
            <p:nvPr/>
          </p:nvSpPr>
          <p:spPr>
            <a:xfrm rot="16200000">
              <a:off x="3464544" y="1356600"/>
              <a:ext cx="97334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/>
                <a:t>ER</a:t>
              </a:r>
              <a:r>
                <a:rPr lang="el-G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r>
                <a:rPr lang="it-IT" sz="1200" dirty="0"/>
                <a:t> </a:t>
              </a:r>
              <a:r>
                <a:rPr lang="it-IT" sz="1200" dirty="0" err="1"/>
                <a:t>Levels</a:t>
              </a:r>
              <a:endParaRPr lang="it-IT" sz="1200" dirty="0"/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-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130" name="CasellaDiTesto 129">
              <a:extLst>
                <a:ext uri="{FF2B5EF4-FFF2-40B4-BE49-F238E27FC236}">
                  <a16:creationId xmlns:a16="http://schemas.microsoft.com/office/drawing/2014/main" id="{528C6B97-75CE-446C-AFDE-285C70B635AE}"/>
                </a:ext>
              </a:extLst>
            </p:cNvPr>
            <p:cNvSpPr txBox="1"/>
            <p:nvPr/>
          </p:nvSpPr>
          <p:spPr>
            <a:xfrm>
              <a:off x="4049679" y="859663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2</a:t>
              </a:r>
            </a:p>
          </p:txBody>
        </p:sp>
        <p:sp>
          <p:nvSpPr>
            <p:cNvPr id="131" name="CasellaDiTesto 130">
              <a:extLst>
                <a:ext uri="{FF2B5EF4-FFF2-40B4-BE49-F238E27FC236}">
                  <a16:creationId xmlns:a16="http://schemas.microsoft.com/office/drawing/2014/main" id="{FE0FFF49-5799-4B0B-A7B4-2EE605787035}"/>
                </a:ext>
              </a:extLst>
            </p:cNvPr>
            <p:cNvSpPr txBox="1"/>
            <p:nvPr/>
          </p:nvSpPr>
          <p:spPr>
            <a:xfrm>
              <a:off x="4049679" y="1450982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6</a:t>
              </a:r>
            </a:p>
          </p:txBody>
        </p:sp>
        <p:sp>
          <p:nvSpPr>
            <p:cNvPr id="132" name="CasellaDiTesto 131">
              <a:extLst>
                <a:ext uri="{FF2B5EF4-FFF2-40B4-BE49-F238E27FC236}">
                  <a16:creationId xmlns:a16="http://schemas.microsoft.com/office/drawing/2014/main" id="{25130578-6CEF-42C2-BD13-41B0057AA849}"/>
                </a:ext>
              </a:extLst>
            </p:cNvPr>
            <p:cNvSpPr txBox="1"/>
            <p:nvPr/>
          </p:nvSpPr>
          <p:spPr>
            <a:xfrm>
              <a:off x="4049679" y="2052252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133" name="CasellaDiTesto 132">
              <a:extLst>
                <a:ext uri="{FF2B5EF4-FFF2-40B4-BE49-F238E27FC236}">
                  <a16:creationId xmlns:a16="http://schemas.microsoft.com/office/drawing/2014/main" id="{07F23D5A-A540-4892-9266-EF7E9757376D}"/>
                </a:ext>
              </a:extLst>
            </p:cNvPr>
            <p:cNvSpPr txBox="1"/>
            <p:nvPr/>
          </p:nvSpPr>
          <p:spPr>
            <a:xfrm>
              <a:off x="4559858" y="2159668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+</a:t>
              </a:r>
            </a:p>
          </p:txBody>
        </p:sp>
        <p:sp>
          <p:nvSpPr>
            <p:cNvPr id="134" name="CasellaDiTesto 133">
              <a:extLst>
                <a:ext uri="{FF2B5EF4-FFF2-40B4-BE49-F238E27FC236}">
                  <a16:creationId xmlns:a16="http://schemas.microsoft.com/office/drawing/2014/main" id="{5C822147-12C7-4C9E-AF59-B7CA9EADA58B}"/>
                </a:ext>
              </a:extLst>
            </p:cNvPr>
            <p:cNvSpPr txBox="1"/>
            <p:nvPr/>
          </p:nvSpPr>
          <p:spPr>
            <a:xfrm>
              <a:off x="4410440" y="2159668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-</a:t>
              </a:r>
            </a:p>
          </p:txBody>
        </p:sp>
        <p:grpSp>
          <p:nvGrpSpPr>
            <p:cNvPr id="135" name="Gruppo 134">
              <a:extLst>
                <a:ext uri="{FF2B5EF4-FFF2-40B4-BE49-F238E27FC236}">
                  <a16:creationId xmlns:a16="http://schemas.microsoft.com/office/drawing/2014/main" id="{368D347A-363A-4A32-ADCD-BFC7CE14E15F}"/>
                </a:ext>
              </a:extLst>
            </p:cNvPr>
            <p:cNvGrpSpPr/>
            <p:nvPr/>
          </p:nvGrpSpPr>
          <p:grpSpPr>
            <a:xfrm>
              <a:off x="4402244" y="2311703"/>
              <a:ext cx="380810" cy="276999"/>
              <a:chOff x="1115218" y="2318898"/>
              <a:chExt cx="380810" cy="276999"/>
            </a:xfrm>
          </p:grpSpPr>
          <p:cxnSp>
            <p:nvCxnSpPr>
              <p:cNvPr id="163" name="Connettore diritto 162">
                <a:extLst>
                  <a:ext uri="{FF2B5EF4-FFF2-40B4-BE49-F238E27FC236}">
                    <a16:creationId xmlns:a16="http://schemas.microsoft.com/office/drawing/2014/main" id="{341099FA-F727-4C47-AEFC-C9EE4884243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72971" y="2368893"/>
                <a:ext cx="288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4" name="CasellaDiTesto 163">
                <a:extLst>
                  <a:ext uri="{FF2B5EF4-FFF2-40B4-BE49-F238E27FC236}">
                    <a16:creationId xmlns:a16="http://schemas.microsoft.com/office/drawing/2014/main" id="{CC37ECE2-A925-4389-BB88-38EDF05D9F54}"/>
                  </a:ext>
                </a:extLst>
              </p:cNvPr>
              <p:cNvSpPr txBox="1"/>
              <p:nvPr/>
            </p:nvSpPr>
            <p:spPr>
              <a:xfrm>
                <a:off x="1115218" y="2318898"/>
                <a:ext cx="3808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Tel</a:t>
                </a:r>
              </a:p>
            </p:txBody>
          </p:sp>
        </p:grpSp>
        <p:sp>
          <p:nvSpPr>
            <p:cNvPr id="136" name="CasellaDiTesto 135">
              <a:extLst>
                <a:ext uri="{FF2B5EF4-FFF2-40B4-BE49-F238E27FC236}">
                  <a16:creationId xmlns:a16="http://schemas.microsoft.com/office/drawing/2014/main" id="{52D31821-CDBF-4107-B709-0BDA29FBF460}"/>
                </a:ext>
              </a:extLst>
            </p:cNvPr>
            <p:cNvSpPr txBox="1"/>
            <p:nvPr/>
          </p:nvSpPr>
          <p:spPr>
            <a:xfrm>
              <a:off x="5002762" y="2159668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+</a:t>
              </a:r>
            </a:p>
          </p:txBody>
        </p:sp>
        <p:sp>
          <p:nvSpPr>
            <p:cNvPr id="137" name="CasellaDiTesto 136">
              <a:extLst>
                <a:ext uri="{FF2B5EF4-FFF2-40B4-BE49-F238E27FC236}">
                  <a16:creationId xmlns:a16="http://schemas.microsoft.com/office/drawing/2014/main" id="{8B588263-3F63-4163-A3A5-D1F320734D27}"/>
                </a:ext>
              </a:extLst>
            </p:cNvPr>
            <p:cNvSpPr txBox="1"/>
            <p:nvPr/>
          </p:nvSpPr>
          <p:spPr>
            <a:xfrm>
              <a:off x="4853344" y="2159668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-</a:t>
              </a:r>
            </a:p>
          </p:txBody>
        </p:sp>
        <p:sp>
          <p:nvSpPr>
            <p:cNvPr id="138" name="CasellaDiTesto 137">
              <a:extLst>
                <a:ext uri="{FF2B5EF4-FFF2-40B4-BE49-F238E27FC236}">
                  <a16:creationId xmlns:a16="http://schemas.microsoft.com/office/drawing/2014/main" id="{E0D10F7E-82B8-4601-A727-2804792ED8A5}"/>
                </a:ext>
              </a:extLst>
            </p:cNvPr>
            <p:cNvSpPr txBox="1"/>
            <p:nvPr/>
          </p:nvSpPr>
          <p:spPr>
            <a:xfrm>
              <a:off x="5457295" y="2159668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+</a:t>
              </a:r>
            </a:p>
          </p:txBody>
        </p:sp>
        <p:sp>
          <p:nvSpPr>
            <p:cNvPr id="139" name="CasellaDiTesto 138">
              <a:extLst>
                <a:ext uri="{FF2B5EF4-FFF2-40B4-BE49-F238E27FC236}">
                  <a16:creationId xmlns:a16="http://schemas.microsoft.com/office/drawing/2014/main" id="{53A02144-BB88-4F01-B2D6-DF8DA839CB91}"/>
                </a:ext>
              </a:extLst>
            </p:cNvPr>
            <p:cNvSpPr txBox="1"/>
            <p:nvPr/>
          </p:nvSpPr>
          <p:spPr>
            <a:xfrm>
              <a:off x="5307877" y="2159668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-</a:t>
              </a:r>
            </a:p>
          </p:txBody>
        </p:sp>
        <p:grpSp>
          <p:nvGrpSpPr>
            <p:cNvPr id="142" name="Gruppo 141">
              <a:extLst>
                <a:ext uri="{FF2B5EF4-FFF2-40B4-BE49-F238E27FC236}">
                  <a16:creationId xmlns:a16="http://schemas.microsoft.com/office/drawing/2014/main" id="{55CE88A2-8BC1-4881-BF21-C70EBA78EB56}"/>
                </a:ext>
              </a:extLst>
            </p:cNvPr>
            <p:cNvGrpSpPr/>
            <p:nvPr/>
          </p:nvGrpSpPr>
          <p:grpSpPr>
            <a:xfrm>
              <a:off x="4876004" y="2311703"/>
              <a:ext cx="380810" cy="276999"/>
              <a:chOff x="1115218" y="2318898"/>
              <a:chExt cx="380810" cy="276999"/>
            </a:xfrm>
          </p:grpSpPr>
          <p:cxnSp>
            <p:nvCxnSpPr>
              <p:cNvPr id="161" name="Connettore diritto 160">
                <a:extLst>
                  <a:ext uri="{FF2B5EF4-FFF2-40B4-BE49-F238E27FC236}">
                    <a16:creationId xmlns:a16="http://schemas.microsoft.com/office/drawing/2014/main" id="{D8EF2CF1-7359-4B48-8161-89A5439C21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72971" y="2368893"/>
                <a:ext cx="288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2" name="CasellaDiTesto 161">
                <a:extLst>
                  <a:ext uri="{FF2B5EF4-FFF2-40B4-BE49-F238E27FC236}">
                    <a16:creationId xmlns:a16="http://schemas.microsoft.com/office/drawing/2014/main" id="{521026B0-50F0-4E8A-9ABB-67FAC178F6CE}"/>
                  </a:ext>
                </a:extLst>
              </p:cNvPr>
              <p:cNvSpPr txBox="1"/>
              <p:nvPr/>
            </p:nvSpPr>
            <p:spPr>
              <a:xfrm>
                <a:off x="1115218" y="2318898"/>
                <a:ext cx="3808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Tel</a:t>
                </a:r>
              </a:p>
            </p:txBody>
          </p:sp>
        </p:grpSp>
        <p:grpSp>
          <p:nvGrpSpPr>
            <p:cNvPr id="143" name="Gruppo 142">
              <a:extLst>
                <a:ext uri="{FF2B5EF4-FFF2-40B4-BE49-F238E27FC236}">
                  <a16:creationId xmlns:a16="http://schemas.microsoft.com/office/drawing/2014/main" id="{EF928566-E06E-4266-BC3D-2958FE4FE7E4}"/>
                </a:ext>
              </a:extLst>
            </p:cNvPr>
            <p:cNvGrpSpPr/>
            <p:nvPr/>
          </p:nvGrpSpPr>
          <p:grpSpPr>
            <a:xfrm>
              <a:off x="5327104" y="2311703"/>
              <a:ext cx="380810" cy="276999"/>
              <a:chOff x="1115218" y="2318898"/>
              <a:chExt cx="380810" cy="276999"/>
            </a:xfrm>
          </p:grpSpPr>
          <p:cxnSp>
            <p:nvCxnSpPr>
              <p:cNvPr id="159" name="Connettore diritto 158">
                <a:extLst>
                  <a:ext uri="{FF2B5EF4-FFF2-40B4-BE49-F238E27FC236}">
                    <a16:creationId xmlns:a16="http://schemas.microsoft.com/office/drawing/2014/main" id="{58952811-F575-4185-AC33-2CD5F3D2025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72971" y="2368893"/>
                <a:ext cx="288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0" name="CasellaDiTesto 159">
                <a:extLst>
                  <a:ext uri="{FF2B5EF4-FFF2-40B4-BE49-F238E27FC236}">
                    <a16:creationId xmlns:a16="http://schemas.microsoft.com/office/drawing/2014/main" id="{498B128F-1298-4EE7-857E-BDCC450F25FB}"/>
                  </a:ext>
                </a:extLst>
              </p:cNvPr>
              <p:cNvSpPr txBox="1"/>
              <p:nvPr/>
            </p:nvSpPr>
            <p:spPr>
              <a:xfrm>
                <a:off x="1115218" y="2318898"/>
                <a:ext cx="3808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Tel</a:t>
                </a:r>
              </a:p>
            </p:txBody>
          </p:sp>
        </p:grpSp>
        <p:grpSp>
          <p:nvGrpSpPr>
            <p:cNvPr id="145" name="Gruppo 144">
              <a:extLst>
                <a:ext uri="{FF2B5EF4-FFF2-40B4-BE49-F238E27FC236}">
                  <a16:creationId xmlns:a16="http://schemas.microsoft.com/office/drawing/2014/main" id="{8AF8057F-ABD3-4D51-8ADE-A57B1839418F}"/>
                </a:ext>
              </a:extLst>
            </p:cNvPr>
            <p:cNvGrpSpPr/>
            <p:nvPr/>
          </p:nvGrpSpPr>
          <p:grpSpPr>
            <a:xfrm>
              <a:off x="4472945" y="412368"/>
              <a:ext cx="300452" cy="654346"/>
              <a:chOff x="1185919" y="502044"/>
              <a:chExt cx="300452" cy="654346"/>
            </a:xfrm>
          </p:grpSpPr>
          <p:cxnSp>
            <p:nvCxnSpPr>
              <p:cNvPr id="155" name="Connettore diritto 154">
                <a:extLst>
                  <a:ext uri="{FF2B5EF4-FFF2-40B4-BE49-F238E27FC236}">
                    <a16:creationId xmlns:a16="http://schemas.microsoft.com/office/drawing/2014/main" id="{C7748CFA-134A-445C-A394-74968904E0D8}"/>
                  </a:ext>
                </a:extLst>
              </p:cNvPr>
              <p:cNvCxnSpPr/>
              <p:nvPr/>
            </p:nvCxnSpPr>
            <p:spPr>
              <a:xfrm>
                <a:off x="1185919" y="1111755"/>
                <a:ext cx="30045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6" name="CasellaDiTesto 155">
                <a:extLst>
                  <a:ext uri="{FF2B5EF4-FFF2-40B4-BE49-F238E27FC236}">
                    <a16:creationId xmlns:a16="http://schemas.microsoft.com/office/drawing/2014/main" id="{225DB805-1CB0-4863-94C1-4888F7FF2D47}"/>
                  </a:ext>
                </a:extLst>
              </p:cNvPr>
              <p:cNvSpPr txBox="1"/>
              <p:nvPr/>
            </p:nvSpPr>
            <p:spPr>
              <a:xfrm rot="16200000">
                <a:off x="1012519" y="690717"/>
                <a:ext cx="65434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MCF-7</a:t>
                </a:r>
              </a:p>
            </p:txBody>
          </p:sp>
        </p:grpSp>
        <p:grpSp>
          <p:nvGrpSpPr>
            <p:cNvPr id="146" name="Gruppo 145">
              <a:extLst>
                <a:ext uri="{FF2B5EF4-FFF2-40B4-BE49-F238E27FC236}">
                  <a16:creationId xmlns:a16="http://schemas.microsoft.com/office/drawing/2014/main" id="{9F1BD8F2-52E0-4274-9090-127D61D9AC81}"/>
                </a:ext>
              </a:extLst>
            </p:cNvPr>
            <p:cNvGrpSpPr/>
            <p:nvPr/>
          </p:nvGrpSpPr>
          <p:grpSpPr>
            <a:xfrm>
              <a:off x="4955429" y="399768"/>
              <a:ext cx="300452" cy="679545"/>
              <a:chOff x="1185919" y="489444"/>
              <a:chExt cx="300452" cy="679545"/>
            </a:xfrm>
          </p:grpSpPr>
          <p:cxnSp>
            <p:nvCxnSpPr>
              <p:cNvPr id="153" name="Connettore diritto 152">
                <a:extLst>
                  <a:ext uri="{FF2B5EF4-FFF2-40B4-BE49-F238E27FC236}">
                    <a16:creationId xmlns:a16="http://schemas.microsoft.com/office/drawing/2014/main" id="{712E7AEF-0753-4C37-A8F6-73A02674EF05}"/>
                  </a:ext>
                </a:extLst>
              </p:cNvPr>
              <p:cNvCxnSpPr/>
              <p:nvPr/>
            </p:nvCxnSpPr>
            <p:spPr>
              <a:xfrm>
                <a:off x="1185919" y="1111755"/>
                <a:ext cx="30045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4" name="CasellaDiTesto 153">
                <a:extLst>
                  <a:ext uri="{FF2B5EF4-FFF2-40B4-BE49-F238E27FC236}">
                    <a16:creationId xmlns:a16="http://schemas.microsoft.com/office/drawing/2014/main" id="{F3E8D19B-ACD0-4487-BB33-FA0205741030}"/>
                  </a:ext>
                </a:extLst>
              </p:cNvPr>
              <p:cNvSpPr txBox="1"/>
              <p:nvPr/>
            </p:nvSpPr>
            <p:spPr>
              <a:xfrm rot="16200000">
                <a:off x="999921" y="690717"/>
                <a:ext cx="67954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BT-474</a:t>
                </a:r>
              </a:p>
            </p:txBody>
          </p:sp>
        </p:grpSp>
        <p:grpSp>
          <p:nvGrpSpPr>
            <p:cNvPr id="147" name="Gruppo 146">
              <a:extLst>
                <a:ext uri="{FF2B5EF4-FFF2-40B4-BE49-F238E27FC236}">
                  <a16:creationId xmlns:a16="http://schemas.microsoft.com/office/drawing/2014/main" id="{DEF1396D-432C-4F10-8628-C091C522E940}"/>
                </a:ext>
              </a:extLst>
            </p:cNvPr>
            <p:cNvGrpSpPr/>
            <p:nvPr/>
          </p:nvGrpSpPr>
          <p:grpSpPr>
            <a:xfrm>
              <a:off x="5367283" y="390727"/>
              <a:ext cx="300452" cy="697627"/>
              <a:chOff x="1185919" y="480403"/>
              <a:chExt cx="300452" cy="697627"/>
            </a:xfrm>
          </p:grpSpPr>
          <p:cxnSp>
            <p:nvCxnSpPr>
              <p:cNvPr id="151" name="Connettore diritto 150">
                <a:extLst>
                  <a:ext uri="{FF2B5EF4-FFF2-40B4-BE49-F238E27FC236}">
                    <a16:creationId xmlns:a16="http://schemas.microsoft.com/office/drawing/2014/main" id="{95F54199-C894-452F-BF4C-1AFA6FB2498D}"/>
                  </a:ext>
                </a:extLst>
              </p:cNvPr>
              <p:cNvCxnSpPr/>
              <p:nvPr/>
            </p:nvCxnSpPr>
            <p:spPr>
              <a:xfrm>
                <a:off x="1185919" y="1111755"/>
                <a:ext cx="30045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2" name="CasellaDiTesto 151">
                <a:extLst>
                  <a:ext uri="{FF2B5EF4-FFF2-40B4-BE49-F238E27FC236}">
                    <a16:creationId xmlns:a16="http://schemas.microsoft.com/office/drawing/2014/main" id="{B0FFB154-DFC4-4846-AD64-0C0FCA479DF6}"/>
                  </a:ext>
                </a:extLst>
              </p:cNvPr>
              <p:cNvSpPr txBox="1"/>
              <p:nvPr/>
            </p:nvSpPr>
            <p:spPr>
              <a:xfrm rot="16200000">
                <a:off x="990880" y="690717"/>
                <a:ext cx="69762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SKOV3</a:t>
                </a:r>
              </a:p>
            </p:txBody>
          </p:sp>
        </p:grpSp>
      </p:grpSp>
      <p:sp>
        <p:nvSpPr>
          <p:cNvPr id="165" name="CasellaDiTesto 164">
            <a:extLst>
              <a:ext uri="{FF2B5EF4-FFF2-40B4-BE49-F238E27FC236}">
                <a16:creationId xmlns:a16="http://schemas.microsoft.com/office/drawing/2014/main" id="{53C426DE-3C9C-4095-9F22-4A3538D7EA35}"/>
              </a:ext>
            </a:extLst>
          </p:cNvPr>
          <p:cNvSpPr txBox="1"/>
          <p:nvPr/>
        </p:nvSpPr>
        <p:spPr>
          <a:xfrm>
            <a:off x="3549088" y="387849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b)</a:t>
            </a:r>
          </a:p>
        </p:txBody>
      </p:sp>
      <p:sp>
        <p:nvSpPr>
          <p:cNvPr id="169" name="CasellaDiTesto 168">
            <a:extLst>
              <a:ext uri="{FF2B5EF4-FFF2-40B4-BE49-F238E27FC236}">
                <a16:creationId xmlns:a16="http://schemas.microsoft.com/office/drawing/2014/main" id="{50FCF0BC-06A0-44FA-AD13-4E285A672083}"/>
              </a:ext>
            </a:extLst>
          </p:cNvPr>
          <p:cNvSpPr txBox="1"/>
          <p:nvPr/>
        </p:nvSpPr>
        <p:spPr>
          <a:xfrm>
            <a:off x="1484784" y="2699792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c)</a:t>
            </a:r>
          </a:p>
        </p:txBody>
      </p:sp>
      <p:grpSp>
        <p:nvGrpSpPr>
          <p:cNvPr id="271" name="Gruppo 270">
            <a:extLst>
              <a:ext uri="{FF2B5EF4-FFF2-40B4-BE49-F238E27FC236}">
                <a16:creationId xmlns:a16="http://schemas.microsoft.com/office/drawing/2014/main" id="{30715158-9BBA-4454-A5EE-144388B7ED34}"/>
              </a:ext>
            </a:extLst>
          </p:cNvPr>
          <p:cNvGrpSpPr/>
          <p:nvPr/>
        </p:nvGrpSpPr>
        <p:grpSpPr>
          <a:xfrm>
            <a:off x="1758792" y="2972124"/>
            <a:ext cx="3104099" cy="1603566"/>
            <a:chOff x="604653" y="3276512"/>
            <a:chExt cx="3104099" cy="1603566"/>
          </a:xfrm>
        </p:grpSpPr>
        <p:pic>
          <p:nvPicPr>
            <p:cNvPr id="203" name="Immagine 202">
              <a:extLst>
                <a:ext uri="{FF2B5EF4-FFF2-40B4-BE49-F238E27FC236}">
                  <a16:creationId xmlns:a16="http://schemas.microsoft.com/office/drawing/2014/main" id="{41AED2C8-C643-40FB-86DD-9C303D3E80A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234766" y="3452143"/>
              <a:ext cx="1938985" cy="1260000"/>
            </a:xfrm>
            <a:prstGeom prst="rect">
              <a:avLst/>
            </a:prstGeom>
          </p:spPr>
        </p:pic>
        <p:grpSp>
          <p:nvGrpSpPr>
            <p:cNvPr id="243" name="Gruppo 242">
              <a:extLst>
                <a:ext uri="{FF2B5EF4-FFF2-40B4-BE49-F238E27FC236}">
                  <a16:creationId xmlns:a16="http://schemas.microsoft.com/office/drawing/2014/main" id="{A519A47A-7556-4C9A-A913-3E43868FFEFF}"/>
                </a:ext>
              </a:extLst>
            </p:cNvPr>
            <p:cNvGrpSpPr/>
            <p:nvPr/>
          </p:nvGrpSpPr>
          <p:grpSpPr>
            <a:xfrm>
              <a:off x="2682729" y="4664634"/>
              <a:ext cx="611924" cy="215444"/>
              <a:chOff x="2682729" y="4654288"/>
              <a:chExt cx="611924" cy="215444"/>
            </a:xfrm>
          </p:grpSpPr>
          <p:sp>
            <p:nvSpPr>
              <p:cNvPr id="186" name="CasellaDiTesto 185">
                <a:extLst>
                  <a:ext uri="{FF2B5EF4-FFF2-40B4-BE49-F238E27FC236}">
                    <a16:creationId xmlns:a16="http://schemas.microsoft.com/office/drawing/2014/main" id="{EFC74B3D-31EA-4A8E-8678-33160D1C9681}"/>
                  </a:ext>
                </a:extLst>
              </p:cNvPr>
              <p:cNvSpPr txBox="1"/>
              <p:nvPr/>
            </p:nvSpPr>
            <p:spPr>
              <a:xfrm>
                <a:off x="2682729" y="4654288"/>
                <a:ext cx="24237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0</a:t>
                </a:r>
              </a:p>
            </p:txBody>
          </p:sp>
          <p:sp>
            <p:nvSpPr>
              <p:cNvPr id="187" name="CasellaDiTesto 186">
                <a:extLst>
                  <a:ext uri="{FF2B5EF4-FFF2-40B4-BE49-F238E27FC236}">
                    <a16:creationId xmlns:a16="http://schemas.microsoft.com/office/drawing/2014/main" id="{E5829677-C302-4BB6-821F-8DFF94277C9B}"/>
                  </a:ext>
                </a:extLst>
              </p:cNvPr>
              <p:cNvSpPr txBox="1"/>
              <p:nvPr/>
            </p:nvSpPr>
            <p:spPr>
              <a:xfrm>
                <a:off x="2753916" y="4654288"/>
                <a:ext cx="300082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10</a:t>
                </a:r>
              </a:p>
            </p:txBody>
          </p:sp>
          <p:sp>
            <p:nvSpPr>
              <p:cNvPr id="188" name="CasellaDiTesto 187">
                <a:extLst>
                  <a:ext uri="{FF2B5EF4-FFF2-40B4-BE49-F238E27FC236}">
                    <a16:creationId xmlns:a16="http://schemas.microsoft.com/office/drawing/2014/main" id="{7C433885-0390-4176-A673-3A771ACDD58A}"/>
                  </a:ext>
                </a:extLst>
              </p:cNvPr>
              <p:cNvSpPr txBox="1"/>
              <p:nvPr/>
            </p:nvSpPr>
            <p:spPr>
              <a:xfrm>
                <a:off x="2874365" y="4654288"/>
                <a:ext cx="300082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20</a:t>
                </a:r>
              </a:p>
            </p:txBody>
          </p:sp>
          <p:sp>
            <p:nvSpPr>
              <p:cNvPr id="189" name="CasellaDiTesto 188">
                <a:extLst>
                  <a:ext uri="{FF2B5EF4-FFF2-40B4-BE49-F238E27FC236}">
                    <a16:creationId xmlns:a16="http://schemas.microsoft.com/office/drawing/2014/main" id="{E7E56788-B808-4B62-848A-774F7450994F}"/>
                  </a:ext>
                </a:extLst>
              </p:cNvPr>
              <p:cNvSpPr txBox="1"/>
              <p:nvPr/>
            </p:nvSpPr>
            <p:spPr>
              <a:xfrm>
                <a:off x="2994571" y="4654288"/>
                <a:ext cx="300082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40</a:t>
                </a:r>
              </a:p>
            </p:txBody>
          </p:sp>
        </p:grpSp>
        <p:sp>
          <p:nvSpPr>
            <p:cNvPr id="190" name="CasellaDiTesto 189">
              <a:extLst>
                <a:ext uri="{FF2B5EF4-FFF2-40B4-BE49-F238E27FC236}">
                  <a16:creationId xmlns:a16="http://schemas.microsoft.com/office/drawing/2014/main" id="{CE049292-B954-48F9-B5DF-EDDEC5429B47}"/>
                </a:ext>
              </a:extLst>
            </p:cNvPr>
            <p:cNvSpPr txBox="1"/>
            <p:nvPr/>
          </p:nvSpPr>
          <p:spPr>
            <a:xfrm>
              <a:off x="3140968" y="4664634"/>
              <a:ext cx="56778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+mn-lt"/>
                </a:rPr>
                <a:t>Tel (µM)</a:t>
              </a:r>
            </a:p>
          </p:txBody>
        </p:sp>
        <p:sp>
          <p:nvSpPr>
            <p:cNvPr id="206" name="CasellaDiTesto 205">
              <a:extLst>
                <a:ext uri="{FF2B5EF4-FFF2-40B4-BE49-F238E27FC236}">
                  <a16:creationId xmlns:a16="http://schemas.microsoft.com/office/drawing/2014/main" id="{A7F53DD9-966C-4CAB-AFB8-EC584EBC7006}"/>
                </a:ext>
              </a:extLst>
            </p:cNvPr>
            <p:cNvSpPr txBox="1"/>
            <p:nvPr/>
          </p:nvSpPr>
          <p:spPr>
            <a:xfrm rot="16200000">
              <a:off x="257442" y="3824121"/>
              <a:ext cx="115608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 err="1"/>
                <a:t>Protein</a:t>
              </a:r>
              <a:r>
                <a:rPr lang="it-IT" sz="1200" dirty="0"/>
                <a:t> </a:t>
              </a:r>
              <a:r>
                <a:rPr lang="it-IT" sz="1200" dirty="0" err="1"/>
                <a:t>Levels</a:t>
              </a:r>
              <a:endParaRPr lang="it-IT" sz="1200" dirty="0"/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0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207" name="CasellaDiTesto 206">
              <a:extLst>
                <a:ext uri="{FF2B5EF4-FFF2-40B4-BE49-F238E27FC236}">
                  <a16:creationId xmlns:a16="http://schemas.microsoft.com/office/drawing/2014/main" id="{C9DEA52C-891A-4813-BD70-2C80ECF0DD2A}"/>
                </a:ext>
              </a:extLst>
            </p:cNvPr>
            <p:cNvSpPr txBox="1"/>
            <p:nvPr/>
          </p:nvSpPr>
          <p:spPr>
            <a:xfrm>
              <a:off x="933949" y="332083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5</a:t>
              </a:r>
            </a:p>
          </p:txBody>
        </p:sp>
        <p:sp>
          <p:nvSpPr>
            <p:cNvPr id="208" name="CasellaDiTesto 207">
              <a:extLst>
                <a:ext uri="{FF2B5EF4-FFF2-40B4-BE49-F238E27FC236}">
                  <a16:creationId xmlns:a16="http://schemas.microsoft.com/office/drawing/2014/main" id="{6C92B3D1-6766-4EA7-B4CD-B54BFC5B7BB3}"/>
                </a:ext>
              </a:extLst>
            </p:cNvPr>
            <p:cNvSpPr txBox="1"/>
            <p:nvPr/>
          </p:nvSpPr>
          <p:spPr>
            <a:xfrm>
              <a:off x="933949" y="371425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0</a:t>
              </a:r>
            </a:p>
          </p:txBody>
        </p:sp>
        <p:sp>
          <p:nvSpPr>
            <p:cNvPr id="209" name="CasellaDiTesto 208">
              <a:extLst>
                <a:ext uri="{FF2B5EF4-FFF2-40B4-BE49-F238E27FC236}">
                  <a16:creationId xmlns:a16="http://schemas.microsoft.com/office/drawing/2014/main" id="{84ECEE61-768F-42DB-A0E6-83FDE9421A7B}"/>
                </a:ext>
              </a:extLst>
            </p:cNvPr>
            <p:cNvSpPr txBox="1"/>
            <p:nvPr/>
          </p:nvSpPr>
          <p:spPr>
            <a:xfrm>
              <a:off x="933949" y="4519773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grpSp>
          <p:nvGrpSpPr>
            <p:cNvPr id="261" name="Gruppo 260">
              <a:extLst>
                <a:ext uri="{FF2B5EF4-FFF2-40B4-BE49-F238E27FC236}">
                  <a16:creationId xmlns:a16="http://schemas.microsoft.com/office/drawing/2014/main" id="{553C324E-DAFA-4D1E-810C-72E1A8692F9A}"/>
                </a:ext>
              </a:extLst>
            </p:cNvPr>
            <p:cNvGrpSpPr/>
            <p:nvPr/>
          </p:nvGrpSpPr>
          <p:grpSpPr>
            <a:xfrm>
              <a:off x="1249198" y="3276512"/>
              <a:ext cx="569387" cy="276999"/>
              <a:chOff x="1249198" y="3449955"/>
              <a:chExt cx="569387" cy="276999"/>
            </a:xfrm>
          </p:grpSpPr>
          <p:cxnSp>
            <p:nvCxnSpPr>
              <p:cNvPr id="232" name="Connettore diritto 231">
                <a:extLst>
                  <a:ext uri="{FF2B5EF4-FFF2-40B4-BE49-F238E27FC236}">
                    <a16:creationId xmlns:a16="http://schemas.microsoft.com/office/drawing/2014/main" id="{AF14BB26-CF92-47AB-9E04-51C12C4CCA1B}"/>
                  </a:ext>
                </a:extLst>
              </p:cNvPr>
              <p:cNvCxnSpPr/>
              <p:nvPr/>
            </p:nvCxnSpPr>
            <p:spPr>
              <a:xfrm>
                <a:off x="1342551" y="3707904"/>
                <a:ext cx="36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33" name="CasellaDiTesto 232">
                <a:extLst>
                  <a:ext uri="{FF2B5EF4-FFF2-40B4-BE49-F238E27FC236}">
                    <a16:creationId xmlns:a16="http://schemas.microsoft.com/office/drawing/2014/main" id="{D4A00E6D-BDBF-4584-9D5D-25B97CBAB94A}"/>
                  </a:ext>
                </a:extLst>
              </p:cNvPr>
              <p:cNvSpPr txBox="1"/>
              <p:nvPr/>
            </p:nvSpPr>
            <p:spPr>
              <a:xfrm>
                <a:off x="1249198" y="3449955"/>
                <a:ext cx="5693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err="1"/>
                  <a:t>pAKT</a:t>
                </a:r>
                <a:endParaRPr lang="it-IT" sz="1200" dirty="0"/>
              </a:p>
            </p:txBody>
          </p:sp>
        </p:grpSp>
        <p:sp>
          <p:nvSpPr>
            <p:cNvPr id="242" name="CasellaDiTesto 241">
              <a:extLst>
                <a:ext uri="{FF2B5EF4-FFF2-40B4-BE49-F238E27FC236}">
                  <a16:creationId xmlns:a16="http://schemas.microsoft.com/office/drawing/2014/main" id="{0A12603A-3A86-491F-B48D-4FF1351902F6}"/>
                </a:ext>
              </a:extLst>
            </p:cNvPr>
            <p:cNvSpPr txBox="1"/>
            <p:nvPr/>
          </p:nvSpPr>
          <p:spPr>
            <a:xfrm>
              <a:off x="933949" y="411072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5</a:t>
              </a:r>
            </a:p>
          </p:txBody>
        </p:sp>
        <p:grpSp>
          <p:nvGrpSpPr>
            <p:cNvPr id="244" name="Gruppo 243">
              <a:extLst>
                <a:ext uri="{FF2B5EF4-FFF2-40B4-BE49-F238E27FC236}">
                  <a16:creationId xmlns:a16="http://schemas.microsoft.com/office/drawing/2014/main" id="{4BE32831-0C41-4EBD-BC24-A2BA1D96D182}"/>
                </a:ext>
              </a:extLst>
            </p:cNvPr>
            <p:cNvGrpSpPr/>
            <p:nvPr/>
          </p:nvGrpSpPr>
          <p:grpSpPr>
            <a:xfrm>
              <a:off x="2188320" y="4664634"/>
              <a:ext cx="611924" cy="215444"/>
              <a:chOff x="2682729" y="4654288"/>
              <a:chExt cx="611924" cy="215444"/>
            </a:xfrm>
          </p:grpSpPr>
          <p:sp>
            <p:nvSpPr>
              <p:cNvPr id="245" name="CasellaDiTesto 244">
                <a:extLst>
                  <a:ext uri="{FF2B5EF4-FFF2-40B4-BE49-F238E27FC236}">
                    <a16:creationId xmlns:a16="http://schemas.microsoft.com/office/drawing/2014/main" id="{4D33DACC-F0EB-4E42-BA19-9C12A5C6EE96}"/>
                  </a:ext>
                </a:extLst>
              </p:cNvPr>
              <p:cNvSpPr txBox="1"/>
              <p:nvPr/>
            </p:nvSpPr>
            <p:spPr>
              <a:xfrm>
                <a:off x="2682729" y="4654288"/>
                <a:ext cx="24237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0</a:t>
                </a:r>
              </a:p>
            </p:txBody>
          </p:sp>
          <p:sp>
            <p:nvSpPr>
              <p:cNvPr id="246" name="CasellaDiTesto 245">
                <a:extLst>
                  <a:ext uri="{FF2B5EF4-FFF2-40B4-BE49-F238E27FC236}">
                    <a16:creationId xmlns:a16="http://schemas.microsoft.com/office/drawing/2014/main" id="{4040B9DE-23BC-45EB-92E8-BF4167B2E7FF}"/>
                  </a:ext>
                </a:extLst>
              </p:cNvPr>
              <p:cNvSpPr txBox="1"/>
              <p:nvPr/>
            </p:nvSpPr>
            <p:spPr>
              <a:xfrm>
                <a:off x="2753916" y="4654288"/>
                <a:ext cx="300082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10</a:t>
                </a:r>
              </a:p>
            </p:txBody>
          </p:sp>
          <p:sp>
            <p:nvSpPr>
              <p:cNvPr id="247" name="CasellaDiTesto 246">
                <a:extLst>
                  <a:ext uri="{FF2B5EF4-FFF2-40B4-BE49-F238E27FC236}">
                    <a16:creationId xmlns:a16="http://schemas.microsoft.com/office/drawing/2014/main" id="{D935481E-ABFB-4C50-A9F1-E0D8235D7C8F}"/>
                  </a:ext>
                </a:extLst>
              </p:cNvPr>
              <p:cNvSpPr txBox="1"/>
              <p:nvPr/>
            </p:nvSpPr>
            <p:spPr>
              <a:xfrm>
                <a:off x="2874365" y="4654288"/>
                <a:ext cx="300082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20</a:t>
                </a:r>
              </a:p>
            </p:txBody>
          </p:sp>
          <p:sp>
            <p:nvSpPr>
              <p:cNvPr id="248" name="CasellaDiTesto 247">
                <a:extLst>
                  <a:ext uri="{FF2B5EF4-FFF2-40B4-BE49-F238E27FC236}">
                    <a16:creationId xmlns:a16="http://schemas.microsoft.com/office/drawing/2014/main" id="{57CCDC4B-0B56-4193-AAA2-8142FD7973D6}"/>
                  </a:ext>
                </a:extLst>
              </p:cNvPr>
              <p:cNvSpPr txBox="1"/>
              <p:nvPr/>
            </p:nvSpPr>
            <p:spPr>
              <a:xfrm>
                <a:off x="2994571" y="4654288"/>
                <a:ext cx="300082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40</a:t>
                </a:r>
              </a:p>
            </p:txBody>
          </p:sp>
        </p:grpSp>
        <p:grpSp>
          <p:nvGrpSpPr>
            <p:cNvPr id="249" name="Gruppo 248">
              <a:extLst>
                <a:ext uri="{FF2B5EF4-FFF2-40B4-BE49-F238E27FC236}">
                  <a16:creationId xmlns:a16="http://schemas.microsoft.com/office/drawing/2014/main" id="{9E0F502F-366D-4B90-AD92-8D5B091A828C}"/>
                </a:ext>
              </a:extLst>
            </p:cNvPr>
            <p:cNvGrpSpPr/>
            <p:nvPr/>
          </p:nvGrpSpPr>
          <p:grpSpPr>
            <a:xfrm>
              <a:off x="1693911" y="4664634"/>
              <a:ext cx="611924" cy="215444"/>
              <a:chOff x="2682729" y="4654288"/>
              <a:chExt cx="611924" cy="215444"/>
            </a:xfrm>
          </p:grpSpPr>
          <p:sp>
            <p:nvSpPr>
              <p:cNvPr id="250" name="CasellaDiTesto 249">
                <a:extLst>
                  <a:ext uri="{FF2B5EF4-FFF2-40B4-BE49-F238E27FC236}">
                    <a16:creationId xmlns:a16="http://schemas.microsoft.com/office/drawing/2014/main" id="{321C0E35-3C1C-457A-8608-62B37C78522C}"/>
                  </a:ext>
                </a:extLst>
              </p:cNvPr>
              <p:cNvSpPr txBox="1"/>
              <p:nvPr/>
            </p:nvSpPr>
            <p:spPr>
              <a:xfrm>
                <a:off x="2682729" y="4654288"/>
                <a:ext cx="24237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0</a:t>
                </a:r>
              </a:p>
            </p:txBody>
          </p:sp>
          <p:sp>
            <p:nvSpPr>
              <p:cNvPr id="251" name="CasellaDiTesto 250">
                <a:extLst>
                  <a:ext uri="{FF2B5EF4-FFF2-40B4-BE49-F238E27FC236}">
                    <a16:creationId xmlns:a16="http://schemas.microsoft.com/office/drawing/2014/main" id="{B2CC48C4-5B8A-4E7B-8796-008777CC42D2}"/>
                  </a:ext>
                </a:extLst>
              </p:cNvPr>
              <p:cNvSpPr txBox="1"/>
              <p:nvPr/>
            </p:nvSpPr>
            <p:spPr>
              <a:xfrm>
                <a:off x="2753916" y="4654288"/>
                <a:ext cx="300082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10</a:t>
                </a:r>
              </a:p>
            </p:txBody>
          </p:sp>
          <p:sp>
            <p:nvSpPr>
              <p:cNvPr id="252" name="CasellaDiTesto 251">
                <a:extLst>
                  <a:ext uri="{FF2B5EF4-FFF2-40B4-BE49-F238E27FC236}">
                    <a16:creationId xmlns:a16="http://schemas.microsoft.com/office/drawing/2014/main" id="{F30A35ED-2AEE-4DF8-B24E-DF3AC7702537}"/>
                  </a:ext>
                </a:extLst>
              </p:cNvPr>
              <p:cNvSpPr txBox="1"/>
              <p:nvPr/>
            </p:nvSpPr>
            <p:spPr>
              <a:xfrm>
                <a:off x="2874365" y="4654288"/>
                <a:ext cx="300082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20</a:t>
                </a:r>
              </a:p>
            </p:txBody>
          </p:sp>
          <p:sp>
            <p:nvSpPr>
              <p:cNvPr id="253" name="CasellaDiTesto 252">
                <a:extLst>
                  <a:ext uri="{FF2B5EF4-FFF2-40B4-BE49-F238E27FC236}">
                    <a16:creationId xmlns:a16="http://schemas.microsoft.com/office/drawing/2014/main" id="{A8BB8688-B58F-481F-9242-B589F6825BA7}"/>
                  </a:ext>
                </a:extLst>
              </p:cNvPr>
              <p:cNvSpPr txBox="1"/>
              <p:nvPr/>
            </p:nvSpPr>
            <p:spPr>
              <a:xfrm>
                <a:off x="2994571" y="4654288"/>
                <a:ext cx="300082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40</a:t>
                </a:r>
              </a:p>
            </p:txBody>
          </p:sp>
        </p:grpSp>
        <p:grpSp>
          <p:nvGrpSpPr>
            <p:cNvPr id="254" name="Gruppo 253">
              <a:extLst>
                <a:ext uri="{FF2B5EF4-FFF2-40B4-BE49-F238E27FC236}">
                  <a16:creationId xmlns:a16="http://schemas.microsoft.com/office/drawing/2014/main" id="{80220653-9845-4EFB-86E9-8B85A1E519AC}"/>
                </a:ext>
              </a:extLst>
            </p:cNvPr>
            <p:cNvGrpSpPr/>
            <p:nvPr/>
          </p:nvGrpSpPr>
          <p:grpSpPr>
            <a:xfrm>
              <a:off x="1210308" y="4664634"/>
              <a:ext cx="611924" cy="215444"/>
              <a:chOff x="2682729" y="4654288"/>
              <a:chExt cx="611924" cy="215444"/>
            </a:xfrm>
          </p:grpSpPr>
          <p:sp>
            <p:nvSpPr>
              <p:cNvPr id="255" name="CasellaDiTesto 254">
                <a:extLst>
                  <a:ext uri="{FF2B5EF4-FFF2-40B4-BE49-F238E27FC236}">
                    <a16:creationId xmlns:a16="http://schemas.microsoft.com/office/drawing/2014/main" id="{5375DAAC-7B32-4BD5-B6B8-1592C7855D86}"/>
                  </a:ext>
                </a:extLst>
              </p:cNvPr>
              <p:cNvSpPr txBox="1"/>
              <p:nvPr/>
            </p:nvSpPr>
            <p:spPr>
              <a:xfrm>
                <a:off x="2682729" y="4654288"/>
                <a:ext cx="24237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0</a:t>
                </a:r>
              </a:p>
            </p:txBody>
          </p:sp>
          <p:sp>
            <p:nvSpPr>
              <p:cNvPr id="256" name="CasellaDiTesto 255">
                <a:extLst>
                  <a:ext uri="{FF2B5EF4-FFF2-40B4-BE49-F238E27FC236}">
                    <a16:creationId xmlns:a16="http://schemas.microsoft.com/office/drawing/2014/main" id="{781D7A49-C8F9-4896-A83F-DC8FA0B1F049}"/>
                  </a:ext>
                </a:extLst>
              </p:cNvPr>
              <p:cNvSpPr txBox="1"/>
              <p:nvPr/>
            </p:nvSpPr>
            <p:spPr>
              <a:xfrm>
                <a:off x="2753916" y="4654288"/>
                <a:ext cx="300082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10</a:t>
                </a:r>
              </a:p>
            </p:txBody>
          </p:sp>
          <p:sp>
            <p:nvSpPr>
              <p:cNvPr id="257" name="CasellaDiTesto 256">
                <a:extLst>
                  <a:ext uri="{FF2B5EF4-FFF2-40B4-BE49-F238E27FC236}">
                    <a16:creationId xmlns:a16="http://schemas.microsoft.com/office/drawing/2014/main" id="{06ED8857-66EC-4960-8DD3-E59669B9E879}"/>
                  </a:ext>
                </a:extLst>
              </p:cNvPr>
              <p:cNvSpPr txBox="1"/>
              <p:nvPr/>
            </p:nvSpPr>
            <p:spPr>
              <a:xfrm>
                <a:off x="2874365" y="4654288"/>
                <a:ext cx="300082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20</a:t>
                </a:r>
              </a:p>
            </p:txBody>
          </p:sp>
          <p:sp>
            <p:nvSpPr>
              <p:cNvPr id="258" name="CasellaDiTesto 257">
                <a:extLst>
                  <a:ext uri="{FF2B5EF4-FFF2-40B4-BE49-F238E27FC236}">
                    <a16:creationId xmlns:a16="http://schemas.microsoft.com/office/drawing/2014/main" id="{95085925-2F0D-4C8B-8D66-68682CE1BBAF}"/>
                  </a:ext>
                </a:extLst>
              </p:cNvPr>
              <p:cNvSpPr txBox="1"/>
              <p:nvPr/>
            </p:nvSpPr>
            <p:spPr>
              <a:xfrm>
                <a:off x="2994571" y="4654288"/>
                <a:ext cx="300082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40</a:t>
                </a:r>
              </a:p>
            </p:txBody>
          </p:sp>
        </p:grpSp>
        <p:grpSp>
          <p:nvGrpSpPr>
            <p:cNvPr id="262" name="Gruppo 261">
              <a:extLst>
                <a:ext uri="{FF2B5EF4-FFF2-40B4-BE49-F238E27FC236}">
                  <a16:creationId xmlns:a16="http://schemas.microsoft.com/office/drawing/2014/main" id="{BD2DCBE6-606D-4A5D-A3A7-3CBD2676E9A2}"/>
                </a:ext>
              </a:extLst>
            </p:cNvPr>
            <p:cNvGrpSpPr/>
            <p:nvPr/>
          </p:nvGrpSpPr>
          <p:grpSpPr>
            <a:xfrm>
              <a:off x="1649756" y="3276512"/>
              <a:ext cx="689612" cy="276999"/>
              <a:chOff x="1185698" y="3449955"/>
              <a:chExt cx="689612" cy="276999"/>
            </a:xfrm>
          </p:grpSpPr>
          <p:cxnSp>
            <p:nvCxnSpPr>
              <p:cNvPr id="263" name="Connettore diritto 262">
                <a:extLst>
                  <a:ext uri="{FF2B5EF4-FFF2-40B4-BE49-F238E27FC236}">
                    <a16:creationId xmlns:a16="http://schemas.microsoft.com/office/drawing/2014/main" id="{62C2D1D5-697B-484A-A67D-10BFC154680F}"/>
                  </a:ext>
                </a:extLst>
              </p:cNvPr>
              <p:cNvCxnSpPr/>
              <p:nvPr/>
            </p:nvCxnSpPr>
            <p:spPr>
              <a:xfrm>
                <a:off x="1342551" y="3707904"/>
                <a:ext cx="36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64" name="CasellaDiTesto 263">
                <a:extLst>
                  <a:ext uri="{FF2B5EF4-FFF2-40B4-BE49-F238E27FC236}">
                    <a16:creationId xmlns:a16="http://schemas.microsoft.com/office/drawing/2014/main" id="{69E3A460-09C0-4D23-9B18-DFCB6BD0C6A0}"/>
                  </a:ext>
                </a:extLst>
              </p:cNvPr>
              <p:cNvSpPr txBox="1"/>
              <p:nvPr/>
            </p:nvSpPr>
            <p:spPr>
              <a:xfrm>
                <a:off x="1185698" y="3449955"/>
                <a:ext cx="6896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IGF1-R</a:t>
                </a:r>
              </a:p>
            </p:txBody>
          </p:sp>
        </p:grpSp>
        <p:grpSp>
          <p:nvGrpSpPr>
            <p:cNvPr id="265" name="Gruppo 264">
              <a:extLst>
                <a:ext uri="{FF2B5EF4-FFF2-40B4-BE49-F238E27FC236}">
                  <a16:creationId xmlns:a16="http://schemas.microsoft.com/office/drawing/2014/main" id="{7A4DF4F0-FD3F-4D5E-938F-66D94441280C}"/>
                </a:ext>
              </a:extLst>
            </p:cNvPr>
            <p:cNvGrpSpPr/>
            <p:nvPr/>
          </p:nvGrpSpPr>
          <p:grpSpPr>
            <a:xfrm>
              <a:off x="2196418" y="3276512"/>
              <a:ext cx="689612" cy="276999"/>
              <a:chOff x="1217448" y="3449955"/>
              <a:chExt cx="689612" cy="276999"/>
            </a:xfrm>
          </p:grpSpPr>
          <p:cxnSp>
            <p:nvCxnSpPr>
              <p:cNvPr id="266" name="Connettore diritto 265">
                <a:extLst>
                  <a:ext uri="{FF2B5EF4-FFF2-40B4-BE49-F238E27FC236}">
                    <a16:creationId xmlns:a16="http://schemas.microsoft.com/office/drawing/2014/main" id="{77096135-92C7-4498-95FA-8D0BADC60760}"/>
                  </a:ext>
                </a:extLst>
              </p:cNvPr>
              <p:cNvCxnSpPr/>
              <p:nvPr/>
            </p:nvCxnSpPr>
            <p:spPr>
              <a:xfrm>
                <a:off x="1342551" y="3707904"/>
                <a:ext cx="36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67" name="CasellaDiTesto 266">
                <a:extLst>
                  <a:ext uri="{FF2B5EF4-FFF2-40B4-BE49-F238E27FC236}">
                    <a16:creationId xmlns:a16="http://schemas.microsoft.com/office/drawing/2014/main" id="{57633AA7-C645-4C2A-B711-079993EEAE38}"/>
                  </a:ext>
                </a:extLst>
              </p:cNvPr>
              <p:cNvSpPr txBox="1"/>
              <p:nvPr/>
            </p:nvSpPr>
            <p:spPr>
              <a:xfrm>
                <a:off x="1217448" y="3449955"/>
                <a:ext cx="6896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FOXA1</a:t>
                </a:r>
              </a:p>
            </p:txBody>
          </p:sp>
        </p:grpSp>
        <p:grpSp>
          <p:nvGrpSpPr>
            <p:cNvPr id="268" name="Gruppo 267">
              <a:extLst>
                <a:ext uri="{FF2B5EF4-FFF2-40B4-BE49-F238E27FC236}">
                  <a16:creationId xmlns:a16="http://schemas.microsoft.com/office/drawing/2014/main" id="{910AC7A8-86E7-4503-803C-27571A9BBD65}"/>
                </a:ext>
              </a:extLst>
            </p:cNvPr>
            <p:cNvGrpSpPr/>
            <p:nvPr/>
          </p:nvGrpSpPr>
          <p:grpSpPr>
            <a:xfrm>
              <a:off x="2755695" y="3276512"/>
              <a:ext cx="487634" cy="276999"/>
              <a:chOff x="1299998" y="3449955"/>
              <a:chExt cx="487634" cy="276999"/>
            </a:xfrm>
          </p:grpSpPr>
          <p:cxnSp>
            <p:nvCxnSpPr>
              <p:cNvPr id="269" name="Connettore diritto 268">
                <a:extLst>
                  <a:ext uri="{FF2B5EF4-FFF2-40B4-BE49-F238E27FC236}">
                    <a16:creationId xmlns:a16="http://schemas.microsoft.com/office/drawing/2014/main" id="{09F74C1D-9834-43FC-AF51-C8B322B859A0}"/>
                  </a:ext>
                </a:extLst>
              </p:cNvPr>
              <p:cNvCxnSpPr/>
              <p:nvPr/>
            </p:nvCxnSpPr>
            <p:spPr>
              <a:xfrm>
                <a:off x="1342551" y="3707904"/>
                <a:ext cx="36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70" name="CasellaDiTesto 269">
                <a:extLst>
                  <a:ext uri="{FF2B5EF4-FFF2-40B4-BE49-F238E27FC236}">
                    <a16:creationId xmlns:a16="http://schemas.microsoft.com/office/drawing/2014/main" id="{C19B390E-622F-4126-A245-357E645EA16F}"/>
                  </a:ext>
                </a:extLst>
              </p:cNvPr>
              <p:cNvSpPr txBox="1"/>
              <p:nvPr/>
            </p:nvSpPr>
            <p:spPr>
              <a:xfrm>
                <a:off x="1299998" y="3449955"/>
                <a:ext cx="4876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ER</a:t>
                </a:r>
                <a:r>
                  <a:rPr lang="el-G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α</a:t>
                </a:r>
                <a:endParaRPr lang="it-IT" sz="1200" dirty="0"/>
              </a:p>
            </p:txBody>
          </p:sp>
        </p:grpSp>
      </p:grpSp>
      <p:sp>
        <p:nvSpPr>
          <p:cNvPr id="272" name="CasellaDiTesto 271">
            <a:extLst>
              <a:ext uri="{FF2B5EF4-FFF2-40B4-BE49-F238E27FC236}">
                <a16:creationId xmlns:a16="http://schemas.microsoft.com/office/drawing/2014/main" id="{1BBD55A0-98C2-47A1-90AF-09AF9F6E4108}"/>
              </a:ext>
            </a:extLst>
          </p:cNvPr>
          <p:cNvSpPr txBox="1"/>
          <p:nvPr/>
        </p:nvSpPr>
        <p:spPr>
          <a:xfrm>
            <a:off x="44624" y="4932040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d)</a:t>
            </a:r>
          </a:p>
        </p:txBody>
      </p:sp>
      <p:sp>
        <p:nvSpPr>
          <p:cNvPr id="274" name="CasellaDiTesto 273">
            <a:extLst>
              <a:ext uri="{FF2B5EF4-FFF2-40B4-BE49-F238E27FC236}">
                <a16:creationId xmlns:a16="http://schemas.microsoft.com/office/drawing/2014/main" id="{20230811-7E23-40C4-952A-4194E7890510}"/>
              </a:ext>
            </a:extLst>
          </p:cNvPr>
          <p:cNvSpPr txBox="1"/>
          <p:nvPr/>
        </p:nvSpPr>
        <p:spPr>
          <a:xfrm>
            <a:off x="3409945" y="4932040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e)</a:t>
            </a:r>
          </a:p>
        </p:txBody>
      </p:sp>
      <p:grpSp>
        <p:nvGrpSpPr>
          <p:cNvPr id="306" name="Gruppo 305">
            <a:extLst>
              <a:ext uri="{FF2B5EF4-FFF2-40B4-BE49-F238E27FC236}">
                <a16:creationId xmlns:a16="http://schemas.microsoft.com/office/drawing/2014/main" id="{A65B5E4D-80A0-4206-9F58-64150E916510}"/>
              </a:ext>
            </a:extLst>
          </p:cNvPr>
          <p:cNvGrpSpPr/>
          <p:nvPr/>
        </p:nvGrpSpPr>
        <p:grpSpPr>
          <a:xfrm>
            <a:off x="4156194" y="5322237"/>
            <a:ext cx="2159617" cy="1691575"/>
            <a:chOff x="615209" y="6211845"/>
            <a:chExt cx="2159617" cy="1691575"/>
          </a:xfrm>
        </p:grpSpPr>
        <p:pic>
          <p:nvPicPr>
            <p:cNvPr id="305" name="Immagine 304">
              <a:extLst>
                <a:ext uri="{FF2B5EF4-FFF2-40B4-BE49-F238E27FC236}">
                  <a16:creationId xmlns:a16="http://schemas.microsoft.com/office/drawing/2014/main" id="{5366FC90-1652-4A15-AB63-405DB21508C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247330" y="6329588"/>
              <a:ext cx="1219909" cy="1260000"/>
            </a:xfrm>
            <a:prstGeom prst="rect">
              <a:avLst/>
            </a:prstGeom>
          </p:spPr>
        </p:pic>
        <p:sp>
          <p:nvSpPr>
            <p:cNvPr id="179" name="CasellaDiTesto 178">
              <a:extLst>
                <a:ext uri="{FF2B5EF4-FFF2-40B4-BE49-F238E27FC236}">
                  <a16:creationId xmlns:a16="http://schemas.microsoft.com/office/drawing/2014/main" id="{8FA549C0-AA37-49F9-AE3A-E1C1D70D6730}"/>
                </a:ext>
              </a:extLst>
            </p:cNvPr>
            <p:cNvSpPr txBox="1"/>
            <p:nvPr/>
          </p:nvSpPr>
          <p:spPr>
            <a:xfrm>
              <a:off x="1368164" y="7496680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180" name="CasellaDiTesto 179">
              <a:extLst>
                <a:ext uri="{FF2B5EF4-FFF2-40B4-BE49-F238E27FC236}">
                  <a16:creationId xmlns:a16="http://schemas.microsoft.com/office/drawing/2014/main" id="{0C456427-ED97-4733-9BED-1AC2EF20777D}"/>
                </a:ext>
              </a:extLst>
            </p:cNvPr>
            <p:cNvSpPr txBox="1"/>
            <p:nvPr/>
          </p:nvSpPr>
          <p:spPr>
            <a:xfrm>
              <a:off x="1615735" y="7496680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sp>
          <p:nvSpPr>
            <p:cNvPr id="181" name="CasellaDiTesto 180">
              <a:extLst>
                <a:ext uri="{FF2B5EF4-FFF2-40B4-BE49-F238E27FC236}">
                  <a16:creationId xmlns:a16="http://schemas.microsoft.com/office/drawing/2014/main" id="{5F16C73D-6F2D-43EC-9872-0C8CBD9F9C4F}"/>
                </a:ext>
              </a:extLst>
            </p:cNvPr>
            <p:cNvSpPr txBox="1"/>
            <p:nvPr/>
          </p:nvSpPr>
          <p:spPr>
            <a:xfrm>
              <a:off x="2412226" y="7496680"/>
              <a:ext cx="36260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Tel</a:t>
              </a:r>
            </a:p>
          </p:txBody>
        </p:sp>
        <p:sp>
          <p:nvSpPr>
            <p:cNvPr id="182" name="CasellaDiTesto 181">
              <a:extLst>
                <a:ext uri="{FF2B5EF4-FFF2-40B4-BE49-F238E27FC236}">
                  <a16:creationId xmlns:a16="http://schemas.microsoft.com/office/drawing/2014/main" id="{555D44FE-3DD3-4626-A721-DEA063B28D07}"/>
                </a:ext>
              </a:extLst>
            </p:cNvPr>
            <p:cNvSpPr txBox="1"/>
            <p:nvPr/>
          </p:nvSpPr>
          <p:spPr>
            <a:xfrm>
              <a:off x="1895992" y="7496680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183" name="CasellaDiTesto 182">
              <a:extLst>
                <a:ext uri="{FF2B5EF4-FFF2-40B4-BE49-F238E27FC236}">
                  <a16:creationId xmlns:a16="http://schemas.microsoft.com/office/drawing/2014/main" id="{2CA7950B-D2AE-4F44-A53A-8FB592DA5DEC}"/>
                </a:ext>
              </a:extLst>
            </p:cNvPr>
            <p:cNvSpPr txBox="1"/>
            <p:nvPr/>
          </p:nvSpPr>
          <p:spPr>
            <a:xfrm>
              <a:off x="2155056" y="7496680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cxnSp>
          <p:nvCxnSpPr>
            <p:cNvPr id="184" name="Connettore diritto 183">
              <a:extLst>
                <a:ext uri="{FF2B5EF4-FFF2-40B4-BE49-F238E27FC236}">
                  <a16:creationId xmlns:a16="http://schemas.microsoft.com/office/drawing/2014/main" id="{93F64027-2E68-4392-A8A3-970D78D7EE3F}"/>
                </a:ext>
              </a:extLst>
            </p:cNvPr>
            <p:cNvCxnSpPr>
              <a:cxnSpLocks/>
            </p:cNvCxnSpPr>
            <p:nvPr/>
          </p:nvCxnSpPr>
          <p:spPr>
            <a:xfrm>
              <a:off x="2009966" y="7695866"/>
              <a:ext cx="27509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5" name="CasellaDiTesto 184">
              <a:extLst>
                <a:ext uri="{FF2B5EF4-FFF2-40B4-BE49-F238E27FC236}">
                  <a16:creationId xmlns:a16="http://schemas.microsoft.com/office/drawing/2014/main" id="{5E8901E5-0A0D-4DE1-9D7C-CF522054192F}"/>
                </a:ext>
              </a:extLst>
            </p:cNvPr>
            <p:cNvSpPr txBox="1"/>
            <p:nvPr/>
          </p:nvSpPr>
          <p:spPr>
            <a:xfrm>
              <a:off x="1933259" y="7657199"/>
              <a:ext cx="44755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NVP</a:t>
              </a:r>
            </a:p>
          </p:txBody>
        </p:sp>
        <p:sp>
          <p:nvSpPr>
            <p:cNvPr id="277" name="CasellaDiTesto 276">
              <a:extLst>
                <a:ext uri="{FF2B5EF4-FFF2-40B4-BE49-F238E27FC236}">
                  <a16:creationId xmlns:a16="http://schemas.microsoft.com/office/drawing/2014/main" id="{2D739848-91AC-4E72-907E-56B7435B8532}"/>
                </a:ext>
              </a:extLst>
            </p:cNvPr>
            <p:cNvSpPr txBox="1"/>
            <p:nvPr/>
          </p:nvSpPr>
          <p:spPr>
            <a:xfrm rot="16200000">
              <a:off x="319872" y="6708782"/>
              <a:ext cx="105233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 err="1"/>
                <a:t>pAKT</a:t>
              </a:r>
              <a:r>
                <a:rPr lang="it-IT" sz="1200" dirty="0"/>
                <a:t> </a:t>
              </a:r>
              <a:r>
                <a:rPr lang="it-IT" sz="1200" dirty="0" err="1"/>
                <a:t>Levels</a:t>
              </a:r>
              <a:endParaRPr lang="it-IT" sz="1200" dirty="0"/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-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278" name="CasellaDiTesto 277">
              <a:extLst>
                <a:ext uri="{FF2B5EF4-FFF2-40B4-BE49-F238E27FC236}">
                  <a16:creationId xmlns:a16="http://schemas.microsoft.com/office/drawing/2014/main" id="{F80109B7-1D05-4B39-8AF2-D0C4CB7B2034}"/>
                </a:ext>
              </a:extLst>
            </p:cNvPr>
            <p:cNvSpPr txBox="1"/>
            <p:nvPr/>
          </p:nvSpPr>
          <p:spPr>
            <a:xfrm>
              <a:off x="944505" y="6211845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2.0</a:t>
              </a:r>
            </a:p>
          </p:txBody>
        </p:sp>
        <p:sp>
          <p:nvSpPr>
            <p:cNvPr id="279" name="CasellaDiTesto 278">
              <a:extLst>
                <a:ext uri="{FF2B5EF4-FFF2-40B4-BE49-F238E27FC236}">
                  <a16:creationId xmlns:a16="http://schemas.microsoft.com/office/drawing/2014/main" id="{59876370-C010-4BD0-89E4-C5013378D93F}"/>
                </a:ext>
              </a:extLst>
            </p:cNvPr>
            <p:cNvSpPr txBox="1"/>
            <p:nvPr/>
          </p:nvSpPr>
          <p:spPr>
            <a:xfrm>
              <a:off x="944505" y="680316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0</a:t>
              </a:r>
            </a:p>
          </p:txBody>
        </p:sp>
        <p:sp>
          <p:nvSpPr>
            <p:cNvPr id="280" name="CasellaDiTesto 279">
              <a:extLst>
                <a:ext uri="{FF2B5EF4-FFF2-40B4-BE49-F238E27FC236}">
                  <a16:creationId xmlns:a16="http://schemas.microsoft.com/office/drawing/2014/main" id="{5B03F997-5322-43BA-A9D0-ABCA92366EE4}"/>
                </a:ext>
              </a:extLst>
            </p:cNvPr>
            <p:cNvSpPr txBox="1"/>
            <p:nvPr/>
          </p:nvSpPr>
          <p:spPr>
            <a:xfrm>
              <a:off x="944505" y="740443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</p:grpSp>
      <p:grpSp>
        <p:nvGrpSpPr>
          <p:cNvPr id="4" name="Gruppo 3">
            <a:extLst>
              <a:ext uri="{FF2B5EF4-FFF2-40B4-BE49-F238E27FC236}">
                <a16:creationId xmlns:a16="http://schemas.microsoft.com/office/drawing/2014/main" id="{D86C858F-6C7D-4761-B011-0F88734AD2B5}"/>
              </a:ext>
            </a:extLst>
          </p:cNvPr>
          <p:cNvGrpSpPr/>
          <p:nvPr/>
        </p:nvGrpSpPr>
        <p:grpSpPr>
          <a:xfrm>
            <a:off x="353554" y="5224652"/>
            <a:ext cx="3034255" cy="1571786"/>
            <a:chOff x="3342310" y="5128023"/>
            <a:chExt cx="3034255" cy="1571786"/>
          </a:xfrm>
        </p:grpSpPr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35221DE0-2889-47DA-832C-E20D32CD98C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974430" y="5271327"/>
              <a:ext cx="1837500" cy="1260000"/>
            </a:xfrm>
            <a:prstGeom prst="rect">
              <a:avLst/>
            </a:prstGeom>
          </p:spPr>
        </p:pic>
        <p:sp>
          <p:nvSpPr>
            <p:cNvPr id="144" name="CasellaDiTesto 143">
              <a:extLst>
                <a:ext uri="{FF2B5EF4-FFF2-40B4-BE49-F238E27FC236}">
                  <a16:creationId xmlns:a16="http://schemas.microsoft.com/office/drawing/2014/main" id="{DCE473C1-36C8-477E-9D83-55EB39080C40}"/>
                </a:ext>
              </a:extLst>
            </p:cNvPr>
            <p:cNvSpPr txBox="1"/>
            <p:nvPr/>
          </p:nvSpPr>
          <p:spPr>
            <a:xfrm rot="16200000">
              <a:off x="2986058" y="5650521"/>
              <a:ext cx="117416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 err="1"/>
                <a:t>pAKT</a:t>
              </a:r>
              <a:r>
                <a:rPr lang="it-IT" sz="1200" dirty="0"/>
                <a:t>/AKT/Vin</a:t>
              </a:r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0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148" name="CasellaDiTesto 147">
              <a:extLst>
                <a:ext uri="{FF2B5EF4-FFF2-40B4-BE49-F238E27FC236}">
                  <a16:creationId xmlns:a16="http://schemas.microsoft.com/office/drawing/2014/main" id="{4A94EE74-2440-4979-8E35-7D78231E33D4}"/>
                </a:ext>
              </a:extLst>
            </p:cNvPr>
            <p:cNvSpPr txBox="1"/>
            <p:nvPr/>
          </p:nvSpPr>
          <p:spPr>
            <a:xfrm>
              <a:off x="3671605" y="515358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2.6</a:t>
              </a:r>
            </a:p>
          </p:txBody>
        </p:sp>
        <p:sp>
          <p:nvSpPr>
            <p:cNvPr id="149" name="CasellaDiTesto 148">
              <a:extLst>
                <a:ext uri="{FF2B5EF4-FFF2-40B4-BE49-F238E27FC236}">
                  <a16:creationId xmlns:a16="http://schemas.microsoft.com/office/drawing/2014/main" id="{6B2D878E-C19E-473C-B6E0-11194BDC80ED}"/>
                </a:ext>
              </a:extLst>
            </p:cNvPr>
            <p:cNvSpPr txBox="1"/>
            <p:nvPr/>
          </p:nvSpPr>
          <p:spPr>
            <a:xfrm>
              <a:off x="3671605" y="5744903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3</a:t>
              </a:r>
            </a:p>
          </p:txBody>
        </p:sp>
        <p:sp>
          <p:nvSpPr>
            <p:cNvPr id="150" name="CasellaDiTesto 149">
              <a:extLst>
                <a:ext uri="{FF2B5EF4-FFF2-40B4-BE49-F238E27FC236}">
                  <a16:creationId xmlns:a16="http://schemas.microsoft.com/office/drawing/2014/main" id="{3C57893B-3EB8-4287-9DB3-4205FAB6CA2C}"/>
                </a:ext>
              </a:extLst>
            </p:cNvPr>
            <p:cNvSpPr txBox="1"/>
            <p:nvPr/>
          </p:nvSpPr>
          <p:spPr>
            <a:xfrm>
              <a:off x="3671605" y="6346173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157" name="CasellaDiTesto 156">
              <a:extLst>
                <a:ext uri="{FF2B5EF4-FFF2-40B4-BE49-F238E27FC236}">
                  <a16:creationId xmlns:a16="http://schemas.microsoft.com/office/drawing/2014/main" id="{2CE5EA72-67BA-4A33-A540-AA4180FDCBBA}"/>
                </a:ext>
              </a:extLst>
            </p:cNvPr>
            <p:cNvSpPr txBox="1"/>
            <p:nvPr/>
          </p:nvSpPr>
          <p:spPr>
            <a:xfrm>
              <a:off x="4177658" y="6453588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0.25</a:t>
              </a:r>
            </a:p>
          </p:txBody>
        </p:sp>
        <p:sp>
          <p:nvSpPr>
            <p:cNvPr id="158" name="CasellaDiTesto 157">
              <a:extLst>
                <a:ext uri="{FF2B5EF4-FFF2-40B4-BE49-F238E27FC236}">
                  <a16:creationId xmlns:a16="http://schemas.microsoft.com/office/drawing/2014/main" id="{47106044-6353-4CAC-BB72-451389BFC3CA}"/>
                </a:ext>
              </a:extLst>
            </p:cNvPr>
            <p:cNvSpPr txBox="1"/>
            <p:nvPr/>
          </p:nvSpPr>
          <p:spPr>
            <a:xfrm>
              <a:off x="4046655" y="645358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0</a:t>
              </a:r>
            </a:p>
          </p:txBody>
        </p:sp>
        <p:sp>
          <p:nvSpPr>
            <p:cNvPr id="215" name="CasellaDiTesto 214">
              <a:extLst>
                <a:ext uri="{FF2B5EF4-FFF2-40B4-BE49-F238E27FC236}">
                  <a16:creationId xmlns:a16="http://schemas.microsoft.com/office/drawing/2014/main" id="{7E35C53C-94B5-4ECD-9541-03B0E6424869}"/>
                </a:ext>
              </a:extLst>
            </p:cNvPr>
            <p:cNvSpPr txBox="1"/>
            <p:nvPr/>
          </p:nvSpPr>
          <p:spPr>
            <a:xfrm>
              <a:off x="5714204" y="6453588"/>
              <a:ext cx="6623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Tel (</a:t>
              </a:r>
              <a:r>
                <a:rPr lang="it-IT" sz="1000" dirty="0" err="1"/>
                <a:t>hrs</a:t>
              </a:r>
              <a:r>
                <a:rPr lang="it-IT" sz="1000" dirty="0"/>
                <a:t>)</a:t>
              </a:r>
            </a:p>
          </p:txBody>
        </p:sp>
        <p:sp>
          <p:nvSpPr>
            <p:cNvPr id="216" name="CasellaDiTesto 215">
              <a:extLst>
                <a:ext uri="{FF2B5EF4-FFF2-40B4-BE49-F238E27FC236}">
                  <a16:creationId xmlns:a16="http://schemas.microsoft.com/office/drawing/2014/main" id="{C3718229-B96C-4DEA-A92E-06B70C4A7C59}"/>
                </a:ext>
              </a:extLst>
            </p:cNvPr>
            <p:cNvSpPr txBox="1"/>
            <p:nvPr/>
          </p:nvSpPr>
          <p:spPr>
            <a:xfrm>
              <a:off x="4436156" y="6453588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0.5</a:t>
              </a:r>
            </a:p>
          </p:txBody>
        </p:sp>
        <p:sp>
          <p:nvSpPr>
            <p:cNvPr id="217" name="CasellaDiTesto 216">
              <a:extLst>
                <a:ext uri="{FF2B5EF4-FFF2-40B4-BE49-F238E27FC236}">
                  <a16:creationId xmlns:a16="http://schemas.microsoft.com/office/drawing/2014/main" id="{FD755104-9BBB-4C50-9CD4-707A4D8AE627}"/>
                </a:ext>
              </a:extLst>
            </p:cNvPr>
            <p:cNvSpPr txBox="1"/>
            <p:nvPr/>
          </p:nvSpPr>
          <p:spPr>
            <a:xfrm>
              <a:off x="4676903" y="645358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1</a:t>
              </a:r>
            </a:p>
          </p:txBody>
        </p:sp>
        <p:sp>
          <p:nvSpPr>
            <p:cNvPr id="218" name="CasellaDiTesto 217">
              <a:extLst>
                <a:ext uri="{FF2B5EF4-FFF2-40B4-BE49-F238E27FC236}">
                  <a16:creationId xmlns:a16="http://schemas.microsoft.com/office/drawing/2014/main" id="{E6247A58-E4DB-4EDF-8438-B134313E8C79}"/>
                </a:ext>
              </a:extLst>
            </p:cNvPr>
            <p:cNvSpPr txBox="1"/>
            <p:nvPr/>
          </p:nvSpPr>
          <p:spPr>
            <a:xfrm>
              <a:off x="4884781" y="645358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3</a:t>
              </a:r>
            </a:p>
          </p:txBody>
        </p:sp>
        <p:sp>
          <p:nvSpPr>
            <p:cNvPr id="219" name="CasellaDiTesto 218">
              <a:extLst>
                <a:ext uri="{FF2B5EF4-FFF2-40B4-BE49-F238E27FC236}">
                  <a16:creationId xmlns:a16="http://schemas.microsoft.com/office/drawing/2014/main" id="{22AB805A-C1CE-4901-A63A-A74082053814}"/>
                </a:ext>
              </a:extLst>
            </p:cNvPr>
            <p:cNvSpPr txBox="1"/>
            <p:nvPr/>
          </p:nvSpPr>
          <p:spPr>
            <a:xfrm>
              <a:off x="5101548" y="645358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6</a:t>
              </a:r>
            </a:p>
          </p:txBody>
        </p:sp>
        <p:sp>
          <p:nvSpPr>
            <p:cNvPr id="220" name="CasellaDiTesto 219">
              <a:extLst>
                <a:ext uri="{FF2B5EF4-FFF2-40B4-BE49-F238E27FC236}">
                  <a16:creationId xmlns:a16="http://schemas.microsoft.com/office/drawing/2014/main" id="{AE812724-FF40-4251-A5F0-45AF5DD84328}"/>
                </a:ext>
              </a:extLst>
            </p:cNvPr>
            <p:cNvSpPr txBox="1"/>
            <p:nvPr/>
          </p:nvSpPr>
          <p:spPr>
            <a:xfrm>
              <a:off x="5277196" y="6453588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24</a:t>
              </a:r>
            </a:p>
          </p:txBody>
        </p:sp>
        <p:sp>
          <p:nvSpPr>
            <p:cNvPr id="221" name="CasellaDiTesto 220">
              <a:extLst>
                <a:ext uri="{FF2B5EF4-FFF2-40B4-BE49-F238E27FC236}">
                  <a16:creationId xmlns:a16="http://schemas.microsoft.com/office/drawing/2014/main" id="{1A800532-F2C5-47B1-BE29-CEABD49AFFBB}"/>
                </a:ext>
              </a:extLst>
            </p:cNvPr>
            <p:cNvSpPr txBox="1"/>
            <p:nvPr/>
          </p:nvSpPr>
          <p:spPr>
            <a:xfrm>
              <a:off x="5486904" y="6453588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48</a:t>
              </a:r>
            </a:p>
          </p:txBody>
        </p:sp>
        <p:sp>
          <p:nvSpPr>
            <p:cNvPr id="222" name="CasellaDiTesto 221">
              <a:extLst>
                <a:ext uri="{FF2B5EF4-FFF2-40B4-BE49-F238E27FC236}">
                  <a16:creationId xmlns:a16="http://schemas.microsoft.com/office/drawing/2014/main" id="{E892C7DF-4B81-4608-BBB7-CE19D6E99E7C}"/>
                </a:ext>
              </a:extLst>
            </p:cNvPr>
            <p:cNvSpPr txBox="1"/>
            <p:nvPr/>
          </p:nvSpPr>
          <p:spPr>
            <a:xfrm>
              <a:off x="5096889" y="5128023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*</a:t>
              </a:r>
            </a:p>
          </p:txBody>
        </p:sp>
        <p:sp>
          <p:nvSpPr>
            <p:cNvPr id="223" name="CasellaDiTesto 222">
              <a:extLst>
                <a:ext uri="{FF2B5EF4-FFF2-40B4-BE49-F238E27FC236}">
                  <a16:creationId xmlns:a16="http://schemas.microsoft.com/office/drawing/2014/main" id="{5893BBC1-0836-42AB-9DF2-123B2DC6400A}"/>
                </a:ext>
              </a:extLst>
            </p:cNvPr>
            <p:cNvSpPr txBox="1"/>
            <p:nvPr/>
          </p:nvSpPr>
          <p:spPr>
            <a:xfrm>
              <a:off x="5286013" y="5280058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**</a:t>
              </a:r>
            </a:p>
          </p:txBody>
        </p:sp>
      </p:grpSp>
      <p:sp>
        <p:nvSpPr>
          <p:cNvPr id="168" name="CasellaDiTesto 167">
            <a:extLst>
              <a:ext uri="{FF2B5EF4-FFF2-40B4-BE49-F238E27FC236}">
                <a16:creationId xmlns:a16="http://schemas.microsoft.com/office/drawing/2014/main" id="{DF684F17-3D51-03B2-4770-26F90483B01F}"/>
              </a:ext>
            </a:extLst>
          </p:cNvPr>
          <p:cNvSpPr txBox="1"/>
          <p:nvPr/>
        </p:nvSpPr>
        <p:spPr>
          <a:xfrm>
            <a:off x="653388" y="7174801"/>
            <a:ext cx="3145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f)</a:t>
            </a:r>
          </a:p>
        </p:txBody>
      </p:sp>
      <p:sp>
        <p:nvSpPr>
          <p:cNvPr id="170" name="CasellaDiTesto 169">
            <a:extLst>
              <a:ext uri="{FF2B5EF4-FFF2-40B4-BE49-F238E27FC236}">
                <a16:creationId xmlns:a16="http://schemas.microsoft.com/office/drawing/2014/main" id="{FB4A362A-865F-FC36-EE21-BC375CA921A2}"/>
              </a:ext>
            </a:extLst>
          </p:cNvPr>
          <p:cNvSpPr txBox="1"/>
          <p:nvPr/>
        </p:nvSpPr>
        <p:spPr>
          <a:xfrm>
            <a:off x="3633404" y="7174801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f’)</a:t>
            </a:r>
          </a:p>
        </p:txBody>
      </p:sp>
      <p:grpSp>
        <p:nvGrpSpPr>
          <p:cNvPr id="6" name="Gruppo 5">
            <a:extLst>
              <a:ext uri="{FF2B5EF4-FFF2-40B4-BE49-F238E27FC236}">
                <a16:creationId xmlns:a16="http://schemas.microsoft.com/office/drawing/2014/main" id="{1B25964C-CA1F-2EB9-3B08-95660632C1DC}"/>
              </a:ext>
            </a:extLst>
          </p:cNvPr>
          <p:cNvGrpSpPr/>
          <p:nvPr/>
        </p:nvGrpSpPr>
        <p:grpSpPr>
          <a:xfrm>
            <a:off x="4156195" y="7320806"/>
            <a:ext cx="2194882" cy="1691575"/>
            <a:chOff x="4156195" y="7320806"/>
            <a:chExt cx="2194882" cy="1691575"/>
          </a:xfrm>
        </p:grpSpPr>
        <p:pic>
          <p:nvPicPr>
            <p:cNvPr id="5" name="Immagine 4">
              <a:extLst>
                <a:ext uri="{FF2B5EF4-FFF2-40B4-BE49-F238E27FC236}">
                  <a16:creationId xmlns:a16="http://schemas.microsoft.com/office/drawing/2014/main" id="{084C6643-7EFF-FA1A-5440-C283A94AF6A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788315" y="7438549"/>
              <a:ext cx="1236881" cy="1260000"/>
            </a:xfrm>
            <a:prstGeom prst="rect">
              <a:avLst/>
            </a:prstGeom>
          </p:spPr>
        </p:pic>
        <p:sp>
          <p:nvSpPr>
            <p:cNvPr id="173" name="CasellaDiTesto 172">
              <a:extLst>
                <a:ext uri="{FF2B5EF4-FFF2-40B4-BE49-F238E27FC236}">
                  <a16:creationId xmlns:a16="http://schemas.microsoft.com/office/drawing/2014/main" id="{777A88F4-AEC3-7F54-3E97-D50D795E73C4}"/>
                </a:ext>
              </a:extLst>
            </p:cNvPr>
            <p:cNvSpPr txBox="1"/>
            <p:nvPr/>
          </p:nvSpPr>
          <p:spPr>
            <a:xfrm>
              <a:off x="4909149" y="8605641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174" name="CasellaDiTesto 173">
              <a:extLst>
                <a:ext uri="{FF2B5EF4-FFF2-40B4-BE49-F238E27FC236}">
                  <a16:creationId xmlns:a16="http://schemas.microsoft.com/office/drawing/2014/main" id="{CEA67595-84D6-EDBC-BE1C-5066B330CDC0}"/>
                </a:ext>
              </a:extLst>
            </p:cNvPr>
            <p:cNvSpPr txBox="1"/>
            <p:nvPr/>
          </p:nvSpPr>
          <p:spPr>
            <a:xfrm>
              <a:off x="5156720" y="8605641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sp>
          <p:nvSpPr>
            <p:cNvPr id="175" name="CasellaDiTesto 174">
              <a:extLst>
                <a:ext uri="{FF2B5EF4-FFF2-40B4-BE49-F238E27FC236}">
                  <a16:creationId xmlns:a16="http://schemas.microsoft.com/office/drawing/2014/main" id="{1628DD2B-3AE1-52E3-89CC-37AA0D5240F4}"/>
                </a:ext>
              </a:extLst>
            </p:cNvPr>
            <p:cNvSpPr txBox="1"/>
            <p:nvPr/>
          </p:nvSpPr>
          <p:spPr>
            <a:xfrm>
              <a:off x="5953211" y="8605641"/>
              <a:ext cx="397866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IGF</a:t>
              </a:r>
            </a:p>
          </p:txBody>
        </p:sp>
        <p:sp>
          <p:nvSpPr>
            <p:cNvPr id="176" name="CasellaDiTesto 175">
              <a:extLst>
                <a:ext uri="{FF2B5EF4-FFF2-40B4-BE49-F238E27FC236}">
                  <a16:creationId xmlns:a16="http://schemas.microsoft.com/office/drawing/2014/main" id="{76119EAD-92EA-0B03-6E9D-4DA798AEFED2}"/>
                </a:ext>
              </a:extLst>
            </p:cNvPr>
            <p:cNvSpPr txBox="1"/>
            <p:nvPr/>
          </p:nvSpPr>
          <p:spPr>
            <a:xfrm>
              <a:off x="5436977" y="8605641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177" name="CasellaDiTesto 176">
              <a:extLst>
                <a:ext uri="{FF2B5EF4-FFF2-40B4-BE49-F238E27FC236}">
                  <a16:creationId xmlns:a16="http://schemas.microsoft.com/office/drawing/2014/main" id="{1C2A3682-9642-42A6-6D95-292A705F605D}"/>
                </a:ext>
              </a:extLst>
            </p:cNvPr>
            <p:cNvSpPr txBox="1"/>
            <p:nvPr/>
          </p:nvSpPr>
          <p:spPr>
            <a:xfrm>
              <a:off x="5696041" y="8605641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cxnSp>
          <p:nvCxnSpPr>
            <p:cNvPr id="178" name="Connettore diritto 177">
              <a:extLst>
                <a:ext uri="{FF2B5EF4-FFF2-40B4-BE49-F238E27FC236}">
                  <a16:creationId xmlns:a16="http://schemas.microsoft.com/office/drawing/2014/main" id="{63E483D7-A459-34C1-3A96-2278CCD42510}"/>
                </a:ext>
              </a:extLst>
            </p:cNvPr>
            <p:cNvCxnSpPr>
              <a:cxnSpLocks/>
            </p:cNvCxnSpPr>
            <p:nvPr/>
          </p:nvCxnSpPr>
          <p:spPr>
            <a:xfrm>
              <a:off x="5550951" y="8804827"/>
              <a:ext cx="27509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1" name="CasellaDiTesto 190">
              <a:extLst>
                <a:ext uri="{FF2B5EF4-FFF2-40B4-BE49-F238E27FC236}">
                  <a16:creationId xmlns:a16="http://schemas.microsoft.com/office/drawing/2014/main" id="{BC7EDF32-D6FE-2472-AE81-372EDC2616CB}"/>
                </a:ext>
              </a:extLst>
            </p:cNvPr>
            <p:cNvSpPr txBox="1"/>
            <p:nvPr/>
          </p:nvSpPr>
          <p:spPr>
            <a:xfrm>
              <a:off x="5474244" y="8766160"/>
              <a:ext cx="44755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NVP</a:t>
              </a:r>
            </a:p>
          </p:txBody>
        </p:sp>
        <p:sp>
          <p:nvSpPr>
            <p:cNvPr id="192" name="CasellaDiTesto 191">
              <a:extLst>
                <a:ext uri="{FF2B5EF4-FFF2-40B4-BE49-F238E27FC236}">
                  <a16:creationId xmlns:a16="http://schemas.microsoft.com/office/drawing/2014/main" id="{1656B70F-2D14-4A02-534F-3295DC071373}"/>
                </a:ext>
              </a:extLst>
            </p:cNvPr>
            <p:cNvSpPr txBox="1"/>
            <p:nvPr/>
          </p:nvSpPr>
          <p:spPr>
            <a:xfrm rot="16200000">
              <a:off x="3756887" y="7817743"/>
              <a:ext cx="126028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/>
                <a:t>pIGF1-R </a:t>
              </a:r>
              <a:r>
                <a:rPr lang="it-IT" sz="1200" dirty="0" err="1"/>
                <a:t>Levels</a:t>
              </a:r>
              <a:endParaRPr lang="it-IT" sz="1200" dirty="0"/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-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193" name="CasellaDiTesto 192">
              <a:extLst>
                <a:ext uri="{FF2B5EF4-FFF2-40B4-BE49-F238E27FC236}">
                  <a16:creationId xmlns:a16="http://schemas.microsoft.com/office/drawing/2014/main" id="{79792095-9B3F-AFE8-9800-3863A610E435}"/>
                </a:ext>
              </a:extLst>
            </p:cNvPr>
            <p:cNvSpPr txBox="1"/>
            <p:nvPr/>
          </p:nvSpPr>
          <p:spPr>
            <a:xfrm>
              <a:off x="4485490" y="7320806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6.0</a:t>
              </a:r>
            </a:p>
          </p:txBody>
        </p:sp>
        <p:sp>
          <p:nvSpPr>
            <p:cNvPr id="194" name="CasellaDiTesto 193">
              <a:extLst>
                <a:ext uri="{FF2B5EF4-FFF2-40B4-BE49-F238E27FC236}">
                  <a16:creationId xmlns:a16="http://schemas.microsoft.com/office/drawing/2014/main" id="{2825BBA4-EF78-07FC-5F1F-61B28B70E38B}"/>
                </a:ext>
              </a:extLst>
            </p:cNvPr>
            <p:cNvSpPr txBox="1"/>
            <p:nvPr/>
          </p:nvSpPr>
          <p:spPr>
            <a:xfrm>
              <a:off x="4485490" y="7912125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3.0</a:t>
              </a:r>
            </a:p>
          </p:txBody>
        </p:sp>
        <p:sp>
          <p:nvSpPr>
            <p:cNvPr id="195" name="CasellaDiTesto 194">
              <a:extLst>
                <a:ext uri="{FF2B5EF4-FFF2-40B4-BE49-F238E27FC236}">
                  <a16:creationId xmlns:a16="http://schemas.microsoft.com/office/drawing/2014/main" id="{23D75452-6A16-7143-658D-E1CEB264FAFF}"/>
                </a:ext>
              </a:extLst>
            </p:cNvPr>
            <p:cNvSpPr txBox="1"/>
            <p:nvPr/>
          </p:nvSpPr>
          <p:spPr>
            <a:xfrm>
              <a:off x="4485490" y="8513395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</p:grpSp>
      <p:grpSp>
        <p:nvGrpSpPr>
          <p:cNvPr id="10" name="Gruppo 9">
            <a:extLst>
              <a:ext uri="{FF2B5EF4-FFF2-40B4-BE49-F238E27FC236}">
                <a16:creationId xmlns:a16="http://schemas.microsoft.com/office/drawing/2014/main" id="{A317D85F-F269-C400-4C66-51AAC734B2DC}"/>
              </a:ext>
            </a:extLst>
          </p:cNvPr>
          <p:cNvGrpSpPr/>
          <p:nvPr/>
        </p:nvGrpSpPr>
        <p:grpSpPr>
          <a:xfrm>
            <a:off x="1265945" y="7451211"/>
            <a:ext cx="1758123" cy="1089854"/>
            <a:chOff x="1265945" y="7451211"/>
            <a:chExt cx="1758123" cy="1089854"/>
          </a:xfrm>
        </p:grpSpPr>
        <p:pic>
          <p:nvPicPr>
            <p:cNvPr id="200" name="Immagine 199">
              <a:extLst>
                <a:ext uri="{FF2B5EF4-FFF2-40B4-BE49-F238E27FC236}">
                  <a16:creationId xmlns:a16="http://schemas.microsoft.com/office/drawing/2014/main" id="{A4D254B6-0089-C75B-ED2F-FEB4F9C5E82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265945" y="7855727"/>
              <a:ext cx="1080000" cy="16422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02" name="CasellaDiTesto 201">
              <a:extLst>
                <a:ext uri="{FF2B5EF4-FFF2-40B4-BE49-F238E27FC236}">
                  <a16:creationId xmlns:a16="http://schemas.microsoft.com/office/drawing/2014/main" id="{576461EF-BB1C-9D34-2AE1-DC17824E8A8F}"/>
                </a:ext>
              </a:extLst>
            </p:cNvPr>
            <p:cNvSpPr txBox="1"/>
            <p:nvPr/>
          </p:nvSpPr>
          <p:spPr>
            <a:xfrm>
              <a:off x="2348883" y="8294844"/>
              <a:ext cx="60305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Tubulin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204" name="CasellaDiTesto 203">
              <a:extLst>
                <a:ext uri="{FF2B5EF4-FFF2-40B4-BE49-F238E27FC236}">
                  <a16:creationId xmlns:a16="http://schemas.microsoft.com/office/drawing/2014/main" id="{0232F8B3-6DD7-D596-7345-D726E5D91F35}"/>
                </a:ext>
              </a:extLst>
            </p:cNvPr>
            <p:cNvSpPr txBox="1"/>
            <p:nvPr/>
          </p:nvSpPr>
          <p:spPr>
            <a:xfrm>
              <a:off x="2348883" y="8054828"/>
              <a:ext cx="604653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IGF1-R</a:t>
              </a:r>
            </a:p>
          </p:txBody>
        </p:sp>
        <p:sp>
          <p:nvSpPr>
            <p:cNvPr id="205" name="CasellaDiTesto 204">
              <a:extLst>
                <a:ext uri="{FF2B5EF4-FFF2-40B4-BE49-F238E27FC236}">
                  <a16:creationId xmlns:a16="http://schemas.microsoft.com/office/drawing/2014/main" id="{789DA033-7ABB-A3CB-7E27-FB8DA13F9574}"/>
                </a:ext>
              </a:extLst>
            </p:cNvPr>
            <p:cNvSpPr txBox="1"/>
            <p:nvPr/>
          </p:nvSpPr>
          <p:spPr>
            <a:xfrm>
              <a:off x="2348883" y="7810264"/>
              <a:ext cx="675185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pIGF1-R</a:t>
              </a:r>
            </a:p>
          </p:txBody>
        </p:sp>
        <p:sp>
          <p:nvSpPr>
            <p:cNvPr id="210" name="CasellaDiTesto 209">
              <a:extLst>
                <a:ext uri="{FF2B5EF4-FFF2-40B4-BE49-F238E27FC236}">
                  <a16:creationId xmlns:a16="http://schemas.microsoft.com/office/drawing/2014/main" id="{3167185B-88F3-E6CD-BC43-5E03F5C68ECD}"/>
                </a:ext>
              </a:extLst>
            </p:cNvPr>
            <p:cNvSpPr txBox="1"/>
            <p:nvPr/>
          </p:nvSpPr>
          <p:spPr>
            <a:xfrm>
              <a:off x="1304821" y="7619289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211" name="CasellaDiTesto 210">
              <a:extLst>
                <a:ext uri="{FF2B5EF4-FFF2-40B4-BE49-F238E27FC236}">
                  <a16:creationId xmlns:a16="http://schemas.microsoft.com/office/drawing/2014/main" id="{2F173B55-22EF-50DE-8C21-6EAE33881F04}"/>
                </a:ext>
              </a:extLst>
            </p:cNvPr>
            <p:cNvSpPr txBox="1"/>
            <p:nvPr/>
          </p:nvSpPr>
          <p:spPr>
            <a:xfrm>
              <a:off x="1528577" y="7619289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sp>
          <p:nvSpPr>
            <p:cNvPr id="212" name="CasellaDiTesto 211">
              <a:extLst>
                <a:ext uri="{FF2B5EF4-FFF2-40B4-BE49-F238E27FC236}">
                  <a16:creationId xmlns:a16="http://schemas.microsoft.com/office/drawing/2014/main" id="{63D860E3-F207-1C3C-6CE2-485A67C25211}"/>
                </a:ext>
              </a:extLst>
            </p:cNvPr>
            <p:cNvSpPr txBox="1"/>
            <p:nvPr/>
          </p:nvSpPr>
          <p:spPr>
            <a:xfrm>
              <a:off x="2348883" y="7619289"/>
              <a:ext cx="397866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IGF</a:t>
              </a:r>
            </a:p>
          </p:txBody>
        </p:sp>
        <p:sp>
          <p:nvSpPr>
            <p:cNvPr id="213" name="CasellaDiTesto 212">
              <a:extLst>
                <a:ext uri="{FF2B5EF4-FFF2-40B4-BE49-F238E27FC236}">
                  <a16:creationId xmlns:a16="http://schemas.microsoft.com/office/drawing/2014/main" id="{8DC925BD-F634-B978-413D-FF82CE2B415A}"/>
                </a:ext>
              </a:extLst>
            </p:cNvPr>
            <p:cNvSpPr txBox="1"/>
            <p:nvPr/>
          </p:nvSpPr>
          <p:spPr>
            <a:xfrm>
              <a:off x="1832649" y="7619289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214" name="CasellaDiTesto 213">
              <a:extLst>
                <a:ext uri="{FF2B5EF4-FFF2-40B4-BE49-F238E27FC236}">
                  <a16:creationId xmlns:a16="http://schemas.microsoft.com/office/drawing/2014/main" id="{9E92291F-93EC-4F2B-8CCF-1B537809C3DF}"/>
                </a:ext>
              </a:extLst>
            </p:cNvPr>
            <p:cNvSpPr txBox="1"/>
            <p:nvPr/>
          </p:nvSpPr>
          <p:spPr>
            <a:xfrm>
              <a:off x="2091713" y="7619289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cxnSp>
          <p:nvCxnSpPr>
            <p:cNvPr id="224" name="Connettore diritto 223">
              <a:extLst>
                <a:ext uri="{FF2B5EF4-FFF2-40B4-BE49-F238E27FC236}">
                  <a16:creationId xmlns:a16="http://schemas.microsoft.com/office/drawing/2014/main" id="{0F271A20-82C8-2D7C-1D0E-F89918417A8B}"/>
                </a:ext>
              </a:extLst>
            </p:cNvPr>
            <p:cNvCxnSpPr>
              <a:cxnSpLocks/>
            </p:cNvCxnSpPr>
            <p:nvPr/>
          </p:nvCxnSpPr>
          <p:spPr>
            <a:xfrm>
              <a:off x="1946623" y="7670089"/>
              <a:ext cx="27509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5" name="CasellaDiTesto 224">
              <a:extLst>
                <a:ext uri="{FF2B5EF4-FFF2-40B4-BE49-F238E27FC236}">
                  <a16:creationId xmlns:a16="http://schemas.microsoft.com/office/drawing/2014/main" id="{5933AC2E-300D-7076-EA03-1041217DC624}"/>
                </a:ext>
              </a:extLst>
            </p:cNvPr>
            <p:cNvSpPr txBox="1"/>
            <p:nvPr/>
          </p:nvSpPr>
          <p:spPr>
            <a:xfrm>
              <a:off x="1869916" y="7451211"/>
              <a:ext cx="44755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NVP</a:t>
              </a:r>
            </a:p>
          </p:txBody>
        </p:sp>
        <p:pic>
          <p:nvPicPr>
            <p:cNvPr id="7" name="Immagine 6">
              <a:extLst>
                <a:ext uri="{FF2B5EF4-FFF2-40B4-BE49-F238E27FC236}">
                  <a16:creationId xmlns:a16="http://schemas.microsoft.com/office/drawing/2014/main" id="{8EC5228E-05C1-7BB7-9600-97C1227C9820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265945" y="7834463"/>
              <a:ext cx="1080000" cy="19782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" name="Immagine 7">
              <a:extLst>
                <a:ext uri="{FF2B5EF4-FFF2-40B4-BE49-F238E27FC236}">
                  <a16:creationId xmlns:a16="http://schemas.microsoft.com/office/drawing/2014/main" id="{05F4D5EA-BB72-0C43-73C7-FDDC3EF9BFF4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265945" y="8079027"/>
              <a:ext cx="1080000" cy="19782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" name="Immagine 8">
              <a:extLst>
                <a:ext uri="{FF2B5EF4-FFF2-40B4-BE49-F238E27FC236}">
                  <a16:creationId xmlns:a16="http://schemas.microsoft.com/office/drawing/2014/main" id="{358FCCF9-4A40-B321-6FA5-5E76FB4C89B3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265945" y="8319043"/>
              <a:ext cx="1080000" cy="19782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196" name="CasellaDiTesto 195">
            <a:extLst>
              <a:ext uri="{FF2B5EF4-FFF2-40B4-BE49-F238E27FC236}">
                <a16:creationId xmlns:a16="http://schemas.microsoft.com/office/drawing/2014/main" id="{7D9FEF7E-468A-EF35-AF45-BB097316E280}"/>
              </a:ext>
            </a:extLst>
          </p:cNvPr>
          <p:cNvSpPr txBox="1"/>
          <p:nvPr/>
        </p:nvSpPr>
        <p:spPr>
          <a:xfrm>
            <a:off x="2669273" y="3347864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***</a:t>
            </a:r>
          </a:p>
        </p:txBody>
      </p:sp>
      <p:sp>
        <p:nvSpPr>
          <p:cNvPr id="197" name="CasellaDiTesto 196">
            <a:extLst>
              <a:ext uri="{FF2B5EF4-FFF2-40B4-BE49-F238E27FC236}">
                <a16:creationId xmlns:a16="http://schemas.microsoft.com/office/drawing/2014/main" id="{3847CBC2-D36D-4A2B-C254-41385A6F8C62}"/>
              </a:ext>
            </a:extLst>
          </p:cNvPr>
          <p:cNvSpPr txBox="1"/>
          <p:nvPr/>
        </p:nvSpPr>
        <p:spPr>
          <a:xfrm>
            <a:off x="3202887" y="3500264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*</a:t>
            </a:r>
          </a:p>
        </p:txBody>
      </p:sp>
      <p:sp>
        <p:nvSpPr>
          <p:cNvPr id="198" name="CasellaDiTesto 197">
            <a:extLst>
              <a:ext uri="{FF2B5EF4-FFF2-40B4-BE49-F238E27FC236}">
                <a16:creationId xmlns:a16="http://schemas.microsoft.com/office/drawing/2014/main" id="{FE2C251E-4CA9-93A6-6E46-9B00C8733EFF}"/>
              </a:ext>
            </a:extLst>
          </p:cNvPr>
          <p:cNvSpPr txBox="1"/>
          <p:nvPr/>
        </p:nvSpPr>
        <p:spPr>
          <a:xfrm>
            <a:off x="3517263" y="3405705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***</a:t>
            </a:r>
          </a:p>
        </p:txBody>
      </p:sp>
      <p:sp>
        <p:nvSpPr>
          <p:cNvPr id="199" name="CasellaDiTesto 198">
            <a:extLst>
              <a:ext uri="{FF2B5EF4-FFF2-40B4-BE49-F238E27FC236}">
                <a16:creationId xmlns:a16="http://schemas.microsoft.com/office/drawing/2014/main" id="{26B21501-EC22-0645-E09D-95B478D6B382}"/>
              </a:ext>
            </a:extLst>
          </p:cNvPr>
          <p:cNvSpPr txBox="1"/>
          <p:nvPr/>
        </p:nvSpPr>
        <p:spPr>
          <a:xfrm>
            <a:off x="3645913" y="3558105"/>
            <a:ext cx="2840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**</a:t>
            </a:r>
          </a:p>
          <a:p>
            <a:r>
              <a:rPr lang="it-IT" sz="1000" dirty="0"/>
              <a:t>**</a:t>
            </a:r>
          </a:p>
        </p:txBody>
      </p:sp>
      <p:sp>
        <p:nvSpPr>
          <p:cNvPr id="201" name="CasellaDiTesto 200">
            <a:extLst>
              <a:ext uri="{FF2B5EF4-FFF2-40B4-BE49-F238E27FC236}">
                <a16:creationId xmlns:a16="http://schemas.microsoft.com/office/drawing/2014/main" id="{5CF3A833-D593-3537-E472-F81BE29D4EF1}"/>
              </a:ext>
            </a:extLst>
          </p:cNvPr>
          <p:cNvSpPr txBox="1"/>
          <p:nvPr/>
        </p:nvSpPr>
        <p:spPr>
          <a:xfrm>
            <a:off x="4156194" y="3589376"/>
            <a:ext cx="2840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**</a:t>
            </a:r>
          </a:p>
          <a:p>
            <a:r>
              <a:rPr lang="it-IT" sz="1000" dirty="0"/>
              <a:t>**</a:t>
            </a:r>
          </a:p>
        </p:txBody>
      </p:sp>
      <p:sp>
        <p:nvSpPr>
          <p:cNvPr id="226" name="CasellaDiTesto 225">
            <a:extLst>
              <a:ext uri="{FF2B5EF4-FFF2-40B4-BE49-F238E27FC236}">
                <a16:creationId xmlns:a16="http://schemas.microsoft.com/office/drawing/2014/main" id="{18FCC738-A54E-0ED6-BB35-1DCECC24C960}"/>
              </a:ext>
            </a:extLst>
          </p:cNvPr>
          <p:cNvSpPr txBox="1"/>
          <p:nvPr/>
        </p:nvSpPr>
        <p:spPr>
          <a:xfrm>
            <a:off x="4028335" y="3427731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**</a:t>
            </a:r>
          </a:p>
        </p:txBody>
      </p:sp>
      <p:sp>
        <p:nvSpPr>
          <p:cNvPr id="227" name="CasellaDiTesto 226">
            <a:extLst>
              <a:ext uri="{FF2B5EF4-FFF2-40B4-BE49-F238E27FC236}">
                <a16:creationId xmlns:a16="http://schemas.microsoft.com/office/drawing/2014/main" id="{6A9EC4EA-EC7E-52E8-92F0-BF8AF8128FA0}"/>
              </a:ext>
            </a:extLst>
          </p:cNvPr>
          <p:cNvSpPr txBox="1"/>
          <p:nvPr/>
        </p:nvSpPr>
        <p:spPr>
          <a:xfrm>
            <a:off x="5093499" y="5309527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****</a:t>
            </a:r>
          </a:p>
        </p:txBody>
      </p:sp>
      <p:sp>
        <p:nvSpPr>
          <p:cNvPr id="228" name="CasellaDiTesto 227">
            <a:extLst>
              <a:ext uri="{FF2B5EF4-FFF2-40B4-BE49-F238E27FC236}">
                <a16:creationId xmlns:a16="http://schemas.microsoft.com/office/drawing/2014/main" id="{18A464AD-A5FF-7BBC-B0A8-DC99B1BCC1C1}"/>
              </a:ext>
            </a:extLst>
          </p:cNvPr>
          <p:cNvSpPr txBox="1"/>
          <p:nvPr/>
        </p:nvSpPr>
        <p:spPr>
          <a:xfrm>
            <a:off x="5621523" y="6114677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°°°°</a:t>
            </a:r>
          </a:p>
        </p:txBody>
      </p:sp>
      <p:sp>
        <p:nvSpPr>
          <p:cNvPr id="229" name="CasellaDiTesto 228">
            <a:extLst>
              <a:ext uri="{FF2B5EF4-FFF2-40B4-BE49-F238E27FC236}">
                <a16:creationId xmlns:a16="http://schemas.microsoft.com/office/drawing/2014/main" id="{D3B1F18F-10AF-F582-EA2D-8FE39CBD098F}"/>
              </a:ext>
            </a:extLst>
          </p:cNvPr>
          <p:cNvSpPr txBox="1"/>
          <p:nvPr/>
        </p:nvSpPr>
        <p:spPr>
          <a:xfrm>
            <a:off x="5115307" y="7376906"/>
            <a:ext cx="3834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****</a:t>
            </a:r>
          </a:p>
        </p:txBody>
      </p:sp>
      <p:sp>
        <p:nvSpPr>
          <p:cNvPr id="230" name="CasellaDiTesto 229">
            <a:extLst>
              <a:ext uri="{FF2B5EF4-FFF2-40B4-BE49-F238E27FC236}">
                <a16:creationId xmlns:a16="http://schemas.microsoft.com/office/drawing/2014/main" id="{8BE0EEF2-5CF8-6AFE-8567-AAD97E4B9AC5}"/>
              </a:ext>
            </a:extLst>
          </p:cNvPr>
          <p:cNvSpPr txBox="1"/>
          <p:nvPr/>
        </p:nvSpPr>
        <p:spPr>
          <a:xfrm>
            <a:off x="5643331" y="7973333"/>
            <a:ext cx="397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°°°°</a:t>
            </a:r>
          </a:p>
        </p:txBody>
      </p:sp>
    </p:spTree>
    <p:extLst>
      <p:ext uri="{BB962C8B-B14F-4D97-AF65-F5344CB8AC3E}">
        <p14:creationId xmlns:p14="http://schemas.microsoft.com/office/powerpoint/2010/main" val="7060348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79BF29A4-9A77-43C2-8CF8-380CD9378097}"/>
              </a:ext>
            </a:extLst>
          </p:cNvPr>
          <p:cNvGrpSpPr/>
          <p:nvPr/>
        </p:nvGrpSpPr>
        <p:grpSpPr>
          <a:xfrm>
            <a:off x="681322" y="428766"/>
            <a:ext cx="2518958" cy="3135122"/>
            <a:chOff x="85320" y="611560"/>
            <a:chExt cx="2518958" cy="3135122"/>
          </a:xfrm>
        </p:grpSpPr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24113030-64BA-4170-936F-84C4B6371B8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17441" y="1695841"/>
              <a:ext cx="1820643" cy="1260000"/>
            </a:xfrm>
            <a:prstGeom prst="rect">
              <a:avLst/>
            </a:prstGeom>
          </p:spPr>
        </p:pic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69249F7E-59C4-480B-9F2F-38680BD52BF1}"/>
                </a:ext>
              </a:extLst>
            </p:cNvPr>
            <p:cNvSpPr txBox="1"/>
            <p:nvPr/>
          </p:nvSpPr>
          <p:spPr>
            <a:xfrm rot="16200000">
              <a:off x="-292347" y="2075035"/>
              <a:ext cx="121700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FOXA1 </a:t>
              </a:r>
              <a:r>
                <a:rPr lang="it-IT" sz="1200" dirty="0" err="1"/>
                <a:t>Levels</a:t>
              </a:r>
              <a:endParaRPr lang="it-IT" sz="1200" dirty="0"/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CTR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DC6DDC4D-7A12-41BB-A98F-DB1A71F514D0}"/>
                </a:ext>
              </a:extLst>
            </p:cNvPr>
            <p:cNvSpPr txBox="1"/>
            <p:nvPr/>
          </p:nvSpPr>
          <p:spPr>
            <a:xfrm>
              <a:off x="414616" y="1578098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2</a:t>
              </a:r>
            </a:p>
          </p:txBody>
        </p:sp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4D5066DA-1577-4E43-966A-CA94809FFB50}"/>
                </a:ext>
              </a:extLst>
            </p:cNvPr>
            <p:cNvSpPr txBox="1"/>
            <p:nvPr/>
          </p:nvSpPr>
          <p:spPr>
            <a:xfrm>
              <a:off x="414616" y="216941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6</a:t>
              </a:r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0A9C8B70-1DC0-4D8E-9741-68876777B6BF}"/>
                </a:ext>
              </a:extLst>
            </p:cNvPr>
            <p:cNvSpPr txBox="1"/>
            <p:nvPr/>
          </p:nvSpPr>
          <p:spPr>
            <a:xfrm>
              <a:off x="414616" y="277068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720AE546-D4F1-496F-872E-47B776822887}"/>
                </a:ext>
              </a:extLst>
            </p:cNvPr>
            <p:cNvSpPr txBox="1"/>
            <p:nvPr/>
          </p:nvSpPr>
          <p:spPr>
            <a:xfrm rot="16200000">
              <a:off x="1957517" y="3186432"/>
              <a:ext cx="8435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si-FOXA1</a:t>
              </a:r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1305C0EF-1BAE-46E6-ADA8-283FE5A8357E}"/>
                </a:ext>
              </a:extLst>
            </p:cNvPr>
            <p:cNvSpPr txBox="1"/>
            <p:nvPr/>
          </p:nvSpPr>
          <p:spPr>
            <a:xfrm>
              <a:off x="2241678" y="1979465"/>
              <a:ext cx="36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*</a:t>
              </a: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DBC0E799-4484-4BB2-970D-A8FFD1E82367}"/>
                </a:ext>
              </a:extLst>
            </p:cNvPr>
            <p:cNvSpPr txBox="1"/>
            <p:nvPr/>
          </p:nvSpPr>
          <p:spPr>
            <a:xfrm>
              <a:off x="1387646" y="1845301"/>
              <a:ext cx="3032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A9B4F47D-D18F-4873-81B4-DD10B5C2A93F}"/>
                </a:ext>
              </a:extLst>
            </p:cNvPr>
            <p:cNvSpPr txBox="1"/>
            <p:nvPr/>
          </p:nvSpPr>
          <p:spPr>
            <a:xfrm>
              <a:off x="1606963" y="1868172"/>
              <a:ext cx="24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987EC4C4-A88E-4A35-9E27-109E48EFA864}"/>
                </a:ext>
              </a:extLst>
            </p:cNvPr>
            <p:cNvSpPr txBox="1"/>
            <p:nvPr/>
          </p:nvSpPr>
          <p:spPr>
            <a:xfrm rot="16200000">
              <a:off x="1290833" y="3010903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NVP</a:t>
              </a: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24676B1B-A884-406F-AF3D-42AF74632969}"/>
                </a:ext>
              </a:extLst>
            </p:cNvPr>
            <p:cNvSpPr txBox="1"/>
            <p:nvPr/>
          </p:nvSpPr>
          <p:spPr>
            <a:xfrm rot="16200000">
              <a:off x="1524507" y="2982402"/>
              <a:ext cx="4354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Tric</a:t>
              </a: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E7078F6E-41F1-405D-B553-206C9D983531}"/>
                </a:ext>
              </a:extLst>
            </p:cNvPr>
            <p:cNvSpPr txBox="1"/>
            <p:nvPr/>
          </p:nvSpPr>
          <p:spPr>
            <a:xfrm rot="16200000">
              <a:off x="643216" y="3014911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CTR</a:t>
              </a:r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572CA6AF-6151-411B-B0A8-FFD3F8615099}"/>
                </a:ext>
              </a:extLst>
            </p:cNvPr>
            <p:cNvSpPr txBox="1"/>
            <p:nvPr/>
          </p:nvSpPr>
          <p:spPr>
            <a:xfrm rot="16200000">
              <a:off x="1753433" y="2963615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PD</a:t>
              </a:r>
            </a:p>
          </p:txBody>
        </p: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DFA68455-3E95-48F9-A6FE-91E7A0C44F7B}"/>
                </a:ext>
              </a:extLst>
            </p:cNvPr>
            <p:cNvSpPr txBox="1"/>
            <p:nvPr/>
          </p:nvSpPr>
          <p:spPr>
            <a:xfrm rot="16200000">
              <a:off x="1955586" y="2950791"/>
              <a:ext cx="3722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Kg</a:t>
              </a:r>
            </a:p>
          </p:txBody>
        </p: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4B8BFA68-2CE1-4B6B-AF74-F97EB2E1D9D2}"/>
                </a:ext>
              </a:extLst>
            </p:cNvPr>
            <p:cNvSpPr txBox="1"/>
            <p:nvPr/>
          </p:nvSpPr>
          <p:spPr>
            <a:xfrm rot="16200000">
              <a:off x="755543" y="3121510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AG-879</a:t>
              </a:r>
            </a:p>
          </p:txBody>
        </p: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452FFEC8-8394-4F3E-830E-ECB802E7C123}"/>
                </a:ext>
              </a:extLst>
            </p:cNvPr>
            <p:cNvSpPr txBox="1"/>
            <p:nvPr/>
          </p:nvSpPr>
          <p:spPr>
            <a:xfrm rot="16200000">
              <a:off x="976099" y="3121510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AG-825</a:t>
              </a:r>
            </a:p>
          </p:txBody>
        </p:sp>
        <p:grpSp>
          <p:nvGrpSpPr>
            <p:cNvPr id="19" name="Gruppo 18">
              <a:extLst>
                <a:ext uri="{FF2B5EF4-FFF2-40B4-BE49-F238E27FC236}">
                  <a16:creationId xmlns:a16="http://schemas.microsoft.com/office/drawing/2014/main" id="{F56CED00-19E0-47D8-930A-63D27825BD6A}"/>
                </a:ext>
              </a:extLst>
            </p:cNvPr>
            <p:cNvGrpSpPr/>
            <p:nvPr/>
          </p:nvGrpSpPr>
          <p:grpSpPr>
            <a:xfrm>
              <a:off x="828884" y="611560"/>
              <a:ext cx="1285085" cy="1247392"/>
              <a:chOff x="717766" y="2915816"/>
              <a:chExt cx="1285085" cy="1247392"/>
            </a:xfrm>
          </p:grpSpPr>
          <p:sp>
            <p:nvSpPr>
              <p:cNvPr id="20" name="CasellaDiTesto 19">
                <a:extLst>
                  <a:ext uri="{FF2B5EF4-FFF2-40B4-BE49-F238E27FC236}">
                    <a16:creationId xmlns:a16="http://schemas.microsoft.com/office/drawing/2014/main" id="{A5E76571-DEF3-417F-8022-3D35E29FD3E9}"/>
                  </a:ext>
                </a:extLst>
              </p:cNvPr>
              <p:cNvSpPr txBox="1"/>
              <p:nvPr/>
            </p:nvSpPr>
            <p:spPr>
              <a:xfrm rot="16200000">
                <a:off x="738798" y="3203074"/>
                <a:ext cx="85151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si-FOXA1</a:t>
                </a:r>
              </a:p>
            </p:txBody>
          </p:sp>
          <p:sp>
            <p:nvSpPr>
              <p:cNvPr id="21" name="CasellaDiTesto 20">
                <a:extLst>
                  <a:ext uri="{FF2B5EF4-FFF2-40B4-BE49-F238E27FC236}">
                    <a16:creationId xmlns:a16="http://schemas.microsoft.com/office/drawing/2014/main" id="{76FA0EA6-8CEE-4128-A4FE-B2A0D8F48713}"/>
                  </a:ext>
                </a:extLst>
              </p:cNvPr>
              <p:cNvSpPr txBox="1"/>
              <p:nvPr/>
            </p:nvSpPr>
            <p:spPr>
              <a:xfrm rot="16200000">
                <a:off x="606037" y="3378602"/>
                <a:ext cx="5004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CTR</a:t>
                </a:r>
              </a:p>
            </p:txBody>
          </p:sp>
          <p:sp>
            <p:nvSpPr>
              <p:cNvPr id="22" name="CasellaDiTesto 21">
                <a:extLst>
                  <a:ext uri="{FF2B5EF4-FFF2-40B4-BE49-F238E27FC236}">
                    <a16:creationId xmlns:a16="http://schemas.microsoft.com/office/drawing/2014/main" id="{4620D002-9B6A-4C73-AF44-ADAEC613211B}"/>
                  </a:ext>
                </a:extLst>
              </p:cNvPr>
              <p:cNvSpPr txBox="1"/>
              <p:nvPr/>
            </p:nvSpPr>
            <p:spPr>
              <a:xfrm>
                <a:off x="1285539" y="3886209"/>
                <a:ext cx="7173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err="1"/>
                  <a:t>Vinculin</a:t>
                </a:r>
                <a:endParaRPr lang="it-IT" sz="1200" dirty="0"/>
              </a:p>
            </p:txBody>
          </p:sp>
          <p:sp>
            <p:nvSpPr>
              <p:cNvPr id="23" name="CasellaDiTesto 22">
                <a:extLst>
                  <a:ext uri="{FF2B5EF4-FFF2-40B4-BE49-F238E27FC236}">
                    <a16:creationId xmlns:a16="http://schemas.microsoft.com/office/drawing/2014/main" id="{AEE7D0E3-A1AE-4391-A93C-36493A8CAE57}"/>
                  </a:ext>
                </a:extLst>
              </p:cNvPr>
              <p:cNvSpPr txBox="1"/>
              <p:nvPr/>
            </p:nvSpPr>
            <p:spPr>
              <a:xfrm>
                <a:off x="1284990" y="3681960"/>
                <a:ext cx="6896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FOXA1</a:t>
                </a:r>
              </a:p>
            </p:txBody>
          </p:sp>
          <p:pic>
            <p:nvPicPr>
              <p:cNvPr id="24" name="Immagine 23">
                <a:extLst>
                  <a:ext uri="{FF2B5EF4-FFF2-40B4-BE49-F238E27FC236}">
                    <a16:creationId xmlns:a16="http://schemas.microsoft.com/office/drawing/2014/main" id="{E2ADDA44-A11B-4CFD-9500-3996AC8265A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732610" y="3737019"/>
                <a:ext cx="540000" cy="16688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5" name="Immagine 24">
                <a:extLst>
                  <a:ext uri="{FF2B5EF4-FFF2-40B4-BE49-F238E27FC236}">
                    <a16:creationId xmlns:a16="http://schemas.microsoft.com/office/drawing/2014/main" id="{A17BF55B-DC68-41BB-ACAE-EAD2EFB732A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732610" y="3941268"/>
                <a:ext cx="540000" cy="16688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</p:grpSp>
      <p:grpSp>
        <p:nvGrpSpPr>
          <p:cNvPr id="26" name="Gruppo 25">
            <a:extLst>
              <a:ext uri="{FF2B5EF4-FFF2-40B4-BE49-F238E27FC236}">
                <a16:creationId xmlns:a16="http://schemas.microsoft.com/office/drawing/2014/main" id="{E39CF939-00E1-4278-9E9C-B77A1AF487B0}"/>
              </a:ext>
            </a:extLst>
          </p:cNvPr>
          <p:cNvGrpSpPr/>
          <p:nvPr/>
        </p:nvGrpSpPr>
        <p:grpSpPr>
          <a:xfrm>
            <a:off x="3894517" y="889116"/>
            <a:ext cx="1766731" cy="1954692"/>
            <a:chOff x="4974637" y="802957"/>
            <a:chExt cx="1766731" cy="1954692"/>
          </a:xfrm>
        </p:grpSpPr>
        <p:pic>
          <p:nvPicPr>
            <p:cNvPr id="27" name="Immagine 26">
              <a:extLst>
                <a:ext uri="{FF2B5EF4-FFF2-40B4-BE49-F238E27FC236}">
                  <a16:creationId xmlns:a16="http://schemas.microsoft.com/office/drawing/2014/main" id="{2626B503-4B49-484D-BF4A-9C00AD03012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618373" y="1077187"/>
              <a:ext cx="1122995" cy="1260000"/>
            </a:xfrm>
            <a:prstGeom prst="rect">
              <a:avLst/>
            </a:prstGeom>
          </p:spPr>
        </p:pic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id="{2FF1220E-BCD6-4F5D-B8A5-425CF4F1E8CD}"/>
                </a:ext>
              </a:extLst>
            </p:cNvPr>
            <p:cNvSpPr txBox="1"/>
            <p:nvPr/>
          </p:nvSpPr>
          <p:spPr>
            <a:xfrm rot="16200000">
              <a:off x="4323658" y="1453936"/>
              <a:ext cx="176362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ESR1-promoter activity</a:t>
              </a:r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CTR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29" name="CasellaDiTesto 28">
              <a:extLst>
                <a:ext uri="{FF2B5EF4-FFF2-40B4-BE49-F238E27FC236}">
                  <a16:creationId xmlns:a16="http://schemas.microsoft.com/office/drawing/2014/main" id="{5A719318-5AC9-46FD-84C6-E42B8B50F1C9}"/>
                </a:ext>
              </a:extLst>
            </p:cNvPr>
            <p:cNvSpPr txBox="1"/>
            <p:nvPr/>
          </p:nvSpPr>
          <p:spPr>
            <a:xfrm>
              <a:off x="5303935" y="95944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2</a:t>
              </a:r>
            </a:p>
          </p:txBody>
        </p:sp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id="{8C841988-523D-49AE-AA63-A922D59AC834}"/>
                </a:ext>
              </a:extLst>
            </p:cNvPr>
            <p:cNvSpPr txBox="1"/>
            <p:nvPr/>
          </p:nvSpPr>
          <p:spPr>
            <a:xfrm>
              <a:off x="5303935" y="1550763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6</a:t>
              </a:r>
            </a:p>
          </p:txBody>
        </p:sp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id="{8D15FBBE-A98E-4C23-B5C3-37F999FAA3AA}"/>
                </a:ext>
              </a:extLst>
            </p:cNvPr>
            <p:cNvSpPr txBox="1"/>
            <p:nvPr/>
          </p:nvSpPr>
          <p:spPr>
            <a:xfrm>
              <a:off x="5303935" y="2152033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32" name="CasellaDiTesto 31">
              <a:extLst>
                <a:ext uri="{FF2B5EF4-FFF2-40B4-BE49-F238E27FC236}">
                  <a16:creationId xmlns:a16="http://schemas.microsoft.com/office/drawing/2014/main" id="{D45E1F19-07AD-410F-BC91-0DD6283DB572}"/>
                </a:ext>
              </a:extLst>
            </p:cNvPr>
            <p:cNvSpPr txBox="1"/>
            <p:nvPr/>
          </p:nvSpPr>
          <p:spPr>
            <a:xfrm rot="16200000">
              <a:off x="6074353" y="2364913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NVP</a:t>
              </a:r>
            </a:p>
          </p:txBody>
        </p: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id="{DC7AD6B5-C5DB-4135-BCDF-2DBD17535FFA}"/>
                </a:ext>
              </a:extLst>
            </p:cNvPr>
            <p:cNvSpPr txBox="1"/>
            <p:nvPr/>
          </p:nvSpPr>
          <p:spPr>
            <a:xfrm rot="16200000">
              <a:off x="5861195" y="2336411"/>
              <a:ext cx="4354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Tric</a:t>
              </a:r>
            </a:p>
          </p:txBody>
        </p:sp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id="{D5CDF359-0CBD-4644-84C8-951086287344}"/>
                </a:ext>
              </a:extLst>
            </p:cNvPr>
            <p:cNvSpPr txBox="1"/>
            <p:nvPr/>
          </p:nvSpPr>
          <p:spPr>
            <a:xfrm rot="16200000">
              <a:off x="5590072" y="2368920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CTR</a:t>
              </a:r>
            </a:p>
          </p:txBody>
        </p:sp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id="{25998730-B131-42CD-94D4-982B837E3DD6}"/>
                </a:ext>
              </a:extLst>
            </p:cNvPr>
            <p:cNvSpPr txBox="1"/>
            <p:nvPr/>
          </p:nvSpPr>
          <p:spPr>
            <a:xfrm>
              <a:off x="5909935" y="1215927"/>
              <a:ext cx="30328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</a:t>
              </a:r>
            </a:p>
            <a:p>
              <a:r>
                <a:rPr lang="it-IT" sz="1200" dirty="0"/>
                <a:t>**</a:t>
              </a:r>
            </a:p>
          </p:txBody>
        </p:sp>
        <p:sp>
          <p:nvSpPr>
            <p:cNvPr id="36" name="CasellaDiTesto 35">
              <a:extLst>
                <a:ext uri="{FF2B5EF4-FFF2-40B4-BE49-F238E27FC236}">
                  <a16:creationId xmlns:a16="http://schemas.microsoft.com/office/drawing/2014/main" id="{2A4E6340-9047-48BD-8BA1-398817C13C68}"/>
                </a:ext>
              </a:extLst>
            </p:cNvPr>
            <p:cNvSpPr txBox="1"/>
            <p:nvPr/>
          </p:nvSpPr>
          <p:spPr>
            <a:xfrm>
              <a:off x="6138535" y="1368327"/>
              <a:ext cx="30328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</a:t>
              </a:r>
            </a:p>
            <a:p>
              <a:r>
                <a:rPr lang="it-IT" sz="1200" dirty="0"/>
                <a:t>**</a:t>
              </a:r>
            </a:p>
          </p:txBody>
        </p:sp>
        <p:sp>
          <p:nvSpPr>
            <p:cNvPr id="37" name="CasellaDiTesto 36">
              <a:extLst>
                <a:ext uri="{FF2B5EF4-FFF2-40B4-BE49-F238E27FC236}">
                  <a16:creationId xmlns:a16="http://schemas.microsoft.com/office/drawing/2014/main" id="{EAE95D58-72C1-43DF-A5E9-898A50AD82D7}"/>
                </a:ext>
              </a:extLst>
            </p:cNvPr>
            <p:cNvSpPr txBox="1"/>
            <p:nvPr/>
          </p:nvSpPr>
          <p:spPr>
            <a:xfrm rot="16200000">
              <a:off x="6326167" y="2364913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PPP</a:t>
              </a:r>
            </a:p>
          </p:txBody>
        </p:sp>
        <p:sp>
          <p:nvSpPr>
            <p:cNvPr id="38" name="CasellaDiTesto 37">
              <a:extLst>
                <a:ext uri="{FF2B5EF4-FFF2-40B4-BE49-F238E27FC236}">
                  <a16:creationId xmlns:a16="http://schemas.microsoft.com/office/drawing/2014/main" id="{019464BD-A4C2-4DEB-B5A8-69C3D626AEF8}"/>
                </a:ext>
              </a:extLst>
            </p:cNvPr>
            <p:cNvSpPr txBox="1"/>
            <p:nvPr/>
          </p:nvSpPr>
          <p:spPr>
            <a:xfrm>
              <a:off x="6425447" y="1520727"/>
              <a:ext cx="30328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</a:t>
              </a:r>
            </a:p>
            <a:p>
              <a:r>
                <a:rPr lang="it-IT" sz="1200" dirty="0"/>
                <a:t>**</a:t>
              </a:r>
            </a:p>
          </p:txBody>
        </p:sp>
      </p:grp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8A01E6F1-0440-4ED6-B837-21F248CD0B8D}"/>
              </a:ext>
            </a:extLst>
          </p:cNvPr>
          <p:cNvSpPr txBox="1"/>
          <p:nvPr/>
        </p:nvSpPr>
        <p:spPr>
          <a:xfrm>
            <a:off x="440518" y="437347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a)</a:t>
            </a: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88E0AE6A-D758-4B38-925D-58E303D2D885}"/>
              </a:ext>
            </a:extLst>
          </p:cNvPr>
          <p:cNvSpPr txBox="1"/>
          <p:nvPr/>
        </p:nvSpPr>
        <p:spPr>
          <a:xfrm>
            <a:off x="3511272" y="437347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b)</a:t>
            </a:r>
          </a:p>
        </p:txBody>
      </p:sp>
      <p:sp>
        <p:nvSpPr>
          <p:cNvPr id="92" name="CasellaDiTesto 91">
            <a:extLst>
              <a:ext uri="{FF2B5EF4-FFF2-40B4-BE49-F238E27FC236}">
                <a16:creationId xmlns:a16="http://schemas.microsoft.com/office/drawing/2014/main" id="{E9CF0909-687C-4E54-9BB8-8832A3B56B91}"/>
              </a:ext>
            </a:extLst>
          </p:cNvPr>
          <p:cNvSpPr txBox="1"/>
          <p:nvPr/>
        </p:nvSpPr>
        <p:spPr>
          <a:xfrm>
            <a:off x="440518" y="6457069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d)</a:t>
            </a:r>
          </a:p>
        </p:txBody>
      </p:sp>
      <p:sp>
        <p:nvSpPr>
          <p:cNvPr id="119" name="CasellaDiTesto 118">
            <a:extLst>
              <a:ext uri="{FF2B5EF4-FFF2-40B4-BE49-F238E27FC236}">
                <a16:creationId xmlns:a16="http://schemas.microsoft.com/office/drawing/2014/main" id="{C92280B0-FF3A-453F-8913-6416D71F08B0}"/>
              </a:ext>
            </a:extLst>
          </p:cNvPr>
          <p:cNvSpPr txBox="1"/>
          <p:nvPr/>
        </p:nvSpPr>
        <p:spPr>
          <a:xfrm>
            <a:off x="444526" y="3544407"/>
            <a:ext cx="34176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it-IT" sz="1000" b="1" dirty="0"/>
              <a:t>(c)</a:t>
            </a:r>
          </a:p>
        </p:txBody>
      </p:sp>
      <p:grpSp>
        <p:nvGrpSpPr>
          <p:cNvPr id="120" name="Gruppo 119">
            <a:extLst>
              <a:ext uri="{FF2B5EF4-FFF2-40B4-BE49-F238E27FC236}">
                <a16:creationId xmlns:a16="http://schemas.microsoft.com/office/drawing/2014/main" id="{6F93F66D-1ED6-4A72-B1C0-B713F6244D97}"/>
              </a:ext>
            </a:extLst>
          </p:cNvPr>
          <p:cNvGrpSpPr/>
          <p:nvPr/>
        </p:nvGrpSpPr>
        <p:grpSpPr>
          <a:xfrm>
            <a:off x="785141" y="3489817"/>
            <a:ext cx="1206676" cy="1982258"/>
            <a:chOff x="1601706" y="3349780"/>
            <a:chExt cx="1206676" cy="1982258"/>
          </a:xfrm>
        </p:grpSpPr>
        <p:sp>
          <p:nvSpPr>
            <p:cNvPr id="121" name="CasellaDiTesto 120">
              <a:extLst>
                <a:ext uri="{FF2B5EF4-FFF2-40B4-BE49-F238E27FC236}">
                  <a16:creationId xmlns:a16="http://schemas.microsoft.com/office/drawing/2014/main" id="{B5628D7D-FA2E-4A7B-AF47-66F883456C9D}"/>
                </a:ext>
              </a:extLst>
            </p:cNvPr>
            <p:cNvSpPr txBox="1"/>
            <p:nvPr/>
          </p:nvSpPr>
          <p:spPr>
            <a:xfrm>
              <a:off x="2176478" y="4957564"/>
              <a:ext cx="43633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ER</a:t>
              </a:r>
              <a:r>
                <a:rPr lang="el-GR" sz="1000" dirty="0">
                  <a:latin typeface="+mn-lt"/>
                  <a:cs typeface="Times New Roman" panose="02020603050405020304" pitchFamily="18" charset="0"/>
                </a:rPr>
                <a:t>α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122" name="CasellaDiTesto 121">
              <a:extLst>
                <a:ext uri="{FF2B5EF4-FFF2-40B4-BE49-F238E27FC236}">
                  <a16:creationId xmlns:a16="http://schemas.microsoft.com/office/drawing/2014/main" id="{B3F58DE2-6AC1-485B-B2E9-078DCE0977B1}"/>
                </a:ext>
              </a:extLst>
            </p:cNvPr>
            <p:cNvSpPr txBox="1"/>
            <p:nvPr/>
          </p:nvSpPr>
          <p:spPr>
            <a:xfrm>
              <a:off x="2176478" y="5085817"/>
              <a:ext cx="63190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Vinculin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123" name="CasellaDiTesto 122">
              <a:extLst>
                <a:ext uri="{FF2B5EF4-FFF2-40B4-BE49-F238E27FC236}">
                  <a16:creationId xmlns:a16="http://schemas.microsoft.com/office/drawing/2014/main" id="{783ACCBC-032F-4B9B-9973-8C3977231EB5}"/>
                </a:ext>
              </a:extLst>
            </p:cNvPr>
            <p:cNvSpPr txBox="1"/>
            <p:nvPr/>
          </p:nvSpPr>
          <p:spPr>
            <a:xfrm>
              <a:off x="2176478" y="4835815"/>
              <a:ext cx="60305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FOXA1</a:t>
              </a:r>
            </a:p>
          </p:txBody>
        </p:sp>
        <p:sp>
          <p:nvSpPr>
            <p:cNvPr id="124" name="CasellaDiTesto 123">
              <a:extLst>
                <a:ext uri="{FF2B5EF4-FFF2-40B4-BE49-F238E27FC236}">
                  <a16:creationId xmlns:a16="http://schemas.microsoft.com/office/drawing/2014/main" id="{EFE13FCF-C8E7-434E-A14D-707151F2C8C3}"/>
                </a:ext>
              </a:extLst>
            </p:cNvPr>
            <p:cNvSpPr txBox="1"/>
            <p:nvPr/>
          </p:nvSpPr>
          <p:spPr>
            <a:xfrm>
              <a:off x="2176478" y="4584032"/>
              <a:ext cx="433132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AKT</a:t>
              </a:r>
            </a:p>
          </p:txBody>
        </p:sp>
        <p:sp>
          <p:nvSpPr>
            <p:cNvPr id="125" name="CasellaDiTesto 124">
              <a:extLst>
                <a:ext uri="{FF2B5EF4-FFF2-40B4-BE49-F238E27FC236}">
                  <a16:creationId xmlns:a16="http://schemas.microsoft.com/office/drawing/2014/main" id="{8F276876-1880-4838-B2EC-39D739C2F1E0}"/>
                </a:ext>
              </a:extLst>
            </p:cNvPr>
            <p:cNvSpPr txBox="1"/>
            <p:nvPr/>
          </p:nvSpPr>
          <p:spPr>
            <a:xfrm>
              <a:off x="2176478" y="4709520"/>
              <a:ext cx="604653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IGF1-R</a:t>
              </a:r>
            </a:p>
          </p:txBody>
        </p:sp>
        <p:sp>
          <p:nvSpPr>
            <p:cNvPr id="126" name="CasellaDiTesto 125">
              <a:extLst>
                <a:ext uri="{FF2B5EF4-FFF2-40B4-BE49-F238E27FC236}">
                  <a16:creationId xmlns:a16="http://schemas.microsoft.com/office/drawing/2014/main" id="{0D203BCE-4839-473E-A5CE-AB1C75748440}"/>
                </a:ext>
              </a:extLst>
            </p:cNvPr>
            <p:cNvSpPr txBox="1"/>
            <p:nvPr/>
          </p:nvSpPr>
          <p:spPr>
            <a:xfrm>
              <a:off x="2176478" y="4447814"/>
              <a:ext cx="50366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pAKT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127" name="CasellaDiTesto 126">
              <a:extLst>
                <a:ext uri="{FF2B5EF4-FFF2-40B4-BE49-F238E27FC236}">
                  <a16:creationId xmlns:a16="http://schemas.microsoft.com/office/drawing/2014/main" id="{4041220B-276C-4457-AA94-377C700D1D36}"/>
                </a:ext>
              </a:extLst>
            </p:cNvPr>
            <p:cNvSpPr txBox="1"/>
            <p:nvPr/>
          </p:nvSpPr>
          <p:spPr>
            <a:xfrm rot="16200000">
              <a:off x="1461715" y="3817597"/>
              <a:ext cx="1212634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it-IT" sz="1200" dirty="0" err="1">
                  <a:latin typeface="+mn-lt"/>
                </a:rPr>
                <a:t>siRNA</a:t>
              </a:r>
              <a:r>
                <a:rPr lang="it-IT" sz="1200" dirty="0">
                  <a:latin typeface="+mn-lt"/>
                </a:rPr>
                <a:t> FOXA1</a:t>
              </a:r>
            </a:p>
          </p:txBody>
        </p:sp>
        <p:sp>
          <p:nvSpPr>
            <p:cNvPr id="128" name="CasellaDiTesto 127">
              <a:extLst>
                <a:ext uri="{FF2B5EF4-FFF2-40B4-BE49-F238E27FC236}">
                  <a16:creationId xmlns:a16="http://schemas.microsoft.com/office/drawing/2014/main" id="{5AF75563-27BA-47C9-B7E1-988197B71B5E}"/>
                </a:ext>
              </a:extLst>
            </p:cNvPr>
            <p:cNvSpPr txBox="1"/>
            <p:nvPr/>
          </p:nvSpPr>
          <p:spPr>
            <a:xfrm rot="16200000">
              <a:off x="1483508" y="4167217"/>
              <a:ext cx="513395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it-IT" sz="1200" dirty="0">
                  <a:latin typeface="+mn-lt"/>
                </a:rPr>
                <a:t>CTR</a:t>
              </a:r>
            </a:p>
          </p:txBody>
        </p:sp>
        <p:pic>
          <p:nvPicPr>
            <p:cNvPr id="129" name="Immagine 128">
              <a:extLst>
                <a:ext uri="{FF2B5EF4-FFF2-40B4-BE49-F238E27FC236}">
                  <a16:creationId xmlns:a16="http://schemas.microsoft.com/office/drawing/2014/main" id="{13540AE9-9A8F-4C53-9954-A4017140FED0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639512" y="4539585"/>
              <a:ext cx="518400" cy="8582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0" name="Immagine 129">
              <a:extLst>
                <a:ext uri="{FF2B5EF4-FFF2-40B4-BE49-F238E27FC236}">
                  <a16:creationId xmlns:a16="http://schemas.microsoft.com/office/drawing/2014/main" id="{B7356E3C-CC90-4318-B591-6B0D4B7D046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639512" y="4664228"/>
              <a:ext cx="518400" cy="8582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1" name="Immagine 130">
              <a:extLst>
                <a:ext uri="{FF2B5EF4-FFF2-40B4-BE49-F238E27FC236}">
                  <a16:creationId xmlns:a16="http://schemas.microsoft.com/office/drawing/2014/main" id="{40525933-21C9-484D-89A9-8AB6E381D1F5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639512" y="4789716"/>
              <a:ext cx="518400" cy="8582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2" name="Immagine 131">
              <a:extLst>
                <a:ext uri="{FF2B5EF4-FFF2-40B4-BE49-F238E27FC236}">
                  <a16:creationId xmlns:a16="http://schemas.microsoft.com/office/drawing/2014/main" id="{78A03315-883A-4D3D-B540-FE1498435386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639512" y="4916011"/>
              <a:ext cx="518400" cy="8582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3" name="Immagine 132">
              <a:extLst>
                <a:ext uri="{FF2B5EF4-FFF2-40B4-BE49-F238E27FC236}">
                  <a16:creationId xmlns:a16="http://schemas.microsoft.com/office/drawing/2014/main" id="{46AB9EBA-9BD2-4DA6-8FDC-DE030BE56E2E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639512" y="5037760"/>
              <a:ext cx="518400" cy="8582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4" name="Immagine 133">
              <a:extLst>
                <a:ext uri="{FF2B5EF4-FFF2-40B4-BE49-F238E27FC236}">
                  <a16:creationId xmlns:a16="http://schemas.microsoft.com/office/drawing/2014/main" id="{0E0A67DC-A042-430A-AF07-4DE1AA433D07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639512" y="5166013"/>
              <a:ext cx="518400" cy="8582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153" name="Gruppo 152">
            <a:extLst>
              <a:ext uri="{FF2B5EF4-FFF2-40B4-BE49-F238E27FC236}">
                <a16:creationId xmlns:a16="http://schemas.microsoft.com/office/drawing/2014/main" id="{F8F4CA2B-8B03-48C6-BDD3-51D135701CE1}"/>
              </a:ext>
            </a:extLst>
          </p:cNvPr>
          <p:cNvGrpSpPr/>
          <p:nvPr/>
        </p:nvGrpSpPr>
        <p:grpSpPr>
          <a:xfrm>
            <a:off x="2383515" y="4152571"/>
            <a:ext cx="1765565" cy="1683742"/>
            <a:chOff x="476792" y="6304875"/>
            <a:chExt cx="1765565" cy="1683742"/>
          </a:xfrm>
        </p:grpSpPr>
        <p:sp>
          <p:nvSpPr>
            <p:cNvPr id="154" name="CasellaDiTesto 153">
              <a:extLst>
                <a:ext uri="{FF2B5EF4-FFF2-40B4-BE49-F238E27FC236}">
                  <a16:creationId xmlns:a16="http://schemas.microsoft.com/office/drawing/2014/main" id="{E37A8507-11DD-4690-A959-1C9142EF181E}"/>
                </a:ext>
              </a:extLst>
            </p:cNvPr>
            <p:cNvSpPr txBox="1"/>
            <p:nvPr/>
          </p:nvSpPr>
          <p:spPr>
            <a:xfrm>
              <a:off x="489929" y="630487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155" name="CasellaDiTesto 154">
              <a:extLst>
                <a:ext uri="{FF2B5EF4-FFF2-40B4-BE49-F238E27FC236}">
                  <a16:creationId xmlns:a16="http://schemas.microsoft.com/office/drawing/2014/main" id="{F01C96C0-60F6-478A-B4D2-28470828AA26}"/>
                </a:ext>
              </a:extLst>
            </p:cNvPr>
            <p:cNvSpPr txBox="1"/>
            <p:nvPr/>
          </p:nvSpPr>
          <p:spPr>
            <a:xfrm>
              <a:off x="668793" y="6304875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.1</a:t>
              </a:r>
            </a:p>
          </p:txBody>
        </p:sp>
        <p:sp>
          <p:nvSpPr>
            <p:cNvPr id="156" name="CasellaDiTesto 155">
              <a:extLst>
                <a:ext uri="{FF2B5EF4-FFF2-40B4-BE49-F238E27FC236}">
                  <a16:creationId xmlns:a16="http://schemas.microsoft.com/office/drawing/2014/main" id="{D57AEFE4-FFC6-44BA-9E9F-A684518ABD24}"/>
                </a:ext>
              </a:extLst>
            </p:cNvPr>
            <p:cNvSpPr txBox="1"/>
            <p:nvPr/>
          </p:nvSpPr>
          <p:spPr>
            <a:xfrm>
              <a:off x="937916" y="6304875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.5</a:t>
              </a:r>
            </a:p>
          </p:txBody>
        </p:sp>
        <p:sp>
          <p:nvSpPr>
            <p:cNvPr id="157" name="CasellaDiTesto 156">
              <a:extLst>
                <a:ext uri="{FF2B5EF4-FFF2-40B4-BE49-F238E27FC236}">
                  <a16:creationId xmlns:a16="http://schemas.microsoft.com/office/drawing/2014/main" id="{0479D374-375D-45D8-ADB6-7A14B32314DE}"/>
                </a:ext>
              </a:extLst>
            </p:cNvPr>
            <p:cNvSpPr txBox="1"/>
            <p:nvPr/>
          </p:nvSpPr>
          <p:spPr>
            <a:xfrm>
              <a:off x="1222687" y="6304875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.0</a:t>
              </a:r>
            </a:p>
          </p:txBody>
        </p:sp>
        <p:sp>
          <p:nvSpPr>
            <p:cNvPr id="158" name="CasellaDiTesto 157">
              <a:extLst>
                <a:ext uri="{FF2B5EF4-FFF2-40B4-BE49-F238E27FC236}">
                  <a16:creationId xmlns:a16="http://schemas.microsoft.com/office/drawing/2014/main" id="{1B056BF2-E187-4D27-B6E1-0F97DC09C3FA}"/>
                </a:ext>
              </a:extLst>
            </p:cNvPr>
            <p:cNvSpPr txBox="1"/>
            <p:nvPr/>
          </p:nvSpPr>
          <p:spPr>
            <a:xfrm>
              <a:off x="1491831" y="6304875"/>
              <a:ext cx="7505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NVP (µM)</a:t>
              </a:r>
            </a:p>
          </p:txBody>
        </p:sp>
        <p:sp>
          <p:nvSpPr>
            <p:cNvPr id="159" name="CasellaDiTesto 158">
              <a:extLst>
                <a:ext uri="{FF2B5EF4-FFF2-40B4-BE49-F238E27FC236}">
                  <a16:creationId xmlns:a16="http://schemas.microsoft.com/office/drawing/2014/main" id="{48F356A9-69E6-415B-A54E-06CA0B040C08}"/>
                </a:ext>
              </a:extLst>
            </p:cNvPr>
            <p:cNvSpPr txBox="1"/>
            <p:nvPr/>
          </p:nvSpPr>
          <p:spPr>
            <a:xfrm>
              <a:off x="1491831" y="7497971"/>
              <a:ext cx="4363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ER</a:t>
              </a:r>
              <a:r>
                <a:rPr lang="el-GR" sz="1000" dirty="0">
                  <a:latin typeface="+mn-lt"/>
                  <a:cs typeface="Times New Roman" panose="02020603050405020304" pitchFamily="18" charset="0"/>
                </a:rPr>
                <a:t>α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160" name="CasellaDiTesto 159">
              <a:extLst>
                <a:ext uri="{FF2B5EF4-FFF2-40B4-BE49-F238E27FC236}">
                  <a16:creationId xmlns:a16="http://schemas.microsoft.com/office/drawing/2014/main" id="{BE258AF2-A53A-4498-9105-5FDE14649C4D}"/>
                </a:ext>
              </a:extLst>
            </p:cNvPr>
            <p:cNvSpPr txBox="1"/>
            <p:nvPr/>
          </p:nvSpPr>
          <p:spPr>
            <a:xfrm>
              <a:off x="1491831" y="7742396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Vinculin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161" name="CasellaDiTesto 160">
              <a:extLst>
                <a:ext uri="{FF2B5EF4-FFF2-40B4-BE49-F238E27FC236}">
                  <a16:creationId xmlns:a16="http://schemas.microsoft.com/office/drawing/2014/main" id="{C848FE93-D20F-4FC2-A13C-DBE4D5FB6581}"/>
                </a:ext>
              </a:extLst>
            </p:cNvPr>
            <p:cNvSpPr txBox="1"/>
            <p:nvPr/>
          </p:nvSpPr>
          <p:spPr>
            <a:xfrm>
              <a:off x="1491831" y="7246236"/>
              <a:ext cx="6030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FOXA1</a:t>
              </a:r>
            </a:p>
          </p:txBody>
        </p:sp>
        <p:sp>
          <p:nvSpPr>
            <p:cNvPr id="162" name="CasellaDiTesto 161">
              <a:extLst>
                <a:ext uri="{FF2B5EF4-FFF2-40B4-BE49-F238E27FC236}">
                  <a16:creationId xmlns:a16="http://schemas.microsoft.com/office/drawing/2014/main" id="{510DF2C2-36F6-44BE-BB26-F0FD8A9A79B9}"/>
                </a:ext>
              </a:extLst>
            </p:cNvPr>
            <p:cNvSpPr txBox="1"/>
            <p:nvPr/>
          </p:nvSpPr>
          <p:spPr>
            <a:xfrm>
              <a:off x="1491831" y="6745238"/>
              <a:ext cx="4331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AKT</a:t>
              </a:r>
            </a:p>
          </p:txBody>
        </p:sp>
        <p:sp>
          <p:nvSpPr>
            <p:cNvPr id="163" name="CasellaDiTesto 162">
              <a:extLst>
                <a:ext uri="{FF2B5EF4-FFF2-40B4-BE49-F238E27FC236}">
                  <a16:creationId xmlns:a16="http://schemas.microsoft.com/office/drawing/2014/main" id="{8756A90D-2A4E-4E76-B7F8-F492FC94E785}"/>
                </a:ext>
              </a:extLst>
            </p:cNvPr>
            <p:cNvSpPr txBox="1"/>
            <p:nvPr/>
          </p:nvSpPr>
          <p:spPr>
            <a:xfrm>
              <a:off x="1491831" y="6999447"/>
              <a:ext cx="6046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IGF1-R</a:t>
              </a:r>
            </a:p>
          </p:txBody>
        </p:sp>
        <p:sp>
          <p:nvSpPr>
            <p:cNvPr id="164" name="CasellaDiTesto 163">
              <a:extLst>
                <a:ext uri="{FF2B5EF4-FFF2-40B4-BE49-F238E27FC236}">
                  <a16:creationId xmlns:a16="http://schemas.microsoft.com/office/drawing/2014/main" id="{15ACFDE6-B3C6-4F57-B671-6F869DEA8011}"/>
                </a:ext>
              </a:extLst>
            </p:cNvPr>
            <p:cNvSpPr txBox="1"/>
            <p:nvPr/>
          </p:nvSpPr>
          <p:spPr>
            <a:xfrm>
              <a:off x="1491831" y="6490278"/>
              <a:ext cx="5036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pAKT</a:t>
              </a:r>
              <a:endParaRPr lang="it-IT" sz="1000" dirty="0">
                <a:latin typeface="+mn-lt"/>
              </a:endParaRPr>
            </a:p>
          </p:txBody>
        </p:sp>
        <p:pic>
          <p:nvPicPr>
            <p:cNvPr id="165" name="Immagine 164">
              <a:extLst>
                <a:ext uri="{FF2B5EF4-FFF2-40B4-BE49-F238E27FC236}">
                  <a16:creationId xmlns:a16="http://schemas.microsoft.com/office/drawing/2014/main" id="{555B3935-6D1F-42ED-B90C-2F744DCEF939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76792" y="7015924"/>
              <a:ext cx="1080000" cy="21326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66" name="Immagine 165">
              <a:extLst>
                <a:ext uri="{FF2B5EF4-FFF2-40B4-BE49-F238E27FC236}">
                  <a16:creationId xmlns:a16="http://schemas.microsoft.com/office/drawing/2014/main" id="{0D934417-5A26-4B3C-B4BC-7A5AE3CD61BF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76792" y="7262713"/>
              <a:ext cx="1080000" cy="21326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67" name="Immagine 166">
              <a:extLst>
                <a:ext uri="{FF2B5EF4-FFF2-40B4-BE49-F238E27FC236}">
                  <a16:creationId xmlns:a16="http://schemas.microsoft.com/office/drawing/2014/main" id="{60C29577-5656-43ED-936E-1B0C9897EA7D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76792" y="7514448"/>
              <a:ext cx="1080000" cy="21326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68" name="Immagine 167">
              <a:extLst>
                <a:ext uri="{FF2B5EF4-FFF2-40B4-BE49-F238E27FC236}">
                  <a16:creationId xmlns:a16="http://schemas.microsoft.com/office/drawing/2014/main" id="{E25080C9-E95F-4BE8-B219-4AB6F76E692E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76792" y="7758873"/>
              <a:ext cx="1080000" cy="21326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69" name="Immagine 168">
              <a:extLst>
                <a:ext uri="{FF2B5EF4-FFF2-40B4-BE49-F238E27FC236}">
                  <a16:creationId xmlns:a16="http://schemas.microsoft.com/office/drawing/2014/main" id="{683EE112-6C56-4276-9CE8-BDF2AFB8F6EA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76792" y="6761715"/>
              <a:ext cx="1080000" cy="21326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70" name="Immagine 169">
              <a:extLst>
                <a:ext uri="{FF2B5EF4-FFF2-40B4-BE49-F238E27FC236}">
                  <a16:creationId xmlns:a16="http://schemas.microsoft.com/office/drawing/2014/main" id="{E6D64E62-ADB5-440C-AB83-085301FB0684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76792" y="6506755"/>
              <a:ext cx="1080000" cy="21326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204" name="CasellaDiTesto 203">
            <a:extLst>
              <a:ext uri="{FF2B5EF4-FFF2-40B4-BE49-F238E27FC236}">
                <a16:creationId xmlns:a16="http://schemas.microsoft.com/office/drawing/2014/main" id="{56595A4C-E202-46D6-8C35-E92377F2E95A}"/>
              </a:ext>
            </a:extLst>
          </p:cNvPr>
          <p:cNvSpPr txBox="1"/>
          <p:nvPr/>
        </p:nvSpPr>
        <p:spPr>
          <a:xfrm>
            <a:off x="2240213" y="0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ementary</a:t>
            </a:r>
            <a:r>
              <a:rPr lang="it-IT" b="1" dirty="0"/>
              <a:t> Fig. 4</a:t>
            </a:r>
          </a:p>
        </p:txBody>
      </p:sp>
      <p:grpSp>
        <p:nvGrpSpPr>
          <p:cNvPr id="47" name="Gruppo 46">
            <a:extLst>
              <a:ext uri="{FF2B5EF4-FFF2-40B4-BE49-F238E27FC236}">
                <a16:creationId xmlns:a16="http://schemas.microsoft.com/office/drawing/2014/main" id="{FB5409DF-EDEB-0B76-5765-8E2A2F9A9830}"/>
              </a:ext>
            </a:extLst>
          </p:cNvPr>
          <p:cNvGrpSpPr/>
          <p:nvPr/>
        </p:nvGrpSpPr>
        <p:grpSpPr>
          <a:xfrm>
            <a:off x="4541708" y="4048732"/>
            <a:ext cx="1723334" cy="1891420"/>
            <a:chOff x="4541708" y="4186443"/>
            <a:chExt cx="1723334" cy="1891420"/>
          </a:xfrm>
        </p:grpSpPr>
        <p:sp>
          <p:nvSpPr>
            <p:cNvPr id="136" name="CasellaDiTesto 135">
              <a:extLst>
                <a:ext uri="{FF2B5EF4-FFF2-40B4-BE49-F238E27FC236}">
                  <a16:creationId xmlns:a16="http://schemas.microsoft.com/office/drawing/2014/main" id="{1BEB58A3-078C-443A-AEFA-0CD447F538EA}"/>
                </a:ext>
              </a:extLst>
            </p:cNvPr>
            <p:cNvSpPr txBox="1"/>
            <p:nvPr/>
          </p:nvSpPr>
          <p:spPr>
            <a:xfrm>
              <a:off x="4560518" y="4186443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137" name="CasellaDiTesto 136">
              <a:extLst>
                <a:ext uri="{FF2B5EF4-FFF2-40B4-BE49-F238E27FC236}">
                  <a16:creationId xmlns:a16="http://schemas.microsoft.com/office/drawing/2014/main" id="{CB4EB2D3-D7A8-47AE-8A4B-FB0AAC039842}"/>
                </a:ext>
              </a:extLst>
            </p:cNvPr>
            <p:cNvSpPr txBox="1"/>
            <p:nvPr/>
          </p:nvSpPr>
          <p:spPr>
            <a:xfrm>
              <a:off x="4725223" y="4186443"/>
              <a:ext cx="43152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.01</a:t>
              </a:r>
            </a:p>
          </p:txBody>
        </p:sp>
        <p:sp>
          <p:nvSpPr>
            <p:cNvPr id="138" name="CasellaDiTesto 137">
              <a:extLst>
                <a:ext uri="{FF2B5EF4-FFF2-40B4-BE49-F238E27FC236}">
                  <a16:creationId xmlns:a16="http://schemas.microsoft.com/office/drawing/2014/main" id="{B69C2601-30C6-47AD-AD56-7820B498DD2F}"/>
                </a:ext>
              </a:extLst>
            </p:cNvPr>
            <p:cNvSpPr txBox="1"/>
            <p:nvPr/>
          </p:nvSpPr>
          <p:spPr>
            <a:xfrm>
              <a:off x="5008505" y="4186443"/>
              <a:ext cx="360996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.1</a:t>
              </a:r>
            </a:p>
          </p:txBody>
        </p:sp>
        <p:sp>
          <p:nvSpPr>
            <p:cNvPr id="139" name="CasellaDiTesto 138">
              <a:extLst>
                <a:ext uri="{FF2B5EF4-FFF2-40B4-BE49-F238E27FC236}">
                  <a16:creationId xmlns:a16="http://schemas.microsoft.com/office/drawing/2014/main" id="{1974C6C3-85C7-4584-AE1C-4764DE3FDE28}"/>
                </a:ext>
              </a:extLst>
            </p:cNvPr>
            <p:cNvSpPr txBox="1"/>
            <p:nvPr/>
          </p:nvSpPr>
          <p:spPr>
            <a:xfrm>
              <a:off x="5293276" y="4186443"/>
              <a:ext cx="360996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.0</a:t>
              </a:r>
            </a:p>
          </p:txBody>
        </p:sp>
        <p:sp>
          <p:nvSpPr>
            <p:cNvPr id="140" name="CasellaDiTesto 139">
              <a:extLst>
                <a:ext uri="{FF2B5EF4-FFF2-40B4-BE49-F238E27FC236}">
                  <a16:creationId xmlns:a16="http://schemas.microsoft.com/office/drawing/2014/main" id="{5107AB64-D2D2-49E4-AB38-9038906EDBA5}"/>
                </a:ext>
              </a:extLst>
            </p:cNvPr>
            <p:cNvSpPr txBox="1"/>
            <p:nvPr/>
          </p:nvSpPr>
          <p:spPr>
            <a:xfrm>
              <a:off x="5585048" y="4186443"/>
              <a:ext cx="67999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MK (µM)</a:t>
              </a:r>
            </a:p>
          </p:txBody>
        </p:sp>
        <p:sp>
          <p:nvSpPr>
            <p:cNvPr id="147" name="CasellaDiTesto 146">
              <a:extLst>
                <a:ext uri="{FF2B5EF4-FFF2-40B4-BE49-F238E27FC236}">
                  <a16:creationId xmlns:a16="http://schemas.microsoft.com/office/drawing/2014/main" id="{8259BCC2-C7D3-4C26-A659-B32DED109CEC}"/>
                </a:ext>
              </a:extLst>
            </p:cNvPr>
            <p:cNvSpPr txBox="1"/>
            <p:nvPr/>
          </p:nvSpPr>
          <p:spPr>
            <a:xfrm>
              <a:off x="5585048" y="5504269"/>
              <a:ext cx="43633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ER</a:t>
              </a:r>
              <a:r>
                <a:rPr lang="el-GR" sz="1000" dirty="0">
                  <a:latin typeface="+mn-lt"/>
                  <a:cs typeface="Times New Roman" panose="02020603050405020304" pitchFamily="18" charset="0"/>
                </a:rPr>
                <a:t>α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148" name="CasellaDiTesto 147">
              <a:extLst>
                <a:ext uri="{FF2B5EF4-FFF2-40B4-BE49-F238E27FC236}">
                  <a16:creationId xmlns:a16="http://schemas.microsoft.com/office/drawing/2014/main" id="{75369A9A-F959-46D4-B24A-E99DD30C683B}"/>
                </a:ext>
              </a:extLst>
            </p:cNvPr>
            <p:cNvSpPr txBox="1"/>
            <p:nvPr/>
          </p:nvSpPr>
          <p:spPr>
            <a:xfrm>
              <a:off x="5585048" y="5820768"/>
              <a:ext cx="63190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Vinculin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149" name="CasellaDiTesto 148">
              <a:extLst>
                <a:ext uri="{FF2B5EF4-FFF2-40B4-BE49-F238E27FC236}">
                  <a16:creationId xmlns:a16="http://schemas.microsoft.com/office/drawing/2014/main" id="{4CFDD517-8EC1-42CC-BCD3-D602FBC09CE6}"/>
                </a:ext>
              </a:extLst>
            </p:cNvPr>
            <p:cNvSpPr txBox="1"/>
            <p:nvPr/>
          </p:nvSpPr>
          <p:spPr>
            <a:xfrm>
              <a:off x="5585048" y="5201486"/>
              <a:ext cx="60305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FOXA1</a:t>
              </a:r>
            </a:p>
          </p:txBody>
        </p:sp>
        <p:sp>
          <p:nvSpPr>
            <p:cNvPr id="150" name="CasellaDiTesto 149">
              <a:extLst>
                <a:ext uri="{FF2B5EF4-FFF2-40B4-BE49-F238E27FC236}">
                  <a16:creationId xmlns:a16="http://schemas.microsoft.com/office/drawing/2014/main" id="{C446CCF3-52DA-4B93-AB4B-0C32825D1970}"/>
                </a:ext>
              </a:extLst>
            </p:cNvPr>
            <p:cNvSpPr txBox="1"/>
            <p:nvPr/>
          </p:nvSpPr>
          <p:spPr>
            <a:xfrm>
              <a:off x="5585048" y="4613811"/>
              <a:ext cx="433132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AKT</a:t>
              </a:r>
            </a:p>
          </p:txBody>
        </p:sp>
        <p:sp>
          <p:nvSpPr>
            <p:cNvPr id="151" name="CasellaDiTesto 150">
              <a:extLst>
                <a:ext uri="{FF2B5EF4-FFF2-40B4-BE49-F238E27FC236}">
                  <a16:creationId xmlns:a16="http://schemas.microsoft.com/office/drawing/2014/main" id="{7B01CB50-B967-4E8D-88CC-99EF0C65DC7B}"/>
                </a:ext>
              </a:extLst>
            </p:cNvPr>
            <p:cNvSpPr txBox="1"/>
            <p:nvPr/>
          </p:nvSpPr>
          <p:spPr>
            <a:xfrm>
              <a:off x="5585048" y="4886147"/>
              <a:ext cx="604653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IGF1-R</a:t>
              </a:r>
            </a:p>
          </p:txBody>
        </p:sp>
        <p:sp>
          <p:nvSpPr>
            <p:cNvPr id="152" name="CasellaDiTesto 151">
              <a:extLst>
                <a:ext uri="{FF2B5EF4-FFF2-40B4-BE49-F238E27FC236}">
                  <a16:creationId xmlns:a16="http://schemas.microsoft.com/office/drawing/2014/main" id="{B085D9A1-7F54-41CF-BF2B-23837C5B2081}"/>
                </a:ext>
              </a:extLst>
            </p:cNvPr>
            <p:cNvSpPr txBox="1"/>
            <p:nvPr/>
          </p:nvSpPr>
          <p:spPr>
            <a:xfrm>
              <a:off x="5585048" y="4377395"/>
              <a:ext cx="50366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pAKT</a:t>
              </a:r>
              <a:endParaRPr lang="it-IT" sz="1000" dirty="0">
                <a:latin typeface="+mn-lt"/>
              </a:endParaRPr>
            </a:p>
          </p:txBody>
        </p:sp>
        <p:pic>
          <p:nvPicPr>
            <p:cNvPr id="41" name="Immagine 40">
              <a:extLst>
                <a:ext uri="{FF2B5EF4-FFF2-40B4-BE49-F238E27FC236}">
                  <a16:creationId xmlns:a16="http://schemas.microsoft.com/office/drawing/2014/main" id="{EFD6283A-FBA5-15BA-56D4-6B2AE1EC25CC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>
              <a:extLst>
                <a:ext uri="{BEBA8EAE-BF5A-486C-A8C5-ECC9F3942E4B}">
                  <a14:imgProps xmlns:a14="http://schemas.microsoft.com/office/drawing/2010/main">
                    <a14:imgLayer r:embed="rId33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541708" y="4643460"/>
              <a:ext cx="1080000" cy="18692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2" name="Immagine 41">
              <a:extLst>
                <a:ext uri="{FF2B5EF4-FFF2-40B4-BE49-F238E27FC236}">
                  <a16:creationId xmlns:a16="http://schemas.microsoft.com/office/drawing/2014/main" id="{35A7BA61-E4F7-003F-7912-204CB01DEA3F}"/>
                </a:ext>
              </a:extLst>
            </p:cNvPr>
            <p:cNvPicPr>
              <a:picLocks noChangeAspect="1"/>
            </p:cNvPicPr>
            <p:nvPr/>
          </p:nvPicPr>
          <p:blipFill>
            <a:blip r:embed="rId34">
              <a:extLst>
                <a:ext uri="{BEBA8EAE-BF5A-486C-A8C5-ECC9F3942E4B}">
                  <a14:imgProps xmlns:a14="http://schemas.microsoft.com/office/drawing/2010/main">
                    <a14:imgLayer r:embed="rId35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541708" y="4407044"/>
              <a:ext cx="1080000" cy="18692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3" name="Immagine 42">
              <a:extLst>
                <a:ext uri="{FF2B5EF4-FFF2-40B4-BE49-F238E27FC236}">
                  <a16:creationId xmlns:a16="http://schemas.microsoft.com/office/drawing/2014/main" id="{403C5477-1387-C68B-8353-E4FA87F36AAD}"/>
                </a:ext>
              </a:extLst>
            </p:cNvPr>
            <p:cNvPicPr>
              <a:picLocks noChangeAspect="1"/>
            </p:cNvPicPr>
            <p:nvPr/>
          </p:nvPicPr>
          <p:blipFill>
            <a:blip r:embed="rId36">
              <a:extLst>
                <a:ext uri="{BEBA8EAE-BF5A-486C-A8C5-ECC9F3942E4B}">
                  <a14:imgProps xmlns:a14="http://schemas.microsoft.com/office/drawing/2010/main">
                    <a14:imgLayer r:embed="rId37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541708" y="4875272"/>
              <a:ext cx="1080000" cy="26797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4" name="Immagine 43">
              <a:extLst>
                <a:ext uri="{FF2B5EF4-FFF2-40B4-BE49-F238E27FC236}">
                  <a16:creationId xmlns:a16="http://schemas.microsoft.com/office/drawing/2014/main" id="{B80D6CA0-1846-BAFE-29AE-CF371B027779}"/>
                </a:ext>
              </a:extLst>
            </p:cNvPr>
            <p:cNvPicPr>
              <a:picLocks noChangeAspect="1"/>
            </p:cNvPicPr>
            <p:nvPr/>
          </p:nvPicPr>
          <p:blipFill>
            <a:blip r:embed="rId38">
              <a:extLst>
                <a:ext uri="{BEBA8EAE-BF5A-486C-A8C5-ECC9F3942E4B}">
                  <a14:imgProps xmlns:a14="http://schemas.microsoft.com/office/drawing/2010/main">
                    <a14:imgLayer r:embed="rId39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541708" y="5190611"/>
              <a:ext cx="1080000" cy="26797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5" name="Immagine 44">
              <a:extLst>
                <a:ext uri="{FF2B5EF4-FFF2-40B4-BE49-F238E27FC236}">
                  <a16:creationId xmlns:a16="http://schemas.microsoft.com/office/drawing/2014/main" id="{445A7D8A-12E1-51F7-7D59-477AC6839067}"/>
                </a:ext>
              </a:extLst>
            </p:cNvPr>
            <p:cNvPicPr>
              <a:picLocks noChangeAspect="1"/>
            </p:cNvPicPr>
            <p:nvPr/>
          </p:nvPicPr>
          <p:blipFill>
            <a:blip r:embed="rId40">
              <a:extLst>
                <a:ext uri="{BEBA8EAE-BF5A-486C-A8C5-ECC9F3942E4B}">
                  <a14:imgProps xmlns:a14="http://schemas.microsoft.com/office/drawing/2010/main">
                    <a14:imgLayer r:embed="rId41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541708" y="5493394"/>
              <a:ext cx="1080000" cy="26797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6" name="Immagine 45">
              <a:extLst>
                <a:ext uri="{FF2B5EF4-FFF2-40B4-BE49-F238E27FC236}">
                  <a16:creationId xmlns:a16="http://schemas.microsoft.com/office/drawing/2014/main" id="{4C0DA9CD-1ECC-3636-CE76-636DC063B5F2}"/>
                </a:ext>
              </a:extLst>
            </p:cNvPr>
            <p:cNvPicPr>
              <a:picLocks noChangeAspect="1"/>
            </p:cNvPicPr>
            <p:nvPr/>
          </p:nvPicPr>
          <p:blipFill>
            <a:blip r:embed="rId42">
              <a:extLst>
                <a:ext uri="{BEBA8EAE-BF5A-486C-A8C5-ECC9F3942E4B}">
                  <a14:imgProps xmlns:a14="http://schemas.microsoft.com/office/drawing/2010/main">
                    <a14:imgLayer r:embed="rId43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541708" y="5809893"/>
              <a:ext cx="1080000" cy="26797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51" name="Gruppo 50">
            <a:extLst>
              <a:ext uri="{FF2B5EF4-FFF2-40B4-BE49-F238E27FC236}">
                <a16:creationId xmlns:a16="http://schemas.microsoft.com/office/drawing/2014/main" id="{2C30E6CD-EE92-FADD-3535-67C8CB6D18CB}"/>
              </a:ext>
            </a:extLst>
          </p:cNvPr>
          <p:cNvGrpSpPr/>
          <p:nvPr/>
        </p:nvGrpSpPr>
        <p:grpSpPr>
          <a:xfrm>
            <a:off x="1713290" y="6697236"/>
            <a:ext cx="3453426" cy="1331148"/>
            <a:chOff x="1713290" y="6697236"/>
            <a:chExt cx="3453426" cy="1331148"/>
          </a:xfrm>
        </p:grpSpPr>
        <p:pic>
          <p:nvPicPr>
            <p:cNvPr id="50" name="Immagine 49">
              <a:extLst>
                <a:ext uri="{FF2B5EF4-FFF2-40B4-BE49-F238E27FC236}">
                  <a16:creationId xmlns:a16="http://schemas.microsoft.com/office/drawing/2014/main" id="{6A1A8334-06FA-53DB-9934-75797D36FB46}"/>
                </a:ext>
              </a:extLst>
            </p:cNvPr>
            <p:cNvPicPr>
              <a:picLocks noChangeAspect="1"/>
            </p:cNvPicPr>
            <p:nvPr/>
          </p:nvPicPr>
          <p:blipFill>
            <a:blip r:embed="rId44"/>
            <a:stretch>
              <a:fillRect/>
            </a:stretch>
          </p:blipFill>
          <p:spPr>
            <a:xfrm>
              <a:off x="1713290" y="7303179"/>
              <a:ext cx="2880000" cy="22648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78" name="CasellaDiTesto 177">
              <a:extLst>
                <a:ext uri="{FF2B5EF4-FFF2-40B4-BE49-F238E27FC236}">
                  <a16:creationId xmlns:a16="http://schemas.microsoft.com/office/drawing/2014/main" id="{A0A82956-22D8-4DEA-8639-B2ADD72EBCBB}"/>
                </a:ext>
              </a:extLst>
            </p:cNvPr>
            <p:cNvSpPr txBox="1"/>
            <p:nvPr/>
          </p:nvSpPr>
          <p:spPr>
            <a:xfrm>
              <a:off x="2180053" y="7108681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</a:t>
              </a:r>
            </a:p>
          </p:txBody>
        </p:sp>
        <p:sp>
          <p:nvSpPr>
            <p:cNvPr id="179" name="CasellaDiTesto 178">
              <a:extLst>
                <a:ext uri="{FF2B5EF4-FFF2-40B4-BE49-F238E27FC236}">
                  <a16:creationId xmlns:a16="http://schemas.microsoft.com/office/drawing/2014/main" id="{604A7B3C-50EB-4160-BD52-A62247203F67}"/>
                </a:ext>
              </a:extLst>
            </p:cNvPr>
            <p:cNvSpPr txBox="1"/>
            <p:nvPr/>
          </p:nvSpPr>
          <p:spPr>
            <a:xfrm>
              <a:off x="2315512" y="6887292"/>
              <a:ext cx="36260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Tel</a:t>
              </a:r>
            </a:p>
          </p:txBody>
        </p:sp>
        <p:sp>
          <p:nvSpPr>
            <p:cNvPr id="180" name="CasellaDiTesto 179">
              <a:extLst>
                <a:ext uri="{FF2B5EF4-FFF2-40B4-BE49-F238E27FC236}">
                  <a16:creationId xmlns:a16="http://schemas.microsoft.com/office/drawing/2014/main" id="{3190244A-F5A3-4F11-BF2B-66F534ED4427}"/>
                </a:ext>
              </a:extLst>
            </p:cNvPr>
            <p:cNvSpPr txBox="1"/>
            <p:nvPr/>
          </p:nvSpPr>
          <p:spPr>
            <a:xfrm>
              <a:off x="4534812" y="7782163"/>
              <a:ext cx="63190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Vinculin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181" name="CasellaDiTesto 180">
              <a:extLst>
                <a:ext uri="{FF2B5EF4-FFF2-40B4-BE49-F238E27FC236}">
                  <a16:creationId xmlns:a16="http://schemas.microsoft.com/office/drawing/2014/main" id="{5F4AF4AA-0CA1-4A9E-81FB-483048AC2F60}"/>
                </a:ext>
              </a:extLst>
            </p:cNvPr>
            <p:cNvSpPr txBox="1"/>
            <p:nvPr/>
          </p:nvSpPr>
          <p:spPr>
            <a:xfrm>
              <a:off x="4534812" y="7538488"/>
              <a:ext cx="433132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AKT</a:t>
              </a:r>
            </a:p>
          </p:txBody>
        </p:sp>
        <p:sp>
          <p:nvSpPr>
            <p:cNvPr id="182" name="CasellaDiTesto 181">
              <a:extLst>
                <a:ext uri="{FF2B5EF4-FFF2-40B4-BE49-F238E27FC236}">
                  <a16:creationId xmlns:a16="http://schemas.microsoft.com/office/drawing/2014/main" id="{A11B54A8-37E6-412E-9FC6-8C1A721F0A4E}"/>
                </a:ext>
              </a:extLst>
            </p:cNvPr>
            <p:cNvSpPr txBox="1"/>
            <p:nvPr/>
          </p:nvSpPr>
          <p:spPr>
            <a:xfrm>
              <a:off x="4534812" y="7293310"/>
              <a:ext cx="50366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pAKT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183" name="CasellaDiTesto 182">
              <a:extLst>
                <a:ext uri="{FF2B5EF4-FFF2-40B4-BE49-F238E27FC236}">
                  <a16:creationId xmlns:a16="http://schemas.microsoft.com/office/drawing/2014/main" id="{86C6DEB9-889B-4FC0-A43E-30302F1441EA}"/>
                </a:ext>
              </a:extLst>
            </p:cNvPr>
            <p:cNvSpPr txBox="1"/>
            <p:nvPr/>
          </p:nvSpPr>
          <p:spPr>
            <a:xfrm>
              <a:off x="2367380" y="7108681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</a:t>
              </a:r>
            </a:p>
          </p:txBody>
        </p:sp>
        <p:sp>
          <p:nvSpPr>
            <p:cNvPr id="184" name="CasellaDiTesto 183">
              <a:extLst>
                <a:ext uri="{FF2B5EF4-FFF2-40B4-BE49-F238E27FC236}">
                  <a16:creationId xmlns:a16="http://schemas.microsoft.com/office/drawing/2014/main" id="{88261562-989E-40B4-81D0-C8137C0858C7}"/>
                </a:ext>
              </a:extLst>
            </p:cNvPr>
            <p:cNvSpPr txBox="1"/>
            <p:nvPr/>
          </p:nvSpPr>
          <p:spPr>
            <a:xfrm>
              <a:off x="2566465" y="7108681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6</a:t>
              </a:r>
            </a:p>
          </p:txBody>
        </p:sp>
        <p:sp>
          <p:nvSpPr>
            <p:cNvPr id="185" name="CasellaDiTesto 184">
              <a:extLst>
                <a:ext uri="{FF2B5EF4-FFF2-40B4-BE49-F238E27FC236}">
                  <a16:creationId xmlns:a16="http://schemas.microsoft.com/office/drawing/2014/main" id="{A970EBBC-9B1D-4886-B9A0-35DBB044CFE5}"/>
                </a:ext>
              </a:extLst>
            </p:cNvPr>
            <p:cNvSpPr txBox="1"/>
            <p:nvPr/>
          </p:nvSpPr>
          <p:spPr>
            <a:xfrm>
              <a:off x="2727734" y="7108681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</a:t>
              </a:r>
            </a:p>
          </p:txBody>
        </p:sp>
        <p:sp>
          <p:nvSpPr>
            <p:cNvPr id="186" name="CasellaDiTesto 185">
              <a:extLst>
                <a:ext uri="{FF2B5EF4-FFF2-40B4-BE49-F238E27FC236}">
                  <a16:creationId xmlns:a16="http://schemas.microsoft.com/office/drawing/2014/main" id="{F0D191E3-44E8-4827-856C-4964055ED77F}"/>
                </a:ext>
              </a:extLst>
            </p:cNvPr>
            <p:cNvSpPr txBox="1"/>
            <p:nvPr/>
          </p:nvSpPr>
          <p:spPr>
            <a:xfrm>
              <a:off x="2915061" y="7108681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</a:t>
              </a:r>
            </a:p>
          </p:txBody>
        </p:sp>
        <p:sp>
          <p:nvSpPr>
            <p:cNvPr id="187" name="CasellaDiTesto 186">
              <a:extLst>
                <a:ext uri="{FF2B5EF4-FFF2-40B4-BE49-F238E27FC236}">
                  <a16:creationId xmlns:a16="http://schemas.microsoft.com/office/drawing/2014/main" id="{4CE9BEC2-39F0-4BF1-BBB7-55DFE62E7E58}"/>
                </a:ext>
              </a:extLst>
            </p:cNvPr>
            <p:cNvSpPr txBox="1"/>
            <p:nvPr/>
          </p:nvSpPr>
          <p:spPr>
            <a:xfrm>
              <a:off x="3114146" y="7108681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6</a:t>
              </a:r>
            </a:p>
          </p:txBody>
        </p:sp>
        <p:sp>
          <p:nvSpPr>
            <p:cNvPr id="188" name="CasellaDiTesto 187">
              <a:extLst>
                <a:ext uri="{FF2B5EF4-FFF2-40B4-BE49-F238E27FC236}">
                  <a16:creationId xmlns:a16="http://schemas.microsoft.com/office/drawing/2014/main" id="{0CB76EB6-7FBA-46F2-BF41-3DD4597CF140}"/>
                </a:ext>
              </a:extLst>
            </p:cNvPr>
            <p:cNvSpPr txBox="1"/>
            <p:nvPr/>
          </p:nvSpPr>
          <p:spPr>
            <a:xfrm>
              <a:off x="3312576" y="7108681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</a:t>
              </a:r>
            </a:p>
          </p:txBody>
        </p:sp>
        <p:sp>
          <p:nvSpPr>
            <p:cNvPr id="189" name="CasellaDiTesto 188">
              <a:extLst>
                <a:ext uri="{FF2B5EF4-FFF2-40B4-BE49-F238E27FC236}">
                  <a16:creationId xmlns:a16="http://schemas.microsoft.com/office/drawing/2014/main" id="{CA1D6382-3B31-439B-A747-2FC78B08C8A2}"/>
                </a:ext>
              </a:extLst>
            </p:cNvPr>
            <p:cNvSpPr txBox="1"/>
            <p:nvPr/>
          </p:nvSpPr>
          <p:spPr>
            <a:xfrm>
              <a:off x="3499903" y="7108681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</a:t>
              </a:r>
            </a:p>
          </p:txBody>
        </p:sp>
        <p:sp>
          <p:nvSpPr>
            <p:cNvPr id="190" name="CasellaDiTesto 189">
              <a:extLst>
                <a:ext uri="{FF2B5EF4-FFF2-40B4-BE49-F238E27FC236}">
                  <a16:creationId xmlns:a16="http://schemas.microsoft.com/office/drawing/2014/main" id="{BD4F8F30-3D0C-4E49-A0B5-0E39CBC4A083}"/>
                </a:ext>
              </a:extLst>
            </p:cNvPr>
            <p:cNvSpPr txBox="1"/>
            <p:nvPr/>
          </p:nvSpPr>
          <p:spPr>
            <a:xfrm>
              <a:off x="3698988" y="7108681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6</a:t>
              </a:r>
            </a:p>
          </p:txBody>
        </p:sp>
        <p:sp>
          <p:nvSpPr>
            <p:cNvPr id="191" name="CasellaDiTesto 190">
              <a:extLst>
                <a:ext uri="{FF2B5EF4-FFF2-40B4-BE49-F238E27FC236}">
                  <a16:creationId xmlns:a16="http://schemas.microsoft.com/office/drawing/2014/main" id="{E4373DF3-BB03-4DD5-A4C3-7D1D3706C909}"/>
                </a:ext>
              </a:extLst>
            </p:cNvPr>
            <p:cNvSpPr txBox="1"/>
            <p:nvPr/>
          </p:nvSpPr>
          <p:spPr>
            <a:xfrm>
              <a:off x="3921390" y="7108681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</a:t>
              </a:r>
            </a:p>
          </p:txBody>
        </p:sp>
        <p:sp>
          <p:nvSpPr>
            <p:cNvPr id="192" name="CasellaDiTesto 191">
              <a:extLst>
                <a:ext uri="{FF2B5EF4-FFF2-40B4-BE49-F238E27FC236}">
                  <a16:creationId xmlns:a16="http://schemas.microsoft.com/office/drawing/2014/main" id="{6DF62CD4-47B3-4E20-AD1D-70B95C89690A}"/>
                </a:ext>
              </a:extLst>
            </p:cNvPr>
            <p:cNvSpPr txBox="1"/>
            <p:nvPr/>
          </p:nvSpPr>
          <p:spPr>
            <a:xfrm>
              <a:off x="4108717" y="7108681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</a:t>
              </a:r>
            </a:p>
          </p:txBody>
        </p:sp>
        <p:sp>
          <p:nvSpPr>
            <p:cNvPr id="193" name="CasellaDiTesto 192">
              <a:extLst>
                <a:ext uri="{FF2B5EF4-FFF2-40B4-BE49-F238E27FC236}">
                  <a16:creationId xmlns:a16="http://schemas.microsoft.com/office/drawing/2014/main" id="{ADBC4FD5-3044-4F40-AA40-0A9D4C1D5D70}"/>
                </a:ext>
              </a:extLst>
            </p:cNvPr>
            <p:cNvSpPr txBox="1"/>
            <p:nvPr/>
          </p:nvSpPr>
          <p:spPr>
            <a:xfrm>
              <a:off x="4307802" y="7108681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6</a:t>
              </a:r>
            </a:p>
          </p:txBody>
        </p:sp>
        <p:cxnSp>
          <p:nvCxnSpPr>
            <p:cNvPr id="194" name="Connettore diritto 193">
              <a:extLst>
                <a:ext uri="{FF2B5EF4-FFF2-40B4-BE49-F238E27FC236}">
                  <a16:creationId xmlns:a16="http://schemas.microsoft.com/office/drawing/2014/main" id="{190D3AA0-1DE1-49EA-B91E-11256308CF2B}"/>
                </a:ext>
              </a:extLst>
            </p:cNvPr>
            <p:cNvCxnSpPr>
              <a:stCxn id="178" idx="0"/>
              <a:endCxn id="184" idx="0"/>
            </p:cNvCxnSpPr>
            <p:nvPr/>
          </p:nvCxnSpPr>
          <p:spPr>
            <a:xfrm>
              <a:off x="2307652" y="7108681"/>
              <a:ext cx="38641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5" name="Connettore diritto 194">
              <a:extLst>
                <a:ext uri="{FF2B5EF4-FFF2-40B4-BE49-F238E27FC236}">
                  <a16:creationId xmlns:a16="http://schemas.microsoft.com/office/drawing/2014/main" id="{301602ED-9CC6-476E-8EBA-09D920D82D00}"/>
                </a:ext>
              </a:extLst>
            </p:cNvPr>
            <p:cNvCxnSpPr>
              <a:stCxn id="185" idx="0"/>
              <a:endCxn id="187" idx="0"/>
            </p:cNvCxnSpPr>
            <p:nvPr/>
          </p:nvCxnSpPr>
          <p:spPr>
            <a:xfrm>
              <a:off x="2855333" y="7108681"/>
              <a:ext cx="38641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6" name="Connettore diritto 195">
              <a:extLst>
                <a:ext uri="{FF2B5EF4-FFF2-40B4-BE49-F238E27FC236}">
                  <a16:creationId xmlns:a16="http://schemas.microsoft.com/office/drawing/2014/main" id="{C9B61802-5344-471A-9CD0-C7D8261D21DC}"/>
                </a:ext>
              </a:extLst>
            </p:cNvPr>
            <p:cNvCxnSpPr>
              <a:stCxn id="188" idx="0"/>
              <a:endCxn id="190" idx="0"/>
            </p:cNvCxnSpPr>
            <p:nvPr/>
          </p:nvCxnSpPr>
          <p:spPr>
            <a:xfrm>
              <a:off x="3440175" y="7108681"/>
              <a:ext cx="38641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7" name="Connettore diritto 196">
              <a:extLst>
                <a:ext uri="{FF2B5EF4-FFF2-40B4-BE49-F238E27FC236}">
                  <a16:creationId xmlns:a16="http://schemas.microsoft.com/office/drawing/2014/main" id="{B7E2454C-C888-4890-BD4B-5137B473BCFA}"/>
                </a:ext>
              </a:extLst>
            </p:cNvPr>
            <p:cNvCxnSpPr>
              <a:stCxn id="191" idx="0"/>
              <a:endCxn id="193" idx="0"/>
            </p:cNvCxnSpPr>
            <p:nvPr/>
          </p:nvCxnSpPr>
          <p:spPr>
            <a:xfrm>
              <a:off x="4048989" y="7108681"/>
              <a:ext cx="38641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8" name="CasellaDiTesto 197">
              <a:extLst>
                <a:ext uri="{FF2B5EF4-FFF2-40B4-BE49-F238E27FC236}">
                  <a16:creationId xmlns:a16="http://schemas.microsoft.com/office/drawing/2014/main" id="{C986196D-83B0-48BC-9BA2-493BA160D90A}"/>
                </a:ext>
              </a:extLst>
            </p:cNvPr>
            <p:cNvSpPr txBox="1"/>
            <p:nvPr/>
          </p:nvSpPr>
          <p:spPr>
            <a:xfrm>
              <a:off x="3442220" y="6887292"/>
              <a:ext cx="36260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Tel</a:t>
              </a:r>
            </a:p>
          </p:txBody>
        </p:sp>
        <p:sp>
          <p:nvSpPr>
            <p:cNvPr id="199" name="CasellaDiTesto 198">
              <a:extLst>
                <a:ext uri="{FF2B5EF4-FFF2-40B4-BE49-F238E27FC236}">
                  <a16:creationId xmlns:a16="http://schemas.microsoft.com/office/drawing/2014/main" id="{F234B049-1FD6-4695-858F-28BF88EB4FB2}"/>
                </a:ext>
              </a:extLst>
            </p:cNvPr>
            <p:cNvSpPr txBox="1"/>
            <p:nvPr/>
          </p:nvSpPr>
          <p:spPr>
            <a:xfrm>
              <a:off x="4018284" y="6887292"/>
              <a:ext cx="44755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NVP</a:t>
              </a:r>
            </a:p>
          </p:txBody>
        </p:sp>
        <p:sp>
          <p:nvSpPr>
            <p:cNvPr id="200" name="CasellaDiTesto 199">
              <a:extLst>
                <a:ext uri="{FF2B5EF4-FFF2-40B4-BE49-F238E27FC236}">
                  <a16:creationId xmlns:a16="http://schemas.microsoft.com/office/drawing/2014/main" id="{96A673C5-F4E1-4EDE-94C2-35A8BF839D2D}"/>
                </a:ext>
              </a:extLst>
            </p:cNvPr>
            <p:cNvSpPr txBox="1"/>
            <p:nvPr/>
          </p:nvSpPr>
          <p:spPr>
            <a:xfrm>
              <a:off x="2852997" y="6887292"/>
              <a:ext cx="44755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NVP</a:t>
              </a:r>
            </a:p>
          </p:txBody>
        </p:sp>
        <p:sp>
          <p:nvSpPr>
            <p:cNvPr id="201" name="CasellaDiTesto 200">
              <a:extLst>
                <a:ext uri="{FF2B5EF4-FFF2-40B4-BE49-F238E27FC236}">
                  <a16:creationId xmlns:a16="http://schemas.microsoft.com/office/drawing/2014/main" id="{070A51A8-231E-4D78-99B0-82C47E36370C}"/>
                </a:ext>
              </a:extLst>
            </p:cNvPr>
            <p:cNvSpPr txBox="1"/>
            <p:nvPr/>
          </p:nvSpPr>
          <p:spPr>
            <a:xfrm rot="16200000">
              <a:off x="1875696" y="6997592"/>
              <a:ext cx="397866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IGF</a:t>
              </a:r>
            </a:p>
          </p:txBody>
        </p:sp>
        <p:sp>
          <p:nvSpPr>
            <p:cNvPr id="202" name="CasellaDiTesto 201">
              <a:extLst>
                <a:ext uri="{FF2B5EF4-FFF2-40B4-BE49-F238E27FC236}">
                  <a16:creationId xmlns:a16="http://schemas.microsoft.com/office/drawing/2014/main" id="{2567F7C0-31A3-454A-AA13-B6404D53394E}"/>
                </a:ext>
              </a:extLst>
            </p:cNvPr>
            <p:cNvSpPr txBox="1"/>
            <p:nvPr/>
          </p:nvSpPr>
          <p:spPr>
            <a:xfrm>
              <a:off x="1747559" y="7108681"/>
              <a:ext cx="27764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C</a:t>
              </a:r>
            </a:p>
          </p:txBody>
        </p:sp>
        <p:sp>
          <p:nvSpPr>
            <p:cNvPr id="203" name="CasellaDiTesto 202">
              <a:extLst>
                <a:ext uri="{FF2B5EF4-FFF2-40B4-BE49-F238E27FC236}">
                  <a16:creationId xmlns:a16="http://schemas.microsoft.com/office/drawing/2014/main" id="{DBC91E65-57A0-405C-8E53-31E761F8DD13}"/>
                </a:ext>
              </a:extLst>
            </p:cNvPr>
            <p:cNvSpPr txBox="1"/>
            <p:nvPr/>
          </p:nvSpPr>
          <p:spPr>
            <a:xfrm>
              <a:off x="4534812" y="7108681"/>
              <a:ext cx="449162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(</a:t>
              </a:r>
              <a:r>
                <a:rPr lang="it-IT" sz="1000" dirty="0" err="1">
                  <a:latin typeface="+mn-lt"/>
                </a:rPr>
                <a:t>hrs</a:t>
              </a:r>
              <a:r>
                <a:rPr lang="it-IT" sz="1000" dirty="0">
                  <a:latin typeface="+mn-lt"/>
                </a:rPr>
                <a:t>)</a:t>
              </a:r>
            </a:p>
          </p:txBody>
        </p:sp>
        <p:cxnSp>
          <p:nvCxnSpPr>
            <p:cNvPr id="173" name="Connettore diritto 172">
              <a:extLst>
                <a:ext uri="{FF2B5EF4-FFF2-40B4-BE49-F238E27FC236}">
                  <a16:creationId xmlns:a16="http://schemas.microsoft.com/office/drawing/2014/main" id="{00EA1F7E-4704-439D-959D-0184BC3702B4}"/>
                </a:ext>
              </a:extLst>
            </p:cNvPr>
            <p:cNvCxnSpPr>
              <a:cxnSpLocks/>
            </p:cNvCxnSpPr>
            <p:nvPr/>
          </p:nvCxnSpPr>
          <p:spPr>
            <a:xfrm>
              <a:off x="3623520" y="6910442"/>
              <a:ext cx="61854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4" name="CasellaDiTesto 173">
              <a:extLst>
                <a:ext uri="{FF2B5EF4-FFF2-40B4-BE49-F238E27FC236}">
                  <a16:creationId xmlns:a16="http://schemas.microsoft.com/office/drawing/2014/main" id="{E24257B3-5DA0-4B5C-83A1-D104B991DD68}"/>
                </a:ext>
              </a:extLst>
            </p:cNvPr>
            <p:cNvSpPr txBox="1"/>
            <p:nvPr/>
          </p:nvSpPr>
          <p:spPr>
            <a:xfrm>
              <a:off x="3715747" y="6697236"/>
              <a:ext cx="397866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IGF</a:t>
              </a:r>
            </a:p>
          </p:txBody>
        </p:sp>
        <p:pic>
          <p:nvPicPr>
            <p:cNvPr id="48" name="Immagine 47">
              <a:extLst>
                <a:ext uri="{FF2B5EF4-FFF2-40B4-BE49-F238E27FC236}">
                  <a16:creationId xmlns:a16="http://schemas.microsoft.com/office/drawing/2014/main" id="{D3954EFE-F1B3-5EED-0DA7-D0B7EDBFAC01}"/>
                </a:ext>
              </a:extLst>
            </p:cNvPr>
            <p:cNvPicPr>
              <a:picLocks noChangeAspect="1"/>
            </p:cNvPicPr>
            <p:nvPr/>
          </p:nvPicPr>
          <p:blipFill>
            <a:blip r:embed="rId45"/>
            <a:stretch>
              <a:fillRect/>
            </a:stretch>
          </p:blipFill>
          <p:spPr>
            <a:xfrm>
              <a:off x="1713290" y="7804247"/>
              <a:ext cx="2880000" cy="20205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9" name="Immagine 48">
              <a:extLst>
                <a:ext uri="{FF2B5EF4-FFF2-40B4-BE49-F238E27FC236}">
                  <a16:creationId xmlns:a16="http://schemas.microsoft.com/office/drawing/2014/main" id="{28CE2940-CAE8-14FD-D54B-4015055243AA}"/>
                </a:ext>
              </a:extLst>
            </p:cNvPr>
            <p:cNvPicPr>
              <a:picLocks noChangeAspect="1"/>
            </p:cNvPicPr>
            <p:nvPr/>
          </p:nvPicPr>
          <p:blipFill>
            <a:blip r:embed="rId46"/>
            <a:stretch>
              <a:fillRect/>
            </a:stretch>
          </p:blipFill>
          <p:spPr>
            <a:xfrm>
              <a:off x="1713290" y="7563997"/>
              <a:ext cx="2880000" cy="19520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26201202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po 7">
            <a:extLst>
              <a:ext uri="{FF2B5EF4-FFF2-40B4-BE49-F238E27FC236}">
                <a16:creationId xmlns:a16="http://schemas.microsoft.com/office/drawing/2014/main" id="{3687F337-D1D3-01DE-47C0-02127BEE8341}"/>
              </a:ext>
            </a:extLst>
          </p:cNvPr>
          <p:cNvGrpSpPr/>
          <p:nvPr/>
        </p:nvGrpSpPr>
        <p:grpSpPr>
          <a:xfrm>
            <a:off x="1690119" y="2546329"/>
            <a:ext cx="3351112" cy="1638693"/>
            <a:chOff x="1690119" y="2546329"/>
            <a:chExt cx="3351112" cy="1638693"/>
          </a:xfrm>
        </p:grpSpPr>
        <p:pic>
          <p:nvPicPr>
            <p:cNvPr id="7" name="Immagine 6">
              <a:extLst>
                <a:ext uri="{FF2B5EF4-FFF2-40B4-BE49-F238E27FC236}">
                  <a16:creationId xmlns:a16="http://schemas.microsoft.com/office/drawing/2014/main" id="{E02E0452-0B57-4A1A-A873-B565B5AC312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20231" y="2775300"/>
              <a:ext cx="2260281" cy="1260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197" name="CasellaDiTesto 196">
              <a:extLst>
                <a:ext uri="{FF2B5EF4-FFF2-40B4-BE49-F238E27FC236}">
                  <a16:creationId xmlns:a16="http://schemas.microsoft.com/office/drawing/2014/main" id="{961F6ADF-D7BC-4A78-BD0D-F656A11C271F}"/>
                </a:ext>
              </a:extLst>
            </p:cNvPr>
            <p:cNvSpPr txBox="1"/>
            <p:nvPr/>
          </p:nvSpPr>
          <p:spPr>
            <a:xfrm>
              <a:off x="4560009" y="4000356"/>
              <a:ext cx="481222" cy="184666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+mn-lt"/>
                </a:rPr>
                <a:t>MK (µM)</a:t>
              </a:r>
            </a:p>
          </p:txBody>
        </p:sp>
        <p:sp>
          <p:nvSpPr>
            <p:cNvPr id="198" name="CasellaDiTesto 197">
              <a:extLst>
                <a:ext uri="{FF2B5EF4-FFF2-40B4-BE49-F238E27FC236}">
                  <a16:creationId xmlns:a16="http://schemas.microsoft.com/office/drawing/2014/main" id="{D96FF9FF-38D3-4EAC-923C-DDBC56D02CBA}"/>
                </a:ext>
              </a:extLst>
            </p:cNvPr>
            <p:cNvSpPr txBox="1"/>
            <p:nvPr/>
          </p:nvSpPr>
          <p:spPr>
            <a:xfrm rot="16200000">
              <a:off x="1342908" y="3147278"/>
              <a:ext cx="1156087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 err="1"/>
                <a:t>Protein</a:t>
              </a:r>
              <a:r>
                <a:rPr lang="it-IT" sz="1200" dirty="0"/>
                <a:t> </a:t>
              </a:r>
              <a:r>
                <a:rPr lang="it-IT" sz="1200" dirty="0" err="1"/>
                <a:t>Levels</a:t>
              </a:r>
              <a:endParaRPr lang="it-IT" sz="1200" dirty="0"/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0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199" name="CasellaDiTesto 198">
              <a:extLst>
                <a:ext uri="{FF2B5EF4-FFF2-40B4-BE49-F238E27FC236}">
                  <a16:creationId xmlns:a16="http://schemas.microsoft.com/office/drawing/2014/main" id="{DEF017D7-78AA-423A-9C7C-41C937FA4D8A}"/>
                </a:ext>
              </a:extLst>
            </p:cNvPr>
            <p:cNvSpPr txBox="1"/>
            <p:nvPr/>
          </p:nvSpPr>
          <p:spPr>
            <a:xfrm>
              <a:off x="2019415" y="2672566"/>
              <a:ext cx="397866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2.0</a:t>
              </a:r>
            </a:p>
          </p:txBody>
        </p:sp>
        <p:sp>
          <p:nvSpPr>
            <p:cNvPr id="200" name="CasellaDiTesto 199">
              <a:extLst>
                <a:ext uri="{FF2B5EF4-FFF2-40B4-BE49-F238E27FC236}">
                  <a16:creationId xmlns:a16="http://schemas.microsoft.com/office/drawing/2014/main" id="{0B60EDFE-93E5-40A2-8EE0-0C924CD540A9}"/>
                </a:ext>
              </a:extLst>
            </p:cNvPr>
            <p:cNvSpPr txBox="1"/>
            <p:nvPr/>
          </p:nvSpPr>
          <p:spPr>
            <a:xfrm>
              <a:off x="2019415" y="3250136"/>
              <a:ext cx="397866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0</a:t>
              </a:r>
            </a:p>
          </p:txBody>
        </p:sp>
        <p:sp>
          <p:nvSpPr>
            <p:cNvPr id="201" name="CasellaDiTesto 200">
              <a:extLst>
                <a:ext uri="{FF2B5EF4-FFF2-40B4-BE49-F238E27FC236}">
                  <a16:creationId xmlns:a16="http://schemas.microsoft.com/office/drawing/2014/main" id="{32A45BA7-1477-4991-B980-6DC3DBF13993}"/>
                </a:ext>
              </a:extLst>
            </p:cNvPr>
            <p:cNvSpPr txBox="1"/>
            <p:nvPr/>
          </p:nvSpPr>
          <p:spPr>
            <a:xfrm>
              <a:off x="2019415" y="3842930"/>
              <a:ext cx="397866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cxnSp>
          <p:nvCxnSpPr>
            <p:cNvPr id="228" name="Connettore diritto 227">
              <a:extLst>
                <a:ext uri="{FF2B5EF4-FFF2-40B4-BE49-F238E27FC236}">
                  <a16:creationId xmlns:a16="http://schemas.microsoft.com/office/drawing/2014/main" id="{DCA7DF36-E0CE-4E0A-A069-4A0A82A30397}"/>
                </a:ext>
              </a:extLst>
            </p:cNvPr>
            <p:cNvCxnSpPr>
              <a:cxnSpLocks/>
            </p:cNvCxnSpPr>
            <p:nvPr/>
          </p:nvCxnSpPr>
          <p:spPr>
            <a:xfrm>
              <a:off x="2472391" y="2804278"/>
              <a:ext cx="36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9" name="CasellaDiTesto 228">
              <a:extLst>
                <a:ext uri="{FF2B5EF4-FFF2-40B4-BE49-F238E27FC236}">
                  <a16:creationId xmlns:a16="http://schemas.microsoft.com/office/drawing/2014/main" id="{325F5CF5-CFDC-48CA-B519-D62DD64F2388}"/>
                </a:ext>
              </a:extLst>
            </p:cNvPr>
            <p:cNvSpPr txBox="1"/>
            <p:nvPr/>
          </p:nvSpPr>
          <p:spPr>
            <a:xfrm>
              <a:off x="2367698" y="2546329"/>
              <a:ext cx="56938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 err="1"/>
                <a:t>pAKT</a:t>
              </a:r>
              <a:endParaRPr lang="it-IT" sz="1200" dirty="0"/>
            </a:p>
          </p:txBody>
        </p:sp>
        <p:grpSp>
          <p:nvGrpSpPr>
            <p:cNvPr id="2" name="Gruppo 1">
              <a:extLst>
                <a:ext uri="{FF2B5EF4-FFF2-40B4-BE49-F238E27FC236}">
                  <a16:creationId xmlns:a16="http://schemas.microsoft.com/office/drawing/2014/main" id="{8C748785-C034-A082-BA2C-B67844B142A3}"/>
                </a:ext>
              </a:extLst>
            </p:cNvPr>
            <p:cNvGrpSpPr/>
            <p:nvPr/>
          </p:nvGrpSpPr>
          <p:grpSpPr>
            <a:xfrm>
              <a:off x="2333877" y="4000356"/>
              <a:ext cx="613160" cy="184666"/>
              <a:chOff x="2333877" y="3995432"/>
              <a:chExt cx="613160" cy="184666"/>
            </a:xfrm>
          </p:grpSpPr>
          <p:sp>
            <p:nvSpPr>
              <p:cNvPr id="216" name="CasellaDiTesto 215">
                <a:extLst>
                  <a:ext uri="{FF2B5EF4-FFF2-40B4-BE49-F238E27FC236}">
                    <a16:creationId xmlns:a16="http://schemas.microsoft.com/office/drawing/2014/main" id="{A86D6EC8-6E2F-4EFB-B557-36F7D66DD808}"/>
                  </a:ext>
                </a:extLst>
              </p:cNvPr>
              <p:cNvSpPr txBox="1"/>
              <p:nvPr/>
            </p:nvSpPr>
            <p:spPr>
              <a:xfrm>
                <a:off x="2333877" y="3995432"/>
                <a:ext cx="227948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600" dirty="0">
                    <a:latin typeface="+mn-lt"/>
                  </a:rPr>
                  <a:t>0</a:t>
                </a:r>
              </a:p>
            </p:txBody>
          </p:sp>
          <p:sp>
            <p:nvSpPr>
              <p:cNvPr id="217" name="CasellaDiTesto 216">
                <a:extLst>
                  <a:ext uri="{FF2B5EF4-FFF2-40B4-BE49-F238E27FC236}">
                    <a16:creationId xmlns:a16="http://schemas.microsoft.com/office/drawing/2014/main" id="{9F717EEE-AAA8-4DF2-9A6F-2614483D9879}"/>
                  </a:ext>
                </a:extLst>
              </p:cNvPr>
              <p:cNvSpPr txBox="1"/>
              <p:nvPr/>
            </p:nvSpPr>
            <p:spPr>
              <a:xfrm>
                <a:off x="2404451" y="3995432"/>
                <a:ext cx="335348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600" dirty="0">
                    <a:latin typeface="+mn-lt"/>
                  </a:rPr>
                  <a:t>0.01</a:t>
                </a:r>
              </a:p>
            </p:txBody>
          </p:sp>
          <p:sp>
            <p:nvSpPr>
              <p:cNvPr id="218" name="CasellaDiTesto 217">
                <a:extLst>
                  <a:ext uri="{FF2B5EF4-FFF2-40B4-BE49-F238E27FC236}">
                    <a16:creationId xmlns:a16="http://schemas.microsoft.com/office/drawing/2014/main" id="{06121880-ACF9-4995-89C8-04B04945349F}"/>
                  </a:ext>
                </a:extLst>
              </p:cNvPr>
              <p:cNvSpPr txBox="1"/>
              <p:nvPr/>
            </p:nvSpPr>
            <p:spPr>
              <a:xfrm>
                <a:off x="2573139" y="3995432"/>
                <a:ext cx="292068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600" dirty="0">
                    <a:latin typeface="+mn-lt"/>
                  </a:rPr>
                  <a:t>0.1</a:t>
                </a:r>
              </a:p>
            </p:txBody>
          </p:sp>
          <p:sp>
            <p:nvSpPr>
              <p:cNvPr id="219" name="CasellaDiTesto 218">
                <a:extLst>
                  <a:ext uri="{FF2B5EF4-FFF2-40B4-BE49-F238E27FC236}">
                    <a16:creationId xmlns:a16="http://schemas.microsoft.com/office/drawing/2014/main" id="{4B0D22FD-8EBC-40BD-8177-77E38720BF92}"/>
                  </a:ext>
                </a:extLst>
              </p:cNvPr>
              <p:cNvSpPr txBox="1"/>
              <p:nvPr/>
            </p:nvSpPr>
            <p:spPr>
              <a:xfrm>
                <a:off x="2719089" y="3995432"/>
                <a:ext cx="227948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600" dirty="0">
                    <a:latin typeface="+mn-lt"/>
                  </a:rPr>
                  <a:t>1</a:t>
                </a:r>
              </a:p>
            </p:txBody>
          </p:sp>
        </p:grpSp>
        <p:cxnSp>
          <p:nvCxnSpPr>
            <p:cNvPr id="214" name="Connettore diritto 213">
              <a:extLst>
                <a:ext uri="{FF2B5EF4-FFF2-40B4-BE49-F238E27FC236}">
                  <a16:creationId xmlns:a16="http://schemas.microsoft.com/office/drawing/2014/main" id="{444CEB4D-54BA-4DBC-B53D-10E302080913}"/>
                </a:ext>
              </a:extLst>
            </p:cNvPr>
            <p:cNvCxnSpPr>
              <a:cxnSpLocks/>
            </p:cNvCxnSpPr>
            <p:nvPr/>
          </p:nvCxnSpPr>
          <p:spPr>
            <a:xfrm>
              <a:off x="3028599" y="2804278"/>
              <a:ext cx="36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5" name="CasellaDiTesto 214">
              <a:extLst>
                <a:ext uri="{FF2B5EF4-FFF2-40B4-BE49-F238E27FC236}">
                  <a16:creationId xmlns:a16="http://schemas.microsoft.com/office/drawing/2014/main" id="{9B7D52DC-031D-47B9-A525-5EFDB819724F}"/>
                </a:ext>
              </a:extLst>
            </p:cNvPr>
            <p:cNvSpPr txBox="1"/>
            <p:nvPr/>
          </p:nvSpPr>
          <p:spPr>
            <a:xfrm>
              <a:off x="2863793" y="2546329"/>
              <a:ext cx="689612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IGF1-R</a:t>
              </a:r>
            </a:p>
          </p:txBody>
        </p:sp>
        <p:cxnSp>
          <p:nvCxnSpPr>
            <p:cNvPr id="212" name="Connettore diritto 211">
              <a:extLst>
                <a:ext uri="{FF2B5EF4-FFF2-40B4-BE49-F238E27FC236}">
                  <a16:creationId xmlns:a16="http://schemas.microsoft.com/office/drawing/2014/main" id="{53F2FA05-1438-48F7-A37D-6B7A4621318D}"/>
                </a:ext>
              </a:extLst>
            </p:cNvPr>
            <p:cNvCxnSpPr>
              <a:cxnSpLocks/>
            </p:cNvCxnSpPr>
            <p:nvPr/>
          </p:nvCxnSpPr>
          <p:spPr>
            <a:xfrm>
              <a:off x="3605683" y="2804278"/>
              <a:ext cx="36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3" name="CasellaDiTesto 212">
              <a:extLst>
                <a:ext uri="{FF2B5EF4-FFF2-40B4-BE49-F238E27FC236}">
                  <a16:creationId xmlns:a16="http://schemas.microsoft.com/office/drawing/2014/main" id="{30C7387D-AD67-479C-AB7A-06EE58C74C1A}"/>
                </a:ext>
              </a:extLst>
            </p:cNvPr>
            <p:cNvSpPr txBox="1"/>
            <p:nvPr/>
          </p:nvSpPr>
          <p:spPr>
            <a:xfrm>
              <a:off x="3440877" y="2546329"/>
              <a:ext cx="689612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FOXA1</a:t>
              </a:r>
            </a:p>
          </p:txBody>
        </p:sp>
        <p:cxnSp>
          <p:nvCxnSpPr>
            <p:cNvPr id="210" name="Connettore diritto 209">
              <a:extLst>
                <a:ext uri="{FF2B5EF4-FFF2-40B4-BE49-F238E27FC236}">
                  <a16:creationId xmlns:a16="http://schemas.microsoft.com/office/drawing/2014/main" id="{10289708-7DA6-4F83-8633-52AC0FE8109B}"/>
                </a:ext>
              </a:extLst>
            </p:cNvPr>
            <p:cNvCxnSpPr>
              <a:cxnSpLocks/>
            </p:cNvCxnSpPr>
            <p:nvPr/>
          </p:nvCxnSpPr>
          <p:spPr>
            <a:xfrm>
              <a:off x="4185893" y="2804278"/>
              <a:ext cx="36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1" name="CasellaDiTesto 210">
              <a:extLst>
                <a:ext uri="{FF2B5EF4-FFF2-40B4-BE49-F238E27FC236}">
                  <a16:creationId xmlns:a16="http://schemas.microsoft.com/office/drawing/2014/main" id="{2521AD77-69B4-4592-8708-256546A50988}"/>
                </a:ext>
              </a:extLst>
            </p:cNvPr>
            <p:cNvSpPr txBox="1"/>
            <p:nvPr/>
          </p:nvSpPr>
          <p:spPr>
            <a:xfrm>
              <a:off x="4122076" y="2546329"/>
              <a:ext cx="487634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ER</a:t>
              </a:r>
              <a:r>
                <a:rPr lang="el-G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endParaRPr lang="it-IT" sz="1200" dirty="0"/>
            </a:p>
          </p:txBody>
        </p:sp>
        <p:sp>
          <p:nvSpPr>
            <p:cNvPr id="173" name="CasellaDiTesto 172">
              <a:extLst>
                <a:ext uri="{FF2B5EF4-FFF2-40B4-BE49-F238E27FC236}">
                  <a16:creationId xmlns:a16="http://schemas.microsoft.com/office/drawing/2014/main" id="{A58538EB-D958-9005-54AC-B9CF97BB8039}"/>
                </a:ext>
              </a:extLst>
            </p:cNvPr>
            <p:cNvSpPr txBox="1"/>
            <p:nvPr/>
          </p:nvSpPr>
          <p:spPr>
            <a:xfrm>
              <a:off x="3276388" y="3337937"/>
              <a:ext cx="303288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*</a:t>
              </a:r>
            </a:p>
          </p:txBody>
        </p:sp>
        <p:sp>
          <p:nvSpPr>
            <p:cNvPr id="177" name="CasellaDiTesto 176">
              <a:extLst>
                <a:ext uri="{FF2B5EF4-FFF2-40B4-BE49-F238E27FC236}">
                  <a16:creationId xmlns:a16="http://schemas.microsoft.com/office/drawing/2014/main" id="{E3A12789-3C25-FCA8-DE04-5FCF50750CBA}"/>
                </a:ext>
              </a:extLst>
            </p:cNvPr>
            <p:cNvSpPr txBox="1"/>
            <p:nvPr/>
          </p:nvSpPr>
          <p:spPr>
            <a:xfrm>
              <a:off x="4348483" y="3164423"/>
              <a:ext cx="30328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**</a:t>
              </a:r>
            </a:p>
            <a:p>
              <a:r>
                <a:rPr lang="it-IT" sz="1200" dirty="0"/>
                <a:t>**</a:t>
              </a:r>
            </a:p>
          </p:txBody>
        </p:sp>
        <p:sp>
          <p:nvSpPr>
            <p:cNvPr id="182" name="CasellaDiTesto 181">
              <a:extLst>
                <a:ext uri="{FF2B5EF4-FFF2-40B4-BE49-F238E27FC236}">
                  <a16:creationId xmlns:a16="http://schemas.microsoft.com/office/drawing/2014/main" id="{E92C4116-E33E-E2C1-6FB5-A0E51CDA35F1}"/>
                </a:ext>
              </a:extLst>
            </p:cNvPr>
            <p:cNvSpPr txBox="1"/>
            <p:nvPr/>
          </p:nvSpPr>
          <p:spPr>
            <a:xfrm>
              <a:off x="3783840" y="3230949"/>
              <a:ext cx="386149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***</a:t>
              </a:r>
            </a:p>
          </p:txBody>
        </p:sp>
        <p:sp>
          <p:nvSpPr>
            <p:cNvPr id="183" name="CasellaDiTesto 182">
              <a:extLst>
                <a:ext uri="{FF2B5EF4-FFF2-40B4-BE49-F238E27FC236}">
                  <a16:creationId xmlns:a16="http://schemas.microsoft.com/office/drawing/2014/main" id="{28524874-D819-A198-1571-FCACFD2C7484}"/>
                </a:ext>
              </a:extLst>
            </p:cNvPr>
            <p:cNvSpPr txBox="1"/>
            <p:nvPr/>
          </p:nvSpPr>
          <p:spPr>
            <a:xfrm>
              <a:off x="4181726" y="3069881"/>
              <a:ext cx="386149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/>
                <a:t>**</a:t>
              </a:r>
            </a:p>
            <a:p>
              <a:pPr algn="ctr"/>
              <a:r>
                <a:rPr lang="it-IT" sz="1200" dirty="0"/>
                <a:t>*</a:t>
              </a:r>
            </a:p>
          </p:txBody>
        </p:sp>
        <p:grpSp>
          <p:nvGrpSpPr>
            <p:cNvPr id="233" name="Gruppo 232">
              <a:extLst>
                <a:ext uri="{FF2B5EF4-FFF2-40B4-BE49-F238E27FC236}">
                  <a16:creationId xmlns:a16="http://schemas.microsoft.com/office/drawing/2014/main" id="{80D7B6E0-9BBE-5A14-8AA3-9E88D1714DF4}"/>
                </a:ext>
              </a:extLst>
            </p:cNvPr>
            <p:cNvGrpSpPr/>
            <p:nvPr/>
          </p:nvGrpSpPr>
          <p:grpSpPr>
            <a:xfrm>
              <a:off x="2916812" y="4000356"/>
              <a:ext cx="613160" cy="184666"/>
              <a:chOff x="2333877" y="3995432"/>
              <a:chExt cx="613160" cy="184666"/>
            </a:xfrm>
          </p:grpSpPr>
          <p:sp>
            <p:nvSpPr>
              <p:cNvPr id="234" name="CasellaDiTesto 233">
                <a:extLst>
                  <a:ext uri="{FF2B5EF4-FFF2-40B4-BE49-F238E27FC236}">
                    <a16:creationId xmlns:a16="http://schemas.microsoft.com/office/drawing/2014/main" id="{B922982A-31EA-A8F9-0D30-7B609C1D8300}"/>
                  </a:ext>
                </a:extLst>
              </p:cNvPr>
              <p:cNvSpPr txBox="1"/>
              <p:nvPr/>
            </p:nvSpPr>
            <p:spPr>
              <a:xfrm>
                <a:off x="2333877" y="3995432"/>
                <a:ext cx="227948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600" dirty="0">
                    <a:latin typeface="+mn-lt"/>
                  </a:rPr>
                  <a:t>0</a:t>
                </a:r>
              </a:p>
            </p:txBody>
          </p:sp>
          <p:sp>
            <p:nvSpPr>
              <p:cNvPr id="235" name="CasellaDiTesto 234">
                <a:extLst>
                  <a:ext uri="{FF2B5EF4-FFF2-40B4-BE49-F238E27FC236}">
                    <a16:creationId xmlns:a16="http://schemas.microsoft.com/office/drawing/2014/main" id="{12D3346F-25D1-A9E7-1844-4A4D27B6304C}"/>
                  </a:ext>
                </a:extLst>
              </p:cNvPr>
              <p:cNvSpPr txBox="1"/>
              <p:nvPr/>
            </p:nvSpPr>
            <p:spPr>
              <a:xfrm>
                <a:off x="2404451" y="3995432"/>
                <a:ext cx="335348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600" dirty="0">
                    <a:latin typeface="+mn-lt"/>
                  </a:rPr>
                  <a:t>0.01</a:t>
                </a:r>
              </a:p>
            </p:txBody>
          </p:sp>
          <p:sp>
            <p:nvSpPr>
              <p:cNvPr id="236" name="CasellaDiTesto 235">
                <a:extLst>
                  <a:ext uri="{FF2B5EF4-FFF2-40B4-BE49-F238E27FC236}">
                    <a16:creationId xmlns:a16="http://schemas.microsoft.com/office/drawing/2014/main" id="{599F4223-DB4F-0DA7-9F58-41549815FE8E}"/>
                  </a:ext>
                </a:extLst>
              </p:cNvPr>
              <p:cNvSpPr txBox="1"/>
              <p:nvPr/>
            </p:nvSpPr>
            <p:spPr>
              <a:xfrm>
                <a:off x="2573139" y="3995432"/>
                <a:ext cx="292068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600" dirty="0">
                    <a:latin typeface="+mn-lt"/>
                  </a:rPr>
                  <a:t>0.1</a:t>
                </a:r>
              </a:p>
            </p:txBody>
          </p:sp>
          <p:sp>
            <p:nvSpPr>
              <p:cNvPr id="237" name="CasellaDiTesto 236">
                <a:extLst>
                  <a:ext uri="{FF2B5EF4-FFF2-40B4-BE49-F238E27FC236}">
                    <a16:creationId xmlns:a16="http://schemas.microsoft.com/office/drawing/2014/main" id="{9E12EC15-01AF-77AC-D70C-A0D5B7060EED}"/>
                  </a:ext>
                </a:extLst>
              </p:cNvPr>
              <p:cNvSpPr txBox="1"/>
              <p:nvPr/>
            </p:nvSpPr>
            <p:spPr>
              <a:xfrm>
                <a:off x="2719089" y="3995432"/>
                <a:ext cx="227948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600" dirty="0">
                    <a:latin typeface="+mn-lt"/>
                  </a:rPr>
                  <a:t>1</a:t>
                </a:r>
              </a:p>
            </p:txBody>
          </p:sp>
        </p:grpSp>
        <p:grpSp>
          <p:nvGrpSpPr>
            <p:cNvPr id="238" name="Gruppo 237">
              <a:extLst>
                <a:ext uri="{FF2B5EF4-FFF2-40B4-BE49-F238E27FC236}">
                  <a16:creationId xmlns:a16="http://schemas.microsoft.com/office/drawing/2014/main" id="{3E02D2D2-D06E-FDD8-28CF-AC552DABB223}"/>
                </a:ext>
              </a:extLst>
            </p:cNvPr>
            <p:cNvGrpSpPr/>
            <p:nvPr/>
          </p:nvGrpSpPr>
          <p:grpSpPr>
            <a:xfrm>
              <a:off x="3472796" y="4000356"/>
              <a:ext cx="613160" cy="184666"/>
              <a:chOff x="2333877" y="3995432"/>
              <a:chExt cx="613160" cy="184666"/>
            </a:xfrm>
          </p:grpSpPr>
          <p:sp>
            <p:nvSpPr>
              <p:cNvPr id="239" name="CasellaDiTesto 238">
                <a:extLst>
                  <a:ext uri="{FF2B5EF4-FFF2-40B4-BE49-F238E27FC236}">
                    <a16:creationId xmlns:a16="http://schemas.microsoft.com/office/drawing/2014/main" id="{82AFED8E-F0A1-54E7-877B-FF81603BD37E}"/>
                  </a:ext>
                </a:extLst>
              </p:cNvPr>
              <p:cNvSpPr txBox="1"/>
              <p:nvPr/>
            </p:nvSpPr>
            <p:spPr>
              <a:xfrm>
                <a:off x="2333877" y="3995432"/>
                <a:ext cx="227948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600" dirty="0">
                    <a:latin typeface="+mn-lt"/>
                  </a:rPr>
                  <a:t>0</a:t>
                </a:r>
              </a:p>
            </p:txBody>
          </p:sp>
          <p:sp>
            <p:nvSpPr>
              <p:cNvPr id="240" name="CasellaDiTesto 239">
                <a:extLst>
                  <a:ext uri="{FF2B5EF4-FFF2-40B4-BE49-F238E27FC236}">
                    <a16:creationId xmlns:a16="http://schemas.microsoft.com/office/drawing/2014/main" id="{4813D7DF-4D23-84A5-8B62-9E0F4BE2A679}"/>
                  </a:ext>
                </a:extLst>
              </p:cNvPr>
              <p:cNvSpPr txBox="1"/>
              <p:nvPr/>
            </p:nvSpPr>
            <p:spPr>
              <a:xfrm>
                <a:off x="2404451" y="3995432"/>
                <a:ext cx="335348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600" dirty="0">
                    <a:latin typeface="+mn-lt"/>
                  </a:rPr>
                  <a:t>0.01</a:t>
                </a:r>
              </a:p>
            </p:txBody>
          </p:sp>
          <p:sp>
            <p:nvSpPr>
              <p:cNvPr id="241" name="CasellaDiTesto 240">
                <a:extLst>
                  <a:ext uri="{FF2B5EF4-FFF2-40B4-BE49-F238E27FC236}">
                    <a16:creationId xmlns:a16="http://schemas.microsoft.com/office/drawing/2014/main" id="{7988A363-A1C4-F64B-7432-87F305477A6A}"/>
                  </a:ext>
                </a:extLst>
              </p:cNvPr>
              <p:cNvSpPr txBox="1"/>
              <p:nvPr/>
            </p:nvSpPr>
            <p:spPr>
              <a:xfrm>
                <a:off x="2573139" y="3995432"/>
                <a:ext cx="292068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600" dirty="0">
                    <a:latin typeface="+mn-lt"/>
                  </a:rPr>
                  <a:t>0.1</a:t>
                </a:r>
              </a:p>
            </p:txBody>
          </p:sp>
          <p:sp>
            <p:nvSpPr>
              <p:cNvPr id="242" name="CasellaDiTesto 241">
                <a:extLst>
                  <a:ext uri="{FF2B5EF4-FFF2-40B4-BE49-F238E27FC236}">
                    <a16:creationId xmlns:a16="http://schemas.microsoft.com/office/drawing/2014/main" id="{F4A5D80D-D3D3-17F6-949B-9B9B41AB4AD4}"/>
                  </a:ext>
                </a:extLst>
              </p:cNvPr>
              <p:cNvSpPr txBox="1"/>
              <p:nvPr/>
            </p:nvSpPr>
            <p:spPr>
              <a:xfrm>
                <a:off x="2719089" y="3995432"/>
                <a:ext cx="227948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600" dirty="0">
                    <a:latin typeface="+mn-lt"/>
                  </a:rPr>
                  <a:t>1</a:t>
                </a:r>
              </a:p>
            </p:txBody>
          </p:sp>
        </p:grpSp>
        <p:grpSp>
          <p:nvGrpSpPr>
            <p:cNvPr id="243" name="Gruppo 242">
              <a:extLst>
                <a:ext uri="{FF2B5EF4-FFF2-40B4-BE49-F238E27FC236}">
                  <a16:creationId xmlns:a16="http://schemas.microsoft.com/office/drawing/2014/main" id="{6B068DF0-3320-AE1C-1853-32320CFD3DD8}"/>
                </a:ext>
              </a:extLst>
            </p:cNvPr>
            <p:cNvGrpSpPr/>
            <p:nvPr/>
          </p:nvGrpSpPr>
          <p:grpSpPr>
            <a:xfrm>
              <a:off x="4041903" y="4000356"/>
              <a:ext cx="613160" cy="184666"/>
              <a:chOff x="2333877" y="3995432"/>
              <a:chExt cx="613160" cy="184666"/>
            </a:xfrm>
          </p:grpSpPr>
          <p:sp>
            <p:nvSpPr>
              <p:cNvPr id="244" name="CasellaDiTesto 243">
                <a:extLst>
                  <a:ext uri="{FF2B5EF4-FFF2-40B4-BE49-F238E27FC236}">
                    <a16:creationId xmlns:a16="http://schemas.microsoft.com/office/drawing/2014/main" id="{6E7CE3C7-C636-EC69-9EEC-C647CE87F4D7}"/>
                  </a:ext>
                </a:extLst>
              </p:cNvPr>
              <p:cNvSpPr txBox="1"/>
              <p:nvPr/>
            </p:nvSpPr>
            <p:spPr>
              <a:xfrm>
                <a:off x="2333877" y="3995432"/>
                <a:ext cx="227948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600" dirty="0">
                    <a:latin typeface="+mn-lt"/>
                  </a:rPr>
                  <a:t>0</a:t>
                </a:r>
              </a:p>
            </p:txBody>
          </p:sp>
          <p:sp>
            <p:nvSpPr>
              <p:cNvPr id="245" name="CasellaDiTesto 244">
                <a:extLst>
                  <a:ext uri="{FF2B5EF4-FFF2-40B4-BE49-F238E27FC236}">
                    <a16:creationId xmlns:a16="http://schemas.microsoft.com/office/drawing/2014/main" id="{D7E153C0-2E1C-6AF1-4482-915EDF9C50D7}"/>
                  </a:ext>
                </a:extLst>
              </p:cNvPr>
              <p:cNvSpPr txBox="1"/>
              <p:nvPr/>
            </p:nvSpPr>
            <p:spPr>
              <a:xfrm>
                <a:off x="2404451" y="3995432"/>
                <a:ext cx="335348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600" dirty="0">
                    <a:latin typeface="+mn-lt"/>
                  </a:rPr>
                  <a:t>0.01</a:t>
                </a:r>
              </a:p>
            </p:txBody>
          </p:sp>
          <p:sp>
            <p:nvSpPr>
              <p:cNvPr id="246" name="CasellaDiTesto 245">
                <a:extLst>
                  <a:ext uri="{FF2B5EF4-FFF2-40B4-BE49-F238E27FC236}">
                    <a16:creationId xmlns:a16="http://schemas.microsoft.com/office/drawing/2014/main" id="{C4B391F6-5E7E-415E-2109-D9C14E2C54E7}"/>
                  </a:ext>
                </a:extLst>
              </p:cNvPr>
              <p:cNvSpPr txBox="1"/>
              <p:nvPr/>
            </p:nvSpPr>
            <p:spPr>
              <a:xfrm>
                <a:off x="2573139" y="3995432"/>
                <a:ext cx="292068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600" dirty="0">
                    <a:latin typeface="+mn-lt"/>
                  </a:rPr>
                  <a:t>0.1</a:t>
                </a:r>
              </a:p>
            </p:txBody>
          </p:sp>
          <p:sp>
            <p:nvSpPr>
              <p:cNvPr id="247" name="CasellaDiTesto 246">
                <a:extLst>
                  <a:ext uri="{FF2B5EF4-FFF2-40B4-BE49-F238E27FC236}">
                    <a16:creationId xmlns:a16="http://schemas.microsoft.com/office/drawing/2014/main" id="{CE0CEBC5-409F-1708-1F4D-9A28493E8F5D}"/>
                  </a:ext>
                </a:extLst>
              </p:cNvPr>
              <p:cNvSpPr txBox="1"/>
              <p:nvPr/>
            </p:nvSpPr>
            <p:spPr>
              <a:xfrm>
                <a:off x="2719089" y="3995432"/>
                <a:ext cx="227948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600" dirty="0">
                    <a:latin typeface="+mn-lt"/>
                  </a:rPr>
                  <a:t>1</a:t>
                </a:r>
              </a:p>
            </p:txBody>
          </p:sp>
        </p:grpSp>
        <p:sp>
          <p:nvSpPr>
            <p:cNvPr id="202" name="CasellaDiTesto 201">
              <a:extLst>
                <a:ext uri="{FF2B5EF4-FFF2-40B4-BE49-F238E27FC236}">
                  <a16:creationId xmlns:a16="http://schemas.microsoft.com/office/drawing/2014/main" id="{9FDDCB9C-BB7E-234F-0CB9-0748B74ECE04}"/>
                </a:ext>
              </a:extLst>
            </p:cNvPr>
            <p:cNvSpPr txBox="1"/>
            <p:nvPr/>
          </p:nvSpPr>
          <p:spPr>
            <a:xfrm>
              <a:off x="2489407" y="2899628"/>
              <a:ext cx="30328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**</a:t>
              </a:r>
            </a:p>
            <a:p>
              <a:r>
                <a:rPr lang="it-IT" sz="1200" dirty="0"/>
                <a:t>**</a:t>
              </a:r>
            </a:p>
          </p:txBody>
        </p:sp>
        <p:sp>
          <p:nvSpPr>
            <p:cNvPr id="207" name="CasellaDiTesto 206">
              <a:extLst>
                <a:ext uri="{FF2B5EF4-FFF2-40B4-BE49-F238E27FC236}">
                  <a16:creationId xmlns:a16="http://schemas.microsoft.com/office/drawing/2014/main" id="{9D44D22C-775B-794A-5C5A-C0C299403E98}"/>
                </a:ext>
              </a:extLst>
            </p:cNvPr>
            <p:cNvSpPr txBox="1"/>
            <p:nvPr/>
          </p:nvSpPr>
          <p:spPr>
            <a:xfrm>
              <a:off x="2591185" y="3188315"/>
              <a:ext cx="30328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**</a:t>
              </a:r>
            </a:p>
            <a:p>
              <a:r>
                <a:rPr lang="it-IT" sz="1200" dirty="0"/>
                <a:t>**</a:t>
              </a:r>
            </a:p>
          </p:txBody>
        </p:sp>
        <p:sp>
          <p:nvSpPr>
            <p:cNvPr id="208" name="CasellaDiTesto 207">
              <a:extLst>
                <a:ext uri="{FF2B5EF4-FFF2-40B4-BE49-F238E27FC236}">
                  <a16:creationId xmlns:a16="http://schemas.microsoft.com/office/drawing/2014/main" id="{81040BEF-766C-D939-8D43-496880AD845D}"/>
                </a:ext>
              </a:extLst>
            </p:cNvPr>
            <p:cNvSpPr txBox="1"/>
            <p:nvPr/>
          </p:nvSpPr>
          <p:spPr>
            <a:xfrm>
              <a:off x="2702050" y="3483131"/>
              <a:ext cx="30328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**</a:t>
              </a:r>
            </a:p>
            <a:p>
              <a:r>
                <a:rPr lang="it-IT" sz="1200" dirty="0"/>
                <a:t>**</a:t>
              </a:r>
            </a:p>
          </p:txBody>
        </p:sp>
      </p:grp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066D7556-77C7-44D9-BFDD-1EA1FF5DA3DB}"/>
              </a:ext>
            </a:extLst>
          </p:cNvPr>
          <p:cNvSpPr txBox="1"/>
          <p:nvPr/>
        </p:nvSpPr>
        <p:spPr>
          <a:xfrm>
            <a:off x="2240213" y="0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ementary</a:t>
            </a:r>
            <a:r>
              <a:rPr lang="it-IT" b="1" dirty="0"/>
              <a:t> Fig. 5</a:t>
            </a:r>
          </a:p>
        </p:txBody>
      </p:sp>
      <p:sp>
        <p:nvSpPr>
          <p:cNvPr id="54" name="CasellaDiTesto 53">
            <a:extLst>
              <a:ext uri="{FF2B5EF4-FFF2-40B4-BE49-F238E27FC236}">
                <a16:creationId xmlns:a16="http://schemas.microsoft.com/office/drawing/2014/main" id="{235815AB-1DD5-4B7C-B34E-2A69F262252D}"/>
              </a:ext>
            </a:extLst>
          </p:cNvPr>
          <p:cNvSpPr txBox="1"/>
          <p:nvPr/>
        </p:nvSpPr>
        <p:spPr>
          <a:xfrm>
            <a:off x="1213491" y="387849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a)</a:t>
            </a:r>
          </a:p>
        </p:txBody>
      </p:sp>
      <p:sp>
        <p:nvSpPr>
          <p:cNvPr id="55" name="CasellaDiTesto 54">
            <a:extLst>
              <a:ext uri="{FF2B5EF4-FFF2-40B4-BE49-F238E27FC236}">
                <a16:creationId xmlns:a16="http://schemas.microsoft.com/office/drawing/2014/main" id="{CBF44166-1A91-4A7B-B47B-004685A4E37F}"/>
              </a:ext>
            </a:extLst>
          </p:cNvPr>
          <p:cNvSpPr txBox="1"/>
          <p:nvPr/>
        </p:nvSpPr>
        <p:spPr>
          <a:xfrm>
            <a:off x="1209483" y="2267744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b)</a:t>
            </a:r>
          </a:p>
        </p:txBody>
      </p:sp>
      <p:sp>
        <p:nvSpPr>
          <p:cNvPr id="57" name="CasellaDiTesto 56">
            <a:extLst>
              <a:ext uri="{FF2B5EF4-FFF2-40B4-BE49-F238E27FC236}">
                <a16:creationId xmlns:a16="http://schemas.microsoft.com/office/drawing/2014/main" id="{C0E3BF50-FE3B-4DFA-943B-F8F41333CD7C}"/>
              </a:ext>
            </a:extLst>
          </p:cNvPr>
          <p:cNvSpPr txBox="1"/>
          <p:nvPr/>
        </p:nvSpPr>
        <p:spPr>
          <a:xfrm>
            <a:off x="1209483" y="5991958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d)</a:t>
            </a:r>
          </a:p>
        </p:txBody>
      </p:sp>
      <p:grpSp>
        <p:nvGrpSpPr>
          <p:cNvPr id="193" name="Gruppo 192">
            <a:extLst>
              <a:ext uri="{FF2B5EF4-FFF2-40B4-BE49-F238E27FC236}">
                <a16:creationId xmlns:a16="http://schemas.microsoft.com/office/drawing/2014/main" id="{94AE7D3B-82B1-4FE8-A978-7EC0EE7D64FE}"/>
              </a:ext>
            </a:extLst>
          </p:cNvPr>
          <p:cNvGrpSpPr/>
          <p:nvPr/>
        </p:nvGrpSpPr>
        <p:grpSpPr>
          <a:xfrm>
            <a:off x="1974888" y="462146"/>
            <a:ext cx="2638676" cy="1878263"/>
            <a:chOff x="395689" y="924208"/>
            <a:chExt cx="2638676" cy="1878263"/>
          </a:xfrm>
        </p:grpSpPr>
        <p:pic>
          <p:nvPicPr>
            <p:cNvPr id="184" name="Immagine 183">
              <a:extLst>
                <a:ext uri="{FF2B5EF4-FFF2-40B4-BE49-F238E27FC236}">
                  <a16:creationId xmlns:a16="http://schemas.microsoft.com/office/drawing/2014/main" id="{56F6AE17-20E9-46D5-89CC-D8A0A01E7DD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25802" y="1099839"/>
              <a:ext cx="1810884" cy="1260000"/>
            </a:xfrm>
            <a:prstGeom prst="rect">
              <a:avLst/>
            </a:prstGeom>
          </p:spPr>
        </p:pic>
        <p:sp>
          <p:nvSpPr>
            <p:cNvPr id="147" name="CasellaDiTesto 146">
              <a:extLst>
                <a:ext uri="{FF2B5EF4-FFF2-40B4-BE49-F238E27FC236}">
                  <a16:creationId xmlns:a16="http://schemas.microsoft.com/office/drawing/2014/main" id="{FD33D232-623A-423C-AB16-68589B988C9D}"/>
                </a:ext>
              </a:extLst>
            </p:cNvPr>
            <p:cNvSpPr txBox="1"/>
            <p:nvPr/>
          </p:nvSpPr>
          <p:spPr>
            <a:xfrm>
              <a:off x="1329469" y="2525472"/>
              <a:ext cx="116730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+mn-lt"/>
                </a:rPr>
                <a:t>FOXA1 </a:t>
              </a:r>
              <a:r>
                <a:rPr lang="it-IT" sz="1200" dirty="0" err="1">
                  <a:latin typeface="+mn-lt"/>
                </a:rPr>
                <a:t>siRNA</a:t>
              </a:r>
              <a:endParaRPr lang="it-IT" sz="1200" dirty="0">
                <a:latin typeface="+mn-lt"/>
              </a:endParaRPr>
            </a:p>
          </p:txBody>
        </p:sp>
        <p:sp>
          <p:nvSpPr>
            <p:cNvPr id="148" name="CasellaDiTesto 147">
              <a:extLst>
                <a:ext uri="{FF2B5EF4-FFF2-40B4-BE49-F238E27FC236}">
                  <a16:creationId xmlns:a16="http://schemas.microsoft.com/office/drawing/2014/main" id="{1007F6C9-F5B4-48AF-9877-64E63BC5750B}"/>
                </a:ext>
              </a:extLst>
            </p:cNvPr>
            <p:cNvSpPr txBox="1"/>
            <p:nvPr/>
          </p:nvSpPr>
          <p:spPr>
            <a:xfrm rot="16200000">
              <a:off x="48478" y="1471817"/>
              <a:ext cx="115608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 err="1"/>
                <a:t>Protein</a:t>
              </a:r>
              <a:r>
                <a:rPr lang="it-IT" sz="1200" dirty="0"/>
                <a:t> </a:t>
              </a:r>
              <a:r>
                <a:rPr lang="it-IT" sz="1200" dirty="0" err="1"/>
                <a:t>Levels</a:t>
              </a:r>
              <a:endParaRPr lang="it-IT" sz="1200" dirty="0"/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0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149" name="CasellaDiTesto 148">
              <a:extLst>
                <a:ext uri="{FF2B5EF4-FFF2-40B4-BE49-F238E27FC236}">
                  <a16:creationId xmlns:a16="http://schemas.microsoft.com/office/drawing/2014/main" id="{D1CF2D2A-58CB-45F6-85AC-E63F0D40DC62}"/>
                </a:ext>
              </a:extLst>
            </p:cNvPr>
            <p:cNvSpPr txBox="1"/>
            <p:nvPr/>
          </p:nvSpPr>
          <p:spPr>
            <a:xfrm>
              <a:off x="724985" y="968530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5</a:t>
              </a:r>
            </a:p>
          </p:txBody>
        </p:sp>
        <p:sp>
          <p:nvSpPr>
            <p:cNvPr id="150" name="CasellaDiTesto 149">
              <a:extLst>
                <a:ext uri="{FF2B5EF4-FFF2-40B4-BE49-F238E27FC236}">
                  <a16:creationId xmlns:a16="http://schemas.microsoft.com/office/drawing/2014/main" id="{51040684-128A-45BD-9E6D-43C59B4668A0}"/>
                </a:ext>
              </a:extLst>
            </p:cNvPr>
            <p:cNvSpPr txBox="1"/>
            <p:nvPr/>
          </p:nvSpPr>
          <p:spPr>
            <a:xfrm>
              <a:off x="724985" y="1361950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0</a:t>
              </a:r>
            </a:p>
          </p:txBody>
        </p:sp>
        <p:sp>
          <p:nvSpPr>
            <p:cNvPr id="151" name="CasellaDiTesto 150">
              <a:extLst>
                <a:ext uri="{FF2B5EF4-FFF2-40B4-BE49-F238E27FC236}">
                  <a16:creationId xmlns:a16="http://schemas.microsoft.com/office/drawing/2014/main" id="{2AB2FD14-6708-451A-9E50-F9B8C2EC7118}"/>
                </a:ext>
              </a:extLst>
            </p:cNvPr>
            <p:cNvSpPr txBox="1"/>
            <p:nvPr/>
          </p:nvSpPr>
          <p:spPr>
            <a:xfrm>
              <a:off x="724985" y="2167469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grpSp>
          <p:nvGrpSpPr>
            <p:cNvPr id="152" name="Gruppo 151">
              <a:extLst>
                <a:ext uri="{FF2B5EF4-FFF2-40B4-BE49-F238E27FC236}">
                  <a16:creationId xmlns:a16="http://schemas.microsoft.com/office/drawing/2014/main" id="{D32598A7-D19F-4862-8F6F-AD78E8B19C69}"/>
                </a:ext>
              </a:extLst>
            </p:cNvPr>
            <p:cNvGrpSpPr/>
            <p:nvPr/>
          </p:nvGrpSpPr>
          <p:grpSpPr>
            <a:xfrm>
              <a:off x="1040234" y="924208"/>
              <a:ext cx="569387" cy="276999"/>
              <a:chOff x="1249198" y="3449955"/>
              <a:chExt cx="569387" cy="276999"/>
            </a:xfrm>
          </p:grpSpPr>
          <p:cxnSp>
            <p:nvCxnSpPr>
              <p:cNvPr id="178" name="Connettore diritto 177">
                <a:extLst>
                  <a:ext uri="{FF2B5EF4-FFF2-40B4-BE49-F238E27FC236}">
                    <a16:creationId xmlns:a16="http://schemas.microsoft.com/office/drawing/2014/main" id="{E553F8D1-0DC2-4574-934E-64AD72B9C3F1}"/>
                  </a:ext>
                </a:extLst>
              </p:cNvPr>
              <p:cNvCxnSpPr/>
              <p:nvPr/>
            </p:nvCxnSpPr>
            <p:spPr>
              <a:xfrm>
                <a:off x="1342551" y="3707904"/>
                <a:ext cx="36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9" name="CasellaDiTesto 178">
                <a:extLst>
                  <a:ext uri="{FF2B5EF4-FFF2-40B4-BE49-F238E27FC236}">
                    <a16:creationId xmlns:a16="http://schemas.microsoft.com/office/drawing/2014/main" id="{0E58E1AE-23E6-417D-9FAC-13D1A8F7C676}"/>
                  </a:ext>
                </a:extLst>
              </p:cNvPr>
              <p:cNvSpPr txBox="1"/>
              <p:nvPr/>
            </p:nvSpPr>
            <p:spPr>
              <a:xfrm>
                <a:off x="1249198" y="3449955"/>
                <a:ext cx="5693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err="1"/>
                  <a:t>pAKT</a:t>
                </a:r>
                <a:endParaRPr lang="it-IT" sz="1200" dirty="0"/>
              </a:p>
            </p:txBody>
          </p:sp>
        </p:grpSp>
        <p:sp>
          <p:nvSpPr>
            <p:cNvPr id="153" name="CasellaDiTesto 152">
              <a:extLst>
                <a:ext uri="{FF2B5EF4-FFF2-40B4-BE49-F238E27FC236}">
                  <a16:creationId xmlns:a16="http://schemas.microsoft.com/office/drawing/2014/main" id="{B506C4AB-7F8A-4D43-AA24-343068F02160}"/>
                </a:ext>
              </a:extLst>
            </p:cNvPr>
            <p:cNvSpPr txBox="1"/>
            <p:nvPr/>
          </p:nvSpPr>
          <p:spPr>
            <a:xfrm>
              <a:off x="724985" y="1758423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5</a:t>
              </a:r>
            </a:p>
          </p:txBody>
        </p:sp>
        <p:sp>
          <p:nvSpPr>
            <p:cNvPr id="168" name="CasellaDiTesto 167">
              <a:extLst>
                <a:ext uri="{FF2B5EF4-FFF2-40B4-BE49-F238E27FC236}">
                  <a16:creationId xmlns:a16="http://schemas.microsoft.com/office/drawing/2014/main" id="{05A04480-E907-4589-82C2-2B0704386F6A}"/>
                </a:ext>
              </a:extLst>
            </p:cNvPr>
            <p:cNvSpPr txBox="1"/>
            <p:nvPr/>
          </p:nvSpPr>
          <p:spPr>
            <a:xfrm>
              <a:off x="1236526" y="2294748"/>
              <a:ext cx="274434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+mn-lt"/>
                </a:rPr>
                <a:t>+</a:t>
              </a:r>
            </a:p>
          </p:txBody>
        </p:sp>
        <p:sp>
          <p:nvSpPr>
            <p:cNvPr id="169" name="CasellaDiTesto 168">
              <a:extLst>
                <a:ext uri="{FF2B5EF4-FFF2-40B4-BE49-F238E27FC236}">
                  <a16:creationId xmlns:a16="http://schemas.microsoft.com/office/drawing/2014/main" id="{35ED9D53-7BF3-476F-A8F7-EC15C1D992D2}"/>
                </a:ext>
              </a:extLst>
            </p:cNvPr>
            <p:cNvSpPr txBox="1"/>
            <p:nvPr/>
          </p:nvSpPr>
          <p:spPr>
            <a:xfrm>
              <a:off x="1091994" y="2294748"/>
              <a:ext cx="235962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+mn-lt"/>
                </a:rPr>
                <a:t>-</a:t>
              </a:r>
            </a:p>
          </p:txBody>
        </p:sp>
        <p:grpSp>
          <p:nvGrpSpPr>
            <p:cNvPr id="157" name="Gruppo 156">
              <a:extLst>
                <a:ext uri="{FF2B5EF4-FFF2-40B4-BE49-F238E27FC236}">
                  <a16:creationId xmlns:a16="http://schemas.microsoft.com/office/drawing/2014/main" id="{2774B794-9021-49F0-8712-CA058D01C532}"/>
                </a:ext>
              </a:extLst>
            </p:cNvPr>
            <p:cNvGrpSpPr/>
            <p:nvPr/>
          </p:nvGrpSpPr>
          <p:grpSpPr>
            <a:xfrm>
              <a:off x="1440792" y="924208"/>
              <a:ext cx="689612" cy="276999"/>
              <a:chOff x="1185698" y="3449955"/>
              <a:chExt cx="689612" cy="276999"/>
            </a:xfrm>
          </p:grpSpPr>
          <p:cxnSp>
            <p:nvCxnSpPr>
              <p:cNvPr id="164" name="Connettore diritto 163">
                <a:extLst>
                  <a:ext uri="{FF2B5EF4-FFF2-40B4-BE49-F238E27FC236}">
                    <a16:creationId xmlns:a16="http://schemas.microsoft.com/office/drawing/2014/main" id="{E8BEF3F7-B2AC-41C0-8322-97A78211F434}"/>
                  </a:ext>
                </a:extLst>
              </p:cNvPr>
              <p:cNvCxnSpPr/>
              <p:nvPr/>
            </p:nvCxnSpPr>
            <p:spPr>
              <a:xfrm>
                <a:off x="1342551" y="3707904"/>
                <a:ext cx="36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5" name="CasellaDiTesto 164">
                <a:extLst>
                  <a:ext uri="{FF2B5EF4-FFF2-40B4-BE49-F238E27FC236}">
                    <a16:creationId xmlns:a16="http://schemas.microsoft.com/office/drawing/2014/main" id="{AA2465F8-0E2D-4481-87FD-4FC64E857915}"/>
                  </a:ext>
                </a:extLst>
              </p:cNvPr>
              <p:cNvSpPr txBox="1"/>
              <p:nvPr/>
            </p:nvSpPr>
            <p:spPr>
              <a:xfrm>
                <a:off x="1185698" y="3449955"/>
                <a:ext cx="6896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IGF1-R</a:t>
                </a:r>
              </a:p>
            </p:txBody>
          </p:sp>
        </p:grpSp>
        <p:grpSp>
          <p:nvGrpSpPr>
            <p:cNvPr id="158" name="Gruppo 157">
              <a:extLst>
                <a:ext uri="{FF2B5EF4-FFF2-40B4-BE49-F238E27FC236}">
                  <a16:creationId xmlns:a16="http://schemas.microsoft.com/office/drawing/2014/main" id="{983D8859-7FC2-4D5E-8E1B-A282F62D059F}"/>
                </a:ext>
              </a:extLst>
            </p:cNvPr>
            <p:cNvGrpSpPr/>
            <p:nvPr/>
          </p:nvGrpSpPr>
          <p:grpSpPr>
            <a:xfrm>
              <a:off x="1987454" y="924208"/>
              <a:ext cx="689612" cy="276999"/>
              <a:chOff x="1217448" y="3449955"/>
              <a:chExt cx="689612" cy="276999"/>
            </a:xfrm>
          </p:grpSpPr>
          <p:cxnSp>
            <p:nvCxnSpPr>
              <p:cNvPr id="162" name="Connettore diritto 161">
                <a:extLst>
                  <a:ext uri="{FF2B5EF4-FFF2-40B4-BE49-F238E27FC236}">
                    <a16:creationId xmlns:a16="http://schemas.microsoft.com/office/drawing/2014/main" id="{1E9ABE8B-3859-425B-847E-E63600CD770F}"/>
                  </a:ext>
                </a:extLst>
              </p:cNvPr>
              <p:cNvCxnSpPr/>
              <p:nvPr/>
            </p:nvCxnSpPr>
            <p:spPr>
              <a:xfrm>
                <a:off x="1342551" y="3707904"/>
                <a:ext cx="36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3" name="CasellaDiTesto 162">
                <a:extLst>
                  <a:ext uri="{FF2B5EF4-FFF2-40B4-BE49-F238E27FC236}">
                    <a16:creationId xmlns:a16="http://schemas.microsoft.com/office/drawing/2014/main" id="{4855CB99-4570-4875-8483-1A921A352062}"/>
                  </a:ext>
                </a:extLst>
              </p:cNvPr>
              <p:cNvSpPr txBox="1"/>
              <p:nvPr/>
            </p:nvSpPr>
            <p:spPr>
              <a:xfrm>
                <a:off x="1217448" y="3449955"/>
                <a:ext cx="6896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FOXA1</a:t>
                </a:r>
              </a:p>
            </p:txBody>
          </p:sp>
        </p:grpSp>
        <p:grpSp>
          <p:nvGrpSpPr>
            <p:cNvPr id="159" name="Gruppo 158">
              <a:extLst>
                <a:ext uri="{FF2B5EF4-FFF2-40B4-BE49-F238E27FC236}">
                  <a16:creationId xmlns:a16="http://schemas.microsoft.com/office/drawing/2014/main" id="{6F91A53D-F303-449C-BB62-64F0332EBADD}"/>
                </a:ext>
              </a:extLst>
            </p:cNvPr>
            <p:cNvGrpSpPr/>
            <p:nvPr/>
          </p:nvGrpSpPr>
          <p:grpSpPr>
            <a:xfrm>
              <a:off x="2546731" y="924208"/>
              <a:ext cx="487634" cy="276999"/>
              <a:chOff x="1299998" y="3449955"/>
              <a:chExt cx="487634" cy="276999"/>
            </a:xfrm>
          </p:grpSpPr>
          <p:cxnSp>
            <p:nvCxnSpPr>
              <p:cNvPr id="160" name="Connettore diritto 159">
                <a:extLst>
                  <a:ext uri="{FF2B5EF4-FFF2-40B4-BE49-F238E27FC236}">
                    <a16:creationId xmlns:a16="http://schemas.microsoft.com/office/drawing/2014/main" id="{2ABA0B76-B562-4E00-9CE1-EC4130FDD6E6}"/>
                  </a:ext>
                </a:extLst>
              </p:cNvPr>
              <p:cNvCxnSpPr/>
              <p:nvPr/>
            </p:nvCxnSpPr>
            <p:spPr>
              <a:xfrm>
                <a:off x="1342551" y="3707904"/>
                <a:ext cx="36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1" name="CasellaDiTesto 160">
                <a:extLst>
                  <a:ext uri="{FF2B5EF4-FFF2-40B4-BE49-F238E27FC236}">
                    <a16:creationId xmlns:a16="http://schemas.microsoft.com/office/drawing/2014/main" id="{7F7F84BA-FFF0-46D5-A277-2812B947D301}"/>
                  </a:ext>
                </a:extLst>
              </p:cNvPr>
              <p:cNvSpPr txBox="1"/>
              <p:nvPr/>
            </p:nvSpPr>
            <p:spPr>
              <a:xfrm>
                <a:off x="1299998" y="3449955"/>
                <a:ext cx="4876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ER</a:t>
                </a:r>
                <a:r>
                  <a:rPr lang="el-G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α</a:t>
                </a:r>
                <a:endParaRPr lang="it-IT" sz="1200" dirty="0"/>
              </a:p>
            </p:txBody>
          </p:sp>
        </p:grpSp>
        <p:sp>
          <p:nvSpPr>
            <p:cNvPr id="185" name="CasellaDiTesto 184">
              <a:extLst>
                <a:ext uri="{FF2B5EF4-FFF2-40B4-BE49-F238E27FC236}">
                  <a16:creationId xmlns:a16="http://schemas.microsoft.com/office/drawing/2014/main" id="{08AC1209-52FE-447C-B57C-B6BB40942C86}"/>
                </a:ext>
              </a:extLst>
            </p:cNvPr>
            <p:cNvSpPr txBox="1"/>
            <p:nvPr/>
          </p:nvSpPr>
          <p:spPr>
            <a:xfrm>
              <a:off x="1694965" y="2294748"/>
              <a:ext cx="274434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+mn-lt"/>
                </a:rPr>
                <a:t>+</a:t>
              </a:r>
            </a:p>
          </p:txBody>
        </p:sp>
        <p:sp>
          <p:nvSpPr>
            <p:cNvPr id="186" name="CasellaDiTesto 185">
              <a:extLst>
                <a:ext uri="{FF2B5EF4-FFF2-40B4-BE49-F238E27FC236}">
                  <a16:creationId xmlns:a16="http://schemas.microsoft.com/office/drawing/2014/main" id="{08C7A70E-A278-4ED2-99A8-7A9C9CED0567}"/>
                </a:ext>
              </a:extLst>
            </p:cNvPr>
            <p:cNvSpPr txBox="1"/>
            <p:nvPr/>
          </p:nvSpPr>
          <p:spPr>
            <a:xfrm>
              <a:off x="1550433" y="2294748"/>
              <a:ext cx="235962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+mn-lt"/>
                </a:rPr>
                <a:t>-</a:t>
              </a:r>
            </a:p>
          </p:txBody>
        </p:sp>
        <p:sp>
          <p:nvSpPr>
            <p:cNvPr id="187" name="CasellaDiTesto 186">
              <a:extLst>
                <a:ext uri="{FF2B5EF4-FFF2-40B4-BE49-F238E27FC236}">
                  <a16:creationId xmlns:a16="http://schemas.microsoft.com/office/drawing/2014/main" id="{1E232DC9-4F58-444A-922C-BCEF577988FE}"/>
                </a:ext>
              </a:extLst>
            </p:cNvPr>
            <p:cNvSpPr txBox="1"/>
            <p:nvPr/>
          </p:nvSpPr>
          <p:spPr>
            <a:xfrm>
              <a:off x="2137847" y="2294748"/>
              <a:ext cx="274434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+mn-lt"/>
                </a:rPr>
                <a:t>+</a:t>
              </a:r>
            </a:p>
          </p:txBody>
        </p:sp>
        <p:sp>
          <p:nvSpPr>
            <p:cNvPr id="188" name="CasellaDiTesto 187">
              <a:extLst>
                <a:ext uri="{FF2B5EF4-FFF2-40B4-BE49-F238E27FC236}">
                  <a16:creationId xmlns:a16="http://schemas.microsoft.com/office/drawing/2014/main" id="{2AB44B7F-A396-4B38-AAB6-EC373D7D6B3D}"/>
                </a:ext>
              </a:extLst>
            </p:cNvPr>
            <p:cNvSpPr txBox="1"/>
            <p:nvPr/>
          </p:nvSpPr>
          <p:spPr>
            <a:xfrm>
              <a:off x="1993315" y="2294748"/>
              <a:ext cx="235962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+mn-lt"/>
                </a:rPr>
                <a:t>-</a:t>
              </a:r>
            </a:p>
          </p:txBody>
        </p:sp>
        <p:sp>
          <p:nvSpPr>
            <p:cNvPr id="189" name="CasellaDiTesto 188">
              <a:extLst>
                <a:ext uri="{FF2B5EF4-FFF2-40B4-BE49-F238E27FC236}">
                  <a16:creationId xmlns:a16="http://schemas.microsoft.com/office/drawing/2014/main" id="{F5C6FA80-E4EF-4596-9FBA-30C53B2AF350}"/>
                </a:ext>
              </a:extLst>
            </p:cNvPr>
            <p:cNvSpPr txBox="1"/>
            <p:nvPr/>
          </p:nvSpPr>
          <p:spPr>
            <a:xfrm>
              <a:off x="2588826" y="2294748"/>
              <a:ext cx="274434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+mn-lt"/>
                </a:rPr>
                <a:t>+</a:t>
              </a:r>
            </a:p>
          </p:txBody>
        </p:sp>
        <p:sp>
          <p:nvSpPr>
            <p:cNvPr id="190" name="CasellaDiTesto 189">
              <a:extLst>
                <a:ext uri="{FF2B5EF4-FFF2-40B4-BE49-F238E27FC236}">
                  <a16:creationId xmlns:a16="http://schemas.microsoft.com/office/drawing/2014/main" id="{07F5D6F3-D282-4BC7-B335-9C10D6EAF876}"/>
                </a:ext>
              </a:extLst>
            </p:cNvPr>
            <p:cNvSpPr txBox="1"/>
            <p:nvPr/>
          </p:nvSpPr>
          <p:spPr>
            <a:xfrm>
              <a:off x="2444294" y="2294748"/>
              <a:ext cx="235962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+mn-lt"/>
                </a:rPr>
                <a:t>-</a:t>
              </a:r>
            </a:p>
          </p:txBody>
        </p:sp>
        <p:cxnSp>
          <p:nvCxnSpPr>
            <p:cNvPr id="192" name="Connettore diritto 191">
              <a:extLst>
                <a:ext uri="{FF2B5EF4-FFF2-40B4-BE49-F238E27FC236}">
                  <a16:creationId xmlns:a16="http://schemas.microsoft.com/office/drawing/2014/main" id="{E60B0391-641E-4978-9532-BE98FFD9E6B8}"/>
                </a:ext>
              </a:extLst>
            </p:cNvPr>
            <p:cNvCxnSpPr>
              <a:cxnSpLocks/>
            </p:cNvCxnSpPr>
            <p:nvPr/>
          </p:nvCxnSpPr>
          <p:spPr>
            <a:xfrm>
              <a:off x="1088626" y="2525447"/>
              <a:ext cx="164899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39" name="Gruppo 338">
            <a:extLst>
              <a:ext uri="{FF2B5EF4-FFF2-40B4-BE49-F238E27FC236}">
                <a16:creationId xmlns:a16="http://schemas.microsoft.com/office/drawing/2014/main" id="{EAEEC81B-8E74-4A4A-B31A-FF895BF47386}"/>
              </a:ext>
            </a:extLst>
          </p:cNvPr>
          <p:cNvGrpSpPr/>
          <p:nvPr/>
        </p:nvGrpSpPr>
        <p:grpSpPr>
          <a:xfrm>
            <a:off x="1669280" y="4375382"/>
            <a:ext cx="3506603" cy="1664547"/>
            <a:chOff x="1637761" y="4375382"/>
            <a:chExt cx="3506603" cy="1664547"/>
          </a:xfrm>
        </p:grpSpPr>
        <p:pic>
          <p:nvPicPr>
            <p:cNvPr id="338" name="Immagine 337">
              <a:extLst>
                <a:ext uri="{FF2B5EF4-FFF2-40B4-BE49-F238E27FC236}">
                  <a16:creationId xmlns:a16="http://schemas.microsoft.com/office/drawing/2014/main" id="{A378D208-082C-48CE-8CD8-9B94061457C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67874" y="4604353"/>
              <a:ext cx="2270438" cy="1260000"/>
            </a:xfrm>
            <a:prstGeom prst="rect">
              <a:avLst/>
            </a:prstGeom>
          </p:spPr>
        </p:pic>
        <p:sp>
          <p:nvSpPr>
            <p:cNvPr id="299" name="CasellaDiTesto 298">
              <a:extLst>
                <a:ext uri="{FF2B5EF4-FFF2-40B4-BE49-F238E27FC236}">
                  <a16:creationId xmlns:a16="http://schemas.microsoft.com/office/drawing/2014/main" id="{1011C501-DC66-4B25-ADF3-37C5E804078F}"/>
                </a:ext>
              </a:extLst>
            </p:cNvPr>
            <p:cNvSpPr txBox="1"/>
            <p:nvPr/>
          </p:nvSpPr>
          <p:spPr>
            <a:xfrm>
              <a:off x="4507651" y="5824485"/>
              <a:ext cx="63671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+mn-lt"/>
                </a:rPr>
                <a:t>NVP (µM)</a:t>
              </a:r>
            </a:p>
          </p:txBody>
        </p:sp>
        <p:sp>
          <p:nvSpPr>
            <p:cNvPr id="300" name="CasellaDiTesto 299">
              <a:extLst>
                <a:ext uri="{FF2B5EF4-FFF2-40B4-BE49-F238E27FC236}">
                  <a16:creationId xmlns:a16="http://schemas.microsoft.com/office/drawing/2014/main" id="{7415D6DC-7B59-4266-9C53-261F6450A80C}"/>
                </a:ext>
              </a:extLst>
            </p:cNvPr>
            <p:cNvSpPr txBox="1"/>
            <p:nvPr/>
          </p:nvSpPr>
          <p:spPr>
            <a:xfrm rot="16200000">
              <a:off x="1290550" y="4976331"/>
              <a:ext cx="115608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 err="1"/>
                <a:t>Protein</a:t>
              </a:r>
              <a:r>
                <a:rPr lang="it-IT" sz="1200" dirty="0"/>
                <a:t> </a:t>
              </a:r>
              <a:r>
                <a:rPr lang="it-IT" sz="1200" dirty="0" err="1"/>
                <a:t>Levels</a:t>
              </a:r>
              <a:endParaRPr lang="it-IT" sz="1200" dirty="0"/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0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301" name="CasellaDiTesto 300">
              <a:extLst>
                <a:ext uri="{FF2B5EF4-FFF2-40B4-BE49-F238E27FC236}">
                  <a16:creationId xmlns:a16="http://schemas.microsoft.com/office/drawing/2014/main" id="{46E4D7E9-F0EB-40BE-B980-2D15271B53DB}"/>
                </a:ext>
              </a:extLst>
            </p:cNvPr>
            <p:cNvSpPr txBox="1"/>
            <p:nvPr/>
          </p:nvSpPr>
          <p:spPr>
            <a:xfrm>
              <a:off x="1967057" y="447304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5</a:t>
              </a:r>
            </a:p>
          </p:txBody>
        </p:sp>
        <p:sp>
          <p:nvSpPr>
            <p:cNvPr id="302" name="CasellaDiTesto 301">
              <a:extLst>
                <a:ext uri="{FF2B5EF4-FFF2-40B4-BE49-F238E27FC236}">
                  <a16:creationId xmlns:a16="http://schemas.microsoft.com/office/drawing/2014/main" id="{13FE9D52-B251-46C5-8D49-8B47C610F079}"/>
                </a:ext>
              </a:extLst>
            </p:cNvPr>
            <p:cNvSpPr txBox="1"/>
            <p:nvPr/>
          </p:nvSpPr>
          <p:spPr>
            <a:xfrm>
              <a:off x="1967057" y="486646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0</a:t>
              </a:r>
            </a:p>
          </p:txBody>
        </p:sp>
        <p:sp>
          <p:nvSpPr>
            <p:cNvPr id="303" name="CasellaDiTesto 302">
              <a:extLst>
                <a:ext uri="{FF2B5EF4-FFF2-40B4-BE49-F238E27FC236}">
                  <a16:creationId xmlns:a16="http://schemas.microsoft.com/office/drawing/2014/main" id="{8B171AC2-DA4A-4878-AD70-AFBB3A52816D}"/>
                </a:ext>
              </a:extLst>
            </p:cNvPr>
            <p:cNvSpPr txBox="1"/>
            <p:nvPr/>
          </p:nvSpPr>
          <p:spPr>
            <a:xfrm>
              <a:off x="1967057" y="5671983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grpSp>
          <p:nvGrpSpPr>
            <p:cNvPr id="304" name="Gruppo 303">
              <a:extLst>
                <a:ext uri="{FF2B5EF4-FFF2-40B4-BE49-F238E27FC236}">
                  <a16:creationId xmlns:a16="http://schemas.microsoft.com/office/drawing/2014/main" id="{19774E60-F852-4765-A8E0-6778AFCEAFD1}"/>
                </a:ext>
              </a:extLst>
            </p:cNvPr>
            <p:cNvGrpSpPr/>
            <p:nvPr/>
          </p:nvGrpSpPr>
          <p:grpSpPr>
            <a:xfrm>
              <a:off x="2315340" y="4375382"/>
              <a:ext cx="569387" cy="276999"/>
              <a:chOff x="1249198" y="3449955"/>
              <a:chExt cx="569387" cy="276999"/>
            </a:xfrm>
          </p:grpSpPr>
          <p:cxnSp>
            <p:nvCxnSpPr>
              <p:cNvPr id="335" name="Connettore diritto 334">
                <a:extLst>
                  <a:ext uri="{FF2B5EF4-FFF2-40B4-BE49-F238E27FC236}">
                    <a16:creationId xmlns:a16="http://schemas.microsoft.com/office/drawing/2014/main" id="{0D60D72F-82A9-44B1-9257-0E14D568CFE0}"/>
                  </a:ext>
                </a:extLst>
              </p:cNvPr>
              <p:cNvCxnSpPr/>
              <p:nvPr/>
            </p:nvCxnSpPr>
            <p:spPr>
              <a:xfrm>
                <a:off x="1342551" y="3707904"/>
                <a:ext cx="36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36" name="CasellaDiTesto 335">
                <a:extLst>
                  <a:ext uri="{FF2B5EF4-FFF2-40B4-BE49-F238E27FC236}">
                    <a16:creationId xmlns:a16="http://schemas.microsoft.com/office/drawing/2014/main" id="{4CA36B8E-8327-4A11-9733-1A412BA1CACE}"/>
                  </a:ext>
                </a:extLst>
              </p:cNvPr>
              <p:cNvSpPr txBox="1"/>
              <p:nvPr/>
            </p:nvSpPr>
            <p:spPr>
              <a:xfrm>
                <a:off x="1249198" y="3449955"/>
                <a:ext cx="5693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err="1"/>
                  <a:t>pAKT</a:t>
                </a:r>
                <a:endParaRPr lang="it-IT" sz="1200" dirty="0"/>
              </a:p>
            </p:txBody>
          </p:sp>
        </p:grpSp>
        <p:sp>
          <p:nvSpPr>
            <p:cNvPr id="305" name="CasellaDiTesto 304">
              <a:extLst>
                <a:ext uri="{FF2B5EF4-FFF2-40B4-BE49-F238E27FC236}">
                  <a16:creationId xmlns:a16="http://schemas.microsoft.com/office/drawing/2014/main" id="{00FF61D6-D4D7-4F73-82E7-B9A7993511FF}"/>
                </a:ext>
              </a:extLst>
            </p:cNvPr>
            <p:cNvSpPr txBox="1"/>
            <p:nvPr/>
          </p:nvSpPr>
          <p:spPr>
            <a:xfrm>
              <a:off x="1967057" y="526293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5</a:t>
              </a:r>
            </a:p>
          </p:txBody>
        </p:sp>
        <p:grpSp>
          <p:nvGrpSpPr>
            <p:cNvPr id="306" name="Gruppo 305">
              <a:extLst>
                <a:ext uri="{FF2B5EF4-FFF2-40B4-BE49-F238E27FC236}">
                  <a16:creationId xmlns:a16="http://schemas.microsoft.com/office/drawing/2014/main" id="{0EF79575-67A2-40A9-B115-4B2A3A0473EB}"/>
                </a:ext>
              </a:extLst>
            </p:cNvPr>
            <p:cNvGrpSpPr/>
            <p:nvPr/>
          </p:nvGrpSpPr>
          <p:grpSpPr>
            <a:xfrm>
              <a:off x="2281519" y="5824485"/>
              <a:ext cx="627586" cy="215444"/>
              <a:chOff x="2264017" y="4022516"/>
              <a:chExt cx="627586" cy="215444"/>
            </a:xfrm>
          </p:grpSpPr>
          <p:sp>
            <p:nvSpPr>
              <p:cNvPr id="331" name="CasellaDiTesto 330">
                <a:extLst>
                  <a:ext uri="{FF2B5EF4-FFF2-40B4-BE49-F238E27FC236}">
                    <a16:creationId xmlns:a16="http://schemas.microsoft.com/office/drawing/2014/main" id="{00D39245-095F-4A24-9149-DB4D849C07CA}"/>
                  </a:ext>
                </a:extLst>
              </p:cNvPr>
              <p:cNvSpPr txBox="1"/>
              <p:nvPr/>
            </p:nvSpPr>
            <p:spPr>
              <a:xfrm>
                <a:off x="2264017" y="4022516"/>
                <a:ext cx="24237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0</a:t>
                </a:r>
              </a:p>
            </p:txBody>
          </p:sp>
          <p:sp>
            <p:nvSpPr>
              <p:cNvPr id="332" name="CasellaDiTesto 331">
                <a:extLst>
                  <a:ext uri="{FF2B5EF4-FFF2-40B4-BE49-F238E27FC236}">
                    <a16:creationId xmlns:a16="http://schemas.microsoft.com/office/drawing/2014/main" id="{D47F7886-1156-49CF-BDF3-0B9CC509AD11}"/>
                  </a:ext>
                </a:extLst>
              </p:cNvPr>
              <p:cNvSpPr txBox="1"/>
              <p:nvPr/>
            </p:nvSpPr>
            <p:spPr>
              <a:xfrm>
                <a:off x="2334591" y="4022516"/>
                <a:ext cx="328936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0.1</a:t>
                </a:r>
              </a:p>
            </p:txBody>
          </p:sp>
          <p:sp>
            <p:nvSpPr>
              <p:cNvPr id="333" name="CasellaDiTesto 332">
                <a:extLst>
                  <a:ext uri="{FF2B5EF4-FFF2-40B4-BE49-F238E27FC236}">
                    <a16:creationId xmlns:a16="http://schemas.microsoft.com/office/drawing/2014/main" id="{9811493B-364C-411A-A558-8974CA27FD2F}"/>
                  </a:ext>
                </a:extLst>
              </p:cNvPr>
              <p:cNvSpPr txBox="1"/>
              <p:nvPr/>
            </p:nvSpPr>
            <p:spPr>
              <a:xfrm>
                <a:off x="2481054" y="4022516"/>
                <a:ext cx="328936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0.5</a:t>
                </a:r>
              </a:p>
            </p:txBody>
          </p:sp>
          <p:sp>
            <p:nvSpPr>
              <p:cNvPr id="334" name="CasellaDiTesto 333">
                <a:extLst>
                  <a:ext uri="{FF2B5EF4-FFF2-40B4-BE49-F238E27FC236}">
                    <a16:creationId xmlns:a16="http://schemas.microsoft.com/office/drawing/2014/main" id="{3AFD2EAF-93F4-4BA1-A543-0C4CB27E3D3E}"/>
                  </a:ext>
                </a:extLst>
              </p:cNvPr>
              <p:cNvSpPr txBox="1"/>
              <p:nvPr/>
            </p:nvSpPr>
            <p:spPr>
              <a:xfrm>
                <a:off x="2649229" y="4022516"/>
                <a:ext cx="24237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1</a:t>
                </a:r>
              </a:p>
            </p:txBody>
          </p:sp>
        </p:grpSp>
        <p:grpSp>
          <p:nvGrpSpPr>
            <p:cNvPr id="307" name="Gruppo 306">
              <a:extLst>
                <a:ext uri="{FF2B5EF4-FFF2-40B4-BE49-F238E27FC236}">
                  <a16:creationId xmlns:a16="http://schemas.microsoft.com/office/drawing/2014/main" id="{BC395F8F-B4F1-4BF9-88D7-D200BA51371E}"/>
                </a:ext>
              </a:extLst>
            </p:cNvPr>
            <p:cNvGrpSpPr/>
            <p:nvPr/>
          </p:nvGrpSpPr>
          <p:grpSpPr>
            <a:xfrm>
              <a:off x="2824135" y="4375382"/>
              <a:ext cx="689612" cy="276999"/>
              <a:chOff x="1185698" y="3449955"/>
              <a:chExt cx="689612" cy="276999"/>
            </a:xfrm>
          </p:grpSpPr>
          <p:cxnSp>
            <p:nvCxnSpPr>
              <p:cNvPr id="329" name="Connettore diritto 328">
                <a:extLst>
                  <a:ext uri="{FF2B5EF4-FFF2-40B4-BE49-F238E27FC236}">
                    <a16:creationId xmlns:a16="http://schemas.microsoft.com/office/drawing/2014/main" id="{E6AD7934-6D53-4FE6-8F5F-24B785AD8E8B}"/>
                  </a:ext>
                </a:extLst>
              </p:cNvPr>
              <p:cNvCxnSpPr/>
              <p:nvPr/>
            </p:nvCxnSpPr>
            <p:spPr>
              <a:xfrm>
                <a:off x="1342551" y="3707904"/>
                <a:ext cx="36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30" name="CasellaDiTesto 329">
                <a:extLst>
                  <a:ext uri="{FF2B5EF4-FFF2-40B4-BE49-F238E27FC236}">
                    <a16:creationId xmlns:a16="http://schemas.microsoft.com/office/drawing/2014/main" id="{203EDB89-EE55-491E-B4DF-A791CF7BF191}"/>
                  </a:ext>
                </a:extLst>
              </p:cNvPr>
              <p:cNvSpPr txBox="1"/>
              <p:nvPr/>
            </p:nvSpPr>
            <p:spPr>
              <a:xfrm>
                <a:off x="1185698" y="3449955"/>
                <a:ext cx="6896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IGF1-R</a:t>
                </a:r>
              </a:p>
            </p:txBody>
          </p:sp>
        </p:grpSp>
        <p:grpSp>
          <p:nvGrpSpPr>
            <p:cNvPr id="308" name="Gruppo 307">
              <a:extLst>
                <a:ext uri="{FF2B5EF4-FFF2-40B4-BE49-F238E27FC236}">
                  <a16:creationId xmlns:a16="http://schemas.microsoft.com/office/drawing/2014/main" id="{D60B6672-6A29-4670-B92D-423C0122027E}"/>
                </a:ext>
              </a:extLst>
            </p:cNvPr>
            <p:cNvGrpSpPr/>
            <p:nvPr/>
          </p:nvGrpSpPr>
          <p:grpSpPr>
            <a:xfrm>
              <a:off x="3356769" y="4375382"/>
              <a:ext cx="689612" cy="276999"/>
              <a:chOff x="1217448" y="3449955"/>
              <a:chExt cx="689612" cy="276999"/>
            </a:xfrm>
          </p:grpSpPr>
          <p:cxnSp>
            <p:nvCxnSpPr>
              <p:cNvPr id="327" name="Connettore diritto 326">
                <a:extLst>
                  <a:ext uri="{FF2B5EF4-FFF2-40B4-BE49-F238E27FC236}">
                    <a16:creationId xmlns:a16="http://schemas.microsoft.com/office/drawing/2014/main" id="{AD20C177-B203-49C6-BF20-4F32C9C6B6B2}"/>
                  </a:ext>
                </a:extLst>
              </p:cNvPr>
              <p:cNvCxnSpPr/>
              <p:nvPr/>
            </p:nvCxnSpPr>
            <p:spPr>
              <a:xfrm>
                <a:off x="1342551" y="3707904"/>
                <a:ext cx="36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8" name="CasellaDiTesto 327">
                <a:extLst>
                  <a:ext uri="{FF2B5EF4-FFF2-40B4-BE49-F238E27FC236}">
                    <a16:creationId xmlns:a16="http://schemas.microsoft.com/office/drawing/2014/main" id="{A557DFA7-5B8C-4236-B08B-5DE2F4CA882E}"/>
                  </a:ext>
                </a:extLst>
              </p:cNvPr>
              <p:cNvSpPr txBox="1"/>
              <p:nvPr/>
            </p:nvSpPr>
            <p:spPr>
              <a:xfrm>
                <a:off x="1217448" y="3449955"/>
                <a:ext cx="6896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FOXA1</a:t>
                </a:r>
              </a:p>
            </p:txBody>
          </p:sp>
        </p:grpSp>
        <p:grpSp>
          <p:nvGrpSpPr>
            <p:cNvPr id="309" name="Gruppo 308">
              <a:extLst>
                <a:ext uri="{FF2B5EF4-FFF2-40B4-BE49-F238E27FC236}">
                  <a16:creationId xmlns:a16="http://schemas.microsoft.com/office/drawing/2014/main" id="{4A1A15F7-7534-4E16-B001-2C175A484812}"/>
                </a:ext>
              </a:extLst>
            </p:cNvPr>
            <p:cNvGrpSpPr/>
            <p:nvPr/>
          </p:nvGrpSpPr>
          <p:grpSpPr>
            <a:xfrm>
              <a:off x="4082418" y="4375382"/>
              <a:ext cx="487634" cy="276999"/>
              <a:chOff x="1299998" y="3449955"/>
              <a:chExt cx="487634" cy="276999"/>
            </a:xfrm>
          </p:grpSpPr>
          <p:cxnSp>
            <p:nvCxnSpPr>
              <p:cNvPr id="325" name="Connettore diritto 324">
                <a:extLst>
                  <a:ext uri="{FF2B5EF4-FFF2-40B4-BE49-F238E27FC236}">
                    <a16:creationId xmlns:a16="http://schemas.microsoft.com/office/drawing/2014/main" id="{D3413494-B456-439D-B2E3-8F8502010DEB}"/>
                  </a:ext>
                </a:extLst>
              </p:cNvPr>
              <p:cNvCxnSpPr/>
              <p:nvPr/>
            </p:nvCxnSpPr>
            <p:spPr>
              <a:xfrm>
                <a:off x="1342551" y="3707904"/>
                <a:ext cx="36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6" name="CasellaDiTesto 325">
                <a:extLst>
                  <a:ext uri="{FF2B5EF4-FFF2-40B4-BE49-F238E27FC236}">
                    <a16:creationId xmlns:a16="http://schemas.microsoft.com/office/drawing/2014/main" id="{957993FE-9AC0-4B4B-9BE0-4D869B57B6ED}"/>
                  </a:ext>
                </a:extLst>
              </p:cNvPr>
              <p:cNvSpPr txBox="1"/>
              <p:nvPr/>
            </p:nvSpPr>
            <p:spPr>
              <a:xfrm>
                <a:off x="1299998" y="3449955"/>
                <a:ext cx="4876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ER</a:t>
                </a:r>
                <a:r>
                  <a:rPr lang="el-G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α</a:t>
                </a:r>
                <a:endParaRPr lang="it-IT" sz="1200" dirty="0"/>
              </a:p>
            </p:txBody>
          </p:sp>
        </p:grpSp>
        <p:grpSp>
          <p:nvGrpSpPr>
            <p:cNvPr id="310" name="Gruppo 309">
              <a:extLst>
                <a:ext uri="{FF2B5EF4-FFF2-40B4-BE49-F238E27FC236}">
                  <a16:creationId xmlns:a16="http://schemas.microsoft.com/office/drawing/2014/main" id="{00C6485E-F495-4E8D-9415-F2DE8CB58310}"/>
                </a:ext>
              </a:extLst>
            </p:cNvPr>
            <p:cNvGrpSpPr/>
            <p:nvPr/>
          </p:nvGrpSpPr>
          <p:grpSpPr>
            <a:xfrm>
              <a:off x="2865832" y="5824485"/>
              <a:ext cx="627586" cy="215444"/>
              <a:chOff x="2264017" y="4022516"/>
              <a:chExt cx="627586" cy="215444"/>
            </a:xfrm>
          </p:grpSpPr>
          <p:sp>
            <p:nvSpPr>
              <p:cNvPr id="321" name="CasellaDiTesto 320">
                <a:extLst>
                  <a:ext uri="{FF2B5EF4-FFF2-40B4-BE49-F238E27FC236}">
                    <a16:creationId xmlns:a16="http://schemas.microsoft.com/office/drawing/2014/main" id="{3E6644DA-A7FE-4E15-BBCA-D04049A3FB95}"/>
                  </a:ext>
                </a:extLst>
              </p:cNvPr>
              <p:cNvSpPr txBox="1"/>
              <p:nvPr/>
            </p:nvSpPr>
            <p:spPr>
              <a:xfrm>
                <a:off x="2264017" y="4022516"/>
                <a:ext cx="24237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0</a:t>
                </a:r>
              </a:p>
            </p:txBody>
          </p:sp>
          <p:sp>
            <p:nvSpPr>
              <p:cNvPr id="322" name="CasellaDiTesto 321">
                <a:extLst>
                  <a:ext uri="{FF2B5EF4-FFF2-40B4-BE49-F238E27FC236}">
                    <a16:creationId xmlns:a16="http://schemas.microsoft.com/office/drawing/2014/main" id="{E208BE4D-8D1B-4D40-A9CE-3591465E7A6D}"/>
                  </a:ext>
                </a:extLst>
              </p:cNvPr>
              <p:cNvSpPr txBox="1"/>
              <p:nvPr/>
            </p:nvSpPr>
            <p:spPr>
              <a:xfrm>
                <a:off x="2334591" y="4022516"/>
                <a:ext cx="328936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0.1</a:t>
                </a:r>
              </a:p>
            </p:txBody>
          </p:sp>
          <p:sp>
            <p:nvSpPr>
              <p:cNvPr id="323" name="CasellaDiTesto 322">
                <a:extLst>
                  <a:ext uri="{FF2B5EF4-FFF2-40B4-BE49-F238E27FC236}">
                    <a16:creationId xmlns:a16="http://schemas.microsoft.com/office/drawing/2014/main" id="{E752FD00-D55A-4BFB-B7F7-6336BD73A7C2}"/>
                  </a:ext>
                </a:extLst>
              </p:cNvPr>
              <p:cNvSpPr txBox="1"/>
              <p:nvPr/>
            </p:nvSpPr>
            <p:spPr>
              <a:xfrm>
                <a:off x="2481054" y="4022516"/>
                <a:ext cx="328936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0.5</a:t>
                </a:r>
              </a:p>
            </p:txBody>
          </p:sp>
          <p:sp>
            <p:nvSpPr>
              <p:cNvPr id="324" name="CasellaDiTesto 323">
                <a:extLst>
                  <a:ext uri="{FF2B5EF4-FFF2-40B4-BE49-F238E27FC236}">
                    <a16:creationId xmlns:a16="http://schemas.microsoft.com/office/drawing/2014/main" id="{9C47DA50-32C0-4236-B376-8F69F22B1700}"/>
                  </a:ext>
                </a:extLst>
              </p:cNvPr>
              <p:cNvSpPr txBox="1"/>
              <p:nvPr/>
            </p:nvSpPr>
            <p:spPr>
              <a:xfrm>
                <a:off x="2649229" y="4022516"/>
                <a:ext cx="24237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1</a:t>
                </a:r>
              </a:p>
            </p:txBody>
          </p:sp>
        </p:grpSp>
        <p:grpSp>
          <p:nvGrpSpPr>
            <p:cNvPr id="311" name="Gruppo 310">
              <a:extLst>
                <a:ext uri="{FF2B5EF4-FFF2-40B4-BE49-F238E27FC236}">
                  <a16:creationId xmlns:a16="http://schemas.microsoft.com/office/drawing/2014/main" id="{56E1F2A2-1FA9-4C49-AB95-F33AF633D9B0}"/>
                </a:ext>
              </a:extLst>
            </p:cNvPr>
            <p:cNvGrpSpPr/>
            <p:nvPr/>
          </p:nvGrpSpPr>
          <p:grpSpPr>
            <a:xfrm>
              <a:off x="3405227" y="5824485"/>
              <a:ext cx="627586" cy="215444"/>
              <a:chOff x="2264017" y="4022516"/>
              <a:chExt cx="627586" cy="215444"/>
            </a:xfrm>
          </p:grpSpPr>
          <p:sp>
            <p:nvSpPr>
              <p:cNvPr id="317" name="CasellaDiTesto 316">
                <a:extLst>
                  <a:ext uri="{FF2B5EF4-FFF2-40B4-BE49-F238E27FC236}">
                    <a16:creationId xmlns:a16="http://schemas.microsoft.com/office/drawing/2014/main" id="{F96133BA-D653-48B1-A1AC-1B0C0FD23A4A}"/>
                  </a:ext>
                </a:extLst>
              </p:cNvPr>
              <p:cNvSpPr txBox="1"/>
              <p:nvPr/>
            </p:nvSpPr>
            <p:spPr>
              <a:xfrm>
                <a:off x="2264017" y="4022516"/>
                <a:ext cx="24237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0</a:t>
                </a:r>
              </a:p>
            </p:txBody>
          </p:sp>
          <p:sp>
            <p:nvSpPr>
              <p:cNvPr id="318" name="CasellaDiTesto 317">
                <a:extLst>
                  <a:ext uri="{FF2B5EF4-FFF2-40B4-BE49-F238E27FC236}">
                    <a16:creationId xmlns:a16="http://schemas.microsoft.com/office/drawing/2014/main" id="{C6F2F194-6FCF-4068-AC93-B0DA8B88F642}"/>
                  </a:ext>
                </a:extLst>
              </p:cNvPr>
              <p:cNvSpPr txBox="1"/>
              <p:nvPr/>
            </p:nvSpPr>
            <p:spPr>
              <a:xfrm>
                <a:off x="2334591" y="4022516"/>
                <a:ext cx="328936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0.1</a:t>
                </a:r>
              </a:p>
            </p:txBody>
          </p:sp>
          <p:sp>
            <p:nvSpPr>
              <p:cNvPr id="319" name="CasellaDiTesto 318">
                <a:extLst>
                  <a:ext uri="{FF2B5EF4-FFF2-40B4-BE49-F238E27FC236}">
                    <a16:creationId xmlns:a16="http://schemas.microsoft.com/office/drawing/2014/main" id="{5FDB147E-AAB7-4B86-9BA7-2C9E36AA9C7E}"/>
                  </a:ext>
                </a:extLst>
              </p:cNvPr>
              <p:cNvSpPr txBox="1"/>
              <p:nvPr/>
            </p:nvSpPr>
            <p:spPr>
              <a:xfrm>
                <a:off x="2481054" y="4022516"/>
                <a:ext cx="328936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0.5</a:t>
                </a:r>
              </a:p>
            </p:txBody>
          </p:sp>
          <p:sp>
            <p:nvSpPr>
              <p:cNvPr id="320" name="CasellaDiTesto 319">
                <a:extLst>
                  <a:ext uri="{FF2B5EF4-FFF2-40B4-BE49-F238E27FC236}">
                    <a16:creationId xmlns:a16="http://schemas.microsoft.com/office/drawing/2014/main" id="{FB318E39-DA1C-4117-8F36-D6C83D86B703}"/>
                  </a:ext>
                </a:extLst>
              </p:cNvPr>
              <p:cNvSpPr txBox="1"/>
              <p:nvPr/>
            </p:nvSpPr>
            <p:spPr>
              <a:xfrm>
                <a:off x="2649229" y="4022516"/>
                <a:ext cx="24237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1</a:t>
                </a:r>
              </a:p>
            </p:txBody>
          </p:sp>
        </p:grpSp>
        <p:grpSp>
          <p:nvGrpSpPr>
            <p:cNvPr id="312" name="Gruppo 311">
              <a:extLst>
                <a:ext uri="{FF2B5EF4-FFF2-40B4-BE49-F238E27FC236}">
                  <a16:creationId xmlns:a16="http://schemas.microsoft.com/office/drawing/2014/main" id="{96E2AE30-BCC9-4D3F-AFED-E27E49E86F3D}"/>
                </a:ext>
              </a:extLst>
            </p:cNvPr>
            <p:cNvGrpSpPr/>
            <p:nvPr/>
          </p:nvGrpSpPr>
          <p:grpSpPr>
            <a:xfrm>
              <a:off x="3964920" y="5824485"/>
              <a:ext cx="627586" cy="215444"/>
              <a:chOff x="2264017" y="4022516"/>
              <a:chExt cx="627586" cy="215444"/>
            </a:xfrm>
          </p:grpSpPr>
          <p:sp>
            <p:nvSpPr>
              <p:cNvPr id="313" name="CasellaDiTesto 312">
                <a:extLst>
                  <a:ext uri="{FF2B5EF4-FFF2-40B4-BE49-F238E27FC236}">
                    <a16:creationId xmlns:a16="http://schemas.microsoft.com/office/drawing/2014/main" id="{46A1FEAC-A3C2-416E-A54C-B226C3F96084}"/>
                  </a:ext>
                </a:extLst>
              </p:cNvPr>
              <p:cNvSpPr txBox="1"/>
              <p:nvPr/>
            </p:nvSpPr>
            <p:spPr>
              <a:xfrm>
                <a:off x="2264017" y="4022516"/>
                <a:ext cx="24237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0</a:t>
                </a:r>
              </a:p>
            </p:txBody>
          </p:sp>
          <p:sp>
            <p:nvSpPr>
              <p:cNvPr id="314" name="CasellaDiTesto 313">
                <a:extLst>
                  <a:ext uri="{FF2B5EF4-FFF2-40B4-BE49-F238E27FC236}">
                    <a16:creationId xmlns:a16="http://schemas.microsoft.com/office/drawing/2014/main" id="{B65DE2CA-A68C-4549-B4A4-1F7030EB16CA}"/>
                  </a:ext>
                </a:extLst>
              </p:cNvPr>
              <p:cNvSpPr txBox="1"/>
              <p:nvPr/>
            </p:nvSpPr>
            <p:spPr>
              <a:xfrm>
                <a:off x="2334591" y="4022516"/>
                <a:ext cx="328936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0.1</a:t>
                </a:r>
              </a:p>
            </p:txBody>
          </p:sp>
          <p:sp>
            <p:nvSpPr>
              <p:cNvPr id="315" name="CasellaDiTesto 314">
                <a:extLst>
                  <a:ext uri="{FF2B5EF4-FFF2-40B4-BE49-F238E27FC236}">
                    <a16:creationId xmlns:a16="http://schemas.microsoft.com/office/drawing/2014/main" id="{CC2E8697-3E27-4091-8DE9-D553BA14A8CE}"/>
                  </a:ext>
                </a:extLst>
              </p:cNvPr>
              <p:cNvSpPr txBox="1"/>
              <p:nvPr/>
            </p:nvSpPr>
            <p:spPr>
              <a:xfrm>
                <a:off x="2481054" y="4022516"/>
                <a:ext cx="328936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0.5</a:t>
                </a:r>
              </a:p>
            </p:txBody>
          </p:sp>
          <p:sp>
            <p:nvSpPr>
              <p:cNvPr id="316" name="CasellaDiTesto 315">
                <a:extLst>
                  <a:ext uri="{FF2B5EF4-FFF2-40B4-BE49-F238E27FC236}">
                    <a16:creationId xmlns:a16="http://schemas.microsoft.com/office/drawing/2014/main" id="{02576811-2D75-4F22-8944-1F156E9FAED8}"/>
                  </a:ext>
                </a:extLst>
              </p:cNvPr>
              <p:cNvSpPr txBox="1"/>
              <p:nvPr/>
            </p:nvSpPr>
            <p:spPr>
              <a:xfrm>
                <a:off x="2649229" y="4022516"/>
                <a:ext cx="24237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+mn-lt"/>
                  </a:rPr>
                  <a:t>1</a:t>
                </a:r>
              </a:p>
            </p:txBody>
          </p:sp>
        </p:grpSp>
      </p:grpSp>
      <p:sp>
        <p:nvSpPr>
          <p:cNvPr id="337" name="CasellaDiTesto 336">
            <a:extLst>
              <a:ext uri="{FF2B5EF4-FFF2-40B4-BE49-F238E27FC236}">
                <a16:creationId xmlns:a16="http://schemas.microsoft.com/office/drawing/2014/main" id="{55B8A910-E482-48D0-A11F-AC09C5FF87F3}"/>
              </a:ext>
            </a:extLst>
          </p:cNvPr>
          <p:cNvSpPr txBox="1"/>
          <p:nvPr/>
        </p:nvSpPr>
        <p:spPr>
          <a:xfrm>
            <a:off x="1213491" y="4139952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c)</a:t>
            </a:r>
          </a:p>
        </p:txBody>
      </p:sp>
      <p:grpSp>
        <p:nvGrpSpPr>
          <p:cNvPr id="6" name="Gruppo 5">
            <a:extLst>
              <a:ext uri="{FF2B5EF4-FFF2-40B4-BE49-F238E27FC236}">
                <a16:creationId xmlns:a16="http://schemas.microsoft.com/office/drawing/2014/main" id="{048D73EE-AB17-4596-AA73-F07C8B30DF84}"/>
              </a:ext>
            </a:extLst>
          </p:cNvPr>
          <p:cNvGrpSpPr/>
          <p:nvPr/>
        </p:nvGrpSpPr>
        <p:grpSpPr>
          <a:xfrm>
            <a:off x="1457263" y="6406334"/>
            <a:ext cx="3930636" cy="2774178"/>
            <a:chOff x="1399207" y="6230482"/>
            <a:chExt cx="3930636" cy="2774178"/>
          </a:xfrm>
        </p:grpSpPr>
        <p:pic>
          <p:nvPicPr>
            <p:cNvPr id="5" name="Immagine 4">
              <a:extLst>
                <a:ext uri="{FF2B5EF4-FFF2-40B4-BE49-F238E27FC236}">
                  <a16:creationId xmlns:a16="http://schemas.microsoft.com/office/drawing/2014/main" id="{5C6FE331-07F5-4863-8EC6-C4795229CA1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043270" y="6318001"/>
              <a:ext cx="2941200" cy="2047671"/>
            </a:xfrm>
            <a:prstGeom prst="rect">
              <a:avLst/>
            </a:prstGeom>
          </p:spPr>
        </p:pic>
        <p:sp>
          <p:nvSpPr>
            <p:cNvPr id="124" name="CasellaDiTesto 123">
              <a:extLst>
                <a:ext uri="{FF2B5EF4-FFF2-40B4-BE49-F238E27FC236}">
                  <a16:creationId xmlns:a16="http://schemas.microsoft.com/office/drawing/2014/main" id="{B378328B-B5CD-40C0-8DAA-A9B5CF14D65B}"/>
                </a:ext>
              </a:extLst>
            </p:cNvPr>
            <p:cNvSpPr txBox="1"/>
            <p:nvPr/>
          </p:nvSpPr>
          <p:spPr>
            <a:xfrm>
              <a:off x="2525922" y="8374668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</a:t>
              </a:r>
            </a:p>
          </p:txBody>
        </p:sp>
        <p:sp>
          <p:nvSpPr>
            <p:cNvPr id="125" name="CasellaDiTesto 124">
              <a:extLst>
                <a:ext uri="{FF2B5EF4-FFF2-40B4-BE49-F238E27FC236}">
                  <a16:creationId xmlns:a16="http://schemas.microsoft.com/office/drawing/2014/main" id="{C9468E0D-3003-418D-BED6-1BD74D953A31}"/>
                </a:ext>
              </a:extLst>
            </p:cNvPr>
            <p:cNvSpPr txBox="1"/>
            <p:nvPr/>
          </p:nvSpPr>
          <p:spPr>
            <a:xfrm>
              <a:off x="2661381" y="8556704"/>
              <a:ext cx="36260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Tel</a:t>
              </a:r>
            </a:p>
          </p:txBody>
        </p:sp>
        <p:sp>
          <p:nvSpPr>
            <p:cNvPr id="129" name="CasellaDiTesto 128">
              <a:extLst>
                <a:ext uri="{FF2B5EF4-FFF2-40B4-BE49-F238E27FC236}">
                  <a16:creationId xmlns:a16="http://schemas.microsoft.com/office/drawing/2014/main" id="{DDAAEE3A-697C-45A0-B235-FC9DA33122BE}"/>
                </a:ext>
              </a:extLst>
            </p:cNvPr>
            <p:cNvSpPr txBox="1"/>
            <p:nvPr/>
          </p:nvSpPr>
          <p:spPr>
            <a:xfrm>
              <a:off x="2713249" y="8374668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</a:t>
              </a:r>
            </a:p>
          </p:txBody>
        </p:sp>
        <p:sp>
          <p:nvSpPr>
            <p:cNvPr id="130" name="CasellaDiTesto 129">
              <a:extLst>
                <a:ext uri="{FF2B5EF4-FFF2-40B4-BE49-F238E27FC236}">
                  <a16:creationId xmlns:a16="http://schemas.microsoft.com/office/drawing/2014/main" id="{D0C6DC68-945B-4913-B0D5-D26663D76F86}"/>
                </a:ext>
              </a:extLst>
            </p:cNvPr>
            <p:cNvSpPr txBox="1"/>
            <p:nvPr/>
          </p:nvSpPr>
          <p:spPr>
            <a:xfrm>
              <a:off x="2912334" y="8374668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6</a:t>
              </a:r>
            </a:p>
          </p:txBody>
        </p:sp>
        <p:sp>
          <p:nvSpPr>
            <p:cNvPr id="131" name="CasellaDiTesto 130">
              <a:extLst>
                <a:ext uri="{FF2B5EF4-FFF2-40B4-BE49-F238E27FC236}">
                  <a16:creationId xmlns:a16="http://schemas.microsoft.com/office/drawing/2014/main" id="{92DA4F5E-624E-47FB-8C42-8EB21AA1C8CF}"/>
                </a:ext>
              </a:extLst>
            </p:cNvPr>
            <p:cNvSpPr txBox="1"/>
            <p:nvPr/>
          </p:nvSpPr>
          <p:spPr>
            <a:xfrm>
              <a:off x="3073603" y="8374668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</a:t>
              </a:r>
            </a:p>
          </p:txBody>
        </p:sp>
        <p:sp>
          <p:nvSpPr>
            <p:cNvPr id="132" name="CasellaDiTesto 131">
              <a:extLst>
                <a:ext uri="{FF2B5EF4-FFF2-40B4-BE49-F238E27FC236}">
                  <a16:creationId xmlns:a16="http://schemas.microsoft.com/office/drawing/2014/main" id="{8B38FAF4-29F4-41B2-AC33-99101F8B1D0B}"/>
                </a:ext>
              </a:extLst>
            </p:cNvPr>
            <p:cNvSpPr txBox="1"/>
            <p:nvPr/>
          </p:nvSpPr>
          <p:spPr>
            <a:xfrm>
              <a:off x="3260930" y="8374668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</a:t>
              </a:r>
            </a:p>
          </p:txBody>
        </p:sp>
        <p:sp>
          <p:nvSpPr>
            <p:cNvPr id="133" name="CasellaDiTesto 132">
              <a:extLst>
                <a:ext uri="{FF2B5EF4-FFF2-40B4-BE49-F238E27FC236}">
                  <a16:creationId xmlns:a16="http://schemas.microsoft.com/office/drawing/2014/main" id="{EE89DD8F-0FEA-4E4E-86B6-7B08488F96D1}"/>
                </a:ext>
              </a:extLst>
            </p:cNvPr>
            <p:cNvSpPr txBox="1"/>
            <p:nvPr/>
          </p:nvSpPr>
          <p:spPr>
            <a:xfrm>
              <a:off x="3460015" y="8374668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6</a:t>
              </a:r>
            </a:p>
          </p:txBody>
        </p:sp>
        <p:sp>
          <p:nvSpPr>
            <p:cNvPr id="134" name="CasellaDiTesto 133">
              <a:extLst>
                <a:ext uri="{FF2B5EF4-FFF2-40B4-BE49-F238E27FC236}">
                  <a16:creationId xmlns:a16="http://schemas.microsoft.com/office/drawing/2014/main" id="{A6FFD1AF-394C-4C7A-9323-E00F91D48E83}"/>
                </a:ext>
              </a:extLst>
            </p:cNvPr>
            <p:cNvSpPr txBox="1"/>
            <p:nvPr/>
          </p:nvSpPr>
          <p:spPr>
            <a:xfrm>
              <a:off x="3658445" y="8374668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</a:t>
              </a:r>
            </a:p>
          </p:txBody>
        </p:sp>
        <p:sp>
          <p:nvSpPr>
            <p:cNvPr id="135" name="CasellaDiTesto 134">
              <a:extLst>
                <a:ext uri="{FF2B5EF4-FFF2-40B4-BE49-F238E27FC236}">
                  <a16:creationId xmlns:a16="http://schemas.microsoft.com/office/drawing/2014/main" id="{04F347B6-05FF-4C76-A30A-00E5D01E756E}"/>
                </a:ext>
              </a:extLst>
            </p:cNvPr>
            <p:cNvSpPr txBox="1"/>
            <p:nvPr/>
          </p:nvSpPr>
          <p:spPr>
            <a:xfrm>
              <a:off x="3845772" y="8374668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</a:t>
              </a:r>
            </a:p>
          </p:txBody>
        </p:sp>
        <p:sp>
          <p:nvSpPr>
            <p:cNvPr id="136" name="CasellaDiTesto 135">
              <a:extLst>
                <a:ext uri="{FF2B5EF4-FFF2-40B4-BE49-F238E27FC236}">
                  <a16:creationId xmlns:a16="http://schemas.microsoft.com/office/drawing/2014/main" id="{5AFAF8AF-DF56-43E7-8DC2-2E81FB20761D}"/>
                </a:ext>
              </a:extLst>
            </p:cNvPr>
            <p:cNvSpPr txBox="1"/>
            <p:nvPr/>
          </p:nvSpPr>
          <p:spPr>
            <a:xfrm>
              <a:off x="4044857" y="8374668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6</a:t>
              </a:r>
            </a:p>
          </p:txBody>
        </p:sp>
        <p:sp>
          <p:nvSpPr>
            <p:cNvPr id="137" name="CasellaDiTesto 136">
              <a:extLst>
                <a:ext uri="{FF2B5EF4-FFF2-40B4-BE49-F238E27FC236}">
                  <a16:creationId xmlns:a16="http://schemas.microsoft.com/office/drawing/2014/main" id="{C64DF925-D889-4994-B72B-9758AC0F60B7}"/>
                </a:ext>
              </a:extLst>
            </p:cNvPr>
            <p:cNvSpPr txBox="1"/>
            <p:nvPr/>
          </p:nvSpPr>
          <p:spPr>
            <a:xfrm>
              <a:off x="4267259" y="8374668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</a:t>
              </a:r>
            </a:p>
          </p:txBody>
        </p:sp>
        <p:sp>
          <p:nvSpPr>
            <p:cNvPr id="138" name="CasellaDiTesto 137">
              <a:extLst>
                <a:ext uri="{FF2B5EF4-FFF2-40B4-BE49-F238E27FC236}">
                  <a16:creationId xmlns:a16="http://schemas.microsoft.com/office/drawing/2014/main" id="{21AAC400-8737-4B33-A260-E6ED5ED4A8E7}"/>
                </a:ext>
              </a:extLst>
            </p:cNvPr>
            <p:cNvSpPr txBox="1"/>
            <p:nvPr/>
          </p:nvSpPr>
          <p:spPr>
            <a:xfrm>
              <a:off x="4454586" y="8374668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</a:t>
              </a:r>
            </a:p>
          </p:txBody>
        </p:sp>
        <p:sp>
          <p:nvSpPr>
            <p:cNvPr id="139" name="CasellaDiTesto 138">
              <a:extLst>
                <a:ext uri="{FF2B5EF4-FFF2-40B4-BE49-F238E27FC236}">
                  <a16:creationId xmlns:a16="http://schemas.microsoft.com/office/drawing/2014/main" id="{BCEF702F-63BC-454B-9A31-FFA03FFF6D2C}"/>
                </a:ext>
              </a:extLst>
            </p:cNvPr>
            <p:cNvSpPr txBox="1"/>
            <p:nvPr/>
          </p:nvSpPr>
          <p:spPr>
            <a:xfrm>
              <a:off x="4653671" y="8374668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6</a:t>
              </a:r>
            </a:p>
          </p:txBody>
        </p:sp>
        <p:cxnSp>
          <p:nvCxnSpPr>
            <p:cNvPr id="140" name="Connettore diritto 139">
              <a:extLst>
                <a:ext uri="{FF2B5EF4-FFF2-40B4-BE49-F238E27FC236}">
                  <a16:creationId xmlns:a16="http://schemas.microsoft.com/office/drawing/2014/main" id="{1B5B8713-46D4-44D2-9BCE-695B82E00D39}"/>
                </a:ext>
              </a:extLst>
            </p:cNvPr>
            <p:cNvCxnSpPr>
              <a:cxnSpLocks/>
            </p:cNvCxnSpPr>
            <p:nvPr/>
          </p:nvCxnSpPr>
          <p:spPr>
            <a:xfrm>
              <a:off x="2653521" y="8580519"/>
              <a:ext cx="38641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1" name="Connettore diritto 140">
              <a:extLst>
                <a:ext uri="{FF2B5EF4-FFF2-40B4-BE49-F238E27FC236}">
                  <a16:creationId xmlns:a16="http://schemas.microsoft.com/office/drawing/2014/main" id="{5BA9DB61-C822-44FB-A611-35859B8554EF}"/>
                </a:ext>
              </a:extLst>
            </p:cNvPr>
            <p:cNvCxnSpPr>
              <a:cxnSpLocks/>
            </p:cNvCxnSpPr>
            <p:nvPr/>
          </p:nvCxnSpPr>
          <p:spPr>
            <a:xfrm>
              <a:off x="3201202" y="8580519"/>
              <a:ext cx="38641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2" name="Connettore diritto 141">
              <a:extLst>
                <a:ext uri="{FF2B5EF4-FFF2-40B4-BE49-F238E27FC236}">
                  <a16:creationId xmlns:a16="http://schemas.microsoft.com/office/drawing/2014/main" id="{BD72CAA4-B39A-43B8-836D-500022D2B2F2}"/>
                </a:ext>
              </a:extLst>
            </p:cNvPr>
            <p:cNvCxnSpPr>
              <a:cxnSpLocks/>
            </p:cNvCxnSpPr>
            <p:nvPr/>
          </p:nvCxnSpPr>
          <p:spPr>
            <a:xfrm>
              <a:off x="3786044" y="8580519"/>
              <a:ext cx="38641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3" name="Connettore diritto 142">
              <a:extLst>
                <a:ext uri="{FF2B5EF4-FFF2-40B4-BE49-F238E27FC236}">
                  <a16:creationId xmlns:a16="http://schemas.microsoft.com/office/drawing/2014/main" id="{9D4F57CF-4F09-4237-854B-6D73985788A7}"/>
                </a:ext>
              </a:extLst>
            </p:cNvPr>
            <p:cNvCxnSpPr>
              <a:cxnSpLocks/>
            </p:cNvCxnSpPr>
            <p:nvPr/>
          </p:nvCxnSpPr>
          <p:spPr>
            <a:xfrm>
              <a:off x="4394858" y="8580519"/>
              <a:ext cx="38641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4" name="CasellaDiTesto 143">
              <a:extLst>
                <a:ext uri="{FF2B5EF4-FFF2-40B4-BE49-F238E27FC236}">
                  <a16:creationId xmlns:a16="http://schemas.microsoft.com/office/drawing/2014/main" id="{13E9D888-6349-4003-8BC6-B2DDF196B525}"/>
                </a:ext>
              </a:extLst>
            </p:cNvPr>
            <p:cNvSpPr txBox="1"/>
            <p:nvPr/>
          </p:nvSpPr>
          <p:spPr>
            <a:xfrm>
              <a:off x="3788089" y="8556704"/>
              <a:ext cx="36260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Tel</a:t>
              </a:r>
            </a:p>
          </p:txBody>
        </p:sp>
        <p:sp>
          <p:nvSpPr>
            <p:cNvPr id="145" name="CasellaDiTesto 144">
              <a:extLst>
                <a:ext uri="{FF2B5EF4-FFF2-40B4-BE49-F238E27FC236}">
                  <a16:creationId xmlns:a16="http://schemas.microsoft.com/office/drawing/2014/main" id="{F84EFF6F-4AA2-4893-B709-C8849A63FEE8}"/>
                </a:ext>
              </a:extLst>
            </p:cNvPr>
            <p:cNvSpPr txBox="1"/>
            <p:nvPr/>
          </p:nvSpPr>
          <p:spPr>
            <a:xfrm>
              <a:off x="4364153" y="8556704"/>
              <a:ext cx="44755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NVP</a:t>
              </a:r>
            </a:p>
          </p:txBody>
        </p:sp>
        <p:sp>
          <p:nvSpPr>
            <p:cNvPr id="146" name="CasellaDiTesto 145">
              <a:extLst>
                <a:ext uri="{FF2B5EF4-FFF2-40B4-BE49-F238E27FC236}">
                  <a16:creationId xmlns:a16="http://schemas.microsoft.com/office/drawing/2014/main" id="{298639ED-644D-4E2D-B106-0AF69426FC0F}"/>
                </a:ext>
              </a:extLst>
            </p:cNvPr>
            <p:cNvSpPr txBox="1"/>
            <p:nvPr/>
          </p:nvSpPr>
          <p:spPr>
            <a:xfrm>
              <a:off x="3198866" y="8556704"/>
              <a:ext cx="44755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NVP</a:t>
              </a:r>
            </a:p>
          </p:txBody>
        </p:sp>
        <p:sp>
          <p:nvSpPr>
            <p:cNvPr id="154" name="CasellaDiTesto 153">
              <a:extLst>
                <a:ext uri="{FF2B5EF4-FFF2-40B4-BE49-F238E27FC236}">
                  <a16:creationId xmlns:a16="http://schemas.microsoft.com/office/drawing/2014/main" id="{73A36DF0-F20E-4384-98EA-1A80D80FC0A7}"/>
                </a:ext>
              </a:extLst>
            </p:cNvPr>
            <p:cNvSpPr txBox="1"/>
            <p:nvPr/>
          </p:nvSpPr>
          <p:spPr>
            <a:xfrm rot="16200000">
              <a:off x="2265107" y="8332186"/>
              <a:ext cx="397866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IGF</a:t>
              </a:r>
            </a:p>
          </p:txBody>
        </p:sp>
        <p:sp>
          <p:nvSpPr>
            <p:cNvPr id="155" name="CasellaDiTesto 154">
              <a:extLst>
                <a:ext uri="{FF2B5EF4-FFF2-40B4-BE49-F238E27FC236}">
                  <a16:creationId xmlns:a16="http://schemas.microsoft.com/office/drawing/2014/main" id="{5354C72D-C25E-4FD8-AC43-9DAA2BB3158A}"/>
                </a:ext>
              </a:extLst>
            </p:cNvPr>
            <p:cNvSpPr txBox="1"/>
            <p:nvPr/>
          </p:nvSpPr>
          <p:spPr>
            <a:xfrm>
              <a:off x="2093428" y="8374668"/>
              <a:ext cx="27764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C</a:t>
              </a:r>
            </a:p>
          </p:txBody>
        </p:sp>
        <p:sp>
          <p:nvSpPr>
            <p:cNvPr id="156" name="CasellaDiTesto 155">
              <a:extLst>
                <a:ext uri="{FF2B5EF4-FFF2-40B4-BE49-F238E27FC236}">
                  <a16:creationId xmlns:a16="http://schemas.microsoft.com/office/drawing/2014/main" id="{037E5C03-36DA-40DA-9776-C4CB8D802259}"/>
                </a:ext>
              </a:extLst>
            </p:cNvPr>
            <p:cNvSpPr txBox="1"/>
            <p:nvPr/>
          </p:nvSpPr>
          <p:spPr>
            <a:xfrm>
              <a:off x="4880681" y="8374668"/>
              <a:ext cx="449162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(</a:t>
              </a:r>
              <a:r>
                <a:rPr lang="it-IT" sz="1000" dirty="0" err="1">
                  <a:latin typeface="+mn-lt"/>
                </a:rPr>
                <a:t>hrs</a:t>
              </a:r>
              <a:r>
                <a:rPr lang="it-IT" sz="1000" dirty="0">
                  <a:latin typeface="+mn-lt"/>
                </a:rPr>
                <a:t>)</a:t>
              </a:r>
            </a:p>
          </p:txBody>
        </p:sp>
        <p:cxnSp>
          <p:nvCxnSpPr>
            <p:cNvPr id="119" name="Connettore diritto 118">
              <a:extLst>
                <a:ext uri="{FF2B5EF4-FFF2-40B4-BE49-F238E27FC236}">
                  <a16:creationId xmlns:a16="http://schemas.microsoft.com/office/drawing/2014/main" id="{B0E5D94D-20EC-4934-99BA-9904BDEDB3F1}"/>
                </a:ext>
              </a:extLst>
            </p:cNvPr>
            <p:cNvCxnSpPr>
              <a:cxnSpLocks/>
            </p:cNvCxnSpPr>
            <p:nvPr/>
          </p:nvCxnSpPr>
          <p:spPr>
            <a:xfrm>
              <a:off x="3969389" y="8772728"/>
              <a:ext cx="61854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0" name="CasellaDiTesto 119">
              <a:extLst>
                <a:ext uri="{FF2B5EF4-FFF2-40B4-BE49-F238E27FC236}">
                  <a16:creationId xmlns:a16="http://schemas.microsoft.com/office/drawing/2014/main" id="{FF5F9D61-C233-4DFB-A08E-0679241BC3EA}"/>
                </a:ext>
              </a:extLst>
            </p:cNvPr>
            <p:cNvSpPr txBox="1"/>
            <p:nvPr/>
          </p:nvSpPr>
          <p:spPr>
            <a:xfrm>
              <a:off x="4061616" y="8758439"/>
              <a:ext cx="397866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IGF</a:t>
              </a:r>
            </a:p>
          </p:txBody>
        </p:sp>
        <p:sp>
          <p:nvSpPr>
            <p:cNvPr id="171" name="CasellaDiTesto 170">
              <a:extLst>
                <a:ext uri="{FF2B5EF4-FFF2-40B4-BE49-F238E27FC236}">
                  <a16:creationId xmlns:a16="http://schemas.microsoft.com/office/drawing/2014/main" id="{67892828-16B1-4882-B260-CA503E4007D9}"/>
                </a:ext>
              </a:extLst>
            </p:cNvPr>
            <p:cNvSpPr txBox="1"/>
            <p:nvPr/>
          </p:nvSpPr>
          <p:spPr>
            <a:xfrm rot="16200000">
              <a:off x="1004484" y="7057818"/>
              <a:ext cx="125111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 err="1"/>
                <a:t>pAKT</a:t>
              </a:r>
              <a:r>
                <a:rPr lang="it-IT" sz="1200" dirty="0"/>
                <a:t>/AKT/</a:t>
              </a:r>
              <a:r>
                <a:rPr lang="it-IT" sz="1200" dirty="0" err="1"/>
                <a:t>Vinc</a:t>
              </a:r>
              <a:endParaRPr lang="it-IT" sz="1200" dirty="0"/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C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172" name="CasellaDiTesto 171">
              <a:extLst>
                <a:ext uri="{FF2B5EF4-FFF2-40B4-BE49-F238E27FC236}">
                  <a16:creationId xmlns:a16="http://schemas.microsoft.com/office/drawing/2014/main" id="{2B98EA01-DEEB-4773-9657-E4F89B0A3099}"/>
                </a:ext>
              </a:extLst>
            </p:cNvPr>
            <p:cNvSpPr txBox="1"/>
            <p:nvPr/>
          </p:nvSpPr>
          <p:spPr>
            <a:xfrm>
              <a:off x="1680974" y="6230482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5.0</a:t>
              </a:r>
            </a:p>
          </p:txBody>
        </p:sp>
        <p:sp>
          <p:nvSpPr>
            <p:cNvPr id="174" name="CasellaDiTesto 173">
              <a:extLst>
                <a:ext uri="{FF2B5EF4-FFF2-40B4-BE49-F238E27FC236}">
                  <a16:creationId xmlns:a16="http://schemas.microsoft.com/office/drawing/2014/main" id="{A1B26510-2BF8-4A23-B573-EC7570301EAC}"/>
                </a:ext>
              </a:extLst>
            </p:cNvPr>
            <p:cNvSpPr txBox="1"/>
            <p:nvPr/>
          </p:nvSpPr>
          <p:spPr>
            <a:xfrm>
              <a:off x="1765932" y="8137840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176" name="CasellaDiTesto 175">
              <a:extLst>
                <a:ext uri="{FF2B5EF4-FFF2-40B4-BE49-F238E27FC236}">
                  <a16:creationId xmlns:a16="http://schemas.microsoft.com/office/drawing/2014/main" id="{0D951320-FE35-4C18-AED4-E84C58465A39}"/>
                </a:ext>
              </a:extLst>
            </p:cNvPr>
            <p:cNvSpPr txBox="1"/>
            <p:nvPr/>
          </p:nvSpPr>
          <p:spPr>
            <a:xfrm>
              <a:off x="1765932" y="713888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2.0</a:t>
              </a:r>
            </a:p>
          </p:txBody>
        </p:sp>
      </p:grpSp>
      <p:sp>
        <p:nvSpPr>
          <p:cNvPr id="191" name="CasellaDiTesto 190">
            <a:extLst>
              <a:ext uri="{FF2B5EF4-FFF2-40B4-BE49-F238E27FC236}">
                <a16:creationId xmlns:a16="http://schemas.microsoft.com/office/drawing/2014/main" id="{B29BBB48-13CD-71CF-1A68-901D8373CF6C}"/>
              </a:ext>
            </a:extLst>
          </p:cNvPr>
          <p:cNvSpPr txBox="1"/>
          <p:nvPr/>
        </p:nvSpPr>
        <p:spPr>
          <a:xfrm>
            <a:off x="2414232" y="4712849"/>
            <a:ext cx="303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**</a:t>
            </a:r>
          </a:p>
        </p:txBody>
      </p:sp>
      <p:sp>
        <p:nvSpPr>
          <p:cNvPr id="194" name="CasellaDiTesto 193">
            <a:extLst>
              <a:ext uri="{FF2B5EF4-FFF2-40B4-BE49-F238E27FC236}">
                <a16:creationId xmlns:a16="http://schemas.microsoft.com/office/drawing/2014/main" id="{25846EE5-72B1-10F3-6ECD-E9A550148D75}"/>
              </a:ext>
            </a:extLst>
          </p:cNvPr>
          <p:cNvSpPr txBox="1"/>
          <p:nvPr/>
        </p:nvSpPr>
        <p:spPr>
          <a:xfrm>
            <a:off x="2511202" y="5068904"/>
            <a:ext cx="3861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***</a:t>
            </a:r>
          </a:p>
        </p:txBody>
      </p:sp>
      <p:sp>
        <p:nvSpPr>
          <p:cNvPr id="195" name="CasellaDiTesto 194">
            <a:extLst>
              <a:ext uri="{FF2B5EF4-FFF2-40B4-BE49-F238E27FC236}">
                <a16:creationId xmlns:a16="http://schemas.microsoft.com/office/drawing/2014/main" id="{3C665EE7-44DF-207E-A446-46773804AF45}"/>
              </a:ext>
            </a:extLst>
          </p:cNvPr>
          <p:cNvSpPr txBox="1"/>
          <p:nvPr/>
        </p:nvSpPr>
        <p:spPr>
          <a:xfrm>
            <a:off x="2663602" y="5221304"/>
            <a:ext cx="3861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***</a:t>
            </a:r>
          </a:p>
        </p:txBody>
      </p:sp>
      <p:sp>
        <p:nvSpPr>
          <p:cNvPr id="196" name="CasellaDiTesto 195">
            <a:extLst>
              <a:ext uri="{FF2B5EF4-FFF2-40B4-BE49-F238E27FC236}">
                <a16:creationId xmlns:a16="http://schemas.microsoft.com/office/drawing/2014/main" id="{0FDACA94-FCE0-606D-2B8F-4C10610CC02E}"/>
              </a:ext>
            </a:extLst>
          </p:cNvPr>
          <p:cNvSpPr txBox="1"/>
          <p:nvPr/>
        </p:nvSpPr>
        <p:spPr>
          <a:xfrm>
            <a:off x="3001750" y="4705449"/>
            <a:ext cx="3032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**</a:t>
            </a:r>
          </a:p>
          <a:p>
            <a:r>
              <a:rPr lang="it-IT" sz="1200" dirty="0"/>
              <a:t>**</a:t>
            </a:r>
          </a:p>
        </p:txBody>
      </p:sp>
      <p:sp>
        <p:nvSpPr>
          <p:cNvPr id="204" name="CasellaDiTesto 203">
            <a:extLst>
              <a:ext uri="{FF2B5EF4-FFF2-40B4-BE49-F238E27FC236}">
                <a16:creationId xmlns:a16="http://schemas.microsoft.com/office/drawing/2014/main" id="{5D84D910-8E3E-03F1-AF43-09DB62945D35}"/>
              </a:ext>
            </a:extLst>
          </p:cNvPr>
          <p:cNvSpPr txBox="1"/>
          <p:nvPr/>
        </p:nvSpPr>
        <p:spPr>
          <a:xfrm>
            <a:off x="3138412" y="4705449"/>
            <a:ext cx="3032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**</a:t>
            </a:r>
          </a:p>
          <a:p>
            <a:r>
              <a:rPr lang="it-IT" sz="1200" dirty="0"/>
              <a:t>**</a:t>
            </a:r>
          </a:p>
        </p:txBody>
      </p:sp>
      <p:sp>
        <p:nvSpPr>
          <p:cNvPr id="205" name="CasellaDiTesto 204">
            <a:extLst>
              <a:ext uri="{FF2B5EF4-FFF2-40B4-BE49-F238E27FC236}">
                <a16:creationId xmlns:a16="http://schemas.microsoft.com/office/drawing/2014/main" id="{1F6DF63C-F273-1907-E241-48F7532D37A9}"/>
              </a:ext>
            </a:extLst>
          </p:cNvPr>
          <p:cNvSpPr txBox="1"/>
          <p:nvPr/>
        </p:nvSpPr>
        <p:spPr>
          <a:xfrm>
            <a:off x="3259584" y="4705449"/>
            <a:ext cx="3032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**</a:t>
            </a:r>
          </a:p>
          <a:p>
            <a:r>
              <a:rPr lang="it-IT" sz="1200" dirty="0"/>
              <a:t>**</a:t>
            </a:r>
          </a:p>
        </p:txBody>
      </p:sp>
      <p:sp>
        <p:nvSpPr>
          <p:cNvPr id="206" name="CasellaDiTesto 205">
            <a:extLst>
              <a:ext uri="{FF2B5EF4-FFF2-40B4-BE49-F238E27FC236}">
                <a16:creationId xmlns:a16="http://schemas.microsoft.com/office/drawing/2014/main" id="{211C68C3-53B9-5FD4-F971-0A4218DDE6E5}"/>
              </a:ext>
            </a:extLst>
          </p:cNvPr>
          <p:cNvSpPr txBox="1"/>
          <p:nvPr/>
        </p:nvSpPr>
        <p:spPr>
          <a:xfrm>
            <a:off x="3686870" y="4752113"/>
            <a:ext cx="303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*</a:t>
            </a:r>
          </a:p>
        </p:txBody>
      </p:sp>
      <p:sp>
        <p:nvSpPr>
          <p:cNvPr id="220" name="CasellaDiTesto 219">
            <a:extLst>
              <a:ext uri="{FF2B5EF4-FFF2-40B4-BE49-F238E27FC236}">
                <a16:creationId xmlns:a16="http://schemas.microsoft.com/office/drawing/2014/main" id="{6B112BC7-C8DF-BCD2-E8CF-8019FDB9F10B}"/>
              </a:ext>
            </a:extLst>
          </p:cNvPr>
          <p:cNvSpPr txBox="1"/>
          <p:nvPr/>
        </p:nvSpPr>
        <p:spPr>
          <a:xfrm>
            <a:off x="3783840" y="5108168"/>
            <a:ext cx="3861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**</a:t>
            </a:r>
          </a:p>
        </p:txBody>
      </p:sp>
      <p:sp>
        <p:nvSpPr>
          <p:cNvPr id="221" name="CasellaDiTesto 220">
            <a:extLst>
              <a:ext uri="{FF2B5EF4-FFF2-40B4-BE49-F238E27FC236}">
                <a16:creationId xmlns:a16="http://schemas.microsoft.com/office/drawing/2014/main" id="{688ED16D-6BC7-781B-85E5-C9189FA95D9A}"/>
              </a:ext>
            </a:extLst>
          </p:cNvPr>
          <p:cNvSpPr txBox="1"/>
          <p:nvPr/>
        </p:nvSpPr>
        <p:spPr>
          <a:xfrm>
            <a:off x="4264027" y="4731201"/>
            <a:ext cx="303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*</a:t>
            </a:r>
          </a:p>
        </p:txBody>
      </p:sp>
      <p:sp>
        <p:nvSpPr>
          <p:cNvPr id="222" name="CasellaDiTesto 221">
            <a:extLst>
              <a:ext uri="{FF2B5EF4-FFF2-40B4-BE49-F238E27FC236}">
                <a16:creationId xmlns:a16="http://schemas.microsoft.com/office/drawing/2014/main" id="{3AC94FEE-FA7F-EAFD-7B5C-FB5E0E2E92A1}"/>
              </a:ext>
            </a:extLst>
          </p:cNvPr>
          <p:cNvSpPr txBox="1"/>
          <p:nvPr/>
        </p:nvSpPr>
        <p:spPr>
          <a:xfrm>
            <a:off x="4329247" y="5087256"/>
            <a:ext cx="3861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***</a:t>
            </a:r>
          </a:p>
        </p:txBody>
      </p:sp>
      <p:sp>
        <p:nvSpPr>
          <p:cNvPr id="223" name="CasellaDiTesto 222">
            <a:extLst>
              <a:ext uri="{FF2B5EF4-FFF2-40B4-BE49-F238E27FC236}">
                <a16:creationId xmlns:a16="http://schemas.microsoft.com/office/drawing/2014/main" id="{7B5FB96A-B5C5-5261-3093-B947DA3F51AF}"/>
              </a:ext>
            </a:extLst>
          </p:cNvPr>
          <p:cNvSpPr txBox="1"/>
          <p:nvPr/>
        </p:nvSpPr>
        <p:spPr>
          <a:xfrm>
            <a:off x="2312538" y="6294695"/>
            <a:ext cx="453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****</a:t>
            </a:r>
          </a:p>
        </p:txBody>
      </p:sp>
      <p:sp>
        <p:nvSpPr>
          <p:cNvPr id="224" name="CasellaDiTesto 223">
            <a:extLst>
              <a:ext uri="{FF2B5EF4-FFF2-40B4-BE49-F238E27FC236}">
                <a16:creationId xmlns:a16="http://schemas.microsoft.com/office/drawing/2014/main" id="{C9490657-70FE-3502-85D2-3423E1C9C6DB}"/>
              </a:ext>
            </a:extLst>
          </p:cNvPr>
          <p:cNvSpPr txBox="1"/>
          <p:nvPr/>
        </p:nvSpPr>
        <p:spPr>
          <a:xfrm>
            <a:off x="4078678" y="6355353"/>
            <a:ext cx="453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****</a:t>
            </a:r>
          </a:p>
        </p:txBody>
      </p:sp>
      <p:sp>
        <p:nvSpPr>
          <p:cNvPr id="225" name="CasellaDiTesto 224">
            <a:extLst>
              <a:ext uri="{FF2B5EF4-FFF2-40B4-BE49-F238E27FC236}">
                <a16:creationId xmlns:a16="http://schemas.microsoft.com/office/drawing/2014/main" id="{B4139019-D1B9-2E61-2C5E-D2DB55C0084D}"/>
              </a:ext>
            </a:extLst>
          </p:cNvPr>
          <p:cNvSpPr txBox="1"/>
          <p:nvPr/>
        </p:nvSpPr>
        <p:spPr>
          <a:xfrm>
            <a:off x="3900735" y="6609818"/>
            <a:ext cx="453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***</a:t>
            </a:r>
          </a:p>
        </p:txBody>
      </p:sp>
      <p:sp>
        <p:nvSpPr>
          <p:cNvPr id="226" name="CasellaDiTesto 225">
            <a:extLst>
              <a:ext uri="{FF2B5EF4-FFF2-40B4-BE49-F238E27FC236}">
                <a16:creationId xmlns:a16="http://schemas.microsoft.com/office/drawing/2014/main" id="{04C96369-71AB-5838-3F97-A4F17AB3A84E}"/>
              </a:ext>
            </a:extLst>
          </p:cNvPr>
          <p:cNvSpPr txBox="1"/>
          <p:nvPr/>
        </p:nvSpPr>
        <p:spPr>
          <a:xfrm>
            <a:off x="3709603" y="6456867"/>
            <a:ext cx="453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***</a:t>
            </a:r>
          </a:p>
        </p:txBody>
      </p:sp>
      <p:sp>
        <p:nvSpPr>
          <p:cNvPr id="227" name="CasellaDiTesto 226">
            <a:extLst>
              <a:ext uri="{FF2B5EF4-FFF2-40B4-BE49-F238E27FC236}">
                <a16:creationId xmlns:a16="http://schemas.microsoft.com/office/drawing/2014/main" id="{C60D6C0D-485D-DFF5-6955-170883933B70}"/>
              </a:ext>
            </a:extLst>
          </p:cNvPr>
          <p:cNvSpPr txBox="1"/>
          <p:nvPr/>
        </p:nvSpPr>
        <p:spPr>
          <a:xfrm>
            <a:off x="4295757" y="7606143"/>
            <a:ext cx="3178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°°</a:t>
            </a:r>
          </a:p>
          <a:p>
            <a:r>
              <a:rPr lang="it-IT" sz="1200" dirty="0"/>
              <a:t>°°</a:t>
            </a:r>
          </a:p>
        </p:txBody>
      </p:sp>
      <p:sp>
        <p:nvSpPr>
          <p:cNvPr id="230" name="CasellaDiTesto 229">
            <a:extLst>
              <a:ext uri="{FF2B5EF4-FFF2-40B4-BE49-F238E27FC236}">
                <a16:creationId xmlns:a16="http://schemas.microsoft.com/office/drawing/2014/main" id="{9AE2B585-63AD-8341-2D2E-0B56EF96EA7A}"/>
              </a:ext>
            </a:extLst>
          </p:cNvPr>
          <p:cNvSpPr txBox="1"/>
          <p:nvPr/>
        </p:nvSpPr>
        <p:spPr>
          <a:xfrm>
            <a:off x="4502838" y="7757982"/>
            <a:ext cx="3178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°°</a:t>
            </a:r>
          </a:p>
          <a:p>
            <a:r>
              <a:rPr lang="it-IT" sz="1200" dirty="0"/>
              <a:t>°°</a:t>
            </a:r>
          </a:p>
        </p:txBody>
      </p:sp>
      <p:sp>
        <p:nvSpPr>
          <p:cNvPr id="231" name="CasellaDiTesto 230">
            <a:extLst>
              <a:ext uri="{FF2B5EF4-FFF2-40B4-BE49-F238E27FC236}">
                <a16:creationId xmlns:a16="http://schemas.microsoft.com/office/drawing/2014/main" id="{FEDC1F1C-B51F-8D6F-AC4C-4469E2A0E7F2}"/>
              </a:ext>
            </a:extLst>
          </p:cNvPr>
          <p:cNvSpPr txBox="1"/>
          <p:nvPr/>
        </p:nvSpPr>
        <p:spPr>
          <a:xfrm>
            <a:off x="4711727" y="7671561"/>
            <a:ext cx="3178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°°</a:t>
            </a:r>
          </a:p>
          <a:p>
            <a:r>
              <a:rPr lang="it-IT" sz="1200" dirty="0"/>
              <a:t>°°</a:t>
            </a:r>
          </a:p>
        </p:txBody>
      </p:sp>
      <p:sp>
        <p:nvSpPr>
          <p:cNvPr id="232" name="CasellaDiTesto 231">
            <a:extLst>
              <a:ext uri="{FF2B5EF4-FFF2-40B4-BE49-F238E27FC236}">
                <a16:creationId xmlns:a16="http://schemas.microsoft.com/office/drawing/2014/main" id="{BB1DFB66-D278-ECA1-6246-A6610CD0A3E9}"/>
              </a:ext>
            </a:extLst>
          </p:cNvPr>
          <p:cNvSpPr txBox="1"/>
          <p:nvPr/>
        </p:nvSpPr>
        <p:spPr>
          <a:xfrm>
            <a:off x="2963044" y="7092280"/>
            <a:ext cx="3062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2489713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C2C26514-7C88-40AB-998D-C434AFA67D67}"/>
              </a:ext>
            </a:extLst>
          </p:cNvPr>
          <p:cNvGrpSpPr/>
          <p:nvPr/>
        </p:nvGrpSpPr>
        <p:grpSpPr>
          <a:xfrm>
            <a:off x="955393" y="2207671"/>
            <a:ext cx="1734007" cy="979986"/>
            <a:chOff x="2780928" y="827584"/>
            <a:chExt cx="1734007" cy="979986"/>
          </a:xfrm>
        </p:grpSpPr>
        <p:sp>
          <p:nvSpPr>
            <p:cNvPr id="3" name="CasellaDiTesto 2">
              <a:extLst>
                <a:ext uri="{FF2B5EF4-FFF2-40B4-BE49-F238E27FC236}">
                  <a16:creationId xmlns:a16="http://schemas.microsoft.com/office/drawing/2014/main" id="{ACA426E4-E63E-482B-A530-16A0DD60B19F}"/>
                </a:ext>
              </a:extLst>
            </p:cNvPr>
            <p:cNvSpPr txBox="1"/>
            <p:nvPr/>
          </p:nvSpPr>
          <p:spPr>
            <a:xfrm>
              <a:off x="3385014" y="827584"/>
              <a:ext cx="44755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NVP</a:t>
              </a:r>
            </a:p>
          </p:txBody>
        </p:sp>
        <p:grpSp>
          <p:nvGrpSpPr>
            <p:cNvPr id="4" name="Gruppo 3">
              <a:extLst>
                <a:ext uri="{FF2B5EF4-FFF2-40B4-BE49-F238E27FC236}">
                  <a16:creationId xmlns:a16="http://schemas.microsoft.com/office/drawing/2014/main" id="{206A4C5E-3841-4524-A248-F898B370451C}"/>
                </a:ext>
              </a:extLst>
            </p:cNvPr>
            <p:cNvGrpSpPr/>
            <p:nvPr/>
          </p:nvGrpSpPr>
          <p:grpSpPr>
            <a:xfrm>
              <a:off x="2780928" y="995662"/>
              <a:ext cx="1734007" cy="811908"/>
              <a:chOff x="2780928" y="995662"/>
              <a:chExt cx="1734007" cy="811908"/>
            </a:xfrm>
          </p:grpSpPr>
          <p:sp>
            <p:nvSpPr>
              <p:cNvPr id="5" name="CasellaDiTesto 4">
                <a:extLst>
                  <a:ext uri="{FF2B5EF4-FFF2-40B4-BE49-F238E27FC236}">
                    <a16:creationId xmlns:a16="http://schemas.microsoft.com/office/drawing/2014/main" id="{E594B0AF-995F-4392-8729-15A388FC90D8}"/>
                  </a:ext>
                </a:extLst>
              </p:cNvPr>
              <p:cNvSpPr txBox="1"/>
              <p:nvPr/>
            </p:nvSpPr>
            <p:spPr>
              <a:xfrm>
                <a:off x="3883031" y="1561349"/>
                <a:ext cx="631904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err="1">
                    <a:latin typeface="+mn-lt"/>
                  </a:rPr>
                  <a:t>Vinculin</a:t>
                </a:r>
                <a:endParaRPr lang="it-IT" sz="1000" dirty="0">
                  <a:latin typeface="+mn-lt"/>
                </a:endParaRPr>
              </a:p>
            </p:txBody>
          </p:sp>
          <p:sp>
            <p:nvSpPr>
              <p:cNvPr id="6" name="CasellaDiTesto 5">
                <a:extLst>
                  <a:ext uri="{FF2B5EF4-FFF2-40B4-BE49-F238E27FC236}">
                    <a16:creationId xmlns:a16="http://schemas.microsoft.com/office/drawing/2014/main" id="{9F648F7D-3A54-4BB8-9708-5A8E2522F097}"/>
                  </a:ext>
                </a:extLst>
              </p:cNvPr>
              <p:cNvSpPr txBox="1"/>
              <p:nvPr/>
            </p:nvSpPr>
            <p:spPr>
              <a:xfrm>
                <a:off x="3883031" y="1351813"/>
                <a:ext cx="433132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+mn-lt"/>
                  </a:rPr>
                  <a:t>AKT</a:t>
                </a:r>
              </a:p>
            </p:txBody>
          </p:sp>
          <p:sp>
            <p:nvSpPr>
              <p:cNvPr id="7" name="CasellaDiTesto 6">
                <a:extLst>
                  <a:ext uri="{FF2B5EF4-FFF2-40B4-BE49-F238E27FC236}">
                    <a16:creationId xmlns:a16="http://schemas.microsoft.com/office/drawing/2014/main" id="{3883E053-8F57-4917-A4B1-17A20BEE6917}"/>
                  </a:ext>
                </a:extLst>
              </p:cNvPr>
              <p:cNvSpPr txBox="1"/>
              <p:nvPr/>
            </p:nvSpPr>
            <p:spPr>
              <a:xfrm>
                <a:off x="3883031" y="1143731"/>
                <a:ext cx="503664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err="1">
                    <a:latin typeface="+mn-lt"/>
                  </a:rPr>
                  <a:t>pAKT</a:t>
                </a:r>
                <a:endParaRPr lang="it-IT" sz="1000" dirty="0">
                  <a:latin typeface="+mn-lt"/>
                </a:endParaRPr>
              </a:p>
            </p:txBody>
          </p:sp>
          <p:sp>
            <p:nvSpPr>
              <p:cNvPr id="8" name="CasellaDiTesto 7">
                <a:extLst>
                  <a:ext uri="{FF2B5EF4-FFF2-40B4-BE49-F238E27FC236}">
                    <a16:creationId xmlns:a16="http://schemas.microsoft.com/office/drawing/2014/main" id="{4105BE4F-728D-4F38-8B3E-D379A8687631}"/>
                  </a:ext>
                </a:extLst>
              </p:cNvPr>
              <p:cNvSpPr txBox="1"/>
              <p:nvPr/>
            </p:nvSpPr>
            <p:spPr>
              <a:xfrm>
                <a:off x="2802912" y="995662"/>
                <a:ext cx="227948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+mn-lt"/>
                  </a:rPr>
                  <a:t>-</a:t>
                </a:r>
              </a:p>
            </p:txBody>
          </p:sp>
          <p:sp>
            <p:nvSpPr>
              <p:cNvPr id="9" name="CasellaDiTesto 8">
                <a:extLst>
                  <a:ext uri="{FF2B5EF4-FFF2-40B4-BE49-F238E27FC236}">
                    <a16:creationId xmlns:a16="http://schemas.microsoft.com/office/drawing/2014/main" id="{3F16DAC9-D517-45B7-80A9-F29F004BFD76}"/>
                  </a:ext>
                </a:extLst>
              </p:cNvPr>
              <p:cNvSpPr txBox="1"/>
              <p:nvPr/>
            </p:nvSpPr>
            <p:spPr>
              <a:xfrm>
                <a:off x="3084770" y="995662"/>
                <a:ext cx="260008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+mn-lt"/>
                  </a:rPr>
                  <a:t>+</a:t>
                </a:r>
              </a:p>
            </p:txBody>
          </p:sp>
          <p:sp>
            <p:nvSpPr>
              <p:cNvPr id="10" name="CasellaDiTesto 9">
                <a:extLst>
                  <a:ext uri="{FF2B5EF4-FFF2-40B4-BE49-F238E27FC236}">
                    <a16:creationId xmlns:a16="http://schemas.microsoft.com/office/drawing/2014/main" id="{CE7EA7DC-48DD-4A8C-BD56-F0CB84D5D0C5}"/>
                  </a:ext>
                </a:extLst>
              </p:cNvPr>
              <p:cNvSpPr txBox="1"/>
              <p:nvPr/>
            </p:nvSpPr>
            <p:spPr>
              <a:xfrm>
                <a:off x="3883031" y="995662"/>
                <a:ext cx="397866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+mn-lt"/>
                  </a:rPr>
                  <a:t>IGF</a:t>
                </a:r>
              </a:p>
            </p:txBody>
          </p:sp>
          <p:sp>
            <p:nvSpPr>
              <p:cNvPr id="11" name="CasellaDiTesto 10">
                <a:extLst>
                  <a:ext uri="{FF2B5EF4-FFF2-40B4-BE49-F238E27FC236}">
                    <a16:creationId xmlns:a16="http://schemas.microsoft.com/office/drawing/2014/main" id="{A2A50D95-6783-48FC-821C-00F439DF74A0}"/>
                  </a:ext>
                </a:extLst>
              </p:cNvPr>
              <p:cNvSpPr txBox="1"/>
              <p:nvPr/>
            </p:nvSpPr>
            <p:spPr>
              <a:xfrm>
                <a:off x="3361444" y="995662"/>
                <a:ext cx="227948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+mn-lt"/>
                  </a:rPr>
                  <a:t>-</a:t>
                </a:r>
              </a:p>
            </p:txBody>
          </p:sp>
          <p:sp>
            <p:nvSpPr>
              <p:cNvPr id="12" name="CasellaDiTesto 11">
                <a:extLst>
                  <a:ext uri="{FF2B5EF4-FFF2-40B4-BE49-F238E27FC236}">
                    <a16:creationId xmlns:a16="http://schemas.microsoft.com/office/drawing/2014/main" id="{2AE91BE3-87DC-49B6-A11D-4BB814638FFD}"/>
                  </a:ext>
                </a:extLst>
              </p:cNvPr>
              <p:cNvSpPr txBox="1"/>
              <p:nvPr/>
            </p:nvSpPr>
            <p:spPr>
              <a:xfrm>
                <a:off x="3606811" y="995662"/>
                <a:ext cx="260008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+mn-lt"/>
                  </a:rPr>
                  <a:t>+</a:t>
                </a:r>
              </a:p>
            </p:txBody>
          </p:sp>
          <p:cxnSp>
            <p:nvCxnSpPr>
              <p:cNvPr id="13" name="Connettore diritto 12">
                <a:extLst>
                  <a:ext uri="{FF2B5EF4-FFF2-40B4-BE49-F238E27FC236}">
                    <a16:creationId xmlns:a16="http://schemas.microsoft.com/office/drawing/2014/main" id="{13DEAE0E-330E-4E66-8FD2-B68CBF7BEB6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75418" y="1046462"/>
                <a:ext cx="26139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pic>
            <p:nvPicPr>
              <p:cNvPr id="14" name="Immagine 13">
                <a:extLst>
                  <a:ext uri="{FF2B5EF4-FFF2-40B4-BE49-F238E27FC236}">
                    <a16:creationId xmlns:a16="http://schemas.microsoft.com/office/drawing/2014/main" id="{6181B0D2-58E1-451F-9880-7ED05286D31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780928" y="1184728"/>
                <a:ext cx="1080000" cy="16422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5" name="Immagine 14">
                <a:extLst>
                  <a:ext uri="{FF2B5EF4-FFF2-40B4-BE49-F238E27FC236}">
                    <a16:creationId xmlns:a16="http://schemas.microsoft.com/office/drawing/2014/main" id="{862A2712-1AD1-4691-BE0A-19BDDD50D52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780928" y="1392810"/>
                <a:ext cx="1080000" cy="16422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6" name="Immagine 15">
                <a:extLst>
                  <a:ext uri="{FF2B5EF4-FFF2-40B4-BE49-F238E27FC236}">
                    <a16:creationId xmlns:a16="http://schemas.microsoft.com/office/drawing/2014/main" id="{4109BB2D-C202-4270-ADDE-143A032AFF7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780928" y="1603732"/>
                <a:ext cx="1080000" cy="16145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</p:grpSp>
      <p:grpSp>
        <p:nvGrpSpPr>
          <p:cNvPr id="17" name="Gruppo 16">
            <a:extLst>
              <a:ext uri="{FF2B5EF4-FFF2-40B4-BE49-F238E27FC236}">
                <a16:creationId xmlns:a16="http://schemas.microsoft.com/office/drawing/2014/main" id="{DDA6C99E-5C99-4640-8272-5026C3237A2B}"/>
              </a:ext>
            </a:extLst>
          </p:cNvPr>
          <p:cNvGrpSpPr/>
          <p:nvPr/>
        </p:nvGrpSpPr>
        <p:grpSpPr>
          <a:xfrm>
            <a:off x="4258853" y="2182051"/>
            <a:ext cx="1702002" cy="979986"/>
            <a:chOff x="5043776" y="827584"/>
            <a:chExt cx="1702002" cy="979986"/>
          </a:xfrm>
        </p:grpSpPr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08AFD039-6312-40E1-828E-46484D1BA365}"/>
                </a:ext>
              </a:extLst>
            </p:cNvPr>
            <p:cNvSpPr txBox="1"/>
            <p:nvPr/>
          </p:nvSpPr>
          <p:spPr>
            <a:xfrm>
              <a:off x="6113874" y="1561349"/>
              <a:ext cx="63190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Vinculin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E78976FD-CD00-4929-A719-B26F1DE35036}"/>
                </a:ext>
              </a:extLst>
            </p:cNvPr>
            <p:cNvSpPr txBox="1"/>
            <p:nvPr/>
          </p:nvSpPr>
          <p:spPr>
            <a:xfrm>
              <a:off x="6113874" y="1351813"/>
              <a:ext cx="433132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AKT</a:t>
              </a:r>
            </a:p>
          </p:txBody>
        </p: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1E6A8447-B75A-4F83-A87B-3A0C7DB7B353}"/>
                </a:ext>
              </a:extLst>
            </p:cNvPr>
            <p:cNvSpPr txBox="1"/>
            <p:nvPr/>
          </p:nvSpPr>
          <p:spPr>
            <a:xfrm>
              <a:off x="6113874" y="1143731"/>
              <a:ext cx="50366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pAKT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B8FAE10A-0EF7-413D-A973-569FA237B83D}"/>
                </a:ext>
              </a:extLst>
            </p:cNvPr>
            <p:cNvSpPr txBox="1"/>
            <p:nvPr/>
          </p:nvSpPr>
          <p:spPr>
            <a:xfrm>
              <a:off x="5092310" y="995662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0A8B3ECC-B848-4B5B-A5D2-D14C402CCA94}"/>
                </a:ext>
              </a:extLst>
            </p:cNvPr>
            <p:cNvSpPr txBox="1"/>
            <p:nvPr/>
          </p:nvSpPr>
          <p:spPr>
            <a:xfrm>
              <a:off x="5329232" y="995662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sp>
          <p:nvSpPr>
            <p:cNvPr id="23" name="CasellaDiTesto 22">
              <a:extLst>
                <a:ext uri="{FF2B5EF4-FFF2-40B4-BE49-F238E27FC236}">
                  <a16:creationId xmlns:a16="http://schemas.microsoft.com/office/drawing/2014/main" id="{BBBDCBE4-B904-4B48-868C-3C45F23B8E27}"/>
                </a:ext>
              </a:extLst>
            </p:cNvPr>
            <p:cNvSpPr txBox="1"/>
            <p:nvPr/>
          </p:nvSpPr>
          <p:spPr>
            <a:xfrm>
              <a:off x="6113874" y="995662"/>
              <a:ext cx="44755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EGF</a:t>
              </a:r>
            </a:p>
          </p:txBody>
        </p: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id="{932EEEF3-FEA0-4D46-B966-98F5C914D35A}"/>
                </a:ext>
              </a:extLst>
            </p:cNvPr>
            <p:cNvSpPr txBox="1"/>
            <p:nvPr/>
          </p:nvSpPr>
          <p:spPr>
            <a:xfrm>
              <a:off x="5602716" y="995662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C1FB2A24-E270-463C-B92E-D3FF2B2BACFE}"/>
                </a:ext>
              </a:extLst>
            </p:cNvPr>
            <p:cNvSpPr txBox="1"/>
            <p:nvPr/>
          </p:nvSpPr>
          <p:spPr>
            <a:xfrm>
              <a:off x="5837654" y="995662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cxnSp>
          <p:nvCxnSpPr>
            <p:cNvPr id="26" name="Connettore diritto 25">
              <a:extLst>
                <a:ext uri="{FF2B5EF4-FFF2-40B4-BE49-F238E27FC236}">
                  <a16:creationId xmlns:a16="http://schemas.microsoft.com/office/drawing/2014/main" id="{941CB2B0-E317-4EF5-81C0-5744A4981B4B}"/>
                </a:ext>
              </a:extLst>
            </p:cNvPr>
            <p:cNvCxnSpPr>
              <a:cxnSpLocks/>
            </p:cNvCxnSpPr>
            <p:nvPr/>
          </p:nvCxnSpPr>
          <p:spPr>
            <a:xfrm>
              <a:off x="5716690" y="1046462"/>
              <a:ext cx="25096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id="{51D6ED7D-6357-4BD2-A0B2-F55E6B873EB7}"/>
                </a:ext>
              </a:extLst>
            </p:cNvPr>
            <p:cNvSpPr txBox="1"/>
            <p:nvPr/>
          </p:nvSpPr>
          <p:spPr>
            <a:xfrm>
              <a:off x="5628557" y="827584"/>
              <a:ext cx="44755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NVP</a:t>
              </a:r>
            </a:p>
          </p:txBody>
        </p:sp>
        <p:pic>
          <p:nvPicPr>
            <p:cNvPr id="28" name="Immagine 27">
              <a:extLst>
                <a:ext uri="{FF2B5EF4-FFF2-40B4-BE49-F238E27FC236}">
                  <a16:creationId xmlns:a16="http://schemas.microsoft.com/office/drawing/2014/main" id="{CAE2944E-97A1-4C8A-ABD1-1B5E182972D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043776" y="1187525"/>
              <a:ext cx="1080000" cy="15863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9" name="Immagine 28">
              <a:extLst>
                <a:ext uri="{FF2B5EF4-FFF2-40B4-BE49-F238E27FC236}">
                  <a16:creationId xmlns:a16="http://schemas.microsoft.com/office/drawing/2014/main" id="{9236AE0A-7BBC-4203-BBD8-6F753D0BFD8F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043776" y="1389422"/>
              <a:ext cx="1080000" cy="17100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0" name="Immagine 29">
              <a:extLst>
                <a:ext uri="{FF2B5EF4-FFF2-40B4-BE49-F238E27FC236}">
                  <a16:creationId xmlns:a16="http://schemas.microsoft.com/office/drawing/2014/main" id="{21D52002-EA94-4475-8424-97AAF3DF6527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043776" y="1603732"/>
              <a:ext cx="1080000" cy="16145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31" name="Gruppo 30">
            <a:extLst>
              <a:ext uri="{FF2B5EF4-FFF2-40B4-BE49-F238E27FC236}">
                <a16:creationId xmlns:a16="http://schemas.microsoft.com/office/drawing/2014/main" id="{DE5DFA23-5114-4C80-9F25-A39AD022C0BE}"/>
              </a:ext>
            </a:extLst>
          </p:cNvPr>
          <p:cNvGrpSpPr/>
          <p:nvPr/>
        </p:nvGrpSpPr>
        <p:grpSpPr>
          <a:xfrm>
            <a:off x="955393" y="5555964"/>
            <a:ext cx="1734007" cy="979986"/>
            <a:chOff x="2772532" y="2274094"/>
            <a:chExt cx="1734007" cy="979986"/>
          </a:xfrm>
        </p:grpSpPr>
        <p:pic>
          <p:nvPicPr>
            <p:cNvPr id="32" name="Immagine 31">
              <a:extLst>
                <a:ext uri="{FF2B5EF4-FFF2-40B4-BE49-F238E27FC236}">
                  <a16:creationId xmlns:a16="http://schemas.microsoft.com/office/drawing/2014/main" id="{4668BCCF-54D9-42EF-A0C3-967209ED0C98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772532" y="2623715"/>
              <a:ext cx="1080000" cy="16895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3" name="Immagine 32">
              <a:extLst>
                <a:ext uri="{FF2B5EF4-FFF2-40B4-BE49-F238E27FC236}">
                  <a16:creationId xmlns:a16="http://schemas.microsoft.com/office/drawing/2014/main" id="{A8A11E5A-A619-4202-BE6E-E3A782707D37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772532" y="2842708"/>
              <a:ext cx="1080000" cy="16422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4" name="Immagine 33">
              <a:extLst>
                <a:ext uri="{FF2B5EF4-FFF2-40B4-BE49-F238E27FC236}">
                  <a16:creationId xmlns:a16="http://schemas.microsoft.com/office/drawing/2014/main" id="{0B865855-9DC7-427F-A20D-4CF18D8D41D4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772532" y="3036931"/>
              <a:ext cx="1080000" cy="17476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id="{EE05A7A2-6809-4B99-9D11-3A3E30B35285}"/>
                </a:ext>
              </a:extLst>
            </p:cNvPr>
            <p:cNvSpPr txBox="1"/>
            <p:nvPr/>
          </p:nvSpPr>
          <p:spPr>
            <a:xfrm>
              <a:off x="3874635" y="3007859"/>
              <a:ext cx="63190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Vinculin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36" name="CasellaDiTesto 35">
              <a:extLst>
                <a:ext uri="{FF2B5EF4-FFF2-40B4-BE49-F238E27FC236}">
                  <a16:creationId xmlns:a16="http://schemas.microsoft.com/office/drawing/2014/main" id="{9B6955AA-FF06-4D0C-8D9B-4D5B8141AAC2}"/>
                </a:ext>
              </a:extLst>
            </p:cNvPr>
            <p:cNvSpPr txBox="1"/>
            <p:nvPr/>
          </p:nvSpPr>
          <p:spPr>
            <a:xfrm>
              <a:off x="3874635" y="2798323"/>
              <a:ext cx="433132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AKT</a:t>
              </a:r>
            </a:p>
          </p:txBody>
        </p:sp>
        <p:sp>
          <p:nvSpPr>
            <p:cNvPr id="37" name="CasellaDiTesto 36">
              <a:extLst>
                <a:ext uri="{FF2B5EF4-FFF2-40B4-BE49-F238E27FC236}">
                  <a16:creationId xmlns:a16="http://schemas.microsoft.com/office/drawing/2014/main" id="{DC5B18C4-C474-48E7-9874-71489EAF2174}"/>
                </a:ext>
              </a:extLst>
            </p:cNvPr>
            <p:cNvSpPr txBox="1"/>
            <p:nvPr/>
          </p:nvSpPr>
          <p:spPr>
            <a:xfrm>
              <a:off x="3874635" y="2590241"/>
              <a:ext cx="50366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pAKT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38" name="CasellaDiTesto 37">
              <a:extLst>
                <a:ext uri="{FF2B5EF4-FFF2-40B4-BE49-F238E27FC236}">
                  <a16:creationId xmlns:a16="http://schemas.microsoft.com/office/drawing/2014/main" id="{5DF010E2-D12D-4173-BCA7-0F6867630B0D}"/>
                </a:ext>
              </a:extLst>
            </p:cNvPr>
            <p:cNvSpPr txBox="1"/>
            <p:nvPr/>
          </p:nvSpPr>
          <p:spPr>
            <a:xfrm>
              <a:off x="2794516" y="2442172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39" name="CasellaDiTesto 38">
              <a:extLst>
                <a:ext uri="{FF2B5EF4-FFF2-40B4-BE49-F238E27FC236}">
                  <a16:creationId xmlns:a16="http://schemas.microsoft.com/office/drawing/2014/main" id="{E97816E9-4ECA-438B-9F63-934C7A82F60F}"/>
                </a:ext>
              </a:extLst>
            </p:cNvPr>
            <p:cNvSpPr txBox="1"/>
            <p:nvPr/>
          </p:nvSpPr>
          <p:spPr>
            <a:xfrm>
              <a:off x="3076374" y="2442172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sp>
          <p:nvSpPr>
            <p:cNvPr id="40" name="CasellaDiTesto 39">
              <a:extLst>
                <a:ext uri="{FF2B5EF4-FFF2-40B4-BE49-F238E27FC236}">
                  <a16:creationId xmlns:a16="http://schemas.microsoft.com/office/drawing/2014/main" id="{92526E48-2384-4EF7-AF25-7D2F56C6AC9E}"/>
                </a:ext>
              </a:extLst>
            </p:cNvPr>
            <p:cNvSpPr txBox="1"/>
            <p:nvPr/>
          </p:nvSpPr>
          <p:spPr>
            <a:xfrm>
              <a:off x="3874635" y="2442172"/>
              <a:ext cx="397866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IGF</a:t>
              </a:r>
            </a:p>
          </p:txBody>
        </p:sp>
        <p:sp>
          <p:nvSpPr>
            <p:cNvPr id="41" name="CasellaDiTesto 40">
              <a:extLst>
                <a:ext uri="{FF2B5EF4-FFF2-40B4-BE49-F238E27FC236}">
                  <a16:creationId xmlns:a16="http://schemas.microsoft.com/office/drawing/2014/main" id="{5EC7CD1A-83BE-475C-B49C-2ACEC9487C81}"/>
                </a:ext>
              </a:extLst>
            </p:cNvPr>
            <p:cNvSpPr txBox="1"/>
            <p:nvPr/>
          </p:nvSpPr>
          <p:spPr>
            <a:xfrm>
              <a:off x="3353048" y="2442172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42" name="CasellaDiTesto 41">
              <a:extLst>
                <a:ext uri="{FF2B5EF4-FFF2-40B4-BE49-F238E27FC236}">
                  <a16:creationId xmlns:a16="http://schemas.microsoft.com/office/drawing/2014/main" id="{D0B529ED-2BD0-41DC-B888-FE672871BA20}"/>
                </a:ext>
              </a:extLst>
            </p:cNvPr>
            <p:cNvSpPr txBox="1"/>
            <p:nvPr/>
          </p:nvSpPr>
          <p:spPr>
            <a:xfrm>
              <a:off x="3598415" y="2442172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cxnSp>
          <p:nvCxnSpPr>
            <p:cNvPr id="43" name="Connettore diritto 42">
              <a:extLst>
                <a:ext uri="{FF2B5EF4-FFF2-40B4-BE49-F238E27FC236}">
                  <a16:creationId xmlns:a16="http://schemas.microsoft.com/office/drawing/2014/main" id="{DF233ED4-5FC5-462E-9397-62FD6F101E3A}"/>
                </a:ext>
              </a:extLst>
            </p:cNvPr>
            <p:cNvCxnSpPr>
              <a:cxnSpLocks/>
            </p:cNvCxnSpPr>
            <p:nvPr/>
          </p:nvCxnSpPr>
          <p:spPr>
            <a:xfrm>
              <a:off x="3467022" y="2492972"/>
              <a:ext cx="26139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CasellaDiTesto 43">
              <a:extLst>
                <a:ext uri="{FF2B5EF4-FFF2-40B4-BE49-F238E27FC236}">
                  <a16:creationId xmlns:a16="http://schemas.microsoft.com/office/drawing/2014/main" id="{6CCD55EA-6726-4808-85D2-EDB201AF86B5}"/>
                </a:ext>
              </a:extLst>
            </p:cNvPr>
            <p:cNvSpPr txBox="1"/>
            <p:nvPr/>
          </p:nvSpPr>
          <p:spPr>
            <a:xfrm>
              <a:off x="3376618" y="2274094"/>
              <a:ext cx="38985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Gef</a:t>
              </a:r>
              <a:endParaRPr lang="it-IT" sz="1000" dirty="0">
                <a:latin typeface="+mn-lt"/>
              </a:endParaRPr>
            </a:p>
          </p:txBody>
        </p:sp>
      </p:grpSp>
      <p:grpSp>
        <p:nvGrpSpPr>
          <p:cNvPr id="45" name="Gruppo 44">
            <a:extLst>
              <a:ext uri="{FF2B5EF4-FFF2-40B4-BE49-F238E27FC236}">
                <a16:creationId xmlns:a16="http://schemas.microsoft.com/office/drawing/2014/main" id="{C1D1A450-A4BB-435D-8BC8-E56E6CE15314}"/>
              </a:ext>
            </a:extLst>
          </p:cNvPr>
          <p:cNvGrpSpPr/>
          <p:nvPr/>
        </p:nvGrpSpPr>
        <p:grpSpPr>
          <a:xfrm>
            <a:off x="4258853" y="5521019"/>
            <a:ext cx="1702002" cy="979986"/>
            <a:chOff x="5035380" y="2274094"/>
            <a:chExt cx="1702002" cy="979986"/>
          </a:xfrm>
        </p:grpSpPr>
        <p:pic>
          <p:nvPicPr>
            <p:cNvPr id="46" name="Immagine 45">
              <a:extLst>
                <a:ext uri="{FF2B5EF4-FFF2-40B4-BE49-F238E27FC236}">
                  <a16:creationId xmlns:a16="http://schemas.microsoft.com/office/drawing/2014/main" id="{EC4CD116-F811-4B58-AE94-519D4B1ECA64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035380" y="2638974"/>
              <a:ext cx="1080000" cy="15369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7" name="Immagine 46">
              <a:extLst>
                <a:ext uri="{FF2B5EF4-FFF2-40B4-BE49-F238E27FC236}">
                  <a16:creationId xmlns:a16="http://schemas.microsoft.com/office/drawing/2014/main" id="{FF3BC238-68F5-4B9C-A897-9FE1744CC38C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035380" y="2853242"/>
              <a:ext cx="1080000" cy="15369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8" name="Immagine 47">
              <a:extLst>
                <a:ext uri="{FF2B5EF4-FFF2-40B4-BE49-F238E27FC236}">
                  <a16:creationId xmlns:a16="http://schemas.microsoft.com/office/drawing/2014/main" id="{29646F95-C6C5-480B-A11F-66673FCCF7FA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035380" y="3051060"/>
              <a:ext cx="1080000" cy="16063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9" name="CasellaDiTesto 48">
              <a:extLst>
                <a:ext uri="{FF2B5EF4-FFF2-40B4-BE49-F238E27FC236}">
                  <a16:creationId xmlns:a16="http://schemas.microsoft.com/office/drawing/2014/main" id="{23D1068B-E4A6-4435-8E97-8240939C372D}"/>
                </a:ext>
              </a:extLst>
            </p:cNvPr>
            <p:cNvSpPr txBox="1"/>
            <p:nvPr/>
          </p:nvSpPr>
          <p:spPr>
            <a:xfrm>
              <a:off x="6105478" y="3007859"/>
              <a:ext cx="63190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Vinculin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50" name="CasellaDiTesto 49">
              <a:extLst>
                <a:ext uri="{FF2B5EF4-FFF2-40B4-BE49-F238E27FC236}">
                  <a16:creationId xmlns:a16="http://schemas.microsoft.com/office/drawing/2014/main" id="{C0A84E8B-22C5-42ED-89F2-005426BEC26F}"/>
                </a:ext>
              </a:extLst>
            </p:cNvPr>
            <p:cNvSpPr txBox="1"/>
            <p:nvPr/>
          </p:nvSpPr>
          <p:spPr>
            <a:xfrm>
              <a:off x="6105478" y="2798323"/>
              <a:ext cx="433132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AKT</a:t>
              </a:r>
            </a:p>
          </p:txBody>
        </p:sp>
        <p:sp>
          <p:nvSpPr>
            <p:cNvPr id="51" name="CasellaDiTesto 50">
              <a:extLst>
                <a:ext uri="{FF2B5EF4-FFF2-40B4-BE49-F238E27FC236}">
                  <a16:creationId xmlns:a16="http://schemas.microsoft.com/office/drawing/2014/main" id="{90F9A237-9796-4359-B603-EF38DBC24144}"/>
                </a:ext>
              </a:extLst>
            </p:cNvPr>
            <p:cNvSpPr txBox="1"/>
            <p:nvPr/>
          </p:nvSpPr>
          <p:spPr>
            <a:xfrm>
              <a:off x="6105478" y="2590241"/>
              <a:ext cx="50366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pAKT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52" name="CasellaDiTesto 51">
              <a:extLst>
                <a:ext uri="{FF2B5EF4-FFF2-40B4-BE49-F238E27FC236}">
                  <a16:creationId xmlns:a16="http://schemas.microsoft.com/office/drawing/2014/main" id="{5EA33D65-3FF3-41C1-A5A3-EF8A4E144928}"/>
                </a:ext>
              </a:extLst>
            </p:cNvPr>
            <p:cNvSpPr txBox="1"/>
            <p:nvPr/>
          </p:nvSpPr>
          <p:spPr>
            <a:xfrm>
              <a:off x="5083914" y="2442172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53" name="CasellaDiTesto 52">
              <a:extLst>
                <a:ext uri="{FF2B5EF4-FFF2-40B4-BE49-F238E27FC236}">
                  <a16:creationId xmlns:a16="http://schemas.microsoft.com/office/drawing/2014/main" id="{5D08BCCC-50BA-4496-A6BC-2FFBEBF304BB}"/>
                </a:ext>
              </a:extLst>
            </p:cNvPr>
            <p:cNvSpPr txBox="1"/>
            <p:nvPr/>
          </p:nvSpPr>
          <p:spPr>
            <a:xfrm>
              <a:off x="5320836" y="2442172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sp>
          <p:nvSpPr>
            <p:cNvPr id="54" name="CasellaDiTesto 53">
              <a:extLst>
                <a:ext uri="{FF2B5EF4-FFF2-40B4-BE49-F238E27FC236}">
                  <a16:creationId xmlns:a16="http://schemas.microsoft.com/office/drawing/2014/main" id="{1A456423-E15F-4DB0-BE5F-3792E3331328}"/>
                </a:ext>
              </a:extLst>
            </p:cNvPr>
            <p:cNvSpPr txBox="1"/>
            <p:nvPr/>
          </p:nvSpPr>
          <p:spPr>
            <a:xfrm>
              <a:off x="6105478" y="2442172"/>
              <a:ext cx="44755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EGF</a:t>
              </a:r>
            </a:p>
          </p:txBody>
        </p:sp>
        <p:sp>
          <p:nvSpPr>
            <p:cNvPr id="55" name="CasellaDiTesto 54">
              <a:extLst>
                <a:ext uri="{FF2B5EF4-FFF2-40B4-BE49-F238E27FC236}">
                  <a16:creationId xmlns:a16="http://schemas.microsoft.com/office/drawing/2014/main" id="{5950BD74-C15B-4883-9617-D6A3EC421940}"/>
                </a:ext>
              </a:extLst>
            </p:cNvPr>
            <p:cNvSpPr txBox="1"/>
            <p:nvPr/>
          </p:nvSpPr>
          <p:spPr>
            <a:xfrm>
              <a:off x="5594320" y="2442172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56" name="CasellaDiTesto 55">
              <a:extLst>
                <a:ext uri="{FF2B5EF4-FFF2-40B4-BE49-F238E27FC236}">
                  <a16:creationId xmlns:a16="http://schemas.microsoft.com/office/drawing/2014/main" id="{FCE24B4A-8A60-482B-87C6-9581FDD21085}"/>
                </a:ext>
              </a:extLst>
            </p:cNvPr>
            <p:cNvSpPr txBox="1"/>
            <p:nvPr/>
          </p:nvSpPr>
          <p:spPr>
            <a:xfrm>
              <a:off x="5829258" y="2442172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cxnSp>
          <p:nvCxnSpPr>
            <p:cNvPr id="57" name="Connettore diritto 56">
              <a:extLst>
                <a:ext uri="{FF2B5EF4-FFF2-40B4-BE49-F238E27FC236}">
                  <a16:creationId xmlns:a16="http://schemas.microsoft.com/office/drawing/2014/main" id="{CB6D06FF-30DE-4C94-92E2-B6E37AB5E5CF}"/>
                </a:ext>
              </a:extLst>
            </p:cNvPr>
            <p:cNvCxnSpPr>
              <a:cxnSpLocks/>
            </p:cNvCxnSpPr>
            <p:nvPr/>
          </p:nvCxnSpPr>
          <p:spPr>
            <a:xfrm>
              <a:off x="5708294" y="2492972"/>
              <a:ext cx="25096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8" name="CasellaDiTesto 57">
              <a:extLst>
                <a:ext uri="{FF2B5EF4-FFF2-40B4-BE49-F238E27FC236}">
                  <a16:creationId xmlns:a16="http://schemas.microsoft.com/office/drawing/2014/main" id="{AD1FFD70-4ADD-4EED-A5BC-0DF461EBD133}"/>
                </a:ext>
              </a:extLst>
            </p:cNvPr>
            <p:cNvSpPr txBox="1"/>
            <p:nvPr/>
          </p:nvSpPr>
          <p:spPr>
            <a:xfrm>
              <a:off x="5620161" y="2274094"/>
              <a:ext cx="38985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Gef</a:t>
              </a:r>
              <a:endParaRPr lang="it-IT" sz="1000" dirty="0">
                <a:latin typeface="+mn-lt"/>
              </a:endParaRPr>
            </a:p>
          </p:txBody>
        </p:sp>
      </p:grpSp>
      <p:sp>
        <p:nvSpPr>
          <p:cNvPr id="59" name="CasellaDiTesto 58">
            <a:extLst>
              <a:ext uri="{FF2B5EF4-FFF2-40B4-BE49-F238E27FC236}">
                <a16:creationId xmlns:a16="http://schemas.microsoft.com/office/drawing/2014/main" id="{3B1B5FC7-F40B-4E8C-BA81-43C08EDD4EBE}"/>
              </a:ext>
            </a:extLst>
          </p:cNvPr>
          <p:cNvSpPr txBox="1"/>
          <p:nvPr/>
        </p:nvSpPr>
        <p:spPr>
          <a:xfrm>
            <a:off x="278281" y="1979712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b)</a:t>
            </a:r>
          </a:p>
        </p:txBody>
      </p:sp>
      <p:sp>
        <p:nvSpPr>
          <p:cNvPr id="60" name="CasellaDiTesto 59">
            <a:extLst>
              <a:ext uri="{FF2B5EF4-FFF2-40B4-BE49-F238E27FC236}">
                <a16:creationId xmlns:a16="http://schemas.microsoft.com/office/drawing/2014/main" id="{A98BF58D-0577-47FC-A25C-DB0867D0C225}"/>
              </a:ext>
            </a:extLst>
          </p:cNvPr>
          <p:cNvSpPr txBox="1"/>
          <p:nvPr/>
        </p:nvSpPr>
        <p:spPr>
          <a:xfrm>
            <a:off x="3352376" y="1979712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c)</a:t>
            </a:r>
          </a:p>
        </p:txBody>
      </p:sp>
      <p:sp>
        <p:nvSpPr>
          <p:cNvPr id="61" name="CasellaDiTesto 60">
            <a:extLst>
              <a:ext uri="{FF2B5EF4-FFF2-40B4-BE49-F238E27FC236}">
                <a16:creationId xmlns:a16="http://schemas.microsoft.com/office/drawing/2014/main" id="{028FEF38-D09D-4825-A3A3-FFE39F11B9E7}"/>
              </a:ext>
            </a:extLst>
          </p:cNvPr>
          <p:cNvSpPr txBox="1"/>
          <p:nvPr/>
        </p:nvSpPr>
        <p:spPr>
          <a:xfrm>
            <a:off x="278281" y="5390763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d)</a:t>
            </a:r>
          </a:p>
        </p:txBody>
      </p:sp>
      <p:sp>
        <p:nvSpPr>
          <p:cNvPr id="62" name="CasellaDiTesto 61">
            <a:extLst>
              <a:ext uri="{FF2B5EF4-FFF2-40B4-BE49-F238E27FC236}">
                <a16:creationId xmlns:a16="http://schemas.microsoft.com/office/drawing/2014/main" id="{92AB2CEA-7E11-44F9-B7A9-5AE3D670EFA2}"/>
              </a:ext>
            </a:extLst>
          </p:cNvPr>
          <p:cNvSpPr txBox="1"/>
          <p:nvPr/>
        </p:nvSpPr>
        <p:spPr>
          <a:xfrm>
            <a:off x="3348368" y="5409445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e)</a:t>
            </a:r>
          </a:p>
        </p:txBody>
      </p:sp>
      <p:grpSp>
        <p:nvGrpSpPr>
          <p:cNvPr id="63" name="Gruppo 62">
            <a:extLst>
              <a:ext uri="{FF2B5EF4-FFF2-40B4-BE49-F238E27FC236}">
                <a16:creationId xmlns:a16="http://schemas.microsoft.com/office/drawing/2014/main" id="{0620E518-3643-44BC-B410-9F808DBFCF73}"/>
              </a:ext>
            </a:extLst>
          </p:cNvPr>
          <p:cNvGrpSpPr/>
          <p:nvPr/>
        </p:nvGrpSpPr>
        <p:grpSpPr>
          <a:xfrm>
            <a:off x="828210" y="751330"/>
            <a:ext cx="1714842" cy="979986"/>
            <a:chOff x="396268" y="2274094"/>
            <a:chExt cx="1714842" cy="979986"/>
          </a:xfrm>
        </p:grpSpPr>
        <p:pic>
          <p:nvPicPr>
            <p:cNvPr id="64" name="Immagine 63">
              <a:extLst>
                <a:ext uri="{FF2B5EF4-FFF2-40B4-BE49-F238E27FC236}">
                  <a16:creationId xmlns:a16="http://schemas.microsoft.com/office/drawing/2014/main" id="{687A6460-CE69-492B-9CE6-4DDBEAE80AEB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96268" y="2833871"/>
              <a:ext cx="1080000" cy="16967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5" name="Immagine 64">
              <a:extLst>
                <a:ext uri="{FF2B5EF4-FFF2-40B4-BE49-F238E27FC236}">
                  <a16:creationId xmlns:a16="http://schemas.microsoft.com/office/drawing/2014/main" id="{6FBA60D3-3A5C-4994-9C95-4F22B3300A49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96268" y="3042021"/>
              <a:ext cx="1080000" cy="16967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6" name="Immagine 65">
              <a:extLst>
                <a:ext uri="{FF2B5EF4-FFF2-40B4-BE49-F238E27FC236}">
                  <a16:creationId xmlns:a16="http://schemas.microsoft.com/office/drawing/2014/main" id="{3595E195-3CDD-4601-8F31-DDB59A24C7E9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96268" y="2631238"/>
              <a:ext cx="1080000" cy="16422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7" name="CasellaDiTesto 66">
              <a:extLst>
                <a:ext uri="{FF2B5EF4-FFF2-40B4-BE49-F238E27FC236}">
                  <a16:creationId xmlns:a16="http://schemas.microsoft.com/office/drawing/2014/main" id="{12C05A33-4F28-4647-9D36-63EF1EB98C38}"/>
                </a:ext>
              </a:extLst>
            </p:cNvPr>
            <p:cNvSpPr txBox="1"/>
            <p:nvPr/>
          </p:nvSpPr>
          <p:spPr>
            <a:xfrm>
              <a:off x="1479206" y="3007859"/>
              <a:ext cx="63190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Vinculin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68" name="CasellaDiTesto 67">
              <a:extLst>
                <a:ext uri="{FF2B5EF4-FFF2-40B4-BE49-F238E27FC236}">
                  <a16:creationId xmlns:a16="http://schemas.microsoft.com/office/drawing/2014/main" id="{23457DB9-29FE-49E6-B12B-D5AB36B86B61}"/>
                </a:ext>
              </a:extLst>
            </p:cNvPr>
            <p:cNvSpPr txBox="1"/>
            <p:nvPr/>
          </p:nvSpPr>
          <p:spPr>
            <a:xfrm>
              <a:off x="1479206" y="2798323"/>
              <a:ext cx="433132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AKT</a:t>
              </a:r>
            </a:p>
          </p:txBody>
        </p:sp>
        <p:sp>
          <p:nvSpPr>
            <p:cNvPr id="69" name="CasellaDiTesto 68">
              <a:extLst>
                <a:ext uri="{FF2B5EF4-FFF2-40B4-BE49-F238E27FC236}">
                  <a16:creationId xmlns:a16="http://schemas.microsoft.com/office/drawing/2014/main" id="{CC0983BB-8AF5-41C3-AFBA-AF74BE4C65B9}"/>
                </a:ext>
              </a:extLst>
            </p:cNvPr>
            <p:cNvSpPr txBox="1"/>
            <p:nvPr/>
          </p:nvSpPr>
          <p:spPr>
            <a:xfrm>
              <a:off x="1479206" y="2610287"/>
              <a:ext cx="50366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pAKT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70" name="CasellaDiTesto 69">
              <a:extLst>
                <a:ext uri="{FF2B5EF4-FFF2-40B4-BE49-F238E27FC236}">
                  <a16:creationId xmlns:a16="http://schemas.microsoft.com/office/drawing/2014/main" id="{AA08B73D-37C7-4593-B682-A0E65AB64231}"/>
                </a:ext>
              </a:extLst>
            </p:cNvPr>
            <p:cNvSpPr txBox="1"/>
            <p:nvPr/>
          </p:nvSpPr>
          <p:spPr>
            <a:xfrm>
              <a:off x="435144" y="2442172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71" name="CasellaDiTesto 70">
              <a:extLst>
                <a:ext uri="{FF2B5EF4-FFF2-40B4-BE49-F238E27FC236}">
                  <a16:creationId xmlns:a16="http://schemas.microsoft.com/office/drawing/2014/main" id="{5EE156E3-DE78-4356-80D0-4EE0DD39A5BE}"/>
                </a:ext>
              </a:extLst>
            </p:cNvPr>
            <p:cNvSpPr txBox="1"/>
            <p:nvPr/>
          </p:nvSpPr>
          <p:spPr>
            <a:xfrm>
              <a:off x="658900" y="2442172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sp>
          <p:nvSpPr>
            <p:cNvPr id="72" name="CasellaDiTesto 71">
              <a:extLst>
                <a:ext uri="{FF2B5EF4-FFF2-40B4-BE49-F238E27FC236}">
                  <a16:creationId xmlns:a16="http://schemas.microsoft.com/office/drawing/2014/main" id="{E7DEAE76-F363-4211-A0F0-76410FCD2BE4}"/>
                </a:ext>
              </a:extLst>
            </p:cNvPr>
            <p:cNvSpPr txBox="1"/>
            <p:nvPr/>
          </p:nvSpPr>
          <p:spPr>
            <a:xfrm>
              <a:off x="1479206" y="2442172"/>
              <a:ext cx="36260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Tel</a:t>
              </a:r>
            </a:p>
          </p:txBody>
        </p:sp>
        <p:sp>
          <p:nvSpPr>
            <p:cNvPr id="73" name="CasellaDiTesto 72">
              <a:extLst>
                <a:ext uri="{FF2B5EF4-FFF2-40B4-BE49-F238E27FC236}">
                  <a16:creationId xmlns:a16="http://schemas.microsoft.com/office/drawing/2014/main" id="{9F39A8AC-8A84-4187-8E8D-9EDE46961B73}"/>
                </a:ext>
              </a:extLst>
            </p:cNvPr>
            <p:cNvSpPr txBox="1"/>
            <p:nvPr/>
          </p:nvSpPr>
          <p:spPr>
            <a:xfrm>
              <a:off x="962972" y="2442172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74" name="CasellaDiTesto 73">
              <a:extLst>
                <a:ext uri="{FF2B5EF4-FFF2-40B4-BE49-F238E27FC236}">
                  <a16:creationId xmlns:a16="http://schemas.microsoft.com/office/drawing/2014/main" id="{F6F079FC-876A-4860-9A27-A0B158900FC7}"/>
                </a:ext>
              </a:extLst>
            </p:cNvPr>
            <p:cNvSpPr txBox="1"/>
            <p:nvPr/>
          </p:nvSpPr>
          <p:spPr>
            <a:xfrm>
              <a:off x="1222036" y="2442172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cxnSp>
          <p:nvCxnSpPr>
            <p:cNvPr id="75" name="Connettore diritto 74">
              <a:extLst>
                <a:ext uri="{FF2B5EF4-FFF2-40B4-BE49-F238E27FC236}">
                  <a16:creationId xmlns:a16="http://schemas.microsoft.com/office/drawing/2014/main" id="{CE8D3CB2-CBF0-4A22-BFF9-77CA5A448468}"/>
                </a:ext>
              </a:extLst>
            </p:cNvPr>
            <p:cNvCxnSpPr>
              <a:cxnSpLocks/>
            </p:cNvCxnSpPr>
            <p:nvPr/>
          </p:nvCxnSpPr>
          <p:spPr>
            <a:xfrm>
              <a:off x="1076946" y="2492972"/>
              <a:ext cx="27509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6" name="CasellaDiTesto 75">
              <a:extLst>
                <a:ext uri="{FF2B5EF4-FFF2-40B4-BE49-F238E27FC236}">
                  <a16:creationId xmlns:a16="http://schemas.microsoft.com/office/drawing/2014/main" id="{9692E7A3-B434-40D9-8081-E44C76E40A6B}"/>
                </a:ext>
              </a:extLst>
            </p:cNvPr>
            <p:cNvSpPr txBox="1"/>
            <p:nvPr/>
          </p:nvSpPr>
          <p:spPr>
            <a:xfrm>
              <a:off x="1000239" y="2274094"/>
              <a:ext cx="38985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Gef</a:t>
              </a:r>
              <a:endParaRPr lang="it-IT" sz="1000" dirty="0">
                <a:latin typeface="+mn-lt"/>
              </a:endParaRPr>
            </a:p>
          </p:txBody>
        </p:sp>
      </p:grpSp>
      <p:sp>
        <p:nvSpPr>
          <p:cNvPr id="105" name="CasellaDiTesto 104">
            <a:extLst>
              <a:ext uri="{FF2B5EF4-FFF2-40B4-BE49-F238E27FC236}">
                <a16:creationId xmlns:a16="http://schemas.microsoft.com/office/drawing/2014/main" id="{53592686-7A78-4900-AD7A-3038A56BC1B6}"/>
              </a:ext>
            </a:extLst>
          </p:cNvPr>
          <p:cNvSpPr txBox="1"/>
          <p:nvPr/>
        </p:nvSpPr>
        <p:spPr>
          <a:xfrm>
            <a:off x="278281" y="365339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a)</a:t>
            </a:r>
          </a:p>
        </p:txBody>
      </p:sp>
      <p:sp>
        <p:nvSpPr>
          <p:cNvPr id="106" name="CasellaDiTesto 105">
            <a:extLst>
              <a:ext uri="{FF2B5EF4-FFF2-40B4-BE49-F238E27FC236}">
                <a16:creationId xmlns:a16="http://schemas.microsoft.com/office/drawing/2014/main" id="{E5EF98AB-F50C-4370-B8FD-EED0B3491049}"/>
              </a:ext>
            </a:extLst>
          </p:cNvPr>
          <p:cNvSpPr txBox="1"/>
          <p:nvPr/>
        </p:nvSpPr>
        <p:spPr>
          <a:xfrm>
            <a:off x="2240213" y="0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ementary</a:t>
            </a:r>
            <a:r>
              <a:rPr lang="it-IT" b="1" dirty="0"/>
              <a:t> Fig. 6</a:t>
            </a:r>
          </a:p>
        </p:txBody>
      </p:sp>
      <p:sp>
        <p:nvSpPr>
          <p:cNvPr id="138" name="CasellaDiTesto 137">
            <a:extLst>
              <a:ext uri="{FF2B5EF4-FFF2-40B4-BE49-F238E27FC236}">
                <a16:creationId xmlns:a16="http://schemas.microsoft.com/office/drawing/2014/main" id="{10D8CD09-42D2-41AE-8DA4-5D4C590CC888}"/>
              </a:ext>
            </a:extLst>
          </p:cNvPr>
          <p:cNvSpPr txBox="1"/>
          <p:nvPr/>
        </p:nvSpPr>
        <p:spPr>
          <a:xfrm>
            <a:off x="260648" y="3263246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b’)</a:t>
            </a:r>
          </a:p>
        </p:txBody>
      </p:sp>
      <p:sp>
        <p:nvSpPr>
          <p:cNvPr id="139" name="CasellaDiTesto 138">
            <a:extLst>
              <a:ext uri="{FF2B5EF4-FFF2-40B4-BE49-F238E27FC236}">
                <a16:creationId xmlns:a16="http://schemas.microsoft.com/office/drawing/2014/main" id="{B63F3BBD-6564-4852-964B-A7442C404310}"/>
              </a:ext>
            </a:extLst>
          </p:cNvPr>
          <p:cNvSpPr txBox="1"/>
          <p:nvPr/>
        </p:nvSpPr>
        <p:spPr>
          <a:xfrm>
            <a:off x="3334743" y="3263246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c’)</a:t>
            </a:r>
          </a:p>
        </p:txBody>
      </p:sp>
      <p:sp>
        <p:nvSpPr>
          <p:cNvPr id="140" name="CasellaDiTesto 139">
            <a:extLst>
              <a:ext uri="{FF2B5EF4-FFF2-40B4-BE49-F238E27FC236}">
                <a16:creationId xmlns:a16="http://schemas.microsoft.com/office/drawing/2014/main" id="{E772652D-48E5-4015-A9D4-7084AC5D7A5F}"/>
              </a:ext>
            </a:extLst>
          </p:cNvPr>
          <p:cNvSpPr txBox="1"/>
          <p:nvPr/>
        </p:nvSpPr>
        <p:spPr>
          <a:xfrm>
            <a:off x="260648" y="6588224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d’)</a:t>
            </a:r>
          </a:p>
        </p:txBody>
      </p:sp>
      <p:sp>
        <p:nvSpPr>
          <p:cNvPr id="141" name="CasellaDiTesto 140">
            <a:extLst>
              <a:ext uri="{FF2B5EF4-FFF2-40B4-BE49-F238E27FC236}">
                <a16:creationId xmlns:a16="http://schemas.microsoft.com/office/drawing/2014/main" id="{7ECA4B5D-1ABE-46C6-9BFC-8D16DD7F7AE5}"/>
              </a:ext>
            </a:extLst>
          </p:cNvPr>
          <p:cNvSpPr txBox="1"/>
          <p:nvPr/>
        </p:nvSpPr>
        <p:spPr>
          <a:xfrm>
            <a:off x="3334743" y="6606906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</a:t>
            </a:r>
            <a:r>
              <a:rPr lang="it-IT" sz="1000" b="1" dirty="0" err="1"/>
              <a:t>e’</a:t>
            </a:r>
            <a:r>
              <a:rPr lang="it-IT" sz="1000" b="1" dirty="0"/>
              <a:t>)</a:t>
            </a:r>
          </a:p>
        </p:txBody>
      </p:sp>
      <p:sp>
        <p:nvSpPr>
          <p:cNvPr id="156" name="CasellaDiTesto 155">
            <a:extLst>
              <a:ext uri="{FF2B5EF4-FFF2-40B4-BE49-F238E27FC236}">
                <a16:creationId xmlns:a16="http://schemas.microsoft.com/office/drawing/2014/main" id="{2C170365-7A0B-466A-A5BC-C718C1A4D52F}"/>
              </a:ext>
            </a:extLst>
          </p:cNvPr>
          <p:cNvSpPr txBox="1"/>
          <p:nvPr/>
        </p:nvSpPr>
        <p:spPr>
          <a:xfrm>
            <a:off x="3334743" y="365339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</a:t>
            </a:r>
            <a:r>
              <a:rPr lang="it-IT" sz="1000" b="1" dirty="0" err="1"/>
              <a:t>a’</a:t>
            </a:r>
            <a:r>
              <a:rPr lang="it-IT" sz="1000" b="1" dirty="0"/>
              <a:t>)</a:t>
            </a:r>
          </a:p>
        </p:txBody>
      </p:sp>
      <p:grpSp>
        <p:nvGrpSpPr>
          <p:cNvPr id="78" name="Gruppo 77">
            <a:extLst>
              <a:ext uri="{FF2B5EF4-FFF2-40B4-BE49-F238E27FC236}">
                <a16:creationId xmlns:a16="http://schemas.microsoft.com/office/drawing/2014/main" id="{643D45EB-1184-4ADA-B2F3-2AD611353D29}"/>
              </a:ext>
            </a:extLst>
          </p:cNvPr>
          <p:cNvGrpSpPr/>
          <p:nvPr/>
        </p:nvGrpSpPr>
        <p:grpSpPr>
          <a:xfrm>
            <a:off x="434064" y="3486686"/>
            <a:ext cx="2288501" cy="1691575"/>
            <a:chOff x="188640" y="5443233"/>
            <a:chExt cx="2288501" cy="1691575"/>
          </a:xfrm>
        </p:grpSpPr>
        <p:pic>
          <p:nvPicPr>
            <p:cNvPr id="77" name="Immagine 76">
              <a:extLst>
                <a:ext uri="{FF2B5EF4-FFF2-40B4-BE49-F238E27FC236}">
                  <a16:creationId xmlns:a16="http://schemas.microsoft.com/office/drawing/2014/main" id="{74409266-1ED3-4227-92C3-05D633979D4D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/>
            <a:stretch>
              <a:fillRect/>
            </a:stretch>
          </p:blipFill>
          <p:spPr>
            <a:xfrm>
              <a:off x="914379" y="5560976"/>
              <a:ext cx="1254167" cy="1260000"/>
            </a:xfrm>
            <a:prstGeom prst="rect">
              <a:avLst/>
            </a:prstGeom>
          </p:spPr>
        </p:pic>
        <p:sp>
          <p:nvSpPr>
            <p:cNvPr id="159" name="CasellaDiTesto 158">
              <a:extLst>
                <a:ext uri="{FF2B5EF4-FFF2-40B4-BE49-F238E27FC236}">
                  <a16:creationId xmlns:a16="http://schemas.microsoft.com/office/drawing/2014/main" id="{02ABF6E7-B689-4A9A-90ED-730F9489E35F}"/>
                </a:ext>
              </a:extLst>
            </p:cNvPr>
            <p:cNvSpPr txBox="1"/>
            <p:nvPr/>
          </p:nvSpPr>
          <p:spPr>
            <a:xfrm>
              <a:off x="1035213" y="6728068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160" name="CasellaDiTesto 159">
              <a:extLst>
                <a:ext uri="{FF2B5EF4-FFF2-40B4-BE49-F238E27FC236}">
                  <a16:creationId xmlns:a16="http://schemas.microsoft.com/office/drawing/2014/main" id="{0598B533-B209-46F3-8D38-8BBD90AC9AA0}"/>
                </a:ext>
              </a:extLst>
            </p:cNvPr>
            <p:cNvSpPr txBox="1"/>
            <p:nvPr/>
          </p:nvSpPr>
          <p:spPr>
            <a:xfrm>
              <a:off x="1282784" y="6728068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sp>
          <p:nvSpPr>
            <p:cNvPr id="161" name="CasellaDiTesto 160">
              <a:extLst>
                <a:ext uri="{FF2B5EF4-FFF2-40B4-BE49-F238E27FC236}">
                  <a16:creationId xmlns:a16="http://schemas.microsoft.com/office/drawing/2014/main" id="{E31DD807-4F20-477F-8341-FD0D8242DB42}"/>
                </a:ext>
              </a:extLst>
            </p:cNvPr>
            <p:cNvSpPr txBox="1"/>
            <p:nvPr/>
          </p:nvSpPr>
          <p:spPr>
            <a:xfrm>
              <a:off x="2079275" y="6728068"/>
              <a:ext cx="397866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IGF</a:t>
              </a:r>
            </a:p>
          </p:txBody>
        </p:sp>
        <p:sp>
          <p:nvSpPr>
            <p:cNvPr id="162" name="CasellaDiTesto 161">
              <a:extLst>
                <a:ext uri="{FF2B5EF4-FFF2-40B4-BE49-F238E27FC236}">
                  <a16:creationId xmlns:a16="http://schemas.microsoft.com/office/drawing/2014/main" id="{89D4976B-1B4F-4515-B7D4-55C45CA5034D}"/>
                </a:ext>
              </a:extLst>
            </p:cNvPr>
            <p:cNvSpPr txBox="1"/>
            <p:nvPr/>
          </p:nvSpPr>
          <p:spPr>
            <a:xfrm>
              <a:off x="1563041" y="6728068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163" name="CasellaDiTesto 162">
              <a:extLst>
                <a:ext uri="{FF2B5EF4-FFF2-40B4-BE49-F238E27FC236}">
                  <a16:creationId xmlns:a16="http://schemas.microsoft.com/office/drawing/2014/main" id="{DC4233B9-348B-4BC0-881F-5871CEC7C50F}"/>
                </a:ext>
              </a:extLst>
            </p:cNvPr>
            <p:cNvSpPr txBox="1"/>
            <p:nvPr/>
          </p:nvSpPr>
          <p:spPr>
            <a:xfrm>
              <a:off x="1822105" y="6728068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cxnSp>
          <p:nvCxnSpPr>
            <p:cNvPr id="164" name="Connettore diritto 163">
              <a:extLst>
                <a:ext uri="{FF2B5EF4-FFF2-40B4-BE49-F238E27FC236}">
                  <a16:creationId xmlns:a16="http://schemas.microsoft.com/office/drawing/2014/main" id="{5AF45267-7455-4135-9CBE-F0FF98CE0B6A}"/>
                </a:ext>
              </a:extLst>
            </p:cNvPr>
            <p:cNvCxnSpPr>
              <a:cxnSpLocks/>
            </p:cNvCxnSpPr>
            <p:nvPr/>
          </p:nvCxnSpPr>
          <p:spPr>
            <a:xfrm>
              <a:off x="1677015" y="6927254"/>
              <a:ext cx="27509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5" name="CasellaDiTesto 164">
              <a:extLst>
                <a:ext uri="{FF2B5EF4-FFF2-40B4-BE49-F238E27FC236}">
                  <a16:creationId xmlns:a16="http://schemas.microsoft.com/office/drawing/2014/main" id="{EE29A55C-ABDE-4B06-A9C0-F54C0E17D6D2}"/>
                </a:ext>
              </a:extLst>
            </p:cNvPr>
            <p:cNvSpPr txBox="1"/>
            <p:nvPr/>
          </p:nvSpPr>
          <p:spPr>
            <a:xfrm>
              <a:off x="1600308" y="6888587"/>
              <a:ext cx="44755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NVP</a:t>
              </a:r>
            </a:p>
          </p:txBody>
        </p:sp>
        <p:sp>
          <p:nvSpPr>
            <p:cNvPr id="166" name="CasellaDiTesto 165">
              <a:extLst>
                <a:ext uri="{FF2B5EF4-FFF2-40B4-BE49-F238E27FC236}">
                  <a16:creationId xmlns:a16="http://schemas.microsoft.com/office/drawing/2014/main" id="{3A875101-BF41-488A-A956-035B235B2706}"/>
                </a:ext>
              </a:extLst>
            </p:cNvPr>
            <p:cNvSpPr txBox="1"/>
            <p:nvPr/>
          </p:nvSpPr>
          <p:spPr>
            <a:xfrm rot="16200000">
              <a:off x="-106697" y="5940170"/>
              <a:ext cx="105233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 err="1"/>
                <a:t>pAKT</a:t>
              </a:r>
              <a:r>
                <a:rPr lang="it-IT" sz="1200" dirty="0"/>
                <a:t> </a:t>
              </a:r>
              <a:r>
                <a:rPr lang="it-IT" sz="1200" dirty="0" err="1"/>
                <a:t>Levels</a:t>
              </a:r>
              <a:endParaRPr lang="it-IT" sz="1200" dirty="0"/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-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167" name="CasellaDiTesto 166">
              <a:extLst>
                <a:ext uri="{FF2B5EF4-FFF2-40B4-BE49-F238E27FC236}">
                  <a16:creationId xmlns:a16="http://schemas.microsoft.com/office/drawing/2014/main" id="{EE468CF2-D30D-4B95-8719-03B197CD0D5F}"/>
                </a:ext>
              </a:extLst>
            </p:cNvPr>
            <p:cNvSpPr txBox="1"/>
            <p:nvPr/>
          </p:nvSpPr>
          <p:spPr>
            <a:xfrm>
              <a:off x="526596" y="5443233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2.0</a:t>
              </a:r>
            </a:p>
          </p:txBody>
        </p:sp>
        <p:sp>
          <p:nvSpPr>
            <p:cNvPr id="168" name="CasellaDiTesto 167">
              <a:extLst>
                <a:ext uri="{FF2B5EF4-FFF2-40B4-BE49-F238E27FC236}">
                  <a16:creationId xmlns:a16="http://schemas.microsoft.com/office/drawing/2014/main" id="{4BBF1DFF-AC56-436C-A50F-BA886635B759}"/>
                </a:ext>
              </a:extLst>
            </p:cNvPr>
            <p:cNvSpPr txBox="1"/>
            <p:nvPr/>
          </p:nvSpPr>
          <p:spPr>
            <a:xfrm>
              <a:off x="611554" y="6034552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6.0</a:t>
              </a:r>
            </a:p>
          </p:txBody>
        </p:sp>
        <p:sp>
          <p:nvSpPr>
            <p:cNvPr id="169" name="CasellaDiTesto 168">
              <a:extLst>
                <a:ext uri="{FF2B5EF4-FFF2-40B4-BE49-F238E27FC236}">
                  <a16:creationId xmlns:a16="http://schemas.microsoft.com/office/drawing/2014/main" id="{025902BF-91BC-456E-82CD-0D296918EA95}"/>
                </a:ext>
              </a:extLst>
            </p:cNvPr>
            <p:cNvSpPr txBox="1"/>
            <p:nvPr/>
          </p:nvSpPr>
          <p:spPr>
            <a:xfrm>
              <a:off x="611554" y="6635822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</p:grpSp>
      <p:grpSp>
        <p:nvGrpSpPr>
          <p:cNvPr id="184" name="Gruppo 183">
            <a:extLst>
              <a:ext uri="{FF2B5EF4-FFF2-40B4-BE49-F238E27FC236}">
                <a16:creationId xmlns:a16="http://schemas.microsoft.com/office/drawing/2014/main" id="{5D58A688-E0B0-4DE1-B400-1851D0A3ADCA}"/>
              </a:ext>
            </a:extLst>
          </p:cNvPr>
          <p:cNvGrpSpPr/>
          <p:nvPr/>
        </p:nvGrpSpPr>
        <p:grpSpPr>
          <a:xfrm>
            <a:off x="3724865" y="3486686"/>
            <a:ext cx="2288501" cy="1691575"/>
            <a:chOff x="3724865" y="3240465"/>
            <a:chExt cx="2288501" cy="1691575"/>
          </a:xfrm>
        </p:grpSpPr>
        <p:pic>
          <p:nvPicPr>
            <p:cNvPr id="170" name="Immagine 169">
              <a:extLst>
                <a:ext uri="{FF2B5EF4-FFF2-40B4-BE49-F238E27FC236}">
                  <a16:creationId xmlns:a16="http://schemas.microsoft.com/office/drawing/2014/main" id="{FDEC6134-D7FC-43F4-A5E5-E03DB03564A3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/>
            <a:stretch>
              <a:fillRect/>
            </a:stretch>
          </p:blipFill>
          <p:spPr>
            <a:xfrm>
              <a:off x="4450604" y="3358208"/>
              <a:ext cx="1220090" cy="1260000"/>
            </a:xfrm>
            <a:prstGeom prst="rect">
              <a:avLst/>
            </a:prstGeom>
          </p:spPr>
        </p:pic>
        <p:sp>
          <p:nvSpPr>
            <p:cNvPr id="173" name="CasellaDiTesto 172">
              <a:extLst>
                <a:ext uri="{FF2B5EF4-FFF2-40B4-BE49-F238E27FC236}">
                  <a16:creationId xmlns:a16="http://schemas.microsoft.com/office/drawing/2014/main" id="{FBA9E13E-74C6-4E82-9969-EC3A8B5C2B99}"/>
                </a:ext>
              </a:extLst>
            </p:cNvPr>
            <p:cNvSpPr txBox="1"/>
            <p:nvPr/>
          </p:nvSpPr>
          <p:spPr>
            <a:xfrm>
              <a:off x="4571438" y="4525300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174" name="CasellaDiTesto 173">
              <a:extLst>
                <a:ext uri="{FF2B5EF4-FFF2-40B4-BE49-F238E27FC236}">
                  <a16:creationId xmlns:a16="http://schemas.microsoft.com/office/drawing/2014/main" id="{CF5E07D8-54D5-4A57-B61F-5D9D733C65B9}"/>
                </a:ext>
              </a:extLst>
            </p:cNvPr>
            <p:cNvSpPr txBox="1"/>
            <p:nvPr/>
          </p:nvSpPr>
          <p:spPr>
            <a:xfrm>
              <a:off x="4819009" y="4525300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sp>
          <p:nvSpPr>
            <p:cNvPr id="175" name="CasellaDiTesto 174">
              <a:extLst>
                <a:ext uri="{FF2B5EF4-FFF2-40B4-BE49-F238E27FC236}">
                  <a16:creationId xmlns:a16="http://schemas.microsoft.com/office/drawing/2014/main" id="{8677AEB8-902F-4CCD-B487-F95C922B8C80}"/>
                </a:ext>
              </a:extLst>
            </p:cNvPr>
            <p:cNvSpPr txBox="1"/>
            <p:nvPr/>
          </p:nvSpPr>
          <p:spPr>
            <a:xfrm>
              <a:off x="5615500" y="4525300"/>
              <a:ext cx="397866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IGF</a:t>
              </a:r>
            </a:p>
          </p:txBody>
        </p:sp>
        <p:sp>
          <p:nvSpPr>
            <p:cNvPr id="176" name="CasellaDiTesto 175">
              <a:extLst>
                <a:ext uri="{FF2B5EF4-FFF2-40B4-BE49-F238E27FC236}">
                  <a16:creationId xmlns:a16="http://schemas.microsoft.com/office/drawing/2014/main" id="{61F03427-9263-441D-9334-82A10EA34BC1}"/>
                </a:ext>
              </a:extLst>
            </p:cNvPr>
            <p:cNvSpPr txBox="1"/>
            <p:nvPr/>
          </p:nvSpPr>
          <p:spPr>
            <a:xfrm>
              <a:off x="5099266" y="4525300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177" name="CasellaDiTesto 176">
              <a:extLst>
                <a:ext uri="{FF2B5EF4-FFF2-40B4-BE49-F238E27FC236}">
                  <a16:creationId xmlns:a16="http://schemas.microsoft.com/office/drawing/2014/main" id="{2511D2D5-54D8-427A-A282-852B98EAAE0B}"/>
                </a:ext>
              </a:extLst>
            </p:cNvPr>
            <p:cNvSpPr txBox="1"/>
            <p:nvPr/>
          </p:nvSpPr>
          <p:spPr>
            <a:xfrm>
              <a:off x="5358330" y="4525300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cxnSp>
          <p:nvCxnSpPr>
            <p:cNvPr id="178" name="Connettore diritto 177">
              <a:extLst>
                <a:ext uri="{FF2B5EF4-FFF2-40B4-BE49-F238E27FC236}">
                  <a16:creationId xmlns:a16="http://schemas.microsoft.com/office/drawing/2014/main" id="{B09E8C77-9320-4CFE-8BDE-F4962A008ED4}"/>
                </a:ext>
              </a:extLst>
            </p:cNvPr>
            <p:cNvCxnSpPr>
              <a:cxnSpLocks/>
            </p:cNvCxnSpPr>
            <p:nvPr/>
          </p:nvCxnSpPr>
          <p:spPr>
            <a:xfrm>
              <a:off x="5213240" y="4724486"/>
              <a:ext cx="27509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9" name="CasellaDiTesto 178">
              <a:extLst>
                <a:ext uri="{FF2B5EF4-FFF2-40B4-BE49-F238E27FC236}">
                  <a16:creationId xmlns:a16="http://schemas.microsoft.com/office/drawing/2014/main" id="{5BE40EC5-6733-450B-A654-E1429EF56153}"/>
                </a:ext>
              </a:extLst>
            </p:cNvPr>
            <p:cNvSpPr txBox="1"/>
            <p:nvPr/>
          </p:nvSpPr>
          <p:spPr>
            <a:xfrm>
              <a:off x="5136533" y="4685819"/>
              <a:ext cx="44755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NVP</a:t>
              </a:r>
            </a:p>
          </p:txBody>
        </p:sp>
        <p:sp>
          <p:nvSpPr>
            <p:cNvPr id="180" name="CasellaDiTesto 179">
              <a:extLst>
                <a:ext uri="{FF2B5EF4-FFF2-40B4-BE49-F238E27FC236}">
                  <a16:creationId xmlns:a16="http://schemas.microsoft.com/office/drawing/2014/main" id="{5B5A5EBB-3884-44E2-9DEC-AD48B52667EE}"/>
                </a:ext>
              </a:extLst>
            </p:cNvPr>
            <p:cNvSpPr txBox="1"/>
            <p:nvPr/>
          </p:nvSpPr>
          <p:spPr>
            <a:xfrm rot="16200000">
              <a:off x="3429528" y="3737402"/>
              <a:ext cx="105233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 err="1"/>
                <a:t>pAKT</a:t>
              </a:r>
              <a:r>
                <a:rPr lang="it-IT" sz="1200" dirty="0"/>
                <a:t> </a:t>
              </a:r>
              <a:r>
                <a:rPr lang="it-IT" sz="1200" dirty="0" err="1"/>
                <a:t>Levels</a:t>
              </a:r>
              <a:endParaRPr lang="it-IT" sz="1200" dirty="0"/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-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181" name="CasellaDiTesto 180">
              <a:extLst>
                <a:ext uri="{FF2B5EF4-FFF2-40B4-BE49-F238E27FC236}">
                  <a16:creationId xmlns:a16="http://schemas.microsoft.com/office/drawing/2014/main" id="{9677D3A4-3800-4B1C-B90D-46A8A734BC5D}"/>
                </a:ext>
              </a:extLst>
            </p:cNvPr>
            <p:cNvSpPr txBox="1"/>
            <p:nvPr/>
          </p:nvSpPr>
          <p:spPr>
            <a:xfrm>
              <a:off x="4147779" y="3240465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5.0</a:t>
              </a:r>
            </a:p>
          </p:txBody>
        </p:sp>
        <p:sp>
          <p:nvSpPr>
            <p:cNvPr id="182" name="CasellaDiTesto 181">
              <a:extLst>
                <a:ext uri="{FF2B5EF4-FFF2-40B4-BE49-F238E27FC236}">
                  <a16:creationId xmlns:a16="http://schemas.microsoft.com/office/drawing/2014/main" id="{FB49925A-764B-49EC-95EA-BA36B08EDD20}"/>
                </a:ext>
              </a:extLst>
            </p:cNvPr>
            <p:cNvSpPr txBox="1"/>
            <p:nvPr/>
          </p:nvSpPr>
          <p:spPr>
            <a:xfrm>
              <a:off x="4147779" y="383178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2.5</a:t>
              </a:r>
            </a:p>
          </p:txBody>
        </p:sp>
        <p:sp>
          <p:nvSpPr>
            <p:cNvPr id="183" name="CasellaDiTesto 182">
              <a:extLst>
                <a:ext uri="{FF2B5EF4-FFF2-40B4-BE49-F238E27FC236}">
                  <a16:creationId xmlns:a16="http://schemas.microsoft.com/office/drawing/2014/main" id="{B68941ED-B29C-4F2B-827C-A788AF78D02F}"/>
                </a:ext>
              </a:extLst>
            </p:cNvPr>
            <p:cNvSpPr txBox="1"/>
            <p:nvPr/>
          </p:nvSpPr>
          <p:spPr>
            <a:xfrm>
              <a:off x="4147779" y="443305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</p:grpSp>
      <p:grpSp>
        <p:nvGrpSpPr>
          <p:cNvPr id="199" name="Gruppo 198">
            <a:extLst>
              <a:ext uri="{FF2B5EF4-FFF2-40B4-BE49-F238E27FC236}">
                <a16:creationId xmlns:a16="http://schemas.microsoft.com/office/drawing/2014/main" id="{9CE67C69-47BE-492E-AF25-85FB71F3D2B5}"/>
              </a:ext>
            </a:extLst>
          </p:cNvPr>
          <p:cNvGrpSpPr/>
          <p:nvPr/>
        </p:nvGrpSpPr>
        <p:grpSpPr>
          <a:xfrm>
            <a:off x="4055764" y="395536"/>
            <a:ext cx="2253235" cy="1691575"/>
            <a:chOff x="4055764" y="525728"/>
            <a:chExt cx="2253235" cy="1691575"/>
          </a:xfrm>
        </p:grpSpPr>
        <p:pic>
          <p:nvPicPr>
            <p:cNvPr id="185" name="Immagine 184">
              <a:extLst>
                <a:ext uri="{FF2B5EF4-FFF2-40B4-BE49-F238E27FC236}">
                  <a16:creationId xmlns:a16="http://schemas.microsoft.com/office/drawing/2014/main" id="{CAEF0E98-78F5-4C69-9C3E-6E0DB277D951}"/>
                </a:ext>
              </a:extLst>
            </p:cNvPr>
            <p:cNvPicPr>
              <a:picLocks noChangeAspect="1"/>
            </p:cNvPicPr>
            <p:nvPr/>
          </p:nvPicPr>
          <p:blipFill>
            <a:blip r:embed="rId34"/>
            <a:stretch>
              <a:fillRect/>
            </a:stretch>
          </p:blipFill>
          <p:spPr>
            <a:xfrm>
              <a:off x="4781503" y="643471"/>
              <a:ext cx="1242500" cy="1260000"/>
            </a:xfrm>
            <a:prstGeom prst="rect">
              <a:avLst/>
            </a:prstGeom>
          </p:spPr>
        </p:pic>
        <p:sp>
          <p:nvSpPr>
            <p:cNvPr id="188" name="CasellaDiTesto 187">
              <a:extLst>
                <a:ext uri="{FF2B5EF4-FFF2-40B4-BE49-F238E27FC236}">
                  <a16:creationId xmlns:a16="http://schemas.microsoft.com/office/drawing/2014/main" id="{66FA5CF4-6CA0-4FB1-B9BD-D8EB02608EDA}"/>
                </a:ext>
              </a:extLst>
            </p:cNvPr>
            <p:cNvSpPr txBox="1"/>
            <p:nvPr/>
          </p:nvSpPr>
          <p:spPr>
            <a:xfrm>
              <a:off x="4902337" y="1810563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189" name="CasellaDiTesto 188">
              <a:extLst>
                <a:ext uri="{FF2B5EF4-FFF2-40B4-BE49-F238E27FC236}">
                  <a16:creationId xmlns:a16="http://schemas.microsoft.com/office/drawing/2014/main" id="{DFA82E58-C160-4E48-BD6C-5EFBA5DB4BBF}"/>
                </a:ext>
              </a:extLst>
            </p:cNvPr>
            <p:cNvSpPr txBox="1"/>
            <p:nvPr/>
          </p:nvSpPr>
          <p:spPr>
            <a:xfrm>
              <a:off x="5149908" y="1810563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sp>
          <p:nvSpPr>
            <p:cNvPr id="190" name="CasellaDiTesto 189">
              <a:extLst>
                <a:ext uri="{FF2B5EF4-FFF2-40B4-BE49-F238E27FC236}">
                  <a16:creationId xmlns:a16="http://schemas.microsoft.com/office/drawing/2014/main" id="{DBBC2261-2923-4E5F-9BB6-57031BE60FAE}"/>
                </a:ext>
              </a:extLst>
            </p:cNvPr>
            <p:cNvSpPr txBox="1"/>
            <p:nvPr/>
          </p:nvSpPr>
          <p:spPr>
            <a:xfrm>
              <a:off x="5946399" y="1810563"/>
              <a:ext cx="36260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Tel</a:t>
              </a:r>
            </a:p>
          </p:txBody>
        </p:sp>
        <p:sp>
          <p:nvSpPr>
            <p:cNvPr id="191" name="CasellaDiTesto 190">
              <a:extLst>
                <a:ext uri="{FF2B5EF4-FFF2-40B4-BE49-F238E27FC236}">
                  <a16:creationId xmlns:a16="http://schemas.microsoft.com/office/drawing/2014/main" id="{84C63672-E5F1-4541-9411-371B2B6EDB11}"/>
                </a:ext>
              </a:extLst>
            </p:cNvPr>
            <p:cNvSpPr txBox="1"/>
            <p:nvPr/>
          </p:nvSpPr>
          <p:spPr>
            <a:xfrm>
              <a:off x="5430165" y="1810563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192" name="CasellaDiTesto 191">
              <a:extLst>
                <a:ext uri="{FF2B5EF4-FFF2-40B4-BE49-F238E27FC236}">
                  <a16:creationId xmlns:a16="http://schemas.microsoft.com/office/drawing/2014/main" id="{5048865E-981B-437D-8608-716ABFACA9B2}"/>
                </a:ext>
              </a:extLst>
            </p:cNvPr>
            <p:cNvSpPr txBox="1"/>
            <p:nvPr/>
          </p:nvSpPr>
          <p:spPr>
            <a:xfrm>
              <a:off x="5689229" y="1810563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cxnSp>
          <p:nvCxnSpPr>
            <p:cNvPr id="193" name="Connettore diritto 192">
              <a:extLst>
                <a:ext uri="{FF2B5EF4-FFF2-40B4-BE49-F238E27FC236}">
                  <a16:creationId xmlns:a16="http://schemas.microsoft.com/office/drawing/2014/main" id="{62E51882-824A-490C-B245-372CA06C7C94}"/>
                </a:ext>
              </a:extLst>
            </p:cNvPr>
            <p:cNvCxnSpPr>
              <a:cxnSpLocks/>
            </p:cNvCxnSpPr>
            <p:nvPr/>
          </p:nvCxnSpPr>
          <p:spPr>
            <a:xfrm>
              <a:off x="5544139" y="2009749"/>
              <a:ext cx="27509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4" name="CasellaDiTesto 193">
              <a:extLst>
                <a:ext uri="{FF2B5EF4-FFF2-40B4-BE49-F238E27FC236}">
                  <a16:creationId xmlns:a16="http://schemas.microsoft.com/office/drawing/2014/main" id="{CC981ECB-1FEC-4ACF-8CBB-FB60B75ACBB3}"/>
                </a:ext>
              </a:extLst>
            </p:cNvPr>
            <p:cNvSpPr txBox="1"/>
            <p:nvPr/>
          </p:nvSpPr>
          <p:spPr>
            <a:xfrm>
              <a:off x="5467432" y="1971082"/>
              <a:ext cx="389850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Gef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195" name="CasellaDiTesto 194">
              <a:extLst>
                <a:ext uri="{FF2B5EF4-FFF2-40B4-BE49-F238E27FC236}">
                  <a16:creationId xmlns:a16="http://schemas.microsoft.com/office/drawing/2014/main" id="{BB3CAF97-ADA8-41EE-A151-22C43569750C}"/>
                </a:ext>
              </a:extLst>
            </p:cNvPr>
            <p:cNvSpPr txBox="1"/>
            <p:nvPr/>
          </p:nvSpPr>
          <p:spPr>
            <a:xfrm rot="16200000">
              <a:off x="3760427" y="1022665"/>
              <a:ext cx="105233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 err="1"/>
                <a:t>pAKT</a:t>
              </a:r>
              <a:r>
                <a:rPr lang="it-IT" sz="1200" dirty="0"/>
                <a:t> </a:t>
              </a:r>
              <a:r>
                <a:rPr lang="it-IT" sz="1200" dirty="0" err="1"/>
                <a:t>Levels</a:t>
              </a:r>
              <a:endParaRPr lang="it-IT" sz="1200" dirty="0"/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-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196" name="CasellaDiTesto 195">
              <a:extLst>
                <a:ext uri="{FF2B5EF4-FFF2-40B4-BE49-F238E27FC236}">
                  <a16:creationId xmlns:a16="http://schemas.microsoft.com/office/drawing/2014/main" id="{88307B80-28C4-4D86-BA0E-708B568B011A}"/>
                </a:ext>
              </a:extLst>
            </p:cNvPr>
            <p:cNvSpPr txBox="1"/>
            <p:nvPr/>
          </p:nvSpPr>
          <p:spPr>
            <a:xfrm>
              <a:off x="4478678" y="525728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2.6</a:t>
              </a:r>
            </a:p>
          </p:txBody>
        </p:sp>
        <p:sp>
          <p:nvSpPr>
            <p:cNvPr id="197" name="CasellaDiTesto 196">
              <a:extLst>
                <a:ext uri="{FF2B5EF4-FFF2-40B4-BE49-F238E27FC236}">
                  <a16:creationId xmlns:a16="http://schemas.microsoft.com/office/drawing/2014/main" id="{0482B92F-5855-41A8-8EF2-E56C833BF9D3}"/>
                </a:ext>
              </a:extLst>
            </p:cNvPr>
            <p:cNvSpPr txBox="1"/>
            <p:nvPr/>
          </p:nvSpPr>
          <p:spPr>
            <a:xfrm>
              <a:off x="4478678" y="111704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3</a:t>
              </a:r>
            </a:p>
          </p:txBody>
        </p:sp>
        <p:sp>
          <p:nvSpPr>
            <p:cNvPr id="198" name="CasellaDiTesto 197">
              <a:extLst>
                <a:ext uri="{FF2B5EF4-FFF2-40B4-BE49-F238E27FC236}">
                  <a16:creationId xmlns:a16="http://schemas.microsoft.com/office/drawing/2014/main" id="{4D0962CF-E703-43F1-8CC5-77BF951CA59C}"/>
                </a:ext>
              </a:extLst>
            </p:cNvPr>
            <p:cNvSpPr txBox="1"/>
            <p:nvPr/>
          </p:nvSpPr>
          <p:spPr>
            <a:xfrm>
              <a:off x="4478678" y="171831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</p:grpSp>
      <p:grpSp>
        <p:nvGrpSpPr>
          <p:cNvPr id="80" name="Gruppo 79">
            <a:extLst>
              <a:ext uri="{FF2B5EF4-FFF2-40B4-BE49-F238E27FC236}">
                <a16:creationId xmlns:a16="http://schemas.microsoft.com/office/drawing/2014/main" id="{8458CE33-19EB-4E9E-A722-8EF2C4A2F746}"/>
              </a:ext>
            </a:extLst>
          </p:cNvPr>
          <p:cNvGrpSpPr/>
          <p:nvPr/>
        </p:nvGrpSpPr>
        <p:grpSpPr>
          <a:xfrm>
            <a:off x="3724865" y="6840865"/>
            <a:ext cx="2338193" cy="1691575"/>
            <a:chOff x="3724865" y="6761368"/>
            <a:chExt cx="2338193" cy="1691575"/>
          </a:xfrm>
        </p:grpSpPr>
        <p:pic>
          <p:nvPicPr>
            <p:cNvPr id="79" name="Immagine 78">
              <a:extLst>
                <a:ext uri="{FF2B5EF4-FFF2-40B4-BE49-F238E27FC236}">
                  <a16:creationId xmlns:a16="http://schemas.microsoft.com/office/drawing/2014/main" id="{AEC89909-7C8E-42CD-A668-70DB01AC0BF2}"/>
                </a:ext>
              </a:extLst>
            </p:cNvPr>
            <p:cNvPicPr>
              <a:picLocks noChangeAspect="1"/>
            </p:cNvPicPr>
            <p:nvPr/>
          </p:nvPicPr>
          <p:blipFill>
            <a:blip r:embed="rId35"/>
            <a:stretch>
              <a:fillRect/>
            </a:stretch>
          </p:blipFill>
          <p:spPr>
            <a:xfrm>
              <a:off x="4450604" y="6879111"/>
              <a:ext cx="1271776" cy="1260000"/>
            </a:xfrm>
            <a:prstGeom prst="rect">
              <a:avLst/>
            </a:prstGeom>
          </p:spPr>
        </p:pic>
        <p:sp>
          <p:nvSpPr>
            <p:cNvPr id="125" name="CasellaDiTesto 124">
              <a:extLst>
                <a:ext uri="{FF2B5EF4-FFF2-40B4-BE49-F238E27FC236}">
                  <a16:creationId xmlns:a16="http://schemas.microsoft.com/office/drawing/2014/main" id="{583D0BA4-803E-4059-9463-044E2B1B781F}"/>
                </a:ext>
              </a:extLst>
            </p:cNvPr>
            <p:cNvSpPr txBox="1"/>
            <p:nvPr/>
          </p:nvSpPr>
          <p:spPr>
            <a:xfrm>
              <a:off x="4571438" y="8046203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126" name="CasellaDiTesto 125">
              <a:extLst>
                <a:ext uri="{FF2B5EF4-FFF2-40B4-BE49-F238E27FC236}">
                  <a16:creationId xmlns:a16="http://schemas.microsoft.com/office/drawing/2014/main" id="{BB244E21-DC1E-47A4-8370-33F715EDAC0C}"/>
                </a:ext>
              </a:extLst>
            </p:cNvPr>
            <p:cNvSpPr txBox="1"/>
            <p:nvPr/>
          </p:nvSpPr>
          <p:spPr>
            <a:xfrm>
              <a:off x="4819009" y="8046203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sp>
          <p:nvSpPr>
            <p:cNvPr id="127" name="CasellaDiTesto 126">
              <a:extLst>
                <a:ext uri="{FF2B5EF4-FFF2-40B4-BE49-F238E27FC236}">
                  <a16:creationId xmlns:a16="http://schemas.microsoft.com/office/drawing/2014/main" id="{73761CD7-5C7D-4AF2-A0CB-87F5C94445A9}"/>
                </a:ext>
              </a:extLst>
            </p:cNvPr>
            <p:cNvSpPr txBox="1"/>
            <p:nvPr/>
          </p:nvSpPr>
          <p:spPr>
            <a:xfrm>
              <a:off x="5615500" y="8046203"/>
              <a:ext cx="44755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EGF</a:t>
              </a:r>
            </a:p>
          </p:txBody>
        </p:sp>
        <p:sp>
          <p:nvSpPr>
            <p:cNvPr id="128" name="CasellaDiTesto 127">
              <a:extLst>
                <a:ext uri="{FF2B5EF4-FFF2-40B4-BE49-F238E27FC236}">
                  <a16:creationId xmlns:a16="http://schemas.microsoft.com/office/drawing/2014/main" id="{47CD8135-983F-4048-84EB-A2D2BB6672E1}"/>
                </a:ext>
              </a:extLst>
            </p:cNvPr>
            <p:cNvSpPr txBox="1"/>
            <p:nvPr/>
          </p:nvSpPr>
          <p:spPr>
            <a:xfrm>
              <a:off x="5099266" y="8046203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129" name="CasellaDiTesto 128">
              <a:extLst>
                <a:ext uri="{FF2B5EF4-FFF2-40B4-BE49-F238E27FC236}">
                  <a16:creationId xmlns:a16="http://schemas.microsoft.com/office/drawing/2014/main" id="{E9C3B578-3E6A-4279-A00C-452FB51F69F7}"/>
                </a:ext>
              </a:extLst>
            </p:cNvPr>
            <p:cNvSpPr txBox="1"/>
            <p:nvPr/>
          </p:nvSpPr>
          <p:spPr>
            <a:xfrm>
              <a:off x="5358330" y="8046203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cxnSp>
          <p:nvCxnSpPr>
            <p:cNvPr id="130" name="Connettore diritto 129">
              <a:extLst>
                <a:ext uri="{FF2B5EF4-FFF2-40B4-BE49-F238E27FC236}">
                  <a16:creationId xmlns:a16="http://schemas.microsoft.com/office/drawing/2014/main" id="{40FFCC47-FA3D-49DB-A82E-05FE9ACE1A42}"/>
                </a:ext>
              </a:extLst>
            </p:cNvPr>
            <p:cNvCxnSpPr>
              <a:cxnSpLocks/>
            </p:cNvCxnSpPr>
            <p:nvPr/>
          </p:nvCxnSpPr>
          <p:spPr>
            <a:xfrm>
              <a:off x="5213240" y="8245389"/>
              <a:ext cx="27509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1" name="CasellaDiTesto 130">
              <a:extLst>
                <a:ext uri="{FF2B5EF4-FFF2-40B4-BE49-F238E27FC236}">
                  <a16:creationId xmlns:a16="http://schemas.microsoft.com/office/drawing/2014/main" id="{1EEF53BC-2BCD-4B92-9444-FC3658B605EB}"/>
                </a:ext>
              </a:extLst>
            </p:cNvPr>
            <p:cNvSpPr txBox="1"/>
            <p:nvPr/>
          </p:nvSpPr>
          <p:spPr>
            <a:xfrm>
              <a:off x="5136533" y="8206722"/>
              <a:ext cx="44755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GEF</a:t>
              </a:r>
            </a:p>
          </p:txBody>
        </p:sp>
        <p:sp>
          <p:nvSpPr>
            <p:cNvPr id="132" name="CasellaDiTesto 131">
              <a:extLst>
                <a:ext uri="{FF2B5EF4-FFF2-40B4-BE49-F238E27FC236}">
                  <a16:creationId xmlns:a16="http://schemas.microsoft.com/office/drawing/2014/main" id="{D804BF9B-C423-4770-9B85-36D3D2B2E78D}"/>
                </a:ext>
              </a:extLst>
            </p:cNvPr>
            <p:cNvSpPr txBox="1"/>
            <p:nvPr/>
          </p:nvSpPr>
          <p:spPr>
            <a:xfrm rot="16200000">
              <a:off x="3429528" y="7258305"/>
              <a:ext cx="105233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 err="1"/>
                <a:t>pAKT</a:t>
              </a:r>
              <a:r>
                <a:rPr lang="it-IT" sz="1200" dirty="0"/>
                <a:t> </a:t>
              </a:r>
              <a:r>
                <a:rPr lang="it-IT" sz="1200" dirty="0" err="1"/>
                <a:t>Levels</a:t>
              </a:r>
              <a:endParaRPr lang="it-IT" sz="1200" dirty="0"/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-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133" name="CasellaDiTesto 132">
              <a:extLst>
                <a:ext uri="{FF2B5EF4-FFF2-40B4-BE49-F238E27FC236}">
                  <a16:creationId xmlns:a16="http://schemas.microsoft.com/office/drawing/2014/main" id="{3D412561-2D1D-4833-8A49-643F65F860A3}"/>
                </a:ext>
              </a:extLst>
            </p:cNvPr>
            <p:cNvSpPr txBox="1"/>
            <p:nvPr/>
          </p:nvSpPr>
          <p:spPr>
            <a:xfrm>
              <a:off x="4147779" y="6761368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2.2</a:t>
              </a:r>
            </a:p>
          </p:txBody>
        </p:sp>
        <p:sp>
          <p:nvSpPr>
            <p:cNvPr id="134" name="CasellaDiTesto 133">
              <a:extLst>
                <a:ext uri="{FF2B5EF4-FFF2-40B4-BE49-F238E27FC236}">
                  <a16:creationId xmlns:a16="http://schemas.microsoft.com/office/drawing/2014/main" id="{F872BDC9-E794-42C3-8BA6-1C9A7EFFA0A6}"/>
                </a:ext>
              </a:extLst>
            </p:cNvPr>
            <p:cNvSpPr txBox="1"/>
            <p:nvPr/>
          </p:nvSpPr>
          <p:spPr>
            <a:xfrm>
              <a:off x="4147779" y="735268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1</a:t>
              </a:r>
            </a:p>
          </p:txBody>
        </p:sp>
        <p:sp>
          <p:nvSpPr>
            <p:cNvPr id="135" name="CasellaDiTesto 134">
              <a:extLst>
                <a:ext uri="{FF2B5EF4-FFF2-40B4-BE49-F238E27FC236}">
                  <a16:creationId xmlns:a16="http://schemas.microsoft.com/office/drawing/2014/main" id="{988DAE6F-C4AC-4AB0-BD42-6F0F209CB067}"/>
                </a:ext>
              </a:extLst>
            </p:cNvPr>
            <p:cNvSpPr txBox="1"/>
            <p:nvPr/>
          </p:nvSpPr>
          <p:spPr>
            <a:xfrm>
              <a:off x="4147779" y="795395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</p:grpSp>
      <p:grpSp>
        <p:nvGrpSpPr>
          <p:cNvPr id="82" name="Gruppo 81">
            <a:extLst>
              <a:ext uri="{FF2B5EF4-FFF2-40B4-BE49-F238E27FC236}">
                <a16:creationId xmlns:a16="http://schemas.microsoft.com/office/drawing/2014/main" id="{60A7B16D-42CF-4C53-BF53-DB7196C531DC}"/>
              </a:ext>
            </a:extLst>
          </p:cNvPr>
          <p:cNvGrpSpPr/>
          <p:nvPr/>
        </p:nvGrpSpPr>
        <p:grpSpPr>
          <a:xfrm>
            <a:off x="384372" y="6840865"/>
            <a:ext cx="2288501" cy="1691575"/>
            <a:chOff x="384372" y="6761368"/>
            <a:chExt cx="2288501" cy="1691575"/>
          </a:xfrm>
        </p:grpSpPr>
        <p:pic>
          <p:nvPicPr>
            <p:cNvPr id="81" name="Immagine 80">
              <a:extLst>
                <a:ext uri="{FF2B5EF4-FFF2-40B4-BE49-F238E27FC236}">
                  <a16:creationId xmlns:a16="http://schemas.microsoft.com/office/drawing/2014/main" id="{33104A2D-9E3E-42C1-AE6B-88D28E135D33}"/>
                </a:ext>
              </a:extLst>
            </p:cNvPr>
            <p:cNvPicPr>
              <a:picLocks noChangeAspect="1"/>
            </p:cNvPicPr>
            <p:nvPr/>
          </p:nvPicPr>
          <p:blipFill>
            <a:blip r:embed="rId36"/>
            <a:stretch>
              <a:fillRect/>
            </a:stretch>
          </p:blipFill>
          <p:spPr>
            <a:xfrm>
              <a:off x="1110111" y="6879111"/>
              <a:ext cx="1260000" cy="1260000"/>
            </a:xfrm>
            <a:prstGeom prst="rect">
              <a:avLst/>
            </a:prstGeom>
          </p:spPr>
        </p:pic>
        <p:sp>
          <p:nvSpPr>
            <p:cNvPr id="144" name="CasellaDiTesto 143">
              <a:extLst>
                <a:ext uri="{FF2B5EF4-FFF2-40B4-BE49-F238E27FC236}">
                  <a16:creationId xmlns:a16="http://schemas.microsoft.com/office/drawing/2014/main" id="{4C94DAB0-F3CA-4490-A40D-69554016E1AE}"/>
                </a:ext>
              </a:extLst>
            </p:cNvPr>
            <p:cNvSpPr txBox="1"/>
            <p:nvPr/>
          </p:nvSpPr>
          <p:spPr>
            <a:xfrm>
              <a:off x="1230945" y="8046203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145" name="CasellaDiTesto 144">
              <a:extLst>
                <a:ext uri="{FF2B5EF4-FFF2-40B4-BE49-F238E27FC236}">
                  <a16:creationId xmlns:a16="http://schemas.microsoft.com/office/drawing/2014/main" id="{09077916-4A8E-4271-B7CC-FEDCD04501B2}"/>
                </a:ext>
              </a:extLst>
            </p:cNvPr>
            <p:cNvSpPr txBox="1"/>
            <p:nvPr/>
          </p:nvSpPr>
          <p:spPr>
            <a:xfrm>
              <a:off x="1478516" y="8046203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sp>
          <p:nvSpPr>
            <p:cNvPr id="146" name="CasellaDiTesto 145">
              <a:extLst>
                <a:ext uri="{FF2B5EF4-FFF2-40B4-BE49-F238E27FC236}">
                  <a16:creationId xmlns:a16="http://schemas.microsoft.com/office/drawing/2014/main" id="{607BAB7D-9332-4928-9D32-92CF3508C2ED}"/>
                </a:ext>
              </a:extLst>
            </p:cNvPr>
            <p:cNvSpPr txBox="1"/>
            <p:nvPr/>
          </p:nvSpPr>
          <p:spPr>
            <a:xfrm>
              <a:off x="2275007" y="8046203"/>
              <a:ext cx="397866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IGF</a:t>
              </a:r>
            </a:p>
          </p:txBody>
        </p:sp>
        <p:sp>
          <p:nvSpPr>
            <p:cNvPr id="147" name="CasellaDiTesto 146">
              <a:extLst>
                <a:ext uri="{FF2B5EF4-FFF2-40B4-BE49-F238E27FC236}">
                  <a16:creationId xmlns:a16="http://schemas.microsoft.com/office/drawing/2014/main" id="{EB8CA924-7CC1-42BD-9C97-E6C46C6C126F}"/>
                </a:ext>
              </a:extLst>
            </p:cNvPr>
            <p:cNvSpPr txBox="1"/>
            <p:nvPr/>
          </p:nvSpPr>
          <p:spPr>
            <a:xfrm>
              <a:off x="1758773" y="8046203"/>
              <a:ext cx="22794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148" name="CasellaDiTesto 147">
              <a:extLst>
                <a:ext uri="{FF2B5EF4-FFF2-40B4-BE49-F238E27FC236}">
                  <a16:creationId xmlns:a16="http://schemas.microsoft.com/office/drawing/2014/main" id="{A01F8C62-DFAA-4181-9345-BD7664388AAF}"/>
                </a:ext>
              </a:extLst>
            </p:cNvPr>
            <p:cNvSpPr txBox="1"/>
            <p:nvPr/>
          </p:nvSpPr>
          <p:spPr>
            <a:xfrm>
              <a:off x="2017837" y="8046203"/>
              <a:ext cx="26000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cxnSp>
          <p:nvCxnSpPr>
            <p:cNvPr id="149" name="Connettore diritto 148">
              <a:extLst>
                <a:ext uri="{FF2B5EF4-FFF2-40B4-BE49-F238E27FC236}">
                  <a16:creationId xmlns:a16="http://schemas.microsoft.com/office/drawing/2014/main" id="{382095F2-0E7F-497B-9124-CFCF683E1F6E}"/>
                </a:ext>
              </a:extLst>
            </p:cNvPr>
            <p:cNvCxnSpPr>
              <a:cxnSpLocks/>
            </p:cNvCxnSpPr>
            <p:nvPr/>
          </p:nvCxnSpPr>
          <p:spPr>
            <a:xfrm>
              <a:off x="1872747" y="8245389"/>
              <a:ext cx="27509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0" name="CasellaDiTesto 149">
              <a:extLst>
                <a:ext uri="{FF2B5EF4-FFF2-40B4-BE49-F238E27FC236}">
                  <a16:creationId xmlns:a16="http://schemas.microsoft.com/office/drawing/2014/main" id="{55B0AE4D-AD4E-413D-B7AC-66FE124F9A91}"/>
                </a:ext>
              </a:extLst>
            </p:cNvPr>
            <p:cNvSpPr txBox="1"/>
            <p:nvPr/>
          </p:nvSpPr>
          <p:spPr>
            <a:xfrm>
              <a:off x="1796040" y="8206722"/>
              <a:ext cx="44755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GEF</a:t>
              </a:r>
            </a:p>
          </p:txBody>
        </p:sp>
        <p:sp>
          <p:nvSpPr>
            <p:cNvPr id="151" name="CasellaDiTesto 150">
              <a:extLst>
                <a:ext uri="{FF2B5EF4-FFF2-40B4-BE49-F238E27FC236}">
                  <a16:creationId xmlns:a16="http://schemas.microsoft.com/office/drawing/2014/main" id="{4CE85E1F-FC75-46C3-9694-41FA9F84BEC9}"/>
                </a:ext>
              </a:extLst>
            </p:cNvPr>
            <p:cNvSpPr txBox="1"/>
            <p:nvPr/>
          </p:nvSpPr>
          <p:spPr>
            <a:xfrm rot="16200000">
              <a:off x="89035" y="7258305"/>
              <a:ext cx="105233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 err="1"/>
                <a:t>pAKT</a:t>
              </a:r>
              <a:r>
                <a:rPr lang="it-IT" sz="1200" dirty="0"/>
                <a:t> </a:t>
              </a:r>
              <a:r>
                <a:rPr lang="it-IT" sz="1200" dirty="0" err="1"/>
                <a:t>Levels</a:t>
              </a:r>
              <a:endParaRPr lang="it-IT" sz="1200" dirty="0"/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-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152" name="CasellaDiTesto 151">
              <a:extLst>
                <a:ext uri="{FF2B5EF4-FFF2-40B4-BE49-F238E27FC236}">
                  <a16:creationId xmlns:a16="http://schemas.microsoft.com/office/drawing/2014/main" id="{E5D4ADAB-5C0D-488B-9C05-FC2959F79D10}"/>
                </a:ext>
              </a:extLst>
            </p:cNvPr>
            <p:cNvSpPr txBox="1"/>
            <p:nvPr/>
          </p:nvSpPr>
          <p:spPr>
            <a:xfrm>
              <a:off x="807286" y="6761368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6.0</a:t>
              </a:r>
            </a:p>
          </p:txBody>
        </p:sp>
        <p:sp>
          <p:nvSpPr>
            <p:cNvPr id="153" name="CasellaDiTesto 152">
              <a:extLst>
                <a:ext uri="{FF2B5EF4-FFF2-40B4-BE49-F238E27FC236}">
                  <a16:creationId xmlns:a16="http://schemas.microsoft.com/office/drawing/2014/main" id="{E7D36588-7CBF-42ED-904D-7FDFE84AEECC}"/>
                </a:ext>
              </a:extLst>
            </p:cNvPr>
            <p:cNvSpPr txBox="1"/>
            <p:nvPr/>
          </p:nvSpPr>
          <p:spPr>
            <a:xfrm>
              <a:off x="807286" y="735268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3.0</a:t>
              </a:r>
            </a:p>
          </p:txBody>
        </p:sp>
        <p:sp>
          <p:nvSpPr>
            <p:cNvPr id="154" name="CasellaDiTesto 153">
              <a:extLst>
                <a:ext uri="{FF2B5EF4-FFF2-40B4-BE49-F238E27FC236}">
                  <a16:creationId xmlns:a16="http://schemas.microsoft.com/office/drawing/2014/main" id="{CFF514FC-F5F7-44D1-85D2-221FB5245895}"/>
                </a:ext>
              </a:extLst>
            </p:cNvPr>
            <p:cNvSpPr txBox="1"/>
            <p:nvPr/>
          </p:nvSpPr>
          <p:spPr>
            <a:xfrm>
              <a:off x="807286" y="795395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</p:grpSp>
      <p:sp>
        <p:nvSpPr>
          <p:cNvPr id="155" name="CasellaDiTesto 154">
            <a:extLst>
              <a:ext uri="{FF2B5EF4-FFF2-40B4-BE49-F238E27FC236}">
                <a16:creationId xmlns:a16="http://schemas.microsoft.com/office/drawing/2014/main" id="{5632CC6B-1E3D-AEBC-9E4E-F7E92F8658AA}"/>
              </a:ext>
            </a:extLst>
          </p:cNvPr>
          <p:cNvSpPr txBox="1"/>
          <p:nvPr/>
        </p:nvSpPr>
        <p:spPr>
          <a:xfrm>
            <a:off x="5111333" y="347621"/>
            <a:ext cx="3834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****</a:t>
            </a:r>
          </a:p>
        </p:txBody>
      </p:sp>
      <p:sp>
        <p:nvSpPr>
          <p:cNvPr id="158" name="CasellaDiTesto 157">
            <a:extLst>
              <a:ext uri="{FF2B5EF4-FFF2-40B4-BE49-F238E27FC236}">
                <a16:creationId xmlns:a16="http://schemas.microsoft.com/office/drawing/2014/main" id="{EA08C1E8-93EB-677D-E171-A427CC7DB63F}"/>
              </a:ext>
            </a:extLst>
          </p:cNvPr>
          <p:cNvSpPr txBox="1"/>
          <p:nvPr/>
        </p:nvSpPr>
        <p:spPr>
          <a:xfrm>
            <a:off x="5637344" y="506763"/>
            <a:ext cx="3834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****</a:t>
            </a:r>
          </a:p>
        </p:txBody>
      </p:sp>
      <p:sp>
        <p:nvSpPr>
          <p:cNvPr id="171" name="CasellaDiTesto 170">
            <a:extLst>
              <a:ext uri="{FF2B5EF4-FFF2-40B4-BE49-F238E27FC236}">
                <a16:creationId xmlns:a16="http://schemas.microsoft.com/office/drawing/2014/main" id="{0C7B8FA3-0FA5-458B-B5E2-A7E003E6246E}"/>
              </a:ext>
            </a:extLst>
          </p:cNvPr>
          <p:cNvSpPr txBox="1"/>
          <p:nvPr/>
        </p:nvSpPr>
        <p:spPr>
          <a:xfrm>
            <a:off x="2012303" y="4459644"/>
            <a:ext cx="3898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°°°°</a:t>
            </a:r>
          </a:p>
        </p:txBody>
      </p:sp>
      <p:sp>
        <p:nvSpPr>
          <p:cNvPr id="172" name="CasellaDiTesto 171">
            <a:extLst>
              <a:ext uri="{FF2B5EF4-FFF2-40B4-BE49-F238E27FC236}">
                <a16:creationId xmlns:a16="http://schemas.microsoft.com/office/drawing/2014/main" id="{6D3C9C40-C35D-4D19-818A-8A7115E0265A}"/>
              </a:ext>
            </a:extLst>
          </p:cNvPr>
          <p:cNvSpPr txBox="1"/>
          <p:nvPr/>
        </p:nvSpPr>
        <p:spPr>
          <a:xfrm>
            <a:off x="1494249" y="3569318"/>
            <a:ext cx="3834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****</a:t>
            </a:r>
          </a:p>
        </p:txBody>
      </p:sp>
      <p:sp>
        <p:nvSpPr>
          <p:cNvPr id="186" name="CasellaDiTesto 185">
            <a:extLst>
              <a:ext uri="{FF2B5EF4-FFF2-40B4-BE49-F238E27FC236}">
                <a16:creationId xmlns:a16="http://schemas.microsoft.com/office/drawing/2014/main" id="{1CB2BFDF-43E4-9AE9-D39E-46B0458AE1AB}"/>
              </a:ext>
            </a:extLst>
          </p:cNvPr>
          <p:cNvSpPr txBox="1"/>
          <p:nvPr/>
        </p:nvSpPr>
        <p:spPr>
          <a:xfrm>
            <a:off x="5280844" y="3966243"/>
            <a:ext cx="3898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°°°°</a:t>
            </a:r>
          </a:p>
        </p:txBody>
      </p:sp>
      <p:sp>
        <p:nvSpPr>
          <p:cNvPr id="187" name="CasellaDiTesto 186">
            <a:extLst>
              <a:ext uri="{FF2B5EF4-FFF2-40B4-BE49-F238E27FC236}">
                <a16:creationId xmlns:a16="http://schemas.microsoft.com/office/drawing/2014/main" id="{B4ABB131-DBA5-50BA-300D-2B02BAE26004}"/>
              </a:ext>
            </a:extLst>
          </p:cNvPr>
          <p:cNvSpPr txBox="1"/>
          <p:nvPr/>
        </p:nvSpPr>
        <p:spPr>
          <a:xfrm>
            <a:off x="4710379" y="3507278"/>
            <a:ext cx="3834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****</a:t>
            </a:r>
          </a:p>
        </p:txBody>
      </p:sp>
      <p:sp>
        <p:nvSpPr>
          <p:cNvPr id="201" name="CasellaDiTesto 200">
            <a:extLst>
              <a:ext uri="{FF2B5EF4-FFF2-40B4-BE49-F238E27FC236}">
                <a16:creationId xmlns:a16="http://schemas.microsoft.com/office/drawing/2014/main" id="{321D0A2A-A0E8-542F-679C-C64F52EAB79E}"/>
              </a:ext>
            </a:extLst>
          </p:cNvPr>
          <p:cNvSpPr txBox="1"/>
          <p:nvPr/>
        </p:nvSpPr>
        <p:spPr>
          <a:xfrm>
            <a:off x="1425027" y="6871223"/>
            <a:ext cx="3834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****</a:t>
            </a:r>
          </a:p>
        </p:txBody>
      </p:sp>
      <p:sp>
        <p:nvSpPr>
          <p:cNvPr id="202" name="CasellaDiTesto 201">
            <a:extLst>
              <a:ext uri="{FF2B5EF4-FFF2-40B4-BE49-F238E27FC236}">
                <a16:creationId xmlns:a16="http://schemas.microsoft.com/office/drawing/2014/main" id="{F824F9EA-02CF-3BE4-8B8E-C4AD2A9A0035}"/>
              </a:ext>
            </a:extLst>
          </p:cNvPr>
          <p:cNvSpPr txBox="1"/>
          <p:nvPr/>
        </p:nvSpPr>
        <p:spPr>
          <a:xfrm>
            <a:off x="5325581" y="7445523"/>
            <a:ext cx="3898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°°°°</a:t>
            </a:r>
          </a:p>
        </p:txBody>
      </p:sp>
      <p:sp>
        <p:nvSpPr>
          <p:cNvPr id="203" name="CasellaDiTesto 202">
            <a:extLst>
              <a:ext uri="{FF2B5EF4-FFF2-40B4-BE49-F238E27FC236}">
                <a16:creationId xmlns:a16="http://schemas.microsoft.com/office/drawing/2014/main" id="{783356E2-AC2E-D9C1-6028-F7E0BD680242}"/>
              </a:ext>
            </a:extLst>
          </p:cNvPr>
          <p:cNvSpPr txBox="1"/>
          <p:nvPr/>
        </p:nvSpPr>
        <p:spPr>
          <a:xfrm>
            <a:off x="4766470" y="6783879"/>
            <a:ext cx="3834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****</a:t>
            </a:r>
          </a:p>
        </p:txBody>
      </p:sp>
      <p:sp>
        <p:nvSpPr>
          <p:cNvPr id="204" name="CasellaDiTesto 203">
            <a:extLst>
              <a:ext uri="{FF2B5EF4-FFF2-40B4-BE49-F238E27FC236}">
                <a16:creationId xmlns:a16="http://schemas.microsoft.com/office/drawing/2014/main" id="{A3B7EE65-8705-40B7-36D6-F9A9CBC3639F}"/>
              </a:ext>
            </a:extLst>
          </p:cNvPr>
          <p:cNvSpPr txBox="1"/>
          <p:nvPr/>
        </p:nvSpPr>
        <p:spPr>
          <a:xfrm>
            <a:off x="1941261" y="6914863"/>
            <a:ext cx="3834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****</a:t>
            </a:r>
          </a:p>
        </p:txBody>
      </p:sp>
    </p:spTree>
    <p:extLst>
      <p:ext uri="{BB962C8B-B14F-4D97-AF65-F5344CB8AC3E}">
        <p14:creationId xmlns:p14="http://schemas.microsoft.com/office/powerpoint/2010/main" val="37632099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2D2571A8-9A72-4410-A823-981F84185F30}"/>
              </a:ext>
            </a:extLst>
          </p:cNvPr>
          <p:cNvGrpSpPr/>
          <p:nvPr/>
        </p:nvGrpSpPr>
        <p:grpSpPr>
          <a:xfrm>
            <a:off x="4608150" y="608573"/>
            <a:ext cx="1770826" cy="1856967"/>
            <a:chOff x="4057625" y="2715033"/>
            <a:chExt cx="1770826" cy="1856967"/>
          </a:xfrm>
        </p:grpSpPr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296D37A3-6C7B-48E1-B58B-963824D5E9B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635625" y="2970708"/>
              <a:ext cx="1177403" cy="1166400"/>
            </a:xfrm>
            <a:prstGeom prst="rect">
              <a:avLst/>
            </a:prstGeom>
          </p:spPr>
        </p:pic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D4B17F64-05EC-41C8-A835-82BA65E338EA}"/>
                </a:ext>
              </a:extLst>
            </p:cNvPr>
            <p:cNvSpPr txBox="1"/>
            <p:nvPr/>
          </p:nvSpPr>
          <p:spPr>
            <a:xfrm rot="16200000">
              <a:off x="3368317" y="3404341"/>
              <a:ext cx="16556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/>
                <a:t>% of sub </a:t>
              </a:r>
              <a:r>
                <a:rPr lang="it-IT" sz="1200" dirty="0" err="1"/>
                <a:t>diploid</a:t>
              </a:r>
              <a:r>
                <a:rPr lang="it-IT" sz="1200" dirty="0"/>
                <a:t> </a:t>
              </a:r>
              <a:r>
                <a:rPr lang="it-IT" sz="1200" dirty="0" err="1"/>
                <a:t>peak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A2F0D6A8-373F-4329-A8B9-25DC85AED1B4}"/>
                </a:ext>
              </a:extLst>
            </p:cNvPr>
            <p:cNvSpPr txBox="1"/>
            <p:nvPr/>
          </p:nvSpPr>
          <p:spPr>
            <a:xfrm>
              <a:off x="4719205" y="409942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</a:t>
              </a:r>
            </a:p>
          </p:txBody>
        </p:sp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D6621BD0-75C8-426D-B2B6-A04B4F6D83CB}"/>
                </a:ext>
              </a:extLst>
            </p:cNvPr>
            <p:cNvSpPr txBox="1"/>
            <p:nvPr/>
          </p:nvSpPr>
          <p:spPr>
            <a:xfrm>
              <a:off x="4214892" y="3406291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0.0</a:t>
              </a:r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FF7E894A-E59E-441F-87C8-A482FF038306}"/>
                </a:ext>
              </a:extLst>
            </p:cNvPr>
            <p:cNvSpPr txBox="1"/>
            <p:nvPr/>
          </p:nvSpPr>
          <p:spPr>
            <a:xfrm>
              <a:off x="4299850" y="3934365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3830807B-C6DB-4151-A0CE-E81245C68F0C}"/>
                </a:ext>
              </a:extLst>
            </p:cNvPr>
            <p:cNvSpPr txBox="1"/>
            <p:nvPr/>
          </p:nvSpPr>
          <p:spPr>
            <a:xfrm>
              <a:off x="4808654" y="4295001"/>
              <a:ext cx="83586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it-IT" sz="1200" dirty="0"/>
                <a:t> Tel (</a:t>
              </a:r>
              <a:r>
                <a:rPr lang="el-G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it-IT" sz="1200" dirty="0"/>
                <a:t>M)</a:t>
              </a:r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DE48DBFB-254E-4A78-B8CA-5029E2BAA069}"/>
                </a:ext>
              </a:extLst>
            </p:cNvPr>
            <p:cNvSpPr txBox="1"/>
            <p:nvPr/>
          </p:nvSpPr>
          <p:spPr>
            <a:xfrm>
              <a:off x="4214892" y="2841501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20.0</a:t>
              </a: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0A2E551C-418C-44EE-9F02-80CF58A2A16D}"/>
                </a:ext>
              </a:extLst>
            </p:cNvPr>
            <p:cNvSpPr txBox="1"/>
            <p:nvPr/>
          </p:nvSpPr>
          <p:spPr>
            <a:xfrm>
              <a:off x="4903147" y="409942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0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E087C7B1-8665-40C2-AA53-8C6D4D1A704B}"/>
                </a:ext>
              </a:extLst>
            </p:cNvPr>
            <p:cNvSpPr txBox="1"/>
            <p:nvPr/>
          </p:nvSpPr>
          <p:spPr>
            <a:xfrm>
              <a:off x="5181778" y="409942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20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89491D4D-A6FE-4392-92CF-1D64BB0CDB03}"/>
                </a:ext>
              </a:extLst>
            </p:cNvPr>
            <p:cNvSpPr txBox="1"/>
            <p:nvPr/>
          </p:nvSpPr>
          <p:spPr>
            <a:xfrm>
              <a:off x="5440204" y="409942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40</a:t>
              </a:r>
            </a:p>
          </p:txBody>
        </p:sp>
        <p:cxnSp>
          <p:nvCxnSpPr>
            <p:cNvPr id="13" name="Connettore diritto 12">
              <a:extLst>
                <a:ext uri="{FF2B5EF4-FFF2-40B4-BE49-F238E27FC236}">
                  <a16:creationId xmlns:a16="http://schemas.microsoft.com/office/drawing/2014/main" id="{990AD752-65B6-4FE6-8D5D-D588F7048BF8}"/>
                </a:ext>
              </a:extLst>
            </p:cNvPr>
            <p:cNvCxnSpPr>
              <a:cxnSpLocks/>
            </p:cNvCxnSpPr>
            <p:nvPr/>
          </p:nvCxnSpPr>
          <p:spPr>
            <a:xfrm>
              <a:off x="4854018" y="4338326"/>
              <a:ext cx="76347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C158FDAF-C8A9-4241-8A5F-AF2BA97AAC66}"/>
                </a:ext>
              </a:extLst>
            </p:cNvPr>
            <p:cNvSpPr txBox="1"/>
            <p:nvPr/>
          </p:nvSpPr>
          <p:spPr>
            <a:xfrm>
              <a:off x="5148115" y="3203848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**</a:t>
              </a:r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9B28DED5-DE34-4C6C-8D2E-DB4DA2CA7BD8}"/>
                </a:ext>
              </a:extLst>
            </p:cNvPr>
            <p:cNvSpPr txBox="1"/>
            <p:nvPr/>
          </p:nvSpPr>
          <p:spPr>
            <a:xfrm>
              <a:off x="5406541" y="2843808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**</a:t>
              </a:r>
            </a:p>
          </p:txBody>
        </p:sp>
      </p:grp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2C412CC6-2FE3-4BC5-8A8C-6704728B72B4}"/>
              </a:ext>
            </a:extLst>
          </p:cNvPr>
          <p:cNvSpPr txBox="1"/>
          <p:nvPr/>
        </p:nvSpPr>
        <p:spPr>
          <a:xfrm>
            <a:off x="56408" y="441836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a)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CB462BA4-0EAA-4B2B-8756-32B78EB0FB49}"/>
              </a:ext>
            </a:extLst>
          </p:cNvPr>
          <p:cNvSpPr txBox="1"/>
          <p:nvPr/>
        </p:nvSpPr>
        <p:spPr>
          <a:xfrm>
            <a:off x="56408" y="4244363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b)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9D9F9DC0-025B-4422-B22F-4ED437B44102}"/>
              </a:ext>
            </a:extLst>
          </p:cNvPr>
          <p:cNvSpPr txBox="1"/>
          <p:nvPr/>
        </p:nvSpPr>
        <p:spPr>
          <a:xfrm>
            <a:off x="4106914" y="441836"/>
            <a:ext cx="4926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/>
              <a:t>(</a:t>
            </a:r>
            <a:r>
              <a:rPr lang="it-IT" sz="1000" b="1" dirty="0" err="1"/>
              <a:t>a’</a:t>
            </a:r>
            <a:r>
              <a:rPr lang="it-IT" sz="1000" b="1" dirty="0"/>
              <a:t>)</a:t>
            </a:r>
          </a:p>
        </p:txBody>
      </p:sp>
      <p:grpSp>
        <p:nvGrpSpPr>
          <p:cNvPr id="19" name="Gruppo 18">
            <a:extLst>
              <a:ext uri="{FF2B5EF4-FFF2-40B4-BE49-F238E27FC236}">
                <a16:creationId xmlns:a16="http://schemas.microsoft.com/office/drawing/2014/main" id="{F19430C4-FBC8-4EAE-B3EE-65C524F726E5}"/>
              </a:ext>
            </a:extLst>
          </p:cNvPr>
          <p:cNvGrpSpPr/>
          <p:nvPr/>
        </p:nvGrpSpPr>
        <p:grpSpPr>
          <a:xfrm>
            <a:off x="134928" y="692277"/>
            <a:ext cx="1794741" cy="1833320"/>
            <a:chOff x="176485" y="2014129"/>
            <a:chExt cx="1794741" cy="1833320"/>
          </a:xfrm>
        </p:grpSpPr>
        <p:grpSp>
          <p:nvGrpSpPr>
            <p:cNvPr id="20" name="Gruppo 19">
              <a:extLst>
                <a:ext uri="{FF2B5EF4-FFF2-40B4-BE49-F238E27FC236}">
                  <a16:creationId xmlns:a16="http://schemas.microsoft.com/office/drawing/2014/main" id="{76E7C58C-9296-4214-9DAA-7BE79C625B8B}"/>
                </a:ext>
              </a:extLst>
            </p:cNvPr>
            <p:cNvGrpSpPr/>
            <p:nvPr/>
          </p:nvGrpSpPr>
          <p:grpSpPr>
            <a:xfrm>
              <a:off x="176485" y="2014129"/>
              <a:ext cx="1785511" cy="1833320"/>
              <a:chOff x="-64359" y="2540764"/>
              <a:chExt cx="1785511" cy="1833320"/>
            </a:xfrm>
          </p:grpSpPr>
          <p:pic>
            <p:nvPicPr>
              <p:cNvPr id="22" name="Immagine 21">
                <a:extLst>
                  <a:ext uri="{FF2B5EF4-FFF2-40B4-BE49-F238E27FC236}">
                    <a16:creationId xmlns:a16="http://schemas.microsoft.com/office/drawing/2014/main" id="{31DD98A5-97CF-4FE7-AF7A-4F3001A2089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81152" y="2545153"/>
                <a:ext cx="1440000" cy="1417847"/>
              </a:xfrm>
              <a:prstGeom prst="rect">
                <a:avLst/>
              </a:prstGeom>
            </p:spPr>
          </p:pic>
          <p:sp>
            <p:nvSpPr>
              <p:cNvPr id="23" name="CasellaDiTesto 22">
                <a:extLst>
                  <a:ext uri="{FF2B5EF4-FFF2-40B4-BE49-F238E27FC236}">
                    <a16:creationId xmlns:a16="http://schemas.microsoft.com/office/drawing/2014/main" id="{480A0642-F990-4F75-B6AE-3C0AC457F349}"/>
                  </a:ext>
                </a:extLst>
              </p:cNvPr>
              <p:cNvSpPr txBox="1"/>
              <p:nvPr/>
            </p:nvSpPr>
            <p:spPr>
              <a:xfrm rot="16200000">
                <a:off x="-189307" y="3083808"/>
                <a:ext cx="52689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/>
                  <a:t>FSC</a:t>
                </a:r>
                <a:endParaRPr lang="it-IT" sz="1200" dirty="0">
                  <a:latin typeface="+mn-lt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CasellaDiTesto 23">
                <a:extLst>
                  <a:ext uri="{FF2B5EF4-FFF2-40B4-BE49-F238E27FC236}">
                    <a16:creationId xmlns:a16="http://schemas.microsoft.com/office/drawing/2014/main" id="{82E1BB24-B3B4-4BB8-A099-BCE674B8E5DC}"/>
                  </a:ext>
                </a:extLst>
              </p:cNvPr>
              <p:cNvSpPr txBox="1"/>
              <p:nvPr/>
            </p:nvSpPr>
            <p:spPr>
              <a:xfrm rot="16200000">
                <a:off x="8292" y="3372158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200</a:t>
                </a:r>
              </a:p>
            </p:txBody>
          </p:sp>
          <p:sp>
            <p:nvSpPr>
              <p:cNvPr id="25" name="CasellaDiTesto 24">
                <a:extLst>
                  <a:ext uri="{FF2B5EF4-FFF2-40B4-BE49-F238E27FC236}">
                    <a16:creationId xmlns:a16="http://schemas.microsoft.com/office/drawing/2014/main" id="{D58BE646-10A3-4774-BB69-EAC415BD7D53}"/>
                  </a:ext>
                </a:extLst>
              </p:cNvPr>
              <p:cNvSpPr txBox="1"/>
              <p:nvPr/>
            </p:nvSpPr>
            <p:spPr>
              <a:xfrm rot="16200000">
                <a:off x="8292" y="2703291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400</a:t>
                </a:r>
              </a:p>
            </p:txBody>
          </p:sp>
          <p:sp>
            <p:nvSpPr>
              <p:cNvPr id="26" name="CasellaDiTesto 25">
                <a:extLst>
                  <a:ext uri="{FF2B5EF4-FFF2-40B4-BE49-F238E27FC236}">
                    <a16:creationId xmlns:a16="http://schemas.microsoft.com/office/drawing/2014/main" id="{75CF1A0E-CB7A-4AE8-9334-A8FA10C10120}"/>
                  </a:ext>
                </a:extLst>
              </p:cNvPr>
              <p:cNvSpPr txBox="1"/>
              <p:nvPr/>
            </p:nvSpPr>
            <p:spPr>
              <a:xfrm>
                <a:off x="372914" y="3941488"/>
                <a:ext cx="4122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0</a:t>
                </a:r>
                <a:r>
                  <a:rPr lang="it-IT" sz="1200" baseline="30000" dirty="0"/>
                  <a:t>2</a:t>
                </a:r>
              </a:p>
            </p:txBody>
          </p:sp>
          <p:sp>
            <p:nvSpPr>
              <p:cNvPr id="27" name="CasellaDiTesto 26">
                <a:extLst>
                  <a:ext uri="{FF2B5EF4-FFF2-40B4-BE49-F238E27FC236}">
                    <a16:creationId xmlns:a16="http://schemas.microsoft.com/office/drawing/2014/main" id="{3D5AD23D-892A-45CF-A706-09CB87EC493E}"/>
                  </a:ext>
                </a:extLst>
              </p:cNvPr>
              <p:cNvSpPr txBox="1"/>
              <p:nvPr/>
            </p:nvSpPr>
            <p:spPr>
              <a:xfrm>
                <a:off x="1221271" y="3941488"/>
                <a:ext cx="4122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0</a:t>
                </a:r>
                <a:r>
                  <a:rPr lang="it-IT" sz="1200" baseline="30000" dirty="0"/>
                  <a:t>6</a:t>
                </a:r>
              </a:p>
            </p:txBody>
          </p:sp>
          <p:sp>
            <p:nvSpPr>
              <p:cNvPr id="28" name="CasellaDiTesto 27">
                <a:extLst>
                  <a:ext uri="{FF2B5EF4-FFF2-40B4-BE49-F238E27FC236}">
                    <a16:creationId xmlns:a16="http://schemas.microsoft.com/office/drawing/2014/main" id="{7101BE7F-F4DE-42B1-BF86-BB79BD4A2583}"/>
                  </a:ext>
                </a:extLst>
              </p:cNvPr>
              <p:cNvSpPr txBox="1"/>
              <p:nvPr/>
            </p:nvSpPr>
            <p:spPr>
              <a:xfrm>
                <a:off x="802039" y="3941488"/>
                <a:ext cx="4122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0</a:t>
                </a:r>
                <a:r>
                  <a:rPr lang="it-IT" sz="1200" baseline="30000" dirty="0"/>
                  <a:t>4</a:t>
                </a:r>
              </a:p>
            </p:txBody>
          </p:sp>
          <p:sp>
            <p:nvSpPr>
              <p:cNvPr id="29" name="CasellaDiTesto 28">
                <a:extLst>
                  <a:ext uri="{FF2B5EF4-FFF2-40B4-BE49-F238E27FC236}">
                    <a16:creationId xmlns:a16="http://schemas.microsoft.com/office/drawing/2014/main" id="{37AFAC89-8279-4F2C-9E80-625E1148F735}"/>
                  </a:ext>
                </a:extLst>
              </p:cNvPr>
              <p:cNvSpPr txBox="1"/>
              <p:nvPr/>
            </p:nvSpPr>
            <p:spPr>
              <a:xfrm>
                <a:off x="733531" y="4097085"/>
                <a:ext cx="52689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/>
                  <a:t>PE</a:t>
                </a:r>
                <a:endParaRPr lang="it-IT" sz="1200" dirty="0">
                  <a:latin typeface="+mn-lt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CasellaDiTesto 29">
                <a:extLst>
                  <a:ext uri="{FF2B5EF4-FFF2-40B4-BE49-F238E27FC236}">
                    <a16:creationId xmlns:a16="http://schemas.microsoft.com/office/drawing/2014/main" id="{BBB01764-AF33-4EB3-B0C0-B3AAF33E4533}"/>
                  </a:ext>
                </a:extLst>
              </p:cNvPr>
              <p:cNvSpPr txBox="1"/>
              <p:nvPr/>
            </p:nvSpPr>
            <p:spPr>
              <a:xfrm>
                <a:off x="446771" y="2540764"/>
                <a:ext cx="63986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>
                    <a:solidFill>
                      <a:srgbClr val="FF9933"/>
                    </a:solidFill>
                  </a:rPr>
                  <a:t>4,90%</a:t>
                </a:r>
                <a:endParaRPr lang="it-IT" sz="1200" dirty="0">
                  <a:solidFill>
                    <a:srgbClr val="FF9933"/>
                  </a:solidFill>
                  <a:latin typeface="+mn-lt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9B8FCA8D-1544-40D6-A4F2-F13C1CB17611}"/>
                </a:ext>
              </a:extLst>
            </p:cNvPr>
            <p:cNvSpPr txBox="1"/>
            <p:nvPr/>
          </p:nvSpPr>
          <p:spPr>
            <a:xfrm rot="16200000">
              <a:off x="1569279" y="3136482"/>
              <a:ext cx="5268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0</a:t>
              </a:r>
              <a:endParaRPr lang="it-IT" sz="1200" b="1" dirty="0">
                <a:latin typeface="+mn-lt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1" name="Gruppo 30">
            <a:extLst>
              <a:ext uri="{FF2B5EF4-FFF2-40B4-BE49-F238E27FC236}">
                <a16:creationId xmlns:a16="http://schemas.microsoft.com/office/drawing/2014/main" id="{62A4D444-A841-45C0-9DF5-29E25A43DB44}"/>
              </a:ext>
            </a:extLst>
          </p:cNvPr>
          <p:cNvGrpSpPr/>
          <p:nvPr/>
        </p:nvGrpSpPr>
        <p:grpSpPr>
          <a:xfrm>
            <a:off x="2158419" y="692277"/>
            <a:ext cx="1785511" cy="1833320"/>
            <a:chOff x="2199976" y="2014129"/>
            <a:chExt cx="1785511" cy="1833320"/>
          </a:xfrm>
        </p:grpSpPr>
        <p:grpSp>
          <p:nvGrpSpPr>
            <p:cNvPr id="32" name="Gruppo 31">
              <a:extLst>
                <a:ext uri="{FF2B5EF4-FFF2-40B4-BE49-F238E27FC236}">
                  <a16:creationId xmlns:a16="http://schemas.microsoft.com/office/drawing/2014/main" id="{4CFFF11F-9924-4C29-ACB3-25CA3D693CAD}"/>
                </a:ext>
              </a:extLst>
            </p:cNvPr>
            <p:cNvGrpSpPr/>
            <p:nvPr/>
          </p:nvGrpSpPr>
          <p:grpSpPr>
            <a:xfrm>
              <a:off x="2199976" y="2014129"/>
              <a:ext cx="1785511" cy="1833320"/>
              <a:chOff x="1692157" y="2540764"/>
              <a:chExt cx="1785511" cy="1833320"/>
            </a:xfrm>
          </p:grpSpPr>
          <p:pic>
            <p:nvPicPr>
              <p:cNvPr id="34" name="Immagine 33">
                <a:extLst>
                  <a:ext uri="{FF2B5EF4-FFF2-40B4-BE49-F238E27FC236}">
                    <a16:creationId xmlns:a16="http://schemas.microsoft.com/office/drawing/2014/main" id="{AD5F9ED2-AF86-417D-9370-2F187EFFE80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037668" y="2545153"/>
                <a:ext cx="1440000" cy="1417847"/>
              </a:xfrm>
              <a:prstGeom prst="rect">
                <a:avLst/>
              </a:prstGeom>
            </p:spPr>
          </p:pic>
          <p:sp>
            <p:nvSpPr>
              <p:cNvPr id="35" name="CasellaDiTesto 34">
                <a:extLst>
                  <a:ext uri="{FF2B5EF4-FFF2-40B4-BE49-F238E27FC236}">
                    <a16:creationId xmlns:a16="http://schemas.microsoft.com/office/drawing/2014/main" id="{B7F972FD-4DF2-48D8-A3C8-36BB19B359BD}"/>
                  </a:ext>
                </a:extLst>
              </p:cNvPr>
              <p:cNvSpPr txBox="1"/>
              <p:nvPr/>
            </p:nvSpPr>
            <p:spPr>
              <a:xfrm rot="16200000">
                <a:off x="1567209" y="3083808"/>
                <a:ext cx="52689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/>
                  <a:t>FSC</a:t>
                </a:r>
                <a:endParaRPr lang="it-IT" sz="1200" dirty="0">
                  <a:latin typeface="+mn-lt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CasellaDiTesto 35">
                <a:extLst>
                  <a:ext uri="{FF2B5EF4-FFF2-40B4-BE49-F238E27FC236}">
                    <a16:creationId xmlns:a16="http://schemas.microsoft.com/office/drawing/2014/main" id="{58A04907-BD4E-42AE-BA61-54D03204B2FA}"/>
                  </a:ext>
                </a:extLst>
              </p:cNvPr>
              <p:cNvSpPr txBox="1"/>
              <p:nvPr/>
            </p:nvSpPr>
            <p:spPr>
              <a:xfrm rot="16200000">
                <a:off x="1764808" y="3372158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200</a:t>
                </a:r>
              </a:p>
            </p:txBody>
          </p:sp>
          <p:sp>
            <p:nvSpPr>
              <p:cNvPr id="37" name="CasellaDiTesto 36">
                <a:extLst>
                  <a:ext uri="{FF2B5EF4-FFF2-40B4-BE49-F238E27FC236}">
                    <a16:creationId xmlns:a16="http://schemas.microsoft.com/office/drawing/2014/main" id="{EE7EBAC0-AE1B-4A3E-988B-288334EF9554}"/>
                  </a:ext>
                </a:extLst>
              </p:cNvPr>
              <p:cNvSpPr txBox="1"/>
              <p:nvPr/>
            </p:nvSpPr>
            <p:spPr>
              <a:xfrm rot="16200000">
                <a:off x="1764808" y="2703291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400</a:t>
                </a:r>
              </a:p>
            </p:txBody>
          </p:sp>
          <p:sp>
            <p:nvSpPr>
              <p:cNvPr id="38" name="CasellaDiTesto 37">
                <a:extLst>
                  <a:ext uri="{FF2B5EF4-FFF2-40B4-BE49-F238E27FC236}">
                    <a16:creationId xmlns:a16="http://schemas.microsoft.com/office/drawing/2014/main" id="{6FC6974D-01EB-4414-A617-39358607658B}"/>
                  </a:ext>
                </a:extLst>
              </p:cNvPr>
              <p:cNvSpPr txBox="1"/>
              <p:nvPr/>
            </p:nvSpPr>
            <p:spPr>
              <a:xfrm>
                <a:off x="2129430" y="3941488"/>
                <a:ext cx="4122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0</a:t>
                </a:r>
                <a:r>
                  <a:rPr lang="it-IT" sz="1200" baseline="30000" dirty="0"/>
                  <a:t>2</a:t>
                </a:r>
              </a:p>
            </p:txBody>
          </p:sp>
          <p:sp>
            <p:nvSpPr>
              <p:cNvPr id="39" name="CasellaDiTesto 38">
                <a:extLst>
                  <a:ext uri="{FF2B5EF4-FFF2-40B4-BE49-F238E27FC236}">
                    <a16:creationId xmlns:a16="http://schemas.microsoft.com/office/drawing/2014/main" id="{F9B0B322-1FDF-498A-86AA-F961D72D6C26}"/>
                  </a:ext>
                </a:extLst>
              </p:cNvPr>
              <p:cNvSpPr txBox="1"/>
              <p:nvPr/>
            </p:nvSpPr>
            <p:spPr>
              <a:xfrm>
                <a:off x="2977787" y="3941488"/>
                <a:ext cx="4122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0</a:t>
                </a:r>
                <a:r>
                  <a:rPr lang="it-IT" sz="1200" baseline="30000" dirty="0"/>
                  <a:t>6</a:t>
                </a:r>
              </a:p>
            </p:txBody>
          </p:sp>
          <p:sp>
            <p:nvSpPr>
              <p:cNvPr id="40" name="CasellaDiTesto 39">
                <a:extLst>
                  <a:ext uri="{FF2B5EF4-FFF2-40B4-BE49-F238E27FC236}">
                    <a16:creationId xmlns:a16="http://schemas.microsoft.com/office/drawing/2014/main" id="{CDBF4EB6-EB86-4031-AE40-CA11E84270B0}"/>
                  </a:ext>
                </a:extLst>
              </p:cNvPr>
              <p:cNvSpPr txBox="1"/>
              <p:nvPr/>
            </p:nvSpPr>
            <p:spPr>
              <a:xfrm>
                <a:off x="2558555" y="3941488"/>
                <a:ext cx="4122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0</a:t>
                </a:r>
                <a:r>
                  <a:rPr lang="it-IT" sz="1200" baseline="30000" dirty="0"/>
                  <a:t>4</a:t>
                </a:r>
              </a:p>
            </p:txBody>
          </p:sp>
          <p:sp>
            <p:nvSpPr>
              <p:cNvPr id="41" name="CasellaDiTesto 40">
                <a:extLst>
                  <a:ext uri="{FF2B5EF4-FFF2-40B4-BE49-F238E27FC236}">
                    <a16:creationId xmlns:a16="http://schemas.microsoft.com/office/drawing/2014/main" id="{5F9FB924-335A-4FE6-8073-66AC05D2EEF9}"/>
                  </a:ext>
                </a:extLst>
              </p:cNvPr>
              <p:cNvSpPr txBox="1"/>
              <p:nvPr/>
            </p:nvSpPr>
            <p:spPr>
              <a:xfrm>
                <a:off x="2490047" y="4097085"/>
                <a:ext cx="52689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/>
                  <a:t>PE</a:t>
                </a:r>
                <a:endParaRPr lang="it-IT" sz="1200" dirty="0">
                  <a:latin typeface="+mn-lt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CasellaDiTesto 41">
                <a:extLst>
                  <a:ext uri="{FF2B5EF4-FFF2-40B4-BE49-F238E27FC236}">
                    <a16:creationId xmlns:a16="http://schemas.microsoft.com/office/drawing/2014/main" id="{6D8D2C9F-6534-45EF-9096-69A9C5649270}"/>
                  </a:ext>
                </a:extLst>
              </p:cNvPr>
              <p:cNvSpPr txBox="1"/>
              <p:nvPr/>
            </p:nvSpPr>
            <p:spPr>
              <a:xfrm>
                <a:off x="2203287" y="2540764"/>
                <a:ext cx="63986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>
                    <a:solidFill>
                      <a:srgbClr val="FF9933"/>
                    </a:solidFill>
                  </a:rPr>
                  <a:t>5,78%</a:t>
                </a:r>
                <a:endParaRPr lang="it-IT" sz="1200" dirty="0">
                  <a:solidFill>
                    <a:srgbClr val="FF9933"/>
                  </a:solidFill>
                  <a:latin typeface="+mn-lt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id="{A0F7B88C-8D90-4E66-B21D-1E54C30C0BB4}"/>
                </a:ext>
              </a:extLst>
            </p:cNvPr>
            <p:cNvSpPr txBox="1"/>
            <p:nvPr/>
          </p:nvSpPr>
          <p:spPr>
            <a:xfrm rot="16200000">
              <a:off x="3244824" y="2915178"/>
              <a:ext cx="12010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Tel 10</a:t>
              </a:r>
              <a:r>
                <a:rPr lang="el-G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it-IT" sz="1200" b="1" dirty="0">
                  <a:latin typeface="+mj-lt"/>
                  <a:cs typeface="Times New Roman" panose="02020603050405020304" pitchFamily="18" charset="0"/>
                </a:rPr>
                <a:t>M</a:t>
              </a:r>
            </a:p>
          </p:txBody>
        </p:sp>
      </p:grpSp>
      <p:grpSp>
        <p:nvGrpSpPr>
          <p:cNvPr id="43" name="Gruppo 42">
            <a:extLst>
              <a:ext uri="{FF2B5EF4-FFF2-40B4-BE49-F238E27FC236}">
                <a16:creationId xmlns:a16="http://schemas.microsoft.com/office/drawing/2014/main" id="{96953F45-2CE4-4B60-B67E-29E713A61D2E}"/>
              </a:ext>
            </a:extLst>
          </p:cNvPr>
          <p:cNvGrpSpPr/>
          <p:nvPr/>
        </p:nvGrpSpPr>
        <p:grpSpPr>
          <a:xfrm>
            <a:off x="2158419" y="2606892"/>
            <a:ext cx="1785511" cy="1833320"/>
            <a:chOff x="2199976" y="3928744"/>
            <a:chExt cx="1785511" cy="1833320"/>
          </a:xfrm>
        </p:grpSpPr>
        <p:grpSp>
          <p:nvGrpSpPr>
            <p:cNvPr id="44" name="Gruppo 43">
              <a:extLst>
                <a:ext uri="{FF2B5EF4-FFF2-40B4-BE49-F238E27FC236}">
                  <a16:creationId xmlns:a16="http://schemas.microsoft.com/office/drawing/2014/main" id="{2799C63A-C347-4E57-A1B9-2B92F920472A}"/>
                </a:ext>
              </a:extLst>
            </p:cNvPr>
            <p:cNvGrpSpPr/>
            <p:nvPr/>
          </p:nvGrpSpPr>
          <p:grpSpPr>
            <a:xfrm>
              <a:off x="2199976" y="3928744"/>
              <a:ext cx="1785511" cy="1833320"/>
              <a:chOff x="813780" y="4224951"/>
              <a:chExt cx="1785511" cy="1833320"/>
            </a:xfrm>
          </p:grpSpPr>
          <p:pic>
            <p:nvPicPr>
              <p:cNvPr id="46" name="Immagine 45">
                <a:extLst>
                  <a:ext uri="{FF2B5EF4-FFF2-40B4-BE49-F238E27FC236}">
                    <a16:creationId xmlns:a16="http://schemas.microsoft.com/office/drawing/2014/main" id="{A0B57B78-0C29-4E9F-A723-6AD08B3183F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159291" y="4229340"/>
                <a:ext cx="1440000" cy="1417847"/>
              </a:xfrm>
              <a:prstGeom prst="rect">
                <a:avLst/>
              </a:prstGeom>
            </p:spPr>
          </p:pic>
          <p:sp>
            <p:nvSpPr>
              <p:cNvPr id="47" name="CasellaDiTesto 46">
                <a:extLst>
                  <a:ext uri="{FF2B5EF4-FFF2-40B4-BE49-F238E27FC236}">
                    <a16:creationId xmlns:a16="http://schemas.microsoft.com/office/drawing/2014/main" id="{A2EE8B45-9244-4B4E-A424-229C93BAAF74}"/>
                  </a:ext>
                </a:extLst>
              </p:cNvPr>
              <p:cNvSpPr txBox="1"/>
              <p:nvPr/>
            </p:nvSpPr>
            <p:spPr>
              <a:xfrm rot="16200000">
                <a:off x="688832" y="4767995"/>
                <a:ext cx="52689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/>
                  <a:t>FSC</a:t>
                </a:r>
                <a:endParaRPr lang="it-IT" sz="1200" dirty="0">
                  <a:latin typeface="+mn-lt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CasellaDiTesto 47">
                <a:extLst>
                  <a:ext uri="{FF2B5EF4-FFF2-40B4-BE49-F238E27FC236}">
                    <a16:creationId xmlns:a16="http://schemas.microsoft.com/office/drawing/2014/main" id="{9E588C35-CA89-43D9-8411-A1033A0D78B0}"/>
                  </a:ext>
                </a:extLst>
              </p:cNvPr>
              <p:cNvSpPr txBox="1"/>
              <p:nvPr/>
            </p:nvSpPr>
            <p:spPr>
              <a:xfrm rot="16200000">
                <a:off x="886431" y="5056345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200</a:t>
                </a:r>
              </a:p>
            </p:txBody>
          </p:sp>
          <p:sp>
            <p:nvSpPr>
              <p:cNvPr id="49" name="CasellaDiTesto 48">
                <a:extLst>
                  <a:ext uri="{FF2B5EF4-FFF2-40B4-BE49-F238E27FC236}">
                    <a16:creationId xmlns:a16="http://schemas.microsoft.com/office/drawing/2014/main" id="{FF5595C0-EFBC-4D21-9CB9-1D92BD0AC840}"/>
                  </a:ext>
                </a:extLst>
              </p:cNvPr>
              <p:cNvSpPr txBox="1"/>
              <p:nvPr/>
            </p:nvSpPr>
            <p:spPr>
              <a:xfrm rot="16200000">
                <a:off x="886431" y="4387478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400</a:t>
                </a:r>
              </a:p>
            </p:txBody>
          </p:sp>
          <p:sp>
            <p:nvSpPr>
              <p:cNvPr id="50" name="CasellaDiTesto 49">
                <a:extLst>
                  <a:ext uri="{FF2B5EF4-FFF2-40B4-BE49-F238E27FC236}">
                    <a16:creationId xmlns:a16="http://schemas.microsoft.com/office/drawing/2014/main" id="{2F1FA737-F4DC-49B9-BB05-31C800A21CDC}"/>
                  </a:ext>
                </a:extLst>
              </p:cNvPr>
              <p:cNvSpPr txBox="1"/>
              <p:nvPr/>
            </p:nvSpPr>
            <p:spPr>
              <a:xfrm>
                <a:off x="1251053" y="5625675"/>
                <a:ext cx="4122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0</a:t>
                </a:r>
                <a:r>
                  <a:rPr lang="it-IT" sz="1200" baseline="30000" dirty="0"/>
                  <a:t>2</a:t>
                </a:r>
              </a:p>
            </p:txBody>
          </p:sp>
          <p:sp>
            <p:nvSpPr>
              <p:cNvPr id="51" name="CasellaDiTesto 50">
                <a:extLst>
                  <a:ext uri="{FF2B5EF4-FFF2-40B4-BE49-F238E27FC236}">
                    <a16:creationId xmlns:a16="http://schemas.microsoft.com/office/drawing/2014/main" id="{76BDBA03-2FB4-4E7B-98E2-F60985C825D5}"/>
                  </a:ext>
                </a:extLst>
              </p:cNvPr>
              <p:cNvSpPr txBox="1"/>
              <p:nvPr/>
            </p:nvSpPr>
            <p:spPr>
              <a:xfrm>
                <a:off x="2099410" y="5625675"/>
                <a:ext cx="4122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0</a:t>
                </a:r>
                <a:r>
                  <a:rPr lang="it-IT" sz="1200" baseline="30000" dirty="0"/>
                  <a:t>6</a:t>
                </a:r>
              </a:p>
            </p:txBody>
          </p:sp>
          <p:sp>
            <p:nvSpPr>
              <p:cNvPr id="52" name="CasellaDiTesto 51">
                <a:extLst>
                  <a:ext uri="{FF2B5EF4-FFF2-40B4-BE49-F238E27FC236}">
                    <a16:creationId xmlns:a16="http://schemas.microsoft.com/office/drawing/2014/main" id="{88984384-FC68-413A-803D-2EEFFAD7B376}"/>
                  </a:ext>
                </a:extLst>
              </p:cNvPr>
              <p:cNvSpPr txBox="1"/>
              <p:nvPr/>
            </p:nvSpPr>
            <p:spPr>
              <a:xfrm>
                <a:off x="1680178" y="5625675"/>
                <a:ext cx="4122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0</a:t>
                </a:r>
                <a:r>
                  <a:rPr lang="it-IT" sz="1200" baseline="30000" dirty="0"/>
                  <a:t>4</a:t>
                </a:r>
              </a:p>
            </p:txBody>
          </p:sp>
          <p:sp>
            <p:nvSpPr>
              <p:cNvPr id="53" name="CasellaDiTesto 52">
                <a:extLst>
                  <a:ext uri="{FF2B5EF4-FFF2-40B4-BE49-F238E27FC236}">
                    <a16:creationId xmlns:a16="http://schemas.microsoft.com/office/drawing/2014/main" id="{08B610D3-3BBD-4878-A7BD-2B4655EABCAC}"/>
                  </a:ext>
                </a:extLst>
              </p:cNvPr>
              <p:cNvSpPr txBox="1"/>
              <p:nvPr/>
            </p:nvSpPr>
            <p:spPr>
              <a:xfrm>
                <a:off x="1611670" y="5781272"/>
                <a:ext cx="52689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/>
                  <a:t>PE</a:t>
                </a:r>
                <a:endParaRPr lang="it-IT" sz="1200" dirty="0">
                  <a:latin typeface="+mn-lt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CasellaDiTesto 53">
                <a:extLst>
                  <a:ext uri="{FF2B5EF4-FFF2-40B4-BE49-F238E27FC236}">
                    <a16:creationId xmlns:a16="http://schemas.microsoft.com/office/drawing/2014/main" id="{B76C650B-E3F6-48DC-B437-F08B8CD19F05}"/>
                  </a:ext>
                </a:extLst>
              </p:cNvPr>
              <p:cNvSpPr txBox="1"/>
              <p:nvPr/>
            </p:nvSpPr>
            <p:spPr>
              <a:xfrm>
                <a:off x="1324910" y="4224951"/>
                <a:ext cx="74625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>
                    <a:solidFill>
                      <a:srgbClr val="FF9933"/>
                    </a:solidFill>
                  </a:rPr>
                  <a:t>19,89%</a:t>
                </a:r>
                <a:endParaRPr lang="it-IT" sz="1200" dirty="0">
                  <a:solidFill>
                    <a:srgbClr val="FF9933"/>
                  </a:solidFill>
                  <a:latin typeface="+mn-lt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5" name="CasellaDiTesto 44">
              <a:extLst>
                <a:ext uri="{FF2B5EF4-FFF2-40B4-BE49-F238E27FC236}">
                  <a16:creationId xmlns:a16="http://schemas.microsoft.com/office/drawing/2014/main" id="{964D2ECD-92C7-4235-A21C-ACCBAB74FB3C}"/>
                </a:ext>
              </a:extLst>
            </p:cNvPr>
            <p:cNvSpPr txBox="1"/>
            <p:nvPr/>
          </p:nvSpPr>
          <p:spPr>
            <a:xfrm rot="16200000">
              <a:off x="3244825" y="4817144"/>
              <a:ext cx="12010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Tel 40</a:t>
              </a:r>
              <a:r>
                <a:rPr lang="el-G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it-IT" sz="1200" b="1" dirty="0">
                  <a:latin typeface="+mj-lt"/>
                  <a:cs typeface="Times New Roman" panose="02020603050405020304" pitchFamily="18" charset="0"/>
                </a:rPr>
                <a:t>M</a:t>
              </a:r>
            </a:p>
          </p:txBody>
        </p:sp>
      </p:grpSp>
      <p:grpSp>
        <p:nvGrpSpPr>
          <p:cNvPr id="55" name="Gruppo 54">
            <a:extLst>
              <a:ext uri="{FF2B5EF4-FFF2-40B4-BE49-F238E27FC236}">
                <a16:creationId xmlns:a16="http://schemas.microsoft.com/office/drawing/2014/main" id="{1575C35E-584A-40F1-B438-FD221F11FA49}"/>
              </a:ext>
            </a:extLst>
          </p:cNvPr>
          <p:cNvGrpSpPr/>
          <p:nvPr/>
        </p:nvGrpSpPr>
        <p:grpSpPr>
          <a:xfrm>
            <a:off x="134928" y="2606892"/>
            <a:ext cx="1794742" cy="1833320"/>
            <a:chOff x="176485" y="3928744"/>
            <a:chExt cx="1794742" cy="1833320"/>
          </a:xfrm>
        </p:grpSpPr>
        <p:grpSp>
          <p:nvGrpSpPr>
            <p:cNvPr id="56" name="Gruppo 55">
              <a:extLst>
                <a:ext uri="{FF2B5EF4-FFF2-40B4-BE49-F238E27FC236}">
                  <a16:creationId xmlns:a16="http://schemas.microsoft.com/office/drawing/2014/main" id="{E6069AA2-970C-49FC-8F8F-2C0240B3D51C}"/>
                </a:ext>
              </a:extLst>
            </p:cNvPr>
            <p:cNvGrpSpPr/>
            <p:nvPr/>
          </p:nvGrpSpPr>
          <p:grpSpPr>
            <a:xfrm>
              <a:off x="176485" y="3928744"/>
              <a:ext cx="1785511" cy="1833320"/>
              <a:chOff x="-2143773" y="3853930"/>
              <a:chExt cx="1785511" cy="1833320"/>
            </a:xfrm>
          </p:grpSpPr>
          <p:pic>
            <p:nvPicPr>
              <p:cNvPr id="58" name="Immagine 57">
                <a:extLst>
                  <a:ext uri="{FF2B5EF4-FFF2-40B4-BE49-F238E27FC236}">
                    <a16:creationId xmlns:a16="http://schemas.microsoft.com/office/drawing/2014/main" id="{5BFB6100-FEB1-4BC2-92A4-DF8F70EB988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-1798262" y="3858319"/>
                <a:ext cx="1440000" cy="1417847"/>
              </a:xfrm>
              <a:prstGeom prst="rect">
                <a:avLst/>
              </a:prstGeom>
            </p:spPr>
          </p:pic>
          <p:sp>
            <p:nvSpPr>
              <p:cNvPr id="59" name="CasellaDiTesto 58">
                <a:extLst>
                  <a:ext uri="{FF2B5EF4-FFF2-40B4-BE49-F238E27FC236}">
                    <a16:creationId xmlns:a16="http://schemas.microsoft.com/office/drawing/2014/main" id="{30E38861-EC35-4731-84F1-2355B5679DA1}"/>
                  </a:ext>
                </a:extLst>
              </p:cNvPr>
              <p:cNvSpPr txBox="1"/>
              <p:nvPr/>
            </p:nvSpPr>
            <p:spPr>
              <a:xfrm rot="16200000">
                <a:off x="-2268721" y="4396974"/>
                <a:ext cx="52689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/>
                  <a:t>FSC</a:t>
                </a:r>
                <a:endParaRPr lang="it-IT" sz="1200" dirty="0">
                  <a:latin typeface="+mn-lt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CasellaDiTesto 59">
                <a:extLst>
                  <a:ext uri="{FF2B5EF4-FFF2-40B4-BE49-F238E27FC236}">
                    <a16:creationId xmlns:a16="http://schemas.microsoft.com/office/drawing/2014/main" id="{3CBB8E06-BBD7-48AD-9A1B-7BD7899D23DA}"/>
                  </a:ext>
                </a:extLst>
              </p:cNvPr>
              <p:cNvSpPr txBox="1"/>
              <p:nvPr/>
            </p:nvSpPr>
            <p:spPr>
              <a:xfrm rot="16200000">
                <a:off x="-2071122" y="4685324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200</a:t>
                </a:r>
              </a:p>
            </p:txBody>
          </p:sp>
          <p:sp>
            <p:nvSpPr>
              <p:cNvPr id="61" name="CasellaDiTesto 60">
                <a:extLst>
                  <a:ext uri="{FF2B5EF4-FFF2-40B4-BE49-F238E27FC236}">
                    <a16:creationId xmlns:a16="http://schemas.microsoft.com/office/drawing/2014/main" id="{74A2870E-92E7-43D4-81BD-F6F3F3AD0C06}"/>
                  </a:ext>
                </a:extLst>
              </p:cNvPr>
              <p:cNvSpPr txBox="1"/>
              <p:nvPr/>
            </p:nvSpPr>
            <p:spPr>
              <a:xfrm rot="16200000">
                <a:off x="-2071122" y="4016457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400</a:t>
                </a:r>
              </a:p>
            </p:txBody>
          </p:sp>
          <p:sp>
            <p:nvSpPr>
              <p:cNvPr id="62" name="CasellaDiTesto 61">
                <a:extLst>
                  <a:ext uri="{FF2B5EF4-FFF2-40B4-BE49-F238E27FC236}">
                    <a16:creationId xmlns:a16="http://schemas.microsoft.com/office/drawing/2014/main" id="{60C8665F-3B32-4F45-A1C2-56E5BAF71152}"/>
                  </a:ext>
                </a:extLst>
              </p:cNvPr>
              <p:cNvSpPr txBox="1"/>
              <p:nvPr/>
            </p:nvSpPr>
            <p:spPr>
              <a:xfrm>
                <a:off x="-1706500" y="5254654"/>
                <a:ext cx="4122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0</a:t>
                </a:r>
                <a:r>
                  <a:rPr lang="it-IT" sz="1200" baseline="30000" dirty="0"/>
                  <a:t>2</a:t>
                </a:r>
              </a:p>
            </p:txBody>
          </p:sp>
          <p:sp>
            <p:nvSpPr>
              <p:cNvPr id="63" name="CasellaDiTesto 62">
                <a:extLst>
                  <a:ext uri="{FF2B5EF4-FFF2-40B4-BE49-F238E27FC236}">
                    <a16:creationId xmlns:a16="http://schemas.microsoft.com/office/drawing/2014/main" id="{D0211F36-FB82-44D0-88E7-52FC19C2E5B7}"/>
                  </a:ext>
                </a:extLst>
              </p:cNvPr>
              <p:cNvSpPr txBox="1"/>
              <p:nvPr/>
            </p:nvSpPr>
            <p:spPr>
              <a:xfrm>
                <a:off x="-858143" y="5254654"/>
                <a:ext cx="4122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0</a:t>
                </a:r>
                <a:r>
                  <a:rPr lang="it-IT" sz="1200" baseline="30000" dirty="0"/>
                  <a:t>6</a:t>
                </a:r>
              </a:p>
            </p:txBody>
          </p:sp>
          <p:sp>
            <p:nvSpPr>
              <p:cNvPr id="64" name="CasellaDiTesto 63">
                <a:extLst>
                  <a:ext uri="{FF2B5EF4-FFF2-40B4-BE49-F238E27FC236}">
                    <a16:creationId xmlns:a16="http://schemas.microsoft.com/office/drawing/2014/main" id="{B6DDD3A3-32E2-48E4-9E25-63F91CBAE59F}"/>
                  </a:ext>
                </a:extLst>
              </p:cNvPr>
              <p:cNvSpPr txBox="1"/>
              <p:nvPr/>
            </p:nvSpPr>
            <p:spPr>
              <a:xfrm>
                <a:off x="-1277375" y="5254654"/>
                <a:ext cx="4122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0</a:t>
                </a:r>
                <a:r>
                  <a:rPr lang="it-IT" sz="1200" baseline="30000" dirty="0"/>
                  <a:t>4</a:t>
                </a:r>
              </a:p>
            </p:txBody>
          </p:sp>
          <p:sp>
            <p:nvSpPr>
              <p:cNvPr id="65" name="CasellaDiTesto 64">
                <a:extLst>
                  <a:ext uri="{FF2B5EF4-FFF2-40B4-BE49-F238E27FC236}">
                    <a16:creationId xmlns:a16="http://schemas.microsoft.com/office/drawing/2014/main" id="{DA53A709-0696-4CA1-92D3-074239B40452}"/>
                  </a:ext>
                </a:extLst>
              </p:cNvPr>
              <p:cNvSpPr txBox="1"/>
              <p:nvPr/>
            </p:nvSpPr>
            <p:spPr>
              <a:xfrm>
                <a:off x="-1345883" y="5410251"/>
                <a:ext cx="52689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/>
                  <a:t>PE</a:t>
                </a:r>
                <a:endParaRPr lang="it-IT" sz="1200" dirty="0">
                  <a:latin typeface="+mn-lt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" name="CasellaDiTesto 65">
                <a:extLst>
                  <a:ext uri="{FF2B5EF4-FFF2-40B4-BE49-F238E27FC236}">
                    <a16:creationId xmlns:a16="http://schemas.microsoft.com/office/drawing/2014/main" id="{4A544DAA-9B97-4236-94E8-157594EEAAE2}"/>
                  </a:ext>
                </a:extLst>
              </p:cNvPr>
              <p:cNvSpPr txBox="1"/>
              <p:nvPr/>
            </p:nvSpPr>
            <p:spPr>
              <a:xfrm>
                <a:off x="-1632643" y="3853930"/>
                <a:ext cx="74625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>
                    <a:solidFill>
                      <a:srgbClr val="FF9933"/>
                    </a:solidFill>
                  </a:rPr>
                  <a:t>11,54%</a:t>
                </a:r>
                <a:endParaRPr lang="it-IT" sz="1200" dirty="0">
                  <a:solidFill>
                    <a:srgbClr val="FF9933"/>
                  </a:solidFill>
                  <a:latin typeface="+mn-lt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7" name="CasellaDiTesto 56">
              <a:extLst>
                <a:ext uri="{FF2B5EF4-FFF2-40B4-BE49-F238E27FC236}">
                  <a16:creationId xmlns:a16="http://schemas.microsoft.com/office/drawing/2014/main" id="{6E2A3BDA-B4A4-4C95-AA31-F1D8271AB09E}"/>
                </a:ext>
              </a:extLst>
            </p:cNvPr>
            <p:cNvSpPr txBox="1"/>
            <p:nvPr/>
          </p:nvSpPr>
          <p:spPr>
            <a:xfrm rot="16200000">
              <a:off x="1232225" y="4817144"/>
              <a:ext cx="12010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/>
                <a:t>Tel 20</a:t>
              </a:r>
              <a:r>
                <a:rPr lang="el-G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it-IT" sz="1200" b="1" dirty="0">
                  <a:latin typeface="+mj-lt"/>
                  <a:cs typeface="Times New Roman" panose="02020603050405020304" pitchFamily="18" charset="0"/>
                </a:rPr>
                <a:t>M</a:t>
              </a:r>
            </a:p>
          </p:txBody>
        </p:sp>
      </p:grpSp>
      <p:grpSp>
        <p:nvGrpSpPr>
          <p:cNvPr id="67" name="Gruppo 66">
            <a:extLst>
              <a:ext uri="{FF2B5EF4-FFF2-40B4-BE49-F238E27FC236}">
                <a16:creationId xmlns:a16="http://schemas.microsoft.com/office/drawing/2014/main" id="{51684A25-7CE4-468B-A6FC-13B124E27331}"/>
              </a:ext>
            </a:extLst>
          </p:cNvPr>
          <p:cNvGrpSpPr/>
          <p:nvPr/>
        </p:nvGrpSpPr>
        <p:grpSpPr>
          <a:xfrm>
            <a:off x="67255" y="4621188"/>
            <a:ext cx="6668269" cy="3119164"/>
            <a:chOff x="108812" y="5989340"/>
            <a:chExt cx="6668269" cy="3119164"/>
          </a:xfrm>
        </p:grpSpPr>
        <p:pic>
          <p:nvPicPr>
            <p:cNvPr id="68" name="Immagine 67">
              <a:extLst>
                <a:ext uri="{FF2B5EF4-FFF2-40B4-BE49-F238E27FC236}">
                  <a16:creationId xmlns:a16="http://schemas.microsoft.com/office/drawing/2014/main" id="{32452A8A-01E8-47A8-B6C7-A8DB7CB5DFC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465462" y="7668504"/>
              <a:ext cx="1311619" cy="1440000"/>
            </a:xfrm>
            <a:prstGeom prst="rect">
              <a:avLst/>
            </a:prstGeom>
          </p:spPr>
        </p:pic>
        <p:pic>
          <p:nvPicPr>
            <p:cNvPr id="69" name="Immagine 68">
              <a:extLst>
                <a:ext uri="{FF2B5EF4-FFF2-40B4-BE49-F238E27FC236}">
                  <a16:creationId xmlns:a16="http://schemas.microsoft.com/office/drawing/2014/main" id="{37FB062A-27F5-4EA8-BB07-2807FB78B23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785528" y="7668504"/>
              <a:ext cx="1311619" cy="1440000"/>
            </a:xfrm>
            <a:prstGeom prst="rect">
              <a:avLst/>
            </a:prstGeom>
          </p:spPr>
        </p:pic>
        <p:pic>
          <p:nvPicPr>
            <p:cNvPr id="70" name="Immagine 69">
              <a:extLst>
                <a:ext uri="{FF2B5EF4-FFF2-40B4-BE49-F238E27FC236}">
                  <a16:creationId xmlns:a16="http://schemas.microsoft.com/office/drawing/2014/main" id="{DDCBD06D-CD52-468B-A4FF-2C2C1F42CA7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113493" y="7668504"/>
              <a:ext cx="1311619" cy="1440000"/>
            </a:xfrm>
            <a:prstGeom prst="rect">
              <a:avLst/>
            </a:prstGeom>
          </p:spPr>
        </p:pic>
        <p:grpSp>
          <p:nvGrpSpPr>
            <p:cNvPr id="71" name="Gruppo 70">
              <a:extLst>
                <a:ext uri="{FF2B5EF4-FFF2-40B4-BE49-F238E27FC236}">
                  <a16:creationId xmlns:a16="http://schemas.microsoft.com/office/drawing/2014/main" id="{4CBECAA3-CD59-4C08-B80D-99C4CB31570E}"/>
                </a:ext>
              </a:extLst>
            </p:cNvPr>
            <p:cNvGrpSpPr/>
            <p:nvPr/>
          </p:nvGrpSpPr>
          <p:grpSpPr>
            <a:xfrm>
              <a:off x="5154648" y="6017551"/>
              <a:ext cx="1622433" cy="1620000"/>
              <a:chOff x="-2206295" y="6300192"/>
              <a:chExt cx="1622433" cy="1620000"/>
            </a:xfrm>
          </p:grpSpPr>
          <p:pic>
            <p:nvPicPr>
              <p:cNvPr id="121" name="Immagine 120">
                <a:extLst>
                  <a:ext uri="{FF2B5EF4-FFF2-40B4-BE49-F238E27FC236}">
                    <a16:creationId xmlns:a16="http://schemas.microsoft.com/office/drawing/2014/main" id="{DE639F3C-F477-475E-92CF-9E576390A9B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-2206295" y="6300192"/>
                <a:ext cx="1622433" cy="1620000"/>
              </a:xfrm>
              <a:prstGeom prst="rect">
                <a:avLst/>
              </a:prstGeom>
            </p:spPr>
          </p:pic>
          <p:sp>
            <p:nvSpPr>
              <p:cNvPr id="122" name="Rettangolo 121">
                <a:extLst>
                  <a:ext uri="{FF2B5EF4-FFF2-40B4-BE49-F238E27FC236}">
                    <a16:creationId xmlns:a16="http://schemas.microsoft.com/office/drawing/2014/main" id="{E439406F-BD93-4D02-8552-B42716EEEADD}"/>
                  </a:ext>
                </a:extLst>
              </p:cNvPr>
              <p:cNvSpPr/>
              <p:nvPr/>
            </p:nvSpPr>
            <p:spPr>
              <a:xfrm>
                <a:off x="-1448149" y="6966444"/>
                <a:ext cx="253213" cy="254611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72" name="Gruppo 71">
              <a:extLst>
                <a:ext uri="{FF2B5EF4-FFF2-40B4-BE49-F238E27FC236}">
                  <a16:creationId xmlns:a16="http://schemas.microsoft.com/office/drawing/2014/main" id="{5053D13E-4003-49A1-B29E-13A432FCE7A6}"/>
                </a:ext>
              </a:extLst>
            </p:cNvPr>
            <p:cNvGrpSpPr/>
            <p:nvPr/>
          </p:nvGrpSpPr>
          <p:grpSpPr>
            <a:xfrm>
              <a:off x="3474714" y="6017551"/>
              <a:ext cx="1622433" cy="1620000"/>
              <a:chOff x="-1395079" y="4141961"/>
              <a:chExt cx="1622433" cy="1620000"/>
            </a:xfrm>
          </p:grpSpPr>
          <p:pic>
            <p:nvPicPr>
              <p:cNvPr id="119" name="Immagine 118">
                <a:extLst>
                  <a:ext uri="{FF2B5EF4-FFF2-40B4-BE49-F238E27FC236}">
                    <a16:creationId xmlns:a16="http://schemas.microsoft.com/office/drawing/2014/main" id="{DCE165A3-3ABD-4821-A11F-B23A2751157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-1395079" y="4141961"/>
                <a:ext cx="1622433" cy="1620000"/>
              </a:xfrm>
              <a:prstGeom prst="rect">
                <a:avLst/>
              </a:prstGeom>
            </p:spPr>
          </p:pic>
          <p:sp>
            <p:nvSpPr>
              <p:cNvPr id="120" name="Rettangolo 119">
                <a:extLst>
                  <a:ext uri="{FF2B5EF4-FFF2-40B4-BE49-F238E27FC236}">
                    <a16:creationId xmlns:a16="http://schemas.microsoft.com/office/drawing/2014/main" id="{27871BFB-8D66-4BBA-9981-AE284BF48062}"/>
                  </a:ext>
                </a:extLst>
              </p:cNvPr>
              <p:cNvSpPr/>
              <p:nvPr/>
            </p:nvSpPr>
            <p:spPr>
              <a:xfrm>
                <a:off x="-749977" y="4864001"/>
                <a:ext cx="253213" cy="234950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73" name="Gruppo 72">
              <a:extLst>
                <a:ext uri="{FF2B5EF4-FFF2-40B4-BE49-F238E27FC236}">
                  <a16:creationId xmlns:a16="http://schemas.microsoft.com/office/drawing/2014/main" id="{97C9707A-A8D1-4B41-86AE-20A76BD489C6}"/>
                </a:ext>
              </a:extLst>
            </p:cNvPr>
            <p:cNvGrpSpPr/>
            <p:nvPr/>
          </p:nvGrpSpPr>
          <p:grpSpPr>
            <a:xfrm>
              <a:off x="1802679" y="6017551"/>
              <a:ext cx="1622433" cy="1620000"/>
              <a:chOff x="-3051720" y="4137223"/>
              <a:chExt cx="1622433" cy="1620000"/>
            </a:xfrm>
          </p:grpSpPr>
          <p:pic>
            <p:nvPicPr>
              <p:cNvPr id="117" name="Immagine 116">
                <a:extLst>
                  <a:ext uri="{FF2B5EF4-FFF2-40B4-BE49-F238E27FC236}">
                    <a16:creationId xmlns:a16="http://schemas.microsoft.com/office/drawing/2014/main" id="{BC2A0841-E8DC-45C3-970E-F936A911EE2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-3051720" y="4137223"/>
                <a:ext cx="1622433" cy="1620000"/>
              </a:xfrm>
              <a:prstGeom prst="rect">
                <a:avLst/>
              </a:prstGeom>
            </p:spPr>
          </p:pic>
          <p:sp>
            <p:nvSpPr>
              <p:cNvPr id="118" name="Rettangolo 117">
                <a:extLst>
                  <a:ext uri="{FF2B5EF4-FFF2-40B4-BE49-F238E27FC236}">
                    <a16:creationId xmlns:a16="http://schemas.microsoft.com/office/drawing/2014/main" id="{54F9C130-0EE9-4469-9F87-EB97FCB62981}"/>
                  </a:ext>
                </a:extLst>
              </p:cNvPr>
              <p:cNvSpPr/>
              <p:nvPr/>
            </p:nvSpPr>
            <p:spPr>
              <a:xfrm>
                <a:off x="-2499246" y="4566289"/>
                <a:ext cx="253213" cy="234950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pic>
          <p:nvPicPr>
            <p:cNvPr id="74" name="Immagine 73">
              <a:extLst>
                <a:ext uri="{FF2B5EF4-FFF2-40B4-BE49-F238E27FC236}">
                  <a16:creationId xmlns:a16="http://schemas.microsoft.com/office/drawing/2014/main" id="{CFF5F31E-7ABB-46F5-8BE0-B4D5D0CF028D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108812" y="6017551"/>
              <a:ext cx="1622433" cy="1620000"/>
            </a:xfrm>
            <a:prstGeom prst="rect">
              <a:avLst/>
            </a:prstGeom>
          </p:spPr>
        </p:pic>
        <p:sp>
          <p:nvSpPr>
            <p:cNvPr id="75" name="Rettangolo 74">
              <a:extLst>
                <a:ext uri="{FF2B5EF4-FFF2-40B4-BE49-F238E27FC236}">
                  <a16:creationId xmlns:a16="http://schemas.microsoft.com/office/drawing/2014/main" id="{85F1C71A-1879-4A9E-B606-2C1CA41A6AE3}"/>
                </a:ext>
              </a:extLst>
            </p:cNvPr>
            <p:cNvSpPr/>
            <p:nvPr/>
          </p:nvSpPr>
          <p:spPr>
            <a:xfrm>
              <a:off x="5514566" y="8973200"/>
              <a:ext cx="199325" cy="72008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76" name="Rettangolo 75">
              <a:extLst>
                <a:ext uri="{FF2B5EF4-FFF2-40B4-BE49-F238E27FC236}">
                  <a16:creationId xmlns:a16="http://schemas.microsoft.com/office/drawing/2014/main" id="{FF48C64C-3D1E-4B51-BD3E-10EB6348C383}"/>
                </a:ext>
              </a:extLst>
            </p:cNvPr>
            <p:cNvSpPr/>
            <p:nvPr/>
          </p:nvSpPr>
          <p:spPr>
            <a:xfrm>
              <a:off x="3865772" y="9008092"/>
              <a:ext cx="199325" cy="72008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77" name="Rettangolo 76">
              <a:extLst>
                <a:ext uri="{FF2B5EF4-FFF2-40B4-BE49-F238E27FC236}">
                  <a16:creationId xmlns:a16="http://schemas.microsoft.com/office/drawing/2014/main" id="{A0969ADD-F02E-43BE-B060-64899A11BE37}"/>
                </a:ext>
              </a:extLst>
            </p:cNvPr>
            <p:cNvSpPr/>
            <p:nvPr/>
          </p:nvSpPr>
          <p:spPr>
            <a:xfrm>
              <a:off x="2170489" y="8984697"/>
              <a:ext cx="199325" cy="72008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grpSp>
          <p:nvGrpSpPr>
            <p:cNvPr id="78" name="Gruppo 77">
              <a:extLst>
                <a:ext uri="{FF2B5EF4-FFF2-40B4-BE49-F238E27FC236}">
                  <a16:creationId xmlns:a16="http://schemas.microsoft.com/office/drawing/2014/main" id="{521438DC-8507-47E4-9F89-D5D6D7FF2308}"/>
                </a:ext>
              </a:extLst>
            </p:cNvPr>
            <p:cNvGrpSpPr/>
            <p:nvPr/>
          </p:nvGrpSpPr>
          <p:grpSpPr>
            <a:xfrm>
              <a:off x="4697117" y="7429128"/>
              <a:ext cx="444352" cy="182613"/>
              <a:chOff x="4697117" y="7087513"/>
              <a:chExt cx="444352" cy="182613"/>
            </a:xfrm>
          </p:grpSpPr>
          <p:grpSp>
            <p:nvGrpSpPr>
              <p:cNvPr id="110" name="Gruppo 109">
                <a:extLst>
                  <a:ext uri="{FF2B5EF4-FFF2-40B4-BE49-F238E27FC236}">
                    <a16:creationId xmlns:a16="http://schemas.microsoft.com/office/drawing/2014/main" id="{6B7024D0-D32D-48AE-817C-E71E4B6D768F}"/>
                  </a:ext>
                </a:extLst>
              </p:cNvPr>
              <p:cNvGrpSpPr/>
              <p:nvPr/>
            </p:nvGrpSpPr>
            <p:grpSpPr>
              <a:xfrm>
                <a:off x="4819631" y="7198118"/>
                <a:ext cx="199325" cy="72008"/>
                <a:chOff x="1412017" y="7812360"/>
                <a:chExt cx="199325" cy="72008"/>
              </a:xfrm>
            </p:grpSpPr>
            <p:sp>
              <p:nvSpPr>
                <p:cNvPr id="112" name="Rettangolo 111">
                  <a:extLst>
                    <a:ext uri="{FF2B5EF4-FFF2-40B4-BE49-F238E27FC236}">
                      <a16:creationId xmlns:a16="http://schemas.microsoft.com/office/drawing/2014/main" id="{3454AE03-4BC2-406A-87E0-667ECEFD9A0C}"/>
                    </a:ext>
                  </a:extLst>
                </p:cNvPr>
                <p:cNvSpPr/>
                <p:nvPr/>
              </p:nvSpPr>
              <p:spPr>
                <a:xfrm>
                  <a:off x="1412017" y="7812360"/>
                  <a:ext cx="199325" cy="72008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grpSp>
              <p:nvGrpSpPr>
                <p:cNvPr id="113" name="Gruppo 112">
                  <a:extLst>
                    <a:ext uri="{FF2B5EF4-FFF2-40B4-BE49-F238E27FC236}">
                      <a16:creationId xmlns:a16="http://schemas.microsoft.com/office/drawing/2014/main" id="{F5E75AEC-FE87-4A94-9D15-D56EEB243E96}"/>
                    </a:ext>
                  </a:extLst>
                </p:cNvPr>
                <p:cNvGrpSpPr/>
                <p:nvPr/>
              </p:nvGrpSpPr>
              <p:grpSpPr>
                <a:xfrm>
                  <a:off x="1449447" y="7824200"/>
                  <a:ext cx="136800" cy="50007"/>
                  <a:chOff x="5722144" y="4932040"/>
                  <a:chExt cx="238128" cy="50007"/>
                </a:xfrm>
              </p:grpSpPr>
              <p:cxnSp>
                <p:nvCxnSpPr>
                  <p:cNvPr id="114" name="Connettore diritto 113">
                    <a:extLst>
                      <a:ext uri="{FF2B5EF4-FFF2-40B4-BE49-F238E27FC236}">
                        <a16:creationId xmlns:a16="http://schemas.microsoft.com/office/drawing/2014/main" id="{9859C4C0-172B-4E84-BFF9-69847D4E004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722144" y="4957043"/>
                    <a:ext cx="234000" cy="0"/>
                  </a:xfrm>
                  <a:prstGeom prst="line">
                    <a:avLst/>
                  </a:prstGeom>
                  <a:ln w="9525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5" name="Connettore diritto 114">
                    <a:extLst>
                      <a:ext uri="{FF2B5EF4-FFF2-40B4-BE49-F238E27FC236}">
                        <a16:creationId xmlns:a16="http://schemas.microsoft.com/office/drawing/2014/main" id="{D3FA6D89-B695-426B-B8DF-1F4AEF0B0F2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960272" y="4932040"/>
                    <a:ext cx="0" cy="50007"/>
                  </a:xfrm>
                  <a:prstGeom prst="line">
                    <a:avLst/>
                  </a:prstGeom>
                  <a:ln w="9525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6" name="Connettore diritto 115">
                    <a:extLst>
                      <a:ext uri="{FF2B5EF4-FFF2-40B4-BE49-F238E27FC236}">
                        <a16:creationId xmlns:a16="http://schemas.microsoft.com/office/drawing/2014/main" id="{C54609EE-C91A-41EE-9559-1B27DDD3AC3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724521" y="4932040"/>
                    <a:ext cx="0" cy="50007"/>
                  </a:xfrm>
                  <a:prstGeom prst="line">
                    <a:avLst/>
                  </a:prstGeom>
                  <a:ln w="9525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11" name="CasellaDiTesto 110">
                <a:extLst>
                  <a:ext uri="{FF2B5EF4-FFF2-40B4-BE49-F238E27FC236}">
                    <a16:creationId xmlns:a16="http://schemas.microsoft.com/office/drawing/2014/main" id="{78149BC0-A3ED-4DAC-9876-9666116DFCB5}"/>
                  </a:ext>
                </a:extLst>
              </p:cNvPr>
              <p:cNvSpPr txBox="1"/>
              <p:nvPr/>
            </p:nvSpPr>
            <p:spPr>
              <a:xfrm>
                <a:off x="4697117" y="7087513"/>
                <a:ext cx="444352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500" dirty="0">
                    <a:solidFill>
                      <a:schemeClr val="bg1"/>
                    </a:solidFill>
                  </a:rPr>
                  <a:t>20,31 </a:t>
                </a:r>
                <a:r>
                  <a:rPr lang="el-GR" sz="5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it-IT" sz="500" dirty="0">
                    <a:solidFill>
                      <a:schemeClr val="bg1"/>
                    </a:solidFill>
                    <a:latin typeface="+mj-lt"/>
                    <a:cs typeface="Times New Roman" panose="02020603050405020304" pitchFamily="18" charset="0"/>
                  </a:rPr>
                  <a:t>m</a:t>
                </a:r>
                <a:endParaRPr lang="it-IT" sz="500" dirty="0">
                  <a:solidFill>
                    <a:schemeClr val="bg1"/>
                  </a:solidFill>
                  <a:latin typeface="+mj-lt"/>
                </a:endParaRPr>
              </a:p>
            </p:txBody>
          </p:sp>
        </p:grpSp>
        <p:grpSp>
          <p:nvGrpSpPr>
            <p:cNvPr id="79" name="Gruppo 78">
              <a:extLst>
                <a:ext uri="{FF2B5EF4-FFF2-40B4-BE49-F238E27FC236}">
                  <a16:creationId xmlns:a16="http://schemas.microsoft.com/office/drawing/2014/main" id="{E9E7A2AE-4282-4D29-A96D-DD377E15C7B3}"/>
                </a:ext>
              </a:extLst>
            </p:cNvPr>
            <p:cNvGrpSpPr/>
            <p:nvPr/>
          </p:nvGrpSpPr>
          <p:grpSpPr>
            <a:xfrm>
              <a:off x="6319550" y="7429128"/>
              <a:ext cx="444352" cy="182613"/>
              <a:chOff x="4697117" y="7087513"/>
              <a:chExt cx="444352" cy="182613"/>
            </a:xfrm>
          </p:grpSpPr>
          <p:grpSp>
            <p:nvGrpSpPr>
              <p:cNvPr id="103" name="Gruppo 102">
                <a:extLst>
                  <a:ext uri="{FF2B5EF4-FFF2-40B4-BE49-F238E27FC236}">
                    <a16:creationId xmlns:a16="http://schemas.microsoft.com/office/drawing/2014/main" id="{E9AF0441-1310-498D-B50E-3D1F00B19C50}"/>
                  </a:ext>
                </a:extLst>
              </p:cNvPr>
              <p:cNvGrpSpPr/>
              <p:nvPr/>
            </p:nvGrpSpPr>
            <p:grpSpPr>
              <a:xfrm>
                <a:off x="4819631" y="7198118"/>
                <a:ext cx="199325" cy="72008"/>
                <a:chOff x="1412017" y="7812360"/>
                <a:chExt cx="199325" cy="72008"/>
              </a:xfrm>
            </p:grpSpPr>
            <p:sp>
              <p:nvSpPr>
                <p:cNvPr id="105" name="Rettangolo 104">
                  <a:extLst>
                    <a:ext uri="{FF2B5EF4-FFF2-40B4-BE49-F238E27FC236}">
                      <a16:creationId xmlns:a16="http://schemas.microsoft.com/office/drawing/2014/main" id="{9F801F84-ADC1-4D25-9754-5249DA39E9E5}"/>
                    </a:ext>
                  </a:extLst>
                </p:cNvPr>
                <p:cNvSpPr/>
                <p:nvPr/>
              </p:nvSpPr>
              <p:spPr>
                <a:xfrm>
                  <a:off x="1412017" y="7812360"/>
                  <a:ext cx="199325" cy="72008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grpSp>
              <p:nvGrpSpPr>
                <p:cNvPr id="106" name="Gruppo 105">
                  <a:extLst>
                    <a:ext uri="{FF2B5EF4-FFF2-40B4-BE49-F238E27FC236}">
                      <a16:creationId xmlns:a16="http://schemas.microsoft.com/office/drawing/2014/main" id="{3CBB101D-7A3A-436D-B6E2-A05C0023077E}"/>
                    </a:ext>
                  </a:extLst>
                </p:cNvPr>
                <p:cNvGrpSpPr/>
                <p:nvPr/>
              </p:nvGrpSpPr>
              <p:grpSpPr>
                <a:xfrm>
                  <a:off x="1449447" y="7824200"/>
                  <a:ext cx="136800" cy="50007"/>
                  <a:chOff x="5722144" y="4932040"/>
                  <a:chExt cx="238128" cy="50007"/>
                </a:xfrm>
              </p:grpSpPr>
              <p:cxnSp>
                <p:nvCxnSpPr>
                  <p:cNvPr id="107" name="Connettore diritto 106">
                    <a:extLst>
                      <a:ext uri="{FF2B5EF4-FFF2-40B4-BE49-F238E27FC236}">
                        <a16:creationId xmlns:a16="http://schemas.microsoft.com/office/drawing/2014/main" id="{ADDE9204-E638-44D9-A0FC-58B4FF465BB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722144" y="4957043"/>
                    <a:ext cx="234000" cy="0"/>
                  </a:xfrm>
                  <a:prstGeom prst="line">
                    <a:avLst/>
                  </a:prstGeom>
                  <a:ln w="9525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8" name="Connettore diritto 107">
                    <a:extLst>
                      <a:ext uri="{FF2B5EF4-FFF2-40B4-BE49-F238E27FC236}">
                        <a16:creationId xmlns:a16="http://schemas.microsoft.com/office/drawing/2014/main" id="{5A9257B7-110B-40A1-B2A1-D33854443ED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960272" y="4932040"/>
                    <a:ext cx="0" cy="50007"/>
                  </a:xfrm>
                  <a:prstGeom prst="line">
                    <a:avLst/>
                  </a:prstGeom>
                  <a:ln w="9525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9" name="Connettore diritto 108">
                    <a:extLst>
                      <a:ext uri="{FF2B5EF4-FFF2-40B4-BE49-F238E27FC236}">
                        <a16:creationId xmlns:a16="http://schemas.microsoft.com/office/drawing/2014/main" id="{E3887EFD-0486-4220-A463-4F1B0E59161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724521" y="4932040"/>
                    <a:ext cx="0" cy="50007"/>
                  </a:xfrm>
                  <a:prstGeom prst="line">
                    <a:avLst/>
                  </a:prstGeom>
                  <a:ln w="9525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04" name="CasellaDiTesto 103">
                <a:extLst>
                  <a:ext uri="{FF2B5EF4-FFF2-40B4-BE49-F238E27FC236}">
                    <a16:creationId xmlns:a16="http://schemas.microsoft.com/office/drawing/2014/main" id="{91ECE71C-FF62-4C01-87D1-70AC4B7BA086}"/>
                  </a:ext>
                </a:extLst>
              </p:cNvPr>
              <p:cNvSpPr txBox="1"/>
              <p:nvPr/>
            </p:nvSpPr>
            <p:spPr>
              <a:xfrm>
                <a:off x="4697117" y="7087513"/>
                <a:ext cx="444352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500" dirty="0">
                    <a:solidFill>
                      <a:schemeClr val="bg1"/>
                    </a:solidFill>
                  </a:rPr>
                  <a:t>20,31 </a:t>
                </a:r>
                <a:r>
                  <a:rPr lang="el-GR" sz="5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it-IT" sz="500" dirty="0">
                    <a:solidFill>
                      <a:schemeClr val="bg1"/>
                    </a:solidFill>
                    <a:latin typeface="+mj-lt"/>
                    <a:cs typeface="Times New Roman" panose="02020603050405020304" pitchFamily="18" charset="0"/>
                  </a:rPr>
                  <a:t>m</a:t>
                </a:r>
                <a:endParaRPr lang="it-IT" sz="500" dirty="0">
                  <a:solidFill>
                    <a:schemeClr val="bg1"/>
                  </a:solidFill>
                  <a:latin typeface="+mj-lt"/>
                </a:endParaRPr>
              </a:p>
            </p:txBody>
          </p:sp>
        </p:grpSp>
        <p:grpSp>
          <p:nvGrpSpPr>
            <p:cNvPr id="80" name="Gruppo 79">
              <a:extLst>
                <a:ext uri="{FF2B5EF4-FFF2-40B4-BE49-F238E27FC236}">
                  <a16:creationId xmlns:a16="http://schemas.microsoft.com/office/drawing/2014/main" id="{FFF07A84-5B3E-4C69-BED6-B384E858DEC7}"/>
                </a:ext>
              </a:extLst>
            </p:cNvPr>
            <p:cNvGrpSpPr/>
            <p:nvPr/>
          </p:nvGrpSpPr>
          <p:grpSpPr>
            <a:xfrm>
              <a:off x="3005268" y="7429128"/>
              <a:ext cx="444352" cy="182613"/>
              <a:chOff x="4697117" y="7087513"/>
              <a:chExt cx="444352" cy="182613"/>
            </a:xfrm>
          </p:grpSpPr>
          <p:grpSp>
            <p:nvGrpSpPr>
              <p:cNvPr id="96" name="Gruppo 95">
                <a:extLst>
                  <a:ext uri="{FF2B5EF4-FFF2-40B4-BE49-F238E27FC236}">
                    <a16:creationId xmlns:a16="http://schemas.microsoft.com/office/drawing/2014/main" id="{FDD331BD-5613-4987-BE66-E16D8B972271}"/>
                  </a:ext>
                </a:extLst>
              </p:cNvPr>
              <p:cNvGrpSpPr/>
              <p:nvPr/>
            </p:nvGrpSpPr>
            <p:grpSpPr>
              <a:xfrm>
                <a:off x="4819631" y="7198118"/>
                <a:ext cx="199325" cy="72008"/>
                <a:chOff x="1412017" y="7812360"/>
                <a:chExt cx="199325" cy="72008"/>
              </a:xfrm>
            </p:grpSpPr>
            <p:sp>
              <p:nvSpPr>
                <p:cNvPr id="98" name="Rettangolo 97">
                  <a:extLst>
                    <a:ext uri="{FF2B5EF4-FFF2-40B4-BE49-F238E27FC236}">
                      <a16:creationId xmlns:a16="http://schemas.microsoft.com/office/drawing/2014/main" id="{2B932DD7-54D6-4778-8314-2AAECF51C05F}"/>
                    </a:ext>
                  </a:extLst>
                </p:cNvPr>
                <p:cNvSpPr/>
                <p:nvPr/>
              </p:nvSpPr>
              <p:spPr>
                <a:xfrm>
                  <a:off x="1412017" y="7812360"/>
                  <a:ext cx="199325" cy="72008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grpSp>
              <p:nvGrpSpPr>
                <p:cNvPr id="99" name="Gruppo 98">
                  <a:extLst>
                    <a:ext uri="{FF2B5EF4-FFF2-40B4-BE49-F238E27FC236}">
                      <a16:creationId xmlns:a16="http://schemas.microsoft.com/office/drawing/2014/main" id="{EA0F4D5D-0E06-4476-A779-32F609AF92EF}"/>
                    </a:ext>
                  </a:extLst>
                </p:cNvPr>
                <p:cNvGrpSpPr/>
                <p:nvPr/>
              </p:nvGrpSpPr>
              <p:grpSpPr>
                <a:xfrm>
                  <a:off x="1449447" y="7824200"/>
                  <a:ext cx="136800" cy="50007"/>
                  <a:chOff x="5722144" y="4932040"/>
                  <a:chExt cx="238128" cy="50007"/>
                </a:xfrm>
              </p:grpSpPr>
              <p:cxnSp>
                <p:nvCxnSpPr>
                  <p:cNvPr id="100" name="Connettore diritto 99">
                    <a:extLst>
                      <a:ext uri="{FF2B5EF4-FFF2-40B4-BE49-F238E27FC236}">
                        <a16:creationId xmlns:a16="http://schemas.microsoft.com/office/drawing/2014/main" id="{FC44CB71-4C4F-4DC4-8CBF-ACB2CFB408C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722144" y="4957043"/>
                    <a:ext cx="234000" cy="0"/>
                  </a:xfrm>
                  <a:prstGeom prst="line">
                    <a:avLst/>
                  </a:prstGeom>
                  <a:ln w="9525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1" name="Connettore diritto 100">
                    <a:extLst>
                      <a:ext uri="{FF2B5EF4-FFF2-40B4-BE49-F238E27FC236}">
                        <a16:creationId xmlns:a16="http://schemas.microsoft.com/office/drawing/2014/main" id="{B3746972-03B9-459B-84E3-02D62E477EE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960272" y="4932040"/>
                    <a:ext cx="0" cy="50007"/>
                  </a:xfrm>
                  <a:prstGeom prst="line">
                    <a:avLst/>
                  </a:prstGeom>
                  <a:ln w="9525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2" name="Connettore diritto 101">
                    <a:extLst>
                      <a:ext uri="{FF2B5EF4-FFF2-40B4-BE49-F238E27FC236}">
                        <a16:creationId xmlns:a16="http://schemas.microsoft.com/office/drawing/2014/main" id="{3D114599-51BD-40FD-B9FA-052011FAF5C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724521" y="4932040"/>
                    <a:ext cx="0" cy="50007"/>
                  </a:xfrm>
                  <a:prstGeom prst="line">
                    <a:avLst/>
                  </a:prstGeom>
                  <a:ln w="9525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97" name="CasellaDiTesto 96">
                <a:extLst>
                  <a:ext uri="{FF2B5EF4-FFF2-40B4-BE49-F238E27FC236}">
                    <a16:creationId xmlns:a16="http://schemas.microsoft.com/office/drawing/2014/main" id="{29E2B53E-770D-4DF9-A3C9-23514E895DED}"/>
                  </a:ext>
                </a:extLst>
              </p:cNvPr>
              <p:cNvSpPr txBox="1"/>
              <p:nvPr/>
            </p:nvSpPr>
            <p:spPr>
              <a:xfrm>
                <a:off x="4697117" y="7087513"/>
                <a:ext cx="444352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500" dirty="0">
                    <a:solidFill>
                      <a:schemeClr val="bg1"/>
                    </a:solidFill>
                  </a:rPr>
                  <a:t>20,31 </a:t>
                </a:r>
                <a:r>
                  <a:rPr lang="el-GR" sz="5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it-IT" sz="500" dirty="0">
                    <a:solidFill>
                      <a:schemeClr val="bg1"/>
                    </a:solidFill>
                    <a:latin typeface="+mj-lt"/>
                    <a:cs typeface="Times New Roman" panose="02020603050405020304" pitchFamily="18" charset="0"/>
                  </a:rPr>
                  <a:t>m</a:t>
                </a:r>
                <a:endParaRPr lang="it-IT" sz="500" dirty="0">
                  <a:solidFill>
                    <a:schemeClr val="bg1"/>
                  </a:solidFill>
                  <a:latin typeface="+mj-lt"/>
                </a:endParaRPr>
              </a:p>
            </p:txBody>
          </p:sp>
        </p:grpSp>
        <p:grpSp>
          <p:nvGrpSpPr>
            <p:cNvPr id="81" name="Gruppo 80">
              <a:extLst>
                <a:ext uri="{FF2B5EF4-FFF2-40B4-BE49-F238E27FC236}">
                  <a16:creationId xmlns:a16="http://schemas.microsoft.com/office/drawing/2014/main" id="{9257644D-10FD-4FD2-8F72-FA9ACD54B440}"/>
                </a:ext>
              </a:extLst>
            </p:cNvPr>
            <p:cNvGrpSpPr/>
            <p:nvPr/>
          </p:nvGrpSpPr>
          <p:grpSpPr>
            <a:xfrm>
              <a:off x="1260322" y="7429128"/>
              <a:ext cx="444352" cy="182613"/>
              <a:chOff x="4697117" y="7087513"/>
              <a:chExt cx="444352" cy="182613"/>
            </a:xfrm>
          </p:grpSpPr>
          <p:grpSp>
            <p:nvGrpSpPr>
              <p:cNvPr id="89" name="Gruppo 88">
                <a:extLst>
                  <a:ext uri="{FF2B5EF4-FFF2-40B4-BE49-F238E27FC236}">
                    <a16:creationId xmlns:a16="http://schemas.microsoft.com/office/drawing/2014/main" id="{8ADBCAA5-231F-4A32-8DFF-A36003AAC227}"/>
                  </a:ext>
                </a:extLst>
              </p:cNvPr>
              <p:cNvGrpSpPr/>
              <p:nvPr/>
            </p:nvGrpSpPr>
            <p:grpSpPr>
              <a:xfrm>
                <a:off x="4819631" y="7198118"/>
                <a:ext cx="199325" cy="72008"/>
                <a:chOff x="1412017" y="7812360"/>
                <a:chExt cx="199325" cy="72008"/>
              </a:xfrm>
            </p:grpSpPr>
            <p:sp>
              <p:nvSpPr>
                <p:cNvPr id="91" name="Rettangolo 90">
                  <a:extLst>
                    <a:ext uri="{FF2B5EF4-FFF2-40B4-BE49-F238E27FC236}">
                      <a16:creationId xmlns:a16="http://schemas.microsoft.com/office/drawing/2014/main" id="{E1E66D87-D2F8-4941-B4CF-E01F36D9C8F8}"/>
                    </a:ext>
                  </a:extLst>
                </p:cNvPr>
                <p:cNvSpPr/>
                <p:nvPr/>
              </p:nvSpPr>
              <p:spPr>
                <a:xfrm>
                  <a:off x="1412017" y="7812360"/>
                  <a:ext cx="199325" cy="72008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grpSp>
              <p:nvGrpSpPr>
                <p:cNvPr id="92" name="Gruppo 91">
                  <a:extLst>
                    <a:ext uri="{FF2B5EF4-FFF2-40B4-BE49-F238E27FC236}">
                      <a16:creationId xmlns:a16="http://schemas.microsoft.com/office/drawing/2014/main" id="{67D6826E-7529-489A-89CC-EC8D28EED3A7}"/>
                    </a:ext>
                  </a:extLst>
                </p:cNvPr>
                <p:cNvGrpSpPr/>
                <p:nvPr/>
              </p:nvGrpSpPr>
              <p:grpSpPr>
                <a:xfrm>
                  <a:off x="1449447" y="7824200"/>
                  <a:ext cx="136800" cy="50007"/>
                  <a:chOff x="5722144" y="4932040"/>
                  <a:chExt cx="238128" cy="50007"/>
                </a:xfrm>
              </p:grpSpPr>
              <p:cxnSp>
                <p:nvCxnSpPr>
                  <p:cNvPr id="93" name="Connettore diritto 92">
                    <a:extLst>
                      <a:ext uri="{FF2B5EF4-FFF2-40B4-BE49-F238E27FC236}">
                        <a16:creationId xmlns:a16="http://schemas.microsoft.com/office/drawing/2014/main" id="{A6F5AE65-E8CA-4736-9BA1-C11922C5FB6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722144" y="4957043"/>
                    <a:ext cx="234000" cy="0"/>
                  </a:xfrm>
                  <a:prstGeom prst="line">
                    <a:avLst/>
                  </a:prstGeom>
                  <a:ln w="9525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4" name="Connettore diritto 93">
                    <a:extLst>
                      <a:ext uri="{FF2B5EF4-FFF2-40B4-BE49-F238E27FC236}">
                        <a16:creationId xmlns:a16="http://schemas.microsoft.com/office/drawing/2014/main" id="{F7B0B581-242B-47A0-AE7C-DABE7290399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960272" y="4932040"/>
                    <a:ext cx="0" cy="50007"/>
                  </a:xfrm>
                  <a:prstGeom prst="line">
                    <a:avLst/>
                  </a:prstGeom>
                  <a:ln w="9525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5" name="Connettore diritto 94">
                    <a:extLst>
                      <a:ext uri="{FF2B5EF4-FFF2-40B4-BE49-F238E27FC236}">
                        <a16:creationId xmlns:a16="http://schemas.microsoft.com/office/drawing/2014/main" id="{D5BD76FC-9A4A-497A-AEAE-DE35D11A284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724521" y="4932040"/>
                    <a:ext cx="0" cy="50007"/>
                  </a:xfrm>
                  <a:prstGeom prst="line">
                    <a:avLst/>
                  </a:prstGeom>
                  <a:ln w="9525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90" name="CasellaDiTesto 89">
                <a:extLst>
                  <a:ext uri="{FF2B5EF4-FFF2-40B4-BE49-F238E27FC236}">
                    <a16:creationId xmlns:a16="http://schemas.microsoft.com/office/drawing/2014/main" id="{B24875B1-CE78-425A-A8E7-3858F087A939}"/>
                  </a:ext>
                </a:extLst>
              </p:cNvPr>
              <p:cNvSpPr txBox="1"/>
              <p:nvPr/>
            </p:nvSpPr>
            <p:spPr>
              <a:xfrm>
                <a:off x="4697117" y="7087513"/>
                <a:ext cx="444352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500" dirty="0">
                    <a:solidFill>
                      <a:schemeClr val="bg1"/>
                    </a:solidFill>
                  </a:rPr>
                  <a:t>20,31 </a:t>
                </a:r>
                <a:r>
                  <a:rPr lang="el-GR" sz="5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it-IT" sz="500" dirty="0">
                    <a:solidFill>
                      <a:schemeClr val="bg1"/>
                    </a:solidFill>
                    <a:latin typeface="+mj-lt"/>
                    <a:cs typeface="Times New Roman" panose="02020603050405020304" pitchFamily="18" charset="0"/>
                  </a:rPr>
                  <a:t>m</a:t>
                </a:r>
                <a:endParaRPr lang="it-IT" sz="500" dirty="0">
                  <a:solidFill>
                    <a:schemeClr val="bg1"/>
                  </a:solidFill>
                  <a:latin typeface="+mj-lt"/>
                </a:endParaRPr>
              </a:p>
            </p:txBody>
          </p:sp>
        </p:grpSp>
        <p:sp>
          <p:nvSpPr>
            <p:cNvPr id="82" name="CasellaDiTesto 81">
              <a:extLst>
                <a:ext uri="{FF2B5EF4-FFF2-40B4-BE49-F238E27FC236}">
                  <a16:creationId xmlns:a16="http://schemas.microsoft.com/office/drawing/2014/main" id="{44BC3936-AF5A-478A-8162-5C809233BC07}"/>
                </a:ext>
              </a:extLst>
            </p:cNvPr>
            <p:cNvSpPr txBox="1"/>
            <p:nvPr/>
          </p:nvSpPr>
          <p:spPr>
            <a:xfrm>
              <a:off x="1558387" y="5989340"/>
              <a:ext cx="1201005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>
                  <a:solidFill>
                    <a:schemeClr val="bg1"/>
                  </a:solidFill>
                </a:rPr>
                <a:t>Tel 10</a:t>
              </a:r>
              <a:r>
                <a:rPr lang="el-GR" sz="12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it-IT" sz="1200" b="1" dirty="0">
                  <a:solidFill>
                    <a:schemeClr val="bg1"/>
                  </a:solidFill>
                  <a:latin typeface="+mj-lt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83" name="CasellaDiTesto 82">
              <a:extLst>
                <a:ext uri="{FF2B5EF4-FFF2-40B4-BE49-F238E27FC236}">
                  <a16:creationId xmlns:a16="http://schemas.microsoft.com/office/drawing/2014/main" id="{6F3910FE-5A10-4980-9DCB-49A885E42C6A}"/>
                </a:ext>
              </a:extLst>
            </p:cNvPr>
            <p:cNvSpPr txBox="1"/>
            <p:nvPr/>
          </p:nvSpPr>
          <p:spPr>
            <a:xfrm>
              <a:off x="3272520" y="5989340"/>
              <a:ext cx="1201005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>
                  <a:solidFill>
                    <a:schemeClr val="bg1"/>
                  </a:solidFill>
                </a:rPr>
                <a:t>Tel 20</a:t>
              </a:r>
              <a:r>
                <a:rPr lang="el-GR" sz="12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it-IT" sz="1200" b="1" dirty="0">
                  <a:solidFill>
                    <a:schemeClr val="bg1"/>
                  </a:solidFill>
                  <a:latin typeface="+mj-lt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84" name="CasellaDiTesto 83">
              <a:extLst>
                <a:ext uri="{FF2B5EF4-FFF2-40B4-BE49-F238E27FC236}">
                  <a16:creationId xmlns:a16="http://schemas.microsoft.com/office/drawing/2014/main" id="{58D04381-1500-440A-8FBC-B0D3EC0E0ACD}"/>
                </a:ext>
              </a:extLst>
            </p:cNvPr>
            <p:cNvSpPr txBox="1"/>
            <p:nvPr/>
          </p:nvSpPr>
          <p:spPr>
            <a:xfrm>
              <a:off x="4894953" y="5989340"/>
              <a:ext cx="1201005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>
                  <a:solidFill>
                    <a:schemeClr val="bg1"/>
                  </a:solidFill>
                </a:rPr>
                <a:t>Tel 40</a:t>
              </a:r>
              <a:r>
                <a:rPr lang="el-GR" sz="12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it-IT" sz="1200" b="1" dirty="0">
                  <a:solidFill>
                    <a:schemeClr val="bg1"/>
                  </a:solidFill>
                  <a:latin typeface="+mj-lt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85" name="CasellaDiTesto 84">
              <a:extLst>
                <a:ext uri="{FF2B5EF4-FFF2-40B4-BE49-F238E27FC236}">
                  <a16:creationId xmlns:a16="http://schemas.microsoft.com/office/drawing/2014/main" id="{28BF46E3-A806-4C41-BE58-DF75255C4B5F}"/>
                </a:ext>
              </a:extLst>
            </p:cNvPr>
            <p:cNvSpPr txBox="1"/>
            <p:nvPr/>
          </p:nvSpPr>
          <p:spPr>
            <a:xfrm>
              <a:off x="1029567" y="5989340"/>
              <a:ext cx="1201005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>
                  <a:solidFill>
                    <a:schemeClr val="bg1"/>
                  </a:solidFill>
                </a:rPr>
                <a:t>0</a:t>
              </a:r>
              <a:endParaRPr lang="it-IT" sz="1200" b="1" dirty="0">
                <a:solidFill>
                  <a:schemeClr val="bg1"/>
                </a:solidFill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86" name="CasellaDiTesto 85">
              <a:extLst>
                <a:ext uri="{FF2B5EF4-FFF2-40B4-BE49-F238E27FC236}">
                  <a16:creationId xmlns:a16="http://schemas.microsoft.com/office/drawing/2014/main" id="{1B609547-1D04-45E2-892B-8F38EEB62B41}"/>
                </a:ext>
              </a:extLst>
            </p:cNvPr>
            <p:cNvSpPr txBox="1"/>
            <p:nvPr/>
          </p:nvSpPr>
          <p:spPr>
            <a:xfrm rot="16200000">
              <a:off x="1612979" y="8253752"/>
              <a:ext cx="1201005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>
                  <a:solidFill>
                    <a:schemeClr val="bg1"/>
                  </a:solidFill>
                </a:rPr>
                <a:t>Tel 10</a:t>
              </a:r>
              <a:r>
                <a:rPr lang="el-GR" sz="12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it-IT" sz="1200" b="1" dirty="0">
                  <a:solidFill>
                    <a:schemeClr val="bg1"/>
                  </a:solidFill>
                  <a:latin typeface="+mj-lt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87" name="CasellaDiTesto 86">
              <a:extLst>
                <a:ext uri="{FF2B5EF4-FFF2-40B4-BE49-F238E27FC236}">
                  <a16:creationId xmlns:a16="http://schemas.microsoft.com/office/drawing/2014/main" id="{3427B71C-2D66-44EE-9A37-8C8CFE198488}"/>
                </a:ext>
              </a:extLst>
            </p:cNvPr>
            <p:cNvSpPr txBox="1"/>
            <p:nvPr/>
          </p:nvSpPr>
          <p:spPr>
            <a:xfrm rot="16200000">
              <a:off x="3280812" y="8253752"/>
              <a:ext cx="1201005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>
                  <a:solidFill>
                    <a:schemeClr val="bg1"/>
                  </a:solidFill>
                </a:rPr>
                <a:t>Tel 20</a:t>
              </a:r>
              <a:r>
                <a:rPr lang="el-GR" sz="12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it-IT" sz="1200" b="1" dirty="0">
                  <a:solidFill>
                    <a:schemeClr val="bg1"/>
                  </a:solidFill>
                  <a:latin typeface="+mj-lt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88" name="CasellaDiTesto 87">
              <a:extLst>
                <a:ext uri="{FF2B5EF4-FFF2-40B4-BE49-F238E27FC236}">
                  <a16:creationId xmlns:a16="http://schemas.microsoft.com/office/drawing/2014/main" id="{B00C0859-A1B9-4E43-986F-E4515713F9AD}"/>
                </a:ext>
              </a:extLst>
            </p:cNvPr>
            <p:cNvSpPr txBox="1"/>
            <p:nvPr/>
          </p:nvSpPr>
          <p:spPr>
            <a:xfrm rot="16200000">
              <a:off x="4968965" y="8253752"/>
              <a:ext cx="1201005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>
                  <a:solidFill>
                    <a:schemeClr val="bg1"/>
                  </a:solidFill>
                </a:rPr>
                <a:t>Tel 40</a:t>
              </a:r>
              <a:r>
                <a:rPr lang="el-GR" sz="12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it-IT" sz="1200" b="1" dirty="0">
                  <a:solidFill>
                    <a:schemeClr val="bg1"/>
                  </a:solidFill>
                  <a:latin typeface="+mj-lt"/>
                  <a:cs typeface="Times New Roman" panose="02020603050405020304" pitchFamily="18" charset="0"/>
                </a:rPr>
                <a:t>M</a:t>
              </a:r>
            </a:p>
          </p:txBody>
        </p:sp>
      </p:grpSp>
      <p:sp>
        <p:nvSpPr>
          <p:cNvPr id="123" name="CasellaDiTesto 122">
            <a:extLst>
              <a:ext uri="{FF2B5EF4-FFF2-40B4-BE49-F238E27FC236}">
                <a16:creationId xmlns:a16="http://schemas.microsoft.com/office/drawing/2014/main" id="{20F2705A-58C2-4916-AE8A-68383FF35F42}"/>
              </a:ext>
            </a:extLst>
          </p:cNvPr>
          <p:cNvSpPr txBox="1"/>
          <p:nvPr/>
        </p:nvSpPr>
        <p:spPr>
          <a:xfrm>
            <a:off x="2240213" y="0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ementary</a:t>
            </a:r>
            <a:r>
              <a:rPr lang="it-IT" b="1" dirty="0"/>
              <a:t> Fig. 7</a:t>
            </a:r>
          </a:p>
        </p:txBody>
      </p:sp>
      <p:sp>
        <p:nvSpPr>
          <p:cNvPr id="124" name="CasellaDiTesto 123">
            <a:extLst>
              <a:ext uri="{FF2B5EF4-FFF2-40B4-BE49-F238E27FC236}">
                <a16:creationId xmlns:a16="http://schemas.microsoft.com/office/drawing/2014/main" id="{1BD8F1E7-1014-61D5-E0B2-8CA13D34F920}"/>
              </a:ext>
            </a:extLst>
          </p:cNvPr>
          <p:cNvSpPr txBox="1"/>
          <p:nvPr/>
        </p:nvSpPr>
        <p:spPr>
          <a:xfrm>
            <a:off x="4200399" y="2580462"/>
            <a:ext cx="4926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/>
              <a:t>(c)</a:t>
            </a:r>
          </a:p>
        </p:txBody>
      </p:sp>
      <p:grpSp>
        <p:nvGrpSpPr>
          <p:cNvPr id="144" name="Gruppo 143">
            <a:extLst>
              <a:ext uri="{FF2B5EF4-FFF2-40B4-BE49-F238E27FC236}">
                <a16:creationId xmlns:a16="http://schemas.microsoft.com/office/drawing/2014/main" id="{84D2B6B1-D731-6CA7-C609-8F6ACD77D91C}"/>
              </a:ext>
            </a:extLst>
          </p:cNvPr>
          <p:cNvGrpSpPr/>
          <p:nvPr/>
        </p:nvGrpSpPr>
        <p:grpSpPr>
          <a:xfrm>
            <a:off x="4515673" y="2609513"/>
            <a:ext cx="1955781" cy="1864079"/>
            <a:chOff x="-168111" y="6883850"/>
            <a:chExt cx="1955781" cy="1864079"/>
          </a:xfrm>
        </p:grpSpPr>
        <p:pic>
          <p:nvPicPr>
            <p:cNvPr id="140" name="Immagine 139">
              <a:extLst>
                <a:ext uri="{FF2B5EF4-FFF2-40B4-BE49-F238E27FC236}">
                  <a16:creationId xmlns:a16="http://schemas.microsoft.com/office/drawing/2014/main" id="{991E5D44-39D3-C499-4CC8-E6911E4F0BA1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71058" y="7146637"/>
              <a:ext cx="1161025" cy="1166400"/>
            </a:xfrm>
            <a:prstGeom prst="rect">
              <a:avLst/>
            </a:prstGeom>
          </p:spPr>
        </p:pic>
        <p:sp>
          <p:nvSpPr>
            <p:cNvPr id="128" name="CasellaDiTesto 127">
              <a:extLst>
                <a:ext uri="{FF2B5EF4-FFF2-40B4-BE49-F238E27FC236}">
                  <a16:creationId xmlns:a16="http://schemas.microsoft.com/office/drawing/2014/main" id="{839FD5C3-2FB3-051B-CE7E-2CC5C0FF8849}"/>
                </a:ext>
              </a:extLst>
            </p:cNvPr>
            <p:cNvSpPr txBox="1"/>
            <p:nvPr/>
          </p:nvSpPr>
          <p:spPr>
            <a:xfrm rot="16200000">
              <a:off x="-765086" y="7480825"/>
              <a:ext cx="165561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/>
                <a:t>Caspase</a:t>
              </a:r>
              <a:r>
                <a:rPr lang="it-IT" sz="1200" dirty="0"/>
                <a:t> 9 Activity</a:t>
              </a:r>
            </a:p>
            <a:p>
              <a:pPr algn="ctr"/>
              <a:r>
                <a:rPr lang="it-IT" sz="1200" dirty="0">
                  <a:latin typeface="+mn-lt"/>
                  <a:cs typeface="Times New Roman" panose="02020603050405020304" pitchFamily="18" charset="0"/>
                </a:rPr>
                <a:t>(RLU - </a:t>
              </a:r>
              <a:r>
                <a:rPr lang="it-IT" sz="1200" dirty="0" err="1">
                  <a:latin typeface="+mn-lt"/>
                  <a:cs typeface="Times New Roman" panose="02020603050405020304" pitchFamily="18" charset="0"/>
                </a:rPr>
                <a:t>Fold</a:t>
              </a:r>
              <a:r>
                <a:rPr lang="it-IT" sz="1200" dirty="0">
                  <a:latin typeface="+mn-lt"/>
                  <a:cs typeface="Times New Roman" panose="02020603050405020304" pitchFamily="18" charset="0"/>
                </a:rPr>
                <a:t> on 0)</a:t>
              </a:r>
            </a:p>
          </p:txBody>
        </p:sp>
        <p:sp>
          <p:nvSpPr>
            <p:cNvPr id="129" name="CasellaDiTesto 128">
              <a:extLst>
                <a:ext uri="{FF2B5EF4-FFF2-40B4-BE49-F238E27FC236}">
                  <a16:creationId xmlns:a16="http://schemas.microsoft.com/office/drawing/2014/main" id="{BF97247F-5FA1-51BA-934F-AEA447C87751}"/>
                </a:ext>
              </a:extLst>
            </p:cNvPr>
            <p:cNvSpPr txBox="1"/>
            <p:nvPr/>
          </p:nvSpPr>
          <p:spPr>
            <a:xfrm>
              <a:off x="615925" y="8275356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</a:t>
              </a:r>
            </a:p>
          </p:txBody>
        </p:sp>
        <p:sp>
          <p:nvSpPr>
            <p:cNvPr id="130" name="CasellaDiTesto 129">
              <a:extLst>
                <a:ext uri="{FF2B5EF4-FFF2-40B4-BE49-F238E27FC236}">
                  <a16:creationId xmlns:a16="http://schemas.microsoft.com/office/drawing/2014/main" id="{B90BAB2B-7F23-54C0-7EA2-6D710804324B}"/>
                </a:ext>
              </a:extLst>
            </p:cNvPr>
            <p:cNvSpPr txBox="1"/>
            <p:nvPr/>
          </p:nvSpPr>
          <p:spPr>
            <a:xfrm>
              <a:off x="235283" y="7582220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5</a:t>
              </a:r>
            </a:p>
          </p:txBody>
        </p:sp>
        <p:sp>
          <p:nvSpPr>
            <p:cNvPr id="131" name="CasellaDiTesto 130">
              <a:extLst>
                <a:ext uri="{FF2B5EF4-FFF2-40B4-BE49-F238E27FC236}">
                  <a16:creationId xmlns:a16="http://schemas.microsoft.com/office/drawing/2014/main" id="{4A9FC5ED-85E5-E0AE-FD0C-A5AA9A33431A}"/>
                </a:ext>
              </a:extLst>
            </p:cNvPr>
            <p:cNvSpPr txBox="1"/>
            <p:nvPr/>
          </p:nvSpPr>
          <p:spPr>
            <a:xfrm>
              <a:off x="235283" y="811029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132" name="CasellaDiTesto 131">
              <a:extLst>
                <a:ext uri="{FF2B5EF4-FFF2-40B4-BE49-F238E27FC236}">
                  <a16:creationId xmlns:a16="http://schemas.microsoft.com/office/drawing/2014/main" id="{36E9C9B1-59EA-6678-2DDB-737DA5DF5F2A}"/>
                </a:ext>
              </a:extLst>
            </p:cNvPr>
            <p:cNvSpPr txBox="1"/>
            <p:nvPr/>
          </p:nvSpPr>
          <p:spPr>
            <a:xfrm>
              <a:off x="644503" y="8470930"/>
              <a:ext cx="83586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it-IT" sz="1200" dirty="0"/>
                <a:t> Tel (</a:t>
              </a:r>
              <a:r>
                <a:rPr lang="el-G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it-IT" sz="1200" dirty="0"/>
                <a:t>M)</a:t>
              </a:r>
            </a:p>
          </p:txBody>
        </p:sp>
        <p:sp>
          <p:nvSpPr>
            <p:cNvPr id="133" name="CasellaDiTesto 132">
              <a:extLst>
                <a:ext uri="{FF2B5EF4-FFF2-40B4-BE49-F238E27FC236}">
                  <a16:creationId xmlns:a16="http://schemas.microsoft.com/office/drawing/2014/main" id="{24059A23-F087-5931-B52B-E7551C1827E5}"/>
                </a:ext>
              </a:extLst>
            </p:cNvPr>
            <p:cNvSpPr txBox="1"/>
            <p:nvPr/>
          </p:nvSpPr>
          <p:spPr>
            <a:xfrm>
              <a:off x="235283" y="7017430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3.0</a:t>
              </a:r>
            </a:p>
          </p:txBody>
        </p:sp>
        <p:sp>
          <p:nvSpPr>
            <p:cNvPr id="134" name="CasellaDiTesto 133">
              <a:extLst>
                <a:ext uri="{FF2B5EF4-FFF2-40B4-BE49-F238E27FC236}">
                  <a16:creationId xmlns:a16="http://schemas.microsoft.com/office/drawing/2014/main" id="{8FD63A47-7CE2-6F2A-BB53-550F85ADFBB8}"/>
                </a:ext>
              </a:extLst>
            </p:cNvPr>
            <p:cNvSpPr txBox="1"/>
            <p:nvPr/>
          </p:nvSpPr>
          <p:spPr>
            <a:xfrm>
              <a:off x="764704" y="827535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0</a:t>
              </a:r>
            </a:p>
          </p:txBody>
        </p:sp>
        <p:sp>
          <p:nvSpPr>
            <p:cNvPr id="135" name="CasellaDiTesto 134">
              <a:extLst>
                <a:ext uri="{FF2B5EF4-FFF2-40B4-BE49-F238E27FC236}">
                  <a16:creationId xmlns:a16="http://schemas.microsoft.com/office/drawing/2014/main" id="{5DA52A71-1CC9-2A76-DFF8-EED78857AB78}"/>
                </a:ext>
              </a:extLst>
            </p:cNvPr>
            <p:cNvSpPr txBox="1"/>
            <p:nvPr/>
          </p:nvSpPr>
          <p:spPr>
            <a:xfrm>
              <a:off x="980728" y="827535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20</a:t>
              </a:r>
            </a:p>
          </p:txBody>
        </p:sp>
        <p:sp>
          <p:nvSpPr>
            <p:cNvPr id="136" name="CasellaDiTesto 135">
              <a:extLst>
                <a:ext uri="{FF2B5EF4-FFF2-40B4-BE49-F238E27FC236}">
                  <a16:creationId xmlns:a16="http://schemas.microsoft.com/office/drawing/2014/main" id="{3223305F-39F7-662D-4E8A-9A9D525B840D}"/>
                </a:ext>
              </a:extLst>
            </p:cNvPr>
            <p:cNvSpPr txBox="1"/>
            <p:nvPr/>
          </p:nvSpPr>
          <p:spPr>
            <a:xfrm>
              <a:off x="1187226" y="827535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40</a:t>
              </a:r>
            </a:p>
          </p:txBody>
        </p:sp>
        <p:cxnSp>
          <p:nvCxnSpPr>
            <p:cNvPr id="137" name="Connettore diritto 136">
              <a:extLst>
                <a:ext uri="{FF2B5EF4-FFF2-40B4-BE49-F238E27FC236}">
                  <a16:creationId xmlns:a16="http://schemas.microsoft.com/office/drawing/2014/main" id="{1AE36AD9-3159-1792-955C-327220C0CBC3}"/>
                </a:ext>
              </a:extLst>
            </p:cNvPr>
            <p:cNvCxnSpPr>
              <a:cxnSpLocks/>
            </p:cNvCxnSpPr>
            <p:nvPr/>
          </p:nvCxnSpPr>
          <p:spPr>
            <a:xfrm>
              <a:off x="692696" y="8514255"/>
              <a:ext cx="76347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8" name="CasellaDiTesto 137">
              <a:extLst>
                <a:ext uri="{FF2B5EF4-FFF2-40B4-BE49-F238E27FC236}">
                  <a16:creationId xmlns:a16="http://schemas.microsoft.com/office/drawing/2014/main" id="{75BB2D6D-6DF6-5962-E3E9-BF7BEE60D892}"/>
                </a:ext>
              </a:extLst>
            </p:cNvPr>
            <p:cNvSpPr txBox="1"/>
            <p:nvPr/>
          </p:nvSpPr>
          <p:spPr>
            <a:xfrm>
              <a:off x="1158046" y="7083709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**</a:t>
              </a:r>
            </a:p>
          </p:txBody>
        </p:sp>
        <p:sp>
          <p:nvSpPr>
            <p:cNvPr id="139" name="CasellaDiTesto 138">
              <a:extLst>
                <a:ext uri="{FF2B5EF4-FFF2-40B4-BE49-F238E27FC236}">
                  <a16:creationId xmlns:a16="http://schemas.microsoft.com/office/drawing/2014/main" id="{942060BE-5EBE-2EC7-DF16-D6B8C5025815}"/>
                </a:ext>
              </a:extLst>
            </p:cNvPr>
            <p:cNvSpPr txBox="1"/>
            <p:nvPr/>
          </p:nvSpPr>
          <p:spPr>
            <a:xfrm>
              <a:off x="1365760" y="7153095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**</a:t>
              </a:r>
            </a:p>
          </p:txBody>
        </p:sp>
        <p:sp>
          <p:nvSpPr>
            <p:cNvPr id="141" name="CasellaDiTesto 140">
              <a:extLst>
                <a:ext uri="{FF2B5EF4-FFF2-40B4-BE49-F238E27FC236}">
                  <a16:creationId xmlns:a16="http://schemas.microsoft.com/office/drawing/2014/main" id="{F501B7B5-3700-86A1-6FE5-4C61A5617311}"/>
                </a:ext>
              </a:extLst>
            </p:cNvPr>
            <p:cNvSpPr txBox="1"/>
            <p:nvPr/>
          </p:nvSpPr>
          <p:spPr>
            <a:xfrm rot="16200000">
              <a:off x="1329359" y="8353539"/>
              <a:ext cx="48613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it-IT" sz="1200" dirty="0"/>
                <a:t>STS</a:t>
              </a:r>
            </a:p>
          </p:txBody>
        </p:sp>
        <p:sp>
          <p:nvSpPr>
            <p:cNvPr id="143" name="CasellaDiTesto 142">
              <a:extLst>
                <a:ext uri="{FF2B5EF4-FFF2-40B4-BE49-F238E27FC236}">
                  <a16:creationId xmlns:a16="http://schemas.microsoft.com/office/drawing/2014/main" id="{E264C86E-C034-57E9-2239-5A32F06A61B4}"/>
                </a:ext>
              </a:extLst>
            </p:cNvPr>
            <p:cNvSpPr txBox="1"/>
            <p:nvPr/>
          </p:nvSpPr>
          <p:spPr>
            <a:xfrm>
              <a:off x="1047806" y="7423742"/>
              <a:ext cx="24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6503935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B14641C2-1A37-4311-BD94-1DD69E890193}"/>
              </a:ext>
            </a:extLst>
          </p:cNvPr>
          <p:cNvSpPr txBox="1"/>
          <p:nvPr/>
        </p:nvSpPr>
        <p:spPr>
          <a:xfrm>
            <a:off x="2240213" y="0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ementary</a:t>
            </a:r>
            <a:r>
              <a:rPr lang="it-IT" b="1" dirty="0"/>
              <a:t> Fig. 8</a:t>
            </a:r>
          </a:p>
        </p:txBody>
      </p:sp>
      <p:grpSp>
        <p:nvGrpSpPr>
          <p:cNvPr id="3" name="Gruppo 2">
            <a:extLst>
              <a:ext uri="{FF2B5EF4-FFF2-40B4-BE49-F238E27FC236}">
                <a16:creationId xmlns:a16="http://schemas.microsoft.com/office/drawing/2014/main" id="{4B2C2836-7F11-4B1E-A829-33FBBFA1A42A}"/>
              </a:ext>
            </a:extLst>
          </p:cNvPr>
          <p:cNvGrpSpPr/>
          <p:nvPr/>
        </p:nvGrpSpPr>
        <p:grpSpPr>
          <a:xfrm>
            <a:off x="982361" y="557370"/>
            <a:ext cx="2247340" cy="1027363"/>
            <a:chOff x="781885" y="1073505"/>
            <a:chExt cx="2247340" cy="1027363"/>
          </a:xfrm>
        </p:grpSpPr>
        <p:pic>
          <p:nvPicPr>
            <p:cNvPr id="4" name="Immagine 3">
              <a:extLst>
                <a:ext uri="{FF2B5EF4-FFF2-40B4-BE49-F238E27FC236}">
                  <a16:creationId xmlns:a16="http://schemas.microsoft.com/office/drawing/2014/main" id="{BAD7A9D0-AC7E-495E-BDA5-B5B993739C5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056707" y="1896276"/>
              <a:ext cx="1440000" cy="1974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" name="Immagine 4">
              <a:extLst>
                <a:ext uri="{FF2B5EF4-FFF2-40B4-BE49-F238E27FC236}">
                  <a16:creationId xmlns:a16="http://schemas.microsoft.com/office/drawing/2014/main" id="{2A2BD71D-0213-4216-9923-DE6A5DE3241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056707" y="1504684"/>
              <a:ext cx="1440000" cy="35149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6" name="Connettore diritto 5">
              <a:extLst>
                <a:ext uri="{FF2B5EF4-FFF2-40B4-BE49-F238E27FC236}">
                  <a16:creationId xmlns:a16="http://schemas.microsoft.com/office/drawing/2014/main" id="{7D2504E0-274C-479B-9E11-FC5BF070981B}"/>
                </a:ext>
              </a:extLst>
            </p:cNvPr>
            <p:cNvCxnSpPr/>
            <p:nvPr/>
          </p:nvCxnSpPr>
          <p:spPr>
            <a:xfrm>
              <a:off x="983971" y="1622464"/>
              <a:ext cx="0" cy="30728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4FAC1AAB-337A-4F06-9A3B-789144D77C82}"/>
                </a:ext>
              </a:extLst>
            </p:cNvPr>
            <p:cNvSpPr txBox="1"/>
            <p:nvPr/>
          </p:nvSpPr>
          <p:spPr>
            <a:xfrm rot="16200000">
              <a:off x="616295" y="1652221"/>
              <a:ext cx="5774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MCF-7</a:t>
              </a: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9AD1915C-F91D-4398-A0A9-B2B86AB5795A}"/>
                </a:ext>
              </a:extLst>
            </p:cNvPr>
            <p:cNvSpPr txBox="1"/>
            <p:nvPr/>
          </p:nvSpPr>
          <p:spPr>
            <a:xfrm>
              <a:off x="2496707" y="1854647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Tub</a:t>
              </a:r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8C5B4B0B-00B4-4D9A-9F43-F6E2BD4E2E4F}"/>
                </a:ext>
              </a:extLst>
            </p:cNvPr>
            <p:cNvSpPr txBox="1"/>
            <p:nvPr/>
          </p:nvSpPr>
          <p:spPr>
            <a:xfrm>
              <a:off x="1056707" y="126041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CC4DB14A-7A90-47D3-8413-0524C76E0B25}"/>
                </a:ext>
              </a:extLst>
            </p:cNvPr>
            <p:cNvSpPr txBox="1"/>
            <p:nvPr/>
          </p:nvSpPr>
          <p:spPr>
            <a:xfrm>
              <a:off x="1286371" y="1260416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.1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7D93643A-B6EB-49E3-9111-A471CA9A3F73}"/>
                </a:ext>
              </a:extLst>
            </p:cNvPr>
            <p:cNvSpPr txBox="1"/>
            <p:nvPr/>
          </p:nvSpPr>
          <p:spPr>
            <a:xfrm>
              <a:off x="1555494" y="1260416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.5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3AEBACF6-9EB6-439A-A1A6-C66DE0753284}"/>
                </a:ext>
              </a:extLst>
            </p:cNvPr>
            <p:cNvSpPr txBox="1"/>
            <p:nvPr/>
          </p:nvSpPr>
          <p:spPr>
            <a:xfrm>
              <a:off x="1833915" y="1260416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.0</a:t>
              </a: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221D75E1-F834-4F49-80BD-D3C38D7286A3}"/>
                </a:ext>
              </a:extLst>
            </p:cNvPr>
            <p:cNvSpPr txBox="1"/>
            <p:nvPr/>
          </p:nvSpPr>
          <p:spPr>
            <a:xfrm>
              <a:off x="1296735" y="1087567"/>
              <a:ext cx="7505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NVP (µM)</a:t>
              </a: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14525585-F52A-40A2-AB38-516A54D83FAA}"/>
                </a:ext>
              </a:extLst>
            </p:cNvPr>
            <p:cNvSpPr txBox="1"/>
            <p:nvPr/>
          </p:nvSpPr>
          <p:spPr>
            <a:xfrm>
              <a:off x="2496707" y="1521338"/>
              <a:ext cx="5325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PARP</a:t>
              </a:r>
            </a:p>
          </p:txBody>
        </p:sp>
        <p:cxnSp>
          <p:nvCxnSpPr>
            <p:cNvPr id="15" name="Connettore diritto 14">
              <a:extLst>
                <a:ext uri="{FF2B5EF4-FFF2-40B4-BE49-F238E27FC236}">
                  <a16:creationId xmlns:a16="http://schemas.microsoft.com/office/drawing/2014/main" id="{E3757363-C898-4B35-8853-1637A4223597}"/>
                </a:ext>
              </a:extLst>
            </p:cNvPr>
            <p:cNvCxnSpPr>
              <a:cxnSpLocks/>
            </p:cNvCxnSpPr>
            <p:nvPr/>
          </p:nvCxnSpPr>
          <p:spPr>
            <a:xfrm>
              <a:off x="1219305" y="1290896"/>
              <a:ext cx="81882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9354A362-58E0-4274-837D-B0953FDE9254}"/>
                </a:ext>
              </a:extLst>
            </p:cNvPr>
            <p:cNvSpPr txBox="1"/>
            <p:nvPr/>
          </p:nvSpPr>
          <p:spPr>
            <a:xfrm rot="16200000">
              <a:off x="2067733" y="1166960"/>
              <a:ext cx="4331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STS</a:t>
              </a:r>
            </a:p>
          </p:txBody>
        </p:sp>
      </p:grpSp>
      <p:grpSp>
        <p:nvGrpSpPr>
          <p:cNvPr id="31" name="Gruppo 30">
            <a:extLst>
              <a:ext uri="{FF2B5EF4-FFF2-40B4-BE49-F238E27FC236}">
                <a16:creationId xmlns:a16="http://schemas.microsoft.com/office/drawing/2014/main" id="{BC2DFB6B-1CDA-473C-B1BA-C9691DF202D6}"/>
              </a:ext>
            </a:extLst>
          </p:cNvPr>
          <p:cNvGrpSpPr/>
          <p:nvPr/>
        </p:nvGrpSpPr>
        <p:grpSpPr>
          <a:xfrm>
            <a:off x="476672" y="2005595"/>
            <a:ext cx="2098066" cy="1730499"/>
            <a:chOff x="3529368" y="840680"/>
            <a:chExt cx="2098066" cy="1730499"/>
          </a:xfrm>
        </p:grpSpPr>
        <p:pic>
          <p:nvPicPr>
            <p:cNvPr id="32" name="Immagine 31">
              <a:extLst>
                <a:ext uri="{FF2B5EF4-FFF2-40B4-BE49-F238E27FC236}">
                  <a16:creationId xmlns:a16="http://schemas.microsoft.com/office/drawing/2014/main" id="{D8366E1E-1675-45A7-A4D3-6050FB3DC32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424989" y="970304"/>
              <a:ext cx="1155600" cy="1166400"/>
            </a:xfrm>
            <a:prstGeom prst="rect">
              <a:avLst/>
            </a:prstGeom>
          </p:spPr>
        </p:pic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id="{FD659C48-E5B1-4C4B-9581-07FFD787A4CF}"/>
                </a:ext>
              </a:extLst>
            </p:cNvPr>
            <p:cNvSpPr txBox="1"/>
            <p:nvPr/>
          </p:nvSpPr>
          <p:spPr>
            <a:xfrm rot="16200000">
              <a:off x="3149316" y="1223608"/>
              <a:ext cx="1406435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/>
                <a:t>Fraction</a:t>
              </a:r>
              <a:r>
                <a:rPr lang="it-IT" sz="1200" dirty="0"/>
                <a:t> of </a:t>
              </a:r>
              <a:r>
                <a:rPr lang="it-IT" sz="1200" dirty="0" err="1"/>
                <a:t>cleaved</a:t>
              </a:r>
              <a:r>
                <a:rPr lang="it-IT" sz="1200" dirty="0"/>
                <a:t> PARP</a:t>
              </a:r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0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id="{E158C8DC-E0BE-409B-B367-D2A0F464C106}"/>
                </a:ext>
              </a:extLst>
            </p:cNvPr>
            <p:cNvSpPr txBox="1"/>
            <p:nvPr/>
          </p:nvSpPr>
          <p:spPr>
            <a:xfrm>
              <a:off x="4508569" y="2098606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</a:t>
              </a:r>
            </a:p>
          </p:txBody>
        </p:sp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id="{7EBA4E4A-B8C0-4105-87CD-1A9747CF25E2}"/>
                </a:ext>
              </a:extLst>
            </p:cNvPr>
            <p:cNvSpPr txBox="1"/>
            <p:nvPr/>
          </p:nvSpPr>
          <p:spPr>
            <a:xfrm>
              <a:off x="4004256" y="1405470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0.0</a:t>
              </a:r>
            </a:p>
          </p:txBody>
        </p:sp>
        <p:sp>
          <p:nvSpPr>
            <p:cNvPr id="36" name="CasellaDiTesto 35">
              <a:extLst>
                <a:ext uri="{FF2B5EF4-FFF2-40B4-BE49-F238E27FC236}">
                  <a16:creationId xmlns:a16="http://schemas.microsoft.com/office/drawing/2014/main" id="{EFE50FCD-C152-43A8-B9BA-DD8762CB6891}"/>
                </a:ext>
              </a:extLst>
            </p:cNvPr>
            <p:cNvSpPr txBox="1"/>
            <p:nvPr/>
          </p:nvSpPr>
          <p:spPr>
            <a:xfrm>
              <a:off x="4089214" y="193354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37" name="CasellaDiTesto 36">
              <a:extLst>
                <a:ext uri="{FF2B5EF4-FFF2-40B4-BE49-F238E27FC236}">
                  <a16:creationId xmlns:a16="http://schemas.microsoft.com/office/drawing/2014/main" id="{3BD94BC8-E5B5-405B-A6E6-B412AAADF124}"/>
                </a:ext>
              </a:extLst>
            </p:cNvPr>
            <p:cNvSpPr txBox="1"/>
            <p:nvPr/>
          </p:nvSpPr>
          <p:spPr>
            <a:xfrm>
              <a:off x="4598018" y="2294180"/>
              <a:ext cx="98257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it-IT" sz="1200" dirty="0"/>
                <a:t> NVP (</a:t>
              </a:r>
              <a:r>
                <a:rPr lang="el-G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it-IT" sz="1200" dirty="0"/>
                <a:t>M)</a:t>
              </a:r>
            </a:p>
          </p:txBody>
        </p:sp>
        <p:sp>
          <p:nvSpPr>
            <p:cNvPr id="38" name="CasellaDiTesto 37">
              <a:extLst>
                <a:ext uri="{FF2B5EF4-FFF2-40B4-BE49-F238E27FC236}">
                  <a16:creationId xmlns:a16="http://schemas.microsoft.com/office/drawing/2014/main" id="{F626BF58-2ACF-4246-A3CD-E827E436724E}"/>
                </a:ext>
              </a:extLst>
            </p:cNvPr>
            <p:cNvSpPr txBox="1"/>
            <p:nvPr/>
          </p:nvSpPr>
          <p:spPr>
            <a:xfrm>
              <a:off x="4004256" y="840680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20.0</a:t>
              </a:r>
            </a:p>
          </p:txBody>
        </p:sp>
        <p:sp>
          <p:nvSpPr>
            <p:cNvPr id="39" name="CasellaDiTesto 38">
              <a:extLst>
                <a:ext uri="{FF2B5EF4-FFF2-40B4-BE49-F238E27FC236}">
                  <a16:creationId xmlns:a16="http://schemas.microsoft.com/office/drawing/2014/main" id="{428AA797-D38D-4049-B886-CBC89A348B34}"/>
                </a:ext>
              </a:extLst>
            </p:cNvPr>
            <p:cNvSpPr txBox="1"/>
            <p:nvPr/>
          </p:nvSpPr>
          <p:spPr>
            <a:xfrm>
              <a:off x="4692511" y="2098606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1</a:t>
              </a:r>
            </a:p>
          </p:txBody>
        </p:sp>
        <p:sp>
          <p:nvSpPr>
            <p:cNvPr id="40" name="CasellaDiTesto 39">
              <a:extLst>
                <a:ext uri="{FF2B5EF4-FFF2-40B4-BE49-F238E27FC236}">
                  <a16:creationId xmlns:a16="http://schemas.microsoft.com/office/drawing/2014/main" id="{CB304EBE-658F-4322-B57D-E3AADC6B7268}"/>
                </a:ext>
              </a:extLst>
            </p:cNvPr>
            <p:cNvSpPr txBox="1"/>
            <p:nvPr/>
          </p:nvSpPr>
          <p:spPr>
            <a:xfrm>
              <a:off x="4971142" y="2098606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5</a:t>
              </a:r>
            </a:p>
          </p:txBody>
        </p:sp>
        <p:sp>
          <p:nvSpPr>
            <p:cNvPr id="41" name="CasellaDiTesto 40">
              <a:extLst>
                <a:ext uri="{FF2B5EF4-FFF2-40B4-BE49-F238E27FC236}">
                  <a16:creationId xmlns:a16="http://schemas.microsoft.com/office/drawing/2014/main" id="{DCFF686C-CFB2-47FD-B17C-5B93C18DBC1F}"/>
                </a:ext>
              </a:extLst>
            </p:cNvPr>
            <p:cNvSpPr txBox="1"/>
            <p:nvPr/>
          </p:nvSpPr>
          <p:spPr>
            <a:xfrm>
              <a:off x="5229568" y="2098606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0</a:t>
              </a:r>
            </a:p>
          </p:txBody>
        </p:sp>
        <p:sp>
          <p:nvSpPr>
            <p:cNvPr id="42" name="CasellaDiTesto 41">
              <a:extLst>
                <a:ext uri="{FF2B5EF4-FFF2-40B4-BE49-F238E27FC236}">
                  <a16:creationId xmlns:a16="http://schemas.microsoft.com/office/drawing/2014/main" id="{CDA0F690-446A-461A-A36F-0853C07E3FB0}"/>
                </a:ext>
              </a:extLst>
            </p:cNvPr>
            <p:cNvSpPr txBox="1"/>
            <p:nvPr/>
          </p:nvSpPr>
          <p:spPr>
            <a:xfrm>
              <a:off x="4975579" y="1403648"/>
              <a:ext cx="36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*</a:t>
              </a:r>
            </a:p>
          </p:txBody>
        </p:sp>
        <p:sp>
          <p:nvSpPr>
            <p:cNvPr id="43" name="CasellaDiTesto 42">
              <a:extLst>
                <a:ext uri="{FF2B5EF4-FFF2-40B4-BE49-F238E27FC236}">
                  <a16:creationId xmlns:a16="http://schemas.microsoft.com/office/drawing/2014/main" id="{0DDCE2B3-EDC0-4BDA-9313-E79B3D9C10BA}"/>
                </a:ext>
              </a:extLst>
            </p:cNvPr>
            <p:cNvSpPr txBox="1"/>
            <p:nvPr/>
          </p:nvSpPr>
          <p:spPr>
            <a:xfrm>
              <a:off x="5257755" y="887717"/>
              <a:ext cx="3032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</a:t>
              </a:r>
            </a:p>
          </p:txBody>
        </p:sp>
        <p:sp>
          <p:nvSpPr>
            <p:cNvPr id="44" name="CasellaDiTesto 43">
              <a:extLst>
                <a:ext uri="{FF2B5EF4-FFF2-40B4-BE49-F238E27FC236}">
                  <a16:creationId xmlns:a16="http://schemas.microsoft.com/office/drawing/2014/main" id="{943BE0FA-209A-4CE9-A4E9-041A9FF2F32E}"/>
                </a:ext>
              </a:extLst>
            </p:cNvPr>
            <p:cNvSpPr txBox="1"/>
            <p:nvPr/>
          </p:nvSpPr>
          <p:spPr>
            <a:xfrm>
              <a:off x="4792877" y="1556048"/>
              <a:ext cx="24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</a:t>
              </a:r>
            </a:p>
          </p:txBody>
        </p:sp>
        <p:cxnSp>
          <p:nvCxnSpPr>
            <p:cNvPr id="45" name="Connettore diritto 44">
              <a:extLst>
                <a:ext uri="{FF2B5EF4-FFF2-40B4-BE49-F238E27FC236}">
                  <a16:creationId xmlns:a16="http://schemas.microsoft.com/office/drawing/2014/main" id="{BFAA0EE3-2BEB-4D4E-B7FC-9C1BB1679707}"/>
                </a:ext>
              </a:extLst>
            </p:cNvPr>
            <p:cNvCxnSpPr>
              <a:cxnSpLocks/>
            </p:cNvCxnSpPr>
            <p:nvPr/>
          </p:nvCxnSpPr>
          <p:spPr>
            <a:xfrm>
              <a:off x="4643382" y="2329885"/>
              <a:ext cx="78511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61" name="CasellaDiTesto 60">
            <a:extLst>
              <a:ext uri="{FF2B5EF4-FFF2-40B4-BE49-F238E27FC236}">
                <a16:creationId xmlns:a16="http://schemas.microsoft.com/office/drawing/2014/main" id="{6922C0BB-7C13-409F-93FE-2F1832C01227}"/>
              </a:ext>
            </a:extLst>
          </p:cNvPr>
          <p:cNvSpPr txBox="1"/>
          <p:nvPr/>
        </p:nvSpPr>
        <p:spPr>
          <a:xfrm>
            <a:off x="260648" y="1605932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</a:t>
            </a:r>
            <a:r>
              <a:rPr lang="it-IT" sz="1000" b="1" dirty="0" err="1"/>
              <a:t>a’</a:t>
            </a:r>
            <a:r>
              <a:rPr lang="it-IT" sz="1000" b="1" dirty="0"/>
              <a:t>)</a:t>
            </a:r>
          </a:p>
        </p:txBody>
      </p:sp>
      <p:sp>
        <p:nvSpPr>
          <p:cNvPr id="62" name="CasellaDiTesto 61">
            <a:extLst>
              <a:ext uri="{FF2B5EF4-FFF2-40B4-BE49-F238E27FC236}">
                <a16:creationId xmlns:a16="http://schemas.microsoft.com/office/drawing/2014/main" id="{301321A7-69B4-4147-B218-1388CADB8946}"/>
              </a:ext>
            </a:extLst>
          </p:cNvPr>
          <p:cNvSpPr txBox="1"/>
          <p:nvPr/>
        </p:nvSpPr>
        <p:spPr>
          <a:xfrm>
            <a:off x="3177093" y="1675161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b’)</a:t>
            </a:r>
          </a:p>
        </p:txBody>
      </p:sp>
      <p:sp>
        <p:nvSpPr>
          <p:cNvPr id="63" name="CasellaDiTesto 62">
            <a:extLst>
              <a:ext uri="{FF2B5EF4-FFF2-40B4-BE49-F238E27FC236}">
                <a16:creationId xmlns:a16="http://schemas.microsoft.com/office/drawing/2014/main" id="{E2C144C3-99CE-472E-9125-F27F2C7CB954}"/>
              </a:ext>
            </a:extLst>
          </p:cNvPr>
          <p:cNvSpPr txBox="1"/>
          <p:nvPr/>
        </p:nvSpPr>
        <p:spPr>
          <a:xfrm>
            <a:off x="278281" y="323528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a)</a:t>
            </a:r>
          </a:p>
        </p:txBody>
      </p:sp>
      <p:sp>
        <p:nvSpPr>
          <p:cNvPr id="64" name="CasellaDiTesto 63">
            <a:extLst>
              <a:ext uri="{FF2B5EF4-FFF2-40B4-BE49-F238E27FC236}">
                <a16:creationId xmlns:a16="http://schemas.microsoft.com/office/drawing/2014/main" id="{3B9ED728-373B-4F49-B89C-60DD32CB71A9}"/>
              </a:ext>
            </a:extLst>
          </p:cNvPr>
          <p:cNvSpPr txBox="1"/>
          <p:nvPr/>
        </p:nvSpPr>
        <p:spPr>
          <a:xfrm>
            <a:off x="3194726" y="392757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b)</a:t>
            </a:r>
          </a:p>
        </p:txBody>
      </p:sp>
      <p:grpSp>
        <p:nvGrpSpPr>
          <p:cNvPr id="65" name="Gruppo 64">
            <a:extLst>
              <a:ext uri="{FF2B5EF4-FFF2-40B4-BE49-F238E27FC236}">
                <a16:creationId xmlns:a16="http://schemas.microsoft.com/office/drawing/2014/main" id="{4DB9F742-6131-4665-A145-802A22CB013A}"/>
              </a:ext>
            </a:extLst>
          </p:cNvPr>
          <p:cNvGrpSpPr/>
          <p:nvPr/>
        </p:nvGrpSpPr>
        <p:grpSpPr>
          <a:xfrm>
            <a:off x="3549866" y="3654919"/>
            <a:ext cx="2106424" cy="1747457"/>
            <a:chOff x="4947793" y="5067615"/>
            <a:chExt cx="2106424" cy="1747457"/>
          </a:xfrm>
        </p:grpSpPr>
        <p:pic>
          <p:nvPicPr>
            <p:cNvPr id="66" name="Immagine 65">
              <a:extLst>
                <a:ext uri="{FF2B5EF4-FFF2-40B4-BE49-F238E27FC236}">
                  <a16:creationId xmlns:a16="http://schemas.microsoft.com/office/drawing/2014/main" id="{80A26390-BA48-4CDA-8F50-9605A23598A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605992" y="5197239"/>
              <a:ext cx="1150200" cy="1166400"/>
            </a:xfrm>
            <a:prstGeom prst="rect">
              <a:avLst/>
            </a:prstGeom>
          </p:spPr>
        </p:pic>
        <p:sp>
          <p:nvSpPr>
            <p:cNvPr id="67" name="CasellaDiTesto 66">
              <a:extLst>
                <a:ext uri="{FF2B5EF4-FFF2-40B4-BE49-F238E27FC236}">
                  <a16:creationId xmlns:a16="http://schemas.microsoft.com/office/drawing/2014/main" id="{77A04565-8DB8-4FB8-8978-C880EB964CDD}"/>
                </a:ext>
              </a:extLst>
            </p:cNvPr>
            <p:cNvSpPr txBox="1"/>
            <p:nvPr/>
          </p:nvSpPr>
          <p:spPr>
            <a:xfrm rot="16200000">
              <a:off x="4475408" y="5542876"/>
              <a:ext cx="140643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/>
                <a:t>FOXA1 </a:t>
              </a:r>
              <a:r>
                <a:rPr lang="it-IT" sz="1200" dirty="0" err="1"/>
                <a:t>Levels</a:t>
              </a:r>
              <a:endParaRPr lang="it-IT" sz="1200" dirty="0"/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-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68" name="CasellaDiTesto 67">
              <a:extLst>
                <a:ext uri="{FF2B5EF4-FFF2-40B4-BE49-F238E27FC236}">
                  <a16:creationId xmlns:a16="http://schemas.microsoft.com/office/drawing/2014/main" id="{3694221F-4A5F-4E39-8DC5-770A61B853D5}"/>
                </a:ext>
              </a:extLst>
            </p:cNvPr>
            <p:cNvSpPr txBox="1"/>
            <p:nvPr/>
          </p:nvSpPr>
          <p:spPr>
            <a:xfrm>
              <a:off x="5305537" y="5632405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6</a:t>
              </a:r>
            </a:p>
          </p:txBody>
        </p:sp>
        <p:sp>
          <p:nvSpPr>
            <p:cNvPr id="69" name="CasellaDiTesto 68">
              <a:extLst>
                <a:ext uri="{FF2B5EF4-FFF2-40B4-BE49-F238E27FC236}">
                  <a16:creationId xmlns:a16="http://schemas.microsoft.com/office/drawing/2014/main" id="{4641109E-1805-48E6-9DEA-FBDBB6494916}"/>
                </a:ext>
              </a:extLst>
            </p:cNvPr>
            <p:cNvSpPr txBox="1"/>
            <p:nvPr/>
          </p:nvSpPr>
          <p:spPr>
            <a:xfrm>
              <a:off x="5305537" y="6160479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70" name="CasellaDiTesto 69">
              <a:extLst>
                <a:ext uri="{FF2B5EF4-FFF2-40B4-BE49-F238E27FC236}">
                  <a16:creationId xmlns:a16="http://schemas.microsoft.com/office/drawing/2014/main" id="{60274499-8FF3-4819-B5A7-777EAAE33B15}"/>
                </a:ext>
              </a:extLst>
            </p:cNvPr>
            <p:cNvSpPr txBox="1"/>
            <p:nvPr/>
          </p:nvSpPr>
          <p:spPr>
            <a:xfrm>
              <a:off x="5305537" y="5067615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2</a:t>
              </a:r>
            </a:p>
          </p:txBody>
        </p:sp>
        <p:sp>
          <p:nvSpPr>
            <p:cNvPr id="71" name="CasellaDiTesto 70">
              <a:extLst>
                <a:ext uri="{FF2B5EF4-FFF2-40B4-BE49-F238E27FC236}">
                  <a16:creationId xmlns:a16="http://schemas.microsoft.com/office/drawing/2014/main" id="{EC92B580-9DAE-413B-9622-2D45B147CA08}"/>
                </a:ext>
              </a:extLst>
            </p:cNvPr>
            <p:cNvSpPr txBox="1"/>
            <p:nvPr/>
          </p:nvSpPr>
          <p:spPr>
            <a:xfrm>
              <a:off x="6118482" y="5807169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**</a:t>
              </a:r>
            </a:p>
          </p:txBody>
        </p:sp>
        <p:sp>
          <p:nvSpPr>
            <p:cNvPr id="72" name="CasellaDiTesto 71">
              <a:extLst>
                <a:ext uri="{FF2B5EF4-FFF2-40B4-BE49-F238E27FC236}">
                  <a16:creationId xmlns:a16="http://schemas.microsoft.com/office/drawing/2014/main" id="{24B1E45E-C1C9-449A-B920-269126A993A3}"/>
                </a:ext>
              </a:extLst>
            </p:cNvPr>
            <p:cNvSpPr txBox="1"/>
            <p:nvPr/>
          </p:nvSpPr>
          <p:spPr>
            <a:xfrm>
              <a:off x="6372083" y="5652120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**</a:t>
              </a:r>
            </a:p>
          </p:txBody>
        </p:sp>
        <p:sp>
          <p:nvSpPr>
            <p:cNvPr id="73" name="CasellaDiTesto 72">
              <a:extLst>
                <a:ext uri="{FF2B5EF4-FFF2-40B4-BE49-F238E27FC236}">
                  <a16:creationId xmlns:a16="http://schemas.microsoft.com/office/drawing/2014/main" id="{8B77D8C2-4F0F-4862-AAC3-50AEA78DD9AE}"/>
                </a:ext>
              </a:extLst>
            </p:cNvPr>
            <p:cNvSpPr txBox="1"/>
            <p:nvPr/>
          </p:nvSpPr>
          <p:spPr>
            <a:xfrm>
              <a:off x="5892535" y="5148064"/>
              <a:ext cx="36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*</a:t>
              </a:r>
            </a:p>
          </p:txBody>
        </p:sp>
        <p:sp>
          <p:nvSpPr>
            <p:cNvPr id="74" name="CasellaDiTesto 73">
              <a:extLst>
                <a:ext uri="{FF2B5EF4-FFF2-40B4-BE49-F238E27FC236}">
                  <a16:creationId xmlns:a16="http://schemas.microsoft.com/office/drawing/2014/main" id="{AC4F6746-1E71-4126-B2B5-15B286D964EF}"/>
                </a:ext>
              </a:extLst>
            </p:cNvPr>
            <p:cNvSpPr txBox="1"/>
            <p:nvPr/>
          </p:nvSpPr>
          <p:spPr>
            <a:xfrm>
              <a:off x="5689786" y="6329941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-</a:t>
              </a:r>
            </a:p>
          </p:txBody>
        </p:sp>
        <p:sp>
          <p:nvSpPr>
            <p:cNvPr id="75" name="CasellaDiTesto 74">
              <a:extLst>
                <a:ext uri="{FF2B5EF4-FFF2-40B4-BE49-F238E27FC236}">
                  <a16:creationId xmlns:a16="http://schemas.microsoft.com/office/drawing/2014/main" id="{23C178FA-51F0-40B2-A0B9-4B29A803BC1D}"/>
                </a:ext>
              </a:extLst>
            </p:cNvPr>
            <p:cNvSpPr txBox="1"/>
            <p:nvPr/>
          </p:nvSpPr>
          <p:spPr>
            <a:xfrm>
              <a:off x="5943906" y="6329941"/>
              <a:ext cx="2504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+</a:t>
              </a:r>
            </a:p>
          </p:txBody>
        </p:sp>
        <p:sp>
          <p:nvSpPr>
            <p:cNvPr id="76" name="CasellaDiTesto 75">
              <a:extLst>
                <a:ext uri="{FF2B5EF4-FFF2-40B4-BE49-F238E27FC236}">
                  <a16:creationId xmlns:a16="http://schemas.microsoft.com/office/drawing/2014/main" id="{2B6025B9-E930-421E-9DD4-3F28D134B024}"/>
                </a:ext>
              </a:extLst>
            </p:cNvPr>
            <p:cNvSpPr txBox="1"/>
            <p:nvPr/>
          </p:nvSpPr>
          <p:spPr>
            <a:xfrm>
              <a:off x="6673407" y="6329941"/>
              <a:ext cx="3808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Tel</a:t>
              </a:r>
            </a:p>
          </p:txBody>
        </p:sp>
        <p:sp>
          <p:nvSpPr>
            <p:cNvPr id="77" name="CasellaDiTesto 76">
              <a:extLst>
                <a:ext uri="{FF2B5EF4-FFF2-40B4-BE49-F238E27FC236}">
                  <a16:creationId xmlns:a16="http://schemas.microsoft.com/office/drawing/2014/main" id="{6859EB66-F2E2-4B32-8BD9-BBC481D7B6DB}"/>
                </a:ext>
              </a:extLst>
            </p:cNvPr>
            <p:cNvSpPr txBox="1"/>
            <p:nvPr/>
          </p:nvSpPr>
          <p:spPr>
            <a:xfrm>
              <a:off x="6210046" y="6329941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-</a:t>
              </a:r>
            </a:p>
          </p:txBody>
        </p:sp>
        <p:sp>
          <p:nvSpPr>
            <p:cNvPr id="78" name="CasellaDiTesto 77">
              <a:extLst>
                <a:ext uri="{FF2B5EF4-FFF2-40B4-BE49-F238E27FC236}">
                  <a16:creationId xmlns:a16="http://schemas.microsoft.com/office/drawing/2014/main" id="{8D4EC3AB-312C-41B0-8496-FBF75C6E6C27}"/>
                </a:ext>
              </a:extLst>
            </p:cNvPr>
            <p:cNvSpPr txBox="1"/>
            <p:nvPr/>
          </p:nvSpPr>
          <p:spPr>
            <a:xfrm>
              <a:off x="6445116" y="6329941"/>
              <a:ext cx="2504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+</a:t>
              </a:r>
            </a:p>
          </p:txBody>
        </p:sp>
        <p:cxnSp>
          <p:nvCxnSpPr>
            <p:cNvPr id="79" name="Connettore diritto 78">
              <a:extLst>
                <a:ext uri="{FF2B5EF4-FFF2-40B4-BE49-F238E27FC236}">
                  <a16:creationId xmlns:a16="http://schemas.microsoft.com/office/drawing/2014/main" id="{2F5BE2CE-B868-4D60-BAE7-E6EB4809C2FB}"/>
                </a:ext>
              </a:extLst>
            </p:cNvPr>
            <p:cNvCxnSpPr>
              <a:cxnSpLocks/>
            </p:cNvCxnSpPr>
            <p:nvPr/>
          </p:nvCxnSpPr>
          <p:spPr>
            <a:xfrm>
              <a:off x="6328027" y="6581540"/>
              <a:ext cx="24231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0" name="CasellaDiTesto 79">
              <a:extLst>
                <a:ext uri="{FF2B5EF4-FFF2-40B4-BE49-F238E27FC236}">
                  <a16:creationId xmlns:a16="http://schemas.microsoft.com/office/drawing/2014/main" id="{DD0C9786-0DB0-4338-9E39-FE50C86B09DA}"/>
                </a:ext>
              </a:extLst>
            </p:cNvPr>
            <p:cNvSpPr txBox="1"/>
            <p:nvPr/>
          </p:nvSpPr>
          <p:spPr>
            <a:xfrm>
              <a:off x="6049369" y="6538073"/>
              <a:ext cx="80021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siFOXA1</a:t>
              </a:r>
            </a:p>
          </p:txBody>
        </p:sp>
        <p:sp>
          <p:nvSpPr>
            <p:cNvPr id="81" name="CasellaDiTesto 80">
              <a:extLst>
                <a:ext uri="{FF2B5EF4-FFF2-40B4-BE49-F238E27FC236}">
                  <a16:creationId xmlns:a16="http://schemas.microsoft.com/office/drawing/2014/main" id="{446E567A-B262-4BF4-B6CF-61A4A590E81D}"/>
                </a:ext>
              </a:extLst>
            </p:cNvPr>
            <p:cNvSpPr txBox="1"/>
            <p:nvPr/>
          </p:nvSpPr>
          <p:spPr>
            <a:xfrm>
              <a:off x="6370106" y="5804520"/>
              <a:ext cx="4283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°°°°</a:t>
              </a:r>
            </a:p>
          </p:txBody>
        </p:sp>
      </p:grpSp>
      <p:grpSp>
        <p:nvGrpSpPr>
          <p:cNvPr id="82" name="Gruppo 81">
            <a:extLst>
              <a:ext uri="{FF2B5EF4-FFF2-40B4-BE49-F238E27FC236}">
                <a16:creationId xmlns:a16="http://schemas.microsoft.com/office/drawing/2014/main" id="{19C8D64A-9DF6-47CF-ADEF-D3EFFFFDDA21}"/>
              </a:ext>
            </a:extLst>
          </p:cNvPr>
          <p:cNvGrpSpPr/>
          <p:nvPr/>
        </p:nvGrpSpPr>
        <p:grpSpPr>
          <a:xfrm>
            <a:off x="431608" y="5618156"/>
            <a:ext cx="2514043" cy="1747457"/>
            <a:chOff x="2211101" y="7379146"/>
            <a:chExt cx="2514043" cy="1747457"/>
          </a:xfrm>
        </p:grpSpPr>
        <p:grpSp>
          <p:nvGrpSpPr>
            <p:cNvPr id="83" name="Gruppo 82">
              <a:extLst>
                <a:ext uri="{FF2B5EF4-FFF2-40B4-BE49-F238E27FC236}">
                  <a16:creationId xmlns:a16="http://schemas.microsoft.com/office/drawing/2014/main" id="{43BB6C14-CA56-4C4F-9C3D-3B040F093363}"/>
                </a:ext>
              </a:extLst>
            </p:cNvPr>
            <p:cNvGrpSpPr/>
            <p:nvPr/>
          </p:nvGrpSpPr>
          <p:grpSpPr>
            <a:xfrm>
              <a:off x="2211101" y="7379146"/>
              <a:ext cx="2514043" cy="1747457"/>
              <a:chOff x="3788776" y="4867344"/>
              <a:chExt cx="2514043" cy="1747457"/>
            </a:xfrm>
          </p:grpSpPr>
          <p:pic>
            <p:nvPicPr>
              <p:cNvPr id="85" name="Immagine 84">
                <a:extLst>
                  <a:ext uri="{FF2B5EF4-FFF2-40B4-BE49-F238E27FC236}">
                    <a16:creationId xmlns:a16="http://schemas.microsoft.com/office/drawing/2014/main" id="{75F3CE48-2AAC-436C-8128-99A4A757612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4795219" y="4996968"/>
                <a:ext cx="1171825" cy="1166400"/>
              </a:xfrm>
              <a:prstGeom prst="rect">
                <a:avLst/>
              </a:prstGeom>
            </p:spPr>
          </p:pic>
          <p:sp>
            <p:nvSpPr>
              <p:cNvPr id="86" name="CasellaDiTesto 85">
                <a:extLst>
                  <a:ext uri="{FF2B5EF4-FFF2-40B4-BE49-F238E27FC236}">
                    <a16:creationId xmlns:a16="http://schemas.microsoft.com/office/drawing/2014/main" id="{FC0E80E2-3C02-47AA-BC35-AE76A69C7350}"/>
                  </a:ext>
                </a:extLst>
              </p:cNvPr>
              <p:cNvSpPr txBox="1"/>
              <p:nvPr/>
            </p:nvSpPr>
            <p:spPr>
              <a:xfrm rot="16200000">
                <a:off x="3408724" y="5250272"/>
                <a:ext cx="140643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 err="1"/>
                  <a:t>Fraction</a:t>
                </a:r>
                <a:r>
                  <a:rPr lang="it-IT" sz="1200" dirty="0"/>
                  <a:t> of </a:t>
                </a:r>
                <a:r>
                  <a:rPr lang="it-IT" sz="1200" dirty="0" err="1"/>
                  <a:t>cleaved</a:t>
                </a:r>
                <a:r>
                  <a:rPr lang="it-IT" sz="1200" dirty="0"/>
                  <a:t> PARP</a:t>
                </a:r>
              </a:p>
              <a:p>
                <a:pPr algn="ctr"/>
                <a:r>
                  <a:rPr lang="it-IT" sz="1200" dirty="0"/>
                  <a:t>(</a:t>
                </a:r>
                <a:r>
                  <a:rPr lang="it-IT" sz="1200" dirty="0" err="1"/>
                  <a:t>Fold</a:t>
                </a:r>
                <a:r>
                  <a:rPr lang="it-IT" sz="1200" dirty="0"/>
                  <a:t> on -)</a:t>
                </a:r>
                <a:endParaRPr lang="it-IT" sz="1200" dirty="0">
                  <a:latin typeface="+mn-lt"/>
                  <a:cs typeface="Times New Roman" panose="02020603050405020304" pitchFamily="18" charset="0"/>
                </a:endParaRPr>
              </a:p>
            </p:txBody>
          </p:sp>
          <p:sp>
            <p:nvSpPr>
              <p:cNvPr id="87" name="CasellaDiTesto 86">
                <a:extLst>
                  <a:ext uri="{FF2B5EF4-FFF2-40B4-BE49-F238E27FC236}">
                    <a16:creationId xmlns:a16="http://schemas.microsoft.com/office/drawing/2014/main" id="{7B2C5F20-D9FF-4638-ADAC-4E51094F1789}"/>
                  </a:ext>
                </a:extLst>
              </p:cNvPr>
              <p:cNvSpPr txBox="1"/>
              <p:nvPr/>
            </p:nvSpPr>
            <p:spPr>
              <a:xfrm>
                <a:off x="4324846" y="5432134"/>
                <a:ext cx="5677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50.0</a:t>
                </a:r>
              </a:p>
            </p:txBody>
          </p:sp>
          <p:sp>
            <p:nvSpPr>
              <p:cNvPr id="88" name="CasellaDiTesto 87">
                <a:extLst>
                  <a:ext uri="{FF2B5EF4-FFF2-40B4-BE49-F238E27FC236}">
                    <a16:creationId xmlns:a16="http://schemas.microsoft.com/office/drawing/2014/main" id="{D308313F-B440-45D7-BE71-B9F34AA36CE5}"/>
                  </a:ext>
                </a:extLst>
              </p:cNvPr>
              <p:cNvSpPr txBox="1"/>
              <p:nvPr/>
            </p:nvSpPr>
            <p:spPr>
              <a:xfrm>
                <a:off x="4494764" y="5960208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0.0</a:t>
                </a:r>
              </a:p>
            </p:txBody>
          </p:sp>
          <p:sp>
            <p:nvSpPr>
              <p:cNvPr id="89" name="CasellaDiTesto 88">
                <a:extLst>
                  <a:ext uri="{FF2B5EF4-FFF2-40B4-BE49-F238E27FC236}">
                    <a16:creationId xmlns:a16="http://schemas.microsoft.com/office/drawing/2014/main" id="{1ADBACA0-83FF-466A-BF65-488D0DBAE762}"/>
                  </a:ext>
                </a:extLst>
              </p:cNvPr>
              <p:cNvSpPr txBox="1"/>
              <p:nvPr/>
            </p:nvSpPr>
            <p:spPr>
              <a:xfrm>
                <a:off x="4324846" y="4867344"/>
                <a:ext cx="5677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300.0</a:t>
                </a:r>
              </a:p>
            </p:txBody>
          </p:sp>
          <p:sp>
            <p:nvSpPr>
              <p:cNvPr id="90" name="CasellaDiTesto 89">
                <a:extLst>
                  <a:ext uri="{FF2B5EF4-FFF2-40B4-BE49-F238E27FC236}">
                    <a16:creationId xmlns:a16="http://schemas.microsoft.com/office/drawing/2014/main" id="{C20B9299-99CF-4953-860C-C0DFBBF8409A}"/>
                  </a:ext>
                </a:extLst>
              </p:cNvPr>
              <p:cNvSpPr txBox="1"/>
              <p:nvPr/>
            </p:nvSpPr>
            <p:spPr>
              <a:xfrm>
                <a:off x="5307709" y="5270141"/>
                <a:ext cx="4219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****</a:t>
                </a:r>
              </a:p>
            </p:txBody>
          </p:sp>
          <p:sp>
            <p:nvSpPr>
              <p:cNvPr id="91" name="CasellaDiTesto 90">
                <a:extLst>
                  <a:ext uri="{FF2B5EF4-FFF2-40B4-BE49-F238E27FC236}">
                    <a16:creationId xmlns:a16="http://schemas.microsoft.com/office/drawing/2014/main" id="{F0A15366-ED7B-4BC9-B34C-FF7360077A5D}"/>
                  </a:ext>
                </a:extLst>
              </p:cNvPr>
              <p:cNvSpPr txBox="1"/>
              <p:nvPr/>
            </p:nvSpPr>
            <p:spPr>
              <a:xfrm>
                <a:off x="5561310" y="5087089"/>
                <a:ext cx="4219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****</a:t>
                </a:r>
              </a:p>
            </p:txBody>
          </p:sp>
          <p:sp>
            <p:nvSpPr>
              <p:cNvPr id="92" name="CasellaDiTesto 91">
                <a:extLst>
                  <a:ext uri="{FF2B5EF4-FFF2-40B4-BE49-F238E27FC236}">
                    <a16:creationId xmlns:a16="http://schemas.microsoft.com/office/drawing/2014/main" id="{918C89DB-A194-485A-994D-89CFE4DCBA6C}"/>
                  </a:ext>
                </a:extLst>
              </p:cNvPr>
              <p:cNvSpPr txBox="1"/>
              <p:nvPr/>
            </p:nvSpPr>
            <p:spPr>
              <a:xfrm>
                <a:off x="5081762" y="5449782"/>
                <a:ext cx="3626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***</a:t>
                </a:r>
              </a:p>
            </p:txBody>
          </p:sp>
          <p:sp>
            <p:nvSpPr>
              <p:cNvPr id="93" name="CasellaDiTesto 92">
                <a:extLst>
                  <a:ext uri="{FF2B5EF4-FFF2-40B4-BE49-F238E27FC236}">
                    <a16:creationId xmlns:a16="http://schemas.microsoft.com/office/drawing/2014/main" id="{D42BAEA4-6E69-4E1C-A343-F4D18A0259F8}"/>
                  </a:ext>
                </a:extLst>
              </p:cNvPr>
              <p:cNvSpPr txBox="1"/>
              <p:nvPr/>
            </p:nvSpPr>
            <p:spPr>
              <a:xfrm>
                <a:off x="4879013" y="6129670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94" name="CasellaDiTesto 93">
                <a:extLst>
                  <a:ext uri="{FF2B5EF4-FFF2-40B4-BE49-F238E27FC236}">
                    <a16:creationId xmlns:a16="http://schemas.microsoft.com/office/drawing/2014/main" id="{F8CD4335-6895-4D26-B05D-9C7BF3D9BF44}"/>
                  </a:ext>
                </a:extLst>
              </p:cNvPr>
              <p:cNvSpPr txBox="1"/>
              <p:nvPr/>
            </p:nvSpPr>
            <p:spPr>
              <a:xfrm>
                <a:off x="5133133" y="6129670"/>
                <a:ext cx="2504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95" name="CasellaDiTesto 94">
                <a:extLst>
                  <a:ext uri="{FF2B5EF4-FFF2-40B4-BE49-F238E27FC236}">
                    <a16:creationId xmlns:a16="http://schemas.microsoft.com/office/drawing/2014/main" id="{397A4A73-FC54-478C-9BEE-6E9EEFE367E0}"/>
                  </a:ext>
                </a:extLst>
              </p:cNvPr>
              <p:cNvSpPr txBox="1"/>
              <p:nvPr/>
            </p:nvSpPr>
            <p:spPr>
              <a:xfrm>
                <a:off x="5922009" y="6129670"/>
                <a:ext cx="3808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Tel</a:t>
                </a:r>
              </a:p>
            </p:txBody>
          </p:sp>
          <p:sp>
            <p:nvSpPr>
              <p:cNvPr id="96" name="CasellaDiTesto 95">
                <a:extLst>
                  <a:ext uri="{FF2B5EF4-FFF2-40B4-BE49-F238E27FC236}">
                    <a16:creationId xmlns:a16="http://schemas.microsoft.com/office/drawing/2014/main" id="{27F922E9-B076-408D-8552-9C2BB72A8A0D}"/>
                  </a:ext>
                </a:extLst>
              </p:cNvPr>
              <p:cNvSpPr txBox="1"/>
              <p:nvPr/>
            </p:nvSpPr>
            <p:spPr>
              <a:xfrm>
                <a:off x="5399273" y="6129670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97" name="CasellaDiTesto 96">
                <a:extLst>
                  <a:ext uri="{FF2B5EF4-FFF2-40B4-BE49-F238E27FC236}">
                    <a16:creationId xmlns:a16="http://schemas.microsoft.com/office/drawing/2014/main" id="{70116E7F-C93D-4FFE-B4CD-3FCC80F19361}"/>
                  </a:ext>
                </a:extLst>
              </p:cNvPr>
              <p:cNvSpPr txBox="1"/>
              <p:nvPr/>
            </p:nvSpPr>
            <p:spPr>
              <a:xfrm>
                <a:off x="5634343" y="6129670"/>
                <a:ext cx="2504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cxnSp>
            <p:nvCxnSpPr>
              <p:cNvPr id="98" name="Connettore diritto 97">
                <a:extLst>
                  <a:ext uri="{FF2B5EF4-FFF2-40B4-BE49-F238E27FC236}">
                    <a16:creationId xmlns:a16="http://schemas.microsoft.com/office/drawing/2014/main" id="{C4D91BB4-D3A3-4D36-B51E-97D33B1D39B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17254" y="6381269"/>
                <a:ext cx="242318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9" name="CasellaDiTesto 98">
                <a:extLst>
                  <a:ext uri="{FF2B5EF4-FFF2-40B4-BE49-F238E27FC236}">
                    <a16:creationId xmlns:a16="http://schemas.microsoft.com/office/drawing/2014/main" id="{DA2F492E-03C5-4D85-9387-3C96FD27C33D}"/>
                  </a:ext>
                </a:extLst>
              </p:cNvPr>
              <p:cNvSpPr txBox="1"/>
              <p:nvPr/>
            </p:nvSpPr>
            <p:spPr>
              <a:xfrm>
                <a:off x="5398616" y="6337802"/>
                <a:ext cx="5004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NVP</a:t>
                </a:r>
              </a:p>
            </p:txBody>
          </p:sp>
        </p:grpSp>
        <p:sp>
          <p:nvSpPr>
            <p:cNvPr id="84" name="CasellaDiTesto 83">
              <a:extLst>
                <a:ext uri="{FF2B5EF4-FFF2-40B4-BE49-F238E27FC236}">
                  <a16:creationId xmlns:a16="http://schemas.microsoft.com/office/drawing/2014/main" id="{35359487-6AEA-4838-BD45-0DA6C0F4B165}"/>
                </a:ext>
              </a:extLst>
            </p:cNvPr>
            <p:cNvSpPr txBox="1"/>
            <p:nvPr/>
          </p:nvSpPr>
          <p:spPr>
            <a:xfrm>
              <a:off x="3980429" y="7474444"/>
              <a:ext cx="4283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°°°°</a:t>
              </a:r>
            </a:p>
          </p:txBody>
        </p:sp>
      </p:grpSp>
      <p:grpSp>
        <p:nvGrpSpPr>
          <p:cNvPr id="100" name="Gruppo 99">
            <a:extLst>
              <a:ext uri="{FF2B5EF4-FFF2-40B4-BE49-F238E27FC236}">
                <a16:creationId xmlns:a16="http://schemas.microsoft.com/office/drawing/2014/main" id="{0F10B6E2-C54F-4709-897B-4825D1D1B210}"/>
              </a:ext>
            </a:extLst>
          </p:cNvPr>
          <p:cNvGrpSpPr/>
          <p:nvPr/>
        </p:nvGrpSpPr>
        <p:grpSpPr>
          <a:xfrm>
            <a:off x="534913" y="3621172"/>
            <a:ext cx="2376883" cy="1814951"/>
            <a:chOff x="2339056" y="5133313"/>
            <a:chExt cx="2376883" cy="1814951"/>
          </a:xfrm>
        </p:grpSpPr>
        <p:grpSp>
          <p:nvGrpSpPr>
            <p:cNvPr id="101" name="Gruppo 100">
              <a:extLst>
                <a:ext uri="{FF2B5EF4-FFF2-40B4-BE49-F238E27FC236}">
                  <a16:creationId xmlns:a16="http://schemas.microsoft.com/office/drawing/2014/main" id="{798E0C87-3600-4929-B671-A0CF62A3D05C}"/>
                </a:ext>
              </a:extLst>
            </p:cNvPr>
            <p:cNvGrpSpPr/>
            <p:nvPr/>
          </p:nvGrpSpPr>
          <p:grpSpPr>
            <a:xfrm>
              <a:off x="2339056" y="5200807"/>
              <a:ext cx="2376883" cy="1747457"/>
              <a:chOff x="-25065" y="6465678"/>
              <a:chExt cx="2376883" cy="1747457"/>
            </a:xfrm>
          </p:grpSpPr>
          <p:pic>
            <p:nvPicPr>
              <p:cNvPr id="103" name="Immagine 102">
                <a:extLst>
                  <a:ext uri="{FF2B5EF4-FFF2-40B4-BE49-F238E27FC236}">
                    <a16:creationId xmlns:a16="http://schemas.microsoft.com/office/drawing/2014/main" id="{AFE700C7-5D3A-4B81-A842-F91ED71C903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844218" y="6595302"/>
                <a:ext cx="1144800" cy="1166400"/>
              </a:xfrm>
              <a:prstGeom prst="rect">
                <a:avLst/>
              </a:prstGeom>
            </p:spPr>
          </p:pic>
          <p:sp>
            <p:nvSpPr>
              <p:cNvPr id="104" name="CasellaDiTesto 103">
                <a:extLst>
                  <a:ext uri="{FF2B5EF4-FFF2-40B4-BE49-F238E27FC236}">
                    <a16:creationId xmlns:a16="http://schemas.microsoft.com/office/drawing/2014/main" id="{FD992E47-7C79-4E37-B92D-8EDDEEF4C3C3}"/>
                  </a:ext>
                </a:extLst>
              </p:cNvPr>
              <p:cNvSpPr txBox="1"/>
              <p:nvPr/>
            </p:nvSpPr>
            <p:spPr>
              <a:xfrm rot="16200000">
                <a:off x="-405117" y="6848606"/>
                <a:ext cx="140643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dirty="0" err="1"/>
                  <a:t>Fraction</a:t>
                </a:r>
                <a:r>
                  <a:rPr lang="it-IT" sz="1200" dirty="0"/>
                  <a:t> of </a:t>
                </a:r>
                <a:r>
                  <a:rPr lang="it-IT" sz="1200" dirty="0" err="1"/>
                  <a:t>cleaved</a:t>
                </a:r>
                <a:r>
                  <a:rPr lang="it-IT" sz="1200" dirty="0"/>
                  <a:t> PARP</a:t>
                </a:r>
              </a:p>
              <a:p>
                <a:pPr algn="ctr"/>
                <a:r>
                  <a:rPr lang="it-IT" sz="1200" dirty="0"/>
                  <a:t>(</a:t>
                </a:r>
                <a:r>
                  <a:rPr lang="it-IT" sz="1200" dirty="0" err="1"/>
                  <a:t>Fold</a:t>
                </a:r>
                <a:r>
                  <a:rPr lang="it-IT" sz="1200" dirty="0"/>
                  <a:t> on -)</a:t>
                </a:r>
                <a:endParaRPr lang="it-IT" sz="1200" dirty="0">
                  <a:latin typeface="+mn-lt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" name="CasellaDiTesto 104">
                <a:extLst>
                  <a:ext uri="{FF2B5EF4-FFF2-40B4-BE49-F238E27FC236}">
                    <a16:creationId xmlns:a16="http://schemas.microsoft.com/office/drawing/2014/main" id="{B66348E8-5950-4104-9220-144B255450CE}"/>
                  </a:ext>
                </a:extLst>
              </p:cNvPr>
              <p:cNvSpPr txBox="1"/>
              <p:nvPr/>
            </p:nvSpPr>
            <p:spPr>
              <a:xfrm>
                <a:off x="543763" y="7030468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6.0</a:t>
                </a:r>
              </a:p>
            </p:txBody>
          </p:sp>
          <p:sp>
            <p:nvSpPr>
              <p:cNvPr id="106" name="CasellaDiTesto 105">
                <a:extLst>
                  <a:ext uri="{FF2B5EF4-FFF2-40B4-BE49-F238E27FC236}">
                    <a16:creationId xmlns:a16="http://schemas.microsoft.com/office/drawing/2014/main" id="{18F96A3A-2D09-49F8-A7E8-DE6CF9359CA8}"/>
                  </a:ext>
                </a:extLst>
              </p:cNvPr>
              <p:cNvSpPr txBox="1"/>
              <p:nvPr/>
            </p:nvSpPr>
            <p:spPr>
              <a:xfrm>
                <a:off x="543763" y="7558542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0.0</a:t>
                </a:r>
              </a:p>
            </p:txBody>
          </p:sp>
          <p:sp>
            <p:nvSpPr>
              <p:cNvPr id="107" name="CasellaDiTesto 106">
                <a:extLst>
                  <a:ext uri="{FF2B5EF4-FFF2-40B4-BE49-F238E27FC236}">
                    <a16:creationId xmlns:a16="http://schemas.microsoft.com/office/drawing/2014/main" id="{69979651-FB30-4A02-8E9A-EB7CD5ED2C0E}"/>
                  </a:ext>
                </a:extLst>
              </p:cNvPr>
              <p:cNvSpPr txBox="1"/>
              <p:nvPr/>
            </p:nvSpPr>
            <p:spPr>
              <a:xfrm>
                <a:off x="458805" y="6465678"/>
                <a:ext cx="48282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12.0</a:t>
                </a:r>
              </a:p>
            </p:txBody>
          </p:sp>
          <p:sp>
            <p:nvSpPr>
              <p:cNvPr id="108" name="CasellaDiTesto 107">
                <a:extLst>
                  <a:ext uri="{FF2B5EF4-FFF2-40B4-BE49-F238E27FC236}">
                    <a16:creationId xmlns:a16="http://schemas.microsoft.com/office/drawing/2014/main" id="{7DE343C8-C69E-4E51-BC5D-ECBEA1BAF9BE}"/>
                  </a:ext>
                </a:extLst>
              </p:cNvPr>
              <p:cNvSpPr txBox="1"/>
              <p:nvPr/>
            </p:nvSpPr>
            <p:spPr>
              <a:xfrm>
                <a:off x="1356708" y="6868475"/>
                <a:ext cx="4219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****</a:t>
                </a:r>
              </a:p>
            </p:txBody>
          </p:sp>
          <p:sp>
            <p:nvSpPr>
              <p:cNvPr id="109" name="CasellaDiTesto 108">
                <a:extLst>
                  <a:ext uri="{FF2B5EF4-FFF2-40B4-BE49-F238E27FC236}">
                    <a16:creationId xmlns:a16="http://schemas.microsoft.com/office/drawing/2014/main" id="{5F521781-8657-4CF0-A2DE-6421B14F4551}"/>
                  </a:ext>
                </a:extLst>
              </p:cNvPr>
              <p:cNvSpPr txBox="1"/>
              <p:nvPr/>
            </p:nvSpPr>
            <p:spPr>
              <a:xfrm>
                <a:off x="1610309" y="6516216"/>
                <a:ext cx="4219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****</a:t>
                </a:r>
              </a:p>
            </p:txBody>
          </p:sp>
          <p:sp>
            <p:nvSpPr>
              <p:cNvPr id="110" name="CasellaDiTesto 109">
                <a:extLst>
                  <a:ext uri="{FF2B5EF4-FFF2-40B4-BE49-F238E27FC236}">
                    <a16:creationId xmlns:a16="http://schemas.microsoft.com/office/drawing/2014/main" id="{E4193FF6-8A46-4581-9793-BADF555BB14F}"/>
                  </a:ext>
                </a:extLst>
              </p:cNvPr>
              <p:cNvSpPr txBox="1"/>
              <p:nvPr/>
            </p:nvSpPr>
            <p:spPr>
              <a:xfrm>
                <a:off x="1130761" y="7048116"/>
                <a:ext cx="3626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***</a:t>
                </a:r>
              </a:p>
            </p:txBody>
          </p:sp>
          <p:sp>
            <p:nvSpPr>
              <p:cNvPr id="111" name="CasellaDiTesto 110">
                <a:extLst>
                  <a:ext uri="{FF2B5EF4-FFF2-40B4-BE49-F238E27FC236}">
                    <a16:creationId xmlns:a16="http://schemas.microsoft.com/office/drawing/2014/main" id="{F7B52921-3417-4F58-86A8-A90D279B423A}"/>
                  </a:ext>
                </a:extLst>
              </p:cNvPr>
              <p:cNvSpPr txBox="1"/>
              <p:nvPr/>
            </p:nvSpPr>
            <p:spPr>
              <a:xfrm>
                <a:off x="928012" y="7728004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112" name="CasellaDiTesto 111">
                <a:extLst>
                  <a:ext uri="{FF2B5EF4-FFF2-40B4-BE49-F238E27FC236}">
                    <a16:creationId xmlns:a16="http://schemas.microsoft.com/office/drawing/2014/main" id="{2ED7EE37-B822-402D-B632-E3C085EB4312}"/>
                  </a:ext>
                </a:extLst>
              </p:cNvPr>
              <p:cNvSpPr txBox="1"/>
              <p:nvPr/>
            </p:nvSpPr>
            <p:spPr>
              <a:xfrm>
                <a:off x="1182132" y="7728004"/>
                <a:ext cx="2504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sp>
            <p:nvSpPr>
              <p:cNvPr id="113" name="CasellaDiTesto 112">
                <a:extLst>
                  <a:ext uri="{FF2B5EF4-FFF2-40B4-BE49-F238E27FC236}">
                    <a16:creationId xmlns:a16="http://schemas.microsoft.com/office/drawing/2014/main" id="{741D3C70-2282-4F98-B5D5-568965AFE8E0}"/>
                  </a:ext>
                </a:extLst>
              </p:cNvPr>
              <p:cNvSpPr txBox="1"/>
              <p:nvPr/>
            </p:nvSpPr>
            <p:spPr>
              <a:xfrm>
                <a:off x="1971008" y="7728004"/>
                <a:ext cx="3808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Tel</a:t>
                </a:r>
              </a:p>
            </p:txBody>
          </p:sp>
          <p:sp>
            <p:nvSpPr>
              <p:cNvPr id="114" name="CasellaDiTesto 113">
                <a:extLst>
                  <a:ext uri="{FF2B5EF4-FFF2-40B4-BE49-F238E27FC236}">
                    <a16:creationId xmlns:a16="http://schemas.microsoft.com/office/drawing/2014/main" id="{E061E1BD-479D-4D42-81EF-849F0E43FA74}"/>
                  </a:ext>
                </a:extLst>
              </p:cNvPr>
              <p:cNvSpPr txBox="1"/>
              <p:nvPr/>
            </p:nvSpPr>
            <p:spPr>
              <a:xfrm>
                <a:off x="1448272" y="7728004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-</a:t>
                </a:r>
              </a:p>
            </p:txBody>
          </p:sp>
          <p:sp>
            <p:nvSpPr>
              <p:cNvPr id="115" name="CasellaDiTesto 114">
                <a:extLst>
                  <a:ext uri="{FF2B5EF4-FFF2-40B4-BE49-F238E27FC236}">
                    <a16:creationId xmlns:a16="http://schemas.microsoft.com/office/drawing/2014/main" id="{DF660FD4-1006-4836-8D32-B8DB02E9A78E}"/>
                  </a:ext>
                </a:extLst>
              </p:cNvPr>
              <p:cNvSpPr txBox="1"/>
              <p:nvPr/>
            </p:nvSpPr>
            <p:spPr>
              <a:xfrm>
                <a:off x="1683342" y="7728004"/>
                <a:ext cx="2504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dirty="0"/>
                  <a:t>+</a:t>
                </a:r>
              </a:p>
            </p:txBody>
          </p:sp>
          <p:cxnSp>
            <p:nvCxnSpPr>
              <p:cNvPr id="116" name="Connettore diritto 115">
                <a:extLst>
                  <a:ext uri="{FF2B5EF4-FFF2-40B4-BE49-F238E27FC236}">
                    <a16:creationId xmlns:a16="http://schemas.microsoft.com/office/drawing/2014/main" id="{BC24E35D-E970-4A63-B310-FEDCBEB3135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66253" y="7979603"/>
                <a:ext cx="242318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7" name="CasellaDiTesto 116">
                <a:extLst>
                  <a:ext uri="{FF2B5EF4-FFF2-40B4-BE49-F238E27FC236}">
                    <a16:creationId xmlns:a16="http://schemas.microsoft.com/office/drawing/2014/main" id="{8E6F11EF-D084-45EA-B846-A63EBF7C3DE4}"/>
                  </a:ext>
                </a:extLst>
              </p:cNvPr>
              <p:cNvSpPr txBox="1"/>
              <p:nvPr/>
            </p:nvSpPr>
            <p:spPr>
              <a:xfrm>
                <a:off x="1287595" y="7936136"/>
                <a:ext cx="80021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siFOXA1</a:t>
                </a:r>
              </a:p>
            </p:txBody>
          </p:sp>
        </p:grpSp>
        <p:sp>
          <p:nvSpPr>
            <p:cNvPr id="102" name="CasellaDiTesto 101">
              <a:extLst>
                <a:ext uri="{FF2B5EF4-FFF2-40B4-BE49-F238E27FC236}">
                  <a16:creationId xmlns:a16="http://schemas.microsoft.com/office/drawing/2014/main" id="{FE7A7670-D662-4995-8D0D-C837E230DFD7}"/>
                </a:ext>
              </a:extLst>
            </p:cNvPr>
            <p:cNvSpPr txBox="1"/>
            <p:nvPr/>
          </p:nvSpPr>
          <p:spPr>
            <a:xfrm>
              <a:off x="3967736" y="5133313"/>
              <a:ext cx="4283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°°°°</a:t>
              </a:r>
            </a:p>
          </p:txBody>
        </p:sp>
      </p:grpSp>
      <p:grpSp>
        <p:nvGrpSpPr>
          <p:cNvPr id="118" name="Gruppo 117">
            <a:extLst>
              <a:ext uri="{FF2B5EF4-FFF2-40B4-BE49-F238E27FC236}">
                <a16:creationId xmlns:a16="http://schemas.microsoft.com/office/drawing/2014/main" id="{9D070C9B-7C4E-4DA5-9569-7144F2C7F434}"/>
              </a:ext>
            </a:extLst>
          </p:cNvPr>
          <p:cNvGrpSpPr/>
          <p:nvPr/>
        </p:nvGrpSpPr>
        <p:grpSpPr>
          <a:xfrm>
            <a:off x="3580532" y="5618156"/>
            <a:ext cx="2106424" cy="1747457"/>
            <a:chOff x="4698820" y="7337777"/>
            <a:chExt cx="2106424" cy="1747457"/>
          </a:xfrm>
        </p:grpSpPr>
        <p:pic>
          <p:nvPicPr>
            <p:cNvPr id="119" name="Immagine 118">
              <a:extLst>
                <a:ext uri="{FF2B5EF4-FFF2-40B4-BE49-F238E27FC236}">
                  <a16:creationId xmlns:a16="http://schemas.microsoft.com/office/drawing/2014/main" id="{F28EAB44-8F4C-4941-9AAB-831FA2060B3D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357019" y="7467401"/>
              <a:ext cx="1150422" cy="1166400"/>
            </a:xfrm>
            <a:prstGeom prst="rect">
              <a:avLst/>
            </a:prstGeom>
          </p:spPr>
        </p:pic>
        <p:sp>
          <p:nvSpPr>
            <p:cNvPr id="120" name="CasellaDiTesto 119">
              <a:extLst>
                <a:ext uri="{FF2B5EF4-FFF2-40B4-BE49-F238E27FC236}">
                  <a16:creationId xmlns:a16="http://schemas.microsoft.com/office/drawing/2014/main" id="{67489E71-EEE0-46BD-B082-7842B4538989}"/>
                </a:ext>
              </a:extLst>
            </p:cNvPr>
            <p:cNvSpPr txBox="1"/>
            <p:nvPr/>
          </p:nvSpPr>
          <p:spPr>
            <a:xfrm rot="16200000">
              <a:off x="4226435" y="7813038"/>
              <a:ext cx="140643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/>
                <a:t>FOXA1 </a:t>
              </a:r>
              <a:r>
                <a:rPr lang="it-IT" sz="1200" dirty="0" err="1"/>
                <a:t>Levels</a:t>
              </a:r>
              <a:endParaRPr lang="it-IT" sz="1200" dirty="0"/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-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121" name="CasellaDiTesto 120">
              <a:extLst>
                <a:ext uri="{FF2B5EF4-FFF2-40B4-BE49-F238E27FC236}">
                  <a16:creationId xmlns:a16="http://schemas.microsoft.com/office/drawing/2014/main" id="{FB85F03D-B8BD-40BD-8E43-E479DB56354D}"/>
                </a:ext>
              </a:extLst>
            </p:cNvPr>
            <p:cNvSpPr txBox="1"/>
            <p:nvPr/>
          </p:nvSpPr>
          <p:spPr>
            <a:xfrm>
              <a:off x="5056564" y="790256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6</a:t>
              </a:r>
            </a:p>
          </p:txBody>
        </p:sp>
        <p:sp>
          <p:nvSpPr>
            <p:cNvPr id="122" name="CasellaDiTesto 121">
              <a:extLst>
                <a:ext uri="{FF2B5EF4-FFF2-40B4-BE49-F238E27FC236}">
                  <a16:creationId xmlns:a16="http://schemas.microsoft.com/office/drawing/2014/main" id="{BFEBB782-5E54-4E4A-80EF-BADC59FA0937}"/>
                </a:ext>
              </a:extLst>
            </p:cNvPr>
            <p:cNvSpPr txBox="1"/>
            <p:nvPr/>
          </p:nvSpPr>
          <p:spPr>
            <a:xfrm>
              <a:off x="5056564" y="8430641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123" name="CasellaDiTesto 122">
              <a:extLst>
                <a:ext uri="{FF2B5EF4-FFF2-40B4-BE49-F238E27FC236}">
                  <a16:creationId xmlns:a16="http://schemas.microsoft.com/office/drawing/2014/main" id="{4A102856-401B-4326-AFAD-0FA3A4AC8EE9}"/>
                </a:ext>
              </a:extLst>
            </p:cNvPr>
            <p:cNvSpPr txBox="1"/>
            <p:nvPr/>
          </p:nvSpPr>
          <p:spPr>
            <a:xfrm>
              <a:off x="5056564" y="733777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2</a:t>
              </a:r>
            </a:p>
          </p:txBody>
        </p:sp>
        <p:sp>
          <p:nvSpPr>
            <p:cNvPr id="124" name="CasellaDiTesto 123">
              <a:extLst>
                <a:ext uri="{FF2B5EF4-FFF2-40B4-BE49-F238E27FC236}">
                  <a16:creationId xmlns:a16="http://schemas.microsoft.com/office/drawing/2014/main" id="{11703306-4225-4610-8B0F-50B8C724BA15}"/>
                </a:ext>
              </a:extLst>
            </p:cNvPr>
            <p:cNvSpPr txBox="1"/>
            <p:nvPr/>
          </p:nvSpPr>
          <p:spPr>
            <a:xfrm>
              <a:off x="5917009" y="7524328"/>
              <a:ext cx="3032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</a:t>
              </a:r>
            </a:p>
          </p:txBody>
        </p:sp>
        <p:sp>
          <p:nvSpPr>
            <p:cNvPr id="125" name="CasellaDiTesto 124">
              <a:extLst>
                <a:ext uri="{FF2B5EF4-FFF2-40B4-BE49-F238E27FC236}">
                  <a16:creationId xmlns:a16="http://schemas.microsoft.com/office/drawing/2014/main" id="{164C4FF6-F036-4AF0-9B52-983BCF9036DB}"/>
                </a:ext>
              </a:extLst>
            </p:cNvPr>
            <p:cNvSpPr txBox="1"/>
            <p:nvPr/>
          </p:nvSpPr>
          <p:spPr>
            <a:xfrm>
              <a:off x="6123110" y="7922282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**</a:t>
              </a:r>
            </a:p>
          </p:txBody>
        </p:sp>
        <p:sp>
          <p:nvSpPr>
            <p:cNvPr id="126" name="CasellaDiTesto 125">
              <a:extLst>
                <a:ext uri="{FF2B5EF4-FFF2-40B4-BE49-F238E27FC236}">
                  <a16:creationId xmlns:a16="http://schemas.microsoft.com/office/drawing/2014/main" id="{DB319B45-62DD-46AF-B889-4D0BE4B956F5}"/>
                </a:ext>
              </a:extLst>
            </p:cNvPr>
            <p:cNvSpPr txBox="1"/>
            <p:nvPr/>
          </p:nvSpPr>
          <p:spPr>
            <a:xfrm>
              <a:off x="5643562" y="7418226"/>
              <a:ext cx="36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*</a:t>
              </a:r>
            </a:p>
          </p:txBody>
        </p:sp>
        <p:sp>
          <p:nvSpPr>
            <p:cNvPr id="127" name="CasellaDiTesto 126">
              <a:extLst>
                <a:ext uri="{FF2B5EF4-FFF2-40B4-BE49-F238E27FC236}">
                  <a16:creationId xmlns:a16="http://schemas.microsoft.com/office/drawing/2014/main" id="{8E1D3AC1-E08D-4DA9-8CB5-3A0AD973054C}"/>
                </a:ext>
              </a:extLst>
            </p:cNvPr>
            <p:cNvSpPr txBox="1"/>
            <p:nvPr/>
          </p:nvSpPr>
          <p:spPr>
            <a:xfrm>
              <a:off x="5440813" y="8600103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-</a:t>
              </a:r>
            </a:p>
          </p:txBody>
        </p:sp>
        <p:sp>
          <p:nvSpPr>
            <p:cNvPr id="128" name="CasellaDiTesto 127">
              <a:extLst>
                <a:ext uri="{FF2B5EF4-FFF2-40B4-BE49-F238E27FC236}">
                  <a16:creationId xmlns:a16="http://schemas.microsoft.com/office/drawing/2014/main" id="{5B6F2DCC-A587-4ADA-A724-955B04D31C49}"/>
                </a:ext>
              </a:extLst>
            </p:cNvPr>
            <p:cNvSpPr txBox="1"/>
            <p:nvPr/>
          </p:nvSpPr>
          <p:spPr>
            <a:xfrm>
              <a:off x="5694933" y="8600103"/>
              <a:ext cx="2504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+</a:t>
              </a:r>
            </a:p>
          </p:txBody>
        </p:sp>
        <p:sp>
          <p:nvSpPr>
            <p:cNvPr id="129" name="CasellaDiTesto 128">
              <a:extLst>
                <a:ext uri="{FF2B5EF4-FFF2-40B4-BE49-F238E27FC236}">
                  <a16:creationId xmlns:a16="http://schemas.microsoft.com/office/drawing/2014/main" id="{31AF8A3A-D267-4F83-9414-342B0458188B}"/>
                </a:ext>
              </a:extLst>
            </p:cNvPr>
            <p:cNvSpPr txBox="1"/>
            <p:nvPr/>
          </p:nvSpPr>
          <p:spPr>
            <a:xfrm>
              <a:off x="6424434" y="8600103"/>
              <a:ext cx="3808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Tel</a:t>
              </a:r>
            </a:p>
          </p:txBody>
        </p:sp>
        <p:sp>
          <p:nvSpPr>
            <p:cNvPr id="130" name="CasellaDiTesto 129">
              <a:extLst>
                <a:ext uri="{FF2B5EF4-FFF2-40B4-BE49-F238E27FC236}">
                  <a16:creationId xmlns:a16="http://schemas.microsoft.com/office/drawing/2014/main" id="{A9F44C3F-5485-4FEE-8398-315B79A4FA34}"/>
                </a:ext>
              </a:extLst>
            </p:cNvPr>
            <p:cNvSpPr txBox="1"/>
            <p:nvPr/>
          </p:nvSpPr>
          <p:spPr>
            <a:xfrm>
              <a:off x="5961073" y="8600103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-</a:t>
              </a:r>
            </a:p>
          </p:txBody>
        </p:sp>
        <p:sp>
          <p:nvSpPr>
            <p:cNvPr id="131" name="CasellaDiTesto 130">
              <a:extLst>
                <a:ext uri="{FF2B5EF4-FFF2-40B4-BE49-F238E27FC236}">
                  <a16:creationId xmlns:a16="http://schemas.microsoft.com/office/drawing/2014/main" id="{2BE2A7C4-99AB-427C-91EB-67FBF5282AF8}"/>
                </a:ext>
              </a:extLst>
            </p:cNvPr>
            <p:cNvSpPr txBox="1"/>
            <p:nvPr/>
          </p:nvSpPr>
          <p:spPr>
            <a:xfrm>
              <a:off x="6196143" y="8600103"/>
              <a:ext cx="2504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+</a:t>
              </a:r>
            </a:p>
          </p:txBody>
        </p:sp>
        <p:cxnSp>
          <p:nvCxnSpPr>
            <p:cNvPr id="132" name="Connettore diritto 131">
              <a:extLst>
                <a:ext uri="{FF2B5EF4-FFF2-40B4-BE49-F238E27FC236}">
                  <a16:creationId xmlns:a16="http://schemas.microsoft.com/office/drawing/2014/main" id="{7E472366-925E-4162-BF56-671D19C7477D}"/>
                </a:ext>
              </a:extLst>
            </p:cNvPr>
            <p:cNvCxnSpPr>
              <a:cxnSpLocks/>
            </p:cNvCxnSpPr>
            <p:nvPr/>
          </p:nvCxnSpPr>
          <p:spPr>
            <a:xfrm>
              <a:off x="6079054" y="8851702"/>
              <a:ext cx="24231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3" name="CasellaDiTesto 132">
              <a:extLst>
                <a:ext uri="{FF2B5EF4-FFF2-40B4-BE49-F238E27FC236}">
                  <a16:creationId xmlns:a16="http://schemas.microsoft.com/office/drawing/2014/main" id="{00A43494-C9E5-4041-A0ED-9D3700408ECC}"/>
                </a:ext>
              </a:extLst>
            </p:cNvPr>
            <p:cNvSpPr txBox="1"/>
            <p:nvPr/>
          </p:nvSpPr>
          <p:spPr>
            <a:xfrm>
              <a:off x="5931021" y="8808235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NVP</a:t>
              </a:r>
            </a:p>
          </p:txBody>
        </p:sp>
        <p:sp>
          <p:nvSpPr>
            <p:cNvPr id="134" name="CasellaDiTesto 133">
              <a:extLst>
                <a:ext uri="{FF2B5EF4-FFF2-40B4-BE49-F238E27FC236}">
                  <a16:creationId xmlns:a16="http://schemas.microsoft.com/office/drawing/2014/main" id="{365EDFC7-5FE5-4C71-A429-ECD381E6DE29}"/>
                </a:ext>
              </a:extLst>
            </p:cNvPr>
            <p:cNvSpPr txBox="1"/>
            <p:nvPr/>
          </p:nvSpPr>
          <p:spPr>
            <a:xfrm>
              <a:off x="6121133" y="8074682"/>
              <a:ext cx="4283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°°°°</a:t>
              </a:r>
            </a:p>
          </p:txBody>
        </p:sp>
      </p:grpSp>
      <p:grpSp>
        <p:nvGrpSpPr>
          <p:cNvPr id="135" name="Gruppo 134">
            <a:extLst>
              <a:ext uri="{FF2B5EF4-FFF2-40B4-BE49-F238E27FC236}">
                <a16:creationId xmlns:a16="http://schemas.microsoft.com/office/drawing/2014/main" id="{B0D69B71-AB4B-47FD-8D2E-A8B4D16853EE}"/>
              </a:ext>
            </a:extLst>
          </p:cNvPr>
          <p:cNvGrpSpPr/>
          <p:nvPr/>
        </p:nvGrpSpPr>
        <p:grpSpPr>
          <a:xfrm>
            <a:off x="3461062" y="7473390"/>
            <a:ext cx="2632234" cy="1711908"/>
            <a:chOff x="4039686" y="2572060"/>
            <a:chExt cx="2632234" cy="1711908"/>
          </a:xfrm>
        </p:grpSpPr>
        <p:pic>
          <p:nvPicPr>
            <p:cNvPr id="136" name="Immagine 135">
              <a:extLst>
                <a:ext uri="{FF2B5EF4-FFF2-40B4-BE49-F238E27FC236}">
                  <a16:creationId xmlns:a16="http://schemas.microsoft.com/office/drawing/2014/main" id="{0752AC99-C942-4DDC-A664-A35538825075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674827" y="2698809"/>
              <a:ext cx="1705996" cy="1166400"/>
            </a:xfrm>
            <a:prstGeom prst="rect">
              <a:avLst/>
            </a:prstGeom>
          </p:spPr>
        </p:pic>
        <p:sp>
          <p:nvSpPr>
            <p:cNvPr id="137" name="CasellaDiTesto 136">
              <a:extLst>
                <a:ext uri="{FF2B5EF4-FFF2-40B4-BE49-F238E27FC236}">
                  <a16:creationId xmlns:a16="http://schemas.microsoft.com/office/drawing/2014/main" id="{BC32C671-3F48-449E-AA3B-CDA7DC3621B9}"/>
                </a:ext>
              </a:extLst>
            </p:cNvPr>
            <p:cNvSpPr txBox="1"/>
            <p:nvPr/>
          </p:nvSpPr>
          <p:spPr>
            <a:xfrm rot="16200000">
              <a:off x="3536523" y="3075223"/>
              <a:ext cx="140643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dirty="0"/>
                <a:t>FOXA1 </a:t>
              </a:r>
              <a:r>
                <a:rPr lang="it-IT" sz="1000" dirty="0" err="1"/>
                <a:t>Levels</a:t>
              </a:r>
              <a:endParaRPr lang="it-IT" sz="1000" dirty="0"/>
            </a:p>
            <a:p>
              <a:pPr algn="ctr"/>
              <a:r>
                <a:rPr lang="it-IT" sz="1000" dirty="0"/>
                <a:t>(</a:t>
              </a:r>
              <a:r>
                <a:rPr lang="it-IT" sz="1000" dirty="0" err="1"/>
                <a:t>Fold</a:t>
              </a:r>
              <a:r>
                <a:rPr lang="it-IT" sz="1000" dirty="0"/>
                <a:t> on -)</a:t>
              </a:r>
              <a:endParaRPr lang="it-IT" sz="10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138" name="CasellaDiTesto 137">
              <a:extLst>
                <a:ext uri="{FF2B5EF4-FFF2-40B4-BE49-F238E27FC236}">
                  <a16:creationId xmlns:a16="http://schemas.microsoft.com/office/drawing/2014/main" id="{D476BE44-4B8A-4E61-9F55-85FB9208C8D4}"/>
                </a:ext>
              </a:extLst>
            </p:cNvPr>
            <p:cNvSpPr txBox="1"/>
            <p:nvPr/>
          </p:nvSpPr>
          <p:spPr>
            <a:xfrm>
              <a:off x="4400012" y="3149215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1.0</a:t>
              </a:r>
            </a:p>
          </p:txBody>
        </p:sp>
        <p:sp>
          <p:nvSpPr>
            <p:cNvPr id="139" name="CasellaDiTesto 138">
              <a:extLst>
                <a:ext uri="{FF2B5EF4-FFF2-40B4-BE49-F238E27FC236}">
                  <a16:creationId xmlns:a16="http://schemas.microsoft.com/office/drawing/2014/main" id="{8F1BD62C-EF12-47EE-B818-D4D2250C54BA}"/>
                </a:ext>
              </a:extLst>
            </p:cNvPr>
            <p:cNvSpPr txBox="1"/>
            <p:nvPr/>
          </p:nvSpPr>
          <p:spPr>
            <a:xfrm>
              <a:off x="4400012" y="3677289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0.0</a:t>
              </a:r>
            </a:p>
          </p:txBody>
        </p:sp>
        <p:sp>
          <p:nvSpPr>
            <p:cNvPr id="140" name="CasellaDiTesto 139">
              <a:extLst>
                <a:ext uri="{FF2B5EF4-FFF2-40B4-BE49-F238E27FC236}">
                  <a16:creationId xmlns:a16="http://schemas.microsoft.com/office/drawing/2014/main" id="{25EFC395-4309-46B7-805D-7D7C28B2ADF9}"/>
                </a:ext>
              </a:extLst>
            </p:cNvPr>
            <p:cNvSpPr txBox="1"/>
            <p:nvPr/>
          </p:nvSpPr>
          <p:spPr>
            <a:xfrm>
              <a:off x="4400012" y="2584425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2.0</a:t>
              </a:r>
            </a:p>
          </p:txBody>
        </p:sp>
        <p:sp>
          <p:nvSpPr>
            <p:cNvPr id="141" name="CasellaDiTesto 140">
              <a:extLst>
                <a:ext uri="{FF2B5EF4-FFF2-40B4-BE49-F238E27FC236}">
                  <a16:creationId xmlns:a16="http://schemas.microsoft.com/office/drawing/2014/main" id="{138CCB11-9A51-4710-B650-6493D4D31E7A}"/>
                </a:ext>
              </a:extLst>
            </p:cNvPr>
            <p:cNvSpPr txBox="1"/>
            <p:nvPr/>
          </p:nvSpPr>
          <p:spPr>
            <a:xfrm>
              <a:off x="4840797" y="3366818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**</a:t>
              </a:r>
            </a:p>
          </p:txBody>
        </p:sp>
        <p:sp>
          <p:nvSpPr>
            <p:cNvPr id="142" name="CasellaDiTesto 141">
              <a:extLst>
                <a:ext uri="{FF2B5EF4-FFF2-40B4-BE49-F238E27FC236}">
                  <a16:creationId xmlns:a16="http://schemas.microsoft.com/office/drawing/2014/main" id="{36FB178C-8934-487E-B81D-2B27E27E69BF}"/>
                </a:ext>
              </a:extLst>
            </p:cNvPr>
            <p:cNvSpPr txBox="1"/>
            <p:nvPr/>
          </p:nvSpPr>
          <p:spPr>
            <a:xfrm>
              <a:off x="5619720" y="3275856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**</a:t>
              </a:r>
            </a:p>
          </p:txBody>
        </p:sp>
        <p:sp>
          <p:nvSpPr>
            <p:cNvPr id="143" name="CasellaDiTesto 142">
              <a:extLst>
                <a:ext uri="{FF2B5EF4-FFF2-40B4-BE49-F238E27FC236}">
                  <a16:creationId xmlns:a16="http://schemas.microsoft.com/office/drawing/2014/main" id="{D45FD00F-7B92-43AA-913C-5D44D11BF780}"/>
                </a:ext>
              </a:extLst>
            </p:cNvPr>
            <p:cNvSpPr txBox="1"/>
            <p:nvPr/>
          </p:nvSpPr>
          <p:spPr>
            <a:xfrm>
              <a:off x="5877272" y="3059832"/>
              <a:ext cx="3032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</a:t>
              </a:r>
            </a:p>
          </p:txBody>
        </p:sp>
        <p:sp>
          <p:nvSpPr>
            <p:cNvPr id="144" name="CasellaDiTesto 143">
              <a:extLst>
                <a:ext uri="{FF2B5EF4-FFF2-40B4-BE49-F238E27FC236}">
                  <a16:creationId xmlns:a16="http://schemas.microsoft.com/office/drawing/2014/main" id="{08682E96-2EA8-4C8D-BC1F-1220DAB5F1A6}"/>
                </a:ext>
              </a:extLst>
            </p:cNvPr>
            <p:cNvSpPr txBox="1"/>
            <p:nvPr/>
          </p:nvSpPr>
          <p:spPr>
            <a:xfrm>
              <a:off x="6054675" y="2886356"/>
              <a:ext cx="36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*</a:t>
              </a:r>
            </a:p>
          </p:txBody>
        </p:sp>
        <p:sp>
          <p:nvSpPr>
            <p:cNvPr id="145" name="CasellaDiTesto 144">
              <a:extLst>
                <a:ext uri="{FF2B5EF4-FFF2-40B4-BE49-F238E27FC236}">
                  <a16:creationId xmlns:a16="http://schemas.microsoft.com/office/drawing/2014/main" id="{20025BE4-995E-4991-A77E-8BAC349E316C}"/>
                </a:ext>
              </a:extLst>
            </p:cNvPr>
            <p:cNvSpPr txBox="1"/>
            <p:nvPr/>
          </p:nvSpPr>
          <p:spPr>
            <a:xfrm>
              <a:off x="6097208" y="3079413"/>
              <a:ext cx="2455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°</a:t>
              </a:r>
            </a:p>
          </p:txBody>
        </p:sp>
        <p:sp>
          <p:nvSpPr>
            <p:cNvPr id="146" name="CasellaDiTesto 145">
              <a:extLst>
                <a:ext uri="{FF2B5EF4-FFF2-40B4-BE49-F238E27FC236}">
                  <a16:creationId xmlns:a16="http://schemas.microsoft.com/office/drawing/2014/main" id="{3E126B37-49C8-4085-AB1B-491E73572CD9}"/>
                </a:ext>
              </a:extLst>
            </p:cNvPr>
            <p:cNvSpPr txBox="1"/>
            <p:nvPr/>
          </p:nvSpPr>
          <p:spPr>
            <a:xfrm>
              <a:off x="4744192" y="3778908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147" name="CasellaDiTesto 146">
              <a:extLst>
                <a:ext uri="{FF2B5EF4-FFF2-40B4-BE49-F238E27FC236}">
                  <a16:creationId xmlns:a16="http://schemas.microsoft.com/office/drawing/2014/main" id="{E2877C0C-AF93-4614-A8D8-A83EC037DE05}"/>
                </a:ext>
              </a:extLst>
            </p:cNvPr>
            <p:cNvSpPr txBox="1"/>
            <p:nvPr/>
          </p:nvSpPr>
          <p:spPr>
            <a:xfrm>
              <a:off x="4927170" y="3778908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sp>
          <p:nvSpPr>
            <p:cNvPr id="148" name="CasellaDiTesto 147">
              <a:extLst>
                <a:ext uri="{FF2B5EF4-FFF2-40B4-BE49-F238E27FC236}">
                  <a16:creationId xmlns:a16="http://schemas.microsoft.com/office/drawing/2014/main" id="{332B7948-0982-4D8A-AD56-1D1DD3B3DE83}"/>
                </a:ext>
              </a:extLst>
            </p:cNvPr>
            <p:cNvSpPr txBox="1"/>
            <p:nvPr/>
          </p:nvSpPr>
          <p:spPr>
            <a:xfrm>
              <a:off x="5138015" y="3778908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149" name="CasellaDiTesto 148">
              <a:extLst>
                <a:ext uri="{FF2B5EF4-FFF2-40B4-BE49-F238E27FC236}">
                  <a16:creationId xmlns:a16="http://schemas.microsoft.com/office/drawing/2014/main" id="{15D9D3F1-13D1-450B-B0E5-3252BBA55325}"/>
                </a:ext>
              </a:extLst>
            </p:cNvPr>
            <p:cNvSpPr txBox="1"/>
            <p:nvPr/>
          </p:nvSpPr>
          <p:spPr>
            <a:xfrm>
              <a:off x="5336612" y="3778908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150" name="CasellaDiTesto 149">
              <a:extLst>
                <a:ext uri="{FF2B5EF4-FFF2-40B4-BE49-F238E27FC236}">
                  <a16:creationId xmlns:a16="http://schemas.microsoft.com/office/drawing/2014/main" id="{B447FC79-D48B-44D6-9183-CB4F8A058A6E}"/>
                </a:ext>
              </a:extLst>
            </p:cNvPr>
            <p:cNvSpPr txBox="1"/>
            <p:nvPr/>
          </p:nvSpPr>
          <p:spPr>
            <a:xfrm>
              <a:off x="5538799" y="3778908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151" name="CasellaDiTesto 150">
              <a:extLst>
                <a:ext uri="{FF2B5EF4-FFF2-40B4-BE49-F238E27FC236}">
                  <a16:creationId xmlns:a16="http://schemas.microsoft.com/office/drawing/2014/main" id="{2ABCCF9F-E17C-4DD2-A522-AFE00C36C1CE}"/>
                </a:ext>
              </a:extLst>
            </p:cNvPr>
            <p:cNvSpPr txBox="1"/>
            <p:nvPr/>
          </p:nvSpPr>
          <p:spPr>
            <a:xfrm>
              <a:off x="5715463" y="3778908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sp>
          <p:nvSpPr>
            <p:cNvPr id="152" name="CasellaDiTesto 151">
              <a:extLst>
                <a:ext uri="{FF2B5EF4-FFF2-40B4-BE49-F238E27FC236}">
                  <a16:creationId xmlns:a16="http://schemas.microsoft.com/office/drawing/2014/main" id="{2512EC3B-3C9E-4432-A5A9-622D6D9E15AA}"/>
                </a:ext>
              </a:extLst>
            </p:cNvPr>
            <p:cNvSpPr txBox="1"/>
            <p:nvPr/>
          </p:nvSpPr>
          <p:spPr>
            <a:xfrm>
              <a:off x="5911181" y="3778908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sp>
          <p:nvSpPr>
            <p:cNvPr id="153" name="CasellaDiTesto 152">
              <a:extLst>
                <a:ext uri="{FF2B5EF4-FFF2-40B4-BE49-F238E27FC236}">
                  <a16:creationId xmlns:a16="http://schemas.microsoft.com/office/drawing/2014/main" id="{81F28CBB-AAAB-482A-B29F-1EA842D1C894}"/>
                </a:ext>
              </a:extLst>
            </p:cNvPr>
            <p:cNvSpPr txBox="1"/>
            <p:nvPr/>
          </p:nvSpPr>
          <p:spPr>
            <a:xfrm>
              <a:off x="6111796" y="3778908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sp>
          <p:nvSpPr>
            <p:cNvPr id="154" name="CasellaDiTesto 153">
              <a:extLst>
                <a:ext uri="{FF2B5EF4-FFF2-40B4-BE49-F238E27FC236}">
                  <a16:creationId xmlns:a16="http://schemas.microsoft.com/office/drawing/2014/main" id="{A77273CF-3156-44C0-9B15-3F7C4D2A52D9}"/>
                </a:ext>
              </a:extLst>
            </p:cNvPr>
            <p:cNvSpPr txBox="1"/>
            <p:nvPr/>
          </p:nvSpPr>
          <p:spPr>
            <a:xfrm>
              <a:off x="6309320" y="3778908"/>
              <a:ext cx="3626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Tel</a:t>
              </a:r>
            </a:p>
          </p:txBody>
        </p:sp>
        <p:sp>
          <p:nvSpPr>
            <p:cNvPr id="155" name="CasellaDiTesto 154">
              <a:extLst>
                <a:ext uri="{FF2B5EF4-FFF2-40B4-BE49-F238E27FC236}">
                  <a16:creationId xmlns:a16="http://schemas.microsoft.com/office/drawing/2014/main" id="{A7D58D27-ACAB-4C69-BBA8-1CA7AAFA1C5A}"/>
                </a:ext>
              </a:extLst>
            </p:cNvPr>
            <p:cNvSpPr txBox="1"/>
            <p:nvPr/>
          </p:nvSpPr>
          <p:spPr>
            <a:xfrm>
              <a:off x="5045853" y="389373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</a:t>
              </a:r>
            </a:p>
          </p:txBody>
        </p:sp>
        <p:sp>
          <p:nvSpPr>
            <p:cNvPr id="156" name="CasellaDiTesto 155">
              <a:extLst>
                <a:ext uri="{FF2B5EF4-FFF2-40B4-BE49-F238E27FC236}">
                  <a16:creationId xmlns:a16="http://schemas.microsoft.com/office/drawing/2014/main" id="{165BE934-B676-4AAA-8551-4F896E77B4B5}"/>
                </a:ext>
              </a:extLst>
            </p:cNvPr>
            <p:cNvSpPr txBox="1"/>
            <p:nvPr/>
          </p:nvSpPr>
          <p:spPr>
            <a:xfrm>
              <a:off x="5212810" y="3893731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0</a:t>
              </a:r>
            </a:p>
          </p:txBody>
        </p:sp>
        <p:sp>
          <p:nvSpPr>
            <p:cNvPr id="157" name="CasellaDiTesto 156">
              <a:extLst>
                <a:ext uri="{FF2B5EF4-FFF2-40B4-BE49-F238E27FC236}">
                  <a16:creationId xmlns:a16="http://schemas.microsoft.com/office/drawing/2014/main" id="{1A0BCF70-7D72-4DE1-ABC2-159062335538}"/>
                </a:ext>
              </a:extLst>
            </p:cNvPr>
            <p:cNvSpPr txBox="1"/>
            <p:nvPr/>
          </p:nvSpPr>
          <p:spPr>
            <a:xfrm>
              <a:off x="5457325" y="3893731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250</a:t>
              </a:r>
            </a:p>
          </p:txBody>
        </p:sp>
        <p:sp>
          <p:nvSpPr>
            <p:cNvPr id="158" name="CasellaDiTesto 157">
              <a:extLst>
                <a:ext uri="{FF2B5EF4-FFF2-40B4-BE49-F238E27FC236}">
                  <a16:creationId xmlns:a16="http://schemas.microsoft.com/office/drawing/2014/main" id="{0F6DAAC4-126B-4B55-99DF-5B71F5BBF76C}"/>
                </a:ext>
              </a:extLst>
            </p:cNvPr>
            <p:cNvSpPr txBox="1"/>
            <p:nvPr/>
          </p:nvSpPr>
          <p:spPr>
            <a:xfrm>
              <a:off x="5697984" y="389373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</a:t>
              </a:r>
            </a:p>
          </p:txBody>
        </p:sp>
        <p:sp>
          <p:nvSpPr>
            <p:cNvPr id="159" name="CasellaDiTesto 158">
              <a:extLst>
                <a:ext uri="{FF2B5EF4-FFF2-40B4-BE49-F238E27FC236}">
                  <a16:creationId xmlns:a16="http://schemas.microsoft.com/office/drawing/2014/main" id="{484C3F30-988F-4E79-9A49-6666EF48C75C}"/>
                </a:ext>
              </a:extLst>
            </p:cNvPr>
            <p:cNvSpPr txBox="1"/>
            <p:nvPr/>
          </p:nvSpPr>
          <p:spPr>
            <a:xfrm>
              <a:off x="5864941" y="3893731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0</a:t>
              </a:r>
            </a:p>
          </p:txBody>
        </p:sp>
        <p:sp>
          <p:nvSpPr>
            <p:cNvPr id="160" name="CasellaDiTesto 159">
              <a:extLst>
                <a:ext uri="{FF2B5EF4-FFF2-40B4-BE49-F238E27FC236}">
                  <a16:creationId xmlns:a16="http://schemas.microsoft.com/office/drawing/2014/main" id="{2B0F3DE6-E29D-4E80-91E7-B40DB59716C2}"/>
                </a:ext>
              </a:extLst>
            </p:cNvPr>
            <p:cNvSpPr txBox="1"/>
            <p:nvPr/>
          </p:nvSpPr>
          <p:spPr>
            <a:xfrm>
              <a:off x="6109456" y="3893731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250</a:t>
              </a:r>
            </a:p>
          </p:txBody>
        </p:sp>
        <p:cxnSp>
          <p:nvCxnSpPr>
            <p:cNvPr id="161" name="Connettore diritto 160">
              <a:extLst>
                <a:ext uri="{FF2B5EF4-FFF2-40B4-BE49-F238E27FC236}">
                  <a16:creationId xmlns:a16="http://schemas.microsoft.com/office/drawing/2014/main" id="{C20F1291-F11C-4F11-9B3C-667D8BD5CC7D}"/>
                </a:ext>
              </a:extLst>
            </p:cNvPr>
            <p:cNvCxnSpPr>
              <a:cxnSpLocks/>
            </p:cNvCxnSpPr>
            <p:nvPr/>
          </p:nvCxnSpPr>
          <p:spPr>
            <a:xfrm>
              <a:off x="5201098" y="4086992"/>
              <a:ext cx="109886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2" name="CasellaDiTesto 161">
              <a:extLst>
                <a:ext uri="{FF2B5EF4-FFF2-40B4-BE49-F238E27FC236}">
                  <a16:creationId xmlns:a16="http://schemas.microsoft.com/office/drawing/2014/main" id="{D728D339-CB60-449E-A204-5DF86C4438A6}"/>
                </a:ext>
              </a:extLst>
            </p:cNvPr>
            <p:cNvSpPr txBox="1"/>
            <p:nvPr/>
          </p:nvSpPr>
          <p:spPr>
            <a:xfrm>
              <a:off x="5374173" y="4037747"/>
              <a:ext cx="8322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IGF (</a:t>
              </a:r>
              <a:r>
                <a:rPr lang="it-IT" sz="1000" dirty="0" err="1">
                  <a:latin typeface="+mn-lt"/>
                </a:rPr>
                <a:t>ng</a:t>
              </a:r>
              <a:r>
                <a:rPr lang="it-IT" sz="1000" dirty="0">
                  <a:latin typeface="+mn-lt"/>
                </a:rPr>
                <a:t>/ml)</a:t>
              </a:r>
            </a:p>
          </p:txBody>
        </p:sp>
      </p:grpSp>
      <p:grpSp>
        <p:nvGrpSpPr>
          <p:cNvPr id="163" name="Gruppo 162">
            <a:extLst>
              <a:ext uri="{FF2B5EF4-FFF2-40B4-BE49-F238E27FC236}">
                <a16:creationId xmlns:a16="http://schemas.microsoft.com/office/drawing/2014/main" id="{E67CAB09-F861-4842-A463-5B3414763FC4}"/>
              </a:ext>
            </a:extLst>
          </p:cNvPr>
          <p:cNvGrpSpPr/>
          <p:nvPr/>
        </p:nvGrpSpPr>
        <p:grpSpPr>
          <a:xfrm>
            <a:off x="476672" y="7444485"/>
            <a:ext cx="2709178" cy="1711908"/>
            <a:chOff x="359782" y="1979712"/>
            <a:chExt cx="2709178" cy="1711908"/>
          </a:xfrm>
        </p:grpSpPr>
        <p:pic>
          <p:nvPicPr>
            <p:cNvPr id="164" name="Immagine 163">
              <a:extLst>
                <a:ext uri="{FF2B5EF4-FFF2-40B4-BE49-F238E27FC236}">
                  <a16:creationId xmlns:a16="http://schemas.microsoft.com/office/drawing/2014/main" id="{269A9610-FC39-481F-BEA5-22675473647C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071867" y="2106461"/>
              <a:ext cx="1714006" cy="1166400"/>
            </a:xfrm>
            <a:prstGeom prst="rect">
              <a:avLst/>
            </a:prstGeom>
          </p:spPr>
        </p:pic>
        <p:sp>
          <p:nvSpPr>
            <p:cNvPr id="165" name="CasellaDiTesto 164">
              <a:extLst>
                <a:ext uri="{FF2B5EF4-FFF2-40B4-BE49-F238E27FC236}">
                  <a16:creationId xmlns:a16="http://schemas.microsoft.com/office/drawing/2014/main" id="{15C8DB80-AFBA-4DC6-AD2E-1A6DC42C16A8}"/>
                </a:ext>
              </a:extLst>
            </p:cNvPr>
            <p:cNvSpPr txBox="1"/>
            <p:nvPr/>
          </p:nvSpPr>
          <p:spPr>
            <a:xfrm rot="16200000">
              <a:off x="-66437" y="2405931"/>
              <a:ext cx="1406435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dirty="0" err="1"/>
                <a:t>Fraction</a:t>
              </a:r>
              <a:r>
                <a:rPr lang="it-IT" sz="1000" dirty="0"/>
                <a:t> of </a:t>
              </a:r>
              <a:r>
                <a:rPr lang="it-IT" sz="1000" dirty="0" err="1"/>
                <a:t>cleaved</a:t>
              </a:r>
              <a:r>
                <a:rPr lang="it-IT" sz="1000" dirty="0"/>
                <a:t> PARP</a:t>
              </a:r>
            </a:p>
            <a:p>
              <a:pPr algn="ctr"/>
              <a:r>
                <a:rPr lang="it-IT" sz="1000" dirty="0"/>
                <a:t>(</a:t>
              </a:r>
              <a:r>
                <a:rPr lang="it-IT" sz="1000" dirty="0" err="1"/>
                <a:t>Fold</a:t>
              </a:r>
              <a:r>
                <a:rPr lang="it-IT" sz="1000" dirty="0"/>
                <a:t> on -)</a:t>
              </a:r>
              <a:endParaRPr lang="it-IT" sz="10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166" name="CasellaDiTesto 165">
              <a:extLst>
                <a:ext uri="{FF2B5EF4-FFF2-40B4-BE49-F238E27FC236}">
                  <a16:creationId xmlns:a16="http://schemas.microsoft.com/office/drawing/2014/main" id="{92F4682F-BA61-4158-9F6A-762834E6D9C4}"/>
                </a:ext>
              </a:extLst>
            </p:cNvPr>
            <p:cNvSpPr txBox="1"/>
            <p:nvPr/>
          </p:nvSpPr>
          <p:spPr>
            <a:xfrm>
              <a:off x="797052" y="2556867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2.0</a:t>
              </a:r>
            </a:p>
          </p:txBody>
        </p:sp>
        <p:sp>
          <p:nvSpPr>
            <p:cNvPr id="167" name="CasellaDiTesto 166">
              <a:extLst>
                <a:ext uri="{FF2B5EF4-FFF2-40B4-BE49-F238E27FC236}">
                  <a16:creationId xmlns:a16="http://schemas.microsoft.com/office/drawing/2014/main" id="{EC3DD950-3752-49A4-8599-DF59CA922E47}"/>
                </a:ext>
              </a:extLst>
            </p:cNvPr>
            <p:cNvSpPr txBox="1"/>
            <p:nvPr/>
          </p:nvSpPr>
          <p:spPr>
            <a:xfrm>
              <a:off x="797052" y="3084941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0.0</a:t>
              </a:r>
            </a:p>
          </p:txBody>
        </p:sp>
        <p:sp>
          <p:nvSpPr>
            <p:cNvPr id="168" name="CasellaDiTesto 167">
              <a:extLst>
                <a:ext uri="{FF2B5EF4-FFF2-40B4-BE49-F238E27FC236}">
                  <a16:creationId xmlns:a16="http://schemas.microsoft.com/office/drawing/2014/main" id="{3B788687-434D-4177-A5B9-713300D40A00}"/>
                </a:ext>
              </a:extLst>
            </p:cNvPr>
            <p:cNvSpPr txBox="1"/>
            <p:nvPr/>
          </p:nvSpPr>
          <p:spPr>
            <a:xfrm>
              <a:off x="797052" y="1992077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4.0</a:t>
              </a:r>
            </a:p>
          </p:txBody>
        </p:sp>
        <p:sp>
          <p:nvSpPr>
            <p:cNvPr id="169" name="CasellaDiTesto 168">
              <a:extLst>
                <a:ext uri="{FF2B5EF4-FFF2-40B4-BE49-F238E27FC236}">
                  <a16:creationId xmlns:a16="http://schemas.microsoft.com/office/drawing/2014/main" id="{8D1D2398-C43C-4A3F-A15A-8D9CA8046C3E}"/>
                </a:ext>
              </a:extLst>
            </p:cNvPr>
            <p:cNvSpPr txBox="1"/>
            <p:nvPr/>
          </p:nvSpPr>
          <p:spPr>
            <a:xfrm>
              <a:off x="1270072" y="2137017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**</a:t>
              </a:r>
            </a:p>
          </p:txBody>
        </p:sp>
        <p:sp>
          <p:nvSpPr>
            <p:cNvPr id="170" name="CasellaDiTesto 169">
              <a:extLst>
                <a:ext uri="{FF2B5EF4-FFF2-40B4-BE49-F238E27FC236}">
                  <a16:creationId xmlns:a16="http://schemas.microsoft.com/office/drawing/2014/main" id="{3AD0AB0F-1FC5-40B0-BA93-E7FBD078EAC4}"/>
                </a:ext>
              </a:extLst>
            </p:cNvPr>
            <p:cNvSpPr txBox="1"/>
            <p:nvPr/>
          </p:nvSpPr>
          <p:spPr>
            <a:xfrm>
              <a:off x="2098086" y="2411760"/>
              <a:ext cx="3064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°°</a:t>
              </a:r>
            </a:p>
          </p:txBody>
        </p:sp>
        <p:sp>
          <p:nvSpPr>
            <p:cNvPr id="171" name="CasellaDiTesto 170">
              <a:extLst>
                <a:ext uri="{FF2B5EF4-FFF2-40B4-BE49-F238E27FC236}">
                  <a16:creationId xmlns:a16="http://schemas.microsoft.com/office/drawing/2014/main" id="{3321A2EF-0A35-482F-A7A5-7D9D0E3C5283}"/>
                </a:ext>
              </a:extLst>
            </p:cNvPr>
            <p:cNvSpPr txBox="1"/>
            <p:nvPr/>
          </p:nvSpPr>
          <p:spPr>
            <a:xfrm>
              <a:off x="1141232" y="3186560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172" name="CasellaDiTesto 171">
              <a:extLst>
                <a:ext uri="{FF2B5EF4-FFF2-40B4-BE49-F238E27FC236}">
                  <a16:creationId xmlns:a16="http://schemas.microsoft.com/office/drawing/2014/main" id="{0FC44226-B94D-4D6A-8210-002B4C7F99B7}"/>
                </a:ext>
              </a:extLst>
            </p:cNvPr>
            <p:cNvSpPr txBox="1"/>
            <p:nvPr/>
          </p:nvSpPr>
          <p:spPr>
            <a:xfrm>
              <a:off x="1324210" y="3186560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sp>
          <p:nvSpPr>
            <p:cNvPr id="173" name="CasellaDiTesto 172">
              <a:extLst>
                <a:ext uri="{FF2B5EF4-FFF2-40B4-BE49-F238E27FC236}">
                  <a16:creationId xmlns:a16="http://schemas.microsoft.com/office/drawing/2014/main" id="{A0918B94-3789-4B6C-9191-E28D32DE5939}"/>
                </a:ext>
              </a:extLst>
            </p:cNvPr>
            <p:cNvSpPr txBox="1"/>
            <p:nvPr/>
          </p:nvSpPr>
          <p:spPr>
            <a:xfrm>
              <a:off x="1535055" y="3186560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174" name="CasellaDiTesto 173">
              <a:extLst>
                <a:ext uri="{FF2B5EF4-FFF2-40B4-BE49-F238E27FC236}">
                  <a16:creationId xmlns:a16="http://schemas.microsoft.com/office/drawing/2014/main" id="{0CCB560F-63FF-41A7-909C-AC3D4FC20F5E}"/>
                </a:ext>
              </a:extLst>
            </p:cNvPr>
            <p:cNvSpPr txBox="1"/>
            <p:nvPr/>
          </p:nvSpPr>
          <p:spPr>
            <a:xfrm>
              <a:off x="1733652" y="3186560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175" name="CasellaDiTesto 174">
              <a:extLst>
                <a:ext uri="{FF2B5EF4-FFF2-40B4-BE49-F238E27FC236}">
                  <a16:creationId xmlns:a16="http://schemas.microsoft.com/office/drawing/2014/main" id="{30BBAA2C-AC95-4E38-9EA5-3AC1762E3899}"/>
                </a:ext>
              </a:extLst>
            </p:cNvPr>
            <p:cNvSpPr txBox="1"/>
            <p:nvPr/>
          </p:nvSpPr>
          <p:spPr>
            <a:xfrm>
              <a:off x="1935839" y="3186560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-</a:t>
              </a:r>
            </a:p>
          </p:txBody>
        </p:sp>
        <p:sp>
          <p:nvSpPr>
            <p:cNvPr id="176" name="CasellaDiTesto 175">
              <a:extLst>
                <a:ext uri="{FF2B5EF4-FFF2-40B4-BE49-F238E27FC236}">
                  <a16:creationId xmlns:a16="http://schemas.microsoft.com/office/drawing/2014/main" id="{E6197E20-D375-460A-9940-A09C413D052E}"/>
                </a:ext>
              </a:extLst>
            </p:cNvPr>
            <p:cNvSpPr txBox="1"/>
            <p:nvPr/>
          </p:nvSpPr>
          <p:spPr>
            <a:xfrm>
              <a:off x="2112503" y="3186560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sp>
          <p:nvSpPr>
            <p:cNvPr id="177" name="CasellaDiTesto 176">
              <a:extLst>
                <a:ext uri="{FF2B5EF4-FFF2-40B4-BE49-F238E27FC236}">
                  <a16:creationId xmlns:a16="http://schemas.microsoft.com/office/drawing/2014/main" id="{C8092721-8833-4285-B62A-FD27B23B350E}"/>
                </a:ext>
              </a:extLst>
            </p:cNvPr>
            <p:cNvSpPr txBox="1"/>
            <p:nvPr/>
          </p:nvSpPr>
          <p:spPr>
            <a:xfrm>
              <a:off x="2308221" y="3186560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sp>
          <p:nvSpPr>
            <p:cNvPr id="178" name="CasellaDiTesto 177">
              <a:extLst>
                <a:ext uri="{FF2B5EF4-FFF2-40B4-BE49-F238E27FC236}">
                  <a16:creationId xmlns:a16="http://schemas.microsoft.com/office/drawing/2014/main" id="{95C7DB4A-87B5-4F22-8C3A-E3CDB7D41956}"/>
                </a:ext>
              </a:extLst>
            </p:cNvPr>
            <p:cNvSpPr txBox="1"/>
            <p:nvPr/>
          </p:nvSpPr>
          <p:spPr>
            <a:xfrm>
              <a:off x="2508836" y="3186560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+</a:t>
              </a:r>
            </a:p>
          </p:txBody>
        </p:sp>
        <p:sp>
          <p:nvSpPr>
            <p:cNvPr id="179" name="CasellaDiTesto 178">
              <a:extLst>
                <a:ext uri="{FF2B5EF4-FFF2-40B4-BE49-F238E27FC236}">
                  <a16:creationId xmlns:a16="http://schemas.microsoft.com/office/drawing/2014/main" id="{45B0353D-0609-4DD1-A4BF-F109F5A9EBF6}"/>
                </a:ext>
              </a:extLst>
            </p:cNvPr>
            <p:cNvSpPr txBox="1"/>
            <p:nvPr/>
          </p:nvSpPr>
          <p:spPr>
            <a:xfrm>
              <a:off x="2706360" y="3186560"/>
              <a:ext cx="3626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Tel</a:t>
              </a:r>
            </a:p>
          </p:txBody>
        </p:sp>
        <p:sp>
          <p:nvSpPr>
            <p:cNvPr id="180" name="CasellaDiTesto 179">
              <a:extLst>
                <a:ext uri="{FF2B5EF4-FFF2-40B4-BE49-F238E27FC236}">
                  <a16:creationId xmlns:a16="http://schemas.microsoft.com/office/drawing/2014/main" id="{821E1AA2-84F8-4053-A424-292FDB9E2FFE}"/>
                </a:ext>
              </a:extLst>
            </p:cNvPr>
            <p:cNvSpPr txBox="1"/>
            <p:nvPr/>
          </p:nvSpPr>
          <p:spPr>
            <a:xfrm>
              <a:off x="1442893" y="330138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</a:t>
              </a:r>
            </a:p>
          </p:txBody>
        </p:sp>
        <p:sp>
          <p:nvSpPr>
            <p:cNvPr id="181" name="CasellaDiTesto 180">
              <a:extLst>
                <a:ext uri="{FF2B5EF4-FFF2-40B4-BE49-F238E27FC236}">
                  <a16:creationId xmlns:a16="http://schemas.microsoft.com/office/drawing/2014/main" id="{8B03998C-E6C7-4286-B753-BEEB591055F0}"/>
                </a:ext>
              </a:extLst>
            </p:cNvPr>
            <p:cNvSpPr txBox="1"/>
            <p:nvPr/>
          </p:nvSpPr>
          <p:spPr>
            <a:xfrm>
              <a:off x="1609850" y="3301383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0</a:t>
              </a:r>
            </a:p>
          </p:txBody>
        </p:sp>
        <p:sp>
          <p:nvSpPr>
            <p:cNvPr id="182" name="CasellaDiTesto 181">
              <a:extLst>
                <a:ext uri="{FF2B5EF4-FFF2-40B4-BE49-F238E27FC236}">
                  <a16:creationId xmlns:a16="http://schemas.microsoft.com/office/drawing/2014/main" id="{A4547C48-8D99-441A-B7C8-CF4628FA4802}"/>
                </a:ext>
              </a:extLst>
            </p:cNvPr>
            <p:cNvSpPr txBox="1"/>
            <p:nvPr/>
          </p:nvSpPr>
          <p:spPr>
            <a:xfrm>
              <a:off x="1854365" y="3301383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250</a:t>
              </a:r>
            </a:p>
          </p:txBody>
        </p:sp>
        <p:sp>
          <p:nvSpPr>
            <p:cNvPr id="183" name="CasellaDiTesto 182">
              <a:extLst>
                <a:ext uri="{FF2B5EF4-FFF2-40B4-BE49-F238E27FC236}">
                  <a16:creationId xmlns:a16="http://schemas.microsoft.com/office/drawing/2014/main" id="{1B66C2F8-55FC-4250-986F-748069EFE0A2}"/>
                </a:ext>
              </a:extLst>
            </p:cNvPr>
            <p:cNvSpPr txBox="1"/>
            <p:nvPr/>
          </p:nvSpPr>
          <p:spPr>
            <a:xfrm>
              <a:off x="2095024" y="330138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</a:t>
              </a:r>
            </a:p>
          </p:txBody>
        </p:sp>
        <p:sp>
          <p:nvSpPr>
            <p:cNvPr id="184" name="CasellaDiTesto 183">
              <a:extLst>
                <a:ext uri="{FF2B5EF4-FFF2-40B4-BE49-F238E27FC236}">
                  <a16:creationId xmlns:a16="http://schemas.microsoft.com/office/drawing/2014/main" id="{F85026A9-4200-4DF6-A407-2D5A1316CE44}"/>
                </a:ext>
              </a:extLst>
            </p:cNvPr>
            <p:cNvSpPr txBox="1"/>
            <p:nvPr/>
          </p:nvSpPr>
          <p:spPr>
            <a:xfrm>
              <a:off x="2261981" y="3301383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0</a:t>
              </a:r>
            </a:p>
          </p:txBody>
        </p:sp>
        <p:sp>
          <p:nvSpPr>
            <p:cNvPr id="185" name="CasellaDiTesto 184">
              <a:extLst>
                <a:ext uri="{FF2B5EF4-FFF2-40B4-BE49-F238E27FC236}">
                  <a16:creationId xmlns:a16="http://schemas.microsoft.com/office/drawing/2014/main" id="{14A20722-FCA4-4B93-A248-C50E22101750}"/>
                </a:ext>
              </a:extLst>
            </p:cNvPr>
            <p:cNvSpPr txBox="1"/>
            <p:nvPr/>
          </p:nvSpPr>
          <p:spPr>
            <a:xfrm>
              <a:off x="2506496" y="3301383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250</a:t>
              </a:r>
            </a:p>
          </p:txBody>
        </p:sp>
        <p:cxnSp>
          <p:nvCxnSpPr>
            <p:cNvPr id="186" name="Connettore diritto 185">
              <a:extLst>
                <a:ext uri="{FF2B5EF4-FFF2-40B4-BE49-F238E27FC236}">
                  <a16:creationId xmlns:a16="http://schemas.microsoft.com/office/drawing/2014/main" id="{CC8B3237-8B0E-45B3-BC9F-9B231A3B2577}"/>
                </a:ext>
              </a:extLst>
            </p:cNvPr>
            <p:cNvCxnSpPr>
              <a:cxnSpLocks/>
            </p:cNvCxnSpPr>
            <p:nvPr/>
          </p:nvCxnSpPr>
          <p:spPr>
            <a:xfrm>
              <a:off x="1598138" y="3494644"/>
              <a:ext cx="109886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7" name="CasellaDiTesto 186">
              <a:extLst>
                <a:ext uri="{FF2B5EF4-FFF2-40B4-BE49-F238E27FC236}">
                  <a16:creationId xmlns:a16="http://schemas.microsoft.com/office/drawing/2014/main" id="{869C99FE-074A-40AC-B819-2CFD91A5EFF1}"/>
                </a:ext>
              </a:extLst>
            </p:cNvPr>
            <p:cNvSpPr txBox="1"/>
            <p:nvPr/>
          </p:nvSpPr>
          <p:spPr>
            <a:xfrm>
              <a:off x="1771213" y="3445399"/>
              <a:ext cx="8322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IGF (</a:t>
              </a:r>
              <a:r>
                <a:rPr lang="it-IT" sz="1000" dirty="0" err="1">
                  <a:latin typeface="+mn-lt"/>
                </a:rPr>
                <a:t>ng</a:t>
              </a:r>
              <a:r>
                <a:rPr lang="it-IT" sz="1000" dirty="0">
                  <a:latin typeface="+mn-lt"/>
                </a:rPr>
                <a:t>/ml)</a:t>
              </a:r>
            </a:p>
          </p:txBody>
        </p:sp>
        <p:sp>
          <p:nvSpPr>
            <p:cNvPr id="188" name="CasellaDiTesto 187">
              <a:extLst>
                <a:ext uri="{FF2B5EF4-FFF2-40B4-BE49-F238E27FC236}">
                  <a16:creationId xmlns:a16="http://schemas.microsoft.com/office/drawing/2014/main" id="{4CB34522-AF42-4823-8BD9-CC06E0446634}"/>
                </a:ext>
              </a:extLst>
            </p:cNvPr>
            <p:cNvSpPr txBox="1"/>
            <p:nvPr/>
          </p:nvSpPr>
          <p:spPr>
            <a:xfrm>
              <a:off x="2262061" y="2564160"/>
              <a:ext cx="3674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°°°</a:t>
              </a:r>
            </a:p>
          </p:txBody>
        </p:sp>
        <p:sp>
          <p:nvSpPr>
            <p:cNvPr id="189" name="CasellaDiTesto 188">
              <a:extLst>
                <a:ext uri="{FF2B5EF4-FFF2-40B4-BE49-F238E27FC236}">
                  <a16:creationId xmlns:a16="http://schemas.microsoft.com/office/drawing/2014/main" id="{833A0256-6CC3-4EDD-A8C2-199E0174CD6A}"/>
                </a:ext>
              </a:extLst>
            </p:cNvPr>
            <p:cNvSpPr txBox="1"/>
            <p:nvPr/>
          </p:nvSpPr>
          <p:spPr>
            <a:xfrm>
              <a:off x="2416289" y="2230288"/>
              <a:ext cx="4283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°°°°</a:t>
              </a:r>
            </a:p>
          </p:txBody>
        </p:sp>
      </p:grpSp>
      <p:sp>
        <p:nvSpPr>
          <p:cNvPr id="190" name="CasellaDiTesto 189">
            <a:extLst>
              <a:ext uri="{FF2B5EF4-FFF2-40B4-BE49-F238E27FC236}">
                <a16:creationId xmlns:a16="http://schemas.microsoft.com/office/drawing/2014/main" id="{66AB2529-AF2E-499A-A293-A25699845206}"/>
              </a:ext>
            </a:extLst>
          </p:cNvPr>
          <p:cNvSpPr txBox="1"/>
          <p:nvPr/>
        </p:nvSpPr>
        <p:spPr>
          <a:xfrm>
            <a:off x="278281" y="3483618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c)</a:t>
            </a:r>
          </a:p>
        </p:txBody>
      </p:sp>
      <p:sp>
        <p:nvSpPr>
          <p:cNvPr id="191" name="CasellaDiTesto 190">
            <a:extLst>
              <a:ext uri="{FF2B5EF4-FFF2-40B4-BE49-F238E27FC236}">
                <a16:creationId xmlns:a16="http://schemas.microsoft.com/office/drawing/2014/main" id="{FD99DBB9-6F9A-4DD3-848A-6DF6EB7ECE28}"/>
              </a:ext>
            </a:extLst>
          </p:cNvPr>
          <p:cNvSpPr txBox="1"/>
          <p:nvPr/>
        </p:nvSpPr>
        <p:spPr>
          <a:xfrm>
            <a:off x="3194726" y="3483618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d)</a:t>
            </a:r>
          </a:p>
        </p:txBody>
      </p:sp>
      <p:sp>
        <p:nvSpPr>
          <p:cNvPr id="192" name="CasellaDiTesto 191">
            <a:extLst>
              <a:ext uri="{FF2B5EF4-FFF2-40B4-BE49-F238E27FC236}">
                <a16:creationId xmlns:a16="http://schemas.microsoft.com/office/drawing/2014/main" id="{37DE3FBD-0C2B-4524-9FF0-466EA0724261}"/>
              </a:ext>
            </a:extLst>
          </p:cNvPr>
          <p:cNvSpPr txBox="1"/>
          <p:nvPr/>
        </p:nvSpPr>
        <p:spPr>
          <a:xfrm>
            <a:off x="278281" y="5169999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e)</a:t>
            </a:r>
          </a:p>
        </p:txBody>
      </p:sp>
      <p:sp>
        <p:nvSpPr>
          <p:cNvPr id="193" name="CasellaDiTesto 192">
            <a:extLst>
              <a:ext uri="{FF2B5EF4-FFF2-40B4-BE49-F238E27FC236}">
                <a16:creationId xmlns:a16="http://schemas.microsoft.com/office/drawing/2014/main" id="{13FFDA18-F145-474C-8E71-C2D24E03664E}"/>
              </a:ext>
            </a:extLst>
          </p:cNvPr>
          <p:cNvSpPr txBox="1"/>
          <p:nvPr/>
        </p:nvSpPr>
        <p:spPr>
          <a:xfrm>
            <a:off x="3212359" y="5169999"/>
            <a:ext cx="3145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f)</a:t>
            </a:r>
          </a:p>
        </p:txBody>
      </p:sp>
      <p:sp>
        <p:nvSpPr>
          <p:cNvPr id="194" name="CasellaDiTesto 193">
            <a:extLst>
              <a:ext uri="{FF2B5EF4-FFF2-40B4-BE49-F238E27FC236}">
                <a16:creationId xmlns:a16="http://schemas.microsoft.com/office/drawing/2014/main" id="{CDC8E2FA-B501-42F3-A144-8DD4DB640E43}"/>
              </a:ext>
            </a:extLst>
          </p:cNvPr>
          <p:cNvSpPr txBox="1"/>
          <p:nvPr/>
        </p:nvSpPr>
        <p:spPr>
          <a:xfrm>
            <a:off x="274273" y="7156026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g)</a:t>
            </a:r>
          </a:p>
        </p:txBody>
      </p:sp>
      <p:sp>
        <p:nvSpPr>
          <p:cNvPr id="195" name="CasellaDiTesto 194">
            <a:extLst>
              <a:ext uri="{FF2B5EF4-FFF2-40B4-BE49-F238E27FC236}">
                <a16:creationId xmlns:a16="http://schemas.microsoft.com/office/drawing/2014/main" id="{C2EFE8F3-22EE-4A8A-ABE9-9CFFB4F6F230}"/>
              </a:ext>
            </a:extLst>
          </p:cNvPr>
          <p:cNvSpPr txBox="1"/>
          <p:nvPr/>
        </p:nvSpPr>
        <p:spPr>
          <a:xfrm>
            <a:off x="3194726" y="7156026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h)</a:t>
            </a:r>
          </a:p>
        </p:txBody>
      </p:sp>
      <p:grpSp>
        <p:nvGrpSpPr>
          <p:cNvPr id="197" name="Gruppo 196">
            <a:extLst>
              <a:ext uri="{FF2B5EF4-FFF2-40B4-BE49-F238E27FC236}">
                <a16:creationId xmlns:a16="http://schemas.microsoft.com/office/drawing/2014/main" id="{0FC84507-3E65-C69C-17D3-B6592335F62D}"/>
              </a:ext>
            </a:extLst>
          </p:cNvPr>
          <p:cNvGrpSpPr/>
          <p:nvPr/>
        </p:nvGrpSpPr>
        <p:grpSpPr>
          <a:xfrm>
            <a:off x="3328409" y="2008471"/>
            <a:ext cx="2111314" cy="1727623"/>
            <a:chOff x="3328409" y="2008471"/>
            <a:chExt cx="2111314" cy="1727623"/>
          </a:xfrm>
        </p:grpSpPr>
        <p:pic>
          <p:nvPicPr>
            <p:cNvPr id="196" name="Immagine 195">
              <a:extLst>
                <a:ext uri="{FF2B5EF4-FFF2-40B4-BE49-F238E27FC236}">
                  <a16:creationId xmlns:a16="http://schemas.microsoft.com/office/drawing/2014/main" id="{106B346E-41E9-91F5-3805-1AB39F780149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201653" y="2135219"/>
              <a:ext cx="1182829" cy="1166400"/>
            </a:xfrm>
            <a:prstGeom prst="rect">
              <a:avLst/>
            </a:prstGeom>
          </p:spPr>
        </p:pic>
        <p:sp>
          <p:nvSpPr>
            <p:cNvPr id="52" name="CasellaDiTesto 51">
              <a:extLst>
                <a:ext uri="{FF2B5EF4-FFF2-40B4-BE49-F238E27FC236}">
                  <a16:creationId xmlns:a16="http://schemas.microsoft.com/office/drawing/2014/main" id="{75FFF2A5-D73E-4D0F-BE4B-CA25D22A59E0}"/>
                </a:ext>
              </a:extLst>
            </p:cNvPr>
            <p:cNvSpPr txBox="1"/>
            <p:nvPr/>
          </p:nvSpPr>
          <p:spPr>
            <a:xfrm>
              <a:off x="4374682" y="3459095"/>
              <a:ext cx="982571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it-IT" sz="1200" dirty="0"/>
                <a:t> MK (</a:t>
              </a:r>
              <a:r>
                <a:rPr lang="el-G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it-IT" sz="1200" dirty="0"/>
                <a:t>M)</a:t>
              </a:r>
            </a:p>
          </p:txBody>
        </p:sp>
        <p:sp>
          <p:nvSpPr>
            <p:cNvPr id="48" name="CasellaDiTesto 47">
              <a:extLst>
                <a:ext uri="{FF2B5EF4-FFF2-40B4-BE49-F238E27FC236}">
                  <a16:creationId xmlns:a16="http://schemas.microsoft.com/office/drawing/2014/main" id="{E55FEA93-EBD7-488C-9473-55358D9DE48C}"/>
                </a:ext>
              </a:extLst>
            </p:cNvPr>
            <p:cNvSpPr txBox="1"/>
            <p:nvPr/>
          </p:nvSpPr>
          <p:spPr>
            <a:xfrm rot="16200000">
              <a:off x="2948357" y="2388523"/>
              <a:ext cx="1406435" cy="64633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/>
                <a:t>Fraction</a:t>
              </a:r>
              <a:r>
                <a:rPr lang="it-IT" sz="1200" dirty="0"/>
                <a:t> of </a:t>
              </a:r>
              <a:r>
                <a:rPr lang="it-IT" sz="1200" dirty="0" err="1"/>
                <a:t>cleaved</a:t>
              </a:r>
              <a:r>
                <a:rPr lang="it-IT" sz="1200" dirty="0"/>
                <a:t> PARP</a:t>
              </a:r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0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49" name="CasellaDiTesto 48">
              <a:extLst>
                <a:ext uri="{FF2B5EF4-FFF2-40B4-BE49-F238E27FC236}">
                  <a16:creationId xmlns:a16="http://schemas.microsoft.com/office/drawing/2014/main" id="{78373B0A-D670-4B40-9A64-D5BBF7C5D21F}"/>
                </a:ext>
              </a:extLst>
            </p:cNvPr>
            <p:cNvSpPr txBox="1"/>
            <p:nvPr/>
          </p:nvSpPr>
          <p:spPr>
            <a:xfrm>
              <a:off x="4285233" y="3263521"/>
              <a:ext cx="269626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</a:t>
              </a:r>
            </a:p>
          </p:txBody>
        </p:sp>
        <p:sp>
          <p:nvSpPr>
            <p:cNvPr id="50" name="CasellaDiTesto 49">
              <a:extLst>
                <a:ext uri="{FF2B5EF4-FFF2-40B4-BE49-F238E27FC236}">
                  <a16:creationId xmlns:a16="http://schemas.microsoft.com/office/drawing/2014/main" id="{065EA109-3923-4391-9D1F-87657F51028A}"/>
                </a:ext>
              </a:extLst>
            </p:cNvPr>
            <p:cNvSpPr txBox="1"/>
            <p:nvPr/>
          </p:nvSpPr>
          <p:spPr>
            <a:xfrm>
              <a:off x="3903336" y="2570385"/>
              <a:ext cx="397866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6.0</a:t>
              </a:r>
            </a:p>
          </p:txBody>
        </p:sp>
        <p:sp>
          <p:nvSpPr>
            <p:cNvPr id="51" name="CasellaDiTesto 50">
              <a:extLst>
                <a:ext uri="{FF2B5EF4-FFF2-40B4-BE49-F238E27FC236}">
                  <a16:creationId xmlns:a16="http://schemas.microsoft.com/office/drawing/2014/main" id="{FA91F10E-A2CC-4491-B65A-8859419CBAC5}"/>
                </a:ext>
              </a:extLst>
            </p:cNvPr>
            <p:cNvSpPr txBox="1"/>
            <p:nvPr/>
          </p:nvSpPr>
          <p:spPr>
            <a:xfrm>
              <a:off x="3903336" y="3098459"/>
              <a:ext cx="397866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53" name="CasellaDiTesto 52">
              <a:extLst>
                <a:ext uri="{FF2B5EF4-FFF2-40B4-BE49-F238E27FC236}">
                  <a16:creationId xmlns:a16="http://schemas.microsoft.com/office/drawing/2014/main" id="{E59DB48C-1568-48F9-A7BD-9F8C2B512295}"/>
                </a:ext>
              </a:extLst>
            </p:cNvPr>
            <p:cNvSpPr txBox="1"/>
            <p:nvPr/>
          </p:nvSpPr>
          <p:spPr>
            <a:xfrm>
              <a:off x="3818378" y="2041220"/>
              <a:ext cx="482824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2.0</a:t>
              </a:r>
            </a:p>
          </p:txBody>
        </p:sp>
        <p:sp>
          <p:nvSpPr>
            <p:cNvPr id="54" name="CasellaDiTesto 53">
              <a:extLst>
                <a:ext uri="{FF2B5EF4-FFF2-40B4-BE49-F238E27FC236}">
                  <a16:creationId xmlns:a16="http://schemas.microsoft.com/office/drawing/2014/main" id="{DEAB80A3-D7C6-46B4-99DC-33F386AB23FE}"/>
                </a:ext>
              </a:extLst>
            </p:cNvPr>
            <p:cNvSpPr txBox="1"/>
            <p:nvPr/>
          </p:nvSpPr>
          <p:spPr>
            <a:xfrm>
              <a:off x="4409800" y="3263521"/>
              <a:ext cx="482824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1</a:t>
              </a:r>
            </a:p>
          </p:txBody>
        </p:sp>
        <p:sp>
          <p:nvSpPr>
            <p:cNvPr id="55" name="CasellaDiTesto 54">
              <a:extLst>
                <a:ext uri="{FF2B5EF4-FFF2-40B4-BE49-F238E27FC236}">
                  <a16:creationId xmlns:a16="http://schemas.microsoft.com/office/drawing/2014/main" id="{9FB9D37B-4340-442C-BCAE-F74DCAE48668}"/>
                </a:ext>
              </a:extLst>
            </p:cNvPr>
            <p:cNvSpPr txBox="1"/>
            <p:nvPr/>
          </p:nvSpPr>
          <p:spPr>
            <a:xfrm>
              <a:off x="4747806" y="3263521"/>
              <a:ext cx="397866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1</a:t>
              </a:r>
            </a:p>
          </p:txBody>
        </p:sp>
        <p:sp>
          <p:nvSpPr>
            <p:cNvPr id="56" name="CasellaDiTesto 55">
              <a:extLst>
                <a:ext uri="{FF2B5EF4-FFF2-40B4-BE49-F238E27FC236}">
                  <a16:creationId xmlns:a16="http://schemas.microsoft.com/office/drawing/2014/main" id="{DDD86ABD-6BDE-4BC5-802F-1F23C1462A2C}"/>
                </a:ext>
              </a:extLst>
            </p:cNvPr>
            <p:cNvSpPr txBox="1"/>
            <p:nvPr/>
          </p:nvSpPr>
          <p:spPr>
            <a:xfrm>
              <a:off x="5041857" y="3263521"/>
              <a:ext cx="397866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1.0</a:t>
              </a:r>
            </a:p>
          </p:txBody>
        </p:sp>
        <p:sp>
          <p:nvSpPr>
            <p:cNvPr id="57" name="CasellaDiTesto 56">
              <a:extLst>
                <a:ext uri="{FF2B5EF4-FFF2-40B4-BE49-F238E27FC236}">
                  <a16:creationId xmlns:a16="http://schemas.microsoft.com/office/drawing/2014/main" id="{286ECD8B-3C9D-4753-B7AF-FF35070ED12E}"/>
                </a:ext>
              </a:extLst>
            </p:cNvPr>
            <p:cNvSpPr txBox="1"/>
            <p:nvPr/>
          </p:nvSpPr>
          <p:spPr>
            <a:xfrm>
              <a:off x="4766656" y="2182761"/>
              <a:ext cx="30328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</a:t>
              </a:r>
            </a:p>
            <a:p>
              <a:r>
                <a:rPr lang="it-IT" sz="1200" dirty="0"/>
                <a:t>**</a:t>
              </a:r>
            </a:p>
          </p:txBody>
        </p:sp>
        <p:sp>
          <p:nvSpPr>
            <p:cNvPr id="58" name="CasellaDiTesto 57">
              <a:extLst>
                <a:ext uri="{FF2B5EF4-FFF2-40B4-BE49-F238E27FC236}">
                  <a16:creationId xmlns:a16="http://schemas.microsoft.com/office/drawing/2014/main" id="{0CA6824A-E1A8-4854-B5CC-5881153B4511}"/>
                </a:ext>
              </a:extLst>
            </p:cNvPr>
            <p:cNvSpPr txBox="1"/>
            <p:nvPr/>
          </p:nvSpPr>
          <p:spPr>
            <a:xfrm>
              <a:off x="4967744" y="2014532"/>
              <a:ext cx="421910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**</a:t>
              </a:r>
            </a:p>
          </p:txBody>
        </p:sp>
        <p:sp>
          <p:nvSpPr>
            <p:cNvPr id="59" name="CasellaDiTesto 58">
              <a:extLst>
                <a:ext uri="{FF2B5EF4-FFF2-40B4-BE49-F238E27FC236}">
                  <a16:creationId xmlns:a16="http://schemas.microsoft.com/office/drawing/2014/main" id="{67E23C50-C0BC-4881-82F1-0463765E3F0C}"/>
                </a:ext>
              </a:extLst>
            </p:cNvPr>
            <p:cNvSpPr txBox="1"/>
            <p:nvPr/>
          </p:nvSpPr>
          <p:spPr>
            <a:xfrm>
              <a:off x="4517786" y="2386153"/>
              <a:ext cx="303288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</a:t>
              </a:r>
            </a:p>
            <a:p>
              <a:r>
                <a:rPr lang="it-IT" sz="1200" dirty="0"/>
                <a:t>**</a:t>
              </a:r>
            </a:p>
          </p:txBody>
        </p:sp>
        <p:cxnSp>
          <p:nvCxnSpPr>
            <p:cNvPr id="60" name="Connettore diritto 59">
              <a:extLst>
                <a:ext uri="{FF2B5EF4-FFF2-40B4-BE49-F238E27FC236}">
                  <a16:creationId xmlns:a16="http://schemas.microsoft.com/office/drawing/2014/main" id="{63C3D013-0061-4FDA-A362-787ABCEFD35E}"/>
                </a:ext>
              </a:extLst>
            </p:cNvPr>
            <p:cNvCxnSpPr>
              <a:cxnSpLocks/>
            </p:cNvCxnSpPr>
            <p:nvPr/>
          </p:nvCxnSpPr>
          <p:spPr>
            <a:xfrm>
              <a:off x="4420046" y="3494800"/>
              <a:ext cx="78511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01" name="Gruppo 200">
            <a:extLst>
              <a:ext uri="{FF2B5EF4-FFF2-40B4-BE49-F238E27FC236}">
                <a16:creationId xmlns:a16="http://schemas.microsoft.com/office/drawing/2014/main" id="{B20980A9-76FF-6500-A5A9-6C6511A91338}"/>
              </a:ext>
            </a:extLst>
          </p:cNvPr>
          <p:cNvGrpSpPr/>
          <p:nvPr/>
        </p:nvGrpSpPr>
        <p:grpSpPr>
          <a:xfrm>
            <a:off x="3782953" y="467544"/>
            <a:ext cx="2346726" cy="1207014"/>
            <a:chOff x="3557924" y="533244"/>
            <a:chExt cx="2346726" cy="1207014"/>
          </a:xfrm>
        </p:grpSpPr>
        <p:pic>
          <p:nvPicPr>
            <p:cNvPr id="198" name="Immagine 197">
              <a:extLst>
                <a:ext uri="{FF2B5EF4-FFF2-40B4-BE49-F238E27FC236}">
                  <a16:creationId xmlns:a16="http://schemas.microsoft.com/office/drawing/2014/main" id="{8E17B733-2FD3-E275-6A28-5B27228289C2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3832746" y="950361"/>
              <a:ext cx="1440000" cy="49927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200" name="Gruppo 199">
              <a:extLst>
                <a:ext uri="{FF2B5EF4-FFF2-40B4-BE49-F238E27FC236}">
                  <a16:creationId xmlns:a16="http://schemas.microsoft.com/office/drawing/2014/main" id="{5509FD13-F636-B0C9-81DA-7BFA875729C2}"/>
                </a:ext>
              </a:extLst>
            </p:cNvPr>
            <p:cNvGrpSpPr/>
            <p:nvPr/>
          </p:nvGrpSpPr>
          <p:grpSpPr>
            <a:xfrm>
              <a:off x="3557924" y="1042270"/>
              <a:ext cx="246221" cy="577402"/>
              <a:chOff x="3557924" y="894208"/>
              <a:chExt cx="246221" cy="577402"/>
            </a:xfrm>
          </p:grpSpPr>
          <p:cxnSp>
            <p:nvCxnSpPr>
              <p:cNvPr id="19" name="Connettore diritto 18">
                <a:extLst>
                  <a:ext uri="{FF2B5EF4-FFF2-40B4-BE49-F238E27FC236}">
                    <a16:creationId xmlns:a16="http://schemas.microsoft.com/office/drawing/2014/main" id="{C7770BC5-2483-4661-A141-E2725D69B186}"/>
                  </a:ext>
                </a:extLst>
              </p:cNvPr>
              <p:cNvCxnSpPr/>
              <p:nvPr/>
            </p:nvCxnSpPr>
            <p:spPr>
              <a:xfrm>
                <a:off x="3760010" y="1030041"/>
                <a:ext cx="0" cy="30728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CasellaDiTesto 19">
                <a:extLst>
                  <a:ext uri="{FF2B5EF4-FFF2-40B4-BE49-F238E27FC236}">
                    <a16:creationId xmlns:a16="http://schemas.microsoft.com/office/drawing/2014/main" id="{FAE24FF5-730D-4351-BBBA-E64C0C8CD160}"/>
                  </a:ext>
                </a:extLst>
              </p:cNvPr>
              <p:cNvSpPr txBox="1"/>
              <p:nvPr/>
            </p:nvSpPr>
            <p:spPr>
              <a:xfrm rot="16200000">
                <a:off x="3392334" y="1059798"/>
                <a:ext cx="577402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+mn-lt"/>
                  </a:rPr>
                  <a:t>MCF-7</a:t>
                </a:r>
              </a:p>
            </p:txBody>
          </p:sp>
        </p:grp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C9BA248E-8DE9-4309-9E5F-F2C6D2D8570C}"/>
                </a:ext>
              </a:extLst>
            </p:cNvPr>
            <p:cNvSpPr txBox="1"/>
            <p:nvPr/>
          </p:nvSpPr>
          <p:spPr>
            <a:xfrm>
              <a:off x="5272746" y="1488356"/>
              <a:ext cx="63190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>
                  <a:latin typeface="+mn-lt"/>
                </a:rPr>
                <a:t>Vinculin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4C0D0416-CA53-401B-9460-CE3CA1E97481}"/>
                </a:ext>
              </a:extLst>
            </p:cNvPr>
            <p:cNvSpPr txBox="1"/>
            <p:nvPr/>
          </p:nvSpPr>
          <p:spPr>
            <a:xfrm>
              <a:off x="3832746" y="706093"/>
              <a:ext cx="255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23" name="CasellaDiTesto 22">
              <a:extLst>
                <a:ext uri="{FF2B5EF4-FFF2-40B4-BE49-F238E27FC236}">
                  <a16:creationId xmlns:a16="http://schemas.microsoft.com/office/drawing/2014/main" id="{B111B969-ADDD-4C6B-9B19-35D787062134}"/>
                </a:ext>
              </a:extLst>
            </p:cNvPr>
            <p:cNvSpPr txBox="1"/>
            <p:nvPr/>
          </p:nvSpPr>
          <p:spPr>
            <a:xfrm>
              <a:off x="4187700" y="706093"/>
              <a:ext cx="43152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.01</a:t>
              </a:r>
            </a:p>
          </p:txBody>
        </p: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id="{3B5BE2B2-D386-4108-8072-67C6CC95A2C9}"/>
                </a:ext>
              </a:extLst>
            </p:cNvPr>
            <p:cNvSpPr txBox="1"/>
            <p:nvPr/>
          </p:nvSpPr>
          <p:spPr>
            <a:xfrm>
              <a:off x="4566483" y="706093"/>
              <a:ext cx="360996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.1</a:t>
              </a:r>
            </a:p>
          </p:txBody>
        </p:sp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02861877-A49C-4779-8B42-21916FA31289}"/>
                </a:ext>
              </a:extLst>
            </p:cNvPr>
            <p:cNvSpPr txBox="1"/>
            <p:nvPr/>
          </p:nvSpPr>
          <p:spPr>
            <a:xfrm>
              <a:off x="4900910" y="706093"/>
              <a:ext cx="360996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.0</a:t>
              </a:r>
            </a:p>
          </p:txBody>
        </p:sp>
        <p:sp>
          <p:nvSpPr>
            <p:cNvPr id="26" name="CasellaDiTesto 25">
              <a:extLst>
                <a:ext uri="{FF2B5EF4-FFF2-40B4-BE49-F238E27FC236}">
                  <a16:creationId xmlns:a16="http://schemas.microsoft.com/office/drawing/2014/main" id="{36CCD239-EE37-4571-B961-33BCF21E33DC}"/>
                </a:ext>
              </a:extLst>
            </p:cNvPr>
            <p:cNvSpPr txBox="1"/>
            <p:nvPr/>
          </p:nvSpPr>
          <p:spPr>
            <a:xfrm>
              <a:off x="4403098" y="533244"/>
              <a:ext cx="679994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MK (µM)</a:t>
              </a:r>
            </a:p>
          </p:txBody>
        </p:sp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id="{A06536CC-4912-44F9-802B-373324655E45}"/>
                </a:ext>
              </a:extLst>
            </p:cNvPr>
            <p:cNvSpPr txBox="1"/>
            <p:nvPr/>
          </p:nvSpPr>
          <p:spPr>
            <a:xfrm>
              <a:off x="5272746" y="967015"/>
              <a:ext cx="53251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PARP</a:t>
              </a:r>
            </a:p>
          </p:txBody>
        </p:sp>
        <p:cxnSp>
          <p:nvCxnSpPr>
            <p:cNvPr id="28" name="Connettore diritto 27">
              <a:extLst>
                <a:ext uri="{FF2B5EF4-FFF2-40B4-BE49-F238E27FC236}">
                  <a16:creationId xmlns:a16="http://schemas.microsoft.com/office/drawing/2014/main" id="{709FD97A-7722-4BD3-B194-6014BE88A44E}"/>
                </a:ext>
              </a:extLst>
            </p:cNvPr>
            <p:cNvCxnSpPr>
              <a:cxnSpLocks/>
            </p:cNvCxnSpPr>
            <p:nvPr/>
          </p:nvCxnSpPr>
          <p:spPr>
            <a:xfrm>
              <a:off x="4325668" y="736573"/>
              <a:ext cx="8188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199" name="Immagine 198">
              <a:extLst>
                <a:ext uri="{FF2B5EF4-FFF2-40B4-BE49-F238E27FC236}">
                  <a16:creationId xmlns:a16="http://schemas.microsoft.com/office/drawing/2014/main" id="{A4F446D6-90B1-35D1-7954-B8AFD1EF7FE5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3832746" y="1493094"/>
              <a:ext cx="1440000" cy="24716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230706703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CasellaDiTesto 175">
            <a:extLst>
              <a:ext uri="{FF2B5EF4-FFF2-40B4-BE49-F238E27FC236}">
                <a16:creationId xmlns:a16="http://schemas.microsoft.com/office/drawing/2014/main" id="{722B450F-3F9B-4F68-8078-9C725D33507C}"/>
              </a:ext>
            </a:extLst>
          </p:cNvPr>
          <p:cNvSpPr txBox="1"/>
          <p:nvPr/>
        </p:nvSpPr>
        <p:spPr>
          <a:xfrm>
            <a:off x="404664" y="520896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a)</a:t>
            </a:r>
          </a:p>
        </p:txBody>
      </p:sp>
      <p:sp>
        <p:nvSpPr>
          <p:cNvPr id="177" name="CasellaDiTesto 176">
            <a:extLst>
              <a:ext uri="{FF2B5EF4-FFF2-40B4-BE49-F238E27FC236}">
                <a16:creationId xmlns:a16="http://schemas.microsoft.com/office/drawing/2014/main" id="{BC3E4455-CC19-43C4-A420-70C2643B7A92}"/>
              </a:ext>
            </a:extLst>
          </p:cNvPr>
          <p:cNvSpPr txBox="1"/>
          <p:nvPr/>
        </p:nvSpPr>
        <p:spPr>
          <a:xfrm>
            <a:off x="3254112" y="520896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/>
              <a:t>(b)</a:t>
            </a:r>
          </a:p>
        </p:txBody>
      </p:sp>
      <p:grpSp>
        <p:nvGrpSpPr>
          <p:cNvPr id="178" name="Gruppo 177">
            <a:extLst>
              <a:ext uri="{FF2B5EF4-FFF2-40B4-BE49-F238E27FC236}">
                <a16:creationId xmlns:a16="http://schemas.microsoft.com/office/drawing/2014/main" id="{E992011D-766B-43CC-9AF2-4DCE84B1EACC}"/>
              </a:ext>
            </a:extLst>
          </p:cNvPr>
          <p:cNvGrpSpPr/>
          <p:nvPr/>
        </p:nvGrpSpPr>
        <p:grpSpPr>
          <a:xfrm>
            <a:off x="3312995" y="988658"/>
            <a:ext cx="2855916" cy="1555838"/>
            <a:chOff x="143594" y="7143527"/>
            <a:chExt cx="2855916" cy="1555838"/>
          </a:xfrm>
        </p:grpSpPr>
        <p:pic>
          <p:nvPicPr>
            <p:cNvPr id="179" name="Immagine 178">
              <a:extLst>
                <a:ext uri="{FF2B5EF4-FFF2-40B4-BE49-F238E27FC236}">
                  <a16:creationId xmlns:a16="http://schemas.microsoft.com/office/drawing/2014/main" id="{A13EA2F8-80C9-426A-8079-547D33F9AB1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98901" y="7334114"/>
              <a:ext cx="1685395" cy="1166400"/>
            </a:xfrm>
            <a:prstGeom prst="rect">
              <a:avLst/>
            </a:prstGeom>
          </p:spPr>
        </p:pic>
        <p:sp>
          <p:nvSpPr>
            <p:cNvPr id="180" name="CasellaDiTesto 179">
              <a:extLst>
                <a:ext uri="{FF2B5EF4-FFF2-40B4-BE49-F238E27FC236}">
                  <a16:creationId xmlns:a16="http://schemas.microsoft.com/office/drawing/2014/main" id="{F0C193CB-5DBC-4163-B3F0-8120C9EA8ECF}"/>
                </a:ext>
              </a:extLst>
            </p:cNvPr>
            <p:cNvSpPr txBox="1"/>
            <p:nvPr/>
          </p:nvSpPr>
          <p:spPr>
            <a:xfrm rot="16200000">
              <a:off x="-236458" y="7587418"/>
              <a:ext cx="1406435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/>
                <a:t>Fraction</a:t>
              </a:r>
              <a:r>
                <a:rPr lang="it-IT" sz="1200" dirty="0"/>
                <a:t> of </a:t>
              </a:r>
              <a:r>
                <a:rPr lang="it-IT" sz="1200" dirty="0" err="1"/>
                <a:t>cleaved</a:t>
              </a:r>
              <a:r>
                <a:rPr lang="it-IT" sz="1200" dirty="0"/>
                <a:t> PARP</a:t>
              </a:r>
            </a:p>
            <a:p>
              <a:pPr algn="ctr"/>
              <a:r>
                <a:rPr lang="it-IT" sz="1200" dirty="0"/>
                <a:t>(</a:t>
              </a:r>
              <a:r>
                <a:rPr lang="it-IT" sz="1200" dirty="0" err="1"/>
                <a:t>Fold</a:t>
              </a:r>
              <a:r>
                <a:rPr lang="it-IT" sz="1200" dirty="0"/>
                <a:t> on -)</a:t>
              </a:r>
              <a:endParaRPr lang="it-IT" sz="1200" dirty="0">
                <a:latin typeface="+mn-lt"/>
                <a:cs typeface="Times New Roman" panose="02020603050405020304" pitchFamily="18" charset="0"/>
              </a:endParaRPr>
            </a:p>
          </p:txBody>
        </p:sp>
        <p:sp>
          <p:nvSpPr>
            <p:cNvPr id="181" name="CasellaDiTesto 180">
              <a:extLst>
                <a:ext uri="{FF2B5EF4-FFF2-40B4-BE49-F238E27FC236}">
                  <a16:creationId xmlns:a16="http://schemas.microsoft.com/office/drawing/2014/main" id="{690A6B70-D5CF-4930-9DAA-EEE21A710337}"/>
                </a:ext>
              </a:extLst>
            </p:cNvPr>
            <p:cNvSpPr txBox="1"/>
            <p:nvPr/>
          </p:nvSpPr>
          <p:spPr>
            <a:xfrm>
              <a:off x="698446" y="7769280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2.5</a:t>
              </a:r>
            </a:p>
          </p:txBody>
        </p:sp>
        <p:sp>
          <p:nvSpPr>
            <p:cNvPr id="182" name="CasellaDiTesto 181">
              <a:extLst>
                <a:ext uri="{FF2B5EF4-FFF2-40B4-BE49-F238E27FC236}">
                  <a16:creationId xmlns:a16="http://schemas.microsoft.com/office/drawing/2014/main" id="{126F0C58-5133-4707-B063-FD26289B56B3}"/>
                </a:ext>
              </a:extLst>
            </p:cNvPr>
            <p:cNvSpPr txBox="1"/>
            <p:nvPr/>
          </p:nvSpPr>
          <p:spPr>
            <a:xfrm>
              <a:off x="698446" y="829735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0.0</a:t>
              </a:r>
            </a:p>
          </p:txBody>
        </p:sp>
        <p:sp>
          <p:nvSpPr>
            <p:cNvPr id="183" name="CasellaDiTesto 182">
              <a:extLst>
                <a:ext uri="{FF2B5EF4-FFF2-40B4-BE49-F238E27FC236}">
                  <a16:creationId xmlns:a16="http://schemas.microsoft.com/office/drawing/2014/main" id="{0C20321D-E322-4CB5-9494-BE1E0EFDDF2C}"/>
                </a:ext>
              </a:extLst>
            </p:cNvPr>
            <p:cNvSpPr txBox="1"/>
            <p:nvPr/>
          </p:nvSpPr>
          <p:spPr>
            <a:xfrm>
              <a:off x="698446" y="7204490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5.0</a:t>
              </a:r>
            </a:p>
          </p:txBody>
        </p:sp>
        <p:sp>
          <p:nvSpPr>
            <p:cNvPr id="184" name="CasellaDiTesto 183">
              <a:extLst>
                <a:ext uri="{FF2B5EF4-FFF2-40B4-BE49-F238E27FC236}">
                  <a16:creationId xmlns:a16="http://schemas.microsoft.com/office/drawing/2014/main" id="{9F610B9C-8AEA-4190-8C54-979EEFA083A6}"/>
                </a:ext>
              </a:extLst>
            </p:cNvPr>
            <p:cNvSpPr txBox="1"/>
            <p:nvPr/>
          </p:nvSpPr>
          <p:spPr>
            <a:xfrm>
              <a:off x="1517987" y="7373839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****</a:t>
              </a:r>
            </a:p>
          </p:txBody>
        </p:sp>
        <p:sp>
          <p:nvSpPr>
            <p:cNvPr id="185" name="CasellaDiTesto 184">
              <a:extLst>
                <a:ext uri="{FF2B5EF4-FFF2-40B4-BE49-F238E27FC236}">
                  <a16:creationId xmlns:a16="http://schemas.microsoft.com/office/drawing/2014/main" id="{34E3DA42-9A71-4182-8B19-8716F2D40CC4}"/>
                </a:ext>
              </a:extLst>
            </p:cNvPr>
            <p:cNvSpPr txBox="1"/>
            <p:nvPr/>
          </p:nvSpPr>
          <p:spPr>
            <a:xfrm>
              <a:off x="2618700" y="8422366"/>
              <a:ext cx="3808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Tel</a:t>
              </a:r>
            </a:p>
          </p:txBody>
        </p:sp>
        <p:sp>
          <p:nvSpPr>
            <p:cNvPr id="186" name="CasellaDiTesto 185">
              <a:extLst>
                <a:ext uri="{FF2B5EF4-FFF2-40B4-BE49-F238E27FC236}">
                  <a16:creationId xmlns:a16="http://schemas.microsoft.com/office/drawing/2014/main" id="{226A9FB2-56AF-47EC-92B3-4785F58D5DD9}"/>
                </a:ext>
              </a:extLst>
            </p:cNvPr>
            <p:cNvSpPr txBox="1"/>
            <p:nvPr/>
          </p:nvSpPr>
          <p:spPr>
            <a:xfrm>
              <a:off x="2284935" y="8422366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-</a:t>
              </a:r>
            </a:p>
          </p:txBody>
        </p:sp>
        <p:sp>
          <p:nvSpPr>
            <p:cNvPr id="187" name="CasellaDiTesto 186">
              <a:extLst>
                <a:ext uri="{FF2B5EF4-FFF2-40B4-BE49-F238E27FC236}">
                  <a16:creationId xmlns:a16="http://schemas.microsoft.com/office/drawing/2014/main" id="{6EE46F5B-4E9B-43E1-8D28-3EB10B5FEE69}"/>
                </a:ext>
              </a:extLst>
            </p:cNvPr>
            <p:cNvSpPr txBox="1"/>
            <p:nvPr/>
          </p:nvSpPr>
          <p:spPr>
            <a:xfrm>
              <a:off x="2415376" y="8422366"/>
              <a:ext cx="2504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+</a:t>
              </a:r>
            </a:p>
          </p:txBody>
        </p:sp>
        <p:sp>
          <p:nvSpPr>
            <p:cNvPr id="188" name="CasellaDiTesto 187">
              <a:extLst>
                <a:ext uri="{FF2B5EF4-FFF2-40B4-BE49-F238E27FC236}">
                  <a16:creationId xmlns:a16="http://schemas.microsoft.com/office/drawing/2014/main" id="{60089EC9-331A-4088-8522-98484D3AF516}"/>
                </a:ext>
              </a:extLst>
            </p:cNvPr>
            <p:cNvSpPr txBox="1"/>
            <p:nvPr/>
          </p:nvSpPr>
          <p:spPr>
            <a:xfrm>
              <a:off x="2152066" y="7947044"/>
              <a:ext cx="6880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SKBR3</a:t>
              </a:r>
            </a:p>
          </p:txBody>
        </p:sp>
        <p:sp>
          <p:nvSpPr>
            <p:cNvPr id="189" name="CasellaDiTesto 188">
              <a:extLst>
                <a:ext uri="{FF2B5EF4-FFF2-40B4-BE49-F238E27FC236}">
                  <a16:creationId xmlns:a16="http://schemas.microsoft.com/office/drawing/2014/main" id="{81AF1C0F-2931-4A51-8C7A-56FFC39BD4B2}"/>
                </a:ext>
              </a:extLst>
            </p:cNvPr>
            <p:cNvSpPr txBox="1"/>
            <p:nvPr/>
          </p:nvSpPr>
          <p:spPr>
            <a:xfrm>
              <a:off x="1870087" y="8422366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-</a:t>
              </a:r>
            </a:p>
          </p:txBody>
        </p:sp>
        <p:sp>
          <p:nvSpPr>
            <p:cNvPr id="190" name="CasellaDiTesto 189">
              <a:extLst>
                <a:ext uri="{FF2B5EF4-FFF2-40B4-BE49-F238E27FC236}">
                  <a16:creationId xmlns:a16="http://schemas.microsoft.com/office/drawing/2014/main" id="{B41157AF-4AF9-486C-AA0B-E278105C496A}"/>
                </a:ext>
              </a:extLst>
            </p:cNvPr>
            <p:cNvSpPr txBox="1"/>
            <p:nvPr/>
          </p:nvSpPr>
          <p:spPr>
            <a:xfrm>
              <a:off x="2000528" y="8422366"/>
              <a:ext cx="2504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+</a:t>
              </a:r>
            </a:p>
          </p:txBody>
        </p:sp>
        <p:sp>
          <p:nvSpPr>
            <p:cNvPr id="191" name="CasellaDiTesto 190">
              <a:extLst>
                <a:ext uri="{FF2B5EF4-FFF2-40B4-BE49-F238E27FC236}">
                  <a16:creationId xmlns:a16="http://schemas.microsoft.com/office/drawing/2014/main" id="{8E17F78A-417C-441E-9267-5C7F88F63DAF}"/>
                </a:ext>
              </a:extLst>
            </p:cNvPr>
            <p:cNvSpPr txBox="1"/>
            <p:nvPr/>
          </p:nvSpPr>
          <p:spPr>
            <a:xfrm>
              <a:off x="1719135" y="7730069"/>
              <a:ext cx="6976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SKOV3</a:t>
              </a:r>
            </a:p>
          </p:txBody>
        </p:sp>
        <p:sp>
          <p:nvSpPr>
            <p:cNvPr id="192" name="CasellaDiTesto 191">
              <a:extLst>
                <a:ext uri="{FF2B5EF4-FFF2-40B4-BE49-F238E27FC236}">
                  <a16:creationId xmlns:a16="http://schemas.microsoft.com/office/drawing/2014/main" id="{4A312E14-93C3-4457-8C0C-DA553C5BE143}"/>
                </a:ext>
              </a:extLst>
            </p:cNvPr>
            <p:cNvSpPr txBox="1"/>
            <p:nvPr/>
          </p:nvSpPr>
          <p:spPr>
            <a:xfrm>
              <a:off x="1047428" y="8422366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-</a:t>
              </a:r>
            </a:p>
          </p:txBody>
        </p:sp>
        <p:sp>
          <p:nvSpPr>
            <p:cNvPr id="193" name="CasellaDiTesto 192">
              <a:extLst>
                <a:ext uri="{FF2B5EF4-FFF2-40B4-BE49-F238E27FC236}">
                  <a16:creationId xmlns:a16="http://schemas.microsoft.com/office/drawing/2014/main" id="{E91A7CCA-D491-4917-A284-28EE7196DE6D}"/>
                </a:ext>
              </a:extLst>
            </p:cNvPr>
            <p:cNvSpPr txBox="1"/>
            <p:nvPr/>
          </p:nvSpPr>
          <p:spPr>
            <a:xfrm>
              <a:off x="1177869" y="8422366"/>
              <a:ext cx="2504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+</a:t>
              </a:r>
            </a:p>
          </p:txBody>
        </p:sp>
        <p:sp>
          <p:nvSpPr>
            <p:cNvPr id="194" name="CasellaDiTesto 193">
              <a:extLst>
                <a:ext uri="{FF2B5EF4-FFF2-40B4-BE49-F238E27FC236}">
                  <a16:creationId xmlns:a16="http://schemas.microsoft.com/office/drawing/2014/main" id="{F3A27F4F-DC51-4694-87ED-11ABD125D200}"/>
                </a:ext>
              </a:extLst>
            </p:cNvPr>
            <p:cNvSpPr txBox="1"/>
            <p:nvPr/>
          </p:nvSpPr>
          <p:spPr>
            <a:xfrm>
              <a:off x="978912" y="7947044"/>
              <a:ext cx="5501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/>
                <a:t>HeLa</a:t>
              </a:r>
              <a:endParaRPr lang="it-IT" sz="1200" dirty="0"/>
            </a:p>
          </p:txBody>
        </p:sp>
        <p:sp>
          <p:nvSpPr>
            <p:cNvPr id="195" name="CasellaDiTesto 194">
              <a:extLst>
                <a:ext uri="{FF2B5EF4-FFF2-40B4-BE49-F238E27FC236}">
                  <a16:creationId xmlns:a16="http://schemas.microsoft.com/office/drawing/2014/main" id="{62F68469-E0F9-41CA-9CC3-CF3C904BEC10}"/>
                </a:ext>
              </a:extLst>
            </p:cNvPr>
            <p:cNvSpPr txBox="1"/>
            <p:nvPr/>
          </p:nvSpPr>
          <p:spPr>
            <a:xfrm>
              <a:off x="1457915" y="8422366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-</a:t>
              </a:r>
            </a:p>
          </p:txBody>
        </p:sp>
        <p:sp>
          <p:nvSpPr>
            <p:cNvPr id="196" name="CasellaDiTesto 195">
              <a:extLst>
                <a:ext uri="{FF2B5EF4-FFF2-40B4-BE49-F238E27FC236}">
                  <a16:creationId xmlns:a16="http://schemas.microsoft.com/office/drawing/2014/main" id="{2F36735B-17A9-41BB-895B-AB50A87B5C57}"/>
                </a:ext>
              </a:extLst>
            </p:cNvPr>
            <p:cNvSpPr txBox="1"/>
            <p:nvPr/>
          </p:nvSpPr>
          <p:spPr>
            <a:xfrm>
              <a:off x="1588356" y="8422366"/>
              <a:ext cx="2504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/>
                <a:t>+</a:t>
              </a:r>
            </a:p>
          </p:txBody>
        </p:sp>
        <p:sp>
          <p:nvSpPr>
            <p:cNvPr id="197" name="CasellaDiTesto 196">
              <a:extLst>
                <a:ext uri="{FF2B5EF4-FFF2-40B4-BE49-F238E27FC236}">
                  <a16:creationId xmlns:a16="http://schemas.microsoft.com/office/drawing/2014/main" id="{4DAD287D-E728-4828-9B93-D7C85129D613}"/>
                </a:ext>
              </a:extLst>
            </p:cNvPr>
            <p:cNvSpPr txBox="1"/>
            <p:nvPr/>
          </p:nvSpPr>
          <p:spPr>
            <a:xfrm>
              <a:off x="1301076" y="7143527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MCF-7</a:t>
              </a:r>
            </a:p>
          </p:txBody>
        </p:sp>
        <p:cxnSp>
          <p:nvCxnSpPr>
            <p:cNvPr id="198" name="Connettore diritto 197">
              <a:extLst>
                <a:ext uri="{FF2B5EF4-FFF2-40B4-BE49-F238E27FC236}">
                  <a16:creationId xmlns:a16="http://schemas.microsoft.com/office/drawing/2014/main" id="{C7568373-C7AF-4D7C-8927-DC90F76EFE16}"/>
                </a:ext>
              </a:extLst>
            </p:cNvPr>
            <p:cNvCxnSpPr>
              <a:cxnSpLocks/>
            </p:cNvCxnSpPr>
            <p:nvPr/>
          </p:nvCxnSpPr>
          <p:spPr>
            <a:xfrm>
              <a:off x="1521080" y="7404690"/>
              <a:ext cx="21433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9" name="Connettore diritto 198">
              <a:extLst>
                <a:ext uri="{FF2B5EF4-FFF2-40B4-BE49-F238E27FC236}">
                  <a16:creationId xmlns:a16="http://schemas.microsoft.com/office/drawing/2014/main" id="{E65CA244-A020-4F89-9A38-C8462FE3E2A3}"/>
                </a:ext>
              </a:extLst>
            </p:cNvPr>
            <p:cNvCxnSpPr>
              <a:cxnSpLocks/>
            </p:cNvCxnSpPr>
            <p:nvPr/>
          </p:nvCxnSpPr>
          <p:spPr>
            <a:xfrm>
              <a:off x="1939897" y="8007068"/>
              <a:ext cx="21433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0" name="Connettore diritto 199">
              <a:extLst>
                <a:ext uri="{FF2B5EF4-FFF2-40B4-BE49-F238E27FC236}">
                  <a16:creationId xmlns:a16="http://schemas.microsoft.com/office/drawing/2014/main" id="{1D054170-1036-4EA3-A662-46F0A9BEE234}"/>
                </a:ext>
              </a:extLst>
            </p:cNvPr>
            <p:cNvCxnSpPr>
              <a:cxnSpLocks/>
            </p:cNvCxnSpPr>
            <p:nvPr/>
          </p:nvCxnSpPr>
          <p:spPr>
            <a:xfrm>
              <a:off x="2364562" y="8156866"/>
              <a:ext cx="21433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1" name="Connettore diritto 200">
              <a:extLst>
                <a:ext uri="{FF2B5EF4-FFF2-40B4-BE49-F238E27FC236}">
                  <a16:creationId xmlns:a16="http://schemas.microsoft.com/office/drawing/2014/main" id="{3F8562DA-C7D5-4641-9FF1-169C08CBA121}"/>
                </a:ext>
              </a:extLst>
            </p:cNvPr>
            <p:cNvCxnSpPr>
              <a:cxnSpLocks/>
            </p:cNvCxnSpPr>
            <p:nvPr/>
          </p:nvCxnSpPr>
          <p:spPr>
            <a:xfrm>
              <a:off x="1122479" y="8160631"/>
              <a:ext cx="21433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02" name="Gruppo 201">
            <a:extLst>
              <a:ext uri="{FF2B5EF4-FFF2-40B4-BE49-F238E27FC236}">
                <a16:creationId xmlns:a16="http://schemas.microsoft.com/office/drawing/2014/main" id="{793F8F83-D844-4696-BA94-330A01405D41}"/>
              </a:ext>
            </a:extLst>
          </p:cNvPr>
          <p:cNvGrpSpPr/>
          <p:nvPr/>
        </p:nvGrpSpPr>
        <p:grpSpPr>
          <a:xfrm>
            <a:off x="994950" y="990391"/>
            <a:ext cx="1742236" cy="1169618"/>
            <a:chOff x="1033512" y="785504"/>
            <a:chExt cx="1742236" cy="1169618"/>
          </a:xfrm>
        </p:grpSpPr>
        <p:pic>
          <p:nvPicPr>
            <p:cNvPr id="203" name="Immagine 202">
              <a:extLst>
                <a:ext uri="{FF2B5EF4-FFF2-40B4-BE49-F238E27FC236}">
                  <a16:creationId xmlns:a16="http://schemas.microsoft.com/office/drawing/2014/main" id="{8453B090-7BAB-4F3C-921E-3E2A99E12B5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054411" y="1340776"/>
              <a:ext cx="1080000" cy="14173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04" name="CasellaDiTesto 203">
              <a:extLst>
                <a:ext uri="{FF2B5EF4-FFF2-40B4-BE49-F238E27FC236}">
                  <a16:creationId xmlns:a16="http://schemas.microsoft.com/office/drawing/2014/main" id="{DCA808C7-C71B-43F5-9A0D-A45FF2F99C50}"/>
                </a:ext>
              </a:extLst>
            </p:cNvPr>
            <p:cNvSpPr txBox="1"/>
            <p:nvPr/>
          </p:nvSpPr>
          <p:spPr>
            <a:xfrm>
              <a:off x="2143844" y="1708901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/>
                <a:t>Vinculin</a:t>
              </a:r>
              <a:endParaRPr lang="it-IT" sz="1000" dirty="0"/>
            </a:p>
          </p:txBody>
        </p:sp>
        <p:sp>
          <p:nvSpPr>
            <p:cNvPr id="205" name="CasellaDiTesto 204">
              <a:extLst>
                <a:ext uri="{FF2B5EF4-FFF2-40B4-BE49-F238E27FC236}">
                  <a16:creationId xmlns:a16="http://schemas.microsoft.com/office/drawing/2014/main" id="{9E321AAD-6460-40B4-B0CC-9CF91DCA7F77}"/>
                </a:ext>
              </a:extLst>
            </p:cNvPr>
            <p:cNvSpPr txBox="1"/>
            <p:nvPr/>
          </p:nvSpPr>
          <p:spPr>
            <a:xfrm>
              <a:off x="2143844" y="1305918"/>
              <a:ext cx="6046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IGF1-R</a:t>
              </a:r>
            </a:p>
          </p:txBody>
        </p:sp>
        <p:sp>
          <p:nvSpPr>
            <p:cNvPr id="206" name="CasellaDiTesto 205">
              <a:extLst>
                <a:ext uri="{FF2B5EF4-FFF2-40B4-BE49-F238E27FC236}">
                  <a16:creationId xmlns:a16="http://schemas.microsoft.com/office/drawing/2014/main" id="{8FA969DD-4B58-4B95-BAC6-A87FDD5589F2}"/>
                </a:ext>
              </a:extLst>
            </p:cNvPr>
            <p:cNvSpPr txBox="1"/>
            <p:nvPr/>
          </p:nvSpPr>
          <p:spPr>
            <a:xfrm>
              <a:off x="2143844" y="1500497"/>
              <a:ext cx="6030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FOXA1</a:t>
              </a:r>
            </a:p>
          </p:txBody>
        </p:sp>
        <p:sp>
          <p:nvSpPr>
            <p:cNvPr id="207" name="CasellaDiTesto 206">
              <a:extLst>
                <a:ext uri="{FF2B5EF4-FFF2-40B4-BE49-F238E27FC236}">
                  <a16:creationId xmlns:a16="http://schemas.microsoft.com/office/drawing/2014/main" id="{CB7A6E6E-AA2A-4A34-BE4D-0FD2810E3E2D}"/>
                </a:ext>
              </a:extLst>
            </p:cNvPr>
            <p:cNvSpPr txBox="1"/>
            <p:nvPr/>
          </p:nvSpPr>
          <p:spPr>
            <a:xfrm rot="16200000">
              <a:off x="912005" y="1027237"/>
              <a:ext cx="4892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err="1"/>
                <a:t>HeLa</a:t>
              </a:r>
              <a:endParaRPr lang="it-IT" sz="1000" dirty="0"/>
            </a:p>
          </p:txBody>
        </p:sp>
        <p:sp>
          <p:nvSpPr>
            <p:cNvPr id="208" name="CasellaDiTesto 207">
              <a:extLst>
                <a:ext uri="{FF2B5EF4-FFF2-40B4-BE49-F238E27FC236}">
                  <a16:creationId xmlns:a16="http://schemas.microsoft.com/office/drawing/2014/main" id="{0305B1D0-3CC2-45A9-B789-148C09980178}"/>
                </a:ext>
              </a:extLst>
            </p:cNvPr>
            <p:cNvSpPr txBox="1"/>
            <p:nvPr/>
          </p:nvSpPr>
          <p:spPr>
            <a:xfrm rot="16200000">
              <a:off x="1152994" y="967124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SKOV3</a:t>
              </a:r>
            </a:p>
          </p:txBody>
        </p:sp>
        <p:sp>
          <p:nvSpPr>
            <p:cNvPr id="209" name="CasellaDiTesto 208">
              <a:extLst>
                <a:ext uri="{FF2B5EF4-FFF2-40B4-BE49-F238E27FC236}">
                  <a16:creationId xmlns:a16="http://schemas.microsoft.com/office/drawing/2014/main" id="{A0F0CD7B-0DC7-4F8E-8997-E0F2A51AFD7E}"/>
                </a:ext>
              </a:extLst>
            </p:cNvPr>
            <p:cNvSpPr txBox="1"/>
            <p:nvPr/>
          </p:nvSpPr>
          <p:spPr>
            <a:xfrm rot="16200000">
              <a:off x="1454701" y="983154"/>
              <a:ext cx="5774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MCF-7</a:t>
              </a:r>
            </a:p>
          </p:txBody>
        </p:sp>
        <p:sp>
          <p:nvSpPr>
            <p:cNvPr id="210" name="CasellaDiTesto 209">
              <a:extLst>
                <a:ext uri="{FF2B5EF4-FFF2-40B4-BE49-F238E27FC236}">
                  <a16:creationId xmlns:a16="http://schemas.microsoft.com/office/drawing/2014/main" id="{B22B8FEE-8C4E-4415-AFF9-C95ADA6D4E8E}"/>
                </a:ext>
              </a:extLst>
            </p:cNvPr>
            <p:cNvSpPr txBox="1"/>
            <p:nvPr/>
          </p:nvSpPr>
          <p:spPr>
            <a:xfrm rot="16200000">
              <a:off x="1721151" y="970330"/>
              <a:ext cx="6030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SKBR3</a:t>
              </a:r>
            </a:p>
          </p:txBody>
        </p:sp>
        <p:pic>
          <p:nvPicPr>
            <p:cNvPr id="211" name="Immagine 210">
              <a:extLst>
                <a:ext uri="{FF2B5EF4-FFF2-40B4-BE49-F238E27FC236}">
                  <a16:creationId xmlns:a16="http://schemas.microsoft.com/office/drawing/2014/main" id="{3F09A956-F582-408E-85AF-6DDBFC8B2AD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054411" y="1752689"/>
              <a:ext cx="1080000" cy="14173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12" name="Immagine 211">
              <a:extLst>
                <a:ext uri="{FF2B5EF4-FFF2-40B4-BE49-F238E27FC236}">
                  <a16:creationId xmlns:a16="http://schemas.microsoft.com/office/drawing/2014/main" id="{AEB187C6-B6BA-4809-89F5-C2BF03D9294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054411" y="1544285"/>
              <a:ext cx="1080000" cy="14173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213" name="CasellaDiTesto 212">
            <a:extLst>
              <a:ext uri="{FF2B5EF4-FFF2-40B4-BE49-F238E27FC236}">
                <a16:creationId xmlns:a16="http://schemas.microsoft.com/office/drawing/2014/main" id="{F28BA8AA-D7EE-49F8-93D1-75E2EC8B2D89}"/>
              </a:ext>
            </a:extLst>
          </p:cNvPr>
          <p:cNvSpPr txBox="1"/>
          <p:nvPr/>
        </p:nvSpPr>
        <p:spPr>
          <a:xfrm>
            <a:off x="2240213" y="0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ementary</a:t>
            </a:r>
            <a:r>
              <a:rPr lang="it-IT" b="1" dirty="0"/>
              <a:t> Fig. </a:t>
            </a:r>
            <a:r>
              <a:rPr lang="it-IT" b="1"/>
              <a:t>9</a:t>
            </a:r>
            <a:endParaRPr lang="it-IT" b="1" dirty="0"/>
          </a:p>
        </p:txBody>
      </p:sp>
    </p:spTree>
    <p:extLst>
      <p:ext uri="{BB962C8B-B14F-4D97-AF65-F5344CB8AC3E}">
        <p14:creationId xmlns:p14="http://schemas.microsoft.com/office/powerpoint/2010/main" val="3258456422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97</TotalTime>
  <Words>1386</Words>
  <Application>Microsoft Office PowerPoint</Application>
  <PresentationFormat>Presentazione su schermo (4:3)</PresentationFormat>
  <Paragraphs>915</Paragraphs>
  <Slides>9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9</vt:i4>
      </vt:variant>
    </vt:vector>
  </HeadingPairs>
  <TitlesOfParts>
    <vt:vector size="13" baseType="lpstr">
      <vt:lpstr>Arial</vt:lpstr>
      <vt:lpstr>Calibri</vt:lpstr>
      <vt:lpstr>Times New Roman</vt:lpstr>
      <vt:lpstr>Default Design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ilippo Acconcia</dc:creator>
  <cp:lastModifiedBy>Filippo Acconcia</cp:lastModifiedBy>
  <cp:revision>618</cp:revision>
  <cp:lastPrinted>2016-12-30T08:51:21Z</cp:lastPrinted>
  <dcterms:created xsi:type="dcterms:W3CDTF">2014-12-18T14:53:45Z</dcterms:created>
  <dcterms:modified xsi:type="dcterms:W3CDTF">2022-08-03T13:31:23Z</dcterms:modified>
</cp:coreProperties>
</file>